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9"/>
  </p:notesMasterIdLst>
  <p:sldIdLst>
    <p:sldId id="266" r:id="rId2"/>
    <p:sldId id="268" r:id="rId3"/>
    <p:sldId id="267" r:id="rId4"/>
    <p:sldId id="269" r:id="rId5"/>
    <p:sldId id="270" r:id="rId6"/>
    <p:sldId id="271" r:id="rId7"/>
    <p:sldId id="273" r:id="rId8"/>
  </p:sldIdLst>
  <p:sldSz cx="7559675" cy="1069181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43">
          <p15:clr>
            <a:srgbClr val="A4A3A4"/>
          </p15:clr>
        </p15:guide>
        <p15:guide id="2" pos="4037">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8" roundtripDataSignature="AMtx7miL/I9Io1jsq2ZyYJBvHA7NIeErYw=="/>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Mark Dickman" initials="" lastIdx="1" clrIdx="0"/>
  <p:cmAuthor id="1" name="Sebastian J Ross" initials="" lastIdx="1"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5C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0C2AAF1B-B053-4F35-835D-4761A034671B}">
  <a:tblStyle styleId="{0C2AAF1B-B053-4F35-835D-4761A034671B}" styleName="Table_0">
    <a:wholeTbl>
      <a:tcTxStyle b="off" i="off">
        <a:font>
          <a:latin typeface="Arial"/>
          <a:ea typeface="Arial"/>
          <a:cs typeface="Arial"/>
        </a:font>
        <a:srgbClr val="000000"/>
      </a:tcTxStyle>
      <a:tcStyle>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 styleId="{BA7AE2D6-699B-43DD-B00F-7FBDF04C7672}" styleName="Table_1">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 styleId="{79560F37-4D0F-48B3-AAA8-2DC8544E5D9D}" styleName="Table_2">
    <a:wholeTbl>
      <a:tcTxStyle b="off" i="off">
        <a:font>
          <a:latin typeface="Calibri"/>
          <a:ea typeface="Calibri"/>
          <a:cs typeface="Calibri"/>
        </a:font>
        <a:schemeClr val="dk1"/>
      </a:tcTxStyle>
      <a:tcStyle>
        <a:tcBdr>
          <a:left>
            <a:ln w="12700" cap="flat" cmpd="sng">
              <a:solidFill>
                <a:schemeClr val="dk1"/>
              </a:solidFill>
              <a:prstDash val="solid"/>
              <a:round/>
              <a:headEnd type="none" w="sm" len="sm"/>
              <a:tailEnd type="none" w="sm" len="sm"/>
            </a:ln>
          </a:left>
          <a:right>
            <a:ln w="12700" cap="flat" cmpd="sng">
              <a:solidFill>
                <a:schemeClr val="dk1"/>
              </a:solidFill>
              <a:prstDash val="solid"/>
              <a:round/>
              <a:headEnd type="none" w="sm" len="sm"/>
              <a:tailEnd type="none" w="sm" len="sm"/>
            </a:ln>
          </a:right>
          <a:top>
            <a:ln w="12700" cap="flat" cmpd="sng">
              <a:solidFill>
                <a:schemeClr val="dk1"/>
              </a:solidFill>
              <a:prstDash val="solid"/>
              <a:round/>
              <a:headEnd type="none" w="sm" len="sm"/>
              <a:tailEnd type="none" w="sm" len="sm"/>
            </a:ln>
          </a:top>
          <a:bottom>
            <a:ln w="12700" cap="flat" cmpd="sng">
              <a:solidFill>
                <a:schemeClr val="dk1"/>
              </a:solidFill>
              <a:prstDash val="solid"/>
              <a:round/>
              <a:headEnd type="none" w="sm" len="sm"/>
              <a:tailEnd type="none" w="sm" len="sm"/>
            </a:ln>
          </a:bottom>
          <a:insideH>
            <a:ln w="12700" cap="flat" cmpd="sng">
              <a:solidFill>
                <a:schemeClr val="dk1"/>
              </a:solidFill>
              <a:prstDash val="solid"/>
              <a:round/>
              <a:headEnd type="none" w="sm" len="sm"/>
              <a:tailEnd type="none" w="sm" len="sm"/>
            </a:ln>
          </a:insideH>
          <a:insideV>
            <a:ln w="12700" cap="flat" cmpd="sng">
              <a:solidFill>
                <a:schemeClr val="dk1"/>
              </a:solidFill>
              <a:prstDash val="solid"/>
              <a:round/>
              <a:headEnd type="none" w="sm" len="sm"/>
              <a:tailEnd type="none" w="sm" len="sm"/>
            </a:ln>
          </a:insideV>
        </a:tcBdr>
        <a:fill>
          <a:solidFill>
            <a:srgbClr val="FFFFFF">
              <a:alpha val="0"/>
            </a:srgbClr>
          </a:solidFill>
        </a:fill>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741" autoAdjust="0"/>
    <p:restoredTop sz="94145" autoAdjust="0"/>
  </p:normalViewPr>
  <p:slideViewPr>
    <p:cSldViewPr snapToGrid="0">
      <p:cViewPr varScale="1">
        <p:scale>
          <a:sx n="41" d="100"/>
          <a:sy n="41" d="100"/>
        </p:scale>
        <p:origin x="1496" y="44"/>
      </p:cViewPr>
      <p:guideLst>
        <p:guide orient="horz" pos="2143"/>
        <p:guide pos="4037"/>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9" Type="http://schemas.openxmlformats.org/officeDocument/2006/relationships/commentAuthors" Target="commentAuthors.xml"/><Relationship Id="rId3" Type="http://schemas.openxmlformats.org/officeDocument/2006/relationships/slide" Target="slides/slide2.xml"/><Relationship Id="rId42" Type="http://schemas.openxmlformats.org/officeDocument/2006/relationships/theme" Target="theme/theme1.xml"/><Relationship Id="rId7" Type="http://schemas.openxmlformats.org/officeDocument/2006/relationships/slide" Target="slides/slide6.xml"/><Relationship Id="rId38" Type="http://customschemas.google.com/relationships/presentationmetadata" Target="metadata"/><Relationship Id="rId2" Type="http://schemas.openxmlformats.org/officeDocument/2006/relationships/slide" Target="slides/slide1.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40"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notesMaster" Target="notesMasters/notesMaster1.xml"/><Relationship Id="rId43"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GB"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6"/>
        <p:cNvGrpSpPr/>
        <p:nvPr/>
      </p:nvGrpSpPr>
      <p:grpSpPr>
        <a:xfrm>
          <a:off x="0" y="0"/>
          <a:ext cx="0" cy="0"/>
          <a:chOff x="0" y="0"/>
          <a:chExt cx="0" cy="0"/>
        </a:xfrm>
      </p:grpSpPr>
      <p:sp>
        <p:nvSpPr>
          <p:cNvPr id="1157" name="Google Shape;1157;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GB" b="1">
                <a:latin typeface="Arial"/>
                <a:ea typeface="Arial"/>
                <a:cs typeface="Arial"/>
                <a:sym typeface="Arial"/>
              </a:rPr>
              <a:t>Supplementary Figure 1.</a:t>
            </a:r>
            <a:r>
              <a:rPr lang="en-GB"/>
              <a:t> </a:t>
            </a:r>
            <a:r>
              <a:rPr lang="en-GB" b="1">
                <a:latin typeface="Arial"/>
                <a:ea typeface="Arial"/>
                <a:cs typeface="Arial"/>
                <a:sym typeface="Arial"/>
              </a:rPr>
              <a:t>Weak IP-RP HPLC chromatograms of GFP and βactin RNA extracts.</a:t>
            </a:r>
            <a:r>
              <a:rPr lang="en-GB">
                <a:latin typeface="Arial"/>
                <a:ea typeface="Arial"/>
                <a:cs typeface="Arial"/>
                <a:sym typeface="Arial"/>
              </a:rPr>
              <a:t> </a:t>
            </a:r>
            <a:r>
              <a:rPr lang="en-GB" b="1">
                <a:latin typeface="Arial"/>
                <a:ea typeface="Arial"/>
                <a:cs typeface="Arial"/>
                <a:sym typeface="Arial"/>
              </a:rPr>
              <a:t>A. </a:t>
            </a:r>
            <a:r>
              <a:rPr lang="en-GB">
                <a:latin typeface="Arial"/>
                <a:ea typeface="Arial"/>
                <a:cs typeface="Arial"/>
                <a:sym typeface="Arial"/>
              </a:rPr>
              <a:t>Weak IP-RP HPLC chromatography analysis of RNA extracts from pNT/1T/3T_GFP inductions in HT115 E.coli cells. RNA extractions were performed under non-denaturing conditions (-RNase T1) or RNase T1 digested. Non RNase T1 digested samples, indicated peaks for both the intended GFP dsRNA at approximately 12.5 mins, as well as two peaks for 16s and 23s rRNA at approximately, 9.7 to 10.2 mins, respectively. RNase T1 digested samples allowed absolute dsRNA quantification via nanadrop spectrometry. Here only the peak for the dsRNA is indicated again at approximately 8.8 mins. </a:t>
            </a:r>
            <a:r>
              <a:rPr lang="en-GB" b="1">
                <a:latin typeface="Arial"/>
                <a:ea typeface="Arial"/>
                <a:cs typeface="Arial"/>
                <a:sym typeface="Arial"/>
              </a:rPr>
              <a:t>B. </a:t>
            </a:r>
            <a:r>
              <a:rPr lang="en-GB">
                <a:latin typeface="Arial"/>
                <a:ea typeface="Arial"/>
                <a:cs typeface="Arial"/>
                <a:sym typeface="Arial"/>
              </a:rPr>
              <a:t>Weak IP-RP HPLC chromatography analysis of RNA extracts from pNT/3T_βactin inductions in HT115 E.coli cells. Non RNase T1 digested samples, indicated peaks for both the intended βactin dsRNA at approximately 12.75 to 13 mins, as well as two peaks for 16s and 23s rRNA at approximately, 9.5 to 10.0 mins, respectively. RNase T1 digested samples allowed absolute dsRNA quantification via nanadrop spectrometry. Here only the peak for the dsRNA is indicated again at approximately 13 mins. RNA samples NT-3T are colour coded and indicated in figure. Analysis was performed under native conditions (50 °C).Weak IP-RP: Buffer A, 100 mM triethylammonium acetate (TEAA) pH 7.0, Buffer B 0.1 M TEAA at pH 7.0 containing 25% acetonitrile.</a:t>
            </a:r>
            <a:endParaRPr/>
          </a:p>
        </p:txBody>
      </p:sp>
      <p:sp>
        <p:nvSpPr>
          <p:cNvPr id="1158" name="Google Shape;1158;p11:notes"/>
          <p:cNvSpPr>
            <a:spLocks noGrp="1" noRot="1" noChangeAspect="1"/>
          </p:cNvSpPr>
          <p:nvPr>
            <p:ph type="sldImg" idx="2"/>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5"/>
        <p:cNvGrpSpPr/>
        <p:nvPr/>
      </p:nvGrpSpPr>
      <p:grpSpPr>
        <a:xfrm>
          <a:off x="0" y="0"/>
          <a:ext cx="0" cy="0"/>
          <a:chOff x="0" y="0"/>
          <a:chExt cx="0" cy="0"/>
        </a:xfrm>
      </p:grpSpPr>
      <p:sp>
        <p:nvSpPr>
          <p:cNvPr id="1766" name="Google Shape;1766;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400"/>
              <a:buFont typeface="Arial"/>
              <a:buNone/>
            </a:pPr>
            <a:r>
              <a:rPr lang="en-GB" b="1">
                <a:latin typeface="Arial"/>
                <a:ea typeface="Arial"/>
                <a:cs typeface="Arial"/>
                <a:sym typeface="Arial"/>
              </a:rPr>
              <a:t>Supplementary figure 3.</a:t>
            </a:r>
            <a:r>
              <a:rPr lang="en-GB">
                <a:latin typeface="Arial"/>
                <a:ea typeface="Arial"/>
                <a:cs typeface="Arial"/>
                <a:sym typeface="Arial"/>
              </a:rPr>
              <a:t> </a:t>
            </a:r>
            <a:r>
              <a:rPr lang="en-GB" b="1">
                <a:latin typeface="Arial"/>
                <a:ea typeface="Arial"/>
                <a:cs typeface="Arial"/>
                <a:sym typeface="Arial"/>
              </a:rPr>
              <a:t>Schematic of linearised template and potential products produced via </a:t>
            </a:r>
            <a:r>
              <a:rPr lang="en-GB" b="1" i="1">
                <a:latin typeface="Arial"/>
                <a:ea typeface="Arial"/>
                <a:cs typeface="Arial"/>
                <a:sym typeface="Arial"/>
              </a:rPr>
              <a:t>In vitro</a:t>
            </a:r>
            <a:r>
              <a:rPr lang="en-GB" b="1">
                <a:latin typeface="Arial"/>
                <a:ea typeface="Arial"/>
                <a:cs typeface="Arial"/>
                <a:sym typeface="Arial"/>
              </a:rPr>
              <a:t> transcription. </a:t>
            </a:r>
            <a:r>
              <a:rPr lang="en-GB">
                <a:latin typeface="Arial"/>
                <a:ea typeface="Arial"/>
                <a:cs typeface="Arial"/>
                <a:sym typeface="Arial"/>
              </a:rPr>
              <a:t>RNA was synthesised using linearised pNT-4T_Dome11 templates via </a:t>
            </a:r>
            <a:r>
              <a:rPr lang="en-GB" i="1">
                <a:latin typeface="Arial"/>
                <a:ea typeface="Arial"/>
                <a:cs typeface="Arial"/>
                <a:sym typeface="Arial"/>
              </a:rPr>
              <a:t>In vitro</a:t>
            </a:r>
            <a:r>
              <a:rPr lang="en-GB">
                <a:latin typeface="Arial"/>
                <a:ea typeface="Arial"/>
                <a:cs typeface="Arial"/>
                <a:sym typeface="Arial"/>
              </a:rPr>
              <a:t> transcription. Templates were linearised within the ampicillin resistance gene located within the plasmid backbone. Four potential products are indicated in the schematic and the sizes depending on the number of transcriptional terminators, the potential sizes are as follows, 427 - 581 nts, 1318 - 1562 nts, and 1873 - 2632 nts. The key indicates the various components within the plasmids. </a:t>
            </a:r>
            <a:endParaRPr>
              <a:latin typeface="Arial"/>
              <a:ea typeface="Arial"/>
              <a:cs typeface="Arial"/>
              <a:sym typeface="Arial"/>
            </a:endParaRPr>
          </a:p>
        </p:txBody>
      </p:sp>
      <p:sp>
        <p:nvSpPr>
          <p:cNvPr id="1767" name="Google Shape;1767;p13:notes"/>
          <p:cNvSpPr>
            <a:spLocks noGrp="1" noRot="1" noChangeAspect="1"/>
          </p:cNvSpPr>
          <p:nvPr>
            <p:ph type="sldImg" idx="2"/>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1"/>
        <p:cNvGrpSpPr/>
        <p:nvPr/>
      </p:nvGrpSpPr>
      <p:grpSpPr>
        <a:xfrm>
          <a:off x="0" y="0"/>
          <a:ext cx="0" cy="0"/>
          <a:chOff x="0" y="0"/>
          <a:chExt cx="0" cy="0"/>
        </a:xfrm>
      </p:grpSpPr>
      <p:sp>
        <p:nvSpPr>
          <p:cNvPr id="1722" name="Google Shape;1722;p12:notes"/>
          <p:cNvSpPr>
            <a:spLocks noGrp="1" noRot="1" noChangeAspect="1"/>
          </p:cNvSpPr>
          <p:nvPr>
            <p:ph type="sldImg" idx="2"/>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23" name="Google Shape;1723;p1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GB" b="1" dirty="0">
                <a:latin typeface="Arial"/>
                <a:ea typeface="Arial"/>
                <a:cs typeface="Arial"/>
                <a:sym typeface="Arial"/>
              </a:rPr>
              <a:t>Supplementary figure 2. High resolution Ex-Gel agarose gel electrophoresis analysis</a:t>
            </a:r>
            <a:r>
              <a:rPr lang="en-GB" dirty="0">
                <a:latin typeface="Arial"/>
                <a:ea typeface="Arial"/>
                <a:cs typeface="Arial"/>
                <a:sym typeface="Arial"/>
              </a:rPr>
              <a:t>. </a:t>
            </a:r>
            <a:endParaRPr dirty="0">
              <a:latin typeface="Arial"/>
              <a:ea typeface="Arial"/>
              <a:cs typeface="Arial"/>
              <a:sym typeface="Arial"/>
            </a:endParaRPr>
          </a:p>
          <a:p>
            <a:pPr marL="0" lvl="0" indent="0" algn="l" rtl="0">
              <a:lnSpc>
                <a:spcPct val="100000"/>
              </a:lnSpc>
              <a:spcBef>
                <a:spcPts val="0"/>
              </a:spcBef>
              <a:spcAft>
                <a:spcPts val="0"/>
              </a:spcAft>
              <a:buSzPts val="1400"/>
              <a:buNone/>
            </a:pPr>
            <a:endParaRPr dirty="0">
              <a:latin typeface="Arial"/>
              <a:ea typeface="Arial"/>
              <a:cs typeface="Arial"/>
              <a:sym typeface="Arial"/>
            </a:endParaRPr>
          </a:p>
          <a:p>
            <a:pPr marL="0" lvl="0" indent="0" algn="l" rtl="0">
              <a:lnSpc>
                <a:spcPct val="100000"/>
              </a:lnSpc>
              <a:spcBef>
                <a:spcPts val="0"/>
              </a:spcBef>
              <a:spcAft>
                <a:spcPts val="0"/>
              </a:spcAft>
              <a:buSzPts val="1400"/>
              <a:buNone/>
            </a:pPr>
            <a:r>
              <a:rPr lang="en-GB" dirty="0">
                <a:latin typeface="Arial"/>
                <a:ea typeface="Arial"/>
                <a:cs typeface="Arial"/>
                <a:sym typeface="Arial"/>
              </a:rPr>
              <a:t>Analysis of RNA extracts from three separate inductions in HT115 E.coli cells transformed with DsRNA plasmids pNT-4T Dome11, pThyb6/10 Dome11.</a:t>
            </a:r>
            <a:r>
              <a:rPr lang="en-GB" baseline="0" dirty="0">
                <a:latin typeface="Arial"/>
                <a:ea typeface="Arial"/>
                <a:cs typeface="Arial"/>
                <a:sym typeface="Arial"/>
              </a:rPr>
              <a:t> </a:t>
            </a:r>
            <a:r>
              <a:rPr lang="en-GB" dirty="0">
                <a:latin typeface="Arial"/>
                <a:ea typeface="Arial"/>
                <a:cs typeface="Arial"/>
                <a:sym typeface="Arial"/>
              </a:rPr>
              <a:t>Three independent inductions were performed for each construct. RNA extractions were performed under non-denaturing conditions (-RNase T1) or RNase T1 digested.</a:t>
            </a:r>
            <a:endParaRPr dirty="0">
              <a:latin typeface="Arial"/>
              <a:ea typeface="Arial"/>
              <a:cs typeface="Arial"/>
              <a:sym typeface="Arial"/>
            </a:endParaRPr>
          </a:p>
          <a:p>
            <a:pPr marL="0" lvl="0" indent="0" algn="l" rtl="0">
              <a:lnSpc>
                <a:spcPct val="100000"/>
              </a:lnSpc>
              <a:spcBef>
                <a:spcPts val="0"/>
              </a:spcBef>
              <a:spcAft>
                <a:spcPts val="0"/>
              </a:spcAft>
              <a:buSzPts val="1400"/>
              <a:buNone/>
            </a:pPr>
            <a:r>
              <a:rPr lang="en-GB" b="1" dirty="0">
                <a:latin typeface="Arial"/>
                <a:ea typeface="Arial"/>
                <a:cs typeface="Arial"/>
                <a:sym typeface="Arial"/>
              </a:rPr>
              <a:t>A.</a:t>
            </a:r>
            <a:r>
              <a:rPr lang="en-GB" dirty="0">
                <a:latin typeface="Arial"/>
                <a:ea typeface="Arial"/>
                <a:cs typeface="Arial"/>
                <a:sym typeface="Arial"/>
              </a:rPr>
              <a:t> Agarose gel electrophoresis analysis of RNA extractions non denaturing conditions. Positive bands for production of Dome11 dsRNA is noted for in all constructs (~450 </a:t>
            </a:r>
            <a:r>
              <a:rPr lang="en-GB" dirty="0" err="1">
                <a:latin typeface="Arial"/>
                <a:ea typeface="Arial"/>
                <a:cs typeface="Arial"/>
                <a:sym typeface="Arial"/>
              </a:rPr>
              <a:t>bp</a:t>
            </a:r>
            <a:r>
              <a:rPr lang="en-GB" dirty="0">
                <a:latin typeface="Arial"/>
                <a:ea typeface="Arial"/>
                <a:cs typeface="Arial"/>
                <a:sym typeface="Arial"/>
              </a:rPr>
              <a:t>). Additional bands are noted for all terminated produced dsRNA, interestingly approximately the same amount of additional bands is noted for each sample, indicated a universal point for in vivo degradation of </a:t>
            </a:r>
            <a:r>
              <a:rPr lang="en-GB" dirty="0" err="1">
                <a:latin typeface="Arial"/>
                <a:ea typeface="Arial"/>
                <a:cs typeface="Arial"/>
                <a:sym typeface="Arial"/>
              </a:rPr>
              <a:t>ssRNA</a:t>
            </a:r>
            <a:r>
              <a:rPr lang="en-GB" dirty="0">
                <a:latin typeface="Arial"/>
                <a:ea typeface="Arial"/>
                <a:cs typeface="Arial"/>
                <a:sym typeface="Arial"/>
              </a:rPr>
              <a:t> overhangs. Bands are also observed for </a:t>
            </a:r>
            <a:r>
              <a:rPr lang="en-GB" dirty="0" err="1">
                <a:latin typeface="Arial"/>
                <a:ea typeface="Arial"/>
                <a:cs typeface="Arial"/>
                <a:sym typeface="Arial"/>
              </a:rPr>
              <a:t>rRNA</a:t>
            </a:r>
            <a:r>
              <a:rPr lang="en-GB" dirty="0">
                <a:latin typeface="Arial"/>
                <a:ea typeface="Arial"/>
                <a:cs typeface="Arial"/>
                <a:sym typeface="Arial"/>
              </a:rPr>
              <a:t> 16S and 23S at approximately (1500 </a:t>
            </a:r>
            <a:r>
              <a:rPr lang="en-GB" dirty="0" err="1">
                <a:latin typeface="Arial"/>
                <a:ea typeface="Arial"/>
                <a:cs typeface="Arial"/>
                <a:sym typeface="Arial"/>
              </a:rPr>
              <a:t>nt</a:t>
            </a:r>
            <a:r>
              <a:rPr lang="en-GB" dirty="0">
                <a:latin typeface="Arial"/>
                <a:ea typeface="Arial"/>
                <a:cs typeface="Arial"/>
                <a:sym typeface="Arial"/>
              </a:rPr>
              <a:t> to 2000 </a:t>
            </a:r>
            <a:r>
              <a:rPr lang="en-GB" dirty="0" err="1">
                <a:latin typeface="Arial"/>
                <a:ea typeface="Arial"/>
                <a:cs typeface="Arial"/>
                <a:sym typeface="Arial"/>
              </a:rPr>
              <a:t>nt</a:t>
            </a:r>
            <a:r>
              <a:rPr lang="en-GB" dirty="0">
                <a:latin typeface="Arial"/>
                <a:ea typeface="Arial"/>
                <a:cs typeface="Arial"/>
                <a:sym typeface="Arial"/>
              </a:rPr>
              <a:t>). </a:t>
            </a:r>
            <a:r>
              <a:rPr lang="en-GB" b="1" dirty="0">
                <a:latin typeface="Arial"/>
                <a:ea typeface="Arial"/>
                <a:cs typeface="Arial"/>
                <a:sym typeface="Arial"/>
              </a:rPr>
              <a:t>B. </a:t>
            </a:r>
            <a:r>
              <a:rPr lang="en-GB" dirty="0">
                <a:latin typeface="Arial"/>
                <a:ea typeface="Arial"/>
                <a:cs typeface="Arial"/>
                <a:sym typeface="Arial"/>
              </a:rPr>
              <a:t>Agarose gel electrophoresis analysis of RNA extractions non denaturing conditions including a RNase T1 digested 3T_D11 RNA extract. Positive bands for production of Dome11 dsRNA is noted for in all constructs. A reduction in intensity of </a:t>
            </a:r>
            <a:r>
              <a:rPr lang="en-GB" dirty="0" err="1">
                <a:latin typeface="Arial"/>
                <a:ea typeface="Arial"/>
                <a:cs typeface="Arial"/>
                <a:sym typeface="Arial"/>
              </a:rPr>
              <a:t>rRNA</a:t>
            </a:r>
            <a:r>
              <a:rPr lang="en-GB" dirty="0">
                <a:latin typeface="Arial"/>
                <a:ea typeface="Arial"/>
                <a:cs typeface="Arial"/>
                <a:sym typeface="Arial"/>
              </a:rPr>
              <a:t> and additional bands indicated dsRNA with </a:t>
            </a:r>
            <a:r>
              <a:rPr lang="en-GB" dirty="0" err="1">
                <a:latin typeface="Arial"/>
                <a:ea typeface="Arial"/>
                <a:cs typeface="Arial"/>
                <a:sym typeface="Arial"/>
              </a:rPr>
              <a:t>ssRNA</a:t>
            </a:r>
            <a:r>
              <a:rPr lang="en-GB" dirty="0">
                <a:latin typeface="Arial"/>
                <a:ea typeface="Arial"/>
                <a:cs typeface="Arial"/>
                <a:sym typeface="Arial"/>
              </a:rPr>
              <a:t> overhangs reduces upon the addition of transcriptional terminators, while the dsRNA Dome11 bands intensity increases. This is noted due to normalisation of sample quantity loaded (100 ng).Bands are also observed for </a:t>
            </a:r>
            <a:r>
              <a:rPr lang="en-GB" dirty="0" err="1">
                <a:latin typeface="Arial"/>
                <a:ea typeface="Arial"/>
                <a:cs typeface="Arial"/>
                <a:sym typeface="Arial"/>
              </a:rPr>
              <a:t>rRNA</a:t>
            </a:r>
            <a:r>
              <a:rPr lang="en-GB" dirty="0">
                <a:latin typeface="Arial"/>
                <a:ea typeface="Arial"/>
                <a:cs typeface="Arial"/>
                <a:sym typeface="Arial"/>
              </a:rPr>
              <a:t> 16S and 23S at approximately. </a:t>
            </a:r>
            <a:endParaRPr b="1" dirty="0">
              <a:latin typeface="Arial"/>
              <a:ea typeface="Arial"/>
              <a:cs typeface="Arial"/>
              <a:sym typeface="Arial"/>
            </a:endParaRPr>
          </a:p>
        </p:txBody>
      </p:sp>
      <p:sp>
        <p:nvSpPr>
          <p:cNvPr id="1724" name="Google Shape;1724;p12: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GB"/>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6"/>
        <p:cNvGrpSpPr/>
        <p:nvPr/>
      </p:nvGrpSpPr>
      <p:grpSpPr>
        <a:xfrm>
          <a:off x="0" y="0"/>
          <a:ext cx="0" cy="0"/>
          <a:chOff x="0" y="0"/>
          <a:chExt cx="0" cy="0"/>
        </a:xfrm>
      </p:grpSpPr>
      <p:sp>
        <p:nvSpPr>
          <p:cNvPr id="1877" name="Google Shape;1877;p14:notes"/>
          <p:cNvSpPr>
            <a:spLocks noGrp="1" noRot="1" noChangeAspect="1"/>
          </p:cNvSpPr>
          <p:nvPr>
            <p:ph type="sldImg" idx="2"/>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78" name="Google Shape;1878;p14: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GB" b="1"/>
              <a:t>Supplementary Figure XX – </a:t>
            </a:r>
            <a:r>
              <a:rPr lang="en-GB"/>
              <a:t>Expression Constructs for Short Model RNAs – Expression constructs designed to produce short model RNAs for intact mass spectrometry analysis. Constructs were designed to produce either a 50nt ssRNA (A) or 120bp dsRNA (B). Constructs were designed to include the ‘3T’ terminator combination (T7 S + </a:t>
            </a:r>
            <a:r>
              <a:rPr lang="en-GB" i="1"/>
              <a:t>rrnB</a:t>
            </a:r>
            <a:r>
              <a:rPr lang="en-GB" i="0"/>
              <a:t> T1 + T7 S) to gain mechanistic insight into transcriptional termination within these systems and the products they produce. </a:t>
            </a:r>
            <a:endParaRPr/>
          </a:p>
        </p:txBody>
      </p:sp>
      <p:sp>
        <p:nvSpPr>
          <p:cNvPr id="1879" name="Google Shape;1879;p14: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GB"/>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6"/>
        <p:cNvGrpSpPr/>
        <p:nvPr/>
      </p:nvGrpSpPr>
      <p:grpSpPr>
        <a:xfrm>
          <a:off x="0" y="0"/>
          <a:ext cx="0" cy="0"/>
          <a:chOff x="0" y="0"/>
          <a:chExt cx="0" cy="0"/>
        </a:xfrm>
      </p:grpSpPr>
      <p:sp>
        <p:nvSpPr>
          <p:cNvPr id="1887" name="Google Shape;1887;p16:notes"/>
          <p:cNvSpPr>
            <a:spLocks noGrp="1" noRot="1" noChangeAspect="1"/>
          </p:cNvSpPr>
          <p:nvPr>
            <p:ph type="sldImg" idx="2"/>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88" name="Google Shape;1888;p16: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GB" b="1"/>
              <a:t>Supplementary Figure XX – </a:t>
            </a:r>
            <a:r>
              <a:rPr lang="en-GB"/>
              <a:t>Mass Spectrometry Analysis of 50nt short ssRNA – (A) Representative MS spectra averaged across the peaks for the major RNA products. (B) Consensus deconvoluted spectrum generated using sliding windows and ReSpect™ algorithm</a:t>
            </a:r>
            <a:endParaRPr/>
          </a:p>
          <a:p>
            <a:pPr marL="0" lvl="0" indent="0" algn="l" rtl="0">
              <a:lnSpc>
                <a:spcPct val="100000"/>
              </a:lnSpc>
              <a:spcBef>
                <a:spcPts val="0"/>
              </a:spcBef>
              <a:spcAft>
                <a:spcPts val="0"/>
              </a:spcAft>
              <a:buSzPts val="1400"/>
              <a:buNone/>
            </a:pPr>
            <a:endParaRPr/>
          </a:p>
        </p:txBody>
      </p:sp>
      <p:sp>
        <p:nvSpPr>
          <p:cNvPr id="1889" name="Google Shape;1889;p16: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GB"/>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00"/>
        <p:cNvGrpSpPr/>
        <p:nvPr/>
      </p:nvGrpSpPr>
      <p:grpSpPr>
        <a:xfrm>
          <a:off x="0" y="0"/>
          <a:ext cx="0" cy="0"/>
          <a:chOff x="0" y="0"/>
          <a:chExt cx="0" cy="0"/>
        </a:xfrm>
      </p:grpSpPr>
      <p:sp>
        <p:nvSpPr>
          <p:cNvPr id="1901" name="Google Shape;1901;p17:notes"/>
          <p:cNvSpPr>
            <a:spLocks noGrp="1" noRot="1" noChangeAspect="1"/>
          </p:cNvSpPr>
          <p:nvPr>
            <p:ph type="sldImg" idx="2"/>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02" name="Google Shape;1902;p17: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GB" b="1"/>
              <a:t>Supplementary Figure XX – Mass Spectrometry Analysis of 120bp short dsRNA – </a:t>
            </a:r>
            <a:r>
              <a:rPr lang="en-GB"/>
              <a:t>(A) Representative MS spectra averaged across the peak for the major RNA product. (B) Representative deconvoluted spectrum generated using the ReSpect™ algorithm averaging across the major peak.</a:t>
            </a:r>
            <a:endParaRPr/>
          </a:p>
          <a:p>
            <a:pPr marL="0" lvl="0" indent="0" algn="l" rtl="0">
              <a:lnSpc>
                <a:spcPct val="100000"/>
              </a:lnSpc>
              <a:spcBef>
                <a:spcPts val="0"/>
              </a:spcBef>
              <a:spcAft>
                <a:spcPts val="0"/>
              </a:spcAft>
              <a:buSzPts val="1400"/>
              <a:buNone/>
            </a:pPr>
            <a:endParaRPr/>
          </a:p>
        </p:txBody>
      </p:sp>
      <p:sp>
        <p:nvSpPr>
          <p:cNvPr id="1903" name="Google Shape;1903;p17: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GB"/>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7"/>
        <p:cNvGrpSpPr/>
        <p:nvPr/>
      </p:nvGrpSpPr>
      <p:grpSpPr>
        <a:xfrm>
          <a:off x="0" y="0"/>
          <a:ext cx="0" cy="0"/>
          <a:chOff x="0" y="0"/>
          <a:chExt cx="0" cy="0"/>
        </a:xfrm>
      </p:grpSpPr>
      <p:sp>
        <p:nvSpPr>
          <p:cNvPr id="1918" name="Google Shape;1918;p19:notes"/>
          <p:cNvSpPr>
            <a:spLocks noGrp="1" noRot="1" noChangeAspect="1"/>
          </p:cNvSpPr>
          <p:nvPr>
            <p:ph type="sldImg" idx="2"/>
          </p:nvPr>
        </p:nvSpPr>
        <p:spPr>
          <a:xfrm>
            <a:off x="2338388" y="1143000"/>
            <a:ext cx="21812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19" name="Google Shape;1919;p19: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920" name="Google Shape;1920;p19: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GB"/>
              <a:t>7</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1"/>
        <p:cNvGrpSpPr/>
        <p:nvPr/>
      </p:nvGrpSpPr>
      <p:grpSpPr>
        <a:xfrm>
          <a:off x="0" y="0"/>
          <a:ext cx="0" cy="0"/>
          <a:chOff x="0" y="0"/>
          <a:chExt cx="0" cy="0"/>
        </a:xfrm>
      </p:grpSpPr>
      <p:sp>
        <p:nvSpPr>
          <p:cNvPr id="22" name="Google Shape;22;p29"/>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29"/>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4" name="Google Shape;24;p29"/>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42"/>
          <p:cNvSpPr txBox="1">
            <a:spLocks noGrp="1"/>
          </p:cNvSpPr>
          <p:nvPr>
            <p:ph type="title"/>
          </p:nvPr>
        </p:nvSpPr>
        <p:spPr>
          <a:xfrm rot="5400000">
            <a:off x="1694512" y="4284621"/>
            <a:ext cx="9060817" cy="163005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42"/>
          <p:cNvSpPr txBox="1">
            <a:spLocks noGrp="1"/>
          </p:cNvSpPr>
          <p:nvPr>
            <p:ph type="body" idx="1"/>
          </p:nvPr>
        </p:nvSpPr>
        <p:spPr>
          <a:xfrm rot="5400000">
            <a:off x="-1612846" y="2701814"/>
            <a:ext cx="9060817" cy="4795669"/>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81" name="Google Shape;81;p42"/>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42"/>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42"/>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5"/>
        <p:cNvGrpSpPr/>
        <p:nvPr/>
      </p:nvGrpSpPr>
      <p:grpSpPr>
        <a:xfrm>
          <a:off x="0" y="0"/>
          <a:ext cx="0" cy="0"/>
          <a:chOff x="0" y="0"/>
          <a:chExt cx="0" cy="0"/>
        </a:xfrm>
      </p:grpSpPr>
      <p:sp>
        <p:nvSpPr>
          <p:cNvPr id="26" name="Google Shape;26;p34"/>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7" name="Google Shape;27;p34"/>
          <p:cNvSpPr txBox="1">
            <a:spLocks noGrp="1"/>
          </p:cNvSpPr>
          <p:nvPr>
            <p:ph type="body" idx="1"/>
          </p:nvPr>
        </p:nvSpPr>
        <p:spPr>
          <a:xfrm>
            <a:off x="519728" y="2846200"/>
            <a:ext cx="6520220"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28" name="Google Shape;28;p34"/>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34"/>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0" name="Google Shape;30;p34"/>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1"/>
        <p:cNvGrpSpPr/>
        <p:nvPr/>
      </p:nvGrpSpPr>
      <p:grpSpPr>
        <a:xfrm>
          <a:off x="0" y="0"/>
          <a:ext cx="0" cy="0"/>
          <a:chOff x="0" y="0"/>
          <a:chExt cx="0" cy="0"/>
        </a:xfrm>
      </p:grpSpPr>
      <p:sp>
        <p:nvSpPr>
          <p:cNvPr id="32" name="Google Shape;32;p35"/>
          <p:cNvSpPr txBox="1">
            <a:spLocks noGrp="1"/>
          </p:cNvSpPr>
          <p:nvPr>
            <p:ph type="title"/>
          </p:nvPr>
        </p:nvSpPr>
        <p:spPr>
          <a:xfrm>
            <a:off x="515791" y="2665532"/>
            <a:ext cx="6520220" cy="444749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960"/>
              <a:buFont typeface="Calibri"/>
              <a:buNone/>
              <a:defRPr sz="496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3" name="Google Shape;33;p35"/>
          <p:cNvSpPr txBox="1">
            <a:spLocks noGrp="1"/>
          </p:cNvSpPr>
          <p:nvPr>
            <p:ph type="body" idx="1"/>
          </p:nvPr>
        </p:nvSpPr>
        <p:spPr>
          <a:xfrm>
            <a:off x="515791" y="7155103"/>
            <a:ext cx="6520220" cy="2338833"/>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984"/>
              <a:buNone/>
              <a:defRPr sz="1984">
                <a:solidFill>
                  <a:schemeClr val="dk1"/>
                </a:solidFill>
              </a:defRPr>
            </a:lvl1pPr>
            <a:lvl2pPr marL="914400" lvl="1" indent="-228600" algn="l">
              <a:lnSpc>
                <a:spcPct val="90000"/>
              </a:lnSpc>
              <a:spcBef>
                <a:spcPts val="413"/>
              </a:spcBef>
              <a:spcAft>
                <a:spcPts val="0"/>
              </a:spcAft>
              <a:buClr>
                <a:srgbClr val="888888"/>
              </a:buClr>
              <a:buSzPts val="1653"/>
              <a:buNone/>
              <a:defRPr sz="1653">
                <a:solidFill>
                  <a:srgbClr val="888888"/>
                </a:solidFill>
              </a:defRPr>
            </a:lvl2pPr>
            <a:lvl3pPr marL="1371600" lvl="2" indent="-228600" algn="l">
              <a:lnSpc>
                <a:spcPct val="90000"/>
              </a:lnSpc>
              <a:spcBef>
                <a:spcPts val="413"/>
              </a:spcBef>
              <a:spcAft>
                <a:spcPts val="0"/>
              </a:spcAft>
              <a:buClr>
                <a:srgbClr val="888888"/>
              </a:buClr>
              <a:buSzPts val="1488"/>
              <a:buNone/>
              <a:defRPr sz="1488">
                <a:solidFill>
                  <a:srgbClr val="888888"/>
                </a:solidFill>
              </a:defRPr>
            </a:lvl3pPr>
            <a:lvl4pPr marL="1828800" lvl="3" indent="-228600" algn="l">
              <a:lnSpc>
                <a:spcPct val="90000"/>
              </a:lnSpc>
              <a:spcBef>
                <a:spcPts val="413"/>
              </a:spcBef>
              <a:spcAft>
                <a:spcPts val="0"/>
              </a:spcAft>
              <a:buClr>
                <a:srgbClr val="888888"/>
              </a:buClr>
              <a:buSzPts val="1323"/>
              <a:buNone/>
              <a:defRPr sz="1323">
                <a:solidFill>
                  <a:srgbClr val="888888"/>
                </a:solidFill>
              </a:defRPr>
            </a:lvl4pPr>
            <a:lvl5pPr marL="2286000" lvl="4" indent="-228600" algn="l">
              <a:lnSpc>
                <a:spcPct val="90000"/>
              </a:lnSpc>
              <a:spcBef>
                <a:spcPts val="413"/>
              </a:spcBef>
              <a:spcAft>
                <a:spcPts val="0"/>
              </a:spcAft>
              <a:buClr>
                <a:srgbClr val="888888"/>
              </a:buClr>
              <a:buSzPts val="1323"/>
              <a:buNone/>
              <a:defRPr sz="1323">
                <a:solidFill>
                  <a:srgbClr val="888888"/>
                </a:solidFill>
              </a:defRPr>
            </a:lvl5pPr>
            <a:lvl6pPr marL="2743200" lvl="5" indent="-228600" algn="l">
              <a:lnSpc>
                <a:spcPct val="90000"/>
              </a:lnSpc>
              <a:spcBef>
                <a:spcPts val="413"/>
              </a:spcBef>
              <a:spcAft>
                <a:spcPts val="0"/>
              </a:spcAft>
              <a:buClr>
                <a:srgbClr val="888888"/>
              </a:buClr>
              <a:buSzPts val="1323"/>
              <a:buNone/>
              <a:defRPr sz="1323">
                <a:solidFill>
                  <a:srgbClr val="888888"/>
                </a:solidFill>
              </a:defRPr>
            </a:lvl6pPr>
            <a:lvl7pPr marL="3200400" lvl="6" indent="-228600" algn="l">
              <a:lnSpc>
                <a:spcPct val="90000"/>
              </a:lnSpc>
              <a:spcBef>
                <a:spcPts val="413"/>
              </a:spcBef>
              <a:spcAft>
                <a:spcPts val="0"/>
              </a:spcAft>
              <a:buClr>
                <a:srgbClr val="888888"/>
              </a:buClr>
              <a:buSzPts val="1323"/>
              <a:buNone/>
              <a:defRPr sz="1323">
                <a:solidFill>
                  <a:srgbClr val="888888"/>
                </a:solidFill>
              </a:defRPr>
            </a:lvl7pPr>
            <a:lvl8pPr marL="3657600" lvl="7" indent="-228600" algn="l">
              <a:lnSpc>
                <a:spcPct val="90000"/>
              </a:lnSpc>
              <a:spcBef>
                <a:spcPts val="413"/>
              </a:spcBef>
              <a:spcAft>
                <a:spcPts val="0"/>
              </a:spcAft>
              <a:buClr>
                <a:srgbClr val="888888"/>
              </a:buClr>
              <a:buSzPts val="1323"/>
              <a:buNone/>
              <a:defRPr sz="1323">
                <a:solidFill>
                  <a:srgbClr val="888888"/>
                </a:solidFill>
              </a:defRPr>
            </a:lvl8pPr>
            <a:lvl9pPr marL="4114800" lvl="8" indent="-228600" algn="l">
              <a:lnSpc>
                <a:spcPct val="90000"/>
              </a:lnSpc>
              <a:spcBef>
                <a:spcPts val="413"/>
              </a:spcBef>
              <a:spcAft>
                <a:spcPts val="0"/>
              </a:spcAft>
              <a:buClr>
                <a:srgbClr val="888888"/>
              </a:buClr>
              <a:buSzPts val="1323"/>
              <a:buNone/>
              <a:defRPr sz="1323">
                <a:solidFill>
                  <a:srgbClr val="888888"/>
                </a:solidFill>
              </a:defRPr>
            </a:lvl9pPr>
          </a:lstStyle>
          <a:p>
            <a:endParaRPr/>
          </a:p>
        </p:txBody>
      </p:sp>
      <p:sp>
        <p:nvSpPr>
          <p:cNvPr id="34" name="Google Shape;34;p35"/>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35"/>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6" name="Google Shape;36;p35"/>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7"/>
        <p:cNvGrpSpPr/>
        <p:nvPr/>
      </p:nvGrpSpPr>
      <p:grpSpPr>
        <a:xfrm>
          <a:off x="0" y="0"/>
          <a:ext cx="0" cy="0"/>
          <a:chOff x="0" y="0"/>
          <a:chExt cx="0" cy="0"/>
        </a:xfrm>
      </p:grpSpPr>
      <p:sp>
        <p:nvSpPr>
          <p:cNvPr id="38" name="Google Shape;38;p36"/>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36"/>
          <p:cNvSpPr txBox="1">
            <a:spLocks noGrp="1"/>
          </p:cNvSpPr>
          <p:nvPr>
            <p:ph type="body" idx="1"/>
          </p:nvPr>
        </p:nvSpPr>
        <p:spPr>
          <a:xfrm>
            <a:off x="519728" y="2846200"/>
            <a:ext cx="3212862"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0" name="Google Shape;40;p36"/>
          <p:cNvSpPr txBox="1">
            <a:spLocks noGrp="1"/>
          </p:cNvSpPr>
          <p:nvPr>
            <p:ph type="body" idx="2"/>
          </p:nvPr>
        </p:nvSpPr>
        <p:spPr>
          <a:xfrm>
            <a:off x="3827085" y="2846200"/>
            <a:ext cx="3212862"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1" name="Google Shape;41;p36"/>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36"/>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36"/>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37"/>
          <p:cNvSpPr txBox="1">
            <a:spLocks noGrp="1"/>
          </p:cNvSpPr>
          <p:nvPr>
            <p:ph type="title"/>
          </p:nvPr>
        </p:nvSpPr>
        <p:spPr>
          <a:xfrm>
            <a:off x="520712"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6" name="Google Shape;46;p37"/>
          <p:cNvSpPr txBox="1">
            <a:spLocks noGrp="1"/>
          </p:cNvSpPr>
          <p:nvPr>
            <p:ph type="body" idx="1"/>
          </p:nvPr>
        </p:nvSpPr>
        <p:spPr>
          <a:xfrm>
            <a:off x="520713" y="2620980"/>
            <a:ext cx="3198096" cy="128450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27"/>
              </a:spcBef>
              <a:spcAft>
                <a:spcPts val="0"/>
              </a:spcAft>
              <a:buClr>
                <a:schemeClr val="dk1"/>
              </a:buClr>
              <a:buSzPts val="1984"/>
              <a:buNone/>
              <a:defRPr sz="1984" b="1"/>
            </a:lvl1pPr>
            <a:lvl2pPr marL="914400" lvl="1" indent="-228600" algn="l">
              <a:lnSpc>
                <a:spcPct val="90000"/>
              </a:lnSpc>
              <a:spcBef>
                <a:spcPts val="413"/>
              </a:spcBef>
              <a:spcAft>
                <a:spcPts val="0"/>
              </a:spcAft>
              <a:buClr>
                <a:schemeClr val="dk1"/>
              </a:buClr>
              <a:buSzPts val="1653"/>
              <a:buNone/>
              <a:defRPr sz="1653" b="1"/>
            </a:lvl2pPr>
            <a:lvl3pPr marL="1371600" lvl="2" indent="-228600" algn="l">
              <a:lnSpc>
                <a:spcPct val="90000"/>
              </a:lnSpc>
              <a:spcBef>
                <a:spcPts val="413"/>
              </a:spcBef>
              <a:spcAft>
                <a:spcPts val="0"/>
              </a:spcAft>
              <a:buClr>
                <a:schemeClr val="dk1"/>
              </a:buClr>
              <a:buSzPts val="1488"/>
              <a:buNone/>
              <a:defRPr sz="1488" b="1"/>
            </a:lvl3pPr>
            <a:lvl4pPr marL="1828800" lvl="3" indent="-228600" algn="l">
              <a:lnSpc>
                <a:spcPct val="90000"/>
              </a:lnSpc>
              <a:spcBef>
                <a:spcPts val="413"/>
              </a:spcBef>
              <a:spcAft>
                <a:spcPts val="0"/>
              </a:spcAft>
              <a:buClr>
                <a:schemeClr val="dk1"/>
              </a:buClr>
              <a:buSzPts val="1323"/>
              <a:buNone/>
              <a:defRPr sz="1323" b="1"/>
            </a:lvl4pPr>
            <a:lvl5pPr marL="2286000" lvl="4" indent="-228600" algn="l">
              <a:lnSpc>
                <a:spcPct val="90000"/>
              </a:lnSpc>
              <a:spcBef>
                <a:spcPts val="413"/>
              </a:spcBef>
              <a:spcAft>
                <a:spcPts val="0"/>
              </a:spcAft>
              <a:buClr>
                <a:schemeClr val="dk1"/>
              </a:buClr>
              <a:buSzPts val="1323"/>
              <a:buNone/>
              <a:defRPr sz="1323" b="1"/>
            </a:lvl5pPr>
            <a:lvl6pPr marL="2743200" lvl="5" indent="-228600" algn="l">
              <a:lnSpc>
                <a:spcPct val="90000"/>
              </a:lnSpc>
              <a:spcBef>
                <a:spcPts val="413"/>
              </a:spcBef>
              <a:spcAft>
                <a:spcPts val="0"/>
              </a:spcAft>
              <a:buClr>
                <a:schemeClr val="dk1"/>
              </a:buClr>
              <a:buSzPts val="1323"/>
              <a:buNone/>
              <a:defRPr sz="1323" b="1"/>
            </a:lvl6pPr>
            <a:lvl7pPr marL="3200400" lvl="6" indent="-228600" algn="l">
              <a:lnSpc>
                <a:spcPct val="90000"/>
              </a:lnSpc>
              <a:spcBef>
                <a:spcPts val="413"/>
              </a:spcBef>
              <a:spcAft>
                <a:spcPts val="0"/>
              </a:spcAft>
              <a:buClr>
                <a:schemeClr val="dk1"/>
              </a:buClr>
              <a:buSzPts val="1323"/>
              <a:buNone/>
              <a:defRPr sz="1323" b="1"/>
            </a:lvl7pPr>
            <a:lvl8pPr marL="3657600" lvl="7" indent="-228600" algn="l">
              <a:lnSpc>
                <a:spcPct val="90000"/>
              </a:lnSpc>
              <a:spcBef>
                <a:spcPts val="413"/>
              </a:spcBef>
              <a:spcAft>
                <a:spcPts val="0"/>
              </a:spcAft>
              <a:buClr>
                <a:schemeClr val="dk1"/>
              </a:buClr>
              <a:buSzPts val="1323"/>
              <a:buNone/>
              <a:defRPr sz="1323" b="1"/>
            </a:lvl8pPr>
            <a:lvl9pPr marL="4114800" lvl="8" indent="-228600" algn="l">
              <a:lnSpc>
                <a:spcPct val="90000"/>
              </a:lnSpc>
              <a:spcBef>
                <a:spcPts val="413"/>
              </a:spcBef>
              <a:spcAft>
                <a:spcPts val="0"/>
              </a:spcAft>
              <a:buClr>
                <a:schemeClr val="dk1"/>
              </a:buClr>
              <a:buSzPts val="1323"/>
              <a:buNone/>
              <a:defRPr sz="1323" b="1"/>
            </a:lvl9pPr>
          </a:lstStyle>
          <a:p>
            <a:endParaRPr/>
          </a:p>
        </p:txBody>
      </p:sp>
      <p:sp>
        <p:nvSpPr>
          <p:cNvPr id="47" name="Google Shape;47;p37"/>
          <p:cNvSpPr txBox="1">
            <a:spLocks noGrp="1"/>
          </p:cNvSpPr>
          <p:nvPr>
            <p:ph type="body" idx="2"/>
          </p:nvPr>
        </p:nvSpPr>
        <p:spPr>
          <a:xfrm>
            <a:off x="520713" y="3905482"/>
            <a:ext cx="3198096" cy="574437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8" name="Google Shape;48;p37"/>
          <p:cNvSpPr txBox="1">
            <a:spLocks noGrp="1"/>
          </p:cNvSpPr>
          <p:nvPr>
            <p:ph type="body" idx="3"/>
          </p:nvPr>
        </p:nvSpPr>
        <p:spPr>
          <a:xfrm>
            <a:off x="3827086" y="2620980"/>
            <a:ext cx="3213847" cy="128450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27"/>
              </a:spcBef>
              <a:spcAft>
                <a:spcPts val="0"/>
              </a:spcAft>
              <a:buClr>
                <a:schemeClr val="dk1"/>
              </a:buClr>
              <a:buSzPts val="1984"/>
              <a:buNone/>
              <a:defRPr sz="1984" b="1"/>
            </a:lvl1pPr>
            <a:lvl2pPr marL="914400" lvl="1" indent="-228600" algn="l">
              <a:lnSpc>
                <a:spcPct val="90000"/>
              </a:lnSpc>
              <a:spcBef>
                <a:spcPts val="413"/>
              </a:spcBef>
              <a:spcAft>
                <a:spcPts val="0"/>
              </a:spcAft>
              <a:buClr>
                <a:schemeClr val="dk1"/>
              </a:buClr>
              <a:buSzPts val="1653"/>
              <a:buNone/>
              <a:defRPr sz="1653" b="1"/>
            </a:lvl2pPr>
            <a:lvl3pPr marL="1371600" lvl="2" indent="-228600" algn="l">
              <a:lnSpc>
                <a:spcPct val="90000"/>
              </a:lnSpc>
              <a:spcBef>
                <a:spcPts val="413"/>
              </a:spcBef>
              <a:spcAft>
                <a:spcPts val="0"/>
              </a:spcAft>
              <a:buClr>
                <a:schemeClr val="dk1"/>
              </a:buClr>
              <a:buSzPts val="1488"/>
              <a:buNone/>
              <a:defRPr sz="1488" b="1"/>
            </a:lvl3pPr>
            <a:lvl4pPr marL="1828800" lvl="3" indent="-228600" algn="l">
              <a:lnSpc>
                <a:spcPct val="90000"/>
              </a:lnSpc>
              <a:spcBef>
                <a:spcPts val="413"/>
              </a:spcBef>
              <a:spcAft>
                <a:spcPts val="0"/>
              </a:spcAft>
              <a:buClr>
                <a:schemeClr val="dk1"/>
              </a:buClr>
              <a:buSzPts val="1323"/>
              <a:buNone/>
              <a:defRPr sz="1323" b="1"/>
            </a:lvl4pPr>
            <a:lvl5pPr marL="2286000" lvl="4" indent="-228600" algn="l">
              <a:lnSpc>
                <a:spcPct val="90000"/>
              </a:lnSpc>
              <a:spcBef>
                <a:spcPts val="413"/>
              </a:spcBef>
              <a:spcAft>
                <a:spcPts val="0"/>
              </a:spcAft>
              <a:buClr>
                <a:schemeClr val="dk1"/>
              </a:buClr>
              <a:buSzPts val="1323"/>
              <a:buNone/>
              <a:defRPr sz="1323" b="1"/>
            </a:lvl5pPr>
            <a:lvl6pPr marL="2743200" lvl="5" indent="-228600" algn="l">
              <a:lnSpc>
                <a:spcPct val="90000"/>
              </a:lnSpc>
              <a:spcBef>
                <a:spcPts val="413"/>
              </a:spcBef>
              <a:spcAft>
                <a:spcPts val="0"/>
              </a:spcAft>
              <a:buClr>
                <a:schemeClr val="dk1"/>
              </a:buClr>
              <a:buSzPts val="1323"/>
              <a:buNone/>
              <a:defRPr sz="1323" b="1"/>
            </a:lvl6pPr>
            <a:lvl7pPr marL="3200400" lvl="6" indent="-228600" algn="l">
              <a:lnSpc>
                <a:spcPct val="90000"/>
              </a:lnSpc>
              <a:spcBef>
                <a:spcPts val="413"/>
              </a:spcBef>
              <a:spcAft>
                <a:spcPts val="0"/>
              </a:spcAft>
              <a:buClr>
                <a:schemeClr val="dk1"/>
              </a:buClr>
              <a:buSzPts val="1323"/>
              <a:buNone/>
              <a:defRPr sz="1323" b="1"/>
            </a:lvl7pPr>
            <a:lvl8pPr marL="3657600" lvl="7" indent="-228600" algn="l">
              <a:lnSpc>
                <a:spcPct val="90000"/>
              </a:lnSpc>
              <a:spcBef>
                <a:spcPts val="413"/>
              </a:spcBef>
              <a:spcAft>
                <a:spcPts val="0"/>
              </a:spcAft>
              <a:buClr>
                <a:schemeClr val="dk1"/>
              </a:buClr>
              <a:buSzPts val="1323"/>
              <a:buNone/>
              <a:defRPr sz="1323" b="1"/>
            </a:lvl8pPr>
            <a:lvl9pPr marL="4114800" lvl="8" indent="-228600" algn="l">
              <a:lnSpc>
                <a:spcPct val="90000"/>
              </a:lnSpc>
              <a:spcBef>
                <a:spcPts val="413"/>
              </a:spcBef>
              <a:spcAft>
                <a:spcPts val="0"/>
              </a:spcAft>
              <a:buClr>
                <a:schemeClr val="dk1"/>
              </a:buClr>
              <a:buSzPts val="1323"/>
              <a:buNone/>
              <a:defRPr sz="1323" b="1"/>
            </a:lvl9pPr>
          </a:lstStyle>
          <a:p>
            <a:endParaRPr/>
          </a:p>
        </p:txBody>
      </p:sp>
      <p:sp>
        <p:nvSpPr>
          <p:cNvPr id="49" name="Google Shape;49;p37"/>
          <p:cNvSpPr txBox="1">
            <a:spLocks noGrp="1"/>
          </p:cNvSpPr>
          <p:nvPr>
            <p:ph type="body" idx="4"/>
          </p:nvPr>
        </p:nvSpPr>
        <p:spPr>
          <a:xfrm>
            <a:off x="3827086" y="3905482"/>
            <a:ext cx="3213847" cy="574437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50" name="Google Shape;50;p37"/>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37"/>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37"/>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38"/>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5" name="Google Shape;55;p38"/>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38"/>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38"/>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39"/>
          <p:cNvSpPr txBox="1">
            <a:spLocks noGrp="1"/>
          </p:cNvSpPr>
          <p:nvPr>
            <p:ph type="title"/>
          </p:nvPr>
        </p:nvSpPr>
        <p:spPr>
          <a:xfrm>
            <a:off x="520712" y="712788"/>
            <a:ext cx="2438192"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645"/>
              <a:buFont typeface="Calibri"/>
              <a:buNone/>
              <a:defRPr sz="2645"/>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39"/>
          <p:cNvSpPr txBox="1">
            <a:spLocks noGrp="1"/>
          </p:cNvSpPr>
          <p:nvPr>
            <p:ph type="body" idx="1"/>
          </p:nvPr>
        </p:nvSpPr>
        <p:spPr>
          <a:xfrm>
            <a:off x="3213847" y="1539425"/>
            <a:ext cx="3827085" cy="7598117"/>
          </a:xfrm>
          <a:prstGeom prst="rect">
            <a:avLst/>
          </a:prstGeom>
          <a:noFill/>
          <a:ln>
            <a:noFill/>
          </a:ln>
        </p:spPr>
        <p:txBody>
          <a:bodyPr spcFirstLastPara="1" wrap="square" lIns="91425" tIns="45700" rIns="91425" bIns="45700" anchor="t" anchorCtr="0">
            <a:normAutofit/>
          </a:bodyPr>
          <a:lstStyle>
            <a:lvl1pPr marL="457200" lvl="0" indent="-396557" algn="l">
              <a:lnSpc>
                <a:spcPct val="90000"/>
              </a:lnSpc>
              <a:spcBef>
                <a:spcPts val="827"/>
              </a:spcBef>
              <a:spcAft>
                <a:spcPts val="0"/>
              </a:spcAft>
              <a:buClr>
                <a:schemeClr val="dk1"/>
              </a:buClr>
              <a:buSzPts val="2645"/>
              <a:buChar char="•"/>
              <a:defRPr sz="2645"/>
            </a:lvl1pPr>
            <a:lvl2pPr marL="914400" lvl="1" indent="-375602" algn="l">
              <a:lnSpc>
                <a:spcPct val="90000"/>
              </a:lnSpc>
              <a:spcBef>
                <a:spcPts val="413"/>
              </a:spcBef>
              <a:spcAft>
                <a:spcPts val="0"/>
              </a:spcAft>
              <a:buClr>
                <a:schemeClr val="dk1"/>
              </a:buClr>
              <a:buSzPts val="2315"/>
              <a:buChar char="•"/>
              <a:defRPr sz="2315"/>
            </a:lvl2pPr>
            <a:lvl3pPr marL="1371600" lvl="2" indent="-354583" algn="l">
              <a:lnSpc>
                <a:spcPct val="90000"/>
              </a:lnSpc>
              <a:spcBef>
                <a:spcPts val="413"/>
              </a:spcBef>
              <a:spcAft>
                <a:spcPts val="0"/>
              </a:spcAft>
              <a:buClr>
                <a:schemeClr val="dk1"/>
              </a:buClr>
              <a:buSzPts val="1984"/>
              <a:buChar char="•"/>
              <a:defRPr sz="1984"/>
            </a:lvl3pPr>
            <a:lvl4pPr marL="1828800" lvl="3" indent="-333565" algn="l">
              <a:lnSpc>
                <a:spcPct val="90000"/>
              </a:lnSpc>
              <a:spcBef>
                <a:spcPts val="413"/>
              </a:spcBef>
              <a:spcAft>
                <a:spcPts val="0"/>
              </a:spcAft>
              <a:buClr>
                <a:schemeClr val="dk1"/>
              </a:buClr>
              <a:buSzPts val="1653"/>
              <a:buChar char="•"/>
              <a:defRPr sz="1653"/>
            </a:lvl4pPr>
            <a:lvl5pPr marL="2286000" lvl="4" indent="-333565" algn="l">
              <a:lnSpc>
                <a:spcPct val="90000"/>
              </a:lnSpc>
              <a:spcBef>
                <a:spcPts val="413"/>
              </a:spcBef>
              <a:spcAft>
                <a:spcPts val="0"/>
              </a:spcAft>
              <a:buClr>
                <a:schemeClr val="dk1"/>
              </a:buClr>
              <a:buSzPts val="1653"/>
              <a:buChar char="•"/>
              <a:defRPr sz="1653"/>
            </a:lvl5pPr>
            <a:lvl6pPr marL="2743200" lvl="5" indent="-333565" algn="l">
              <a:lnSpc>
                <a:spcPct val="90000"/>
              </a:lnSpc>
              <a:spcBef>
                <a:spcPts val="413"/>
              </a:spcBef>
              <a:spcAft>
                <a:spcPts val="0"/>
              </a:spcAft>
              <a:buClr>
                <a:schemeClr val="dk1"/>
              </a:buClr>
              <a:buSzPts val="1653"/>
              <a:buChar char="•"/>
              <a:defRPr sz="1653"/>
            </a:lvl6pPr>
            <a:lvl7pPr marL="3200400" lvl="6" indent="-333565" algn="l">
              <a:lnSpc>
                <a:spcPct val="90000"/>
              </a:lnSpc>
              <a:spcBef>
                <a:spcPts val="413"/>
              </a:spcBef>
              <a:spcAft>
                <a:spcPts val="0"/>
              </a:spcAft>
              <a:buClr>
                <a:schemeClr val="dk1"/>
              </a:buClr>
              <a:buSzPts val="1653"/>
              <a:buChar char="•"/>
              <a:defRPr sz="1653"/>
            </a:lvl7pPr>
            <a:lvl8pPr marL="3657600" lvl="7" indent="-333565" algn="l">
              <a:lnSpc>
                <a:spcPct val="90000"/>
              </a:lnSpc>
              <a:spcBef>
                <a:spcPts val="413"/>
              </a:spcBef>
              <a:spcAft>
                <a:spcPts val="0"/>
              </a:spcAft>
              <a:buClr>
                <a:schemeClr val="dk1"/>
              </a:buClr>
              <a:buSzPts val="1653"/>
              <a:buChar char="•"/>
              <a:defRPr sz="1653"/>
            </a:lvl8pPr>
            <a:lvl9pPr marL="4114800" lvl="8" indent="-333565" algn="l">
              <a:lnSpc>
                <a:spcPct val="90000"/>
              </a:lnSpc>
              <a:spcBef>
                <a:spcPts val="413"/>
              </a:spcBef>
              <a:spcAft>
                <a:spcPts val="0"/>
              </a:spcAft>
              <a:buClr>
                <a:schemeClr val="dk1"/>
              </a:buClr>
              <a:buSzPts val="1653"/>
              <a:buChar char="•"/>
              <a:defRPr sz="1653"/>
            </a:lvl9pPr>
          </a:lstStyle>
          <a:p>
            <a:endParaRPr/>
          </a:p>
        </p:txBody>
      </p:sp>
      <p:sp>
        <p:nvSpPr>
          <p:cNvPr id="61" name="Google Shape;61;p39"/>
          <p:cNvSpPr txBox="1">
            <a:spLocks noGrp="1"/>
          </p:cNvSpPr>
          <p:nvPr>
            <p:ph type="body" idx="2"/>
          </p:nvPr>
        </p:nvSpPr>
        <p:spPr>
          <a:xfrm>
            <a:off x="520712" y="3207544"/>
            <a:ext cx="2438192" cy="594237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323"/>
              <a:buNone/>
              <a:defRPr sz="1323"/>
            </a:lvl1pPr>
            <a:lvl2pPr marL="914400" lvl="1" indent="-228600" algn="l">
              <a:lnSpc>
                <a:spcPct val="90000"/>
              </a:lnSpc>
              <a:spcBef>
                <a:spcPts val="413"/>
              </a:spcBef>
              <a:spcAft>
                <a:spcPts val="0"/>
              </a:spcAft>
              <a:buClr>
                <a:schemeClr val="dk1"/>
              </a:buClr>
              <a:buSzPts val="1157"/>
              <a:buNone/>
              <a:defRPr sz="1157"/>
            </a:lvl2pPr>
            <a:lvl3pPr marL="1371600" lvl="2" indent="-228600" algn="l">
              <a:lnSpc>
                <a:spcPct val="90000"/>
              </a:lnSpc>
              <a:spcBef>
                <a:spcPts val="413"/>
              </a:spcBef>
              <a:spcAft>
                <a:spcPts val="0"/>
              </a:spcAft>
              <a:buClr>
                <a:schemeClr val="dk1"/>
              </a:buClr>
              <a:buSzPts val="992"/>
              <a:buNone/>
              <a:defRPr sz="992"/>
            </a:lvl3pPr>
            <a:lvl4pPr marL="1828800" lvl="3" indent="-228600" algn="l">
              <a:lnSpc>
                <a:spcPct val="90000"/>
              </a:lnSpc>
              <a:spcBef>
                <a:spcPts val="413"/>
              </a:spcBef>
              <a:spcAft>
                <a:spcPts val="0"/>
              </a:spcAft>
              <a:buClr>
                <a:schemeClr val="dk1"/>
              </a:buClr>
              <a:buSzPts val="827"/>
              <a:buNone/>
              <a:defRPr sz="827"/>
            </a:lvl4pPr>
            <a:lvl5pPr marL="2286000" lvl="4" indent="-228600" algn="l">
              <a:lnSpc>
                <a:spcPct val="90000"/>
              </a:lnSpc>
              <a:spcBef>
                <a:spcPts val="413"/>
              </a:spcBef>
              <a:spcAft>
                <a:spcPts val="0"/>
              </a:spcAft>
              <a:buClr>
                <a:schemeClr val="dk1"/>
              </a:buClr>
              <a:buSzPts val="827"/>
              <a:buNone/>
              <a:defRPr sz="827"/>
            </a:lvl5pPr>
            <a:lvl6pPr marL="2743200" lvl="5" indent="-228600" algn="l">
              <a:lnSpc>
                <a:spcPct val="90000"/>
              </a:lnSpc>
              <a:spcBef>
                <a:spcPts val="413"/>
              </a:spcBef>
              <a:spcAft>
                <a:spcPts val="0"/>
              </a:spcAft>
              <a:buClr>
                <a:schemeClr val="dk1"/>
              </a:buClr>
              <a:buSzPts val="827"/>
              <a:buNone/>
              <a:defRPr sz="827"/>
            </a:lvl6pPr>
            <a:lvl7pPr marL="3200400" lvl="6" indent="-228600" algn="l">
              <a:lnSpc>
                <a:spcPct val="90000"/>
              </a:lnSpc>
              <a:spcBef>
                <a:spcPts val="413"/>
              </a:spcBef>
              <a:spcAft>
                <a:spcPts val="0"/>
              </a:spcAft>
              <a:buClr>
                <a:schemeClr val="dk1"/>
              </a:buClr>
              <a:buSzPts val="827"/>
              <a:buNone/>
              <a:defRPr sz="827"/>
            </a:lvl7pPr>
            <a:lvl8pPr marL="3657600" lvl="7" indent="-228600" algn="l">
              <a:lnSpc>
                <a:spcPct val="90000"/>
              </a:lnSpc>
              <a:spcBef>
                <a:spcPts val="413"/>
              </a:spcBef>
              <a:spcAft>
                <a:spcPts val="0"/>
              </a:spcAft>
              <a:buClr>
                <a:schemeClr val="dk1"/>
              </a:buClr>
              <a:buSzPts val="827"/>
              <a:buNone/>
              <a:defRPr sz="827"/>
            </a:lvl8pPr>
            <a:lvl9pPr marL="4114800" lvl="8" indent="-228600" algn="l">
              <a:lnSpc>
                <a:spcPct val="90000"/>
              </a:lnSpc>
              <a:spcBef>
                <a:spcPts val="413"/>
              </a:spcBef>
              <a:spcAft>
                <a:spcPts val="0"/>
              </a:spcAft>
              <a:buClr>
                <a:schemeClr val="dk1"/>
              </a:buClr>
              <a:buSzPts val="827"/>
              <a:buNone/>
              <a:defRPr sz="827"/>
            </a:lvl9pPr>
          </a:lstStyle>
          <a:p>
            <a:endParaRPr/>
          </a:p>
        </p:txBody>
      </p:sp>
      <p:sp>
        <p:nvSpPr>
          <p:cNvPr id="62" name="Google Shape;62;p39"/>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39"/>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39"/>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40"/>
          <p:cNvSpPr txBox="1">
            <a:spLocks noGrp="1"/>
          </p:cNvSpPr>
          <p:nvPr>
            <p:ph type="title"/>
          </p:nvPr>
        </p:nvSpPr>
        <p:spPr>
          <a:xfrm>
            <a:off x="520712" y="712788"/>
            <a:ext cx="2438192"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645"/>
              <a:buFont typeface="Calibri"/>
              <a:buNone/>
              <a:defRPr sz="2645"/>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40"/>
          <p:cNvSpPr>
            <a:spLocks noGrp="1"/>
          </p:cNvSpPr>
          <p:nvPr>
            <p:ph type="pic" idx="2"/>
          </p:nvPr>
        </p:nvSpPr>
        <p:spPr>
          <a:xfrm>
            <a:off x="3213847" y="1539425"/>
            <a:ext cx="3827085" cy="7598117"/>
          </a:xfrm>
          <a:prstGeom prst="rect">
            <a:avLst/>
          </a:prstGeom>
          <a:noFill/>
          <a:ln>
            <a:noFill/>
          </a:ln>
        </p:spPr>
      </p:sp>
      <p:sp>
        <p:nvSpPr>
          <p:cNvPr id="68" name="Google Shape;68;p40"/>
          <p:cNvSpPr txBox="1">
            <a:spLocks noGrp="1"/>
          </p:cNvSpPr>
          <p:nvPr>
            <p:ph type="body" idx="1"/>
          </p:nvPr>
        </p:nvSpPr>
        <p:spPr>
          <a:xfrm>
            <a:off x="520712" y="3207544"/>
            <a:ext cx="2438192" cy="594237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323"/>
              <a:buNone/>
              <a:defRPr sz="1323"/>
            </a:lvl1pPr>
            <a:lvl2pPr marL="914400" lvl="1" indent="-228600" algn="l">
              <a:lnSpc>
                <a:spcPct val="90000"/>
              </a:lnSpc>
              <a:spcBef>
                <a:spcPts val="413"/>
              </a:spcBef>
              <a:spcAft>
                <a:spcPts val="0"/>
              </a:spcAft>
              <a:buClr>
                <a:schemeClr val="dk1"/>
              </a:buClr>
              <a:buSzPts val="1157"/>
              <a:buNone/>
              <a:defRPr sz="1157"/>
            </a:lvl2pPr>
            <a:lvl3pPr marL="1371600" lvl="2" indent="-228600" algn="l">
              <a:lnSpc>
                <a:spcPct val="90000"/>
              </a:lnSpc>
              <a:spcBef>
                <a:spcPts val="413"/>
              </a:spcBef>
              <a:spcAft>
                <a:spcPts val="0"/>
              </a:spcAft>
              <a:buClr>
                <a:schemeClr val="dk1"/>
              </a:buClr>
              <a:buSzPts val="992"/>
              <a:buNone/>
              <a:defRPr sz="992"/>
            </a:lvl3pPr>
            <a:lvl4pPr marL="1828800" lvl="3" indent="-228600" algn="l">
              <a:lnSpc>
                <a:spcPct val="90000"/>
              </a:lnSpc>
              <a:spcBef>
                <a:spcPts val="413"/>
              </a:spcBef>
              <a:spcAft>
                <a:spcPts val="0"/>
              </a:spcAft>
              <a:buClr>
                <a:schemeClr val="dk1"/>
              </a:buClr>
              <a:buSzPts val="827"/>
              <a:buNone/>
              <a:defRPr sz="827"/>
            </a:lvl4pPr>
            <a:lvl5pPr marL="2286000" lvl="4" indent="-228600" algn="l">
              <a:lnSpc>
                <a:spcPct val="90000"/>
              </a:lnSpc>
              <a:spcBef>
                <a:spcPts val="413"/>
              </a:spcBef>
              <a:spcAft>
                <a:spcPts val="0"/>
              </a:spcAft>
              <a:buClr>
                <a:schemeClr val="dk1"/>
              </a:buClr>
              <a:buSzPts val="827"/>
              <a:buNone/>
              <a:defRPr sz="827"/>
            </a:lvl5pPr>
            <a:lvl6pPr marL="2743200" lvl="5" indent="-228600" algn="l">
              <a:lnSpc>
                <a:spcPct val="90000"/>
              </a:lnSpc>
              <a:spcBef>
                <a:spcPts val="413"/>
              </a:spcBef>
              <a:spcAft>
                <a:spcPts val="0"/>
              </a:spcAft>
              <a:buClr>
                <a:schemeClr val="dk1"/>
              </a:buClr>
              <a:buSzPts val="827"/>
              <a:buNone/>
              <a:defRPr sz="827"/>
            </a:lvl6pPr>
            <a:lvl7pPr marL="3200400" lvl="6" indent="-228600" algn="l">
              <a:lnSpc>
                <a:spcPct val="90000"/>
              </a:lnSpc>
              <a:spcBef>
                <a:spcPts val="413"/>
              </a:spcBef>
              <a:spcAft>
                <a:spcPts val="0"/>
              </a:spcAft>
              <a:buClr>
                <a:schemeClr val="dk1"/>
              </a:buClr>
              <a:buSzPts val="827"/>
              <a:buNone/>
              <a:defRPr sz="827"/>
            </a:lvl7pPr>
            <a:lvl8pPr marL="3657600" lvl="7" indent="-228600" algn="l">
              <a:lnSpc>
                <a:spcPct val="90000"/>
              </a:lnSpc>
              <a:spcBef>
                <a:spcPts val="413"/>
              </a:spcBef>
              <a:spcAft>
                <a:spcPts val="0"/>
              </a:spcAft>
              <a:buClr>
                <a:schemeClr val="dk1"/>
              </a:buClr>
              <a:buSzPts val="827"/>
              <a:buNone/>
              <a:defRPr sz="827"/>
            </a:lvl8pPr>
            <a:lvl9pPr marL="4114800" lvl="8" indent="-228600" algn="l">
              <a:lnSpc>
                <a:spcPct val="90000"/>
              </a:lnSpc>
              <a:spcBef>
                <a:spcPts val="413"/>
              </a:spcBef>
              <a:spcAft>
                <a:spcPts val="0"/>
              </a:spcAft>
              <a:buClr>
                <a:schemeClr val="dk1"/>
              </a:buClr>
              <a:buSzPts val="827"/>
              <a:buNone/>
              <a:defRPr sz="827"/>
            </a:lvl9pPr>
          </a:lstStyle>
          <a:p>
            <a:endParaRPr/>
          </a:p>
        </p:txBody>
      </p:sp>
      <p:sp>
        <p:nvSpPr>
          <p:cNvPr id="69" name="Google Shape;69;p40"/>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40"/>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40"/>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41"/>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41"/>
          <p:cNvSpPr txBox="1">
            <a:spLocks noGrp="1"/>
          </p:cNvSpPr>
          <p:nvPr>
            <p:ph type="body" idx="1"/>
          </p:nvPr>
        </p:nvSpPr>
        <p:spPr>
          <a:xfrm rot="5400000">
            <a:off x="387910" y="2978019"/>
            <a:ext cx="6783857" cy="652022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75" name="Google Shape;75;p41"/>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41"/>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41"/>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7"/>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637"/>
              <a:buFont typeface="Calibri"/>
              <a:buNone/>
              <a:defRPr sz="3637"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27"/>
          <p:cNvSpPr txBox="1">
            <a:spLocks noGrp="1"/>
          </p:cNvSpPr>
          <p:nvPr>
            <p:ph type="body" idx="1"/>
          </p:nvPr>
        </p:nvSpPr>
        <p:spPr>
          <a:xfrm>
            <a:off x="519728" y="2846200"/>
            <a:ext cx="6520220" cy="6783857"/>
          </a:xfrm>
          <a:prstGeom prst="rect">
            <a:avLst/>
          </a:prstGeom>
          <a:noFill/>
          <a:ln>
            <a:noFill/>
          </a:ln>
        </p:spPr>
        <p:txBody>
          <a:bodyPr spcFirstLastPara="1" wrap="square" lIns="91425" tIns="45700" rIns="91425" bIns="45700" anchor="t" anchorCtr="0">
            <a:normAutofit/>
          </a:bodyPr>
          <a:lstStyle>
            <a:lvl1pPr marL="457200" marR="0" lvl="0" indent="-375602" algn="l" rtl="0">
              <a:lnSpc>
                <a:spcPct val="90000"/>
              </a:lnSpc>
              <a:spcBef>
                <a:spcPts val="827"/>
              </a:spcBef>
              <a:spcAft>
                <a:spcPts val="0"/>
              </a:spcAft>
              <a:buClr>
                <a:schemeClr val="dk1"/>
              </a:buClr>
              <a:buSzPts val="2315"/>
              <a:buFont typeface="Arial"/>
              <a:buChar char="•"/>
              <a:defRPr sz="2315" b="0" i="0" u="none" strike="noStrike" cap="none">
                <a:solidFill>
                  <a:schemeClr val="dk1"/>
                </a:solidFill>
                <a:latin typeface="Calibri"/>
                <a:ea typeface="Calibri"/>
                <a:cs typeface="Calibri"/>
                <a:sym typeface="Calibri"/>
              </a:defRPr>
            </a:lvl1pPr>
            <a:lvl2pPr marL="914400" marR="0" lvl="1" indent="-354583" algn="l" rtl="0">
              <a:lnSpc>
                <a:spcPct val="90000"/>
              </a:lnSpc>
              <a:spcBef>
                <a:spcPts val="413"/>
              </a:spcBef>
              <a:spcAft>
                <a:spcPts val="0"/>
              </a:spcAft>
              <a:buClr>
                <a:schemeClr val="dk1"/>
              </a:buClr>
              <a:buSzPts val="1984"/>
              <a:buFont typeface="Arial"/>
              <a:buChar char="•"/>
              <a:defRPr sz="1984" b="0" i="0" u="none" strike="noStrike" cap="none">
                <a:solidFill>
                  <a:schemeClr val="dk1"/>
                </a:solidFill>
                <a:latin typeface="Calibri"/>
                <a:ea typeface="Calibri"/>
                <a:cs typeface="Calibri"/>
                <a:sym typeface="Calibri"/>
              </a:defRPr>
            </a:lvl2pPr>
            <a:lvl3pPr marL="1371600" marR="0" lvl="2" indent="-333565" algn="l" rtl="0">
              <a:lnSpc>
                <a:spcPct val="90000"/>
              </a:lnSpc>
              <a:spcBef>
                <a:spcPts val="413"/>
              </a:spcBef>
              <a:spcAft>
                <a:spcPts val="0"/>
              </a:spcAft>
              <a:buClr>
                <a:schemeClr val="dk1"/>
              </a:buClr>
              <a:buSzPts val="1653"/>
              <a:buFont typeface="Arial"/>
              <a:buChar char="•"/>
              <a:defRPr sz="1653" b="0" i="0" u="none" strike="noStrike" cap="none">
                <a:solidFill>
                  <a:schemeClr val="dk1"/>
                </a:solidFill>
                <a:latin typeface="Calibri"/>
                <a:ea typeface="Calibri"/>
                <a:cs typeface="Calibri"/>
                <a:sym typeface="Calibri"/>
              </a:defRPr>
            </a:lvl3pPr>
            <a:lvl4pPr marL="1828800" marR="0" lvl="3"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4pPr>
            <a:lvl5pPr marL="2286000" marR="0" lvl="4"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5pPr>
            <a:lvl6pPr marL="2743200" marR="0" lvl="5"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6pPr>
            <a:lvl7pPr marL="3200400" marR="0" lvl="6"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7pPr>
            <a:lvl8pPr marL="3657600" marR="0" lvl="7"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8pPr>
            <a:lvl9pPr marL="4114800" marR="0" lvl="8"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9pPr>
          </a:lstStyle>
          <a:p>
            <a:endParaRPr/>
          </a:p>
        </p:txBody>
      </p:sp>
      <p:sp>
        <p:nvSpPr>
          <p:cNvPr id="12" name="Google Shape;12;p27"/>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92"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27"/>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992"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27"/>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GB"/>
              <a:t>‹#›</a:t>
            </a:fld>
            <a:endParaRPr/>
          </a:p>
        </p:txBody>
      </p:sp>
    </p:spTree>
  </p:cSld>
  <p:clrMap bg1="lt1" tx1="dk1" bg2="dk2" tx2="lt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1.xml"/><Relationship Id="rId4" Type="http://schemas.openxmlformats.org/officeDocument/2006/relationships/image" Target="../media/image9.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159"/>
        <p:cNvGrpSpPr/>
        <p:nvPr/>
      </p:nvGrpSpPr>
      <p:grpSpPr>
        <a:xfrm>
          <a:off x="0" y="0"/>
          <a:ext cx="0" cy="0"/>
          <a:chOff x="0" y="0"/>
          <a:chExt cx="0" cy="0"/>
        </a:xfrm>
      </p:grpSpPr>
      <p:grpSp>
        <p:nvGrpSpPr>
          <p:cNvPr id="1160" name="Google Shape;1160;p11"/>
          <p:cNvGrpSpPr/>
          <p:nvPr/>
        </p:nvGrpSpPr>
        <p:grpSpPr>
          <a:xfrm>
            <a:off x="132574" y="309281"/>
            <a:ext cx="7007814" cy="8923551"/>
            <a:chOff x="-15343" y="23232"/>
            <a:chExt cx="7081267" cy="10085970"/>
          </a:xfrm>
        </p:grpSpPr>
        <p:grpSp>
          <p:nvGrpSpPr>
            <p:cNvPr id="1161" name="Google Shape;1161;p11"/>
            <p:cNvGrpSpPr/>
            <p:nvPr/>
          </p:nvGrpSpPr>
          <p:grpSpPr>
            <a:xfrm>
              <a:off x="376783" y="4986540"/>
              <a:ext cx="6606754" cy="2292882"/>
              <a:chOff x="1845463" y="1681723"/>
              <a:chExt cx="8466939" cy="4314795"/>
            </a:xfrm>
          </p:grpSpPr>
          <p:grpSp>
            <p:nvGrpSpPr>
              <p:cNvPr id="1162" name="Google Shape;1162;p11"/>
              <p:cNvGrpSpPr/>
              <p:nvPr/>
            </p:nvGrpSpPr>
            <p:grpSpPr>
              <a:xfrm>
                <a:off x="1845463" y="1702329"/>
                <a:ext cx="8466939" cy="4294189"/>
                <a:chOff x="1193" y="1195"/>
                <a:chExt cx="5336" cy="2705"/>
              </a:xfrm>
            </p:grpSpPr>
            <p:cxnSp>
              <p:nvCxnSpPr>
                <p:cNvPr id="1163" name="Google Shape;1163;p11"/>
                <p:cNvCxnSpPr/>
                <p:nvPr/>
              </p:nvCxnSpPr>
              <p:spPr>
                <a:xfrm>
                  <a:off x="1453" y="3741"/>
                  <a:ext cx="4960" cy="0"/>
                </a:xfrm>
                <a:prstGeom prst="straightConnector1">
                  <a:avLst/>
                </a:prstGeom>
                <a:noFill/>
                <a:ln w="9525" cap="flat" cmpd="sng">
                  <a:solidFill>
                    <a:srgbClr val="000000"/>
                  </a:solidFill>
                  <a:prstDash val="solid"/>
                  <a:round/>
                  <a:headEnd type="none" w="sm" len="sm"/>
                  <a:tailEnd type="none" w="sm" len="sm"/>
                </a:ln>
              </p:spPr>
            </p:cxnSp>
            <p:cxnSp>
              <p:nvCxnSpPr>
                <p:cNvPr id="1164" name="Google Shape;1164;p11"/>
                <p:cNvCxnSpPr/>
                <p:nvPr/>
              </p:nvCxnSpPr>
              <p:spPr>
                <a:xfrm>
                  <a:off x="1453" y="3741"/>
                  <a:ext cx="0" cy="15"/>
                </a:xfrm>
                <a:prstGeom prst="straightConnector1">
                  <a:avLst/>
                </a:prstGeom>
                <a:noFill/>
                <a:ln w="9525" cap="flat" cmpd="sng">
                  <a:solidFill>
                    <a:srgbClr val="000000"/>
                  </a:solidFill>
                  <a:prstDash val="solid"/>
                  <a:round/>
                  <a:headEnd type="none" w="sm" len="sm"/>
                  <a:tailEnd type="none" w="sm" len="sm"/>
                </a:ln>
              </p:spPr>
            </p:cxnSp>
            <p:sp>
              <p:nvSpPr>
                <p:cNvPr id="1165" name="Google Shape;1165;p11"/>
                <p:cNvSpPr/>
                <p:nvPr/>
              </p:nvSpPr>
              <p:spPr>
                <a:xfrm>
                  <a:off x="1413" y="3754"/>
                  <a:ext cx="12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4.5</a:t>
                  </a:r>
                  <a:endParaRPr sz="800" b="0" i="0" u="none" strike="noStrike" cap="none">
                    <a:solidFill>
                      <a:srgbClr val="000000"/>
                    </a:solidFill>
                    <a:latin typeface="Arial"/>
                    <a:ea typeface="Arial"/>
                    <a:cs typeface="Arial"/>
                    <a:sym typeface="Arial"/>
                  </a:endParaRPr>
                </a:p>
              </p:txBody>
            </p:sp>
            <p:cxnSp>
              <p:nvCxnSpPr>
                <p:cNvPr id="1166" name="Google Shape;1166;p11"/>
                <p:cNvCxnSpPr/>
                <p:nvPr/>
              </p:nvCxnSpPr>
              <p:spPr>
                <a:xfrm>
                  <a:off x="1453" y="3741"/>
                  <a:ext cx="0" cy="9"/>
                </a:xfrm>
                <a:prstGeom prst="straightConnector1">
                  <a:avLst/>
                </a:prstGeom>
                <a:noFill/>
                <a:ln w="9525" cap="flat" cmpd="sng">
                  <a:solidFill>
                    <a:srgbClr val="000000"/>
                  </a:solidFill>
                  <a:prstDash val="solid"/>
                  <a:round/>
                  <a:headEnd type="none" w="sm" len="sm"/>
                  <a:tailEnd type="none" w="sm" len="sm"/>
                </a:ln>
              </p:spPr>
            </p:cxnSp>
            <p:cxnSp>
              <p:nvCxnSpPr>
                <p:cNvPr id="1167" name="Google Shape;1167;p11"/>
                <p:cNvCxnSpPr/>
                <p:nvPr/>
              </p:nvCxnSpPr>
              <p:spPr>
                <a:xfrm>
                  <a:off x="1566" y="3741"/>
                  <a:ext cx="0" cy="9"/>
                </a:xfrm>
                <a:prstGeom prst="straightConnector1">
                  <a:avLst/>
                </a:prstGeom>
                <a:noFill/>
                <a:ln w="9525" cap="flat" cmpd="sng">
                  <a:solidFill>
                    <a:srgbClr val="000000"/>
                  </a:solidFill>
                  <a:prstDash val="solid"/>
                  <a:round/>
                  <a:headEnd type="none" w="sm" len="sm"/>
                  <a:tailEnd type="none" w="sm" len="sm"/>
                </a:ln>
              </p:spPr>
            </p:cxnSp>
            <p:cxnSp>
              <p:nvCxnSpPr>
                <p:cNvPr id="1168" name="Google Shape;1168;p11"/>
                <p:cNvCxnSpPr/>
                <p:nvPr/>
              </p:nvCxnSpPr>
              <p:spPr>
                <a:xfrm>
                  <a:off x="1679" y="3741"/>
                  <a:ext cx="0" cy="15"/>
                </a:xfrm>
                <a:prstGeom prst="straightConnector1">
                  <a:avLst/>
                </a:prstGeom>
                <a:noFill/>
                <a:ln w="9525" cap="flat" cmpd="sng">
                  <a:solidFill>
                    <a:srgbClr val="000000"/>
                  </a:solidFill>
                  <a:prstDash val="solid"/>
                  <a:round/>
                  <a:headEnd type="none" w="sm" len="sm"/>
                  <a:tailEnd type="none" w="sm" len="sm"/>
                </a:ln>
              </p:spPr>
            </p:cxnSp>
            <p:sp>
              <p:nvSpPr>
                <p:cNvPr id="1169" name="Google Shape;1169;p11"/>
                <p:cNvSpPr/>
                <p:nvPr/>
              </p:nvSpPr>
              <p:spPr>
                <a:xfrm>
                  <a:off x="1639" y="3754"/>
                  <a:ext cx="12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5.0</a:t>
                  </a:r>
                  <a:endParaRPr sz="800" b="0" i="0" u="none" strike="noStrike" cap="none">
                    <a:solidFill>
                      <a:srgbClr val="000000"/>
                    </a:solidFill>
                    <a:latin typeface="Arial"/>
                    <a:ea typeface="Arial"/>
                    <a:cs typeface="Arial"/>
                    <a:sym typeface="Arial"/>
                  </a:endParaRPr>
                </a:p>
              </p:txBody>
            </p:sp>
            <p:cxnSp>
              <p:nvCxnSpPr>
                <p:cNvPr id="1170" name="Google Shape;1170;p11"/>
                <p:cNvCxnSpPr/>
                <p:nvPr/>
              </p:nvCxnSpPr>
              <p:spPr>
                <a:xfrm>
                  <a:off x="1791" y="3741"/>
                  <a:ext cx="0" cy="9"/>
                </a:xfrm>
                <a:prstGeom prst="straightConnector1">
                  <a:avLst/>
                </a:prstGeom>
                <a:noFill/>
                <a:ln w="9525" cap="flat" cmpd="sng">
                  <a:solidFill>
                    <a:srgbClr val="000000"/>
                  </a:solidFill>
                  <a:prstDash val="solid"/>
                  <a:round/>
                  <a:headEnd type="none" w="sm" len="sm"/>
                  <a:tailEnd type="none" w="sm" len="sm"/>
                </a:ln>
              </p:spPr>
            </p:cxnSp>
            <p:cxnSp>
              <p:nvCxnSpPr>
                <p:cNvPr id="1171" name="Google Shape;1171;p11"/>
                <p:cNvCxnSpPr/>
                <p:nvPr/>
              </p:nvCxnSpPr>
              <p:spPr>
                <a:xfrm>
                  <a:off x="1904" y="3741"/>
                  <a:ext cx="0" cy="9"/>
                </a:xfrm>
                <a:prstGeom prst="straightConnector1">
                  <a:avLst/>
                </a:prstGeom>
                <a:noFill/>
                <a:ln w="9525" cap="flat" cmpd="sng">
                  <a:solidFill>
                    <a:srgbClr val="000000"/>
                  </a:solidFill>
                  <a:prstDash val="solid"/>
                  <a:round/>
                  <a:headEnd type="none" w="sm" len="sm"/>
                  <a:tailEnd type="none" w="sm" len="sm"/>
                </a:ln>
              </p:spPr>
            </p:cxnSp>
            <p:cxnSp>
              <p:nvCxnSpPr>
                <p:cNvPr id="1172" name="Google Shape;1172;p11"/>
                <p:cNvCxnSpPr/>
                <p:nvPr/>
              </p:nvCxnSpPr>
              <p:spPr>
                <a:xfrm>
                  <a:off x="2017" y="3741"/>
                  <a:ext cx="0" cy="9"/>
                </a:xfrm>
                <a:prstGeom prst="straightConnector1">
                  <a:avLst/>
                </a:prstGeom>
                <a:noFill/>
                <a:ln w="9525" cap="flat" cmpd="sng">
                  <a:solidFill>
                    <a:srgbClr val="000000"/>
                  </a:solidFill>
                  <a:prstDash val="solid"/>
                  <a:round/>
                  <a:headEnd type="none" w="sm" len="sm"/>
                  <a:tailEnd type="none" w="sm" len="sm"/>
                </a:ln>
              </p:spPr>
            </p:cxnSp>
            <p:cxnSp>
              <p:nvCxnSpPr>
                <p:cNvPr id="1173" name="Google Shape;1173;p11"/>
                <p:cNvCxnSpPr/>
                <p:nvPr/>
              </p:nvCxnSpPr>
              <p:spPr>
                <a:xfrm>
                  <a:off x="2130" y="3741"/>
                  <a:ext cx="0" cy="15"/>
                </a:xfrm>
                <a:prstGeom prst="straightConnector1">
                  <a:avLst/>
                </a:prstGeom>
                <a:noFill/>
                <a:ln w="9525" cap="flat" cmpd="sng">
                  <a:solidFill>
                    <a:srgbClr val="000000"/>
                  </a:solidFill>
                  <a:prstDash val="solid"/>
                  <a:round/>
                  <a:headEnd type="none" w="sm" len="sm"/>
                  <a:tailEnd type="none" w="sm" len="sm"/>
                </a:ln>
              </p:spPr>
            </p:cxnSp>
            <p:sp>
              <p:nvSpPr>
                <p:cNvPr id="1174" name="Google Shape;1174;p11"/>
                <p:cNvSpPr/>
                <p:nvPr/>
              </p:nvSpPr>
              <p:spPr>
                <a:xfrm>
                  <a:off x="2089" y="3754"/>
                  <a:ext cx="12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6.0</a:t>
                  </a:r>
                  <a:endParaRPr sz="800" b="0" i="0" u="none" strike="noStrike" cap="none">
                    <a:solidFill>
                      <a:srgbClr val="000000"/>
                    </a:solidFill>
                    <a:latin typeface="Arial"/>
                    <a:ea typeface="Arial"/>
                    <a:cs typeface="Arial"/>
                    <a:sym typeface="Arial"/>
                  </a:endParaRPr>
                </a:p>
              </p:txBody>
            </p:sp>
            <p:cxnSp>
              <p:nvCxnSpPr>
                <p:cNvPr id="1175" name="Google Shape;1175;p11"/>
                <p:cNvCxnSpPr/>
                <p:nvPr/>
              </p:nvCxnSpPr>
              <p:spPr>
                <a:xfrm>
                  <a:off x="2242" y="3741"/>
                  <a:ext cx="0" cy="9"/>
                </a:xfrm>
                <a:prstGeom prst="straightConnector1">
                  <a:avLst/>
                </a:prstGeom>
                <a:noFill/>
                <a:ln w="9525" cap="flat" cmpd="sng">
                  <a:solidFill>
                    <a:srgbClr val="000000"/>
                  </a:solidFill>
                  <a:prstDash val="solid"/>
                  <a:round/>
                  <a:headEnd type="none" w="sm" len="sm"/>
                  <a:tailEnd type="none" w="sm" len="sm"/>
                </a:ln>
              </p:spPr>
            </p:cxnSp>
            <p:cxnSp>
              <p:nvCxnSpPr>
                <p:cNvPr id="1176" name="Google Shape;1176;p11"/>
                <p:cNvCxnSpPr/>
                <p:nvPr/>
              </p:nvCxnSpPr>
              <p:spPr>
                <a:xfrm>
                  <a:off x="2355" y="3741"/>
                  <a:ext cx="0" cy="9"/>
                </a:xfrm>
                <a:prstGeom prst="straightConnector1">
                  <a:avLst/>
                </a:prstGeom>
                <a:noFill/>
                <a:ln w="9525" cap="flat" cmpd="sng">
                  <a:solidFill>
                    <a:srgbClr val="000000"/>
                  </a:solidFill>
                  <a:prstDash val="solid"/>
                  <a:round/>
                  <a:headEnd type="none" w="sm" len="sm"/>
                  <a:tailEnd type="none" w="sm" len="sm"/>
                </a:ln>
              </p:spPr>
            </p:cxnSp>
            <p:cxnSp>
              <p:nvCxnSpPr>
                <p:cNvPr id="1177" name="Google Shape;1177;p11"/>
                <p:cNvCxnSpPr/>
                <p:nvPr/>
              </p:nvCxnSpPr>
              <p:spPr>
                <a:xfrm>
                  <a:off x="2468" y="3741"/>
                  <a:ext cx="0" cy="9"/>
                </a:xfrm>
                <a:prstGeom prst="straightConnector1">
                  <a:avLst/>
                </a:prstGeom>
                <a:noFill/>
                <a:ln w="9525" cap="flat" cmpd="sng">
                  <a:solidFill>
                    <a:srgbClr val="000000"/>
                  </a:solidFill>
                  <a:prstDash val="solid"/>
                  <a:round/>
                  <a:headEnd type="none" w="sm" len="sm"/>
                  <a:tailEnd type="none" w="sm" len="sm"/>
                </a:ln>
              </p:spPr>
            </p:cxnSp>
            <p:cxnSp>
              <p:nvCxnSpPr>
                <p:cNvPr id="1178" name="Google Shape;1178;p11"/>
                <p:cNvCxnSpPr/>
                <p:nvPr/>
              </p:nvCxnSpPr>
              <p:spPr>
                <a:xfrm>
                  <a:off x="2581" y="3741"/>
                  <a:ext cx="0" cy="15"/>
                </a:xfrm>
                <a:prstGeom prst="straightConnector1">
                  <a:avLst/>
                </a:prstGeom>
                <a:noFill/>
                <a:ln w="9525" cap="flat" cmpd="sng">
                  <a:solidFill>
                    <a:srgbClr val="000000"/>
                  </a:solidFill>
                  <a:prstDash val="solid"/>
                  <a:round/>
                  <a:headEnd type="none" w="sm" len="sm"/>
                  <a:tailEnd type="none" w="sm" len="sm"/>
                </a:ln>
              </p:spPr>
            </p:cxnSp>
            <p:sp>
              <p:nvSpPr>
                <p:cNvPr id="1179" name="Google Shape;1179;p11"/>
                <p:cNvSpPr/>
                <p:nvPr/>
              </p:nvSpPr>
              <p:spPr>
                <a:xfrm>
                  <a:off x="2540" y="3754"/>
                  <a:ext cx="12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7.0</a:t>
                  </a:r>
                  <a:endParaRPr sz="800" b="0" i="0" u="none" strike="noStrike" cap="none">
                    <a:solidFill>
                      <a:srgbClr val="000000"/>
                    </a:solidFill>
                    <a:latin typeface="Arial"/>
                    <a:ea typeface="Arial"/>
                    <a:cs typeface="Arial"/>
                    <a:sym typeface="Arial"/>
                  </a:endParaRPr>
                </a:p>
              </p:txBody>
            </p:sp>
            <p:cxnSp>
              <p:nvCxnSpPr>
                <p:cNvPr id="1180" name="Google Shape;1180;p11"/>
                <p:cNvCxnSpPr/>
                <p:nvPr/>
              </p:nvCxnSpPr>
              <p:spPr>
                <a:xfrm>
                  <a:off x="2693" y="3741"/>
                  <a:ext cx="0" cy="9"/>
                </a:xfrm>
                <a:prstGeom prst="straightConnector1">
                  <a:avLst/>
                </a:prstGeom>
                <a:noFill/>
                <a:ln w="9525" cap="flat" cmpd="sng">
                  <a:solidFill>
                    <a:srgbClr val="000000"/>
                  </a:solidFill>
                  <a:prstDash val="solid"/>
                  <a:round/>
                  <a:headEnd type="none" w="sm" len="sm"/>
                  <a:tailEnd type="none" w="sm" len="sm"/>
                </a:ln>
              </p:spPr>
            </p:cxnSp>
            <p:cxnSp>
              <p:nvCxnSpPr>
                <p:cNvPr id="1181" name="Google Shape;1181;p11"/>
                <p:cNvCxnSpPr/>
                <p:nvPr/>
              </p:nvCxnSpPr>
              <p:spPr>
                <a:xfrm>
                  <a:off x="2806" y="3741"/>
                  <a:ext cx="0" cy="9"/>
                </a:xfrm>
                <a:prstGeom prst="straightConnector1">
                  <a:avLst/>
                </a:prstGeom>
                <a:noFill/>
                <a:ln w="9525" cap="flat" cmpd="sng">
                  <a:solidFill>
                    <a:srgbClr val="000000"/>
                  </a:solidFill>
                  <a:prstDash val="solid"/>
                  <a:round/>
                  <a:headEnd type="none" w="sm" len="sm"/>
                  <a:tailEnd type="none" w="sm" len="sm"/>
                </a:ln>
              </p:spPr>
            </p:cxnSp>
            <p:cxnSp>
              <p:nvCxnSpPr>
                <p:cNvPr id="1182" name="Google Shape;1182;p11"/>
                <p:cNvCxnSpPr/>
                <p:nvPr/>
              </p:nvCxnSpPr>
              <p:spPr>
                <a:xfrm>
                  <a:off x="2919" y="3741"/>
                  <a:ext cx="0" cy="9"/>
                </a:xfrm>
                <a:prstGeom prst="straightConnector1">
                  <a:avLst/>
                </a:prstGeom>
                <a:noFill/>
                <a:ln w="9525" cap="flat" cmpd="sng">
                  <a:solidFill>
                    <a:srgbClr val="000000"/>
                  </a:solidFill>
                  <a:prstDash val="solid"/>
                  <a:round/>
                  <a:headEnd type="none" w="sm" len="sm"/>
                  <a:tailEnd type="none" w="sm" len="sm"/>
                </a:ln>
              </p:spPr>
            </p:cxnSp>
            <p:cxnSp>
              <p:nvCxnSpPr>
                <p:cNvPr id="1183" name="Google Shape;1183;p11"/>
                <p:cNvCxnSpPr/>
                <p:nvPr/>
              </p:nvCxnSpPr>
              <p:spPr>
                <a:xfrm>
                  <a:off x="3032" y="3741"/>
                  <a:ext cx="0" cy="15"/>
                </a:xfrm>
                <a:prstGeom prst="straightConnector1">
                  <a:avLst/>
                </a:prstGeom>
                <a:noFill/>
                <a:ln w="9525" cap="flat" cmpd="sng">
                  <a:solidFill>
                    <a:srgbClr val="000000"/>
                  </a:solidFill>
                  <a:prstDash val="solid"/>
                  <a:round/>
                  <a:headEnd type="none" w="sm" len="sm"/>
                  <a:tailEnd type="none" w="sm" len="sm"/>
                </a:ln>
              </p:spPr>
            </p:cxnSp>
            <p:sp>
              <p:nvSpPr>
                <p:cNvPr id="1184" name="Google Shape;1184;p11"/>
                <p:cNvSpPr/>
                <p:nvPr/>
              </p:nvSpPr>
              <p:spPr>
                <a:xfrm>
                  <a:off x="2991" y="3754"/>
                  <a:ext cx="12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8.0</a:t>
                  </a:r>
                  <a:endParaRPr sz="800" b="0" i="0" u="none" strike="noStrike" cap="none">
                    <a:solidFill>
                      <a:srgbClr val="000000"/>
                    </a:solidFill>
                    <a:latin typeface="Arial"/>
                    <a:ea typeface="Arial"/>
                    <a:cs typeface="Arial"/>
                    <a:sym typeface="Arial"/>
                  </a:endParaRPr>
                </a:p>
              </p:txBody>
            </p:sp>
            <p:cxnSp>
              <p:nvCxnSpPr>
                <p:cNvPr id="1185" name="Google Shape;1185;p11"/>
                <p:cNvCxnSpPr/>
                <p:nvPr/>
              </p:nvCxnSpPr>
              <p:spPr>
                <a:xfrm>
                  <a:off x="3144" y="3741"/>
                  <a:ext cx="0" cy="9"/>
                </a:xfrm>
                <a:prstGeom prst="straightConnector1">
                  <a:avLst/>
                </a:prstGeom>
                <a:noFill/>
                <a:ln w="9525" cap="flat" cmpd="sng">
                  <a:solidFill>
                    <a:srgbClr val="000000"/>
                  </a:solidFill>
                  <a:prstDash val="solid"/>
                  <a:round/>
                  <a:headEnd type="none" w="sm" len="sm"/>
                  <a:tailEnd type="none" w="sm" len="sm"/>
                </a:ln>
              </p:spPr>
            </p:cxnSp>
            <p:cxnSp>
              <p:nvCxnSpPr>
                <p:cNvPr id="1186" name="Google Shape;1186;p11"/>
                <p:cNvCxnSpPr/>
                <p:nvPr/>
              </p:nvCxnSpPr>
              <p:spPr>
                <a:xfrm>
                  <a:off x="3257" y="3741"/>
                  <a:ext cx="0" cy="9"/>
                </a:xfrm>
                <a:prstGeom prst="straightConnector1">
                  <a:avLst/>
                </a:prstGeom>
                <a:noFill/>
                <a:ln w="9525" cap="flat" cmpd="sng">
                  <a:solidFill>
                    <a:srgbClr val="000000"/>
                  </a:solidFill>
                  <a:prstDash val="solid"/>
                  <a:round/>
                  <a:headEnd type="none" w="sm" len="sm"/>
                  <a:tailEnd type="none" w="sm" len="sm"/>
                </a:ln>
              </p:spPr>
            </p:cxnSp>
            <p:cxnSp>
              <p:nvCxnSpPr>
                <p:cNvPr id="1187" name="Google Shape;1187;p11"/>
                <p:cNvCxnSpPr/>
                <p:nvPr/>
              </p:nvCxnSpPr>
              <p:spPr>
                <a:xfrm>
                  <a:off x="3370" y="3741"/>
                  <a:ext cx="0" cy="9"/>
                </a:xfrm>
                <a:prstGeom prst="straightConnector1">
                  <a:avLst/>
                </a:prstGeom>
                <a:noFill/>
                <a:ln w="9525" cap="flat" cmpd="sng">
                  <a:solidFill>
                    <a:srgbClr val="000000"/>
                  </a:solidFill>
                  <a:prstDash val="solid"/>
                  <a:round/>
                  <a:headEnd type="none" w="sm" len="sm"/>
                  <a:tailEnd type="none" w="sm" len="sm"/>
                </a:ln>
              </p:spPr>
            </p:cxnSp>
            <p:cxnSp>
              <p:nvCxnSpPr>
                <p:cNvPr id="1188" name="Google Shape;1188;p11"/>
                <p:cNvCxnSpPr/>
                <p:nvPr/>
              </p:nvCxnSpPr>
              <p:spPr>
                <a:xfrm>
                  <a:off x="3483" y="3741"/>
                  <a:ext cx="0" cy="15"/>
                </a:xfrm>
                <a:prstGeom prst="straightConnector1">
                  <a:avLst/>
                </a:prstGeom>
                <a:noFill/>
                <a:ln w="9525" cap="flat" cmpd="sng">
                  <a:solidFill>
                    <a:srgbClr val="000000"/>
                  </a:solidFill>
                  <a:prstDash val="solid"/>
                  <a:round/>
                  <a:headEnd type="none" w="sm" len="sm"/>
                  <a:tailEnd type="none" w="sm" len="sm"/>
                </a:ln>
              </p:spPr>
            </p:cxnSp>
            <p:sp>
              <p:nvSpPr>
                <p:cNvPr id="1189" name="Google Shape;1189;p11"/>
                <p:cNvSpPr/>
                <p:nvPr/>
              </p:nvSpPr>
              <p:spPr>
                <a:xfrm>
                  <a:off x="3442" y="3754"/>
                  <a:ext cx="12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9.0</a:t>
                  </a:r>
                  <a:endParaRPr sz="800" b="0" i="0" u="none" strike="noStrike" cap="none">
                    <a:solidFill>
                      <a:srgbClr val="000000"/>
                    </a:solidFill>
                    <a:latin typeface="Arial"/>
                    <a:ea typeface="Arial"/>
                    <a:cs typeface="Arial"/>
                    <a:sym typeface="Arial"/>
                  </a:endParaRPr>
                </a:p>
              </p:txBody>
            </p:sp>
            <p:cxnSp>
              <p:nvCxnSpPr>
                <p:cNvPr id="1190" name="Google Shape;1190;p11"/>
                <p:cNvCxnSpPr/>
                <p:nvPr/>
              </p:nvCxnSpPr>
              <p:spPr>
                <a:xfrm>
                  <a:off x="3595" y="3741"/>
                  <a:ext cx="0" cy="9"/>
                </a:xfrm>
                <a:prstGeom prst="straightConnector1">
                  <a:avLst/>
                </a:prstGeom>
                <a:noFill/>
                <a:ln w="9525" cap="flat" cmpd="sng">
                  <a:solidFill>
                    <a:srgbClr val="000000"/>
                  </a:solidFill>
                  <a:prstDash val="solid"/>
                  <a:round/>
                  <a:headEnd type="none" w="sm" len="sm"/>
                  <a:tailEnd type="none" w="sm" len="sm"/>
                </a:ln>
              </p:spPr>
            </p:cxnSp>
            <p:cxnSp>
              <p:nvCxnSpPr>
                <p:cNvPr id="1191" name="Google Shape;1191;p11"/>
                <p:cNvCxnSpPr/>
                <p:nvPr/>
              </p:nvCxnSpPr>
              <p:spPr>
                <a:xfrm>
                  <a:off x="3708" y="3741"/>
                  <a:ext cx="0" cy="9"/>
                </a:xfrm>
                <a:prstGeom prst="straightConnector1">
                  <a:avLst/>
                </a:prstGeom>
                <a:noFill/>
                <a:ln w="9525" cap="flat" cmpd="sng">
                  <a:solidFill>
                    <a:srgbClr val="000000"/>
                  </a:solidFill>
                  <a:prstDash val="solid"/>
                  <a:round/>
                  <a:headEnd type="none" w="sm" len="sm"/>
                  <a:tailEnd type="none" w="sm" len="sm"/>
                </a:ln>
              </p:spPr>
            </p:cxnSp>
            <p:cxnSp>
              <p:nvCxnSpPr>
                <p:cNvPr id="1192" name="Google Shape;1192;p11"/>
                <p:cNvCxnSpPr/>
                <p:nvPr/>
              </p:nvCxnSpPr>
              <p:spPr>
                <a:xfrm>
                  <a:off x="3821" y="3741"/>
                  <a:ext cx="0" cy="9"/>
                </a:xfrm>
                <a:prstGeom prst="straightConnector1">
                  <a:avLst/>
                </a:prstGeom>
                <a:noFill/>
                <a:ln w="9525" cap="flat" cmpd="sng">
                  <a:solidFill>
                    <a:srgbClr val="000000"/>
                  </a:solidFill>
                  <a:prstDash val="solid"/>
                  <a:round/>
                  <a:headEnd type="none" w="sm" len="sm"/>
                  <a:tailEnd type="none" w="sm" len="sm"/>
                </a:ln>
              </p:spPr>
            </p:cxnSp>
            <p:cxnSp>
              <p:nvCxnSpPr>
                <p:cNvPr id="1193" name="Google Shape;1193;p11"/>
                <p:cNvCxnSpPr/>
                <p:nvPr/>
              </p:nvCxnSpPr>
              <p:spPr>
                <a:xfrm>
                  <a:off x="3933" y="3741"/>
                  <a:ext cx="0" cy="15"/>
                </a:xfrm>
                <a:prstGeom prst="straightConnector1">
                  <a:avLst/>
                </a:prstGeom>
                <a:noFill/>
                <a:ln w="9525" cap="flat" cmpd="sng">
                  <a:solidFill>
                    <a:srgbClr val="000000"/>
                  </a:solidFill>
                  <a:prstDash val="solid"/>
                  <a:round/>
                  <a:headEnd type="none" w="sm" len="sm"/>
                  <a:tailEnd type="none" w="sm" len="sm"/>
                </a:ln>
              </p:spPr>
            </p:cxnSp>
            <p:sp>
              <p:nvSpPr>
                <p:cNvPr id="1194" name="Google Shape;1194;p11"/>
                <p:cNvSpPr/>
                <p:nvPr/>
              </p:nvSpPr>
              <p:spPr>
                <a:xfrm>
                  <a:off x="3877" y="3754"/>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0.0</a:t>
                  </a:r>
                  <a:endParaRPr sz="800" b="0" i="0" u="none" strike="noStrike" cap="none">
                    <a:solidFill>
                      <a:srgbClr val="000000"/>
                    </a:solidFill>
                    <a:latin typeface="Arial"/>
                    <a:ea typeface="Arial"/>
                    <a:cs typeface="Arial"/>
                    <a:sym typeface="Arial"/>
                  </a:endParaRPr>
                </a:p>
              </p:txBody>
            </p:sp>
            <p:cxnSp>
              <p:nvCxnSpPr>
                <p:cNvPr id="1195" name="Google Shape;1195;p11"/>
                <p:cNvCxnSpPr/>
                <p:nvPr/>
              </p:nvCxnSpPr>
              <p:spPr>
                <a:xfrm>
                  <a:off x="4046" y="3741"/>
                  <a:ext cx="0" cy="9"/>
                </a:xfrm>
                <a:prstGeom prst="straightConnector1">
                  <a:avLst/>
                </a:prstGeom>
                <a:noFill/>
                <a:ln w="9525" cap="flat" cmpd="sng">
                  <a:solidFill>
                    <a:srgbClr val="000000"/>
                  </a:solidFill>
                  <a:prstDash val="solid"/>
                  <a:round/>
                  <a:headEnd type="none" w="sm" len="sm"/>
                  <a:tailEnd type="none" w="sm" len="sm"/>
                </a:ln>
              </p:spPr>
            </p:cxnSp>
            <p:cxnSp>
              <p:nvCxnSpPr>
                <p:cNvPr id="1196" name="Google Shape;1196;p11"/>
                <p:cNvCxnSpPr/>
                <p:nvPr/>
              </p:nvCxnSpPr>
              <p:spPr>
                <a:xfrm>
                  <a:off x="4159" y="3741"/>
                  <a:ext cx="0" cy="9"/>
                </a:xfrm>
                <a:prstGeom prst="straightConnector1">
                  <a:avLst/>
                </a:prstGeom>
                <a:noFill/>
                <a:ln w="9525" cap="flat" cmpd="sng">
                  <a:solidFill>
                    <a:srgbClr val="000000"/>
                  </a:solidFill>
                  <a:prstDash val="solid"/>
                  <a:round/>
                  <a:headEnd type="none" w="sm" len="sm"/>
                  <a:tailEnd type="none" w="sm" len="sm"/>
                </a:ln>
              </p:spPr>
            </p:cxnSp>
            <p:cxnSp>
              <p:nvCxnSpPr>
                <p:cNvPr id="1197" name="Google Shape;1197;p11"/>
                <p:cNvCxnSpPr/>
                <p:nvPr/>
              </p:nvCxnSpPr>
              <p:spPr>
                <a:xfrm>
                  <a:off x="4272" y="3741"/>
                  <a:ext cx="0" cy="9"/>
                </a:xfrm>
                <a:prstGeom prst="straightConnector1">
                  <a:avLst/>
                </a:prstGeom>
                <a:noFill/>
                <a:ln w="9525" cap="flat" cmpd="sng">
                  <a:solidFill>
                    <a:srgbClr val="000000"/>
                  </a:solidFill>
                  <a:prstDash val="solid"/>
                  <a:round/>
                  <a:headEnd type="none" w="sm" len="sm"/>
                  <a:tailEnd type="none" w="sm" len="sm"/>
                </a:ln>
              </p:spPr>
            </p:cxnSp>
            <p:cxnSp>
              <p:nvCxnSpPr>
                <p:cNvPr id="1198" name="Google Shape;1198;p11"/>
                <p:cNvCxnSpPr/>
                <p:nvPr/>
              </p:nvCxnSpPr>
              <p:spPr>
                <a:xfrm>
                  <a:off x="4384" y="3741"/>
                  <a:ext cx="0" cy="15"/>
                </a:xfrm>
                <a:prstGeom prst="straightConnector1">
                  <a:avLst/>
                </a:prstGeom>
                <a:noFill/>
                <a:ln w="9525" cap="flat" cmpd="sng">
                  <a:solidFill>
                    <a:srgbClr val="000000"/>
                  </a:solidFill>
                  <a:prstDash val="solid"/>
                  <a:round/>
                  <a:headEnd type="none" w="sm" len="sm"/>
                  <a:tailEnd type="none" w="sm" len="sm"/>
                </a:ln>
              </p:spPr>
            </p:cxnSp>
            <p:sp>
              <p:nvSpPr>
                <p:cNvPr id="1199" name="Google Shape;1199;p11"/>
                <p:cNvSpPr/>
                <p:nvPr/>
              </p:nvSpPr>
              <p:spPr>
                <a:xfrm>
                  <a:off x="4330" y="3754"/>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1.0</a:t>
                  </a:r>
                  <a:endParaRPr sz="800" b="0" i="0" u="none" strike="noStrike" cap="none">
                    <a:solidFill>
                      <a:srgbClr val="000000"/>
                    </a:solidFill>
                    <a:latin typeface="Arial"/>
                    <a:ea typeface="Arial"/>
                    <a:cs typeface="Arial"/>
                    <a:sym typeface="Arial"/>
                  </a:endParaRPr>
                </a:p>
              </p:txBody>
            </p:sp>
            <p:cxnSp>
              <p:nvCxnSpPr>
                <p:cNvPr id="1200" name="Google Shape;1200;p11"/>
                <p:cNvCxnSpPr/>
                <p:nvPr/>
              </p:nvCxnSpPr>
              <p:spPr>
                <a:xfrm>
                  <a:off x="4497" y="3741"/>
                  <a:ext cx="0" cy="9"/>
                </a:xfrm>
                <a:prstGeom prst="straightConnector1">
                  <a:avLst/>
                </a:prstGeom>
                <a:noFill/>
                <a:ln w="9525" cap="flat" cmpd="sng">
                  <a:solidFill>
                    <a:srgbClr val="000000"/>
                  </a:solidFill>
                  <a:prstDash val="solid"/>
                  <a:round/>
                  <a:headEnd type="none" w="sm" len="sm"/>
                  <a:tailEnd type="none" w="sm" len="sm"/>
                </a:ln>
              </p:spPr>
            </p:cxnSp>
            <p:cxnSp>
              <p:nvCxnSpPr>
                <p:cNvPr id="1201" name="Google Shape;1201;p11"/>
                <p:cNvCxnSpPr/>
                <p:nvPr/>
              </p:nvCxnSpPr>
              <p:spPr>
                <a:xfrm>
                  <a:off x="4610" y="3741"/>
                  <a:ext cx="0" cy="9"/>
                </a:xfrm>
                <a:prstGeom prst="straightConnector1">
                  <a:avLst/>
                </a:prstGeom>
                <a:noFill/>
                <a:ln w="9525" cap="flat" cmpd="sng">
                  <a:solidFill>
                    <a:srgbClr val="000000"/>
                  </a:solidFill>
                  <a:prstDash val="solid"/>
                  <a:round/>
                  <a:headEnd type="none" w="sm" len="sm"/>
                  <a:tailEnd type="none" w="sm" len="sm"/>
                </a:ln>
              </p:spPr>
            </p:cxnSp>
            <p:cxnSp>
              <p:nvCxnSpPr>
                <p:cNvPr id="1202" name="Google Shape;1202;p11"/>
                <p:cNvCxnSpPr/>
                <p:nvPr/>
              </p:nvCxnSpPr>
              <p:spPr>
                <a:xfrm>
                  <a:off x="4723" y="3741"/>
                  <a:ext cx="0" cy="9"/>
                </a:xfrm>
                <a:prstGeom prst="straightConnector1">
                  <a:avLst/>
                </a:prstGeom>
                <a:noFill/>
                <a:ln w="9525" cap="flat" cmpd="sng">
                  <a:solidFill>
                    <a:srgbClr val="000000"/>
                  </a:solidFill>
                  <a:prstDash val="solid"/>
                  <a:round/>
                  <a:headEnd type="none" w="sm" len="sm"/>
                  <a:tailEnd type="none" w="sm" len="sm"/>
                </a:ln>
              </p:spPr>
            </p:cxnSp>
            <p:cxnSp>
              <p:nvCxnSpPr>
                <p:cNvPr id="1203" name="Google Shape;1203;p11"/>
                <p:cNvCxnSpPr/>
                <p:nvPr/>
              </p:nvCxnSpPr>
              <p:spPr>
                <a:xfrm>
                  <a:off x="4835" y="3741"/>
                  <a:ext cx="0" cy="15"/>
                </a:xfrm>
                <a:prstGeom prst="straightConnector1">
                  <a:avLst/>
                </a:prstGeom>
                <a:noFill/>
                <a:ln w="9525" cap="flat" cmpd="sng">
                  <a:solidFill>
                    <a:srgbClr val="000000"/>
                  </a:solidFill>
                  <a:prstDash val="solid"/>
                  <a:round/>
                  <a:headEnd type="none" w="sm" len="sm"/>
                  <a:tailEnd type="none" w="sm" len="sm"/>
                </a:ln>
              </p:spPr>
            </p:cxnSp>
            <p:sp>
              <p:nvSpPr>
                <p:cNvPr id="1204" name="Google Shape;1204;p11"/>
                <p:cNvSpPr/>
                <p:nvPr/>
              </p:nvSpPr>
              <p:spPr>
                <a:xfrm>
                  <a:off x="4778" y="3754"/>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2.0</a:t>
                  </a:r>
                  <a:endParaRPr sz="800" b="0" i="0" u="none" strike="noStrike" cap="none">
                    <a:solidFill>
                      <a:srgbClr val="000000"/>
                    </a:solidFill>
                    <a:latin typeface="Arial"/>
                    <a:ea typeface="Arial"/>
                    <a:cs typeface="Arial"/>
                    <a:sym typeface="Arial"/>
                  </a:endParaRPr>
                </a:p>
              </p:txBody>
            </p:sp>
            <p:cxnSp>
              <p:nvCxnSpPr>
                <p:cNvPr id="1205" name="Google Shape;1205;p11"/>
                <p:cNvCxnSpPr/>
                <p:nvPr/>
              </p:nvCxnSpPr>
              <p:spPr>
                <a:xfrm>
                  <a:off x="4948" y="3741"/>
                  <a:ext cx="0" cy="9"/>
                </a:xfrm>
                <a:prstGeom prst="straightConnector1">
                  <a:avLst/>
                </a:prstGeom>
                <a:noFill/>
                <a:ln w="9525" cap="flat" cmpd="sng">
                  <a:solidFill>
                    <a:srgbClr val="000000"/>
                  </a:solidFill>
                  <a:prstDash val="solid"/>
                  <a:round/>
                  <a:headEnd type="none" w="sm" len="sm"/>
                  <a:tailEnd type="none" w="sm" len="sm"/>
                </a:ln>
              </p:spPr>
            </p:cxnSp>
            <p:cxnSp>
              <p:nvCxnSpPr>
                <p:cNvPr id="1206" name="Google Shape;1206;p11"/>
                <p:cNvCxnSpPr/>
                <p:nvPr/>
              </p:nvCxnSpPr>
              <p:spPr>
                <a:xfrm>
                  <a:off x="5061" y="3741"/>
                  <a:ext cx="0" cy="9"/>
                </a:xfrm>
                <a:prstGeom prst="straightConnector1">
                  <a:avLst/>
                </a:prstGeom>
                <a:noFill/>
                <a:ln w="9525" cap="flat" cmpd="sng">
                  <a:solidFill>
                    <a:srgbClr val="000000"/>
                  </a:solidFill>
                  <a:prstDash val="solid"/>
                  <a:round/>
                  <a:headEnd type="none" w="sm" len="sm"/>
                  <a:tailEnd type="none" w="sm" len="sm"/>
                </a:ln>
              </p:spPr>
            </p:cxnSp>
            <p:cxnSp>
              <p:nvCxnSpPr>
                <p:cNvPr id="1207" name="Google Shape;1207;p11"/>
                <p:cNvCxnSpPr/>
                <p:nvPr/>
              </p:nvCxnSpPr>
              <p:spPr>
                <a:xfrm>
                  <a:off x="5174" y="3741"/>
                  <a:ext cx="0" cy="9"/>
                </a:xfrm>
                <a:prstGeom prst="straightConnector1">
                  <a:avLst/>
                </a:prstGeom>
                <a:noFill/>
                <a:ln w="9525" cap="flat" cmpd="sng">
                  <a:solidFill>
                    <a:srgbClr val="000000"/>
                  </a:solidFill>
                  <a:prstDash val="solid"/>
                  <a:round/>
                  <a:headEnd type="none" w="sm" len="sm"/>
                  <a:tailEnd type="none" w="sm" len="sm"/>
                </a:ln>
              </p:spPr>
            </p:cxnSp>
            <p:cxnSp>
              <p:nvCxnSpPr>
                <p:cNvPr id="1208" name="Google Shape;1208;p11"/>
                <p:cNvCxnSpPr/>
                <p:nvPr/>
              </p:nvCxnSpPr>
              <p:spPr>
                <a:xfrm>
                  <a:off x="5286" y="3741"/>
                  <a:ext cx="0" cy="15"/>
                </a:xfrm>
                <a:prstGeom prst="straightConnector1">
                  <a:avLst/>
                </a:prstGeom>
                <a:noFill/>
                <a:ln w="9525" cap="flat" cmpd="sng">
                  <a:solidFill>
                    <a:srgbClr val="000000"/>
                  </a:solidFill>
                  <a:prstDash val="solid"/>
                  <a:round/>
                  <a:headEnd type="none" w="sm" len="sm"/>
                  <a:tailEnd type="none" w="sm" len="sm"/>
                </a:ln>
              </p:spPr>
            </p:cxnSp>
            <p:sp>
              <p:nvSpPr>
                <p:cNvPr id="1209" name="Google Shape;1209;p11"/>
                <p:cNvSpPr/>
                <p:nvPr/>
              </p:nvSpPr>
              <p:spPr>
                <a:xfrm>
                  <a:off x="5229" y="3754"/>
                  <a:ext cx="30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3.0</a:t>
                  </a:r>
                  <a:endParaRPr sz="800" b="0" i="0" u="none" strike="noStrike" cap="none">
                    <a:solidFill>
                      <a:srgbClr val="000000"/>
                    </a:solidFill>
                    <a:latin typeface="Arial"/>
                    <a:ea typeface="Arial"/>
                    <a:cs typeface="Arial"/>
                    <a:sym typeface="Arial"/>
                  </a:endParaRPr>
                </a:p>
              </p:txBody>
            </p:sp>
            <p:cxnSp>
              <p:nvCxnSpPr>
                <p:cNvPr id="1210" name="Google Shape;1210;p11"/>
                <p:cNvCxnSpPr/>
                <p:nvPr/>
              </p:nvCxnSpPr>
              <p:spPr>
                <a:xfrm>
                  <a:off x="5399" y="3741"/>
                  <a:ext cx="0" cy="9"/>
                </a:xfrm>
                <a:prstGeom prst="straightConnector1">
                  <a:avLst/>
                </a:prstGeom>
                <a:noFill/>
                <a:ln w="9525" cap="flat" cmpd="sng">
                  <a:solidFill>
                    <a:srgbClr val="000000"/>
                  </a:solidFill>
                  <a:prstDash val="solid"/>
                  <a:round/>
                  <a:headEnd type="none" w="sm" len="sm"/>
                  <a:tailEnd type="none" w="sm" len="sm"/>
                </a:ln>
              </p:spPr>
            </p:cxnSp>
            <p:cxnSp>
              <p:nvCxnSpPr>
                <p:cNvPr id="1211" name="Google Shape;1211;p11"/>
                <p:cNvCxnSpPr/>
                <p:nvPr/>
              </p:nvCxnSpPr>
              <p:spPr>
                <a:xfrm>
                  <a:off x="5512" y="3741"/>
                  <a:ext cx="0" cy="9"/>
                </a:xfrm>
                <a:prstGeom prst="straightConnector1">
                  <a:avLst/>
                </a:prstGeom>
                <a:noFill/>
                <a:ln w="9525" cap="flat" cmpd="sng">
                  <a:solidFill>
                    <a:srgbClr val="000000"/>
                  </a:solidFill>
                  <a:prstDash val="solid"/>
                  <a:round/>
                  <a:headEnd type="none" w="sm" len="sm"/>
                  <a:tailEnd type="none" w="sm" len="sm"/>
                </a:ln>
              </p:spPr>
            </p:cxnSp>
            <p:cxnSp>
              <p:nvCxnSpPr>
                <p:cNvPr id="1212" name="Google Shape;1212;p11"/>
                <p:cNvCxnSpPr/>
                <p:nvPr/>
              </p:nvCxnSpPr>
              <p:spPr>
                <a:xfrm>
                  <a:off x="5625" y="3741"/>
                  <a:ext cx="0" cy="9"/>
                </a:xfrm>
                <a:prstGeom prst="straightConnector1">
                  <a:avLst/>
                </a:prstGeom>
                <a:noFill/>
                <a:ln w="9525" cap="flat" cmpd="sng">
                  <a:solidFill>
                    <a:srgbClr val="000000"/>
                  </a:solidFill>
                  <a:prstDash val="solid"/>
                  <a:round/>
                  <a:headEnd type="none" w="sm" len="sm"/>
                  <a:tailEnd type="none" w="sm" len="sm"/>
                </a:ln>
              </p:spPr>
            </p:cxnSp>
            <p:cxnSp>
              <p:nvCxnSpPr>
                <p:cNvPr id="1213" name="Google Shape;1213;p11"/>
                <p:cNvCxnSpPr/>
                <p:nvPr/>
              </p:nvCxnSpPr>
              <p:spPr>
                <a:xfrm>
                  <a:off x="5737" y="3741"/>
                  <a:ext cx="0" cy="15"/>
                </a:xfrm>
                <a:prstGeom prst="straightConnector1">
                  <a:avLst/>
                </a:prstGeom>
                <a:noFill/>
                <a:ln w="9525" cap="flat" cmpd="sng">
                  <a:solidFill>
                    <a:srgbClr val="000000"/>
                  </a:solidFill>
                  <a:prstDash val="solid"/>
                  <a:round/>
                  <a:headEnd type="none" w="sm" len="sm"/>
                  <a:tailEnd type="none" w="sm" len="sm"/>
                </a:ln>
              </p:spPr>
            </p:cxnSp>
            <p:sp>
              <p:nvSpPr>
                <p:cNvPr id="1214" name="Google Shape;1214;p11"/>
                <p:cNvSpPr/>
                <p:nvPr/>
              </p:nvSpPr>
              <p:spPr>
                <a:xfrm>
                  <a:off x="5679" y="3754"/>
                  <a:ext cx="30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4.0</a:t>
                  </a:r>
                  <a:endParaRPr sz="800" b="0" i="0" u="none" strike="noStrike" cap="none">
                    <a:solidFill>
                      <a:srgbClr val="000000"/>
                    </a:solidFill>
                    <a:latin typeface="Arial"/>
                    <a:ea typeface="Arial"/>
                    <a:cs typeface="Arial"/>
                    <a:sym typeface="Arial"/>
                  </a:endParaRPr>
                </a:p>
              </p:txBody>
            </p:sp>
            <p:cxnSp>
              <p:nvCxnSpPr>
                <p:cNvPr id="1215" name="Google Shape;1215;p11"/>
                <p:cNvCxnSpPr/>
                <p:nvPr/>
              </p:nvCxnSpPr>
              <p:spPr>
                <a:xfrm>
                  <a:off x="5850" y="3741"/>
                  <a:ext cx="0" cy="9"/>
                </a:xfrm>
                <a:prstGeom prst="straightConnector1">
                  <a:avLst/>
                </a:prstGeom>
                <a:noFill/>
                <a:ln w="9525" cap="flat" cmpd="sng">
                  <a:solidFill>
                    <a:srgbClr val="000000"/>
                  </a:solidFill>
                  <a:prstDash val="solid"/>
                  <a:round/>
                  <a:headEnd type="none" w="sm" len="sm"/>
                  <a:tailEnd type="none" w="sm" len="sm"/>
                </a:ln>
              </p:spPr>
            </p:cxnSp>
            <p:cxnSp>
              <p:nvCxnSpPr>
                <p:cNvPr id="1216" name="Google Shape;1216;p11"/>
                <p:cNvCxnSpPr/>
                <p:nvPr/>
              </p:nvCxnSpPr>
              <p:spPr>
                <a:xfrm>
                  <a:off x="5963" y="3741"/>
                  <a:ext cx="0" cy="9"/>
                </a:xfrm>
                <a:prstGeom prst="straightConnector1">
                  <a:avLst/>
                </a:prstGeom>
                <a:noFill/>
                <a:ln w="9525" cap="flat" cmpd="sng">
                  <a:solidFill>
                    <a:srgbClr val="000000"/>
                  </a:solidFill>
                  <a:prstDash val="solid"/>
                  <a:round/>
                  <a:headEnd type="none" w="sm" len="sm"/>
                  <a:tailEnd type="none" w="sm" len="sm"/>
                </a:ln>
              </p:spPr>
            </p:cxnSp>
            <p:cxnSp>
              <p:nvCxnSpPr>
                <p:cNvPr id="1217" name="Google Shape;1217;p11"/>
                <p:cNvCxnSpPr/>
                <p:nvPr/>
              </p:nvCxnSpPr>
              <p:spPr>
                <a:xfrm>
                  <a:off x="6075" y="3741"/>
                  <a:ext cx="0" cy="9"/>
                </a:xfrm>
                <a:prstGeom prst="straightConnector1">
                  <a:avLst/>
                </a:prstGeom>
                <a:noFill/>
                <a:ln w="9525" cap="flat" cmpd="sng">
                  <a:solidFill>
                    <a:srgbClr val="000000"/>
                  </a:solidFill>
                  <a:prstDash val="solid"/>
                  <a:round/>
                  <a:headEnd type="none" w="sm" len="sm"/>
                  <a:tailEnd type="none" w="sm" len="sm"/>
                </a:ln>
              </p:spPr>
            </p:cxnSp>
            <p:cxnSp>
              <p:nvCxnSpPr>
                <p:cNvPr id="1218" name="Google Shape;1218;p11"/>
                <p:cNvCxnSpPr/>
                <p:nvPr/>
              </p:nvCxnSpPr>
              <p:spPr>
                <a:xfrm>
                  <a:off x="6188" y="3741"/>
                  <a:ext cx="0" cy="15"/>
                </a:xfrm>
                <a:prstGeom prst="straightConnector1">
                  <a:avLst/>
                </a:prstGeom>
                <a:noFill/>
                <a:ln w="9525" cap="flat" cmpd="sng">
                  <a:solidFill>
                    <a:srgbClr val="000000"/>
                  </a:solidFill>
                  <a:prstDash val="solid"/>
                  <a:round/>
                  <a:headEnd type="none" w="sm" len="sm"/>
                  <a:tailEnd type="none" w="sm" len="sm"/>
                </a:ln>
              </p:spPr>
            </p:cxnSp>
            <p:sp>
              <p:nvSpPr>
                <p:cNvPr id="1219" name="Google Shape;1219;p11"/>
                <p:cNvSpPr/>
                <p:nvPr/>
              </p:nvSpPr>
              <p:spPr>
                <a:xfrm>
                  <a:off x="6130" y="3754"/>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5.0</a:t>
                  </a:r>
                  <a:endParaRPr sz="800" b="0" i="0" u="none" strike="noStrike" cap="none">
                    <a:solidFill>
                      <a:srgbClr val="000000"/>
                    </a:solidFill>
                    <a:latin typeface="Arial"/>
                    <a:ea typeface="Arial"/>
                    <a:cs typeface="Arial"/>
                    <a:sym typeface="Arial"/>
                  </a:endParaRPr>
                </a:p>
              </p:txBody>
            </p:sp>
            <p:cxnSp>
              <p:nvCxnSpPr>
                <p:cNvPr id="1220" name="Google Shape;1220;p11"/>
                <p:cNvCxnSpPr/>
                <p:nvPr/>
              </p:nvCxnSpPr>
              <p:spPr>
                <a:xfrm>
                  <a:off x="6301" y="3741"/>
                  <a:ext cx="0" cy="9"/>
                </a:xfrm>
                <a:prstGeom prst="straightConnector1">
                  <a:avLst/>
                </a:prstGeom>
                <a:noFill/>
                <a:ln w="9525" cap="flat" cmpd="sng">
                  <a:solidFill>
                    <a:srgbClr val="000000"/>
                  </a:solidFill>
                  <a:prstDash val="solid"/>
                  <a:round/>
                  <a:headEnd type="none" w="sm" len="sm"/>
                  <a:tailEnd type="none" w="sm" len="sm"/>
                </a:ln>
              </p:spPr>
            </p:cxnSp>
            <p:cxnSp>
              <p:nvCxnSpPr>
                <p:cNvPr id="1221" name="Google Shape;1221;p11"/>
                <p:cNvCxnSpPr/>
                <p:nvPr/>
              </p:nvCxnSpPr>
              <p:spPr>
                <a:xfrm>
                  <a:off x="6413" y="3741"/>
                  <a:ext cx="0" cy="15"/>
                </a:xfrm>
                <a:prstGeom prst="straightConnector1">
                  <a:avLst/>
                </a:prstGeom>
                <a:noFill/>
                <a:ln w="9525" cap="flat" cmpd="sng">
                  <a:solidFill>
                    <a:srgbClr val="000000"/>
                  </a:solidFill>
                  <a:prstDash val="solid"/>
                  <a:round/>
                  <a:headEnd type="none" w="sm" len="sm"/>
                  <a:tailEnd type="none" w="sm" len="sm"/>
                </a:ln>
              </p:spPr>
            </p:cxnSp>
            <p:sp>
              <p:nvSpPr>
                <p:cNvPr id="1222" name="Google Shape;1222;p11"/>
                <p:cNvSpPr/>
                <p:nvPr/>
              </p:nvSpPr>
              <p:spPr>
                <a:xfrm>
                  <a:off x="6356" y="3754"/>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rgbClr val="000000"/>
                    </a:solidFill>
                    <a:latin typeface="Arial"/>
                    <a:ea typeface="Arial"/>
                    <a:cs typeface="Arial"/>
                    <a:sym typeface="Arial"/>
                  </a:endParaRPr>
                </a:p>
              </p:txBody>
            </p:sp>
            <p:cxnSp>
              <p:nvCxnSpPr>
                <p:cNvPr id="1223" name="Google Shape;1223;p11"/>
                <p:cNvCxnSpPr/>
                <p:nvPr/>
              </p:nvCxnSpPr>
              <p:spPr>
                <a:xfrm>
                  <a:off x="1441" y="1243"/>
                  <a:ext cx="0" cy="2486"/>
                </a:xfrm>
                <a:prstGeom prst="straightConnector1">
                  <a:avLst/>
                </a:prstGeom>
                <a:noFill/>
                <a:ln w="9525" cap="flat" cmpd="sng">
                  <a:solidFill>
                    <a:srgbClr val="000000"/>
                  </a:solidFill>
                  <a:prstDash val="solid"/>
                  <a:round/>
                  <a:headEnd type="none" w="sm" len="sm"/>
                  <a:tailEnd type="none" w="sm" len="sm"/>
                </a:ln>
              </p:spPr>
            </p:cxnSp>
            <p:cxnSp>
              <p:nvCxnSpPr>
                <p:cNvPr id="1224" name="Google Shape;1224;p11"/>
                <p:cNvCxnSpPr/>
                <p:nvPr/>
              </p:nvCxnSpPr>
              <p:spPr>
                <a:xfrm rot="10800000">
                  <a:off x="1426" y="3729"/>
                  <a:ext cx="15" cy="0"/>
                </a:xfrm>
                <a:prstGeom prst="straightConnector1">
                  <a:avLst/>
                </a:prstGeom>
                <a:noFill/>
                <a:ln w="9525" cap="flat" cmpd="sng">
                  <a:solidFill>
                    <a:srgbClr val="000000"/>
                  </a:solidFill>
                  <a:prstDash val="solid"/>
                  <a:round/>
                  <a:headEnd type="none" w="sm" len="sm"/>
                  <a:tailEnd type="none" w="sm" len="sm"/>
                </a:ln>
              </p:spPr>
            </p:cxnSp>
            <p:sp>
              <p:nvSpPr>
                <p:cNvPr id="1225" name="Google Shape;1225;p11"/>
                <p:cNvSpPr/>
                <p:nvPr/>
              </p:nvSpPr>
              <p:spPr>
                <a:xfrm>
                  <a:off x="1218" y="3682"/>
                  <a:ext cx="202"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0.0</a:t>
                  </a:r>
                  <a:endParaRPr sz="800" b="0" i="0" u="none" strike="noStrike" cap="none">
                    <a:solidFill>
                      <a:srgbClr val="000000"/>
                    </a:solidFill>
                    <a:latin typeface="Arial"/>
                    <a:ea typeface="Arial"/>
                    <a:cs typeface="Arial"/>
                    <a:sym typeface="Arial"/>
                  </a:endParaRPr>
                </a:p>
              </p:txBody>
            </p:sp>
            <p:cxnSp>
              <p:nvCxnSpPr>
                <p:cNvPr id="1226" name="Google Shape;1226;p11"/>
                <p:cNvCxnSpPr/>
                <p:nvPr/>
              </p:nvCxnSpPr>
              <p:spPr>
                <a:xfrm rot="10800000">
                  <a:off x="1432" y="3693"/>
                  <a:ext cx="9" cy="0"/>
                </a:xfrm>
                <a:prstGeom prst="straightConnector1">
                  <a:avLst/>
                </a:prstGeom>
                <a:noFill/>
                <a:ln w="9525" cap="flat" cmpd="sng">
                  <a:solidFill>
                    <a:srgbClr val="000000"/>
                  </a:solidFill>
                  <a:prstDash val="solid"/>
                  <a:round/>
                  <a:headEnd type="none" w="sm" len="sm"/>
                  <a:tailEnd type="none" w="sm" len="sm"/>
                </a:ln>
              </p:spPr>
            </p:cxnSp>
            <p:cxnSp>
              <p:nvCxnSpPr>
                <p:cNvPr id="1227" name="Google Shape;1227;p11"/>
                <p:cNvCxnSpPr/>
                <p:nvPr/>
              </p:nvCxnSpPr>
              <p:spPr>
                <a:xfrm rot="10800000">
                  <a:off x="1432" y="3658"/>
                  <a:ext cx="9" cy="0"/>
                </a:xfrm>
                <a:prstGeom prst="straightConnector1">
                  <a:avLst/>
                </a:prstGeom>
                <a:noFill/>
                <a:ln w="9525" cap="flat" cmpd="sng">
                  <a:solidFill>
                    <a:srgbClr val="000000"/>
                  </a:solidFill>
                  <a:prstDash val="solid"/>
                  <a:round/>
                  <a:headEnd type="none" w="sm" len="sm"/>
                  <a:tailEnd type="none" w="sm" len="sm"/>
                </a:ln>
              </p:spPr>
            </p:cxnSp>
            <p:cxnSp>
              <p:nvCxnSpPr>
                <p:cNvPr id="1228" name="Google Shape;1228;p11"/>
                <p:cNvCxnSpPr/>
                <p:nvPr/>
              </p:nvCxnSpPr>
              <p:spPr>
                <a:xfrm rot="10800000">
                  <a:off x="1432" y="3622"/>
                  <a:ext cx="9" cy="0"/>
                </a:xfrm>
                <a:prstGeom prst="straightConnector1">
                  <a:avLst/>
                </a:prstGeom>
                <a:noFill/>
                <a:ln w="9525" cap="flat" cmpd="sng">
                  <a:solidFill>
                    <a:srgbClr val="000000"/>
                  </a:solidFill>
                  <a:prstDash val="solid"/>
                  <a:round/>
                  <a:headEnd type="none" w="sm" len="sm"/>
                  <a:tailEnd type="none" w="sm" len="sm"/>
                </a:ln>
              </p:spPr>
            </p:cxnSp>
            <p:cxnSp>
              <p:nvCxnSpPr>
                <p:cNvPr id="1229" name="Google Shape;1229;p11"/>
                <p:cNvCxnSpPr/>
                <p:nvPr/>
              </p:nvCxnSpPr>
              <p:spPr>
                <a:xfrm rot="10800000">
                  <a:off x="1432" y="3587"/>
                  <a:ext cx="9" cy="0"/>
                </a:xfrm>
                <a:prstGeom prst="straightConnector1">
                  <a:avLst/>
                </a:prstGeom>
                <a:noFill/>
                <a:ln w="9525" cap="flat" cmpd="sng">
                  <a:solidFill>
                    <a:srgbClr val="000000"/>
                  </a:solidFill>
                  <a:prstDash val="solid"/>
                  <a:round/>
                  <a:headEnd type="none" w="sm" len="sm"/>
                  <a:tailEnd type="none" w="sm" len="sm"/>
                </a:ln>
              </p:spPr>
            </p:cxnSp>
            <p:cxnSp>
              <p:nvCxnSpPr>
                <p:cNvPr id="1230" name="Google Shape;1230;p11"/>
                <p:cNvCxnSpPr/>
                <p:nvPr/>
              </p:nvCxnSpPr>
              <p:spPr>
                <a:xfrm rot="10800000">
                  <a:off x="1426" y="3551"/>
                  <a:ext cx="15" cy="0"/>
                </a:xfrm>
                <a:prstGeom prst="straightConnector1">
                  <a:avLst/>
                </a:prstGeom>
                <a:noFill/>
                <a:ln w="9525" cap="flat" cmpd="sng">
                  <a:solidFill>
                    <a:srgbClr val="000000"/>
                  </a:solidFill>
                  <a:prstDash val="solid"/>
                  <a:round/>
                  <a:headEnd type="none" w="sm" len="sm"/>
                  <a:tailEnd type="none" w="sm" len="sm"/>
                </a:ln>
              </p:spPr>
            </p:cxnSp>
            <p:sp>
              <p:nvSpPr>
                <p:cNvPr id="1231" name="Google Shape;1231;p11"/>
                <p:cNvSpPr/>
                <p:nvPr/>
              </p:nvSpPr>
              <p:spPr>
                <a:xfrm>
                  <a:off x="1250" y="3504"/>
                  <a:ext cx="152"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5.0</a:t>
                  </a:r>
                  <a:endParaRPr sz="800" b="0" i="0" u="none" strike="noStrike" cap="none">
                    <a:solidFill>
                      <a:srgbClr val="000000"/>
                    </a:solidFill>
                    <a:latin typeface="Arial"/>
                    <a:ea typeface="Arial"/>
                    <a:cs typeface="Arial"/>
                    <a:sym typeface="Arial"/>
                  </a:endParaRPr>
                </a:p>
              </p:txBody>
            </p:sp>
            <p:cxnSp>
              <p:nvCxnSpPr>
                <p:cNvPr id="1232" name="Google Shape;1232;p11"/>
                <p:cNvCxnSpPr/>
                <p:nvPr/>
              </p:nvCxnSpPr>
              <p:spPr>
                <a:xfrm rot="10800000">
                  <a:off x="1432" y="3516"/>
                  <a:ext cx="9" cy="0"/>
                </a:xfrm>
                <a:prstGeom prst="straightConnector1">
                  <a:avLst/>
                </a:prstGeom>
                <a:noFill/>
                <a:ln w="9525" cap="flat" cmpd="sng">
                  <a:solidFill>
                    <a:srgbClr val="000000"/>
                  </a:solidFill>
                  <a:prstDash val="solid"/>
                  <a:round/>
                  <a:headEnd type="none" w="sm" len="sm"/>
                  <a:tailEnd type="none" w="sm" len="sm"/>
                </a:ln>
              </p:spPr>
            </p:cxnSp>
            <p:cxnSp>
              <p:nvCxnSpPr>
                <p:cNvPr id="1233" name="Google Shape;1233;p11"/>
                <p:cNvCxnSpPr/>
                <p:nvPr/>
              </p:nvCxnSpPr>
              <p:spPr>
                <a:xfrm rot="10800000">
                  <a:off x="1432" y="3480"/>
                  <a:ext cx="9" cy="0"/>
                </a:xfrm>
                <a:prstGeom prst="straightConnector1">
                  <a:avLst/>
                </a:prstGeom>
                <a:noFill/>
                <a:ln w="9525" cap="flat" cmpd="sng">
                  <a:solidFill>
                    <a:srgbClr val="000000"/>
                  </a:solidFill>
                  <a:prstDash val="solid"/>
                  <a:round/>
                  <a:headEnd type="none" w="sm" len="sm"/>
                  <a:tailEnd type="none" w="sm" len="sm"/>
                </a:ln>
              </p:spPr>
            </p:cxnSp>
            <p:cxnSp>
              <p:nvCxnSpPr>
                <p:cNvPr id="1234" name="Google Shape;1234;p11"/>
                <p:cNvCxnSpPr/>
                <p:nvPr/>
              </p:nvCxnSpPr>
              <p:spPr>
                <a:xfrm rot="10800000">
                  <a:off x="1432" y="3445"/>
                  <a:ext cx="9" cy="0"/>
                </a:xfrm>
                <a:prstGeom prst="straightConnector1">
                  <a:avLst/>
                </a:prstGeom>
                <a:noFill/>
                <a:ln w="9525" cap="flat" cmpd="sng">
                  <a:solidFill>
                    <a:srgbClr val="000000"/>
                  </a:solidFill>
                  <a:prstDash val="solid"/>
                  <a:round/>
                  <a:headEnd type="none" w="sm" len="sm"/>
                  <a:tailEnd type="none" w="sm" len="sm"/>
                </a:ln>
              </p:spPr>
            </p:cxnSp>
            <p:cxnSp>
              <p:nvCxnSpPr>
                <p:cNvPr id="1235" name="Google Shape;1235;p11"/>
                <p:cNvCxnSpPr/>
                <p:nvPr/>
              </p:nvCxnSpPr>
              <p:spPr>
                <a:xfrm rot="10800000">
                  <a:off x="1432" y="3409"/>
                  <a:ext cx="9" cy="0"/>
                </a:xfrm>
                <a:prstGeom prst="straightConnector1">
                  <a:avLst/>
                </a:prstGeom>
                <a:noFill/>
                <a:ln w="9525" cap="flat" cmpd="sng">
                  <a:solidFill>
                    <a:srgbClr val="000000"/>
                  </a:solidFill>
                  <a:prstDash val="solid"/>
                  <a:round/>
                  <a:headEnd type="none" w="sm" len="sm"/>
                  <a:tailEnd type="none" w="sm" len="sm"/>
                </a:ln>
              </p:spPr>
            </p:cxnSp>
            <p:cxnSp>
              <p:nvCxnSpPr>
                <p:cNvPr id="1236" name="Google Shape;1236;p11"/>
                <p:cNvCxnSpPr/>
                <p:nvPr/>
              </p:nvCxnSpPr>
              <p:spPr>
                <a:xfrm rot="10800000">
                  <a:off x="1426" y="3374"/>
                  <a:ext cx="15" cy="0"/>
                </a:xfrm>
                <a:prstGeom prst="straightConnector1">
                  <a:avLst/>
                </a:prstGeom>
                <a:noFill/>
                <a:ln w="9525" cap="flat" cmpd="sng">
                  <a:solidFill>
                    <a:srgbClr val="000000"/>
                  </a:solidFill>
                  <a:prstDash val="solid"/>
                  <a:round/>
                  <a:headEnd type="none" w="sm" len="sm"/>
                  <a:tailEnd type="none" w="sm" len="sm"/>
                </a:ln>
              </p:spPr>
            </p:cxnSp>
            <p:sp>
              <p:nvSpPr>
                <p:cNvPr id="1237" name="Google Shape;1237;p11"/>
                <p:cNvSpPr/>
                <p:nvPr/>
              </p:nvSpPr>
              <p:spPr>
                <a:xfrm>
                  <a:off x="1269" y="3327"/>
                  <a:ext cx="12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0.0</a:t>
                  </a:r>
                  <a:endParaRPr sz="800" b="0" i="0" u="none" strike="noStrike" cap="none">
                    <a:solidFill>
                      <a:srgbClr val="000000"/>
                    </a:solidFill>
                    <a:latin typeface="Arial"/>
                    <a:ea typeface="Arial"/>
                    <a:cs typeface="Arial"/>
                    <a:sym typeface="Arial"/>
                  </a:endParaRPr>
                </a:p>
              </p:txBody>
            </p:sp>
            <p:cxnSp>
              <p:nvCxnSpPr>
                <p:cNvPr id="1238" name="Google Shape;1238;p11"/>
                <p:cNvCxnSpPr/>
                <p:nvPr/>
              </p:nvCxnSpPr>
              <p:spPr>
                <a:xfrm rot="10800000">
                  <a:off x="1432" y="3338"/>
                  <a:ext cx="9" cy="0"/>
                </a:xfrm>
                <a:prstGeom prst="straightConnector1">
                  <a:avLst/>
                </a:prstGeom>
                <a:noFill/>
                <a:ln w="9525" cap="flat" cmpd="sng">
                  <a:solidFill>
                    <a:srgbClr val="000000"/>
                  </a:solidFill>
                  <a:prstDash val="solid"/>
                  <a:round/>
                  <a:headEnd type="none" w="sm" len="sm"/>
                  <a:tailEnd type="none" w="sm" len="sm"/>
                </a:ln>
              </p:spPr>
            </p:cxnSp>
            <p:cxnSp>
              <p:nvCxnSpPr>
                <p:cNvPr id="1239" name="Google Shape;1239;p11"/>
                <p:cNvCxnSpPr/>
                <p:nvPr/>
              </p:nvCxnSpPr>
              <p:spPr>
                <a:xfrm rot="10800000">
                  <a:off x="1432" y="3303"/>
                  <a:ext cx="9" cy="0"/>
                </a:xfrm>
                <a:prstGeom prst="straightConnector1">
                  <a:avLst/>
                </a:prstGeom>
                <a:noFill/>
                <a:ln w="9525" cap="flat" cmpd="sng">
                  <a:solidFill>
                    <a:srgbClr val="000000"/>
                  </a:solidFill>
                  <a:prstDash val="solid"/>
                  <a:round/>
                  <a:headEnd type="none" w="sm" len="sm"/>
                  <a:tailEnd type="none" w="sm" len="sm"/>
                </a:ln>
              </p:spPr>
            </p:cxnSp>
            <p:cxnSp>
              <p:nvCxnSpPr>
                <p:cNvPr id="1240" name="Google Shape;1240;p11"/>
                <p:cNvCxnSpPr/>
                <p:nvPr/>
              </p:nvCxnSpPr>
              <p:spPr>
                <a:xfrm rot="10800000">
                  <a:off x="1432" y="3267"/>
                  <a:ext cx="9" cy="0"/>
                </a:xfrm>
                <a:prstGeom prst="straightConnector1">
                  <a:avLst/>
                </a:prstGeom>
                <a:noFill/>
                <a:ln w="9525" cap="flat" cmpd="sng">
                  <a:solidFill>
                    <a:srgbClr val="000000"/>
                  </a:solidFill>
                  <a:prstDash val="solid"/>
                  <a:round/>
                  <a:headEnd type="none" w="sm" len="sm"/>
                  <a:tailEnd type="none" w="sm" len="sm"/>
                </a:ln>
              </p:spPr>
            </p:cxnSp>
            <p:cxnSp>
              <p:nvCxnSpPr>
                <p:cNvPr id="1241" name="Google Shape;1241;p11"/>
                <p:cNvCxnSpPr/>
                <p:nvPr/>
              </p:nvCxnSpPr>
              <p:spPr>
                <a:xfrm rot="10800000">
                  <a:off x="1432" y="3232"/>
                  <a:ext cx="9" cy="0"/>
                </a:xfrm>
                <a:prstGeom prst="straightConnector1">
                  <a:avLst/>
                </a:prstGeom>
                <a:noFill/>
                <a:ln w="9525" cap="flat" cmpd="sng">
                  <a:solidFill>
                    <a:srgbClr val="000000"/>
                  </a:solidFill>
                  <a:prstDash val="solid"/>
                  <a:round/>
                  <a:headEnd type="none" w="sm" len="sm"/>
                  <a:tailEnd type="none" w="sm" len="sm"/>
                </a:ln>
              </p:spPr>
            </p:cxnSp>
            <p:cxnSp>
              <p:nvCxnSpPr>
                <p:cNvPr id="1242" name="Google Shape;1242;p11"/>
                <p:cNvCxnSpPr/>
                <p:nvPr/>
              </p:nvCxnSpPr>
              <p:spPr>
                <a:xfrm rot="10800000">
                  <a:off x="1426" y="3196"/>
                  <a:ext cx="15" cy="0"/>
                </a:xfrm>
                <a:prstGeom prst="straightConnector1">
                  <a:avLst/>
                </a:prstGeom>
                <a:noFill/>
                <a:ln w="9525" cap="flat" cmpd="sng">
                  <a:solidFill>
                    <a:srgbClr val="000000"/>
                  </a:solidFill>
                  <a:prstDash val="solid"/>
                  <a:round/>
                  <a:headEnd type="none" w="sm" len="sm"/>
                  <a:tailEnd type="none" w="sm" len="sm"/>
                </a:ln>
              </p:spPr>
            </p:cxnSp>
            <p:sp>
              <p:nvSpPr>
                <p:cNvPr id="1243" name="Google Shape;1243;p11"/>
                <p:cNvSpPr/>
                <p:nvPr/>
              </p:nvSpPr>
              <p:spPr>
                <a:xfrm>
                  <a:off x="1269" y="3149"/>
                  <a:ext cx="12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5.0</a:t>
                  </a:r>
                  <a:endParaRPr sz="800" b="0" i="0" u="none" strike="noStrike" cap="none">
                    <a:solidFill>
                      <a:srgbClr val="000000"/>
                    </a:solidFill>
                    <a:latin typeface="Arial"/>
                    <a:ea typeface="Arial"/>
                    <a:cs typeface="Arial"/>
                    <a:sym typeface="Arial"/>
                  </a:endParaRPr>
                </a:p>
              </p:txBody>
            </p:sp>
            <p:cxnSp>
              <p:nvCxnSpPr>
                <p:cNvPr id="1244" name="Google Shape;1244;p11"/>
                <p:cNvCxnSpPr/>
                <p:nvPr/>
              </p:nvCxnSpPr>
              <p:spPr>
                <a:xfrm rot="10800000">
                  <a:off x="1432" y="3161"/>
                  <a:ext cx="9" cy="0"/>
                </a:xfrm>
                <a:prstGeom prst="straightConnector1">
                  <a:avLst/>
                </a:prstGeom>
                <a:noFill/>
                <a:ln w="9525" cap="flat" cmpd="sng">
                  <a:solidFill>
                    <a:srgbClr val="000000"/>
                  </a:solidFill>
                  <a:prstDash val="solid"/>
                  <a:round/>
                  <a:headEnd type="none" w="sm" len="sm"/>
                  <a:tailEnd type="none" w="sm" len="sm"/>
                </a:ln>
              </p:spPr>
            </p:cxnSp>
            <p:cxnSp>
              <p:nvCxnSpPr>
                <p:cNvPr id="1245" name="Google Shape;1245;p11"/>
                <p:cNvCxnSpPr/>
                <p:nvPr/>
              </p:nvCxnSpPr>
              <p:spPr>
                <a:xfrm rot="10800000">
                  <a:off x="1432" y="3125"/>
                  <a:ext cx="9" cy="0"/>
                </a:xfrm>
                <a:prstGeom prst="straightConnector1">
                  <a:avLst/>
                </a:prstGeom>
                <a:noFill/>
                <a:ln w="9525" cap="flat" cmpd="sng">
                  <a:solidFill>
                    <a:srgbClr val="000000"/>
                  </a:solidFill>
                  <a:prstDash val="solid"/>
                  <a:round/>
                  <a:headEnd type="none" w="sm" len="sm"/>
                  <a:tailEnd type="none" w="sm" len="sm"/>
                </a:ln>
              </p:spPr>
            </p:cxnSp>
            <p:cxnSp>
              <p:nvCxnSpPr>
                <p:cNvPr id="1246" name="Google Shape;1246;p11"/>
                <p:cNvCxnSpPr/>
                <p:nvPr/>
              </p:nvCxnSpPr>
              <p:spPr>
                <a:xfrm rot="10800000">
                  <a:off x="1432" y="3089"/>
                  <a:ext cx="9" cy="0"/>
                </a:xfrm>
                <a:prstGeom prst="straightConnector1">
                  <a:avLst/>
                </a:prstGeom>
                <a:noFill/>
                <a:ln w="9525" cap="flat" cmpd="sng">
                  <a:solidFill>
                    <a:srgbClr val="000000"/>
                  </a:solidFill>
                  <a:prstDash val="solid"/>
                  <a:round/>
                  <a:headEnd type="none" w="sm" len="sm"/>
                  <a:tailEnd type="none" w="sm" len="sm"/>
                </a:ln>
              </p:spPr>
            </p:cxnSp>
            <p:cxnSp>
              <p:nvCxnSpPr>
                <p:cNvPr id="1247" name="Google Shape;1247;p11"/>
                <p:cNvCxnSpPr/>
                <p:nvPr/>
              </p:nvCxnSpPr>
              <p:spPr>
                <a:xfrm rot="10800000">
                  <a:off x="1432" y="3054"/>
                  <a:ext cx="9" cy="0"/>
                </a:xfrm>
                <a:prstGeom prst="straightConnector1">
                  <a:avLst/>
                </a:prstGeom>
                <a:noFill/>
                <a:ln w="9525" cap="flat" cmpd="sng">
                  <a:solidFill>
                    <a:srgbClr val="000000"/>
                  </a:solidFill>
                  <a:prstDash val="solid"/>
                  <a:round/>
                  <a:headEnd type="none" w="sm" len="sm"/>
                  <a:tailEnd type="none" w="sm" len="sm"/>
                </a:ln>
              </p:spPr>
            </p:cxnSp>
            <p:cxnSp>
              <p:nvCxnSpPr>
                <p:cNvPr id="1248" name="Google Shape;1248;p11"/>
                <p:cNvCxnSpPr/>
                <p:nvPr/>
              </p:nvCxnSpPr>
              <p:spPr>
                <a:xfrm rot="10800000">
                  <a:off x="1426" y="3018"/>
                  <a:ext cx="15" cy="0"/>
                </a:xfrm>
                <a:prstGeom prst="straightConnector1">
                  <a:avLst/>
                </a:prstGeom>
                <a:noFill/>
                <a:ln w="9525" cap="flat" cmpd="sng">
                  <a:solidFill>
                    <a:srgbClr val="000000"/>
                  </a:solidFill>
                  <a:prstDash val="solid"/>
                  <a:round/>
                  <a:headEnd type="none" w="sm" len="sm"/>
                  <a:tailEnd type="none" w="sm" len="sm"/>
                </a:ln>
              </p:spPr>
            </p:cxnSp>
            <p:sp>
              <p:nvSpPr>
                <p:cNvPr id="1249" name="Google Shape;1249;p11"/>
                <p:cNvSpPr/>
                <p:nvPr/>
              </p:nvSpPr>
              <p:spPr>
                <a:xfrm>
                  <a:off x="1237" y="2971"/>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0.0</a:t>
                  </a:r>
                  <a:endParaRPr sz="800" b="0" i="0" u="none" strike="noStrike" cap="none">
                    <a:solidFill>
                      <a:srgbClr val="000000"/>
                    </a:solidFill>
                    <a:latin typeface="Arial"/>
                    <a:ea typeface="Arial"/>
                    <a:cs typeface="Arial"/>
                    <a:sym typeface="Arial"/>
                  </a:endParaRPr>
                </a:p>
              </p:txBody>
            </p:sp>
            <p:cxnSp>
              <p:nvCxnSpPr>
                <p:cNvPr id="1250" name="Google Shape;1250;p11"/>
                <p:cNvCxnSpPr/>
                <p:nvPr/>
              </p:nvCxnSpPr>
              <p:spPr>
                <a:xfrm rot="10800000">
                  <a:off x="1432" y="2983"/>
                  <a:ext cx="9" cy="0"/>
                </a:xfrm>
                <a:prstGeom prst="straightConnector1">
                  <a:avLst/>
                </a:prstGeom>
                <a:noFill/>
                <a:ln w="9525" cap="flat" cmpd="sng">
                  <a:solidFill>
                    <a:srgbClr val="000000"/>
                  </a:solidFill>
                  <a:prstDash val="solid"/>
                  <a:round/>
                  <a:headEnd type="none" w="sm" len="sm"/>
                  <a:tailEnd type="none" w="sm" len="sm"/>
                </a:ln>
              </p:spPr>
            </p:cxnSp>
            <p:cxnSp>
              <p:nvCxnSpPr>
                <p:cNvPr id="1251" name="Google Shape;1251;p11"/>
                <p:cNvCxnSpPr/>
                <p:nvPr/>
              </p:nvCxnSpPr>
              <p:spPr>
                <a:xfrm rot="10800000">
                  <a:off x="1432" y="2947"/>
                  <a:ext cx="9" cy="0"/>
                </a:xfrm>
                <a:prstGeom prst="straightConnector1">
                  <a:avLst/>
                </a:prstGeom>
                <a:noFill/>
                <a:ln w="9525" cap="flat" cmpd="sng">
                  <a:solidFill>
                    <a:srgbClr val="000000"/>
                  </a:solidFill>
                  <a:prstDash val="solid"/>
                  <a:round/>
                  <a:headEnd type="none" w="sm" len="sm"/>
                  <a:tailEnd type="none" w="sm" len="sm"/>
                </a:ln>
              </p:spPr>
            </p:cxnSp>
            <p:cxnSp>
              <p:nvCxnSpPr>
                <p:cNvPr id="1252" name="Google Shape;1252;p11"/>
                <p:cNvCxnSpPr/>
                <p:nvPr/>
              </p:nvCxnSpPr>
              <p:spPr>
                <a:xfrm rot="10800000">
                  <a:off x="1432" y="2912"/>
                  <a:ext cx="9" cy="0"/>
                </a:xfrm>
                <a:prstGeom prst="straightConnector1">
                  <a:avLst/>
                </a:prstGeom>
                <a:noFill/>
                <a:ln w="9525" cap="flat" cmpd="sng">
                  <a:solidFill>
                    <a:srgbClr val="000000"/>
                  </a:solidFill>
                  <a:prstDash val="solid"/>
                  <a:round/>
                  <a:headEnd type="none" w="sm" len="sm"/>
                  <a:tailEnd type="none" w="sm" len="sm"/>
                </a:ln>
              </p:spPr>
            </p:cxnSp>
            <p:cxnSp>
              <p:nvCxnSpPr>
                <p:cNvPr id="1253" name="Google Shape;1253;p11"/>
                <p:cNvCxnSpPr/>
                <p:nvPr/>
              </p:nvCxnSpPr>
              <p:spPr>
                <a:xfrm rot="10800000">
                  <a:off x="1432" y="2876"/>
                  <a:ext cx="9" cy="0"/>
                </a:xfrm>
                <a:prstGeom prst="straightConnector1">
                  <a:avLst/>
                </a:prstGeom>
                <a:noFill/>
                <a:ln w="9525" cap="flat" cmpd="sng">
                  <a:solidFill>
                    <a:srgbClr val="000000"/>
                  </a:solidFill>
                  <a:prstDash val="solid"/>
                  <a:round/>
                  <a:headEnd type="none" w="sm" len="sm"/>
                  <a:tailEnd type="none" w="sm" len="sm"/>
                </a:ln>
              </p:spPr>
            </p:cxnSp>
            <p:cxnSp>
              <p:nvCxnSpPr>
                <p:cNvPr id="1254" name="Google Shape;1254;p11"/>
                <p:cNvCxnSpPr/>
                <p:nvPr/>
              </p:nvCxnSpPr>
              <p:spPr>
                <a:xfrm rot="10800000">
                  <a:off x="1426" y="2841"/>
                  <a:ext cx="15" cy="0"/>
                </a:xfrm>
                <a:prstGeom prst="straightConnector1">
                  <a:avLst/>
                </a:prstGeom>
                <a:noFill/>
                <a:ln w="9525" cap="flat" cmpd="sng">
                  <a:solidFill>
                    <a:srgbClr val="000000"/>
                  </a:solidFill>
                  <a:prstDash val="solid"/>
                  <a:round/>
                  <a:headEnd type="none" w="sm" len="sm"/>
                  <a:tailEnd type="none" w="sm" len="sm"/>
                </a:ln>
              </p:spPr>
            </p:cxnSp>
            <p:sp>
              <p:nvSpPr>
                <p:cNvPr id="1255" name="Google Shape;1255;p11"/>
                <p:cNvSpPr/>
                <p:nvPr/>
              </p:nvSpPr>
              <p:spPr>
                <a:xfrm>
                  <a:off x="1237" y="2794"/>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5.0</a:t>
                  </a:r>
                  <a:endParaRPr sz="800" b="0" i="0" u="none" strike="noStrike" cap="none">
                    <a:solidFill>
                      <a:srgbClr val="000000"/>
                    </a:solidFill>
                    <a:latin typeface="Arial"/>
                    <a:ea typeface="Arial"/>
                    <a:cs typeface="Arial"/>
                    <a:sym typeface="Arial"/>
                  </a:endParaRPr>
                </a:p>
              </p:txBody>
            </p:sp>
            <p:cxnSp>
              <p:nvCxnSpPr>
                <p:cNvPr id="1256" name="Google Shape;1256;p11"/>
                <p:cNvCxnSpPr/>
                <p:nvPr/>
              </p:nvCxnSpPr>
              <p:spPr>
                <a:xfrm rot="10800000">
                  <a:off x="1432" y="2805"/>
                  <a:ext cx="9" cy="0"/>
                </a:xfrm>
                <a:prstGeom prst="straightConnector1">
                  <a:avLst/>
                </a:prstGeom>
                <a:noFill/>
                <a:ln w="9525" cap="flat" cmpd="sng">
                  <a:solidFill>
                    <a:srgbClr val="000000"/>
                  </a:solidFill>
                  <a:prstDash val="solid"/>
                  <a:round/>
                  <a:headEnd type="none" w="sm" len="sm"/>
                  <a:tailEnd type="none" w="sm" len="sm"/>
                </a:ln>
              </p:spPr>
            </p:cxnSp>
            <p:cxnSp>
              <p:nvCxnSpPr>
                <p:cNvPr id="1257" name="Google Shape;1257;p11"/>
                <p:cNvCxnSpPr/>
                <p:nvPr/>
              </p:nvCxnSpPr>
              <p:spPr>
                <a:xfrm rot="10800000">
                  <a:off x="1432" y="2770"/>
                  <a:ext cx="9" cy="0"/>
                </a:xfrm>
                <a:prstGeom prst="straightConnector1">
                  <a:avLst/>
                </a:prstGeom>
                <a:noFill/>
                <a:ln w="9525" cap="flat" cmpd="sng">
                  <a:solidFill>
                    <a:srgbClr val="000000"/>
                  </a:solidFill>
                  <a:prstDash val="solid"/>
                  <a:round/>
                  <a:headEnd type="none" w="sm" len="sm"/>
                  <a:tailEnd type="none" w="sm" len="sm"/>
                </a:ln>
              </p:spPr>
            </p:cxnSp>
            <p:cxnSp>
              <p:nvCxnSpPr>
                <p:cNvPr id="1258" name="Google Shape;1258;p11"/>
                <p:cNvCxnSpPr/>
                <p:nvPr/>
              </p:nvCxnSpPr>
              <p:spPr>
                <a:xfrm rot="10800000">
                  <a:off x="1432" y="2734"/>
                  <a:ext cx="9" cy="0"/>
                </a:xfrm>
                <a:prstGeom prst="straightConnector1">
                  <a:avLst/>
                </a:prstGeom>
                <a:noFill/>
                <a:ln w="9525" cap="flat" cmpd="sng">
                  <a:solidFill>
                    <a:srgbClr val="000000"/>
                  </a:solidFill>
                  <a:prstDash val="solid"/>
                  <a:round/>
                  <a:headEnd type="none" w="sm" len="sm"/>
                  <a:tailEnd type="none" w="sm" len="sm"/>
                </a:ln>
              </p:spPr>
            </p:cxnSp>
            <p:cxnSp>
              <p:nvCxnSpPr>
                <p:cNvPr id="1259" name="Google Shape;1259;p11"/>
                <p:cNvCxnSpPr/>
                <p:nvPr/>
              </p:nvCxnSpPr>
              <p:spPr>
                <a:xfrm rot="10800000">
                  <a:off x="1432" y="2699"/>
                  <a:ext cx="9" cy="0"/>
                </a:xfrm>
                <a:prstGeom prst="straightConnector1">
                  <a:avLst/>
                </a:prstGeom>
                <a:noFill/>
                <a:ln w="9525" cap="flat" cmpd="sng">
                  <a:solidFill>
                    <a:srgbClr val="000000"/>
                  </a:solidFill>
                  <a:prstDash val="solid"/>
                  <a:round/>
                  <a:headEnd type="none" w="sm" len="sm"/>
                  <a:tailEnd type="none" w="sm" len="sm"/>
                </a:ln>
              </p:spPr>
            </p:cxnSp>
            <p:cxnSp>
              <p:nvCxnSpPr>
                <p:cNvPr id="1260" name="Google Shape;1260;p11"/>
                <p:cNvCxnSpPr/>
                <p:nvPr/>
              </p:nvCxnSpPr>
              <p:spPr>
                <a:xfrm rot="10800000">
                  <a:off x="1426" y="2663"/>
                  <a:ext cx="15" cy="0"/>
                </a:xfrm>
                <a:prstGeom prst="straightConnector1">
                  <a:avLst/>
                </a:prstGeom>
                <a:noFill/>
                <a:ln w="9525" cap="flat" cmpd="sng">
                  <a:solidFill>
                    <a:srgbClr val="000000"/>
                  </a:solidFill>
                  <a:prstDash val="solid"/>
                  <a:round/>
                  <a:headEnd type="none" w="sm" len="sm"/>
                  <a:tailEnd type="none" w="sm" len="sm"/>
                </a:ln>
              </p:spPr>
            </p:cxnSp>
            <p:sp>
              <p:nvSpPr>
                <p:cNvPr id="1261" name="Google Shape;1261;p11"/>
                <p:cNvSpPr/>
                <p:nvPr/>
              </p:nvSpPr>
              <p:spPr>
                <a:xfrm>
                  <a:off x="1237" y="2616"/>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20.0</a:t>
                  </a:r>
                  <a:endParaRPr sz="800" b="0" i="0" u="none" strike="noStrike" cap="none">
                    <a:solidFill>
                      <a:srgbClr val="000000"/>
                    </a:solidFill>
                    <a:latin typeface="Arial"/>
                    <a:ea typeface="Arial"/>
                    <a:cs typeface="Arial"/>
                    <a:sym typeface="Arial"/>
                  </a:endParaRPr>
                </a:p>
              </p:txBody>
            </p:sp>
            <p:cxnSp>
              <p:nvCxnSpPr>
                <p:cNvPr id="1262" name="Google Shape;1262;p11"/>
                <p:cNvCxnSpPr/>
                <p:nvPr/>
              </p:nvCxnSpPr>
              <p:spPr>
                <a:xfrm rot="10800000">
                  <a:off x="1432" y="2628"/>
                  <a:ext cx="9" cy="0"/>
                </a:xfrm>
                <a:prstGeom prst="straightConnector1">
                  <a:avLst/>
                </a:prstGeom>
                <a:noFill/>
                <a:ln w="9525" cap="flat" cmpd="sng">
                  <a:solidFill>
                    <a:srgbClr val="000000"/>
                  </a:solidFill>
                  <a:prstDash val="solid"/>
                  <a:round/>
                  <a:headEnd type="none" w="sm" len="sm"/>
                  <a:tailEnd type="none" w="sm" len="sm"/>
                </a:ln>
              </p:spPr>
            </p:cxnSp>
            <p:cxnSp>
              <p:nvCxnSpPr>
                <p:cNvPr id="1263" name="Google Shape;1263;p11"/>
                <p:cNvCxnSpPr/>
                <p:nvPr/>
              </p:nvCxnSpPr>
              <p:spPr>
                <a:xfrm rot="10800000">
                  <a:off x="1432" y="2592"/>
                  <a:ext cx="9" cy="0"/>
                </a:xfrm>
                <a:prstGeom prst="straightConnector1">
                  <a:avLst/>
                </a:prstGeom>
                <a:noFill/>
                <a:ln w="9525" cap="flat" cmpd="sng">
                  <a:solidFill>
                    <a:srgbClr val="000000"/>
                  </a:solidFill>
                  <a:prstDash val="solid"/>
                  <a:round/>
                  <a:headEnd type="none" w="sm" len="sm"/>
                  <a:tailEnd type="none" w="sm" len="sm"/>
                </a:ln>
              </p:spPr>
            </p:cxnSp>
            <p:cxnSp>
              <p:nvCxnSpPr>
                <p:cNvPr id="1264" name="Google Shape;1264;p11"/>
                <p:cNvCxnSpPr/>
                <p:nvPr/>
              </p:nvCxnSpPr>
              <p:spPr>
                <a:xfrm rot="10800000">
                  <a:off x="1432" y="2557"/>
                  <a:ext cx="9" cy="0"/>
                </a:xfrm>
                <a:prstGeom prst="straightConnector1">
                  <a:avLst/>
                </a:prstGeom>
                <a:noFill/>
                <a:ln w="9525" cap="flat" cmpd="sng">
                  <a:solidFill>
                    <a:srgbClr val="000000"/>
                  </a:solidFill>
                  <a:prstDash val="solid"/>
                  <a:round/>
                  <a:headEnd type="none" w="sm" len="sm"/>
                  <a:tailEnd type="none" w="sm" len="sm"/>
                </a:ln>
              </p:spPr>
            </p:cxnSp>
            <p:cxnSp>
              <p:nvCxnSpPr>
                <p:cNvPr id="1265" name="Google Shape;1265;p11"/>
                <p:cNvCxnSpPr/>
                <p:nvPr/>
              </p:nvCxnSpPr>
              <p:spPr>
                <a:xfrm rot="10800000">
                  <a:off x="1432" y="2521"/>
                  <a:ext cx="9" cy="0"/>
                </a:xfrm>
                <a:prstGeom prst="straightConnector1">
                  <a:avLst/>
                </a:prstGeom>
                <a:noFill/>
                <a:ln w="9525" cap="flat" cmpd="sng">
                  <a:solidFill>
                    <a:srgbClr val="000000"/>
                  </a:solidFill>
                  <a:prstDash val="solid"/>
                  <a:round/>
                  <a:headEnd type="none" w="sm" len="sm"/>
                  <a:tailEnd type="none" w="sm" len="sm"/>
                </a:ln>
              </p:spPr>
            </p:cxnSp>
            <p:cxnSp>
              <p:nvCxnSpPr>
                <p:cNvPr id="1266" name="Google Shape;1266;p11"/>
                <p:cNvCxnSpPr/>
                <p:nvPr/>
              </p:nvCxnSpPr>
              <p:spPr>
                <a:xfrm rot="10800000">
                  <a:off x="1426" y="2486"/>
                  <a:ext cx="15" cy="0"/>
                </a:xfrm>
                <a:prstGeom prst="straightConnector1">
                  <a:avLst/>
                </a:prstGeom>
                <a:noFill/>
                <a:ln w="9525" cap="flat" cmpd="sng">
                  <a:solidFill>
                    <a:srgbClr val="000000"/>
                  </a:solidFill>
                  <a:prstDash val="solid"/>
                  <a:round/>
                  <a:headEnd type="none" w="sm" len="sm"/>
                  <a:tailEnd type="none" w="sm" len="sm"/>
                </a:ln>
              </p:spPr>
            </p:cxnSp>
            <p:sp>
              <p:nvSpPr>
                <p:cNvPr id="1267" name="Google Shape;1267;p11"/>
                <p:cNvSpPr/>
                <p:nvPr/>
              </p:nvSpPr>
              <p:spPr>
                <a:xfrm>
                  <a:off x="1237" y="2438"/>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25.0</a:t>
                  </a:r>
                  <a:endParaRPr sz="800" b="0" i="0" u="none" strike="noStrike" cap="none">
                    <a:solidFill>
                      <a:srgbClr val="000000"/>
                    </a:solidFill>
                    <a:latin typeface="Arial"/>
                    <a:ea typeface="Arial"/>
                    <a:cs typeface="Arial"/>
                    <a:sym typeface="Arial"/>
                  </a:endParaRPr>
                </a:p>
              </p:txBody>
            </p:sp>
            <p:cxnSp>
              <p:nvCxnSpPr>
                <p:cNvPr id="1268" name="Google Shape;1268;p11"/>
                <p:cNvCxnSpPr/>
                <p:nvPr/>
              </p:nvCxnSpPr>
              <p:spPr>
                <a:xfrm rot="10800000">
                  <a:off x="1432" y="2450"/>
                  <a:ext cx="9" cy="0"/>
                </a:xfrm>
                <a:prstGeom prst="straightConnector1">
                  <a:avLst/>
                </a:prstGeom>
                <a:noFill/>
                <a:ln w="9525" cap="flat" cmpd="sng">
                  <a:solidFill>
                    <a:srgbClr val="000000"/>
                  </a:solidFill>
                  <a:prstDash val="solid"/>
                  <a:round/>
                  <a:headEnd type="none" w="sm" len="sm"/>
                  <a:tailEnd type="none" w="sm" len="sm"/>
                </a:ln>
              </p:spPr>
            </p:cxnSp>
            <p:cxnSp>
              <p:nvCxnSpPr>
                <p:cNvPr id="1269" name="Google Shape;1269;p11"/>
                <p:cNvCxnSpPr/>
                <p:nvPr/>
              </p:nvCxnSpPr>
              <p:spPr>
                <a:xfrm rot="10800000">
                  <a:off x="1432" y="2415"/>
                  <a:ext cx="9" cy="0"/>
                </a:xfrm>
                <a:prstGeom prst="straightConnector1">
                  <a:avLst/>
                </a:prstGeom>
                <a:noFill/>
                <a:ln w="9525" cap="flat" cmpd="sng">
                  <a:solidFill>
                    <a:srgbClr val="000000"/>
                  </a:solidFill>
                  <a:prstDash val="solid"/>
                  <a:round/>
                  <a:headEnd type="none" w="sm" len="sm"/>
                  <a:tailEnd type="none" w="sm" len="sm"/>
                </a:ln>
              </p:spPr>
            </p:cxnSp>
            <p:cxnSp>
              <p:nvCxnSpPr>
                <p:cNvPr id="1270" name="Google Shape;1270;p11"/>
                <p:cNvCxnSpPr/>
                <p:nvPr/>
              </p:nvCxnSpPr>
              <p:spPr>
                <a:xfrm rot="10800000">
                  <a:off x="1432" y="2379"/>
                  <a:ext cx="9" cy="0"/>
                </a:xfrm>
                <a:prstGeom prst="straightConnector1">
                  <a:avLst/>
                </a:prstGeom>
                <a:noFill/>
                <a:ln w="9525" cap="flat" cmpd="sng">
                  <a:solidFill>
                    <a:srgbClr val="000000"/>
                  </a:solidFill>
                  <a:prstDash val="solid"/>
                  <a:round/>
                  <a:headEnd type="none" w="sm" len="sm"/>
                  <a:tailEnd type="none" w="sm" len="sm"/>
                </a:ln>
              </p:spPr>
            </p:cxnSp>
            <p:cxnSp>
              <p:nvCxnSpPr>
                <p:cNvPr id="1271" name="Google Shape;1271;p11"/>
                <p:cNvCxnSpPr/>
                <p:nvPr/>
              </p:nvCxnSpPr>
              <p:spPr>
                <a:xfrm rot="10800000">
                  <a:off x="1432" y="2344"/>
                  <a:ext cx="9" cy="0"/>
                </a:xfrm>
                <a:prstGeom prst="straightConnector1">
                  <a:avLst/>
                </a:prstGeom>
                <a:noFill/>
                <a:ln w="9525" cap="flat" cmpd="sng">
                  <a:solidFill>
                    <a:srgbClr val="000000"/>
                  </a:solidFill>
                  <a:prstDash val="solid"/>
                  <a:round/>
                  <a:headEnd type="none" w="sm" len="sm"/>
                  <a:tailEnd type="none" w="sm" len="sm"/>
                </a:ln>
              </p:spPr>
            </p:cxnSp>
            <p:cxnSp>
              <p:nvCxnSpPr>
                <p:cNvPr id="1272" name="Google Shape;1272;p11"/>
                <p:cNvCxnSpPr/>
                <p:nvPr/>
              </p:nvCxnSpPr>
              <p:spPr>
                <a:xfrm rot="10800000">
                  <a:off x="1426" y="2308"/>
                  <a:ext cx="15" cy="0"/>
                </a:xfrm>
                <a:prstGeom prst="straightConnector1">
                  <a:avLst/>
                </a:prstGeom>
                <a:noFill/>
                <a:ln w="9525" cap="flat" cmpd="sng">
                  <a:solidFill>
                    <a:srgbClr val="000000"/>
                  </a:solidFill>
                  <a:prstDash val="solid"/>
                  <a:round/>
                  <a:headEnd type="none" w="sm" len="sm"/>
                  <a:tailEnd type="none" w="sm" len="sm"/>
                </a:ln>
              </p:spPr>
            </p:cxnSp>
            <p:sp>
              <p:nvSpPr>
                <p:cNvPr id="1273" name="Google Shape;1273;p11"/>
                <p:cNvSpPr/>
                <p:nvPr/>
              </p:nvSpPr>
              <p:spPr>
                <a:xfrm>
                  <a:off x="1237" y="2261"/>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30.0</a:t>
                  </a:r>
                  <a:endParaRPr sz="800" b="0" i="0" u="none" strike="noStrike" cap="none">
                    <a:solidFill>
                      <a:srgbClr val="000000"/>
                    </a:solidFill>
                    <a:latin typeface="Arial"/>
                    <a:ea typeface="Arial"/>
                    <a:cs typeface="Arial"/>
                    <a:sym typeface="Arial"/>
                  </a:endParaRPr>
                </a:p>
              </p:txBody>
            </p:sp>
            <p:cxnSp>
              <p:nvCxnSpPr>
                <p:cNvPr id="1274" name="Google Shape;1274;p11"/>
                <p:cNvCxnSpPr/>
                <p:nvPr/>
              </p:nvCxnSpPr>
              <p:spPr>
                <a:xfrm rot="10800000">
                  <a:off x="1432" y="2273"/>
                  <a:ext cx="9" cy="0"/>
                </a:xfrm>
                <a:prstGeom prst="straightConnector1">
                  <a:avLst/>
                </a:prstGeom>
                <a:noFill/>
                <a:ln w="9525" cap="flat" cmpd="sng">
                  <a:solidFill>
                    <a:srgbClr val="000000"/>
                  </a:solidFill>
                  <a:prstDash val="solid"/>
                  <a:round/>
                  <a:headEnd type="none" w="sm" len="sm"/>
                  <a:tailEnd type="none" w="sm" len="sm"/>
                </a:ln>
              </p:spPr>
            </p:cxnSp>
            <p:cxnSp>
              <p:nvCxnSpPr>
                <p:cNvPr id="1275" name="Google Shape;1275;p11"/>
                <p:cNvCxnSpPr/>
                <p:nvPr/>
              </p:nvCxnSpPr>
              <p:spPr>
                <a:xfrm rot="10800000">
                  <a:off x="1432" y="2237"/>
                  <a:ext cx="9" cy="0"/>
                </a:xfrm>
                <a:prstGeom prst="straightConnector1">
                  <a:avLst/>
                </a:prstGeom>
                <a:noFill/>
                <a:ln w="9525" cap="flat" cmpd="sng">
                  <a:solidFill>
                    <a:srgbClr val="000000"/>
                  </a:solidFill>
                  <a:prstDash val="solid"/>
                  <a:round/>
                  <a:headEnd type="none" w="sm" len="sm"/>
                  <a:tailEnd type="none" w="sm" len="sm"/>
                </a:ln>
              </p:spPr>
            </p:cxnSp>
            <p:cxnSp>
              <p:nvCxnSpPr>
                <p:cNvPr id="1276" name="Google Shape;1276;p11"/>
                <p:cNvCxnSpPr/>
                <p:nvPr/>
              </p:nvCxnSpPr>
              <p:spPr>
                <a:xfrm rot="10800000">
                  <a:off x="1432" y="2202"/>
                  <a:ext cx="9" cy="0"/>
                </a:xfrm>
                <a:prstGeom prst="straightConnector1">
                  <a:avLst/>
                </a:prstGeom>
                <a:noFill/>
                <a:ln w="9525" cap="flat" cmpd="sng">
                  <a:solidFill>
                    <a:srgbClr val="000000"/>
                  </a:solidFill>
                  <a:prstDash val="solid"/>
                  <a:round/>
                  <a:headEnd type="none" w="sm" len="sm"/>
                  <a:tailEnd type="none" w="sm" len="sm"/>
                </a:ln>
              </p:spPr>
            </p:cxnSp>
            <p:cxnSp>
              <p:nvCxnSpPr>
                <p:cNvPr id="1277" name="Google Shape;1277;p11"/>
                <p:cNvCxnSpPr/>
                <p:nvPr/>
              </p:nvCxnSpPr>
              <p:spPr>
                <a:xfrm rot="10800000">
                  <a:off x="1432" y="2166"/>
                  <a:ext cx="9" cy="0"/>
                </a:xfrm>
                <a:prstGeom prst="straightConnector1">
                  <a:avLst/>
                </a:prstGeom>
                <a:noFill/>
                <a:ln w="9525" cap="flat" cmpd="sng">
                  <a:solidFill>
                    <a:srgbClr val="000000"/>
                  </a:solidFill>
                  <a:prstDash val="solid"/>
                  <a:round/>
                  <a:headEnd type="none" w="sm" len="sm"/>
                  <a:tailEnd type="none" w="sm" len="sm"/>
                </a:ln>
              </p:spPr>
            </p:cxnSp>
            <p:cxnSp>
              <p:nvCxnSpPr>
                <p:cNvPr id="1278" name="Google Shape;1278;p11"/>
                <p:cNvCxnSpPr/>
                <p:nvPr/>
              </p:nvCxnSpPr>
              <p:spPr>
                <a:xfrm rot="10800000">
                  <a:off x="1426" y="2131"/>
                  <a:ext cx="15" cy="0"/>
                </a:xfrm>
                <a:prstGeom prst="straightConnector1">
                  <a:avLst/>
                </a:prstGeom>
                <a:noFill/>
                <a:ln w="9525" cap="flat" cmpd="sng">
                  <a:solidFill>
                    <a:srgbClr val="000000"/>
                  </a:solidFill>
                  <a:prstDash val="solid"/>
                  <a:round/>
                  <a:headEnd type="none" w="sm" len="sm"/>
                  <a:tailEnd type="none" w="sm" len="sm"/>
                </a:ln>
              </p:spPr>
            </p:cxnSp>
            <p:sp>
              <p:nvSpPr>
                <p:cNvPr id="1279" name="Google Shape;1279;p11"/>
                <p:cNvSpPr/>
                <p:nvPr/>
              </p:nvSpPr>
              <p:spPr>
                <a:xfrm>
                  <a:off x="1237" y="2083"/>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35.0</a:t>
                  </a:r>
                  <a:endParaRPr sz="800" b="0" i="0" u="none" strike="noStrike" cap="none">
                    <a:solidFill>
                      <a:srgbClr val="000000"/>
                    </a:solidFill>
                    <a:latin typeface="Arial"/>
                    <a:ea typeface="Arial"/>
                    <a:cs typeface="Arial"/>
                    <a:sym typeface="Arial"/>
                  </a:endParaRPr>
                </a:p>
              </p:txBody>
            </p:sp>
            <p:cxnSp>
              <p:nvCxnSpPr>
                <p:cNvPr id="1280" name="Google Shape;1280;p11"/>
                <p:cNvCxnSpPr/>
                <p:nvPr/>
              </p:nvCxnSpPr>
              <p:spPr>
                <a:xfrm rot="10800000">
                  <a:off x="1432" y="2095"/>
                  <a:ext cx="9" cy="0"/>
                </a:xfrm>
                <a:prstGeom prst="straightConnector1">
                  <a:avLst/>
                </a:prstGeom>
                <a:noFill/>
                <a:ln w="9525" cap="flat" cmpd="sng">
                  <a:solidFill>
                    <a:srgbClr val="000000"/>
                  </a:solidFill>
                  <a:prstDash val="solid"/>
                  <a:round/>
                  <a:headEnd type="none" w="sm" len="sm"/>
                  <a:tailEnd type="none" w="sm" len="sm"/>
                </a:ln>
              </p:spPr>
            </p:cxnSp>
            <p:cxnSp>
              <p:nvCxnSpPr>
                <p:cNvPr id="1281" name="Google Shape;1281;p11"/>
                <p:cNvCxnSpPr/>
                <p:nvPr/>
              </p:nvCxnSpPr>
              <p:spPr>
                <a:xfrm rot="10800000">
                  <a:off x="1432" y="2060"/>
                  <a:ext cx="9" cy="0"/>
                </a:xfrm>
                <a:prstGeom prst="straightConnector1">
                  <a:avLst/>
                </a:prstGeom>
                <a:noFill/>
                <a:ln w="9525" cap="flat" cmpd="sng">
                  <a:solidFill>
                    <a:srgbClr val="000000"/>
                  </a:solidFill>
                  <a:prstDash val="solid"/>
                  <a:round/>
                  <a:headEnd type="none" w="sm" len="sm"/>
                  <a:tailEnd type="none" w="sm" len="sm"/>
                </a:ln>
              </p:spPr>
            </p:cxnSp>
            <p:cxnSp>
              <p:nvCxnSpPr>
                <p:cNvPr id="1282" name="Google Shape;1282;p11"/>
                <p:cNvCxnSpPr/>
                <p:nvPr/>
              </p:nvCxnSpPr>
              <p:spPr>
                <a:xfrm rot="10800000">
                  <a:off x="1432" y="2024"/>
                  <a:ext cx="9" cy="0"/>
                </a:xfrm>
                <a:prstGeom prst="straightConnector1">
                  <a:avLst/>
                </a:prstGeom>
                <a:noFill/>
                <a:ln w="9525" cap="flat" cmpd="sng">
                  <a:solidFill>
                    <a:srgbClr val="000000"/>
                  </a:solidFill>
                  <a:prstDash val="solid"/>
                  <a:round/>
                  <a:headEnd type="none" w="sm" len="sm"/>
                  <a:tailEnd type="none" w="sm" len="sm"/>
                </a:ln>
              </p:spPr>
            </p:cxnSp>
            <p:cxnSp>
              <p:nvCxnSpPr>
                <p:cNvPr id="1283" name="Google Shape;1283;p11"/>
                <p:cNvCxnSpPr/>
                <p:nvPr/>
              </p:nvCxnSpPr>
              <p:spPr>
                <a:xfrm rot="10800000">
                  <a:off x="1432" y="1989"/>
                  <a:ext cx="9" cy="0"/>
                </a:xfrm>
                <a:prstGeom prst="straightConnector1">
                  <a:avLst/>
                </a:prstGeom>
                <a:noFill/>
                <a:ln w="9525" cap="flat" cmpd="sng">
                  <a:solidFill>
                    <a:srgbClr val="000000"/>
                  </a:solidFill>
                  <a:prstDash val="solid"/>
                  <a:round/>
                  <a:headEnd type="none" w="sm" len="sm"/>
                  <a:tailEnd type="none" w="sm" len="sm"/>
                </a:ln>
              </p:spPr>
            </p:cxnSp>
            <p:cxnSp>
              <p:nvCxnSpPr>
                <p:cNvPr id="1284" name="Google Shape;1284;p11"/>
                <p:cNvCxnSpPr/>
                <p:nvPr/>
              </p:nvCxnSpPr>
              <p:spPr>
                <a:xfrm rot="10800000">
                  <a:off x="1426" y="1953"/>
                  <a:ext cx="15" cy="0"/>
                </a:xfrm>
                <a:prstGeom prst="straightConnector1">
                  <a:avLst/>
                </a:prstGeom>
                <a:noFill/>
                <a:ln w="9525" cap="flat" cmpd="sng">
                  <a:solidFill>
                    <a:srgbClr val="000000"/>
                  </a:solidFill>
                  <a:prstDash val="solid"/>
                  <a:round/>
                  <a:headEnd type="none" w="sm" len="sm"/>
                  <a:tailEnd type="none" w="sm" len="sm"/>
                </a:ln>
              </p:spPr>
            </p:cxnSp>
            <p:sp>
              <p:nvSpPr>
                <p:cNvPr id="1285" name="Google Shape;1285;p11"/>
                <p:cNvSpPr/>
                <p:nvPr/>
              </p:nvSpPr>
              <p:spPr>
                <a:xfrm>
                  <a:off x="1237" y="1905"/>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40.0</a:t>
                  </a:r>
                  <a:endParaRPr sz="800" b="0" i="0" u="none" strike="noStrike" cap="none">
                    <a:solidFill>
                      <a:srgbClr val="000000"/>
                    </a:solidFill>
                    <a:latin typeface="Arial"/>
                    <a:ea typeface="Arial"/>
                    <a:cs typeface="Arial"/>
                    <a:sym typeface="Arial"/>
                  </a:endParaRPr>
                </a:p>
              </p:txBody>
            </p:sp>
            <p:cxnSp>
              <p:nvCxnSpPr>
                <p:cNvPr id="1286" name="Google Shape;1286;p11"/>
                <p:cNvCxnSpPr/>
                <p:nvPr/>
              </p:nvCxnSpPr>
              <p:spPr>
                <a:xfrm rot="10800000">
                  <a:off x="1432" y="1918"/>
                  <a:ext cx="9" cy="0"/>
                </a:xfrm>
                <a:prstGeom prst="straightConnector1">
                  <a:avLst/>
                </a:prstGeom>
                <a:noFill/>
                <a:ln w="9525" cap="flat" cmpd="sng">
                  <a:solidFill>
                    <a:srgbClr val="000000"/>
                  </a:solidFill>
                  <a:prstDash val="solid"/>
                  <a:round/>
                  <a:headEnd type="none" w="sm" len="sm"/>
                  <a:tailEnd type="none" w="sm" len="sm"/>
                </a:ln>
              </p:spPr>
            </p:cxnSp>
            <p:cxnSp>
              <p:nvCxnSpPr>
                <p:cNvPr id="1287" name="Google Shape;1287;p11"/>
                <p:cNvCxnSpPr/>
                <p:nvPr/>
              </p:nvCxnSpPr>
              <p:spPr>
                <a:xfrm rot="10800000">
                  <a:off x="1432" y="1882"/>
                  <a:ext cx="9" cy="0"/>
                </a:xfrm>
                <a:prstGeom prst="straightConnector1">
                  <a:avLst/>
                </a:prstGeom>
                <a:noFill/>
                <a:ln w="9525" cap="flat" cmpd="sng">
                  <a:solidFill>
                    <a:srgbClr val="000000"/>
                  </a:solidFill>
                  <a:prstDash val="solid"/>
                  <a:round/>
                  <a:headEnd type="none" w="sm" len="sm"/>
                  <a:tailEnd type="none" w="sm" len="sm"/>
                </a:ln>
              </p:spPr>
            </p:cxnSp>
            <p:cxnSp>
              <p:nvCxnSpPr>
                <p:cNvPr id="1288" name="Google Shape;1288;p11"/>
                <p:cNvCxnSpPr/>
                <p:nvPr/>
              </p:nvCxnSpPr>
              <p:spPr>
                <a:xfrm rot="10800000">
                  <a:off x="1432" y="1847"/>
                  <a:ext cx="9" cy="0"/>
                </a:xfrm>
                <a:prstGeom prst="straightConnector1">
                  <a:avLst/>
                </a:prstGeom>
                <a:noFill/>
                <a:ln w="9525" cap="flat" cmpd="sng">
                  <a:solidFill>
                    <a:srgbClr val="000000"/>
                  </a:solidFill>
                  <a:prstDash val="solid"/>
                  <a:round/>
                  <a:headEnd type="none" w="sm" len="sm"/>
                  <a:tailEnd type="none" w="sm" len="sm"/>
                </a:ln>
              </p:spPr>
            </p:cxnSp>
            <p:cxnSp>
              <p:nvCxnSpPr>
                <p:cNvPr id="1289" name="Google Shape;1289;p11"/>
                <p:cNvCxnSpPr/>
                <p:nvPr/>
              </p:nvCxnSpPr>
              <p:spPr>
                <a:xfrm rot="10800000">
                  <a:off x="1432" y="1811"/>
                  <a:ext cx="9" cy="0"/>
                </a:xfrm>
                <a:prstGeom prst="straightConnector1">
                  <a:avLst/>
                </a:prstGeom>
                <a:noFill/>
                <a:ln w="9525" cap="flat" cmpd="sng">
                  <a:solidFill>
                    <a:srgbClr val="000000"/>
                  </a:solidFill>
                  <a:prstDash val="solid"/>
                  <a:round/>
                  <a:headEnd type="none" w="sm" len="sm"/>
                  <a:tailEnd type="none" w="sm" len="sm"/>
                </a:ln>
              </p:spPr>
            </p:cxnSp>
            <p:cxnSp>
              <p:nvCxnSpPr>
                <p:cNvPr id="1290" name="Google Shape;1290;p11"/>
                <p:cNvCxnSpPr/>
                <p:nvPr/>
              </p:nvCxnSpPr>
              <p:spPr>
                <a:xfrm rot="10800000">
                  <a:off x="1426" y="1775"/>
                  <a:ext cx="15" cy="0"/>
                </a:xfrm>
                <a:prstGeom prst="straightConnector1">
                  <a:avLst/>
                </a:prstGeom>
                <a:noFill/>
                <a:ln w="9525" cap="flat" cmpd="sng">
                  <a:solidFill>
                    <a:srgbClr val="000000"/>
                  </a:solidFill>
                  <a:prstDash val="solid"/>
                  <a:round/>
                  <a:headEnd type="none" w="sm" len="sm"/>
                  <a:tailEnd type="none" w="sm" len="sm"/>
                </a:ln>
              </p:spPr>
            </p:cxnSp>
            <p:sp>
              <p:nvSpPr>
                <p:cNvPr id="1291" name="Google Shape;1291;p11"/>
                <p:cNvSpPr/>
                <p:nvPr/>
              </p:nvSpPr>
              <p:spPr>
                <a:xfrm>
                  <a:off x="1237" y="1728"/>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45.0</a:t>
                  </a:r>
                  <a:endParaRPr sz="800" b="0" i="0" u="none" strike="noStrike" cap="none">
                    <a:solidFill>
                      <a:srgbClr val="000000"/>
                    </a:solidFill>
                    <a:latin typeface="Arial"/>
                    <a:ea typeface="Arial"/>
                    <a:cs typeface="Arial"/>
                    <a:sym typeface="Arial"/>
                  </a:endParaRPr>
                </a:p>
              </p:txBody>
            </p:sp>
            <p:cxnSp>
              <p:nvCxnSpPr>
                <p:cNvPr id="1292" name="Google Shape;1292;p11"/>
                <p:cNvCxnSpPr/>
                <p:nvPr/>
              </p:nvCxnSpPr>
              <p:spPr>
                <a:xfrm rot="10800000">
                  <a:off x="1432" y="1740"/>
                  <a:ext cx="9" cy="0"/>
                </a:xfrm>
                <a:prstGeom prst="straightConnector1">
                  <a:avLst/>
                </a:prstGeom>
                <a:noFill/>
                <a:ln w="9525" cap="flat" cmpd="sng">
                  <a:solidFill>
                    <a:srgbClr val="000000"/>
                  </a:solidFill>
                  <a:prstDash val="solid"/>
                  <a:round/>
                  <a:headEnd type="none" w="sm" len="sm"/>
                  <a:tailEnd type="none" w="sm" len="sm"/>
                </a:ln>
              </p:spPr>
            </p:cxnSp>
            <p:cxnSp>
              <p:nvCxnSpPr>
                <p:cNvPr id="1293" name="Google Shape;1293;p11"/>
                <p:cNvCxnSpPr/>
                <p:nvPr/>
              </p:nvCxnSpPr>
              <p:spPr>
                <a:xfrm rot="10800000">
                  <a:off x="1432" y="1704"/>
                  <a:ext cx="9" cy="0"/>
                </a:xfrm>
                <a:prstGeom prst="straightConnector1">
                  <a:avLst/>
                </a:prstGeom>
                <a:noFill/>
                <a:ln w="9525" cap="flat" cmpd="sng">
                  <a:solidFill>
                    <a:srgbClr val="000000"/>
                  </a:solidFill>
                  <a:prstDash val="solid"/>
                  <a:round/>
                  <a:headEnd type="none" w="sm" len="sm"/>
                  <a:tailEnd type="none" w="sm" len="sm"/>
                </a:ln>
              </p:spPr>
            </p:cxnSp>
            <p:cxnSp>
              <p:nvCxnSpPr>
                <p:cNvPr id="1294" name="Google Shape;1294;p11"/>
                <p:cNvCxnSpPr/>
                <p:nvPr/>
              </p:nvCxnSpPr>
              <p:spPr>
                <a:xfrm rot="10800000">
                  <a:off x="1432" y="1669"/>
                  <a:ext cx="9" cy="0"/>
                </a:xfrm>
                <a:prstGeom prst="straightConnector1">
                  <a:avLst/>
                </a:prstGeom>
                <a:noFill/>
                <a:ln w="9525" cap="flat" cmpd="sng">
                  <a:solidFill>
                    <a:srgbClr val="000000"/>
                  </a:solidFill>
                  <a:prstDash val="solid"/>
                  <a:round/>
                  <a:headEnd type="none" w="sm" len="sm"/>
                  <a:tailEnd type="none" w="sm" len="sm"/>
                </a:ln>
              </p:spPr>
            </p:cxnSp>
            <p:cxnSp>
              <p:nvCxnSpPr>
                <p:cNvPr id="1295" name="Google Shape;1295;p11"/>
                <p:cNvCxnSpPr/>
                <p:nvPr/>
              </p:nvCxnSpPr>
              <p:spPr>
                <a:xfrm rot="10800000">
                  <a:off x="1432" y="1633"/>
                  <a:ext cx="9" cy="0"/>
                </a:xfrm>
                <a:prstGeom prst="straightConnector1">
                  <a:avLst/>
                </a:prstGeom>
                <a:noFill/>
                <a:ln w="9525" cap="flat" cmpd="sng">
                  <a:solidFill>
                    <a:srgbClr val="000000"/>
                  </a:solidFill>
                  <a:prstDash val="solid"/>
                  <a:round/>
                  <a:headEnd type="none" w="sm" len="sm"/>
                  <a:tailEnd type="none" w="sm" len="sm"/>
                </a:ln>
              </p:spPr>
            </p:cxnSp>
            <p:cxnSp>
              <p:nvCxnSpPr>
                <p:cNvPr id="1296" name="Google Shape;1296;p11"/>
                <p:cNvCxnSpPr/>
                <p:nvPr/>
              </p:nvCxnSpPr>
              <p:spPr>
                <a:xfrm rot="10800000">
                  <a:off x="1426" y="1598"/>
                  <a:ext cx="15" cy="0"/>
                </a:xfrm>
                <a:prstGeom prst="straightConnector1">
                  <a:avLst/>
                </a:prstGeom>
                <a:noFill/>
                <a:ln w="9525" cap="flat" cmpd="sng">
                  <a:solidFill>
                    <a:srgbClr val="000000"/>
                  </a:solidFill>
                  <a:prstDash val="solid"/>
                  <a:round/>
                  <a:headEnd type="none" w="sm" len="sm"/>
                  <a:tailEnd type="none" w="sm" len="sm"/>
                </a:ln>
              </p:spPr>
            </p:cxnSp>
            <p:sp>
              <p:nvSpPr>
                <p:cNvPr id="1297" name="Google Shape;1297;p11"/>
                <p:cNvSpPr/>
                <p:nvPr/>
              </p:nvSpPr>
              <p:spPr>
                <a:xfrm>
                  <a:off x="1237" y="1550"/>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50.0</a:t>
                  </a:r>
                  <a:endParaRPr sz="800" b="0" i="0" u="none" strike="noStrike" cap="none">
                    <a:solidFill>
                      <a:srgbClr val="000000"/>
                    </a:solidFill>
                    <a:latin typeface="Arial"/>
                    <a:ea typeface="Arial"/>
                    <a:cs typeface="Arial"/>
                    <a:sym typeface="Arial"/>
                  </a:endParaRPr>
                </a:p>
              </p:txBody>
            </p:sp>
            <p:cxnSp>
              <p:nvCxnSpPr>
                <p:cNvPr id="1298" name="Google Shape;1298;p11"/>
                <p:cNvCxnSpPr/>
                <p:nvPr/>
              </p:nvCxnSpPr>
              <p:spPr>
                <a:xfrm rot="10800000">
                  <a:off x="1432" y="1562"/>
                  <a:ext cx="9" cy="0"/>
                </a:xfrm>
                <a:prstGeom prst="straightConnector1">
                  <a:avLst/>
                </a:prstGeom>
                <a:noFill/>
                <a:ln w="9525" cap="flat" cmpd="sng">
                  <a:solidFill>
                    <a:srgbClr val="000000"/>
                  </a:solidFill>
                  <a:prstDash val="solid"/>
                  <a:round/>
                  <a:headEnd type="none" w="sm" len="sm"/>
                  <a:tailEnd type="none" w="sm" len="sm"/>
                </a:ln>
              </p:spPr>
            </p:cxnSp>
            <p:cxnSp>
              <p:nvCxnSpPr>
                <p:cNvPr id="1299" name="Google Shape;1299;p11"/>
                <p:cNvCxnSpPr/>
                <p:nvPr/>
              </p:nvCxnSpPr>
              <p:spPr>
                <a:xfrm rot="10800000">
                  <a:off x="1432" y="1527"/>
                  <a:ext cx="9" cy="0"/>
                </a:xfrm>
                <a:prstGeom prst="straightConnector1">
                  <a:avLst/>
                </a:prstGeom>
                <a:noFill/>
                <a:ln w="9525" cap="flat" cmpd="sng">
                  <a:solidFill>
                    <a:srgbClr val="000000"/>
                  </a:solidFill>
                  <a:prstDash val="solid"/>
                  <a:round/>
                  <a:headEnd type="none" w="sm" len="sm"/>
                  <a:tailEnd type="none" w="sm" len="sm"/>
                </a:ln>
              </p:spPr>
            </p:cxnSp>
            <p:cxnSp>
              <p:nvCxnSpPr>
                <p:cNvPr id="1300" name="Google Shape;1300;p11"/>
                <p:cNvCxnSpPr/>
                <p:nvPr/>
              </p:nvCxnSpPr>
              <p:spPr>
                <a:xfrm rot="10800000">
                  <a:off x="1432" y="1491"/>
                  <a:ext cx="9" cy="0"/>
                </a:xfrm>
                <a:prstGeom prst="straightConnector1">
                  <a:avLst/>
                </a:prstGeom>
                <a:noFill/>
                <a:ln w="9525" cap="flat" cmpd="sng">
                  <a:solidFill>
                    <a:srgbClr val="000000"/>
                  </a:solidFill>
                  <a:prstDash val="solid"/>
                  <a:round/>
                  <a:headEnd type="none" w="sm" len="sm"/>
                  <a:tailEnd type="none" w="sm" len="sm"/>
                </a:ln>
              </p:spPr>
            </p:cxnSp>
            <p:cxnSp>
              <p:nvCxnSpPr>
                <p:cNvPr id="1301" name="Google Shape;1301;p11"/>
                <p:cNvCxnSpPr/>
                <p:nvPr/>
              </p:nvCxnSpPr>
              <p:spPr>
                <a:xfrm rot="10800000">
                  <a:off x="1432" y="1456"/>
                  <a:ext cx="9" cy="0"/>
                </a:xfrm>
                <a:prstGeom prst="straightConnector1">
                  <a:avLst/>
                </a:prstGeom>
                <a:noFill/>
                <a:ln w="9525" cap="flat" cmpd="sng">
                  <a:solidFill>
                    <a:srgbClr val="000000"/>
                  </a:solidFill>
                  <a:prstDash val="solid"/>
                  <a:round/>
                  <a:headEnd type="none" w="sm" len="sm"/>
                  <a:tailEnd type="none" w="sm" len="sm"/>
                </a:ln>
              </p:spPr>
            </p:cxnSp>
            <p:cxnSp>
              <p:nvCxnSpPr>
                <p:cNvPr id="1302" name="Google Shape;1302;p11"/>
                <p:cNvCxnSpPr/>
                <p:nvPr/>
              </p:nvCxnSpPr>
              <p:spPr>
                <a:xfrm rot="10800000">
                  <a:off x="1426" y="1420"/>
                  <a:ext cx="15" cy="0"/>
                </a:xfrm>
                <a:prstGeom prst="straightConnector1">
                  <a:avLst/>
                </a:prstGeom>
                <a:noFill/>
                <a:ln w="9525" cap="flat" cmpd="sng">
                  <a:solidFill>
                    <a:srgbClr val="000000"/>
                  </a:solidFill>
                  <a:prstDash val="solid"/>
                  <a:round/>
                  <a:headEnd type="none" w="sm" len="sm"/>
                  <a:tailEnd type="none" w="sm" len="sm"/>
                </a:ln>
              </p:spPr>
            </p:cxnSp>
            <p:sp>
              <p:nvSpPr>
                <p:cNvPr id="1303" name="Google Shape;1303;p11"/>
                <p:cNvSpPr/>
                <p:nvPr/>
              </p:nvSpPr>
              <p:spPr>
                <a:xfrm>
                  <a:off x="1241" y="1373"/>
                  <a:ext cx="30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55.0</a:t>
                  </a:r>
                  <a:endParaRPr sz="800" b="0" i="0" u="none" strike="noStrike" cap="none">
                    <a:solidFill>
                      <a:srgbClr val="000000"/>
                    </a:solidFill>
                    <a:latin typeface="Arial"/>
                    <a:ea typeface="Arial"/>
                    <a:cs typeface="Arial"/>
                    <a:sym typeface="Arial"/>
                  </a:endParaRPr>
                </a:p>
              </p:txBody>
            </p:sp>
            <p:cxnSp>
              <p:nvCxnSpPr>
                <p:cNvPr id="1304" name="Google Shape;1304;p11"/>
                <p:cNvCxnSpPr/>
                <p:nvPr/>
              </p:nvCxnSpPr>
              <p:spPr>
                <a:xfrm rot="10800000">
                  <a:off x="1432" y="1385"/>
                  <a:ext cx="9" cy="0"/>
                </a:xfrm>
                <a:prstGeom prst="straightConnector1">
                  <a:avLst/>
                </a:prstGeom>
                <a:noFill/>
                <a:ln w="9525" cap="flat" cmpd="sng">
                  <a:solidFill>
                    <a:srgbClr val="000000"/>
                  </a:solidFill>
                  <a:prstDash val="solid"/>
                  <a:round/>
                  <a:headEnd type="none" w="sm" len="sm"/>
                  <a:tailEnd type="none" w="sm" len="sm"/>
                </a:ln>
              </p:spPr>
            </p:cxnSp>
            <p:cxnSp>
              <p:nvCxnSpPr>
                <p:cNvPr id="1305" name="Google Shape;1305;p11"/>
                <p:cNvCxnSpPr/>
                <p:nvPr/>
              </p:nvCxnSpPr>
              <p:spPr>
                <a:xfrm rot="10800000">
                  <a:off x="1432" y="1349"/>
                  <a:ext cx="9" cy="0"/>
                </a:xfrm>
                <a:prstGeom prst="straightConnector1">
                  <a:avLst/>
                </a:prstGeom>
                <a:noFill/>
                <a:ln w="9525" cap="flat" cmpd="sng">
                  <a:solidFill>
                    <a:srgbClr val="000000"/>
                  </a:solidFill>
                  <a:prstDash val="solid"/>
                  <a:round/>
                  <a:headEnd type="none" w="sm" len="sm"/>
                  <a:tailEnd type="none" w="sm" len="sm"/>
                </a:ln>
              </p:spPr>
            </p:cxnSp>
            <p:cxnSp>
              <p:nvCxnSpPr>
                <p:cNvPr id="1306" name="Google Shape;1306;p11"/>
                <p:cNvCxnSpPr/>
                <p:nvPr/>
              </p:nvCxnSpPr>
              <p:spPr>
                <a:xfrm rot="10800000">
                  <a:off x="1432" y="1314"/>
                  <a:ext cx="9" cy="0"/>
                </a:xfrm>
                <a:prstGeom prst="straightConnector1">
                  <a:avLst/>
                </a:prstGeom>
                <a:noFill/>
                <a:ln w="9525" cap="flat" cmpd="sng">
                  <a:solidFill>
                    <a:srgbClr val="000000"/>
                  </a:solidFill>
                  <a:prstDash val="solid"/>
                  <a:round/>
                  <a:headEnd type="none" w="sm" len="sm"/>
                  <a:tailEnd type="none" w="sm" len="sm"/>
                </a:ln>
              </p:spPr>
            </p:cxnSp>
            <p:cxnSp>
              <p:nvCxnSpPr>
                <p:cNvPr id="1307" name="Google Shape;1307;p11"/>
                <p:cNvCxnSpPr/>
                <p:nvPr/>
              </p:nvCxnSpPr>
              <p:spPr>
                <a:xfrm rot="10800000">
                  <a:off x="1432" y="1278"/>
                  <a:ext cx="9" cy="0"/>
                </a:xfrm>
                <a:prstGeom prst="straightConnector1">
                  <a:avLst/>
                </a:prstGeom>
                <a:noFill/>
                <a:ln w="9525" cap="flat" cmpd="sng">
                  <a:solidFill>
                    <a:srgbClr val="000000"/>
                  </a:solidFill>
                  <a:prstDash val="solid"/>
                  <a:round/>
                  <a:headEnd type="none" w="sm" len="sm"/>
                  <a:tailEnd type="none" w="sm" len="sm"/>
                </a:ln>
              </p:spPr>
            </p:cxnSp>
            <p:cxnSp>
              <p:nvCxnSpPr>
                <p:cNvPr id="1308" name="Google Shape;1308;p11"/>
                <p:cNvCxnSpPr/>
                <p:nvPr/>
              </p:nvCxnSpPr>
              <p:spPr>
                <a:xfrm rot="10800000">
                  <a:off x="1426" y="1243"/>
                  <a:ext cx="15" cy="0"/>
                </a:xfrm>
                <a:prstGeom prst="straightConnector1">
                  <a:avLst/>
                </a:prstGeom>
                <a:noFill/>
                <a:ln w="9525" cap="flat" cmpd="sng">
                  <a:solidFill>
                    <a:srgbClr val="000000"/>
                  </a:solidFill>
                  <a:prstDash val="solid"/>
                  <a:round/>
                  <a:headEnd type="none" w="sm" len="sm"/>
                  <a:tailEnd type="none" w="sm" len="sm"/>
                </a:ln>
              </p:spPr>
            </p:cxnSp>
            <p:cxnSp>
              <p:nvCxnSpPr>
                <p:cNvPr id="1309" name="Google Shape;1309;p11"/>
                <p:cNvCxnSpPr/>
                <p:nvPr/>
              </p:nvCxnSpPr>
              <p:spPr>
                <a:xfrm rot="10800000">
                  <a:off x="1426" y="1243"/>
                  <a:ext cx="15" cy="0"/>
                </a:xfrm>
                <a:prstGeom prst="straightConnector1">
                  <a:avLst/>
                </a:prstGeom>
                <a:noFill/>
                <a:ln w="9525" cap="flat" cmpd="sng">
                  <a:solidFill>
                    <a:srgbClr val="000000"/>
                  </a:solidFill>
                  <a:prstDash val="solid"/>
                  <a:round/>
                  <a:headEnd type="none" w="sm" len="sm"/>
                  <a:tailEnd type="none" w="sm" len="sm"/>
                </a:ln>
              </p:spPr>
            </p:cxnSp>
            <p:sp>
              <p:nvSpPr>
                <p:cNvPr id="1310" name="Google Shape;1310;p11"/>
                <p:cNvSpPr/>
                <p:nvPr/>
              </p:nvSpPr>
              <p:spPr>
                <a:xfrm>
                  <a:off x="1237" y="1195"/>
                  <a:ext cx="173"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60.0</a:t>
                  </a:r>
                  <a:endParaRPr sz="800" b="0" i="0" u="none" strike="noStrike" cap="none">
                    <a:solidFill>
                      <a:srgbClr val="000000"/>
                    </a:solidFill>
                    <a:latin typeface="Arial"/>
                    <a:ea typeface="Arial"/>
                    <a:cs typeface="Arial"/>
                    <a:sym typeface="Arial"/>
                  </a:endParaRPr>
                </a:p>
              </p:txBody>
            </p:sp>
            <p:sp>
              <p:nvSpPr>
                <p:cNvPr id="1311" name="Google Shape;1311;p11"/>
                <p:cNvSpPr/>
                <p:nvPr/>
              </p:nvSpPr>
              <p:spPr>
                <a:xfrm rot="10800000">
                  <a:off x="1245" y="2616"/>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12" name="Google Shape;1312;p11"/>
                <p:cNvSpPr/>
                <p:nvPr/>
              </p:nvSpPr>
              <p:spPr>
                <a:xfrm rot="10800000">
                  <a:off x="1245" y="2552"/>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13" name="Google Shape;1313;p11"/>
                <p:cNvSpPr/>
                <p:nvPr/>
              </p:nvSpPr>
              <p:spPr>
                <a:xfrm rot="10800000">
                  <a:off x="1243" y="2521"/>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14" name="Google Shape;1314;p11"/>
                <p:cNvSpPr/>
                <p:nvPr/>
              </p:nvSpPr>
              <p:spPr>
                <a:xfrm rot="10800000">
                  <a:off x="1243" y="2439"/>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15" name="Google Shape;1315;p11"/>
                <p:cNvSpPr/>
                <p:nvPr/>
              </p:nvSpPr>
              <p:spPr>
                <a:xfrm rot="10800000">
                  <a:off x="1243" y="2407"/>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16" name="Google Shape;1316;p11"/>
                <p:cNvSpPr/>
                <p:nvPr/>
              </p:nvSpPr>
              <p:spPr>
                <a:xfrm rot="10800000">
                  <a:off x="1245" y="2377"/>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17" name="Google Shape;1317;p11"/>
                <p:cNvSpPr/>
                <p:nvPr/>
              </p:nvSpPr>
              <p:spPr>
                <a:xfrm rot="10800000">
                  <a:off x="1243" y="2347"/>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18" name="Google Shape;1318;p11"/>
                <p:cNvSpPr/>
                <p:nvPr/>
              </p:nvSpPr>
              <p:spPr>
                <a:xfrm rot="16200000">
                  <a:off x="1231" y="2346"/>
                  <a:ext cx="24" cy="99"/>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 </a:t>
                  </a:r>
                  <a:endParaRPr sz="800" b="0" i="0" u="none" strike="noStrike" cap="none">
                    <a:solidFill>
                      <a:srgbClr val="000000"/>
                    </a:solidFill>
                    <a:latin typeface="Arial"/>
                    <a:ea typeface="Arial"/>
                    <a:cs typeface="Arial"/>
                    <a:sym typeface="Arial"/>
                  </a:endParaRPr>
                </a:p>
              </p:txBody>
            </p:sp>
            <p:sp>
              <p:nvSpPr>
                <p:cNvPr id="1319" name="Google Shape;1319;p11"/>
                <p:cNvSpPr/>
                <p:nvPr/>
              </p:nvSpPr>
              <p:spPr>
                <a:xfrm rot="10800000">
                  <a:off x="1243" y="2307"/>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20" name="Google Shape;1320;p11"/>
                <p:cNvSpPr/>
                <p:nvPr/>
              </p:nvSpPr>
              <p:spPr>
                <a:xfrm rot="10800000">
                  <a:off x="1247" y="2275"/>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21" name="Google Shape;1321;p11"/>
                <p:cNvSpPr/>
                <p:nvPr/>
              </p:nvSpPr>
              <p:spPr>
                <a:xfrm rot="10800000">
                  <a:off x="1243" y="2167"/>
                  <a:ext cx="0" cy="146"/>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322" name="Google Shape;1322;p11"/>
                <p:cNvSpPr/>
                <p:nvPr/>
              </p:nvSpPr>
              <p:spPr>
                <a:xfrm>
                  <a:off x="1453" y="1564"/>
                  <a:ext cx="4961" cy="1799"/>
                </a:xfrm>
                <a:custGeom>
                  <a:avLst/>
                  <a:gdLst/>
                  <a:ahLst/>
                  <a:cxnLst/>
                  <a:rect l="l" t="t" r="r" b="b"/>
                  <a:pathLst>
                    <a:path w="4961" h="1799" extrusionOk="0">
                      <a:moveTo>
                        <a:pt x="0" y="1798"/>
                      </a:moveTo>
                      <a:lnTo>
                        <a:pt x="4" y="1798"/>
                      </a:lnTo>
                      <a:lnTo>
                        <a:pt x="8" y="1798"/>
                      </a:lnTo>
                      <a:lnTo>
                        <a:pt x="11" y="1799"/>
                      </a:lnTo>
                      <a:lnTo>
                        <a:pt x="15" y="1798"/>
                      </a:lnTo>
                      <a:lnTo>
                        <a:pt x="19" y="1799"/>
                      </a:lnTo>
                      <a:lnTo>
                        <a:pt x="23" y="1798"/>
                      </a:lnTo>
                      <a:lnTo>
                        <a:pt x="26" y="1798"/>
                      </a:lnTo>
                      <a:lnTo>
                        <a:pt x="30" y="1798"/>
                      </a:lnTo>
                      <a:lnTo>
                        <a:pt x="34" y="1799"/>
                      </a:lnTo>
                      <a:lnTo>
                        <a:pt x="38" y="1798"/>
                      </a:lnTo>
                      <a:lnTo>
                        <a:pt x="41" y="1798"/>
                      </a:lnTo>
                      <a:lnTo>
                        <a:pt x="45" y="1798"/>
                      </a:lnTo>
                      <a:lnTo>
                        <a:pt x="49" y="1798"/>
                      </a:lnTo>
                      <a:lnTo>
                        <a:pt x="53" y="1798"/>
                      </a:lnTo>
                      <a:lnTo>
                        <a:pt x="57" y="1798"/>
                      </a:lnTo>
                      <a:lnTo>
                        <a:pt x="60" y="1798"/>
                      </a:lnTo>
                      <a:lnTo>
                        <a:pt x="64" y="1798"/>
                      </a:lnTo>
                      <a:lnTo>
                        <a:pt x="68" y="1798"/>
                      </a:lnTo>
                      <a:lnTo>
                        <a:pt x="71" y="1798"/>
                      </a:lnTo>
                      <a:lnTo>
                        <a:pt x="75" y="1798"/>
                      </a:lnTo>
                      <a:lnTo>
                        <a:pt x="79" y="1798"/>
                      </a:lnTo>
                      <a:lnTo>
                        <a:pt x="83" y="1798"/>
                      </a:lnTo>
                      <a:lnTo>
                        <a:pt x="87" y="1798"/>
                      </a:lnTo>
                      <a:lnTo>
                        <a:pt x="90" y="1798"/>
                      </a:lnTo>
                      <a:lnTo>
                        <a:pt x="94" y="1798"/>
                      </a:lnTo>
                      <a:lnTo>
                        <a:pt x="98" y="1798"/>
                      </a:lnTo>
                      <a:lnTo>
                        <a:pt x="102" y="1798"/>
                      </a:lnTo>
                      <a:lnTo>
                        <a:pt x="105" y="1798"/>
                      </a:lnTo>
                      <a:lnTo>
                        <a:pt x="109" y="1797"/>
                      </a:lnTo>
                      <a:lnTo>
                        <a:pt x="113" y="1798"/>
                      </a:lnTo>
                      <a:lnTo>
                        <a:pt x="117" y="1797"/>
                      </a:lnTo>
                      <a:lnTo>
                        <a:pt x="120" y="1797"/>
                      </a:lnTo>
                      <a:lnTo>
                        <a:pt x="124" y="1797"/>
                      </a:lnTo>
                      <a:lnTo>
                        <a:pt x="128" y="1797"/>
                      </a:lnTo>
                      <a:lnTo>
                        <a:pt x="132" y="1797"/>
                      </a:lnTo>
                      <a:lnTo>
                        <a:pt x="135" y="1797"/>
                      </a:lnTo>
                      <a:lnTo>
                        <a:pt x="139" y="1797"/>
                      </a:lnTo>
                      <a:lnTo>
                        <a:pt x="143" y="1797"/>
                      </a:lnTo>
                      <a:lnTo>
                        <a:pt x="147" y="1798"/>
                      </a:lnTo>
                      <a:lnTo>
                        <a:pt x="150" y="1798"/>
                      </a:lnTo>
                      <a:lnTo>
                        <a:pt x="154" y="1797"/>
                      </a:lnTo>
                      <a:lnTo>
                        <a:pt x="158" y="1797"/>
                      </a:lnTo>
                      <a:lnTo>
                        <a:pt x="162" y="1797"/>
                      </a:lnTo>
                      <a:lnTo>
                        <a:pt x="165" y="1797"/>
                      </a:lnTo>
                      <a:lnTo>
                        <a:pt x="169" y="1796"/>
                      </a:lnTo>
                      <a:lnTo>
                        <a:pt x="173" y="1797"/>
                      </a:lnTo>
                      <a:lnTo>
                        <a:pt x="177" y="1797"/>
                      </a:lnTo>
                      <a:lnTo>
                        <a:pt x="181" y="1797"/>
                      </a:lnTo>
                      <a:lnTo>
                        <a:pt x="184" y="1797"/>
                      </a:lnTo>
                      <a:lnTo>
                        <a:pt x="188" y="1798"/>
                      </a:lnTo>
                      <a:lnTo>
                        <a:pt x="192" y="1797"/>
                      </a:lnTo>
                      <a:lnTo>
                        <a:pt x="195" y="1797"/>
                      </a:lnTo>
                      <a:lnTo>
                        <a:pt x="199" y="1797"/>
                      </a:lnTo>
                      <a:lnTo>
                        <a:pt x="203" y="1797"/>
                      </a:lnTo>
                      <a:lnTo>
                        <a:pt x="207" y="1797"/>
                      </a:lnTo>
                      <a:lnTo>
                        <a:pt x="211" y="1796"/>
                      </a:lnTo>
                      <a:lnTo>
                        <a:pt x="214" y="1796"/>
                      </a:lnTo>
                      <a:lnTo>
                        <a:pt x="218" y="1797"/>
                      </a:lnTo>
                      <a:lnTo>
                        <a:pt x="222" y="1795"/>
                      </a:lnTo>
                      <a:lnTo>
                        <a:pt x="226" y="1795"/>
                      </a:lnTo>
                      <a:lnTo>
                        <a:pt x="229" y="1794"/>
                      </a:lnTo>
                      <a:lnTo>
                        <a:pt x="233" y="1793"/>
                      </a:lnTo>
                      <a:lnTo>
                        <a:pt x="237" y="1791"/>
                      </a:lnTo>
                      <a:lnTo>
                        <a:pt x="241" y="1788"/>
                      </a:lnTo>
                      <a:lnTo>
                        <a:pt x="244" y="1785"/>
                      </a:lnTo>
                      <a:lnTo>
                        <a:pt x="248" y="1781"/>
                      </a:lnTo>
                      <a:lnTo>
                        <a:pt x="252" y="1779"/>
                      </a:lnTo>
                      <a:lnTo>
                        <a:pt x="256" y="1775"/>
                      </a:lnTo>
                      <a:lnTo>
                        <a:pt x="259" y="1774"/>
                      </a:lnTo>
                      <a:lnTo>
                        <a:pt x="263" y="1775"/>
                      </a:lnTo>
                      <a:lnTo>
                        <a:pt x="267" y="1778"/>
                      </a:lnTo>
                      <a:lnTo>
                        <a:pt x="271" y="1783"/>
                      </a:lnTo>
                      <a:lnTo>
                        <a:pt x="274" y="1784"/>
                      </a:lnTo>
                      <a:lnTo>
                        <a:pt x="278" y="1787"/>
                      </a:lnTo>
                      <a:lnTo>
                        <a:pt x="282" y="1789"/>
                      </a:lnTo>
                      <a:lnTo>
                        <a:pt x="286" y="1789"/>
                      </a:lnTo>
                      <a:lnTo>
                        <a:pt x="289" y="1788"/>
                      </a:lnTo>
                      <a:lnTo>
                        <a:pt x="293" y="1787"/>
                      </a:lnTo>
                      <a:lnTo>
                        <a:pt x="297" y="1786"/>
                      </a:lnTo>
                      <a:lnTo>
                        <a:pt x="301" y="1785"/>
                      </a:lnTo>
                      <a:lnTo>
                        <a:pt x="305" y="1784"/>
                      </a:lnTo>
                      <a:lnTo>
                        <a:pt x="308" y="1784"/>
                      </a:lnTo>
                      <a:lnTo>
                        <a:pt x="312" y="1782"/>
                      </a:lnTo>
                      <a:lnTo>
                        <a:pt x="316" y="1782"/>
                      </a:lnTo>
                      <a:lnTo>
                        <a:pt x="319" y="1781"/>
                      </a:lnTo>
                      <a:lnTo>
                        <a:pt x="323" y="1781"/>
                      </a:lnTo>
                      <a:lnTo>
                        <a:pt x="327" y="1779"/>
                      </a:lnTo>
                      <a:lnTo>
                        <a:pt x="331" y="1779"/>
                      </a:lnTo>
                      <a:lnTo>
                        <a:pt x="335" y="1778"/>
                      </a:lnTo>
                      <a:lnTo>
                        <a:pt x="338" y="1777"/>
                      </a:lnTo>
                      <a:lnTo>
                        <a:pt x="342" y="1776"/>
                      </a:lnTo>
                      <a:lnTo>
                        <a:pt x="346" y="1777"/>
                      </a:lnTo>
                      <a:lnTo>
                        <a:pt x="350" y="1778"/>
                      </a:lnTo>
                      <a:lnTo>
                        <a:pt x="353" y="1778"/>
                      </a:lnTo>
                      <a:lnTo>
                        <a:pt x="357" y="1777"/>
                      </a:lnTo>
                      <a:lnTo>
                        <a:pt x="361" y="1776"/>
                      </a:lnTo>
                      <a:lnTo>
                        <a:pt x="365" y="1775"/>
                      </a:lnTo>
                      <a:lnTo>
                        <a:pt x="368" y="1771"/>
                      </a:lnTo>
                      <a:lnTo>
                        <a:pt x="372" y="1769"/>
                      </a:lnTo>
                      <a:lnTo>
                        <a:pt x="376" y="1768"/>
                      </a:lnTo>
                      <a:lnTo>
                        <a:pt x="380" y="1768"/>
                      </a:lnTo>
                      <a:lnTo>
                        <a:pt x="384" y="1770"/>
                      </a:lnTo>
                      <a:lnTo>
                        <a:pt x="387" y="1772"/>
                      </a:lnTo>
                      <a:lnTo>
                        <a:pt x="391" y="1776"/>
                      </a:lnTo>
                      <a:lnTo>
                        <a:pt x="395" y="1778"/>
                      </a:lnTo>
                      <a:lnTo>
                        <a:pt x="398" y="1780"/>
                      </a:lnTo>
                      <a:lnTo>
                        <a:pt x="402" y="1781"/>
                      </a:lnTo>
                      <a:lnTo>
                        <a:pt x="406" y="1783"/>
                      </a:lnTo>
                      <a:lnTo>
                        <a:pt x="410" y="1783"/>
                      </a:lnTo>
                      <a:lnTo>
                        <a:pt x="413" y="1785"/>
                      </a:lnTo>
                      <a:lnTo>
                        <a:pt x="417" y="1785"/>
                      </a:lnTo>
                      <a:lnTo>
                        <a:pt x="421" y="1785"/>
                      </a:lnTo>
                      <a:lnTo>
                        <a:pt x="425" y="1785"/>
                      </a:lnTo>
                      <a:lnTo>
                        <a:pt x="429" y="1784"/>
                      </a:lnTo>
                      <a:lnTo>
                        <a:pt x="432" y="1784"/>
                      </a:lnTo>
                      <a:lnTo>
                        <a:pt x="436" y="1785"/>
                      </a:lnTo>
                      <a:lnTo>
                        <a:pt x="440" y="1785"/>
                      </a:lnTo>
                      <a:lnTo>
                        <a:pt x="444" y="1786"/>
                      </a:lnTo>
                      <a:lnTo>
                        <a:pt x="447" y="1787"/>
                      </a:lnTo>
                      <a:lnTo>
                        <a:pt x="451" y="1789"/>
                      </a:lnTo>
                      <a:lnTo>
                        <a:pt x="455" y="1789"/>
                      </a:lnTo>
                      <a:lnTo>
                        <a:pt x="459" y="1789"/>
                      </a:lnTo>
                      <a:lnTo>
                        <a:pt x="462" y="1789"/>
                      </a:lnTo>
                      <a:lnTo>
                        <a:pt x="466" y="1789"/>
                      </a:lnTo>
                      <a:lnTo>
                        <a:pt x="470" y="1789"/>
                      </a:lnTo>
                      <a:lnTo>
                        <a:pt x="474" y="1790"/>
                      </a:lnTo>
                      <a:lnTo>
                        <a:pt x="477" y="1789"/>
                      </a:lnTo>
                      <a:lnTo>
                        <a:pt x="481" y="1789"/>
                      </a:lnTo>
                      <a:lnTo>
                        <a:pt x="485" y="1789"/>
                      </a:lnTo>
                      <a:lnTo>
                        <a:pt x="489" y="1790"/>
                      </a:lnTo>
                      <a:lnTo>
                        <a:pt x="492" y="1791"/>
                      </a:lnTo>
                      <a:lnTo>
                        <a:pt x="496" y="1791"/>
                      </a:lnTo>
                      <a:lnTo>
                        <a:pt x="500" y="1791"/>
                      </a:lnTo>
                      <a:lnTo>
                        <a:pt x="504" y="1792"/>
                      </a:lnTo>
                      <a:lnTo>
                        <a:pt x="508" y="1792"/>
                      </a:lnTo>
                      <a:lnTo>
                        <a:pt x="511" y="1792"/>
                      </a:lnTo>
                      <a:lnTo>
                        <a:pt x="515" y="1792"/>
                      </a:lnTo>
                      <a:lnTo>
                        <a:pt x="519" y="1793"/>
                      </a:lnTo>
                      <a:lnTo>
                        <a:pt x="522" y="1793"/>
                      </a:lnTo>
                      <a:lnTo>
                        <a:pt x="526" y="1793"/>
                      </a:lnTo>
                      <a:lnTo>
                        <a:pt x="530" y="1793"/>
                      </a:lnTo>
                      <a:lnTo>
                        <a:pt x="534" y="1793"/>
                      </a:lnTo>
                      <a:lnTo>
                        <a:pt x="537" y="1792"/>
                      </a:lnTo>
                      <a:lnTo>
                        <a:pt x="541" y="1793"/>
                      </a:lnTo>
                      <a:lnTo>
                        <a:pt x="545" y="1793"/>
                      </a:lnTo>
                      <a:lnTo>
                        <a:pt x="549" y="1793"/>
                      </a:lnTo>
                      <a:lnTo>
                        <a:pt x="553" y="1792"/>
                      </a:lnTo>
                      <a:lnTo>
                        <a:pt x="556" y="1793"/>
                      </a:lnTo>
                      <a:lnTo>
                        <a:pt x="560" y="1792"/>
                      </a:lnTo>
                      <a:lnTo>
                        <a:pt x="564" y="1792"/>
                      </a:lnTo>
                      <a:lnTo>
                        <a:pt x="568" y="1793"/>
                      </a:lnTo>
                      <a:lnTo>
                        <a:pt x="571" y="1792"/>
                      </a:lnTo>
                      <a:lnTo>
                        <a:pt x="575" y="1792"/>
                      </a:lnTo>
                      <a:lnTo>
                        <a:pt x="579" y="1792"/>
                      </a:lnTo>
                      <a:lnTo>
                        <a:pt x="582" y="1792"/>
                      </a:lnTo>
                      <a:lnTo>
                        <a:pt x="586" y="1791"/>
                      </a:lnTo>
                      <a:lnTo>
                        <a:pt x="590" y="1790"/>
                      </a:lnTo>
                      <a:lnTo>
                        <a:pt x="594" y="1789"/>
                      </a:lnTo>
                      <a:lnTo>
                        <a:pt x="598" y="1784"/>
                      </a:lnTo>
                      <a:lnTo>
                        <a:pt x="601" y="1777"/>
                      </a:lnTo>
                      <a:lnTo>
                        <a:pt x="605" y="1763"/>
                      </a:lnTo>
                      <a:lnTo>
                        <a:pt x="609" y="1744"/>
                      </a:lnTo>
                      <a:lnTo>
                        <a:pt x="613" y="1718"/>
                      </a:lnTo>
                      <a:lnTo>
                        <a:pt x="616" y="1690"/>
                      </a:lnTo>
                      <a:lnTo>
                        <a:pt x="620" y="1663"/>
                      </a:lnTo>
                      <a:lnTo>
                        <a:pt x="624" y="1648"/>
                      </a:lnTo>
                      <a:lnTo>
                        <a:pt x="628" y="1646"/>
                      </a:lnTo>
                      <a:lnTo>
                        <a:pt x="631" y="1655"/>
                      </a:lnTo>
                      <a:lnTo>
                        <a:pt x="635" y="1676"/>
                      </a:lnTo>
                      <a:lnTo>
                        <a:pt x="639" y="1702"/>
                      </a:lnTo>
                      <a:lnTo>
                        <a:pt x="643" y="1728"/>
                      </a:lnTo>
                      <a:lnTo>
                        <a:pt x="646" y="1749"/>
                      </a:lnTo>
                      <a:lnTo>
                        <a:pt x="650" y="1765"/>
                      </a:lnTo>
                      <a:lnTo>
                        <a:pt x="654" y="1777"/>
                      </a:lnTo>
                      <a:lnTo>
                        <a:pt x="658" y="1782"/>
                      </a:lnTo>
                      <a:lnTo>
                        <a:pt x="661" y="1786"/>
                      </a:lnTo>
                      <a:lnTo>
                        <a:pt x="665" y="1789"/>
                      </a:lnTo>
                      <a:lnTo>
                        <a:pt x="669" y="1790"/>
                      </a:lnTo>
                      <a:lnTo>
                        <a:pt x="673" y="1791"/>
                      </a:lnTo>
                      <a:lnTo>
                        <a:pt x="677" y="1791"/>
                      </a:lnTo>
                      <a:lnTo>
                        <a:pt x="680" y="1791"/>
                      </a:lnTo>
                      <a:lnTo>
                        <a:pt x="684" y="1791"/>
                      </a:lnTo>
                      <a:lnTo>
                        <a:pt x="688" y="1791"/>
                      </a:lnTo>
                      <a:lnTo>
                        <a:pt x="692" y="1791"/>
                      </a:lnTo>
                      <a:lnTo>
                        <a:pt x="695" y="1791"/>
                      </a:lnTo>
                      <a:lnTo>
                        <a:pt x="699" y="1791"/>
                      </a:lnTo>
                      <a:lnTo>
                        <a:pt x="703" y="1792"/>
                      </a:lnTo>
                      <a:lnTo>
                        <a:pt x="706" y="1792"/>
                      </a:lnTo>
                      <a:lnTo>
                        <a:pt x="710" y="1791"/>
                      </a:lnTo>
                      <a:lnTo>
                        <a:pt x="714" y="1792"/>
                      </a:lnTo>
                      <a:lnTo>
                        <a:pt x="718" y="1792"/>
                      </a:lnTo>
                      <a:lnTo>
                        <a:pt x="722" y="1792"/>
                      </a:lnTo>
                      <a:lnTo>
                        <a:pt x="725" y="1792"/>
                      </a:lnTo>
                      <a:lnTo>
                        <a:pt x="729" y="1791"/>
                      </a:lnTo>
                      <a:lnTo>
                        <a:pt x="733" y="1791"/>
                      </a:lnTo>
                      <a:lnTo>
                        <a:pt x="737" y="1792"/>
                      </a:lnTo>
                      <a:lnTo>
                        <a:pt x="740" y="1791"/>
                      </a:lnTo>
                      <a:lnTo>
                        <a:pt x="744" y="1792"/>
                      </a:lnTo>
                      <a:lnTo>
                        <a:pt x="748" y="1791"/>
                      </a:lnTo>
                      <a:lnTo>
                        <a:pt x="752" y="1791"/>
                      </a:lnTo>
                      <a:lnTo>
                        <a:pt x="755" y="1790"/>
                      </a:lnTo>
                      <a:lnTo>
                        <a:pt x="759" y="1791"/>
                      </a:lnTo>
                      <a:lnTo>
                        <a:pt x="763" y="1791"/>
                      </a:lnTo>
                      <a:lnTo>
                        <a:pt x="767" y="1790"/>
                      </a:lnTo>
                      <a:lnTo>
                        <a:pt x="770" y="1789"/>
                      </a:lnTo>
                      <a:lnTo>
                        <a:pt x="774" y="1789"/>
                      </a:lnTo>
                      <a:lnTo>
                        <a:pt x="778" y="1789"/>
                      </a:lnTo>
                      <a:lnTo>
                        <a:pt x="782" y="1790"/>
                      </a:lnTo>
                      <a:lnTo>
                        <a:pt x="785" y="1790"/>
                      </a:lnTo>
                      <a:lnTo>
                        <a:pt x="789" y="1790"/>
                      </a:lnTo>
                      <a:lnTo>
                        <a:pt x="793" y="1790"/>
                      </a:lnTo>
                      <a:lnTo>
                        <a:pt x="797" y="1791"/>
                      </a:lnTo>
                      <a:lnTo>
                        <a:pt x="801" y="1791"/>
                      </a:lnTo>
                      <a:lnTo>
                        <a:pt x="804" y="1791"/>
                      </a:lnTo>
                      <a:lnTo>
                        <a:pt x="808" y="1790"/>
                      </a:lnTo>
                      <a:lnTo>
                        <a:pt x="812" y="1791"/>
                      </a:lnTo>
                      <a:lnTo>
                        <a:pt x="816" y="1791"/>
                      </a:lnTo>
                      <a:lnTo>
                        <a:pt x="819" y="1790"/>
                      </a:lnTo>
                      <a:lnTo>
                        <a:pt x="823" y="1791"/>
                      </a:lnTo>
                      <a:lnTo>
                        <a:pt x="827" y="1791"/>
                      </a:lnTo>
                      <a:lnTo>
                        <a:pt x="831" y="1791"/>
                      </a:lnTo>
                      <a:lnTo>
                        <a:pt x="834" y="1790"/>
                      </a:lnTo>
                      <a:lnTo>
                        <a:pt x="838" y="1791"/>
                      </a:lnTo>
                      <a:lnTo>
                        <a:pt x="842" y="1790"/>
                      </a:lnTo>
                      <a:lnTo>
                        <a:pt x="846" y="1791"/>
                      </a:lnTo>
                      <a:lnTo>
                        <a:pt x="849" y="1791"/>
                      </a:lnTo>
                      <a:lnTo>
                        <a:pt x="853" y="1791"/>
                      </a:lnTo>
                      <a:lnTo>
                        <a:pt x="857" y="1791"/>
                      </a:lnTo>
                      <a:lnTo>
                        <a:pt x="861" y="1791"/>
                      </a:lnTo>
                      <a:lnTo>
                        <a:pt x="864" y="1791"/>
                      </a:lnTo>
                      <a:lnTo>
                        <a:pt x="868" y="1790"/>
                      </a:lnTo>
                      <a:lnTo>
                        <a:pt x="872" y="1790"/>
                      </a:lnTo>
                      <a:lnTo>
                        <a:pt x="876" y="1791"/>
                      </a:lnTo>
                      <a:lnTo>
                        <a:pt x="879" y="1789"/>
                      </a:lnTo>
                      <a:lnTo>
                        <a:pt x="883" y="1790"/>
                      </a:lnTo>
                      <a:lnTo>
                        <a:pt x="887" y="1790"/>
                      </a:lnTo>
                      <a:lnTo>
                        <a:pt x="891" y="1791"/>
                      </a:lnTo>
                      <a:lnTo>
                        <a:pt x="895" y="1790"/>
                      </a:lnTo>
                      <a:lnTo>
                        <a:pt x="898" y="1790"/>
                      </a:lnTo>
                      <a:lnTo>
                        <a:pt x="902" y="1790"/>
                      </a:lnTo>
                      <a:lnTo>
                        <a:pt x="906" y="1790"/>
                      </a:lnTo>
                      <a:lnTo>
                        <a:pt x="909" y="1790"/>
                      </a:lnTo>
                      <a:lnTo>
                        <a:pt x="913" y="1790"/>
                      </a:lnTo>
                      <a:lnTo>
                        <a:pt x="917" y="1789"/>
                      </a:lnTo>
                      <a:lnTo>
                        <a:pt x="921" y="1788"/>
                      </a:lnTo>
                      <a:lnTo>
                        <a:pt x="925" y="1789"/>
                      </a:lnTo>
                      <a:lnTo>
                        <a:pt x="928" y="1789"/>
                      </a:lnTo>
                      <a:lnTo>
                        <a:pt x="932" y="1787"/>
                      </a:lnTo>
                      <a:lnTo>
                        <a:pt x="936" y="1786"/>
                      </a:lnTo>
                      <a:lnTo>
                        <a:pt x="940" y="1784"/>
                      </a:lnTo>
                      <a:lnTo>
                        <a:pt x="943" y="1784"/>
                      </a:lnTo>
                      <a:lnTo>
                        <a:pt x="947" y="1782"/>
                      </a:lnTo>
                      <a:lnTo>
                        <a:pt x="951" y="1782"/>
                      </a:lnTo>
                      <a:lnTo>
                        <a:pt x="955" y="1781"/>
                      </a:lnTo>
                      <a:lnTo>
                        <a:pt x="958" y="1781"/>
                      </a:lnTo>
                      <a:lnTo>
                        <a:pt x="962" y="1781"/>
                      </a:lnTo>
                      <a:lnTo>
                        <a:pt x="966" y="1782"/>
                      </a:lnTo>
                      <a:lnTo>
                        <a:pt x="970" y="1782"/>
                      </a:lnTo>
                      <a:lnTo>
                        <a:pt x="973" y="1783"/>
                      </a:lnTo>
                      <a:lnTo>
                        <a:pt x="977" y="1784"/>
                      </a:lnTo>
                      <a:lnTo>
                        <a:pt x="981" y="1785"/>
                      </a:lnTo>
                      <a:lnTo>
                        <a:pt x="985" y="1786"/>
                      </a:lnTo>
                      <a:lnTo>
                        <a:pt x="988" y="1787"/>
                      </a:lnTo>
                      <a:lnTo>
                        <a:pt x="992" y="1787"/>
                      </a:lnTo>
                      <a:lnTo>
                        <a:pt x="996" y="1788"/>
                      </a:lnTo>
                      <a:lnTo>
                        <a:pt x="1000" y="1788"/>
                      </a:lnTo>
                      <a:lnTo>
                        <a:pt x="1003" y="1789"/>
                      </a:lnTo>
                      <a:lnTo>
                        <a:pt x="1007" y="1789"/>
                      </a:lnTo>
                      <a:lnTo>
                        <a:pt x="1011" y="1788"/>
                      </a:lnTo>
                      <a:lnTo>
                        <a:pt x="1015" y="1788"/>
                      </a:lnTo>
                      <a:lnTo>
                        <a:pt x="1019" y="1788"/>
                      </a:lnTo>
                      <a:lnTo>
                        <a:pt x="1022" y="1788"/>
                      </a:lnTo>
                      <a:lnTo>
                        <a:pt x="1026" y="1788"/>
                      </a:lnTo>
                      <a:lnTo>
                        <a:pt x="1030" y="1787"/>
                      </a:lnTo>
                      <a:lnTo>
                        <a:pt x="1033" y="1787"/>
                      </a:lnTo>
                      <a:lnTo>
                        <a:pt x="1037" y="1787"/>
                      </a:lnTo>
                      <a:lnTo>
                        <a:pt x="1041" y="1787"/>
                      </a:lnTo>
                      <a:lnTo>
                        <a:pt x="1045" y="1788"/>
                      </a:lnTo>
                      <a:lnTo>
                        <a:pt x="1049" y="1788"/>
                      </a:lnTo>
                      <a:lnTo>
                        <a:pt x="1052" y="1788"/>
                      </a:lnTo>
                      <a:lnTo>
                        <a:pt x="1056" y="1789"/>
                      </a:lnTo>
                      <a:lnTo>
                        <a:pt x="1060" y="1788"/>
                      </a:lnTo>
                      <a:lnTo>
                        <a:pt x="1064" y="1789"/>
                      </a:lnTo>
                      <a:lnTo>
                        <a:pt x="1067" y="1788"/>
                      </a:lnTo>
                      <a:lnTo>
                        <a:pt x="1071" y="1788"/>
                      </a:lnTo>
                      <a:lnTo>
                        <a:pt x="1075" y="1788"/>
                      </a:lnTo>
                      <a:lnTo>
                        <a:pt x="1079" y="1788"/>
                      </a:lnTo>
                      <a:lnTo>
                        <a:pt x="1082" y="1788"/>
                      </a:lnTo>
                      <a:lnTo>
                        <a:pt x="1086" y="1788"/>
                      </a:lnTo>
                      <a:lnTo>
                        <a:pt x="1090" y="1789"/>
                      </a:lnTo>
                      <a:lnTo>
                        <a:pt x="1094" y="1787"/>
                      </a:lnTo>
                      <a:lnTo>
                        <a:pt x="1097" y="1788"/>
                      </a:lnTo>
                      <a:lnTo>
                        <a:pt x="1101" y="1788"/>
                      </a:lnTo>
                      <a:lnTo>
                        <a:pt x="1105" y="1787"/>
                      </a:lnTo>
                      <a:lnTo>
                        <a:pt x="1109" y="1787"/>
                      </a:lnTo>
                      <a:lnTo>
                        <a:pt x="1112" y="1786"/>
                      </a:lnTo>
                      <a:lnTo>
                        <a:pt x="1116" y="1787"/>
                      </a:lnTo>
                      <a:lnTo>
                        <a:pt x="1120" y="1786"/>
                      </a:lnTo>
                      <a:lnTo>
                        <a:pt x="1124" y="1787"/>
                      </a:lnTo>
                      <a:lnTo>
                        <a:pt x="1127" y="1786"/>
                      </a:lnTo>
                      <a:lnTo>
                        <a:pt x="1131" y="1785"/>
                      </a:lnTo>
                      <a:lnTo>
                        <a:pt x="1135" y="1786"/>
                      </a:lnTo>
                      <a:lnTo>
                        <a:pt x="1139" y="1787"/>
                      </a:lnTo>
                      <a:lnTo>
                        <a:pt x="1143" y="1786"/>
                      </a:lnTo>
                      <a:lnTo>
                        <a:pt x="1146" y="1786"/>
                      </a:lnTo>
                      <a:lnTo>
                        <a:pt x="1150" y="1787"/>
                      </a:lnTo>
                      <a:lnTo>
                        <a:pt x="1154" y="1786"/>
                      </a:lnTo>
                      <a:lnTo>
                        <a:pt x="1157" y="1787"/>
                      </a:lnTo>
                      <a:lnTo>
                        <a:pt x="1161" y="1787"/>
                      </a:lnTo>
                      <a:lnTo>
                        <a:pt x="1165" y="1787"/>
                      </a:lnTo>
                      <a:lnTo>
                        <a:pt x="1169" y="1787"/>
                      </a:lnTo>
                      <a:lnTo>
                        <a:pt x="1172" y="1787"/>
                      </a:lnTo>
                      <a:lnTo>
                        <a:pt x="1176" y="1787"/>
                      </a:lnTo>
                      <a:lnTo>
                        <a:pt x="1180" y="1787"/>
                      </a:lnTo>
                      <a:lnTo>
                        <a:pt x="1184" y="1786"/>
                      </a:lnTo>
                      <a:lnTo>
                        <a:pt x="1188" y="1786"/>
                      </a:lnTo>
                      <a:lnTo>
                        <a:pt x="1191" y="1787"/>
                      </a:lnTo>
                      <a:lnTo>
                        <a:pt x="1195" y="1786"/>
                      </a:lnTo>
                      <a:lnTo>
                        <a:pt x="1199" y="1786"/>
                      </a:lnTo>
                      <a:lnTo>
                        <a:pt x="1203" y="1786"/>
                      </a:lnTo>
                      <a:lnTo>
                        <a:pt x="1206" y="1785"/>
                      </a:lnTo>
                      <a:lnTo>
                        <a:pt x="1210" y="1785"/>
                      </a:lnTo>
                      <a:lnTo>
                        <a:pt x="1214" y="1785"/>
                      </a:lnTo>
                      <a:lnTo>
                        <a:pt x="1218" y="1785"/>
                      </a:lnTo>
                      <a:lnTo>
                        <a:pt x="1221" y="1785"/>
                      </a:lnTo>
                      <a:lnTo>
                        <a:pt x="1225" y="1784"/>
                      </a:lnTo>
                      <a:lnTo>
                        <a:pt x="1229" y="1785"/>
                      </a:lnTo>
                      <a:lnTo>
                        <a:pt x="1233" y="1783"/>
                      </a:lnTo>
                      <a:lnTo>
                        <a:pt x="1236" y="1784"/>
                      </a:lnTo>
                      <a:lnTo>
                        <a:pt x="1240" y="1785"/>
                      </a:lnTo>
                      <a:lnTo>
                        <a:pt x="1244" y="1785"/>
                      </a:lnTo>
                      <a:lnTo>
                        <a:pt x="1248" y="1784"/>
                      </a:lnTo>
                      <a:lnTo>
                        <a:pt x="1251" y="1784"/>
                      </a:lnTo>
                      <a:lnTo>
                        <a:pt x="1255" y="1784"/>
                      </a:lnTo>
                      <a:lnTo>
                        <a:pt x="1259" y="1785"/>
                      </a:lnTo>
                      <a:lnTo>
                        <a:pt x="1263" y="1785"/>
                      </a:lnTo>
                      <a:lnTo>
                        <a:pt x="1267" y="1785"/>
                      </a:lnTo>
                      <a:lnTo>
                        <a:pt x="1270" y="1784"/>
                      </a:lnTo>
                      <a:lnTo>
                        <a:pt x="1274" y="1784"/>
                      </a:lnTo>
                      <a:lnTo>
                        <a:pt x="1278" y="1784"/>
                      </a:lnTo>
                      <a:lnTo>
                        <a:pt x="1282" y="1784"/>
                      </a:lnTo>
                      <a:lnTo>
                        <a:pt x="1285" y="1784"/>
                      </a:lnTo>
                      <a:lnTo>
                        <a:pt x="1289" y="1784"/>
                      </a:lnTo>
                      <a:lnTo>
                        <a:pt x="1293" y="1784"/>
                      </a:lnTo>
                      <a:lnTo>
                        <a:pt x="1296" y="1783"/>
                      </a:lnTo>
                      <a:lnTo>
                        <a:pt x="1300" y="1784"/>
                      </a:lnTo>
                      <a:lnTo>
                        <a:pt x="1304" y="1783"/>
                      </a:lnTo>
                      <a:lnTo>
                        <a:pt x="1308" y="1782"/>
                      </a:lnTo>
                      <a:lnTo>
                        <a:pt x="1312" y="1782"/>
                      </a:lnTo>
                      <a:lnTo>
                        <a:pt x="1315" y="1783"/>
                      </a:lnTo>
                      <a:lnTo>
                        <a:pt x="1319" y="1783"/>
                      </a:lnTo>
                      <a:lnTo>
                        <a:pt x="1323" y="1783"/>
                      </a:lnTo>
                      <a:lnTo>
                        <a:pt x="1327" y="1782"/>
                      </a:lnTo>
                      <a:lnTo>
                        <a:pt x="1330" y="1782"/>
                      </a:lnTo>
                      <a:lnTo>
                        <a:pt x="1334" y="1782"/>
                      </a:lnTo>
                      <a:lnTo>
                        <a:pt x="1338" y="1781"/>
                      </a:lnTo>
                      <a:lnTo>
                        <a:pt x="1342" y="1781"/>
                      </a:lnTo>
                      <a:lnTo>
                        <a:pt x="1345" y="1780"/>
                      </a:lnTo>
                      <a:lnTo>
                        <a:pt x="1349" y="1779"/>
                      </a:lnTo>
                      <a:lnTo>
                        <a:pt x="1353" y="1779"/>
                      </a:lnTo>
                      <a:lnTo>
                        <a:pt x="1357" y="1778"/>
                      </a:lnTo>
                      <a:lnTo>
                        <a:pt x="1360" y="1778"/>
                      </a:lnTo>
                      <a:lnTo>
                        <a:pt x="1364" y="1778"/>
                      </a:lnTo>
                      <a:lnTo>
                        <a:pt x="1368" y="1777"/>
                      </a:lnTo>
                      <a:lnTo>
                        <a:pt x="1372" y="1777"/>
                      </a:lnTo>
                      <a:lnTo>
                        <a:pt x="1375" y="1777"/>
                      </a:lnTo>
                      <a:lnTo>
                        <a:pt x="1379" y="1778"/>
                      </a:lnTo>
                      <a:lnTo>
                        <a:pt x="1383" y="1776"/>
                      </a:lnTo>
                      <a:lnTo>
                        <a:pt x="1387" y="1776"/>
                      </a:lnTo>
                      <a:lnTo>
                        <a:pt x="1391" y="1776"/>
                      </a:lnTo>
                      <a:lnTo>
                        <a:pt x="1394" y="1776"/>
                      </a:lnTo>
                      <a:lnTo>
                        <a:pt x="1398" y="1776"/>
                      </a:lnTo>
                      <a:lnTo>
                        <a:pt x="1402" y="1777"/>
                      </a:lnTo>
                      <a:lnTo>
                        <a:pt x="1406" y="1775"/>
                      </a:lnTo>
                      <a:lnTo>
                        <a:pt x="1409" y="1775"/>
                      </a:lnTo>
                      <a:lnTo>
                        <a:pt x="1413" y="1774"/>
                      </a:lnTo>
                      <a:lnTo>
                        <a:pt x="1417" y="1774"/>
                      </a:lnTo>
                      <a:lnTo>
                        <a:pt x="1420" y="1775"/>
                      </a:lnTo>
                      <a:lnTo>
                        <a:pt x="1424" y="1774"/>
                      </a:lnTo>
                      <a:lnTo>
                        <a:pt x="1428" y="1775"/>
                      </a:lnTo>
                      <a:lnTo>
                        <a:pt x="1432" y="1775"/>
                      </a:lnTo>
                      <a:lnTo>
                        <a:pt x="1436" y="1775"/>
                      </a:lnTo>
                      <a:lnTo>
                        <a:pt x="1439" y="1775"/>
                      </a:lnTo>
                      <a:lnTo>
                        <a:pt x="1443" y="1775"/>
                      </a:lnTo>
                      <a:lnTo>
                        <a:pt x="1447" y="1774"/>
                      </a:lnTo>
                      <a:lnTo>
                        <a:pt x="1451" y="1772"/>
                      </a:lnTo>
                      <a:lnTo>
                        <a:pt x="1454" y="1771"/>
                      </a:lnTo>
                      <a:lnTo>
                        <a:pt x="1458" y="1770"/>
                      </a:lnTo>
                      <a:lnTo>
                        <a:pt x="1462" y="1769"/>
                      </a:lnTo>
                      <a:lnTo>
                        <a:pt x="1466" y="1769"/>
                      </a:lnTo>
                      <a:lnTo>
                        <a:pt x="1469" y="1770"/>
                      </a:lnTo>
                      <a:lnTo>
                        <a:pt x="1473" y="1770"/>
                      </a:lnTo>
                      <a:lnTo>
                        <a:pt x="1477" y="1770"/>
                      </a:lnTo>
                      <a:lnTo>
                        <a:pt x="1481" y="1771"/>
                      </a:lnTo>
                      <a:lnTo>
                        <a:pt x="1484" y="1772"/>
                      </a:lnTo>
                      <a:lnTo>
                        <a:pt x="1488" y="1771"/>
                      </a:lnTo>
                      <a:lnTo>
                        <a:pt x="1492" y="1771"/>
                      </a:lnTo>
                      <a:lnTo>
                        <a:pt x="1496" y="1770"/>
                      </a:lnTo>
                      <a:lnTo>
                        <a:pt x="1499" y="1768"/>
                      </a:lnTo>
                      <a:lnTo>
                        <a:pt x="1503" y="1765"/>
                      </a:lnTo>
                      <a:lnTo>
                        <a:pt x="1507" y="1762"/>
                      </a:lnTo>
                      <a:lnTo>
                        <a:pt x="1511" y="1759"/>
                      </a:lnTo>
                      <a:lnTo>
                        <a:pt x="1515" y="1756"/>
                      </a:lnTo>
                      <a:lnTo>
                        <a:pt x="1518" y="1753"/>
                      </a:lnTo>
                      <a:lnTo>
                        <a:pt x="1522" y="1752"/>
                      </a:lnTo>
                      <a:lnTo>
                        <a:pt x="1526" y="1754"/>
                      </a:lnTo>
                      <a:lnTo>
                        <a:pt x="1530" y="1756"/>
                      </a:lnTo>
                      <a:lnTo>
                        <a:pt x="1533" y="1759"/>
                      </a:lnTo>
                      <a:lnTo>
                        <a:pt x="1537" y="1764"/>
                      </a:lnTo>
                      <a:lnTo>
                        <a:pt x="1541" y="1765"/>
                      </a:lnTo>
                      <a:lnTo>
                        <a:pt x="1544" y="1767"/>
                      </a:lnTo>
                      <a:lnTo>
                        <a:pt x="1548" y="1769"/>
                      </a:lnTo>
                      <a:lnTo>
                        <a:pt x="1552" y="1769"/>
                      </a:lnTo>
                      <a:lnTo>
                        <a:pt x="1556" y="1770"/>
                      </a:lnTo>
                      <a:lnTo>
                        <a:pt x="1560" y="1768"/>
                      </a:lnTo>
                      <a:lnTo>
                        <a:pt x="1563" y="1768"/>
                      </a:lnTo>
                      <a:lnTo>
                        <a:pt x="1567" y="1768"/>
                      </a:lnTo>
                      <a:lnTo>
                        <a:pt x="1571" y="1768"/>
                      </a:lnTo>
                      <a:lnTo>
                        <a:pt x="1575" y="1768"/>
                      </a:lnTo>
                      <a:lnTo>
                        <a:pt x="1578" y="1767"/>
                      </a:lnTo>
                      <a:lnTo>
                        <a:pt x="1582" y="1767"/>
                      </a:lnTo>
                      <a:lnTo>
                        <a:pt x="1586" y="1768"/>
                      </a:lnTo>
                      <a:lnTo>
                        <a:pt x="1590" y="1768"/>
                      </a:lnTo>
                      <a:lnTo>
                        <a:pt x="1593" y="1767"/>
                      </a:lnTo>
                      <a:lnTo>
                        <a:pt x="1597" y="1767"/>
                      </a:lnTo>
                      <a:lnTo>
                        <a:pt x="1601" y="1767"/>
                      </a:lnTo>
                      <a:lnTo>
                        <a:pt x="1605" y="1767"/>
                      </a:lnTo>
                      <a:lnTo>
                        <a:pt x="1608" y="1767"/>
                      </a:lnTo>
                      <a:lnTo>
                        <a:pt x="1612" y="1767"/>
                      </a:lnTo>
                      <a:lnTo>
                        <a:pt x="1616" y="1766"/>
                      </a:lnTo>
                      <a:lnTo>
                        <a:pt x="1620" y="1765"/>
                      </a:lnTo>
                      <a:lnTo>
                        <a:pt x="1623" y="1765"/>
                      </a:lnTo>
                      <a:lnTo>
                        <a:pt x="1627" y="1765"/>
                      </a:lnTo>
                      <a:lnTo>
                        <a:pt x="1631" y="1765"/>
                      </a:lnTo>
                      <a:lnTo>
                        <a:pt x="1635" y="1764"/>
                      </a:lnTo>
                      <a:lnTo>
                        <a:pt x="1639" y="1763"/>
                      </a:lnTo>
                      <a:lnTo>
                        <a:pt x="1642" y="1763"/>
                      </a:lnTo>
                      <a:lnTo>
                        <a:pt x="1646" y="1762"/>
                      </a:lnTo>
                      <a:lnTo>
                        <a:pt x="1650" y="1762"/>
                      </a:lnTo>
                      <a:lnTo>
                        <a:pt x="1654" y="1761"/>
                      </a:lnTo>
                      <a:lnTo>
                        <a:pt x="1657" y="1761"/>
                      </a:lnTo>
                      <a:lnTo>
                        <a:pt x="1661" y="1760"/>
                      </a:lnTo>
                      <a:lnTo>
                        <a:pt x="1665" y="1759"/>
                      </a:lnTo>
                      <a:lnTo>
                        <a:pt x="1669" y="1760"/>
                      </a:lnTo>
                      <a:lnTo>
                        <a:pt x="1672" y="1759"/>
                      </a:lnTo>
                      <a:lnTo>
                        <a:pt x="1676" y="1758"/>
                      </a:lnTo>
                      <a:lnTo>
                        <a:pt x="1680" y="1758"/>
                      </a:lnTo>
                      <a:lnTo>
                        <a:pt x="1684" y="1758"/>
                      </a:lnTo>
                      <a:lnTo>
                        <a:pt x="1687" y="1757"/>
                      </a:lnTo>
                      <a:lnTo>
                        <a:pt x="1691" y="1757"/>
                      </a:lnTo>
                      <a:lnTo>
                        <a:pt x="1695" y="1757"/>
                      </a:lnTo>
                      <a:lnTo>
                        <a:pt x="1699" y="1757"/>
                      </a:lnTo>
                      <a:lnTo>
                        <a:pt x="1702" y="1757"/>
                      </a:lnTo>
                      <a:lnTo>
                        <a:pt x="1706" y="1758"/>
                      </a:lnTo>
                      <a:lnTo>
                        <a:pt x="1710" y="1758"/>
                      </a:lnTo>
                      <a:lnTo>
                        <a:pt x="1714" y="1757"/>
                      </a:lnTo>
                      <a:lnTo>
                        <a:pt x="1717" y="1756"/>
                      </a:lnTo>
                      <a:lnTo>
                        <a:pt x="1721" y="1757"/>
                      </a:lnTo>
                      <a:lnTo>
                        <a:pt x="1725" y="1756"/>
                      </a:lnTo>
                      <a:lnTo>
                        <a:pt x="1729" y="1756"/>
                      </a:lnTo>
                      <a:lnTo>
                        <a:pt x="1733" y="1755"/>
                      </a:lnTo>
                      <a:lnTo>
                        <a:pt x="1736" y="1755"/>
                      </a:lnTo>
                      <a:lnTo>
                        <a:pt x="1740" y="1753"/>
                      </a:lnTo>
                      <a:lnTo>
                        <a:pt x="1744" y="1752"/>
                      </a:lnTo>
                      <a:lnTo>
                        <a:pt x="1747" y="1751"/>
                      </a:lnTo>
                      <a:lnTo>
                        <a:pt x="1751" y="1749"/>
                      </a:lnTo>
                      <a:lnTo>
                        <a:pt x="1755" y="1747"/>
                      </a:lnTo>
                      <a:lnTo>
                        <a:pt x="1759" y="1745"/>
                      </a:lnTo>
                      <a:lnTo>
                        <a:pt x="1762" y="1744"/>
                      </a:lnTo>
                      <a:lnTo>
                        <a:pt x="1766" y="1744"/>
                      </a:lnTo>
                      <a:lnTo>
                        <a:pt x="1770" y="1743"/>
                      </a:lnTo>
                      <a:lnTo>
                        <a:pt x="1774" y="1742"/>
                      </a:lnTo>
                      <a:lnTo>
                        <a:pt x="1778" y="1741"/>
                      </a:lnTo>
                      <a:lnTo>
                        <a:pt x="1781" y="1742"/>
                      </a:lnTo>
                      <a:lnTo>
                        <a:pt x="1785" y="1743"/>
                      </a:lnTo>
                      <a:lnTo>
                        <a:pt x="1789" y="1744"/>
                      </a:lnTo>
                      <a:lnTo>
                        <a:pt x="1793" y="1745"/>
                      </a:lnTo>
                      <a:lnTo>
                        <a:pt x="1796" y="1745"/>
                      </a:lnTo>
                      <a:lnTo>
                        <a:pt x="1800" y="1746"/>
                      </a:lnTo>
                      <a:lnTo>
                        <a:pt x="1804" y="1748"/>
                      </a:lnTo>
                      <a:lnTo>
                        <a:pt x="1808" y="1748"/>
                      </a:lnTo>
                      <a:lnTo>
                        <a:pt x="1811" y="1748"/>
                      </a:lnTo>
                      <a:lnTo>
                        <a:pt x="1815" y="1748"/>
                      </a:lnTo>
                      <a:lnTo>
                        <a:pt x="1819" y="1748"/>
                      </a:lnTo>
                      <a:lnTo>
                        <a:pt x="1823" y="1746"/>
                      </a:lnTo>
                      <a:lnTo>
                        <a:pt x="1826" y="1745"/>
                      </a:lnTo>
                      <a:lnTo>
                        <a:pt x="1830" y="1744"/>
                      </a:lnTo>
                      <a:lnTo>
                        <a:pt x="1834" y="1743"/>
                      </a:lnTo>
                      <a:lnTo>
                        <a:pt x="1838" y="1742"/>
                      </a:lnTo>
                      <a:lnTo>
                        <a:pt x="1841" y="1741"/>
                      </a:lnTo>
                      <a:lnTo>
                        <a:pt x="1845" y="1742"/>
                      </a:lnTo>
                      <a:lnTo>
                        <a:pt x="1849" y="1743"/>
                      </a:lnTo>
                      <a:lnTo>
                        <a:pt x="1853" y="1743"/>
                      </a:lnTo>
                      <a:lnTo>
                        <a:pt x="1857" y="1743"/>
                      </a:lnTo>
                      <a:lnTo>
                        <a:pt x="1860" y="1743"/>
                      </a:lnTo>
                      <a:lnTo>
                        <a:pt x="1864" y="1743"/>
                      </a:lnTo>
                      <a:lnTo>
                        <a:pt x="1868" y="1742"/>
                      </a:lnTo>
                      <a:lnTo>
                        <a:pt x="1871" y="1742"/>
                      </a:lnTo>
                      <a:lnTo>
                        <a:pt x="1875" y="1740"/>
                      </a:lnTo>
                      <a:lnTo>
                        <a:pt x="1879" y="1740"/>
                      </a:lnTo>
                      <a:lnTo>
                        <a:pt x="1883" y="1737"/>
                      </a:lnTo>
                      <a:lnTo>
                        <a:pt x="1886" y="1736"/>
                      </a:lnTo>
                      <a:lnTo>
                        <a:pt x="1890" y="1736"/>
                      </a:lnTo>
                      <a:lnTo>
                        <a:pt x="1894" y="1734"/>
                      </a:lnTo>
                      <a:lnTo>
                        <a:pt x="1898" y="1732"/>
                      </a:lnTo>
                      <a:lnTo>
                        <a:pt x="1902" y="1731"/>
                      </a:lnTo>
                      <a:lnTo>
                        <a:pt x="1905" y="1729"/>
                      </a:lnTo>
                      <a:lnTo>
                        <a:pt x="1909" y="1728"/>
                      </a:lnTo>
                      <a:lnTo>
                        <a:pt x="1913" y="1728"/>
                      </a:lnTo>
                      <a:lnTo>
                        <a:pt x="1917" y="1727"/>
                      </a:lnTo>
                      <a:lnTo>
                        <a:pt x="1920" y="1726"/>
                      </a:lnTo>
                      <a:lnTo>
                        <a:pt x="1924" y="1725"/>
                      </a:lnTo>
                      <a:lnTo>
                        <a:pt x="1928" y="1724"/>
                      </a:lnTo>
                      <a:lnTo>
                        <a:pt x="1932" y="1723"/>
                      </a:lnTo>
                      <a:lnTo>
                        <a:pt x="1935" y="1723"/>
                      </a:lnTo>
                      <a:lnTo>
                        <a:pt x="1939" y="1722"/>
                      </a:lnTo>
                      <a:lnTo>
                        <a:pt x="1943" y="1721"/>
                      </a:lnTo>
                      <a:lnTo>
                        <a:pt x="1947" y="1720"/>
                      </a:lnTo>
                      <a:lnTo>
                        <a:pt x="1950" y="1718"/>
                      </a:lnTo>
                      <a:lnTo>
                        <a:pt x="1954" y="1717"/>
                      </a:lnTo>
                      <a:lnTo>
                        <a:pt x="1958" y="1717"/>
                      </a:lnTo>
                      <a:lnTo>
                        <a:pt x="1962" y="1716"/>
                      </a:lnTo>
                      <a:lnTo>
                        <a:pt x="1965" y="1715"/>
                      </a:lnTo>
                      <a:lnTo>
                        <a:pt x="1969" y="1714"/>
                      </a:lnTo>
                      <a:lnTo>
                        <a:pt x="1973" y="1714"/>
                      </a:lnTo>
                      <a:lnTo>
                        <a:pt x="1977" y="1715"/>
                      </a:lnTo>
                      <a:lnTo>
                        <a:pt x="1981" y="1714"/>
                      </a:lnTo>
                      <a:lnTo>
                        <a:pt x="1984" y="1714"/>
                      </a:lnTo>
                      <a:lnTo>
                        <a:pt x="1988" y="1714"/>
                      </a:lnTo>
                      <a:lnTo>
                        <a:pt x="1992" y="1714"/>
                      </a:lnTo>
                      <a:lnTo>
                        <a:pt x="1995" y="1713"/>
                      </a:lnTo>
                      <a:lnTo>
                        <a:pt x="1999" y="1712"/>
                      </a:lnTo>
                      <a:lnTo>
                        <a:pt x="2003" y="1710"/>
                      </a:lnTo>
                      <a:lnTo>
                        <a:pt x="2007" y="1707"/>
                      </a:lnTo>
                      <a:lnTo>
                        <a:pt x="2010" y="1703"/>
                      </a:lnTo>
                      <a:lnTo>
                        <a:pt x="2014" y="1700"/>
                      </a:lnTo>
                      <a:lnTo>
                        <a:pt x="2018" y="1696"/>
                      </a:lnTo>
                      <a:lnTo>
                        <a:pt x="2022" y="1693"/>
                      </a:lnTo>
                      <a:lnTo>
                        <a:pt x="2026" y="1689"/>
                      </a:lnTo>
                      <a:lnTo>
                        <a:pt x="2029" y="1688"/>
                      </a:lnTo>
                      <a:lnTo>
                        <a:pt x="2033" y="1687"/>
                      </a:lnTo>
                      <a:lnTo>
                        <a:pt x="2037" y="1686"/>
                      </a:lnTo>
                      <a:lnTo>
                        <a:pt x="2041" y="1687"/>
                      </a:lnTo>
                      <a:lnTo>
                        <a:pt x="2044" y="1686"/>
                      </a:lnTo>
                      <a:lnTo>
                        <a:pt x="2048" y="1686"/>
                      </a:lnTo>
                      <a:lnTo>
                        <a:pt x="2052" y="1686"/>
                      </a:lnTo>
                      <a:lnTo>
                        <a:pt x="2056" y="1685"/>
                      </a:lnTo>
                      <a:lnTo>
                        <a:pt x="2059" y="1685"/>
                      </a:lnTo>
                      <a:lnTo>
                        <a:pt x="2063" y="1684"/>
                      </a:lnTo>
                      <a:lnTo>
                        <a:pt x="2067" y="1683"/>
                      </a:lnTo>
                      <a:lnTo>
                        <a:pt x="2071" y="1682"/>
                      </a:lnTo>
                      <a:lnTo>
                        <a:pt x="2074" y="1681"/>
                      </a:lnTo>
                      <a:lnTo>
                        <a:pt x="2078" y="1680"/>
                      </a:lnTo>
                      <a:lnTo>
                        <a:pt x="2082" y="1680"/>
                      </a:lnTo>
                      <a:lnTo>
                        <a:pt x="2086" y="1679"/>
                      </a:lnTo>
                      <a:lnTo>
                        <a:pt x="2089" y="1679"/>
                      </a:lnTo>
                      <a:lnTo>
                        <a:pt x="2093" y="1680"/>
                      </a:lnTo>
                      <a:lnTo>
                        <a:pt x="2097" y="1679"/>
                      </a:lnTo>
                      <a:lnTo>
                        <a:pt x="2101" y="1680"/>
                      </a:lnTo>
                      <a:lnTo>
                        <a:pt x="2105" y="1678"/>
                      </a:lnTo>
                      <a:lnTo>
                        <a:pt x="2108" y="1677"/>
                      </a:lnTo>
                      <a:lnTo>
                        <a:pt x="2112" y="1673"/>
                      </a:lnTo>
                      <a:lnTo>
                        <a:pt x="2116" y="1669"/>
                      </a:lnTo>
                      <a:lnTo>
                        <a:pt x="2120" y="1665"/>
                      </a:lnTo>
                      <a:lnTo>
                        <a:pt x="2123" y="1659"/>
                      </a:lnTo>
                      <a:lnTo>
                        <a:pt x="2127" y="1653"/>
                      </a:lnTo>
                      <a:lnTo>
                        <a:pt x="2131" y="1650"/>
                      </a:lnTo>
                      <a:lnTo>
                        <a:pt x="2134" y="1646"/>
                      </a:lnTo>
                      <a:lnTo>
                        <a:pt x="2138" y="1643"/>
                      </a:lnTo>
                      <a:lnTo>
                        <a:pt x="2142" y="1640"/>
                      </a:lnTo>
                      <a:lnTo>
                        <a:pt x="2146" y="1638"/>
                      </a:lnTo>
                      <a:lnTo>
                        <a:pt x="2150" y="1636"/>
                      </a:lnTo>
                      <a:lnTo>
                        <a:pt x="2153" y="1636"/>
                      </a:lnTo>
                      <a:lnTo>
                        <a:pt x="2157" y="1636"/>
                      </a:lnTo>
                      <a:lnTo>
                        <a:pt x="2161" y="1638"/>
                      </a:lnTo>
                      <a:lnTo>
                        <a:pt x="2165" y="1639"/>
                      </a:lnTo>
                      <a:lnTo>
                        <a:pt x="2168" y="1641"/>
                      </a:lnTo>
                      <a:lnTo>
                        <a:pt x="2172" y="1642"/>
                      </a:lnTo>
                      <a:lnTo>
                        <a:pt x="2176" y="1643"/>
                      </a:lnTo>
                      <a:lnTo>
                        <a:pt x="2180" y="1643"/>
                      </a:lnTo>
                      <a:lnTo>
                        <a:pt x="2183" y="1643"/>
                      </a:lnTo>
                      <a:lnTo>
                        <a:pt x="2187" y="1641"/>
                      </a:lnTo>
                      <a:lnTo>
                        <a:pt x="2191" y="1638"/>
                      </a:lnTo>
                      <a:lnTo>
                        <a:pt x="2195" y="1635"/>
                      </a:lnTo>
                      <a:lnTo>
                        <a:pt x="2198" y="1630"/>
                      </a:lnTo>
                      <a:lnTo>
                        <a:pt x="2202" y="1625"/>
                      </a:lnTo>
                      <a:lnTo>
                        <a:pt x="2206" y="1619"/>
                      </a:lnTo>
                      <a:lnTo>
                        <a:pt x="2210" y="1611"/>
                      </a:lnTo>
                      <a:lnTo>
                        <a:pt x="2213" y="1603"/>
                      </a:lnTo>
                      <a:lnTo>
                        <a:pt x="2217" y="1590"/>
                      </a:lnTo>
                      <a:lnTo>
                        <a:pt x="2221" y="1578"/>
                      </a:lnTo>
                      <a:lnTo>
                        <a:pt x="2225" y="1563"/>
                      </a:lnTo>
                      <a:lnTo>
                        <a:pt x="2229" y="1547"/>
                      </a:lnTo>
                      <a:lnTo>
                        <a:pt x="2232" y="1533"/>
                      </a:lnTo>
                      <a:lnTo>
                        <a:pt x="2236" y="1519"/>
                      </a:lnTo>
                      <a:lnTo>
                        <a:pt x="2240" y="1508"/>
                      </a:lnTo>
                      <a:lnTo>
                        <a:pt x="2244" y="1500"/>
                      </a:lnTo>
                      <a:lnTo>
                        <a:pt x="2247" y="1493"/>
                      </a:lnTo>
                      <a:lnTo>
                        <a:pt x="2251" y="1489"/>
                      </a:lnTo>
                      <a:lnTo>
                        <a:pt x="2255" y="1487"/>
                      </a:lnTo>
                      <a:lnTo>
                        <a:pt x="2258" y="1487"/>
                      </a:lnTo>
                      <a:lnTo>
                        <a:pt x="2262" y="1489"/>
                      </a:lnTo>
                      <a:lnTo>
                        <a:pt x="2266" y="1492"/>
                      </a:lnTo>
                      <a:lnTo>
                        <a:pt x="2270" y="1491"/>
                      </a:lnTo>
                      <a:lnTo>
                        <a:pt x="2274" y="1479"/>
                      </a:lnTo>
                      <a:lnTo>
                        <a:pt x="2277" y="1445"/>
                      </a:lnTo>
                      <a:lnTo>
                        <a:pt x="2278" y="1436"/>
                      </a:lnTo>
                      <a:lnTo>
                        <a:pt x="2281" y="1378"/>
                      </a:lnTo>
                      <a:lnTo>
                        <a:pt x="2282" y="1359"/>
                      </a:lnTo>
                      <a:lnTo>
                        <a:pt x="2284" y="1291"/>
                      </a:lnTo>
                      <a:lnTo>
                        <a:pt x="2285" y="1265"/>
                      </a:lnTo>
                      <a:lnTo>
                        <a:pt x="2289" y="1107"/>
                      </a:lnTo>
                      <a:lnTo>
                        <a:pt x="2292" y="912"/>
                      </a:lnTo>
                      <a:lnTo>
                        <a:pt x="2296" y="704"/>
                      </a:lnTo>
                      <a:lnTo>
                        <a:pt x="2300" y="512"/>
                      </a:lnTo>
                      <a:lnTo>
                        <a:pt x="2301" y="478"/>
                      </a:lnTo>
                      <a:lnTo>
                        <a:pt x="2303" y="389"/>
                      </a:lnTo>
                      <a:lnTo>
                        <a:pt x="2304" y="365"/>
                      </a:lnTo>
                      <a:lnTo>
                        <a:pt x="2304" y="343"/>
                      </a:lnTo>
                      <a:lnTo>
                        <a:pt x="2307" y="298"/>
                      </a:lnTo>
                      <a:lnTo>
                        <a:pt x="2307" y="289"/>
                      </a:lnTo>
                      <a:lnTo>
                        <a:pt x="2309" y="283"/>
                      </a:lnTo>
                      <a:lnTo>
                        <a:pt x="2310" y="291"/>
                      </a:lnTo>
                      <a:lnTo>
                        <a:pt x="2311" y="300"/>
                      </a:lnTo>
                      <a:lnTo>
                        <a:pt x="2312" y="312"/>
                      </a:lnTo>
                      <a:lnTo>
                        <a:pt x="2314" y="368"/>
                      </a:lnTo>
                      <a:lnTo>
                        <a:pt x="2315" y="393"/>
                      </a:lnTo>
                      <a:lnTo>
                        <a:pt x="2316" y="419"/>
                      </a:lnTo>
                      <a:lnTo>
                        <a:pt x="2319" y="547"/>
                      </a:lnTo>
                      <a:lnTo>
                        <a:pt x="2322" y="735"/>
                      </a:lnTo>
                      <a:lnTo>
                        <a:pt x="2326" y="927"/>
                      </a:lnTo>
                      <a:lnTo>
                        <a:pt x="2330" y="1104"/>
                      </a:lnTo>
                      <a:lnTo>
                        <a:pt x="2334" y="1250"/>
                      </a:lnTo>
                      <a:lnTo>
                        <a:pt x="2337" y="1363"/>
                      </a:lnTo>
                      <a:lnTo>
                        <a:pt x="2341" y="1444"/>
                      </a:lnTo>
                      <a:lnTo>
                        <a:pt x="2345" y="1499"/>
                      </a:lnTo>
                      <a:lnTo>
                        <a:pt x="2349" y="1534"/>
                      </a:lnTo>
                      <a:lnTo>
                        <a:pt x="2352" y="1554"/>
                      </a:lnTo>
                      <a:lnTo>
                        <a:pt x="2356" y="1565"/>
                      </a:lnTo>
                      <a:lnTo>
                        <a:pt x="2360" y="1570"/>
                      </a:lnTo>
                      <a:lnTo>
                        <a:pt x="2364" y="1572"/>
                      </a:lnTo>
                      <a:lnTo>
                        <a:pt x="2368" y="1570"/>
                      </a:lnTo>
                      <a:lnTo>
                        <a:pt x="2371" y="1567"/>
                      </a:lnTo>
                      <a:lnTo>
                        <a:pt x="2375" y="1565"/>
                      </a:lnTo>
                      <a:lnTo>
                        <a:pt x="2379" y="1561"/>
                      </a:lnTo>
                      <a:lnTo>
                        <a:pt x="2382" y="1557"/>
                      </a:lnTo>
                      <a:lnTo>
                        <a:pt x="2386" y="1555"/>
                      </a:lnTo>
                      <a:lnTo>
                        <a:pt x="2390" y="1552"/>
                      </a:lnTo>
                      <a:lnTo>
                        <a:pt x="2394" y="1549"/>
                      </a:lnTo>
                      <a:lnTo>
                        <a:pt x="2398" y="1547"/>
                      </a:lnTo>
                      <a:lnTo>
                        <a:pt x="2401" y="1544"/>
                      </a:lnTo>
                      <a:lnTo>
                        <a:pt x="2405" y="1542"/>
                      </a:lnTo>
                      <a:lnTo>
                        <a:pt x="2409" y="1539"/>
                      </a:lnTo>
                      <a:lnTo>
                        <a:pt x="2413" y="1536"/>
                      </a:lnTo>
                      <a:lnTo>
                        <a:pt x="2416" y="1534"/>
                      </a:lnTo>
                      <a:lnTo>
                        <a:pt x="2420" y="1529"/>
                      </a:lnTo>
                      <a:lnTo>
                        <a:pt x="2424" y="1524"/>
                      </a:lnTo>
                      <a:lnTo>
                        <a:pt x="2428" y="1517"/>
                      </a:lnTo>
                      <a:lnTo>
                        <a:pt x="2431" y="1508"/>
                      </a:lnTo>
                      <a:lnTo>
                        <a:pt x="2435" y="1497"/>
                      </a:lnTo>
                      <a:lnTo>
                        <a:pt x="2439" y="1483"/>
                      </a:lnTo>
                      <a:lnTo>
                        <a:pt x="2443" y="1463"/>
                      </a:lnTo>
                      <a:lnTo>
                        <a:pt x="2446" y="1436"/>
                      </a:lnTo>
                      <a:lnTo>
                        <a:pt x="2450" y="1400"/>
                      </a:lnTo>
                      <a:lnTo>
                        <a:pt x="2454" y="1346"/>
                      </a:lnTo>
                      <a:lnTo>
                        <a:pt x="2458" y="1269"/>
                      </a:lnTo>
                      <a:lnTo>
                        <a:pt x="2461" y="1181"/>
                      </a:lnTo>
                      <a:lnTo>
                        <a:pt x="2461" y="1154"/>
                      </a:lnTo>
                      <a:lnTo>
                        <a:pt x="2464" y="1032"/>
                      </a:lnTo>
                      <a:lnTo>
                        <a:pt x="2465" y="997"/>
                      </a:lnTo>
                      <a:lnTo>
                        <a:pt x="2466" y="961"/>
                      </a:lnTo>
                      <a:lnTo>
                        <a:pt x="2468" y="844"/>
                      </a:lnTo>
                      <a:lnTo>
                        <a:pt x="2469" y="801"/>
                      </a:lnTo>
                      <a:lnTo>
                        <a:pt x="2473" y="578"/>
                      </a:lnTo>
                      <a:lnTo>
                        <a:pt x="2476" y="353"/>
                      </a:lnTo>
                      <a:lnTo>
                        <a:pt x="2477" y="312"/>
                      </a:lnTo>
                      <a:lnTo>
                        <a:pt x="2479" y="196"/>
                      </a:lnTo>
                      <a:lnTo>
                        <a:pt x="2480" y="162"/>
                      </a:lnTo>
                      <a:lnTo>
                        <a:pt x="2481" y="130"/>
                      </a:lnTo>
                      <a:lnTo>
                        <a:pt x="2483" y="55"/>
                      </a:lnTo>
                      <a:lnTo>
                        <a:pt x="2484" y="37"/>
                      </a:lnTo>
                      <a:lnTo>
                        <a:pt x="2485" y="22"/>
                      </a:lnTo>
                      <a:lnTo>
                        <a:pt x="2487" y="0"/>
                      </a:lnTo>
                      <a:lnTo>
                        <a:pt x="2488" y="1"/>
                      </a:lnTo>
                      <a:lnTo>
                        <a:pt x="2489" y="6"/>
                      </a:lnTo>
                      <a:lnTo>
                        <a:pt x="2491" y="44"/>
                      </a:lnTo>
                      <a:lnTo>
                        <a:pt x="2492" y="64"/>
                      </a:lnTo>
                      <a:lnTo>
                        <a:pt x="2492" y="87"/>
                      </a:lnTo>
                      <a:lnTo>
                        <a:pt x="2495" y="175"/>
                      </a:lnTo>
                      <a:lnTo>
                        <a:pt x="2495" y="210"/>
                      </a:lnTo>
                      <a:lnTo>
                        <a:pt x="2496" y="247"/>
                      </a:lnTo>
                      <a:lnTo>
                        <a:pt x="2499" y="414"/>
                      </a:lnTo>
                      <a:lnTo>
                        <a:pt x="2503" y="643"/>
                      </a:lnTo>
                      <a:lnTo>
                        <a:pt x="2507" y="867"/>
                      </a:lnTo>
                      <a:lnTo>
                        <a:pt x="2510" y="1070"/>
                      </a:lnTo>
                      <a:lnTo>
                        <a:pt x="2513" y="1209"/>
                      </a:lnTo>
                      <a:lnTo>
                        <a:pt x="2514" y="1240"/>
                      </a:lnTo>
                      <a:lnTo>
                        <a:pt x="2518" y="1374"/>
                      </a:lnTo>
                      <a:lnTo>
                        <a:pt x="2522" y="1477"/>
                      </a:lnTo>
                      <a:lnTo>
                        <a:pt x="2525" y="1551"/>
                      </a:lnTo>
                      <a:lnTo>
                        <a:pt x="2529" y="1605"/>
                      </a:lnTo>
                      <a:lnTo>
                        <a:pt x="2533" y="1644"/>
                      </a:lnTo>
                      <a:lnTo>
                        <a:pt x="2537" y="1672"/>
                      </a:lnTo>
                      <a:lnTo>
                        <a:pt x="2540" y="1693"/>
                      </a:lnTo>
                      <a:lnTo>
                        <a:pt x="2544" y="1709"/>
                      </a:lnTo>
                      <a:lnTo>
                        <a:pt x="2548" y="1719"/>
                      </a:lnTo>
                      <a:lnTo>
                        <a:pt x="2552" y="1728"/>
                      </a:lnTo>
                      <a:lnTo>
                        <a:pt x="2555" y="1735"/>
                      </a:lnTo>
                      <a:lnTo>
                        <a:pt x="2559" y="1739"/>
                      </a:lnTo>
                      <a:lnTo>
                        <a:pt x="2563" y="1743"/>
                      </a:lnTo>
                      <a:lnTo>
                        <a:pt x="2567" y="1746"/>
                      </a:lnTo>
                      <a:lnTo>
                        <a:pt x="2571" y="1749"/>
                      </a:lnTo>
                      <a:lnTo>
                        <a:pt x="2574" y="1751"/>
                      </a:lnTo>
                      <a:lnTo>
                        <a:pt x="2578" y="1753"/>
                      </a:lnTo>
                      <a:lnTo>
                        <a:pt x="2582" y="1755"/>
                      </a:lnTo>
                      <a:lnTo>
                        <a:pt x="2585" y="1756"/>
                      </a:lnTo>
                      <a:lnTo>
                        <a:pt x="2589" y="1758"/>
                      </a:lnTo>
                      <a:lnTo>
                        <a:pt x="2593" y="1760"/>
                      </a:lnTo>
                      <a:lnTo>
                        <a:pt x="2597" y="1760"/>
                      </a:lnTo>
                      <a:lnTo>
                        <a:pt x="2600" y="1764"/>
                      </a:lnTo>
                      <a:lnTo>
                        <a:pt x="2604" y="1765"/>
                      </a:lnTo>
                      <a:lnTo>
                        <a:pt x="2608" y="1766"/>
                      </a:lnTo>
                      <a:lnTo>
                        <a:pt x="2612" y="1768"/>
                      </a:lnTo>
                      <a:lnTo>
                        <a:pt x="2616" y="1769"/>
                      </a:lnTo>
                      <a:lnTo>
                        <a:pt x="2619" y="1771"/>
                      </a:lnTo>
                      <a:lnTo>
                        <a:pt x="2623" y="1772"/>
                      </a:lnTo>
                      <a:lnTo>
                        <a:pt x="2627" y="1773"/>
                      </a:lnTo>
                      <a:lnTo>
                        <a:pt x="2631" y="1775"/>
                      </a:lnTo>
                      <a:lnTo>
                        <a:pt x="2634" y="1775"/>
                      </a:lnTo>
                      <a:lnTo>
                        <a:pt x="2638" y="1775"/>
                      </a:lnTo>
                      <a:lnTo>
                        <a:pt x="2642" y="1776"/>
                      </a:lnTo>
                      <a:lnTo>
                        <a:pt x="2646" y="1777"/>
                      </a:lnTo>
                      <a:lnTo>
                        <a:pt x="2649" y="1777"/>
                      </a:lnTo>
                      <a:lnTo>
                        <a:pt x="2653" y="1777"/>
                      </a:lnTo>
                      <a:lnTo>
                        <a:pt x="2657" y="1778"/>
                      </a:lnTo>
                      <a:lnTo>
                        <a:pt x="2661" y="1778"/>
                      </a:lnTo>
                      <a:lnTo>
                        <a:pt x="2664" y="1778"/>
                      </a:lnTo>
                      <a:lnTo>
                        <a:pt x="2668" y="1779"/>
                      </a:lnTo>
                      <a:lnTo>
                        <a:pt x="2672" y="1779"/>
                      </a:lnTo>
                      <a:lnTo>
                        <a:pt x="2676" y="1779"/>
                      </a:lnTo>
                      <a:lnTo>
                        <a:pt x="2679" y="1779"/>
                      </a:lnTo>
                      <a:lnTo>
                        <a:pt x="2683" y="1780"/>
                      </a:lnTo>
                      <a:lnTo>
                        <a:pt x="2687" y="1780"/>
                      </a:lnTo>
                      <a:lnTo>
                        <a:pt x="2691" y="1780"/>
                      </a:lnTo>
                      <a:lnTo>
                        <a:pt x="2695" y="1780"/>
                      </a:lnTo>
                      <a:lnTo>
                        <a:pt x="2698" y="1780"/>
                      </a:lnTo>
                      <a:lnTo>
                        <a:pt x="2702" y="1780"/>
                      </a:lnTo>
                      <a:lnTo>
                        <a:pt x="2706" y="1780"/>
                      </a:lnTo>
                      <a:lnTo>
                        <a:pt x="2709" y="1780"/>
                      </a:lnTo>
                      <a:lnTo>
                        <a:pt x="2713" y="1780"/>
                      </a:lnTo>
                      <a:lnTo>
                        <a:pt x="2717" y="1780"/>
                      </a:lnTo>
                      <a:lnTo>
                        <a:pt x="2721" y="1779"/>
                      </a:lnTo>
                      <a:lnTo>
                        <a:pt x="2724" y="1779"/>
                      </a:lnTo>
                      <a:lnTo>
                        <a:pt x="2728" y="1780"/>
                      </a:lnTo>
                      <a:lnTo>
                        <a:pt x="2732" y="1780"/>
                      </a:lnTo>
                      <a:lnTo>
                        <a:pt x="2736" y="1780"/>
                      </a:lnTo>
                      <a:lnTo>
                        <a:pt x="2740" y="1779"/>
                      </a:lnTo>
                      <a:lnTo>
                        <a:pt x="2743" y="1780"/>
                      </a:lnTo>
                      <a:lnTo>
                        <a:pt x="2747" y="1780"/>
                      </a:lnTo>
                      <a:lnTo>
                        <a:pt x="2751" y="1780"/>
                      </a:lnTo>
                      <a:lnTo>
                        <a:pt x="2755" y="1780"/>
                      </a:lnTo>
                      <a:lnTo>
                        <a:pt x="2758" y="1780"/>
                      </a:lnTo>
                      <a:lnTo>
                        <a:pt x="2762" y="1780"/>
                      </a:lnTo>
                      <a:lnTo>
                        <a:pt x="2766" y="1780"/>
                      </a:lnTo>
                      <a:lnTo>
                        <a:pt x="2770" y="1781"/>
                      </a:lnTo>
                      <a:lnTo>
                        <a:pt x="2773" y="1782"/>
                      </a:lnTo>
                      <a:lnTo>
                        <a:pt x="2777" y="1781"/>
                      </a:lnTo>
                      <a:lnTo>
                        <a:pt x="2781" y="1782"/>
                      </a:lnTo>
                      <a:lnTo>
                        <a:pt x="2785" y="1782"/>
                      </a:lnTo>
                      <a:lnTo>
                        <a:pt x="2788" y="1782"/>
                      </a:lnTo>
                      <a:lnTo>
                        <a:pt x="2792" y="1782"/>
                      </a:lnTo>
                      <a:lnTo>
                        <a:pt x="2796" y="1782"/>
                      </a:lnTo>
                      <a:lnTo>
                        <a:pt x="2800" y="1781"/>
                      </a:lnTo>
                      <a:lnTo>
                        <a:pt x="2803" y="1782"/>
                      </a:lnTo>
                      <a:lnTo>
                        <a:pt x="2807" y="1782"/>
                      </a:lnTo>
                      <a:lnTo>
                        <a:pt x="2811" y="1782"/>
                      </a:lnTo>
                      <a:lnTo>
                        <a:pt x="2815" y="1782"/>
                      </a:lnTo>
                      <a:lnTo>
                        <a:pt x="2819" y="1782"/>
                      </a:lnTo>
                      <a:lnTo>
                        <a:pt x="2822" y="1783"/>
                      </a:lnTo>
                      <a:lnTo>
                        <a:pt x="2826" y="1781"/>
                      </a:lnTo>
                      <a:lnTo>
                        <a:pt x="2830" y="1782"/>
                      </a:lnTo>
                      <a:lnTo>
                        <a:pt x="2833" y="1782"/>
                      </a:lnTo>
                      <a:lnTo>
                        <a:pt x="2837" y="1782"/>
                      </a:lnTo>
                      <a:lnTo>
                        <a:pt x="2841" y="1782"/>
                      </a:lnTo>
                      <a:lnTo>
                        <a:pt x="2845" y="1782"/>
                      </a:lnTo>
                      <a:lnTo>
                        <a:pt x="2848" y="1781"/>
                      </a:lnTo>
                      <a:lnTo>
                        <a:pt x="2852" y="1782"/>
                      </a:lnTo>
                      <a:lnTo>
                        <a:pt x="2856" y="1782"/>
                      </a:lnTo>
                      <a:lnTo>
                        <a:pt x="2860" y="1781"/>
                      </a:lnTo>
                      <a:lnTo>
                        <a:pt x="2864" y="1782"/>
                      </a:lnTo>
                      <a:lnTo>
                        <a:pt x="2867" y="1781"/>
                      </a:lnTo>
                      <a:lnTo>
                        <a:pt x="2871" y="1782"/>
                      </a:lnTo>
                      <a:lnTo>
                        <a:pt x="2875" y="1782"/>
                      </a:lnTo>
                      <a:lnTo>
                        <a:pt x="2879" y="1782"/>
                      </a:lnTo>
                      <a:lnTo>
                        <a:pt x="2882" y="1782"/>
                      </a:lnTo>
                      <a:lnTo>
                        <a:pt x="2886" y="1782"/>
                      </a:lnTo>
                      <a:lnTo>
                        <a:pt x="2890" y="1781"/>
                      </a:lnTo>
                      <a:lnTo>
                        <a:pt x="2894" y="1782"/>
                      </a:lnTo>
                      <a:lnTo>
                        <a:pt x="2897" y="1782"/>
                      </a:lnTo>
                      <a:lnTo>
                        <a:pt x="2901" y="1783"/>
                      </a:lnTo>
                      <a:lnTo>
                        <a:pt x="2905" y="1783"/>
                      </a:lnTo>
                      <a:lnTo>
                        <a:pt x="2909" y="1783"/>
                      </a:lnTo>
                      <a:lnTo>
                        <a:pt x="2912" y="1784"/>
                      </a:lnTo>
                      <a:lnTo>
                        <a:pt x="2916" y="1783"/>
                      </a:lnTo>
                      <a:lnTo>
                        <a:pt x="2920" y="1784"/>
                      </a:lnTo>
                      <a:lnTo>
                        <a:pt x="2924" y="1784"/>
                      </a:lnTo>
                      <a:lnTo>
                        <a:pt x="2927" y="1783"/>
                      </a:lnTo>
                      <a:lnTo>
                        <a:pt x="2931" y="1784"/>
                      </a:lnTo>
                      <a:lnTo>
                        <a:pt x="2935" y="1784"/>
                      </a:lnTo>
                      <a:lnTo>
                        <a:pt x="2939" y="1785"/>
                      </a:lnTo>
                      <a:lnTo>
                        <a:pt x="2942" y="1784"/>
                      </a:lnTo>
                      <a:lnTo>
                        <a:pt x="2946" y="1784"/>
                      </a:lnTo>
                      <a:lnTo>
                        <a:pt x="2950" y="1785"/>
                      </a:lnTo>
                      <a:lnTo>
                        <a:pt x="2954" y="1785"/>
                      </a:lnTo>
                      <a:lnTo>
                        <a:pt x="2958" y="1784"/>
                      </a:lnTo>
                      <a:lnTo>
                        <a:pt x="2961" y="1785"/>
                      </a:lnTo>
                      <a:lnTo>
                        <a:pt x="2965" y="1785"/>
                      </a:lnTo>
                      <a:lnTo>
                        <a:pt x="2969" y="1785"/>
                      </a:lnTo>
                      <a:lnTo>
                        <a:pt x="2972" y="1786"/>
                      </a:lnTo>
                      <a:lnTo>
                        <a:pt x="2976" y="1785"/>
                      </a:lnTo>
                      <a:lnTo>
                        <a:pt x="2980" y="1785"/>
                      </a:lnTo>
                      <a:lnTo>
                        <a:pt x="2984" y="1785"/>
                      </a:lnTo>
                      <a:lnTo>
                        <a:pt x="2988" y="1785"/>
                      </a:lnTo>
                      <a:lnTo>
                        <a:pt x="2991" y="1786"/>
                      </a:lnTo>
                      <a:lnTo>
                        <a:pt x="2995" y="1786"/>
                      </a:lnTo>
                      <a:lnTo>
                        <a:pt x="2999" y="1786"/>
                      </a:lnTo>
                      <a:lnTo>
                        <a:pt x="3003" y="1786"/>
                      </a:lnTo>
                      <a:lnTo>
                        <a:pt x="3006" y="1786"/>
                      </a:lnTo>
                      <a:lnTo>
                        <a:pt x="3010" y="1785"/>
                      </a:lnTo>
                      <a:lnTo>
                        <a:pt x="3014" y="1786"/>
                      </a:lnTo>
                      <a:lnTo>
                        <a:pt x="3018" y="1786"/>
                      </a:lnTo>
                      <a:lnTo>
                        <a:pt x="3021" y="1786"/>
                      </a:lnTo>
                      <a:lnTo>
                        <a:pt x="3025" y="1786"/>
                      </a:lnTo>
                      <a:lnTo>
                        <a:pt x="3029" y="1785"/>
                      </a:lnTo>
                      <a:lnTo>
                        <a:pt x="3033" y="1785"/>
                      </a:lnTo>
                      <a:lnTo>
                        <a:pt x="3036" y="1784"/>
                      </a:lnTo>
                      <a:lnTo>
                        <a:pt x="3040" y="1786"/>
                      </a:lnTo>
                      <a:lnTo>
                        <a:pt x="3044" y="1786"/>
                      </a:lnTo>
                      <a:lnTo>
                        <a:pt x="3048" y="1785"/>
                      </a:lnTo>
                      <a:lnTo>
                        <a:pt x="3051" y="1785"/>
                      </a:lnTo>
                      <a:lnTo>
                        <a:pt x="3055" y="1785"/>
                      </a:lnTo>
                      <a:lnTo>
                        <a:pt x="3059" y="1785"/>
                      </a:lnTo>
                      <a:lnTo>
                        <a:pt x="3063" y="1785"/>
                      </a:lnTo>
                      <a:lnTo>
                        <a:pt x="3066" y="1786"/>
                      </a:lnTo>
                      <a:lnTo>
                        <a:pt x="3070" y="1785"/>
                      </a:lnTo>
                      <a:lnTo>
                        <a:pt x="3074" y="1786"/>
                      </a:lnTo>
                      <a:lnTo>
                        <a:pt x="3078" y="1785"/>
                      </a:lnTo>
                      <a:lnTo>
                        <a:pt x="3082" y="1786"/>
                      </a:lnTo>
                      <a:lnTo>
                        <a:pt x="3085" y="1786"/>
                      </a:lnTo>
                      <a:lnTo>
                        <a:pt x="3089" y="1785"/>
                      </a:lnTo>
                      <a:lnTo>
                        <a:pt x="3093" y="1785"/>
                      </a:lnTo>
                      <a:lnTo>
                        <a:pt x="3096" y="1785"/>
                      </a:lnTo>
                      <a:lnTo>
                        <a:pt x="3100" y="1785"/>
                      </a:lnTo>
                      <a:lnTo>
                        <a:pt x="3104" y="1785"/>
                      </a:lnTo>
                      <a:lnTo>
                        <a:pt x="3108" y="1785"/>
                      </a:lnTo>
                      <a:lnTo>
                        <a:pt x="3112" y="1785"/>
                      </a:lnTo>
                      <a:lnTo>
                        <a:pt x="3115" y="1785"/>
                      </a:lnTo>
                      <a:lnTo>
                        <a:pt x="3119" y="1785"/>
                      </a:lnTo>
                      <a:lnTo>
                        <a:pt x="3123" y="1785"/>
                      </a:lnTo>
                      <a:lnTo>
                        <a:pt x="3127" y="1786"/>
                      </a:lnTo>
                      <a:lnTo>
                        <a:pt x="3130" y="1785"/>
                      </a:lnTo>
                      <a:lnTo>
                        <a:pt x="3134" y="1785"/>
                      </a:lnTo>
                      <a:lnTo>
                        <a:pt x="3138" y="1785"/>
                      </a:lnTo>
                      <a:lnTo>
                        <a:pt x="3142" y="1785"/>
                      </a:lnTo>
                      <a:lnTo>
                        <a:pt x="3145" y="1785"/>
                      </a:lnTo>
                      <a:lnTo>
                        <a:pt x="3149" y="1785"/>
                      </a:lnTo>
                      <a:lnTo>
                        <a:pt x="3153" y="1785"/>
                      </a:lnTo>
                      <a:lnTo>
                        <a:pt x="3157" y="1785"/>
                      </a:lnTo>
                      <a:lnTo>
                        <a:pt x="3160" y="1785"/>
                      </a:lnTo>
                      <a:lnTo>
                        <a:pt x="3164" y="1785"/>
                      </a:lnTo>
                      <a:lnTo>
                        <a:pt x="3168" y="1785"/>
                      </a:lnTo>
                      <a:lnTo>
                        <a:pt x="3172" y="1785"/>
                      </a:lnTo>
                      <a:lnTo>
                        <a:pt x="3175" y="1786"/>
                      </a:lnTo>
                      <a:lnTo>
                        <a:pt x="3179" y="1785"/>
                      </a:lnTo>
                      <a:lnTo>
                        <a:pt x="3183" y="1785"/>
                      </a:lnTo>
                      <a:lnTo>
                        <a:pt x="3187" y="1785"/>
                      </a:lnTo>
                      <a:lnTo>
                        <a:pt x="3190" y="1784"/>
                      </a:lnTo>
                      <a:lnTo>
                        <a:pt x="3194" y="1784"/>
                      </a:lnTo>
                      <a:lnTo>
                        <a:pt x="3198" y="1785"/>
                      </a:lnTo>
                      <a:lnTo>
                        <a:pt x="3202" y="1784"/>
                      </a:lnTo>
                      <a:lnTo>
                        <a:pt x="3206" y="1785"/>
                      </a:lnTo>
                      <a:lnTo>
                        <a:pt x="3209" y="1785"/>
                      </a:lnTo>
                      <a:lnTo>
                        <a:pt x="3213" y="1785"/>
                      </a:lnTo>
                      <a:lnTo>
                        <a:pt x="3217" y="1785"/>
                      </a:lnTo>
                      <a:lnTo>
                        <a:pt x="3220" y="1785"/>
                      </a:lnTo>
                      <a:lnTo>
                        <a:pt x="3224" y="1784"/>
                      </a:lnTo>
                      <a:lnTo>
                        <a:pt x="3228" y="1784"/>
                      </a:lnTo>
                      <a:lnTo>
                        <a:pt x="3232" y="1785"/>
                      </a:lnTo>
                      <a:lnTo>
                        <a:pt x="3236" y="1784"/>
                      </a:lnTo>
                      <a:lnTo>
                        <a:pt x="3239" y="1784"/>
                      </a:lnTo>
                      <a:lnTo>
                        <a:pt x="3243" y="1784"/>
                      </a:lnTo>
                      <a:lnTo>
                        <a:pt x="3247" y="1784"/>
                      </a:lnTo>
                      <a:lnTo>
                        <a:pt x="3251" y="1784"/>
                      </a:lnTo>
                      <a:lnTo>
                        <a:pt x="3254" y="1784"/>
                      </a:lnTo>
                      <a:lnTo>
                        <a:pt x="3258" y="1784"/>
                      </a:lnTo>
                      <a:lnTo>
                        <a:pt x="3262" y="1784"/>
                      </a:lnTo>
                      <a:lnTo>
                        <a:pt x="3266" y="1783"/>
                      </a:lnTo>
                      <a:lnTo>
                        <a:pt x="3269" y="1784"/>
                      </a:lnTo>
                      <a:lnTo>
                        <a:pt x="3273" y="1784"/>
                      </a:lnTo>
                      <a:lnTo>
                        <a:pt x="3277" y="1783"/>
                      </a:lnTo>
                      <a:lnTo>
                        <a:pt x="3281" y="1785"/>
                      </a:lnTo>
                      <a:lnTo>
                        <a:pt x="3284" y="1784"/>
                      </a:lnTo>
                      <a:lnTo>
                        <a:pt x="3288" y="1784"/>
                      </a:lnTo>
                      <a:lnTo>
                        <a:pt x="3292" y="1784"/>
                      </a:lnTo>
                      <a:lnTo>
                        <a:pt x="3296" y="1783"/>
                      </a:lnTo>
                      <a:lnTo>
                        <a:pt x="3299" y="1783"/>
                      </a:lnTo>
                      <a:lnTo>
                        <a:pt x="3303" y="1783"/>
                      </a:lnTo>
                      <a:lnTo>
                        <a:pt x="3307" y="1783"/>
                      </a:lnTo>
                      <a:lnTo>
                        <a:pt x="3311" y="1783"/>
                      </a:lnTo>
                      <a:lnTo>
                        <a:pt x="3314" y="1783"/>
                      </a:lnTo>
                      <a:lnTo>
                        <a:pt x="3318" y="1783"/>
                      </a:lnTo>
                      <a:lnTo>
                        <a:pt x="3322" y="1783"/>
                      </a:lnTo>
                      <a:lnTo>
                        <a:pt x="3326" y="1783"/>
                      </a:lnTo>
                      <a:lnTo>
                        <a:pt x="3330" y="1783"/>
                      </a:lnTo>
                      <a:lnTo>
                        <a:pt x="3333" y="1783"/>
                      </a:lnTo>
                      <a:lnTo>
                        <a:pt x="3337" y="1783"/>
                      </a:lnTo>
                      <a:lnTo>
                        <a:pt x="3341" y="1782"/>
                      </a:lnTo>
                      <a:lnTo>
                        <a:pt x="3345" y="1783"/>
                      </a:lnTo>
                      <a:lnTo>
                        <a:pt x="3348" y="1782"/>
                      </a:lnTo>
                      <a:lnTo>
                        <a:pt x="3352" y="1782"/>
                      </a:lnTo>
                      <a:lnTo>
                        <a:pt x="3356" y="1783"/>
                      </a:lnTo>
                      <a:lnTo>
                        <a:pt x="3360" y="1782"/>
                      </a:lnTo>
                      <a:lnTo>
                        <a:pt x="3363" y="1781"/>
                      </a:lnTo>
                      <a:lnTo>
                        <a:pt x="3367" y="1782"/>
                      </a:lnTo>
                      <a:lnTo>
                        <a:pt x="3371" y="1782"/>
                      </a:lnTo>
                      <a:lnTo>
                        <a:pt x="3375" y="1782"/>
                      </a:lnTo>
                      <a:lnTo>
                        <a:pt x="3378" y="1782"/>
                      </a:lnTo>
                      <a:lnTo>
                        <a:pt x="3382" y="1782"/>
                      </a:lnTo>
                      <a:lnTo>
                        <a:pt x="3386" y="1782"/>
                      </a:lnTo>
                      <a:lnTo>
                        <a:pt x="3390" y="1781"/>
                      </a:lnTo>
                      <a:lnTo>
                        <a:pt x="3393" y="1782"/>
                      </a:lnTo>
                      <a:lnTo>
                        <a:pt x="3397" y="1781"/>
                      </a:lnTo>
                      <a:lnTo>
                        <a:pt x="3401" y="1782"/>
                      </a:lnTo>
                      <a:lnTo>
                        <a:pt x="3405" y="1781"/>
                      </a:lnTo>
                      <a:lnTo>
                        <a:pt x="3409" y="1781"/>
                      </a:lnTo>
                      <a:lnTo>
                        <a:pt x="3412" y="1781"/>
                      </a:lnTo>
                      <a:lnTo>
                        <a:pt x="3416" y="1781"/>
                      </a:lnTo>
                      <a:lnTo>
                        <a:pt x="3420" y="1781"/>
                      </a:lnTo>
                      <a:lnTo>
                        <a:pt x="3423" y="1781"/>
                      </a:lnTo>
                      <a:lnTo>
                        <a:pt x="3427" y="1781"/>
                      </a:lnTo>
                      <a:lnTo>
                        <a:pt x="3431" y="1780"/>
                      </a:lnTo>
                      <a:lnTo>
                        <a:pt x="3435" y="1781"/>
                      </a:lnTo>
                      <a:lnTo>
                        <a:pt x="3438" y="1781"/>
                      </a:lnTo>
                      <a:lnTo>
                        <a:pt x="3442" y="1781"/>
                      </a:lnTo>
                      <a:lnTo>
                        <a:pt x="3446" y="1780"/>
                      </a:lnTo>
                      <a:lnTo>
                        <a:pt x="3450" y="1781"/>
                      </a:lnTo>
                      <a:lnTo>
                        <a:pt x="3454" y="1780"/>
                      </a:lnTo>
                      <a:lnTo>
                        <a:pt x="3457" y="1780"/>
                      </a:lnTo>
                      <a:lnTo>
                        <a:pt x="3461" y="1781"/>
                      </a:lnTo>
                      <a:lnTo>
                        <a:pt x="3465" y="1780"/>
                      </a:lnTo>
                      <a:lnTo>
                        <a:pt x="3469" y="1781"/>
                      </a:lnTo>
                      <a:lnTo>
                        <a:pt x="3472" y="1780"/>
                      </a:lnTo>
                      <a:lnTo>
                        <a:pt x="3476" y="1780"/>
                      </a:lnTo>
                      <a:lnTo>
                        <a:pt x="3480" y="1780"/>
                      </a:lnTo>
                      <a:lnTo>
                        <a:pt x="3483" y="1780"/>
                      </a:lnTo>
                      <a:lnTo>
                        <a:pt x="3487" y="1780"/>
                      </a:lnTo>
                      <a:lnTo>
                        <a:pt x="3491" y="1780"/>
                      </a:lnTo>
                      <a:lnTo>
                        <a:pt x="3495" y="1779"/>
                      </a:lnTo>
                      <a:lnTo>
                        <a:pt x="3499" y="1780"/>
                      </a:lnTo>
                      <a:lnTo>
                        <a:pt x="3502" y="1780"/>
                      </a:lnTo>
                      <a:lnTo>
                        <a:pt x="3506" y="1779"/>
                      </a:lnTo>
                      <a:lnTo>
                        <a:pt x="3510" y="1780"/>
                      </a:lnTo>
                      <a:lnTo>
                        <a:pt x="3514" y="1780"/>
                      </a:lnTo>
                      <a:lnTo>
                        <a:pt x="3517" y="1779"/>
                      </a:lnTo>
                      <a:lnTo>
                        <a:pt x="3521" y="1779"/>
                      </a:lnTo>
                      <a:lnTo>
                        <a:pt x="3525" y="1779"/>
                      </a:lnTo>
                      <a:lnTo>
                        <a:pt x="3529" y="1778"/>
                      </a:lnTo>
                      <a:lnTo>
                        <a:pt x="3533" y="1778"/>
                      </a:lnTo>
                      <a:lnTo>
                        <a:pt x="3536" y="1778"/>
                      </a:lnTo>
                      <a:lnTo>
                        <a:pt x="3540" y="1779"/>
                      </a:lnTo>
                      <a:lnTo>
                        <a:pt x="3544" y="1778"/>
                      </a:lnTo>
                      <a:lnTo>
                        <a:pt x="3547" y="1778"/>
                      </a:lnTo>
                      <a:lnTo>
                        <a:pt x="3551" y="1779"/>
                      </a:lnTo>
                      <a:lnTo>
                        <a:pt x="3555" y="1778"/>
                      </a:lnTo>
                      <a:lnTo>
                        <a:pt x="3559" y="1777"/>
                      </a:lnTo>
                      <a:lnTo>
                        <a:pt x="3562" y="1777"/>
                      </a:lnTo>
                      <a:lnTo>
                        <a:pt x="3566" y="1777"/>
                      </a:lnTo>
                      <a:lnTo>
                        <a:pt x="3570" y="1777"/>
                      </a:lnTo>
                      <a:lnTo>
                        <a:pt x="3574" y="1778"/>
                      </a:lnTo>
                      <a:lnTo>
                        <a:pt x="3578" y="1777"/>
                      </a:lnTo>
                      <a:lnTo>
                        <a:pt x="3581" y="1778"/>
                      </a:lnTo>
                      <a:lnTo>
                        <a:pt x="3585" y="1777"/>
                      </a:lnTo>
                      <a:lnTo>
                        <a:pt x="3589" y="1777"/>
                      </a:lnTo>
                      <a:lnTo>
                        <a:pt x="3593" y="1777"/>
                      </a:lnTo>
                      <a:lnTo>
                        <a:pt x="3596" y="1776"/>
                      </a:lnTo>
                      <a:lnTo>
                        <a:pt x="3600" y="1776"/>
                      </a:lnTo>
                      <a:lnTo>
                        <a:pt x="3604" y="1776"/>
                      </a:lnTo>
                      <a:lnTo>
                        <a:pt x="3607" y="1776"/>
                      </a:lnTo>
                      <a:lnTo>
                        <a:pt x="3611" y="1777"/>
                      </a:lnTo>
                      <a:lnTo>
                        <a:pt x="3615" y="1777"/>
                      </a:lnTo>
                      <a:lnTo>
                        <a:pt x="3619" y="1776"/>
                      </a:lnTo>
                      <a:lnTo>
                        <a:pt x="3623" y="1776"/>
                      </a:lnTo>
                      <a:lnTo>
                        <a:pt x="3626" y="1776"/>
                      </a:lnTo>
                      <a:lnTo>
                        <a:pt x="3630" y="1775"/>
                      </a:lnTo>
                      <a:lnTo>
                        <a:pt x="3634" y="1775"/>
                      </a:lnTo>
                      <a:lnTo>
                        <a:pt x="3638" y="1776"/>
                      </a:lnTo>
                      <a:lnTo>
                        <a:pt x="3641" y="1774"/>
                      </a:lnTo>
                      <a:lnTo>
                        <a:pt x="3645" y="1775"/>
                      </a:lnTo>
                      <a:lnTo>
                        <a:pt x="3649" y="1774"/>
                      </a:lnTo>
                      <a:lnTo>
                        <a:pt x="3653" y="1775"/>
                      </a:lnTo>
                      <a:lnTo>
                        <a:pt x="3656" y="1774"/>
                      </a:lnTo>
                      <a:lnTo>
                        <a:pt x="3660" y="1774"/>
                      </a:lnTo>
                      <a:lnTo>
                        <a:pt x="3664" y="1774"/>
                      </a:lnTo>
                      <a:lnTo>
                        <a:pt x="3668" y="1773"/>
                      </a:lnTo>
                      <a:lnTo>
                        <a:pt x="3671" y="1773"/>
                      </a:lnTo>
                      <a:lnTo>
                        <a:pt x="3675" y="1773"/>
                      </a:lnTo>
                      <a:lnTo>
                        <a:pt x="3679" y="1773"/>
                      </a:lnTo>
                      <a:lnTo>
                        <a:pt x="3683" y="1771"/>
                      </a:lnTo>
                      <a:lnTo>
                        <a:pt x="3686" y="1771"/>
                      </a:lnTo>
                      <a:lnTo>
                        <a:pt x="3690" y="1772"/>
                      </a:lnTo>
                      <a:lnTo>
                        <a:pt x="3694" y="1771"/>
                      </a:lnTo>
                      <a:lnTo>
                        <a:pt x="3698" y="1770"/>
                      </a:lnTo>
                      <a:lnTo>
                        <a:pt x="3702" y="1769"/>
                      </a:lnTo>
                      <a:lnTo>
                        <a:pt x="3705" y="1769"/>
                      </a:lnTo>
                      <a:lnTo>
                        <a:pt x="3709" y="1768"/>
                      </a:lnTo>
                      <a:lnTo>
                        <a:pt x="3713" y="1767"/>
                      </a:lnTo>
                      <a:lnTo>
                        <a:pt x="3717" y="1766"/>
                      </a:lnTo>
                      <a:lnTo>
                        <a:pt x="3720" y="1765"/>
                      </a:lnTo>
                      <a:lnTo>
                        <a:pt x="3724" y="1765"/>
                      </a:lnTo>
                      <a:lnTo>
                        <a:pt x="3728" y="1763"/>
                      </a:lnTo>
                      <a:lnTo>
                        <a:pt x="3731" y="1762"/>
                      </a:lnTo>
                      <a:lnTo>
                        <a:pt x="3735" y="1761"/>
                      </a:lnTo>
                      <a:lnTo>
                        <a:pt x="3739" y="1760"/>
                      </a:lnTo>
                      <a:lnTo>
                        <a:pt x="3743" y="1757"/>
                      </a:lnTo>
                      <a:lnTo>
                        <a:pt x="3747" y="1756"/>
                      </a:lnTo>
                      <a:lnTo>
                        <a:pt x="3750" y="1753"/>
                      </a:lnTo>
                      <a:lnTo>
                        <a:pt x="3754" y="1751"/>
                      </a:lnTo>
                      <a:lnTo>
                        <a:pt x="3758" y="1749"/>
                      </a:lnTo>
                      <a:lnTo>
                        <a:pt x="3762" y="1745"/>
                      </a:lnTo>
                      <a:lnTo>
                        <a:pt x="3765" y="1741"/>
                      </a:lnTo>
                      <a:lnTo>
                        <a:pt x="3769" y="1737"/>
                      </a:lnTo>
                      <a:lnTo>
                        <a:pt x="3773" y="1732"/>
                      </a:lnTo>
                      <a:lnTo>
                        <a:pt x="3777" y="1726"/>
                      </a:lnTo>
                      <a:lnTo>
                        <a:pt x="3780" y="1720"/>
                      </a:lnTo>
                      <a:lnTo>
                        <a:pt x="3784" y="1713"/>
                      </a:lnTo>
                      <a:lnTo>
                        <a:pt x="3788" y="1705"/>
                      </a:lnTo>
                      <a:lnTo>
                        <a:pt x="3792" y="1696"/>
                      </a:lnTo>
                      <a:lnTo>
                        <a:pt x="3795" y="1687"/>
                      </a:lnTo>
                      <a:lnTo>
                        <a:pt x="3799" y="1677"/>
                      </a:lnTo>
                      <a:lnTo>
                        <a:pt x="3803" y="1666"/>
                      </a:lnTo>
                      <a:lnTo>
                        <a:pt x="3807" y="1655"/>
                      </a:lnTo>
                      <a:lnTo>
                        <a:pt x="3810" y="1644"/>
                      </a:lnTo>
                      <a:lnTo>
                        <a:pt x="3814" y="1632"/>
                      </a:lnTo>
                      <a:lnTo>
                        <a:pt x="3818" y="1622"/>
                      </a:lnTo>
                      <a:lnTo>
                        <a:pt x="3822" y="1611"/>
                      </a:lnTo>
                      <a:lnTo>
                        <a:pt x="3826" y="1601"/>
                      </a:lnTo>
                      <a:lnTo>
                        <a:pt x="3829" y="1592"/>
                      </a:lnTo>
                      <a:lnTo>
                        <a:pt x="3833" y="1584"/>
                      </a:lnTo>
                      <a:lnTo>
                        <a:pt x="3837" y="1575"/>
                      </a:lnTo>
                      <a:lnTo>
                        <a:pt x="3841" y="1569"/>
                      </a:lnTo>
                      <a:lnTo>
                        <a:pt x="3844" y="1563"/>
                      </a:lnTo>
                      <a:lnTo>
                        <a:pt x="3848" y="1561"/>
                      </a:lnTo>
                      <a:lnTo>
                        <a:pt x="3852" y="1557"/>
                      </a:lnTo>
                      <a:lnTo>
                        <a:pt x="3856" y="1558"/>
                      </a:lnTo>
                      <a:lnTo>
                        <a:pt x="3859" y="1559"/>
                      </a:lnTo>
                      <a:lnTo>
                        <a:pt x="3863" y="1560"/>
                      </a:lnTo>
                      <a:lnTo>
                        <a:pt x="3867" y="1565"/>
                      </a:lnTo>
                      <a:lnTo>
                        <a:pt x="3871" y="1570"/>
                      </a:lnTo>
                      <a:lnTo>
                        <a:pt x="3874" y="1575"/>
                      </a:lnTo>
                      <a:lnTo>
                        <a:pt x="3878" y="1582"/>
                      </a:lnTo>
                      <a:lnTo>
                        <a:pt x="3882" y="1588"/>
                      </a:lnTo>
                      <a:lnTo>
                        <a:pt x="3886" y="1595"/>
                      </a:lnTo>
                      <a:lnTo>
                        <a:pt x="3889" y="1603"/>
                      </a:lnTo>
                      <a:lnTo>
                        <a:pt x="3893" y="1612"/>
                      </a:lnTo>
                      <a:lnTo>
                        <a:pt x="3897" y="1621"/>
                      </a:lnTo>
                      <a:lnTo>
                        <a:pt x="3901" y="1628"/>
                      </a:lnTo>
                      <a:lnTo>
                        <a:pt x="3904" y="1637"/>
                      </a:lnTo>
                      <a:lnTo>
                        <a:pt x="3908" y="1645"/>
                      </a:lnTo>
                      <a:lnTo>
                        <a:pt x="3912" y="1654"/>
                      </a:lnTo>
                      <a:lnTo>
                        <a:pt x="3916" y="1662"/>
                      </a:lnTo>
                      <a:lnTo>
                        <a:pt x="3920" y="1669"/>
                      </a:lnTo>
                      <a:lnTo>
                        <a:pt x="3923" y="1676"/>
                      </a:lnTo>
                      <a:lnTo>
                        <a:pt x="3927" y="1683"/>
                      </a:lnTo>
                      <a:lnTo>
                        <a:pt x="3931" y="1689"/>
                      </a:lnTo>
                      <a:lnTo>
                        <a:pt x="3934" y="1697"/>
                      </a:lnTo>
                      <a:lnTo>
                        <a:pt x="3938" y="1702"/>
                      </a:lnTo>
                      <a:lnTo>
                        <a:pt x="3942" y="1708"/>
                      </a:lnTo>
                      <a:lnTo>
                        <a:pt x="3946" y="1714"/>
                      </a:lnTo>
                      <a:lnTo>
                        <a:pt x="3950" y="1719"/>
                      </a:lnTo>
                      <a:lnTo>
                        <a:pt x="3953" y="1724"/>
                      </a:lnTo>
                      <a:lnTo>
                        <a:pt x="3957" y="1728"/>
                      </a:lnTo>
                      <a:lnTo>
                        <a:pt x="3961" y="1733"/>
                      </a:lnTo>
                      <a:lnTo>
                        <a:pt x="3965" y="1737"/>
                      </a:lnTo>
                      <a:lnTo>
                        <a:pt x="3968" y="1741"/>
                      </a:lnTo>
                      <a:lnTo>
                        <a:pt x="3972" y="1744"/>
                      </a:lnTo>
                      <a:lnTo>
                        <a:pt x="3976" y="1748"/>
                      </a:lnTo>
                      <a:lnTo>
                        <a:pt x="3980" y="1751"/>
                      </a:lnTo>
                      <a:lnTo>
                        <a:pt x="3983" y="1754"/>
                      </a:lnTo>
                      <a:lnTo>
                        <a:pt x="3987" y="1756"/>
                      </a:lnTo>
                      <a:lnTo>
                        <a:pt x="3991" y="1759"/>
                      </a:lnTo>
                      <a:lnTo>
                        <a:pt x="3995" y="1762"/>
                      </a:lnTo>
                      <a:lnTo>
                        <a:pt x="3998" y="1764"/>
                      </a:lnTo>
                      <a:lnTo>
                        <a:pt x="4002" y="1766"/>
                      </a:lnTo>
                      <a:lnTo>
                        <a:pt x="4006" y="1767"/>
                      </a:lnTo>
                      <a:lnTo>
                        <a:pt x="4010" y="1769"/>
                      </a:lnTo>
                      <a:lnTo>
                        <a:pt x="4013" y="1771"/>
                      </a:lnTo>
                      <a:lnTo>
                        <a:pt x="4017" y="1772"/>
                      </a:lnTo>
                      <a:lnTo>
                        <a:pt x="4021" y="1774"/>
                      </a:lnTo>
                      <a:lnTo>
                        <a:pt x="4025" y="1775"/>
                      </a:lnTo>
                      <a:lnTo>
                        <a:pt x="4028" y="1776"/>
                      </a:lnTo>
                      <a:lnTo>
                        <a:pt x="4032" y="1777"/>
                      </a:lnTo>
                      <a:lnTo>
                        <a:pt x="4036" y="1777"/>
                      </a:lnTo>
                      <a:lnTo>
                        <a:pt x="4040" y="1778"/>
                      </a:lnTo>
                      <a:lnTo>
                        <a:pt x="4044" y="1779"/>
                      </a:lnTo>
                      <a:lnTo>
                        <a:pt x="4047" y="1780"/>
                      </a:lnTo>
                      <a:lnTo>
                        <a:pt x="4051" y="1780"/>
                      </a:lnTo>
                      <a:lnTo>
                        <a:pt x="4055" y="1781"/>
                      </a:lnTo>
                      <a:lnTo>
                        <a:pt x="4058" y="1782"/>
                      </a:lnTo>
                      <a:lnTo>
                        <a:pt x="4062" y="1782"/>
                      </a:lnTo>
                      <a:lnTo>
                        <a:pt x="4066" y="1782"/>
                      </a:lnTo>
                      <a:lnTo>
                        <a:pt x="4070" y="1783"/>
                      </a:lnTo>
                      <a:lnTo>
                        <a:pt x="4074" y="1784"/>
                      </a:lnTo>
                      <a:lnTo>
                        <a:pt x="4077" y="1783"/>
                      </a:lnTo>
                      <a:lnTo>
                        <a:pt x="4081" y="1783"/>
                      </a:lnTo>
                      <a:lnTo>
                        <a:pt x="4085" y="1784"/>
                      </a:lnTo>
                      <a:lnTo>
                        <a:pt x="4089" y="1784"/>
                      </a:lnTo>
                      <a:lnTo>
                        <a:pt x="4092" y="1785"/>
                      </a:lnTo>
                      <a:lnTo>
                        <a:pt x="4096" y="1786"/>
                      </a:lnTo>
                      <a:lnTo>
                        <a:pt x="4100" y="1785"/>
                      </a:lnTo>
                      <a:lnTo>
                        <a:pt x="4104" y="1786"/>
                      </a:lnTo>
                      <a:lnTo>
                        <a:pt x="4107" y="1786"/>
                      </a:lnTo>
                      <a:lnTo>
                        <a:pt x="4111" y="1786"/>
                      </a:lnTo>
                      <a:lnTo>
                        <a:pt x="4115" y="1787"/>
                      </a:lnTo>
                      <a:lnTo>
                        <a:pt x="4119" y="1787"/>
                      </a:lnTo>
                      <a:lnTo>
                        <a:pt x="4122" y="1786"/>
                      </a:lnTo>
                      <a:lnTo>
                        <a:pt x="4126" y="1786"/>
                      </a:lnTo>
                      <a:lnTo>
                        <a:pt x="4130" y="1787"/>
                      </a:lnTo>
                      <a:lnTo>
                        <a:pt x="4134" y="1787"/>
                      </a:lnTo>
                      <a:lnTo>
                        <a:pt x="4137" y="1787"/>
                      </a:lnTo>
                      <a:lnTo>
                        <a:pt x="4141" y="1787"/>
                      </a:lnTo>
                      <a:lnTo>
                        <a:pt x="4145" y="1788"/>
                      </a:lnTo>
                      <a:lnTo>
                        <a:pt x="4149" y="1788"/>
                      </a:lnTo>
                      <a:lnTo>
                        <a:pt x="4152" y="1787"/>
                      </a:lnTo>
                      <a:lnTo>
                        <a:pt x="4156" y="1787"/>
                      </a:lnTo>
                      <a:lnTo>
                        <a:pt x="4160" y="1788"/>
                      </a:lnTo>
                      <a:lnTo>
                        <a:pt x="4164" y="1789"/>
                      </a:lnTo>
                      <a:lnTo>
                        <a:pt x="4168" y="1789"/>
                      </a:lnTo>
                      <a:lnTo>
                        <a:pt x="4171" y="1789"/>
                      </a:lnTo>
                      <a:lnTo>
                        <a:pt x="4175" y="1789"/>
                      </a:lnTo>
                      <a:lnTo>
                        <a:pt x="4179" y="1789"/>
                      </a:lnTo>
                      <a:lnTo>
                        <a:pt x="4182" y="1788"/>
                      </a:lnTo>
                      <a:lnTo>
                        <a:pt x="4186" y="1789"/>
                      </a:lnTo>
                      <a:lnTo>
                        <a:pt x="4190" y="1790"/>
                      </a:lnTo>
                      <a:lnTo>
                        <a:pt x="4194" y="1789"/>
                      </a:lnTo>
                      <a:lnTo>
                        <a:pt x="4197" y="1789"/>
                      </a:lnTo>
                      <a:lnTo>
                        <a:pt x="4201" y="1789"/>
                      </a:lnTo>
                      <a:lnTo>
                        <a:pt x="4205" y="1790"/>
                      </a:lnTo>
                      <a:lnTo>
                        <a:pt x="4209" y="1789"/>
                      </a:lnTo>
                      <a:lnTo>
                        <a:pt x="4213" y="1789"/>
                      </a:lnTo>
                      <a:lnTo>
                        <a:pt x="4216" y="1790"/>
                      </a:lnTo>
                      <a:lnTo>
                        <a:pt x="4220" y="1790"/>
                      </a:lnTo>
                      <a:lnTo>
                        <a:pt x="4224" y="1789"/>
                      </a:lnTo>
                      <a:lnTo>
                        <a:pt x="4228" y="1789"/>
                      </a:lnTo>
                      <a:lnTo>
                        <a:pt x="4231" y="1789"/>
                      </a:lnTo>
                      <a:lnTo>
                        <a:pt x="4235" y="1790"/>
                      </a:lnTo>
                      <a:lnTo>
                        <a:pt x="4239" y="1790"/>
                      </a:lnTo>
                      <a:lnTo>
                        <a:pt x="4243" y="1791"/>
                      </a:lnTo>
                      <a:lnTo>
                        <a:pt x="4246" y="1790"/>
                      </a:lnTo>
                      <a:lnTo>
                        <a:pt x="4250" y="1789"/>
                      </a:lnTo>
                      <a:lnTo>
                        <a:pt x="4254" y="1790"/>
                      </a:lnTo>
                      <a:lnTo>
                        <a:pt x="4258" y="1790"/>
                      </a:lnTo>
                      <a:lnTo>
                        <a:pt x="4261" y="1790"/>
                      </a:lnTo>
                      <a:lnTo>
                        <a:pt x="4265" y="1790"/>
                      </a:lnTo>
                      <a:lnTo>
                        <a:pt x="4269" y="1790"/>
                      </a:lnTo>
                      <a:lnTo>
                        <a:pt x="4273" y="1790"/>
                      </a:lnTo>
                      <a:lnTo>
                        <a:pt x="4276" y="1791"/>
                      </a:lnTo>
                      <a:lnTo>
                        <a:pt x="4280" y="1790"/>
                      </a:lnTo>
                      <a:lnTo>
                        <a:pt x="4284" y="1790"/>
                      </a:lnTo>
                      <a:lnTo>
                        <a:pt x="4288" y="1790"/>
                      </a:lnTo>
                      <a:lnTo>
                        <a:pt x="4292" y="1791"/>
                      </a:lnTo>
                      <a:lnTo>
                        <a:pt x="4295" y="1791"/>
                      </a:lnTo>
                      <a:lnTo>
                        <a:pt x="4299" y="1790"/>
                      </a:lnTo>
                      <a:lnTo>
                        <a:pt x="4303" y="1790"/>
                      </a:lnTo>
                      <a:lnTo>
                        <a:pt x="4307" y="1791"/>
                      </a:lnTo>
                      <a:lnTo>
                        <a:pt x="4310" y="1791"/>
                      </a:lnTo>
                      <a:lnTo>
                        <a:pt x="4314" y="1791"/>
                      </a:lnTo>
                      <a:lnTo>
                        <a:pt x="4318" y="1790"/>
                      </a:lnTo>
                      <a:lnTo>
                        <a:pt x="4321" y="1789"/>
                      </a:lnTo>
                      <a:lnTo>
                        <a:pt x="4325" y="1790"/>
                      </a:lnTo>
                      <a:lnTo>
                        <a:pt x="4329" y="1791"/>
                      </a:lnTo>
                      <a:lnTo>
                        <a:pt x="4333" y="1790"/>
                      </a:lnTo>
                      <a:lnTo>
                        <a:pt x="4337" y="1791"/>
                      </a:lnTo>
                      <a:lnTo>
                        <a:pt x="4340" y="1790"/>
                      </a:lnTo>
                      <a:lnTo>
                        <a:pt x="4344" y="1790"/>
                      </a:lnTo>
                      <a:lnTo>
                        <a:pt x="4348" y="1790"/>
                      </a:lnTo>
                      <a:lnTo>
                        <a:pt x="4352" y="1791"/>
                      </a:lnTo>
                      <a:lnTo>
                        <a:pt x="4355" y="1791"/>
                      </a:lnTo>
                      <a:lnTo>
                        <a:pt x="4359" y="1791"/>
                      </a:lnTo>
                      <a:lnTo>
                        <a:pt x="4363" y="1791"/>
                      </a:lnTo>
                      <a:lnTo>
                        <a:pt x="4367" y="1791"/>
                      </a:lnTo>
                      <a:lnTo>
                        <a:pt x="4370" y="1791"/>
                      </a:lnTo>
                      <a:lnTo>
                        <a:pt x="4374" y="1790"/>
                      </a:lnTo>
                      <a:lnTo>
                        <a:pt x="4378" y="1790"/>
                      </a:lnTo>
                      <a:lnTo>
                        <a:pt x="4382" y="1791"/>
                      </a:lnTo>
                      <a:lnTo>
                        <a:pt x="4385" y="1791"/>
                      </a:lnTo>
                      <a:lnTo>
                        <a:pt x="4389" y="1791"/>
                      </a:lnTo>
                      <a:lnTo>
                        <a:pt x="4393" y="1792"/>
                      </a:lnTo>
                      <a:lnTo>
                        <a:pt x="4397" y="1791"/>
                      </a:lnTo>
                      <a:lnTo>
                        <a:pt x="4400" y="1791"/>
                      </a:lnTo>
                      <a:lnTo>
                        <a:pt x="4404" y="1791"/>
                      </a:lnTo>
                      <a:lnTo>
                        <a:pt x="4408" y="1791"/>
                      </a:lnTo>
                      <a:lnTo>
                        <a:pt x="4412" y="1792"/>
                      </a:lnTo>
                      <a:lnTo>
                        <a:pt x="4416" y="1791"/>
                      </a:lnTo>
                      <a:lnTo>
                        <a:pt x="4419" y="1791"/>
                      </a:lnTo>
                      <a:lnTo>
                        <a:pt x="4423" y="1791"/>
                      </a:lnTo>
                      <a:lnTo>
                        <a:pt x="4427" y="1791"/>
                      </a:lnTo>
                      <a:lnTo>
                        <a:pt x="4431" y="1791"/>
                      </a:lnTo>
                      <a:lnTo>
                        <a:pt x="4434" y="1791"/>
                      </a:lnTo>
                      <a:lnTo>
                        <a:pt x="4438" y="1792"/>
                      </a:lnTo>
                      <a:lnTo>
                        <a:pt x="4442" y="1792"/>
                      </a:lnTo>
                      <a:lnTo>
                        <a:pt x="4445" y="1792"/>
                      </a:lnTo>
                      <a:lnTo>
                        <a:pt x="4449" y="1791"/>
                      </a:lnTo>
                      <a:lnTo>
                        <a:pt x="4453" y="1792"/>
                      </a:lnTo>
                      <a:lnTo>
                        <a:pt x="4457" y="1792"/>
                      </a:lnTo>
                      <a:lnTo>
                        <a:pt x="4461" y="1792"/>
                      </a:lnTo>
                      <a:lnTo>
                        <a:pt x="4464" y="1792"/>
                      </a:lnTo>
                      <a:lnTo>
                        <a:pt x="4468" y="1791"/>
                      </a:lnTo>
                      <a:lnTo>
                        <a:pt x="4472" y="1791"/>
                      </a:lnTo>
                      <a:lnTo>
                        <a:pt x="4476" y="1793"/>
                      </a:lnTo>
                      <a:lnTo>
                        <a:pt x="4479" y="1792"/>
                      </a:lnTo>
                      <a:lnTo>
                        <a:pt x="4483" y="1792"/>
                      </a:lnTo>
                      <a:lnTo>
                        <a:pt x="4487" y="1791"/>
                      </a:lnTo>
                      <a:lnTo>
                        <a:pt x="4491" y="1792"/>
                      </a:lnTo>
                      <a:lnTo>
                        <a:pt x="4494" y="1792"/>
                      </a:lnTo>
                      <a:lnTo>
                        <a:pt x="4498" y="1792"/>
                      </a:lnTo>
                      <a:lnTo>
                        <a:pt x="4502" y="1792"/>
                      </a:lnTo>
                      <a:lnTo>
                        <a:pt x="4506" y="1792"/>
                      </a:lnTo>
                      <a:lnTo>
                        <a:pt x="4509" y="1792"/>
                      </a:lnTo>
                      <a:lnTo>
                        <a:pt x="4513" y="1792"/>
                      </a:lnTo>
                      <a:lnTo>
                        <a:pt x="4517" y="1791"/>
                      </a:lnTo>
                      <a:lnTo>
                        <a:pt x="4521" y="1791"/>
                      </a:lnTo>
                      <a:lnTo>
                        <a:pt x="4524" y="1792"/>
                      </a:lnTo>
                      <a:lnTo>
                        <a:pt x="4528" y="1792"/>
                      </a:lnTo>
                      <a:lnTo>
                        <a:pt x="4532" y="1792"/>
                      </a:lnTo>
                      <a:lnTo>
                        <a:pt x="4536" y="1792"/>
                      </a:lnTo>
                      <a:lnTo>
                        <a:pt x="4540" y="1792"/>
                      </a:lnTo>
                      <a:lnTo>
                        <a:pt x="4543" y="1792"/>
                      </a:lnTo>
                      <a:lnTo>
                        <a:pt x="4547" y="1793"/>
                      </a:lnTo>
                      <a:lnTo>
                        <a:pt x="4551" y="1792"/>
                      </a:lnTo>
                      <a:lnTo>
                        <a:pt x="4555" y="1792"/>
                      </a:lnTo>
                      <a:lnTo>
                        <a:pt x="4558" y="1792"/>
                      </a:lnTo>
                      <a:lnTo>
                        <a:pt x="4562" y="1792"/>
                      </a:lnTo>
                      <a:lnTo>
                        <a:pt x="4566" y="1792"/>
                      </a:lnTo>
                      <a:lnTo>
                        <a:pt x="4569" y="1792"/>
                      </a:lnTo>
                      <a:lnTo>
                        <a:pt x="4573" y="1792"/>
                      </a:lnTo>
                      <a:lnTo>
                        <a:pt x="4577" y="1792"/>
                      </a:lnTo>
                      <a:lnTo>
                        <a:pt x="4581" y="1793"/>
                      </a:lnTo>
                      <a:lnTo>
                        <a:pt x="4585" y="1792"/>
                      </a:lnTo>
                      <a:lnTo>
                        <a:pt x="4588" y="1793"/>
                      </a:lnTo>
                      <a:lnTo>
                        <a:pt x="4592" y="1792"/>
                      </a:lnTo>
                      <a:lnTo>
                        <a:pt x="4596" y="1792"/>
                      </a:lnTo>
                      <a:lnTo>
                        <a:pt x="4600" y="1792"/>
                      </a:lnTo>
                      <a:lnTo>
                        <a:pt x="4603" y="1792"/>
                      </a:lnTo>
                      <a:lnTo>
                        <a:pt x="4607" y="1792"/>
                      </a:lnTo>
                      <a:lnTo>
                        <a:pt x="4611" y="1792"/>
                      </a:lnTo>
                      <a:lnTo>
                        <a:pt x="4615" y="1792"/>
                      </a:lnTo>
                      <a:lnTo>
                        <a:pt x="4618" y="1792"/>
                      </a:lnTo>
                      <a:lnTo>
                        <a:pt x="4622" y="1792"/>
                      </a:lnTo>
                      <a:lnTo>
                        <a:pt x="4626" y="1792"/>
                      </a:lnTo>
                      <a:lnTo>
                        <a:pt x="4630" y="1793"/>
                      </a:lnTo>
                      <a:lnTo>
                        <a:pt x="4633" y="1792"/>
                      </a:lnTo>
                      <a:lnTo>
                        <a:pt x="4637" y="1792"/>
                      </a:lnTo>
                      <a:lnTo>
                        <a:pt x="4641" y="1792"/>
                      </a:lnTo>
                      <a:lnTo>
                        <a:pt x="4645" y="1792"/>
                      </a:lnTo>
                      <a:lnTo>
                        <a:pt x="4648" y="1792"/>
                      </a:lnTo>
                      <a:lnTo>
                        <a:pt x="4652" y="1793"/>
                      </a:lnTo>
                      <a:lnTo>
                        <a:pt x="4656" y="1792"/>
                      </a:lnTo>
                      <a:lnTo>
                        <a:pt x="4660" y="1792"/>
                      </a:lnTo>
                      <a:lnTo>
                        <a:pt x="4664" y="1792"/>
                      </a:lnTo>
                      <a:lnTo>
                        <a:pt x="4667" y="1793"/>
                      </a:lnTo>
                      <a:lnTo>
                        <a:pt x="4671" y="1792"/>
                      </a:lnTo>
                      <a:lnTo>
                        <a:pt x="4675" y="1791"/>
                      </a:lnTo>
                      <a:lnTo>
                        <a:pt x="4679" y="1793"/>
                      </a:lnTo>
                      <a:lnTo>
                        <a:pt x="4682" y="1791"/>
                      </a:lnTo>
                      <a:lnTo>
                        <a:pt x="4686" y="1793"/>
                      </a:lnTo>
                      <a:lnTo>
                        <a:pt x="4690" y="1793"/>
                      </a:lnTo>
                      <a:lnTo>
                        <a:pt x="4694" y="1793"/>
                      </a:lnTo>
                      <a:lnTo>
                        <a:pt x="4697" y="1792"/>
                      </a:lnTo>
                      <a:lnTo>
                        <a:pt x="4701" y="1792"/>
                      </a:lnTo>
                      <a:lnTo>
                        <a:pt x="4705" y="1793"/>
                      </a:lnTo>
                      <a:lnTo>
                        <a:pt x="4709" y="1792"/>
                      </a:lnTo>
                      <a:lnTo>
                        <a:pt x="4712" y="1792"/>
                      </a:lnTo>
                      <a:lnTo>
                        <a:pt x="4716" y="1792"/>
                      </a:lnTo>
                      <a:lnTo>
                        <a:pt x="4720" y="1792"/>
                      </a:lnTo>
                      <a:lnTo>
                        <a:pt x="4724" y="1792"/>
                      </a:lnTo>
                      <a:lnTo>
                        <a:pt x="4727" y="1792"/>
                      </a:lnTo>
                      <a:lnTo>
                        <a:pt x="4731" y="1793"/>
                      </a:lnTo>
                      <a:lnTo>
                        <a:pt x="4735" y="1792"/>
                      </a:lnTo>
                      <a:lnTo>
                        <a:pt x="4739" y="1793"/>
                      </a:lnTo>
                      <a:lnTo>
                        <a:pt x="4742" y="1793"/>
                      </a:lnTo>
                      <a:lnTo>
                        <a:pt x="4746" y="1793"/>
                      </a:lnTo>
                      <a:lnTo>
                        <a:pt x="4750" y="1792"/>
                      </a:lnTo>
                      <a:lnTo>
                        <a:pt x="4754" y="1792"/>
                      </a:lnTo>
                      <a:lnTo>
                        <a:pt x="4758" y="1792"/>
                      </a:lnTo>
                      <a:lnTo>
                        <a:pt x="4761" y="1792"/>
                      </a:lnTo>
                      <a:lnTo>
                        <a:pt x="4765" y="1793"/>
                      </a:lnTo>
                      <a:lnTo>
                        <a:pt x="4769" y="1793"/>
                      </a:lnTo>
                      <a:lnTo>
                        <a:pt x="4772" y="1792"/>
                      </a:lnTo>
                      <a:lnTo>
                        <a:pt x="4776" y="1793"/>
                      </a:lnTo>
                      <a:lnTo>
                        <a:pt x="4780" y="1792"/>
                      </a:lnTo>
                      <a:lnTo>
                        <a:pt x="4784" y="1793"/>
                      </a:lnTo>
                      <a:lnTo>
                        <a:pt x="4787" y="1793"/>
                      </a:lnTo>
                      <a:lnTo>
                        <a:pt x="4791" y="1793"/>
                      </a:lnTo>
                      <a:lnTo>
                        <a:pt x="4795" y="1793"/>
                      </a:lnTo>
                      <a:lnTo>
                        <a:pt x="4799" y="1792"/>
                      </a:lnTo>
                      <a:lnTo>
                        <a:pt x="4803" y="1793"/>
                      </a:lnTo>
                      <a:lnTo>
                        <a:pt x="4806" y="1793"/>
                      </a:lnTo>
                      <a:lnTo>
                        <a:pt x="4810" y="1793"/>
                      </a:lnTo>
                      <a:lnTo>
                        <a:pt x="4814" y="1793"/>
                      </a:lnTo>
                      <a:lnTo>
                        <a:pt x="4818" y="1793"/>
                      </a:lnTo>
                      <a:lnTo>
                        <a:pt x="4821" y="1793"/>
                      </a:lnTo>
                      <a:lnTo>
                        <a:pt x="4825" y="1793"/>
                      </a:lnTo>
                      <a:lnTo>
                        <a:pt x="4829" y="1793"/>
                      </a:lnTo>
                      <a:lnTo>
                        <a:pt x="4833" y="1793"/>
                      </a:lnTo>
                      <a:lnTo>
                        <a:pt x="4836" y="1793"/>
                      </a:lnTo>
                      <a:lnTo>
                        <a:pt x="4840" y="1793"/>
                      </a:lnTo>
                      <a:lnTo>
                        <a:pt x="4844" y="1793"/>
                      </a:lnTo>
                      <a:lnTo>
                        <a:pt x="4848" y="1793"/>
                      </a:lnTo>
                      <a:lnTo>
                        <a:pt x="4851" y="1793"/>
                      </a:lnTo>
                      <a:lnTo>
                        <a:pt x="4855" y="1793"/>
                      </a:lnTo>
                      <a:lnTo>
                        <a:pt x="4859" y="1793"/>
                      </a:lnTo>
                      <a:lnTo>
                        <a:pt x="4863" y="1793"/>
                      </a:lnTo>
                      <a:lnTo>
                        <a:pt x="4866" y="1793"/>
                      </a:lnTo>
                      <a:lnTo>
                        <a:pt x="4870" y="1793"/>
                      </a:lnTo>
                      <a:lnTo>
                        <a:pt x="4874" y="1793"/>
                      </a:lnTo>
                      <a:lnTo>
                        <a:pt x="4878" y="1792"/>
                      </a:lnTo>
                      <a:lnTo>
                        <a:pt x="4882" y="1793"/>
                      </a:lnTo>
                      <a:lnTo>
                        <a:pt x="4885" y="1793"/>
                      </a:lnTo>
                      <a:lnTo>
                        <a:pt x="4889" y="1792"/>
                      </a:lnTo>
                      <a:lnTo>
                        <a:pt x="4893" y="1793"/>
                      </a:lnTo>
                      <a:lnTo>
                        <a:pt x="4896" y="1793"/>
                      </a:lnTo>
                      <a:lnTo>
                        <a:pt x="4900" y="1793"/>
                      </a:lnTo>
                      <a:lnTo>
                        <a:pt x="4904" y="1793"/>
                      </a:lnTo>
                      <a:lnTo>
                        <a:pt x="4908" y="1792"/>
                      </a:lnTo>
                      <a:lnTo>
                        <a:pt x="4911" y="1793"/>
                      </a:lnTo>
                      <a:lnTo>
                        <a:pt x="4915" y="1793"/>
                      </a:lnTo>
                      <a:lnTo>
                        <a:pt x="4919" y="1793"/>
                      </a:lnTo>
                      <a:lnTo>
                        <a:pt x="4923" y="1793"/>
                      </a:lnTo>
                      <a:lnTo>
                        <a:pt x="4927" y="1793"/>
                      </a:lnTo>
                      <a:lnTo>
                        <a:pt x="4930" y="1793"/>
                      </a:lnTo>
                      <a:lnTo>
                        <a:pt x="4934" y="1793"/>
                      </a:lnTo>
                      <a:lnTo>
                        <a:pt x="4938" y="1793"/>
                      </a:lnTo>
                      <a:lnTo>
                        <a:pt x="4942" y="1794"/>
                      </a:lnTo>
                      <a:lnTo>
                        <a:pt x="4945" y="1793"/>
                      </a:lnTo>
                      <a:lnTo>
                        <a:pt x="4949" y="1793"/>
                      </a:lnTo>
                      <a:lnTo>
                        <a:pt x="4953" y="1793"/>
                      </a:lnTo>
                      <a:lnTo>
                        <a:pt x="4957" y="1793"/>
                      </a:lnTo>
                      <a:lnTo>
                        <a:pt x="4960" y="1793"/>
                      </a:lnTo>
                      <a:lnTo>
                        <a:pt x="4961" y="1792"/>
                      </a:lnTo>
                    </a:path>
                  </a:pathLst>
                </a:custGeom>
                <a:noFill/>
                <a:ln w="9525" cap="flat" cmpd="sng">
                  <a:solidFill>
                    <a:srgbClr val="0000FF"/>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rgbClr val="000000"/>
                    </a:solidFill>
                    <a:latin typeface="Arial"/>
                    <a:ea typeface="Arial"/>
                    <a:cs typeface="Arial"/>
                    <a:sym typeface="Arial"/>
                  </a:endParaRPr>
                </a:p>
              </p:txBody>
            </p:sp>
            <p:sp>
              <p:nvSpPr>
                <p:cNvPr id="1323" name="Google Shape;1323;p11"/>
                <p:cNvSpPr/>
                <p:nvPr/>
              </p:nvSpPr>
              <p:spPr>
                <a:xfrm>
                  <a:off x="1453" y="1412"/>
                  <a:ext cx="4961" cy="1954"/>
                </a:xfrm>
                <a:custGeom>
                  <a:avLst/>
                  <a:gdLst/>
                  <a:ahLst/>
                  <a:cxnLst/>
                  <a:rect l="l" t="t" r="r" b="b"/>
                  <a:pathLst>
                    <a:path w="4961" h="1954" extrusionOk="0">
                      <a:moveTo>
                        <a:pt x="0" y="1954"/>
                      </a:moveTo>
                      <a:lnTo>
                        <a:pt x="4" y="1954"/>
                      </a:lnTo>
                      <a:lnTo>
                        <a:pt x="8" y="1954"/>
                      </a:lnTo>
                      <a:lnTo>
                        <a:pt x="11" y="1954"/>
                      </a:lnTo>
                      <a:lnTo>
                        <a:pt x="15" y="1953"/>
                      </a:lnTo>
                      <a:lnTo>
                        <a:pt x="19" y="1953"/>
                      </a:lnTo>
                      <a:lnTo>
                        <a:pt x="23" y="1954"/>
                      </a:lnTo>
                      <a:lnTo>
                        <a:pt x="26" y="1953"/>
                      </a:lnTo>
                      <a:lnTo>
                        <a:pt x="30" y="1954"/>
                      </a:lnTo>
                      <a:lnTo>
                        <a:pt x="34" y="1954"/>
                      </a:lnTo>
                      <a:lnTo>
                        <a:pt x="38" y="1954"/>
                      </a:lnTo>
                      <a:lnTo>
                        <a:pt x="41" y="1954"/>
                      </a:lnTo>
                      <a:lnTo>
                        <a:pt x="45" y="1954"/>
                      </a:lnTo>
                      <a:lnTo>
                        <a:pt x="49" y="1954"/>
                      </a:lnTo>
                      <a:lnTo>
                        <a:pt x="53" y="1954"/>
                      </a:lnTo>
                      <a:lnTo>
                        <a:pt x="57" y="1953"/>
                      </a:lnTo>
                      <a:lnTo>
                        <a:pt x="60" y="1954"/>
                      </a:lnTo>
                      <a:lnTo>
                        <a:pt x="64" y="1954"/>
                      </a:lnTo>
                      <a:lnTo>
                        <a:pt x="68" y="1954"/>
                      </a:lnTo>
                      <a:lnTo>
                        <a:pt x="71" y="1954"/>
                      </a:lnTo>
                      <a:lnTo>
                        <a:pt x="75" y="1954"/>
                      </a:lnTo>
                      <a:lnTo>
                        <a:pt x="79" y="1954"/>
                      </a:lnTo>
                      <a:lnTo>
                        <a:pt x="83" y="1953"/>
                      </a:lnTo>
                      <a:lnTo>
                        <a:pt x="87" y="1953"/>
                      </a:lnTo>
                      <a:lnTo>
                        <a:pt x="90" y="1954"/>
                      </a:lnTo>
                      <a:lnTo>
                        <a:pt x="94" y="1954"/>
                      </a:lnTo>
                      <a:lnTo>
                        <a:pt x="98" y="1953"/>
                      </a:lnTo>
                      <a:lnTo>
                        <a:pt x="102" y="1953"/>
                      </a:lnTo>
                      <a:lnTo>
                        <a:pt x="105" y="1953"/>
                      </a:lnTo>
                      <a:lnTo>
                        <a:pt x="109" y="1954"/>
                      </a:lnTo>
                      <a:lnTo>
                        <a:pt x="113" y="1953"/>
                      </a:lnTo>
                      <a:lnTo>
                        <a:pt x="117" y="1954"/>
                      </a:lnTo>
                      <a:lnTo>
                        <a:pt x="120" y="1953"/>
                      </a:lnTo>
                      <a:lnTo>
                        <a:pt x="124" y="1954"/>
                      </a:lnTo>
                      <a:lnTo>
                        <a:pt x="128" y="1953"/>
                      </a:lnTo>
                      <a:lnTo>
                        <a:pt x="132" y="1954"/>
                      </a:lnTo>
                      <a:lnTo>
                        <a:pt x="135" y="1953"/>
                      </a:lnTo>
                      <a:lnTo>
                        <a:pt x="139" y="1953"/>
                      </a:lnTo>
                      <a:lnTo>
                        <a:pt x="143" y="1953"/>
                      </a:lnTo>
                      <a:lnTo>
                        <a:pt x="147" y="1953"/>
                      </a:lnTo>
                      <a:lnTo>
                        <a:pt x="150" y="1953"/>
                      </a:lnTo>
                      <a:lnTo>
                        <a:pt x="154" y="1953"/>
                      </a:lnTo>
                      <a:lnTo>
                        <a:pt x="158" y="1952"/>
                      </a:lnTo>
                      <a:lnTo>
                        <a:pt x="162" y="1952"/>
                      </a:lnTo>
                      <a:lnTo>
                        <a:pt x="165" y="1951"/>
                      </a:lnTo>
                      <a:lnTo>
                        <a:pt x="169" y="1950"/>
                      </a:lnTo>
                      <a:lnTo>
                        <a:pt x="173" y="1949"/>
                      </a:lnTo>
                      <a:lnTo>
                        <a:pt x="177" y="1949"/>
                      </a:lnTo>
                      <a:lnTo>
                        <a:pt x="181" y="1947"/>
                      </a:lnTo>
                      <a:lnTo>
                        <a:pt x="184" y="1945"/>
                      </a:lnTo>
                      <a:lnTo>
                        <a:pt x="188" y="1943"/>
                      </a:lnTo>
                      <a:lnTo>
                        <a:pt x="192" y="1942"/>
                      </a:lnTo>
                      <a:lnTo>
                        <a:pt x="195" y="1941"/>
                      </a:lnTo>
                      <a:lnTo>
                        <a:pt x="199" y="1940"/>
                      </a:lnTo>
                      <a:lnTo>
                        <a:pt x="203" y="1940"/>
                      </a:lnTo>
                      <a:lnTo>
                        <a:pt x="207" y="1939"/>
                      </a:lnTo>
                      <a:lnTo>
                        <a:pt x="211" y="1940"/>
                      </a:lnTo>
                      <a:lnTo>
                        <a:pt x="214" y="1940"/>
                      </a:lnTo>
                      <a:lnTo>
                        <a:pt x="218" y="1940"/>
                      </a:lnTo>
                      <a:lnTo>
                        <a:pt x="222" y="1940"/>
                      </a:lnTo>
                      <a:lnTo>
                        <a:pt x="226" y="1939"/>
                      </a:lnTo>
                      <a:lnTo>
                        <a:pt x="229" y="1938"/>
                      </a:lnTo>
                      <a:lnTo>
                        <a:pt x="233" y="1937"/>
                      </a:lnTo>
                      <a:lnTo>
                        <a:pt x="237" y="1933"/>
                      </a:lnTo>
                      <a:lnTo>
                        <a:pt x="241" y="1931"/>
                      </a:lnTo>
                      <a:lnTo>
                        <a:pt x="244" y="1929"/>
                      </a:lnTo>
                      <a:lnTo>
                        <a:pt x="248" y="1928"/>
                      </a:lnTo>
                      <a:lnTo>
                        <a:pt x="252" y="1929"/>
                      </a:lnTo>
                      <a:lnTo>
                        <a:pt x="256" y="1929"/>
                      </a:lnTo>
                      <a:lnTo>
                        <a:pt x="259" y="1931"/>
                      </a:lnTo>
                      <a:lnTo>
                        <a:pt x="263" y="1932"/>
                      </a:lnTo>
                      <a:lnTo>
                        <a:pt x="267" y="1933"/>
                      </a:lnTo>
                      <a:lnTo>
                        <a:pt x="271" y="1935"/>
                      </a:lnTo>
                      <a:lnTo>
                        <a:pt x="274" y="1936"/>
                      </a:lnTo>
                      <a:lnTo>
                        <a:pt x="278" y="1936"/>
                      </a:lnTo>
                      <a:lnTo>
                        <a:pt x="282" y="1938"/>
                      </a:lnTo>
                      <a:lnTo>
                        <a:pt x="286" y="1940"/>
                      </a:lnTo>
                      <a:lnTo>
                        <a:pt x="289" y="1941"/>
                      </a:lnTo>
                      <a:lnTo>
                        <a:pt x="293" y="1943"/>
                      </a:lnTo>
                      <a:lnTo>
                        <a:pt x="297" y="1944"/>
                      </a:lnTo>
                      <a:lnTo>
                        <a:pt x="301" y="1945"/>
                      </a:lnTo>
                      <a:lnTo>
                        <a:pt x="305" y="1946"/>
                      </a:lnTo>
                      <a:lnTo>
                        <a:pt x="308" y="1947"/>
                      </a:lnTo>
                      <a:lnTo>
                        <a:pt x="312" y="1948"/>
                      </a:lnTo>
                      <a:lnTo>
                        <a:pt x="316" y="1949"/>
                      </a:lnTo>
                      <a:lnTo>
                        <a:pt x="319" y="1949"/>
                      </a:lnTo>
                      <a:lnTo>
                        <a:pt x="323" y="1949"/>
                      </a:lnTo>
                      <a:lnTo>
                        <a:pt x="327" y="1950"/>
                      </a:lnTo>
                      <a:lnTo>
                        <a:pt x="331" y="1949"/>
                      </a:lnTo>
                      <a:lnTo>
                        <a:pt x="335" y="1949"/>
                      </a:lnTo>
                      <a:lnTo>
                        <a:pt x="338" y="1949"/>
                      </a:lnTo>
                      <a:lnTo>
                        <a:pt x="342" y="1949"/>
                      </a:lnTo>
                      <a:lnTo>
                        <a:pt x="346" y="1948"/>
                      </a:lnTo>
                      <a:lnTo>
                        <a:pt x="350" y="1948"/>
                      </a:lnTo>
                      <a:lnTo>
                        <a:pt x="353" y="1948"/>
                      </a:lnTo>
                      <a:lnTo>
                        <a:pt x="357" y="1948"/>
                      </a:lnTo>
                      <a:lnTo>
                        <a:pt x="361" y="1947"/>
                      </a:lnTo>
                      <a:lnTo>
                        <a:pt x="365" y="1948"/>
                      </a:lnTo>
                      <a:lnTo>
                        <a:pt x="368" y="1948"/>
                      </a:lnTo>
                      <a:lnTo>
                        <a:pt x="372" y="1947"/>
                      </a:lnTo>
                      <a:lnTo>
                        <a:pt x="376" y="1947"/>
                      </a:lnTo>
                      <a:lnTo>
                        <a:pt x="380" y="1946"/>
                      </a:lnTo>
                      <a:lnTo>
                        <a:pt x="384" y="1945"/>
                      </a:lnTo>
                      <a:lnTo>
                        <a:pt x="387" y="1945"/>
                      </a:lnTo>
                      <a:lnTo>
                        <a:pt x="391" y="1944"/>
                      </a:lnTo>
                      <a:lnTo>
                        <a:pt x="395" y="1944"/>
                      </a:lnTo>
                      <a:lnTo>
                        <a:pt x="398" y="1946"/>
                      </a:lnTo>
                      <a:lnTo>
                        <a:pt x="402" y="1946"/>
                      </a:lnTo>
                      <a:lnTo>
                        <a:pt x="406" y="1947"/>
                      </a:lnTo>
                      <a:lnTo>
                        <a:pt x="410" y="1948"/>
                      </a:lnTo>
                      <a:lnTo>
                        <a:pt x="413" y="1948"/>
                      </a:lnTo>
                      <a:lnTo>
                        <a:pt x="417" y="1949"/>
                      </a:lnTo>
                      <a:lnTo>
                        <a:pt x="421" y="1950"/>
                      </a:lnTo>
                      <a:lnTo>
                        <a:pt x="425" y="1949"/>
                      </a:lnTo>
                      <a:lnTo>
                        <a:pt x="429" y="1950"/>
                      </a:lnTo>
                      <a:lnTo>
                        <a:pt x="432" y="1951"/>
                      </a:lnTo>
                      <a:lnTo>
                        <a:pt x="436" y="1951"/>
                      </a:lnTo>
                      <a:lnTo>
                        <a:pt x="440" y="1951"/>
                      </a:lnTo>
                      <a:lnTo>
                        <a:pt x="444" y="1950"/>
                      </a:lnTo>
                      <a:lnTo>
                        <a:pt x="447" y="1951"/>
                      </a:lnTo>
                      <a:lnTo>
                        <a:pt x="451" y="1950"/>
                      </a:lnTo>
                      <a:lnTo>
                        <a:pt x="455" y="1950"/>
                      </a:lnTo>
                      <a:lnTo>
                        <a:pt x="459" y="1949"/>
                      </a:lnTo>
                      <a:lnTo>
                        <a:pt x="462" y="1949"/>
                      </a:lnTo>
                      <a:lnTo>
                        <a:pt x="466" y="1948"/>
                      </a:lnTo>
                      <a:lnTo>
                        <a:pt x="470" y="1947"/>
                      </a:lnTo>
                      <a:lnTo>
                        <a:pt x="474" y="1947"/>
                      </a:lnTo>
                      <a:lnTo>
                        <a:pt x="477" y="1946"/>
                      </a:lnTo>
                      <a:lnTo>
                        <a:pt x="481" y="1945"/>
                      </a:lnTo>
                      <a:lnTo>
                        <a:pt x="485" y="1945"/>
                      </a:lnTo>
                      <a:lnTo>
                        <a:pt x="489" y="1946"/>
                      </a:lnTo>
                      <a:lnTo>
                        <a:pt x="492" y="1945"/>
                      </a:lnTo>
                      <a:lnTo>
                        <a:pt x="496" y="1944"/>
                      </a:lnTo>
                      <a:lnTo>
                        <a:pt x="500" y="1945"/>
                      </a:lnTo>
                      <a:lnTo>
                        <a:pt x="504" y="1946"/>
                      </a:lnTo>
                      <a:lnTo>
                        <a:pt x="508" y="1946"/>
                      </a:lnTo>
                      <a:lnTo>
                        <a:pt x="511" y="1945"/>
                      </a:lnTo>
                      <a:lnTo>
                        <a:pt x="515" y="1946"/>
                      </a:lnTo>
                      <a:lnTo>
                        <a:pt x="519" y="1946"/>
                      </a:lnTo>
                      <a:lnTo>
                        <a:pt x="522" y="1946"/>
                      </a:lnTo>
                      <a:lnTo>
                        <a:pt x="526" y="1945"/>
                      </a:lnTo>
                      <a:lnTo>
                        <a:pt x="530" y="1946"/>
                      </a:lnTo>
                      <a:lnTo>
                        <a:pt x="534" y="1946"/>
                      </a:lnTo>
                      <a:lnTo>
                        <a:pt x="537" y="1945"/>
                      </a:lnTo>
                      <a:lnTo>
                        <a:pt x="541" y="1944"/>
                      </a:lnTo>
                      <a:lnTo>
                        <a:pt x="545" y="1943"/>
                      </a:lnTo>
                      <a:lnTo>
                        <a:pt x="549" y="1941"/>
                      </a:lnTo>
                      <a:lnTo>
                        <a:pt x="553" y="1938"/>
                      </a:lnTo>
                      <a:lnTo>
                        <a:pt x="556" y="1933"/>
                      </a:lnTo>
                      <a:lnTo>
                        <a:pt x="560" y="1927"/>
                      </a:lnTo>
                      <a:lnTo>
                        <a:pt x="564" y="1918"/>
                      </a:lnTo>
                      <a:lnTo>
                        <a:pt x="568" y="1907"/>
                      </a:lnTo>
                      <a:lnTo>
                        <a:pt x="571" y="1895"/>
                      </a:lnTo>
                      <a:lnTo>
                        <a:pt x="575" y="1882"/>
                      </a:lnTo>
                      <a:lnTo>
                        <a:pt x="579" y="1872"/>
                      </a:lnTo>
                      <a:lnTo>
                        <a:pt x="582" y="1867"/>
                      </a:lnTo>
                      <a:lnTo>
                        <a:pt x="586" y="1866"/>
                      </a:lnTo>
                      <a:lnTo>
                        <a:pt x="590" y="1872"/>
                      </a:lnTo>
                      <a:lnTo>
                        <a:pt x="594" y="1881"/>
                      </a:lnTo>
                      <a:lnTo>
                        <a:pt x="598" y="1894"/>
                      </a:lnTo>
                      <a:lnTo>
                        <a:pt x="601" y="1907"/>
                      </a:lnTo>
                      <a:lnTo>
                        <a:pt x="605" y="1918"/>
                      </a:lnTo>
                      <a:lnTo>
                        <a:pt x="609" y="1926"/>
                      </a:lnTo>
                      <a:lnTo>
                        <a:pt x="613" y="1933"/>
                      </a:lnTo>
                      <a:lnTo>
                        <a:pt x="616" y="1937"/>
                      </a:lnTo>
                      <a:lnTo>
                        <a:pt x="620" y="1940"/>
                      </a:lnTo>
                      <a:lnTo>
                        <a:pt x="624" y="1942"/>
                      </a:lnTo>
                      <a:lnTo>
                        <a:pt x="628" y="1943"/>
                      </a:lnTo>
                      <a:lnTo>
                        <a:pt x="631" y="1944"/>
                      </a:lnTo>
                      <a:lnTo>
                        <a:pt x="635" y="1944"/>
                      </a:lnTo>
                      <a:lnTo>
                        <a:pt x="639" y="1945"/>
                      </a:lnTo>
                      <a:lnTo>
                        <a:pt x="643" y="1945"/>
                      </a:lnTo>
                      <a:lnTo>
                        <a:pt x="646" y="1946"/>
                      </a:lnTo>
                      <a:lnTo>
                        <a:pt x="650" y="1945"/>
                      </a:lnTo>
                      <a:lnTo>
                        <a:pt x="654" y="1945"/>
                      </a:lnTo>
                      <a:lnTo>
                        <a:pt x="658" y="1946"/>
                      </a:lnTo>
                      <a:lnTo>
                        <a:pt x="661" y="1946"/>
                      </a:lnTo>
                      <a:lnTo>
                        <a:pt x="665" y="1945"/>
                      </a:lnTo>
                      <a:lnTo>
                        <a:pt x="669" y="1945"/>
                      </a:lnTo>
                      <a:lnTo>
                        <a:pt x="673" y="1946"/>
                      </a:lnTo>
                      <a:lnTo>
                        <a:pt x="677" y="1947"/>
                      </a:lnTo>
                      <a:lnTo>
                        <a:pt x="680" y="1946"/>
                      </a:lnTo>
                      <a:lnTo>
                        <a:pt x="684" y="1946"/>
                      </a:lnTo>
                      <a:lnTo>
                        <a:pt x="688" y="1947"/>
                      </a:lnTo>
                      <a:lnTo>
                        <a:pt x="692" y="1947"/>
                      </a:lnTo>
                      <a:lnTo>
                        <a:pt x="695" y="1947"/>
                      </a:lnTo>
                      <a:lnTo>
                        <a:pt x="699" y="1947"/>
                      </a:lnTo>
                      <a:lnTo>
                        <a:pt x="703" y="1947"/>
                      </a:lnTo>
                      <a:lnTo>
                        <a:pt x="706" y="1947"/>
                      </a:lnTo>
                      <a:lnTo>
                        <a:pt x="710" y="1947"/>
                      </a:lnTo>
                      <a:lnTo>
                        <a:pt x="714" y="1947"/>
                      </a:lnTo>
                      <a:lnTo>
                        <a:pt x="718" y="1946"/>
                      </a:lnTo>
                      <a:lnTo>
                        <a:pt x="722" y="1946"/>
                      </a:lnTo>
                      <a:lnTo>
                        <a:pt x="725" y="1946"/>
                      </a:lnTo>
                      <a:lnTo>
                        <a:pt x="729" y="1946"/>
                      </a:lnTo>
                      <a:lnTo>
                        <a:pt x="733" y="1944"/>
                      </a:lnTo>
                      <a:lnTo>
                        <a:pt x="737" y="1944"/>
                      </a:lnTo>
                      <a:lnTo>
                        <a:pt x="740" y="1944"/>
                      </a:lnTo>
                      <a:lnTo>
                        <a:pt x="744" y="1946"/>
                      </a:lnTo>
                      <a:lnTo>
                        <a:pt x="748" y="1945"/>
                      </a:lnTo>
                      <a:lnTo>
                        <a:pt x="752" y="1945"/>
                      </a:lnTo>
                      <a:lnTo>
                        <a:pt x="755" y="1947"/>
                      </a:lnTo>
                      <a:lnTo>
                        <a:pt x="759" y="1947"/>
                      </a:lnTo>
                      <a:lnTo>
                        <a:pt x="763" y="1947"/>
                      </a:lnTo>
                      <a:lnTo>
                        <a:pt x="767" y="1947"/>
                      </a:lnTo>
                      <a:lnTo>
                        <a:pt x="770" y="1947"/>
                      </a:lnTo>
                      <a:lnTo>
                        <a:pt x="774" y="1946"/>
                      </a:lnTo>
                      <a:lnTo>
                        <a:pt x="778" y="1948"/>
                      </a:lnTo>
                      <a:lnTo>
                        <a:pt x="782" y="1947"/>
                      </a:lnTo>
                      <a:lnTo>
                        <a:pt x="785" y="1947"/>
                      </a:lnTo>
                      <a:lnTo>
                        <a:pt x="789" y="1947"/>
                      </a:lnTo>
                      <a:lnTo>
                        <a:pt x="793" y="1947"/>
                      </a:lnTo>
                      <a:lnTo>
                        <a:pt x="797" y="1947"/>
                      </a:lnTo>
                      <a:lnTo>
                        <a:pt x="801" y="1947"/>
                      </a:lnTo>
                      <a:lnTo>
                        <a:pt x="804" y="1946"/>
                      </a:lnTo>
                      <a:lnTo>
                        <a:pt x="808" y="1947"/>
                      </a:lnTo>
                      <a:lnTo>
                        <a:pt x="812" y="1947"/>
                      </a:lnTo>
                      <a:lnTo>
                        <a:pt x="816" y="1946"/>
                      </a:lnTo>
                      <a:lnTo>
                        <a:pt x="819" y="1946"/>
                      </a:lnTo>
                      <a:lnTo>
                        <a:pt x="823" y="1947"/>
                      </a:lnTo>
                      <a:lnTo>
                        <a:pt x="827" y="1947"/>
                      </a:lnTo>
                      <a:lnTo>
                        <a:pt x="831" y="1946"/>
                      </a:lnTo>
                      <a:lnTo>
                        <a:pt x="834" y="1946"/>
                      </a:lnTo>
                      <a:lnTo>
                        <a:pt x="838" y="1946"/>
                      </a:lnTo>
                      <a:lnTo>
                        <a:pt x="842" y="1946"/>
                      </a:lnTo>
                      <a:lnTo>
                        <a:pt x="846" y="1945"/>
                      </a:lnTo>
                      <a:lnTo>
                        <a:pt x="849" y="1946"/>
                      </a:lnTo>
                      <a:lnTo>
                        <a:pt x="853" y="1946"/>
                      </a:lnTo>
                      <a:lnTo>
                        <a:pt x="857" y="1947"/>
                      </a:lnTo>
                      <a:lnTo>
                        <a:pt x="861" y="1947"/>
                      </a:lnTo>
                      <a:lnTo>
                        <a:pt x="864" y="1948"/>
                      </a:lnTo>
                      <a:lnTo>
                        <a:pt x="868" y="1946"/>
                      </a:lnTo>
                      <a:lnTo>
                        <a:pt x="872" y="1947"/>
                      </a:lnTo>
                      <a:lnTo>
                        <a:pt x="876" y="1947"/>
                      </a:lnTo>
                      <a:lnTo>
                        <a:pt x="879" y="1946"/>
                      </a:lnTo>
                      <a:lnTo>
                        <a:pt x="883" y="1946"/>
                      </a:lnTo>
                      <a:lnTo>
                        <a:pt x="887" y="1945"/>
                      </a:lnTo>
                      <a:lnTo>
                        <a:pt x="891" y="1945"/>
                      </a:lnTo>
                      <a:lnTo>
                        <a:pt x="895" y="1943"/>
                      </a:lnTo>
                      <a:lnTo>
                        <a:pt x="898" y="1943"/>
                      </a:lnTo>
                      <a:lnTo>
                        <a:pt x="902" y="1942"/>
                      </a:lnTo>
                      <a:lnTo>
                        <a:pt x="906" y="1941"/>
                      </a:lnTo>
                      <a:lnTo>
                        <a:pt x="909" y="1941"/>
                      </a:lnTo>
                      <a:lnTo>
                        <a:pt x="913" y="1940"/>
                      </a:lnTo>
                      <a:lnTo>
                        <a:pt x="917" y="1941"/>
                      </a:lnTo>
                      <a:lnTo>
                        <a:pt x="921" y="1941"/>
                      </a:lnTo>
                      <a:lnTo>
                        <a:pt x="925" y="1941"/>
                      </a:lnTo>
                      <a:lnTo>
                        <a:pt x="928" y="1942"/>
                      </a:lnTo>
                      <a:lnTo>
                        <a:pt x="932" y="1942"/>
                      </a:lnTo>
                      <a:lnTo>
                        <a:pt x="936" y="1943"/>
                      </a:lnTo>
                      <a:lnTo>
                        <a:pt x="940" y="1943"/>
                      </a:lnTo>
                      <a:lnTo>
                        <a:pt x="943" y="1943"/>
                      </a:lnTo>
                      <a:lnTo>
                        <a:pt x="947" y="1944"/>
                      </a:lnTo>
                      <a:lnTo>
                        <a:pt x="951" y="1944"/>
                      </a:lnTo>
                      <a:lnTo>
                        <a:pt x="955" y="1943"/>
                      </a:lnTo>
                      <a:lnTo>
                        <a:pt x="958" y="1944"/>
                      </a:lnTo>
                      <a:lnTo>
                        <a:pt x="962" y="1944"/>
                      </a:lnTo>
                      <a:lnTo>
                        <a:pt x="966" y="1944"/>
                      </a:lnTo>
                      <a:lnTo>
                        <a:pt x="970" y="1944"/>
                      </a:lnTo>
                      <a:lnTo>
                        <a:pt x="973" y="1944"/>
                      </a:lnTo>
                      <a:lnTo>
                        <a:pt x="977" y="1944"/>
                      </a:lnTo>
                      <a:lnTo>
                        <a:pt x="981" y="1944"/>
                      </a:lnTo>
                      <a:lnTo>
                        <a:pt x="985" y="1943"/>
                      </a:lnTo>
                      <a:lnTo>
                        <a:pt x="988" y="1944"/>
                      </a:lnTo>
                      <a:lnTo>
                        <a:pt x="992" y="1943"/>
                      </a:lnTo>
                      <a:lnTo>
                        <a:pt x="996" y="1943"/>
                      </a:lnTo>
                      <a:lnTo>
                        <a:pt x="1000" y="1943"/>
                      </a:lnTo>
                      <a:lnTo>
                        <a:pt x="1003" y="1943"/>
                      </a:lnTo>
                      <a:lnTo>
                        <a:pt x="1007" y="1943"/>
                      </a:lnTo>
                      <a:lnTo>
                        <a:pt x="1011" y="1943"/>
                      </a:lnTo>
                      <a:lnTo>
                        <a:pt x="1015" y="1943"/>
                      </a:lnTo>
                      <a:lnTo>
                        <a:pt x="1019" y="1943"/>
                      </a:lnTo>
                      <a:lnTo>
                        <a:pt x="1022" y="1942"/>
                      </a:lnTo>
                      <a:lnTo>
                        <a:pt x="1026" y="1943"/>
                      </a:lnTo>
                      <a:lnTo>
                        <a:pt x="1030" y="1942"/>
                      </a:lnTo>
                      <a:lnTo>
                        <a:pt x="1033" y="1943"/>
                      </a:lnTo>
                      <a:lnTo>
                        <a:pt x="1037" y="1942"/>
                      </a:lnTo>
                      <a:lnTo>
                        <a:pt x="1041" y="1943"/>
                      </a:lnTo>
                      <a:lnTo>
                        <a:pt x="1045" y="1943"/>
                      </a:lnTo>
                      <a:lnTo>
                        <a:pt x="1049" y="1942"/>
                      </a:lnTo>
                      <a:lnTo>
                        <a:pt x="1052" y="1941"/>
                      </a:lnTo>
                      <a:lnTo>
                        <a:pt x="1056" y="1941"/>
                      </a:lnTo>
                      <a:lnTo>
                        <a:pt x="1060" y="1941"/>
                      </a:lnTo>
                      <a:lnTo>
                        <a:pt x="1064" y="1940"/>
                      </a:lnTo>
                      <a:lnTo>
                        <a:pt x="1067" y="1941"/>
                      </a:lnTo>
                      <a:lnTo>
                        <a:pt x="1071" y="1940"/>
                      </a:lnTo>
                      <a:lnTo>
                        <a:pt x="1075" y="1940"/>
                      </a:lnTo>
                      <a:lnTo>
                        <a:pt x="1079" y="1940"/>
                      </a:lnTo>
                      <a:lnTo>
                        <a:pt x="1082" y="1939"/>
                      </a:lnTo>
                      <a:lnTo>
                        <a:pt x="1086" y="1938"/>
                      </a:lnTo>
                      <a:lnTo>
                        <a:pt x="1090" y="1938"/>
                      </a:lnTo>
                      <a:lnTo>
                        <a:pt x="1094" y="1939"/>
                      </a:lnTo>
                      <a:lnTo>
                        <a:pt x="1097" y="1939"/>
                      </a:lnTo>
                      <a:lnTo>
                        <a:pt x="1101" y="1938"/>
                      </a:lnTo>
                      <a:lnTo>
                        <a:pt x="1105" y="1938"/>
                      </a:lnTo>
                      <a:lnTo>
                        <a:pt x="1109" y="1939"/>
                      </a:lnTo>
                      <a:lnTo>
                        <a:pt x="1112" y="1937"/>
                      </a:lnTo>
                      <a:lnTo>
                        <a:pt x="1116" y="1938"/>
                      </a:lnTo>
                      <a:lnTo>
                        <a:pt x="1120" y="1938"/>
                      </a:lnTo>
                      <a:lnTo>
                        <a:pt x="1124" y="1938"/>
                      </a:lnTo>
                      <a:lnTo>
                        <a:pt x="1127" y="1938"/>
                      </a:lnTo>
                      <a:lnTo>
                        <a:pt x="1131" y="1938"/>
                      </a:lnTo>
                      <a:lnTo>
                        <a:pt x="1135" y="1937"/>
                      </a:lnTo>
                      <a:lnTo>
                        <a:pt x="1139" y="1937"/>
                      </a:lnTo>
                      <a:lnTo>
                        <a:pt x="1143" y="1937"/>
                      </a:lnTo>
                      <a:lnTo>
                        <a:pt x="1146" y="1937"/>
                      </a:lnTo>
                      <a:lnTo>
                        <a:pt x="1150" y="1935"/>
                      </a:lnTo>
                      <a:lnTo>
                        <a:pt x="1154" y="1936"/>
                      </a:lnTo>
                      <a:lnTo>
                        <a:pt x="1157" y="1935"/>
                      </a:lnTo>
                      <a:lnTo>
                        <a:pt x="1161" y="1934"/>
                      </a:lnTo>
                      <a:lnTo>
                        <a:pt x="1165" y="1935"/>
                      </a:lnTo>
                      <a:lnTo>
                        <a:pt x="1169" y="1934"/>
                      </a:lnTo>
                      <a:lnTo>
                        <a:pt x="1172" y="1935"/>
                      </a:lnTo>
                      <a:lnTo>
                        <a:pt x="1176" y="1934"/>
                      </a:lnTo>
                      <a:lnTo>
                        <a:pt x="1180" y="1934"/>
                      </a:lnTo>
                      <a:lnTo>
                        <a:pt x="1184" y="1934"/>
                      </a:lnTo>
                      <a:lnTo>
                        <a:pt x="1188" y="1933"/>
                      </a:lnTo>
                      <a:lnTo>
                        <a:pt x="1191" y="1934"/>
                      </a:lnTo>
                      <a:lnTo>
                        <a:pt x="1195" y="1934"/>
                      </a:lnTo>
                      <a:lnTo>
                        <a:pt x="1199" y="1933"/>
                      </a:lnTo>
                      <a:lnTo>
                        <a:pt x="1203" y="1933"/>
                      </a:lnTo>
                      <a:lnTo>
                        <a:pt x="1206" y="1932"/>
                      </a:lnTo>
                      <a:lnTo>
                        <a:pt x="1210" y="1932"/>
                      </a:lnTo>
                      <a:lnTo>
                        <a:pt x="1214" y="1932"/>
                      </a:lnTo>
                      <a:lnTo>
                        <a:pt x="1218" y="1931"/>
                      </a:lnTo>
                      <a:lnTo>
                        <a:pt x="1221" y="1931"/>
                      </a:lnTo>
                      <a:lnTo>
                        <a:pt x="1225" y="1932"/>
                      </a:lnTo>
                      <a:lnTo>
                        <a:pt x="1229" y="1931"/>
                      </a:lnTo>
                      <a:lnTo>
                        <a:pt x="1233" y="1931"/>
                      </a:lnTo>
                      <a:lnTo>
                        <a:pt x="1236" y="1930"/>
                      </a:lnTo>
                      <a:lnTo>
                        <a:pt x="1240" y="1930"/>
                      </a:lnTo>
                      <a:lnTo>
                        <a:pt x="1244" y="1929"/>
                      </a:lnTo>
                      <a:lnTo>
                        <a:pt x="1248" y="1929"/>
                      </a:lnTo>
                      <a:lnTo>
                        <a:pt x="1251" y="1928"/>
                      </a:lnTo>
                      <a:lnTo>
                        <a:pt x="1255" y="1929"/>
                      </a:lnTo>
                      <a:lnTo>
                        <a:pt x="1259" y="1928"/>
                      </a:lnTo>
                      <a:lnTo>
                        <a:pt x="1263" y="1928"/>
                      </a:lnTo>
                      <a:lnTo>
                        <a:pt x="1267" y="1928"/>
                      </a:lnTo>
                      <a:lnTo>
                        <a:pt x="1270" y="1927"/>
                      </a:lnTo>
                      <a:lnTo>
                        <a:pt x="1274" y="1928"/>
                      </a:lnTo>
                      <a:lnTo>
                        <a:pt x="1278" y="1928"/>
                      </a:lnTo>
                      <a:lnTo>
                        <a:pt x="1282" y="1928"/>
                      </a:lnTo>
                      <a:lnTo>
                        <a:pt x="1285" y="1927"/>
                      </a:lnTo>
                      <a:lnTo>
                        <a:pt x="1289" y="1928"/>
                      </a:lnTo>
                      <a:lnTo>
                        <a:pt x="1293" y="1927"/>
                      </a:lnTo>
                      <a:lnTo>
                        <a:pt x="1296" y="1927"/>
                      </a:lnTo>
                      <a:lnTo>
                        <a:pt x="1300" y="1925"/>
                      </a:lnTo>
                      <a:lnTo>
                        <a:pt x="1304" y="1925"/>
                      </a:lnTo>
                      <a:lnTo>
                        <a:pt x="1308" y="1925"/>
                      </a:lnTo>
                      <a:lnTo>
                        <a:pt x="1312" y="1924"/>
                      </a:lnTo>
                      <a:lnTo>
                        <a:pt x="1315" y="1923"/>
                      </a:lnTo>
                      <a:lnTo>
                        <a:pt x="1319" y="1922"/>
                      </a:lnTo>
                      <a:lnTo>
                        <a:pt x="1323" y="1921"/>
                      </a:lnTo>
                      <a:lnTo>
                        <a:pt x="1327" y="1921"/>
                      </a:lnTo>
                      <a:lnTo>
                        <a:pt x="1330" y="1920"/>
                      </a:lnTo>
                      <a:lnTo>
                        <a:pt x="1334" y="1919"/>
                      </a:lnTo>
                      <a:lnTo>
                        <a:pt x="1338" y="1918"/>
                      </a:lnTo>
                      <a:lnTo>
                        <a:pt x="1342" y="1918"/>
                      </a:lnTo>
                      <a:lnTo>
                        <a:pt x="1345" y="1919"/>
                      </a:lnTo>
                      <a:lnTo>
                        <a:pt x="1349" y="1919"/>
                      </a:lnTo>
                      <a:lnTo>
                        <a:pt x="1353" y="1919"/>
                      </a:lnTo>
                      <a:lnTo>
                        <a:pt x="1357" y="1918"/>
                      </a:lnTo>
                      <a:lnTo>
                        <a:pt x="1360" y="1918"/>
                      </a:lnTo>
                      <a:lnTo>
                        <a:pt x="1364" y="1918"/>
                      </a:lnTo>
                      <a:lnTo>
                        <a:pt x="1368" y="1918"/>
                      </a:lnTo>
                      <a:lnTo>
                        <a:pt x="1372" y="1918"/>
                      </a:lnTo>
                      <a:lnTo>
                        <a:pt x="1375" y="1917"/>
                      </a:lnTo>
                      <a:lnTo>
                        <a:pt x="1379" y="1916"/>
                      </a:lnTo>
                      <a:lnTo>
                        <a:pt x="1383" y="1915"/>
                      </a:lnTo>
                      <a:lnTo>
                        <a:pt x="1387" y="1914"/>
                      </a:lnTo>
                      <a:lnTo>
                        <a:pt x="1391" y="1914"/>
                      </a:lnTo>
                      <a:lnTo>
                        <a:pt x="1394" y="1913"/>
                      </a:lnTo>
                      <a:lnTo>
                        <a:pt x="1398" y="1913"/>
                      </a:lnTo>
                      <a:lnTo>
                        <a:pt x="1402" y="1913"/>
                      </a:lnTo>
                      <a:lnTo>
                        <a:pt x="1406" y="1911"/>
                      </a:lnTo>
                      <a:lnTo>
                        <a:pt x="1409" y="1910"/>
                      </a:lnTo>
                      <a:lnTo>
                        <a:pt x="1413" y="1909"/>
                      </a:lnTo>
                      <a:lnTo>
                        <a:pt x="1417" y="1906"/>
                      </a:lnTo>
                      <a:lnTo>
                        <a:pt x="1420" y="1906"/>
                      </a:lnTo>
                      <a:lnTo>
                        <a:pt x="1424" y="1905"/>
                      </a:lnTo>
                      <a:lnTo>
                        <a:pt x="1428" y="1905"/>
                      </a:lnTo>
                      <a:lnTo>
                        <a:pt x="1432" y="1904"/>
                      </a:lnTo>
                      <a:lnTo>
                        <a:pt x="1436" y="1904"/>
                      </a:lnTo>
                      <a:lnTo>
                        <a:pt x="1439" y="1904"/>
                      </a:lnTo>
                      <a:lnTo>
                        <a:pt x="1443" y="1903"/>
                      </a:lnTo>
                      <a:lnTo>
                        <a:pt x="1447" y="1902"/>
                      </a:lnTo>
                      <a:lnTo>
                        <a:pt x="1451" y="1901"/>
                      </a:lnTo>
                      <a:lnTo>
                        <a:pt x="1454" y="1898"/>
                      </a:lnTo>
                      <a:lnTo>
                        <a:pt x="1458" y="1896"/>
                      </a:lnTo>
                      <a:lnTo>
                        <a:pt x="1462" y="1892"/>
                      </a:lnTo>
                      <a:lnTo>
                        <a:pt x="1466" y="1889"/>
                      </a:lnTo>
                      <a:lnTo>
                        <a:pt x="1469" y="1886"/>
                      </a:lnTo>
                      <a:lnTo>
                        <a:pt x="1473" y="1883"/>
                      </a:lnTo>
                      <a:lnTo>
                        <a:pt x="1477" y="1882"/>
                      </a:lnTo>
                      <a:lnTo>
                        <a:pt x="1481" y="1882"/>
                      </a:lnTo>
                      <a:lnTo>
                        <a:pt x="1484" y="1883"/>
                      </a:lnTo>
                      <a:lnTo>
                        <a:pt x="1488" y="1885"/>
                      </a:lnTo>
                      <a:lnTo>
                        <a:pt x="1492" y="1887"/>
                      </a:lnTo>
                      <a:lnTo>
                        <a:pt x="1496" y="1889"/>
                      </a:lnTo>
                      <a:lnTo>
                        <a:pt x="1499" y="1892"/>
                      </a:lnTo>
                      <a:lnTo>
                        <a:pt x="1503" y="1894"/>
                      </a:lnTo>
                      <a:lnTo>
                        <a:pt x="1507" y="1896"/>
                      </a:lnTo>
                      <a:lnTo>
                        <a:pt x="1511" y="1896"/>
                      </a:lnTo>
                      <a:lnTo>
                        <a:pt x="1515" y="1897"/>
                      </a:lnTo>
                      <a:lnTo>
                        <a:pt x="1518" y="1896"/>
                      </a:lnTo>
                      <a:lnTo>
                        <a:pt x="1522" y="1896"/>
                      </a:lnTo>
                      <a:lnTo>
                        <a:pt x="1526" y="1895"/>
                      </a:lnTo>
                      <a:lnTo>
                        <a:pt x="1530" y="1894"/>
                      </a:lnTo>
                      <a:lnTo>
                        <a:pt x="1533" y="1893"/>
                      </a:lnTo>
                      <a:lnTo>
                        <a:pt x="1537" y="1893"/>
                      </a:lnTo>
                      <a:lnTo>
                        <a:pt x="1541" y="1893"/>
                      </a:lnTo>
                      <a:lnTo>
                        <a:pt x="1544" y="1893"/>
                      </a:lnTo>
                      <a:lnTo>
                        <a:pt x="1548" y="1892"/>
                      </a:lnTo>
                      <a:lnTo>
                        <a:pt x="1552" y="1891"/>
                      </a:lnTo>
                      <a:lnTo>
                        <a:pt x="1556" y="1890"/>
                      </a:lnTo>
                      <a:lnTo>
                        <a:pt x="1560" y="1890"/>
                      </a:lnTo>
                      <a:lnTo>
                        <a:pt x="1563" y="1890"/>
                      </a:lnTo>
                      <a:lnTo>
                        <a:pt x="1567" y="1888"/>
                      </a:lnTo>
                      <a:lnTo>
                        <a:pt x="1571" y="1888"/>
                      </a:lnTo>
                      <a:lnTo>
                        <a:pt x="1575" y="1888"/>
                      </a:lnTo>
                      <a:lnTo>
                        <a:pt x="1578" y="1887"/>
                      </a:lnTo>
                      <a:lnTo>
                        <a:pt x="1582" y="1885"/>
                      </a:lnTo>
                      <a:lnTo>
                        <a:pt x="1586" y="1885"/>
                      </a:lnTo>
                      <a:lnTo>
                        <a:pt x="1590" y="1884"/>
                      </a:lnTo>
                      <a:lnTo>
                        <a:pt x="1593" y="1883"/>
                      </a:lnTo>
                      <a:lnTo>
                        <a:pt x="1597" y="1883"/>
                      </a:lnTo>
                      <a:lnTo>
                        <a:pt x="1601" y="1882"/>
                      </a:lnTo>
                      <a:lnTo>
                        <a:pt x="1605" y="1880"/>
                      </a:lnTo>
                      <a:lnTo>
                        <a:pt x="1608" y="1879"/>
                      </a:lnTo>
                      <a:lnTo>
                        <a:pt x="1612" y="1879"/>
                      </a:lnTo>
                      <a:lnTo>
                        <a:pt x="1616" y="1878"/>
                      </a:lnTo>
                      <a:lnTo>
                        <a:pt x="1620" y="1877"/>
                      </a:lnTo>
                      <a:lnTo>
                        <a:pt x="1623" y="1877"/>
                      </a:lnTo>
                      <a:lnTo>
                        <a:pt x="1627" y="1877"/>
                      </a:lnTo>
                      <a:lnTo>
                        <a:pt x="1631" y="1876"/>
                      </a:lnTo>
                      <a:lnTo>
                        <a:pt x="1635" y="1876"/>
                      </a:lnTo>
                      <a:lnTo>
                        <a:pt x="1639" y="1874"/>
                      </a:lnTo>
                      <a:lnTo>
                        <a:pt x="1642" y="1873"/>
                      </a:lnTo>
                      <a:lnTo>
                        <a:pt x="1646" y="1872"/>
                      </a:lnTo>
                      <a:lnTo>
                        <a:pt x="1650" y="1871"/>
                      </a:lnTo>
                      <a:lnTo>
                        <a:pt x="1654" y="1870"/>
                      </a:lnTo>
                      <a:lnTo>
                        <a:pt x="1657" y="1869"/>
                      </a:lnTo>
                      <a:lnTo>
                        <a:pt x="1661" y="1868"/>
                      </a:lnTo>
                      <a:lnTo>
                        <a:pt x="1665" y="1867"/>
                      </a:lnTo>
                      <a:lnTo>
                        <a:pt x="1669" y="1867"/>
                      </a:lnTo>
                      <a:lnTo>
                        <a:pt x="1672" y="1866"/>
                      </a:lnTo>
                      <a:lnTo>
                        <a:pt x="1676" y="1866"/>
                      </a:lnTo>
                      <a:lnTo>
                        <a:pt x="1680" y="1865"/>
                      </a:lnTo>
                      <a:lnTo>
                        <a:pt x="1684" y="1865"/>
                      </a:lnTo>
                      <a:lnTo>
                        <a:pt x="1687" y="1865"/>
                      </a:lnTo>
                      <a:lnTo>
                        <a:pt x="1691" y="1863"/>
                      </a:lnTo>
                      <a:lnTo>
                        <a:pt x="1695" y="1863"/>
                      </a:lnTo>
                      <a:lnTo>
                        <a:pt x="1699" y="1862"/>
                      </a:lnTo>
                      <a:lnTo>
                        <a:pt x="1702" y="1861"/>
                      </a:lnTo>
                      <a:lnTo>
                        <a:pt x="1706" y="1859"/>
                      </a:lnTo>
                      <a:lnTo>
                        <a:pt x="1710" y="1856"/>
                      </a:lnTo>
                      <a:lnTo>
                        <a:pt x="1714" y="1854"/>
                      </a:lnTo>
                      <a:lnTo>
                        <a:pt x="1717" y="1852"/>
                      </a:lnTo>
                      <a:lnTo>
                        <a:pt x="1721" y="1849"/>
                      </a:lnTo>
                      <a:lnTo>
                        <a:pt x="1725" y="1848"/>
                      </a:lnTo>
                      <a:lnTo>
                        <a:pt x="1729" y="1846"/>
                      </a:lnTo>
                      <a:lnTo>
                        <a:pt x="1733" y="1845"/>
                      </a:lnTo>
                      <a:lnTo>
                        <a:pt x="1736" y="1844"/>
                      </a:lnTo>
                      <a:lnTo>
                        <a:pt x="1740" y="1843"/>
                      </a:lnTo>
                      <a:lnTo>
                        <a:pt x="1744" y="1843"/>
                      </a:lnTo>
                      <a:lnTo>
                        <a:pt x="1747" y="1843"/>
                      </a:lnTo>
                      <a:lnTo>
                        <a:pt x="1751" y="1843"/>
                      </a:lnTo>
                      <a:lnTo>
                        <a:pt x="1755" y="1844"/>
                      </a:lnTo>
                      <a:lnTo>
                        <a:pt x="1759" y="1844"/>
                      </a:lnTo>
                      <a:lnTo>
                        <a:pt x="1762" y="1846"/>
                      </a:lnTo>
                      <a:lnTo>
                        <a:pt x="1766" y="1846"/>
                      </a:lnTo>
                      <a:lnTo>
                        <a:pt x="1770" y="1846"/>
                      </a:lnTo>
                      <a:lnTo>
                        <a:pt x="1774" y="1847"/>
                      </a:lnTo>
                      <a:lnTo>
                        <a:pt x="1778" y="1846"/>
                      </a:lnTo>
                      <a:lnTo>
                        <a:pt x="1781" y="1844"/>
                      </a:lnTo>
                      <a:lnTo>
                        <a:pt x="1785" y="1843"/>
                      </a:lnTo>
                      <a:lnTo>
                        <a:pt x="1789" y="1840"/>
                      </a:lnTo>
                      <a:lnTo>
                        <a:pt x="1793" y="1837"/>
                      </a:lnTo>
                      <a:lnTo>
                        <a:pt x="1796" y="1835"/>
                      </a:lnTo>
                      <a:lnTo>
                        <a:pt x="1800" y="1834"/>
                      </a:lnTo>
                      <a:lnTo>
                        <a:pt x="1804" y="1833"/>
                      </a:lnTo>
                      <a:lnTo>
                        <a:pt x="1808" y="1833"/>
                      </a:lnTo>
                      <a:lnTo>
                        <a:pt x="1811" y="1833"/>
                      </a:lnTo>
                      <a:lnTo>
                        <a:pt x="1815" y="1834"/>
                      </a:lnTo>
                      <a:lnTo>
                        <a:pt x="1819" y="1836"/>
                      </a:lnTo>
                      <a:lnTo>
                        <a:pt x="1823" y="1836"/>
                      </a:lnTo>
                      <a:lnTo>
                        <a:pt x="1826" y="1837"/>
                      </a:lnTo>
                      <a:lnTo>
                        <a:pt x="1830" y="1836"/>
                      </a:lnTo>
                      <a:lnTo>
                        <a:pt x="1834" y="1835"/>
                      </a:lnTo>
                      <a:lnTo>
                        <a:pt x="1838" y="1834"/>
                      </a:lnTo>
                      <a:lnTo>
                        <a:pt x="1841" y="1832"/>
                      </a:lnTo>
                      <a:lnTo>
                        <a:pt x="1845" y="1829"/>
                      </a:lnTo>
                      <a:lnTo>
                        <a:pt x="1849" y="1826"/>
                      </a:lnTo>
                      <a:lnTo>
                        <a:pt x="1853" y="1822"/>
                      </a:lnTo>
                      <a:lnTo>
                        <a:pt x="1857" y="1820"/>
                      </a:lnTo>
                      <a:lnTo>
                        <a:pt x="1860" y="1817"/>
                      </a:lnTo>
                      <a:lnTo>
                        <a:pt x="1864" y="1815"/>
                      </a:lnTo>
                      <a:lnTo>
                        <a:pt x="1868" y="1811"/>
                      </a:lnTo>
                      <a:lnTo>
                        <a:pt x="1871" y="1810"/>
                      </a:lnTo>
                      <a:lnTo>
                        <a:pt x="1875" y="1807"/>
                      </a:lnTo>
                      <a:lnTo>
                        <a:pt x="1879" y="1805"/>
                      </a:lnTo>
                      <a:lnTo>
                        <a:pt x="1883" y="1803"/>
                      </a:lnTo>
                      <a:lnTo>
                        <a:pt x="1886" y="1801"/>
                      </a:lnTo>
                      <a:lnTo>
                        <a:pt x="1890" y="1799"/>
                      </a:lnTo>
                      <a:lnTo>
                        <a:pt x="1894" y="1797"/>
                      </a:lnTo>
                      <a:lnTo>
                        <a:pt x="1898" y="1795"/>
                      </a:lnTo>
                      <a:lnTo>
                        <a:pt x="1902" y="1792"/>
                      </a:lnTo>
                      <a:lnTo>
                        <a:pt x="1905" y="1789"/>
                      </a:lnTo>
                      <a:lnTo>
                        <a:pt x="1909" y="1786"/>
                      </a:lnTo>
                      <a:lnTo>
                        <a:pt x="1913" y="1783"/>
                      </a:lnTo>
                      <a:lnTo>
                        <a:pt x="1917" y="1780"/>
                      </a:lnTo>
                      <a:lnTo>
                        <a:pt x="1920" y="1777"/>
                      </a:lnTo>
                      <a:lnTo>
                        <a:pt x="1924" y="1774"/>
                      </a:lnTo>
                      <a:lnTo>
                        <a:pt x="1928" y="1771"/>
                      </a:lnTo>
                      <a:lnTo>
                        <a:pt x="1932" y="1769"/>
                      </a:lnTo>
                      <a:lnTo>
                        <a:pt x="1935" y="1767"/>
                      </a:lnTo>
                      <a:lnTo>
                        <a:pt x="1939" y="1766"/>
                      </a:lnTo>
                      <a:lnTo>
                        <a:pt x="1943" y="1765"/>
                      </a:lnTo>
                      <a:lnTo>
                        <a:pt x="1947" y="1765"/>
                      </a:lnTo>
                      <a:lnTo>
                        <a:pt x="1950" y="1764"/>
                      </a:lnTo>
                      <a:lnTo>
                        <a:pt x="1954" y="1763"/>
                      </a:lnTo>
                      <a:lnTo>
                        <a:pt x="1958" y="1762"/>
                      </a:lnTo>
                      <a:lnTo>
                        <a:pt x="1962" y="1761"/>
                      </a:lnTo>
                      <a:lnTo>
                        <a:pt x="1965" y="1757"/>
                      </a:lnTo>
                      <a:lnTo>
                        <a:pt x="1969" y="1754"/>
                      </a:lnTo>
                      <a:lnTo>
                        <a:pt x="1973" y="1748"/>
                      </a:lnTo>
                      <a:lnTo>
                        <a:pt x="1977" y="1743"/>
                      </a:lnTo>
                      <a:lnTo>
                        <a:pt x="1981" y="1738"/>
                      </a:lnTo>
                      <a:lnTo>
                        <a:pt x="1984" y="1732"/>
                      </a:lnTo>
                      <a:lnTo>
                        <a:pt x="1988" y="1726"/>
                      </a:lnTo>
                      <a:lnTo>
                        <a:pt x="1992" y="1721"/>
                      </a:lnTo>
                      <a:lnTo>
                        <a:pt x="1995" y="1719"/>
                      </a:lnTo>
                      <a:lnTo>
                        <a:pt x="1999" y="1717"/>
                      </a:lnTo>
                      <a:lnTo>
                        <a:pt x="2003" y="1714"/>
                      </a:lnTo>
                      <a:lnTo>
                        <a:pt x="2007" y="1712"/>
                      </a:lnTo>
                      <a:lnTo>
                        <a:pt x="2010" y="1711"/>
                      </a:lnTo>
                      <a:lnTo>
                        <a:pt x="2014" y="1709"/>
                      </a:lnTo>
                      <a:lnTo>
                        <a:pt x="2018" y="1707"/>
                      </a:lnTo>
                      <a:lnTo>
                        <a:pt x="2022" y="1704"/>
                      </a:lnTo>
                      <a:lnTo>
                        <a:pt x="2026" y="1701"/>
                      </a:lnTo>
                      <a:lnTo>
                        <a:pt x="2029" y="1698"/>
                      </a:lnTo>
                      <a:lnTo>
                        <a:pt x="2033" y="1696"/>
                      </a:lnTo>
                      <a:lnTo>
                        <a:pt x="2037" y="1692"/>
                      </a:lnTo>
                      <a:lnTo>
                        <a:pt x="2041" y="1691"/>
                      </a:lnTo>
                      <a:lnTo>
                        <a:pt x="2044" y="1689"/>
                      </a:lnTo>
                      <a:lnTo>
                        <a:pt x="2048" y="1689"/>
                      </a:lnTo>
                      <a:lnTo>
                        <a:pt x="2052" y="1688"/>
                      </a:lnTo>
                      <a:lnTo>
                        <a:pt x="2056" y="1688"/>
                      </a:lnTo>
                      <a:lnTo>
                        <a:pt x="2059" y="1686"/>
                      </a:lnTo>
                      <a:lnTo>
                        <a:pt x="2063" y="1684"/>
                      </a:lnTo>
                      <a:lnTo>
                        <a:pt x="2067" y="1683"/>
                      </a:lnTo>
                      <a:lnTo>
                        <a:pt x="2071" y="1680"/>
                      </a:lnTo>
                      <a:lnTo>
                        <a:pt x="2074" y="1676"/>
                      </a:lnTo>
                      <a:lnTo>
                        <a:pt x="2078" y="1670"/>
                      </a:lnTo>
                      <a:lnTo>
                        <a:pt x="2082" y="1665"/>
                      </a:lnTo>
                      <a:lnTo>
                        <a:pt x="2086" y="1659"/>
                      </a:lnTo>
                      <a:lnTo>
                        <a:pt x="2089" y="1652"/>
                      </a:lnTo>
                      <a:lnTo>
                        <a:pt x="2093" y="1645"/>
                      </a:lnTo>
                      <a:lnTo>
                        <a:pt x="2097" y="1640"/>
                      </a:lnTo>
                      <a:lnTo>
                        <a:pt x="2101" y="1633"/>
                      </a:lnTo>
                      <a:lnTo>
                        <a:pt x="2105" y="1628"/>
                      </a:lnTo>
                      <a:lnTo>
                        <a:pt x="2108" y="1624"/>
                      </a:lnTo>
                      <a:lnTo>
                        <a:pt x="2112" y="1621"/>
                      </a:lnTo>
                      <a:lnTo>
                        <a:pt x="2116" y="1620"/>
                      </a:lnTo>
                      <a:lnTo>
                        <a:pt x="2120" y="1619"/>
                      </a:lnTo>
                      <a:lnTo>
                        <a:pt x="2123" y="1619"/>
                      </a:lnTo>
                      <a:lnTo>
                        <a:pt x="2127" y="1622"/>
                      </a:lnTo>
                      <a:lnTo>
                        <a:pt x="2131" y="1624"/>
                      </a:lnTo>
                      <a:lnTo>
                        <a:pt x="2134" y="1626"/>
                      </a:lnTo>
                      <a:lnTo>
                        <a:pt x="2138" y="1628"/>
                      </a:lnTo>
                      <a:lnTo>
                        <a:pt x="2142" y="1627"/>
                      </a:lnTo>
                      <a:lnTo>
                        <a:pt x="2146" y="1624"/>
                      </a:lnTo>
                      <a:lnTo>
                        <a:pt x="2150" y="1620"/>
                      </a:lnTo>
                      <a:lnTo>
                        <a:pt x="2153" y="1615"/>
                      </a:lnTo>
                      <a:lnTo>
                        <a:pt x="2157" y="1607"/>
                      </a:lnTo>
                      <a:lnTo>
                        <a:pt x="2161" y="1599"/>
                      </a:lnTo>
                      <a:lnTo>
                        <a:pt x="2165" y="1591"/>
                      </a:lnTo>
                      <a:lnTo>
                        <a:pt x="2168" y="1582"/>
                      </a:lnTo>
                      <a:lnTo>
                        <a:pt x="2172" y="1571"/>
                      </a:lnTo>
                      <a:lnTo>
                        <a:pt x="2176" y="1557"/>
                      </a:lnTo>
                      <a:lnTo>
                        <a:pt x="2180" y="1543"/>
                      </a:lnTo>
                      <a:lnTo>
                        <a:pt x="2183" y="1526"/>
                      </a:lnTo>
                      <a:lnTo>
                        <a:pt x="2187" y="1509"/>
                      </a:lnTo>
                      <a:lnTo>
                        <a:pt x="2191" y="1492"/>
                      </a:lnTo>
                      <a:lnTo>
                        <a:pt x="2195" y="1475"/>
                      </a:lnTo>
                      <a:lnTo>
                        <a:pt x="2198" y="1457"/>
                      </a:lnTo>
                      <a:lnTo>
                        <a:pt x="2202" y="1442"/>
                      </a:lnTo>
                      <a:lnTo>
                        <a:pt x="2206" y="1428"/>
                      </a:lnTo>
                      <a:lnTo>
                        <a:pt x="2210" y="1416"/>
                      </a:lnTo>
                      <a:lnTo>
                        <a:pt x="2213" y="1406"/>
                      </a:lnTo>
                      <a:lnTo>
                        <a:pt x="2217" y="1396"/>
                      </a:lnTo>
                      <a:lnTo>
                        <a:pt x="2221" y="1390"/>
                      </a:lnTo>
                      <a:lnTo>
                        <a:pt x="2225" y="1385"/>
                      </a:lnTo>
                      <a:lnTo>
                        <a:pt x="2229" y="1381"/>
                      </a:lnTo>
                      <a:lnTo>
                        <a:pt x="2232" y="1374"/>
                      </a:lnTo>
                      <a:lnTo>
                        <a:pt x="2236" y="1360"/>
                      </a:lnTo>
                      <a:lnTo>
                        <a:pt x="2240" y="1328"/>
                      </a:lnTo>
                      <a:lnTo>
                        <a:pt x="2244" y="1268"/>
                      </a:lnTo>
                      <a:lnTo>
                        <a:pt x="2244" y="1253"/>
                      </a:lnTo>
                      <a:lnTo>
                        <a:pt x="2247" y="1172"/>
                      </a:lnTo>
                      <a:lnTo>
                        <a:pt x="2248" y="1148"/>
                      </a:lnTo>
                      <a:lnTo>
                        <a:pt x="2251" y="1034"/>
                      </a:lnTo>
                      <a:lnTo>
                        <a:pt x="2255" y="860"/>
                      </a:lnTo>
                      <a:lnTo>
                        <a:pt x="2258" y="660"/>
                      </a:lnTo>
                      <a:lnTo>
                        <a:pt x="2262" y="456"/>
                      </a:lnTo>
                      <a:lnTo>
                        <a:pt x="2266" y="277"/>
                      </a:lnTo>
                      <a:lnTo>
                        <a:pt x="2267" y="246"/>
                      </a:lnTo>
                      <a:lnTo>
                        <a:pt x="2269" y="167"/>
                      </a:lnTo>
                      <a:lnTo>
                        <a:pt x="2270" y="147"/>
                      </a:lnTo>
                      <a:lnTo>
                        <a:pt x="2271" y="129"/>
                      </a:lnTo>
                      <a:lnTo>
                        <a:pt x="2273" y="93"/>
                      </a:lnTo>
                      <a:lnTo>
                        <a:pt x="2274" y="86"/>
                      </a:lnTo>
                      <a:lnTo>
                        <a:pt x="2274" y="82"/>
                      </a:lnTo>
                      <a:lnTo>
                        <a:pt x="2277" y="92"/>
                      </a:lnTo>
                      <a:lnTo>
                        <a:pt x="2277" y="102"/>
                      </a:lnTo>
                      <a:lnTo>
                        <a:pt x="2278" y="114"/>
                      </a:lnTo>
                      <a:lnTo>
                        <a:pt x="2280" y="165"/>
                      </a:lnTo>
                      <a:lnTo>
                        <a:pt x="2281" y="187"/>
                      </a:lnTo>
                      <a:lnTo>
                        <a:pt x="2282" y="212"/>
                      </a:lnTo>
                      <a:lnTo>
                        <a:pt x="2285" y="329"/>
                      </a:lnTo>
                      <a:lnTo>
                        <a:pt x="2289" y="507"/>
                      </a:lnTo>
                      <a:lnTo>
                        <a:pt x="2292" y="697"/>
                      </a:lnTo>
                      <a:lnTo>
                        <a:pt x="2296" y="881"/>
                      </a:lnTo>
                      <a:lnTo>
                        <a:pt x="2300" y="1045"/>
                      </a:lnTo>
                      <a:lnTo>
                        <a:pt x="2304" y="1183"/>
                      </a:lnTo>
                      <a:lnTo>
                        <a:pt x="2304" y="1208"/>
                      </a:lnTo>
                      <a:lnTo>
                        <a:pt x="2307" y="1293"/>
                      </a:lnTo>
                      <a:lnTo>
                        <a:pt x="2311" y="1376"/>
                      </a:lnTo>
                      <a:lnTo>
                        <a:pt x="2315" y="1435"/>
                      </a:lnTo>
                      <a:lnTo>
                        <a:pt x="2319" y="1475"/>
                      </a:lnTo>
                      <a:lnTo>
                        <a:pt x="2322" y="1500"/>
                      </a:lnTo>
                      <a:lnTo>
                        <a:pt x="2326" y="1514"/>
                      </a:lnTo>
                      <a:lnTo>
                        <a:pt x="2330" y="1519"/>
                      </a:lnTo>
                      <a:lnTo>
                        <a:pt x="2334" y="1519"/>
                      </a:lnTo>
                      <a:lnTo>
                        <a:pt x="2337" y="1515"/>
                      </a:lnTo>
                      <a:lnTo>
                        <a:pt x="2341" y="1508"/>
                      </a:lnTo>
                      <a:lnTo>
                        <a:pt x="2345" y="1501"/>
                      </a:lnTo>
                      <a:lnTo>
                        <a:pt x="2349" y="1494"/>
                      </a:lnTo>
                      <a:lnTo>
                        <a:pt x="2352" y="1486"/>
                      </a:lnTo>
                      <a:lnTo>
                        <a:pt x="2356" y="1479"/>
                      </a:lnTo>
                      <a:lnTo>
                        <a:pt x="2360" y="1473"/>
                      </a:lnTo>
                      <a:lnTo>
                        <a:pt x="2364" y="1467"/>
                      </a:lnTo>
                      <a:lnTo>
                        <a:pt x="2368" y="1462"/>
                      </a:lnTo>
                      <a:lnTo>
                        <a:pt x="2371" y="1459"/>
                      </a:lnTo>
                      <a:lnTo>
                        <a:pt x="2375" y="1455"/>
                      </a:lnTo>
                      <a:lnTo>
                        <a:pt x="2379" y="1451"/>
                      </a:lnTo>
                      <a:lnTo>
                        <a:pt x="2382" y="1447"/>
                      </a:lnTo>
                      <a:lnTo>
                        <a:pt x="2386" y="1442"/>
                      </a:lnTo>
                      <a:lnTo>
                        <a:pt x="2390" y="1436"/>
                      </a:lnTo>
                      <a:lnTo>
                        <a:pt x="2394" y="1429"/>
                      </a:lnTo>
                      <a:lnTo>
                        <a:pt x="2398" y="1418"/>
                      </a:lnTo>
                      <a:lnTo>
                        <a:pt x="2401" y="1405"/>
                      </a:lnTo>
                      <a:lnTo>
                        <a:pt x="2405" y="1386"/>
                      </a:lnTo>
                      <a:lnTo>
                        <a:pt x="2409" y="1362"/>
                      </a:lnTo>
                      <a:lnTo>
                        <a:pt x="2413" y="1329"/>
                      </a:lnTo>
                      <a:lnTo>
                        <a:pt x="2416" y="1288"/>
                      </a:lnTo>
                      <a:lnTo>
                        <a:pt x="2420" y="1234"/>
                      </a:lnTo>
                      <a:lnTo>
                        <a:pt x="2424" y="1166"/>
                      </a:lnTo>
                      <a:lnTo>
                        <a:pt x="2428" y="1080"/>
                      </a:lnTo>
                      <a:lnTo>
                        <a:pt x="2431" y="969"/>
                      </a:lnTo>
                      <a:lnTo>
                        <a:pt x="2435" y="834"/>
                      </a:lnTo>
                      <a:lnTo>
                        <a:pt x="2439" y="676"/>
                      </a:lnTo>
                      <a:lnTo>
                        <a:pt x="2443" y="505"/>
                      </a:lnTo>
                      <a:lnTo>
                        <a:pt x="2446" y="341"/>
                      </a:lnTo>
                      <a:lnTo>
                        <a:pt x="2450" y="228"/>
                      </a:lnTo>
                      <a:lnTo>
                        <a:pt x="2450" y="204"/>
                      </a:lnTo>
                      <a:lnTo>
                        <a:pt x="2451" y="182"/>
                      </a:lnTo>
                      <a:lnTo>
                        <a:pt x="2453" y="129"/>
                      </a:lnTo>
                      <a:lnTo>
                        <a:pt x="2454" y="118"/>
                      </a:lnTo>
                      <a:lnTo>
                        <a:pt x="2455" y="109"/>
                      </a:lnTo>
                      <a:lnTo>
                        <a:pt x="2457" y="97"/>
                      </a:lnTo>
                      <a:lnTo>
                        <a:pt x="2458" y="100"/>
                      </a:lnTo>
                      <a:lnTo>
                        <a:pt x="2458" y="105"/>
                      </a:lnTo>
                      <a:lnTo>
                        <a:pt x="2461" y="140"/>
                      </a:lnTo>
                      <a:lnTo>
                        <a:pt x="2461" y="156"/>
                      </a:lnTo>
                      <a:lnTo>
                        <a:pt x="2462" y="176"/>
                      </a:lnTo>
                      <a:lnTo>
                        <a:pt x="2465" y="282"/>
                      </a:lnTo>
                      <a:lnTo>
                        <a:pt x="2466" y="314"/>
                      </a:lnTo>
                      <a:lnTo>
                        <a:pt x="2469" y="458"/>
                      </a:lnTo>
                      <a:lnTo>
                        <a:pt x="2473" y="663"/>
                      </a:lnTo>
                      <a:lnTo>
                        <a:pt x="2476" y="874"/>
                      </a:lnTo>
                      <a:lnTo>
                        <a:pt x="2480" y="1074"/>
                      </a:lnTo>
                      <a:lnTo>
                        <a:pt x="2484" y="1252"/>
                      </a:lnTo>
                      <a:lnTo>
                        <a:pt x="2488" y="1400"/>
                      </a:lnTo>
                      <a:lnTo>
                        <a:pt x="2492" y="1518"/>
                      </a:lnTo>
                      <a:lnTo>
                        <a:pt x="2495" y="1609"/>
                      </a:lnTo>
                      <a:lnTo>
                        <a:pt x="2499" y="1677"/>
                      </a:lnTo>
                      <a:lnTo>
                        <a:pt x="2503" y="1728"/>
                      </a:lnTo>
                      <a:lnTo>
                        <a:pt x="2507" y="1766"/>
                      </a:lnTo>
                      <a:lnTo>
                        <a:pt x="2510" y="1793"/>
                      </a:lnTo>
                      <a:lnTo>
                        <a:pt x="2514" y="1812"/>
                      </a:lnTo>
                      <a:lnTo>
                        <a:pt x="2518" y="1828"/>
                      </a:lnTo>
                      <a:lnTo>
                        <a:pt x="2522" y="1838"/>
                      </a:lnTo>
                      <a:lnTo>
                        <a:pt x="2525" y="1847"/>
                      </a:lnTo>
                      <a:lnTo>
                        <a:pt x="2529" y="1854"/>
                      </a:lnTo>
                      <a:lnTo>
                        <a:pt x="2533" y="1859"/>
                      </a:lnTo>
                      <a:lnTo>
                        <a:pt x="2537" y="1863"/>
                      </a:lnTo>
                      <a:lnTo>
                        <a:pt x="2540" y="1868"/>
                      </a:lnTo>
                      <a:lnTo>
                        <a:pt x="2544" y="1871"/>
                      </a:lnTo>
                      <a:lnTo>
                        <a:pt x="2548" y="1876"/>
                      </a:lnTo>
                      <a:lnTo>
                        <a:pt x="2552" y="1880"/>
                      </a:lnTo>
                      <a:lnTo>
                        <a:pt x="2555" y="1884"/>
                      </a:lnTo>
                      <a:lnTo>
                        <a:pt x="2559" y="1887"/>
                      </a:lnTo>
                      <a:lnTo>
                        <a:pt x="2563" y="1891"/>
                      </a:lnTo>
                      <a:lnTo>
                        <a:pt x="2567" y="1894"/>
                      </a:lnTo>
                      <a:lnTo>
                        <a:pt x="2571" y="1898"/>
                      </a:lnTo>
                      <a:lnTo>
                        <a:pt x="2574" y="1900"/>
                      </a:lnTo>
                      <a:lnTo>
                        <a:pt x="2578" y="1904"/>
                      </a:lnTo>
                      <a:lnTo>
                        <a:pt x="2582" y="1906"/>
                      </a:lnTo>
                      <a:lnTo>
                        <a:pt x="2585" y="1909"/>
                      </a:lnTo>
                      <a:lnTo>
                        <a:pt x="2589" y="1911"/>
                      </a:lnTo>
                      <a:lnTo>
                        <a:pt x="2593" y="1913"/>
                      </a:lnTo>
                      <a:lnTo>
                        <a:pt x="2597" y="1914"/>
                      </a:lnTo>
                      <a:lnTo>
                        <a:pt x="2600" y="1916"/>
                      </a:lnTo>
                      <a:lnTo>
                        <a:pt x="2604" y="1916"/>
                      </a:lnTo>
                      <a:lnTo>
                        <a:pt x="2608" y="1918"/>
                      </a:lnTo>
                      <a:lnTo>
                        <a:pt x="2612" y="1918"/>
                      </a:lnTo>
                      <a:lnTo>
                        <a:pt x="2616" y="1918"/>
                      </a:lnTo>
                      <a:lnTo>
                        <a:pt x="2619" y="1919"/>
                      </a:lnTo>
                      <a:lnTo>
                        <a:pt x="2623" y="1918"/>
                      </a:lnTo>
                      <a:lnTo>
                        <a:pt x="2627" y="1918"/>
                      </a:lnTo>
                      <a:lnTo>
                        <a:pt x="2631" y="1919"/>
                      </a:lnTo>
                      <a:lnTo>
                        <a:pt x="2634" y="1919"/>
                      </a:lnTo>
                      <a:lnTo>
                        <a:pt x="2638" y="1920"/>
                      </a:lnTo>
                      <a:lnTo>
                        <a:pt x="2642" y="1920"/>
                      </a:lnTo>
                      <a:lnTo>
                        <a:pt x="2646" y="1920"/>
                      </a:lnTo>
                      <a:lnTo>
                        <a:pt x="2649" y="1920"/>
                      </a:lnTo>
                      <a:lnTo>
                        <a:pt x="2653" y="1920"/>
                      </a:lnTo>
                      <a:lnTo>
                        <a:pt x="2657" y="1920"/>
                      </a:lnTo>
                      <a:lnTo>
                        <a:pt x="2661" y="1920"/>
                      </a:lnTo>
                      <a:lnTo>
                        <a:pt x="2664" y="1920"/>
                      </a:lnTo>
                      <a:lnTo>
                        <a:pt x="2668" y="1920"/>
                      </a:lnTo>
                      <a:lnTo>
                        <a:pt x="2672" y="1920"/>
                      </a:lnTo>
                      <a:lnTo>
                        <a:pt x="2676" y="1920"/>
                      </a:lnTo>
                      <a:lnTo>
                        <a:pt x="2679" y="1921"/>
                      </a:lnTo>
                      <a:lnTo>
                        <a:pt x="2683" y="1920"/>
                      </a:lnTo>
                      <a:lnTo>
                        <a:pt x="2687" y="1920"/>
                      </a:lnTo>
                      <a:lnTo>
                        <a:pt x="2691" y="1920"/>
                      </a:lnTo>
                      <a:lnTo>
                        <a:pt x="2695" y="1921"/>
                      </a:lnTo>
                      <a:lnTo>
                        <a:pt x="2698" y="1921"/>
                      </a:lnTo>
                      <a:lnTo>
                        <a:pt x="2702" y="1921"/>
                      </a:lnTo>
                      <a:lnTo>
                        <a:pt x="2706" y="1921"/>
                      </a:lnTo>
                      <a:lnTo>
                        <a:pt x="2709" y="1921"/>
                      </a:lnTo>
                      <a:lnTo>
                        <a:pt x="2713" y="1923"/>
                      </a:lnTo>
                      <a:lnTo>
                        <a:pt x="2717" y="1922"/>
                      </a:lnTo>
                      <a:lnTo>
                        <a:pt x="2721" y="1922"/>
                      </a:lnTo>
                      <a:lnTo>
                        <a:pt x="2724" y="1923"/>
                      </a:lnTo>
                      <a:lnTo>
                        <a:pt x="2728" y="1923"/>
                      </a:lnTo>
                      <a:lnTo>
                        <a:pt x="2732" y="1922"/>
                      </a:lnTo>
                      <a:lnTo>
                        <a:pt x="2736" y="1923"/>
                      </a:lnTo>
                      <a:lnTo>
                        <a:pt x="2740" y="1923"/>
                      </a:lnTo>
                      <a:lnTo>
                        <a:pt x="2743" y="1924"/>
                      </a:lnTo>
                      <a:lnTo>
                        <a:pt x="2747" y="1924"/>
                      </a:lnTo>
                      <a:lnTo>
                        <a:pt x="2751" y="1923"/>
                      </a:lnTo>
                      <a:lnTo>
                        <a:pt x="2755" y="1924"/>
                      </a:lnTo>
                      <a:lnTo>
                        <a:pt x="2758" y="1924"/>
                      </a:lnTo>
                      <a:lnTo>
                        <a:pt x="2762" y="1925"/>
                      </a:lnTo>
                      <a:lnTo>
                        <a:pt x="2766" y="1925"/>
                      </a:lnTo>
                      <a:lnTo>
                        <a:pt x="2770" y="1925"/>
                      </a:lnTo>
                      <a:lnTo>
                        <a:pt x="2773" y="1925"/>
                      </a:lnTo>
                      <a:lnTo>
                        <a:pt x="2777" y="1925"/>
                      </a:lnTo>
                      <a:lnTo>
                        <a:pt x="2781" y="1926"/>
                      </a:lnTo>
                      <a:lnTo>
                        <a:pt x="2785" y="1925"/>
                      </a:lnTo>
                      <a:lnTo>
                        <a:pt x="2788" y="1926"/>
                      </a:lnTo>
                      <a:lnTo>
                        <a:pt x="2792" y="1925"/>
                      </a:lnTo>
                      <a:lnTo>
                        <a:pt x="2796" y="1926"/>
                      </a:lnTo>
                      <a:lnTo>
                        <a:pt x="2800" y="1925"/>
                      </a:lnTo>
                      <a:lnTo>
                        <a:pt x="2803" y="1926"/>
                      </a:lnTo>
                      <a:lnTo>
                        <a:pt x="2807" y="1926"/>
                      </a:lnTo>
                      <a:lnTo>
                        <a:pt x="2811" y="1926"/>
                      </a:lnTo>
                      <a:lnTo>
                        <a:pt x="2815" y="1926"/>
                      </a:lnTo>
                      <a:lnTo>
                        <a:pt x="2819" y="1926"/>
                      </a:lnTo>
                      <a:lnTo>
                        <a:pt x="2822" y="1927"/>
                      </a:lnTo>
                      <a:lnTo>
                        <a:pt x="2826" y="1926"/>
                      </a:lnTo>
                      <a:lnTo>
                        <a:pt x="2830" y="1927"/>
                      </a:lnTo>
                      <a:lnTo>
                        <a:pt x="2833" y="1927"/>
                      </a:lnTo>
                      <a:lnTo>
                        <a:pt x="2837" y="1927"/>
                      </a:lnTo>
                      <a:lnTo>
                        <a:pt x="2841" y="1927"/>
                      </a:lnTo>
                      <a:lnTo>
                        <a:pt x="2845" y="1927"/>
                      </a:lnTo>
                      <a:lnTo>
                        <a:pt x="2848" y="1927"/>
                      </a:lnTo>
                      <a:lnTo>
                        <a:pt x="2852" y="1927"/>
                      </a:lnTo>
                      <a:lnTo>
                        <a:pt x="2856" y="1928"/>
                      </a:lnTo>
                      <a:lnTo>
                        <a:pt x="2860" y="1928"/>
                      </a:lnTo>
                      <a:lnTo>
                        <a:pt x="2864" y="1927"/>
                      </a:lnTo>
                      <a:lnTo>
                        <a:pt x="2867" y="1927"/>
                      </a:lnTo>
                      <a:lnTo>
                        <a:pt x="2871" y="1928"/>
                      </a:lnTo>
                      <a:lnTo>
                        <a:pt x="2875" y="1927"/>
                      </a:lnTo>
                      <a:lnTo>
                        <a:pt x="2879" y="1927"/>
                      </a:lnTo>
                      <a:lnTo>
                        <a:pt x="2882" y="1927"/>
                      </a:lnTo>
                      <a:lnTo>
                        <a:pt x="2886" y="1927"/>
                      </a:lnTo>
                      <a:lnTo>
                        <a:pt x="2890" y="1928"/>
                      </a:lnTo>
                      <a:lnTo>
                        <a:pt x="2894" y="1928"/>
                      </a:lnTo>
                      <a:lnTo>
                        <a:pt x="2897" y="1929"/>
                      </a:lnTo>
                      <a:lnTo>
                        <a:pt x="2901" y="1928"/>
                      </a:lnTo>
                      <a:lnTo>
                        <a:pt x="2905" y="1927"/>
                      </a:lnTo>
                      <a:lnTo>
                        <a:pt x="2909" y="1929"/>
                      </a:lnTo>
                      <a:lnTo>
                        <a:pt x="2912" y="1928"/>
                      </a:lnTo>
                      <a:lnTo>
                        <a:pt x="2916" y="1927"/>
                      </a:lnTo>
                      <a:lnTo>
                        <a:pt x="2920" y="1929"/>
                      </a:lnTo>
                      <a:lnTo>
                        <a:pt x="2924" y="1929"/>
                      </a:lnTo>
                      <a:lnTo>
                        <a:pt x="2927" y="1928"/>
                      </a:lnTo>
                      <a:lnTo>
                        <a:pt x="2931" y="1928"/>
                      </a:lnTo>
                      <a:lnTo>
                        <a:pt x="2935" y="1929"/>
                      </a:lnTo>
                      <a:lnTo>
                        <a:pt x="2939" y="1929"/>
                      </a:lnTo>
                      <a:lnTo>
                        <a:pt x="2942" y="1929"/>
                      </a:lnTo>
                      <a:lnTo>
                        <a:pt x="2946" y="1928"/>
                      </a:lnTo>
                      <a:lnTo>
                        <a:pt x="2950" y="1928"/>
                      </a:lnTo>
                      <a:lnTo>
                        <a:pt x="2954" y="1929"/>
                      </a:lnTo>
                      <a:lnTo>
                        <a:pt x="2958" y="1929"/>
                      </a:lnTo>
                      <a:lnTo>
                        <a:pt x="2961" y="1929"/>
                      </a:lnTo>
                      <a:lnTo>
                        <a:pt x="2965" y="1929"/>
                      </a:lnTo>
                      <a:lnTo>
                        <a:pt x="2969" y="1929"/>
                      </a:lnTo>
                      <a:lnTo>
                        <a:pt x="2972" y="1929"/>
                      </a:lnTo>
                      <a:lnTo>
                        <a:pt x="2976" y="1930"/>
                      </a:lnTo>
                      <a:lnTo>
                        <a:pt x="2980" y="1929"/>
                      </a:lnTo>
                      <a:lnTo>
                        <a:pt x="2984" y="1930"/>
                      </a:lnTo>
                      <a:lnTo>
                        <a:pt x="2988" y="1929"/>
                      </a:lnTo>
                      <a:lnTo>
                        <a:pt x="2991" y="1929"/>
                      </a:lnTo>
                      <a:lnTo>
                        <a:pt x="2995" y="1929"/>
                      </a:lnTo>
                      <a:lnTo>
                        <a:pt x="2999" y="1930"/>
                      </a:lnTo>
                      <a:lnTo>
                        <a:pt x="3003" y="1930"/>
                      </a:lnTo>
                      <a:lnTo>
                        <a:pt x="3006" y="1929"/>
                      </a:lnTo>
                      <a:lnTo>
                        <a:pt x="3010" y="1929"/>
                      </a:lnTo>
                      <a:lnTo>
                        <a:pt x="3014" y="1928"/>
                      </a:lnTo>
                      <a:lnTo>
                        <a:pt x="3018" y="1928"/>
                      </a:lnTo>
                      <a:lnTo>
                        <a:pt x="3021" y="1928"/>
                      </a:lnTo>
                      <a:lnTo>
                        <a:pt x="3025" y="1929"/>
                      </a:lnTo>
                      <a:lnTo>
                        <a:pt x="3029" y="1928"/>
                      </a:lnTo>
                      <a:lnTo>
                        <a:pt x="3033" y="1928"/>
                      </a:lnTo>
                      <a:lnTo>
                        <a:pt x="3036" y="1928"/>
                      </a:lnTo>
                      <a:lnTo>
                        <a:pt x="3040" y="1928"/>
                      </a:lnTo>
                      <a:lnTo>
                        <a:pt x="3044" y="1928"/>
                      </a:lnTo>
                      <a:lnTo>
                        <a:pt x="3048" y="1927"/>
                      </a:lnTo>
                      <a:lnTo>
                        <a:pt x="3051" y="1927"/>
                      </a:lnTo>
                      <a:lnTo>
                        <a:pt x="3055" y="1928"/>
                      </a:lnTo>
                      <a:lnTo>
                        <a:pt x="3059" y="1928"/>
                      </a:lnTo>
                      <a:lnTo>
                        <a:pt x="3063" y="1927"/>
                      </a:lnTo>
                      <a:lnTo>
                        <a:pt x="3066" y="1927"/>
                      </a:lnTo>
                      <a:lnTo>
                        <a:pt x="3070" y="1927"/>
                      </a:lnTo>
                      <a:lnTo>
                        <a:pt x="3074" y="1927"/>
                      </a:lnTo>
                      <a:lnTo>
                        <a:pt x="3078" y="1927"/>
                      </a:lnTo>
                      <a:lnTo>
                        <a:pt x="3082" y="1926"/>
                      </a:lnTo>
                      <a:lnTo>
                        <a:pt x="3085" y="1926"/>
                      </a:lnTo>
                      <a:lnTo>
                        <a:pt x="3089" y="1927"/>
                      </a:lnTo>
                      <a:lnTo>
                        <a:pt x="3093" y="1926"/>
                      </a:lnTo>
                      <a:lnTo>
                        <a:pt x="3096" y="1926"/>
                      </a:lnTo>
                      <a:lnTo>
                        <a:pt x="3100" y="1926"/>
                      </a:lnTo>
                      <a:lnTo>
                        <a:pt x="3104" y="1927"/>
                      </a:lnTo>
                      <a:lnTo>
                        <a:pt x="3108" y="1926"/>
                      </a:lnTo>
                      <a:lnTo>
                        <a:pt x="3112" y="1924"/>
                      </a:lnTo>
                      <a:lnTo>
                        <a:pt x="3115" y="1925"/>
                      </a:lnTo>
                      <a:lnTo>
                        <a:pt x="3119" y="1925"/>
                      </a:lnTo>
                      <a:lnTo>
                        <a:pt x="3123" y="1925"/>
                      </a:lnTo>
                      <a:lnTo>
                        <a:pt x="3127" y="1925"/>
                      </a:lnTo>
                      <a:lnTo>
                        <a:pt x="3130" y="1924"/>
                      </a:lnTo>
                      <a:lnTo>
                        <a:pt x="3134" y="1924"/>
                      </a:lnTo>
                      <a:lnTo>
                        <a:pt x="3138" y="1924"/>
                      </a:lnTo>
                      <a:lnTo>
                        <a:pt x="3142" y="1924"/>
                      </a:lnTo>
                      <a:lnTo>
                        <a:pt x="3145" y="1923"/>
                      </a:lnTo>
                      <a:lnTo>
                        <a:pt x="3149" y="1924"/>
                      </a:lnTo>
                      <a:lnTo>
                        <a:pt x="3153" y="1923"/>
                      </a:lnTo>
                      <a:lnTo>
                        <a:pt x="3157" y="1923"/>
                      </a:lnTo>
                      <a:lnTo>
                        <a:pt x="3160" y="1922"/>
                      </a:lnTo>
                      <a:lnTo>
                        <a:pt x="3164" y="1923"/>
                      </a:lnTo>
                      <a:lnTo>
                        <a:pt x="3168" y="1923"/>
                      </a:lnTo>
                      <a:lnTo>
                        <a:pt x="3172" y="1922"/>
                      </a:lnTo>
                      <a:lnTo>
                        <a:pt x="3175" y="1921"/>
                      </a:lnTo>
                      <a:lnTo>
                        <a:pt x="3179" y="1922"/>
                      </a:lnTo>
                      <a:lnTo>
                        <a:pt x="3183" y="1922"/>
                      </a:lnTo>
                      <a:lnTo>
                        <a:pt x="3187" y="1921"/>
                      </a:lnTo>
                      <a:lnTo>
                        <a:pt x="3190" y="1921"/>
                      </a:lnTo>
                      <a:lnTo>
                        <a:pt x="3194" y="1921"/>
                      </a:lnTo>
                      <a:lnTo>
                        <a:pt x="3198" y="1921"/>
                      </a:lnTo>
                      <a:lnTo>
                        <a:pt x="3202" y="1921"/>
                      </a:lnTo>
                      <a:lnTo>
                        <a:pt x="3206" y="1921"/>
                      </a:lnTo>
                      <a:lnTo>
                        <a:pt x="3209" y="1920"/>
                      </a:lnTo>
                      <a:lnTo>
                        <a:pt x="3213" y="1920"/>
                      </a:lnTo>
                      <a:lnTo>
                        <a:pt x="3217" y="1919"/>
                      </a:lnTo>
                      <a:lnTo>
                        <a:pt x="3220" y="1919"/>
                      </a:lnTo>
                      <a:lnTo>
                        <a:pt x="3224" y="1919"/>
                      </a:lnTo>
                      <a:lnTo>
                        <a:pt x="3228" y="1919"/>
                      </a:lnTo>
                      <a:lnTo>
                        <a:pt x="3232" y="1918"/>
                      </a:lnTo>
                      <a:lnTo>
                        <a:pt x="3236" y="1919"/>
                      </a:lnTo>
                      <a:lnTo>
                        <a:pt x="3239" y="1918"/>
                      </a:lnTo>
                      <a:lnTo>
                        <a:pt x="3243" y="1917"/>
                      </a:lnTo>
                      <a:lnTo>
                        <a:pt x="3247" y="1918"/>
                      </a:lnTo>
                      <a:lnTo>
                        <a:pt x="3251" y="1917"/>
                      </a:lnTo>
                      <a:lnTo>
                        <a:pt x="3254" y="1918"/>
                      </a:lnTo>
                      <a:lnTo>
                        <a:pt x="3258" y="1916"/>
                      </a:lnTo>
                      <a:lnTo>
                        <a:pt x="3262" y="1916"/>
                      </a:lnTo>
                      <a:lnTo>
                        <a:pt x="3266" y="1915"/>
                      </a:lnTo>
                      <a:lnTo>
                        <a:pt x="3269" y="1914"/>
                      </a:lnTo>
                      <a:lnTo>
                        <a:pt x="3273" y="1913"/>
                      </a:lnTo>
                      <a:lnTo>
                        <a:pt x="3277" y="1912"/>
                      </a:lnTo>
                      <a:lnTo>
                        <a:pt x="3281" y="1913"/>
                      </a:lnTo>
                      <a:lnTo>
                        <a:pt x="3284" y="1911"/>
                      </a:lnTo>
                      <a:lnTo>
                        <a:pt x="3288" y="1910"/>
                      </a:lnTo>
                      <a:lnTo>
                        <a:pt x="3292" y="1909"/>
                      </a:lnTo>
                      <a:lnTo>
                        <a:pt x="3296" y="1909"/>
                      </a:lnTo>
                      <a:lnTo>
                        <a:pt x="3299" y="1908"/>
                      </a:lnTo>
                      <a:lnTo>
                        <a:pt x="3303" y="1907"/>
                      </a:lnTo>
                      <a:lnTo>
                        <a:pt x="3307" y="1907"/>
                      </a:lnTo>
                      <a:lnTo>
                        <a:pt x="3311" y="1905"/>
                      </a:lnTo>
                      <a:lnTo>
                        <a:pt x="3314" y="1904"/>
                      </a:lnTo>
                      <a:lnTo>
                        <a:pt x="3318" y="1902"/>
                      </a:lnTo>
                      <a:lnTo>
                        <a:pt x="3322" y="1901"/>
                      </a:lnTo>
                      <a:lnTo>
                        <a:pt x="3326" y="1900"/>
                      </a:lnTo>
                      <a:lnTo>
                        <a:pt x="3330" y="1899"/>
                      </a:lnTo>
                      <a:lnTo>
                        <a:pt x="3333" y="1897"/>
                      </a:lnTo>
                      <a:lnTo>
                        <a:pt x="3337" y="1895"/>
                      </a:lnTo>
                      <a:lnTo>
                        <a:pt x="3341" y="1895"/>
                      </a:lnTo>
                      <a:lnTo>
                        <a:pt x="3345" y="1892"/>
                      </a:lnTo>
                      <a:lnTo>
                        <a:pt x="3348" y="1890"/>
                      </a:lnTo>
                      <a:lnTo>
                        <a:pt x="3352" y="1889"/>
                      </a:lnTo>
                      <a:lnTo>
                        <a:pt x="3356" y="1887"/>
                      </a:lnTo>
                      <a:lnTo>
                        <a:pt x="3360" y="1885"/>
                      </a:lnTo>
                      <a:lnTo>
                        <a:pt x="3363" y="1883"/>
                      </a:lnTo>
                      <a:lnTo>
                        <a:pt x="3367" y="1881"/>
                      </a:lnTo>
                      <a:lnTo>
                        <a:pt x="3371" y="1879"/>
                      </a:lnTo>
                      <a:lnTo>
                        <a:pt x="3375" y="1876"/>
                      </a:lnTo>
                      <a:lnTo>
                        <a:pt x="3378" y="1874"/>
                      </a:lnTo>
                      <a:lnTo>
                        <a:pt x="3382" y="1871"/>
                      </a:lnTo>
                      <a:lnTo>
                        <a:pt x="3386" y="1869"/>
                      </a:lnTo>
                      <a:lnTo>
                        <a:pt x="3390" y="1866"/>
                      </a:lnTo>
                      <a:lnTo>
                        <a:pt x="3393" y="1864"/>
                      </a:lnTo>
                      <a:lnTo>
                        <a:pt x="3397" y="1863"/>
                      </a:lnTo>
                      <a:lnTo>
                        <a:pt x="3401" y="1860"/>
                      </a:lnTo>
                      <a:lnTo>
                        <a:pt x="3405" y="1859"/>
                      </a:lnTo>
                      <a:lnTo>
                        <a:pt x="3409" y="1858"/>
                      </a:lnTo>
                      <a:lnTo>
                        <a:pt x="3412" y="1856"/>
                      </a:lnTo>
                      <a:lnTo>
                        <a:pt x="3416" y="1855"/>
                      </a:lnTo>
                      <a:lnTo>
                        <a:pt x="3420" y="1853"/>
                      </a:lnTo>
                      <a:lnTo>
                        <a:pt x="3423" y="1852"/>
                      </a:lnTo>
                      <a:lnTo>
                        <a:pt x="3427" y="1850"/>
                      </a:lnTo>
                      <a:lnTo>
                        <a:pt x="3431" y="1851"/>
                      </a:lnTo>
                      <a:lnTo>
                        <a:pt x="3435" y="1851"/>
                      </a:lnTo>
                      <a:lnTo>
                        <a:pt x="3438" y="1850"/>
                      </a:lnTo>
                      <a:lnTo>
                        <a:pt x="3442" y="1848"/>
                      </a:lnTo>
                      <a:lnTo>
                        <a:pt x="3446" y="1848"/>
                      </a:lnTo>
                      <a:lnTo>
                        <a:pt x="3450" y="1846"/>
                      </a:lnTo>
                      <a:lnTo>
                        <a:pt x="3454" y="1846"/>
                      </a:lnTo>
                      <a:lnTo>
                        <a:pt x="3457" y="1844"/>
                      </a:lnTo>
                      <a:lnTo>
                        <a:pt x="3461" y="1843"/>
                      </a:lnTo>
                      <a:lnTo>
                        <a:pt x="3465" y="1840"/>
                      </a:lnTo>
                      <a:lnTo>
                        <a:pt x="3469" y="1837"/>
                      </a:lnTo>
                      <a:lnTo>
                        <a:pt x="3472" y="1835"/>
                      </a:lnTo>
                      <a:lnTo>
                        <a:pt x="3476" y="1831"/>
                      </a:lnTo>
                      <a:lnTo>
                        <a:pt x="3480" y="1827"/>
                      </a:lnTo>
                      <a:lnTo>
                        <a:pt x="3483" y="1823"/>
                      </a:lnTo>
                      <a:lnTo>
                        <a:pt x="3487" y="1818"/>
                      </a:lnTo>
                      <a:lnTo>
                        <a:pt x="3491" y="1812"/>
                      </a:lnTo>
                      <a:lnTo>
                        <a:pt x="3495" y="1806"/>
                      </a:lnTo>
                      <a:lnTo>
                        <a:pt x="3499" y="1800"/>
                      </a:lnTo>
                      <a:lnTo>
                        <a:pt x="3502" y="1792"/>
                      </a:lnTo>
                      <a:lnTo>
                        <a:pt x="3506" y="1785"/>
                      </a:lnTo>
                      <a:lnTo>
                        <a:pt x="3510" y="1777"/>
                      </a:lnTo>
                      <a:lnTo>
                        <a:pt x="3514" y="1768"/>
                      </a:lnTo>
                      <a:lnTo>
                        <a:pt x="3517" y="1760"/>
                      </a:lnTo>
                      <a:lnTo>
                        <a:pt x="3521" y="1751"/>
                      </a:lnTo>
                      <a:lnTo>
                        <a:pt x="3525" y="1742"/>
                      </a:lnTo>
                      <a:lnTo>
                        <a:pt x="3529" y="1733"/>
                      </a:lnTo>
                      <a:lnTo>
                        <a:pt x="3533" y="1723"/>
                      </a:lnTo>
                      <a:lnTo>
                        <a:pt x="3536" y="1713"/>
                      </a:lnTo>
                      <a:lnTo>
                        <a:pt x="3540" y="1703"/>
                      </a:lnTo>
                      <a:lnTo>
                        <a:pt x="3544" y="1693"/>
                      </a:lnTo>
                      <a:lnTo>
                        <a:pt x="3547" y="1684"/>
                      </a:lnTo>
                      <a:lnTo>
                        <a:pt x="3551" y="1672"/>
                      </a:lnTo>
                      <a:lnTo>
                        <a:pt x="3555" y="1661"/>
                      </a:lnTo>
                      <a:lnTo>
                        <a:pt x="3559" y="1650"/>
                      </a:lnTo>
                      <a:lnTo>
                        <a:pt x="3562" y="1639"/>
                      </a:lnTo>
                      <a:lnTo>
                        <a:pt x="3566" y="1626"/>
                      </a:lnTo>
                      <a:lnTo>
                        <a:pt x="3570" y="1613"/>
                      </a:lnTo>
                      <a:lnTo>
                        <a:pt x="3574" y="1598"/>
                      </a:lnTo>
                      <a:lnTo>
                        <a:pt x="3578" y="1583"/>
                      </a:lnTo>
                      <a:lnTo>
                        <a:pt x="3581" y="1566"/>
                      </a:lnTo>
                      <a:lnTo>
                        <a:pt x="3585" y="1547"/>
                      </a:lnTo>
                      <a:lnTo>
                        <a:pt x="3589" y="1525"/>
                      </a:lnTo>
                      <a:lnTo>
                        <a:pt x="3593" y="1501"/>
                      </a:lnTo>
                      <a:lnTo>
                        <a:pt x="3596" y="1474"/>
                      </a:lnTo>
                      <a:lnTo>
                        <a:pt x="3600" y="1443"/>
                      </a:lnTo>
                      <a:lnTo>
                        <a:pt x="3604" y="1409"/>
                      </a:lnTo>
                      <a:lnTo>
                        <a:pt x="3607" y="1372"/>
                      </a:lnTo>
                      <a:lnTo>
                        <a:pt x="3611" y="1329"/>
                      </a:lnTo>
                      <a:lnTo>
                        <a:pt x="3615" y="1283"/>
                      </a:lnTo>
                      <a:lnTo>
                        <a:pt x="3619" y="1232"/>
                      </a:lnTo>
                      <a:lnTo>
                        <a:pt x="3623" y="1179"/>
                      </a:lnTo>
                      <a:lnTo>
                        <a:pt x="3626" y="1121"/>
                      </a:lnTo>
                      <a:lnTo>
                        <a:pt x="3630" y="1061"/>
                      </a:lnTo>
                      <a:lnTo>
                        <a:pt x="3634" y="999"/>
                      </a:lnTo>
                      <a:lnTo>
                        <a:pt x="3638" y="936"/>
                      </a:lnTo>
                      <a:lnTo>
                        <a:pt x="3641" y="871"/>
                      </a:lnTo>
                      <a:lnTo>
                        <a:pt x="3645" y="804"/>
                      </a:lnTo>
                      <a:lnTo>
                        <a:pt x="3649" y="737"/>
                      </a:lnTo>
                      <a:lnTo>
                        <a:pt x="3653" y="672"/>
                      </a:lnTo>
                      <a:lnTo>
                        <a:pt x="3656" y="606"/>
                      </a:lnTo>
                      <a:lnTo>
                        <a:pt x="3660" y="543"/>
                      </a:lnTo>
                      <a:lnTo>
                        <a:pt x="3664" y="482"/>
                      </a:lnTo>
                      <a:lnTo>
                        <a:pt x="3668" y="424"/>
                      </a:lnTo>
                      <a:lnTo>
                        <a:pt x="3671" y="370"/>
                      </a:lnTo>
                      <a:lnTo>
                        <a:pt x="3675" y="320"/>
                      </a:lnTo>
                      <a:lnTo>
                        <a:pt x="3679" y="273"/>
                      </a:lnTo>
                      <a:lnTo>
                        <a:pt x="3683" y="231"/>
                      </a:lnTo>
                      <a:lnTo>
                        <a:pt x="3686" y="192"/>
                      </a:lnTo>
                      <a:lnTo>
                        <a:pt x="3690" y="157"/>
                      </a:lnTo>
                      <a:lnTo>
                        <a:pt x="3694" y="124"/>
                      </a:lnTo>
                      <a:lnTo>
                        <a:pt x="3698" y="95"/>
                      </a:lnTo>
                      <a:lnTo>
                        <a:pt x="3702" y="68"/>
                      </a:lnTo>
                      <a:lnTo>
                        <a:pt x="3705" y="46"/>
                      </a:lnTo>
                      <a:lnTo>
                        <a:pt x="3709" y="28"/>
                      </a:lnTo>
                      <a:lnTo>
                        <a:pt x="3713" y="13"/>
                      </a:lnTo>
                      <a:lnTo>
                        <a:pt x="3717" y="5"/>
                      </a:lnTo>
                      <a:lnTo>
                        <a:pt x="3720" y="0"/>
                      </a:lnTo>
                      <a:lnTo>
                        <a:pt x="3724" y="1"/>
                      </a:lnTo>
                      <a:lnTo>
                        <a:pt x="3728" y="6"/>
                      </a:lnTo>
                      <a:lnTo>
                        <a:pt x="3731" y="16"/>
                      </a:lnTo>
                      <a:lnTo>
                        <a:pt x="3735" y="31"/>
                      </a:lnTo>
                      <a:lnTo>
                        <a:pt x="3739" y="51"/>
                      </a:lnTo>
                      <a:lnTo>
                        <a:pt x="3743" y="76"/>
                      </a:lnTo>
                      <a:lnTo>
                        <a:pt x="3747" y="105"/>
                      </a:lnTo>
                      <a:lnTo>
                        <a:pt x="3750" y="138"/>
                      </a:lnTo>
                      <a:lnTo>
                        <a:pt x="3754" y="175"/>
                      </a:lnTo>
                      <a:lnTo>
                        <a:pt x="3758" y="214"/>
                      </a:lnTo>
                      <a:lnTo>
                        <a:pt x="3762" y="255"/>
                      </a:lnTo>
                      <a:lnTo>
                        <a:pt x="3765" y="299"/>
                      </a:lnTo>
                      <a:lnTo>
                        <a:pt x="3769" y="345"/>
                      </a:lnTo>
                      <a:lnTo>
                        <a:pt x="3773" y="392"/>
                      </a:lnTo>
                      <a:lnTo>
                        <a:pt x="3777" y="440"/>
                      </a:lnTo>
                      <a:lnTo>
                        <a:pt x="3780" y="490"/>
                      </a:lnTo>
                      <a:lnTo>
                        <a:pt x="3784" y="538"/>
                      </a:lnTo>
                      <a:lnTo>
                        <a:pt x="3788" y="587"/>
                      </a:lnTo>
                      <a:lnTo>
                        <a:pt x="3792" y="636"/>
                      </a:lnTo>
                      <a:lnTo>
                        <a:pt x="3795" y="684"/>
                      </a:lnTo>
                      <a:lnTo>
                        <a:pt x="3799" y="732"/>
                      </a:lnTo>
                      <a:lnTo>
                        <a:pt x="3803" y="779"/>
                      </a:lnTo>
                      <a:lnTo>
                        <a:pt x="3807" y="824"/>
                      </a:lnTo>
                      <a:lnTo>
                        <a:pt x="3810" y="870"/>
                      </a:lnTo>
                      <a:lnTo>
                        <a:pt x="3814" y="914"/>
                      </a:lnTo>
                      <a:lnTo>
                        <a:pt x="3818" y="957"/>
                      </a:lnTo>
                      <a:lnTo>
                        <a:pt x="3822" y="999"/>
                      </a:lnTo>
                      <a:lnTo>
                        <a:pt x="3826" y="1041"/>
                      </a:lnTo>
                      <a:lnTo>
                        <a:pt x="3829" y="1081"/>
                      </a:lnTo>
                      <a:lnTo>
                        <a:pt x="3833" y="1120"/>
                      </a:lnTo>
                      <a:lnTo>
                        <a:pt x="3837" y="1158"/>
                      </a:lnTo>
                      <a:lnTo>
                        <a:pt x="3841" y="1195"/>
                      </a:lnTo>
                      <a:lnTo>
                        <a:pt x="3844" y="1230"/>
                      </a:lnTo>
                      <a:lnTo>
                        <a:pt x="3848" y="1265"/>
                      </a:lnTo>
                      <a:lnTo>
                        <a:pt x="3852" y="1299"/>
                      </a:lnTo>
                      <a:lnTo>
                        <a:pt x="3856" y="1332"/>
                      </a:lnTo>
                      <a:lnTo>
                        <a:pt x="3859" y="1363"/>
                      </a:lnTo>
                      <a:lnTo>
                        <a:pt x="3863" y="1394"/>
                      </a:lnTo>
                      <a:lnTo>
                        <a:pt x="3867" y="1425"/>
                      </a:lnTo>
                      <a:lnTo>
                        <a:pt x="3871" y="1454"/>
                      </a:lnTo>
                      <a:lnTo>
                        <a:pt x="3874" y="1481"/>
                      </a:lnTo>
                      <a:lnTo>
                        <a:pt x="3878" y="1509"/>
                      </a:lnTo>
                      <a:lnTo>
                        <a:pt x="3882" y="1534"/>
                      </a:lnTo>
                      <a:lnTo>
                        <a:pt x="3886" y="1560"/>
                      </a:lnTo>
                      <a:lnTo>
                        <a:pt x="3889" y="1585"/>
                      </a:lnTo>
                      <a:lnTo>
                        <a:pt x="3893" y="1607"/>
                      </a:lnTo>
                      <a:lnTo>
                        <a:pt x="3897" y="1630"/>
                      </a:lnTo>
                      <a:lnTo>
                        <a:pt x="3901" y="1651"/>
                      </a:lnTo>
                      <a:lnTo>
                        <a:pt x="3904" y="1671"/>
                      </a:lnTo>
                      <a:lnTo>
                        <a:pt x="3908" y="1690"/>
                      </a:lnTo>
                      <a:lnTo>
                        <a:pt x="3912" y="1707"/>
                      </a:lnTo>
                      <a:lnTo>
                        <a:pt x="3916" y="1724"/>
                      </a:lnTo>
                      <a:lnTo>
                        <a:pt x="3920" y="1740"/>
                      </a:lnTo>
                      <a:lnTo>
                        <a:pt x="3923" y="1756"/>
                      </a:lnTo>
                      <a:lnTo>
                        <a:pt x="3927" y="1769"/>
                      </a:lnTo>
                      <a:lnTo>
                        <a:pt x="3931" y="1781"/>
                      </a:lnTo>
                      <a:lnTo>
                        <a:pt x="3934" y="1792"/>
                      </a:lnTo>
                      <a:lnTo>
                        <a:pt x="3938" y="1804"/>
                      </a:lnTo>
                      <a:lnTo>
                        <a:pt x="3942" y="1814"/>
                      </a:lnTo>
                      <a:lnTo>
                        <a:pt x="3946" y="1824"/>
                      </a:lnTo>
                      <a:lnTo>
                        <a:pt x="3950" y="1832"/>
                      </a:lnTo>
                      <a:lnTo>
                        <a:pt x="3953" y="1841"/>
                      </a:lnTo>
                      <a:lnTo>
                        <a:pt x="3957" y="1848"/>
                      </a:lnTo>
                      <a:lnTo>
                        <a:pt x="3961" y="1855"/>
                      </a:lnTo>
                      <a:lnTo>
                        <a:pt x="3965" y="1861"/>
                      </a:lnTo>
                      <a:lnTo>
                        <a:pt x="3968" y="1867"/>
                      </a:lnTo>
                      <a:lnTo>
                        <a:pt x="3972" y="1872"/>
                      </a:lnTo>
                      <a:lnTo>
                        <a:pt x="3976" y="1877"/>
                      </a:lnTo>
                      <a:lnTo>
                        <a:pt x="3980" y="1882"/>
                      </a:lnTo>
                      <a:lnTo>
                        <a:pt x="3983" y="1887"/>
                      </a:lnTo>
                      <a:lnTo>
                        <a:pt x="3987" y="1889"/>
                      </a:lnTo>
                      <a:lnTo>
                        <a:pt x="3991" y="1894"/>
                      </a:lnTo>
                      <a:lnTo>
                        <a:pt x="3995" y="1896"/>
                      </a:lnTo>
                      <a:lnTo>
                        <a:pt x="3998" y="1899"/>
                      </a:lnTo>
                      <a:lnTo>
                        <a:pt x="4002" y="1903"/>
                      </a:lnTo>
                      <a:lnTo>
                        <a:pt x="4006" y="1905"/>
                      </a:lnTo>
                      <a:lnTo>
                        <a:pt x="4010" y="1907"/>
                      </a:lnTo>
                      <a:lnTo>
                        <a:pt x="4013" y="1910"/>
                      </a:lnTo>
                      <a:lnTo>
                        <a:pt x="4017" y="1911"/>
                      </a:lnTo>
                      <a:lnTo>
                        <a:pt x="4021" y="1913"/>
                      </a:lnTo>
                      <a:lnTo>
                        <a:pt x="4025" y="1916"/>
                      </a:lnTo>
                      <a:lnTo>
                        <a:pt x="4028" y="1916"/>
                      </a:lnTo>
                      <a:lnTo>
                        <a:pt x="4032" y="1917"/>
                      </a:lnTo>
                      <a:lnTo>
                        <a:pt x="4036" y="1918"/>
                      </a:lnTo>
                      <a:lnTo>
                        <a:pt x="4040" y="1919"/>
                      </a:lnTo>
                      <a:lnTo>
                        <a:pt x="4044" y="1921"/>
                      </a:lnTo>
                      <a:lnTo>
                        <a:pt x="4047" y="1922"/>
                      </a:lnTo>
                      <a:lnTo>
                        <a:pt x="4051" y="1923"/>
                      </a:lnTo>
                      <a:lnTo>
                        <a:pt x="4055" y="1923"/>
                      </a:lnTo>
                      <a:lnTo>
                        <a:pt x="4058" y="1924"/>
                      </a:lnTo>
                      <a:lnTo>
                        <a:pt x="4062" y="1924"/>
                      </a:lnTo>
                      <a:lnTo>
                        <a:pt x="4066" y="1925"/>
                      </a:lnTo>
                      <a:lnTo>
                        <a:pt x="4070" y="1925"/>
                      </a:lnTo>
                      <a:lnTo>
                        <a:pt x="4074" y="1926"/>
                      </a:lnTo>
                      <a:lnTo>
                        <a:pt x="4077" y="1927"/>
                      </a:lnTo>
                      <a:lnTo>
                        <a:pt x="4081" y="1927"/>
                      </a:lnTo>
                      <a:lnTo>
                        <a:pt x="4085" y="1928"/>
                      </a:lnTo>
                      <a:lnTo>
                        <a:pt x="4089" y="1928"/>
                      </a:lnTo>
                      <a:lnTo>
                        <a:pt x="4092" y="1928"/>
                      </a:lnTo>
                      <a:lnTo>
                        <a:pt x="4096" y="1928"/>
                      </a:lnTo>
                      <a:lnTo>
                        <a:pt x="4100" y="1929"/>
                      </a:lnTo>
                      <a:lnTo>
                        <a:pt x="4104" y="1929"/>
                      </a:lnTo>
                      <a:lnTo>
                        <a:pt x="4107" y="1929"/>
                      </a:lnTo>
                      <a:lnTo>
                        <a:pt x="4111" y="1930"/>
                      </a:lnTo>
                      <a:lnTo>
                        <a:pt x="4115" y="1930"/>
                      </a:lnTo>
                      <a:lnTo>
                        <a:pt x="4119" y="1930"/>
                      </a:lnTo>
                      <a:lnTo>
                        <a:pt x="4122" y="1931"/>
                      </a:lnTo>
                      <a:lnTo>
                        <a:pt x="4126" y="1930"/>
                      </a:lnTo>
                      <a:lnTo>
                        <a:pt x="4130" y="1931"/>
                      </a:lnTo>
                      <a:lnTo>
                        <a:pt x="4134" y="1930"/>
                      </a:lnTo>
                      <a:lnTo>
                        <a:pt x="4137" y="1931"/>
                      </a:lnTo>
                      <a:lnTo>
                        <a:pt x="4141" y="1931"/>
                      </a:lnTo>
                      <a:lnTo>
                        <a:pt x="4145" y="1931"/>
                      </a:lnTo>
                      <a:lnTo>
                        <a:pt x="4149" y="1932"/>
                      </a:lnTo>
                      <a:lnTo>
                        <a:pt x="4152" y="1932"/>
                      </a:lnTo>
                      <a:lnTo>
                        <a:pt x="4156" y="1932"/>
                      </a:lnTo>
                      <a:lnTo>
                        <a:pt x="4160" y="1932"/>
                      </a:lnTo>
                      <a:lnTo>
                        <a:pt x="4164" y="1932"/>
                      </a:lnTo>
                      <a:lnTo>
                        <a:pt x="4168" y="1932"/>
                      </a:lnTo>
                      <a:lnTo>
                        <a:pt x="4171" y="1932"/>
                      </a:lnTo>
                      <a:lnTo>
                        <a:pt x="4175" y="1933"/>
                      </a:lnTo>
                      <a:lnTo>
                        <a:pt x="4179" y="1934"/>
                      </a:lnTo>
                      <a:lnTo>
                        <a:pt x="4182" y="1933"/>
                      </a:lnTo>
                      <a:lnTo>
                        <a:pt x="4186" y="1933"/>
                      </a:lnTo>
                      <a:lnTo>
                        <a:pt x="4190" y="1933"/>
                      </a:lnTo>
                      <a:lnTo>
                        <a:pt x="4194" y="1933"/>
                      </a:lnTo>
                      <a:lnTo>
                        <a:pt x="4197" y="1934"/>
                      </a:lnTo>
                      <a:lnTo>
                        <a:pt x="4201" y="1934"/>
                      </a:lnTo>
                      <a:lnTo>
                        <a:pt x="4205" y="1933"/>
                      </a:lnTo>
                      <a:lnTo>
                        <a:pt x="4209" y="1934"/>
                      </a:lnTo>
                      <a:lnTo>
                        <a:pt x="4213" y="1933"/>
                      </a:lnTo>
                      <a:lnTo>
                        <a:pt x="4216" y="1933"/>
                      </a:lnTo>
                      <a:lnTo>
                        <a:pt x="4220" y="1933"/>
                      </a:lnTo>
                      <a:lnTo>
                        <a:pt x="4224" y="1933"/>
                      </a:lnTo>
                      <a:lnTo>
                        <a:pt x="4228" y="1934"/>
                      </a:lnTo>
                      <a:lnTo>
                        <a:pt x="4231" y="1934"/>
                      </a:lnTo>
                      <a:lnTo>
                        <a:pt x="4235" y="1934"/>
                      </a:lnTo>
                      <a:lnTo>
                        <a:pt x="4239" y="1933"/>
                      </a:lnTo>
                      <a:lnTo>
                        <a:pt x="4243" y="1933"/>
                      </a:lnTo>
                      <a:lnTo>
                        <a:pt x="4246" y="1933"/>
                      </a:lnTo>
                      <a:lnTo>
                        <a:pt x="4250" y="1934"/>
                      </a:lnTo>
                      <a:lnTo>
                        <a:pt x="4254" y="1934"/>
                      </a:lnTo>
                      <a:lnTo>
                        <a:pt x="4258" y="1933"/>
                      </a:lnTo>
                      <a:lnTo>
                        <a:pt x="4261" y="1934"/>
                      </a:lnTo>
                      <a:lnTo>
                        <a:pt x="4265" y="1934"/>
                      </a:lnTo>
                      <a:lnTo>
                        <a:pt x="4269" y="1934"/>
                      </a:lnTo>
                      <a:lnTo>
                        <a:pt x="4273" y="1933"/>
                      </a:lnTo>
                      <a:lnTo>
                        <a:pt x="4276" y="1934"/>
                      </a:lnTo>
                      <a:lnTo>
                        <a:pt x="4280" y="1933"/>
                      </a:lnTo>
                      <a:lnTo>
                        <a:pt x="4284" y="1934"/>
                      </a:lnTo>
                      <a:lnTo>
                        <a:pt x="4288" y="1934"/>
                      </a:lnTo>
                      <a:lnTo>
                        <a:pt x="4292" y="1933"/>
                      </a:lnTo>
                      <a:lnTo>
                        <a:pt x="4295" y="1934"/>
                      </a:lnTo>
                      <a:lnTo>
                        <a:pt x="4299" y="1933"/>
                      </a:lnTo>
                      <a:lnTo>
                        <a:pt x="4303" y="1933"/>
                      </a:lnTo>
                      <a:lnTo>
                        <a:pt x="4307" y="1934"/>
                      </a:lnTo>
                      <a:lnTo>
                        <a:pt x="4310" y="1934"/>
                      </a:lnTo>
                      <a:lnTo>
                        <a:pt x="4314" y="1933"/>
                      </a:lnTo>
                      <a:lnTo>
                        <a:pt x="4318" y="1934"/>
                      </a:lnTo>
                      <a:lnTo>
                        <a:pt x="4321" y="1933"/>
                      </a:lnTo>
                      <a:lnTo>
                        <a:pt x="4325" y="1933"/>
                      </a:lnTo>
                      <a:lnTo>
                        <a:pt x="4329" y="1933"/>
                      </a:lnTo>
                      <a:lnTo>
                        <a:pt x="4333" y="1933"/>
                      </a:lnTo>
                      <a:lnTo>
                        <a:pt x="4337" y="1934"/>
                      </a:lnTo>
                      <a:lnTo>
                        <a:pt x="4340" y="1933"/>
                      </a:lnTo>
                      <a:lnTo>
                        <a:pt x="4344" y="1934"/>
                      </a:lnTo>
                      <a:lnTo>
                        <a:pt x="4348" y="1934"/>
                      </a:lnTo>
                      <a:lnTo>
                        <a:pt x="4352" y="1934"/>
                      </a:lnTo>
                      <a:lnTo>
                        <a:pt x="4355" y="1933"/>
                      </a:lnTo>
                      <a:lnTo>
                        <a:pt x="4359" y="1934"/>
                      </a:lnTo>
                      <a:lnTo>
                        <a:pt x="4363" y="1934"/>
                      </a:lnTo>
                      <a:lnTo>
                        <a:pt x="4367" y="1933"/>
                      </a:lnTo>
                      <a:lnTo>
                        <a:pt x="4370" y="1934"/>
                      </a:lnTo>
                      <a:lnTo>
                        <a:pt x="4374" y="1933"/>
                      </a:lnTo>
                      <a:lnTo>
                        <a:pt x="4378" y="1935"/>
                      </a:lnTo>
                      <a:lnTo>
                        <a:pt x="4382" y="1934"/>
                      </a:lnTo>
                      <a:lnTo>
                        <a:pt x="4385" y="1934"/>
                      </a:lnTo>
                      <a:lnTo>
                        <a:pt x="4389" y="1934"/>
                      </a:lnTo>
                      <a:lnTo>
                        <a:pt x="4393" y="1934"/>
                      </a:lnTo>
                      <a:lnTo>
                        <a:pt x="4397" y="1934"/>
                      </a:lnTo>
                      <a:lnTo>
                        <a:pt x="4400" y="1933"/>
                      </a:lnTo>
                      <a:lnTo>
                        <a:pt x="4404" y="1934"/>
                      </a:lnTo>
                      <a:lnTo>
                        <a:pt x="4408" y="1934"/>
                      </a:lnTo>
                      <a:lnTo>
                        <a:pt x="4412" y="1934"/>
                      </a:lnTo>
                      <a:lnTo>
                        <a:pt x="4416" y="1934"/>
                      </a:lnTo>
                      <a:lnTo>
                        <a:pt x="4419" y="1935"/>
                      </a:lnTo>
                      <a:lnTo>
                        <a:pt x="4423" y="1934"/>
                      </a:lnTo>
                      <a:lnTo>
                        <a:pt x="4427" y="1934"/>
                      </a:lnTo>
                      <a:lnTo>
                        <a:pt x="4431" y="1934"/>
                      </a:lnTo>
                      <a:lnTo>
                        <a:pt x="4434" y="1934"/>
                      </a:lnTo>
                      <a:lnTo>
                        <a:pt x="4438" y="1935"/>
                      </a:lnTo>
                      <a:lnTo>
                        <a:pt x="4442" y="1935"/>
                      </a:lnTo>
                      <a:lnTo>
                        <a:pt x="4445" y="1934"/>
                      </a:lnTo>
                      <a:lnTo>
                        <a:pt x="4449" y="1934"/>
                      </a:lnTo>
                      <a:lnTo>
                        <a:pt x="4453" y="1935"/>
                      </a:lnTo>
                      <a:lnTo>
                        <a:pt x="4457" y="1934"/>
                      </a:lnTo>
                      <a:lnTo>
                        <a:pt x="4461" y="1934"/>
                      </a:lnTo>
                      <a:lnTo>
                        <a:pt x="4464" y="1934"/>
                      </a:lnTo>
                      <a:lnTo>
                        <a:pt x="4468" y="1935"/>
                      </a:lnTo>
                      <a:lnTo>
                        <a:pt x="4472" y="1934"/>
                      </a:lnTo>
                      <a:lnTo>
                        <a:pt x="4476" y="1934"/>
                      </a:lnTo>
                      <a:lnTo>
                        <a:pt x="4479" y="1934"/>
                      </a:lnTo>
                      <a:lnTo>
                        <a:pt x="4483" y="1935"/>
                      </a:lnTo>
                      <a:lnTo>
                        <a:pt x="4487" y="1935"/>
                      </a:lnTo>
                      <a:lnTo>
                        <a:pt x="4491" y="1935"/>
                      </a:lnTo>
                      <a:lnTo>
                        <a:pt x="4494" y="1935"/>
                      </a:lnTo>
                      <a:lnTo>
                        <a:pt x="4498" y="1934"/>
                      </a:lnTo>
                      <a:lnTo>
                        <a:pt x="4502" y="1934"/>
                      </a:lnTo>
                      <a:lnTo>
                        <a:pt x="4506" y="1935"/>
                      </a:lnTo>
                      <a:lnTo>
                        <a:pt x="4509" y="1934"/>
                      </a:lnTo>
                      <a:lnTo>
                        <a:pt x="4513" y="1935"/>
                      </a:lnTo>
                      <a:lnTo>
                        <a:pt x="4517" y="1935"/>
                      </a:lnTo>
                      <a:lnTo>
                        <a:pt x="4521" y="1935"/>
                      </a:lnTo>
                      <a:lnTo>
                        <a:pt x="4524" y="1935"/>
                      </a:lnTo>
                      <a:lnTo>
                        <a:pt x="4528" y="1936"/>
                      </a:lnTo>
                      <a:lnTo>
                        <a:pt x="4532" y="1935"/>
                      </a:lnTo>
                      <a:lnTo>
                        <a:pt x="4536" y="1935"/>
                      </a:lnTo>
                      <a:lnTo>
                        <a:pt x="4540" y="1935"/>
                      </a:lnTo>
                      <a:lnTo>
                        <a:pt x="4543" y="1935"/>
                      </a:lnTo>
                      <a:lnTo>
                        <a:pt x="4547" y="1935"/>
                      </a:lnTo>
                      <a:lnTo>
                        <a:pt x="4551" y="1934"/>
                      </a:lnTo>
                      <a:lnTo>
                        <a:pt x="4555" y="1934"/>
                      </a:lnTo>
                      <a:lnTo>
                        <a:pt x="4558" y="1935"/>
                      </a:lnTo>
                      <a:lnTo>
                        <a:pt x="4562" y="1935"/>
                      </a:lnTo>
                      <a:lnTo>
                        <a:pt x="4566" y="1935"/>
                      </a:lnTo>
                      <a:lnTo>
                        <a:pt x="4569" y="1935"/>
                      </a:lnTo>
                      <a:lnTo>
                        <a:pt x="4573" y="1935"/>
                      </a:lnTo>
                      <a:lnTo>
                        <a:pt x="4577" y="1935"/>
                      </a:lnTo>
                      <a:lnTo>
                        <a:pt x="4581" y="1935"/>
                      </a:lnTo>
                      <a:lnTo>
                        <a:pt x="4585" y="1935"/>
                      </a:lnTo>
                      <a:lnTo>
                        <a:pt x="4588" y="1935"/>
                      </a:lnTo>
                      <a:lnTo>
                        <a:pt x="4592" y="1935"/>
                      </a:lnTo>
                      <a:lnTo>
                        <a:pt x="4596" y="1935"/>
                      </a:lnTo>
                      <a:lnTo>
                        <a:pt x="4600" y="1935"/>
                      </a:lnTo>
                      <a:lnTo>
                        <a:pt x="4603" y="1936"/>
                      </a:lnTo>
                      <a:lnTo>
                        <a:pt x="4607" y="1935"/>
                      </a:lnTo>
                      <a:lnTo>
                        <a:pt x="4611" y="1935"/>
                      </a:lnTo>
                      <a:lnTo>
                        <a:pt x="4615" y="1935"/>
                      </a:lnTo>
                      <a:lnTo>
                        <a:pt x="4618" y="1935"/>
                      </a:lnTo>
                      <a:lnTo>
                        <a:pt x="4622" y="1937"/>
                      </a:lnTo>
                      <a:lnTo>
                        <a:pt x="4626" y="1936"/>
                      </a:lnTo>
                      <a:lnTo>
                        <a:pt x="4630" y="1935"/>
                      </a:lnTo>
                      <a:lnTo>
                        <a:pt x="4633" y="1935"/>
                      </a:lnTo>
                      <a:lnTo>
                        <a:pt x="4637" y="1936"/>
                      </a:lnTo>
                      <a:lnTo>
                        <a:pt x="4641" y="1935"/>
                      </a:lnTo>
                      <a:lnTo>
                        <a:pt x="4645" y="1936"/>
                      </a:lnTo>
                      <a:lnTo>
                        <a:pt x="4648" y="1936"/>
                      </a:lnTo>
                      <a:lnTo>
                        <a:pt x="4652" y="1936"/>
                      </a:lnTo>
                      <a:lnTo>
                        <a:pt x="4656" y="1936"/>
                      </a:lnTo>
                      <a:lnTo>
                        <a:pt x="4660" y="1935"/>
                      </a:lnTo>
                      <a:lnTo>
                        <a:pt x="4664" y="1936"/>
                      </a:lnTo>
                      <a:lnTo>
                        <a:pt x="4667" y="1936"/>
                      </a:lnTo>
                      <a:lnTo>
                        <a:pt x="4671" y="1936"/>
                      </a:lnTo>
                      <a:lnTo>
                        <a:pt x="4675" y="1936"/>
                      </a:lnTo>
                      <a:lnTo>
                        <a:pt x="4679" y="1936"/>
                      </a:lnTo>
                      <a:lnTo>
                        <a:pt x="4682" y="1936"/>
                      </a:lnTo>
                      <a:lnTo>
                        <a:pt x="4686" y="1936"/>
                      </a:lnTo>
                      <a:lnTo>
                        <a:pt x="4690" y="1936"/>
                      </a:lnTo>
                      <a:lnTo>
                        <a:pt x="4694" y="1936"/>
                      </a:lnTo>
                      <a:lnTo>
                        <a:pt x="4697" y="1936"/>
                      </a:lnTo>
                      <a:lnTo>
                        <a:pt x="4701" y="1936"/>
                      </a:lnTo>
                      <a:lnTo>
                        <a:pt x="4705" y="1936"/>
                      </a:lnTo>
                      <a:lnTo>
                        <a:pt x="4709" y="1936"/>
                      </a:lnTo>
                      <a:lnTo>
                        <a:pt x="4712" y="1935"/>
                      </a:lnTo>
                      <a:lnTo>
                        <a:pt x="4716" y="1936"/>
                      </a:lnTo>
                      <a:lnTo>
                        <a:pt x="4720" y="1937"/>
                      </a:lnTo>
                      <a:lnTo>
                        <a:pt x="4724" y="1936"/>
                      </a:lnTo>
                      <a:lnTo>
                        <a:pt x="4727" y="1937"/>
                      </a:lnTo>
                      <a:lnTo>
                        <a:pt x="4731" y="1936"/>
                      </a:lnTo>
                      <a:lnTo>
                        <a:pt x="4735" y="1936"/>
                      </a:lnTo>
                      <a:lnTo>
                        <a:pt x="4739" y="1937"/>
                      </a:lnTo>
                      <a:lnTo>
                        <a:pt x="4742" y="1937"/>
                      </a:lnTo>
                      <a:lnTo>
                        <a:pt x="4746" y="1937"/>
                      </a:lnTo>
                      <a:lnTo>
                        <a:pt x="4750" y="1937"/>
                      </a:lnTo>
                      <a:lnTo>
                        <a:pt x="4754" y="1936"/>
                      </a:lnTo>
                      <a:lnTo>
                        <a:pt x="4758" y="1936"/>
                      </a:lnTo>
                      <a:lnTo>
                        <a:pt x="4761" y="1937"/>
                      </a:lnTo>
                      <a:lnTo>
                        <a:pt x="4765" y="1936"/>
                      </a:lnTo>
                      <a:lnTo>
                        <a:pt x="4769" y="1937"/>
                      </a:lnTo>
                      <a:lnTo>
                        <a:pt x="4772" y="1937"/>
                      </a:lnTo>
                      <a:lnTo>
                        <a:pt x="4776" y="1937"/>
                      </a:lnTo>
                      <a:lnTo>
                        <a:pt x="4780" y="1936"/>
                      </a:lnTo>
                      <a:lnTo>
                        <a:pt x="4784" y="1936"/>
                      </a:lnTo>
                      <a:lnTo>
                        <a:pt x="4787" y="1936"/>
                      </a:lnTo>
                      <a:lnTo>
                        <a:pt x="4791" y="1937"/>
                      </a:lnTo>
                      <a:lnTo>
                        <a:pt x="4795" y="1937"/>
                      </a:lnTo>
                      <a:lnTo>
                        <a:pt x="4799" y="1936"/>
                      </a:lnTo>
                      <a:lnTo>
                        <a:pt x="4803" y="1937"/>
                      </a:lnTo>
                      <a:lnTo>
                        <a:pt x="4806" y="1936"/>
                      </a:lnTo>
                      <a:lnTo>
                        <a:pt x="4810" y="1937"/>
                      </a:lnTo>
                      <a:lnTo>
                        <a:pt x="4814" y="1936"/>
                      </a:lnTo>
                      <a:lnTo>
                        <a:pt x="4818" y="1936"/>
                      </a:lnTo>
                      <a:lnTo>
                        <a:pt x="4821" y="1936"/>
                      </a:lnTo>
                      <a:lnTo>
                        <a:pt x="4825" y="1936"/>
                      </a:lnTo>
                      <a:lnTo>
                        <a:pt x="4829" y="1936"/>
                      </a:lnTo>
                      <a:lnTo>
                        <a:pt x="4833" y="1936"/>
                      </a:lnTo>
                      <a:lnTo>
                        <a:pt x="4836" y="1937"/>
                      </a:lnTo>
                      <a:lnTo>
                        <a:pt x="4840" y="1936"/>
                      </a:lnTo>
                      <a:lnTo>
                        <a:pt x="4844" y="1936"/>
                      </a:lnTo>
                      <a:lnTo>
                        <a:pt x="4848" y="1936"/>
                      </a:lnTo>
                      <a:lnTo>
                        <a:pt x="4851" y="1936"/>
                      </a:lnTo>
                      <a:lnTo>
                        <a:pt x="4855" y="1937"/>
                      </a:lnTo>
                      <a:lnTo>
                        <a:pt x="4859" y="1937"/>
                      </a:lnTo>
                      <a:lnTo>
                        <a:pt x="4863" y="1936"/>
                      </a:lnTo>
                      <a:lnTo>
                        <a:pt x="4866" y="1937"/>
                      </a:lnTo>
                      <a:lnTo>
                        <a:pt x="4870" y="1936"/>
                      </a:lnTo>
                      <a:lnTo>
                        <a:pt x="4874" y="1936"/>
                      </a:lnTo>
                      <a:lnTo>
                        <a:pt x="4878" y="1936"/>
                      </a:lnTo>
                      <a:lnTo>
                        <a:pt x="4882" y="1937"/>
                      </a:lnTo>
                      <a:lnTo>
                        <a:pt x="4885" y="1936"/>
                      </a:lnTo>
                      <a:lnTo>
                        <a:pt x="4889" y="1936"/>
                      </a:lnTo>
                      <a:lnTo>
                        <a:pt x="4893" y="1936"/>
                      </a:lnTo>
                      <a:lnTo>
                        <a:pt x="4896" y="1937"/>
                      </a:lnTo>
                      <a:lnTo>
                        <a:pt x="4900" y="1936"/>
                      </a:lnTo>
                      <a:lnTo>
                        <a:pt x="4904" y="1937"/>
                      </a:lnTo>
                      <a:lnTo>
                        <a:pt x="4908" y="1937"/>
                      </a:lnTo>
                      <a:lnTo>
                        <a:pt x="4911" y="1937"/>
                      </a:lnTo>
                      <a:lnTo>
                        <a:pt x="4915" y="1937"/>
                      </a:lnTo>
                      <a:lnTo>
                        <a:pt x="4919" y="1936"/>
                      </a:lnTo>
                      <a:lnTo>
                        <a:pt x="4923" y="1938"/>
                      </a:lnTo>
                      <a:lnTo>
                        <a:pt x="4927" y="1937"/>
                      </a:lnTo>
                      <a:lnTo>
                        <a:pt x="4930" y="1938"/>
                      </a:lnTo>
                      <a:lnTo>
                        <a:pt x="4934" y="1937"/>
                      </a:lnTo>
                      <a:lnTo>
                        <a:pt x="4938" y="1937"/>
                      </a:lnTo>
                      <a:lnTo>
                        <a:pt x="4942" y="1938"/>
                      </a:lnTo>
                      <a:lnTo>
                        <a:pt x="4945" y="1937"/>
                      </a:lnTo>
                      <a:lnTo>
                        <a:pt x="4949" y="1937"/>
                      </a:lnTo>
                      <a:lnTo>
                        <a:pt x="4953" y="1938"/>
                      </a:lnTo>
                      <a:lnTo>
                        <a:pt x="4957" y="1938"/>
                      </a:lnTo>
                      <a:lnTo>
                        <a:pt x="4960" y="1938"/>
                      </a:lnTo>
                      <a:lnTo>
                        <a:pt x="4961" y="1938"/>
                      </a:lnTo>
                    </a:path>
                  </a:pathLst>
                </a:custGeom>
                <a:noFill/>
                <a:ln w="9525" cap="flat" cmpd="sng">
                  <a:solidFill>
                    <a:schemeClr val="dk1"/>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rgbClr val="000000"/>
                    </a:solidFill>
                    <a:latin typeface="Arial"/>
                    <a:ea typeface="Arial"/>
                    <a:cs typeface="Arial"/>
                    <a:sym typeface="Arial"/>
                  </a:endParaRPr>
                </a:p>
              </p:txBody>
            </p:sp>
          </p:grpSp>
          <p:sp>
            <p:nvSpPr>
              <p:cNvPr id="1324" name="Google Shape;1324;p11"/>
              <p:cNvSpPr/>
              <p:nvPr/>
            </p:nvSpPr>
            <p:spPr>
              <a:xfrm>
                <a:off x="9421812" y="3593487"/>
                <a:ext cx="144000" cy="144000"/>
              </a:xfrm>
              <a:prstGeom prst="rect">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800" b="0" i="0" u="none" strike="noStrike" cap="none">
                  <a:solidFill>
                    <a:schemeClr val="lt1"/>
                  </a:solidFill>
                  <a:latin typeface="Arial"/>
                  <a:ea typeface="Arial"/>
                  <a:cs typeface="Arial"/>
                  <a:sym typeface="Arial"/>
                </a:endParaRPr>
              </a:p>
            </p:txBody>
          </p:sp>
          <p:sp>
            <p:nvSpPr>
              <p:cNvPr id="1325" name="Google Shape;1325;p11"/>
              <p:cNvSpPr/>
              <p:nvPr/>
            </p:nvSpPr>
            <p:spPr>
              <a:xfrm>
                <a:off x="9425553" y="3149861"/>
                <a:ext cx="144000" cy="144000"/>
              </a:xfrm>
              <a:prstGeom prst="rect">
                <a:avLst/>
              </a:prstGeom>
              <a:solidFill>
                <a:srgbClr val="0000FF"/>
              </a:solidFill>
              <a:ln w="25400" cap="flat" cmpd="sng">
                <a:solidFill>
                  <a:srgbClr val="0000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800" b="0" i="0" u="none" strike="noStrike" cap="none">
                  <a:solidFill>
                    <a:schemeClr val="lt1"/>
                  </a:solidFill>
                  <a:latin typeface="Arial"/>
                  <a:ea typeface="Arial"/>
                  <a:cs typeface="Arial"/>
                  <a:sym typeface="Arial"/>
                </a:endParaRPr>
              </a:p>
            </p:txBody>
          </p:sp>
          <p:sp>
            <p:nvSpPr>
              <p:cNvPr id="1326" name="Google Shape;1326;p11"/>
              <p:cNvSpPr txBox="1"/>
              <p:nvPr/>
            </p:nvSpPr>
            <p:spPr>
              <a:xfrm>
                <a:off x="9533017" y="3445493"/>
                <a:ext cx="521100" cy="4545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3T</a:t>
                </a:r>
                <a:endParaRPr sz="800" b="0" i="0" u="none" strike="noStrike" cap="none">
                  <a:solidFill>
                    <a:srgbClr val="000000"/>
                  </a:solidFill>
                  <a:latin typeface="Arial"/>
                  <a:ea typeface="Arial"/>
                  <a:cs typeface="Arial"/>
                  <a:sym typeface="Arial"/>
                </a:endParaRPr>
              </a:p>
            </p:txBody>
          </p:sp>
          <p:sp>
            <p:nvSpPr>
              <p:cNvPr id="1327" name="Google Shape;1327;p11"/>
              <p:cNvSpPr txBox="1"/>
              <p:nvPr/>
            </p:nvSpPr>
            <p:spPr>
              <a:xfrm>
                <a:off x="9533015" y="3009389"/>
                <a:ext cx="603300" cy="4545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T</a:t>
                </a:r>
                <a:endParaRPr sz="800" b="0" i="0" u="none" strike="noStrike" cap="none">
                  <a:solidFill>
                    <a:srgbClr val="000000"/>
                  </a:solidFill>
                  <a:latin typeface="Arial"/>
                  <a:ea typeface="Arial"/>
                  <a:cs typeface="Arial"/>
                  <a:sym typeface="Arial"/>
                </a:endParaRPr>
              </a:p>
            </p:txBody>
          </p:sp>
          <p:sp>
            <p:nvSpPr>
              <p:cNvPr id="1330" name="Google Shape;1330;p11"/>
              <p:cNvSpPr txBox="1"/>
              <p:nvPr/>
            </p:nvSpPr>
            <p:spPr>
              <a:xfrm>
                <a:off x="7804797" y="1681723"/>
                <a:ext cx="992100" cy="45450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dirty="0">
                    <a:solidFill>
                      <a:srgbClr val="000000"/>
                    </a:solidFill>
                    <a:latin typeface="Arial"/>
                    <a:ea typeface="Arial"/>
                    <a:cs typeface="Arial"/>
                    <a:sym typeface="Arial"/>
                  </a:rPr>
                  <a:t>dsRNA</a:t>
                </a:r>
                <a:endParaRPr sz="800" b="0" i="0" u="none" strike="noStrike" cap="none" dirty="0">
                  <a:solidFill>
                    <a:srgbClr val="000000"/>
                  </a:solidFill>
                  <a:latin typeface="Arial"/>
                  <a:ea typeface="Arial"/>
                  <a:cs typeface="Arial"/>
                  <a:sym typeface="Arial"/>
                </a:endParaRPr>
              </a:p>
            </p:txBody>
          </p:sp>
          <p:sp>
            <p:nvSpPr>
              <p:cNvPr id="1331" name="Google Shape;1331;p11"/>
              <p:cNvSpPr txBox="1"/>
              <p:nvPr/>
            </p:nvSpPr>
            <p:spPr>
              <a:xfrm>
                <a:off x="5914244" y="1708362"/>
                <a:ext cx="1070100" cy="4545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dirty="0">
                    <a:solidFill>
                      <a:srgbClr val="000000"/>
                    </a:solidFill>
                    <a:latin typeface="Arial"/>
                    <a:ea typeface="Arial"/>
                    <a:cs typeface="Arial"/>
                    <a:sym typeface="Arial"/>
                  </a:rPr>
                  <a:t>23S </a:t>
                </a:r>
                <a:r>
                  <a:rPr lang="en-GB" sz="800" b="0" i="0" u="none" strike="noStrike" cap="none" dirty="0" err="1">
                    <a:solidFill>
                      <a:srgbClr val="000000"/>
                    </a:solidFill>
                    <a:latin typeface="Arial"/>
                    <a:ea typeface="Arial"/>
                    <a:cs typeface="Arial"/>
                    <a:sym typeface="Arial"/>
                  </a:rPr>
                  <a:t>rRNA</a:t>
                </a:r>
                <a:endParaRPr sz="800" b="0" i="0" u="none" strike="noStrike" cap="none" dirty="0">
                  <a:solidFill>
                    <a:srgbClr val="000000"/>
                  </a:solidFill>
                  <a:latin typeface="Arial"/>
                  <a:ea typeface="Arial"/>
                  <a:cs typeface="Arial"/>
                  <a:sym typeface="Arial"/>
                </a:endParaRPr>
              </a:p>
            </p:txBody>
          </p:sp>
          <p:sp>
            <p:nvSpPr>
              <p:cNvPr id="1332" name="Google Shape;1332;p11"/>
              <p:cNvSpPr txBox="1"/>
              <p:nvPr/>
            </p:nvSpPr>
            <p:spPr>
              <a:xfrm>
                <a:off x="5280650" y="1731944"/>
                <a:ext cx="1070100" cy="4545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dirty="0">
                    <a:solidFill>
                      <a:srgbClr val="000000"/>
                    </a:solidFill>
                    <a:latin typeface="Arial"/>
                    <a:ea typeface="Arial"/>
                    <a:cs typeface="Arial"/>
                    <a:sym typeface="Arial"/>
                  </a:rPr>
                  <a:t>16S </a:t>
                </a:r>
                <a:r>
                  <a:rPr lang="en-GB" sz="800" b="0" i="0" u="none" strike="noStrike" cap="none" dirty="0" err="1">
                    <a:solidFill>
                      <a:srgbClr val="000000"/>
                    </a:solidFill>
                    <a:latin typeface="Arial"/>
                    <a:ea typeface="Arial"/>
                    <a:cs typeface="Arial"/>
                    <a:sym typeface="Arial"/>
                  </a:rPr>
                  <a:t>rRNA</a:t>
                </a:r>
                <a:endParaRPr sz="800" b="0" i="0" u="none" strike="noStrike" cap="none" dirty="0">
                  <a:solidFill>
                    <a:srgbClr val="000000"/>
                  </a:solidFill>
                  <a:latin typeface="Arial"/>
                  <a:ea typeface="Arial"/>
                  <a:cs typeface="Arial"/>
                  <a:sym typeface="Arial"/>
                </a:endParaRPr>
              </a:p>
            </p:txBody>
          </p:sp>
        </p:grpSp>
        <p:grpSp>
          <p:nvGrpSpPr>
            <p:cNvPr id="1334" name="Google Shape;1334;p11"/>
            <p:cNvGrpSpPr/>
            <p:nvPr/>
          </p:nvGrpSpPr>
          <p:grpSpPr>
            <a:xfrm>
              <a:off x="180026" y="4117000"/>
              <a:ext cx="6774123" cy="5992202"/>
              <a:chOff x="1641720" y="-4388280"/>
              <a:chExt cx="8718306" cy="11098727"/>
            </a:xfrm>
          </p:grpSpPr>
          <p:grpSp>
            <p:nvGrpSpPr>
              <p:cNvPr id="1335" name="Google Shape;1335;p11"/>
              <p:cNvGrpSpPr/>
              <p:nvPr/>
            </p:nvGrpSpPr>
            <p:grpSpPr>
              <a:xfrm>
                <a:off x="1893093" y="1825625"/>
                <a:ext cx="8466933" cy="4362451"/>
                <a:chOff x="1194" y="1150"/>
                <a:chExt cx="5335" cy="2748"/>
              </a:xfrm>
            </p:grpSpPr>
            <p:sp>
              <p:nvSpPr>
                <p:cNvPr id="1336" name="Google Shape;1336;p11"/>
                <p:cNvSpPr/>
                <p:nvPr/>
              </p:nvSpPr>
              <p:spPr>
                <a:xfrm>
                  <a:off x="1207" y="1150"/>
                  <a:ext cx="5266" cy="274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endParaRPr sz="800" b="0" i="0" u="none" strike="noStrike" cap="none">
                    <a:solidFill>
                      <a:srgbClr val="000000"/>
                    </a:solidFill>
                    <a:latin typeface="Arial"/>
                    <a:ea typeface="Arial"/>
                    <a:cs typeface="Arial"/>
                    <a:sym typeface="Arial"/>
                  </a:endParaRPr>
                </a:p>
              </p:txBody>
            </p:sp>
            <p:cxnSp>
              <p:nvCxnSpPr>
                <p:cNvPr id="1337" name="Google Shape;1337;p11"/>
                <p:cNvCxnSpPr/>
                <p:nvPr/>
              </p:nvCxnSpPr>
              <p:spPr>
                <a:xfrm>
                  <a:off x="1453" y="3741"/>
                  <a:ext cx="4960" cy="0"/>
                </a:xfrm>
                <a:prstGeom prst="straightConnector1">
                  <a:avLst/>
                </a:prstGeom>
                <a:noFill/>
                <a:ln w="9525" cap="flat" cmpd="sng">
                  <a:solidFill>
                    <a:srgbClr val="000000"/>
                  </a:solidFill>
                  <a:prstDash val="solid"/>
                  <a:round/>
                  <a:headEnd type="none" w="sm" len="sm"/>
                  <a:tailEnd type="none" w="sm" len="sm"/>
                </a:ln>
              </p:spPr>
            </p:cxnSp>
            <p:cxnSp>
              <p:nvCxnSpPr>
                <p:cNvPr id="1338" name="Google Shape;1338;p11"/>
                <p:cNvCxnSpPr/>
                <p:nvPr/>
              </p:nvCxnSpPr>
              <p:spPr>
                <a:xfrm>
                  <a:off x="1453" y="3741"/>
                  <a:ext cx="0" cy="15"/>
                </a:xfrm>
                <a:prstGeom prst="straightConnector1">
                  <a:avLst/>
                </a:prstGeom>
                <a:noFill/>
                <a:ln w="9525" cap="flat" cmpd="sng">
                  <a:solidFill>
                    <a:srgbClr val="000000"/>
                  </a:solidFill>
                  <a:prstDash val="solid"/>
                  <a:round/>
                  <a:headEnd type="none" w="sm" len="sm"/>
                  <a:tailEnd type="none" w="sm" len="sm"/>
                </a:ln>
              </p:spPr>
            </p:cxnSp>
            <p:sp>
              <p:nvSpPr>
                <p:cNvPr id="1339" name="Google Shape;1339;p11"/>
                <p:cNvSpPr/>
                <p:nvPr/>
              </p:nvSpPr>
              <p:spPr>
                <a:xfrm>
                  <a:off x="1413" y="3754"/>
                  <a:ext cx="12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4.5</a:t>
                  </a:r>
                  <a:endParaRPr sz="800" b="0" i="0" u="none" strike="noStrike" cap="none">
                    <a:solidFill>
                      <a:srgbClr val="000000"/>
                    </a:solidFill>
                    <a:latin typeface="Arial"/>
                    <a:ea typeface="Arial"/>
                    <a:cs typeface="Arial"/>
                    <a:sym typeface="Arial"/>
                  </a:endParaRPr>
                </a:p>
              </p:txBody>
            </p:sp>
            <p:cxnSp>
              <p:nvCxnSpPr>
                <p:cNvPr id="1340" name="Google Shape;1340;p11"/>
                <p:cNvCxnSpPr/>
                <p:nvPr/>
              </p:nvCxnSpPr>
              <p:spPr>
                <a:xfrm>
                  <a:off x="1453" y="3741"/>
                  <a:ext cx="0" cy="9"/>
                </a:xfrm>
                <a:prstGeom prst="straightConnector1">
                  <a:avLst/>
                </a:prstGeom>
                <a:noFill/>
                <a:ln w="9525" cap="flat" cmpd="sng">
                  <a:solidFill>
                    <a:srgbClr val="000000"/>
                  </a:solidFill>
                  <a:prstDash val="solid"/>
                  <a:round/>
                  <a:headEnd type="none" w="sm" len="sm"/>
                  <a:tailEnd type="none" w="sm" len="sm"/>
                </a:ln>
              </p:spPr>
            </p:cxnSp>
            <p:cxnSp>
              <p:nvCxnSpPr>
                <p:cNvPr id="1341" name="Google Shape;1341;p11"/>
                <p:cNvCxnSpPr/>
                <p:nvPr/>
              </p:nvCxnSpPr>
              <p:spPr>
                <a:xfrm>
                  <a:off x="1566" y="3741"/>
                  <a:ext cx="0" cy="9"/>
                </a:xfrm>
                <a:prstGeom prst="straightConnector1">
                  <a:avLst/>
                </a:prstGeom>
                <a:noFill/>
                <a:ln w="9525" cap="flat" cmpd="sng">
                  <a:solidFill>
                    <a:srgbClr val="000000"/>
                  </a:solidFill>
                  <a:prstDash val="solid"/>
                  <a:round/>
                  <a:headEnd type="none" w="sm" len="sm"/>
                  <a:tailEnd type="none" w="sm" len="sm"/>
                </a:ln>
              </p:spPr>
            </p:cxnSp>
            <p:cxnSp>
              <p:nvCxnSpPr>
                <p:cNvPr id="1342" name="Google Shape;1342;p11"/>
                <p:cNvCxnSpPr/>
                <p:nvPr/>
              </p:nvCxnSpPr>
              <p:spPr>
                <a:xfrm>
                  <a:off x="1679" y="3741"/>
                  <a:ext cx="0" cy="15"/>
                </a:xfrm>
                <a:prstGeom prst="straightConnector1">
                  <a:avLst/>
                </a:prstGeom>
                <a:noFill/>
                <a:ln w="9525" cap="flat" cmpd="sng">
                  <a:solidFill>
                    <a:srgbClr val="000000"/>
                  </a:solidFill>
                  <a:prstDash val="solid"/>
                  <a:round/>
                  <a:headEnd type="none" w="sm" len="sm"/>
                  <a:tailEnd type="none" w="sm" len="sm"/>
                </a:ln>
              </p:spPr>
            </p:cxnSp>
            <p:sp>
              <p:nvSpPr>
                <p:cNvPr id="1343" name="Google Shape;1343;p11"/>
                <p:cNvSpPr/>
                <p:nvPr/>
              </p:nvSpPr>
              <p:spPr>
                <a:xfrm>
                  <a:off x="1639" y="3754"/>
                  <a:ext cx="12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5.0</a:t>
                  </a:r>
                  <a:endParaRPr sz="800" b="0" i="0" u="none" strike="noStrike" cap="none">
                    <a:solidFill>
                      <a:srgbClr val="000000"/>
                    </a:solidFill>
                    <a:latin typeface="Arial"/>
                    <a:ea typeface="Arial"/>
                    <a:cs typeface="Arial"/>
                    <a:sym typeface="Arial"/>
                  </a:endParaRPr>
                </a:p>
              </p:txBody>
            </p:sp>
            <p:cxnSp>
              <p:nvCxnSpPr>
                <p:cNvPr id="1344" name="Google Shape;1344;p11"/>
                <p:cNvCxnSpPr/>
                <p:nvPr/>
              </p:nvCxnSpPr>
              <p:spPr>
                <a:xfrm>
                  <a:off x="1791" y="3741"/>
                  <a:ext cx="0" cy="9"/>
                </a:xfrm>
                <a:prstGeom prst="straightConnector1">
                  <a:avLst/>
                </a:prstGeom>
                <a:noFill/>
                <a:ln w="9525" cap="flat" cmpd="sng">
                  <a:solidFill>
                    <a:srgbClr val="000000"/>
                  </a:solidFill>
                  <a:prstDash val="solid"/>
                  <a:round/>
                  <a:headEnd type="none" w="sm" len="sm"/>
                  <a:tailEnd type="none" w="sm" len="sm"/>
                </a:ln>
              </p:spPr>
            </p:cxnSp>
            <p:cxnSp>
              <p:nvCxnSpPr>
                <p:cNvPr id="1345" name="Google Shape;1345;p11"/>
                <p:cNvCxnSpPr/>
                <p:nvPr/>
              </p:nvCxnSpPr>
              <p:spPr>
                <a:xfrm>
                  <a:off x="1904" y="3741"/>
                  <a:ext cx="0" cy="9"/>
                </a:xfrm>
                <a:prstGeom prst="straightConnector1">
                  <a:avLst/>
                </a:prstGeom>
                <a:noFill/>
                <a:ln w="9525" cap="flat" cmpd="sng">
                  <a:solidFill>
                    <a:srgbClr val="000000"/>
                  </a:solidFill>
                  <a:prstDash val="solid"/>
                  <a:round/>
                  <a:headEnd type="none" w="sm" len="sm"/>
                  <a:tailEnd type="none" w="sm" len="sm"/>
                </a:ln>
              </p:spPr>
            </p:cxnSp>
            <p:cxnSp>
              <p:nvCxnSpPr>
                <p:cNvPr id="1346" name="Google Shape;1346;p11"/>
                <p:cNvCxnSpPr/>
                <p:nvPr/>
              </p:nvCxnSpPr>
              <p:spPr>
                <a:xfrm>
                  <a:off x="2017" y="3741"/>
                  <a:ext cx="0" cy="9"/>
                </a:xfrm>
                <a:prstGeom prst="straightConnector1">
                  <a:avLst/>
                </a:prstGeom>
                <a:noFill/>
                <a:ln w="9525" cap="flat" cmpd="sng">
                  <a:solidFill>
                    <a:srgbClr val="000000"/>
                  </a:solidFill>
                  <a:prstDash val="solid"/>
                  <a:round/>
                  <a:headEnd type="none" w="sm" len="sm"/>
                  <a:tailEnd type="none" w="sm" len="sm"/>
                </a:ln>
              </p:spPr>
            </p:cxnSp>
            <p:cxnSp>
              <p:nvCxnSpPr>
                <p:cNvPr id="1347" name="Google Shape;1347;p11"/>
                <p:cNvCxnSpPr/>
                <p:nvPr/>
              </p:nvCxnSpPr>
              <p:spPr>
                <a:xfrm>
                  <a:off x="2130" y="3741"/>
                  <a:ext cx="0" cy="15"/>
                </a:xfrm>
                <a:prstGeom prst="straightConnector1">
                  <a:avLst/>
                </a:prstGeom>
                <a:noFill/>
                <a:ln w="9525" cap="flat" cmpd="sng">
                  <a:solidFill>
                    <a:srgbClr val="000000"/>
                  </a:solidFill>
                  <a:prstDash val="solid"/>
                  <a:round/>
                  <a:headEnd type="none" w="sm" len="sm"/>
                  <a:tailEnd type="none" w="sm" len="sm"/>
                </a:ln>
              </p:spPr>
            </p:cxnSp>
            <p:sp>
              <p:nvSpPr>
                <p:cNvPr id="1348" name="Google Shape;1348;p11"/>
                <p:cNvSpPr/>
                <p:nvPr/>
              </p:nvSpPr>
              <p:spPr>
                <a:xfrm>
                  <a:off x="2089" y="3754"/>
                  <a:ext cx="12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6.0</a:t>
                  </a:r>
                  <a:endParaRPr sz="800" b="0" i="0" u="none" strike="noStrike" cap="none">
                    <a:solidFill>
                      <a:srgbClr val="000000"/>
                    </a:solidFill>
                    <a:latin typeface="Arial"/>
                    <a:ea typeface="Arial"/>
                    <a:cs typeface="Arial"/>
                    <a:sym typeface="Arial"/>
                  </a:endParaRPr>
                </a:p>
              </p:txBody>
            </p:sp>
            <p:cxnSp>
              <p:nvCxnSpPr>
                <p:cNvPr id="1349" name="Google Shape;1349;p11"/>
                <p:cNvCxnSpPr/>
                <p:nvPr/>
              </p:nvCxnSpPr>
              <p:spPr>
                <a:xfrm>
                  <a:off x="2242" y="3741"/>
                  <a:ext cx="0" cy="9"/>
                </a:xfrm>
                <a:prstGeom prst="straightConnector1">
                  <a:avLst/>
                </a:prstGeom>
                <a:noFill/>
                <a:ln w="9525" cap="flat" cmpd="sng">
                  <a:solidFill>
                    <a:srgbClr val="000000"/>
                  </a:solidFill>
                  <a:prstDash val="solid"/>
                  <a:round/>
                  <a:headEnd type="none" w="sm" len="sm"/>
                  <a:tailEnd type="none" w="sm" len="sm"/>
                </a:ln>
              </p:spPr>
            </p:cxnSp>
            <p:cxnSp>
              <p:nvCxnSpPr>
                <p:cNvPr id="1350" name="Google Shape;1350;p11"/>
                <p:cNvCxnSpPr/>
                <p:nvPr/>
              </p:nvCxnSpPr>
              <p:spPr>
                <a:xfrm>
                  <a:off x="2355" y="3741"/>
                  <a:ext cx="0" cy="9"/>
                </a:xfrm>
                <a:prstGeom prst="straightConnector1">
                  <a:avLst/>
                </a:prstGeom>
                <a:noFill/>
                <a:ln w="9525" cap="flat" cmpd="sng">
                  <a:solidFill>
                    <a:srgbClr val="000000"/>
                  </a:solidFill>
                  <a:prstDash val="solid"/>
                  <a:round/>
                  <a:headEnd type="none" w="sm" len="sm"/>
                  <a:tailEnd type="none" w="sm" len="sm"/>
                </a:ln>
              </p:spPr>
            </p:cxnSp>
            <p:cxnSp>
              <p:nvCxnSpPr>
                <p:cNvPr id="1351" name="Google Shape;1351;p11"/>
                <p:cNvCxnSpPr/>
                <p:nvPr/>
              </p:nvCxnSpPr>
              <p:spPr>
                <a:xfrm>
                  <a:off x="2468" y="3741"/>
                  <a:ext cx="0" cy="9"/>
                </a:xfrm>
                <a:prstGeom prst="straightConnector1">
                  <a:avLst/>
                </a:prstGeom>
                <a:noFill/>
                <a:ln w="9525" cap="flat" cmpd="sng">
                  <a:solidFill>
                    <a:srgbClr val="000000"/>
                  </a:solidFill>
                  <a:prstDash val="solid"/>
                  <a:round/>
                  <a:headEnd type="none" w="sm" len="sm"/>
                  <a:tailEnd type="none" w="sm" len="sm"/>
                </a:ln>
              </p:spPr>
            </p:cxnSp>
            <p:cxnSp>
              <p:nvCxnSpPr>
                <p:cNvPr id="1352" name="Google Shape;1352;p11"/>
                <p:cNvCxnSpPr/>
                <p:nvPr/>
              </p:nvCxnSpPr>
              <p:spPr>
                <a:xfrm>
                  <a:off x="2581" y="3741"/>
                  <a:ext cx="0" cy="15"/>
                </a:xfrm>
                <a:prstGeom prst="straightConnector1">
                  <a:avLst/>
                </a:prstGeom>
                <a:noFill/>
                <a:ln w="9525" cap="flat" cmpd="sng">
                  <a:solidFill>
                    <a:srgbClr val="000000"/>
                  </a:solidFill>
                  <a:prstDash val="solid"/>
                  <a:round/>
                  <a:headEnd type="none" w="sm" len="sm"/>
                  <a:tailEnd type="none" w="sm" len="sm"/>
                </a:ln>
              </p:spPr>
            </p:cxnSp>
            <p:sp>
              <p:nvSpPr>
                <p:cNvPr id="1353" name="Google Shape;1353;p11"/>
                <p:cNvSpPr/>
                <p:nvPr/>
              </p:nvSpPr>
              <p:spPr>
                <a:xfrm>
                  <a:off x="2540" y="3754"/>
                  <a:ext cx="12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7.0</a:t>
                  </a:r>
                  <a:endParaRPr sz="800" b="0" i="0" u="none" strike="noStrike" cap="none">
                    <a:solidFill>
                      <a:srgbClr val="000000"/>
                    </a:solidFill>
                    <a:latin typeface="Arial"/>
                    <a:ea typeface="Arial"/>
                    <a:cs typeface="Arial"/>
                    <a:sym typeface="Arial"/>
                  </a:endParaRPr>
                </a:p>
              </p:txBody>
            </p:sp>
            <p:cxnSp>
              <p:nvCxnSpPr>
                <p:cNvPr id="1354" name="Google Shape;1354;p11"/>
                <p:cNvCxnSpPr/>
                <p:nvPr/>
              </p:nvCxnSpPr>
              <p:spPr>
                <a:xfrm>
                  <a:off x="2693" y="3741"/>
                  <a:ext cx="0" cy="9"/>
                </a:xfrm>
                <a:prstGeom prst="straightConnector1">
                  <a:avLst/>
                </a:prstGeom>
                <a:noFill/>
                <a:ln w="9525" cap="flat" cmpd="sng">
                  <a:solidFill>
                    <a:srgbClr val="000000"/>
                  </a:solidFill>
                  <a:prstDash val="solid"/>
                  <a:round/>
                  <a:headEnd type="none" w="sm" len="sm"/>
                  <a:tailEnd type="none" w="sm" len="sm"/>
                </a:ln>
              </p:spPr>
            </p:cxnSp>
            <p:cxnSp>
              <p:nvCxnSpPr>
                <p:cNvPr id="1355" name="Google Shape;1355;p11"/>
                <p:cNvCxnSpPr/>
                <p:nvPr/>
              </p:nvCxnSpPr>
              <p:spPr>
                <a:xfrm>
                  <a:off x="2806" y="3741"/>
                  <a:ext cx="0" cy="9"/>
                </a:xfrm>
                <a:prstGeom prst="straightConnector1">
                  <a:avLst/>
                </a:prstGeom>
                <a:noFill/>
                <a:ln w="9525" cap="flat" cmpd="sng">
                  <a:solidFill>
                    <a:srgbClr val="000000"/>
                  </a:solidFill>
                  <a:prstDash val="solid"/>
                  <a:round/>
                  <a:headEnd type="none" w="sm" len="sm"/>
                  <a:tailEnd type="none" w="sm" len="sm"/>
                </a:ln>
              </p:spPr>
            </p:cxnSp>
            <p:cxnSp>
              <p:nvCxnSpPr>
                <p:cNvPr id="1356" name="Google Shape;1356;p11"/>
                <p:cNvCxnSpPr/>
                <p:nvPr/>
              </p:nvCxnSpPr>
              <p:spPr>
                <a:xfrm>
                  <a:off x="2919" y="3741"/>
                  <a:ext cx="0" cy="9"/>
                </a:xfrm>
                <a:prstGeom prst="straightConnector1">
                  <a:avLst/>
                </a:prstGeom>
                <a:noFill/>
                <a:ln w="9525" cap="flat" cmpd="sng">
                  <a:solidFill>
                    <a:srgbClr val="000000"/>
                  </a:solidFill>
                  <a:prstDash val="solid"/>
                  <a:round/>
                  <a:headEnd type="none" w="sm" len="sm"/>
                  <a:tailEnd type="none" w="sm" len="sm"/>
                </a:ln>
              </p:spPr>
            </p:cxnSp>
            <p:cxnSp>
              <p:nvCxnSpPr>
                <p:cNvPr id="1357" name="Google Shape;1357;p11"/>
                <p:cNvCxnSpPr/>
                <p:nvPr/>
              </p:nvCxnSpPr>
              <p:spPr>
                <a:xfrm>
                  <a:off x="3032" y="3741"/>
                  <a:ext cx="0" cy="15"/>
                </a:xfrm>
                <a:prstGeom prst="straightConnector1">
                  <a:avLst/>
                </a:prstGeom>
                <a:noFill/>
                <a:ln w="9525" cap="flat" cmpd="sng">
                  <a:solidFill>
                    <a:srgbClr val="000000"/>
                  </a:solidFill>
                  <a:prstDash val="solid"/>
                  <a:round/>
                  <a:headEnd type="none" w="sm" len="sm"/>
                  <a:tailEnd type="none" w="sm" len="sm"/>
                </a:ln>
              </p:spPr>
            </p:cxnSp>
            <p:sp>
              <p:nvSpPr>
                <p:cNvPr id="1358" name="Google Shape;1358;p11"/>
                <p:cNvSpPr/>
                <p:nvPr/>
              </p:nvSpPr>
              <p:spPr>
                <a:xfrm>
                  <a:off x="2991" y="3754"/>
                  <a:ext cx="12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8.0</a:t>
                  </a:r>
                  <a:endParaRPr sz="800" b="0" i="0" u="none" strike="noStrike" cap="none">
                    <a:solidFill>
                      <a:srgbClr val="000000"/>
                    </a:solidFill>
                    <a:latin typeface="Arial"/>
                    <a:ea typeface="Arial"/>
                    <a:cs typeface="Arial"/>
                    <a:sym typeface="Arial"/>
                  </a:endParaRPr>
                </a:p>
              </p:txBody>
            </p:sp>
            <p:cxnSp>
              <p:nvCxnSpPr>
                <p:cNvPr id="1359" name="Google Shape;1359;p11"/>
                <p:cNvCxnSpPr/>
                <p:nvPr/>
              </p:nvCxnSpPr>
              <p:spPr>
                <a:xfrm>
                  <a:off x="3144" y="3741"/>
                  <a:ext cx="0" cy="9"/>
                </a:xfrm>
                <a:prstGeom prst="straightConnector1">
                  <a:avLst/>
                </a:prstGeom>
                <a:noFill/>
                <a:ln w="9525" cap="flat" cmpd="sng">
                  <a:solidFill>
                    <a:srgbClr val="000000"/>
                  </a:solidFill>
                  <a:prstDash val="solid"/>
                  <a:round/>
                  <a:headEnd type="none" w="sm" len="sm"/>
                  <a:tailEnd type="none" w="sm" len="sm"/>
                </a:ln>
              </p:spPr>
            </p:cxnSp>
            <p:cxnSp>
              <p:nvCxnSpPr>
                <p:cNvPr id="1360" name="Google Shape;1360;p11"/>
                <p:cNvCxnSpPr/>
                <p:nvPr/>
              </p:nvCxnSpPr>
              <p:spPr>
                <a:xfrm>
                  <a:off x="3257" y="3741"/>
                  <a:ext cx="0" cy="9"/>
                </a:xfrm>
                <a:prstGeom prst="straightConnector1">
                  <a:avLst/>
                </a:prstGeom>
                <a:noFill/>
                <a:ln w="9525" cap="flat" cmpd="sng">
                  <a:solidFill>
                    <a:srgbClr val="000000"/>
                  </a:solidFill>
                  <a:prstDash val="solid"/>
                  <a:round/>
                  <a:headEnd type="none" w="sm" len="sm"/>
                  <a:tailEnd type="none" w="sm" len="sm"/>
                </a:ln>
              </p:spPr>
            </p:cxnSp>
            <p:cxnSp>
              <p:nvCxnSpPr>
                <p:cNvPr id="1361" name="Google Shape;1361;p11"/>
                <p:cNvCxnSpPr/>
                <p:nvPr/>
              </p:nvCxnSpPr>
              <p:spPr>
                <a:xfrm>
                  <a:off x="3370" y="3741"/>
                  <a:ext cx="0" cy="9"/>
                </a:xfrm>
                <a:prstGeom prst="straightConnector1">
                  <a:avLst/>
                </a:prstGeom>
                <a:noFill/>
                <a:ln w="9525" cap="flat" cmpd="sng">
                  <a:solidFill>
                    <a:srgbClr val="000000"/>
                  </a:solidFill>
                  <a:prstDash val="solid"/>
                  <a:round/>
                  <a:headEnd type="none" w="sm" len="sm"/>
                  <a:tailEnd type="none" w="sm" len="sm"/>
                </a:ln>
              </p:spPr>
            </p:cxnSp>
            <p:cxnSp>
              <p:nvCxnSpPr>
                <p:cNvPr id="1362" name="Google Shape;1362;p11"/>
                <p:cNvCxnSpPr/>
                <p:nvPr/>
              </p:nvCxnSpPr>
              <p:spPr>
                <a:xfrm>
                  <a:off x="3483" y="3741"/>
                  <a:ext cx="0" cy="15"/>
                </a:xfrm>
                <a:prstGeom prst="straightConnector1">
                  <a:avLst/>
                </a:prstGeom>
                <a:noFill/>
                <a:ln w="9525" cap="flat" cmpd="sng">
                  <a:solidFill>
                    <a:srgbClr val="000000"/>
                  </a:solidFill>
                  <a:prstDash val="solid"/>
                  <a:round/>
                  <a:headEnd type="none" w="sm" len="sm"/>
                  <a:tailEnd type="none" w="sm" len="sm"/>
                </a:ln>
              </p:spPr>
            </p:cxnSp>
            <p:sp>
              <p:nvSpPr>
                <p:cNvPr id="1363" name="Google Shape;1363;p11"/>
                <p:cNvSpPr/>
                <p:nvPr/>
              </p:nvSpPr>
              <p:spPr>
                <a:xfrm>
                  <a:off x="3442" y="3754"/>
                  <a:ext cx="12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9.0</a:t>
                  </a:r>
                  <a:endParaRPr sz="800" b="0" i="0" u="none" strike="noStrike" cap="none">
                    <a:solidFill>
                      <a:srgbClr val="000000"/>
                    </a:solidFill>
                    <a:latin typeface="Arial"/>
                    <a:ea typeface="Arial"/>
                    <a:cs typeface="Arial"/>
                    <a:sym typeface="Arial"/>
                  </a:endParaRPr>
                </a:p>
              </p:txBody>
            </p:sp>
            <p:cxnSp>
              <p:nvCxnSpPr>
                <p:cNvPr id="1364" name="Google Shape;1364;p11"/>
                <p:cNvCxnSpPr/>
                <p:nvPr/>
              </p:nvCxnSpPr>
              <p:spPr>
                <a:xfrm>
                  <a:off x="3595" y="3741"/>
                  <a:ext cx="0" cy="9"/>
                </a:xfrm>
                <a:prstGeom prst="straightConnector1">
                  <a:avLst/>
                </a:prstGeom>
                <a:noFill/>
                <a:ln w="9525" cap="flat" cmpd="sng">
                  <a:solidFill>
                    <a:srgbClr val="000000"/>
                  </a:solidFill>
                  <a:prstDash val="solid"/>
                  <a:round/>
                  <a:headEnd type="none" w="sm" len="sm"/>
                  <a:tailEnd type="none" w="sm" len="sm"/>
                </a:ln>
              </p:spPr>
            </p:cxnSp>
            <p:cxnSp>
              <p:nvCxnSpPr>
                <p:cNvPr id="1365" name="Google Shape;1365;p11"/>
                <p:cNvCxnSpPr/>
                <p:nvPr/>
              </p:nvCxnSpPr>
              <p:spPr>
                <a:xfrm>
                  <a:off x="3708" y="3741"/>
                  <a:ext cx="0" cy="9"/>
                </a:xfrm>
                <a:prstGeom prst="straightConnector1">
                  <a:avLst/>
                </a:prstGeom>
                <a:noFill/>
                <a:ln w="9525" cap="flat" cmpd="sng">
                  <a:solidFill>
                    <a:srgbClr val="000000"/>
                  </a:solidFill>
                  <a:prstDash val="solid"/>
                  <a:round/>
                  <a:headEnd type="none" w="sm" len="sm"/>
                  <a:tailEnd type="none" w="sm" len="sm"/>
                </a:ln>
              </p:spPr>
            </p:cxnSp>
            <p:cxnSp>
              <p:nvCxnSpPr>
                <p:cNvPr id="1366" name="Google Shape;1366;p11"/>
                <p:cNvCxnSpPr/>
                <p:nvPr/>
              </p:nvCxnSpPr>
              <p:spPr>
                <a:xfrm>
                  <a:off x="3821" y="3741"/>
                  <a:ext cx="0" cy="9"/>
                </a:xfrm>
                <a:prstGeom prst="straightConnector1">
                  <a:avLst/>
                </a:prstGeom>
                <a:noFill/>
                <a:ln w="9525" cap="flat" cmpd="sng">
                  <a:solidFill>
                    <a:srgbClr val="000000"/>
                  </a:solidFill>
                  <a:prstDash val="solid"/>
                  <a:round/>
                  <a:headEnd type="none" w="sm" len="sm"/>
                  <a:tailEnd type="none" w="sm" len="sm"/>
                </a:ln>
              </p:spPr>
            </p:cxnSp>
            <p:cxnSp>
              <p:nvCxnSpPr>
                <p:cNvPr id="1367" name="Google Shape;1367;p11"/>
                <p:cNvCxnSpPr/>
                <p:nvPr/>
              </p:nvCxnSpPr>
              <p:spPr>
                <a:xfrm>
                  <a:off x="3933" y="3741"/>
                  <a:ext cx="0" cy="15"/>
                </a:xfrm>
                <a:prstGeom prst="straightConnector1">
                  <a:avLst/>
                </a:prstGeom>
                <a:noFill/>
                <a:ln w="9525" cap="flat" cmpd="sng">
                  <a:solidFill>
                    <a:srgbClr val="000000"/>
                  </a:solidFill>
                  <a:prstDash val="solid"/>
                  <a:round/>
                  <a:headEnd type="none" w="sm" len="sm"/>
                  <a:tailEnd type="none" w="sm" len="sm"/>
                </a:ln>
              </p:spPr>
            </p:cxnSp>
            <p:sp>
              <p:nvSpPr>
                <p:cNvPr id="1368" name="Google Shape;1368;p11"/>
                <p:cNvSpPr/>
                <p:nvPr/>
              </p:nvSpPr>
              <p:spPr>
                <a:xfrm>
                  <a:off x="3877" y="3754"/>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0.0</a:t>
                  </a:r>
                  <a:endParaRPr sz="800" b="0" i="0" u="none" strike="noStrike" cap="none">
                    <a:solidFill>
                      <a:srgbClr val="000000"/>
                    </a:solidFill>
                    <a:latin typeface="Arial"/>
                    <a:ea typeface="Arial"/>
                    <a:cs typeface="Arial"/>
                    <a:sym typeface="Arial"/>
                  </a:endParaRPr>
                </a:p>
              </p:txBody>
            </p:sp>
            <p:cxnSp>
              <p:nvCxnSpPr>
                <p:cNvPr id="1369" name="Google Shape;1369;p11"/>
                <p:cNvCxnSpPr/>
                <p:nvPr/>
              </p:nvCxnSpPr>
              <p:spPr>
                <a:xfrm>
                  <a:off x="4046" y="3741"/>
                  <a:ext cx="0" cy="9"/>
                </a:xfrm>
                <a:prstGeom prst="straightConnector1">
                  <a:avLst/>
                </a:prstGeom>
                <a:noFill/>
                <a:ln w="9525" cap="flat" cmpd="sng">
                  <a:solidFill>
                    <a:srgbClr val="000000"/>
                  </a:solidFill>
                  <a:prstDash val="solid"/>
                  <a:round/>
                  <a:headEnd type="none" w="sm" len="sm"/>
                  <a:tailEnd type="none" w="sm" len="sm"/>
                </a:ln>
              </p:spPr>
            </p:cxnSp>
            <p:cxnSp>
              <p:nvCxnSpPr>
                <p:cNvPr id="1370" name="Google Shape;1370;p11"/>
                <p:cNvCxnSpPr/>
                <p:nvPr/>
              </p:nvCxnSpPr>
              <p:spPr>
                <a:xfrm>
                  <a:off x="4159" y="3741"/>
                  <a:ext cx="0" cy="9"/>
                </a:xfrm>
                <a:prstGeom prst="straightConnector1">
                  <a:avLst/>
                </a:prstGeom>
                <a:noFill/>
                <a:ln w="9525" cap="flat" cmpd="sng">
                  <a:solidFill>
                    <a:srgbClr val="000000"/>
                  </a:solidFill>
                  <a:prstDash val="solid"/>
                  <a:round/>
                  <a:headEnd type="none" w="sm" len="sm"/>
                  <a:tailEnd type="none" w="sm" len="sm"/>
                </a:ln>
              </p:spPr>
            </p:cxnSp>
            <p:cxnSp>
              <p:nvCxnSpPr>
                <p:cNvPr id="1371" name="Google Shape;1371;p11"/>
                <p:cNvCxnSpPr/>
                <p:nvPr/>
              </p:nvCxnSpPr>
              <p:spPr>
                <a:xfrm>
                  <a:off x="4272" y="3741"/>
                  <a:ext cx="0" cy="9"/>
                </a:xfrm>
                <a:prstGeom prst="straightConnector1">
                  <a:avLst/>
                </a:prstGeom>
                <a:noFill/>
                <a:ln w="9525" cap="flat" cmpd="sng">
                  <a:solidFill>
                    <a:srgbClr val="000000"/>
                  </a:solidFill>
                  <a:prstDash val="solid"/>
                  <a:round/>
                  <a:headEnd type="none" w="sm" len="sm"/>
                  <a:tailEnd type="none" w="sm" len="sm"/>
                </a:ln>
              </p:spPr>
            </p:cxnSp>
            <p:cxnSp>
              <p:nvCxnSpPr>
                <p:cNvPr id="1372" name="Google Shape;1372;p11"/>
                <p:cNvCxnSpPr/>
                <p:nvPr/>
              </p:nvCxnSpPr>
              <p:spPr>
                <a:xfrm>
                  <a:off x="4384" y="3741"/>
                  <a:ext cx="0" cy="15"/>
                </a:xfrm>
                <a:prstGeom prst="straightConnector1">
                  <a:avLst/>
                </a:prstGeom>
                <a:noFill/>
                <a:ln w="9525" cap="flat" cmpd="sng">
                  <a:solidFill>
                    <a:srgbClr val="000000"/>
                  </a:solidFill>
                  <a:prstDash val="solid"/>
                  <a:round/>
                  <a:headEnd type="none" w="sm" len="sm"/>
                  <a:tailEnd type="none" w="sm" len="sm"/>
                </a:ln>
              </p:spPr>
            </p:cxnSp>
            <p:sp>
              <p:nvSpPr>
                <p:cNvPr id="1373" name="Google Shape;1373;p11"/>
                <p:cNvSpPr/>
                <p:nvPr/>
              </p:nvSpPr>
              <p:spPr>
                <a:xfrm>
                  <a:off x="4330" y="3754"/>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1.0</a:t>
                  </a:r>
                  <a:endParaRPr sz="800" b="0" i="0" u="none" strike="noStrike" cap="none">
                    <a:solidFill>
                      <a:srgbClr val="000000"/>
                    </a:solidFill>
                    <a:latin typeface="Arial"/>
                    <a:ea typeface="Arial"/>
                    <a:cs typeface="Arial"/>
                    <a:sym typeface="Arial"/>
                  </a:endParaRPr>
                </a:p>
              </p:txBody>
            </p:sp>
            <p:cxnSp>
              <p:nvCxnSpPr>
                <p:cNvPr id="1374" name="Google Shape;1374;p11"/>
                <p:cNvCxnSpPr/>
                <p:nvPr/>
              </p:nvCxnSpPr>
              <p:spPr>
                <a:xfrm>
                  <a:off x="4497" y="3741"/>
                  <a:ext cx="0" cy="9"/>
                </a:xfrm>
                <a:prstGeom prst="straightConnector1">
                  <a:avLst/>
                </a:prstGeom>
                <a:noFill/>
                <a:ln w="9525" cap="flat" cmpd="sng">
                  <a:solidFill>
                    <a:srgbClr val="000000"/>
                  </a:solidFill>
                  <a:prstDash val="solid"/>
                  <a:round/>
                  <a:headEnd type="none" w="sm" len="sm"/>
                  <a:tailEnd type="none" w="sm" len="sm"/>
                </a:ln>
              </p:spPr>
            </p:cxnSp>
            <p:cxnSp>
              <p:nvCxnSpPr>
                <p:cNvPr id="1375" name="Google Shape;1375;p11"/>
                <p:cNvCxnSpPr/>
                <p:nvPr/>
              </p:nvCxnSpPr>
              <p:spPr>
                <a:xfrm>
                  <a:off x="4610" y="3741"/>
                  <a:ext cx="0" cy="9"/>
                </a:xfrm>
                <a:prstGeom prst="straightConnector1">
                  <a:avLst/>
                </a:prstGeom>
                <a:noFill/>
                <a:ln w="9525" cap="flat" cmpd="sng">
                  <a:solidFill>
                    <a:srgbClr val="000000"/>
                  </a:solidFill>
                  <a:prstDash val="solid"/>
                  <a:round/>
                  <a:headEnd type="none" w="sm" len="sm"/>
                  <a:tailEnd type="none" w="sm" len="sm"/>
                </a:ln>
              </p:spPr>
            </p:cxnSp>
            <p:cxnSp>
              <p:nvCxnSpPr>
                <p:cNvPr id="1376" name="Google Shape;1376;p11"/>
                <p:cNvCxnSpPr/>
                <p:nvPr/>
              </p:nvCxnSpPr>
              <p:spPr>
                <a:xfrm>
                  <a:off x="4723" y="3741"/>
                  <a:ext cx="0" cy="9"/>
                </a:xfrm>
                <a:prstGeom prst="straightConnector1">
                  <a:avLst/>
                </a:prstGeom>
                <a:noFill/>
                <a:ln w="9525" cap="flat" cmpd="sng">
                  <a:solidFill>
                    <a:srgbClr val="000000"/>
                  </a:solidFill>
                  <a:prstDash val="solid"/>
                  <a:round/>
                  <a:headEnd type="none" w="sm" len="sm"/>
                  <a:tailEnd type="none" w="sm" len="sm"/>
                </a:ln>
              </p:spPr>
            </p:cxnSp>
            <p:cxnSp>
              <p:nvCxnSpPr>
                <p:cNvPr id="1377" name="Google Shape;1377;p11"/>
                <p:cNvCxnSpPr/>
                <p:nvPr/>
              </p:nvCxnSpPr>
              <p:spPr>
                <a:xfrm>
                  <a:off x="4835" y="3741"/>
                  <a:ext cx="0" cy="15"/>
                </a:xfrm>
                <a:prstGeom prst="straightConnector1">
                  <a:avLst/>
                </a:prstGeom>
                <a:noFill/>
                <a:ln w="9525" cap="flat" cmpd="sng">
                  <a:solidFill>
                    <a:srgbClr val="000000"/>
                  </a:solidFill>
                  <a:prstDash val="solid"/>
                  <a:round/>
                  <a:headEnd type="none" w="sm" len="sm"/>
                  <a:tailEnd type="none" w="sm" len="sm"/>
                </a:ln>
              </p:spPr>
            </p:cxnSp>
            <p:sp>
              <p:nvSpPr>
                <p:cNvPr id="1378" name="Google Shape;1378;p11"/>
                <p:cNvSpPr/>
                <p:nvPr/>
              </p:nvSpPr>
              <p:spPr>
                <a:xfrm>
                  <a:off x="4778" y="3754"/>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2.0</a:t>
                  </a:r>
                  <a:endParaRPr sz="800" b="0" i="0" u="none" strike="noStrike" cap="none">
                    <a:solidFill>
                      <a:srgbClr val="000000"/>
                    </a:solidFill>
                    <a:latin typeface="Arial"/>
                    <a:ea typeface="Arial"/>
                    <a:cs typeface="Arial"/>
                    <a:sym typeface="Arial"/>
                  </a:endParaRPr>
                </a:p>
              </p:txBody>
            </p:sp>
            <p:cxnSp>
              <p:nvCxnSpPr>
                <p:cNvPr id="1379" name="Google Shape;1379;p11"/>
                <p:cNvCxnSpPr/>
                <p:nvPr/>
              </p:nvCxnSpPr>
              <p:spPr>
                <a:xfrm>
                  <a:off x="4948" y="3741"/>
                  <a:ext cx="0" cy="9"/>
                </a:xfrm>
                <a:prstGeom prst="straightConnector1">
                  <a:avLst/>
                </a:prstGeom>
                <a:noFill/>
                <a:ln w="9525" cap="flat" cmpd="sng">
                  <a:solidFill>
                    <a:srgbClr val="000000"/>
                  </a:solidFill>
                  <a:prstDash val="solid"/>
                  <a:round/>
                  <a:headEnd type="none" w="sm" len="sm"/>
                  <a:tailEnd type="none" w="sm" len="sm"/>
                </a:ln>
              </p:spPr>
            </p:cxnSp>
            <p:cxnSp>
              <p:nvCxnSpPr>
                <p:cNvPr id="1380" name="Google Shape;1380;p11"/>
                <p:cNvCxnSpPr/>
                <p:nvPr/>
              </p:nvCxnSpPr>
              <p:spPr>
                <a:xfrm>
                  <a:off x="5061" y="3741"/>
                  <a:ext cx="0" cy="9"/>
                </a:xfrm>
                <a:prstGeom prst="straightConnector1">
                  <a:avLst/>
                </a:prstGeom>
                <a:noFill/>
                <a:ln w="9525" cap="flat" cmpd="sng">
                  <a:solidFill>
                    <a:srgbClr val="000000"/>
                  </a:solidFill>
                  <a:prstDash val="solid"/>
                  <a:round/>
                  <a:headEnd type="none" w="sm" len="sm"/>
                  <a:tailEnd type="none" w="sm" len="sm"/>
                </a:ln>
              </p:spPr>
            </p:cxnSp>
            <p:cxnSp>
              <p:nvCxnSpPr>
                <p:cNvPr id="1381" name="Google Shape;1381;p11"/>
                <p:cNvCxnSpPr/>
                <p:nvPr/>
              </p:nvCxnSpPr>
              <p:spPr>
                <a:xfrm>
                  <a:off x="5174" y="3741"/>
                  <a:ext cx="0" cy="9"/>
                </a:xfrm>
                <a:prstGeom prst="straightConnector1">
                  <a:avLst/>
                </a:prstGeom>
                <a:noFill/>
                <a:ln w="9525" cap="flat" cmpd="sng">
                  <a:solidFill>
                    <a:srgbClr val="000000"/>
                  </a:solidFill>
                  <a:prstDash val="solid"/>
                  <a:round/>
                  <a:headEnd type="none" w="sm" len="sm"/>
                  <a:tailEnd type="none" w="sm" len="sm"/>
                </a:ln>
              </p:spPr>
            </p:cxnSp>
            <p:cxnSp>
              <p:nvCxnSpPr>
                <p:cNvPr id="1382" name="Google Shape;1382;p11"/>
                <p:cNvCxnSpPr/>
                <p:nvPr/>
              </p:nvCxnSpPr>
              <p:spPr>
                <a:xfrm>
                  <a:off x="5286" y="3741"/>
                  <a:ext cx="0" cy="15"/>
                </a:xfrm>
                <a:prstGeom prst="straightConnector1">
                  <a:avLst/>
                </a:prstGeom>
                <a:noFill/>
                <a:ln w="9525" cap="flat" cmpd="sng">
                  <a:solidFill>
                    <a:srgbClr val="000000"/>
                  </a:solidFill>
                  <a:prstDash val="solid"/>
                  <a:round/>
                  <a:headEnd type="none" w="sm" len="sm"/>
                  <a:tailEnd type="none" w="sm" len="sm"/>
                </a:ln>
              </p:spPr>
            </p:cxnSp>
            <p:sp>
              <p:nvSpPr>
                <p:cNvPr id="1383" name="Google Shape;1383;p11"/>
                <p:cNvSpPr/>
                <p:nvPr/>
              </p:nvSpPr>
              <p:spPr>
                <a:xfrm>
                  <a:off x="5229" y="3754"/>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3.0</a:t>
                  </a:r>
                  <a:endParaRPr sz="800" b="0" i="0" u="none" strike="noStrike" cap="none">
                    <a:solidFill>
                      <a:srgbClr val="000000"/>
                    </a:solidFill>
                    <a:latin typeface="Arial"/>
                    <a:ea typeface="Arial"/>
                    <a:cs typeface="Arial"/>
                    <a:sym typeface="Arial"/>
                  </a:endParaRPr>
                </a:p>
              </p:txBody>
            </p:sp>
            <p:cxnSp>
              <p:nvCxnSpPr>
                <p:cNvPr id="1384" name="Google Shape;1384;p11"/>
                <p:cNvCxnSpPr/>
                <p:nvPr/>
              </p:nvCxnSpPr>
              <p:spPr>
                <a:xfrm>
                  <a:off x="5399" y="3741"/>
                  <a:ext cx="0" cy="9"/>
                </a:xfrm>
                <a:prstGeom prst="straightConnector1">
                  <a:avLst/>
                </a:prstGeom>
                <a:noFill/>
                <a:ln w="9525" cap="flat" cmpd="sng">
                  <a:solidFill>
                    <a:srgbClr val="000000"/>
                  </a:solidFill>
                  <a:prstDash val="solid"/>
                  <a:round/>
                  <a:headEnd type="none" w="sm" len="sm"/>
                  <a:tailEnd type="none" w="sm" len="sm"/>
                </a:ln>
              </p:spPr>
            </p:cxnSp>
            <p:cxnSp>
              <p:nvCxnSpPr>
                <p:cNvPr id="1385" name="Google Shape;1385;p11"/>
                <p:cNvCxnSpPr/>
                <p:nvPr/>
              </p:nvCxnSpPr>
              <p:spPr>
                <a:xfrm>
                  <a:off x="5512" y="3741"/>
                  <a:ext cx="0" cy="9"/>
                </a:xfrm>
                <a:prstGeom prst="straightConnector1">
                  <a:avLst/>
                </a:prstGeom>
                <a:noFill/>
                <a:ln w="9525" cap="flat" cmpd="sng">
                  <a:solidFill>
                    <a:srgbClr val="000000"/>
                  </a:solidFill>
                  <a:prstDash val="solid"/>
                  <a:round/>
                  <a:headEnd type="none" w="sm" len="sm"/>
                  <a:tailEnd type="none" w="sm" len="sm"/>
                </a:ln>
              </p:spPr>
            </p:cxnSp>
            <p:cxnSp>
              <p:nvCxnSpPr>
                <p:cNvPr id="1386" name="Google Shape;1386;p11"/>
                <p:cNvCxnSpPr/>
                <p:nvPr/>
              </p:nvCxnSpPr>
              <p:spPr>
                <a:xfrm>
                  <a:off x="5625" y="3741"/>
                  <a:ext cx="0" cy="9"/>
                </a:xfrm>
                <a:prstGeom prst="straightConnector1">
                  <a:avLst/>
                </a:prstGeom>
                <a:noFill/>
                <a:ln w="9525" cap="flat" cmpd="sng">
                  <a:solidFill>
                    <a:srgbClr val="000000"/>
                  </a:solidFill>
                  <a:prstDash val="solid"/>
                  <a:round/>
                  <a:headEnd type="none" w="sm" len="sm"/>
                  <a:tailEnd type="none" w="sm" len="sm"/>
                </a:ln>
              </p:spPr>
            </p:cxnSp>
            <p:cxnSp>
              <p:nvCxnSpPr>
                <p:cNvPr id="1387" name="Google Shape;1387;p11"/>
                <p:cNvCxnSpPr/>
                <p:nvPr/>
              </p:nvCxnSpPr>
              <p:spPr>
                <a:xfrm>
                  <a:off x="5737" y="3741"/>
                  <a:ext cx="0" cy="15"/>
                </a:xfrm>
                <a:prstGeom prst="straightConnector1">
                  <a:avLst/>
                </a:prstGeom>
                <a:noFill/>
                <a:ln w="9525" cap="flat" cmpd="sng">
                  <a:solidFill>
                    <a:srgbClr val="000000"/>
                  </a:solidFill>
                  <a:prstDash val="solid"/>
                  <a:round/>
                  <a:headEnd type="none" w="sm" len="sm"/>
                  <a:tailEnd type="none" w="sm" len="sm"/>
                </a:ln>
              </p:spPr>
            </p:cxnSp>
            <p:sp>
              <p:nvSpPr>
                <p:cNvPr id="1388" name="Google Shape;1388;p11"/>
                <p:cNvSpPr/>
                <p:nvPr/>
              </p:nvSpPr>
              <p:spPr>
                <a:xfrm>
                  <a:off x="5679" y="3754"/>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4.0</a:t>
                  </a:r>
                  <a:endParaRPr sz="800" b="0" i="0" u="none" strike="noStrike" cap="none">
                    <a:solidFill>
                      <a:srgbClr val="000000"/>
                    </a:solidFill>
                    <a:latin typeface="Arial"/>
                    <a:ea typeface="Arial"/>
                    <a:cs typeface="Arial"/>
                    <a:sym typeface="Arial"/>
                  </a:endParaRPr>
                </a:p>
              </p:txBody>
            </p:sp>
            <p:cxnSp>
              <p:nvCxnSpPr>
                <p:cNvPr id="1389" name="Google Shape;1389;p11"/>
                <p:cNvCxnSpPr/>
                <p:nvPr/>
              </p:nvCxnSpPr>
              <p:spPr>
                <a:xfrm>
                  <a:off x="5850" y="3741"/>
                  <a:ext cx="0" cy="9"/>
                </a:xfrm>
                <a:prstGeom prst="straightConnector1">
                  <a:avLst/>
                </a:prstGeom>
                <a:noFill/>
                <a:ln w="9525" cap="flat" cmpd="sng">
                  <a:solidFill>
                    <a:srgbClr val="000000"/>
                  </a:solidFill>
                  <a:prstDash val="solid"/>
                  <a:round/>
                  <a:headEnd type="none" w="sm" len="sm"/>
                  <a:tailEnd type="none" w="sm" len="sm"/>
                </a:ln>
              </p:spPr>
            </p:cxnSp>
            <p:cxnSp>
              <p:nvCxnSpPr>
                <p:cNvPr id="1390" name="Google Shape;1390;p11"/>
                <p:cNvCxnSpPr/>
                <p:nvPr/>
              </p:nvCxnSpPr>
              <p:spPr>
                <a:xfrm>
                  <a:off x="5963" y="3741"/>
                  <a:ext cx="0" cy="9"/>
                </a:xfrm>
                <a:prstGeom prst="straightConnector1">
                  <a:avLst/>
                </a:prstGeom>
                <a:noFill/>
                <a:ln w="9525" cap="flat" cmpd="sng">
                  <a:solidFill>
                    <a:srgbClr val="000000"/>
                  </a:solidFill>
                  <a:prstDash val="solid"/>
                  <a:round/>
                  <a:headEnd type="none" w="sm" len="sm"/>
                  <a:tailEnd type="none" w="sm" len="sm"/>
                </a:ln>
              </p:spPr>
            </p:cxnSp>
            <p:cxnSp>
              <p:nvCxnSpPr>
                <p:cNvPr id="1391" name="Google Shape;1391;p11"/>
                <p:cNvCxnSpPr/>
                <p:nvPr/>
              </p:nvCxnSpPr>
              <p:spPr>
                <a:xfrm>
                  <a:off x="6075" y="3741"/>
                  <a:ext cx="0" cy="9"/>
                </a:xfrm>
                <a:prstGeom prst="straightConnector1">
                  <a:avLst/>
                </a:prstGeom>
                <a:noFill/>
                <a:ln w="9525" cap="flat" cmpd="sng">
                  <a:solidFill>
                    <a:srgbClr val="000000"/>
                  </a:solidFill>
                  <a:prstDash val="solid"/>
                  <a:round/>
                  <a:headEnd type="none" w="sm" len="sm"/>
                  <a:tailEnd type="none" w="sm" len="sm"/>
                </a:ln>
              </p:spPr>
            </p:cxnSp>
            <p:cxnSp>
              <p:nvCxnSpPr>
                <p:cNvPr id="1392" name="Google Shape;1392;p11"/>
                <p:cNvCxnSpPr/>
                <p:nvPr/>
              </p:nvCxnSpPr>
              <p:spPr>
                <a:xfrm>
                  <a:off x="6188" y="3741"/>
                  <a:ext cx="0" cy="15"/>
                </a:xfrm>
                <a:prstGeom prst="straightConnector1">
                  <a:avLst/>
                </a:prstGeom>
                <a:noFill/>
                <a:ln w="9525" cap="flat" cmpd="sng">
                  <a:solidFill>
                    <a:srgbClr val="000000"/>
                  </a:solidFill>
                  <a:prstDash val="solid"/>
                  <a:round/>
                  <a:headEnd type="none" w="sm" len="sm"/>
                  <a:tailEnd type="none" w="sm" len="sm"/>
                </a:ln>
              </p:spPr>
            </p:cxnSp>
            <p:sp>
              <p:nvSpPr>
                <p:cNvPr id="1393" name="Google Shape;1393;p11"/>
                <p:cNvSpPr/>
                <p:nvPr/>
              </p:nvSpPr>
              <p:spPr>
                <a:xfrm>
                  <a:off x="6130" y="3754"/>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5.0</a:t>
                  </a:r>
                  <a:endParaRPr sz="800" b="0" i="0" u="none" strike="noStrike" cap="none">
                    <a:solidFill>
                      <a:srgbClr val="000000"/>
                    </a:solidFill>
                    <a:latin typeface="Arial"/>
                    <a:ea typeface="Arial"/>
                    <a:cs typeface="Arial"/>
                    <a:sym typeface="Arial"/>
                  </a:endParaRPr>
                </a:p>
              </p:txBody>
            </p:sp>
            <p:cxnSp>
              <p:nvCxnSpPr>
                <p:cNvPr id="1394" name="Google Shape;1394;p11"/>
                <p:cNvCxnSpPr/>
                <p:nvPr/>
              </p:nvCxnSpPr>
              <p:spPr>
                <a:xfrm>
                  <a:off x="6301" y="3741"/>
                  <a:ext cx="0" cy="9"/>
                </a:xfrm>
                <a:prstGeom prst="straightConnector1">
                  <a:avLst/>
                </a:prstGeom>
                <a:noFill/>
                <a:ln w="9525" cap="flat" cmpd="sng">
                  <a:solidFill>
                    <a:srgbClr val="000000"/>
                  </a:solidFill>
                  <a:prstDash val="solid"/>
                  <a:round/>
                  <a:headEnd type="none" w="sm" len="sm"/>
                  <a:tailEnd type="none" w="sm" len="sm"/>
                </a:ln>
              </p:spPr>
            </p:cxnSp>
            <p:cxnSp>
              <p:nvCxnSpPr>
                <p:cNvPr id="1395" name="Google Shape;1395;p11"/>
                <p:cNvCxnSpPr/>
                <p:nvPr/>
              </p:nvCxnSpPr>
              <p:spPr>
                <a:xfrm>
                  <a:off x="6413" y="3741"/>
                  <a:ext cx="0" cy="15"/>
                </a:xfrm>
                <a:prstGeom prst="straightConnector1">
                  <a:avLst/>
                </a:prstGeom>
                <a:noFill/>
                <a:ln w="9525" cap="flat" cmpd="sng">
                  <a:solidFill>
                    <a:srgbClr val="000000"/>
                  </a:solidFill>
                  <a:prstDash val="solid"/>
                  <a:round/>
                  <a:headEnd type="none" w="sm" len="sm"/>
                  <a:tailEnd type="none" w="sm" len="sm"/>
                </a:ln>
              </p:spPr>
            </p:cxnSp>
            <p:sp>
              <p:nvSpPr>
                <p:cNvPr id="1396" name="Google Shape;1396;p11"/>
                <p:cNvSpPr/>
                <p:nvPr/>
              </p:nvSpPr>
              <p:spPr>
                <a:xfrm>
                  <a:off x="6356" y="3754"/>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5.5</a:t>
                  </a:r>
                  <a:endParaRPr sz="800" b="0" i="0" u="none" strike="noStrike" cap="none">
                    <a:solidFill>
                      <a:srgbClr val="000000"/>
                    </a:solidFill>
                    <a:latin typeface="Arial"/>
                    <a:ea typeface="Arial"/>
                    <a:cs typeface="Arial"/>
                    <a:sym typeface="Arial"/>
                  </a:endParaRPr>
                </a:p>
              </p:txBody>
            </p:sp>
            <p:cxnSp>
              <p:nvCxnSpPr>
                <p:cNvPr id="1397" name="Google Shape;1397;p11"/>
                <p:cNvCxnSpPr/>
                <p:nvPr/>
              </p:nvCxnSpPr>
              <p:spPr>
                <a:xfrm>
                  <a:off x="1441" y="1243"/>
                  <a:ext cx="0" cy="2486"/>
                </a:xfrm>
                <a:prstGeom prst="straightConnector1">
                  <a:avLst/>
                </a:prstGeom>
                <a:noFill/>
                <a:ln w="9525" cap="flat" cmpd="sng">
                  <a:solidFill>
                    <a:srgbClr val="000000"/>
                  </a:solidFill>
                  <a:prstDash val="solid"/>
                  <a:round/>
                  <a:headEnd type="none" w="sm" len="sm"/>
                  <a:tailEnd type="none" w="sm" len="sm"/>
                </a:ln>
              </p:spPr>
            </p:cxnSp>
            <p:cxnSp>
              <p:nvCxnSpPr>
                <p:cNvPr id="1398" name="Google Shape;1398;p11"/>
                <p:cNvCxnSpPr/>
                <p:nvPr/>
              </p:nvCxnSpPr>
              <p:spPr>
                <a:xfrm rot="10800000">
                  <a:off x="1426" y="3729"/>
                  <a:ext cx="15" cy="0"/>
                </a:xfrm>
                <a:prstGeom prst="straightConnector1">
                  <a:avLst/>
                </a:prstGeom>
                <a:noFill/>
                <a:ln w="9525" cap="flat" cmpd="sng">
                  <a:solidFill>
                    <a:srgbClr val="000000"/>
                  </a:solidFill>
                  <a:prstDash val="solid"/>
                  <a:round/>
                  <a:headEnd type="none" w="sm" len="sm"/>
                  <a:tailEnd type="none" w="sm" len="sm"/>
                </a:ln>
              </p:spPr>
            </p:cxnSp>
            <p:sp>
              <p:nvSpPr>
                <p:cNvPr id="1399" name="Google Shape;1399;p11"/>
                <p:cNvSpPr/>
                <p:nvPr/>
              </p:nvSpPr>
              <p:spPr>
                <a:xfrm>
                  <a:off x="1208" y="3682"/>
                  <a:ext cx="202"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0.0</a:t>
                  </a:r>
                  <a:endParaRPr sz="800" b="0" i="0" u="none" strike="noStrike" cap="none">
                    <a:solidFill>
                      <a:srgbClr val="000000"/>
                    </a:solidFill>
                    <a:latin typeface="Arial"/>
                    <a:ea typeface="Arial"/>
                    <a:cs typeface="Arial"/>
                    <a:sym typeface="Arial"/>
                  </a:endParaRPr>
                </a:p>
              </p:txBody>
            </p:sp>
            <p:cxnSp>
              <p:nvCxnSpPr>
                <p:cNvPr id="1400" name="Google Shape;1400;p11"/>
                <p:cNvCxnSpPr/>
                <p:nvPr/>
              </p:nvCxnSpPr>
              <p:spPr>
                <a:xfrm rot="10800000">
                  <a:off x="1426" y="3729"/>
                  <a:ext cx="15" cy="0"/>
                </a:xfrm>
                <a:prstGeom prst="straightConnector1">
                  <a:avLst/>
                </a:prstGeom>
                <a:noFill/>
                <a:ln w="9525" cap="flat" cmpd="sng">
                  <a:solidFill>
                    <a:srgbClr val="000000"/>
                  </a:solidFill>
                  <a:prstDash val="solid"/>
                  <a:round/>
                  <a:headEnd type="none" w="sm" len="sm"/>
                  <a:tailEnd type="none" w="sm" len="sm"/>
                </a:ln>
              </p:spPr>
            </p:cxnSp>
            <p:cxnSp>
              <p:nvCxnSpPr>
                <p:cNvPr id="1401" name="Google Shape;1401;p11"/>
                <p:cNvCxnSpPr/>
                <p:nvPr/>
              </p:nvCxnSpPr>
              <p:spPr>
                <a:xfrm rot="10800000">
                  <a:off x="1432" y="3651"/>
                  <a:ext cx="9" cy="0"/>
                </a:xfrm>
                <a:prstGeom prst="straightConnector1">
                  <a:avLst/>
                </a:prstGeom>
                <a:noFill/>
                <a:ln w="9525" cap="flat" cmpd="sng">
                  <a:solidFill>
                    <a:srgbClr val="000000"/>
                  </a:solidFill>
                  <a:prstDash val="solid"/>
                  <a:round/>
                  <a:headEnd type="none" w="sm" len="sm"/>
                  <a:tailEnd type="none" w="sm" len="sm"/>
                </a:ln>
              </p:spPr>
            </p:cxnSp>
            <p:cxnSp>
              <p:nvCxnSpPr>
                <p:cNvPr id="1402" name="Google Shape;1402;p11"/>
                <p:cNvCxnSpPr/>
                <p:nvPr/>
              </p:nvCxnSpPr>
              <p:spPr>
                <a:xfrm rot="10800000">
                  <a:off x="1432" y="3573"/>
                  <a:ext cx="9" cy="0"/>
                </a:xfrm>
                <a:prstGeom prst="straightConnector1">
                  <a:avLst/>
                </a:prstGeom>
                <a:noFill/>
                <a:ln w="9525" cap="flat" cmpd="sng">
                  <a:solidFill>
                    <a:srgbClr val="000000"/>
                  </a:solidFill>
                  <a:prstDash val="solid"/>
                  <a:round/>
                  <a:headEnd type="none" w="sm" len="sm"/>
                  <a:tailEnd type="none" w="sm" len="sm"/>
                </a:ln>
              </p:spPr>
            </p:cxnSp>
            <p:cxnSp>
              <p:nvCxnSpPr>
                <p:cNvPr id="1403" name="Google Shape;1403;p11"/>
                <p:cNvCxnSpPr/>
                <p:nvPr/>
              </p:nvCxnSpPr>
              <p:spPr>
                <a:xfrm rot="10800000">
                  <a:off x="1432" y="3496"/>
                  <a:ext cx="9" cy="0"/>
                </a:xfrm>
                <a:prstGeom prst="straightConnector1">
                  <a:avLst/>
                </a:prstGeom>
                <a:noFill/>
                <a:ln w="9525" cap="flat" cmpd="sng">
                  <a:solidFill>
                    <a:srgbClr val="000000"/>
                  </a:solidFill>
                  <a:prstDash val="solid"/>
                  <a:round/>
                  <a:headEnd type="none" w="sm" len="sm"/>
                  <a:tailEnd type="none" w="sm" len="sm"/>
                </a:ln>
              </p:spPr>
            </p:cxnSp>
            <p:cxnSp>
              <p:nvCxnSpPr>
                <p:cNvPr id="1404" name="Google Shape;1404;p11"/>
                <p:cNvCxnSpPr/>
                <p:nvPr/>
              </p:nvCxnSpPr>
              <p:spPr>
                <a:xfrm rot="10800000">
                  <a:off x="1426" y="3418"/>
                  <a:ext cx="15" cy="0"/>
                </a:xfrm>
                <a:prstGeom prst="straightConnector1">
                  <a:avLst/>
                </a:prstGeom>
                <a:noFill/>
                <a:ln w="9525" cap="flat" cmpd="sng">
                  <a:solidFill>
                    <a:srgbClr val="000000"/>
                  </a:solidFill>
                  <a:prstDash val="solid"/>
                  <a:round/>
                  <a:headEnd type="none" w="sm" len="sm"/>
                  <a:tailEnd type="none" w="sm" len="sm"/>
                </a:ln>
              </p:spPr>
            </p:cxnSp>
            <p:sp>
              <p:nvSpPr>
                <p:cNvPr id="1405" name="Google Shape;1405;p11"/>
                <p:cNvSpPr/>
                <p:nvPr/>
              </p:nvSpPr>
              <p:spPr>
                <a:xfrm>
                  <a:off x="1259" y="3371"/>
                  <a:ext cx="12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0.0</a:t>
                  </a:r>
                  <a:endParaRPr sz="800" b="0" i="0" u="none" strike="noStrike" cap="none">
                    <a:solidFill>
                      <a:srgbClr val="000000"/>
                    </a:solidFill>
                    <a:latin typeface="Arial"/>
                    <a:ea typeface="Arial"/>
                    <a:cs typeface="Arial"/>
                    <a:sym typeface="Arial"/>
                  </a:endParaRPr>
                </a:p>
              </p:txBody>
            </p:sp>
            <p:cxnSp>
              <p:nvCxnSpPr>
                <p:cNvPr id="1406" name="Google Shape;1406;p11"/>
                <p:cNvCxnSpPr/>
                <p:nvPr/>
              </p:nvCxnSpPr>
              <p:spPr>
                <a:xfrm rot="10800000">
                  <a:off x="1432" y="3340"/>
                  <a:ext cx="9" cy="0"/>
                </a:xfrm>
                <a:prstGeom prst="straightConnector1">
                  <a:avLst/>
                </a:prstGeom>
                <a:noFill/>
                <a:ln w="9525" cap="flat" cmpd="sng">
                  <a:solidFill>
                    <a:srgbClr val="000000"/>
                  </a:solidFill>
                  <a:prstDash val="solid"/>
                  <a:round/>
                  <a:headEnd type="none" w="sm" len="sm"/>
                  <a:tailEnd type="none" w="sm" len="sm"/>
                </a:ln>
              </p:spPr>
            </p:cxnSp>
            <p:cxnSp>
              <p:nvCxnSpPr>
                <p:cNvPr id="1407" name="Google Shape;1407;p11"/>
                <p:cNvCxnSpPr/>
                <p:nvPr/>
              </p:nvCxnSpPr>
              <p:spPr>
                <a:xfrm rot="10800000">
                  <a:off x="1432" y="3262"/>
                  <a:ext cx="9" cy="0"/>
                </a:xfrm>
                <a:prstGeom prst="straightConnector1">
                  <a:avLst/>
                </a:prstGeom>
                <a:noFill/>
                <a:ln w="9525" cap="flat" cmpd="sng">
                  <a:solidFill>
                    <a:srgbClr val="000000"/>
                  </a:solidFill>
                  <a:prstDash val="solid"/>
                  <a:round/>
                  <a:headEnd type="none" w="sm" len="sm"/>
                  <a:tailEnd type="none" w="sm" len="sm"/>
                </a:ln>
              </p:spPr>
            </p:cxnSp>
            <p:cxnSp>
              <p:nvCxnSpPr>
                <p:cNvPr id="1408" name="Google Shape;1408;p11"/>
                <p:cNvCxnSpPr/>
                <p:nvPr/>
              </p:nvCxnSpPr>
              <p:spPr>
                <a:xfrm rot="10800000">
                  <a:off x="1432" y="3185"/>
                  <a:ext cx="9" cy="0"/>
                </a:xfrm>
                <a:prstGeom prst="straightConnector1">
                  <a:avLst/>
                </a:prstGeom>
                <a:noFill/>
                <a:ln w="9525" cap="flat" cmpd="sng">
                  <a:solidFill>
                    <a:srgbClr val="000000"/>
                  </a:solidFill>
                  <a:prstDash val="solid"/>
                  <a:round/>
                  <a:headEnd type="none" w="sm" len="sm"/>
                  <a:tailEnd type="none" w="sm" len="sm"/>
                </a:ln>
              </p:spPr>
            </p:cxnSp>
            <p:cxnSp>
              <p:nvCxnSpPr>
                <p:cNvPr id="1409" name="Google Shape;1409;p11"/>
                <p:cNvCxnSpPr/>
                <p:nvPr/>
              </p:nvCxnSpPr>
              <p:spPr>
                <a:xfrm rot="10800000">
                  <a:off x="1426" y="3107"/>
                  <a:ext cx="15" cy="0"/>
                </a:xfrm>
                <a:prstGeom prst="straightConnector1">
                  <a:avLst/>
                </a:prstGeom>
                <a:noFill/>
                <a:ln w="9525" cap="flat" cmpd="sng">
                  <a:solidFill>
                    <a:srgbClr val="000000"/>
                  </a:solidFill>
                  <a:prstDash val="solid"/>
                  <a:round/>
                  <a:headEnd type="none" w="sm" len="sm"/>
                  <a:tailEnd type="none" w="sm" len="sm"/>
                </a:ln>
              </p:spPr>
            </p:cxnSp>
            <p:sp>
              <p:nvSpPr>
                <p:cNvPr id="1410" name="Google Shape;1410;p11"/>
                <p:cNvSpPr/>
                <p:nvPr/>
              </p:nvSpPr>
              <p:spPr>
                <a:xfrm>
                  <a:off x="1227" y="3060"/>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0.0</a:t>
                  </a:r>
                  <a:endParaRPr sz="800" b="0" i="0" u="none" strike="noStrike" cap="none">
                    <a:solidFill>
                      <a:srgbClr val="000000"/>
                    </a:solidFill>
                    <a:latin typeface="Arial"/>
                    <a:ea typeface="Arial"/>
                    <a:cs typeface="Arial"/>
                    <a:sym typeface="Arial"/>
                  </a:endParaRPr>
                </a:p>
              </p:txBody>
            </p:sp>
            <p:cxnSp>
              <p:nvCxnSpPr>
                <p:cNvPr id="1411" name="Google Shape;1411;p11"/>
                <p:cNvCxnSpPr/>
                <p:nvPr/>
              </p:nvCxnSpPr>
              <p:spPr>
                <a:xfrm rot="10800000">
                  <a:off x="1432" y="3030"/>
                  <a:ext cx="9" cy="0"/>
                </a:xfrm>
                <a:prstGeom prst="straightConnector1">
                  <a:avLst/>
                </a:prstGeom>
                <a:noFill/>
                <a:ln w="9525" cap="flat" cmpd="sng">
                  <a:solidFill>
                    <a:srgbClr val="000000"/>
                  </a:solidFill>
                  <a:prstDash val="solid"/>
                  <a:round/>
                  <a:headEnd type="none" w="sm" len="sm"/>
                  <a:tailEnd type="none" w="sm" len="sm"/>
                </a:ln>
              </p:spPr>
            </p:cxnSp>
            <p:cxnSp>
              <p:nvCxnSpPr>
                <p:cNvPr id="1412" name="Google Shape;1412;p11"/>
                <p:cNvCxnSpPr/>
                <p:nvPr/>
              </p:nvCxnSpPr>
              <p:spPr>
                <a:xfrm rot="10800000">
                  <a:off x="1432" y="2952"/>
                  <a:ext cx="9" cy="0"/>
                </a:xfrm>
                <a:prstGeom prst="straightConnector1">
                  <a:avLst/>
                </a:prstGeom>
                <a:noFill/>
                <a:ln w="9525" cap="flat" cmpd="sng">
                  <a:solidFill>
                    <a:srgbClr val="000000"/>
                  </a:solidFill>
                  <a:prstDash val="solid"/>
                  <a:round/>
                  <a:headEnd type="none" w="sm" len="sm"/>
                  <a:tailEnd type="none" w="sm" len="sm"/>
                </a:ln>
              </p:spPr>
            </p:cxnSp>
            <p:cxnSp>
              <p:nvCxnSpPr>
                <p:cNvPr id="1413" name="Google Shape;1413;p11"/>
                <p:cNvCxnSpPr/>
                <p:nvPr/>
              </p:nvCxnSpPr>
              <p:spPr>
                <a:xfrm rot="10800000">
                  <a:off x="1432" y="2874"/>
                  <a:ext cx="9" cy="0"/>
                </a:xfrm>
                <a:prstGeom prst="straightConnector1">
                  <a:avLst/>
                </a:prstGeom>
                <a:noFill/>
                <a:ln w="9525" cap="flat" cmpd="sng">
                  <a:solidFill>
                    <a:srgbClr val="000000"/>
                  </a:solidFill>
                  <a:prstDash val="solid"/>
                  <a:round/>
                  <a:headEnd type="none" w="sm" len="sm"/>
                  <a:tailEnd type="none" w="sm" len="sm"/>
                </a:ln>
              </p:spPr>
            </p:cxnSp>
            <p:cxnSp>
              <p:nvCxnSpPr>
                <p:cNvPr id="1414" name="Google Shape;1414;p11"/>
                <p:cNvCxnSpPr/>
                <p:nvPr/>
              </p:nvCxnSpPr>
              <p:spPr>
                <a:xfrm rot="10800000">
                  <a:off x="1426" y="2797"/>
                  <a:ext cx="15" cy="0"/>
                </a:xfrm>
                <a:prstGeom prst="straightConnector1">
                  <a:avLst/>
                </a:prstGeom>
                <a:noFill/>
                <a:ln w="9525" cap="flat" cmpd="sng">
                  <a:solidFill>
                    <a:srgbClr val="000000"/>
                  </a:solidFill>
                  <a:prstDash val="solid"/>
                  <a:round/>
                  <a:headEnd type="none" w="sm" len="sm"/>
                  <a:tailEnd type="none" w="sm" len="sm"/>
                </a:ln>
              </p:spPr>
            </p:cxnSp>
            <p:sp>
              <p:nvSpPr>
                <p:cNvPr id="1415" name="Google Shape;1415;p11"/>
                <p:cNvSpPr/>
                <p:nvPr/>
              </p:nvSpPr>
              <p:spPr>
                <a:xfrm>
                  <a:off x="1227" y="2749"/>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20.0</a:t>
                  </a:r>
                  <a:endParaRPr sz="800" b="0" i="0" u="none" strike="noStrike" cap="none">
                    <a:solidFill>
                      <a:srgbClr val="000000"/>
                    </a:solidFill>
                    <a:latin typeface="Arial"/>
                    <a:ea typeface="Arial"/>
                    <a:cs typeface="Arial"/>
                    <a:sym typeface="Arial"/>
                  </a:endParaRPr>
                </a:p>
              </p:txBody>
            </p:sp>
            <p:cxnSp>
              <p:nvCxnSpPr>
                <p:cNvPr id="1416" name="Google Shape;1416;p11"/>
                <p:cNvCxnSpPr/>
                <p:nvPr/>
              </p:nvCxnSpPr>
              <p:spPr>
                <a:xfrm rot="10800000">
                  <a:off x="1432" y="2719"/>
                  <a:ext cx="9" cy="0"/>
                </a:xfrm>
                <a:prstGeom prst="straightConnector1">
                  <a:avLst/>
                </a:prstGeom>
                <a:noFill/>
                <a:ln w="9525" cap="flat" cmpd="sng">
                  <a:solidFill>
                    <a:srgbClr val="000000"/>
                  </a:solidFill>
                  <a:prstDash val="solid"/>
                  <a:round/>
                  <a:headEnd type="none" w="sm" len="sm"/>
                  <a:tailEnd type="none" w="sm" len="sm"/>
                </a:ln>
              </p:spPr>
            </p:cxnSp>
            <p:cxnSp>
              <p:nvCxnSpPr>
                <p:cNvPr id="1417" name="Google Shape;1417;p11"/>
                <p:cNvCxnSpPr/>
                <p:nvPr/>
              </p:nvCxnSpPr>
              <p:spPr>
                <a:xfrm rot="10800000">
                  <a:off x="1432" y="2641"/>
                  <a:ext cx="9" cy="0"/>
                </a:xfrm>
                <a:prstGeom prst="straightConnector1">
                  <a:avLst/>
                </a:prstGeom>
                <a:noFill/>
                <a:ln w="9525" cap="flat" cmpd="sng">
                  <a:solidFill>
                    <a:srgbClr val="000000"/>
                  </a:solidFill>
                  <a:prstDash val="solid"/>
                  <a:round/>
                  <a:headEnd type="none" w="sm" len="sm"/>
                  <a:tailEnd type="none" w="sm" len="sm"/>
                </a:ln>
              </p:spPr>
            </p:cxnSp>
            <p:cxnSp>
              <p:nvCxnSpPr>
                <p:cNvPr id="1418" name="Google Shape;1418;p11"/>
                <p:cNvCxnSpPr/>
                <p:nvPr/>
              </p:nvCxnSpPr>
              <p:spPr>
                <a:xfrm rot="10800000">
                  <a:off x="1432" y="2563"/>
                  <a:ext cx="9" cy="0"/>
                </a:xfrm>
                <a:prstGeom prst="straightConnector1">
                  <a:avLst/>
                </a:prstGeom>
                <a:noFill/>
                <a:ln w="9525" cap="flat" cmpd="sng">
                  <a:solidFill>
                    <a:srgbClr val="000000"/>
                  </a:solidFill>
                  <a:prstDash val="solid"/>
                  <a:round/>
                  <a:headEnd type="none" w="sm" len="sm"/>
                  <a:tailEnd type="none" w="sm" len="sm"/>
                </a:ln>
              </p:spPr>
            </p:cxnSp>
            <p:cxnSp>
              <p:nvCxnSpPr>
                <p:cNvPr id="1419" name="Google Shape;1419;p11"/>
                <p:cNvCxnSpPr/>
                <p:nvPr/>
              </p:nvCxnSpPr>
              <p:spPr>
                <a:xfrm rot="10800000">
                  <a:off x="1426" y="2486"/>
                  <a:ext cx="15" cy="0"/>
                </a:xfrm>
                <a:prstGeom prst="straightConnector1">
                  <a:avLst/>
                </a:prstGeom>
                <a:noFill/>
                <a:ln w="9525" cap="flat" cmpd="sng">
                  <a:solidFill>
                    <a:srgbClr val="000000"/>
                  </a:solidFill>
                  <a:prstDash val="solid"/>
                  <a:round/>
                  <a:headEnd type="none" w="sm" len="sm"/>
                  <a:tailEnd type="none" w="sm" len="sm"/>
                </a:ln>
              </p:spPr>
            </p:cxnSp>
            <p:sp>
              <p:nvSpPr>
                <p:cNvPr id="1420" name="Google Shape;1420;p11"/>
                <p:cNvSpPr/>
                <p:nvPr/>
              </p:nvSpPr>
              <p:spPr>
                <a:xfrm>
                  <a:off x="1227" y="2438"/>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30.0</a:t>
                  </a:r>
                  <a:endParaRPr sz="800" b="0" i="0" u="none" strike="noStrike" cap="none">
                    <a:solidFill>
                      <a:srgbClr val="000000"/>
                    </a:solidFill>
                    <a:latin typeface="Arial"/>
                    <a:ea typeface="Arial"/>
                    <a:cs typeface="Arial"/>
                    <a:sym typeface="Arial"/>
                  </a:endParaRPr>
                </a:p>
              </p:txBody>
            </p:sp>
            <p:cxnSp>
              <p:nvCxnSpPr>
                <p:cNvPr id="1421" name="Google Shape;1421;p11"/>
                <p:cNvCxnSpPr/>
                <p:nvPr/>
              </p:nvCxnSpPr>
              <p:spPr>
                <a:xfrm rot="10800000">
                  <a:off x="1432" y="2408"/>
                  <a:ext cx="9" cy="0"/>
                </a:xfrm>
                <a:prstGeom prst="straightConnector1">
                  <a:avLst/>
                </a:prstGeom>
                <a:noFill/>
                <a:ln w="9525" cap="flat" cmpd="sng">
                  <a:solidFill>
                    <a:srgbClr val="000000"/>
                  </a:solidFill>
                  <a:prstDash val="solid"/>
                  <a:round/>
                  <a:headEnd type="none" w="sm" len="sm"/>
                  <a:tailEnd type="none" w="sm" len="sm"/>
                </a:ln>
              </p:spPr>
            </p:cxnSp>
            <p:cxnSp>
              <p:nvCxnSpPr>
                <p:cNvPr id="1422" name="Google Shape;1422;p11"/>
                <p:cNvCxnSpPr/>
                <p:nvPr/>
              </p:nvCxnSpPr>
              <p:spPr>
                <a:xfrm rot="10800000">
                  <a:off x="1432" y="2330"/>
                  <a:ext cx="9" cy="0"/>
                </a:xfrm>
                <a:prstGeom prst="straightConnector1">
                  <a:avLst/>
                </a:prstGeom>
                <a:noFill/>
                <a:ln w="9525" cap="flat" cmpd="sng">
                  <a:solidFill>
                    <a:srgbClr val="000000"/>
                  </a:solidFill>
                  <a:prstDash val="solid"/>
                  <a:round/>
                  <a:headEnd type="none" w="sm" len="sm"/>
                  <a:tailEnd type="none" w="sm" len="sm"/>
                </a:ln>
              </p:spPr>
            </p:cxnSp>
            <p:cxnSp>
              <p:nvCxnSpPr>
                <p:cNvPr id="1423" name="Google Shape;1423;p11"/>
                <p:cNvCxnSpPr/>
                <p:nvPr/>
              </p:nvCxnSpPr>
              <p:spPr>
                <a:xfrm rot="10800000">
                  <a:off x="1432" y="2253"/>
                  <a:ext cx="9" cy="0"/>
                </a:xfrm>
                <a:prstGeom prst="straightConnector1">
                  <a:avLst/>
                </a:prstGeom>
                <a:noFill/>
                <a:ln w="9525" cap="flat" cmpd="sng">
                  <a:solidFill>
                    <a:srgbClr val="000000"/>
                  </a:solidFill>
                  <a:prstDash val="solid"/>
                  <a:round/>
                  <a:headEnd type="none" w="sm" len="sm"/>
                  <a:tailEnd type="none" w="sm" len="sm"/>
                </a:ln>
              </p:spPr>
            </p:cxnSp>
            <p:cxnSp>
              <p:nvCxnSpPr>
                <p:cNvPr id="1424" name="Google Shape;1424;p11"/>
                <p:cNvCxnSpPr/>
                <p:nvPr/>
              </p:nvCxnSpPr>
              <p:spPr>
                <a:xfrm rot="10800000">
                  <a:off x="1426" y="2175"/>
                  <a:ext cx="15" cy="0"/>
                </a:xfrm>
                <a:prstGeom prst="straightConnector1">
                  <a:avLst/>
                </a:prstGeom>
                <a:noFill/>
                <a:ln w="9525" cap="flat" cmpd="sng">
                  <a:solidFill>
                    <a:srgbClr val="000000"/>
                  </a:solidFill>
                  <a:prstDash val="solid"/>
                  <a:round/>
                  <a:headEnd type="none" w="sm" len="sm"/>
                  <a:tailEnd type="none" w="sm" len="sm"/>
                </a:ln>
              </p:spPr>
            </p:cxnSp>
            <p:sp>
              <p:nvSpPr>
                <p:cNvPr id="1425" name="Google Shape;1425;p11"/>
                <p:cNvSpPr/>
                <p:nvPr/>
              </p:nvSpPr>
              <p:spPr>
                <a:xfrm>
                  <a:off x="1227" y="2127"/>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40.0</a:t>
                  </a:r>
                  <a:endParaRPr sz="800" b="0" i="0" u="none" strike="noStrike" cap="none">
                    <a:solidFill>
                      <a:srgbClr val="000000"/>
                    </a:solidFill>
                    <a:latin typeface="Arial"/>
                    <a:ea typeface="Arial"/>
                    <a:cs typeface="Arial"/>
                    <a:sym typeface="Arial"/>
                  </a:endParaRPr>
                </a:p>
              </p:txBody>
            </p:sp>
            <p:cxnSp>
              <p:nvCxnSpPr>
                <p:cNvPr id="1426" name="Google Shape;1426;p11"/>
                <p:cNvCxnSpPr/>
                <p:nvPr/>
              </p:nvCxnSpPr>
              <p:spPr>
                <a:xfrm rot="10800000">
                  <a:off x="1432" y="2097"/>
                  <a:ext cx="9" cy="0"/>
                </a:xfrm>
                <a:prstGeom prst="straightConnector1">
                  <a:avLst/>
                </a:prstGeom>
                <a:noFill/>
                <a:ln w="9525" cap="flat" cmpd="sng">
                  <a:solidFill>
                    <a:srgbClr val="000000"/>
                  </a:solidFill>
                  <a:prstDash val="solid"/>
                  <a:round/>
                  <a:headEnd type="none" w="sm" len="sm"/>
                  <a:tailEnd type="none" w="sm" len="sm"/>
                </a:ln>
              </p:spPr>
            </p:cxnSp>
            <p:cxnSp>
              <p:nvCxnSpPr>
                <p:cNvPr id="1427" name="Google Shape;1427;p11"/>
                <p:cNvCxnSpPr/>
                <p:nvPr/>
              </p:nvCxnSpPr>
              <p:spPr>
                <a:xfrm rot="10800000">
                  <a:off x="1432" y="2020"/>
                  <a:ext cx="9" cy="0"/>
                </a:xfrm>
                <a:prstGeom prst="straightConnector1">
                  <a:avLst/>
                </a:prstGeom>
                <a:noFill/>
                <a:ln w="9525" cap="flat" cmpd="sng">
                  <a:solidFill>
                    <a:srgbClr val="000000"/>
                  </a:solidFill>
                  <a:prstDash val="solid"/>
                  <a:round/>
                  <a:headEnd type="none" w="sm" len="sm"/>
                  <a:tailEnd type="none" w="sm" len="sm"/>
                </a:ln>
              </p:spPr>
            </p:cxnSp>
            <p:cxnSp>
              <p:nvCxnSpPr>
                <p:cNvPr id="1428" name="Google Shape;1428;p11"/>
                <p:cNvCxnSpPr/>
                <p:nvPr/>
              </p:nvCxnSpPr>
              <p:spPr>
                <a:xfrm rot="10800000">
                  <a:off x="1432" y="1942"/>
                  <a:ext cx="9" cy="0"/>
                </a:xfrm>
                <a:prstGeom prst="straightConnector1">
                  <a:avLst/>
                </a:prstGeom>
                <a:noFill/>
                <a:ln w="9525" cap="flat" cmpd="sng">
                  <a:solidFill>
                    <a:srgbClr val="000000"/>
                  </a:solidFill>
                  <a:prstDash val="solid"/>
                  <a:round/>
                  <a:headEnd type="none" w="sm" len="sm"/>
                  <a:tailEnd type="none" w="sm" len="sm"/>
                </a:ln>
              </p:spPr>
            </p:cxnSp>
            <p:cxnSp>
              <p:nvCxnSpPr>
                <p:cNvPr id="1429" name="Google Shape;1429;p11"/>
                <p:cNvCxnSpPr/>
                <p:nvPr/>
              </p:nvCxnSpPr>
              <p:spPr>
                <a:xfrm rot="10800000">
                  <a:off x="1426" y="1864"/>
                  <a:ext cx="15" cy="0"/>
                </a:xfrm>
                <a:prstGeom prst="straightConnector1">
                  <a:avLst/>
                </a:prstGeom>
                <a:noFill/>
                <a:ln w="9525" cap="flat" cmpd="sng">
                  <a:solidFill>
                    <a:srgbClr val="000000"/>
                  </a:solidFill>
                  <a:prstDash val="solid"/>
                  <a:round/>
                  <a:headEnd type="none" w="sm" len="sm"/>
                  <a:tailEnd type="none" w="sm" len="sm"/>
                </a:ln>
              </p:spPr>
            </p:cxnSp>
            <p:sp>
              <p:nvSpPr>
                <p:cNvPr id="1430" name="Google Shape;1430;p11"/>
                <p:cNvSpPr/>
                <p:nvPr/>
              </p:nvSpPr>
              <p:spPr>
                <a:xfrm>
                  <a:off x="1227" y="1817"/>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50.0</a:t>
                  </a:r>
                  <a:endParaRPr sz="800" b="0" i="0" u="none" strike="noStrike" cap="none">
                    <a:solidFill>
                      <a:srgbClr val="000000"/>
                    </a:solidFill>
                    <a:latin typeface="Arial"/>
                    <a:ea typeface="Arial"/>
                    <a:cs typeface="Arial"/>
                    <a:sym typeface="Arial"/>
                  </a:endParaRPr>
                </a:p>
              </p:txBody>
            </p:sp>
            <p:cxnSp>
              <p:nvCxnSpPr>
                <p:cNvPr id="1431" name="Google Shape;1431;p11"/>
                <p:cNvCxnSpPr/>
                <p:nvPr/>
              </p:nvCxnSpPr>
              <p:spPr>
                <a:xfrm rot="10800000">
                  <a:off x="1432" y="1787"/>
                  <a:ext cx="9" cy="0"/>
                </a:xfrm>
                <a:prstGeom prst="straightConnector1">
                  <a:avLst/>
                </a:prstGeom>
                <a:noFill/>
                <a:ln w="9525" cap="flat" cmpd="sng">
                  <a:solidFill>
                    <a:srgbClr val="000000"/>
                  </a:solidFill>
                  <a:prstDash val="solid"/>
                  <a:round/>
                  <a:headEnd type="none" w="sm" len="sm"/>
                  <a:tailEnd type="none" w="sm" len="sm"/>
                </a:ln>
              </p:spPr>
            </p:cxnSp>
            <p:cxnSp>
              <p:nvCxnSpPr>
                <p:cNvPr id="1432" name="Google Shape;1432;p11"/>
                <p:cNvCxnSpPr/>
                <p:nvPr/>
              </p:nvCxnSpPr>
              <p:spPr>
                <a:xfrm rot="10800000">
                  <a:off x="1432" y="1709"/>
                  <a:ext cx="9" cy="0"/>
                </a:xfrm>
                <a:prstGeom prst="straightConnector1">
                  <a:avLst/>
                </a:prstGeom>
                <a:noFill/>
                <a:ln w="9525" cap="flat" cmpd="sng">
                  <a:solidFill>
                    <a:srgbClr val="000000"/>
                  </a:solidFill>
                  <a:prstDash val="solid"/>
                  <a:round/>
                  <a:headEnd type="none" w="sm" len="sm"/>
                  <a:tailEnd type="none" w="sm" len="sm"/>
                </a:ln>
              </p:spPr>
            </p:cxnSp>
            <p:cxnSp>
              <p:nvCxnSpPr>
                <p:cNvPr id="1433" name="Google Shape;1433;p11"/>
                <p:cNvCxnSpPr/>
                <p:nvPr/>
              </p:nvCxnSpPr>
              <p:spPr>
                <a:xfrm rot="10800000">
                  <a:off x="1432" y="1631"/>
                  <a:ext cx="9" cy="0"/>
                </a:xfrm>
                <a:prstGeom prst="straightConnector1">
                  <a:avLst/>
                </a:prstGeom>
                <a:noFill/>
                <a:ln w="9525" cap="flat" cmpd="sng">
                  <a:solidFill>
                    <a:srgbClr val="000000"/>
                  </a:solidFill>
                  <a:prstDash val="solid"/>
                  <a:round/>
                  <a:headEnd type="none" w="sm" len="sm"/>
                  <a:tailEnd type="none" w="sm" len="sm"/>
                </a:ln>
              </p:spPr>
            </p:cxnSp>
            <p:cxnSp>
              <p:nvCxnSpPr>
                <p:cNvPr id="1434" name="Google Shape;1434;p11"/>
                <p:cNvCxnSpPr/>
                <p:nvPr/>
              </p:nvCxnSpPr>
              <p:spPr>
                <a:xfrm rot="10800000">
                  <a:off x="1426" y="1554"/>
                  <a:ext cx="15" cy="0"/>
                </a:xfrm>
                <a:prstGeom prst="straightConnector1">
                  <a:avLst/>
                </a:prstGeom>
                <a:noFill/>
                <a:ln w="9525" cap="flat" cmpd="sng">
                  <a:solidFill>
                    <a:srgbClr val="000000"/>
                  </a:solidFill>
                  <a:prstDash val="solid"/>
                  <a:round/>
                  <a:headEnd type="none" w="sm" len="sm"/>
                  <a:tailEnd type="none" w="sm" len="sm"/>
                </a:ln>
              </p:spPr>
            </p:cxnSp>
            <p:sp>
              <p:nvSpPr>
                <p:cNvPr id="1435" name="Google Shape;1435;p11"/>
                <p:cNvSpPr/>
                <p:nvPr/>
              </p:nvSpPr>
              <p:spPr>
                <a:xfrm>
                  <a:off x="1227" y="1506"/>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60.0</a:t>
                  </a:r>
                  <a:endParaRPr sz="800" b="0" i="0" u="none" strike="noStrike" cap="none">
                    <a:solidFill>
                      <a:srgbClr val="000000"/>
                    </a:solidFill>
                    <a:latin typeface="Arial"/>
                    <a:ea typeface="Arial"/>
                    <a:cs typeface="Arial"/>
                    <a:sym typeface="Arial"/>
                  </a:endParaRPr>
                </a:p>
              </p:txBody>
            </p:sp>
            <p:cxnSp>
              <p:nvCxnSpPr>
                <p:cNvPr id="1436" name="Google Shape;1436;p11"/>
                <p:cNvCxnSpPr/>
                <p:nvPr/>
              </p:nvCxnSpPr>
              <p:spPr>
                <a:xfrm rot="10800000">
                  <a:off x="1432" y="1476"/>
                  <a:ext cx="9" cy="0"/>
                </a:xfrm>
                <a:prstGeom prst="straightConnector1">
                  <a:avLst/>
                </a:prstGeom>
                <a:noFill/>
                <a:ln w="9525" cap="flat" cmpd="sng">
                  <a:solidFill>
                    <a:srgbClr val="000000"/>
                  </a:solidFill>
                  <a:prstDash val="solid"/>
                  <a:round/>
                  <a:headEnd type="none" w="sm" len="sm"/>
                  <a:tailEnd type="none" w="sm" len="sm"/>
                </a:ln>
              </p:spPr>
            </p:cxnSp>
            <p:cxnSp>
              <p:nvCxnSpPr>
                <p:cNvPr id="1437" name="Google Shape;1437;p11"/>
                <p:cNvCxnSpPr/>
                <p:nvPr/>
              </p:nvCxnSpPr>
              <p:spPr>
                <a:xfrm rot="10800000">
                  <a:off x="1432" y="1398"/>
                  <a:ext cx="9" cy="0"/>
                </a:xfrm>
                <a:prstGeom prst="straightConnector1">
                  <a:avLst/>
                </a:prstGeom>
                <a:noFill/>
                <a:ln w="9525" cap="flat" cmpd="sng">
                  <a:solidFill>
                    <a:srgbClr val="000000"/>
                  </a:solidFill>
                  <a:prstDash val="solid"/>
                  <a:round/>
                  <a:headEnd type="none" w="sm" len="sm"/>
                  <a:tailEnd type="none" w="sm" len="sm"/>
                </a:ln>
              </p:spPr>
            </p:cxnSp>
            <p:cxnSp>
              <p:nvCxnSpPr>
                <p:cNvPr id="1438" name="Google Shape;1438;p11"/>
                <p:cNvCxnSpPr/>
                <p:nvPr/>
              </p:nvCxnSpPr>
              <p:spPr>
                <a:xfrm rot="10800000">
                  <a:off x="1432" y="1321"/>
                  <a:ext cx="9" cy="0"/>
                </a:xfrm>
                <a:prstGeom prst="straightConnector1">
                  <a:avLst/>
                </a:prstGeom>
                <a:noFill/>
                <a:ln w="9525" cap="flat" cmpd="sng">
                  <a:solidFill>
                    <a:srgbClr val="000000"/>
                  </a:solidFill>
                  <a:prstDash val="solid"/>
                  <a:round/>
                  <a:headEnd type="none" w="sm" len="sm"/>
                  <a:tailEnd type="none" w="sm" len="sm"/>
                </a:ln>
              </p:spPr>
            </p:cxnSp>
            <p:cxnSp>
              <p:nvCxnSpPr>
                <p:cNvPr id="1439" name="Google Shape;1439;p11"/>
                <p:cNvCxnSpPr/>
                <p:nvPr/>
              </p:nvCxnSpPr>
              <p:spPr>
                <a:xfrm rot="10800000">
                  <a:off x="1426" y="1243"/>
                  <a:ext cx="15" cy="0"/>
                </a:xfrm>
                <a:prstGeom prst="straightConnector1">
                  <a:avLst/>
                </a:prstGeom>
                <a:noFill/>
                <a:ln w="9525" cap="flat" cmpd="sng">
                  <a:solidFill>
                    <a:srgbClr val="000000"/>
                  </a:solidFill>
                  <a:prstDash val="solid"/>
                  <a:round/>
                  <a:headEnd type="none" w="sm" len="sm"/>
                  <a:tailEnd type="none" w="sm" len="sm"/>
                </a:ln>
              </p:spPr>
            </p:cxnSp>
            <p:sp>
              <p:nvSpPr>
                <p:cNvPr id="1440" name="Google Shape;1440;p11"/>
                <p:cNvSpPr/>
                <p:nvPr/>
              </p:nvSpPr>
              <p:spPr>
                <a:xfrm>
                  <a:off x="1227" y="1195"/>
                  <a:ext cx="173"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70.0</a:t>
                  </a:r>
                  <a:endParaRPr sz="800" b="0" i="0" u="none" strike="noStrike" cap="none">
                    <a:solidFill>
                      <a:srgbClr val="000000"/>
                    </a:solidFill>
                    <a:latin typeface="Arial"/>
                    <a:ea typeface="Arial"/>
                    <a:cs typeface="Arial"/>
                    <a:sym typeface="Arial"/>
                  </a:endParaRPr>
                </a:p>
              </p:txBody>
            </p:sp>
            <p:sp>
              <p:nvSpPr>
                <p:cNvPr id="1441" name="Google Shape;1441;p11"/>
                <p:cNvSpPr/>
                <p:nvPr/>
              </p:nvSpPr>
              <p:spPr>
                <a:xfrm rot="16200000">
                  <a:off x="1232" y="2346"/>
                  <a:ext cx="24" cy="100"/>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 </a:t>
                  </a:r>
                  <a:endParaRPr sz="800" b="0" i="0" u="none" strike="noStrike" cap="none">
                    <a:solidFill>
                      <a:srgbClr val="000000"/>
                    </a:solidFill>
                    <a:latin typeface="Arial"/>
                    <a:ea typeface="Arial"/>
                    <a:cs typeface="Arial"/>
                    <a:sym typeface="Arial"/>
                  </a:endParaRPr>
                </a:p>
              </p:txBody>
            </p:sp>
            <p:sp>
              <p:nvSpPr>
                <p:cNvPr id="1442" name="Google Shape;1442;p11"/>
                <p:cNvSpPr/>
                <p:nvPr/>
              </p:nvSpPr>
              <p:spPr>
                <a:xfrm rot="10800000">
                  <a:off x="1245" y="2276"/>
                  <a:ext cx="0" cy="144"/>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100"/>
                    <a:buFont typeface="Arial"/>
                    <a:buNone/>
                  </a:pPr>
                  <a:endParaRPr sz="800" b="0" i="0" u="none" strike="noStrike" cap="none">
                    <a:solidFill>
                      <a:schemeClr val="dk1"/>
                    </a:solidFill>
                    <a:latin typeface="Arial"/>
                    <a:ea typeface="Arial"/>
                    <a:cs typeface="Arial"/>
                    <a:sym typeface="Arial"/>
                  </a:endParaRPr>
                </a:p>
              </p:txBody>
            </p:sp>
            <p:sp>
              <p:nvSpPr>
                <p:cNvPr id="1443" name="Google Shape;1443;p11"/>
                <p:cNvSpPr/>
                <p:nvPr/>
              </p:nvSpPr>
              <p:spPr>
                <a:xfrm>
                  <a:off x="1453" y="1424"/>
                  <a:ext cx="4961" cy="1986"/>
                </a:xfrm>
                <a:custGeom>
                  <a:avLst/>
                  <a:gdLst/>
                  <a:ahLst/>
                  <a:cxnLst/>
                  <a:rect l="l" t="t" r="r" b="b"/>
                  <a:pathLst>
                    <a:path w="4961" h="1986" extrusionOk="0">
                      <a:moveTo>
                        <a:pt x="0" y="1983"/>
                      </a:moveTo>
                      <a:lnTo>
                        <a:pt x="4" y="1983"/>
                      </a:lnTo>
                      <a:lnTo>
                        <a:pt x="8" y="1983"/>
                      </a:lnTo>
                      <a:lnTo>
                        <a:pt x="11" y="1982"/>
                      </a:lnTo>
                      <a:lnTo>
                        <a:pt x="15" y="1983"/>
                      </a:lnTo>
                      <a:lnTo>
                        <a:pt x="19" y="1983"/>
                      </a:lnTo>
                      <a:lnTo>
                        <a:pt x="23" y="1982"/>
                      </a:lnTo>
                      <a:lnTo>
                        <a:pt x="26" y="1983"/>
                      </a:lnTo>
                      <a:lnTo>
                        <a:pt x="30" y="1982"/>
                      </a:lnTo>
                      <a:lnTo>
                        <a:pt x="34" y="1983"/>
                      </a:lnTo>
                      <a:lnTo>
                        <a:pt x="38" y="1984"/>
                      </a:lnTo>
                      <a:lnTo>
                        <a:pt x="41" y="1983"/>
                      </a:lnTo>
                      <a:lnTo>
                        <a:pt x="45" y="1984"/>
                      </a:lnTo>
                      <a:lnTo>
                        <a:pt x="49" y="1983"/>
                      </a:lnTo>
                      <a:lnTo>
                        <a:pt x="53" y="1984"/>
                      </a:lnTo>
                      <a:lnTo>
                        <a:pt x="57" y="1984"/>
                      </a:lnTo>
                      <a:lnTo>
                        <a:pt x="60" y="1984"/>
                      </a:lnTo>
                      <a:lnTo>
                        <a:pt x="64" y="1984"/>
                      </a:lnTo>
                      <a:lnTo>
                        <a:pt x="68" y="1984"/>
                      </a:lnTo>
                      <a:lnTo>
                        <a:pt x="71" y="1984"/>
                      </a:lnTo>
                      <a:lnTo>
                        <a:pt x="75" y="1984"/>
                      </a:lnTo>
                      <a:lnTo>
                        <a:pt x="79" y="1984"/>
                      </a:lnTo>
                      <a:lnTo>
                        <a:pt x="83" y="1984"/>
                      </a:lnTo>
                      <a:lnTo>
                        <a:pt x="87" y="1984"/>
                      </a:lnTo>
                      <a:lnTo>
                        <a:pt x="90" y="1984"/>
                      </a:lnTo>
                      <a:lnTo>
                        <a:pt x="94" y="1984"/>
                      </a:lnTo>
                      <a:lnTo>
                        <a:pt x="98" y="1983"/>
                      </a:lnTo>
                      <a:lnTo>
                        <a:pt x="102" y="1983"/>
                      </a:lnTo>
                      <a:lnTo>
                        <a:pt x="105" y="1982"/>
                      </a:lnTo>
                      <a:lnTo>
                        <a:pt x="109" y="1983"/>
                      </a:lnTo>
                      <a:lnTo>
                        <a:pt x="113" y="1982"/>
                      </a:lnTo>
                      <a:lnTo>
                        <a:pt x="117" y="1983"/>
                      </a:lnTo>
                      <a:lnTo>
                        <a:pt x="120" y="1983"/>
                      </a:lnTo>
                      <a:lnTo>
                        <a:pt x="124" y="1983"/>
                      </a:lnTo>
                      <a:lnTo>
                        <a:pt x="128" y="1984"/>
                      </a:lnTo>
                      <a:lnTo>
                        <a:pt x="132" y="1984"/>
                      </a:lnTo>
                      <a:lnTo>
                        <a:pt x="135" y="1984"/>
                      </a:lnTo>
                      <a:lnTo>
                        <a:pt x="139" y="1983"/>
                      </a:lnTo>
                      <a:lnTo>
                        <a:pt x="143" y="1984"/>
                      </a:lnTo>
                      <a:lnTo>
                        <a:pt x="147" y="1983"/>
                      </a:lnTo>
                      <a:lnTo>
                        <a:pt x="150" y="1983"/>
                      </a:lnTo>
                      <a:lnTo>
                        <a:pt x="154" y="1983"/>
                      </a:lnTo>
                      <a:lnTo>
                        <a:pt x="158" y="1983"/>
                      </a:lnTo>
                      <a:lnTo>
                        <a:pt x="162" y="1983"/>
                      </a:lnTo>
                      <a:lnTo>
                        <a:pt x="165" y="1983"/>
                      </a:lnTo>
                      <a:lnTo>
                        <a:pt x="169" y="1983"/>
                      </a:lnTo>
                      <a:lnTo>
                        <a:pt x="173" y="1984"/>
                      </a:lnTo>
                      <a:lnTo>
                        <a:pt x="177" y="1984"/>
                      </a:lnTo>
                      <a:lnTo>
                        <a:pt x="181" y="1984"/>
                      </a:lnTo>
                      <a:lnTo>
                        <a:pt x="184" y="1984"/>
                      </a:lnTo>
                      <a:lnTo>
                        <a:pt x="188" y="1984"/>
                      </a:lnTo>
                      <a:lnTo>
                        <a:pt x="192" y="1984"/>
                      </a:lnTo>
                      <a:lnTo>
                        <a:pt x="195" y="1984"/>
                      </a:lnTo>
                      <a:lnTo>
                        <a:pt x="199" y="1983"/>
                      </a:lnTo>
                      <a:lnTo>
                        <a:pt x="203" y="1983"/>
                      </a:lnTo>
                      <a:lnTo>
                        <a:pt x="207" y="1983"/>
                      </a:lnTo>
                      <a:lnTo>
                        <a:pt x="211" y="1984"/>
                      </a:lnTo>
                      <a:lnTo>
                        <a:pt x="214" y="1984"/>
                      </a:lnTo>
                      <a:lnTo>
                        <a:pt x="218" y="1984"/>
                      </a:lnTo>
                      <a:lnTo>
                        <a:pt x="222" y="1984"/>
                      </a:lnTo>
                      <a:lnTo>
                        <a:pt x="226" y="1984"/>
                      </a:lnTo>
                      <a:lnTo>
                        <a:pt x="229" y="1984"/>
                      </a:lnTo>
                      <a:lnTo>
                        <a:pt x="233" y="1985"/>
                      </a:lnTo>
                      <a:lnTo>
                        <a:pt x="237" y="1985"/>
                      </a:lnTo>
                      <a:lnTo>
                        <a:pt x="241" y="1984"/>
                      </a:lnTo>
                      <a:lnTo>
                        <a:pt x="244" y="1983"/>
                      </a:lnTo>
                      <a:lnTo>
                        <a:pt x="248" y="1984"/>
                      </a:lnTo>
                      <a:lnTo>
                        <a:pt x="252" y="1984"/>
                      </a:lnTo>
                      <a:lnTo>
                        <a:pt x="256" y="1984"/>
                      </a:lnTo>
                      <a:lnTo>
                        <a:pt x="259" y="1985"/>
                      </a:lnTo>
                      <a:lnTo>
                        <a:pt x="263" y="1983"/>
                      </a:lnTo>
                      <a:lnTo>
                        <a:pt x="267" y="1984"/>
                      </a:lnTo>
                      <a:lnTo>
                        <a:pt x="271" y="1984"/>
                      </a:lnTo>
                      <a:lnTo>
                        <a:pt x="274" y="1983"/>
                      </a:lnTo>
                      <a:lnTo>
                        <a:pt x="278" y="1983"/>
                      </a:lnTo>
                      <a:lnTo>
                        <a:pt x="282" y="1983"/>
                      </a:lnTo>
                      <a:lnTo>
                        <a:pt x="286" y="1982"/>
                      </a:lnTo>
                      <a:lnTo>
                        <a:pt x="289" y="1983"/>
                      </a:lnTo>
                      <a:lnTo>
                        <a:pt x="293" y="1983"/>
                      </a:lnTo>
                      <a:lnTo>
                        <a:pt x="297" y="1983"/>
                      </a:lnTo>
                      <a:lnTo>
                        <a:pt x="301" y="1983"/>
                      </a:lnTo>
                      <a:lnTo>
                        <a:pt x="305" y="1983"/>
                      </a:lnTo>
                      <a:lnTo>
                        <a:pt x="308" y="1983"/>
                      </a:lnTo>
                      <a:lnTo>
                        <a:pt x="312" y="1983"/>
                      </a:lnTo>
                      <a:lnTo>
                        <a:pt x="316" y="1983"/>
                      </a:lnTo>
                      <a:lnTo>
                        <a:pt x="319" y="1983"/>
                      </a:lnTo>
                      <a:lnTo>
                        <a:pt x="323" y="1982"/>
                      </a:lnTo>
                      <a:lnTo>
                        <a:pt x="327" y="1983"/>
                      </a:lnTo>
                      <a:lnTo>
                        <a:pt x="331" y="1982"/>
                      </a:lnTo>
                      <a:lnTo>
                        <a:pt x="335" y="1984"/>
                      </a:lnTo>
                      <a:lnTo>
                        <a:pt x="338" y="1983"/>
                      </a:lnTo>
                      <a:lnTo>
                        <a:pt x="342" y="1984"/>
                      </a:lnTo>
                      <a:lnTo>
                        <a:pt x="346" y="1983"/>
                      </a:lnTo>
                      <a:lnTo>
                        <a:pt x="350" y="1983"/>
                      </a:lnTo>
                      <a:lnTo>
                        <a:pt x="353" y="1983"/>
                      </a:lnTo>
                      <a:lnTo>
                        <a:pt x="357" y="1984"/>
                      </a:lnTo>
                      <a:lnTo>
                        <a:pt x="361" y="1983"/>
                      </a:lnTo>
                      <a:lnTo>
                        <a:pt x="365" y="1982"/>
                      </a:lnTo>
                      <a:lnTo>
                        <a:pt x="368" y="1983"/>
                      </a:lnTo>
                      <a:lnTo>
                        <a:pt x="372" y="1983"/>
                      </a:lnTo>
                      <a:lnTo>
                        <a:pt x="376" y="1983"/>
                      </a:lnTo>
                      <a:lnTo>
                        <a:pt x="380" y="1983"/>
                      </a:lnTo>
                      <a:lnTo>
                        <a:pt x="384" y="1983"/>
                      </a:lnTo>
                      <a:lnTo>
                        <a:pt x="387" y="1983"/>
                      </a:lnTo>
                      <a:lnTo>
                        <a:pt x="391" y="1984"/>
                      </a:lnTo>
                      <a:lnTo>
                        <a:pt x="395" y="1983"/>
                      </a:lnTo>
                      <a:lnTo>
                        <a:pt x="398" y="1984"/>
                      </a:lnTo>
                      <a:lnTo>
                        <a:pt x="402" y="1983"/>
                      </a:lnTo>
                      <a:lnTo>
                        <a:pt x="406" y="1983"/>
                      </a:lnTo>
                      <a:lnTo>
                        <a:pt x="410" y="1983"/>
                      </a:lnTo>
                      <a:lnTo>
                        <a:pt x="413" y="1983"/>
                      </a:lnTo>
                      <a:lnTo>
                        <a:pt x="417" y="1983"/>
                      </a:lnTo>
                      <a:lnTo>
                        <a:pt x="421" y="1983"/>
                      </a:lnTo>
                      <a:lnTo>
                        <a:pt x="425" y="1984"/>
                      </a:lnTo>
                      <a:lnTo>
                        <a:pt x="429" y="1983"/>
                      </a:lnTo>
                      <a:lnTo>
                        <a:pt x="432" y="1984"/>
                      </a:lnTo>
                      <a:lnTo>
                        <a:pt x="436" y="1984"/>
                      </a:lnTo>
                      <a:lnTo>
                        <a:pt x="440" y="1983"/>
                      </a:lnTo>
                      <a:lnTo>
                        <a:pt x="444" y="1983"/>
                      </a:lnTo>
                      <a:lnTo>
                        <a:pt x="447" y="1984"/>
                      </a:lnTo>
                      <a:lnTo>
                        <a:pt x="451" y="1983"/>
                      </a:lnTo>
                      <a:lnTo>
                        <a:pt x="455" y="1984"/>
                      </a:lnTo>
                      <a:lnTo>
                        <a:pt x="459" y="1984"/>
                      </a:lnTo>
                      <a:lnTo>
                        <a:pt x="462" y="1984"/>
                      </a:lnTo>
                      <a:lnTo>
                        <a:pt x="466" y="1984"/>
                      </a:lnTo>
                      <a:lnTo>
                        <a:pt x="470" y="1984"/>
                      </a:lnTo>
                      <a:lnTo>
                        <a:pt x="474" y="1984"/>
                      </a:lnTo>
                      <a:lnTo>
                        <a:pt x="477" y="1984"/>
                      </a:lnTo>
                      <a:lnTo>
                        <a:pt x="481" y="1983"/>
                      </a:lnTo>
                      <a:lnTo>
                        <a:pt x="485" y="1983"/>
                      </a:lnTo>
                      <a:lnTo>
                        <a:pt x="489" y="1983"/>
                      </a:lnTo>
                      <a:lnTo>
                        <a:pt x="492" y="1983"/>
                      </a:lnTo>
                      <a:lnTo>
                        <a:pt x="496" y="1983"/>
                      </a:lnTo>
                      <a:lnTo>
                        <a:pt x="500" y="1983"/>
                      </a:lnTo>
                      <a:lnTo>
                        <a:pt x="504" y="1982"/>
                      </a:lnTo>
                      <a:lnTo>
                        <a:pt x="508" y="1983"/>
                      </a:lnTo>
                      <a:lnTo>
                        <a:pt x="511" y="1983"/>
                      </a:lnTo>
                      <a:lnTo>
                        <a:pt x="515" y="1982"/>
                      </a:lnTo>
                      <a:lnTo>
                        <a:pt x="519" y="1983"/>
                      </a:lnTo>
                      <a:lnTo>
                        <a:pt x="522" y="1982"/>
                      </a:lnTo>
                      <a:lnTo>
                        <a:pt x="526" y="1982"/>
                      </a:lnTo>
                      <a:lnTo>
                        <a:pt x="530" y="1982"/>
                      </a:lnTo>
                      <a:lnTo>
                        <a:pt x="534" y="1982"/>
                      </a:lnTo>
                      <a:lnTo>
                        <a:pt x="537" y="1982"/>
                      </a:lnTo>
                      <a:lnTo>
                        <a:pt x="541" y="1982"/>
                      </a:lnTo>
                      <a:lnTo>
                        <a:pt x="545" y="1982"/>
                      </a:lnTo>
                      <a:lnTo>
                        <a:pt x="549" y="1983"/>
                      </a:lnTo>
                      <a:lnTo>
                        <a:pt x="553" y="1983"/>
                      </a:lnTo>
                      <a:lnTo>
                        <a:pt x="556" y="1983"/>
                      </a:lnTo>
                      <a:lnTo>
                        <a:pt x="560" y="1983"/>
                      </a:lnTo>
                      <a:lnTo>
                        <a:pt x="564" y="1982"/>
                      </a:lnTo>
                      <a:lnTo>
                        <a:pt x="568" y="1982"/>
                      </a:lnTo>
                      <a:lnTo>
                        <a:pt x="571" y="1982"/>
                      </a:lnTo>
                      <a:lnTo>
                        <a:pt x="575" y="1982"/>
                      </a:lnTo>
                      <a:lnTo>
                        <a:pt x="579" y="1982"/>
                      </a:lnTo>
                      <a:lnTo>
                        <a:pt x="582" y="1982"/>
                      </a:lnTo>
                      <a:lnTo>
                        <a:pt x="586" y="1982"/>
                      </a:lnTo>
                      <a:lnTo>
                        <a:pt x="590" y="1982"/>
                      </a:lnTo>
                      <a:lnTo>
                        <a:pt x="594" y="1982"/>
                      </a:lnTo>
                      <a:lnTo>
                        <a:pt x="598" y="1982"/>
                      </a:lnTo>
                      <a:lnTo>
                        <a:pt x="601" y="1982"/>
                      </a:lnTo>
                      <a:lnTo>
                        <a:pt x="605" y="1981"/>
                      </a:lnTo>
                      <a:lnTo>
                        <a:pt x="609" y="1982"/>
                      </a:lnTo>
                      <a:lnTo>
                        <a:pt x="613" y="1982"/>
                      </a:lnTo>
                      <a:lnTo>
                        <a:pt x="616" y="1982"/>
                      </a:lnTo>
                      <a:lnTo>
                        <a:pt x="620" y="1983"/>
                      </a:lnTo>
                      <a:lnTo>
                        <a:pt x="624" y="1982"/>
                      </a:lnTo>
                      <a:lnTo>
                        <a:pt x="628" y="1982"/>
                      </a:lnTo>
                      <a:lnTo>
                        <a:pt x="631" y="1983"/>
                      </a:lnTo>
                      <a:lnTo>
                        <a:pt x="635" y="1982"/>
                      </a:lnTo>
                      <a:lnTo>
                        <a:pt x="639" y="1982"/>
                      </a:lnTo>
                      <a:lnTo>
                        <a:pt x="643" y="1983"/>
                      </a:lnTo>
                      <a:lnTo>
                        <a:pt x="646" y="1982"/>
                      </a:lnTo>
                      <a:lnTo>
                        <a:pt x="650" y="1982"/>
                      </a:lnTo>
                      <a:lnTo>
                        <a:pt x="654" y="1982"/>
                      </a:lnTo>
                      <a:lnTo>
                        <a:pt x="658" y="1983"/>
                      </a:lnTo>
                      <a:lnTo>
                        <a:pt x="661" y="1983"/>
                      </a:lnTo>
                      <a:lnTo>
                        <a:pt x="665" y="1983"/>
                      </a:lnTo>
                      <a:lnTo>
                        <a:pt x="669" y="1983"/>
                      </a:lnTo>
                      <a:lnTo>
                        <a:pt x="673" y="1984"/>
                      </a:lnTo>
                      <a:lnTo>
                        <a:pt x="677" y="1984"/>
                      </a:lnTo>
                      <a:lnTo>
                        <a:pt x="680" y="1984"/>
                      </a:lnTo>
                      <a:lnTo>
                        <a:pt x="684" y="1984"/>
                      </a:lnTo>
                      <a:lnTo>
                        <a:pt x="688" y="1984"/>
                      </a:lnTo>
                      <a:lnTo>
                        <a:pt x="692" y="1984"/>
                      </a:lnTo>
                      <a:lnTo>
                        <a:pt x="695" y="1983"/>
                      </a:lnTo>
                      <a:lnTo>
                        <a:pt x="699" y="1983"/>
                      </a:lnTo>
                      <a:lnTo>
                        <a:pt x="703" y="1983"/>
                      </a:lnTo>
                      <a:lnTo>
                        <a:pt x="706" y="1983"/>
                      </a:lnTo>
                      <a:lnTo>
                        <a:pt x="710" y="1983"/>
                      </a:lnTo>
                      <a:lnTo>
                        <a:pt x="714" y="1983"/>
                      </a:lnTo>
                      <a:lnTo>
                        <a:pt x="718" y="1983"/>
                      </a:lnTo>
                      <a:lnTo>
                        <a:pt x="722" y="1983"/>
                      </a:lnTo>
                      <a:lnTo>
                        <a:pt x="725" y="1983"/>
                      </a:lnTo>
                      <a:lnTo>
                        <a:pt x="729" y="1983"/>
                      </a:lnTo>
                      <a:lnTo>
                        <a:pt x="733" y="1984"/>
                      </a:lnTo>
                      <a:lnTo>
                        <a:pt x="737" y="1983"/>
                      </a:lnTo>
                      <a:lnTo>
                        <a:pt x="740" y="1983"/>
                      </a:lnTo>
                      <a:lnTo>
                        <a:pt x="744" y="1983"/>
                      </a:lnTo>
                      <a:lnTo>
                        <a:pt x="748" y="1984"/>
                      </a:lnTo>
                      <a:lnTo>
                        <a:pt x="752" y="1984"/>
                      </a:lnTo>
                      <a:lnTo>
                        <a:pt x="755" y="1984"/>
                      </a:lnTo>
                      <a:lnTo>
                        <a:pt x="759" y="1983"/>
                      </a:lnTo>
                      <a:lnTo>
                        <a:pt x="763" y="1984"/>
                      </a:lnTo>
                      <a:lnTo>
                        <a:pt x="767" y="1984"/>
                      </a:lnTo>
                      <a:lnTo>
                        <a:pt x="770" y="1984"/>
                      </a:lnTo>
                      <a:lnTo>
                        <a:pt x="774" y="1985"/>
                      </a:lnTo>
                      <a:lnTo>
                        <a:pt x="778" y="1985"/>
                      </a:lnTo>
                      <a:lnTo>
                        <a:pt x="782" y="1985"/>
                      </a:lnTo>
                      <a:lnTo>
                        <a:pt x="785" y="1985"/>
                      </a:lnTo>
                      <a:lnTo>
                        <a:pt x="789" y="1985"/>
                      </a:lnTo>
                      <a:lnTo>
                        <a:pt x="793" y="1984"/>
                      </a:lnTo>
                      <a:lnTo>
                        <a:pt x="797" y="1984"/>
                      </a:lnTo>
                      <a:lnTo>
                        <a:pt x="801" y="1984"/>
                      </a:lnTo>
                      <a:lnTo>
                        <a:pt x="804" y="1985"/>
                      </a:lnTo>
                      <a:lnTo>
                        <a:pt x="808" y="1985"/>
                      </a:lnTo>
                      <a:lnTo>
                        <a:pt x="812" y="1985"/>
                      </a:lnTo>
                      <a:lnTo>
                        <a:pt x="816" y="1986"/>
                      </a:lnTo>
                      <a:lnTo>
                        <a:pt x="819" y="1985"/>
                      </a:lnTo>
                      <a:lnTo>
                        <a:pt x="823" y="1985"/>
                      </a:lnTo>
                      <a:lnTo>
                        <a:pt x="827" y="1985"/>
                      </a:lnTo>
                      <a:lnTo>
                        <a:pt x="831" y="1986"/>
                      </a:lnTo>
                      <a:lnTo>
                        <a:pt x="834" y="1985"/>
                      </a:lnTo>
                      <a:lnTo>
                        <a:pt x="838" y="1985"/>
                      </a:lnTo>
                      <a:lnTo>
                        <a:pt x="842" y="1985"/>
                      </a:lnTo>
                      <a:lnTo>
                        <a:pt x="846" y="1985"/>
                      </a:lnTo>
                      <a:lnTo>
                        <a:pt x="849" y="1986"/>
                      </a:lnTo>
                      <a:lnTo>
                        <a:pt x="853" y="1986"/>
                      </a:lnTo>
                      <a:lnTo>
                        <a:pt x="857" y="1986"/>
                      </a:lnTo>
                      <a:lnTo>
                        <a:pt x="861" y="1985"/>
                      </a:lnTo>
                      <a:lnTo>
                        <a:pt x="864" y="1985"/>
                      </a:lnTo>
                      <a:lnTo>
                        <a:pt x="868" y="1985"/>
                      </a:lnTo>
                      <a:lnTo>
                        <a:pt x="872" y="1986"/>
                      </a:lnTo>
                      <a:lnTo>
                        <a:pt x="876" y="1985"/>
                      </a:lnTo>
                      <a:lnTo>
                        <a:pt x="879" y="1985"/>
                      </a:lnTo>
                      <a:lnTo>
                        <a:pt x="883" y="1985"/>
                      </a:lnTo>
                      <a:lnTo>
                        <a:pt x="887" y="1985"/>
                      </a:lnTo>
                      <a:lnTo>
                        <a:pt x="891" y="1985"/>
                      </a:lnTo>
                      <a:lnTo>
                        <a:pt x="895" y="1985"/>
                      </a:lnTo>
                      <a:lnTo>
                        <a:pt x="898" y="1985"/>
                      </a:lnTo>
                      <a:lnTo>
                        <a:pt x="902" y="1985"/>
                      </a:lnTo>
                      <a:lnTo>
                        <a:pt x="906" y="1985"/>
                      </a:lnTo>
                      <a:lnTo>
                        <a:pt x="909" y="1985"/>
                      </a:lnTo>
                      <a:lnTo>
                        <a:pt x="913" y="1985"/>
                      </a:lnTo>
                      <a:lnTo>
                        <a:pt x="917" y="1985"/>
                      </a:lnTo>
                      <a:lnTo>
                        <a:pt x="921" y="1985"/>
                      </a:lnTo>
                      <a:lnTo>
                        <a:pt x="925" y="1985"/>
                      </a:lnTo>
                      <a:lnTo>
                        <a:pt x="928" y="1984"/>
                      </a:lnTo>
                      <a:lnTo>
                        <a:pt x="932" y="1984"/>
                      </a:lnTo>
                      <a:lnTo>
                        <a:pt x="936" y="1984"/>
                      </a:lnTo>
                      <a:lnTo>
                        <a:pt x="940" y="1985"/>
                      </a:lnTo>
                      <a:lnTo>
                        <a:pt x="943" y="1985"/>
                      </a:lnTo>
                      <a:lnTo>
                        <a:pt x="947" y="1985"/>
                      </a:lnTo>
                      <a:lnTo>
                        <a:pt x="951" y="1985"/>
                      </a:lnTo>
                      <a:lnTo>
                        <a:pt x="955" y="1985"/>
                      </a:lnTo>
                      <a:lnTo>
                        <a:pt x="958" y="1984"/>
                      </a:lnTo>
                      <a:lnTo>
                        <a:pt x="962" y="1985"/>
                      </a:lnTo>
                      <a:lnTo>
                        <a:pt x="966" y="1986"/>
                      </a:lnTo>
                      <a:lnTo>
                        <a:pt x="970" y="1986"/>
                      </a:lnTo>
                      <a:lnTo>
                        <a:pt x="973" y="1986"/>
                      </a:lnTo>
                      <a:lnTo>
                        <a:pt x="977" y="1986"/>
                      </a:lnTo>
                      <a:lnTo>
                        <a:pt x="981" y="1985"/>
                      </a:lnTo>
                      <a:lnTo>
                        <a:pt x="985" y="1984"/>
                      </a:lnTo>
                      <a:lnTo>
                        <a:pt x="988" y="1985"/>
                      </a:lnTo>
                      <a:lnTo>
                        <a:pt x="992" y="1985"/>
                      </a:lnTo>
                      <a:lnTo>
                        <a:pt x="996" y="1986"/>
                      </a:lnTo>
                      <a:lnTo>
                        <a:pt x="1000" y="1985"/>
                      </a:lnTo>
                      <a:lnTo>
                        <a:pt x="1003" y="1986"/>
                      </a:lnTo>
                      <a:lnTo>
                        <a:pt x="1007" y="1985"/>
                      </a:lnTo>
                      <a:lnTo>
                        <a:pt x="1011" y="1985"/>
                      </a:lnTo>
                      <a:lnTo>
                        <a:pt x="1015" y="1985"/>
                      </a:lnTo>
                      <a:lnTo>
                        <a:pt x="1019" y="1985"/>
                      </a:lnTo>
                      <a:lnTo>
                        <a:pt x="1022" y="1986"/>
                      </a:lnTo>
                      <a:lnTo>
                        <a:pt x="1026" y="1985"/>
                      </a:lnTo>
                      <a:lnTo>
                        <a:pt x="1030" y="1986"/>
                      </a:lnTo>
                      <a:lnTo>
                        <a:pt x="1033" y="1985"/>
                      </a:lnTo>
                      <a:lnTo>
                        <a:pt x="1037" y="1985"/>
                      </a:lnTo>
                      <a:lnTo>
                        <a:pt x="1041" y="1985"/>
                      </a:lnTo>
                      <a:lnTo>
                        <a:pt x="1045" y="1985"/>
                      </a:lnTo>
                      <a:lnTo>
                        <a:pt x="1049" y="1985"/>
                      </a:lnTo>
                      <a:lnTo>
                        <a:pt x="1052" y="1984"/>
                      </a:lnTo>
                      <a:lnTo>
                        <a:pt x="1056" y="1984"/>
                      </a:lnTo>
                      <a:lnTo>
                        <a:pt x="1060" y="1984"/>
                      </a:lnTo>
                      <a:lnTo>
                        <a:pt x="1064" y="1983"/>
                      </a:lnTo>
                      <a:lnTo>
                        <a:pt x="1067" y="1983"/>
                      </a:lnTo>
                      <a:lnTo>
                        <a:pt x="1071" y="1983"/>
                      </a:lnTo>
                      <a:lnTo>
                        <a:pt x="1075" y="1983"/>
                      </a:lnTo>
                      <a:lnTo>
                        <a:pt x="1079" y="1984"/>
                      </a:lnTo>
                      <a:lnTo>
                        <a:pt x="1082" y="1984"/>
                      </a:lnTo>
                      <a:lnTo>
                        <a:pt x="1086" y="1983"/>
                      </a:lnTo>
                      <a:lnTo>
                        <a:pt x="1090" y="1984"/>
                      </a:lnTo>
                      <a:lnTo>
                        <a:pt x="1094" y="1985"/>
                      </a:lnTo>
                      <a:lnTo>
                        <a:pt x="1097" y="1985"/>
                      </a:lnTo>
                      <a:lnTo>
                        <a:pt x="1101" y="1985"/>
                      </a:lnTo>
                      <a:lnTo>
                        <a:pt x="1105" y="1985"/>
                      </a:lnTo>
                      <a:lnTo>
                        <a:pt x="1109" y="1985"/>
                      </a:lnTo>
                      <a:lnTo>
                        <a:pt x="1112" y="1986"/>
                      </a:lnTo>
                      <a:lnTo>
                        <a:pt x="1116" y="1985"/>
                      </a:lnTo>
                      <a:lnTo>
                        <a:pt x="1120" y="1985"/>
                      </a:lnTo>
                      <a:lnTo>
                        <a:pt x="1124" y="1986"/>
                      </a:lnTo>
                      <a:lnTo>
                        <a:pt x="1127" y="1985"/>
                      </a:lnTo>
                      <a:lnTo>
                        <a:pt x="1131" y="1986"/>
                      </a:lnTo>
                      <a:lnTo>
                        <a:pt x="1135" y="1986"/>
                      </a:lnTo>
                      <a:lnTo>
                        <a:pt x="1139" y="1986"/>
                      </a:lnTo>
                      <a:lnTo>
                        <a:pt x="1143" y="1986"/>
                      </a:lnTo>
                      <a:lnTo>
                        <a:pt x="1146" y="1986"/>
                      </a:lnTo>
                      <a:lnTo>
                        <a:pt x="1150" y="1986"/>
                      </a:lnTo>
                      <a:lnTo>
                        <a:pt x="1154" y="1986"/>
                      </a:lnTo>
                      <a:lnTo>
                        <a:pt x="1157" y="1986"/>
                      </a:lnTo>
                      <a:lnTo>
                        <a:pt x="1161" y="1985"/>
                      </a:lnTo>
                      <a:lnTo>
                        <a:pt x="1165" y="1985"/>
                      </a:lnTo>
                      <a:lnTo>
                        <a:pt x="1169" y="1986"/>
                      </a:lnTo>
                      <a:lnTo>
                        <a:pt x="1172" y="1986"/>
                      </a:lnTo>
                      <a:lnTo>
                        <a:pt x="1176" y="1986"/>
                      </a:lnTo>
                      <a:lnTo>
                        <a:pt x="1180" y="1985"/>
                      </a:lnTo>
                      <a:lnTo>
                        <a:pt x="1184" y="1986"/>
                      </a:lnTo>
                      <a:lnTo>
                        <a:pt x="1188" y="1985"/>
                      </a:lnTo>
                      <a:lnTo>
                        <a:pt x="1191" y="1986"/>
                      </a:lnTo>
                      <a:lnTo>
                        <a:pt x="1195" y="1985"/>
                      </a:lnTo>
                      <a:lnTo>
                        <a:pt x="1199" y="1985"/>
                      </a:lnTo>
                      <a:lnTo>
                        <a:pt x="1203" y="1986"/>
                      </a:lnTo>
                      <a:lnTo>
                        <a:pt x="1206" y="1985"/>
                      </a:lnTo>
                      <a:lnTo>
                        <a:pt x="1210" y="1986"/>
                      </a:lnTo>
                      <a:lnTo>
                        <a:pt x="1214" y="1986"/>
                      </a:lnTo>
                      <a:lnTo>
                        <a:pt x="1218" y="1985"/>
                      </a:lnTo>
                      <a:lnTo>
                        <a:pt x="1221" y="1985"/>
                      </a:lnTo>
                      <a:lnTo>
                        <a:pt x="1225" y="1985"/>
                      </a:lnTo>
                      <a:lnTo>
                        <a:pt x="1229" y="1986"/>
                      </a:lnTo>
                      <a:lnTo>
                        <a:pt x="1233" y="1985"/>
                      </a:lnTo>
                      <a:lnTo>
                        <a:pt x="1236" y="1985"/>
                      </a:lnTo>
                      <a:lnTo>
                        <a:pt x="1240" y="1985"/>
                      </a:lnTo>
                      <a:lnTo>
                        <a:pt x="1244" y="1985"/>
                      </a:lnTo>
                      <a:lnTo>
                        <a:pt x="1248" y="1985"/>
                      </a:lnTo>
                      <a:lnTo>
                        <a:pt x="1251" y="1986"/>
                      </a:lnTo>
                      <a:lnTo>
                        <a:pt x="1255" y="1986"/>
                      </a:lnTo>
                      <a:lnTo>
                        <a:pt x="1259" y="1985"/>
                      </a:lnTo>
                      <a:lnTo>
                        <a:pt x="1263" y="1985"/>
                      </a:lnTo>
                      <a:lnTo>
                        <a:pt x="1267" y="1985"/>
                      </a:lnTo>
                      <a:lnTo>
                        <a:pt x="1270" y="1985"/>
                      </a:lnTo>
                      <a:lnTo>
                        <a:pt x="1274" y="1985"/>
                      </a:lnTo>
                      <a:lnTo>
                        <a:pt x="1278" y="1985"/>
                      </a:lnTo>
                      <a:lnTo>
                        <a:pt x="1282" y="1985"/>
                      </a:lnTo>
                      <a:lnTo>
                        <a:pt x="1285" y="1985"/>
                      </a:lnTo>
                      <a:lnTo>
                        <a:pt x="1289" y="1985"/>
                      </a:lnTo>
                      <a:lnTo>
                        <a:pt x="1293" y="1986"/>
                      </a:lnTo>
                      <a:lnTo>
                        <a:pt x="1296" y="1985"/>
                      </a:lnTo>
                      <a:lnTo>
                        <a:pt x="1300" y="1985"/>
                      </a:lnTo>
                      <a:lnTo>
                        <a:pt x="1304" y="1985"/>
                      </a:lnTo>
                      <a:lnTo>
                        <a:pt x="1308" y="1985"/>
                      </a:lnTo>
                      <a:lnTo>
                        <a:pt x="1312" y="1985"/>
                      </a:lnTo>
                      <a:lnTo>
                        <a:pt x="1315" y="1984"/>
                      </a:lnTo>
                      <a:lnTo>
                        <a:pt x="1319" y="1984"/>
                      </a:lnTo>
                      <a:lnTo>
                        <a:pt x="1323" y="1985"/>
                      </a:lnTo>
                      <a:lnTo>
                        <a:pt x="1327" y="1985"/>
                      </a:lnTo>
                      <a:lnTo>
                        <a:pt x="1330" y="1985"/>
                      </a:lnTo>
                      <a:lnTo>
                        <a:pt x="1334" y="1985"/>
                      </a:lnTo>
                      <a:lnTo>
                        <a:pt x="1338" y="1985"/>
                      </a:lnTo>
                      <a:lnTo>
                        <a:pt x="1342" y="1985"/>
                      </a:lnTo>
                      <a:lnTo>
                        <a:pt x="1345" y="1984"/>
                      </a:lnTo>
                      <a:lnTo>
                        <a:pt x="1349" y="1984"/>
                      </a:lnTo>
                      <a:lnTo>
                        <a:pt x="1353" y="1984"/>
                      </a:lnTo>
                      <a:lnTo>
                        <a:pt x="1357" y="1984"/>
                      </a:lnTo>
                      <a:lnTo>
                        <a:pt x="1360" y="1984"/>
                      </a:lnTo>
                      <a:lnTo>
                        <a:pt x="1364" y="1984"/>
                      </a:lnTo>
                      <a:lnTo>
                        <a:pt x="1368" y="1984"/>
                      </a:lnTo>
                      <a:lnTo>
                        <a:pt x="1372" y="1984"/>
                      </a:lnTo>
                      <a:lnTo>
                        <a:pt x="1375" y="1984"/>
                      </a:lnTo>
                      <a:lnTo>
                        <a:pt x="1379" y="1983"/>
                      </a:lnTo>
                      <a:lnTo>
                        <a:pt x="1383" y="1983"/>
                      </a:lnTo>
                      <a:lnTo>
                        <a:pt x="1387" y="1984"/>
                      </a:lnTo>
                      <a:lnTo>
                        <a:pt x="1391" y="1983"/>
                      </a:lnTo>
                      <a:lnTo>
                        <a:pt x="1394" y="1983"/>
                      </a:lnTo>
                      <a:lnTo>
                        <a:pt x="1398" y="1983"/>
                      </a:lnTo>
                      <a:lnTo>
                        <a:pt x="1402" y="1983"/>
                      </a:lnTo>
                      <a:lnTo>
                        <a:pt x="1406" y="1983"/>
                      </a:lnTo>
                      <a:lnTo>
                        <a:pt x="1409" y="1983"/>
                      </a:lnTo>
                      <a:lnTo>
                        <a:pt x="1413" y="1983"/>
                      </a:lnTo>
                      <a:lnTo>
                        <a:pt x="1417" y="1983"/>
                      </a:lnTo>
                      <a:lnTo>
                        <a:pt x="1420" y="1983"/>
                      </a:lnTo>
                      <a:lnTo>
                        <a:pt x="1424" y="1983"/>
                      </a:lnTo>
                      <a:lnTo>
                        <a:pt x="1428" y="1983"/>
                      </a:lnTo>
                      <a:lnTo>
                        <a:pt x="1432" y="1982"/>
                      </a:lnTo>
                      <a:lnTo>
                        <a:pt x="1436" y="1983"/>
                      </a:lnTo>
                      <a:lnTo>
                        <a:pt x="1439" y="1982"/>
                      </a:lnTo>
                      <a:lnTo>
                        <a:pt x="1443" y="1982"/>
                      </a:lnTo>
                      <a:lnTo>
                        <a:pt x="1447" y="1982"/>
                      </a:lnTo>
                      <a:lnTo>
                        <a:pt x="1451" y="1982"/>
                      </a:lnTo>
                      <a:lnTo>
                        <a:pt x="1454" y="1982"/>
                      </a:lnTo>
                      <a:lnTo>
                        <a:pt x="1458" y="1982"/>
                      </a:lnTo>
                      <a:lnTo>
                        <a:pt x="1462" y="1982"/>
                      </a:lnTo>
                      <a:lnTo>
                        <a:pt x="1466" y="1982"/>
                      </a:lnTo>
                      <a:lnTo>
                        <a:pt x="1469" y="1982"/>
                      </a:lnTo>
                      <a:lnTo>
                        <a:pt x="1473" y="1982"/>
                      </a:lnTo>
                      <a:lnTo>
                        <a:pt x="1477" y="1981"/>
                      </a:lnTo>
                      <a:lnTo>
                        <a:pt x="1481" y="1982"/>
                      </a:lnTo>
                      <a:lnTo>
                        <a:pt x="1484" y="1981"/>
                      </a:lnTo>
                      <a:lnTo>
                        <a:pt x="1488" y="1982"/>
                      </a:lnTo>
                      <a:lnTo>
                        <a:pt x="1492" y="1981"/>
                      </a:lnTo>
                      <a:lnTo>
                        <a:pt x="1496" y="1981"/>
                      </a:lnTo>
                      <a:lnTo>
                        <a:pt x="1499" y="1982"/>
                      </a:lnTo>
                      <a:lnTo>
                        <a:pt x="1503" y="1981"/>
                      </a:lnTo>
                      <a:lnTo>
                        <a:pt x="1507" y="1981"/>
                      </a:lnTo>
                      <a:lnTo>
                        <a:pt x="1511" y="1981"/>
                      </a:lnTo>
                      <a:lnTo>
                        <a:pt x="1515" y="1982"/>
                      </a:lnTo>
                      <a:lnTo>
                        <a:pt x="1518" y="1981"/>
                      </a:lnTo>
                      <a:lnTo>
                        <a:pt x="1522" y="1981"/>
                      </a:lnTo>
                      <a:lnTo>
                        <a:pt x="1526" y="1982"/>
                      </a:lnTo>
                      <a:lnTo>
                        <a:pt x="1530" y="1981"/>
                      </a:lnTo>
                      <a:lnTo>
                        <a:pt x="1533" y="1982"/>
                      </a:lnTo>
                      <a:lnTo>
                        <a:pt x="1537" y="1982"/>
                      </a:lnTo>
                      <a:lnTo>
                        <a:pt x="1541" y="1981"/>
                      </a:lnTo>
                      <a:lnTo>
                        <a:pt x="1544" y="1981"/>
                      </a:lnTo>
                      <a:lnTo>
                        <a:pt x="1548" y="1982"/>
                      </a:lnTo>
                      <a:lnTo>
                        <a:pt x="1552" y="1981"/>
                      </a:lnTo>
                      <a:lnTo>
                        <a:pt x="1556" y="1981"/>
                      </a:lnTo>
                      <a:lnTo>
                        <a:pt x="1560" y="1981"/>
                      </a:lnTo>
                      <a:lnTo>
                        <a:pt x="1563" y="1981"/>
                      </a:lnTo>
                      <a:lnTo>
                        <a:pt x="1567" y="1981"/>
                      </a:lnTo>
                      <a:lnTo>
                        <a:pt x="1571" y="1980"/>
                      </a:lnTo>
                      <a:lnTo>
                        <a:pt x="1575" y="1980"/>
                      </a:lnTo>
                      <a:lnTo>
                        <a:pt x="1578" y="1980"/>
                      </a:lnTo>
                      <a:lnTo>
                        <a:pt x="1582" y="1979"/>
                      </a:lnTo>
                      <a:lnTo>
                        <a:pt x="1586" y="1980"/>
                      </a:lnTo>
                      <a:lnTo>
                        <a:pt x="1590" y="1979"/>
                      </a:lnTo>
                      <a:lnTo>
                        <a:pt x="1593" y="1979"/>
                      </a:lnTo>
                      <a:lnTo>
                        <a:pt x="1597" y="1979"/>
                      </a:lnTo>
                      <a:lnTo>
                        <a:pt x="1601" y="1978"/>
                      </a:lnTo>
                      <a:lnTo>
                        <a:pt x="1605" y="1978"/>
                      </a:lnTo>
                      <a:lnTo>
                        <a:pt x="1608" y="1978"/>
                      </a:lnTo>
                      <a:lnTo>
                        <a:pt x="1612" y="1977"/>
                      </a:lnTo>
                      <a:lnTo>
                        <a:pt x="1616" y="1977"/>
                      </a:lnTo>
                      <a:lnTo>
                        <a:pt x="1620" y="1977"/>
                      </a:lnTo>
                      <a:lnTo>
                        <a:pt x="1623" y="1977"/>
                      </a:lnTo>
                      <a:lnTo>
                        <a:pt x="1627" y="1977"/>
                      </a:lnTo>
                      <a:lnTo>
                        <a:pt x="1631" y="1977"/>
                      </a:lnTo>
                      <a:lnTo>
                        <a:pt x="1635" y="1977"/>
                      </a:lnTo>
                      <a:lnTo>
                        <a:pt x="1639" y="1976"/>
                      </a:lnTo>
                      <a:lnTo>
                        <a:pt x="1642" y="1977"/>
                      </a:lnTo>
                      <a:lnTo>
                        <a:pt x="1646" y="1976"/>
                      </a:lnTo>
                      <a:lnTo>
                        <a:pt x="1650" y="1977"/>
                      </a:lnTo>
                      <a:lnTo>
                        <a:pt x="1654" y="1976"/>
                      </a:lnTo>
                      <a:lnTo>
                        <a:pt x="1657" y="1976"/>
                      </a:lnTo>
                      <a:lnTo>
                        <a:pt x="1661" y="1976"/>
                      </a:lnTo>
                      <a:lnTo>
                        <a:pt x="1665" y="1976"/>
                      </a:lnTo>
                      <a:lnTo>
                        <a:pt x="1669" y="1975"/>
                      </a:lnTo>
                      <a:lnTo>
                        <a:pt x="1672" y="1975"/>
                      </a:lnTo>
                      <a:lnTo>
                        <a:pt x="1676" y="1976"/>
                      </a:lnTo>
                      <a:lnTo>
                        <a:pt x="1680" y="1975"/>
                      </a:lnTo>
                      <a:lnTo>
                        <a:pt x="1684" y="1975"/>
                      </a:lnTo>
                      <a:lnTo>
                        <a:pt x="1687" y="1975"/>
                      </a:lnTo>
                      <a:lnTo>
                        <a:pt x="1691" y="1975"/>
                      </a:lnTo>
                      <a:lnTo>
                        <a:pt x="1695" y="1975"/>
                      </a:lnTo>
                      <a:lnTo>
                        <a:pt x="1699" y="1975"/>
                      </a:lnTo>
                      <a:lnTo>
                        <a:pt x="1702" y="1975"/>
                      </a:lnTo>
                      <a:lnTo>
                        <a:pt x="1706" y="1975"/>
                      </a:lnTo>
                      <a:lnTo>
                        <a:pt x="1710" y="1975"/>
                      </a:lnTo>
                      <a:lnTo>
                        <a:pt x="1714" y="1976"/>
                      </a:lnTo>
                      <a:lnTo>
                        <a:pt x="1717" y="1976"/>
                      </a:lnTo>
                      <a:lnTo>
                        <a:pt x="1721" y="1976"/>
                      </a:lnTo>
                      <a:lnTo>
                        <a:pt x="1725" y="1977"/>
                      </a:lnTo>
                      <a:lnTo>
                        <a:pt x="1729" y="1977"/>
                      </a:lnTo>
                      <a:lnTo>
                        <a:pt x="1733" y="1977"/>
                      </a:lnTo>
                      <a:lnTo>
                        <a:pt x="1736" y="1977"/>
                      </a:lnTo>
                      <a:lnTo>
                        <a:pt x="1740" y="1978"/>
                      </a:lnTo>
                      <a:lnTo>
                        <a:pt x="1744" y="1978"/>
                      </a:lnTo>
                      <a:lnTo>
                        <a:pt x="1747" y="1979"/>
                      </a:lnTo>
                      <a:lnTo>
                        <a:pt x="1751" y="1979"/>
                      </a:lnTo>
                      <a:lnTo>
                        <a:pt x="1755" y="1979"/>
                      </a:lnTo>
                      <a:lnTo>
                        <a:pt x="1759" y="1979"/>
                      </a:lnTo>
                      <a:lnTo>
                        <a:pt x="1762" y="1979"/>
                      </a:lnTo>
                      <a:lnTo>
                        <a:pt x="1766" y="1979"/>
                      </a:lnTo>
                      <a:lnTo>
                        <a:pt x="1770" y="1980"/>
                      </a:lnTo>
                      <a:lnTo>
                        <a:pt x="1774" y="1980"/>
                      </a:lnTo>
                      <a:lnTo>
                        <a:pt x="1778" y="1980"/>
                      </a:lnTo>
                      <a:lnTo>
                        <a:pt x="1781" y="1981"/>
                      </a:lnTo>
                      <a:lnTo>
                        <a:pt x="1785" y="1980"/>
                      </a:lnTo>
                      <a:lnTo>
                        <a:pt x="1789" y="1981"/>
                      </a:lnTo>
                      <a:lnTo>
                        <a:pt x="1793" y="1980"/>
                      </a:lnTo>
                      <a:lnTo>
                        <a:pt x="1796" y="1981"/>
                      </a:lnTo>
                      <a:lnTo>
                        <a:pt x="1800" y="1981"/>
                      </a:lnTo>
                      <a:lnTo>
                        <a:pt x="1804" y="1981"/>
                      </a:lnTo>
                      <a:lnTo>
                        <a:pt x="1808" y="1981"/>
                      </a:lnTo>
                      <a:lnTo>
                        <a:pt x="1811" y="1981"/>
                      </a:lnTo>
                      <a:lnTo>
                        <a:pt x="1815" y="1981"/>
                      </a:lnTo>
                      <a:lnTo>
                        <a:pt x="1819" y="1981"/>
                      </a:lnTo>
                      <a:lnTo>
                        <a:pt x="1823" y="1981"/>
                      </a:lnTo>
                      <a:lnTo>
                        <a:pt x="1826" y="1981"/>
                      </a:lnTo>
                      <a:lnTo>
                        <a:pt x="1830" y="1981"/>
                      </a:lnTo>
                      <a:lnTo>
                        <a:pt x="1834" y="1981"/>
                      </a:lnTo>
                      <a:lnTo>
                        <a:pt x="1838" y="1982"/>
                      </a:lnTo>
                      <a:lnTo>
                        <a:pt x="1841" y="1982"/>
                      </a:lnTo>
                      <a:lnTo>
                        <a:pt x="1845" y="1982"/>
                      </a:lnTo>
                      <a:lnTo>
                        <a:pt x="1849" y="1982"/>
                      </a:lnTo>
                      <a:lnTo>
                        <a:pt x="1853" y="1982"/>
                      </a:lnTo>
                      <a:lnTo>
                        <a:pt x="1857" y="1982"/>
                      </a:lnTo>
                      <a:lnTo>
                        <a:pt x="1860" y="1981"/>
                      </a:lnTo>
                      <a:lnTo>
                        <a:pt x="1864" y="1982"/>
                      </a:lnTo>
                      <a:lnTo>
                        <a:pt x="1868" y="1983"/>
                      </a:lnTo>
                      <a:lnTo>
                        <a:pt x="1871" y="1982"/>
                      </a:lnTo>
                      <a:lnTo>
                        <a:pt x="1875" y="1982"/>
                      </a:lnTo>
                      <a:lnTo>
                        <a:pt x="1879" y="1982"/>
                      </a:lnTo>
                      <a:lnTo>
                        <a:pt x="1883" y="1982"/>
                      </a:lnTo>
                      <a:lnTo>
                        <a:pt x="1886" y="1982"/>
                      </a:lnTo>
                      <a:lnTo>
                        <a:pt x="1890" y="1982"/>
                      </a:lnTo>
                      <a:lnTo>
                        <a:pt x="1894" y="1982"/>
                      </a:lnTo>
                      <a:lnTo>
                        <a:pt x="1898" y="1982"/>
                      </a:lnTo>
                      <a:lnTo>
                        <a:pt x="1902" y="1982"/>
                      </a:lnTo>
                      <a:lnTo>
                        <a:pt x="1905" y="1982"/>
                      </a:lnTo>
                      <a:lnTo>
                        <a:pt x="1909" y="1981"/>
                      </a:lnTo>
                      <a:lnTo>
                        <a:pt x="1913" y="1981"/>
                      </a:lnTo>
                      <a:lnTo>
                        <a:pt x="1917" y="1982"/>
                      </a:lnTo>
                      <a:lnTo>
                        <a:pt x="1920" y="1982"/>
                      </a:lnTo>
                      <a:lnTo>
                        <a:pt x="1924" y="1981"/>
                      </a:lnTo>
                      <a:lnTo>
                        <a:pt x="1928" y="1981"/>
                      </a:lnTo>
                      <a:lnTo>
                        <a:pt x="1932" y="1981"/>
                      </a:lnTo>
                      <a:lnTo>
                        <a:pt x="1935" y="1980"/>
                      </a:lnTo>
                      <a:lnTo>
                        <a:pt x="1939" y="1980"/>
                      </a:lnTo>
                      <a:lnTo>
                        <a:pt x="1943" y="1979"/>
                      </a:lnTo>
                      <a:lnTo>
                        <a:pt x="1947" y="1980"/>
                      </a:lnTo>
                      <a:lnTo>
                        <a:pt x="1950" y="1979"/>
                      </a:lnTo>
                      <a:lnTo>
                        <a:pt x="1954" y="1979"/>
                      </a:lnTo>
                      <a:lnTo>
                        <a:pt x="1958" y="1979"/>
                      </a:lnTo>
                      <a:lnTo>
                        <a:pt x="1962" y="1979"/>
                      </a:lnTo>
                      <a:lnTo>
                        <a:pt x="1965" y="1978"/>
                      </a:lnTo>
                      <a:lnTo>
                        <a:pt x="1969" y="1978"/>
                      </a:lnTo>
                      <a:lnTo>
                        <a:pt x="1973" y="1977"/>
                      </a:lnTo>
                      <a:lnTo>
                        <a:pt x="1977" y="1977"/>
                      </a:lnTo>
                      <a:lnTo>
                        <a:pt x="1981" y="1977"/>
                      </a:lnTo>
                      <a:lnTo>
                        <a:pt x="1984" y="1977"/>
                      </a:lnTo>
                      <a:lnTo>
                        <a:pt x="1988" y="1977"/>
                      </a:lnTo>
                      <a:lnTo>
                        <a:pt x="1992" y="1977"/>
                      </a:lnTo>
                      <a:lnTo>
                        <a:pt x="1995" y="1977"/>
                      </a:lnTo>
                      <a:lnTo>
                        <a:pt x="1999" y="1977"/>
                      </a:lnTo>
                      <a:lnTo>
                        <a:pt x="2003" y="1977"/>
                      </a:lnTo>
                      <a:lnTo>
                        <a:pt x="2007" y="1977"/>
                      </a:lnTo>
                      <a:lnTo>
                        <a:pt x="2010" y="1976"/>
                      </a:lnTo>
                      <a:lnTo>
                        <a:pt x="2014" y="1977"/>
                      </a:lnTo>
                      <a:lnTo>
                        <a:pt x="2018" y="1977"/>
                      </a:lnTo>
                      <a:lnTo>
                        <a:pt x="2022" y="1977"/>
                      </a:lnTo>
                      <a:lnTo>
                        <a:pt x="2026" y="1977"/>
                      </a:lnTo>
                      <a:lnTo>
                        <a:pt x="2029" y="1977"/>
                      </a:lnTo>
                      <a:lnTo>
                        <a:pt x="2033" y="1977"/>
                      </a:lnTo>
                      <a:lnTo>
                        <a:pt x="2037" y="1977"/>
                      </a:lnTo>
                      <a:lnTo>
                        <a:pt x="2041" y="1977"/>
                      </a:lnTo>
                      <a:lnTo>
                        <a:pt x="2044" y="1977"/>
                      </a:lnTo>
                      <a:lnTo>
                        <a:pt x="2048" y="1977"/>
                      </a:lnTo>
                      <a:lnTo>
                        <a:pt x="2052" y="1977"/>
                      </a:lnTo>
                      <a:lnTo>
                        <a:pt x="2056" y="1978"/>
                      </a:lnTo>
                      <a:lnTo>
                        <a:pt x="2059" y="1977"/>
                      </a:lnTo>
                      <a:lnTo>
                        <a:pt x="2063" y="1977"/>
                      </a:lnTo>
                      <a:lnTo>
                        <a:pt x="2067" y="1976"/>
                      </a:lnTo>
                      <a:lnTo>
                        <a:pt x="2071" y="1977"/>
                      </a:lnTo>
                      <a:lnTo>
                        <a:pt x="2074" y="1976"/>
                      </a:lnTo>
                      <a:lnTo>
                        <a:pt x="2078" y="1976"/>
                      </a:lnTo>
                      <a:lnTo>
                        <a:pt x="2082" y="1976"/>
                      </a:lnTo>
                      <a:lnTo>
                        <a:pt x="2086" y="1976"/>
                      </a:lnTo>
                      <a:lnTo>
                        <a:pt x="2089" y="1976"/>
                      </a:lnTo>
                      <a:lnTo>
                        <a:pt x="2093" y="1975"/>
                      </a:lnTo>
                      <a:lnTo>
                        <a:pt x="2097" y="1975"/>
                      </a:lnTo>
                      <a:lnTo>
                        <a:pt x="2101" y="1975"/>
                      </a:lnTo>
                      <a:lnTo>
                        <a:pt x="2105" y="1976"/>
                      </a:lnTo>
                      <a:lnTo>
                        <a:pt x="2108" y="1975"/>
                      </a:lnTo>
                      <a:lnTo>
                        <a:pt x="2112" y="1975"/>
                      </a:lnTo>
                      <a:lnTo>
                        <a:pt x="2116" y="1975"/>
                      </a:lnTo>
                      <a:lnTo>
                        <a:pt x="2120" y="1975"/>
                      </a:lnTo>
                      <a:lnTo>
                        <a:pt x="2123" y="1975"/>
                      </a:lnTo>
                      <a:lnTo>
                        <a:pt x="2127" y="1975"/>
                      </a:lnTo>
                      <a:lnTo>
                        <a:pt x="2131" y="1976"/>
                      </a:lnTo>
                      <a:lnTo>
                        <a:pt x="2134" y="1976"/>
                      </a:lnTo>
                      <a:lnTo>
                        <a:pt x="2138" y="1976"/>
                      </a:lnTo>
                      <a:lnTo>
                        <a:pt x="2142" y="1976"/>
                      </a:lnTo>
                      <a:lnTo>
                        <a:pt x="2146" y="1976"/>
                      </a:lnTo>
                      <a:lnTo>
                        <a:pt x="2150" y="1977"/>
                      </a:lnTo>
                      <a:lnTo>
                        <a:pt x="2153" y="1977"/>
                      </a:lnTo>
                      <a:lnTo>
                        <a:pt x="2157" y="1978"/>
                      </a:lnTo>
                      <a:lnTo>
                        <a:pt x="2161" y="1978"/>
                      </a:lnTo>
                      <a:lnTo>
                        <a:pt x="2165" y="1978"/>
                      </a:lnTo>
                      <a:lnTo>
                        <a:pt x="2168" y="1978"/>
                      </a:lnTo>
                      <a:lnTo>
                        <a:pt x="2172" y="1978"/>
                      </a:lnTo>
                      <a:lnTo>
                        <a:pt x="2176" y="1978"/>
                      </a:lnTo>
                      <a:lnTo>
                        <a:pt x="2180" y="1979"/>
                      </a:lnTo>
                      <a:lnTo>
                        <a:pt x="2183" y="1979"/>
                      </a:lnTo>
                      <a:lnTo>
                        <a:pt x="2187" y="1980"/>
                      </a:lnTo>
                      <a:lnTo>
                        <a:pt x="2191" y="1980"/>
                      </a:lnTo>
                      <a:lnTo>
                        <a:pt x="2195" y="1980"/>
                      </a:lnTo>
                      <a:lnTo>
                        <a:pt x="2198" y="1980"/>
                      </a:lnTo>
                      <a:lnTo>
                        <a:pt x="2202" y="1981"/>
                      </a:lnTo>
                      <a:lnTo>
                        <a:pt x="2206" y="1981"/>
                      </a:lnTo>
                      <a:lnTo>
                        <a:pt x="2210" y="1980"/>
                      </a:lnTo>
                      <a:lnTo>
                        <a:pt x="2213" y="1980"/>
                      </a:lnTo>
                      <a:lnTo>
                        <a:pt x="2217" y="1980"/>
                      </a:lnTo>
                      <a:lnTo>
                        <a:pt x="2221" y="1982"/>
                      </a:lnTo>
                      <a:lnTo>
                        <a:pt x="2225" y="1981"/>
                      </a:lnTo>
                      <a:lnTo>
                        <a:pt x="2229" y="1981"/>
                      </a:lnTo>
                      <a:lnTo>
                        <a:pt x="2232" y="1981"/>
                      </a:lnTo>
                      <a:lnTo>
                        <a:pt x="2236" y="1981"/>
                      </a:lnTo>
                      <a:lnTo>
                        <a:pt x="2240" y="1981"/>
                      </a:lnTo>
                      <a:lnTo>
                        <a:pt x="2244" y="1981"/>
                      </a:lnTo>
                      <a:lnTo>
                        <a:pt x="2247" y="1982"/>
                      </a:lnTo>
                      <a:lnTo>
                        <a:pt x="2251" y="1981"/>
                      </a:lnTo>
                      <a:lnTo>
                        <a:pt x="2255" y="1981"/>
                      </a:lnTo>
                      <a:lnTo>
                        <a:pt x="2258" y="1982"/>
                      </a:lnTo>
                      <a:lnTo>
                        <a:pt x="2262" y="1981"/>
                      </a:lnTo>
                      <a:lnTo>
                        <a:pt x="2266" y="1981"/>
                      </a:lnTo>
                      <a:lnTo>
                        <a:pt x="2270" y="1982"/>
                      </a:lnTo>
                      <a:lnTo>
                        <a:pt x="2274" y="1981"/>
                      </a:lnTo>
                      <a:lnTo>
                        <a:pt x="2277" y="1980"/>
                      </a:lnTo>
                      <a:lnTo>
                        <a:pt x="2281" y="1980"/>
                      </a:lnTo>
                      <a:lnTo>
                        <a:pt x="2285" y="1981"/>
                      </a:lnTo>
                      <a:lnTo>
                        <a:pt x="2289" y="1981"/>
                      </a:lnTo>
                      <a:lnTo>
                        <a:pt x="2292" y="1981"/>
                      </a:lnTo>
                      <a:lnTo>
                        <a:pt x="2296" y="1980"/>
                      </a:lnTo>
                      <a:lnTo>
                        <a:pt x="2300" y="1981"/>
                      </a:lnTo>
                      <a:lnTo>
                        <a:pt x="2304" y="1981"/>
                      </a:lnTo>
                      <a:lnTo>
                        <a:pt x="2307" y="1980"/>
                      </a:lnTo>
                      <a:lnTo>
                        <a:pt x="2311" y="1980"/>
                      </a:lnTo>
                      <a:lnTo>
                        <a:pt x="2315" y="1980"/>
                      </a:lnTo>
                      <a:lnTo>
                        <a:pt x="2319" y="1981"/>
                      </a:lnTo>
                      <a:lnTo>
                        <a:pt x="2322" y="1981"/>
                      </a:lnTo>
                      <a:lnTo>
                        <a:pt x="2326" y="1980"/>
                      </a:lnTo>
                      <a:lnTo>
                        <a:pt x="2330" y="1980"/>
                      </a:lnTo>
                      <a:lnTo>
                        <a:pt x="2334" y="1980"/>
                      </a:lnTo>
                      <a:lnTo>
                        <a:pt x="2337" y="1979"/>
                      </a:lnTo>
                      <a:lnTo>
                        <a:pt x="2341" y="1980"/>
                      </a:lnTo>
                      <a:lnTo>
                        <a:pt x="2345" y="1980"/>
                      </a:lnTo>
                      <a:lnTo>
                        <a:pt x="2349" y="1979"/>
                      </a:lnTo>
                      <a:lnTo>
                        <a:pt x="2352" y="1980"/>
                      </a:lnTo>
                      <a:lnTo>
                        <a:pt x="2356" y="1979"/>
                      </a:lnTo>
                      <a:lnTo>
                        <a:pt x="2360" y="1978"/>
                      </a:lnTo>
                      <a:lnTo>
                        <a:pt x="2364" y="1979"/>
                      </a:lnTo>
                      <a:lnTo>
                        <a:pt x="2368" y="1978"/>
                      </a:lnTo>
                      <a:lnTo>
                        <a:pt x="2371" y="1978"/>
                      </a:lnTo>
                      <a:lnTo>
                        <a:pt x="2375" y="1978"/>
                      </a:lnTo>
                      <a:lnTo>
                        <a:pt x="2379" y="1978"/>
                      </a:lnTo>
                      <a:lnTo>
                        <a:pt x="2382" y="1978"/>
                      </a:lnTo>
                      <a:lnTo>
                        <a:pt x="2386" y="1978"/>
                      </a:lnTo>
                      <a:lnTo>
                        <a:pt x="2390" y="1978"/>
                      </a:lnTo>
                      <a:lnTo>
                        <a:pt x="2394" y="1978"/>
                      </a:lnTo>
                      <a:lnTo>
                        <a:pt x="2398" y="1977"/>
                      </a:lnTo>
                      <a:lnTo>
                        <a:pt x="2401" y="1978"/>
                      </a:lnTo>
                      <a:lnTo>
                        <a:pt x="2405" y="1977"/>
                      </a:lnTo>
                      <a:lnTo>
                        <a:pt x="2409" y="1977"/>
                      </a:lnTo>
                      <a:lnTo>
                        <a:pt x="2413" y="1977"/>
                      </a:lnTo>
                      <a:lnTo>
                        <a:pt x="2416" y="1977"/>
                      </a:lnTo>
                      <a:lnTo>
                        <a:pt x="2420" y="1977"/>
                      </a:lnTo>
                      <a:lnTo>
                        <a:pt x="2424" y="1976"/>
                      </a:lnTo>
                      <a:lnTo>
                        <a:pt x="2428" y="1976"/>
                      </a:lnTo>
                      <a:lnTo>
                        <a:pt x="2431" y="1976"/>
                      </a:lnTo>
                      <a:lnTo>
                        <a:pt x="2435" y="1976"/>
                      </a:lnTo>
                      <a:lnTo>
                        <a:pt x="2439" y="1976"/>
                      </a:lnTo>
                      <a:lnTo>
                        <a:pt x="2443" y="1975"/>
                      </a:lnTo>
                      <a:lnTo>
                        <a:pt x="2446" y="1976"/>
                      </a:lnTo>
                      <a:lnTo>
                        <a:pt x="2450" y="1976"/>
                      </a:lnTo>
                      <a:lnTo>
                        <a:pt x="2454" y="1975"/>
                      </a:lnTo>
                      <a:lnTo>
                        <a:pt x="2458" y="1976"/>
                      </a:lnTo>
                      <a:lnTo>
                        <a:pt x="2461" y="1976"/>
                      </a:lnTo>
                      <a:lnTo>
                        <a:pt x="2465" y="1975"/>
                      </a:lnTo>
                      <a:lnTo>
                        <a:pt x="2469" y="1975"/>
                      </a:lnTo>
                      <a:lnTo>
                        <a:pt x="2473" y="1975"/>
                      </a:lnTo>
                      <a:lnTo>
                        <a:pt x="2476" y="1975"/>
                      </a:lnTo>
                      <a:lnTo>
                        <a:pt x="2480" y="1974"/>
                      </a:lnTo>
                      <a:lnTo>
                        <a:pt x="2484" y="1974"/>
                      </a:lnTo>
                      <a:lnTo>
                        <a:pt x="2488" y="1974"/>
                      </a:lnTo>
                      <a:lnTo>
                        <a:pt x="2492" y="1974"/>
                      </a:lnTo>
                      <a:lnTo>
                        <a:pt x="2495" y="1974"/>
                      </a:lnTo>
                      <a:lnTo>
                        <a:pt x="2499" y="1973"/>
                      </a:lnTo>
                      <a:lnTo>
                        <a:pt x="2503" y="1973"/>
                      </a:lnTo>
                      <a:lnTo>
                        <a:pt x="2507" y="1972"/>
                      </a:lnTo>
                      <a:lnTo>
                        <a:pt x="2510" y="1972"/>
                      </a:lnTo>
                      <a:lnTo>
                        <a:pt x="2514" y="1971"/>
                      </a:lnTo>
                      <a:lnTo>
                        <a:pt x="2518" y="1971"/>
                      </a:lnTo>
                      <a:lnTo>
                        <a:pt x="2522" y="1970"/>
                      </a:lnTo>
                      <a:lnTo>
                        <a:pt x="2525" y="1970"/>
                      </a:lnTo>
                      <a:lnTo>
                        <a:pt x="2529" y="1971"/>
                      </a:lnTo>
                      <a:lnTo>
                        <a:pt x="2533" y="1970"/>
                      </a:lnTo>
                      <a:lnTo>
                        <a:pt x="2537" y="1970"/>
                      </a:lnTo>
                      <a:lnTo>
                        <a:pt x="2540" y="1970"/>
                      </a:lnTo>
                      <a:lnTo>
                        <a:pt x="2544" y="1971"/>
                      </a:lnTo>
                      <a:lnTo>
                        <a:pt x="2548" y="1971"/>
                      </a:lnTo>
                      <a:lnTo>
                        <a:pt x="2552" y="1971"/>
                      </a:lnTo>
                      <a:lnTo>
                        <a:pt x="2555" y="1971"/>
                      </a:lnTo>
                      <a:lnTo>
                        <a:pt x="2559" y="1971"/>
                      </a:lnTo>
                      <a:lnTo>
                        <a:pt x="2563" y="1972"/>
                      </a:lnTo>
                      <a:lnTo>
                        <a:pt x="2567" y="1972"/>
                      </a:lnTo>
                      <a:lnTo>
                        <a:pt x="2571" y="1972"/>
                      </a:lnTo>
                      <a:lnTo>
                        <a:pt x="2574" y="1972"/>
                      </a:lnTo>
                      <a:lnTo>
                        <a:pt x="2578" y="1971"/>
                      </a:lnTo>
                      <a:lnTo>
                        <a:pt x="2582" y="1971"/>
                      </a:lnTo>
                      <a:lnTo>
                        <a:pt x="2585" y="1971"/>
                      </a:lnTo>
                      <a:lnTo>
                        <a:pt x="2589" y="1971"/>
                      </a:lnTo>
                      <a:lnTo>
                        <a:pt x="2593" y="1971"/>
                      </a:lnTo>
                      <a:lnTo>
                        <a:pt x="2597" y="1970"/>
                      </a:lnTo>
                      <a:lnTo>
                        <a:pt x="2600" y="1971"/>
                      </a:lnTo>
                      <a:lnTo>
                        <a:pt x="2604" y="1971"/>
                      </a:lnTo>
                      <a:lnTo>
                        <a:pt x="2608" y="1971"/>
                      </a:lnTo>
                      <a:lnTo>
                        <a:pt x="2612" y="1970"/>
                      </a:lnTo>
                      <a:lnTo>
                        <a:pt x="2616" y="1970"/>
                      </a:lnTo>
                      <a:lnTo>
                        <a:pt x="2619" y="1969"/>
                      </a:lnTo>
                      <a:lnTo>
                        <a:pt x="2623" y="1969"/>
                      </a:lnTo>
                      <a:lnTo>
                        <a:pt x="2627" y="1969"/>
                      </a:lnTo>
                      <a:lnTo>
                        <a:pt x="2631" y="1969"/>
                      </a:lnTo>
                      <a:lnTo>
                        <a:pt x="2634" y="1968"/>
                      </a:lnTo>
                      <a:lnTo>
                        <a:pt x="2638" y="1969"/>
                      </a:lnTo>
                      <a:lnTo>
                        <a:pt x="2642" y="1968"/>
                      </a:lnTo>
                      <a:lnTo>
                        <a:pt x="2646" y="1968"/>
                      </a:lnTo>
                      <a:lnTo>
                        <a:pt x="2649" y="1967"/>
                      </a:lnTo>
                      <a:lnTo>
                        <a:pt x="2653" y="1966"/>
                      </a:lnTo>
                      <a:lnTo>
                        <a:pt x="2657" y="1966"/>
                      </a:lnTo>
                      <a:lnTo>
                        <a:pt x="2661" y="1965"/>
                      </a:lnTo>
                      <a:lnTo>
                        <a:pt x="2664" y="1965"/>
                      </a:lnTo>
                      <a:lnTo>
                        <a:pt x="2668" y="1964"/>
                      </a:lnTo>
                      <a:lnTo>
                        <a:pt x="2672" y="1963"/>
                      </a:lnTo>
                      <a:lnTo>
                        <a:pt x="2676" y="1964"/>
                      </a:lnTo>
                      <a:lnTo>
                        <a:pt x="2679" y="1963"/>
                      </a:lnTo>
                      <a:lnTo>
                        <a:pt x="2683" y="1962"/>
                      </a:lnTo>
                      <a:lnTo>
                        <a:pt x="2687" y="1961"/>
                      </a:lnTo>
                      <a:lnTo>
                        <a:pt x="2691" y="1961"/>
                      </a:lnTo>
                      <a:lnTo>
                        <a:pt x="2695" y="1962"/>
                      </a:lnTo>
                      <a:lnTo>
                        <a:pt x="2698" y="1961"/>
                      </a:lnTo>
                      <a:lnTo>
                        <a:pt x="2702" y="1960"/>
                      </a:lnTo>
                      <a:lnTo>
                        <a:pt x="2706" y="1960"/>
                      </a:lnTo>
                      <a:lnTo>
                        <a:pt x="2709" y="1960"/>
                      </a:lnTo>
                      <a:lnTo>
                        <a:pt x="2713" y="1960"/>
                      </a:lnTo>
                      <a:lnTo>
                        <a:pt x="2717" y="1959"/>
                      </a:lnTo>
                      <a:lnTo>
                        <a:pt x="2721" y="1960"/>
                      </a:lnTo>
                      <a:lnTo>
                        <a:pt x="2724" y="1959"/>
                      </a:lnTo>
                      <a:lnTo>
                        <a:pt x="2728" y="1960"/>
                      </a:lnTo>
                      <a:lnTo>
                        <a:pt x="2732" y="1960"/>
                      </a:lnTo>
                      <a:lnTo>
                        <a:pt x="2736" y="1960"/>
                      </a:lnTo>
                      <a:lnTo>
                        <a:pt x="2740" y="1960"/>
                      </a:lnTo>
                      <a:lnTo>
                        <a:pt x="2743" y="1960"/>
                      </a:lnTo>
                      <a:lnTo>
                        <a:pt x="2747" y="1960"/>
                      </a:lnTo>
                      <a:lnTo>
                        <a:pt x="2751" y="1960"/>
                      </a:lnTo>
                      <a:lnTo>
                        <a:pt x="2755" y="1960"/>
                      </a:lnTo>
                      <a:lnTo>
                        <a:pt x="2758" y="1960"/>
                      </a:lnTo>
                      <a:lnTo>
                        <a:pt x="2762" y="1960"/>
                      </a:lnTo>
                      <a:lnTo>
                        <a:pt x="2766" y="1961"/>
                      </a:lnTo>
                      <a:lnTo>
                        <a:pt x="2770" y="1960"/>
                      </a:lnTo>
                      <a:lnTo>
                        <a:pt x="2773" y="1961"/>
                      </a:lnTo>
                      <a:lnTo>
                        <a:pt x="2777" y="1960"/>
                      </a:lnTo>
                      <a:lnTo>
                        <a:pt x="2781" y="1961"/>
                      </a:lnTo>
                      <a:lnTo>
                        <a:pt x="2785" y="1962"/>
                      </a:lnTo>
                      <a:lnTo>
                        <a:pt x="2788" y="1962"/>
                      </a:lnTo>
                      <a:lnTo>
                        <a:pt x="2792" y="1961"/>
                      </a:lnTo>
                      <a:lnTo>
                        <a:pt x="2796" y="1962"/>
                      </a:lnTo>
                      <a:lnTo>
                        <a:pt x="2800" y="1962"/>
                      </a:lnTo>
                      <a:lnTo>
                        <a:pt x="2803" y="1962"/>
                      </a:lnTo>
                      <a:lnTo>
                        <a:pt x="2807" y="1962"/>
                      </a:lnTo>
                      <a:lnTo>
                        <a:pt x="2811" y="1963"/>
                      </a:lnTo>
                      <a:lnTo>
                        <a:pt x="2815" y="1963"/>
                      </a:lnTo>
                      <a:lnTo>
                        <a:pt x="2819" y="1963"/>
                      </a:lnTo>
                      <a:lnTo>
                        <a:pt x="2822" y="1963"/>
                      </a:lnTo>
                      <a:lnTo>
                        <a:pt x="2826" y="1963"/>
                      </a:lnTo>
                      <a:lnTo>
                        <a:pt x="2830" y="1963"/>
                      </a:lnTo>
                      <a:lnTo>
                        <a:pt x="2833" y="1963"/>
                      </a:lnTo>
                      <a:lnTo>
                        <a:pt x="2837" y="1964"/>
                      </a:lnTo>
                      <a:lnTo>
                        <a:pt x="2841" y="1963"/>
                      </a:lnTo>
                      <a:lnTo>
                        <a:pt x="2845" y="1964"/>
                      </a:lnTo>
                      <a:lnTo>
                        <a:pt x="2848" y="1964"/>
                      </a:lnTo>
                      <a:lnTo>
                        <a:pt x="2852" y="1965"/>
                      </a:lnTo>
                      <a:lnTo>
                        <a:pt x="2856" y="1965"/>
                      </a:lnTo>
                      <a:lnTo>
                        <a:pt x="2860" y="1965"/>
                      </a:lnTo>
                      <a:lnTo>
                        <a:pt x="2864" y="1965"/>
                      </a:lnTo>
                      <a:lnTo>
                        <a:pt x="2867" y="1966"/>
                      </a:lnTo>
                      <a:lnTo>
                        <a:pt x="2871" y="1965"/>
                      </a:lnTo>
                      <a:lnTo>
                        <a:pt x="2875" y="1966"/>
                      </a:lnTo>
                      <a:lnTo>
                        <a:pt x="2879" y="1966"/>
                      </a:lnTo>
                      <a:lnTo>
                        <a:pt x="2882" y="1966"/>
                      </a:lnTo>
                      <a:lnTo>
                        <a:pt x="2886" y="1966"/>
                      </a:lnTo>
                      <a:lnTo>
                        <a:pt x="2890" y="1967"/>
                      </a:lnTo>
                      <a:lnTo>
                        <a:pt x="2894" y="1967"/>
                      </a:lnTo>
                      <a:lnTo>
                        <a:pt x="2897" y="1968"/>
                      </a:lnTo>
                      <a:lnTo>
                        <a:pt x="2901" y="1969"/>
                      </a:lnTo>
                      <a:lnTo>
                        <a:pt x="2905" y="1968"/>
                      </a:lnTo>
                      <a:lnTo>
                        <a:pt x="2909" y="1968"/>
                      </a:lnTo>
                      <a:lnTo>
                        <a:pt x="2912" y="1969"/>
                      </a:lnTo>
                      <a:lnTo>
                        <a:pt x="2916" y="1969"/>
                      </a:lnTo>
                      <a:lnTo>
                        <a:pt x="2920" y="1969"/>
                      </a:lnTo>
                      <a:lnTo>
                        <a:pt x="2924" y="1969"/>
                      </a:lnTo>
                      <a:lnTo>
                        <a:pt x="2927" y="1969"/>
                      </a:lnTo>
                      <a:lnTo>
                        <a:pt x="2931" y="1970"/>
                      </a:lnTo>
                      <a:lnTo>
                        <a:pt x="2935" y="1969"/>
                      </a:lnTo>
                      <a:lnTo>
                        <a:pt x="2939" y="1969"/>
                      </a:lnTo>
                      <a:lnTo>
                        <a:pt x="2942" y="1969"/>
                      </a:lnTo>
                      <a:lnTo>
                        <a:pt x="2946" y="1969"/>
                      </a:lnTo>
                      <a:lnTo>
                        <a:pt x="2950" y="1970"/>
                      </a:lnTo>
                      <a:lnTo>
                        <a:pt x="2954" y="1970"/>
                      </a:lnTo>
                      <a:lnTo>
                        <a:pt x="2958" y="1970"/>
                      </a:lnTo>
                      <a:lnTo>
                        <a:pt x="2961" y="1969"/>
                      </a:lnTo>
                      <a:lnTo>
                        <a:pt x="2965" y="1969"/>
                      </a:lnTo>
                      <a:lnTo>
                        <a:pt x="2969" y="1969"/>
                      </a:lnTo>
                      <a:lnTo>
                        <a:pt x="2972" y="1969"/>
                      </a:lnTo>
                      <a:lnTo>
                        <a:pt x="2976" y="1969"/>
                      </a:lnTo>
                      <a:lnTo>
                        <a:pt x="2980" y="1969"/>
                      </a:lnTo>
                      <a:lnTo>
                        <a:pt x="2984" y="1969"/>
                      </a:lnTo>
                      <a:lnTo>
                        <a:pt x="2988" y="1969"/>
                      </a:lnTo>
                      <a:lnTo>
                        <a:pt x="2991" y="1969"/>
                      </a:lnTo>
                      <a:lnTo>
                        <a:pt x="2995" y="1970"/>
                      </a:lnTo>
                      <a:lnTo>
                        <a:pt x="2999" y="1969"/>
                      </a:lnTo>
                      <a:lnTo>
                        <a:pt x="3003" y="1969"/>
                      </a:lnTo>
                      <a:lnTo>
                        <a:pt x="3006" y="1970"/>
                      </a:lnTo>
                      <a:lnTo>
                        <a:pt x="3010" y="1969"/>
                      </a:lnTo>
                      <a:lnTo>
                        <a:pt x="3014" y="1969"/>
                      </a:lnTo>
                      <a:lnTo>
                        <a:pt x="3018" y="1969"/>
                      </a:lnTo>
                      <a:lnTo>
                        <a:pt x="3021" y="1969"/>
                      </a:lnTo>
                      <a:lnTo>
                        <a:pt x="3025" y="1969"/>
                      </a:lnTo>
                      <a:lnTo>
                        <a:pt x="3029" y="1970"/>
                      </a:lnTo>
                      <a:lnTo>
                        <a:pt x="3033" y="1969"/>
                      </a:lnTo>
                      <a:lnTo>
                        <a:pt x="3036" y="1969"/>
                      </a:lnTo>
                      <a:lnTo>
                        <a:pt x="3040" y="1969"/>
                      </a:lnTo>
                      <a:lnTo>
                        <a:pt x="3044" y="1970"/>
                      </a:lnTo>
                      <a:lnTo>
                        <a:pt x="3048" y="1969"/>
                      </a:lnTo>
                      <a:lnTo>
                        <a:pt x="3051" y="1970"/>
                      </a:lnTo>
                      <a:lnTo>
                        <a:pt x="3055" y="1969"/>
                      </a:lnTo>
                      <a:lnTo>
                        <a:pt x="3059" y="1969"/>
                      </a:lnTo>
                      <a:lnTo>
                        <a:pt x="3063" y="1969"/>
                      </a:lnTo>
                      <a:lnTo>
                        <a:pt x="3066" y="1969"/>
                      </a:lnTo>
                      <a:lnTo>
                        <a:pt x="3070" y="1970"/>
                      </a:lnTo>
                      <a:lnTo>
                        <a:pt x="3074" y="1970"/>
                      </a:lnTo>
                      <a:lnTo>
                        <a:pt x="3078" y="1970"/>
                      </a:lnTo>
                      <a:lnTo>
                        <a:pt x="3082" y="1970"/>
                      </a:lnTo>
                      <a:lnTo>
                        <a:pt x="3085" y="1970"/>
                      </a:lnTo>
                      <a:lnTo>
                        <a:pt x="3089" y="1969"/>
                      </a:lnTo>
                      <a:lnTo>
                        <a:pt x="3093" y="1969"/>
                      </a:lnTo>
                      <a:lnTo>
                        <a:pt x="3096" y="1969"/>
                      </a:lnTo>
                      <a:lnTo>
                        <a:pt x="3100" y="1969"/>
                      </a:lnTo>
                      <a:lnTo>
                        <a:pt x="3104" y="1969"/>
                      </a:lnTo>
                      <a:lnTo>
                        <a:pt x="3108" y="1970"/>
                      </a:lnTo>
                      <a:lnTo>
                        <a:pt x="3112" y="1969"/>
                      </a:lnTo>
                      <a:lnTo>
                        <a:pt x="3115" y="1969"/>
                      </a:lnTo>
                      <a:lnTo>
                        <a:pt x="3119" y="1969"/>
                      </a:lnTo>
                      <a:lnTo>
                        <a:pt x="3123" y="1969"/>
                      </a:lnTo>
                      <a:lnTo>
                        <a:pt x="3127" y="1968"/>
                      </a:lnTo>
                      <a:lnTo>
                        <a:pt x="3130" y="1969"/>
                      </a:lnTo>
                      <a:lnTo>
                        <a:pt x="3134" y="1969"/>
                      </a:lnTo>
                      <a:lnTo>
                        <a:pt x="3138" y="1969"/>
                      </a:lnTo>
                      <a:lnTo>
                        <a:pt x="3142" y="1969"/>
                      </a:lnTo>
                      <a:lnTo>
                        <a:pt x="3145" y="1968"/>
                      </a:lnTo>
                      <a:lnTo>
                        <a:pt x="3149" y="1968"/>
                      </a:lnTo>
                      <a:lnTo>
                        <a:pt x="3153" y="1969"/>
                      </a:lnTo>
                      <a:lnTo>
                        <a:pt x="3157" y="1968"/>
                      </a:lnTo>
                      <a:lnTo>
                        <a:pt x="3160" y="1968"/>
                      </a:lnTo>
                      <a:lnTo>
                        <a:pt x="3164" y="1968"/>
                      </a:lnTo>
                      <a:lnTo>
                        <a:pt x="3168" y="1968"/>
                      </a:lnTo>
                      <a:lnTo>
                        <a:pt x="3172" y="1969"/>
                      </a:lnTo>
                      <a:lnTo>
                        <a:pt x="3175" y="1968"/>
                      </a:lnTo>
                      <a:lnTo>
                        <a:pt x="3179" y="1968"/>
                      </a:lnTo>
                      <a:lnTo>
                        <a:pt x="3183" y="1968"/>
                      </a:lnTo>
                      <a:lnTo>
                        <a:pt x="3187" y="1968"/>
                      </a:lnTo>
                      <a:lnTo>
                        <a:pt x="3190" y="1968"/>
                      </a:lnTo>
                      <a:lnTo>
                        <a:pt x="3194" y="1968"/>
                      </a:lnTo>
                      <a:lnTo>
                        <a:pt x="3198" y="1967"/>
                      </a:lnTo>
                      <a:lnTo>
                        <a:pt x="3202" y="1967"/>
                      </a:lnTo>
                      <a:lnTo>
                        <a:pt x="3206" y="1967"/>
                      </a:lnTo>
                      <a:lnTo>
                        <a:pt x="3209" y="1967"/>
                      </a:lnTo>
                      <a:lnTo>
                        <a:pt x="3213" y="1967"/>
                      </a:lnTo>
                      <a:lnTo>
                        <a:pt x="3217" y="1967"/>
                      </a:lnTo>
                      <a:lnTo>
                        <a:pt x="3220" y="1966"/>
                      </a:lnTo>
                      <a:lnTo>
                        <a:pt x="3224" y="1966"/>
                      </a:lnTo>
                      <a:lnTo>
                        <a:pt x="3228" y="1967"/>
                      </a:lnTo>
                      <a:lnTo>
                        <a:pt x="3232" y="1966"/>
                      </a:lnTo>
                      <a:lnTo>
                        <a:pt x="3236" y="1966"/>
                      </a:lnTo>
                      <a:lnTo>
                        <a:pt x="3239" y="1965"/>
                      </a:lnTo>
                      <a:lnTo>
                        <a:pt x="3243" y="1966"/>
                      </a:lnTo>
                      <a:lnTo>
                        <a:pt x="3247" y="1966"/>
                      </a:lnTo>
                      <a:lnTo>
                        <a:pt x="3251" y="1965"/>
                      </a:lnTo>
                      <a:lnTo>
                        <a:pt x="3254" y="1965"/>
                      </a:lnTo>
                      <a:lnTo>
                        <a:pt x="3258" y="1965"/>
                      </a:lnTo>
                      <a:lnTo>
                        <a:pt x="3262" y="1965"/>
                      </a:lnTo>
                      <a:lnTo>
                        <a:pt x="3266" y="1965"/>
                      </a:lnTo>
                      <a:lnTo>
                        <a:pt x="3269" y="1965"/>
                      </a:lnTo>
                      <a:lnTo>
                        <a:pt x="3273" y="1965"/>
                      </a:lnTo>
                      <a:lnTo>
                        <a:pt x="3277" y="1965"/>
                      </a:lnTo>
                      <a:lnTo>
                        <a:pt x="3281" y="1964"/>
                      </a:lnTo>
                      <a:lnTo>
                        <a:pt x="3284" y="1964"/>
                      </a:lnTo>
                      <a:lnTo>
                        <a:pt x="3288" y="1964"/>
                      </a:lnTo>
                      <a:lnTo>
                        <a:pt x="3292" y="1964"/>
                      </a:lnTo>
                      <a:lnTo>
                        <a:pt x="3296" y="1964"/>
                      </a:lnTo>
                      <a:lnTo>
                        <a:pt x="3299" y="1963"/>
                      </a:lnTo>
                      <a:lnTo>
                        <a:pt x="3303" y="1963"/>
                      </a:lnTo>
                      <a:lnTo>
                        <a:pt x="3307" y="1964"/>
                      </a:lnTo>
                      <a:lnTo>
                        <a:pt x="3311" y="1963"/>
                      </a:lnTo>
                      <a:lnTo>
                        <a:pt x="3314" y="1962"/>
                      </a:lnTo>
                      <a:lnTo>
                        <a:pt x="3318" y="1963"/>
                      </a:lnTo>
                      <a:lnTo>
                        <a:pt x="3322" y="1963"/>
                      </a:lnTo>
                      <a:lnTo>
                        <a:pt x="3326" y="1963"/>
                      </a:lnTo>
                      <a:lnTo>
                        <a:pt x="3330" y="1962"/>
                      </a:lnTo>
                      <a:lnTo>
                        <a:pt x="3333" y="1963"/>
                      </a:lnTo>
                      <a:lnTo>
                        <a:pt x="3337" y="1963"/>
                      </a:lnTo>
                      <a:lnTo>
                        <a:pt x="3341" y="1962"/>
                      </a:lnTo>
                      <a:lnTo>
                        <a:pt x="3345" y="1962"/>
                      </a:lnTo>
                      <a:lnTo>
                        <a:pt x="3348" y="1963"/>
                      </a:lnTo>
                      <a:lnTo>
                        <a:pt x="3352" y="1961"/>
                      </a:lnTo>
                      <a:lnTo>
                        <a:pt x="3356" y="1962"/>
                      </a:lnTo>
                      <a:lnTo>
                        <a:pt x="3360" y="1962"/>
                      </a:lnTo>
                      <a:lnTo>
                        <a:pt x="3363" y="1961"/>
                      </a:lnTo>
                      <a:lnTo>
                        <a:pt x="3367" y="1961"/>
                      </a:lnTo>
                      <a:lnTo>
                        <a:pt x="3371" y="1960"/>
                      </a:lnTo>
                      <a:lnTo>
                        <a:pt x="3375" y="1960"/>
                      </a:lnTo>
                      <a:lnTo>
                        <a:pt x="3378" y="1960"/>
                      </a:lnTo>
                      <a:lnTo>
                        <a:pt x="3382" y="1959"/>
                      </a:lnTo>
                      <a:lnTo>
                        <a:pt x="3386" y="1958"/>
                      </a:lnTo>
                      <a:lnTo>
                        <a:pt x="3390" y="1958"/>
                      </a:lnTo>
                      <a:lnTo>
                        <a:pt x="3393" y="1957"/>
                      </a:lnTo>
                      <a:lnTo>
                        <a:pt x="3397" y="1956"/>
                      </a:lnTo>
                      <a:lnTo>
                        <a:pt x="3401" y="1956"/>
                      </a:lnTo>
                      <a:lnTo>
                        <a:pt x="3405" y="1955"/>
                      </a:lnTo>
                      <a:lnTo>
                        <a:pt x="3409" y="1954"/>
                      </a:lnTo>
                      <a:lnTo>
                        <a:pt x="3412" y="1953"/>
                      </a:lnTo>
                      <a:lnTo>
                        <a:pt x="3416" y="1952"/>
                      </a:lnTo>
                      <a:lnTo>
                        <a:pt x="3420" y="1951"/>
                      </a:lnTo>
                      <a:lnTo>
                        <a:pt x="3423" y="1950"/>
                      </a:lnTo>
                      <a:lnTo>
                        <a:pt x="3427" y="1948"/>
                      </a:lnTo>
                      <a:lnTo>
                        <a:pt x="3431" y="1946"/>
                      </a:lnTo>
                      <a:lnTo>
                        <a:pt x="3435" y="1945"/>
                      </a:lnTo>
                      <a:lnTo>
                        <a:pt x="3438" y="1944"/>
                      </a:lnTo>
                      <a:lnTo>
                        <a:pt x="3442" y="1941"/>
                      </a:lnTo>
                      <a:lnTo>
                        <a:pt x="3446" y="1939"/>
                      </a:lnTo>
                      <a:lnTo>
                        <a:pt x="3450" y="1938"/>
                      </a:lnTo>
                      <a:lnTo>
                        <a:pt x="3454" y="1935"/>
                      </a:lnTo>
                      <a:lnTo>
                        <a:pt x="3457" y="1932"/>
                      </a:lnTo>
                      <a:lnTo>
                        <a:pt x="3461" y="1929"/>
                      </a:lnTo>
                      <a:lnTo>
                        <a:pt x="3465" y="1927"/>
                      </a:lnTo>
                      <a:lnTo>
                        <a:pt x="3469" y="1925"/>
                      </a:lnTo>
                      <a:lnTo>
                        <a:pt x="3472" y="1922"/>
                      </a:lnTo>
                      <a:lnTo>
                        <a:pt x="3476" y="1920"/>
                      </a:lnTo>
                      <a:lnTo>
                        <a:pt x="3480" y="1918"/>
                      </a:lnTo>
                      <a:lnTo>
                        <a:pt x="3483" y="1915"/>
                      </a:lnTo>
                      <a:lnTo>
                        <a:pt x="3487" y="1914"/>
                      </a:lnTo>
                      <a:lnTo>
                        <a:pt x="3491" y="1912"/>
                      </a:lnTo>
                      <a:lnTo>
                        <a:pt x="3495" y="1911"/>
                      </a:lnTo>
                      <a:lnTo>
                        <a:pt x="3499" y="1910"/>
                      </a:lnTo>
                      <a:lnTo>
                        <a:pt x="3502" y="1910"/>
                      </a:lnTo>
                      <a:lnTo>
                        <a:pt x="3506" y="1908"/>
                      </a:lnTo>
                      <a:lnTo>
                        <a:pt x="3510" y="1908"/>
                      </a:lnTo>
                      <a:lnTo>
                        <a:pt x="3514" y="1908"/>
                      </a:lnTo>
                      <a:lnTo>
                        <a:pt x="3517" y="1909"/>
                      </a:lnTo>
                      <a:lnTo>
                        <a:pt x="3521" y="1909"/>
                      </a:lnTo>
                      <a:lnTo>
                        <a:pt x="3525" y="1911"/>
                      </a:lnTo>
                      <a:lnTo>
                        <a:pt x="3529" y="1912"/>
                      </a:lnTo>
                      <a:lnTo>
                        <a:pt x="3533" y="1913"/>
                      </a:lnTo>
                      <a:lnTo>
                        <a:pt x="3536" y="1914"/>
                      </a:lnTo>
                      <a:lnTo>
                        <a:pt x="3540" y="1915"/>
                      </a:lnTo>
                      <a:lnTo>
                        <a:pt x="3544" y="1915"/>
                      </a:lnTo>
                      <a:lnTo>
                        <a:pt x="3547" y="1917"/>
                      </a:lnTo>
                      <a:lnTo>
                        <a:pt x="3551" y="1917"/>
                      </a:lnTo>
                      <a:lnTo>
                        <a:pt x="3555" y="1918"/>
                      </a:lnTo>
                      <a:lnTo>
                        <a:pt x="3559" y="1918"/>
                      </a:lnTo>
                      <a:lnTo>
                        <a:pt x="3562" y="1918"/>
                      </a:lnTo>
                      <a:lnTo>
                        <a:pt x="3566" y="1918"/>
                      </a:lnTo>
                      <a:lnTo>
                        <a:pt x="3570" y="1918"/>
                      </a:lnTo>
                      <a:lnTo>
                        <a:pt x="3574" y="1917"/>
                      </a:lnTo>
                      <a:lnTo>
                        <a:pt x="3578" y="1916"/>
                      </a:lnTo>
                      <a:lnTo>
                        <a:pt x="3581" y="1914"/>
                      </a:lnTo>
                      <a:lnTo>
                        <a:pt x="3585" y="1912"/>
                      </a:lnTo>
                      <a:lnTo>
                        <a:pt x="3589" y="1909"/>
                      </a:lnTo>
                      <a:lnTo>
                        <a:pt x="3593" y="1907"/>
                      </a:lnTo>
                      <a:lnTo>
                        <a:pt x="3596" y="1903"/>
                      </a:lnTo>
                      <a:lnTo>
                        <a:pt x="3600" y="1899"/>
                      </a:lnTo>
                      <a:lnTo>
                        <a:pt x="3604" y="1895"/>
                      </a:lnTo>
                      <a:lnTo>
                        <a:pt x="3607" y="1890"/>
                      </a:lnTo>
                      <a:lnTo>
                        <a:pt x="3611" y="1884"/>
                      </a:lnTo>
                      <a:lnTo>
                        <a:pt x="3615" y="1880"/>
                      </a:lnTo>
                      <a:lnTo>
                        <a:pt x="3619" y="1874"/>
                      </a:lnTo>
                      <a:lnTo>
                        <a:pt x="3623" y="1867"/>
                      </a:lnTo>
                      <a:lnTo>
                        <a:pt x="3626" y="1861"/>
                      </a:lnTo>
                      <a:lnTo>
                        <a:pt x="3630" y="1854"/>
                      </a:lnTo>
                      <a:lnTo>
                        <a:pt x="3634" y="1847"/>
                      </a:lnTo>
                      <a:lnTo>
                        <a:pt x="3638" y="1840"/>
                      </a:lnTo>
                      <a:lnTo>
                        <a:pt x="3641" y="1833"/>
                      </a:lnTo>
                      <a:lnTo>
                        <a:pt x="3645" y="1826"/>
                      </a:lnTo>
                      <a:lnTo>
                        <a:pt x="3649" y="1819"/>
                      </a:lnTo>
                      <a:lnTo>
                        <a:pt x="3653" y="1812"/>
                      </a:lnTo>
                      <a:lnTo>
                        <a:pt x="3656" y="1804"/>
                      </a:lnTo>
                      <a:lnTo>
                        <a:pt x="3660" y="1797"/>
                      </a:lnTo>
                      <a:lnTo>
                        <a:pt x="3664" y="1790"/>
                      </a:lnTo>
                      <a:lnTo>
                        <a:pt x="3668" y="1782"/>
                      </a:lnTo>
                      <a:lnTo>
                        <a:pt x="3671" y="1776"/>
                      </a:lnTo>
                      <a:lnTo>
                        <a:pt x="3675" y="1768"/>
                      </a:lnTo>
                      <a:lnTo>
                        <a:pt x="3679" y="1760"/>
                      </a:lnTo>
                      <a:lnTo>
                        <a:pt x="3683" y="1753"/>
                      </a:lnTo>
                      <a:lnTo>
                        <a:pt x="3686" y="1745"/>
                      </a:lnTo>
                      <a:lnTo>
                        <a:pt x="3690" y="1737"/>
                      </a:lnTo>
                      <a:lnTo>
                        <a:pt x="3694" y="1730"/>
                      </a:lnTo>
                      <a:lnTo>
                        <a:pt x="3698" y="1722"/>
                      </a:lnTo>
                      <a:lnTo>
                        <a:pt x="3702" y="1714"/>
                      </a:lnTo>
                      <a:lnTo>
                        <a:pt x="3705" y="1706"/>
                      </a:lnTo>
                      <a:lnTo>
                        <a:pt x="3709" y="1695"/>
                      </a:lnTo>
                      <a:lnTo>
                        <a:pt x="3713" y="1683"/>
                      </a:lnTo>
                      <a:lnTo>
                        <a:pt x="3717" y="1667"/>
                      </a:lnTo>
                      <a:lnTo>
                        <a:pt x="3720" y="1646"/>
                      </a:lnTo>
                      <a:lnTo>
                        <a:pt x="3724" y="1619"/>
                      </a:lnTo>
                      <a:lnTo>
                        <a:pt x="3728" y="1581"/>
                      </a:lnTo>
                      <a:lnTo>
                        <a:pt x="3731" y="1533"/>
                      </a:lnTo>
                      <a:lnTo>
                        <a:pt x="3735" y="1472"/>
                      </a:lnTo>
                      <a:lnTo>
                        <a:pt x="3739" y="1402"/>
                      </a:lnTo>
                      <a:lnTo>
                        <a:pt x="3743" y="1324"/>
                      </a:lnTo>
                      <a:lnTo>
                        <a:pt x="3747" y="1238"/>
                      </a:lnTo>
                      <a:lnTo>
                        <a:pt x="3750" y="1145"/>
                      </a:lnTo>
                      <a:lnTo>
                        <a:pt x="3754" y="1046"/>
                      </a:lnTo>
                      <a:lnTo>
                        <a:pt x="3758" y="944"/>
                      </a:lnTo>
                      <a:lnTo>
                        <a:pt x="3762" y="837"/>
                      </a:lnTo>
                      <a:lnTo>
                        <a:pt x="3765" y="727"/>
                      </a:lnTo>
                      <a:lnTo>
                        <a:pt x="3769" y="615"/>
                      </a:lnTo>
                      <a:lnTo>
                        <a:pt x="3773" y="502"/>
                      </a:lnTo>
                      <a:lnTo>
                        <a:pt x="3777" y="393"/>
                      </a:lnTo>
                      <a:lnTo>
                        <a:pt x="3780" y="290"/>
                      </a:lnTo>
                      <a:lnTo>
                        <a:pt x="3784" y="198"/>
                      </a:lnTo>
                      <a:lnTo>
                        <a:pt x="3788" y="121"/>
                      </a:lnTo>
                      <a:lnTo>
                        <a:pt x="3792" y="63"/>
                      </a:lnTo>
                      <a:lnTo>
                        <a:pt x="3795" y="25"/>
                      </a:lnTo>
                      <a:lnTo>
                        <a:pt x="3799" y="5"/>
                      </a:lnTo>
                      <a:lnTo>
                        <a:pt x="3803" y="0"/>
                      </a:lnTo>
                      <a:lnTo>
                        <a:pt x="3807" y="9"/>
                      </a:lnTo>
                      <a:lnTo>
                        <a:pt x="3810" y="27"/>
                      </a:lnTo>
                      <a:lnTo>
                        <a:pt x="3814" y="52"/>
                      </a:lnTo>
                      <a:lnTo>
                        <a:pt x="3818" y="82"/>
                      </a:lnTo>
                      <a:lnTo>
                        <a:pt x="3822" y="117"/>
                      </a:lnTo>
                      <a:lnTo>
                        <a:pt x="3826" y="154"/>
                      </a:lnTo>
                      <a:lnTo>
                        <a:pt x="3829" y="193"/>
                      </a:lnTo>
                      <a:lnTo>
                        <a:pt x="3833" y="234"/>
                      </a:lnTo>
                      <a:lnTo>
                        <a:pt x="3837" y="277"/>
                      </a:lnTo>
                      <a:lnTo>
                        <a:pt x="3841" y="321"/>
                      </a:lnTo>
                      <a:lnTo>
                        <a:pt x="3844" y="365"/>
                      </a:lnTo>
                      <a:lnTo>
                        <a:pt x="3848" y="410"/>
                      </a:lnTo>
                      <a:lnTo>
                        <a:pt x="3852" y="455"/>
                      </a:lnTo>
                      <a:lnTo>
                        <a:pt x="3856" y="500"/>
                      </a:lnTo>
                      <a:lnTo>
                        <a:pt x="3859" y="546"/>
                      </a:lnTo>
                      <a:lnTo>
                        <a:pt x="3863" y="590"/>
                      </a:lnTo>
                      <a:lnTo>
                        <a:pt x="3867" y="635"/>
                      </a:lnTo>
                      <a:lnTo>
                        <a:pt x="3871" y="679"/>
                      </a:lnTo>
                      <a:lnTo>
                        <a:pt x="3874" y="722"/>
                      </a:lnTo>
                      <a:lnTo>
                        <a:pt x="3878" y="766"/>
                      </a:lnTo>
                      <a:lnTo>
                        <a:pt x="3882" y="808"/>
                      </a:lnTo>
                      <a:lnTo>
                        <a:pt x="3886" y="850"/>
                      </a:lnTo>
                      <a:lnTo>
                        <a:pt x="3889" y="891"/>
                      </a:lnTo>
                      <a:lnTo>
                        <a:pt x="3893" y="932"/>
                      </a:lnTo>
                      <a:lnTo>
                        <a:pt x="3897" y="972"/>
                      </a:lnTo>
                      <a:lnTo>
                        <a:pt x="3901" y="1011"/>
                      </a:lnTo>
                      <a:lnTo>
                        <a:pt x="3904" y="1049"/>
                      </a:lnTo>
                      <a:lnTo>
                        <a:pt x="3908" y="1085"/>
                      </a:lnTo>
                      <a:lnTo>
                        <a:pt x="3912" y="1122"/>
                      </a:lnTo>
                      <a:lnTo>
                        <a:pt x="3916" y="1157"/>
                      </a:lnTo>
                      <a:lnTo>
                        <a:pt x="3920" y="1192"/>
                      </a:lnTo>
                      <a:lnTo>
                        <a:pt x="3923" y="1226"/>
                      </a:lnTo>
                      <a:lnTo>
                        <a:pt x="3927" y="1258"/>
                      </a:lnTo>
                      <a:lnTo>
                        <a:pt x="3931" y="1290"/>
                      </a:lnTo>
                      <a:lnTo>
                        <a:pt x="3934" y="1321"/>
                      </a:lnTo>
                      <a:lnTo>
                        <a:pt x="3938" y="1351"/>
                      </a:lnTo>
                      <a:lnTo>
                        <a:pt x="3942" y="1380"/>
                      </a:lnTo>
                      <a:lnTo>
                        <a:pt x="3946" y="1408"/>
                      </a:lnTo>
                      <a:lnTo>
                        <a:pt x="3950" y="1436"/>
                      </a:lnTo>
                      <a:lnTo>
                        <a:pt x="3953" y="1462"/>
                      </a:lnTo>
                      <a:lnTo>
                        <a:pt x="3957" y="1487"/>
                      </a:lnTo>
                      <a:lnTo>
                        <a:pt x="3961" y="1511"/>
                      </a:lnTo>
                      <a:lnTo>
                        <a:pt x="3965" y="1535"/>
                      </a:lnTo>
                      <a:lnTo>
                        <a:pt x="3968" y="1557"/>
                      </a:lnTo>
                      <a:lnTo>
                        <a:pt x="3972" y="1579"/>
                      </a:lnTo>
                      <a:lnTo>
                        <a:pt x="3976" y="1600"/>
                      </a:lnTo>
                      <a:lnTo>
                        <a:pt x="3980" y="1621"/>
                      </a:lnTo>
                      <a:lnTo>
                        <a:pt x="3983" y="1640"/>
                      </a:lnTo>
                      <a:lnTo>
                        <a:pt x="3987" y="1658"/>
                      </a:lnTo>
                      <a:lnTo>
                        <a:pt x="3991" y="1677"/>
                      </a:lnTo>
                      <a:lnTo>
                        <a:pt x="3995" y="1693"/>
                      </a:lnTo>
                      <a:lnTo>
                        <a:pt x="3998" y="1710"/>
                      </a:lnTo>
                      <a:lnTo>
                        <a:pt x="4002" y="1726"/>
                      </a:lnTo>
                      <a:lnTo>
                        <a:pt x="4006" y="1741"/>
                      </a:lnTo>
                      <a:lnTo>
                        <a:pt x="4010" y="1755"/>
                      </a:lnTo>
                      <a:lnTo>
                        <a:pt x="4013" y="1769"/>
                      </a:lnTo>
                      <a:lnTo>
                        <a:pt x="4017" y="1782"/>
                      </a:lnTo>
                      <a:lnTo>
                        <a:pt x="4021" y="1794"/>
                      </a:lnTo>
                      <a:lnTo>
                        <a:pt x="4025" y="1806"/>
                      </a:lnTo>
                      <a:lnTo>
                        <a:pt x="4028" y="1817"/>
                      </a:lnTo>
                      <a:lnTo>
                        <a:pt x="4032" y="1826"/>
                      </a:lnTo>
                      <a:lnTo>
                        <a:pt x="4036" y="1837"/>
                      </a:lnTo>
                      <a:lnTo>
                        <a:pt x="4040" y="1846"/>
                      </a:lnTo>
                      <a:lnTo>
                        <a:pt x="4044" y="1854"/>
                      </a:lnTo>
                      <a:lnTo>
                        <a:pt x="4047" y="1863"/>
                      </a:lnTo>
                      <a:lnTo>
                        <a:pt x="4051" y="1870"/>
                      </a:lnTo>
                      <a:lnTo>
                        <a:pt x="4055" y="1878"/>
                      </a:lnTo>
                      <a:lnTo>
                        <a:pt x="4058" y="1884"/>
                      </a:lnTo>
                      <a:lnTo>
                        <a:pt x="4062" y="1890"/>
                      </a:lnTo>
                      <a:lnTo>
                        <a:pt x="4066" y="1896"/>
                      </a:lnTo>
                      <a:lnTo>
                        <a:pt x="4070" y="1902"/>
                      </a:lnTo>
                      <a:lnTo>
                        <a:pt x="4074" y="1907"/>
                      </a:lnTo>
                      <a:lnTo>
                        <a:pt x="4077" y="1911"/>
                      </a:lnTo>
                      <a:lnTo>
                        <a:pt x="4081" y="1916"/>
                      </a:lnTo>
                      <a:lnTo>
                        <a:pt x="4085" y="1920"/>
                      </a:lnTo>
                      <a:lnTo>
                        <a:pt x="4089" y="1924"/>
                      </a:lnTo>
                      <a:lnTo>
                        <a:pt x="4092" y="1927"/>
                      </a:lnTo>
                      <a:lnTo>
                        <a:pt x="4096" y="1930"/>
                      </a:lnTo>
                      <a:lnTo>
                        <a:pt x="4100" y="1934"/>
                      </a:lnTo>
                      <a:lnTo>
                        <a:pt x="4104" y="1936"/>
                      </a:lnTo>
                      <a:lnTo>
                        <a:pt x="4107" y="1940"/>
                      </a:lnTo>
                      <a:lnTo>
                        <a:pt x="4111" y="1941"/>
                      </a:lnTo>
                      <a:lnTo>
                        <a:pt x="4115" y="1943"/>
                      </a:lnTo>
                      <a:lnTo>
                        <a:pt x="4119" y="1945"/>
                      </a:lnTo>
                      <a:lnTo>
                        <a:pt x="4122" y="1948"/>
                      </a:lnTo>
                      <a:lnTo>
                        <a:pt x="4126" y="1949"/>
                      </a:lnTo>
                      <a:lnTo>
                        <a:pt x="4130" y="1951"/>
                      </a:lnTo>
                      <a:lnTo>
                        <a:pt x="4134" y="1952"/>
                      </a:lnTo>
                      <a:lnTo>
                        <a:pt x="4137" y="1953"/>
                      </a:lnTo>
                      <a:lnTo>
                        <a:pt x="4141" y="1954"/>
                      </a:lnTo>
                      <a:lnTo>
                        <a:pt x="4145" y="1956"/>
                      </a:lnTo>
                      <a:lnTo>
                        <a:pt x="4149" y="1957"/>
                      </a:lnTo>
                      <a:lnTo>
                        <a:pt x="4152" y="1958"/>
                      </a:lnTo>
                      <a:lnTo>
                        <a:pt x="4156" y="1959"/>
                      </a:lnTo>
                      <a:lnTo>
                        <a:pt x="4160" y="1959"/>
                      </a:lnTo>
                      <a:lnTo>
                        <a:pt x="4164" y="1960"/>
                      </a:lnTo>
                      <a:lnTo>
                        <a:pt x="4168" y="1961"/>
                      </a:lnTo>
                      <a:lnTo>
                        <a:pt x="4171" y="1962"/>
                      </a:lnTo>
                      <a:lnTo>
                        <a:pt x="4175" y="1962"/>
                      </a:lnTo>
                      <a:lnTo>
                        <a:pt x="4179" y="1963"/>
                      </a:lnTo>
                      <a:lnTo>
                        <a:pt x="4182" y="1963"/>
                      </a:lnTo>
                      <a:lnTo>
                        <a:pt x="4186" y="1963"/>
                      </a:lnTo>
                      <a:lnTo>
                        <a:pt x="4190" y="1964"/>
                      </a:lnTo>
                      <a:lnTo>
                        <a:pt x="4194" y="1965"/>
                      </a:lnTo>
                      <a:lnTo>
                        <a:pt x="4197" y="1965"/>
                      </a:lnTo>
                      <a:lnTo>
                        <a:pt x="4201" y="1966"/>
                      </a:lnTo>
                      <a:lnTo>
                        <a:pt x="4205" y="1967"/>
                      </a:lnTo>
                      <a:lnTo>
                        <a:pt x="4209" y="1966"/>
                      </a:lnTo>
                      <a:lnTo>
                        <a:pt x="4213" y="1967"/>
                      </a:lnTo>
                      <a:lnTo>
                        <a:pt x="4216" y="1967"/>
                      </a:lnTo>
                      <a:lnTo>
                        <a:pt x="4220" y="1967"/>
                      </a:lnTo>
                      <a:lnTo>
                        <a:pt x="4224" y="1968"/>
                      </a:lnTo>
                      <a:lnTo>
                        <a:pt x="4228" y="1968"/>
                      </a:lnTo>
                      <a:lnTo>
                        <a:pt x="4231" y="1968"/>
                      </a:lnTo>
                      <a:lnTo>
                        <a:pt x="4235" y="1968"/>
                      </a:lnTo>
                      <a:lnTo>
                        <a:pt x="4239" y="1968"/>
                      </a:lnTo>
                      <a:lnTo>
                        <a:pt x="4243" y="1969"/>
                      </a:lnTo>
                      <a:lnTo>
                        <a:pt x="4246" y="1969"/>
                      </a:lnTo>
                      <a:lnTo>
                        <a:pt x="4250" y="1969"/>
                      </a:lnTo>
                      <a:lnTo>
                        <a:pt x="4254" y="1969"/>
                      </a:lnTo>
                      <a:lnTo>
                        <a:pt x="4258" y="1969"/>
                      </a:lnTo>
                      <a:lnTo>
                        <a:pt x="4261" y="1970"/>
                      </a:lnTo>
                      <a:lnTo>
                        <a:pt x="4265" y="1970"/>
                      </a:lnTo>
                      <a:lnTo>
                        <a:pt x="4269" y="1971"/>
                      </a:lnTo>
                      <a:lnTo>
                        <a:pt x="4273" y="1971"/>
                      </a:lnTo>
                      <a:lnTo>
                        <a:pt x="4276" y="1971"/>
                      </a:lnTo>
                      <a:lnTo>
                        <a:pt x="4280" y="1970"/>
                      </a:lnTo>
                      <a:lnTo>
                        <a:pt x="4284" y="1971"/>
                      </a:lnTo>
                      <a:lnTo>
                        <a:pt x="4288" y="1971"/>
                      </a:lnTo>
                      <a:lnTo>
                        <a:pt x="4292" y="1971"/>
                      </a:lnTo>
                      <a:lnTo>
                        <a:pt x="4295" y="1971"/>
                      </a:lnTo>
                      <a:lnTo>
                        <a:pt x="4299" y="1972"/>
                      </a:lnTo>
                      <a:lnTo>
                        <a:pt x="4303" y="1972"/>
                      </a:lnTo>
                      <a:lnTo>
                        <a:pt x="4307" y="1972"/>
                      </a:lnTo>
                      <a:lnTo>
                        <a:pt x="4310" y="1972"/>
                      </a:lnTo>
                      <a:lnTo>
                        <a:pt x="4314" y="1972"/>
                      </a:lnTo>
                      <a:lnTo>
                        <a:pt x="4318" y="1972"/>
                      </a:lnTo>
                      <a:lnTo>
                        <a:pt x="4321" y="1972"/>
                      </a:lnTo>
                      <a:lnTo>
                        <a:pt x="4325" y="1973"/>
                      </a:lnTo>
                      <a:lnTo>
                        <a:pt x="4329" y="1972"/>
                      </a:lnTo>
                      <a:lnTo>
                        <a:pt x="4333" y="1972"/>
                      </a:lnTo>
                      <a:lnTo>
                        <a:pt x="4337" y="1973"/>
                      </a:lnTo>
                      <a:lnTo>
                        <a:pt x="4340" y="1973"/>
                      </a:lnTo>
                      <a:lnTo>
                        <a:pt x="4344" y="1973"/>
                      </a:lnTo>
                      <a:lnTo>
                        <a:pt x="4348" y="1974"/>
                      </a:lnTo>
                      <a:lnTo>
                        <a:pt x="4352" y="1973"/>
                      </a:lnTo>
                      <a:lnTo>
                        <a:pt x="4355" y="1973"/>
                      </a:lnTo>
                      <a:lnTo>
                        <a:pt x="4359" y="1973"/>
                      </a:lnTo>
                      <a:lnTo>
                        <a:pt x="4363" y="1974"/>
                      </a:lnTo>
                      <a:lnTo>
                        <a:pt x="4367" y="1974"/>
                      </a:lnTo>
                      <a:lnTo>
                        <a:pt x="4370" y="1974"/>
                      </a:lnTo>
                      <a:lnTo>
                        <a:pt x="4374" y="1974"/>
                      </a:lnTo>
                      <a:lnTo>
                        <a:pt x="4378" y="1974"/>
                      </a:lnTo>
                      <a:lnTo>
                        <a:pt x="4382" y="1974"/>
                      </a:lnTo>
                      <a:lnTo>
                        <a:pt x="4385" y="1974"/>
                      </a:lnTo>
                      <a:lnTo>
                        <a:pt x="4389" y="1974"/>
                      </a:lnTo>
                      <a:lnTo>
                        <a:pt x="4393" y="1974"/>
                      </a:lnTo>
                      <a:lnTo>
                        <a:pt x="4397" y="1974"/>
                      </a:lnTo>
                      <a:lnTo>
                        <a:pt x="4400" y="1974"/>
                      </a:lnTo>
                      <a:lnTo>
                        <a:pt x="4404" y="1974"/>
                      </a:lnTo>
                      <a:lnTo>
                        <a:pt x="4408" y="1974"/>
                      </a:lnTo>
                      <a:lnTo>
                        <a:pt x="4412" y="1975"/>
                      </a:lnTo>
                      <a:lnTo>
                        <a:pt x="4416" y="1974"/>
                      </a:lnTo>
                      <a:lnTo>
                        <a:pt x="4419" y="1974"/>
                      </a:lnTo>
                      <a:lnTo>
                        <a:pt x="4423" y="1974"/>
                      </a:lnTo>
                      <a:lnTo>
                        <a:pt x="4427" y="1975"/>
                      </a:lnTo>
                      <a:lnTo>
                        <a:pt x="4431" y="1974"/>
                      </a:lnTo>
                      <a:lnTo>
                        <a:pt x="4434" y="1974"/>
                      </a:lnTo>
                      <a:lnTo>
                        <a:pt x="4438" y="1975"/>
                      </a:lnTo>
                      <a:lnTo>
                        <a:pt x="4442" y="1974"/>
                      </a:lnTo>
                      <a:lnTo>
                        <a:pt x="4445" y="1974"/>
                      </a:lnTo>
                      <a:lnTo>
                        <a:pt x="4449" y="1974"/>
                      </a:lnTo>
                      <a:lnTo>
                        <a:pt x="4453" y="1974"/>
                      </a:lnTo>
                      <a:lnTo>
                        <a:pt x="4457" y="1974"/>
                      </a:lnTo>
                      <a:lnTo>
                        <a:pt x="4461" y="1974"/>
                      </a:lnTo>
                      <a:lnTo>
                        <a:pt x="4464" y="1975"/>
                      </a:lnTo>
                      <a:lnTo>
                        <a:pt x="4468" y="1975"/>
                      </a:lnTo>
                      <a:lnTo>
                        <a:pt x="4472" y="1975"/>
                      </a:lnTo>
                      <a:lnTo>
                        <a:pt x="4476" y="1975"/>
                      </a:lnTo>
                      <a:lnTo>
                        <a:pt x="4479" y="1974"/>
                      </a:lnTo>
                      <a:lnTo>
                        <a:pt x="4483" y="1975"/>
                      </a:lnTo>
                      <a:lnTo>
                        <a:pt x="4487" y="1975"/>
                      </a:lnTo>
                      <a:lnTo>
                        <a:pt x="4491" y="1975"/>
                      </a:lnTo>
                      <a:lnTo>
                        <a:pt x="4494" y="1975"/>
                      </a:lnTo>
                      <a:lnTo>
                        <a:pt x="4498" y="1975"/>
                      </a:lnTo>
                      <a:lnTo>
                        <a:pt x="4502" y="1975"/>
                      </a:lnTo>
                      <a:lnTo>
                        <a:pt x="4506" y="1974"/>
                      </a:lnTo>
                      <a:lnTo>
                        <a:pt x="4509" y="1975"/>
                      </a:lnTo>
                      <a:lnTo>
                        <a:pt x="4513" y="1975"/>
                      </a:lnTo>
                      <a:lnTo>
                        <a:pt x="4517" y="1975"/>
                      </a:lnTo>
                      <a:lnTo>
                        <a:pt x="4521" y="1975"/>
                      </a:lnTo>
                      <a:lnTo>
                        <a:pt x="4524" y="1975"/>
                      </a:lnTo>
                      <a:lnTo>
                        <a:pt x="4528" y="1975"/>
                      </a:lnTo>
                      <a:lnTo>
                        <a:pt x="4532" y="1975"/>
                      </a:lnTo>
                      <a:lnTo>
                        <a:pt x="4536" y="1975"/>
                      </a:lnTo>
                      <a:lnTo>
                        <a:pt x="4540" y="1975"/>
                      </a:lnTo>
                      <a:lnTo>
                        <a:pt x="4543" y="1975"/>
                      </a:lnTo>
                      <a:lnTo>
                        <a:pt x="4547" y="1975"/>
                      </a:lnTo>
                      <a:lnTo>
                        <a:pt x="4551" y="1975"/>
                      </a:lnTo>
                      <a:lnTo>
                        <a:pt x="4555" y="1975"/>
                      </a:lnTo>
                      <a:lnTo>
                        <a:pt x="4558" y="1975"/>
                      </a:lnTo>
                      <a:lnTo>
                        <a:pt x="4562" y="1976"/>
                      </a:lnTo>
                      <a:lnTo>
                        <a:pt x="4566" y="1975"/>
                      </a:lnTo>
                      <a:lnTo>
                        <a:pt x="4569" y="1976"/>
                      </a:lnTo>
                      <a:lnTo>
                        <a:pt x="4573" y="1976"/>
                      </a:lnTo>
                      <a:lnTo>
                        <a:pt x="4577" y="1976"/>
                      </a:lnTo>
                      <a:lnTo>
                        <a:pt x="4581" y="1977"/>
                      </a:lnTo>
                      <a:lnTo>
                        <a:pt x="4585" y="1976"/>
                      </a:lnTo>
                      <a:lnTo>
                        <a:pt x="4588" y="1976"/>
                      </a:lnTo>
                      <a:lnTo>
                        <a:pt x="4592" y="1976"/>
                      </a:lnTo>
                      <a:lnTo>
                        <a:pt x="4596" y="1977"/>
                      </a:lnTo>
                      <a:lnTo>
                        <a:pt x="4600" y="1976"/>
                      </a:lnTo>
                      <a:lnTo>
                        <a:pt x="4603" y="1976"/>
                      </a:lnTo>
                      <a:lnTo>
                        <a:pt x="4607" y="1976"/>
                      </a:lnTo>
                      <a:lnTo>
                        <a:pt x="4611" y="1977"/>
                      </a:lnTo>
                      <a:lnTo>
                        <a:pt x="4615" y="1976"/>
                      </a:lnTo>
                      <a:lnTo>
                        <a:pt x="4618" y="1976"/>
                      </a:lnTo>
                      <a:lnTo>
                        <a:pt x="4622" y="1976"/>
                      </a:lnTo>
                      <a:lnTo>
                        <a:pt x="4626" y="1977"/>
                      </a:lnTo>
                      <a:lnTo>
                        <a:pt x="4630" y="1977"/>
                      </a:lnTo>
                      <a:lnTo>
                        <a:pt x="4633" y="1976"/>
                      </a:lnTo>
                      <a:lnTo>
                        <a:pt x="4637" y="1976"/>
                      </a:lnTo>
                      <a:lnTo>
                        <a:pt x="4641" y="1977"/>
                      </a:lnTo>
                      <a:lnTo>
                        <a:pt x="4645" y="1977"/>
                      </a:lnTo>
                      <a:lnTo>
                        <a:pt x="4648" y="1977"/>
                      </a:lnTo>
                      <a:lnTo>
                        <a:pt x="4652" y="1977"/>
                      </a:lnTo>
                      <a:lnTo>
                        <a:pt x="4656" y="1977"/>
                      </a:lnTo>
                      <a:lnTo>
                        <a:pt x="4660" y="1977"/>
                      </a:lnTo>
                      <a:lnTo>
                        <a:pt x="4664" y="1977"/>
                      </a:lnTo>
                      <a:lnTo>
                        <a:pt x="4667" y="1977"/>
                      </a:lnTo>
                      <a:lnTo>
                        <a:pt x="4671" y="1977"/>
                      </a:lnTo>
                      <a:lnTo>
                        <a:pt x="4675" y="1977"/>
                      </a:lnTo>
                      <a:lnTo>
                        <a:pt x="4679" y="1977"/>
                      </a:lnTo>
                      <a:lnTo>
                        <a:pt x="4682" y="1977"/>
                      </a:lnTo>
                      <a:lnTo>
                        <a:pt x="4686" y="1977"/>
                      </a:lnTo>
                      <a:lnTo>
                        <a:pt x="4690" y="1977"/>
                      </a:lnTo>
                      <a:lnTo>
                        <a:pt x="4694" y="1977"/>
                      </a:lnTo>
                      <a:lnTo>
                        <a:pt x="4697" y="1977"/>
                      </a:lnTo>
                      <a:lnTo>
                        <a:pt x="4701" y="1977"/>
                      </a:lnTo>
                      <a:lnTo>
                        <a:pt x="4705" y="1977"/>
                      </a:lnTo>
                      <a:lnTo>
                        <a:pt x="4709" y="1977"/>
                      </a:lnTo>
                      <a:lnTo>
                        <a:pt x="4712" y="1978"/>
                      </a:lnTo>
                      <a:lnTo>
                        <a:pt x="4716" y="1977"/>
                      </a:lnTo>
                      <a:lnTo>
                        <a:pt x="4720" y="1977"/>
                      </a:lnTo>
                      <a:lnTo>
                        <a:pt x="4724" y="1977"/>
                      </a:lnTo>
                      <a:lnTo>
                        <a:pt x="4727" y="1977"/>
                      </a:lnTo>
                      <a:lnTo>
                        <a:pt x="4731" y="1977"/>
                      </a:lnTo>
                      <a:lnTo>
                        <a:pt x="4735" y="1978"/>
                      </a:lnTo>
                      <a:lnTo>
                        <a:pt x="4739" y="1977"/>
                      </a:lnTo>
                      <a:lnTo>
                        <a:pt x="4742" y="1977"/>
                      </a:lnTo>
                      <a:lnTo>
                        <a:pt x="4746" y="1977"/>
                      </a:lnTo>
                      <a:lnTo>
                        <a:pt x="4750" y="1977"/>
                      </a:lnTo>
                      <a:lnTo>
                        <a:pt x="4754" y="1977"/>
                      </a:lnTo>
                      <a:lnTo>
                        <a:pt x="4758" y="1977"/>
                      </a:lnTo>
                      <a:lnTo>
                        <a:pt x="4761" y="1977"/>
                      </a:lnTo>
                      <a:lnTo>
                        <a:pt x="4765" y="1977"/>
                      </a:lnTo>
                      <a:lnTo>
                        <a:pt x="4769" y="1977"/>
                      </a:lnTo>
                      <a:lnTo>
                        <a:pt x="4772" y="1977"/>
                      </a:lnTo>
                      <a:lnTo>
                        <a:pt x="4776" y="1977"/>
                      </a:lnTo>
                      <a:lnTo>
                        <a:pt x="4780" y="1978"/>
                      </a:lnTo>
                      <a:lnTo>
                        <a:pt x="4784" y="1977"/>
                      </a:lnTo>
                      <a:lnTo>
                        <a:pt x="4787" y="1977"/>
                      </a:lnTo>
                      <a:lnTo>
                        <a:pt x="4791" y="1977"/>
                      </a:lnTo>
                      <a:lnTo>
                        <a:pt x="4795" y="1977"/>
                      </a:lnTo>
                      <a:lnTo>
                        <a:pt x="4799" y="1977"/>
                      </a:lnTo>
                      <a:lnTo>
                        <a:pt x="4803" y="1978"/>
                      </a:lnTo>
                      <a:lnTo>
                        <a:pt x="4806" y="1977"/>
                      </a:lnTo>
                      <a:lnTo>
                        <a:pt x="4810" y="1977"/>
                      </a:lnTo>
                      <a:lnTo>
                        <a:pt x="4814" y="1978"/>
                      </a:lnTo>
                      <a:lnTo>
                        <a:pt x="4818" y="1977"/>
                      </a:lnTo>
                      <a:lnTo>
                        <a:pt x="4821" y="1977"/>
                      </a:lnTo>
                      <a:lnTo>
                        <a:pt x="4825" y="1977"/>
                      </a:lnTo>
                      <a:lnTo>
                        <a:pt x="4829" y="1978"/>
                      </a:lnTo>
                      <a:lnTo>
                        <a:pt x="4833" y="1977"/>
                      </a:lnTo>
                      <a:lnTo>
                        <a:pt x="4836" y="1977"/>
                      </a:lnTo>
                      <a:lnTo>
                        <a:pt x="4840" y="1977"/>
                      </a:lnTo>
                      <a:lnTo>
                        <a:pt x="4844" y="1978"/>
                      </a:lnTo>
                      <a:lnTo>
                        <a:pt x="4848" y="1977"/>
                      </a:lnTo>
                      <a:lnTo>
                        <a:pt x="4851" y="1977"/>
                      </a:lnTo>
                      <a:lnTo>
                        <a:pt x="4855" y="1978"/>
                      </a:lnTo>
                      <a:lnTo>
                        <a:pt x="4859" y="1978"/>
                      </a:lnTo>
                      <a:lnTo>
                        <a:pt x="4863" y="1978"/>
                      </a:lnTo>
                      <a:lnTo>
                        <a:pt x="4866" y="1978"/>
                      </a:lnTo>
                      <a:lnTo>
                        <a:pt x="4870" y="1977"/>
                      </a:lnTo>
                      <a:lnTo>
                        <a:pt x="4874" y="1978"/>
                      </a:lnTo>
                      <a:lnTo>
                        <a:pt x="4878" y="1977"/>
                      </a:lnTo>
                      <a:lnTo>
                        <a:pt x="4882" y="1978"/>
                      </a:lnTo>
                      <a:lnTo>
                        <a:pt x="4885" y="1978"/>
                      </a:lnTo>
                      <a:lnTo>
                        <a:pt x="4889" y="1977"/>
                      </a:lnTo>
                      <a:lnTo>
                        <a:pt x="4893" y="1977"/>
                      </a:lnTo>
                      <a:lnTo>
                        <a:pt x="4896" y="1977"/>
                      </a:lnTo>
                      <a:lnTo>
                        <a:pt x="4900" y="1978"/>
                      </a:lnTo>
                      <a:lnTo>
                        <a:pt x="4904" y="1978"/>
                      </a:lnTo>
                      <a:lnTo>
                        <a:pt x="4908" y="1978"/>
                      </a:lnTo>
                      <a:lnTo>
                        <a:pt x="4911" y="1978"/>
                      </a:lnTo>
                      <a:lnTo>
                        <a:pt x="4915" y="1977"/>
                      </a:lnTo>
                      <a:lnTo>
                        <a:pt x="4919" y="1978"/>
                      </a:lnTo>
                      <a:lnTo>
                        <a:pt x="4923" y="1978"/>
                      </a:lnTo>
                      <a:lnTo>
                        <a:pt x="4927" y="1978"/>
                      </a:lnTo>
                      <a:lnTo>
                        <a:pt x="4930" y="1978"/>
                      </a:lnTo>
                      <a:lnTo>
                        <a:pt x="4934" y="1978"/>
                      </a:lnTo>
                      <a:lnTo>
                        <a:pt x="4938" y="1978"/>
                      </a:lnTo>
                      <a:lnTo>
                        <a:pt x="4942" y="1978"/>
                      </a:lnTo>
                      <a:lnTo>
                        <a:pt x="4945" y="1978"/>
                      </a:lnTo>
                      <a:lnTo>
                        <a:pt x="4949" y="1978"/>
                      </a:lnTo>
                      <a:lnTo>
                        <a:pt x="4953" y="1978"/>
                      </a:lnTo>
                      <a:lnTo>
                        <a:pt x="4957" y="1977"/>
                      </a:lnTo>
                      <a:lnTo>
                        <a:pt x="4960" y="1978"/>
                      </a:lnTo>
                      <a:lnTo>
                        <a:pt x="4961" y="1978"/>
                      </a:lnTo>
                    </a:path>
                  </a:pathLst>
                </a:custGeom>
                <a:noFill/>
                <a:ln w="9525" cap="flat" cmpd="sng">
                  <a:solidFill>
                    <a:schemeClr val="dk1"/>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chemeClr val="dk1"/>
                    </a:solidFill>
                    <a:latin typeface="Arial"/>
                    <a:ea typeface="Arial"/>
                    <a:cs typeface="Arial"/>
                    <a:sym typeface="Arial"/>
                  </a:endParaRPr>
                </a:p>
              </p:txBody>
            </p:sp>
            <p:sp>
              <p:nvSpPr>
                <p:cNvPr id="1444" name="Google Shape;1444;p11"/>
                <p:cNvSpPr/>
                <p:nvPr/>
              </p:nvSpPr>
              <p:spPr>
                <a:xfrm>
                  <a:off x="1453" y="2992"/>
                  <a:ext cx="4961" cy="420"/>
                </a:xfrm>
                <a:custGeom>
                  <a:avLst/>
                  <a:gdLst/>
                  <a:ahLst/>
                  <a:cxnLst/>
                  <a:rect l="l" t="t" r="r" b="b"/>
                  <a:pathLst>
                    <a:path w="4961" h="420" extrusionOk="0">
                      <a:moveTo>
                        <a:pt x="0" y="413"/>
                      </a:moveTo>
                      <a:lnTo>
                        <a:pt x="4" y="413"/>
                      </a:lnTo>
                      <a:lnTo>
                        <a:pt x="8" y="413"/>
                      </a:lnTo>
                      <a:lnTo>
                        <a:pt x="11" y="414"/>
                      </a:lnTo>
                      <a:lnTo>
                        <a:pt x="15" y="413"/>
                      </a:lnTo>
                      <a:lnTo>
                        <a:pt x="19" y="414"/>
                      </a:lnTo>
                      <a:lnTo>
                        <a:pt x="23" y="414"/>
                      </a:lnTo>
                      <a:lnTo>
                        <a:pt x="26" y="414"/>
                      </a:lnTo>
                      <a:lnTo>
                        <a:pt x="30" y="414"/>
                      </a:lnTo>
                      <a:lnTo>
                        <a:pt x="34" y="413"/>
                      </a:lnTo>
                      <a:lnTo>
                        <a:pt x="38" y="414"/>
                      </a:lnTo>
                      <a:lnTo>
                        <a:pt x="41" y="415"/>
                      </a:lnTo>
                      <a:lnTo>
                        <a:pt x="45" y="414"/>
                      </a:lnTo>
                      <a:lnTo>
                        <a:pt x="49" y="415"/>
                      </a:lnTo>
                      <a:lnTo>
                        <a:pt x="53" y="414"/>
                      </a:lnTo>
                      <a:lnTo>
                        <a:pt x="57" y="414"/>
                      </a:lnTo>
                      <a:lnTo>
                        <a:pt x="60" y="414"/>
                      </a:lnTo>
                      <a:lnTo>
                        <a:pt x="64" y="414"/>
                      </a:lnTo>
                      <a:lnTo>
                        <a:pt x="68" y="415"/>
                      </a:lnTo>
                      <a:lnTo>
                        <a:pt x="71" y="414"/>
                      </a:lnTo>
                      <a:lnTo>
                        <a:pt x="75" y="414"/>
                      </a:lnTo>
                      <a:lnTo>
                        <a:pt x="79" y="415"/>
                      </a:lnTo>
                      <a:lnTo>
                        <a:pt x="83" y="414"/>
                      </a:lnTo>
                      <a:lnTo>
                        <a:pt x="87" y="415"/>
                      </a:lnTo>
                      <a:lnTo>
                        <a:pt x="90" y="415"/>
                      </a:lnTo>
                      <a:lnTo>
                        <a:pt x="94" y="414"/>
                      </a:lnTo>
                      <a:lnTo>
                        <a:pt x="98" y="415"/>
                      </a:lnTo>
                      <a:lnTo>
                        <a:pt x="102" y="414"/>
                      </a:lnTo>
                      <a:lnTo>
                        <a:pt x="105" y="415"/>
                      </a:lnTo>
                      <a:lnTo>
                        <a:pt x="109" y="415"/>
                      </a:lnTo>
                      <a:lnTo>
                        <a:pt x="113" y="414"/>
                      </a:lnTo>
                      <a:lnTo>
                        <a:pt x="117" y="415"/>
                      </a:lnTo>
                      <a:lnTo>
                        <a:pt x="120" y="414"/>
                      </a:lnTo>
                      <a:lnTo>
                        <a:pt x="124" y="414"/>
                      </a:lnTo>
                      <a:lnTo>
                        <a:pt x="128" y="414"/>
                      </a:lnTo>
                      <a:lnTo>
                        <a:pt x="132" y="414"/>
                      </a:lnTo>
                      <a:lnTo>
                        <a:pt x="135" y="414"/>
                      </a:lnTo>
                      <a:lnTo>
                        <a:pt x="139" y="414"/>
                      </a:lnTo>
                      <a:lnTo>
                        <a:pt x="143" y="415"/>
                      </a:lnTo>
                      <a:lnTo>
                        <a:pt x="147" y="414"/>
                      </a:lnTo>
                      <a:lnTo>
                        <a:pt x="150" y="415"/>
                      </a:lnTo>
                      <a:lnTo>
                        <a:pt x="154" y="415"/>
                      </a:lnTo>
                      <a:lnTo>
                        <a:pt x="158" y="414"/>
                      </a:lnTo>
                      <a:lnTo>
                        <a:pt x="162" y="414"/>
                      </a:lnTo>
                      <a:lnTo>
                        <a:pt x="165" y="414"/>
                      </a:lnTo>
                      <a:lnTo>
                        <a:pt x="169" y="414"/>
                      </a:lnTo>
                      <a:lnTo>
                        <a:pt x="173" y="415"/>
                      </a:lnTo>
                      <a:lnTo>
                        <a:pt x="177" y="415"/>
                      </a:lnTo>
                      <a:lnTo>
                        <a:pt x="181" y="415"/>
                      </a:lnTo>
                      <a:lnTo>
                        <a:pt x="184" y="415"/>
                      </a:lnTo>
                      <a:lnTo>
                        <a:pt x="188" y="416"/>
                      </a:lnTo>
                      <a:lnTo>
                        <a:pt x="192" y="415"/>
                      </a:lnTo>
                      <a:lnTo>
                        <a:pt x="195" y="415"/>
                      </a:lnTo>
                      <a:lnTo>
                        <a:pt x="199" y="415"/>
                      </a:lnTo>
                      <a:lnTo>
                        <a:pt x="203" y="415"/>
                      </a:lnTo>
                      <a:lnTo>
                        <a:pt x="207" y="415"/>
                      </a:lnTo>
                      <a:lnTo>
                        <a:pt x="211" y="415"/>
                      </a:lnTo>
                      <a:lnTo>
                        <a:pt x="214" y="414"/>
                      </a:lnTo>
                      <a:lnTo>
                        <a:pt x="218" y="414"/>
                      </a:lnTo>
                      <a:lnTo>
                        <a:pt x="222" y="415"/>
                      </a:lnTo>
                      <a:lnTo>
                        <a:pt x="226" y="414"/>
                      </a:lnTo>
                      <a:lnTo>
                        <a:pt x="229" y="414"/>
                      </a:lnTo>
                      <a:lnTo>
                        <a:pt x="233" y="415"/>
                      </a:lnTo>
                      <a:lnTo>
                        <a:pt x="237" y="414"/>
                      </a:lnTo>
                      <a:lnTo>
                        <a:pt x="241" y="414"/>
                      </a:lnTo>
                      <a:lnTo>
                        <a:pt x="244" y="414"/>
                      </a:lnTo>
                      <a:lnTo>
                        <a:pt x="248" y="415"/>
                      </a:lnTo>
                      <a:lnTo>
                        <a:pt x="252" y="415"/>
                      </a:lnTo>
                      <a:lnTo>
                        <a:pt x="256" y="414"/>
                      </a:lnTo>
                      <a:lnTo>
                        <a:pt x="259" y="415"/>
                      </a:lnTo>
                      <a:lnTo>
                        <a:pt x="263" y="414"/>
                      </a:lnTo>
                      <a:lnTo>
                        <a:pt x="267" y="415"/>
                      </a:lnTo>
                      <a:lnTo>
                        <a:pt x="271" y="414"/>
                      </a:lnTo>
                      <a:lnTo>
                        <a:pt x="274" y="414"/>
                      </a:lnTo>
                      <a:lnTo>
                        <a:pt x="278" y="413"/>
                      </a:lnTo>
                      <a:lnTo>
                        <a:pt x="282" y="413"/>
                      </a:lnTo>
                      <a:lnTo>
                        <a:pt x="286" y="413"/>
                      </a:lnTo>
                      <a:lnTo>
                        <a:pt x="289" y="413"/>
                      </a:lnTo>
                      <a:lnTo>
                        <a:pt x="293" y="414"/>
                      </a:lnTo>
                      <a:lnTo>
                        <a:pt x="297" y="413"/>
                      </a:lnTo>
                      <a:lnTo>
                        <a:pt x="301" y="414"/>
                      </a:lnTo>
                      <a:lnTo>
                        <a:pt x="305" y="414"/>
                      </a:lnTo>
                      <a:lnTo>
                        <a:pt x="308" y="414"/>
                      </a:lnTo>
                      <a:lnTo>
                        <a:pt x="312" y="414"/>
                      </a:lnTo>
                      <a:lnTo>
                        <a:pt x="316" y="415"/>
                      </a:lnTo>
                      <a:lnTo>
                        <a:pt x="319" y="414"/>
                      </a:lnTo>
                      <a:lnTo>
                        <a:pt x="323" y="414"/>
                      </a:lnTo>
                      <a:lnTo>
                        <a:pt x="327" y="415"/>
                      </a:lnTo>
                      <a:lnTo>
                        <a:pt x="331" y="414"/>
                      </a:lnTo>
                      <a:lnTo>
                        <a:pt x="335" y="414"/>
                      </a:lnTo>
                      <a:lnTo>
                        <a:pt x="338" y="414"/>
                      </a:lnTo>
                      <a:lnTo>
                        <a:pt x="342" y="415"/>
                      </a:lnTo>
                      <a:lnTo>
                        <a:pt x="346" y="414"/>
                      </a:lnTo>
                      <a:lnTo>
                        <a:pt x="350" y="415"/>
                      </a:lnTo>
                      <a:lnTo>
                        <a:pt x="353" y="414"/>
                      </a:lnTo>
                      <a:lnTo>
                        <a:pt x="357" y="414"/>
                      </a:lnTo>
                      <a:lnTo>
                        <a:pt x="361" y="415"/>
                      </a:lnTo>
                      <a:lnTo>
                        <a:pt x="365" y="414"/>
                      </a:lnTo>
                      <a:lnTo>
                        <a:pt x="368" y="414"/>
                      </a:lnTo>
                      <a:lnTo>
                        <a:pt x="372" y="414"/>
                      </a:lnTo>
                      <a:lnTo>
                        <a:pt x="376" y="414"/>
                      </a:lnTo>
                      <a:lnTo>
                        <a:pt x="380" y="415"/>
                      </a:lnTo>
                      <a:lnTo>
                        <a:pt x="384" y="414"/>
                      </a:lnTo>
                      <a:lnTo>
                        <a:pt x="387" y="414"/>
                      </a:lnTo>
                      <a:lnTo>
                        <a:pt x="391" y="414"/>
                      </a:lnTo>
                      <a:lnTo>
                        <a:pt x="395" y="414"/>
                      </a:lnTo>
                      <a:lnTo>
                        <a:pt x="398" y="415"/>
                      </a:lnTo>
                      <a:lnTo>
                        <a:pt x="402" y="415"/>
                      </a:lnTo>
                      <a:lnTo>
                        <a:pt x="406" y="414"/>
                      </a:lnTo>
                      <a:lnTo>
                        <a:pt x="410" y="415"/>
                      </a:lnTo>
                      <a:lnTo>
                        <a:pt x="413" y="415"/>
                      </a:lnTo>
                      <a:lnTo>
                        <a:pt x="417" y="415"/>
                      </a:lnTo>
                      <a:lnTo>
                        <a:pt x="421" y="416"/>
                      </a:lnTo>
                      <a:lnTo>
                        <a:pt x="425" y="416"/>
                      </a:lnTo>
                      <a:lnTo>
                        <a:pt x="429" y="416"/>
                      </a:lnTo>
                      <a:lnTo>
                        <a:pt x="432" y="416"/>
                      </a:lnTo>
                      <a:lnTo>
                        <a:pt x="436" y="416"/>
                      </a:lnTo>
                      <a:lnTo>
                        <a:pt x="440" y="416"/>
                      </a:lnTo>
                      <a:lnTo>
                        <a:pt x="444" y="416"/>
                      </a:lnTo>
                      <a:lnTo>
                        <a:pt x="447" y="416"/>
                      </a:lnTo>
                      <a:lnTo>
                        <a:pt x="451" y="415"/>
                      </a:lnTo>
                      <a:lnTo>
                        <a:pt x="455" y="416"/>
                      </a:lnTo>
                      <a:lnTo>
                        <a:pt x="459" y="416"/>
                      </a:lnTo>
                      <a:lnTo>
                        <a:pt x="462" y="416"/>
                      </a:lnTo>
                      <a:lnTo>
                        <a:pt x="466" y="416"/>
                      </a:lnTo>
                      <a:lnTo>
                        <a:pt x="470" y="416"/>
                      </a:lnTo>
                      <a:lnTo>
                        <a:pt x="474" y="416"/>
                      </a:lnTo>
                      <a:lnTo>
                        <a:pt x="477" y="416"/>
                      </a:lnTo>
                      <a:lnTo>
                        <a:pt x="481" y="415"/>
                      </a:lnTo>
                      <a:lnTo>
                        <a:pt x="485" y="416"/>
                      </a:lnTo>
                      <a:lnTo>
                        <a:pt x="489" y="415"/>
                      </a:lnTo>
                      <a:lnTo>
                        <a:pt x="492" y="415"/>
                      </a:lnTo>
                      <a:lnTo>
                        <a:pt x="496" y="416"/>
                      </a:lnTo>
                      <a:lnTo>
                        <a:pt x="500" y="416"/>
                      </a:lnTo>
                      <a:lnTo>
                        <a:pt x="504" y="416"/>
                      </a:lnTo>
                      <a:lnTo>
                        <a:pt x="508" y="416"/>
                      </a:lnTo>
                      <a:lnTo>
                        <a:pt x="511" y="416"/>
                      </a:lnTo>
                      <a:lnTo>
                        <a:pt x="515" y="416"/>
                      </a:lnTo>
                      <a:lnTo>
                        <a:pt x="519" y="416"/>
                      </a:lnTo>
                      <a:lnTo>
                        <a:pt x="522" y="416"/>
                      </a:lnTo>
                      <a:lnTo>
                        <a:pt x="526" y="415"/>
                      </a:lnTo>
                      <a:lnTo>
                        <a:pt x="530" y="416"/>
                      </a:lnTo>
                      <a:lnTo>
                        <a:pt x="534" y="416"/>
                      </a:lnTo>
                      <a:lnTo>
                        <a:pt x="537" y="416"/>
                      </a:lnTo>
                      <a:lnTo>
                        <a:pt x="541" y="416"/>
                      </a:lnTo>
                      <a:lnTo>
                        <a:pt x="545" y="417"/>
                      </a:lnTo>
                      <a:lnTo>
                        <a:pt x="549" y="417"/>
                      </a:lnTo>
                      <a:lnTo>
                        <a:pt x="553" y="417"/>
                      </a:lnTo>
                      <a:lnTo>
                        <a:pt x="556" y="416"/>
                      </a:lnTo>
                      <a:lnTo>
                        <a:pt x="560" y="417"/>
                      </a:lnTo>
                      <a:lnTo>
                        <a:pt x="564" y="417"/>
                      </a:lnTo>
                      <a:lnTo>
                        <a:pt x="568" y="416"/>
                      </a:lnTo>
                      <a:lnTo>
                        <a:pt x="571" y="416"/>
                      </a:lnTo>
                      <a:lnTo>
                        <a:pt x="575" y="417"/>
                      </a:lnTo>
                      <a:lnTo>
                        <a:pt x="579" y="416"/>
                      </a:lnTo>
                      <a:lnTo>
                        <a:pt x="582" y="416"/>
                      </a:lnTo>
                      <a:lnTo>
                        <a:pt x="586" y="416"/>
                      </a:lnTo>
                      <a:lnTo>
                        <a:pt x="590" y="416"/>
                      </a:lnTo>
                      <a:lnTo>
                        <a:pt x="594" y="416"/>
                      </a:lnTo>
                      <a:lnTo>
                        <a:pt x="598" y="416"/>
                      </a:lnTo>
                      <a:lnTo>
                        <a:pt x="601" y="417"/>
                      </a:lnTo>
                      <a:lnTo>
                        <a:pt x="605" y="416"/>
                      </a:lnTo>
                      <a:lnTo>
                        <a:pt x="609" y="416"/>
                      </a:lnTo>
                      <a:lnTo>
                        <a:pt x="613" y="416"/>
                      </a:lnTo>
                      <a:lnTo>
                        <a:pt x="616" y="416"/>
                      </a:lnTo>
                      <a:lnTo>
                        <a:pt x="620" y="416"/>
                      </a:lnTo>
                      <a:lnTo>
                        <a:pt x="624" y="416"/>
                      </a:lnTo>
                      <a:lnTo>
                        <a:pt x="628" y="416"/>
                      </a:lnTo>
                      <a:lnTo>
                        <a:pt x="631" y="416"/>
                      </a:lnTo>
                      <a:lnTo>
                        <a:pt x="635" y="417"/>
                      </a:lnTo>
                      <a:lnTo>
                        <a:pt x="639" y="417"/>
                      </a:lnTo>
                      <a:lnTo>
                        <a:pt x="643" y="416"/>
                      </a:lnTo>
                      <a:lnTo>
                        <a:pt x="646" y="417"/>
                      </a:lnTo>
                      <a:lnTo>
                        <a:pt x="650" y="416"/>
                      </a:lnTo>
                      <a:lnTo>
                        <a:pt x="654" y="417"/>
                      </a:lnTo>
                      <a:lnTo>
                        <a:pt x="658" y="416"/>
                      </a:lnTo>
                      <a:lnTo>
                        <a:pt x="661" y="417"/>
                      </a:lnTo>
                      <a:lnTo>
                        <a:pt x="665" y="416"/>
                      </a:lnTo>
                      <a:lnTo>
                        <a:pt x="669" y="416"/>
                      </a:lnTo>
                      <a:lnTo>
                        <a:pt x="673" y="417"/>
                      </a:lnTo>
                      <a:lnTo>
                        <a:pt x="677" y="417"/>
                      </a:lnTo>
                      <a:lnTo>
                        <a:pt x="680" y="417"/>
                      </a:lnTo>
                      <a:lnTo>
                        <a:pt x="684" y="417"/>
                      </a:lnTo>
                      <a:lnTo>
                        <a:pt x="688" y="417"/>
                      </a:lnTo>
                      <a:lnTo>
                        <a:pt x="692" y="416"/>
                      </a:lnTo>
                      <a:lnTo>
                        <a:pt x="695" y="417"/>
                      </a:lnTo>
                      <a:lnTo>
                        <a:pt x="699" y="417"/>
                      </a:lnTo>
                      <a:lnTo>
                        <a:pt x="703" y="417"/>
                      </a:lnTo>
                      <a:lnTo>
                        <a:pt x="706" y="417"/>
                      </a:lnTo>
                      <a:lnTo>
                        <a:pt x="710" y="417"/>
                      </a:lnTo>
                      <a:lnTo>
                        <a:pt x="714" y="416"/>
                      </a:lnTo>
                      <a:lnTo>
                        <a:pt x="718" y="416"/>
                      </a:lnTo>
                      <a:lnTo>
                        <a:pt x="722" y="416"/>
                      </a:lnTo>
                      <a:lnTo>
                        <a:pt x="725" y="416"/>
                      </a:lnTo>
                      <a:lnTo>
                        <a:pt x="729" y="416"/>
                      </a:lnTo>
                      <a:lnTo>
                        <a:pt x="733" y="416"/>
                      </a:lnTo>
                      <a:lnTo>
                        <a:pt x="737" y="416"/>
                      </a:lnTo>
                      <a:lnTo>
                        <a:pt x="740" y="416"/>
                      </a:lnTo>
                      <a:lnTo>
                        <a:pt x="744" y="416"/>
                      </a:lnTo>
                      <a:lnTo>
                        <a:pt x="748" y="417"/>
                      </a:lnTo>
                      <a:lnTo>
                        <a:pt x="752" y="417"/>
                      </a:lnTo>
                      <a:lnTo>
                        <a:pt x="755" y="417"/>
                      </a:lnTo>
                      <a:lnTo>
                        <a:pt x="759" y="417"/>
                      </a:lnTo>
                      <a:lnTo>
                        <a:pt x="763" y="417"/>
                      </a:lnTo>
                      <a:lnTo>
                        <a:pt x="767" y="417"/>
                      </a:lnTo>
                      <a:lnTo>
                        <a:pt x="770" y="418"/>
                      </a:lnTo>
                      <a:lnTo>
                        <a:pt x="774" y="418"/>
                      </a:lnTo>
                      <a:lnTo>
                        <a:pt x="778" y="418"/>
                      </a:lnTo>
                      <a:lnTo>
                        <a:pt x="782" y="418"/>
                      </a:lnTo>
                      <a:lnTo>
                        <a:pt x="785" y="417"/>
                      </a:lnTo>
                      <a:lnTo>
                        <a:pt x="789" y="417"/>
                      </a:lnTo>
                      <a:lnTo>
                        <a:pt x="793" y="417"/>
                      </a:lnTo>
                      <a:lnTo>
                        <a:pt x="797" y="418"/>
                      </a:lnTo>
                      <a:lnTo>
                        <a:pt x="801" y="417"/>
                      </a:lnTo>
                      <a:lnTo>
                        <a:pt x="804" y="417"/>
                      </a:lnTo>
                      <a:lnTo>
                        <a:pt x="808" y="418"/>
                      </a:lnTo>
                      <a:lnTo>
                        <a:pt x="812" y="419"/>
                      </a:lnTo>
                      <a:lnTo>
                        <a:pt x="816" y="418"/>
                      </a:lnTo>
                      <a:lnTo>
                        <a:pt x="819" y="417"/>
                      </a:lnTo>
                      <a:lnTo>
                        <a:pt x="823" y="418"/>
                      </a:lnTo>
                      <a:lnTo>
                        <a:pt x="827" y="417"/>
                      </a:lnTo>
                      <a:lnTo>
                        <a:pt x="831" y="418"/>
                      </a:lnTo>
                      <a:lnTo>
                        <a:pt x="834" y="419"/>
                      </a:lnTo>
                      <a:lnTo>
                        <a:pt x="838" y="418"/>
                      </a:lnTo>
                      <a:lnTo>
                        <a:pt x="842" y="418"/>
                      </a:lnTo>
                      <a:lnTo>
                        <a:pt x="846" y="418"/>
                      </a:lnTo>
                      <a:lnTo>
                        <a:pt x="849" y="418"/>
                      </a:lnTo>
                      <a:lnTo>
                        <a:pt x="853" y="418"/>
                      </a:lnTo>
                      <a:lnTo>
                        <a:pt x="857" y="418"/>
                      </a:lnTo>
                      <a:lnTo>
                        <a:pt x="861" y="418"/>
                      </a:lnTo>
                      <a:lnTo>
                        <a:pt x="864" y="418"/>
                      </a:lnTo>
                      <a:lnTo>
                        <a:pt x="868" y="418"/>
                      </a:lnTo>
                      <a:lnTo>
                        <a:pt x="872" y="418"/>
                      </a:lnTo>
                      <a:lnTo>
                        <a:pt x="876" y="418"/>
                      </a:lnTo>
                      <a:lnTo>
                        <a:pt x="879" y="418"/>
                      </a:lnTo>
                      <a:lnTo>
                        <a:pt x="883" y="418"/>
                      </a:lnTo>
                      <a:lnTo>
                        <a:pt x="887" y="417"/>
                      </a:lnTo>
                      <a:lnTo>
                        <a:pt x="891" y="417"/>
                      </a:lnTo>
                      <a:lnTo>
                        <a:pt x="895" y="418"/>
                      </a:lnTo>
                      <a:lnTo>
                        <a:pt x="898" y="418"/>
                      </a:lnTo>
                      <a:lnTo>
                        <a:pt x="902" y="417"/>
                      </a:lnTo>
                      <a:lnTo>
                        <a:pt x="906" y="417"/>
                      </a:lnTo>
                      <a:lnTo>
                        <a:pt x="909" y="418"/>
                      </a:lnTo>
                      <a:lnTo>
                        <a:pt x="913" y="418"/>
                      </a:lnTo>
                      <a:lnTo>
                        <a:pt x="917" y="418"/>
                      </a:lnTo>
                      <a:lnTo>
                        <a:pt x="921" y="417"/>
                      </a:lnTo>
                      <a:lnTo>
                        <a:pt x="925" y="417"/>
                      </a:lnTo>
                      <a:lnTo>
                        <a:pt x="928" y="418"/>
                      </a:lnTo>
                      <a:lnTo>
                        <a:pt x="932" y="418"/>
                      </a:lnTo>
                      <a:lnTo>
                        <a:pt x="936" y="418"/>
                      </a:lnTo>
                      <a:lnTo>
                        <a:pt x="940" y="418"/>
                      </a:lnTo>
                      <a:lnTo>
                        <a:pt x="943" y="418"/>
                      </a:lnTo>
                      <a:lnTo>
                        <a:pt x="947" y="418"/>
                      </a:lnTo>
                      <a:lnTo>
                        <a:pt x="951" y="418"/>
                      </a:lnTo>
                      <a:lnTo>
                        <a:pt x="955" y="418"/>
                      </a:lnTo>
                      <a:lnTo>
                        <a:pt x="958" y="418"/>
                      </a:lnTo>
                      <a:lnTo>
                        <a:pt x="962" y="418"/>
                      </a:lnTo>
                      <a:lnTo>
                        <a:pt x="966" y="418"/>
                      </a:lnTo>
                      <a:lnTo>
                        <a:pt x="970" y="418"/>
                      </a:lnTo>
                      <a:lnTo>
                        <a:pt x="973" y="419"/>
                      </a:lnTo>
                      <a:lnTo>
                        <a:pt x="977" y="417"/>
                      </a:lnTo>
                      <a:lnTo>
                        <a:pt x="981" y="419"/>
                      </a:lnTo>
                      <a:lnTo>
                        <a:pt x="985" y="419"/>
                      </a:lnTo>
                      <a:lnTo>
                        <a:pt x="988" y="418"/>
                      </a:lnTo>
                      <a:lnTo>
                        <a:pt x="992" y="418"/>
                      </a:lnTo>
                      <a:lnTo>
                        <a:pt x="996" y="418"/>
                      </a:lnTo>
                      <a:lnTo>
                        <a:pt x="1000" y="419"/>
                      </a:lnTo>
                      <a:lnTo>
                        <a:pt x="1003" y="418"/>
                      </a:lnTo>
                      <a:lnTo>
                        <a:pt x="1007" y="418"/>
                      </a:lnTo>
                      <a:lnTo>
                        <a:pt x="1011" y="419"/>
                      </a:lnTo>
                      <a:lnTo>
                        <a:pt x="1015" y="418"/>
                      </a:lnTo>
                      <a:lnTo>
                        <a:pt x="1019" y="418"/>
                      </a:lnTo>
                      <a:lnTo>
                        <a:pt x="1022" y="418"/>
                      </a:lnTo>
                      <a:lnTo>
                        <a:pt x="1026" y="418"/>
                      </a:lnTo>
                      <a:lnTo>
                        <a:pt x="1030" y="419"/>
                      </a:lnTo>
                      <a:lnTo>
                        <a:pt x="1033" y="419"/>
                      </a:lnTo>
                      <a:lnTo>
                        <a:pt x="1037" y="418"/>
                      </a:lnTo>
                      <a:lnTo>
                        <a:pt x="1041" y="418"/>
                      </a:lnTo>
                      <a:lnTo>
                        <a:pt x="1045" y="419"/>
                      </a:lnTo>
                      <a:lnTo>
                        <a:pt x="1049" y="418"/>
                      </a:lnTo>
                      <a:lnTo>
                        <a:pt x="1052" y="418"/>
                      </a:lnTo>
                      <a:lnTo>
                        <a:pt x="1056" y="418"/>
                      </a:lnTo>
                      <a:lnTo>
                        <a:pt x="1060" y="419"/>
                      </a:lnTo>
                      <a:lnTo>
                        <a:pt x="1064" y="419"/>
                      </a:lnTo>
                      <a:lnTo>
                        <a:pt x="1067" y="418"/>
                      </a:lnTo>
                      <a:lnTo>
                        <a:pt x="1071" y="417"/>
                      </a:lnTo>
                      <a:lnTo>
                        <a:pt x="1075" y="418"/>
                      </a:lnTo>
                      <a:lnTo>
                        <a:pt x="1079" y="418"/>
                      </a:lnTo>
                      <a:lnTo>
                        <a:pt x="1082" y="418"/>
                      </a:lnTo>
                      <a:lnTo>
                        <a:pt x="1086" y="419"/>
                      </a:lnTo>
                      <a:lnTo>
                        <a:pt x="1090" y="419"/>
                      </a:lnTo>
                      <a:lnTo>
                        <a:pt x="1094" y="418"/>
                      </a:lnTo>
                      <a:lnTo>
                        <a:pt x="1097" y="418"/>
                      </a:lnTo>
                      <a:lnTo>
                        <a:pt x="1101" y="419"/>
                      </a:lnTo>
                      <a:lnTo>
                        <a:pt x="1105" y="419"/>
                      </a:lnTo>
                      <a:lnTo>
                        <a:pt x="1109" y="419"/>
                      </a:lnTo>
                      <a:lnTo>
                        <a:pt x="1112" y="418"/>
                      </a:lnTo>
                      <a:lnTo>
                        <a:pt x="1116" y="419"/>
                      </a:lnTo>
                      <a:lnTo>
                        <a:pt x="1120" y="419"/>
                      </a:lnTo>
                      <a:lnTo>
                        <a:pt x="1124" y="419"/>
                      </a:lnTo>
                      <a:lnTo>
                        <a:pt x="1127" y="419"/>
                      </a:lnTo>
                      <a:lnTo>
                        <a:pt x="1131" y="419"/>
                      </a:lnTo>
                      <a:lnTo>
                        <a:pt x="1135" y="419"/>
                      </a:lnTo>
                      <a:lnTo>
                        <a:pt x="1139" y="420"/>
                      </a:lnTo>
                      <a:lnTo>
                        <a:pt x="1143" y="419"/>
                      </a:lnTo>
                      <a:lnTo>
                        <a:pt x="1146" y="419"/>
                      </a:lnTo>
                      <a:lnTo>
                        <a:pt x="1150" y="418"/>
                      </a:lnTo>
                      <a:lnTo>
                        <a:pt x="1154" y="419"/>
                      </a:lnTo>
                      <a:lnTo>
                        <a:pt x="1157" y="420"/>
                      </a:lnTo>
                      <a:lnTo>
                        <a:pt x="1161" y="419"/>
                      </a:lnTo>
                      <a:lnTo>
                        <a:pt x="1165" y="419"/>
                      </a:lnTo>
                      <a:lnTo>
                        <a:pt x="1169" y="419"/>
                      </a:lnTo>
                      <a:lnTo>
                        <a:pt x="1172" y="419"/>
                      </a:lnTo>
                      <a:lnTo>
                        <a:pt x="1176" y="419"/>
                      </a:lnTo>
                      <a:lnTo>
                        <a:pt x="1180" y="419"/>
                      </a:lnTo>
                      <a:lnTo>
                        <a:pt x="1184" y="419"/>
                      </a:lnTo>
                      <a:lnTo>
                        <a:pt x="1188" y="419"/>
                      </a:lnTo>
                      <a:lnTo>
                        <a:pt x="1191" y="419"/>
                      </a:lnTo>
                      <a:lnTo>
                        <a:pt x="1195" y="420"/>
                      </a:lnTo>
                      <a:lnTo>
                        <a:pt x="1199" y="419"/>
                      </a:lnTo>
                      <a:lnTo>
                        <a:pt x="1203" y="419"/>
                      </a:lnTo>
                      <a:lnTo>
                        <a:pt x="1206" y="419"/>
                      </a:lnTo>
                      <a:lnTo>
                        <a:pt x="1210" y="419"/>
                      </a:lnTo>
                      <a:lnTo>
                        <a:pt x="1214" y="420"/>
                      </a:lnTo>
                      <a:lnTo>
                        <a:pt x="1218" y="419"/>
                      </a:lnTo>
                      <a:lnTo>
                        <a:pt x="1221" y="419"/>
                      </a:lnTo>
                      <a:lnTo>
                        <a:pt x="1225" y="419"/>
                      </a:lnTo>
                      <a:lnTo>
                        <a:pt x="1229" y="419"/>
                      </a:lnTo>
                      <a:lnTo>
                        <a:pt x="1233" y="419"/>
                      </a:lnTo>
                      <a:lnTo>
                        <a:pt x="1236" y="419"/>
                      </a:lnTo>
                      <a:lnTo>
                        <a:pt x="1240" y="418"/>
                      </a:lnTo>
                      <a:lnTo>
                        <a:pt x="1244" y="419"/>
                      </a:lnTo>
                      <a:lnTo>
                        <a:pt x="1248" y="419"/>
                      </a:lnTo>
                      <a:lnTo>
                        <a:pt x="1251" y="419"/>
                      </a:lnTo>
                      <a:lnTo>
                        <a:pt x="1255" y="419"/>
                      </a:lnTo>
                      <a:lnTo>
                        <a:pt x="1259" y="419"/>
                      </a:lnTo>
                      <a:lnTo>
                        <a:pt x="1263" y="419"/>
                      </a:lnTo>
                      <a:lnTo>
                        <a:pt x="1267" y="418"/>
                      </a:lnTo>
                      <a:lnTo>
                        <a:pt x="1270" y="418"/>
                      </a:lnTo>
                      <a:lnTo>
                        <a:pt x="1274" y="419"/>
                      </a:lnTo>
                      <a:lnTo>
                        <a:pt x="1278" y="419"/>
                      </a:lnTo>
                      <a:lnTo>
                        <a:pt x="1282" y="419"/>
                      </a:lnTo>
                      <a:lnTo>
                        <a:pt x="1285" y="419"/>
                      </a:lnTo>
                      <a:lnTo>
                        <a:pt x="1289" y="419"/>
                      </a:lnTo>
                      <a:lnTo>
                        <a:pt x="1293" y="419"/>
                      </a:lnTo>
                      <a:lnTo>
                        <a:pt x="1296" y="418"/>
                      </a:lnTo>
                      <a:lnTo>
                        <a:pt x="1300" y="418"/>
                      </a:lnTo>
                      <a:lnTo>
                        <a:pt x="1304" y="419"/>
                      </a:lnTo>
                      <a:lnTo>
                        <a:pt x="1308" y="419"/>
                      </a:lnTo>
                      <a:lnTo>
                        <a:pt x="1312" y="418"/>
                      </a:lnTo>
                      <a:lnTo>
                        <a:pt x="1315" y="419"/>
                      </a:lnTo>
                      <a:lnTo>
                        <a:pt x="1319" y="419"/>
                      </a:lnTo>
                      <a:lnTo>
                        <a:pt x="1323" y="419"/>
                      </a:lnTo>
                      <a:lnTo>
                        <a:pt x="1327" y="419"/>
                      </a:lnTo>
                      <a:lnTo>
                        <a:pt x="1330" y="419"/>
                      </a:lnTo>
                      <a:lnTo>
                        <a:pt x="1334" y="418"/>
                      </a:lnTo>
                      <a:lnTo>
                        <a:pt x="1338" y="419"/>
                      </a:lnTo>
                      <a:lnTo>
                        <a:pt x="1342" y="419"/>
                      </a:lnTo>
                      <a:lnTo>
                        <a:pt x="1345" y="418"/>
                      </a:lnTo>
                      <a:lnTo>
                        <a:pt x="1349" y="419"/>
                      </a:lnTo>
                      <a:lnTo>
                        <a:pt x="1353" y="418"/>
                      </a:lnTo>
                      <a:lnTo>
                        <a:pt x="1357" y="418"/>
                      </a:lnTo>
                      <a:lnTo>
                        <a:pt x="1360" y="418"/>
                      </a:lnTo>
                      <a:lnTo>
                        <a:pt x="1364" y="419"/>
                      </a:lnTo>
                      <a:lnTo>
                        <a:pt x="1368" y="419"/>
                      </a:lnTo>
                      <a:lnTo>
                        <a:pt x="1372" y="419"/>
                      </a:lnTo>
                      <a:lnTo>
                        <a:pt x="1375" y="419"/>
                      </a:lnTo>
                      <a:lnTo>
                        <a:pt x="1379" y="419"/>
                      </a:lnTo>
                      <a:lnTo>
                        <a:pt x="1383" y="419"/>
                      </a:lnTo>
                      <a:lnTo>
                        <a:pt x="1387" y="419"/>
                      </a:lnTo>
                      <a:lnTo>
                        <a:pt x="1391" y="419"/>
                      </a:lnTo>
                      <a:lnTo>
                        <a:pt x="1394" y="419"/>
                      </a:lnTo>
                      <a:lnTo>
                        <a:pt x="1398" y="418"/>
                      </a:lnTo>
                      <a:lnTo>
                        <a:pt x="1402" y="419"/>
                      </a:lnTo>
                      <a:lnTo>
                        <a:pt x="1406" y="419"/>
                      </a:lnTo>
                      <a:lnTo>
                        <a:pt x="1409" y="419"/>
                      </a:lnTo>
                      <a:lnTo>
                        <a:pt x="1413" y="418"/>
                      </a:lnTo>
                      <a:lnTo>
                        <a:pt x="1417" y="419"/>
                      </a:lnTo>
                      <a:lnTo>
                        <a:pt x="1420" y="418"/>
                      </a:lnTo>
                      <a:lnTo>
                        <a:pt x="1424" y="419"/>
                      </a:lnTo>
                      <a:lnTo>
                        <a:pt x="1428" y="419"/>
                      </a:lnTo>
                      <a:lnTo>
                        <a:pt x="1432" y="419"/>
                      </a:lnTo>
                      <a:lnTo>
                        <a:pt x="1436" y="419"/>
                      </a:lnTo>
                      <a:lnTo>
                        <a:pt x="1439" y="419"/>
                      </a:lnTo>
                      <a:lnTo>
                        <a:pt x="1443" y="419"/>
                      </a:lnTo>
                      <a:lnTo>
                        <a:pt x="1447" y="419"/>
                      </a:lnTo>
                      <a:lnTo>
                        <a:pt x="1451" y="418"/>
                      </a:lnTo>
                      <a:lnTo>
                        <a:pt x="1454" y="419"/>
                      </a:lnTo>
                      <a:lnTo>
                        <a:pt x="1458" y="419"/>
                      </a:lnTo>
                      <a:lnTo>
                        <a:pt x="1462" y="418"/>
                      </a:lnTo>
                      <a:lnTo>
                        <a:pt x="1466" y="419"/>
                      </a:lnTo>
                      <a:lnTo>
                        <a:pt x="1469" y="418"/>
                      </a:lnTo>
                      <a:lnTo>
                        <a:pt x="1473" y="419"/>
                      </a:lnTo>
                      <a:lnTo>
                        <a:pt x="1477" y="419"/>
                      </a:lnTo>
                      <a:lnTo>
                        <a:pt x="1481" y="419"/>
                      </a:lnTo>
                      <a:lnTo>
                        <a:pt x="1484" y="418"/>
                      </a:lnTo>
                      <a:lnTo>
                        <a:pt x="1488" y="419"/>
                      </a:lnTo>
                      <a:lnTo>
                        <a:pt x="1492" y="418"/>
                      </a:lnTo>
                      <a:lnTo>
                        <a:pt x="1496" y="419"/>
                      </a:lnTo>
                      <a:lnTo>
                        <a:pt x="1499" y="418"/>
                      </a:lnTo>
                      <a:lnTo>
                        <a:pt x="1503" y="418"/>
                      </a:lnTo>
                      <a:lnTo>
                        <a:pt x="1507" y="419"/>
                      </a:lnTo>
                      <a:lnTo>
                        <a:pt x="1511" y="419"/>
                      </a:lnTo>
                      <a:lnTo>
                        <a:pt x="1515" y="418"/>
                      </a:lnTo>
                      <a:lnTo>
                        <a:pt x="1518" y="418"/>
                      </a:lnTo>
                      <a:lnTo>
                        <a:pt x="1522" y="418"/>
                      </a:lnTo>
                      <a:lnTo>
                        <a:pt x="1526" y="418"/>
                      </a:lnTo>
                      <a:lnTo>
                        <a:pt x="1530" y="418"/>
                      </a:lnTo>
                      <a:lnTo>
                        <a:pt x="1533" y="418"/>
                      </a:lnTo>
                      <a:lnTo>
                        <a:pt x="1537" y="419"/>
                      </a:lnTo>
                      <a:lnTo>
                        <a:pt x="1541" y="419"/>
                      </a:lnTo>
                      <a:lnTo>
                        <a:pt x="1544" y="418"/>
                      </a:lnTo>
                      <a:lnTo>
                        <a:pt x="1548" y="419"/>
                      </a:lnTo>
                      <a:lnTo>
                        <a:pt x="1552" y="419"/>
                      </a:lnTo>
                      <a:lnTo>
                        <a:pt x="1556" y="419"/>
                      </a:lnTo>
                      <a:lnTo>
                        <a:pt x="1560" y="418"/>
                      </a:lnTo>
                      <a:lnTo>
                        <a:pt x="1563" y="419"/>
                      </a:lnTo>
                      <a:lnTo>
                        <a:pt x="1567" y="418"/>
                      </a:lnTo>
                      <a:lnTo>
                        <a:pt x="1571" y="419"/>
                      </a:lnTo>
                      <a:lnTo>
                        <a:pt x="1575" y="418"/>
                      </a:lnTo>
                      <a:lnTo>
                        <a:pt x="1578" y="418"/>
                      </a:lnTo>
                      <a:lnTo>
                        <a:pt x="1582" y="418"/>
                      </a:lnTo>
                      <a:lnTo>
                        <a:pt x="1586" y="419"/>
                      </a:lnTo>
                      <a:lnTo>
                        <a:pt x="1590" y="419"/>
                      </a:lnTo>
                      <a:lnTo>
                        <a:pt x="1593" y="419"/>
                      </a:lnTo>
                      <a:lnTo>
                        <a:pt x="1597" y="419"/>
                      </a:lnTo>
                      <a:lnTo>
                        <a:pt x="1601" y="419"/>
                      </a:lnTo>
                      <a:lnTo>
                        <a:pt x="1605" y="419"/>
                      </a:lnTo>
                      <a:lnTo>
                        <a:pt x="1608" y="418"/>
                      </a:lnTo>
                      <a:lnTo>
                        <a:pt x="1612" y="419"/>
                      </a:lnTo>
                      <a:lnTo>
                        <a:pt x="1616" y="418"/>
                      </a:lnTo>
                      <a:lnTo>
                        <a:pt x="1620" y="419"/>
                      </a:lnTo>
                      <a:lnTo>
                        <a:pt x="1623" y="418"/>
                      </a:lnTo>
                      <a:lnTo>
                        <a:pt x="1627" y="419"/>
                      </a:lnTo>
                      <a:lnTo>
                        <a:pt x="1631" y="418"/>
                      </a:lnTo>
                      <a:lnTo>
                        <a:pt x="1635" y="418"/>
                      </a:lnTo>
                      <a:lnTo>
                        <a:pt x="1639" y="418"/>
                      </a:lnTo>
                      <a:lnTo>
                        <a:pt x="1642" y="419"/>
                      </a:lnTo>
                      <a:lnTo>
                        <a:pt x="1646" y="418"/>
                      </a:lnTo>
                      <a:lnTo>
                        <a:pt x="1650" y="418"/>
                      </a:lnTo>
                      <a:lnTo>
                        <a:pt x="1654" y="418"/>
                      </a:lnTo>
                      <a:lnTo>
                        <a:pt x="1657" y="419"/>
                      </a:lnTo>
                      <a:lnTo>
                        <a:pt x="1661" y="419"/>
                      </a:lnTo>
                      <a:lnTo>
                        <a:pt x="1665" y="418"/>
                      </a:lnTo>
                      <a:lnTo>
                        <a:pt x="1669" y="418"/>
                      </a:lnTo>
                      <a:lnTo>
                        <a:pt x="1672" y="418"/>
                      </a:lnTo>
                      <a:lnTo>
                        <a:pt x="1676" y="417"/>
                      </a:lnTo>
                      <a:lnTo>
                        <a:pt x="1680" y="419"/>
                      </a:lnTo>
                      <a:lnTo>
                        <a:pt x="1684" y="418"/>
                      </a:lnTo>
                      <a:lnTo>
                        <a:pt x="1687" y="418"/>
                      </a:lnTo>
                      <a:lnTo>
                        <a:pt x="1691" y="418"/>
                      </a:lnTo>
                      <a:lnTo>
                        <a:pt x="1695" y="418"/>
                      </a:lnTo>
                      <a:lnTo>
                        <a:pt x="1699" y="418"/>
                      </a:lnTo>
                      <a:lnTo>
                        <a:pt x="1702" y="418"/>
                      </a:lnTo>
                      <a:lnTo>
                        <a:pt x="1706" y="418"/>
                      </a:lnTo>
                      <a:lnTo>
                        <a:pt x="1710" y="418"/>
                      </a:lnTo>
                      <a:lnTo>
                        <a:pt x="1714" y="418"/>
                      </a:lnTo>
                      <a:lnTo>
                        <a:pt x="1717" y="418"/>
                      </a:lnTo>
                      <a:lnTo>
                        <a:pt x="1721" y="419"/>
                      </a:lnTo>
                      <a:lnTo>
                        <a:pt x="1725" y="418"/>
                      </a:lnTo>
                      <a:lnTo>
                        <a:pt x="1729" y="418"/>
                      </a:lnTo>
                      <a:lnTo>
                        <a:pt x="1733" y="419"/>
                      </a:lnTo>
                      <a:lnTo>
                        <a:pt x="1736" y="418"/>
                      </a:lnTo>
                      <a:lnTo>
                        <a:pt x="1740" y="418"/>
                      </a:lnTo>
                      <a:lnTo>
                        <a:pt x="1744" y="419"/>
                      </a:lnTo>
                      <a:lnTo>
                        <a:pt x="1747" y="419"/>
                      </a:lnTo>
                      <a:lnTo>
                        <a:pt x="1751" y="418"/>
                      </a:lnTo>
                      <a:lnTo>
                        <a:pt x="1755" y="418"/>
                      </a:lnTo>
                      <a:lnTo>
                        <a:pt x="1759" y="417"/>
                      </a:lnTo>
                      <a:lnTo>
                        <a:pt x="1762" y="418"/>
                      </a:lnTo>
                      <a:lnTo>
                        <a:pt x="1766" y="417"/>
                      </a:lnTo>
                      <a:lnTo>
                        <a:pt x="1770" y="418"/>
                      </a:lnTo>
                      <a:lnTo>
                        <a:pt x="1774" y="418"/>
                      </a:lnTo>
                      <a:lnTo>
                        <a:pt x="1778" y="419"/>
                      </a:lnTo>
                      <a:lnTo>
                        <a:pt x="1781" y="418"/>
                      </a:lnTo>
                      <a:lnTo>
                        <a:pt x="1785" y="418"/>
                      </a:lnTo>
                      <a:lnTo>
                        <a:pt x="1789" y="419"/>
                      </a:lnTo>
                      <a:lnTo>
                        <a:pt x="1793" y="419"/>
                      </a:lnTo>
                      <a:lnTo>
                        <a:pt x="1796" y="418"/>
                      </a:lnTo>
                      <a:lnTo>
                        <a:pt x="1800" y="418"/>
                      </a:lnTo>
                      <a:lnTo>
                        <a:pt x="1804" y="418"/>
                      </a:lnTo>
                      <a:lnTo>
                        <a:pt x="1808" y="418"/>
                      </a:lnTo>
                      <a:lnTo>
                        <a:pt x="1811" y="418"/>
                      </a:lnTo>
                      <a:lnTo>
                        <a:pt x="1815" y="418"/>
                      </a:lnTo>
                      <a:lnTo>
                        <a:pt x="1819" y="419"/>
                      </a:lnTo>
                      <a:lnTo>
                        <a:pt x="1823" y="418"/>
                      </a:lnTo>
                      <a:lnTo>
                        <a:pt x="1826" y="418"/>
                      </a:lnTo>
                      <a:lnTo>
                        <a:pt x="1830" y="418"/>
                      </a:lnTo>
                      <a:lnTo>
                        <a:pt x="1834" y="418"/>
                      </a:lnTo>
                      <a:lnTo>
                        <a:pt x="1838" y="418"/>
                      </a:lnTo>
                      <a:lnTo>
                        <a:pt x="1841" y="418"/>
                      </a:lnTo>
                      <a:lnTo>
                        <a:pt x="1845" y="419"/>
                      </a:lnTo>
                      <a:lnTo>
                        <a:pt x="1849" y="419"/>
                      </a:lnTo>
                      <a:lnTo>
                        <a:pt x="1853" y="418"/>
                      </a:lnTo>
                      <a:lnTo>
                        <a:pt x="1857" y="418"/>
                      </a:lnTo>
                      <a:lnTo>
                        <a:pt x="1860" y="419"/>
                      </a:lnTo>
                      <a:lnTo>
                        <a:pt x="1864" y="418"/>
                      </a:lnTo>
                      <a:lnTo>
                        <a:pt x="1868" y="418"/>
                      </a:lnTo>
                      <a:lnTo>
                        <a:pt x="1871" y="418"/>
                      </a:lnTo>
                      <a:lnTo>
                        <a:pt x="1875" y="418"/>
                      </a:lnTo>
                      <a:lnTo>
                        <a:pt x="1879" y="418"/>
                      </a:lnTo>
                      <a:lnTo>
                        <a:pt x="1883" y="418"/>
                      </a:lnTo>
                      <a:lnTo>
                        <a:pt x="1886" y="418"/>
                      </a:lnTo>
                      <a:lnTo>
                        <a:pt x="1890" y="419"/>
                      </a:lnTo>
                      <a:lnTo>
                        <a:pt x="1894" y="418"/>
                      </a:lnTo>
                      <a:lnTo>
                        <a:pt x="1898" y="419"/>
                      </a:lnTo>
                      <a:lnTo>
                        <a:pt x="1902" y="418"/>
                      </a:lnTo>
                      <a:lnTo>
                        <a:pt x="1905" y="417"/>
                      </a:lnTo>
                      <a:lnTo>
                        <a:pt x="1909" y="419"/>
                      </a:lnTo>
                      <a:lnTo>
                        <a:pt x="1913" y="418"/>
                      </a:lnTo>
                      <a:lnTo>
                        <a:pt x="1917" y="418"/>
                      </a:lnTo>
                      <a:lnTo>
                        <a:pt x="1920" y="418"/>
                      </a:lnTo>
                      <a:lnTo>
                        <a:pt x="1924" y="418"/>
                      </a:lnTo>
                      <a:lnTo>
                        <a:pt x="1928" y="418"/>
                      </a:lnTo>
                      <a:lnTo>
                        <a:pt x="1932" y="418"/>
                      </a:lnTo>
                      <a:lnTo>
                        <a:pt x="1935" y="418"/>
                      </a:lnTo>
                      <a:lnTo>
                        <a:pt x="1939" y="418"/>
                      </a:lnTo>
                      <a:lnTo>
                        <a:pt x="1943" y="418"/>
                      </a:lnTo>
                      <a:lnTo>
                        <a:pt x="1947" y="418"/>
                      </a:lnTo>
                      <a:lnTo>
                        <a:pt x="1950" y="418"/>
                      </a:lnTo>
                      <a:lnTo>
                        <a:pt x="1954" y="417"/>
                      </a:lnTo>
                      <a:lnTo>
                        <a:pt x="1958" y="418"/>
                      </a:lnTo>
                      <a:lnTo>
                        <a:pt x="1962" y="418"/>
                      </a:lnTo>
                      <a:lnTo>
                        <a:pt x="1965" y="417"/>
                      </a:lnTo>
                      <a:lnTo>
                        <a:pt x="1969" y="418"/>
                      </a:lnTo>
                      <a:lnTo>
                        <a:pt x="1973" y="418"/>
                      </a:lnTo>
                      <a:lnTo>
                        <a:pt x="1977" y="417"/>
                      </a:lnTo>
                      <a:lnTo>
                        <a:pt x="1981" y="417"/>
                      </a:lnTo>
                      <a:lnTo>
                        <a:pt x="1984" y="417"/>
                      </a:lnTo>
                      <a:lnTo>
                        <a:pt x="1988" y="418"/>
                      </a:lnTo>
                      <a:lnTo>
                        <a:pt x="1992" y="417"/>
                      </a:lnTo>
                      <a:lnTo>
                        <a:pt x="1995" y="417"/>
                      </a:lnTo>
                      <a:lnTo>
                        <a:pt x="1999" y="417"/>
                      </a:lnTo>
                      <a:lnTo>
                        <a:pt x="2003" y="417"/>
                      </a:lnTo>
                      <a:lnTo>
                        <a:pt x="2007" y="417"/>
                      </a:lnTo>
                      <a:lnTo>
                        <a:pt x="2010" y="417"/>
                      </a:lnTo>
                      <a:lnTo>
                        <a:pt x="2014" y="417"/>
                      </a:lnTo>
                      <a:lnTo>
                        <a:pt x="2018" y="417"/>
                      </a:lnTo>
                      <a:lnTo>
                        <a:pt x="2022" y="417"/>
                      </a:lnTo>
                      <a:lnTo>
                        <a:pt x="2026" y="417"/>
                      </a:lnTo>
                      <a:lnTo>
                        <a:pt x="2029" y="417"/>
                      </a:lnTo>
                      <a:lnTo>
                        <a:pt x="2033" y="417"/>
                      </a:lnTo>
                      <a:lnTo>
                        <a:pt x="2037" y="417"/>
                      </a:lnTo>
                      <a:lnTo>
                        <a:pt x="2041" y="417"/>
                      </a:lnTo>
                      <a:lnTo>
                        <a:pt x="2044" y="417"/>
                      </a:lnTo>
                      <a:lnTo>
                        <a:pt x="2048" y="417"/>
                      </a:lnTo>
                      <a:lnTo>
                        <a:pt x="2052" y="418"/>
                      </a:lnTo>
                      <a:lnTo>
                        <a:pt x="2056" y="418"/>
                      </a:lnTo>
                      <a:lnTo>
                        <a:pt x="2059" y="416"/>
                      </a:lnTo>
                      <a:lnTo>
                        <a:pt x="2063" y="417"/>
                      </a:lnTo>
                      <a:lnTo>
                        <a:pt x="2067" y="417"/>
                      </a:lnTo>
                      <a:lnTo>
                        <a:pt x="2071" y="417"/>
                      </a:lnTo>
                      <a:lnTo>
                        <a:pt x="2074" y="417"/>
                      </a:lnTo>
                      <a:lnTo>
                        <a:pt x="2078" y="417"/>
                      </a:lnTo>
                      <a:lnTo>
                        <a:pt x="2082" y="416"/>
                      </a:lnTo>
                      <a:lnTo>
                        <a:pt x="2086" y="417"/>
                      </a:lnTo>
                      <a:lnTo>
                        <a:pt x="2089" y="417"/>
                      </a:lnTo>
                      <a:lnTo>
                        <a:pt x="2093" y="416"/>
                      </a:lnTo>
                      <a:lnTo>
                        <a:pt x="2097" y="416"/>
                      </a:lnTo>
                      <a:lnTo>
                        <a:pt x="2101" y="416"/>
                      </a:lnTo>
                      <a:lnTo>
                        <a:pt x="2105" y="416"/>
                      </a:lnTo>
                      <a:lnTo>
                        <a:pt x="2108" y="416"/>
                      </a:lnTo>
                      <a:lnTo>
                        <a:pt x="2112" y="416"/>
                      </a:lnTo>
                      <a:lnTo>
                        <a:pt x="2116" y="417"/>
                      </a:lnTo>
                      <a:lnTo>
                        <a:pt x="2120" y="416"/>
                      </a:lnTo>
                      <a:lnTo>
                        <a:pt x="2123" y="416"/>
                      </a:lnTo>
                      <a:lnTo>
                        <a:pt x="2127" y="416"/>
                      </a:lnTo>
                      <a:lnTo>
                        <a:pt x="2131" y="417"/>
                      </a:lnTo>
                      <a:lnTo>
                        <a:pt x="2134" y="416"/>
                      </a:lnTo>
                      <a:lnTo>
                        <a:pt x="2138" y="417"/>
                      </a:lnTo>
                      <a:lnTo>
                        <a:pt x="2142" y="416"/>
                      </a:lnTo>
                      <a:lnTo>
                        <a:pt x="2146" y="417"/>
                      </a:lnTo>
                      <a:lnTo>
                        <a:pt x="2150" y="416"/>
                      </a:lnTo>
                      <a:lnTo>
                        <a:pt x="2153" y="416"/>
                      </a:lnTo>
                      <a:lnTo>
                        <a:pt x="2157" y="416"/>
                      </a:lnTo>
                      <a:lnTo>
                        <a:pt x="2161" y="416"/>
                      </a:lnTo>
                      <a:lnTo>
                        <a:pt x="2165" y="416"/>
                      </a:lnTo>
                      <a:lnTo>
                        <a:pt x="2168" y="416"/>
                      </a:lnTo>
                      <a:lnTo>
                        <a:pt x="2172" y="417"/>
                      </a:lnTo>
                      <a:lnTo>
                        <a:pt x="2176" y="416"/>
                      </a:lnTo>
                      <a:lnTo>
                        <a:pt x="2180" y="417"/>
                      </a:lnTo>
                      <a:lnTo>
                        <a:pt x="2183" y="416"/>
                      </a:lnTo>
                      <a:lnTo>
                        <a:pt x="2187" y="416"/>
                      </a:lnTo>
                      <a:lnTo>
                        <a:pt x="2191" y="416"/>
                      </a:lnTo>
                      <a:lnTo>
                        <a:pt x="2195" y="417"/>
                      </a:lnTo>
                      <a:lnTo>
                        <a:pt x="2198" y="417"/>
                      </a:lnTo>
                      <a:lnTo>
                        <a:pt x="2202" y="416"/>
                      </a:lnTo>
                      <a:lnTo>
                        <a:pt x="2206" y="416"/>
                      </a:lnTo>
                      <a:lnTo>
                        <a:pt x="2210" y="417"/>
                      </a:lnTo>
                      <a:lnTo>
                        <a:pt x="2213" y="417"/>
                      </a:lnTo>
                      <a:lnTo>
                        <a:pt x="2217" y="417"/>
                      </a:lnTo>
                      <a:lnTo>
                        <a:pt x="2221" y="417"/>
                      </a:lnTo>
                      <a:lnTo>
                        <a:pt x="2225" y="417"/>
                      </a:lnTo>
                      <a:lnTo>
                        <a:pt x="2229" y="417"/>
                      </a:lnTo>
                      <a:lnTo>
                        <a:pt x="2232" y="417"/>
                      </a:lnTo>
                      <a:lnTo>
                        <a:pt x="2236" y="417"/>
                      </a:lnTo>
                      <a:lnTo>
                        <a:pt x="2240" y="416"/>
                      </a:lnTo>
                      <a:lnTo>
                        <a:pt x="2244" y="418"/>
                      </a:lnTo>
                      <a:lnTo>
                        <a:pt x="2247" y="417"/>
                      </a:lnTo>
                      <a:lnTo>
                        <a:pt x="2251" y="417"/>
                      </a:lnTo>
                      <a:lnTo>
                        <a:pt x="2255" y="417"/>
                      </a:lnTo>
                      <a:lnTo>
                        <a:pt x="2258" y="417"/>
                      </a:lnTo>
                      <a:lnTo>
                        <a:pt x="2262" y="417"/>
                      </a:lnTo>
                      <a:lnTo>
                        <a:pt x="2266" y="416"/>
                      </a:lnTo>
                      <a:lnTo>
                        <a:pt x="2270" y="417"/>
                      </a:lnTo>
                      <a:lnTo>
                        <a:pt x="2274" y="416"/>
                      </a:lnTo>
                      <a:lnTo>
                        <a:pt x="2277" y="417"/>
                      </a:lnTo>
                      <a:lnTo>
                        <a:pt x="2281" y="417"/>
                      </a:lnTo>
                      <a:lnTo>
                        <a:pt x="2285" y="416"/>
                      </a:lnTo>
                      <a:lnTo>
                        <a:pt x="2289" y="416"/>
                      </a:lnTo>
                      <a:lnTo>
                        <a:pt x="2292" y="416"/>
                      </a:lnTo>
                      <a:lnTo>
                        <a:pt x="2296" y="416"/>
                      </a:lnTo>
                      <a:lnTo>
                        <a:pt x="2300" y="416"/>
                      </a:lnTo>
                      <a:lnTo>
                        <a:pt x="2304" y="416"/>
                      </a:lnTo>
                      <a:lnTo>
                        <a:pt x="2307" y="416"/>
                      </a:lnTo>
                      <a:lnTo>
                        <a:pt x="2311" y="416"/>
                      </a:lnTo>
                      <a:lnTo>
                        <a:pt x="2315" y="416"/>
                      </a:lnTo>
                      <a:lnTo>
                        <a:pt x="2319" y="416"/>
                      </a:lnTo>
                      <a:lnTo>
                        <a:pt x="2322" y="416"/>
                      </a:lnTo>
                      <a:lnTo>
                        <a:pt x="2326" y="415"/>
                      </a:lnTo>
                      <a:lnTo>
                        <a:pt x="2330" y="415"/>
                      </a:lnTo>
                      <a:lnTo>
                        <a:pt x="2334" y="415"/>
                      </a:lnTo>
                      <a:lnTo>
                        <a:pt x="2337" y="415"/>
                      </a:lnTo>
                      <a:lnTo>
                        <a:pt x="2341" y="414"/>
                      </a:lnTo>
                      <a:lnTo>
                        <a:pt x="2345" y="414"/>
                      </a:lnTo>
                      <a:lnTo>
                        <a:pt x="2349" y="413"/>
                      </a:lnTo>
                      <a:lnTo>
                        <a:pt x="2352" y="413"/>
                      </a:lnTo>
                      <a:lnTo>
                        <a:pt x="2356" y="414"/>
                      </a:lnTo>
                      <a:lnTo>
                        <a:pt x="2360" y="413"/>
                      </a:lnTo>
                      <a:lnTo>
                        <a:pt x="2364" y="413"/>
                      </a:lnTo>
                      <a:lnTo>
                        <a:pt x="2368" y="414"/>
                      </a:lnTo>
                      <a:lnTo>
                        <a:pt x="2371" y="414"/>
                      </a:lnTo>
                      <a:lnTo>
                        <a:pt x="2375" y="414"/>
                      </a:lnTo>
                      <a:lnTo>
                        <a:pt x="2379" y="414"/>
                      </a:lnTo>
                      <a:lnTo>
                        <a:pt x="2382" y="415"/>
                      </a:lnTo>
                      <a:lnTo>
                        <a:pt x="2386" y="414"/>
                      </a:lnTo>
                      <a:lnTo>
                        <a:pt x="2390" y="415"/>
                      </a:lnTo>
                      <a:lnTo>
                        <a:pt x="2394" y="414"/>
                      </a:lnTo>
                      <a:lnTo>
                        <a:pt x="2398" y="414"/>
                      </a:lnTo>
                      <a:lnTo>
                        <a:pt x="2401" y="415"/>
                      </a:lnTo>
                      <a:lnTo>
                        <a:pt x="2405" y="415"/>
                      </a:lnTo>
                      <a:lnTo>
                        <a:pt x="2409" y="415"/>
                      </a:lnTo>
                      <a:lnTo>
                        <a:pt x="2413" y="414"/>
                      </a:lnTo>
                      <a:lnTo>
                        <a:pt x="2416" y="415"/>
                      </a:lnTo>
                      <a:lnTo>
                        <a:pt x="2420" y="415"/>
                      </a:lnTo>
                      <a:lnTo>
                        <a:pt x="2424" y="414"/>
                      </a:lnTo>
                      <a:lnTo>
                        <a:pt x="2428" y="414"/>
                      </a:lnTo>
                      <a:lnTo>
                        <a:pt x="2431" y="414"/>
                      </a:lnTo>
                      <a:lnTo>
                        <a:pt x="2435" y="415"/>
                      </a:lnTo>
                      <a:lnTo>
                        <a:pt x="2439" y="415"/>
                      </a:lnTo>
                      <a:lnTo>
                        <a:pt x="2443" y="414"/>
                      </a:lnTo>
                      <a:lnTo>
                        <a:pt x="2446" y="414"/>
                      </a:lnTo>
                      <a:lnTo>
                        <a:pt x="2450" y="413"/>
                      </a:lnTo>
                      <a:lnTo>
                        <a:pt x="2454" y="413"/>
                      </a:lnTo>
                      <a:lnTo>
                        <a:pt x="2458" y="413"/>
                      </a:lnTo>
                      <a:lnTo>
                        <a:pt x="2461" y="412"/>
                      </a:lnTo>
                      <a:lnTo>
                        <a:pt x="2465" y="413"/>
                      </a:lnTo>
                      <a:lnTo>
                        <a:pt x="2469" y="412"/>
                      </a:lnTo>
                      <a:lnTo>
                        <a:pt x="2473" y="412"/>
                      </a:lnTo>
                      <a:lnTo>
                        <a:pt x="2476" y="411"/>
                      </a:lnTo>
                      <a:lnTo>
                        <a:pt x="2480" y="411"/>
                      </a:lnTo>
                      <a:lnTo>
                        <a:pt x="2484" y="410"/>
                      </a:lnTo>
                      <a:lnTo>
                        <a:pt x="2488" y="409"/>
                      </a:lnTo>
                      <a:lnTo>
                        <a:pt x="2492" y="409"/>
                      </a:lnTo>
                      <a:lnTo>
                        <a:pt x="2495" y="408"/>
                      </a:lnTo>
                      <a:lnTo>
                        <a:pt x="2499" y="407"/>
                      </a:lnTo>
                      <a:lnTo>
                        <a:pt x="2503" y="406"/>
                      </a:lnTo>
                      <a:lnTo>
                        <a:pt x="2507" y="405"/>
                      </a:lnTo>
                      <a:lnTo>
                        <a:pt x="2510" y="406"/>
                      </a:lnTo>
                      <a:lnTo>
                        <a:pt x="2514" y="405"/>
                      </a:lnTo>
                      <a:lnTo>
                        <a:pt x="2518" y="405"/>
                      </a:lnTo>
                      <a:lnTo>
                        <a:pt x="2522" y="405"/>
                      </a:lnTo>
                      <a:lnTo>
                        <a:pt x="2525" y="406"/>
                      </a:lnTo>
                      <a:lnTo>
                        <a:pt x="2529" y="406"/>
                      </a:lnTo>
                      <a:lnTo>
                        <a:pt x="2533" y="406"/>
                      </a:lnTo>
                      <a:lnTo>
                        <a:pt x="2537" y="406"/>
                      </a:lnTo>
                      <a:lnTo>
                        <a:pt x="2540" y="407"/>
                      </a:lnTo>
                      <a:lnTo>
                        <a:pt x="2544" y="408"/>
                      </a:lnTo>
                      <a:lnTo>
                        <a:pt x="2548" y="408"/>
                      </a:lnTo>
                      <a:lnTo>
                        <a:pt x="2552" y="409"/>
                      </a:lnTo>
                      <a:lnTo>
                        <a:pt x="2555" y="409"/>
                      </a:lnTo>
                      <a:lnTo>
                        <a:pt x="2559" y="410"/>
                      </a:lnTo>
                      <a:lnTo>
                        <a:pt x="2563" y="410"/>
                      </a:lnTo>
                      <a:lnTo>
                        <a:pt x="2567" y="411"/>
                      </a:lnTo>
                      <a:lnTo>
                        <a:pt x="2571" y="412"/>
                      </a:lnTo>
                      <a:lnTo>
                        <a:pt x="2574" y="412"/>
                      </a:lnTo>
                      <a:lnTo>
                        <a:pt x="2578" y="412"/>
                      </a:lnTo>
                      <a:lnTo>
                        <a:pt x="2582" y="413"/>
                      </a:lnTo>
                      <a:lnTo>
                        <a:pt x="2585" y="413"/>
                      </a:lnTo>
                      <a:lnTo>
                        <a:pt x="2589" y="412"/>
                      </a:lnTo>
                      <a:lnTo>
                        <a:pt x="2593" y="413"/>
                      </a:lnTo>
                      <a:lnTo>
                        <a:pt x="2597" y="413"/>
                      </a:lnTo>
                      <a:lnTo>
                        <a:pt x="2600" y="413"/>
                      </a:lnTo>
                      <a:lnTo>
                        <a:pt x="2604" y="413"/>
                      </a:lnTo>
                      <a:lnTo>
                        <a:pt x="2608" y="412"/>
                      </a:lnTo>
                      <a:lnTo>
                        <a:pt x="2612" y="412"/>
                      </a:lnTo>
                      <a:lnTo>
                        <a:pt x="2616" y="412"/>
                      </a:lnTo>
                      <a:lnTo>
                        <a:pt x="2619" y="413"/>
                      </a:lnTo>
                      <a:lnTo>
                        <a:pt x="2623" y="413"/>
                      </a:lnTo>
                      <a:lnTo>
                        <a:pt x="2627" y="412"/>
                      </a:lnTo>
                      <a:lnTo>
                        <a:pt x="2631" y="412"/>
                      </a:lnTo>
                      <a:lnTo>
                        <a:pt x="2634" y="413"/>
                      </a:lnTo>
                      <a:lnTo>
                        <a:pt x="2638" y="412"/>
                      </a:lnTo>
                      <a:lnTo>
                        <a:pt x="2642" y="413"/>
                      </a:lnTo>
                      <a:lnTo>
                        <a:pt x="2646" y="412"/>
                      </a:lnTo>
                      <a:lnTo>
                        <a:pt x="2649" y="413"/>
                      </a:lnTo>
                      <a:lnTo>
                        <a:pt x="2653" y="412"/>
                      </a:lnTo>
                      <a:lnTo>
                        <a:pt x="2657" y="411"/>
                      </a:lnTo>
                      <a:lnTo>
                        <a:pt x="2661" y="411"/>
                      </a:lnTo>
                      <a:lnTo>
                        <a:pt x="2664" y="411"/>
                      </a:lnTo>
                      <a:lnTo>
                        <a:pt x="2668" y="411"/>
                      </a:lnTo>
                      <a:lnTo>
                        <a:pt x="2672" y="412"/>
                      </a:lnTo>
                      <a:lnTo>
                        <a:pt x="2676" y="412"/>
                      </a:lnTo>
                      <a:lnTo>
                        <a:pt x="2679" y="411"/>
                      </a:lnTo>
                      <a:lnTo>
                        <a:pt x="2683" y="412"/>
                      </a:lnTo>
                      <a:lnTo>
                        <a:pt x="2687" y="411"/>
                      </a:lnTo>
                      <a:lnTo>
                        <a:pt x="2691" y="411"/>
                      </a:lnTo>
                      <a:lnTo>
                        <a:pt x="2695" y="411"/>
                      </a:lnTo>
                      <a:lnTo>
                        <a:pt x="2698" y="410"/>
                      </a:lnTo>
                      <a:lnTo>
                        <a:pt x="2702" y="410"/>
                      </a:lnTo>
                      <a:lnTo>
                        <a:pt x="2706" y="410"/>
                      </a:lnTo>
                      <a:lnTo>
                        <a:pt x="2709" y="411"/>
                      </a:lnTo>
                      <a:lnTo>
                        <a:pt x="2713" y="411"/>
                      </a:lnTo>
                      <a:lnTo>
                        <a:pt x="2717" y="410"/>
                      </a:lnTo>
                      <a:lnTo>
                        <a:pt x="2721" y="410"/>
                      </a:lnTo>
                      <a:lnTo>
                        <a:pt x="2724" y="411"/>
                      </a:lnTo>
                      <a:lnTo>
                        <a:pt x="2728" y="410"/>
                      </a:lnTo>
                      <a:lnTo>
                        <a:pt x="2732" y="410"/>
                      </a:lnTo>
                      <a:lnTo>
                        <a:pt x="2736" y="410"/>
                      </a:lnTo>
                      <a:lnTo>
                        <a:pt x="2740" y="410"/>
                      </a:lnTo>
                      <a:lnTo>
                        <a:pt x="2743" y="409"/>
                      </a:lnTo>
                      <a:lnTo>
                        <a:pt x="2747" y="410"/>
                      </a:lnTo>
                      <a:lnTo>
                        <a:pt x="2751" y="411"/>
                      </a:lnTo>
                      <a:lnTo>
                        <a:pt x="2755" y="410"/>
                      </a:lnTo>
                      <a:lnTo>
                        <a:pt x="2758" y="409"/>
                      </a:lnTo>
                      <a:lnTo>
                        <a:pt x="2762" y="410"/>
                      </a:lnTo>
                      <a:lnTo>
                        <a:pt x="2766" y="409"/>
                      </a:lnTo>
                      <a:lnTo>
                        <a:pt x="2770" y="410"/>
                      </a:lnTo>
                      <a:lnTo>
                        <a:pt x="2773" y="410"/>
                      </a:lnTo>
                      <a:lnTo>
                        <a:pt x="2777" y="410"/>
                      </a:lnTo>
                      <a:lnTo>
                        <a:pt x="2781" y="411"/>
                      </a:lnTo>
                      <a:lnTo>
                        <a:pt x="2785" y="409"/>
                      </a:lnTo>
                      <a:lnTo>
                        <a:pt x="2788" y="410"/>
                      </a:lnTo>
                      <a:lnTo>
                        <a:pt x="2792" y="411"/>
                      </a:lnTo>
                      <a:lnTo>
                        <a:pt x="2796" y="410"/>
                      </a:lnTo>
                      <a:lnTo>
                        <a:pt x="2800" y="411"/>
                      </a:lnTo>
                      <a:lnTo>
                        <a:pt x="2803" y="410"/>
                      </a:lnTo>
                      <a:lnTo>
                        <a:pt x="2807" y="410"/>
                      </a:lnTo>
                      <a:lnTo>
                        <a:pt x="2811" y="410"/>
                      </a:lnTo>
                      <a:lnTo>
                        <a:pt x="2815" y="410"/>
                      </a:lnTo>
                      <a:lnTo>
                        <a:pt x="2819" y="411"/>
                      </a:lnTo>
                      <a:lnTo>
                        <a:pt x="2822" y="410"/>
                      </a:lnTo>
                      <a:lnTo>
                        <a:pt x="2826" y="410"/>
                      </a:lnTo>
                      <a:lnTo>
                        <a:pt x="2830" y="410"/>
                      </a:lnTo>
                      <a:lnTo>
                        <a:pt x="2833" y="410"/>
                      </a:lnTo>
                      <a:lnTo>
                        <a:pt x="2837" y="410"/>
                      </a:lnTo>
                      <a:lnTo>
                        <a:pt x="2841" y="411"/>
                      </a:lnTo>
                      <a:lnTo>
                        <a:pt x="2845" y="410"/>
                      </a:lnTo>
                      <a:lnTo>
                        <a:pt x="2848" y="411"/>
                      </a:lnTo>
                      <a:lnTo>
                        <a:pt x="2852" y="411"/>
                      </a:lnTo>
                      <a:lnTo>
                        <a:pt x="2856" y="411"/>
                      </a:lnTo>
                      <a:lnTo>
                        <a:pt x="2860" y="411"/>
                      </a:lnTo>
                      <a:lnTo>
                        <a:pt x="2864" y="411"/>
                      </a:lnTo>
                      <a:lnTo>
                        <a:pt x="2867" y="411"/>
                      </a:lnTo>
                      <a:lnTo>
                        <a:pt x="2871" y="411"/>
                      </a:lnTo>
                      <a:lnTo>
                        <a:pt x="2875" y="411"/>
                      </a:lnTo>
                      <a:lnTo>
                        <a:pt x="2879" y="411"/>
                      </a:lnTo>
                      <a:lnTo>
                        <a:pt x="2882" y="411"/>
                      </a:lnTo>
                      <a:lnTo>
                        <a:pt x="2886" y="412"/>
                      </a:lnTo>
                      <a:lnTo>
                        <a:pt x="2890" y="412"/>
                      </a:lnTo>
                      <a:lnTo>
                        <a:pt x="2894" y="412"/>
                      </a:lnTo>
                      <a:lnTo>
                        <a:pt x="2897" y="412"/>
                      </a:lnTo>
                      <a:lnTo>
                        <a:pt x="2901" y="411"/>
                      </a:lnTo>
                      <a:lnTo>
                        <a:pt x="2905" y="412"/>
                      </a:lnTo>
                      <a:lnTo>
                        <a:pt x="2909" y="412"/>
                      </a:lnTo>
                      <a:lnTo>
                        <a:pt x="2912" y="413"/>
                      </a:lnTo>
                      <a:lnTo>
                        <a:pt x="2916" y="411"/>
                      </a:lnTo>
                      <a:lnTo>
                        <a:pt x="2920" y="412"/>
                      </a:lnTo>
                      <a:lnTo>
                        <a:pt x="2924" y="411"/>
                      </a:lnTo>
                      <a:lnTo>
                        <a:pt x="2927" y="412"/>
                      </a:lnTo>
                      <a:lnTo>
                        <a:pt x="2931" y="412"/>
                      </a:lnTo>
                      <a:lnTo>
                        <a:pt x="2935" y="411"/>
                      </a:lnTo>
                      <a:lnTo>
                        <a:pt x="2939" y="412"/>
                      </a:lnTo>
                      <a:lnTo>
                        <a:pt x="2942" y="412"/>
                      </a:lnTo>
                      <a:lnTo>
                        <a:pt x="2946" y="412"/>
                      </a:lnTo>
                      <a:lnTo>
                        <a:pt x="2950" y="413"/>
                      </a:lnTo>
                      <a:lnTo>
                        <a:pt x="2954" y="412"/>
                      </a:lnTo>
                      <a:lnTo>
                        <a:pt x="2958" y="413"/>
                      </a:lnTo>
                      <a:lnTo>
                        <a:pt x="2961" y="411"/>
                      </a:lnTo>
                      <a:lnTo>
                        <a:pt x="2965" y="412"/>
                      </a:lnTo>
                      <a:lnTo>
                        <a:pt x="2969" y="412"/>
                      </a:lnTo>
                      <a:lnTo>
                        <a:pt x="2972" y="412"/>
                      </a:lnTo>
                      <a:lnTo>
                        <a:pt x="2976" y="412"/>
                      </a:lnTo>
                      <a:lnTo>
                        <a:pt x="2980" y="412"/>
                      </a:lnTo>
                      <a:lnTo>
                        <a:pt x="2984" y="412"/>
                      </a:lnTo>
                      <a:lnTo>
                        <a:pt x="2988" y="412"/>
                      </a:lnTo>
                      <a:lnTo>
                        <a:pt x="2991" y="412"/>
                      </a:lnTo>
                      <a:lnTo>
                        <a:pt x="2995" y="411"/>
                      </a:lnTo>
                      <a:lnTo>
                        <a:pt x="2999" y="411"/>
                      </a:lnTo>
                      <a:lnTo>
                        <a:pt x="3003" y="411"/>
                      </a:lnTo>
                      <a:lnTo>
                        <a:pt x="3006" y="412"/>
                      </a:lnTo>
                      <a:lnTo>
                        <a:pt x="3010" y="412"/>
                      </a:lnTo>
                      <a:lnTo>
                        <a:pt x="3014" y="412"/>
                      </a:lnTo>
                      <a:lnTo>
                        <a:pt x="3018" y="412"/>
                      </a:lnTo>
                      <a:lnTo>
                        <a:pt x="3021" y="412"/>
                      </a:lnTo>
                      <a:lnTo>
                        <a:pt x="3025" y="412"/>
                      </a:lnTo>
                      <a:lnTo>
                        <a:pt x="3029" y="412"/>
                      </a:lnTo>
                      <a:lnTo>
                        <a:pt x="3033" y="411"/>
                      </a:lnTo>
                      <a:lnTo>
                        <a:pt x="3036" y="412"/>
                      </a:lnTo>
                      <a:lnTo>
                        <a:pt x="3040" y="412"/>
                      </a:lnTo>
                      <a:lnTo>
                        <a:pt x="3044" y="412"/>
                      </a:lnTo>
                      <a:lnTo>
                        <a:pt x="3048" y="412"/>
                      </a:lnTo>
                      <a:lnTo>
                        <a:pt x="3051" y="411"/>
                      </a:lnTo>
                      <a:lnTo>
                        <a:pt x="3055" y="412"/>
                      </a:lnTo>
                      <a:lnTo>
                        <a:pt x="3059" y="412"/>
                      </a:lnTo>
                      <a:lnTo>
                        <a:pt x="3063" y="412"/>
                      </a:lnTo>
                      <a:lnTo>
                        <a:pt x="3066" y="411"/>
                      </a:lnTo>
                      <a:lnTo>
                        <a:pt x="3070" y="412"/>
                      </a:lnTo>
                      <a:lnTo>
                        <a:pt x="3074" y="411"/>
                      </a:lnTo>
                      <a:lnTo>
                        <a:pt x="3078" y="412"/>
                      </a:lnTo>
                      <a:lnTo>
                        <a:pt x="3082" y="411"/>
                      </a:lnTo>
                      <a:lnTo>
                        <a:pt x="3085" y="412"/>
                      </a:lnTo>
                      <a:lnTo>
                        <a:pt x="3089" y="411"/>
                      </a:lnTo>
                      <a:lnTo>
                        <a:pt x="3093" y="411"/>
                      </a:lnTo>
                      <a:lnTo>
                        <a:pt x="3096" y="411"/>
                      </a:lnTo>
                      <a:lnTo>
                        <a:pt x="3100" y="411"/>
                      </a:lnTo>
                      <a:lnTo>
                        <a:pt x="3104" y="411"/>
                      </a:lnTo>
                      <a:lnTo>
                        <a:pt x="3108" y="411"/>
                      </a:lnTo>
                      <a:lnTo>
                        <a:pt x="3112" y="411"/>
                      </a:lnTo>
                      <a:lnTo>
                        <a:pt x="3115" y="411"/>
                      </a:lnTo>
                      <a:lnTo>
                        <a:pt x="3119" y="411"/>
                      </a:lnTo>
                      <a:lnTo>
                        <a:pt x="3123" y="412"/>
                      </a:lnTo>
                      <a:lnTo>
                        <a:pt x="3127" y="412"/>
                      </a:lnTo>
                      <a:lnTo>
                        <a:pt x="3130" y="412"/>
                      </a:lnTo>
                      <a:lnTo>
                        <a:pt x="3134" y="411"/>
                      </a:lnTo>
                      <a:lnTo>
                        <a:pt x="3138" y="411"/>
                      </a:lnTo>
                      <a:lnTo>
                        <a:pt x="3142" y="411"/>
                      </a:lnTo>
                      <a:lnTo>
                        <a:pt x="3145" y="411"/>
                      </a:lnTo>
                      <a:lnTo>
                        <a:pt x="3149" y="410"/>
                      </a:lnTo>
                      <a:lnTo>
                        <a:pt x="3153" y="410"/>
                      </a:lnTo>
                      <a:lnTo>
                        <a:pt x="3157" y="411"/>
                      </a:lnTo>
                      <a:lnTo>
                        <a:pt x="3160" y="411"/>
                      </a:lnTo>
                      <a:lnTo>
                        <a:pt x="3164" y="411"/>
                      </a:lnTo>
                      <a:lnTo>
                        <a:pt x="3168" y="411"/>
                      </a:lnTo>
                      <a:lnTo>
                        <a:pt x="3172" y="411"/>
                      </a:lnTo>
                      <a:lnTo>
                        <a:pt x="3175" y="411"/>
                      </a:lnTo>
                      <a:lnTo>
                        <a:pt x="3179" y="411"/>
                      </a:lnTo>
                      <a:lnTo>
                        <a:pt x="3183" y="411"/>
                      </a:lnTo>
                      <a:lnTo>
                        <a:pt x="3187" y="410"/>
                      </a:lnTo>
                      <a:lnTo>
                        <a:pt x="3190" y="410"/>
                      </a:lnTo>
                      <a:lnTo>
                        <a:pt x="3194" y="411"/>
                      </a:lnTo>
                      <a:lnTo>
                        <a:pt x="3198" y="411"/>
                      </a:lnTo>
                      <a:lnTo>
                        <a:pt x="3202" y="410"/>
                      </a:lnTo>
                      <a:lnTo>
                        <a:pt x="3206" y="410"/>
                      </a:lnTo>
                      <a:lnTo>
                        <a:pt x="3209" y="410"/>
                      </a:lnTo>
                      <a:lnTo>
                        <a:pt x="3213" y="410"/>
                      </a:lnTo>
                      <a:lnTo>
                        <a:pt x="3217" y="411"/>
                      </a:lnTo>
                      <a:lnTo>
                        <a:pt x="3220" y="410"/>
                      </a:lnTo>
                      <a:lnTo>
                        <a:pt x="3224" y="410"/>
                      </a:lnTo>
                      <a:lnTo>
                        <a:pt x="3228" y="410"/>
                      </a:lnTo>
                      <a:lnTo>
                        <a:pt x="3232" y="410"/>
                      </a:lnTo>
                      <a:lnTo>
                        <a:pt x="3236" y="410"/>
                      </a:lnTo>
                      <a:lnTo>
                        <a:pt x="3239" y="410"/>
                      </a:lnTo>
                      <a:lnTo>
                        <a:pt x="3243" y="410"/>
                      </a:lnTo>
                      <a:lnTo>
                        <a:pt x="3247" y="409"/>
                      </a:lnTo>
                      <a:lnTo>
                        <a:pt x="3251" y="410"/>
                      </a:lnTo>
                      <a:lnTo>
                        <a:pt x="3254" y="410"/>
                      </a:lnTo>
                      <a:lnTo>
                        <a:pt x="3258" y="410"/>
                      </a:lnTo>
                      <a:lnTo>
                        <a:pt x="3262" y="410"/>
                      </a:lnTo>
                      <a:lnTo>
                        <a:pt x="3266" y="410"/>
                      </a:lnTo>
                      <a:lnTo>
                        <a:pt x="3269" y="410"/>
                      </a:lnTo>
                      <a:lnTo>
                        <a:pt x="3273" y="410"/>
                      </a:lnTo>
                      <a:lnTo>
                        <a:pt x="3277" y="410"/>
                      </a:lnTo>
                      <a:lnTo>
                        <a:pt x="3281" y="409"/>
                      </a:lnTo>
                      <a:lnTo>
                        <a:pt x="3284" y="410"/>
                      </a:lnTo>
                      <a:lnTo>
                        <a:pt x="3288" y="409"/>
                      </a:lnTo>
                      <a:lnTo>
                        <a:pt x="3292" y="409"/>
                      </a:lnTo>
                      <a:lnTo>
                        <a:pt x="3296" y="409"/>
                      </a:lnTo>
                      <a:lnTo>
                        <a:pt x="3299" y="409"/>
                      </a:lnTo>
                      <a:lnTo>
                        <a:pt x="3303" y="409"/>
                      </a:lnTo>
                      <a:lnTo>
                        <a:pt x="3307" y="409"/>
                      </a:lnTo>
                      <a:lnTo>
                        <a:pt x="3311" y="409"/>
                      </a:lnTo>
                      <a:lnTo>
                        <a:pt x="3314" y="408"/>
                      </a:lnTo>
                      <a:lnTo>
                        <a:pt x="3318" y="408"/>
                      </a:lnTo>
                      <a:lnTo>
                        <a:pt x="3322" y="408"/>
                      </a:lnTo>
                      <a:lnTo>
                        <a:pt x="3326" y="409"/>
                      </a:lnTo>
                      <a:lnTo>
                        <a:pt x="3330" y="409"/>
                      </a:lnTo>
                      <a:lnTo>
                        <a:pt x="3333" y="408"/>
                      </a:lnTo>
                      <a:lnTo>
                        <a:pt x="3337" y="409"/>
                      </a:lnTo>
                      <a:lnTo>
                        <a:pt x="3341" y="408"/>
                      </a:lnTo>
                      <a:lnTo>
                        <a:pt x="3345" y="408"/>
                      </a:lnTo>
                      <a:lnTo>
                        <a:pt x="3348" y="408"/>
                      </a:lnTo>
                      <a:lnTo>
                        <a:pt x="3352" y="408"/>
                      </a:lnTo>
                      <a:lnTo>
                        <a:pt x="3356" y="408"/>
                      </a:lnTo>
                      <a:lnTo>
                        <a:pt x="3360" y="407"/>
                      </a:lnTo>
                      <a:lnTo>
                        <a:pt x="3363" y="408"/>
                      </a:lnTo>
                      <a:lnTo>
                        <a:pt x="3367" y="407"/>
                      </a:lnTo>
                      <a:lnTo>
                        <a:pt x="3371" y="408"/>
                      </a:lnTo>
                      <a:lnTo>
                        <a:pt x="3375" y="407"/>
                      </a:lnTo>
                      <a:lnTo>
                        <a:pt x="3378" y="407"/>
                      </a:lnTo>
                      <a:lnTo>
                        <a:pt x="3382" y="407"/>
                      </a:lnTo>
                      <a:lnTo>
                        <a:pt x="3386" y="407"/>
                      </a:lnTo>
                      <a:lnTo>
                        <a:pt x="3390" y="407"/>
                      </a:lnTo>
                      <a:lnTo>
                        <a:pt x="3393" y="407"/>
                      </a:lnTo>
                      <a:lnTo>
                        <a:pt x="3397" y="406"/>
                      </a:lnTo>
                      <a:lnTo>
                        <a:pt x="3401" y="406"/>
                      </a:lnTo>
                      <a:lnTo>
                        <a:pt x="3405" y="406"/>
                      </a:lnTo>
                      <a:lnTo>
                        <a:pt x="3409" y="405"/>
                      </a:lnTo>
                      <a:lnTo>
                        <a:pt x="3412" y="406"/>
                      </a:lnTo>
                      <a:lnTo>
                        <a:pt x="3416" y="406"/>
                      </a:lnTo>
                      <a:lnTo>
                        <a:pt x="3420" y="406"/>
                      </a:lnTo>
                      <a:lnTo>
                        <a:pt x="3423" y="405"/>
                      </a:lnTo>
                      <a:lnTo>
                        <a:pt x="3427" y="405"/>
                      </a:lnTo>
                      <a:lnTo>
                        <a:pt x="3431" y="405"/>
                      </a:lnTo>
                      <a:lnTo>
                        <a:pt x="3435" y="405"/>
                      </a:lnTo>
                      <a:lnTo>
                        <a:pt x="3438" y="404"/>
                      </a:lnTo>
                      <a:lnTo>
                        <a:pt x="3442" y="404"/>
                      </a:lnTo>
                      <a:lnTo>
                        <a:pt x="3446" y="404"/>
                      </a:lnTo>
                      <a:lnTo>
                        <a:pt x="3450" y="404"/>
                      </a:lnTo>
                      <a:lnTo>
                        <a:pt x="3454" y="404"/>
                      </a:lnTo>
                      <a:lnTo>
                        <a:pt x="3457" y="404"/>
                      </a:lnTo>
                      <a:lnTo>
                        <a:pt x="3461" y="403"/>
                      </a:lnTo>
                      <a:lnTo>
                        <a:pt x="3465" y="404"/>
                      </a:lnTo>
                      <a:lnTo>
                        <a:pt x="3469" y="403"/>
                      </a:lnTo>
                      <a:lnTo>
                        <a:pt x="3472" y="403"/>
                      </a:lnTo>
                      <a:lnTo>
                        <a:pt x="3476" y="403"/>
                      </a:lnTo>
                      <a:lnTo>
                        <a:pt x="3480" y="403"/>
                      </a:lnTo>
                      <a:lnTo>
                        <a:pt x="3483" y="402"/>
                      </a:lnTo>
                      <a:lnTo>
                        <a:pt x="3487" y="402"/>
                      </a:lnTo>
                      <a:lnTo>
                        <a:pt x="3491" y="402"/>
                      </a:lnTo>
                      <a:lnTo>
                        <a:pt x="3495" y="402"/>
                      </a:lnTo>
                      <a:lnTo>
                        <a:pt x="3499" y="402"/>
                      </a:lnTo>
                      <a:lnTo>
                        <a:pt x="3502" y="401"/>
                      </a:lnTo>
                      <a:lnTo>
                        <a:pt x="3506" y="401"/>
                      </a:lnTo>
                      <a:lnTo>
                        <a:pt x="3510" y="401"/>
                      </a:lnTo>
                      <a:lnTo>
                        <a:pt x="3514" y="401"/>
                      </a:lnTo>
                      <a:lnTo>
                        <a:pt x="3517" y="400"/>
                      </a:lnTo>
                      <a:lnTo>
                        <a:pt x="3521" y="401"/>
                      </a:lnTo>
                      <a:lnTo>
                        <a:pt x="3525" y="401"/>
                      </a:lnTo>
                      <a:lnTo>
                        <a:pt x="3529" y="400"/>
                      </a:lnTo>
                      <a:lnTo>
                        <a:pt x="3533" y="400"/>
                      </a:lnTo>
                      <a:lnTo>
                        <a:pt x="3536" y="401"/>
                      </a:lnTo>
                      <a:lnTo>
                        <a:pt x="3540" y="400"/>
                      </a:lnTo>
                      <a:lnTo>
                        <a:pt x="3544" y="400"/>
                      </a:lnTo>
                      <a:lnTo>
                        <a:pt x="3547" y="400"/>
                      </a:lnTo>
                      <a:lnTo>
                        <a:pt x="3551" y="400"/>
                      </a:lnTo>
                      <a:lnTo>
                        <a:pt x="3555" y="400"/>
                      </a:lnTo>
                      <a:lnTo>
                        <a:pt x="3559" y="400"/>
                      </a:lnTo>
                      <a:lnTo>
                        <a:pt x="3562" y="400"/>
                      </a:lnTo>
                      <a:lnTo>
                        <a:pt x="3566" y="399"/>
                      </a:lnTo>
                      <a:lnTo>
                        <a:pt x="3570" y="400"/>
                      </a:lnTo>
                      <a:lnTo>
                        <a:pt x="3574" y="399"/>
                      </a:lnTo>
                      <a:lnTo>
                        <a:pt x="3578" y="399"/>
                      </a:lnTo>
                      <a:lnTo>
                        <a:pt x="3581" y="399"/>
                      </a:lnTo>
                      <a:lnTo>
                        <a:pt x="3585" y="399"/>
                      </a:lnTo>
                      <a:lnTo>
                        <a:pt x="3589" y="399"/>
                      </a:lnTo>
                      <a:lnTo>
                        <a:pt x="3593" y="399"/>
                      </a:lnTo>
                      <a:lnTo>
                        <a:pt x="3596" y="399"/>
                      </a:lnTo>
                      <a:lnTo>
                        <a:pt x="3600" y="398"/>
                      </a:lnTo>
                      <a:lnTo>
                        <a:pt x="3604" y="399"/>
                      </a:lnTo>
                      <a:lnTo>
                        <a:pt x="3607" y="397"/>
                      </a:lnTo>
                      <a:lnTo>
                        <a:pt x="3611" y="397"/>
                      </a:lnTo>
                      <a:lnTo>
                        <a:pt x="3615" y="397"/>
                      </a:lnTo>
                      <a:lnTo>
                        <a:pt x="3619" y="397"/>
                      </a:lnTo>
                      <a:lnTo>
                        <a:pt x="3623" y="396"/>
                      </a:lnTo>
                      <a:lnTo>
                        <a:pt x="3626" y="397"/>
                      </a:lnTo>
                      <a:lnTo>
                        <a:pt x="3630" y="396"/>
                      </a:lnTo>
                      <a:lnTo>
                        <a:pt x="3634" y="397"/>
                      </a:lnTo>
                      <a:lnTo>
                        <a:pt x="3638" y="395"/>
                      </a:lnTo>
                      <a:lnTo>
                        <a:pt x="3641" y="395"/>
                      </a:lnTo>
                      <a:lnTo>
                        <a:pt x="3645" y="394"/>
                      </a:lnTo>
                      <a:lnTo>
                        <a:pt x="3649" y="394"/>
                      </a:lnTo>
                      <a:lnTo>
                        <a:pt x="3653" y="393"/>
                      </a:lnTo>
                      <a:lnTo>
                        <a:pt x="3656" y="393"/>
                      </a:lnTo>
                      <a:lnTo>
                        <a:pt x="3660" y="391"/>
                      </a:lnTo>
                      <a:lnTo>
                        <a:pt x="3664" y="392"/>
                      </a:lnTo>
                      <a:lnTo>
                        <a:pt x="3668" y="390"/>
                      </a:lnTo>
                      <a:lnTo>
                        <a:pt x="3671" y="390"/>
                      </a:lnTo>
                      <a:lnTo>
                        <a:pt x="3675" y="389"/>
                      </a:lnTo>
                      <a:lnTo>
                        <a:pt x="3679" y="390"/>
                      </a:lnTo>
                      <a:lnTo>
                        <a:pt x="3683" y="387"/>
                      </a:lnTo>
                      <a:lnTo>
                        <a:pt x="3686" y="387"/>
                      </a:lnTo>
                      <a:lnTo>
                        <a:pt x="3690" y="386"/>
                      </a:lnTo>
                      <a:lnTo>
                        <a:pt x="3694" y="386"/>
                      </a:lnTo>
                      <a:lnTo>
                        <a:pt x="3698" y="385"/>
                      </a:lnTo>
                      <a:lnTo>
                        <a:pt x="3702" y="384"/>
                      </a:lnTo>
                      <a:lnTo>
                        <a:pt x="3705" y="384"/>
                      </a:lnTo>
                      <a:lnTo>
                        <a:pt x="3709" y="384"/>
                      </a:lnTo>
                      <a:lnTo>
                        <a:pt x="3713" y="382"/>
                      </a:lnTo>
                      <a:lnTo>
                        <a:pt x="3717" y="381"/>
                      </a:lnTo>
                      <a:lnTo>
                        <a:pt x="3720" y="380"/>
                      </a:lnTo>
                      <a:lnTo>
                        <a:pt x="3724" y="379"/>
                      </a:lnTo>
                      <a:lnTo>
                        <a:pt x="3728" y="378"/>
                      </a:lnTo>
                      <a:lnTo>
                        <a:pt x="3731" y="377"/>
                      </a:lnTo>
                      <a:lnTo>
                        <a:pt x="3735" y="377"/>
                      </a:lnTo>
                      <a:lnTo>
                        <a:pt x="3739" y="377"/>
                      </a:lnTo>
                      <a:lnTo>
                        <a:pt x="3743" y="375"/>
                      </a:lnTo>
                      <a:lnTo>
                        <a:pt x="3747" y="375"/>
                      </a:lnTo>
                      <a:lnTo>
                        <a:pt x="3750" y="374"/>
                      </a:lnTo>
                      <a:lnTo>
                        <a:pt x="3754" y="373"/>
                      </a:lnTo>
                      <a:lnTo>
                        <a:pt x="3758" y="372"/>
                      </a:lnTo>
                      <a:lnTo>
                        <a:pt x="3762" y="371"/>
                      </a:lnTo>
                      <a:lnTo>
                        <a:pt x="3765" y="370"/>
                      </a:lnTo>
                      <a:lnTo>
                        <a:pt x="3769" y="369"/>
                      </a:lnTo>
                      <a:lnTo>
                        <a:pt x="3773" y="367"/>
                      </a:lnTo>
                      <a:lnTo>
                        <a:pt x="3777" y="366"/>
                      </a:lnTo>
                      <a:lnTo>
                        <a:pt x="3780" y="364"/>
                      </a:lnTo>
                      <a:lnTo>
                        <a:pt x="3784" y="362"/>
                      </a:lnTo>
                      <a:lnTo>
                        <a:pt x="3788" y="361"/>
                      </a:lnTo>
                      <a:lnTo>
                        <a:pt x="3792" y="357"/>
                      </a:lnTo>
                      <a:lnTo>
                        <a:pt x="3795" y="354"/>
                      </a:lnTo>
                      <a:lnTo>
                        <a:pt x="3799" y="350"/>
                      </a:lnTo>
                      <a:lnTo>
                        <a:pt x="3803" y="345"/>
                      </a:lnTo>
                      <a:lnTo>
                        <a:pt x="3807" y="338"/>
                      </a:lnTo>
                      <a:lnTo>
                        <a:pt x="3810" y="329"/>
                      </a:lnTo>
                      <a:lnTo>
                        <a:pt x="3814" y="319"/>
                      </a:lnTo>
                      <a:lnTo>
                        <a:pt x="3818" y="308"/>
                      </a:lnTo>
                      <a:lnTo>
                        <a:pt x="3822" y="295"/>
                      </a:lnTo>
                      <a:lnTo>
                        <a:pt x="3826" y="279"/>
                      </a:lnTo>
                      <a:lnTo>
                        <a:pt x="3829" y="261"/>
                      </a:lnTo>
                      <a:lnTo>
                        <a:pt x="3833" y="242"/>
                      </a:lnTo>
                      <a:lnTo>
                        <a:pt x="3837" y="222"/>
                      </a:lnTo>
                      <a:lnTo>
                        <a:pt x="3841" y="200"/>
                      </a:lnTo>
                      <a:lnTo>
                        <a:pt x="3844" y="176"/>
                      </a:lnTo>
                      <a:lnTo>
                        <a:pt x="3848" y="154"/>
                      </a:lnTo>
                      <a:lnTo>
                        <a:pt x="3852" y="130"/>
                      </a:lnTo>
                      <a:lnTo>
                        <a:pt x="3856" y="107"/>
                      </a:lnTo>
                      <a:lnTo>
                        <a:pt x="3859" y="85"/>
                      </a:lnTo>
                      <a:lnTo>
                        <a:pt x="3863" y="64"/>
                      </a:lnTo>
                      <a:lnTo>
                        <a:pt x="3867" y="46"/>
                      </a:lnTo>
                      <a:lnTo>
                        <a:pt x="3871" y="30"/>
                      </a:lnTo>
                      <a:lnTo>
                        <a:pt x="3874" y="18"/>
                      </a:lnTo>
                      <a:lnTo>
                        <a:pt x="3878" y="9"/>
                      </a:lnTo>
                      <a:lnTo>
                        <a:pt x="3882" y="3"/>
                      </a:lnTo>
                      <a:lnTo>
                        <a:pt x="3886" y="0"/>
                      </a:lnTo>
                      <a:lnTo>
                        <a:pt x="3889" y="0"/>
                      </a:lnTo>
                      <a:lnTo>
                        <a:pt x="3893" y="3"/>
                      </a:lnTo>
                      <a:lnTo>
                        <a:pt x="3897" y="8"/>
                      </a:lnTo>
                      <a:lnTo>
                        <a:pt x="3901" y="14"/>
                      </a:lnTo>
                      <a:lnTo>
                        <a:pt x="3904" y="23"/>
                      </a:lnTo>
                      <a:lnTo>
                        <a:pt x="3908" y="32"/>
                      </a:lnTo>
                      <a:lnTo>
                        <a:pt x="3912" y="42"/>
                      </a:lnTo>
                      <a:lnTo>
                        <a:pt x="3916" y="54"/>
                      </a:lnTo>
                      <a:lnTo>
                        <a:pt x="3920" y="64"/>
                      </a:lnTo>
                      <a:lnTo>
                        <a:pt x="3923" y="77"/>
                      </a:lnTo>
                      <a:lnTo>
                        <a:pt x="3927" y="89"/>
                      </a:lnTo>
                      <a:lnTo>
                        <a:pt x="3931" y="102"/>
                      </a:lnTo>
                      <a:lnTo>
                        <a:pt x="3934" y="114"/>
                      </a:lnTo>
                      <a:lnTo>
                        <a:pt x="3938" y="126"/>
                      </a:lnTo>
                      <a:lnTo>
                        <a:pt x="3942" y="139"/>
                      </a:lnTo>
                      <a:lnTo>
                        <a:pt x="3946" y="150"/>
                      </a:lnTo>
                      <a:lnTo>
                        <a:pt x="3950" y="163"/>
                      </a:lnTo>
                      <a:lnTo>
                        <a:pt x="3953" y="175"/>
                      </a:lnTo>
                      <a:lnTo>
                        <a:pt x="3957" y="187"/>
                      </a:lnTo>
                      <a:lnTo>
                        <a:pt x="3961" y="197"/>
                      </a:lnTo>
                      <a:lnTo>
                        <a:pt x="3965" y="209"/>
                      </a:lnTo>
                      <a:lnTo>
                        <a:pt x="3968" y="220"/>
                      </a:lnTo>
                      <a:lnTo>
                        <a:pt x="3972" y="230"/>
                      </a:lnTo>
                      <a:lnTo>
                        <a:pt x="3976" y="241"/>
                      </a:lnTo>
                      <a:lnTo>
                        <a:pt x="3980" y="250"/>
                      </a:lnTo>
                      <a:lnTo>
                        <a:pt x="3983" y="259"/>
                      </a:lnTo>
                      <a:lnTo>
                        <a:pt x="3987" y="268"/>
                      </a:lnTo>
                      <a:lnTo>
                        <a:pt x="3991" y="276"/>
                      </a:lnTo>
                      <a:lnTo>
                        <a:pt x="3995" y="285"/>
                      </a:lnTo>
                      <a:lnTo>
                        <a:pt x="3998" y="292"/>
                      </a:lnTo>
                      <a:lnTo>
                        <a:pt x="4002" y="300"/>
                      </a:lnTo>
                      <a:lnTo>
                        <a:pt x="4006" y="307"/>
                      </a:lnTo>
                      <a:lnTo>
                        <a:pt x="4010" y="313"/>
                      </a:lnTo>
                      <a:lnTo>
                        <a:pt x="4013" y="320"/>
                      </a:lnTo>
                      <a:lnTo>
                        <a:pt x="4017" y="325"/>
                      </a:lnTo>
                      <a:lnTo>
                        <a:pt x="4021" y="331"/>
                      </a:lnTo>
                      <a:lnTo>
                        <a:pt x="4025" y="336"/>
                      </a:lnTo>
                      <a:lnTo>
                        <a:pt x="4028" y="341"/>
                      </a:lnTo>
                      <a:lnTo>
                        <a:pt x="4032" y="347"/>
                      </a:lnTo>
                      <a:lnTo>
                        <a:pt x="4036" y="350"/>
                      </a:lnTo>
                      <a:lnTo>
                        <a:pt x="4040" y="354"/>
                      </a:lnTo>
                      <a:lnTo>
                        <a:pt x="4044" y="358"/>
                      </a:lnTo>
                      <a:lnTo>
                        <a:pt x="4047" y="361"/>
                      </a:lnTo>
                      <a:lnTo>
                        <a:pt x="4051" y="364"/>
                      </a:lnTo>
                      <a:lnTo>
                        <a:pt x="4055" y="368"/>
                      </a:lnTo>
                      <a:lnTo>
                        <a:pt x="4058" y="370"/>
                      </a:lnTo>
                      <a:lnTo>
                        <a:pt x="4062" y="373"/>
                      </a:lnTo>
                      <a:lnTo>
                        <a:pt x="4066" y="375"/>
                      </a:lnTo>
                      <a:lnTo>
                        <a:pt x="4070" y="378"/>
                      </a:lnTo>
                      <a:lnTo>
                        <a:pt x="4074" y="380"/>
                      </a:lnTo>
                      <a:lnTo>
                        <a:pt x="4077" y="382"/>
                      </a:lnTo>
                      <a:lnTo>
                        <a:pt x="4081" y="384"/>
                      </a:lnTo>
                      <a:lnTo>
                        <a:pt x="4085" y="385"/>
                      </a:lnTo>
                      <a:lnTo>
                        <a:pt x="4089" y="386"/>
                      </a:lnTo>
                      <a:lnTo>
                        <a:pt x="4092" y="388"/>
                      </a:lnTo>
                      <a:lnTo>
                        <a:pt x="4096" y="389"/>
                      </a:lnTo>
                      <a:lnTo>
                        <a:pt x="4100" y="391"/>
                      </a:lnTo>
                      <a:lnTo>
                        <a:pt x="4104" y="392"/>
                      </a:lnTo>
                      <a:lnTo>
                        <a:pt x="4107" y="393"/>
                      </a:lnTo>
                      <a:lnTo>
                        <a:pt x="4111" y="393"/>
                      </a:lnTo>
                      <a:lnTo>
                        <a:pt x="4115" y="395"/>
                      </a:lnTo>
                      <a:lnTo>
                        <a:pt x="4119" y="395"/>
                      </a:lnTo>
                      <a:lnTo>
                        <a:pt x="4122" y="396"/>
                      </a:lnTo>
                      <a:lnTo>
                        <a:pt x="4126" y="397"/>
                      </a:lnTo>
                      <a:lnTo>
                        <a:pt x="4130" y="397"/>
                      </a:lnTo>
                      <a:lnTo>
                        <a:pt x="4134" y="398"/>
                      </a:lnTo>
                      <a:lnTo>
                        <a:pt x="4137" y="399"/>
                      </a:lnTo>
                      <a:lnTo>
                        <a:pt x="4141" y="400"/>
                      </a:lnTo>
                      <a:lnTo>
                        <a:pt x="4145" y="400"/>
                      </a:lnTo>
                      <a:lnTo>
                        <a:pt x="4149" y="400"/>
                      </a:lnTo>
                      <a:lnTo>
                        <a:pt x="4152" y="401"/>
                      </a:lnTo>
                      <a:lnTo>
                        <a:pt x="4156" y="401"/>
                      </a:lnTo>
                      <a:lnTo>
                        <a:pt x="4160" y="401"/>
                      </a:lnTo>
                      <a:lnTo>
                        <a:pt x="4164" y="402"/>
                      </a:lnTo>
                      <a:lnTo>
                        <a:pt x="4168" y="402"/>
                      </a:lnTo>
                      <a:lnTo>
                        <a:pt x="4171" y="402"/>
                      </a:lnTo>
                      <a:lnTo>
                        <a:pt x="4175" y="403"/>
                      </a:lnTo>
                      <a:lnTo>
                        <a:pt x="4179" y="404"/>
                      </a:lnTo>
                      <a:lnTo>
                        <a:pt x="4182" y="403"/>
                      </a:lnTo>
                      <a:lnTo>
                        <a:pt x="4186" y="403"/>
                      </a:lnTo>
                      <a:lnTo>
                        <a:pt x="4190" y="404"/>
                      </a:lnTo>
                      <a:lnTo>
                        <a:pt x="4194" y="404"/>
                      </a:lnTo>
                      <a:lnTo>
                        <a:pt x="4197" y="404"/>
                      </a:lnTo>
                      <a:lnTo>
                        <a:pt x="4201" y="405"/>
                      </a:lnTo>
                      <a:lnTo>
                        <a:pt x="4205" y="405"/>
                      </a:lnTo>
                      <a:lnTo>
                        <a:pt x="4209" y="405"/>
                      </a:lnTo>
                      <a:lnTo>
                        <a:pt x="4213" y="405"/>
                      </a:lnTo>
                      <a:lnTo>
                        <a:pt x="4216" y="405"/>
                      </a:lnTo>
                      <a:lnTo>
                        <a:pt x="4220" y="406"/>
                      </a:lnTo>
                      <a:lnTo>
                        <a:pt x="4224" y="406"/>
                      </a:lnTo>
                      <a:lnTo>
                        <a:pt x="4228" y="405"/>
                      </a:lnTo>
                      <a:lnTo>
                        <a:pt x="4231" y="406"/>
                      </a:lnTo>
                      <a:lnTo>
                        <a:pt x="4235" y="406"/>
                      </a:lnTo>
                      <a:lnTo>
                        <a:pt x="4239" y="406"/>
                      </a:lnTo>
                      <a:lnTo>
                        <a:pt x="4243" y="406"/>
                      </a:lnTo>
                      <a:lnTo>
                        <a:pt x="4246" y="406"/>
                      </a:lnTo>
                      <a:lnTo>
                        <a:pt x="4250" y="406"/>
                      </a:lnTo>
                      <a:lnTo>
                        <a:pt x="4254" y="407"/>
                      </a:lnTo>
                      <a:lnTo>
                        <a:pt x="4258" y="406"/>
                      </a:lnTo>
                      <a:lnTo>
                        <a:pt x="4261" y="407"/>
                      </a:lnTo>
                      <a:lnTo>
                        <a:pt x="4265" y="407"/>
                      </a:lnTo>
                      <a:lnTo>
                        <a:pt x="4269" y="407"/>
                      </a:lnTo>
                      <a:lnTo>
                        <a:pt x="4273" y="407"/>
                      </a:lnTo>
                      <a:lnTo>
                        <a:pt x="4276" y="407"/>
                      </a:lnTo>
                      <a:lnTo>
                        <a:pt x="4280" y="407"/>
                      </a:lnTo>
                      <a:lnTo>
                        <a:pt x="4284" y="407"/>
                      </a:lnTo>
                      <a:lnTo>
                        <a:pt x="4288" y="407"/>
                      </a:lnTo>
                      <a:lnTo>
                        <a:pt x="4292" y="408"/>
                      </a:lnTo>
                      <a:lnTo>
                        <a:pt x="4295" y="408"/>
                      </a:lnTo>
                      <a:lnTo>
                        <a:pt x="4299" y="408"/>
                      </a:lnTo>
                      <a:lnTo>
                        <a:pt x="4303" y="407"/>
                      </a:lnTo>
                      <a:lnTo>
                        <a:pt x="4307" y="408"/>
                      </a:lnTo>
                      <a:lnTo>
                        <a:pt x="4310" y="407"/>
                      </a:lnTo>
                      <a:lnTo>
                        <a:pt x="4314" y="408"/>
                      </a:lnTo>
                      <a:lnTo>
                        <a:pt x="4318" y="408"/>
                      </a:lnTo>
                      <a:lnTo>
                        <a:pt x="4321" y="408"/>
                      </a:lnTo>
                      <a:lnTo>
                        <a:pt x="4325" y="408"/>
                      </a:lnTo>
                      <a:lnTo>
                        <a:pt x="4329" y="409"/>
                      </a:lnTo>
                      <a:lnTo>
                        <a:pt x="4333" y="408"/>
                      </a:lnTo>
                      <a:lnTo>
                        <a:pt x="4337" y="408"/>
                      </a:lnTo>
                      <a:lnTo>
                        <a:pt x="4340" y="408"/>
                      </a:lnTo>
                      <a:lnTo>
                        <a:pt x="4344" y="408"/>
                      </a:lnTo>
                      <a:lnTo>
                        <a:pt x="4348" y="409"/>
                      </a:lnTo>
                      <a:lnTo>
                        <a:pt x="4352" y="408"/>
                      </a:lnTo>
                      <a:lnTo>
                        <a:pt x="4355" y="408"/>
                      </a:lnTo>
                      <a:lnTo>
                        <a:pt x="4359" y="408"/>
                      </a:lnTo>
                      <a:lnTo>
                        <a:pt x="4363" y="408"/>
                      </a:lnTo>
                      <a:lnTo>
                        <a:pt x="4367" y="409"/>
                      </a:lnTo>
                      <a:lnTo>
                        <a:pt x="4370" y="408"/>
                      </a:lnTo>
                      <a:lnTo>
                        <a:pt x="4374" y="409"/>
                      </a:lnTo>
                      <a:lnTo>
                        <a:pt x="4378" y="409"/>
                      </a:lnTo>
                      <a:lnTo>
                        <a:pt x="4382" y="409"/>
                      </a:lnTo>
                      <a:lnTo>
                        <a:pt x="4385" y="409"/>
                      </a:lnTo>
                      <a:lnTo>
                        <a:pt x="4389" y="409"/>
                      </a:lnTo>
                      <a:lnTo>
                        <a:pt x="4393" y="409"/>
                      </a:lnTo>
                      <a:lnTo>
                        <a:pt x="4397" y="409"/>
                      </a:lnTo>
                      <a:lnTo>
                        <a:pt x="4400" y="409"/>
                      </a:lnTo>
                      <a:lnTo>
                        <a:pt x="4404" y="409"/>
                      </a:lnTo>
                      <a:lnTo>
                        <a:pt x="4408" y="409"/>
                      </a:lnTo>
                      <a:lnTo>
                        <a:pt x="4412" y="409"/>
                      </a:lnTo>
                      <a:lnTo>
                        <a:pt x="4416" y="410"/>
                      </a:lnTo>
                      <a:lnTo>
                        <a:pt x="4419" y="409"/>
                      </a:lnTo>
                      <a:lnTo>
                        <a:pt x="4423" y="410"/>
                      </a:lnTo>
                      <a:lnTo>
                        <a:pt x="4427" y="409"/>
                      </a:lnTo>
                      <a:lnTo>
                        <a:pt x="4431" y="409"/>
                      </a:lnTo>
                      <a:lnTo>
                        <a:pt x="4434" y="410"/>
                      </a:lnTo>
                      <a:lnTo>
                        <a:pt x="4438" y="409"/>
                      </a:lnTo>
                      <a:lnTo>
                        <a:pt x="4442" y="409"/>
                      </a:lnTo>
                      <a:lnTo>
                        <a:pt x="4445" y="410"/>
                      </a:lnTo>
                      <a:lnTo>
                        <a:pt x="4449" y="409"/>
                      </a:lnTo>
                      <a:lnTo>
                        <a:pt x="4453" y="410"/>
                      </a:lnTo>
                      <a:lnTo>
                        <a:pt x="4457" y="410"/>
                      </a:lnTo>
                      <a:lnTo>
                        <a:pt x="4461" y="410"/>
                      </a:lnTo>
                      <a:lnTo>
                        <a:pt x="4464" y="410"/>
                      </a:lnTo>
                      <a:lnTo>
                        <a:pt x="4468" y="410"/>
                      </a:lnTo>
                      <a:lnTo>
                        <a:pt x="4472" y="411"/>
                      </a:lnTo>
                      <a:lnTo>
                        <a:pt x="4476" y="410"/>
                      </a:lnTo>
                      <a:lnTo>
                        <a:pt x="4479" y="409"/>
                      </a:lnTo>
                      <a:lnTo>
                        <a:pt x="4483" y="411"/>
                      </a:lnTo>
                      <a:lnTo>
                        <a:pt x="4487" y="410"/>
                      </a:lnTo>
                      <a:lnTo>
                        <a:pt x="4491" y="410"/>
                      </a:lnTo>
                      <a:lnTo>
                        <a:pt x="4494" y="411"/>
                      </a:lnTo>
                      <a:lnTo>
                        <a:pt x="4498" y="411"/>
                      </a:lnTo>
                      <a:lnTo>
                        <a:pt x="4502" y="411"/>
                      </a:lnTo>
                      <a:lnTo>
                        <a:pt x="4506" y="409"/>
                      </a:lnTo>
                      <a:lnTo>
                        <a:pt x="4509" y="410"/>
                      </a:lnTo>
                      <a:lnTo>
                        <a:pt x="4513" y="411"/>
                      </a:lnTo>
                      <a:lnTo>
                        <a:pt x="4517" y="410"/>
                      </a:lnTo>
                      <a:lnTo>
                        <a:pt x="4521" y="411"/>
                      </a:lnTo>
                      <a:lnTo>
                        <a:pt x="4524" y="410"/>
                      </a:lnTo>
                      <a:lnTo>
                        <a:pt x="4528" y="410"/>
                      </a:lnTo>
                      <a:lnTo>
                        <a:pt x="4532" y="410"/>
                      </a:lnTo>
                      <a:lnTo>
                        <a:pt x="4536" y="411"/>
                      </a:lnTo>
                      <a:lnTo>
                        <a:pt x="4540" y="410"/>
                      </a:lnTo>
                      <a:lnTo>
                        <a:pt x="4543" y="410"/>
                      </a:lnTo>
                      <a:lnTo>
                        <a:pt x="4547" y="411"/>
                      </a:lnTo>
                      <a:lnTo>
                        <a:pt x="4551" y="411"/>
                      </a:lnTo>
                      <a:lnTo>
                        <a:pt x="4555" y="411"/>
                      </a:lnTo>
                      <a:lnTo>
                        <a:pt x="4558" y="411"/>
                      </a:lnTo>
                      <a:lnTo>
                        <a:pt x="4562" y="411"/>
                      </a:lnTo>
                      <a:lnTo>
                        <a:pt x="4566" y="411"/>
                      </a:lnTo>
                      <a:lnTo>
                        <a:pt x="4569" y="411"/>
                      </a:lnTo>
                      <a:lnTo>
                        <a:pt x="4573" y="411"/>
                      </a:lnTo>
                      <a:lnTo>
                        <a:pt x="4577" y="411"/>
                      </a:lnTo>
                      <a:lnTo>
                        <a:pt x="4581" y="410"/>
                      </a:lnTo>
                      <a:lnTo>
                        <a:pt x="4585" y="410"/>
                      </a:lnTo>
                      <a:lnTo>
                        <a:pt x="4588" y="411"/>
                      </a:lnTo>
                      <a:lnTo>
                        <a:pt x="4592" y="411"/>
                      </a:lnTo>
                      <a:lnTo>
                        <a:pt x="4596" y="411"/>
                      </a:lnTo>
                      <a:lnTo>
                        <a:pt x="4600" y="411"/>
                      </a:lnTo>
                      <a:lnTo>
                        <a:pt x="4603" y="411"/>
                      </a:lnTo>
                      <a:lnTo>
                        <a:pt x="4607" y="412"/>
                      </a:lnTo>
                      <a:lnTo>
                        <a:pt x="4611" y="412"/>
                      </a:lnTo>
                      <a:lnTo>
                        <a:pt x="4615" y="410"/>
                      </a:lnTo>
                      <a:lnTo>
                        <a:pt x="4618" y="411"/>
                      </a:lnTo>
                      <a:lnTo>
                        <a:pt x="4622" y="412"/>
                      </a:lnTo>
                      <a:lnTo>
                        <a:pt x="4626" y="411"/>
                      </a:lnTo>
                      <a:lnTo>
                        <a:pt x="4630" y="410"/>
                      </a:lnTo>
                      <a:lnTo>
                        <a:pt x="4633" y="412"/>
                      </a:lnTo>
                      <a:lnTo>
                        <a:pt x="4637" y="412"/>
                      </a:lnTo>
                      <a:lnTo>
                        <a:pt x="4641" y="411"/>
                      </a:lnTo>
                      <a:lnTo>
                        <a:pt x="4645" y="412"/>
                      </a:lnTo>
                      <a:lnTo>
                        <a:pt x="4648" y="411"/>
                      </a:lnTo>
                      <a:lnTo>
                        <a:pt x="4652" y="411"/>
                      </a:lnTo>
                      <a:lnTo>
                        <a:pt x="4656" y="411"/>
                      </a:lnTo>
                      <a:lnTo>
                        <a:pt x="4660" y="412"/>
                      </a:lnTo>
                      <a:lnTo>
                        <a:pt x="4664" y="412"/>
                      </a:lnTo>
                      <a:lnTo>
                        <a:pt x="4667" y="411"/>
                      </a:lnTo>
                      <a:lnTo>
                        <a:pt x="4671" y="412"/>
                      </a:lnTo>
                      <a:lnTo>
                        <a:pt x="4675" y="411"/>
                      </a:lnTo>
                      <a:lnTo>
                        <a:pt x="4679" y="412"/>
                      </a:lnTo>
                      <a:lnTo>
                        <a:pt x="4682" y="412"/>
                      </a:lnTo>
                      <a:lnTo>
                        <a:pt x="4686" y="412"/>
                      </a:lnTo>
                      <a:lnTo>
                        <a:pt x="4690" y="411"/>
                      </a:lnTo>
                      <a:lnTo>
                        <a:pt x="4694" y="411"/>
                      </a:lnTo>
                      <a:lnTo>
                        <a:pt x="4697" y="412"/>
                      </a:lnTo>
                      <a:lnTo>
                        <a:pt x="4701" y="412"/>
                      </a:lnTo>
                      <a:lnTo>
                        <a:pt x="4705" y="411"/>
                      </a:lnTo>
                      <a:lnTo>
                        <a:pt x="4709" y="411"/>
                      </a:lnTo>
                      <a:lnTo>
                        <a:pt x="4712" y="412"/>
                      </a:lnTo>
                      <a:lnTo>
                        <a:pt x="4716" y="412"/>
                      </a:lnTo>
                      <a:lnTo>
                        <a:pt x="4720" y="411"/>
                      </a:lnTo>
                      <a:lnTo>
                        <a:pt x="4724" y="412"/>
                      </a:lnTo>
                      <a:lnTo>
                        <a:pt x="4727" y="412"/>
                      </a:lnTo>
                      <a:lnTo>
                        <a:pt x="4731" y="412"/>
                      </a:lnTo>
                      <a:lnTo>
                        <a:pt x="4735" y="412"/>
                      </a:lnTo>
                      <a:lnTo>
                        <a:pt x="4739" y="412"/>
                      </a:lnTo>
                      <a:lnTo>
                        <a:pt x="4742" y="412"/>
                      </a:lnTo>
                      <a:lnTo>
                        <a:pt x="4746" y="412"/>
                      </a:lnTo>
                      <a:lnTo>
                        <a:pt x="4750" y="411"/>
                      </a:lnTo>
                      <a:lnTo>
                        <a:pt x="4754" y="412"/>
                      </a:lnTo>
                      <a:lnTo>
                        <a:pt x="4758" y="412"/>
                      </a:lnTo>
                      <a:lnTo>
                        <a:pt x="4761" y="412"/>
                      </a:lnTo>
                      <a:lnTo>
                        <a:pt x="4765" y="412"/>
                      </a:lnTo>
                      <a:lnTo>
                        <a:pt x="4769" y="412"/>
                      </a:lnTo>
                      <a:lnTo>
                        <a:pt x="4772" y="412"/>
                      </a:lnTo>
                      <a:lnTo>
                        <a:pt x="4776" y="411"/>
                      </a:lnTo>
                      <a:lnTo>
                        <a:pt x="4780" y="411"/>
                      </a:lnTo>
                      <a:lnTo>
                        <a:pt x="4784" y="412"/>
                      </a:lnTo>
                      <a:lnTo>
                        <a:pt x="4787" y="411"/>
                      </a:lnTo>
                      <a:lnTo>
                        <a:pt x="4791" y="412"/>
                      </a:lnTo>
                      <a:lnTo>
                        <a:pt x="4795" y="411"/>
                      </a:lnTo>
                      <a:lnTo>
                        <a:pt x="4799" y="412"/>
                      </a:lnTo>
                      <a:lnTo>
                        <a:pt x="4803" y="411"/>
                      </a:lnTo>
                      <a:lnTo>
                        <a:pt x="4806" y="411"/>
                      </a:lnTo>
                      <a:lnTo>
                        <a:pt x="4810" y="411"/>
                      </a:lnTo>
                      <a:lnTo>
                        <a:pt x="4814" y="411"/>
                      </a:lnTo>
                      <a:lnTo>
                        <a:pt x="4818" y="411"/>
                      </a:lnTo>
                      <a:lnTo>
                        <a:pt x="4821" y="411"/>
                      </a:lnTo>
                      <a:lnTo>
                        <a:pt x="4825" y="412"/>
                      </a:lnTo>
                      <a:lnTo>
                        <a:pt x="4829" y="412"/>
                      </a:lnTo>
                      <a:lnTo>
                        <a:pt x="4833" y="412"/>
                      </a:lnTo>
                      <a:lnTo>
                        <a:pt x="4836" y="412"/>
                      </a:lnTo>
                      <a:lnTo>
                        <a:pt x="4840" y="412"/>
                      </a:lnTo>
                      <a:lnTo>
                        <a:pt x="4844" y="412"/>
                      </a:lnTo>
                      <a:lnTo>
                        <a:pt x="4848" y="412"/>
                      </a:lnTo>
                      <a:lnTo>
                        <a:pt x="4851" y="412"/>
                      </a:lnTo>
                      <a:lnTo>
                        <a:pt x="4855" y="412"/>
                      </a:lnTo>
                      <a:lnTo>
                        <a:pt x="4859" y="412"/>
                      </a:lnTo>
                      <a:lnTo>
                        <a:pt x="4863" y="412"/>
                      </a:lnTo>
                      <a:lnTo>
                        <a:pt x="4866" y="412"/>
                      </a:lnTo>
                      <a:lnTo>
                        <a:pt x="4870" y="412"/>
                      </a:lnTo>
                      <a:lnTo>
                        <a:pt x="4874" y="412"/>
                      </a:lnTo>
                      <a:lnTo>
                        <a:pt x="4878" y="412"/>
                      </a:lnTo>
                      <a:lnTo>
                        <a:pt x="4882" y="412"/>
                      </a:lnTo>
                      <a:lnTo>
                        <a:pt x="4885" y="412"/>
                      </a:lnTo>
                      <a:lnTo>
                        <a:pt x="4889" y="412"/>
                      </a:lnTo>
                      <a:lnTo>
                        <a:pt x="4893" y="412"/>
                      </a:lnTo>
                      <a:lnTo>
                        <a:pt x="4896" y="412"/>
                      </a:lnTo>
                      <a:lnTo>
                        <a:pt x="4900" y="412"/>
                      </a:lnTo>
                      <a:lnTo>
                        <a:pt x="4904" y="412"/>
                      </a:lnTo>
                      <a:lnTo>
                        <a:pt x="4908" y="412"/>
                      </a:lnTo>
                      <a:lnTo>
                        <a:pt x="4911" y="412"/>
                      </a:lnTo>
                      <a:lnTo>
                        <a:pt x="4915" y="412"/>
                      </a:lnTo>
                      <a:lnTo>
                        <a:pt x="4919" y="412"/>
                      </a:lnTo>
                      <a:lnTo>
                        <a:pt x="4923" y="412"/>
                      </a:lnTo>
                      <a:lnTo>
                        <a:pt x="4927" y="412"/>
                      </a:lnTo>
                      <a:lnTo>
                        <a:pt x="4930" y="412"/>
                      </a:lnTo>
                      <a:lnTo>
                        <a:pt x="4934" y="412"/>
                      </a:lnTo>
                      <a:lnTo>
                        <a:pt x="4938" y="412"/>
                      </a:lnTo>
                      <a:lnTo>
                        <a:pt x="4942" y="412"/>
                      </a:lnTo>
                      <a:lnTo>
                        <a:pt x="4945" y="412"/>
                      </a:lnTo>
                      <a:lnTo>
                        <a:pt x="4949" y="412"/>
                      </a:lnTo>
                      <a:lnTo>
                        <a:pt x="4953" y="412"/>
                      </a:lnTo>
                      <a:lnTo>
                        <a:pt x="4957" y="412"/>
                      </a:lnTo>
                      <a:lnTo>
                        <a:pt x="4960" y="412"/>
                      </a:lnTo>
                      <a:lnTo>
                        <a:pt x="4961" y="412"/>
                      </a:lnTo>
                    </a:path>
                  </a:pathLst>
                </a:custGeom>
                <a:noFill/>
                <a:ln w="9525" cap="flat" cmpd="sng">
                  <a:solidFill>
                    <a:srgbClr val="0000FF"/>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rgbClr val="000000"/>
                    </a:solidFill>
                    <a:latin typeface="Arial"/>
                    <a:ea typeface="Arial"/>
                    <a:cs typeface="Arial"/>
                    <a:sym typeface="Arial"/>
                  </a:endParaRPr>
                </a:p>
              </p:txBody>
            </p:sp>
            <p:sp>
              <p:nvSpPr>
                <p:cNvPr id="1445" name="Google Shape;1445;p11"/>
                <p:cNvSpPr/>
                <p:nvPr/>
              </p:nvSpPr>
              <p:spPr>
                <a:xfrm>
                  <a:off x="1451" y="1153"/>
                  <a:ext cx="4" cy="45"/>
                </a:xfrm>
                <a:prstGeom prst="rect">
                  <a:avLst/>
                </a:prstGeom>
                <a:solidFill>
                  <a:srgbClr val="F3F6FF"/>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rgbClr val="000000"/>
                    </a:solidFill>
                    <a:latin typeface="Arial"/>
                    <a:ea typeface="Arial"/>
                    <a:cs typeface="Arial"/>
                    <a:sym typeface="Arial"/>
                  </a:endParaRPr>
                </a:p>
              </p:txBody>
            </p:sp>
          </p:grpSp>
          <p:sp>
            <p:nvSpPr>
              <p:cNvPr id="1446" name="Google Shape;1446;p11"/>
              <p:cNvSpPr/>
              <p:nvPr/>
            </p:nvSpPr>
            <p:spPr>
              <a:xfrm>
                <a:off x="9528608" y="4072532"/>
                <a:ext cx="144000" cy="144000"/>
              </a:xfrm>
              <a:prstGeom prst="rect">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800" b="0" i="0" u="none" strike="noStrike" cap="none">
                  <a:solidFill>
                    <a:schemeClr val="lt1"/>
                  </a:solidFill>
                  <a:latin typeface="Arial"/>
                  <a:ea typeface="Arial"/>
                  <a:cs typeface="Arial"/>
                  <a:sym typeface="Arial"/>
                </a:endParaRPr>
              </a:p>
            </p:txBody>
          </p:sp>
          <p:sp>
            <p:nvSpPr>
              <p:cNvPr id="1447" name="Google Shape;1447;p11"/>
              <p:cNvSpPr/>
              <p:nvPr/>
            </p:nvSpPr>
            <p:spPr>
              <a:xfrm>
                <a:off x="9532349" y="3628906"/>
                <a:ext cx="144000" cy="144000"/>
              </a:xfrm>
              <a:prstGeom prst="rect">
                <a:avLst/>
              </a:prstGeom>
              <a:solidFill>
                <a:srgbClr val="0000FF"/>
              </a:solidFill>
              <a:ln w="25400" cap="flat" cmpd="sng">
                <a:solidFill>
                  <a:srgbClr val="0000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800" b="0" i="0" u="none" strike="noStrike" cap="none">
                  <a:solidFill>
                    <a:schemeClr val="lt1"/>
                  </a:solidFill>
                  <a:latin typeface="Arial"/>
                  <a:ea typeface="Arial"/>
                  <a:cs typeface="Arial"/>
                  <a:sym typeface="Arial"/>
                </a:endParaRPr>
              </a:p>
            </p:txBody>
          </p:sp>
          <p:sp>
            <p:nvSpPr>
              <p:cNvPr id="1448" name="Google Shape;1448;p11"/>
              <p:cNvSpPr txBox="1"/>
              <p:nvPr/>
            </p:nvSpPr>
            <p:spPr>
              <a:xfrm>
                <a:off x="9639813" y="3883453"/>
                <a:ext cx="632959" cy="484254"/>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3T</a:t>
                </a:r>
                <a:endParaRPr sz="800" b="0" i="0" u="none" strike="noStrike" cap="none">
                  <a:solidFill>
                    <a:srgbClr val="000000"/>
                  </a:solidFill>
                  <a:latin typeface="Arial"/>
                  <a:ea typeface="Arial"/>
                  <a:cs typeface="Arial"/>
                  <a:sym typeface="Arial"/>
                </a:endParaRPr>
              </a:p>
            </p:txBody>
          </p:sp>
          <p:sp>
            <p:nvSpPr>
              <p:cNvPr id="1449" name="Google Shape;1449;p11"/>
              <p:cNvSpPr txBox="1"/>
              <p:nvPr/>
            </p:nvSpPr>
            <p:spPr>
              <a:xfrm>
                <a:off x="9639813" y="3447347"/>
                <a:ext cx="450339" cy="484254"/>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T</a:t>
                </a:r>
                <a:endParaRPr sz="800" b="0" i="0" u="none" strike="noStrike" cap="none">
                  <a:solidFill>
                    <a:srgbClr val="000000"/>
                  </a:solidFill>
                  <a:latin typeface="Arial"/>
                  <a:ea typeface="Arial"/>
                  <a:cs typeface="Arial"/>
                  <a:sym typeface="Arial"/>
                </a:endParaRPr>
              </a:p>
            </p:txBody>
          </p:sp>
          <p:sp>
            <p:nvSpPr>
              <p:cNvPr id="1450" name="Google Shape;1450;p11"/>
              <p:cNvSpPr/>
              <p:nvPr/>
            </p:nvSpPr>
            <p:spPr>
              <a:xfrm>
                <a:off x="5460789" y="6388287"/>
                <a:ext cx="2245110" cy="322160"/>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200"/>
                  <a:buFont typeface="Arial"/>
                  <a:buNone/>
                </a:pPr>
                <a:r>
                  <a:rPr lang="en-GB" sz="1000" b="0" i="0" u="none" strike="noStrike" cap="none" dirty="0">
                    <a:solidFill>
                      <a:schemeClr val="dk1"/>
                    </a:solidFill>
                    <a:latin typeface="Arial"/>
                    <a:ea typeface="Arial"/>
                    <a:cs typeface="Arial"/>
                    <a:sym typeface="Arial"/>
                  </a:rPr>
                  <a:t>Retention Time (minutes)</a:t>
                </a:r>
                <a:endParaRPr sz="1000" b="0" i="0" u="none" strike="noStrike" cap="none" dirty="0">
                  <a:solidFill>
                    <a:srgbClr val="000000"/>
                  </a:solidFill>
                  <a:latin typeface="Arial"/>
                  <a:ea typeface="Arial"/>
                  <a:cs typeface="Arial"/>
                  <a:sym typeface="Arial"/>
                </a:endParaRPr>
              </a:p>
            </p:txBody>
          </p:sp>
          <p:sp>
            <p:nvSpPr>
              <p:cNvPr id="1451" name="Google Shape;1451;p11"/>
              <p:cNvSpPr txBox="1"/>
              <p:nvPr/>
            </p:nvSpPr>
            <p:spPr>
              <a:xfrm rot="-5400000">
                <a:off x="420570" y="-3167130"/>
                <a:ext cx="2781600" cy="3393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200"/>
                  <a:buFont typeface="Arial"/>
                  <a:buNone/>
                </a:pPr>
                <a:r>
                  <a:rPr lang="en-GB" sz="1000" b="0" i="0" u="none" strike="noStrike" cap="none" dirty="0">
                    <a:solidFill>
                      <a:srgbClr val="000000"/>
                    </a:solidFill>
                    <a:latin typeface="Arial"/>
                    <a:ea typeface="Arial"/>
                    <a:cs typeface="Arial"/>
                    <a:sym typeface="Arial"/>
                  </a:rPr>
                  <a:t>Absorbance (</a:t>
                </a:r>
                <a:r>
                  <a:rPr lang="en-GB" sz="1000" b="0" i="0" u="none" strike="noStrike" cap="none" dirty="0" err="1">
                    <a:solidFill>
                      <a:srgbClr val="000000"/>
                    </a:solidFill>
                    <a:latin typeface="Arial"/>
                    <a:ea typeface="Arial"/>
                    <a:cs typeface="Arial"/>
                    <a:sym typeface="Arial"/>
                  </a:rPr>
                  <a:t>mAU</a:t>
                </a:r>
                <a:r>
                  <a:rPr lang="en-GB" sz="1000" dirty="0"/>
                  <a:t>)</a:t>
                </a:r>
                <a:r>
                  <a:rPr lang="en-GB" sz="1000" b="0" i="0" u="none" strike="noStrike" cap="none" dirty="0">
                    <a:solidFill>
                      <a:srgbClr val="000000"/>
                    </a:solidFill>
                    <a:latin typeface="Arial"/>
                    <a:ea typeface="Arial"/>
                    <a:cs typeface="Arial"/>
                    <a:sym typeface="Arial"/>
                  </a:rPr>
                  <a:t> </a:t>
                </a:r>
                <a:endParaRPr sz="1000" b="0" i="0" u="none" strike="noStrike" cap="none" dirty="0">
                  <a:solidFill>
                    <a:srgbClr val="000000"/>
                  </a:solidFill>
                  <a:latin typeface="Arial"/>
                  <a:ea typeface="Arial"/>
                  <a:cs typeface="Arial"/>
                  <a:sym typeface="Arial"/>
                </a:endParaRPr>
              </a:p>
            </p:txBody>
          </p:sp>
          <p:sp>
            <p:nvSpPr>
              <p:cNvPr id="1452" name="Google Shape;1452;p11"/>
              <p:cNvSpPr txBox="1"/>
              <p:nvPr/>
            </p:nvSpPr>
            <p:spPr>
              <a:xfrm>
                <a:off x="8051114" y="1919152"/>
                <a:ext cx="992101" cy="48420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dirty="0">
                    <a:solidFill>
                      <a:srgbClr val="000000"/>
                    </a:solidFill>
                    <a:latin typeface="Arial"/>
                    <a:ea typeface="Arial"/>
                    <a:cs typeface="Arial"/>
                    <a:sym typeface="Arial"/>
                  </a:rPr>
                  <a:t>dsRNA</a:t>
                </a:r>
                <a:endParaRPr sz="800" b="0" i="0" u="none" strike="noStrike" cap="none" dirty="0">
                  <a:solidFill>
                    <a:srgbClr val="000000"/>
                  </a:solidFill>
                  <a:latin typeface="Arial"/>
                  <a:ea typeface="Arial"/>
                  <a:cs typeface="Arial"/>
                  <a:sym typeface="Arial"/>
                </a:endParaRPr>
              </a:p>
            </p:txBody>
          </p:sp>
        </p:grpSp>
        <p:grpSp>
          <p:nvGrpSpPr>
            <p:cNvPr id="1454" name="Google Shape;1454;p11"/>
            <p:cNvGrpSpPr/>
            <p:nvPr/>
          </p:nvGrpSpPr>
          <p:grpSpPr>
            <a:xfrm>
              <a:off x="372738" y="23232"/>
              <a:ext cx="6617949" cy="2379586"/>
              <a:chOff x="1582064" y="1286609"/>
              <a:chExt cx="8515117" cy="4806272"/>
            </a:xfrm>
          </p:grpSpPr>
          <p:grpSp>
            <p:nvGrpSpPr>
              <p:cNvPr id="1455" name="Google Shape;1455;p11"/>
              <p:cNvGrpSpPr/>
              <p:nvPr/>
            </p:nvGrpSpPr>
            <p:grpSpPr>
              <a:xfrm>
                <a:off x="1582064" y="1286609"/>
                <a:ext cx="8515117" cy="4806272"/>
                <a:chOff x="1207" y="1150"/>
                <a:chExt cx="4865" cy="2746"/>
              </a:xfrm>
            </p:grpSpPr>
            <p:sp>
              <p:nvSpPr>
                <p:cNvPr id="1456" name="Google Shape;1456;p11"/>
                <p:cNvSpPr/>
                <p:nvPr/>
              </p:nvSpPr>
              <p:spPr>
                <a:xfrm>
                  <a:off x="1207" y="1150"/>
                  <a:ext cx="4815" cy="274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endParaRPr sz="800" b="0" i="0" u="none" strike="noStrike" cap="none">
                    <a:solidFill>
                      <a:srgbClr val="000000"/>
                    </a:solidFill>
                    <a:latin typeface="Arial"/>
                    <a:ea typeface="Arial"/>
                    <a:cs typeface="Arial"/>
                    <a:sym typeface="Arial"/>
                  </a:endParaRPr>
                </a:p>
              </p:txBody>
            </p:sp>
            <p:cxnSp>
              <p:nvCxnSpPr>
                <p:cNvPr id="1457" name="Google Shape;1457;p11"/>
                <p:cNvCxnSpPr/>
                <p:nvPr/>
              </p:nvCxnSpPr>
              <p:spPr>
                <a:xfrm>
                  <a:off x="1432" y="3741"/>
                  <a:ext cx="4536" cy="0"/>
                </a:xfrm>
                <a:prstGeom prst="straightConnector1">
                  <a:avLst/>
                </a:prstGeom>
                <a:noFill/>
                <a:ln w="9525" cap="flat" cmpd="sng">
                  <a:solidFill>
                    <a:srgbClr val="000000"/>
                  </a:solidFill>
                  <a:prstDash val="solid"/>
                  <a:round/>
                  <a:headEnd type="none" w="sm" len="sm"/>
                  <a:tailEnd type="none" w="sm" len="sm"/>
                </a:ln>
              </p:spPr>
            </p:cxnSp>
            <p:cxnSp>
              <p:nvCxnSpPr>
                <p:cNvPr id="1458" name="Google Shape;1458;p11"/>
                <p:cNvCxnSpPr/>
                <p:nvPr/>
              </p:nvCxnSpPr>
              <p:spPr>
                <a:xfrm>
                  <a:off x="1432" y="3741"/>
                  <a:ext cx="0" cy="15"/>
                </a:xfrm>
                <a:prstGeom prst="straightConnector1">
                  <a:avLst/>
                </a:prstGeom>
                <a:noFill/>
                <a:ln w="9525" cap="flat" cmpd="sng">
                  <a:solidFill>
                    <a:srgbClr val="000000"/>
                  </a:solidFill>
                  <a:prstDash val="solid"/>
                  <a:round/>
                  <a:headEnd type="none" w="sm" len="sm"/>
                  <a:tailEnd type="none" w="sm" len="sm"/>
                </a:ln>
              </p:spPr>
            </p:cxnSp>
            <p:sp>
              <p:nvSpPr>
                <p:cNvPr id="1459" name="Google Shape;1459;p11"/>
                <p:cNvSpPr/>
                <p:nvPr/>
              </p:nvSpPr>
              <p:spPr>
                <a:xfrm>
                  <a:off x="1396" y="3754"/>
                  <a:ext cx="112"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4.5</a:t>
                  </a:r>
                  <a:endParaRPr sz="800" b="0" i="0" u="none" strike="noStrike" cap="none">
                    <a:solidFill>
                      <a:schemeClr val="dk1"/>
                    </a:solidFill>
                    <a:latin typeface="Arial"/>
                    <a:ea typeface="Arial"/>
                    <a:cs typeface="Arial"/>
                    <a:sym typeface="Arial"/>
                  </a:endParaRPr>
                </a:p>
              </p:txBody>
            </p:sp>
            <p:cxnSp>
              <p:nvCxnSpPr>
                <p:cNvPr id="1460" name="Google Shape;1460;p11"/>
                <p:cNvCxnSpPr/>
                <p:nvPr/>
              </p:nvCxnSpPr>
              <p:spPr>
                <a:xfrm>
                  <a:off x="1432" y="3741"/>
                  <a:ext cx="0" cy="9"/>
                </a:xfrm>
                <a:prstGeom prst="straightConnector1">
                  <a:avLst/>
                </a:prstGeom>
                <a:noFill/>
                <a:ln w="9525" cap="flat" cmpd="sng">
                  <a:solidFill>
                    <a:srgbClr val="000000"/>
                  </a:solidFill>
                  <a:prstDash val="solid"/>
                  <a:round/>
                  <a:headEnd type="none" w="sm" len="sm"/>
                  <a:tailEnd type="none" w="sm" len="sm"/>
                </a:ln>
              </p:spPr>
            </p:cxnSp>
            <p:cxnSp>
              <p:nvCxnSpPr>
                <p:cNvPr id="1461" name="Google Shape;1461;p11"/>
                <p:cNvCxnSpPr/>
                <p:nvPr/>
              </p:nvCxnSpPr>
              <p:spPr>
                <a:xfrm>
                  <a:off x="1535" y="3741"/>
                  <a:ext cx="0" cy="9"/>
                </a:xfrm>
                <a:prstGeom prst="straightConnector1">
                  <a:avLst/>
                </a:prstGeom>
                <a:noFill/>
                <a:ln w="9525" cap="flat" cmpd="sng">
                  <a:solidFill>
                    <a:srgbClr val="000000"/>
                  </a:solidFill>
                  <a:prstDash val="solid"/>
                  <a:round/>
                  <a:headEnd type="none" w="sm" len="sm"/>
                  <a:tailEnd type="none" w="sm" len="sm"/>
                </a:ln>
              </p:spPr>
            </p:cxnSp>
            <p:cxnSp>
              <p:nvCxnSpPr>
                <p:cNvPr id="1462" name="Google Shape;1462;p11"/>
                <p:cNvCxnSpPr/>
                <p:nvPr/>
              </p:nvCxnSpPr>
              <p:spPr>
                <a:xfrm>
                  <a:off x="1638" y="3741"/>
                  <a:ext cx="0" cy="15"/>
                </a:xfrm>
                <a:prstGeom prst="straightConnector1">
                  <a:avLst/>
                </a:prstGeom>
                <a:noFill/>
                <a:ln w="9525" cap="flat" cmpd="sng">
                  <a:solidFill>
                    <a:srgbClr val="000000"/>
                  </a:solidFill>
                  <a:prstDash val="solid"/>
                  <a:round/>
                  <a:headEnd type="none" w="sm" len="sm"/>
                  <a:tailEnd type="none" w="sm" len="sm"/>
                </a:ln>
              </p:spPr>
            </p:cxnSp>
            <p:sp>
              <p:nvSpPr>
                <p:cNvPr id="1463" name="Google Shape;1463;p11"/>
                <p:cNvSpPr/>
                <p:nvPr/>
              </p:nvSpPr>
              <p:spPr>
                <a:xfrm>
                  <a:off x="1602" y="3754"/>
                  <a:ext cx="112"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5.0</a:t>
                  </a:r>
                  <a:endParaRPr sz="800" b="0" i="0" u="none" strike="noStrike" cap="none">
                    <a:solidFill>
                      <a:schemeClr val="dk1"/>
                    </a:solidFill>
                    <a:latin typeface="Arial"/>
                    <a:ea typeface="Arial"/>
                    <a:cs typeface="Arial"/>
                    <a:sym typeface="Arial"/>
                  </a:endParaRPr>
                </a:p>
              </p:txBody>
            </p:sp>
            <p:cxnSp>
              <p:nvCxnSpPr>
                <p:cNvPr id="1464" name="Google Shape;1464;p11"/>
                <p:cNvCxnSpPr/>
                <p:nvPr/>
              </p:nvCxnSpPr>
              <p:spPr>
                <a:xfrm>
                  <a:off x="1741" y="3741"/>
                  <a:ext cx="0" cy="9"/>
                </a:xfrm>
                <a:prstGeom prst="straightConnector1">
                  <a:avLst/>
                </a:prstGeom>
                <a:noFill/>
                <a:ln w="9525" cap="flat" cmpd="sng">
                  <a:solidFill>
                    <a:srgbClr val="000000"/>
                  </a:solidFill>
                  <a:prstDash val="solid"/>
                  <a:round/>
                  <a:headEnd type="none" w="sm" len="sm"/>
                  <a:tailEnd type="none" w="sm" len="sm"/>
                </a:ln>
              </p:spPr>
            </p:cxnSp>
            <p:cxnSp>
              <p:nvCxnSpPr>
                <p:cNvPr id="1465" name="Google Shape;1465;p11"/>
                <p:cNvCxnSpPr/>
                <p:nvPr/>
              </p:nvCxnSpPr>
              <p:spPr>
                <a:xfrm>
                  <a:off x="1844" y="3741"/>
                  <a:ext cx="0" cy="9"/>
                </a:xfrm>
                <a:prstGeom prst="straightConnector1">
                  <a:avLst/>
                </a:prstGeom>
                <a:noFill/>
                <a:ln w="9525" cap="flat" cmpd="sng">
                  <a:solidFill>
                    <a:srgbClr val="000000"/>
                  </a:solidFill>
                  <a:prstDash val="solid"/>
                  <a:round/>
                  <a:headEnd type="none" w="sm" len="sm"/>
                  <a:tailEnd type="none" w="sm" len="sm"/>
                </a:ln>
              </p:spPr>
            </p:cxnSp>
            <p:cxnSp>
              <p:nvCxnSpPr>
                <p:cNvPr id="1466" name="Google Shape;1466;p11"/>
                <p:cNvCxnSpPr/>
                <p:nvPr/>
              </p:nvCxnSpPr>
              <p:spPr>
                <a:xfrm>
                  <a:off x="1948" y="3741"/>
                  <a:ext cx="0" cy="9"/>
                </a:xfrm>
                <a:prstGeom prst="straightConnector1">
                  <a:avLst/>
                </a:prstGeom>
                <a:noFill/>
                <a:ln w="9525" cap="flat" cmpd="sng">
                  <a:solidFill>
                    <a:srgbClr val="000000"/>
                  </a:solidFill>
                  <a:prstDash val="solid"/>
                  <a:round/>
                  <a:headEnd type="none" w="sm" len="sm"/>
                  <a:tailEnd type="none" w="sm" len="sm"/>
                </a:ln>
              </p:spPr>
            </p:cxnSp>
            <p:cxnSp>
              <p:nvCxnSpPr>
                <p:cNvPr id="1467" name="Google Shape;1467;p11"/>
                <p:cNvCxnSpPr/>
                <p:nvPr/>
              </p:nvCxnSpPr>
              <p:spPr>
                <a:xfrm>
                  <a:off x="2051" y="3741"/>
                  <a:ext cx="0" cy="15"/>
                </a:xfrm>
                <a:prstGeom prst="straightConnector1">
                  <a:avLst/>
                </a:prstGeom>
                <a:noFill/>
                <a:ln w="9525" cap="flat" cmpd="sng">
                  <a:solidFill>
                    <a:srgbClr val="000000"/>
                  </a:solidFill>
                  <a:prstDash val="solid"/>
                  <a:round/>
                  <a:headEnd type="none" w="sm" len="sm"/>
                  <a:tailEnd type="none" w="sm" len="sm"/>
                </a:ln>
              </p:spPr>
            </p:cxnSp>
            <p:sp>
              <p:nvSpPr>
                <p:cNvPr id="1468" name="Google Shape;1468;p11"/>
                <p:cNvSpPr/>
                <p:nvPr/>
              </p:nvSpPr>
              <p:spPr>
                <a:xfrm>
                  <a:off x="2014" y="3754"/>
                  <a:ext cx="112"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6.0</a:t>
                  </a:r>
                  <a:endParaRPr sz="800" b="0" i="0" u="none" strike="noStrike" cap="none">
                    <a:solidFill>
                      <a:schemeClr val="dk1"/>
                    </a:solidFill>
                    <a:latin typeface="Arial"/>
                    <a:ea typeface="Arial"/>
                    <a:cs typeface="Arial"/>
                    <a:sym typeface="Arial"/>
                  </a:endParaRPr>
                </a:p>
              </p:txBody>
            </p:sp>
            <p:cxnSp>
              <p:nvCxnSpPr>
                <p:cNvPr id="1469" name="Google Shape;1469;p11"/>
                <p:cNvCxnSpPr/>
                <p:nvPr/>
              </p:nvCxnSpPr>
              <p:spPr>
                <a:xfrm>
                  <a:off x="2154" y="3741"/>
                  <a:ext cx="0" cy="9"/>
                </a:xfrm>
                <a:prstGeom prst="straightConnector1">
                  <a:avLst/>
                </a:prstGeom>
                <a:noFill/>
                <a:ln w="9525" cap="flat" cmpd="sng">
                  <a:solidFill>
                    <a:srgbClr val="000000"/>
                  </a:solidFill>
                  <a:prstDash val="solid"/>
                  <a:round/>
                  <a:headEnd type="none" w="sm" len="sm"/>
                  <a:tailEnd type="none" w="sm" len="sm"/>
                </a:ln>
              </p:spPr>
            </p:cxnSp>
            <p:cxnSp>
              <p:nvCxnSpPr>
                <p:cNvPr id="1470" name="Google Shape;1470;p11"/>
                <p:cNvCxnSpPr/>
                <p:nvPr/>
              </p:nvCxnSpPr>
              <p:spPr>
                <a:xfrm>
                  <a:off x="2257" y="3741"/>
                  <a:ext cx="0" cy="9"/>
                </a:xfrm>
                <a:prstGeom prst="straightConnector1">
                  <a:avLst/>
                </a:prstGeom>
                <a:noFill/>
                <a:ln w="9525" cap="flat" cmpd="sng">
                  <a:solidFill>
                    <a:srgbClr val="000000"/>
                  </a:solidFill>
                  <a:prstDash val="solid"/>
                  <a:round/>
                  <a:headEnd type="none" w="sm" len="sm"/>
                  <a:tailEnd type="none" w="sm" len="sm"/>
                </a:ln>
              </p:spPr>
            </p:cxnSp>
            <p:cxnSp>
              <p:nvCxnSpPr>
                <p:cNvPr id="1471" name="Google Shape;1471;p11"/>
                <p:cNvCxnSpPr/>
                <p:nvPr/>
              </p:nvCxnSpPr>
              <p:spPr>
                <a:xfrm>
                  <a:off x="2360" y="3741"/>
                  <a:ext cx="0" cy="9"/>
                </a:xfrm>
                <a:prstGeom prst="straightConnector1">
                  <a:avLst/>
                </a:prstGeom>
                <a:noFill/>
                <a:ln w="9525" cap="flat" cmpd="sng">
                  <a:solidFill>
                    <a:srgbClr val="000000"/>
                  </a:solidFill>
                  <a:prstDash val="solid"/>
                  <a:round/>
                  <a:headEnd type="none" w="sm" len="sm"/>
                  <a:tailEnd type="none" w="sm" len="sm"/>
                </a:ln>
              </p:spPr>
            </p:cxnSp>
            <p:cxnSp>
              <p:nvCxnSpPr>
                <p:cNvPr id="1472" name="Google Shape;1472;p11"/>
                <p:cNvCxnSpPr/>
                <p:nvPr/>
              </p:nvCxnSpPr>
              <p:spPr>
                <a:xfrm>
                  <a:off x="2463" y="3741"/>
                  <a:ext cx="0" cy="15"/>
                </a:xfrm>
                <a:prstGeom prst="straightConnector1">
                  <a:avLst/>
                </a:prstGeom>
                <a:noFill/>
                <a:ln w="9525" cap="flat" cmpd="sng">
                  <a:solidFill>
                    <a:srgbClr val="000000"/>
                  </a:solidFill>
                  <a:prstDash val="solid"/>
                  <a:round/>
                  <a:headEnd type="none" w="sm" len="sm"/>
                  <a:tailEnd type="none" w="sm" len="sm"/>
                </a:ln>
              </p:spPr>
            </p:cxnSp>
            <p:sp>
              <p:nvSpPr>
                <p:cNvPr id="1473" name="Google Shape;1473;p11"/>
                <p:cNvSpPr/>
                <p:nvPr/>
              </p:nvSpPr>
              <p:spPr>
                <a:xfrm>
                  <a:off x="2426" y="3754"/>
                  <a:ext cx="112"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7.0</a:t>
                  </a:r>
                  <a:endParaRPr sz="800" b="0" i="0" u="none" strike="noStrike" cap="none">
                    <a:solidFill>
                      <a:schemeClr val="dk1"/>
                    </a:solidFill>
                    <a:latin typeface="Arial"/>
                    <a:ea typeface="Arial"/>
                    <a:cs typeface="Arial"/>
                    <a:sym typeface="Arial"/>
                  </a:endParaRPr>
                </a:p>
              </p:txBody>
            </p:sp>
            <p:cxnSp>
              <p:nvCxnSpPr>
                <p:cNvPr id="1474" name="Google Shape;1474;p11"/>
                <p:cNvCxnSpPr/>
                <p:nvPr/>
              </p:nvCxnSpPr>
              <p:spPr>
                <a:xfrm>
                  <a:off x="2566" y="3741"/>
                  <a:ext cx="0" cy="9"/>
                </a:xfrm>
                <a:prstGeom prst="straightConnector1">
                  <a:avLst/>
                </a:prstGeom>
                <a:noFill/>
                <a:ln w="9525" cap="flat" cmpd="sng">
                  <a:solidFill>
                    <a:srgbClr val="000000"/>
                  </a:solidFill>
                  <a:prstDash val="solid"/>
                  <a:round/>
                  <a:headEnd type="none" w="sm" len="sm"/>
                  <a:tailEnd type="none" w="sm" len="sm"/>
                </a:ln>
              </p:spPr>
            </p:cxnSp>
            <p:cxnSp>
              <p:nvCxnSpPr>
                <p:cNvPr id="1475" name="Google Shape;1475;p11"/>
                <p:cNvCxnSpPr/>
                <p:nvPr/>
              </p:nvCxnSpPr>
              <p:spPr>
                <a:xfrm>
                  <a:off x="2669" y="3741"/>
                  <a:ext cx="0" cy="9"/>
                </a:xfrm>
                <a:prstGeom prst="straightConnector1">
                  <a:avLst/>
                </a:prstGeom>
                <a:noFill/>
                <a:ln w="9525" cap="flat" cmpd="sng">
                  <a:solidFill>
                    <a:srgbClr val="000000"/>
                  </a:solidFill>
                  <a:prstDash val="solid"/>
                  <a:round/>
                  <a:headEnd type="none" w="sm" len="sm"/>
                  <a:tailEnd type="none" w="sm" len="sm"/>
                </a:ln>
              </p:spPr>
            </p:cxnSp>
            <p:cxnSp>
              <p:nvCxnSpPr>
                <p:cNvPr id="1476" name="Google Shape;1476;p11"/>
                <p:cNvCxnSpPr/>
                <p:nvPr/>
              </p:nvCxnSpPr>
              <p:spPr>
                <a:xfrm>
                  <a:off x="2772" y="3741"/>
                  <a:ext cx="0" cy="9"/>
                </a:xfrm>
                <a:prstGeom prst="straightConnector1">
                  <a:avLst/>
                </a:prstGeom>
                <a:noFill/>
                <a:ln w="9525" cap="flat" cmpd="sng">
                  <a:solidFill>
                    <a:srgbClr val="000000"/>
                  </a:solidFill>
                  <a:prstDash val="solid"/>
                  <a:round/>
                  <a:headEnd type="none" w="sm" len="sm"/>
                  <a:tailEnd type="none" w="sm" len="sm"/>
                </a:ln>
              </p:spPr>
            </p:cxnSp>
            <p:cxnSp>
              <p:nvCxnSpPr>
                <p:cNvPr id="1477" name="Google Shape;1477;p11"/>
                <p:cNvCxnSpPr/>
                <p:nvPr/>
              </p:nvCxnSpPr>
              <p:spPr>
                <a:xfrm>
                  <a:off x="2875" y="3741"/>
                  <a:ext cx="0" cy="15"/>
                </a:xfrm>
                <a:prstGeom prst="straightConnector1">
                  <a:avLst/>
                </a:prstGeom>
                <a:noFill/>
                <a:ln w="9525" cap="flat" cmpd="sng">
                  <a:solidFill>
                    <a:srgbClr val="000000"/>
                  </a:solidFill>
                  <a:prstDash val="solid"/>
                  <a:round/>
                  <a:headEnd type="none" w="sm" len="sm"/>
                  <a:tailEnd type="none" w="sm" len="sm"/>
                </a:ln>
              </p:spPr>
            </p:cxnSp>
            <p:sp>
              <p:nvSpPr>
                <p:cNvPr id="1478" name="Google Shape;1478;p11"/>
                <p:cNvSpPr/>
                <p:nvPr/>
              </p:nvSpPr>
              <p:spPr>
                <a:xfrm>
                  <a:off x="2838" y="3754"/>
                  <a:ext cx="112"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8.0</a:t>
                  </a:r>
                  <a:endParaRPr sz="800" b="0" i="0" u="none" strike="noStrike" cap="none">
                    <a:solidFill>
                      <a:schemeClr val="dk1"/>
                    </a:solidFill>
                    <a:latin typeface="Arial"/>
                    <a:ea typeface="Arial"/>
                    <a:cs typeface="Arial"/>
                    <a:sym typeface="Arial"/>
                  </a:endParaRPr>
                </a:p>
              </p:txBody>
            </p:sp>
            <p:cxnSp>
              <p:nvCxnSpPr>
                <p:cNvPr id="1479" name="Google Shape;1479;p11"/>
                <p:cNvCxnSpPr/>
                <p:nvPr/>
              </p:nvCxnSpPr>
              <p:spPr>
                <a:xfrm>
                  <a:off x="2978" y="3741"/>
                  <a:ext cx="0" cy="9"/>
                </a:xfrm>
                <a:prstGeom prst="straightConnector1">
                  <a:avLst/>
                </a:prstGeom>
                <a:noFill/>
                <a:ln w="9525" cap="flat" cmpd="sng">
                  <a:solidFill>
                    <a:srgbClr val="000000"/>
                  </a:solidFill>
                  <a:prstDash val="solid"/>
                  <a:round/>
                  <a:headEnd type="none" w="sm" len="sm"/>
                  <a:tailEnd type="none" w="sm" len="sm"/>
                </a:ln>
              </p:spPr>
            </p:cxnSp>
            <p:cxnSp>
              <p:nvCxnSpPr>
                <p:cNvPr id="1480" name="Google Shape;1480;p11"/>
                <p:cNvCxnSpPr/>
                <p:nvPr/>
              </p:nvCxnSpPr>
              <p:spPr>
                <a:xfrm>
                  <a:off x="3081" y="3741"/>
                  <a:ext cx="0" cy="9"/>
                </a:xfrm>
                <a:prstGeom prst="straightConnector1">
                  <a:avLst/>
                </a:prstGeom>
                <a:noFill/>
                <a:ln w="9525" cap="flat" cmpd="sng">
                  <a:solidFill>
                    <a:srgbClr val="000000"/>
                  </a:solidFill>
                  <a:prstDash val="solid"/>
                  <a:round/>
                  <a:headEnd type="none" w="sm" len="sm"/>
                  <a:tailEnd type="none" w="sm" len="sm"/>
                </a:ln>
              </p:spPr>
            </p:cxnSp>
            <p:cxnSp>
              <p:nvCxnSpPr>
                <p:cNvPr id="1481" name="Google Shape;1481;p11"/>
                <p:cNvCxnSpPr/>
                <p:nvPr/>
              </p:nvCxnSpPr>
              <p:spPr>
                <a:xfrm>
                  <a:off x="3185" y="3741"/>
                  <a:ext cx="0" cy="9"/>
                </a:xfrm>
                <a:prstGeom prst="straightConnector1">
                  <a:avLst/>
                </a:prstGeom>
                <a:noFill/>
                <a:ln w="9525" cap="flat" cmpd="sng">
                  <a:solidFill>
                    <a:srgbClr val="000000"/>
                  </a:solidFill>
                  <a:prstDash val="solid"/>
                  <a:round/>
                  <a:headEnd type="none" w="sm" len="sm"/>
                  <a:tailEnd type="none" w="sm" len="sm"/>
                </a:ln>
              </p:spPr>
            </p:cxnSp>
            <p:cxnSp>
              <p:nvCxnSpPr>
                <p:cNvPr id="1482" name="Google Shape;1482;p11"/>
                <p:cNvCxnSpPr/>
                <p:nvPr/>
              </p:nvCxnSpPr>
              <p:spPr>
                <a:xfrm>
                  <a:off x="3288" y="3741"/>
                  <a:ext cx="0" cy="15"/>
                </a:xfrm>
                <a:prstGeom prst="straightConnector1">
                  <a:avLst/>
                </a:prstGeom>
                <a:noFill/>
                <a:ln w="9525" cap="flat" cmpd="sng">
                  <a:solidFill>
                    <a:srgbClr val="000000"/>
                  </a:solidFill>
                  <a:prstDash val="solid"/>
                  <a:round/>
                  <a:headEnd type="none" w="sm" len="sm"/>
                  <a:tailEnd type="none" w="sm" len="sm"/>
                </a:ln>
              </p:spPr>
            </p:cxnSp>
            <p:sp>
              <p:nvSpPr>
                <p:cNvPr id="1483" name="Google Shape;1483;p11"/>
                <p:cNvSpPr/>
                <p:nvPr/>
              </p:nvSpPr>
              <p:spPr>
                <a:xfrm>
                  <a:off x="3250" y="3754"/>
                  <a:ext cx="112"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9.0</a:t>
                  </a:r>
                  <a:endParaRPr sz="800" b="0" i="0" u="none" strike="noStrike" cap="none">
                    <a:solidFill>
                      <a:schemeClr val="dk1"/>
                    </a:solidFill>
                    <a:latin typeface="Arial"/>
                    <a:ea typeface="Arial"/>
                    <a:cs typeface="Arial"/>
                    <a:sym typeface="Arial"/>
                  </a:endParaRPr>
                </a:p>
              </p:txBody>
            </p:sp>
            <p:cxnSp>
              <p:nvCxnSpPr>
                <p:cNvPr id="1484" name="Google Shape;1484;p11"/>
                <p:cNvCxnSpPr/>
                <p:nvPr/>
              </p:nvCxnSpPr>
              <p:spPr>
                <a:xfrm>
                  <a:off x="3391" y="3741"/>
                  <a:ext cx="0" cy="9"/>
                </a:xfrm>
                <a:prstGeom prst="straightConnector1">
                  <a:avLst/>
                </a:prstGeom>
                <a:noFill/>
                <a:ln w="9525" cap="flat" cmpd="sng">
                  <a:solidFill>
                    <a:srgbClr val="000000"/>
                  </a:solidFill>
                  <a:prstDash val="solid"/>
                  <a:round/>
                  <a:headEnd type="none" w="sm" len="sm"/>
                  <a:tailEnd type="none" w="sm" len="sm"/>
                </a:ln>
              </p:spPr>
            </p:cxnSp>
            <p:cxnSp>
              <p:nvCxnSpPr>
                <p:cNvPr id="1485" name="Google Shape;1485;p11"/>
                <p:cNvCxnSpPr/>
                <p:nvPr/>
              </p:nvCxnSpPr>
              <p:spPr>
                <a:xfrm>
                  <a:off x="3494" y="3741"/>
                  <a:ext cx="0" cy="9"/>
                </a:xfrm>
                <a:prstGeom prst="straightConnector1">
                  <a:avLst/>
                </a:prstGeom>
                <a:noFill/>
                <a:ln w="9525" cap="flat" cmpd="sng">
                  <a:solidFill>
                    <a:srgbClr val="000000"/>
                  </a:solidFill>
                  <a:prstDash val="solid"/>
                  <a:round/>
                  <a:headEnd type="none" w="sm" len="sm"/>
                  <a:tailEnd type="none" w="sm" len="sm"/>
                </a:ln>
              </p:spPr>
            </p:cxnSp>
            <p:cxnSp>
              <p:nvCxnSpPr>
                <p:cNvPr id="1486" name="Google Shape;1486;p11"/>
                <p:cNvCxnSpPr/>
                <p:nvPr/>
              </p:nvCxnSpPr>
              <p:spPr>
                <a:xfrm>
                  <a:off x="3597" y="3741"/>
                  <a:ext cx="0" cy="9"/>
                </a:xfrm>
                <a:prstGeom prst="straightConnector1">
                  <a:avLst/>
                </a:prstGeom>
                <a:noFill/>
                <a:ln w="9525" cap="flat" cmpd="sng">
                  <a:solidFill>
                    <a:srgbClr val="000000"/>
                  </a:solidFill>
                  <a:prstDash val="solid"/>
                  <a:round/>
                  <a:headEnd type="none" w="sm" len="sm"/>
                  <a:tailEnd type="none" w="sm" len="sm"/>
                </a:ln>
              </p:spPr>
            </p:cxnSp>
            <p:cxnSp>
              <p:nvCxnSpPr>
                <p:cNvPr id="1487" name="Google Shape;1487;p11"/>
                <p:cNvCxnSpPr/>
                <p:nvPr/>
              </p:nvCxnSpPr>
              <p:spPr>
                <a:xfrm>
                  <a:off x="3700" y="3741"/>
                  <a:ext cx="0" cy="15"/>
                </a:xfrm>
                <a:prstGeom prst="straightConnector1">
                  <a:avLst/>
                </a:prstGeom>
                <a:noFill/>
                <a:ln w="9525" cap="flat" cmpd="sng">
                  <a:solidFill>
                    <a:srgbClr val="000000"/>
                  </a:solidFill>
                  <a:prstDash val="solid"/>
                  <a:round/>
                  <a:headEnd type="none" w="sm" len="sm"/>
                  <a:tailEnd type="none" w="sm" len="sm"/>
                </a:ln>
              </p:spPr>
            </p:cxnSp>
            <p:sp>
              <p:nvSpPr>
                <p:cNvPr id="1488" name="Google Shape;1488;p11"/>
                <p:cNvSpPr/>
                <p:nvPr/>
              </p:nvSpPr>
              <p:spPr>
                <a:xfrm>
                  <a:off x="3648" y="3754"/>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0.0</a:t>
                  </a:r>
                  <a:endParaRPr sz="800" b="0" i="0" u="none" strike="noStrike" cap="none">
                    <a:solidFill>
                      <a:schemeClr val="dk1"/>
                    </a:solidFill>
                    <a:latin typeface="Arial"/>
                    <a:ea typeface="Arial"/>
                    <a:cs typeface="Arial"/>
                    <a:sym typeface="Arial"/>
                  </a:endParaRPr>
                </a:p>
              </p:txBody>
            </p:sp>
            <p:cxnSp>
              <p:nvCxnSpPr>
                <p:cNvPr id="1489" name="Google Shape;1489;p11"/>
                <p:cNvCxnSpPr/>
                <p:nvPr/>
              </p:nvCxnSpPr>
              <p:spPr>
                <a:xfrm>
                  <a:off x="3803" y="3741"/>
                  <a:ext cx="0" cy="9"/>
                </a:xfrm>
                <a:prstGeom prst="straightConnector1">
                  <a:avLst/>
                </a:prstGeom>
                <a:noFill/>
                <a:ln w="9525" cap="flat" cmpd="sng">
                  <a:solidFill>
                    <a:srgbClr val="000000"/>
                  </a:solidFill>
                  <a:prstDash val="solid"/>
                  <a:round/>
                  <a:headEnd type="none" w="sm" len="sm"/>
                  <a:tailEnd type="none" w="sm" len="sm"/>
                </a:ln>
              </p:spPr>
            </p:cxnSp>
            <p:cxnSp>
              <p:nvCxnSpPr>
                <p:cNvPr id="1490" name="Google Shape;1490;p11"/>
                <p:cNvCxnSpPr/>
                <p:nvPr/>
              </p:nvCxnSpPr>
              <p:spPr>
                <a:xfrm>
                  <a:off x="3906" y="3741"/>
                  <a:ext cx="0" cy="9"/>
                </a:xfrm>
                <a:prstGeom prst="straightConnector1">
                  <a:avLst/>
                </a:prstGeom>
                <a:noFill/>
                <a:ln w="9525" cap="flat" cmpd="sng">
                  <a:solidFill>
                    <a:srgbClr val="000000"/>
                  </a:solidFill>
                  <a:prstDash val="solid"/>
                  <a:round/>
                  <a:headEnd type="none" w="sm" len="sm"/>
                  <a:tailEnd type="none" w="sm" len="sm"/>
                </a:ln>
              </p:spPr>
            </p:cxnSp>
            <p:cxnSp>
              <p:nvCxnSpPr>
                <p:cNvPr id="1491" name="Google Shape;1491;p11"/>
                <p:cNvCxnSpPr/>
                <p:nvPr/>
              </p:nvCxnSpPr>
              <p:spPr>
                <a:xfrm>
                  <a:off x="4009" y="3741"/>
                  <a:ext cx="0" cy="9"/>
                </a:xfrm>
                <a:prstGeom prst="straightConnector1">
                  <a:avLst/>
                </a:prstGeom>
                <a:noFill/>
                <a:ln w="9525" cap="flat" cmpd="sng">
                  <a:solidFill>
                    <a:srgbClr val="000000"/>
                  </a:solidFill>
                  <a:prstDash val="solid"/>
                  <a:round/>
                  <a:headEnd type="none" w="sm" len="sm"/>
                  <a:tailEnd type="none" w="sm" len="sm"/>
                </a:ln>
              </p:spPr>
            </p:cxnSp>
            <p:cxnSp>
              <p:nvCxnSpPr>
                <p:cNvPr id="1492" name="Google Shape;1492;p11"/>
                <p:cNvCxnSpPr/>
                <p:nvPr/>
              </p:nvCxnSpPr>
              <p:spPr>
                <a:xfrm>
                  <a:off x="4112" y="3741"/>
                  <a:ext cx="0" cy="15"/>
                </a:xfrm>
                <a:prstGeom prst="straightConnector1">
                  <a:avLst/>
                </a:prstGeom>
                <a:noFill/>
                <a:ln w="9525" cap="flat" cmpd="sng">
                  <a:solidFill>
                    <a:srgbClr val="000000"/>
                  </a:solidFill>
                  <a:prstDash val="solid"/>
                  <a:round/>
                  <a:headEnd type="none" w="sm" len="sm"/>
                  <a:tailEnd type="none" w="sm" len="sm"/>
                </a:ln>
              </p:spPr>
            </p:cxnSp>
            <p:sp>
              <p:nvSpPr>
                <p:cNvPr id="1493" name="Google Shape;1493;p11"/>
                <p:cNvSpPr/>
                <p:nvPr/>
              </p:nvSpPr>
              <p:spPr>
                <a:xfrm>
                  <a:off x="4063" y="3754"/>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1.0</a:t>
                  </a:r>
                  <a:endParaRPr sz="800" b="0" i="0" u="none" strike="noStrike" cap="none">
                    <a:solidFill>
                      <a:schemeClr val="dk1"/>
                    </a:solidFill>
                    <a:latin typeface="Arial"/>
                    <a:ea typeface="Arial"/>
                    <a:cs typeface="Arial"/>
                    <a:sym typeface="Arial"/>
                  </a:endParaRPr>
                </a:p>
              </p:txBody>
            </p:sp>
            <p:cxnSp>
              <p:nvCxnSpPr>
                <p:cNvPr id="1494" name="Google Shape;1494;p11"/>
                <p:cNvCxnSpPr/>
                <p:nvPr/>
              </p:nvCxnSpPr>
              <p:spPr>
                <a:xfrm>
                  <a:off x="4215" y="3741"/>
                  <a:ext cx="0" cy="9"/>
                </a:xfrm>
                <a:prstGeom prst="straightConnector1">
                  <a:avLst/>
                </a:prstGeom>
                <a:noFill/>
                <a:ln w="9525" cap="flat" cmpd="sng">
                  <a:solidFill>
                    <a:srgbClr val="000000"/>
                  </a:solidFill>
                  <a:prstDash val="solid"/>
                  <a:round/>
                  <a:headEnd type="none" w="sm" len="sm"/>
                  <a:tailEnd type="none" w="sm" len="sm"/>
                </a:ln>
              </p:spPr>
            </p:cxnSp>
            <p:cxnSp>
              <p:nvCxnSpPr>
                <p:cNvPr id="1495" name="Google Shape;1495;p11"/>
                <p:cNvCxnSpPr/>
                <p:nvPr/>
              </p:nvCxnSpPr>
              <p:spPr>
                <a:xfrm>
                  <a:off x="4318" y="3741"/>
                  <a:ext cx="0" cy="9"/>
                </a:xfrm>
                <a:prstGeom prst="straightConnector1">
                  <a:avLst/>
                </a:prstGeom>
                <a:noFill/>
                <a:ln w="9525" cap="flat" cmpd="sng">
                  <a:solidFill>
                    <a:srgbClr val="000000"/>
                  </a:solidFill>
                  <a:prstDash val="solid"/>
                  <a:round/>
                  <a:headEnd type="none" w="sm" len="sm"/>
                  <a:tailEnd type="none" w="sm" len="sm"/>
                </a:ln>
              </p:spPr>
            </p:cxnSp>
            <p:cxnSp>
              <p:nvCxnSpPr>
                <p:cNvPr id="1496" name="Google Shape;1496;p11"/>
                <p:cNvCxnSpPr/>
                <p:nvPr/>
              </p:nvCxnSpPr>
              <p:spPr>
                <a:xfrm>
                  <a:off x="4422" y="3741"/>
                  <a:ext cx="0" cy="9"/>
                </a:xfrm>
                <a:prstGeom prst="straightConnector1">
                  <a:avLst/>
                </a:prstGeom>
                <a:noFill/>
                <a:ln w="9525" cap="flat" cmpd="sng">
                  <a:solidFill>
                    <a:srgbClr val="000000"/>
                  </a:solidFill>
                  <a:prstDash val="solid"/>
                  <a:round/>
                  <a:headEnd type="none" w="sm" len="sm"/>
                  <a:tailEnd type="none" w="sm" len="sm"/>
                </a:ln>
              </p:spPr>
            </p:cxnSp>
            <p:cxnSp>
              <p:nvCxnSpPr>
                <p:cNvPr id="1497" name="Google Shape;1497;p11"/>
                <p:cNvCxnSpPr/>
                <p:nvPr/>
              </p:nvCxnSpPr>
              <p:spPr>
                <a:xfrm>
                  <a:off x="4525" y="3741"/>
                  <a:ext cx="0" cy="15"/>
                </a:xfrm>
                <a:prstGeom prst="straightConnector1">
                  <a:avLst/>
                </a:prstGeom>
                <a:noFill/>
                <a:ln w="9525" cap="flat" cmpd="sng">
                  <a:solidFill>
                    <a:srgbClr val="000000"/>
                  </a:solidFill>
                  <a:prstDash val="solid"/>
                  <a:round/>
                  <a:headEnd type="none" w="sm" len="sm"/>
                  <a:tailEnd type="none" w="sm" len="sm"/>
                </a:ln>
              </p:spPr>
            </p:cxnSp>
            <p:sp>
              <p:nvSpPr>
                <p:cNvPr id="1498" name="Google Shape;1498;p11"/>
                <p:cNvSpPr/>
                <p:nvPr/>
              </p:nvSpPr>
              <p:spPr>
                <a:xfrm>
                  <a:off x="4472" y="3754"/>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2.0</a:t>
                  </a:r>
                  <a:endParaRPr sz="800" b="0" i="0" u="none" strike="noStrike" cap="none">
                    <a:solidFill>
                      <a:schemeClr val="dk1"/>
                    </a:solidFill>
                    <a:latin typeface="Arial"/>
                    <a:ea typeface="Arial"/>
                    <a:cs typeface="Arial"/>
                    <a:sym typeface="Arial"/>
                  </a:endParaRPr>
                </a:p>
              </p:txBody>
            </p:sp>
            <p:cxnSp>
              <p:nvCxnSpPr>
                <p:cNvPr id="1499" name="Google Shape;1499;p11"/>
                <p:cNvCxnSpPr/>
                <p:nvPr/>
              </p:nvCxnSpPr>
              <p:spPr>
                <a:xfrm>
                  <a:off x="4628" y="3741"/>
                  <a:ext cx="0" cy="9"/>
                </a:xfrm>
                <a:prstGeom prst="straightConnector1">
                  <a:avLst/>
                </a:prstGeom>
                <a:noFill/>
                <a:ln w="9525" cap="flat" cmpd="sng">
                  <a:solidFill>
                    <a:srgbClr val="000000"/>
                  </a:solidFill>
                  <a:prstDash val="solid"/>
                  <a:round/>
                  <a:headEnd type="none" w="sm" len="sm"/>
                  <a:tailEnd type="none" w="sm" len="sm"/>
                </a:ln>
              </p:spPr>
            </p:cxnSp>
            <p:cxnSp>
              <p:nvCxnSpPr>
                <p:cNvPr id="1500" name="Google Shape;1500;p11"/>
                <p:cNvCxnSpPr/>
                <p:nvPr/>
              </p:nvCxnSpPr>
              <p:spPr>
                <a:xfrm>
                  <a:off x="4731" y="3741"/>
                  <a:ext cx="0" cy="9"/>
                </a:xfrm>
                <a:prstGeom prst="straightConnector1">
                  <a:avLst/>
                </a:prstGeom>
                <a:noFill/>
                <a:ln w="9525" cap="flat" cmpd="sng">
                  <a:solidFill>
                    <a:srgbClr val="000000"/>
                  </a:solidFill>
                  <a:prstDash val="solid"/>
                  <a:round/>
                  <a:headEnd type="none" w="sm" len="sm"/>
                  <a:tailEnd type="none" w="sm" len="sm"/>
                </a:ln>
              </p:spPr>
            </p:cxnSp>
            <p:cxnSp>
              <p:nvCxnSpPr>
                <p:cNvPr id="1501" name="Google Shape;1501;p11"/>
                <p:cNvCxnSpPr/>
                <p:nvPr/>
              </p:nvCxnSpPr>
              <p:spPr>
                <a:xfrm>
                  <a:off x="4834" y="3741"/>
                  <a:ext cx="0" cy="9"/>
                </a:xfrm>
                <a:prstGeom prst="straightConnector1">
                  <a:avLst/>
                </a:prstGeom>
                <a:noFill/>
                <a:ln w="9525" cap="flat" cmpd="sng">
                  <a:solidFill>
                    <a:srgbClr val="000000"/>
                  </a:solidFill>
                  <a:prstDash val="solid"/>
                  <a:round/>
                  <a:headEnd type="none" w="sm" len="sm"/>
                  <a:tailEnd type="none" w="sm" len="sm"/>
                </a:ln>
              </p:spPr>
            </p:cxnSp>
            <p:cxnSp>
              <p:nvCxnSpPr>
                <p:cNvPr id="1502" name="Google Shape;1502;p11"/>
                <p:cNvCxnSpPr/>
                <p:nvPr/>
              </p:nvCxnSpPr>
              <p:spPr>
                <a:xfrm>
                  <a:off x="4937" y="3741"/>
                  <a:ext cx="0" cy="15"/>
                </a:xfrm>
                <a:prstGeom prst="straightConnector1">
                  <a:avLst/>
                </a:prstGeom>
                <a:noFill/>
                <a:ln w="9525" cap="flat" cmpd="sng">
                  <a:solidFill>
                    <a:srgbClr val="000000"/>
                  </a:solidFill>
                  <a:prstDash val="solid"/>
                  <a:round/>
                  <a:headEnd type="none" w="sm" len="sm"/>
                  <a:tailEnd type="none" w="sm" len="sm"/>
                </a:ln>
              </p:spPr>
            </p:cxnSp>
            <p:sp>
              <p:nvSpPr>
                <p:cNvPr id="1503" name="Google Shape;1503;p11"/>
                <p:cNvSpPr/>
                <p:nvPr/>
              </p:nvSpPr>
              <p:spPr>
                <a:xfrm>
                  <a:off x="4884" y="3754"/>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3.0</a:t>
                  </a:r>
                  <a:endParaRPr sz="800" b="0" i="0" u="none" strike="noStrike" cap="none">
                    <a:solidFill>
                      <a:schemeClr val="dk1"/>
                    </a:solidFill>
                    <a:latin typeface="Arial"/>
                    <a:ea typeface="Arial"/>
                    <a:cs typeface="Arial"/>
                    <a:sym typeface="Arial"/>
                  </a:endParaRPr>
                </a:p>
              </p:txBody>
            </p:sp>
            <p:cxnSp>
              <p:nvCxnSpPr>
                <p:cNvPr id="1504" name="Google Shape;1504;p11"/>
                <p:cNvCxnSpPr/>
                <p:nvPr/>
              </p:nvCxnSpPr>
              <p:spPr>
                <a:xfrm>
                  <a:off x="5040" y="3741"/>
                  <a:ext cx="0" cy="9"/>
                </a:xfrm>
                <a:prstGeom prst="straightConnector1">
                  <a:avLst/>
                </a:prstGeom>
                <a:noFill/>
                <a:ln w="9525" cap="flat" cmpd="sng">
                  <a:solidFill>
                    <a:srgbClr val="000000"/>
                  </a:solidFill>
                  <a:prstDash val="solid"/>
                  <a:round/>
                  <a:headEnd type="none" w="sm" len="sm"/>
                  <a:tailEnd type="none" w="sm" len="sm"/>
                </a:ln>
              </p:spPr>
            </p:cxnSp>
            <p:cxnSp>
              <p:nvCxnSpPr>
                <p:cNvPr id="1505" name="Google Shape;1505;p11"/>
                <p:cNvCxnSpPr/>
                <p:nvPr/>
              </p:nvCxnSpPr>
              <p:spPr>
                <a:xfrm>
                  <a:off x="5143" y="3741"/>
                  <a:ext cx="0" cy="9"/>
                </a:xfrm>
                <a:prstGeom prst="straightConnector1">
                  <a:avLst/>
                </a:prstGeom>
                <a:noFill/>
                <a:ln w="9525" cap="flat" cmpd="sng">
                  <a:solidFill>
                    <a:srgbClr val="000000"/>
                  </a:solidFill>
                  <a:prstDash val="solid"/>
                  <a:round/>
                  <a:headEnd type="none" w="sm" len="sm"/>
                  <a:tailEnd type="none" w="sm" len="sm"/>
                </a:ln>
              </p:spPr>
            </p:cxnSp>
            <p:cxnSp>
              <p:nvCxnSpPr>
                <p:cNvPr id="1506" name="Google Shape;1506;p11"/>
                <p:cNvCxnSpPr/>
                <p:nvPr/>
              </p:nvCxnSpPr>
              <p:spPr>
                <a:xfrm>
                  <a:off x="5246" y="3741"/>
                  <a:ext cx="0" cy="9"/>
                </a:xfrm>
                <a:prstGeom prst="straightConnector1">
                  <a:avLst/>
                </a:prstGeom>
                <a:noFill/>
                <a:ln w="9525" cap="flat" cmpd="sng">
                  <a:solidFill>
                    <a:srgbClr val="000000"/>
                  </a:solidFill>
                  <a:prstDash val="solid"/>
                  <a:round/>
                  <a:headEnd type="none" w="sm" len="sm"/>
                  <a:tailEnd type="none" w="sm" len="sm"/>
                </a:ln>
              </p:spPr>
            </p:cxnSp>
            <p:cxnSp>
              <p:nvCxnSpPr>
                <p:cNvPr id="1507" name="Google Shape;1507;p11"/>
                <p:cNvCxnSpPr/>
                <p:nvPr/>
              </p:nvCxnSpPr>
              <p:spPr>
                <a:xfrm>
                  <a:off x="5349" y="3741"/>
                  <a:ext cx="0" cy="15"/>
                </a:xfrm>
                <a:prstGeom prst="straightConnector1">
                  <a:avLst/>
                </a:prstGeom>
                <a:noFill/>
                <a:ln w="9525" cap="flat" cmpd="sng">
                  <a:solidFill>
                    <a:srgbClr val="000000"/>
                  </a:solidFill>
                  <a:prstDash val="solid"/>
                  <a:round/>
                  <a:headEnd type="none" w="sm" len="sm"/>
                  <a:tailEnd type="none" w="sm" len="sm"/>
                </a:ln>
              </p:spPr>
            </p:cxnSp>
            <p:sp>
              <p:nvSpPr>
                <p:cNvPr id="1508" name="Google Shape;1508;p11"/>
                <p:cNvSpPr/>
                <p:nvPr/>
              </p:nvSpPr>
              <p:spPr>
                <a:xfrm>
                  <a:off x="5296" y="3754"/>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4.0</a:t>
                  </a:r>
                  <a:endParaRPr sz="800" b="0" i="0" u="none" strike="noStrike" cap="none">
                    <a:solidFill>
                      <a:schemeClr val="dk1"/>
                    </a:solidFill>
                    <a:latin typeface="Arial"/>
                    <a:ea typeface="Arial"/>
                    <a:cs typeface="Arial"/>
                    <a:sym typeface="Arial"/>
                  </a:endParaRPr>
                </a:p>
              </p:txBody>
            </p:sp>
            <p:cxnSp>
              <p:nvCxnSpPr>
                <p:cNvPr id="1509" name="Google Shape;1509;p11"/>
                <p:cNvCxnSpPr/>
                <p:nvPr/>
              </p:nvCxnSpPr>
              <p:spPr>
                <a:xfrm>
                  <a:off x="5452" y="3741"/>
                  <a:ext cx="0" cy="9"/>
                </a:xfrm>
                <a:prstGeom prst="straightConnector1">
                  <a:avLst/>
                </a:prstGeom>
                <a:noFill/>
                <a:ln w="9525" cap="flat" cmpd="sng">
                  <a:solidFill>
                    <a:srgbClr val="000000"/>
                  </a:solidFill>
                  <a:prstDash val="solid"/>
                  <a:round/>
                  <a:headEnd type="none" w="sm" len="sm"/>
                  <a:tailEnd type="none" w="sm" len="sm"/>
                </a:ln>
              </p:spPr>
            </p:cxnSp>
            <p:cxnSp>
              <p:nvCxnSpPr>
                <p:cNvPr id="1510" name="Google Shape;1510;p11"/>
                <p:cNvCxnSpPr/>
                <p:nvPr/>
              </p:nvCxnSpPr>
              <p:spPr>
                <a:xfrm>
                  <a:off x="5555" y="3741"/>
                  <a:ext cx="0" cy="9"/>
                </a:xfrm>
                <a:prstGeom prst="straightConnector1">
                  <a:avLst/>
                </a:prstGeom>
                <a:noFill/>
                <a:ln w="9525" cap="flat" cmpd="sng">
                  <a:solidFill>
                    <a:srgbClr val="000000"/>
                  </a:solidFill>
                  <a:prstDash val="solid"/>
                  <a:round/>
                  <a:headEnd type="none" w="sm" len="sm"/>
                  <a:tailEnd type="none" w="sm" len="sm"/>
                </a:ln>
              </p:spPr>
            </p:cxnSp>
            <p:cxnSp>
              <p:nvCxnSpPr>
                <p:cNvPr id="1511" name="Google Shape;1511;p11"/>
                <p:cNvCxnSpPr/>
                <p:nvPr/>
              </p:nvCxnSpPr>
              <p:spPr>
                <a:xfrm>
                  <a:off x="5658" y="3741"/>
                  <a:ext cx="0" cy="9"/>
                </a:xfrm>
                <a:prstGeom prst="straightConnector1">
                  <a:avLst/>
                </a:prstGeom>
                <a:noFill/>
                <a:ln w="9525" cap="flat" cmpd="sng">
                  <a:solidFill>
                    <a:srgbClr val="000000"/>
                  </a:solidFill>
                  <a:prstDash val="solid"/>
                  <a:round/>
                  <a:headEnd type="none" w="sm" len="sm"/>
                  <a:tailEnd type="none" w="sm" len="sm"/>
                </a:ln>
              </p:spPr>
            </p:cxnSp>
            <p:cxnSp>
              <p:nvCxnSpPr>
                <p:cNvPr id="1512" name="Google Shape;1512;p11"/>
                <p:cNvCxnSpPr/>
                <p:nvPr/>
              </p:nvCxnSpPr>
              <p:spPr>
                <a:xfrm>
                  <a:off x="5762" y="3741"/>
                  <a:ext cx="0" cy="15"/>
                </a:xfrm>
                <a:prstGeom prst="straightConnector1">
                  <a:avLst/>
                </a:prstGeom>
                <a:noFill/>
                <a:ln w="9525" cap="flat" cmpd="sng">
                  <a:solidFill>
                    <a:srgbClr val="000000"/>
                  </a:solidFill>
                  <a:prstDash val="solid"/>
                  <a:round/>
                  <a:headEnd type="none" w="sm" len="sm"/>
                  <a:tailEnd type="none" w="sm" len="sm"/>
                </a:ln>
              </p:spPr>
            </p:cxnSp>
            <p:sp>
              <p:nvSpPr>
                <p:cNvPr id="1513" name="Google Shape;1513;p11"/>
                <p:cNvSpPr/>
                <p:nvPr/>
              </p:nvSpPr>
              <p:spPr>
                <a:xfrm>
                  <a:off x="5709" y="3754"/>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5.0</a:t>
                  </a:r>
                  <a:endParaRPr sz="800" b="0" i="0" u="none" strike="noStrike" cap="none">
                    <a:solidFill>
                      <a:schemeClr val="dk1"/>
                    </a:solidFill>
                    <a:latin typeface="Arial"/>
                    <a:ea typeface="Arial"/>
                    <a:cs typeface="Arial"/>
                    <a:sym typeface="Arial"/>
                  </a:endParaRPr>
                </a:p>
              </p:txBody>
            </p:sp>
            <p:cxnSp>
              <p:nvCxnSpPr>
                <p:cNvPr id="1514" name="Google Shape;1514;p11"/>
                <p:cNvCxnSpPr/>
                <p:nvPr/>
              </p:nvCxnSpPr>
              <p:spPr>
                <a:xfrm>
                  <a:off x="5865" y="3741"/>
                  <a:ext cx="0" cy="9"/>
                </a:xfrm>
                <a:prstGeom prst="straightConnector1">
                  <a:avLst/>
                </a:prstGeom>
                <a:noFill/>
                <a:ln w="9525" cap="flat" cmpd="sng">
                  <a:solidFill>
                    <a:srgbClr val="000000"/>
                  </a:solidFill>
                  <a:prstDash val="solid"/>
                  <a:round/>
                  <a:headEnd type="none" w="sm" len="sm"/>
                  <a:tailEnd type="none" w="sm" len="sm"/>
                </a:ln>
              </p:spPr>
            </p:cxnSp>
            <p:cxnSp>
              <p:nvCxnSpPr>
                <p:cNvPr id="1515" name="Google Shape;1515;p11"/>
                <p:cNvCxnSpPr/>
                <p:nvPr/>
              </p:nvCxnSpPr>
              <p:spPr>
                <a:xfrm>
                  <a:off x="5968" y="3741"/>
                  <a:ext cx="0" cy="15"/>
                </a:xfrm>
                <a:prstGeom prst="straightConnector1">
                  <a:avLst/>
                </a:prstGeom>
                <a:noFill/>
                <a:ln w="9525" cap="flat" cmpd="sng">
                  <a:solidFill>
                    <a:srgbClr val="000000"/>
                  </a:solidFill>
                  <a:prstDash val="solid"/>
                  <a:round/>
                  <a:headEnd type="none" w="sm" len="sm"/>
                  <a:tailEnd type="none" w="sm" len="sm"/>
                </a:ln>
              </p:spPr>
            </p:cxnSp>
            <p:sp>
              <p:nvSpPr>
                <p:cNvPr id="1516" name="Google Shape;1516;p11"/>
                <p:cNvSpPr/>
                <p:nvPr/>
              </p:nvSpPr>
              <p:spPr>
                <a:xfrm>
                  <a:off x="5915" y="3754"/>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5.5</a:t>
                  </a:r>
                  <a:endParaRPr sz="800" b="0" i="0" u="none" strike="noStrike" cap="none">
                    <a:solidFill>
                      <a:schemeClr val="dk1"/>
                    </a:solidFill>
                    <a:latin typeface="Arial"/>
                    <a:ea typeface="Arial"/>
                    <a:cs typeface="Arial"/>
                    <a:sym typeface="Arial"/>
                  </a:endParaRPr>
                </a:p>
              </p:txBody>
            </p:sp>
            <p:cxnSp>
              <p:nvCxnSpPr>
                <p:cNvPr id="1517" name="Google Shape;1517;p11"/>
                <p:cNvCxnSpPr/>
                <p:nvPr/>
              </p:nvCxnSpPr>
              <p:spPr>
                <a:xfrm>
                  <a:off x="1421" y="1286"/>
                  <a:ext cx="0" cy="2443"/>
                </a:xfrm>
                <a:prstGeom prst="straightConnector1">
                  <a:avLst/>
                </a:prstGeom>
                <a:noFill/>
                <a:ln w="9525" cap="flat" cmpd="sng">
                  <a:solidFill>
                    <a:srgbClr val="000000"/>
                  </a:solidFill>
                  <a:prstDash val="solid"/>
                  <a:round/>
                  <a:headEnd type="none" w="sm" len="sm"/>
                  <a:tailEnd type="none" w="sm" len="sm"/>
                </a:ln>
              </p:spPr>
            </p:cxnSp>
            <p:cxnSp>
              <p:nvCxnSpPr>
                <p:cNvPr id="1518" name="Google Shape;1518;p11"/>
                <p:cNvCxnSpPr/>
                <p:nvPr/>
              </p:nvCxnSpPr>
              <p:spPr>
                <a:xfrm rot="10800000">
                  <a:off x="1407" y="3729"/>
                  <a:ext cx="14" cy="0"/>
                </a:xfrm>
                <a:prstGeom prst="straightConnector1">
                  <a:avLst/>
                </a:prstGeom>
                <a:noFill/>
                <a:ln w="9525" cap="flat" cmpd="sng">
                  <a:solidFill>
                    <a:srgbClr val="000000"/>
                  </a:solidFill>
                  <a:prstDash val="solid"/>
                  <a:round/>
                  <a:headEnd type="none" w="sm" len="sm"/>
                  <a:tailEnd type="none" w="sm" len="sm"/>
                </a:ln>
              </p:spPr>
            </p:cxnSp>
            <p:sp>
              <p:nvSpPr>
                <p:cNvPr id="1519" name="Google Shape;1519;p11"/>
                <p:cNvSpPr/>
                <p:nvPr/>
              </p:nvSpPr>
              <p:spPr>
                <a:xfrm>
                  <a:off x="1212" y="3684"/>
                  <a:ext cx="183"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0.0</a:t>
                  </a:r>
                  <a:endParaRPr sz="800" b="0" i="0" u="none" strike="noStrike" cap="none">
                    <a:solidFill>
                      <a:schemeClr val="dk1"/>
                    </a:solidFill>
                    <a:latin typeface="Arial"/>
                    <a:ea typeface="Arial"/>
                    <a:cs typeface="Arial"/>
                    <a:sym typeface="Arial"/>
                  </a:endParaRPr>
                </a:p>
              </p:txBody>
            </p:sp>
            <p:cxnSp>
              <p:nvCxnSpPr>
                <p:cNvPr id="1520" name="Google Shape;1520;p11"/>
                <p:cNvCxnSpPr/>
                <p:nvPr/>
              </p:nvCxnSpPr>
              <p:spPr>
                <a:xfrm rot="10800000">
                  <a:off x="1407" y="3729"/>
                  <a:ext cx="14" cy="0"/>
                </a:xfrm>
                <a:prstGeom prst="straightConnector1">
                  <a:avLst/>
                </a:prstGeom>
                <a:noFill/>
                <a:ln w="9525" cap="flat" cmpd="sng">
                  <a:solidFill>
                    <a:srgbClr val="000000"/>
                  </a:solidFill>
                  <a:prstDash val="solid"/>
                  <a:round/>
                  <a:headEnd type="none" w="sm" len="sm"/>
                  <a:tailEnd type="none" w="sm" len="sm"/>
                </a:ln>
              </p:spPr>
            </p:cxnSp>
            <p:cxnSp>
              <p:nvCxnSpPr>
                <p:cNvPr id="1521" name="Google Shape;1521;p11"/>
                <p:cNvCxnSpPr/>
                <p:nvPr/>
              </p:nvCxnSpPr>
              <p:spPr>
                <a:xfrm rot="10800000">
                  <a:off x="1413" y="3652"/>
                  <a:ext cx="8" cy="0"/>
                </a:xfrm>
                <a:prstGeom prst="straightConnector1">
                  <a:avLst/>
                </a:prstGeom>
                <a:noFill/>
                <a:ln w="9525" cap="flat" cmpd="sng">
                  <a:solidFill>
                    <a:srgbClr val="000000"/>
                  </a:solidFill>
                  <a:prstDash val="solid"/>
                  <a:round/>
                  <a:headEnd type="none" w="sm" len="sm"/>
                  <a:tailEnd type="none" w="sm" len="sm"/>
                </a:ln>
              </p:spPr>
            </p:cxnSp>
            <p:cxnSp>
              <p:nvCxnSpPr>
                <p:cNvPr id="1522" name="Google Shape;1522;p11"/>
                <p:cNvCxnSpPr/>
                <p:nvPr/>
              </p:nvCxnSpPr>
              <p:spPr>
                <a:xfrm rot="10800000">
                  <a:off x="1413" y="3576"/>
                  <a:ext cx="8" cy="0"/>
                </a:xfrm>
                <a:prstGeom prst="straightConnector1">
                  <a:avLst/>
                </a:prstGeom>
                <a:noFill/>
                <a:ln w="9525" cap="flat" cmpd="sng">
                  <a:solidFill>
                    <a:srgbClr val="000000"/>
                  </a:solidFill>
                  <a:prstDash val="solid"/>
                  <a:round/>
                  <a:headEnd type="none" w="sm" len="sm"/>
                  <a:tailEnd type="none" w="sm" len="sm"/>
                </a:ln>
              </p:spPr>
            </p:cxnSp>
            <p:cxnSp>
              <p:nvCxnSpPr>
                <p:cNvPr id="1523" name="Google Shape;1523;p11"/>
                <p:cNvCxnSpPr/>
                <p:nvPr/>
              </p:nvCxnSpPr>
              <p:spPr>
                <a:xfrm rot="10800000">
                  <a:off x="1413" y="3500"/>
                  <a:ext cx="8" cy="0"/>
                </a:xfrm>
                <a:prstGeom prst="straightConnector1">
                  <a:avLst/>
                </a:prstGeom>
                <a:noFill/>
                <a:ln w="9525" cap="flat" cmpd="sng">
                  <a:solidFill>
                    <a:srgbClr val="000000"/>
                  </a:solidFill>
                  <a:prstDash val="solid"/>
                  <a:round/>
                  <a:headEnd type="none" w="sm" len="sm"/>
                  <a:tailEnd type="none" w="sm" len="sm"/>
                </a:ln>
              </p:spPr>
            </p:cxnSp>
            <p:cxnSp>
              <p:nvCxnSpPr>
                <p:cNvPr id="1524" name="Google Shape;1524;p11"/>
                <p:cNvCxnSpPr/>
                <p:nvPr/>
              </p:nvCxnSpPr>
              <p:spPr>
                <a:xfrm rot="10800000">
                  <a:off x="1407" y="3423"/>
                  <a:ext cx="14" cy="0"/>
                </a:xfrm>
                <a:prstGeom prst="straightConnector1">
                  <a:avLst/>
                </a:prstGeom>
                <a:noFill/>
                <a:ln w="9525" cap="flat" cmpd="sng">
                  <a:solidFill>
                    <a:srgbClr val="000000"/>
                  </a:solidFill>
                  <a:prstDash val="solid"/>
                  <a:round/>
                  <a:headEnd type="none" w="sm" len="sm"/>
                  <a:tailEnd type="none" w="sm" len="sm"/>
                </a:ln>
              </p:spPr>
            </p:cxnSp>
            <p:sp>
              <p:nvSpPr>
                <p:cNvPr id="1525" name="Google Shape;1525;p11"/>
                <p:cNvSpPr/>
                <p:nvPr/>
              </p:nvSpPr>
              <p:spPr>
                <a:xfrm>
                  <a:off x="1258" y="3379"/>
                  <a:ext cx="112"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0.0</a:t>
                  </a:r>
                  <a:endParaRPr sz="800" b="0" i="0" u="none" strike="noStrike" cap="none">
                    <a:solidFill>
                      <a:schemeClr val="dk1"/>
                    </a:solidFill>
                    <a:latin typeface="Arial"/>
                    <a:ea typeface="Arial"/>
                    <a:cs typeface="Arial"/>
                    <a:sym typeface="Arial"/>
                  </a:endParaRPr>
                </a:p>
              </p:txBody>
            </p:sp>
            <p:cxnSp>
              <p:nvCxnSpPr>
                <p:cNvPr id="1526" name="Google Shape;1526;p11"/>
                <p:cNvCxnSpPr/>
                <p:nvPr/>
              </p:nvCxnSpPr>
              <p:spPr>
                <a:xfrm rot="10800000">
                  <a:off x="1413" y="3347"/>
                  <a:ext cx="8" cy="0"/>
                </a:xfrm>
                <a:prstGeom prst="straightConnector1">
                  <a:avLst/>
                </a:prstGeom>
                <a:noFill/>
                <a:ln w="9525" cap="flat" cmpd="sng">
                  <a:solidFill>
                    <a:srgbClr val="000000"/>
                  </a:solidFill>
                  <a:prstDash val="solid"/>
                  <a:round/>
                  <a:headEnd type="none" w="sm" len="sm"/>
                  <a:tailEnd type="none" w="sm" len="sm"/>
                </a:ln>
              </p:spPr>
            </p:cxnSp>
            <p:cxnSp>
              <p:nvCxnSpPr>
                <p:cNvPr id="1527" name="Google Shape;1527;p11"/>
                <p:cNvCxnSpPr/>
                <p:nvPr/>
              </p:nvCxnSpPr>
              <p:spPr>
                <a:xfrm rot="10800000">
                  <a:off x="1413" y="3271"/>
                  <a:ext cx="8" cy="0"/>
                </a:xfrm>
                <a:prstGeom prst="straightConnector1">
                  <a:avLst/>
                </a:prstGeom>
                <a:noFill/>
                <a:ln w="9525" cap="flat" cmpd="sng">
                  <a:solidFill>
                    <a:srgbClr val="000000"/>
                  </a:solidFill>
                  <a:prstDash val="solid"/>
                  <a:round/>
                  <a:headEnd type="none" w="sm" len="sm"/>
                  <a:tailEnd type="none" w="sm" len="sm"/>
                </a:ln>
              </p:spPr>
            </p:cxnSp>
            <p:cxnSp>
              <p:nvCxnSpPr>
                <p:cNvPr id="1528" name="Google Shape;1528;p11"/>
                <p:cNvCxnSpPr/>
                <p:nvPr/>
              </p:nvCxnSpPr>
              <p:spPr>
                <a:xfrm rot="10800000">
                  <a:off x="1413" y="3194"/>
                  <a:ext cx="8" cy="0"/>
                </a:xfrm>
                <a:prstGeom prst="straightConnector1">
                  <a:avLst/>
                </a:prstGeom>
                <a:noFill/>
                <a:ln w="9525" cap="flat" cmpd="sng">
                  <a:solidFill>
                    <a:srgbClr val="000000"/>
                  </a:solidFill>
                  <a:prstDash val="solid"/>
                  <a:round/>
                  <a:headEnd type="none" w="sm" len="sm"/>
                  <a:tailEnd type="none" w="sm" len="sm"/>
                </a:ln>
              </p:spPr>
            </p:cxnSp>
            <p:cxnSp>
              <p:nvCxnSpPr>
                <p:cNvPr id="1529" name="Google Shape;1529;p11"/>
                <p:cNvCxnSpPr/>
                <p:nvPr/>
              </p:nvCxnSpPr>
              <p:spPr>
                <a:xfrm rot="10800000">
                  <a:off x="1407" y="3118"/>
                  <a:ext cx="14" cy="0"/>
                </a:xfrm>
                <a:prstGeom prst="straightConnector1">
                  <a:avLst/>
                </a:prstGeom>
                <a:noFill/>
                <a:ln w="9525" cap="flat" cmpd="sng">
                  <a:solidFill>
                    <a:srgbClr val="000000"/>
                  </a:solidFill>
                  <a:prstDash val="solid"/>
                  <a:round/>
                  <a:headEnd type="none" w="sm" len="sm"/>
                  <a:tailEnd type="none" w="sm" len="sm"/>
                </a:ln>
              </p:spPr>
            </p:cxnSp>
            <p:sp>
              <p:nvSpPr>
                <p:cNvPr id="1530" name="Google Shape;1530;p11"/>
                <p:cNvSpPr/>
                <p:nvPr/>
              </p:nvSpPr>
              <p:spPr>
                <a:xfrm>
                  <a:off x="1229" y="3072"/>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0.0</a:t>
                  </a:r>
                  <a:endParaRPr sz="800" b="0" i="0" u="none" strike="noStrike" cap="none">
                    <a:solidFill>
                      <a:schemeClr val="dk1"/>
                    </a:solidFill>
                    <a:latin typeface="Arial"/>
                    <a:ea typeface="Arial"/>
                    <a:cs typeface="Arial"/>
                    <a:sym typeface="Arial"/>
                  </a:endParaRPr>
                </a:p>
              </p:txBody>
            </p:sp>
            <p:cxnSp>
              <p:nvCxnSpPr>
                <p:cNvPr id="1531" name="Google Shape;1531;p11"/>
                <p:cNvCxnSpPr/>
                <p:nvPr/>
              </p:nvCxnSpPr>
              <p:spPr>
                <a:xfrm rot="10800000">
                  <a:off x="1413" y="3042"/>
                  <a:ext cx="8" cy="0"/>
                </a:xfrm>
                <a:prstGeom prst="straightConnector1">
                  <a:avLst/>
                </a:prstGeom>
                <a:noFill/>
                <a:ln w="9525" cap="flat" cmpd="sng">
                  <a:solidFill>
                    <a:srgbClr val="000000"/>
                  </a:solidFill>
                  <a:prstDash val="solid"/>
                  <a:round/>
                  <a:headEnd type="none" w="sm" len="sm"/>
                  <a:tailEnd type="none" w="sm" len="sm"/>
                </a:ln>
              </p:spPr>
            </p:cxnSp>
            <p:cxnSp>
              <p:nvCxnSpPr>
                <p:cNvPr id="1532" name="Google Shape;1532;p11"/>
                <p:cNvCxnSpPr/>
                <p:nvPr/>
              </p:nvCxnSpPr>
              <p:spPr>
                <a:xfrm rot="10800000">
                  <a:off x="1413" y="2965"/>
                  <a:ext cx="8" cy="0"/>
                </a:xfrm>
                <a:prstGeom prst="straightConnector1">
                  <a:avLst/>
                </a:prstGeom>
                <a:noFill/>
                <a:ln w="9525" cap="flat" cmpd="sng">
                  <a:solidFill>
                    <a:srgbClr val="000000"/>
                  </a:solidFill>
                  <a:prstDash val="solid"/>
                  <a:round/>
                  <a:headEnd type="none" w="sm" len="sm"/>
                  <a:tailEnd type="none" w="sm" len="sm"/>
                </a:ln>
              </p:spPr>
            </p:cxnSp>
            <p:cxnSp>
              <p:nvCxnSpPr>
                <p:cNvPr id="1533" name="Google Shape;1533;p11"/>
                <p:cNvCxnSpPr/>
                <p:nvPr/>
              </p:nvCxnSpPr>
              <p:spPr>
                <a:xfrm rot="10800000">
                  <a:off x="1413" y="2889"/>
                  <a:ext cx="8" cy="0"/>
                </a:xfrm>
                <a:prstGeom prst="straightConnector1">
                  <a:avLst/>
                </a:prstGeom>
                <a:noFill/>
                <a:ln w="9525" cap="flat" cmpd="sng">
                  <a:solidFill>
                    <a:srgbClr val="000000"/>
                  </a:solidFill>
                  <a:prstDash val="solid"/>
                  <a:round/>
                  <a:headEnd type="none" w="sm" len="sm"/>
                  <a:tailEnd type="none" w="sm" len="sm"/>
                </a:ln>
              </p:spPr>
            </p:cxnSp>
            <p:cxnSp>
              <p:nvCxnSpPr>
                <p:cNvPr id="1534" name="Google Shape;1534;p11"/>
                <p:cNvCxnSpPr/>
                <p:nvPr/>
              </p:nvCxnSpPr>
              <p:spPr>
                <a:xfrm rot="10800000">
                  <a:off x="1407" y="2813"/>
                  <a:ext cx="14" cy="0"/>
                </a:xfrm>
                <a:prstGeom prst="straightConnector1">
                  <a:avLst/>
                </a:prstGeom>
                <a:noFill/>
                <a:ln w="9525" cap="flat" cmpd="sng">
                  <a:solidFill>
                    <a:srgbClr val="000000"/>
                  </a:solidFill>
                  <a:prstDash val="solid"/>
                  <a:round/>
                  <a:headEnd type="none" w="sm" len="sm"/>
                  <a:tailEnd type="none" w="sm" len="sm"/>
                </a:ln>
              </p:spPr>
            </p:cxnSp>
            <p:sp>
              <p:nvSpPr>
                <p:cNvPr id="1535" name="Google Shape;1535;p11"/>
                <p:cNvSpPr/>
                <p:nvPr/>
              </p:nvSpPr>
              <p:spPr>
                <a:xfrm>
                  <a:off x="1229" y="2767"/>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20.0</a:t>
                  </a:r>
                  <a:endParaRPr sz="800" b="0" i="0" u="none" strike="noStrike" cap="none">
                    <a:solidFill>
                      <a:schemeClr val="dk1"/>
                    </a:solidFill>
                    <a:latin typeface="Arial"/>
                    <a:ea typeface="Arial"/>
                    <a:cs typeface="Arial"/>
                    <a:sym typeface="Arial"/>
                  </a:endParaRPr>
                </a:p>
              </p:txBody>
            </p:sp>
            <p:cxnSp>
              <p:nvCxnSpPr>
                <p:cNvPr id="1536" name="Google Shape;1536;p11"/>
                <p:cNvCxnSpPr/>
                <p:nvPr/>
              </p:nvCxnSpPr>
              <p:spPr>
                <a:xfrm rot="10800000">
                  <a:off x="1413" y="2736"/>
                  <a:ext cx="8" cy="0"/>
                </a:xfrm>
                <a:prstGeom prst="straightConnector1">
                  <a:avLst/>
                </a:prstGeom>
                <a:noFill/>
                <a:ln w="9525" cap="flat" cmpd="sng">
                  <a:solidFill>
                    <a:srgbClr val="000000"/>
                  </a:solidFill>
                  <a:prstDash val="solid"/>
                  <a:round/>
                  <a:headEnd type="none" w="sm" len="sm"/>
                  <a:tailEnd type="none" w="sm" len="sm"/>
                </a:ln>
              </p:spPr>
            </p:cxnSp>
            <p:cxnSp>
              <p:nvCxnSpPr>
                <p:cNvPr id="1537" name="Google Shape;1537;p11"/>
                <p:cNvCxnSpPr/>
                <p:nvPr/>
              </p:nvCxnSpPr>
              <p:spPr>
                <a:xfrm rot="10800000">
                  <a:off x="1413" y="2660"/>
                  <a:ext cx="8" cy="0"/>
                </a:xfrm>
                <a:prstGeom prst="straightConnector1">
                  <a:avLst/>
                </a:prstGeom>
                <a:noFill/>
                <a:ln w="9525" cap="flat" cmpd="sng">
                  <a:solidFill>
                    <a:srgbClr val="000000"/>
                  </a:solidFill>
                  <a:prstDash val="solid"/>
                  <a:round/>
                  <a:headEnd type="none" w="sm" len="sm"/>
                  <a:tailEnd type="none" w="sm" len="sm"/>
                </a:ln>
              </p:spPr>
            </p:cxnSp>
            <p:cxnSp>
              <p:nvCxnSpPr>
                <p:cNvPr id="1538" name="Google Shape;1538;p11"/>
                <p:cNvCxnSpPr/>
                <p:nvPr/>
              </p:nvCxnSpPr>
              <p:spPr>
                <a:xfrm rot="10800000">
                  <a:off x="1413" y="2584"/>
                  <a:ext cx="8" cy="0"/>
                </a:xfrm>
                <a:prstGeom prst="straightConnector1">
                  <a:avLst/>
                </a:prstGeom>
                <a:noFill/>
                <a:ln w="9525" cap="flat" cmpd="sng">
                  <a:solidFill>
                    <a:srgbClr val="000000"/>
                  </a:solidFill>
                  <a:prstDash val="solid"/>
                  <a:round/>
                  <a:headEnd type="none" w="sm" len="sm"/>
                  <a:tailEnd type="none" w="sm" len="sm"/>
                </a:ln>
              </p:spPr>
            </p:cxnSp>
            <p:cxnSp>
              <p:nvCxnSpPr>
                <p:cNvPr id="1539" name="Google Shape;1539;p11"/>
                <p:cNvCxnSpPr/>
                <p:nvPr/>
              </p:nvCxnSpPr>
              <p:spPr>
                <a:xfrm rot="10800000">
                  <a:off x="1407" y="2507"/>
                  <a:ext cx="14" cy="0"/>
                </a:xfrm>
                <a:prstGeom prst="straightConnector1">
                  <a:avLst/>
                </a:prstGeom>
                <a:noFill/>
                <a:ln w="9525" cap="flat" cmpd="sng">
                  <a:solidFill>
                    <a:srgbClr val="000000"/>
                  </a:solidFill>
                  <a:prstDash val="solid"/>
                  <a:round/>
                  <a:headEnd type="none" w="sm" len="sm"/>
                  <a:tailEnd type="none" w="sm" len="sm"/>
                </a:ln>
              </p:spPr>
            </p:cxnSp>
            <p:sp>
              <p:nvSpPr>
                <p:cNvPr id="1540" name="Google Shape;1540;p11"/>
                <p:cNvSpPr/>
                <p:nvPr/>
              </p:nvSpPr>
              <p:spPr>
                <a:xfrm>
                  <a:off x="1229" y="2463"/>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30.0</a:t>
                  </a:r>
                  <a:endParaRPr sz="800" b="0" i="0" u="none" strike="noStrike" cap="none">
                    <a:solidFill>
                      <a:schemeClr val="dk1"/>
                    </a:solidFill>
                    <a:latin typeface="Arial"/>
                    <a:ea typeface="Arial"/>
                    <a:cs typeface="Arial"/>
                    <a:sym typeface="Arial"/>
                  </a:endParaRPr>
                </a:p>
              </p:txBody>
            </p:sp>
            <p:cxnSp>
              <p:nvCxnSpPr>
                <p:cNvPr id="1541" name="Google Shape;1541;p11"/>
                <p:cNvCxnSpPr/>
                <p:nvPr/>
              </p:nvCxnSpPr>
              <p:spPr>
                <a:xfrm rot="10800000">
                  <a:off x="1413" y="2431"/>
                  <a:ext cx="8" cy="0"/>
                </a:xfrm>
                <a:prstGeom prst="straightConnector1">
                  <a:avLst/>
                </a:prstGeom>
                <a:noFill/>
                <a:ln w="9525" cap="flat" cmpd="sng">
                  <a:solidFill>
                    <a:srgbClr val="000000"/>
                  </a:solidFill>
                  <a:prstDash val="solid"/>
                  <a:round/>
                  <a:headEnd type="none" w="sm" len="sm"/>
                  <a:tailEnd type="none" w="sm" len="sm"/>
                </a:ln>
              </p:spPr>
            </p:cxnSp>
            <p:cxnSp>
              <p:nvCxnSpPr>
                <p:cNvPr id="1542" name="Google Shape;1542;p11"/>
                <p:cNvCxnSpPr/>
                <p:nvPr/>
              </p:nvCxnSpPr>
              <p:spPr>
                <a:xfrm rot="10800000">
                  <a:off x="1413" y="2355"/>
                  <a:ext cx="8" cy="0"/>
                </a:xfrm>
                <a:prstGeom prst="straightConnector1">
                  <a:avLst/>
                </a:prstGeom>
                <a:noFill/>
                <a:ln w="9525" cap="flat" cmpd="sng">
                  <a:solidFill>
                    <a:srgbClr val="000000"/>
                  </a:solidFill>
                  <a:prstDash val="solid"/>
                  <a:round/>
                  <a:headEnd type="none" w="sm" len="sm"/>
                  <a:tailEnd type="none" w="sm" len="sm"/>
                </a:ln>
              </p:spPr>
            </p:cxnSp>
            <p:cxnSp>
              <p:nvCxnSpPr>
                <p:cNvPr id="1543" name="Google Shape;1543;p11"/>
                <p:cNvCxnSpPr/>
                <p:nvPr/>
              </p:nvCxnSpPr>
              <p:spPr>
                <a:xfrm rot="10800000">
                  <a:off x="1413" y="2278"/>
                  <a:ext cx="8" cy="0"/>
                </a:xfrm>
                <a:prstGeom prst="straightConnector1">
                  <a:avLst/>
                </a:prstGeom>
                <a:noFill/>
                <a:ln w="9525" cap="flat" cmpd="sng">
                  <a:solidFill>
                    <a:srgbClr val="000000"/>
                  </a:solidFill>
                  <a:prstDash val="solid"/>
                  <a:round/>
                  <a:headEnd type="none" w="sm" len="sm"/>
                  <a:tailEnd type="none" w="sm" len="sm"/>
                </a:ln>
              </p:spPr>
            </p:cxnSp>
            <p:cxnSp>
              <p:nvCxnSpPr>
                <p:cNvPr id="1544" name="Google Shape;1544;p11"/>
                <p:cNvCxnSpPr/>
                <p:nvPr/>
              </p:nvCxnSpPr>
              <p:spPr>
                <a:xfrm rot="10800000">
                  <a:off x="1407" y="2202"/>
                  <a:ext cx="14" cy="0"/>
                </a:xfrm>
                <a:prstGeom prst="straightConnector1">
                  <a:avLst/>
                </a:prstGeom>
                <a:noFill/>
                <a:ln w="9525" cap="flat" cmpd="sng">
                  <a:solidFill>
                    <a:srgbClr val="000000"/>
                  </a:solidFill>
                  <a:prstDash val="solid"/>
                  <a:round/>
                  <a:headEnd type="none" w="sm" len="sm"/>
                  <a:tailEnd type="none" w="sm" len="sm"/>
                </a:ln>
              </p:spPr>
            </p:cxnSp>
            <p:sp>
              <p:nvSpPr>
                <p:cNvPr id="1545" name="Google Shape;1545;p11"/>
                <p:cNvSpPr/>
                <p:nvPr/>
              </p:nvSpPr>
              <p:spPr>
                <a:xfrm>
                  <a:off x="1229" y="2158"/>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40.0</a:t>
                  </a:r>
                  <a:endParaRPr sz="800" b="0" i="0" u="none" strike="noStrike" cap="none">
                    <a:solidFill>
                      <a:schemeClr val="dk1"/>
                    </a:solidFill>
                    <a:latin typeface="Arial"/>
                    <a:ea typeface="Arial"/>
                    <a:cs typeface="Arial"/>
                    <a:sym typeface="Arial"/>
                  </a:endParaRPr>
                </a:p>
              </p:txBody>
            </p:sp>
            <p:cxnSp>
              <p:nvCxnSpPr>
                <p:cNvPr id="1546" name="Google Shape;1546;p11"/>
                <p:cNvCxnSpPr/>
                <p:nvPr/>
              </p:nvCxnSpPr>
              <p:spPr>
                <a:xfrm rot="10800000">
                  <a:off x="1413" y="2126"/>
                  <a:ext cx="8" cy="0"/>
                </a:xfrm>
                <a:prstGeom prst="straightConnector1">
                  <a:avLst/>
                </a:prstGeom>
                <a:noFill/>
                <a:ln w="9525" cap="flat" cmpd="sng">
                  <a:solidFill>
                    <a:srgbClr val="000000"/>
                  </a:solidFill>
                  <a:prstDash val="solid"/>
                  <a:round/>
                  <a:headEnd type="none" w="sm" len="sm"/>
                  <a:tailEnd type="none" w="sm" len="sm"/>
                </a:ln>
              </p:spPr>
            </p:cxnSp>
            <p:cxnSp>
              <p:nvCxnSpPr>
                <p:cNvPr id="1547" name="Google Shape;1547;p11"/>
                <p:cNvCxnSpPr/>
                <p:nvPr/>
              </p:nvCxnSpPr>
              <p:spPr>
                <a:xfrm rot="10800000">
                  <a:off x="1413" y="2049"/>
                  <a:ext cx="8" cy="0"/>
                </a:xfrm>
                <a:prstGeom prst="straightConnector1">
                  <a:avLst/>
                </a:prstGeom>
                <a:noFill/>
                <a:ln w="9525" cap="flat" cmpd="sng">
                  <a:solidFill>
                    <a:srgbClr val="000000"/>
                  </a:solidFill>
                  <a:prstDash val="solid"/>
                  <a:round/>
                  <a:headEnd type="none" w="sm" len="sm"/>
                  <a:tailEnd type="none" w="sm" len="sm"/>
                </a:ln>
              </p:spPr>
            </p:cxnSp>
            <p:cxnSp>
              <p:nvCxnSpPr>
                <p:cNvPr id="1548" name="Google Shape;1548;p11"/>
                <p:cNvCxnSpPr/>
                <p:nvPr/>
              </p:nvCxnSpPr>
              <p:spPr>
                <a:xfrm rot="10800000">
                  <a:off x="1413" y="1973"/>
                  <a:ext cx="8" cy="0"/>
                </a:xfrm>
                <a:prstGeom prst="straightConnector1">
                  <a:avLst/>
                </a:prstGeom>
                <a:noFill/>
                <a:ln w="9525" cap="flat" cmpd="sng">
                  <a:solidFill>
                    <a:srgbClr val="000000"/>
                  </a:solidFill>
                  <a:prstDash val="solid"/>
                  <a:round/>
                  <a:headEnd type="none" w="sm" len="sm"/>
                  <a:tailEnd type="none" w="sm" len="sm"/>
                </a:ln>
              </p:spPr>
            </p:cxnSp>
            <p:cxnSp>
              <p:nvCxnSpPr>
                <p:cNvPr id="1549" name="Google Shape;1549;p11"/>
                <p:cNvCxnSpPr/>
                <p:nvPr/>
              </p:nvCxnSpPr>
              <p:spPr>
                <a:xfrm rot="10800000">
                  <a:off x="1407" y="1897"/>
                  <a:ext cx="14" cy="0"/>
                </a:xfrm>
                <a:prstGeom prst="straightConnector1">
                  <a:avLst/>
                </a:prstGeom>
                <a:noFill/>
                <a:ln w="9525" cap="flat" cmpd="sng">
                  <a:solidFill>
                    <a:srgbClr val="000000"/>
                  </a:solidFill>
                  <a:prstDash val="solid"/>
                  <a:round/>
                  <a:headEnd type="none" w="sm" len="sm"/>
                  <a:tailEnd type="none" w="sm" len="sm"/>
                </a:ln>
              </p:spPr>
            </p:cxnSp>
            <p:sp>
              <p:nvSpPr>
                <p:cNvPr id="1550" name="Google Shape;1550;p11"/>
                <p:cNvSpPr/>
                <p:nvPr/>
              </p:nvSpPr>
              <p:spPr>
                <a:xfrm>
                  <a:off x="1229" y="1850"/>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50.0</a:t>
                  </a:r>
                  <a:endParaRPr sz="800" b="0" i="0" u="none" strike="noStrike" cap="none">
                    <a:solidFill>
                      <a:schemeClr val="dk1"/>
                    </a:solidFill>
                    <a:latin typeface="Arial"/>
                    <a:ea typeface="Arial"/>
                    <a:cs typeface="Arial"/>
                    <a:sym typeface="Arial"/>
                  </a:endParaRPr>
                </a:p>
              </p:txBody>
            </p:sp>
            <p:cxnSp>
              <p:nvCxnSpPr>
                <p:cNvPr id="1551" name="Google Shape;1551;p11"/>
                <p:cNvCxnSpPr/>
                <p:nvPr/>
              </p:nvCxnSpPr>
              <p:spPr>
                <a:xfrm rot="10800000">
                  <a:off x="1413" y="1820"/>
                  <a:ext cx="8" cy="0"/>
                </a:xfrm>
                <a:prstGeom prst="straightConnector1">
                  <a:avLst/>
                </a:prstGeom>
                <a:noFill/>
                <a:ln w="9525" cap="flat" cmpd="sng">
                  <a:solidFill>
                    <a:srgbClr val="000000"/>
                  </a:solidFill>
                  <a:prstDash val="solid"/>
                  <a:round/>
                  <a:headEnd type="none" w="sm" len="sm"/>
                  <a:tailEnd type="none" w="sm" len="sm"/>
                </a:ln>
              </p:spPr>
            </p:cxnSp>
            <p:cxnSp>
              <p:nvCxnSpPr>
                <p:cNvPr id="1552" name="Google Shape;1552;p11"/>
                <p:cNvCxnSpPr/>
                <p:nvPr/>
              </p:nvCxnSpPr>
              <p:spPr>
                <a:xfrm rot="10800000">
                  <a:off x="1413" y="1744"/>
                  <a:ext cx="8" cy="0"/>
                </a:xfrm>
                <a:prstGeom prst="straightConnector1">
                  <a:avLst/>
                </a:prstGeom>
                <a:noFill/>
                <a:ln w="9525" cap="flat" cmpd="sng">
                  <a:solidFill>
                    <a:srgbClr val="000000"/>
                  </a:solidFill>
                  <a:prstDash val="solid"/>
                  <a:round/>
                  <a:headEnd type="none" w="sm" len="sm"/>
                  <a:tailEnd type="none" w="sm" len="sm"/>
                </a:ln>
              </p:spPr>
            </p:cxnSp>
            <p:cxnSp>
              <p:nvCxnSpPr>
                <p:cNvPr id="1553" name="Google Shape;1553;p11"/>
                <p:cNvCxnSpPr/>
                <p:nvPr/>
              </p:nvCxnSpPr>
              <p:spPr>
                <a:xfrm rot="10800000">
                  <a:off x="1413" y="1668"/>
                  <a:ext cx="8" cy="0"/>
                </a:xfrm>
                <a:prstGeom prst="straightConnector1">
                  <a:avLst/>
                </a:prstGeom>
                <a:noFill/>
                <a:ln w="9525" cap="flat" cmpd="sng">
                  <a:solidFill>
                    <a:srgbClr val="000000"/>
                  </a:solidFill>
                  <a:prstDash val="solid"/>
                  <a:round/>
                  <a:headEnd type="none" w="sm" len="sm"/>
                  <a:tailEnd type="none" w="sm" len="sm"/>
                </a:ln>
              </p:spPr>
            </p:cxnSp>
            <p:cxnSp>
              <p:nvCxnSpPr>
                <p:cNvPr id="1554" name="Google Shape;1554;p11"/>
                <p:cNvCxnSpPr/>
                <p:nvPr/>
              </p:nvCxnSpPr>
              <p:spPr>
                <a:xfrm rot="10800000">
                  <a:off x="1407" y="1591"/>
                  <a:ext cx="14" cy="0"/>
                </a:xfrm>
                <a:prstGeom prst="straightConnector1">
                  <a:avLst/>
                </a:prstGeom>
                <a:noFill/>
                <a:ln w="9525" cap="flat" cmpd="sng">
                  <a:solidFill>
                    <a:srgbClr val="000000"/>
                  </a:solidFill>
                  <a:prstDash val="solid"/>
                  <a:round/>
                  <a:headEnd type="none" w="sm" len="sm"/>
                  <a:tailEnd type="none" w="sm" len="sm"/>
                </a:ln>
              </p:spPr>
            </p:cxnSp>
            <p:sp>
              <p:nvSpPr>
                <p:cNvPr id="1555" name="Google Shape;1555;p11"/>
                <p:cNvSpPr/>
                <p:nvPr/>
              </p:nvSpPr>
              <p:spPr>
                <a:xfrm>
                  <a:off x="1229" y="1546"/>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60.0</a:t>
                  </a:r>
                  <a:endParaRPr sz="800" b="0" i="0" u="none" strike="noStrike" cap="none">
                    <a:solidFill>
                      <a:schemeClr val="dk1"/>
                    </a:solidFill>
                    <a:latin typeface="Arial"/>
                    <a:ea typeface="Arial"/>
                    <a:cs typeface="Arial"/>
                    <a:sym typeface="Arial"/>
                  </a:endParaRPr>
                </a:p>
              </p:txBody>
            </p:sp>
            <p:cxnSp>
              <p:nvCxnSpPr>
                <p:cNvPr id="1556" name="Google Shape;1556;p11"/>
                <p:cNvCxnSpPr/>
                <p:nvPr/>
              </p:nvCxnSpPr>
              <p:spPr>
                <a:xfrm rot="10800000">
                  <a:off x="1413" y="1515"/>
                  <a:ext cx="8" cy="0"/>
                </a:xfrm>
                <a:prstGeom prst="straightConnector1">
                  <a:avLst/>
                </a:prstGeom>
                <a:noFill/>
                <a:ln w="9525" cap="flat" cmpd="sng">
                  <a:solidFill>
                    <a:srgbClr val="000000"/>
                  </a:solidFill>
                  <a:prstDash val="solid"/>
                  <a:round/>
                  <a:headEnd type="none" w="sm" len="sm"/>
                  <a:tailEnd type="none" w="sm" len="sm"/>
                </a:ln>
              </p:spPr>
            </p:cxnSp>
            <p:cxnSp>
              <p:nvCxnSpPr>
                <p:cNvPr id="1557" name="Google Shape;1557;p11"/>
                <p:cNvCxnSpPr/>
                <p:nvPr/>
              </p:nvCxnSpPr>
              <p:spPr>
                <a:xfrm rot="10800000">
                  <a:off x="1413" y="1439"/>
                  <a:ext cx="8" cy="0"/>
                </a:xfrm>
                <a:prstGeom prst="straightConnector1">
                  <a:avLst/>
                </a:prstGeom>
                <a:noFill/>
                <a:ln w="9525" cap="flat" cmpd="sng">
                  <a:solidFill>
                    <a:srgbClr val="000000"/>
                  </a:solidFill>
                  <a:prstDash val="solid"/>
                  <a:round/>
                  <a:headEnd type="none" w="sm" len="sm"/>
                  <a:tailEnd type="none" w="sm" len="sm"/>
                </a:ln>
              </p:spPr>
            </p:cxnSp>
            <p:cxnSp>
              <p:nvCxnSpPr>
                <p:cNvPr id="1558" name="Google Shape;1558;p11"/>
                <p:cNvCxnSpPr/>
                <p:nvPr/>
              </p:nvCxnSpPr>
              <p:spPr>
                <a:xfrm rot="10800000">
                  <a:off x="1413" y="1362"/>
                  <a:ext cx="8" cy="0"/>
                </a:xfrm>
                <a:prstGeom prst="straightConnector1">
                  <a:avLst/>
                </a:prstGeom>
                <a:noFill/>
                <a:ln w="9525" cap="flat" cmpd="sng">
                  <a:solidFill>
                    <a:srgbClr val="000000"/>
                  </a:solidFill>
                  <a:prstDash val="solid"/>
                  <a:round/>
                  <a:headEnd type="none" w="sm" len="sm"/>
                  <a:tailEnd type="none" w="sm" len="sm"/>
                </a:ln>
              </p:spPr>
            </p:cxnSp>
            <p:cxnSp>
              <p:nvCxnSpPr>
                <p:cNvPr id="1559" name="Google Shape;1559;p11"/>
                <p:cNvCxnSpPr/>
                <p:nvPr/>
              </p:nvCxnSpPr>
              <p:spPr>
                <a:xfrm rot="10800000">
                  <a:off x="1407" y="1286"/>
                  <a:ext cx="14" cy="0"/>
                </a:xfrm>
                <a:prstGeom prst="straightConnector1">
                  <a:avLst/>
                </a:prstGeom>
                <a:noFill/>
                <a:ln w="9525" cap="flat" cmpd="sng">
                  <a:solidFill>
                    <a:srgbClr val="000000"/>
                  </a:solidFill>
                  <a:prstDash val="solid"/>
                  <a:round/>
                  <a:headEnd type="none" w="sm" len="sm"/>
                  <a:tailEnd type="none" w="sm" len="sm"/>
                </a:ln>
              </p:spPr>
            </p:cxnSp>
            <p:sp>
              <p:nvSpPr>
                <p:cNvPr id="1560" name="Google Shape;1560;p11"/>
                <p:cNvSpPr/>
                <p:nvPr/>
              </p:nvSpPr>
              <p:spPr>
                <a:xfrm>
                  <a:off x="1229" y="1241"/>
                  <a:ext cx="157" cy="142"/>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70.0</a:t>
                  </a:r>
                  <a:endParaRPr sz="800" b="0" i="0" u="none" strike="noStrike" cap="none">
                    <a:solidFill>
                      <a:schemeClr val="dk1"/>
                    </a:solidFill>
                    <a:latin typeface="Arial"/>
                    <a:ea typeface="Arial"/>
                    <a:cs typeface="Arial"/>
                    <a:sym typeface="Arial"/>
                  </a:endParaRPr>
                </a:p>
              </p:txBody>
            </p:sp>
            <p:sp>
              <p:nvSpPr>
                <p:cNvPr id="1561" name="Google Shape;1561;p11"/>
                <p:cNvSpPr/>
                <p:nvPr/>
              </p:nvSpPr>
              <p:spPr>
                <a:xfrm>
                  <a:off x="1432" y="1622"/>
                  <a:ext cx="4536" cy="1795"/>
                </a:xfrm>
                <a:custGeom>
                  <a:avLst/>
                  <a:gdLst/>
                  <a:ahLst/>
                  <a:cxnLst/>
                  <a:rect l="l" t="t" r="r" b="b"/>
                  <a:pathLst>
                    <a:path w="4536" h="1795" extrusionOk="0">
                      <a:moveTo>
                        <a:pt x="0" y="1794"/>
                      </a:moveTo>
                      <a:lnTo>
                        <a:pt x="3" y="1794"/>
                      </a:lnTo>
                      <a:lnTo>
                        <a:pt x="7" y="1795"/>
                      </a:lnTo>
                      <a:lnTo>
                        <a:pt x="10" y="1795"/>
                      </a:lnTo>
                      <a:lnTo>
                        <a:pt x="14" y="1795"/>
                      </a:lnTo>
                      <a:lnTo>
                        <a:pt x="17" y="1795"/>
                      </a:lnTo>
                      <a:lnTo>
                        <a:pt x="21" y="1795"/>
                      </a:lnTo>
                      <a:lnTo>
                        <a:pt x="24" y="1794"/>
                      </a:lnTo>
                      <a:lnTo>
                        <a:pt x="28" y="1795"/>
                      </a:lnTo>
                      <a:lnTo>
                        <a:pt x="31" y="1794"/>
                      </a:lnTo>
                      <a:lnTo>
                        <a:pt x="34" y="1795"/>
                      </a:lnTo>
                      <a:lnTo>
                        <a:pt x="38" y="1795"/>
                      </a:lnTo>
                      <a:lnTo>
                        <a:pt x="41" y="1795"/>
                      </a:lnTo>
                      <a:lnTo>
                        <a:pt x="45" y="1794"/>
                      </a:lnTo>
                      <a:lnTo>
                        <a:pt x="48" y="1794"/>
                      </a:lnTo>
                      <a:lnTo>
                        <a:pt x="52" y="1794"/>
                      </a:lnTo>
                      <a:lnTo>
                        <a:pt x="55" y="1794"/>
                      </a:lnTo>
                      <a:lnTo>
                        <a:pt x="58" y="1795"/>
                      </a:lnTo>
                      <a:lnTo>
                        <a:pt x="62" y="1794"/>
                      </a:lnTo>
                      <a:lnTo>
                        <a:pt x="65" y="1794"/>
                      </a:lnTo>
                      <a:lnTo>
                        <a:pt x="69" y="1794"/>
                      </a:lnTo>
                      <a:lnTo>
                        <a:pt x="72" y="1794"/>
                      </a:lnTo>
                      <a:lnTo>
                        <a:pt x="76" y="1794"/>
                      </a:lnTo>
                      <a:lnTo>
                        <a:pt x="79" y="1794"/>
                      </a:lnTo>
                      <a:lnTo>
                        <a:pt x="82" y="1794"/>
                      </a:lnTo>
                      <a:lnTo>
                        <a:pt x="86" y="1794"/>
                      </a:lnTo>
                      <a:lnTo>
                        <a:pt x="89" y="1794"/>
                      </a:lnTo>
                      <a:lnTo>
                        <a:pt x="93" y="1793"/>
                      </a:lnTo>
                      <a:lnTo>
                        <a:pt x="96" y="1794"/>
                      </a:lnTo>
                      <a:lnTo>
                        <a:pt x="100" y="1793"/>
                      </a:lnTo>
                      <a:lnTo>
                        <a:pt x="103" y="1793"/>
                      </a:lnTo>
                      <a:lnTo>
                        <a:pt x="107" y="1794"/>
                      </a:lnTo>
                      <a:lnTo>
                        <a:pt x="110" y="1794"/>
                      </a:lnTo>
                      <a:lnTo>
                        <a:pt x="114" y="1793"/>
                      </a:lnTo>
                      <a:lnTo>
                        <a:pt x="117" y="1793"/>
                      </a:lnTo>
                      <a:lnTo>
                        <a:pt x="120" y="1793"/>
                      </a:lnTo>
                      <a:lnTo>
                        <a:pt x="124" y="1792"/>
                      </a:lnTo>
                      <a:lnTo>
                        <a:pt x="127" y="1793"/>
                      </a:lnTo>
                      <a:lnTo>
                        <a:pt x="131" y="1793"/>
                      </a:lnTo>
                      <a:lnTo>
                        <a:pt x="134" y="1794"/>
                      </a:lnTo>
                      <a:lnTo>
                        <a:pt x="137" y="1793"/>
                      </a:lnTo>
                      <a:lnTo>
                        <a:pt x="141" y="1793"/>
                      </a:lnTo>
                      <a:lnTo>
                        <a:pt x="144" y="1793"/>
                      </a:lnTo>
                      <a:lnTo>
                        <a:pt x="148" y="1793"/>
                      </a:lnTo>
                      <a:lnTo>
                        <a:pt x="151" y="1794"/>
                      </a:lnTo>
                      <a:lnTo>
                        <a:pt x="155" y="1794"/>
                      </a:lnTo>
                      <a:lnTo>
                        <a:pt x="158" y="1794"/>
                      </a:lnTo>
                      <a:lnTo>
                        <a:pt x="162" y="1794"/>
                      </a:lnTo>
                      <a:lnTo>
                        <a:pt x="165" y="1793"/>
                      </a:lnTo>
                      <a:lnTo>
                        <a:pt x="168" y="1793"/>
                      </a:lnTo>
                      <a:lnTo>
                        <a:pt x="172" y="1793"/>
                      </a:lnTo>
                      <a:lnTo>
                        <a:pt x="175" y="1793"/>
                      </a:lnTo>
                      <a:lnTo>
                        <a:pt x="179" y="1792"/>
                      </a:lnTo>
                      <a:lnTo>
                        <a:pt x="182" y="1792"/>
                      </a:lnTo>
                      <a:lnTo>
                        <a:pt x="186" y="1791"/>
                      </a:lnTo>
                      <a:lnTo>
                        <a:pt x="189" y="1791"/>
                      </a:lnTo>
                      <a:lnTo>
                        <a:pt x="192" y="1790"/>
                      </a:lnTo>
                      <a:lnTo>
                        <a:pt x="196" y="1788"/>
                      </a:lnTo>
                      <a:lnTo>
                        <a:pt x="199" y="1786"/>
                      </a:lnTo>
                      <a:lnTo>
                        <a:pt x="203" y="1784"/>
                      </a:lnTo>
                      <a:lnTo>
                        <a:pt x="206" y="1781"/>
                      </a:lnTo>
                      <a:lnTo>
                        <a:pt x="210" y="1779"/>
                      </a:lnTo>
                      <a:lnTo>
                        <a:pt x="213" y="1777"/>
                      </a:lnTo>
                      <a:lnTo>
                        <a:pt x="217" y="1776"/>
                      </a:lnTo>
                      <a:lnTo>
                        <a:pt x="220" y="1775"/>
                      </a:lnTo>
                      <a:lnTo>
                        <a:pt x="223" y="1777"/>
                      </a:lnTo>
                      <a:lnTo>
                        <a:pt x="227" y="1780"/>
                      </a:lnTo>
                      <a:lnTo>
                        <a:pt x="230" y="1782"/>
                      </a:lnTo>
                      <a:lnTo>
                        <a:pt x="234" y="1785"/>
                      </a:lnTo>
                      <a:lnTo>
                        <a:pt x="237" y="1785"/>
                      </a:lnTo>
                      <a:lnTo>
                        <a:pt x="240" y="1786"/>
                      </a:lnTo>
                      <a:lnTo>
                        <a:pt x="244" y="1785"/>
                      </a:lnTo>
                      <a:lnTo>
                        <a:pt x="247" y="1784"/>
                      </a:lnTo>
                      <a:lnTo>
                        <a:pt x="251" y="1783"/>
                      </a:lnTo>
                      <a:lnTo>
                        <a:pt x="254" y="1782"/>
                      </a:lnTo>
                      <a:lnTo>
                        <a:pt x="258" y="1781"/>
                      </a:lnTo>
                      <a:lnTo>
                        <a:pt x="261" y="1780"/>
                      </a:lnTo>
                      <a:lnTo>
                        <a:pt x="265" y="1779"/>
                      </a:lnTo>
                      <a:lnTo>
                        <a:pt x="268" y="1778"/>
                      </a:lnTo>
                      <a:lnTo>
                        <a:pt x="272" y="1778"/>
                      </a:lnTo>
                      <a:lnTo>
                        <a:pt x="275" y="1777"/>
                      </a:lnTo>
                      <a:lnTo>
                        <a:pt x="278" y="1776"/>
                      </a:lnTo>
                      <a:lnTo>
                        <a:pt x="282" y="1775"/>
                      </a:lnTo>
                      <a:lnTo>
                        <a:pt x="285" y="1773"/>
                      </a:lnTo>
                      <a:lnTo>
                        <a:pt x="289" y="1770"/>
                      </a:lnTo>
                      <a:lnTo>
                        <a:pt x="292" y="1770"/>
                      </a:lnTo>
                      <a:lnTo>
                        <a:pt x="295" y="1769"/>
                      </a:lnTo>
                      <a:lnTo>
                        <a:pt x="299" y="1771"/>
                      </a:lnTo>
                      <a:lnTo>
                        <a:pt x="302" y="1773"/>
                      </a:lnTo>
                      <a:lnTo>
                        <a:pt x="306" y="1774"/>
                      </a:lnTo>
                      <a:lnTo>
                        <a:pt x="309" y="1774"/>
                      </a:lnTo>
                      <a:lnTo>
                        <a:pt x="313" y="1774"/>
                      </a:lnTo>
                      <a:lnTo>
                        <a:pt x="316" y="1772"/>
                      </a:lnTo>
                      <a:lnTo>
                        <a:pt x="320" y="1770"/>
                      </a:lnTo>
                      <a:lnTo>
                        <a:pt x="323" y="1769"/>
                      </a:lnTo>
                      <a:lnTo>
                        <a:pt x="326" y="1767"/>
                      </a:lnTo>
                      <a:lnTo>
                        <a:pt x="330" y="1768"/>
                      </a:lnTo>
                      <a:lnTo>
                        <a:pt x="333" y="1770"/>
                      </a:lnTo>
                      <a:lnTo>
                        <a:pt x="337" y="1772"/>
                      </a:lnTo>
                      <a:lnTo>
                        <a:pt x="340" y="1774"/>
                      </a:lnTo>
                      <a:lnTo>
                        <a:pt x="344" y="1776"/>
                      </a:lnTo>
                      <a:lnTo>
                        <a:pt x="347" y="1777"/>
                      </a:lnTo>
                      <a:lnTo>
                        <a:pt x="351" y="1779"/>
                      </a:lnTo>
                      <a:lnTo>
                        <a:pt x="354" y="1781"/>
                      </a:lnTo>
                      <a:lnTo>
                        <a:pt x="357" y="1782"/>
                      </a:lnTo>
                      <a:lnTo>
                        <a:pt x="361" y="1782"/>
                      </a:lnTo>
                      <a:lnTo>
                        <a:pt x="364" y="1783"/>
                      </a:lnTo>
                      <a:lnTo>
                        <a:pt x="368" y="1783"/>
                      </a:lnTo>
                      <a:lnTo>
                        <a:pt x="371" y="1783"/>
                      </a:lnTo>
                      <a:lnTo>
                        <a:pt x="375" y="1782"/>
                      </a:lnTo>
                      <a:lnTo>
                        <a:pt x="378" y="1783"/>
                      </a:lnTo>
                      <a:lnTo>
                        <a:pt x="381" y="1784"/>
                      </a:lnTo>
                      <a:lnTo>
                        <a:pt x="385" y="1784"/>
                      </a:lnTo>
                      <a:lnTo>
                        <a:pt x="388" y="1784"/>
                      </a:lnTo>
                      <a:lnTo>
                        <a:pt x="392" y="1786"/>
                      </a:lnTo>
                      <a:lnTo>
                        <a:pt x="395" y="1785"/>
                      </a:lnTo>
                      <a:lnTo>
                        <a:pt x="399" y="1786"/>
                      </a:lnTo>
                      <a:lnTo>
                        <a:pt x="402" y="1786"/>
                      </a:lnTo>
                      <a:lnTo>
                        <a:pt x="406" y="1787"/>
                      </a:lnTo>
                      <a:lnTo>
                        <a:pt x="409" y="1787"/>
                      </a:lnTo>
                      <a:lnTo>
                        <a:pt x="412" y="1787"/>
                      </a:lnTo>
                      <a:lnTo>
                        <a:pt x="416" y="1788"/>
                      </a:lnTo>
                      <a:lnTo>
                        <a:pt x="419" y="1787"/>
                      </a:lnTo>
                      <a:lnTo>
                        <a:pt x="423" y="1786"/>
                      </a:lnTo>
                      <a:lnTo>
                        <a:pt x="426" y="1786"/>
                      </a:lnTo>
                      <a:lnTo>
                        <a:pt x="430" y="1786"/>
                      </a:lnTo>
                      <a:lnTo>
                        <a:pt x="433" y="1787"/>
                      </a:lnTo>
                      <a:lnTo>
                        <a:pt x="436" y="1787"/>
                      </a:lnTo>
                      <a:lnTo>
                        <a:pt x="440" y="1787"/>
                      </a:lnTo>
                      <a:lnTo>
                        <a:pt x="443" y="1788"/>
                      </a:lnTo>
                      <a:lnTo>
                        <a:pt x="447" y="1788"/>
                      </a:lnTo>
                      <a:lnTo>
                        <a:pt x="450" y="1788"/>
                      </a:lnTo>
                      <a:lnTo>
                        <a:pt x="454" y="1788"/>
                      </a:lnTo>
                      <a:lnTo>
                        <a:pt x="457" y="1790"/>
                      </a:lnTo>
                      <a:lnTo>
                        <a:pt x="461" y="1789"/>
                      </a:lnTo>
                      <a:lnTo>
                        <a:pt x="464" y="1790"/>
                      </a:lnTo>
                      <a:lnTo>
                        <a:pt x="467" y="1789"/>
                      </a:lnTo>
                      <a:lnTo>
                        <a:pt x="471" y="1789"/>
                      </a:lnTo>
                      <a:lnTo>
                        <a:pt x="474" y="1789"/>
                      </a:lnTo>
                      <a:lnTo>
                        <a:pt x="478" y="1789"/>
                      </a:lnTo>
                      <a:lnTo>
                        <a:pt x="481" y="1788"/>
                      </a:lnTo>
                      <a:lnTo>
                        <a:pt x="484" y="1788"/>
                      </a:lnTo>
                      <a:lnTo>
                        <a:pt x="488" y="1788"/>
                      </a:lnTo>
                      <a:lnTo>
                        <a:pt x="491" y="1789"/>
                      </a:lnTo>
                      <a:lnTo>
                        <a:pt x="495" y="1788"/>
                      </a:lnTo>
                      <a:lnTo>
                        <a:pt x="498" y="1789"/>
                      </a:lnTo>
                      <a:lnTo>
                        <a:pt x="502" y="1789"/>
                      </a:lnTo>
                      <a:lnTo>
                        <a:pt x="505" y="1789"/>
                      </a:lnTo>
                      <a:lnTo>
                        <a:pt x="509" y="1788"/>
                      </a:lnTo>
                      <a:lnTo>
                        <a:pt x="512" y="1788"/>
                      </a:lnTo>
                      <a:lnTo>
                        <a:pt x="515" y="1789"/>
                      </a:lnTo>
                      <a:lnTo>
                        <a:pt x="519" y="1788"/>
                      </a:lnTo>
                      <a:lnTo>
                        <a:pt x="522" y="1788"/>
                      </a:lnTo>
                      <a:lnTo>
                        <a:pt x="526" y="1787"/>
                      </a:lnTo>
                      <a:lnTo>
                        <a:pt x="529" y="1787"/>
                      </a:lnTo>
                      <a:lnTo>
                        <a:pt x="533" y="1786"/>
                      </a:lnTo>
                      <a:lnTo>
                        <a:pt x="536" y="1782"/>
                      </a:lnTo>
                      <a:lnTo>
                        <a:pt x="539" y="1775"/>
                      </a:lnTo>
                      <a:lnTo>
                        <a:pt x="543" y="1763"/>
                      </a:lnTo>
                      <a:lnTo>
                        <a:pt x="546" y="1744"/>
                      </a:lnTo>
                      <a:lnTo>
                        <a:pt x="550" y="1718"/>
                      </a:lnTo>
                      <a:lnTo>
                        <a:pt x="553" y="1689"/>
                      </a:lnTo>
                      <a:lnTo>
                        <a:pt x="557" y="1659"/>
                      </a:lnTo>
                      <a:lnTo>
                        <a:pt x="560" y="1636"/>
                      </a:lnTo>
                      <a:lnTo>
                        <a:pt x="564" y="1625"/>
                      </a:lnTo>
                      <a:lnTo>
                        <a:pt x="567" y="1629"/>
                      </a:lnTo>
                      <a:lnTo>
                        <a:pt x="570" y="1647"/>
                      </a:lnTo>
                      <a:lnTo>
                        <a:pt x="574" y="1673"/>
                      </a:lnTo>
                      <a:lnTo>
                        <a:pt x="577" y="1700"/>
                      </a:lnTo>
                      <a:lnTo>
                        <a:pt x="581" y="1726"/>
                      </a:lnTo>
                      <a:lnTo>
                        <a:pt x="584" y="1747"/>
                      </a:lnTo>
                      <a:lnTo>
                        <a:pt x="588" y="1763"/>
                      </a:lnTo>
                      <a:lnTo>
                        <a:pt x="591" y="1773"/>
                      </a:lnTo>
                      <a:lnTo>
                        <a:pt x="594" y="1779"/>
                      </a:lnTo>
                      <a:lnTo>
                        <a:pt x="598" y="1783"/>
                      </a:lnTo>
                      <a:lnTo>
                        <a:pt x="601" y="1784"/>
                      </a:lnTo>
                      <a:lnTo>
                        <a:pt x="605" y="1786"/>
                      </a:lnTo>
                      <a:lnTo>
                        <a:pt x="608" y="1787"/>
                      </a:lnTo>
                      <a:lnTo>
                        <a:pt x="612" y="1787"/>
                      </a:lnTo>
                      <a:lnTo>
                        <a:pt x="615" y="1786"/>
                      </a:lnTo>
                      <a:lnTo>
                        <a:pt x="619" y="1787"/>
                      </a:lnTo>
                      <a:lnTo>
                        <a:pt x="622" y="1787"/>
                      </a:lnTo>
                      <a:lnTo>
                        <a:pt x="625" y="1787"/>
                      </a:lnTo>
                      <a:lnTo>
                        <a:pt x="629" y="1787"/>
                      </a:lnTo>
                      <a:lnTo>
                        <a:pt x="632" y="1787"/>
                      </a:lnTo>
                      <a:lnTo>
                        <a:pt x="636" y="1786"/>
                      </a:lnTo>
                      <a:lnTo>
                        <a:pt x="639" y="1787"/>
                      </a:lnTo>
                      <a:lnTo>
                        <a:pt x="643" y="1787"/>
                      </a:lnTo>
                      <a:lnTo>
                        <a:pt x="646" y="1787"/>
                      </a:lnTo>
                      <a:lnTo>
                        <a:pt x="649" y="1788"/>
                      </a:lnTo>
                      <a:lnTo>
                        <a:pt x="653" y="1788"/>
                      </a:lnTo>
                      <a:lnTo>
                        <a:pt x="656" y="1787"/>
                      </a:lnTo>
                      <a:lnTo>
                        <a:pt x="660" y="1787"/>
                      </a:lnTo>
                      <a:lnTo>
                        <a:pt x="663" y="1787"/>
                      </a:lnTo>
                      <a:lnTo>
                        <a:pt x="667" y="1787"/>
                      </a:lnTo>
                      <a:lnTo>
                        <a:pt x="670" y="1787"/>
                      </a:lnTo>
                      <a:lnTo>
                        <a:pt x="673" y="1788"/>
                      </a:lnTo>
                      <a:lnTo>
                        <a:pt x="677" y="1787"/>
                      </a:lnTo>
                      <a:lnTo>
                        <a:pt x="680" y="1787"/>
                      </a:lnTo>
                      <a:lnTo>
                        <a:pt x="684" y="1788"/>
                      </a:lnTo>
                      <a:lnTo>
                        <a:pt x="687" y="1788"/>
                      </a:lnTo>
                      <a:lnTo>
                        <a:pt x="691" y="1787"/>
                      </a:lnTo>
                      <a:lnTo>
                        <a:pt x="694" y="1787"/>
                      </a:lnTo>
                      <a:lnTo>
                        <a:pt x="698" y="1787"/>
                      </a:lnTo>
                      <a:lnTo>
                        <a:pt x="701" y="1786"/>
                      </a:lnTo>
                      <a:lnTo>
                        <a:pt x="704" y="1786"/>
                      </a:lnTo>
                      <a:lnTo>
                        <a:pt x="708" y="1786"/>
                      </a:lnTo>
                      <a:lnTo>
                        <a:pt x="711" y="1786"/>
                      </a:lnTo>
                      <a:lnTo>
                        <a:pt x="715" y="1786"/>
                      </a:lnTo>
                      <a:lnTo>
                        <a:pt x="718" y="1786"/>
                      </a:lnTo>
                      <a:lnTo>
                        <a:pt x="722" y="1787"/>
                      </a:lnTo>
                      <a:lnTo>
                        <a:pt x="725" y="1786"/>
                      </a:lnTo>
                      <a:lnTo>
                        <a:pt x="728" y="1787"/>
                      </a:lnTo>
                      <a:lnTo>
                        <a:pt x="732" y="1787"/>
                      </a:lnTo>
                      <a:lnTo>
                        <a:pt x="735" y="1787"/>
                      </a:lnTo>
                      <a:lnTo>
                        <a:pt x="739" y="1786"/>
                      </a:lnTo>
                      <a:lnTo>
                        <a:pt x="742" y="1785"/>
                      </a:lnTo>
                      <a:lnTo>
                        <a:pt x="746" y="1786"/>
                      </a:lnTo>
                      <a:lnTo>
                        <a:pt x="749" y="1785"/>
                      </a:lnTo>
                      <a:lnTo>
                        <a:pt x="753" y="1785"/>
                      </a:lnTo>
                      <a:lnTo>
                        <a:pt x="756" y="1785"/>
                      </a:lnTo>
                      <a:lnTo>
                        <a:pt x="759" y="1785"/>
                      </a:lnTo>
                      <a:lnTo>
                        <a:pt x="763" y="1785"/>
                      </a:lnTo>
                      <a:lnTo>
                        <a:pt x="766" y="1785"/>
                      </a:lnTo>
                      <a:lnTo>
                        <a:pt x="770" y="1786"/>
                      </a:lnTo>
                      <a:lnTo>
                        <a:pt x="773" y="1786"/>
                      </a:lnTo>
                      <a:lnTo>
                        <a:pt x="777" y="1785"/>
                      </a:lnTo>
                      <a:lnTo>
                        <a:pt x="780" y="1786"/>
                      </a:lnTo>
                      <a:lnTo>
                        <a:pt x="783" y="1786"/>
                      </a:lnTo>
                      <a:lnTo>
                        <a:pt x="787" y="1785"/>
                      </a:lnTo>
                      <a:lnTo>
                        <a:pt x="790" y="1784"/>
                      </a:lnTo>
                      <a:lnTo>
                        <a:pt x="794" y="1785"/>
                      </a:lnTo>
                      <a:lnTo>
                        <a:pt x="797" y="1784"/>
                      </a:lnTo>
                      <a:lnTo>
                        <a:pt x="801" y="1783"/>
                      </a:lnTo>
                      <a:lnTo>
                        <a:pt x="804" y="1783"/>
                      </a:lnTo>
                      <a:lnTo>
                        <a:pt x="808" y="1781"/>
                      </a:lnTo>
                      <a:lnTo>
                        <a:pt x="811" y="1780"/>
                      </a:lnTo>
                      <a:lnTo>
                        <a:pt x="814" y="1780"/>
                      </a:lnTo>
                      <a:lnTo>
                        <a:pt x="818" y="1779"/>
                      </a:lnTo>
                      <a:lnTo>
                        <a:pt x="821" y="1780"/>
                      </a:lnTo>
                      <a:lnTo>
                        <a:pt x="825" y="1779"/>
                      </a:lnTo>
                      <a:lnTo>
                        <a:pt x="828" y="1778"/>
                      </a:lnTo>
                      <a:lnTo>
                        <a:pt x="831" y="1779"/>
                      </a:lnTo>
                      <a:lnTo>
                        <a:pt x="835" y="1778"/>
                      </a:lnTo>
                      <a:lnTo>
                        <a:pt x="838" y="1778"/>
                      </a:lnTo>
                      <a:lnTo>
                        <a:pt x="842" y="1778"/>
                      </a:lnTo>
                      <a:lnTo>
                        <a:pt x="845" y="1777"/>
                      </a:lnTo>
                      <a:lnTo>
                        <a:pt x="849" y="1776"/>
                      </a:lnTo>
                      <a:lnTo>
                        <a:pt x="852" y="1774"/>
                      </a:lnTo>
                      <a:lnTo>
                        <a:pt x="856" y="1773"/>
                      </a:lnTo>
                      <a:lnTo>
                        <a:pt x="859" y="1771"/>
                      </a:lnTo>
                      <a:lnTo>
                        <a:pt x="863" y="1770"/>
                      </a:lnTo>
                      <a:lnTo>
                        <a:pt x="866" y="1769"/>
                      </a:lnTo>
                      <a:lnTo>
                        <a:pt x="869" y="1768"/>
                      </a:lnTo>
                      <a:lnTo>
                        <a:pt x="873" y="1768"/>
                      </a:lnTo>
                      <a:lnTo>
                        <a:pt x="876" y="1769"/>
                      </a:lnTo>
                      <a:lnTo>
                        <a:pt x="880" y="1769"/>
                      </a:lnTo>
                      <a:lnTo>
                        <a:pt x="883" y="1770"/>
                      </a:lnTo>
                      <a:lnTo>
                        <a:pt x="886" y="1771"/>
                      </a:lnTo>
                      <a:lnTo>
                        <a:pt x="890" y="1773"/>
                      </a:lnTo>
                      <a:lnTo>
                        <a:pt x="893" y="1773"/>
                      </a:lnTo>
                      <a:lnTo>
                        <a:pt x="897" y="1775"/>
                      </a:lnTo>
                      <a:lnTo>
                        <a:pt x="900" y="1776"/>
                      </a:lnTo>
                      <a:lnTo>
                        <a:pt x="904" y="1777"/>
                      </a:lnTo>
                      <a:lnTo>
                        <a:pt x="907" y="1778"/>
                      </a:lnTo>
                      <a:lnTo>
                        <a:pt x="911" y="1779"/>
                      </a:lnTo>
                      <a:lnTo>
                        <a:pt x="914" y="1779"/>
                      </a:lnTo>
                      <a:lnTo>
                        <a:pt x="917" y="1780"/>
                      </a:lnTo>
                      <a:lnTo>
                        <a:pt x="921" y="1780"/>
                      </a:lnTo>
                      <a:lnTo>
                        <a:pt x="924" y="1779"/>
                      </a:lnTo>
                      <a:lnTo>
                        <a:pt x="928" y="1780"/>
                      </a:lnTo>
                      <a:lnTo>
                        <a:pt x="931" y="1780"/>
                      </a:lnTo>
                      <a:lnTo>
                        <a:pt x="935" y="1779"/>
                      </a:lnTo>
                      <a:lnTo>
                        <a:pt x="938" y="1779"/>
                      </a:lnTo>
                      <a:lnTo>
                        <a:pt x="941" y="1778"/>
                      </a:lnTo>
                      <a:lnTo>
                        <a:pt x="945" y="1778"/>
                      </a:lnTo>
                      <a:lnTo>
                        <a:pt x="948" y="1778"/>
                      </a:lnTo>
                      <a:lnTo>
                        <a:pt x="952" y="1778"/>
                      </a:lnTo>
                      <a:lnTo>
                        <a:pt x="955" y="1778"/>
                      </a:lnTo>
                      <a:lnTo>
                        <a:pt x="959" y="1779"/>
                      </a:lnTo>
                      <a:lnTo>
                        <a:pt x="962" y="1779"/>
                      </a:lnTo>
                      <a:lnTo>
                        <a:pt x="966" y="1778"/>
                      </a:lnTo>
                      <a:lnTo>
                        <a:pt x="969" y="1779"/>
                      </a:lnTo>
                      <a:lnTo>
                        <a:pt x="972" y="1778"/>
                      </a:lnTo>
                      <a:lnTo>
                        <a:pt x="976" y="1778"/>
                      </a:lnTo>
                      <a:lnTo>
                        <a:pt x="979" y="1778"/>
                      </a:lnTo>
                      <a:lnTo>
                        <a:pt x="983" y="1776"/>
                      </a:lnTo>
                      <a:lnTo>
                        <a:pt x="986" y="1777"/>
                      </a:lnTo>
                      <a:lnTo>
                        <a:pt x="990" y="1777"/>
                      </a:lnTo>
                      <a:lnTo>
                        <a:pt x="993" y="1776"/>
                      </a:lnTo>
                      <a:lnTo>
                        <a:pt x="997" y="1777"/>
                      </a:lnTo>
                      <a:lnTo>
                        <a:pt x="1000" y="1777"/>
                      </a:lnTo>
                      <a:lnTo>
                        <a:pt x="1003" y="1777"/>
                      </a:lnTo>
                      <a:lnTo>
                        <a:pt x="1007" y="1777"/>
                      </a:lnTo>
                      <a:lnTo>
                        <a:pt x="1010" y="1777"/>
                      </a:lnTo>
                      <a:lnTo>
                        <a:pt x="1014" y="1776"/>
                      </a:lnTo>
                      <a:lnTo>
                        <a:pt x="1017" y="1776"/>
                      </a:lnTo>
                      <a:lnTo>
                        <a:pt x="1020" y="1775"/>
                      </a:lnTo>
                      <a:lnTo>
                        <a:pt x="1024" y="1775"/>
                      </a:lnTo>
                      <a:lnTo>
                        <a:pt x="1027" y="1774"/>
                      </a:lnTo>
                      <a:lnTo>
                        <a:pt x="1031" y="1774"/>
                      </a:lnTo>
                      <a:lnTo>
                        <a:pt x="1034" y="1774"/>
                      </a:lnTo>
                      <a:lnTo>
                        <a:pt x="1038" y="1773"/>
                      </a:lnTo>
                      <a:lnTo>
                        <a:pt x="1041" y="1772"/>
                      </a:lnTo>
                      <a:lnTo>
                        <a:pt x="1045" y="1773"/>
                      </a:lnTo>
                      <a:lnTo>
                        <a:pt x="1048" y="1773"/>
                      </a:lnTo>
                      <a:lnTo>
                        <a:pt x="1052" y="1773"/>
                      </a:lnTo>
                      <a:lnTo>
                        <a:pt x="1055" y="1773"/>
                      </a:lnTo>
                      <a:lnTo>
                        <a:pt x="1058" y="1773"/>
                      </a:lnTo>
                      <a:lnTo>
                        <a:pt x="1062" y="1773"/>
                      </a:lnTo>
                      <a:lnTo>
                        <a:pt x="1065" y="1773"/>
                      </a:lnTo>
                      <a:lnTo>
                        <a:pt x="1069" y="1773"/>
                      </a:lnTo>
                      <a:lnTo>
                        <a:pt x="1072" y="1773"/>
                      </a:lnTo>
                      <a:lnTo>
                        <a:pt x="1075" y="1772"/>
                      </a:lnTo>
                      <a:lnTo>
                        <a:pt x="1079" y="1773"/>
                      </a:lnTo>
                      <a:lnTo>
                        <a:pt x="1082" y="1772"/>
                      </a:lnTo>
                      <a:lnTo>
                        <a:pt x="1086" y="1773"/>
                      </a:lnTo>
                      <a:lnTo>
                        <a:pt x="1089" y="1774"/>
                      </a:lnTo>
                      <a:lnTo>
                        <a:pt x="1093" y="1773"/>
                      </a:lnTo>
                      <a:lnTo>
                        <a:pt x="1096" y="1773"/>
                      </a:lnTo>
                      <a:lnTo>
                        <a:pt x="1100" y="1772"/>
                      </a:lnTo>
                      <a:lnTo>
                        <a:pt x="1103" y="1772"/>
                      </a:lnTo>
                      <a:lnTo>
                        <a:pt x="1106" y="1772"/>
                      </a:lnTo>
                      <a:lnTo>
                        <a:pt x="1110" y="1771"/>
                      </a:lnTo>
                      <a:lnTo>
                        <a:pt x="1113" y="1771"/>
                      </a:lnTo>
                      <a:lnTo>
                        <a:pt x="1117" y="1771"/>
                      </a:lnTo>
                      <a:lnTo>
                        <a:pt x="1120" y="1771"/>
                      </a:lnTo>
                      <a:lnTo>
                        <a:pt x="1124" y="1770"/>
                      </a:lnTo>
                      <a:lnTo>
                        <a:pt x="1127" y="1770"/>
                      </a:lnTo>
                      <a:lnTo>
                        <a:pt x="1130" y="1770"/>
                      </a:lnTo>
                      <a:lnTo>
                        <a:pt x="1134" y="1768"/>
                      </a:lnTo>
                      <a:lnTo>
                        <a:pt x="1137" y="1768"/>
                      </a:lnTo>
                      <a:lnTo>
                        <a:pt x="1141" y="1768"/>
                      </a:lnTo>
                      <a:lnTo>
                        <a:pt x="1144" y="1767"/>
                      </a:lnTo>
                      <a:lnTo>
                        <a:pt x="1148" y="1767"/>
                      </a:lnTo>
                      <a:lnTo>
                        <a:pt x="1151" y="1768"/>
                      </a:lnTo>
                      <a:lnTo>
                        <a:pt x="1155" y="1768"/>
                      </a:lnTo>
                      <a:lnTo>
                        <a:pt x="1158" y="1768"/>
                      </a:lnTo>
                      <a:lnTo>
                        <a:pt x="1161" y="1767"/>
                      </a:lnTo>
                      <a:lnTo>
                        <a:pt x="1165" y="1767"/>
                      </a:lnTo>
                      <a:lnTo>
                        <a:pt x="1168" y="1767"/>
                      </a:lnTo>
                      <a:lnTo>
                        <a:pt x="1172" y="1767"/>
                      </a:lnTo>
                      <a:lnTo>
                        <a:pt x="1175" y="1767"/>
                      </a:lnTo>
                      <a:lnTo>
                        <a:pt x="1178" y="1766"/>
                      </a:lnTo>
                      <a:lnTo>
                        <a:pt x="1182" y="1765"/>
                      </a:lnTo>
                      <a:lnTo>
                        <a:pt x="1185" y="1765"/>
                      </a:lnTo>
                      <a:lnTo>
                        <a:pt x="1189" y="1765"/>
                      </a:lnTo>
                      <a:lnTo>
                        <a:pt x="1192" y="1766"/>
                      </a:lnTo>
                      <a:lnTo>
                        <a:pt x="1196" y="1765"/>
                      </a:lnTo>
                      <a:lnTo>
                        <a:pt x="1199" y="1765"/>
                      </a:lnTo>
                      <a:lnTo>
                        <a:pt x="1203" y="1764"/>
                      </a:lnTo>
                      <a:lnTo>
                        <a:pt x="1206" y="1764"/>
                      </a:lnTo>
                      <a:lnTo>
                        <a:pt x="1210" y="1763"/>
                      </a:lnTo>
                      <a:lnTo>
                        <a:pt x="1213" y="1763"/>
                      </a:lnTo>
                      <a:lnTo>
                        <a:pt x="1216" y="1763"/>
                      </a:lnTo>
                      <a:lnTo>
                        <a:pt x="1220" y="1763"/>
                      </a:lnTo>
                      <a:lnTo>
                        <a:pt x="1223" y="1762"/>
                      </a:lnTo>
                      <a:lnTo>
                        <a:pt x="1227" y="1762"/>
                      </a:lnTo>
                      <a:lnTo>
                        <a:pt x="1230" y="1761"/>
                      </a:lnTo>
                      <a:lnTo>
                        <a:pt x="1234" y="1760"/>
                      </a:lnTo>
                      <a:lnTo>
                        <a:pt x="1237" y="1759"/>
                      </a:lnTo>
                      <a:lnTo>
                        <a:pt x="1240" y="1758"/>
                      </a:lnTo>
                      <a:lnTo>
                        <a:pt x="1244" y="1758"/>
                      </a:lnTo>
                      <a:lnTo>
                        <a:pt x="1247" y="1758"/>
                      </a:lnTo>
                      <a:lnTo>
                        <a:pt x="1251" y="1758"/>
                      </a:lnTo>
                      <a:lnTo>
                        <a:pt x="1254" y="1756"/>
                      </a:lnTo>
                      <a:lnTo>
                        <a:pt x="1258" y="1757"/>
                      </a:lnTo>
                      <a:lnTo>
                        <a:pt x="1261" y="1755"/>
                      </a:lnTo>
                      <a:lnTo>
                        <a:pt x="1264" y="1755"/>
                      </a:lnTo>
                      <a:lnTo>
                        <a:pt x="1268" y="1755"/>
                      </a:lnTo>
                      <a:lnTo>
                        <a:pt x="1271" y="1754"/>
                      </a:lnTo>
                      <a:lnTo>
                        <a:pt x="1275" y="1755"/>
                      </a:lnTo>
                      <a:lnTo>
                        <a:pt x="1278" y="1754"/>
                      </a:lnTo>
                      <a:lnTo>
                        <a:pt x="1282" y="1754"/>
                      </a:lnTo>
                      <a:lnTo>
                        <a:pt x="1285" y="1754"/>
                      </a:lnTo>
                      <a:lnTo>
                        <a:pt x="1289" y="1753"/>
                      </a:lnTo>
                      <a:lnTo>
                        <a:pt x="1292" y="1753"/>
                      </a:lnTo>
                      <a:lnTo>
                        <a:pt x="1295" y="1752"/>
                      </a:lnTo>
                      <a:lnTo>
                        <a:pt x="1299" y="1752"/>
                      </a:lnTo>
                      <a:lnTo>
                        <a:pt x="1302" y="1751"/>
                      </a:lnTo>
                      <a:lnTo>
                        <a:pt x="1306" y="1751"/>
                      </a:lnTo>
                      <a:lnTo>
                        <a:pt x="1309" y="1751"/>
                      </a:lnTo>
                      <a:lnTo>
                        <a:pt x="1313" y="1750"/>
                      </a:lnTo>
                      <a:lnTo>
                        <a:pt x="1316" y="1750"/>
                      </a:lnTo>
                      <a:lnTo>
                        <a:pt x="1319" y="1750"/>
                      </a:lnTo>
                      <a:lnTo>
                        <a:pt x="1323" y="1750"/>
                      </a:lnTo>
                      <a:lnTo>
                        <a:pt x="1326" y="1750"/>
                      </a:lnTo>
                      <a:lnTo>
                        <a:pt x="1330" y="1748"/>
                      </a:lnTo>
                      <a:lnTo>
                        <a:pt x="1333" y="1748"/>
                      </a:lnTo>
                      <a:lnTo>
                        <a:pt x="1337" y="1747"/>
                      </a:lnTo>
                      <a:lnTo>
                        <a:pt x="1340" y="1745"/>
                      </a:lnTo>
                      <a:lnTo>
                        <a:pt x="1344" y="1744"/>
                      </a:lnTo>
                      <a:lnTo>
                        <a:pt x="1347" y="1743"/>
                      </a:lnTo>
                      <a:lnTo>
                        <a:pt x="1350" y="1742"/>
                      </a:lnTo>
                      <a:lnTo>
                        <a:pt x="1354" y="1741"/>
                      </a:lnTo>
                      <a:lnTo>
                        <a:pt x="1357" y="1740"/>
                      </a:lnTo>
                      <a:lnTo>
                        <a:pt x="1361" y="1740"/>
                      </a:lnTo>
                      <a:lnTo>
                        <a:pt x="1364" y="1740"/>
                      </a:lnTo>
                      <a:lnTo>
                        <a:pt x="1368" y="1740"/>
                      </a:lnTo>
                      <a:lnTo>
                        <a:pt x="1371" y="1740"/>
                      </a:lnTo>
                      <a:lnTo>
                        <a:pt x="1374" y="1740"/>
                      </a:lnTo>
                      <a:lnTo>
                        <a:pt x="1378" y="1740"/>
                      </a:lnTo>
                      <a:lnTo>
                        <a:pt x="1381" y="1738"/>
                      </a:lnTo>
                      <a:lnTo>
                        <a:pt x="1385" y="1736"/>
                      </a:lnTo>
                      <a:lnTo>
                        <a:pt x="1388" y="1733"/>
                      </a:lnTo>
                      <a:lnTo>
                        <a:pt x="1392" y="1730"/>
                      </a:lnTo>
                      <a:lnTo>
                        <a:pt x="1395" y="1725"/>
                      </a:lnTo>
                      <a:lnTo>
                        <a:pt x="1399" y="1719"/>
                      </a:lnTo>
                      <a:lnTo>
                        <a:pt x="1402" y="1715"/>
                      </a:lnTo>
                      <a:lnTo>
                        <a:pt x="1405" y="1713"/>
                      </a:lnTo>
                      <a:lnTo>
                        <a:pt x="1409" y="1712"/>
                      </a:lnTo>
                      <a:lnTo>
                        <a:pt x="1412" y="1714"/>
                      </a:lnTo>
                      <a:lnTo>
                        <a:pt x="1416" y="1718"/>
                      </a:lnTo>
                      <a:lnTo>
                        <a:pt x="1419" y="1723"/>
                      </a:lnTo>
                      <a:lnTo>
                        <a:pt x="1422" y="1729"/>
                      </a:lnTo>
                      <a:lnTo>
                        <a:pt x="1426" y="1733"/>
                      </a:lnTo>
                      <a:lnTo>
                        <a:pt x="1429" y="1736"/>
                      </a:lnTo>
                      <a:lnTo>
                        <a:pt x="1433" y="1737"/>
                      </a:lnTo>
                      <a:lnTo>
                        <a:pt x="1436" y="1738"/>
                      </a:lnTo>
                      <a:lnTo>
                        <a:pt x="1440" y="1737"/>
                      </a:lnTo>
                      <a:lnTo>
                        <a:pt x="1443" y="1736"/>
                      </a:lnTo>
                      <a:lnTo>
                        <a:pt x="1447" y="1736"/>
                      </a:lnTo>
                      <a:lnTo>
                        <a:pt x="1450" y="1734"/>
                      </a:lnTo>
                      <a:lnTo>
                        <a:pt x="1453" y="1732"/>
                      </a:lnTo>
                      <a:lnTo>
                        <a:pt x="1457" y="1732"/>
                      </a:lnTo>
                      <a:lnTo>
                        <a:pt x="1460" y="1731"/>
                      </a:lnTo>
                      <a:lnTo>
                        <a:pt x="1464" y="1731"/>
                      </a:lnTo>
                      <a:lnTo>
                        <a:pt x="1467" y="1731"/>
                      </a:lnTo>
                      <a:lnTo>
                        <a:pt x="1471" y="1731"/>
                      </a:lnTo>
                      <a:lnTo>
                        <a:pt x="1474" y="1730"/>
                      </a:lnTo>
                      <a:lnTo>
                        <a:pt x="1477" y="1729"/>
                      </a:lnTo>
                      <a:lnTo>
                        <a:pt x="1481" y="1729"/>
                      </a:lnTo>
                      <a:lnTo>
                        <a:pt x="1484" y="1729"/>
                      </a:lnTo>
                      <a:lnTo>
                        <a:pt x="1488" y="1728"/>
                      </a:lnTo>
                      <a:lnTo>
                        <a:pt x="1491" y="1728"/>
                      </a:lnTo>
                      <a:lnTo>
                        <a:pt x="1495" y="1727"/>
                      </a:lnTo>
                      <a:lnTo>
                        <a:pt x="1498" y="1727"/>
                      </a:lnTo>
                      <a:lnTo>
                        <a:pt x="1502" y="1726"/>
                      </a:lnTo>
                      <a:lnTo>
                        <a:pt x="1505" y="1725"/>
                      </a:lnTo>
                      <a:lnTo>
                        <a:pt x="1508" y="1725"/>
                      </a:lnTo>
                      <a:lnTo>
                        <a:pt x="1512" y="1724"/>
                      </a:lnTo>
                      <a:lnTo>
                        <a:pt x="1515" y="1724"/>
                      </a:lnTo>
                      <a:lnTo>
                        <a:pt x="1519" y="1723"/>
                      </a:lnTo>
                      <a:lnTo>
                        <a:pt x="1522" y="1722"/>
                      </a:lnTo>
                      <a:lnTo>
                        <a:pt x="1526" y="1722"/>
                      </a:lnTo>
                      <a:lnTo>
                        <a:pt x="1529" y="1720"/>
                      </a:lnTo>
                      <a:lnTo>
                        <a:pt x="1532" y="1720"/>
                      </a:lnTo>
                      <a:lnTo>
                        <a:pt x="1536" y="1720"/>
                      </a:lnTo>
                      <a:lnTo>
                        <a:pt x="1539" y="1719"/>
                      </a:lnTo>
                      <a:lnTo>
                        <a:pt x="1543" y="1718"/>
                      </a:lnTo>
                      <a:lnTo>
                        <a:pt x="1546" y="1716"/>
                      </a:lnTo>
                      <a:lnTo>
                        <a:pt x="1550" y="1715"/>
                      </a:lnTo>
                      <a:lnTo>
                        <a:pt x="1553" y="1715"/>
                      </a:lnTo>
                      <a:lnTo>
                        <a:pt x="1557" y="1713"/>
                      </a:lnTo>
                      <a:lnTo>
                        <a:pt x="1560" y="1712"/>
                      </a:lnTo>
                      <a:lnTo>
                        <a:pt x="1563" y="1711"/>
                      </a:lnTo>
                      <a:lnTo>
                        <a:pt x="1567" y="1710"/>
                      </a:lnTo>
                      <a:lnTo>
                        <a:pt x="1570" y="1709"/>
                      </a:lnTo>
                      <a:lnTo>
                        <a:pt x="1574" y="1708"/>
                      </a:lnTo>
                      <a:lnTo>
                        <a:pt x="1577" y="1707"/>
                      </a:lnTo>
                      <a:lnTo>
                        <a:pt x="1581" y="1707"/>
                      </a:lnTo>
                      <a:lnTo>
                        <a:pt x="1584" y="1707"/>
                      </a:lnTo>
                      <a:lnTo>
                        <a:pt x="1587" y="1707"/>
                      </a:lnTo>
                      <a:lnTo>
                        <a:pt x="1591" y="1707"/>
                      </a:lnTo>
                      <a:lnTo>
                        <a:pt x="1594" y="1708"/>
                      </a:lnTo>
                      <a:lnTo>
                        <a:pt x="1598" y="1708"/>
                      </a:lnTo>
                      <a:lnTo>
                        <a:pt x="1601" y="1708"/>
                      </a:lnTo>
                      <a:lnTo>
                        <a:pt x="1605" y="1709"/>
                      </a:lnTo>
                      <a:lnTo>
                        <a:pt x="1608" y="1708"/>
                      </a:lnTo>
                      <a:lnTo>
                        <a:pt x="1611" y="1708"/>
                      </a:lnTo>
                      <a:lnTo>
                        <a:pt x="1615" y="1707"/>
                      </a:lnTo>
                      <a:lnTo>
                        <a:pt x="1618" y="1706"/>
                      </a:lnTo>
                      <a:lnTo>
                        <a:pt x="1622" y="1703"/>
                      </a:lnTo>
                      <a:lnTo>
                        <a:pt x="1625" y="1699"/>
                      </a:lnTo>
                      <a:lnTo>
                        <a:pt x="1629" y="1695"/>
                      </a:lnTo>
                      <a:lnTo>
                        <a:pt x="1632" y="1692"/>
                      </a:lnTo>
                      <a:lnTo>
                        <a:pt x="1636" y="1688"/>
                      </a:lnTo>
                      <a:lnTo>
                        <a:pt x="1639" y="1685"/>
                      </a:lnTo>
                      <a:lnTo>
                        <a:pt x="1643" y="1683"/>
                      </a:lnTo>
                      <a:lnTo>
                        <a:pt x="1646" y="1682"/>
                      </a:lnTo>
                      <a:lnTo>
                        <a:pt x="1649" y="1681"/>
                      </a:lnTo>
                      <a:lnTo>
                        <a:pt x="1653" y="1681"/>
                      </a:lnTo>
                      <a:lnTo>
                        <a:pt x="1656" y="1682"/>
                      </a:lnTo>
                      <a:lnTo>
                        <a:pt x="1660" y="1683"/>
                      </a:lnTo>
                      <a:lnTo>
                        <a:pt x="1663" y="1683"/>
                      </a:lnTo>
                      <a:lnTo>
                        <a:pt x="1666" y="1684"/>
                      </a:lnTo>
                      <a:lnTo>
                        <a:pt x="1670" y="1685"/>
                      </a:lnTo>
                      <a:lnTo>
                        <a:pt x="1673" y="1686"/>
                      </a:lnTo>
                      <a:lnTo>
                        <a:pt x="1677" y="1687"/>
                      </a:lnTo>
                      <a:lnTo>
                        <a:pt x="1680" y="1686"/>
                      </a:lnTo>
                      <a:lnTo>
                        <a:pt x="1684" y="1686"/>
                      </a:lnTo>
                      <a:lnTo>
                        <a:pt x="1687" y="1683"/>
                      </a:lnTo>
                      <a:lnTo>
                        <a:pt x="1691" y="1682"/>
                      </a:lnTo>
                      <a:lnTo>
                        <a:pt x="1694" y="1678"/>
                      </a:lnTo>
                      <a:lnTo>
                        <a:pt x="1697" y="1673"/>
                      </a:lnTo>
                      <a:lnTo>
                        <a:pt x="1701" y="1671"/>
                      </a:lnTo>
                      <a:lnTo>
                        <a:pt x="1704" y="1668"/>
                      </a:lnTo>
                      <a:lnTo>
                        <a:pt x="1708" y="1666"/>
                      </a:lnTo>
                      <a:lnTo>
                        <a:pt x="1711" y="1666"/>
                      </a:lnTo>
                      <a:lnTo>
                        <a:pt x="1715" y="1667"/>
                      </a:lnTo>
                      <a:lnTo>
                        <a:pt x="1718" y="1668"/>
                      </a:lnTo>
                      <a:lnTo>
                        <a:pt x="1721" y="1670"/>
                      </a:lnTo>
                      <a:lnTo>
                        <a:pt x="1725" y="1670"/>
                      </a:lnTo>
                      <a:lnTo>
                        <a:pt x="1728" y="1672"/>
                      </a:lnTo>
                      <a:lnTo>
                        <a:pt x="1732" y="1672"/>
                      </a:lnTo>
                      <a:lnTo>
                        <a:pt x="1735" y="1671"/>
                      </a:lnTo>
                      <a:lnTo>
                        <a:pt x="1739" y="1670"/>
                      </a:lnTo>
                      <a:lnTo>
                        <a:pt x="1742" y="1669"/>
                      </a:lnTo>
                      <a:lnTo>
                        <a:pt x="1746" y="1665"/>
                      </a:lnTo>
                      <a:lnTo>
                        <a:pt x="1749" y="1663"/>
                      </a:lnTo>
                      <a:lnTo>
                        <a:pt x="1752" y="1661"/>
                      </a:lnTo>
                      <a:lnTo>
                        <a:pt x="1756" y="1658"/>
                      </a:lnTo>
                      <a:lnTo>
                        <a:pt x="1759" y="1655"/>
                      </a:lnTo>
                      <a:lnTo>
                        <a:pt x="1763" y="1653"/>
                      </a:lnTo>
                      <a:lnTo>
                        <a:pt x="1766" y="1649"/>
                      </a:lnTo>
                      <a:lnTo>
                        <a:pt x="1769" y="1646"/>
                      </a:lnTo>
                      <a:lnTo>
                        <a:pt x="1773" y="1643"/>
                      </a:lnTo>
                      <a:lnTo>
                        <a:pt x="1776" y="1641"/>
                      </a:lnTo>
                      <a:lnTo>
                        <a:pt x="1780" y="1639"/>
                      </a:lnTo>
                      <a:lnTo>
                        <a:pt x="1783" y="1638"/>
                      </a:lnTo>
                      <a:lnTo>
                        <a:pt x="1787" y="1635"/>
                      </a:lnTo>
                      <a:lnTo>
                        <a:pt x="1790" y="1634"/>
                      </a:lnTo>
                      <a:lnTo>
                        <a:pt x="1794" y="1632"/>
                      </a:lnTo>
                      <a:lnTo>
                        <a:pt x="1797" y="1631"/>
                      </a:lnTo>
                      <a:lnTo>
                        <a:pt x="1800" y="1631"/>
                      </a:lnTo>
                      <a:lnTo>
                        <a:pt x="1804" y="1628"/>
                      </a:lnTo>
                      <a:lnTo>
                        <a:pt x="1807" y="1627"/>
                      </a:lnTo>
                      <a:lnTo>
                        <a:pt x="1811" y="1626"/>
                      </a:lnTo>
                      <a:lnTo>
                        <a:pt x="1814" y="1624"/>
                      </a:lnTo>
                      <a:lnTo>
                        <a:pt x="1818" y="1623"/>
                      </a:lnTo>
                      <a:lnTo>
                        <a:pt x="1821" y="1624"/>
                      </a:lnTo>
                      <a:lnTo>
                        <a:pt x="1824" y="1624"/>
                      </a:lnTo>
                      <a:lnTo>
                        <a:pt x="1828" y="1624"/>
                      </a:lnTo>
                      <a:lnTo>
                        <a:pt x="1831" y="1624"/>
                      </a:lnTo>
                      <a:lnTo>
                        <a:pt x="1835" y="1625"/>
                      </a:lnTo>
                      <a:lnTo>
                        <a:pt x="1838" y="1624"/>
                      </a:lnTo>
                      <a:lnTo>
                        <a:pt x="1842" y="1624"/>
                      </a:lnTo>
                      <a:lnTo>
                        <a:pt x="1845" y="1623"/>
                      </a:lnTo>
                      <a:lnTo>
                        <a:pt x="1849" y="1623"/>
                      </a:lnTo>
                      <a:lnTo>
                        <a:pt x="1852" y="1622"/>
                      </a:lnTo>
                      <a:lnTo>
                        <a:pt x="1855" y="1620"/>
                      </a:lnTo>
                      <a:lnTo>
                        <a:pt x="1859" y="1617"/>
                      </a:lnTo>
                      <a:lnTo>
                        <a:pt x="1862" y="1614"/>
                      </a:lnTo>
                      <a:lnTo>
                        <a:pt x="1866" y="1609"/>
                      </a:lnTo>
                      <a:lnTo>
                        <a:pt x="1869" y="1602"/>
                      </a:lnTo>
                      <a:lnTo>
                        <a:pt x="1873" y="1597"/>
                      </a:lnTo>
                      <a:lnTo>
                        <a:pt x="1876" y="1590"/>
                      </a:lnTo>
                      <a:lnTo>
                        <a:pt x="1880" y="1584"/>
                      </a:lnTo>
                      <a:lnTo>
                        <a:pt x="1883" y="1579"/>
                      </a:lnTo>
                      <a:lnTo>
                        <a:pt x="1886" y="1577"/>
                      </a:lnTo>
                      <a:lnTo>
                        <a:pt x="1890" y="1576"/>
                      </a:lnTo>
                      <a:lnTo>
                        <a:pt x="1893" y="1575"/>
                      </a:lnTo>
                      <a:lnTo>
                        <a:pt x="1897" y="1577"/>
                      </a:lnTo>
                      <a:lnTo>
                        <a:pt x="1900" y="1577"/>
                      </a:lnTo>
                      <a:lnTo>
                        <a:pt x="1904" y="1577"/>
                      </a:lnTo>
                      <a:lnTo>
                        <a:pt x="1907" y="1576"/>
                      </a:lnTo>
                      <a:lnTo>
                        <a:pt x="1910" y="1574"/>
                      </a:lnTo>
                      <a:lnTo>
                        <a:pt x="1914" y="1572"/>
                      </a:lnTo>
                      <a:lnTo>
                        <a:pt x="1917" y="1569"/>
                      </a:lnTo>
                      <a:lnTo>
                        <a:pt x="1921" y="1566"/>
                      </a:lnTo>
                      <a:lnTo>
                        <a:pt x="1924" y="1564"/>
                      </a:lnTo>
                      <a:lnTo>
                        <a:pt x="1928" y="1561"/>
                      </a:lnTo>
                      <a:lnTo>
                        <a:pt x="1931" y="1560"/>
                      </a:lnTo>
                      <a:lnTo>
                        <a:pt x="1935" y="1558"/>
                      </a:lnTo>
                      <a:lnTo>
                        <a:pt x="1938" y="1558"/>
                      </a:lnTo>
                      <a:lnTo>
                        <a:pt x="1941" y="1556"/>
                      </a:lnTo>
                      <a:lnTo>
                        <a:pt x="1945" y="1555"/>
                      </a:lnTo>
                      <a:lnTo>
                        <a:pt x="1948" y="1554"/>
                      </a:lnTo>
                      <a:lnTo>
                        <a:pt x="1952" y="1552"/>
                      </a:lnTo>
                      <a:lnTo>
                        <a:pt x="1955" y="1549"/>
                      </a:lnTo>
                      <a:lnTo>
                        <a:pt x="1958" y="1546"/>
                      </a:lnTo>
                      <a:lnTo>
                        <a:pt x="1962" y="1541"/>
                      </a:lnTo>
                      <a:lnTo>
                        <a:pt x="1965" y="1537"/>
                      </a:lnTo>
                      <a:lnTo>
                        <a:pt x="1969" y="1530"/>
                      </a:lnTo>
                      <a:lnTo>
                        <a:pt x="1972" y="1524"/>
                      </a:lnTo>
                      <a:lnTo>
                        <a:pt x="1976" y="1518"/>
                      </a:lnTo>
                      <a:lnTo>
                        <a:pt x="1979" y="1512"/>
                      </a:lnTo>
                      <a:lnTo>
                        <a:pt x="1983" y="1506"/>
                      </a:lnTo>
                      <a:lnTo>
                        <a:pt x="1986" y="1501"/>
                      </a:lnTo>
                      <a:lnTo>
                        <a:pt x="1990" y="1497"/>
                      </a:lnTo>
                      <a:lnTo>
                        <a:pt x="1993" y="1491"/>
                      </a:lnTo>
                      <a:lnTo>
                        <a:pt x="1996" y="1488"/>
                      </a:lnTo>
                      <a:lnTo>
                        <a:pt x="2000" y="1486"/>
                      </a:lnTo>
                      <a:lnTo>
                        <a:pt x="2003" y="1484"/>
                      </a:lnTo>
                      <a:lnTo>
                        <a:pt x="2007" y="1483"/>
                      </a:lnTo>
                      <a:lnTo>
                        <a:pt x="2010" y="1485"/>
                      </a:lnTo>
                      <a:lnTo>
                        <a:pt x="2013" y="1485"/>
                      </a:lnTo>
                      <a:lnTo>
                        <a:pt x="2017" y="1488"/>
                      </a:lnTo>
                      <a:lnTo>
                        <a:pt x="2020" y="1490"/>
                      </a:lnTo>
                      <a:lnTo>
                        <a:pt x="2024" y="1490"/>
                      </a:lnTo>
                      <a:lnTo>
                        <a:pt x="2027" y="1489"/>
                      </a:lnTo>
                      <a:lnTo>
                        <a:pt x="2031" y="1486"/>
                      </a:lnTo>
                      <a:lnTo>
                        <a:pt x="2034" y="1480"/>
                      </a:lnTo>
                      <a:lnTo>
                        <a:pt x="2038" y="1474"/>
                      </a:lnTo>
                      <a:lnTo>
                        <a:pt x="2041" y="1466"/>
                      </a:lnTo>
                      <a:lnTo>
                        <a:pt x="2044" y="1459"/>
                      </a:lnTo>
                      <a:lnTo>
                        <a:pt x="2048" y="1452"/>
                      </a:lnTo>
                      <a:lnTo>
                        <a:pt x="2051" y="1444"/>
                      </a:lnTo>
                      <a:lnTo>
                        <a:pt x="2055" y="1435"/>
                      </a:lnTo>
                      <a:lnTo>
                        <a:pt x="2058" y="1425"/>
                      </a:lnTo>
                      <a:lnTo>
                        <a:pt x="2062" y="1413"/>
                      </a:lnTo>
                      <a:lnTo>
                        <a:pt x="2065" y="1397"/>
                      </a:lnTo>
                      <a:lnTo>
                        <a:pt x="2068" y="1377"/>
                      </a:lnTo>
                      <a:lnTo>
                        <a:pt x="2072" y="1354"/>
                      </a:lnTo>
                      <a:lnTo>
                        <a:pt x="2075" y="1330"/>
                      </a:lnTo>
                      <a:lnTo>
                        <a:pt x="2079" y="1305"/>
                      </a:lnTo>
                      <a:lnTo>
                        <a:pt x="2082" y="1283"/>
                      </a:lnTo>
                      <a:lnTo>
                        <a:pt x="2086" y="1266"/>
                      </a:lnTo>
                      <a:lnTo>
                        <a:pt x="2089" y="1255"/>
                      </a:lnTo>
                      <a:lnTo>
                        <a:pt x="2093" y="1251"/>
                      </a:lnTo>
                      <a:lnTo>
                        <a:pt x="2096" y="1253"/>
                      </a:lnTo>
                      <a:lnTo>
                        <a:pt x="2099" y="1260"/>
                      </a:lnTo>
                      <a:lnTo>
                        <a:pt x="2103" y="1270"/>
                      </a:lnTo>
                      <a:lnTo>
                        <a:pt x="2106" y="1281"/>
                      </a:lnTo>
                      <a:lnTo>
                        <a:pt x="2110" y="1292"/>
                      </a:lnTo>
                      <a:lnTo>
                        <a:pt x="2113" y="1299"/>
                      </a:lnTo>
                      <a:lnTo>
                        <a:pt x="2116" y="1298"/>
                      </a:lnTo>
                      <a:lnTo>
                        <a:pt x="2120" y="1282"/>
                      </a:lnTo>
                      <a:lnTo>
                        <a:pt x="2123" y="1243"/>
                      </a:lnTo>
                      <a:lnTo>
                        <a:pt x="2124" y="1232"/>
                      </a:lnTo>
                      <a:lnTo>
                        <a:pt x="2127" y="1169"/>
                      </a:lnTo>
                      <a:lnTo>
                        <a:pt x="2130" y="1051"/>
                      </a:lnTo>
                      <a:lnTo>
                        <a:pt x="2134" y="892"/>
                      </a:lnTo>
                      <a:lnTo>
                        <a:pt x="2137" y="699"/>
                      </a:lnTo>
                      <a:lnTo>
                        <a:pt x="2141" y="492"/>
                      </a:lnTo>
                      <a:lnTo>
                        <a:pt x="2144" y="297"/>
                      </a:lnTo>
                      <a:lnTo>
                        <a:pt x="2145" y="261"/>
                      </a:lnTo>
                      <a:lnTo>
                        <a:pt x="2147" y="166"/>
                      </a:lnTo>
                      <a:lnTo>
                        <a:pt x="2148" y="139"/>
                      </a:lnTo>
                      <a:lnTo>
                        <a:pt x="2148" y="114"/>
                      </a:lnTo>
                      <a:lnTo>
                        <a:pt x="2150" y="56"/>
                      </a:lnTo>
                      <a:lnTo>
                        <a:pt x="2151" y="43"/>
                      </a:lnTo>
                      <a:lnTo>
                        <a:pt x="2152" y="33"/>
                      </a:lnTo>
                      <a:lnTo>
                        <a:pt x="2153" y="23"/>
                      </a:lnTo>
                      <a:lnTo>
                        <a:pt x="2154" y="27"/>
                      </a:lnTo>
                      <a:lnTo>
                        <a:pt x="2155" y="34"/>
                      </a:lnTo>
                      <a:lnTo>
                        <a:pt x="2157" y="73"/>
                      </a:lnTo>
                      <a:lnTo>
                        <a:pt x="2158" y="92"/>
                      </a:lnTo>
                      <a:lnTo>
                        <a:pt x="2159" y="114"/>
                      </a:lnTo>
                      <a:lnTo>
                        <a:pt x="2161" y="194"/>
                      </a:lnTo>
                      <a:lnTo>
                        <a:pt x="2161" y="226"/>
                      </a:lnTo>
                      <a:lnTo>
                        <a:pt x="2165" y="407"/>
                      </a:lnTo>
                      <a:lnTo>
                        <a:pt x="2168" y="606"/>
                      </a:lnTo>
                      <a:lnTo>
                        <a:pt x="2172" y="804"/>
                      </a:lnTo>
                      <a:lnTo>
                        <a:pt x="2175" y="979"/>
                      </a:lnTo>
                      <a:lnTo>
                        <a:pt x="2178" y="1124"/>
                      </a:lnTo>
                      <a:lnTo>
                        <a:pt x="2182" y="1235"/>
                      </a:lnTo>
                      <a:lnTo>
                        <a:pt x="2185" y="1315"/>
                      </a:lnTo>
                      <a:lnTo>
                        <a:pt x="2189" y="1369"/>
                      </a:lnTo>
                      <a:lnTo>
                        <a:pt x="2192" y="1403"/>
                      </a:lnTo>
                      <a:lnTo>
                        <a:pt x="2196" y="1421"/>
                      </a:lnTo>
                      <a:lnTo>
                        <a:pt x="2199" y="1430"/>
                      </a:lnTo>
                      <a:lnTo>
                        <a:pt x="2202" y="1431"/>
                      </a:lnTo>
                      <a:lnTo>
                        <a:pt x="2206" y="1430"/>
                      </a:lnTo>
                      <a:lnTo>
                        <a:pt x="2209" y="1426"/>
                      </a:lnTo>
                      <a:lnTo>
                        <a:pt x="2213" y="1420"/>
                      </a:lnTo>
                      <a:lnTo>
                        <a:pt x="2216" y="1414"/>
                      </a:lnTo>
                      <a:lnTo>
                        <a:pt x="2220" y="1409"/>
                      </a:lnTo>
                      <a:lnTo>
                        <a:pt x="2223" y="1405"/>
                      </a:lnTo>
                      <a:lnTo>
                        <a:pt x="2227" y="1400"/>
                      </a:lnTo>
                      <a:lnTo>
                        <a:pt x="2230" y="1397"/>
                      </a:lnTo>
                      <a:lnTo>
                        <a:pt x="2233" y="1395"/>
                      </a:lnTo>
                      <a:lnTo>
                        <a:pt x="2237" y="1393"/>
                      </a:lnTo>
                      <a:lnTo>
                        <a:pt x="2240" y="1391"/>
                      </a:lnTo>
                      <a:lnTo>
                        <a:pt x="2244" y="1390"/>
                      </a:lnTo>
                      <a:lnTo>
                        <a:pt x="2247" y="1389"/>
                      </a:lnTo>
                      <a:lnTo>
                        <a:pt x="2251" y="1388"/>
                      </a:lnTo>
                      <a:lnTo>
                        <a:pt x="2254" y="1385"/>
                      </a:lnTo>
                      <a:lnTo>
                        <a:pt x="2257" y="1381"/>
                      </a:lnTo>
                      <a:lnTo>
                        <a:pt x="2261" y="1375"/>
                      </a:lnTo>
                      <a:lnTo>
                        <a:pt x="2264" y="1367"/>
                      </a:lnTo>
                      <a:lnTo>
                        <a:pt x="2268" y="1357"/>
                      </a:lnTo>
                      <a:lnTo>
                        <a:pt x="2271" y="1344"/>
                      </a:lnTo>
                      <a:lnTo>
                        <a:pt x="2275" y="1332"/>
                      </a:lnTo>
                      <a:lnTo>
                        <a:pt x="2278" y="1315"/>
                      </a:lnTo>
                      <a:lnTo>
                        <a:pt x="2282" y="1297"/>
                      </a:lnTo>
                      <a:lnTo>
                        <a:pt x="2285" y="1276"/>
                      </a:lnTo>
                      <a:lnTo>
                        <a:pt x="2288" y="1249"/>
                      </a:lnTo>
                      <a:lnTo>
                        <a:pt x="2292" y="1217"/>
                      </a:lnTo>
                      <a:lnTo>
                        <a:pt x="2295" y="1179"/>
                      </a:lnTo>
                      <a:lnTo>
                        <a:pt x="2299" y="1130"/>
                      </a:lnTo>
                      <a:lnTo>
                        <a:pt x="2302" y="1065"/>
                      </a:lnTo>
                      <a:lnTo>
                        <a:pt x="2306" y="979"/>
                      </a:lnTo>
                      <a:lnTo>
                        <a:pt x="2309" y="863"/>
                      </a:lnTo>
                      <a:lnTo>
                        <a:pt x="2312" y="718"/>
                      </a:lnTo>
                      <a:lnTo>
                        <a:pt x="2316" y="547"/>
                      </a:lnTo>
                      <a:lnTo>
                        <a:pt x="2319" y="368"/>
                      </a:lnTo>
                      <a:lnTo>
                        <a:pt x="2323" y="202"/>
                      </a:lnTo>
                      <a:lnTo>
                        <a:pt x="2323" y="172"/>
                      </a:lnTo>
                      <a:lnTo>
                        <a:pt x="2326" y="73"/>
                      </a:lnTo>
                      <a:lnTo>
                        <a:pt x="2327" y="54"/>
                      </a:lnTo>
                      <a:lnTo>
                        <a:pt x="2329" y="14"/>
                      </a:lnTo>
                      <a:lnTo>
                        <a:pt x="2330" y="6"/>
                      </a:lnTo>
                      <a:lnTo>
                        <a:pt x="2331" y="0"/>
                      </a:lnTo>
                      <a:lnTo>
                        <a:pt x="2332" y="6"/>
                      </a:lnTo>
                      <a:lnTo>
                        <a:pt x="2333" y="14"/>
                      </a:lnTo>
                      <a:lnTo>
                        <a:pt x="2334" y="26"/>
                      </a:lnTo>
                      <a:lnTo>
                        <a:pt x="2336" y="77"/>
                      </a:lnTo>
                      <a:lnTo>
                        <a:pt x="2337" y="99"/>
                      </a:lnTo>
                      <a:lnTo>
                        <a:pt x="2337" y="125"/>
                      </a:lnTo>
                      <a:lnTo>
                        <a:pt x="2340" y="250"/>
                      </a:lnTo>
                      <a:lnTo>
                        <a:pt x="2343" y="443"/>
                      </a:lnTo>
                      <a:lnTo>
                        <a:pt x="2347" y="654"/>
                      </a:lnTo>
                      <a:lnTo>
                        <a:pt x="2350" y="863"/>
                      </a:lnTo>
                      <a:lnTo>
                        <a:pt x="2354" y="1052"/>
                      </a:lnTo>
                      <a:lnTo>
                        <a:pt x="2357" y="1213"/>
                      </a:lnTo>
                      <a:lnTo>
                        <a:pt x="2360" y="1345"/>
                      </a:lnTo>
                      <a:lnTo>
                        <a:pt x="2364" y="1448"/>
                      </a:lnTo>
                      <a:lnTo>
                        <a:pt x="2367" y="1524"/>
                      </a:lnTo>
                      <a:lnTo>
                        <a:pt x="2371" y="1581"/>
                      </a:lnTo>
                      <a:lnTo>
                        <a:pt x="2374" y="1623"/>
                      </a:lnTo>
                      <a:lnTo>
                        <a:pt x="2378" y="1654"/>
                      </a:lnTo>
                      <a:lnTo>
                        <a:pt x="2381" y="1676"/>
                      </a:lnTo>
                      <a:lnTo>
                        <a:pt x="2385" y="1692"/>
                      </a:lnTo>
                      <a:lnTo>
                        <a:pt x="2388" y="1704"/>
                      </a:lnTo>
                      <a:lnTo>
                        <a:pt x="2391" y="1714"/>
                      </a:lnTo>
                      <a:lnTo>
                        <a:pt x="2395" y="1721"/>
                      </a:lnTo>
                      <a:lnTo>
                        <a:pt x="2398" y="1726"/>
                      </a:lnTo>
                      <a:lnTo>
                        <a:pt x="2402" y="1731"/>
                      </a:lnTo>
                      <a:lnTo>
                        <a:pt x="2405" y="1734"/>
                      </a:lnTo>
                      <a:lnTo>
                        <a:pt x="2409" y="1737"/>
                      </a:lnTo>
                      <a:lnTo>
                        <a:pt x="2412" y="1739"/>
                      </a:lnTo>
                      <a:lnTo>
                        <a:pt x="2415" y="1742"/>
                      </a:lnTo>
                      <a:lnTo>
                        <a:pt x="2419" y="1743"/>
                      </a:lnTo>
                      <a:lnTo>
                        <a:pt x="2422" y="1746"/>
                      </a:lnTo>
                      <a:lnTo>
                        <a:pt x="2426" y="1747"/>
                      </a:lnTo>
                      <a:lnTo>
                        <a:pt x="2429" y="1749"/>
                      </a:lnTo>
                      <a:lnTo>
                        <a:pt x="2433" y="1750"/>
                      </a:lnTo>
                      <a:lnTo>
                        <a:pt x="2436" y="1752"/>
                      </a:lnTo>
                      <a:lnTo>
                        <a:pt x="2440" y="1754"/>
                      </a:lnTo>
                      <a:lnTo>
                        <a:pt x="2443" y="1755"/>
                      </a:lnTo>
                      <a:lnTo>
                        <a:pt x="2446" y="1757"/>
                      </a:lnTo>
                      <a:lnTo>
                        <a:pt x="2450" y="1758"/>
                      </a:lnTo>
                      <a:lnTo>
                        <a:pt x="2453" y="1761"/>
                      </a:lnTo>
                      <a:lnTo>
                        <a:pt x="2457" y="1762"/>
                      </a:lnTo>
                      <a:lnTo>
                        <a:pt x="2460" y="1763"/>
                      </a:lnTo>
                      <a:lnTo>
                        <a:pt x="2464" y="1764"/>
                      </a:lnTo>
                      <a:lnTo>
                        <a:pt x="2467" y="1765"/>
                      </a:lnTo>
                      <a:lnTo>
                        <a:pt x="2470" y="1766"/>
                      </a:lnTo>
                      <a:lnTo>
                        <a:pt x="2474" y="1767"/>
                      </a:lnTo>
                      <a:lnTo>
                        <a:pt x="2477" y="1768"/>
                      </a:lnTo>
                      <a:lnTo>
                        <a:pt x="2481" y="1768"/>
                      </a:lnTo>
                      <a:lnTo>
                        <a:pt x="2484" y="1768"/>
                      </a:lnTo>
                      <a:lnTo>
                        <a:pt x="2488" y="1768"/>
                      </a:lnTo>
                      <a:lnTo>
                        <a:pt x="2491" y="1768"/>
                      </a:lnTo>
                      <a:lnTo>
                        <a:pt x="2495" y="1768"/>
                      </a:lnTo>
                      <a:lnTo>
                        <a:pt x="2498" y="1768"/>
                      </a:lnTo>
                      <a:lnTo>
                        <a:pt x="2501" y="1769"/>
                      </a:lnTo>
                      <a:lnTo>
                        <a:pt x="2505" y="1770"/>
                      </a:lnTo>
                      <a:lnTo>
                        <a:pt x="2508" y="1769"/>
                      </a:lnTo>
                      <a:lnTo>
                        <a:pt x="2512" y="1769"/>
                      </a:lnTo>
                      <a:lnTo>
                        <a:pt x="2515" y="1770"/>
                      </a:lnTo>
                      <a:lnTo>
                        <a:pt x="2519" y="1770"/>
                      </a:lnTo>
                      <a:lnTo>
                        <a:pt x="2522" y="1770"/>
                      </a:lnTo>
                      <a:lnTo>
                        <a:pt x="2526" y="1770"/>
                      </a:lnTo>
                      <a:lnTo>
                        <a:pt x="2529" y="1770"/>
                      </a:lnTo>
                      <a:lnTo>
                        <a:pt x="2532" y="1770"/>
                      </a:lnTo>
                      <a:lnTo>
                        <a:pt x="2536" y="1771"/>
                      </a:lnTo>
                      <a:lnTo>
                        <a:pt x="2539" y="1770"/>
                      </a:lnTo>
                      <a:lnTo>
                        <a:pt x="2543" y="1770"/>
                      </a:lnTo>
                      <a:lnTo>
                        <a:pt x="2546" y="1770"/>
                      </a:lnTo>
                      <a:lnTo>
                        <a:pt x="2549" y="1770"/>
                      </a:lnTo>
                      <a:lnTo>
                        <a:pt x="2553" y="1770"/>
                      </a:lnTo>
                      <a:lnTo>
                        <a:pt x="2556" y="1770"/>
                      </a:lnTo>
                      <a:lnTo>
                        <a:pt x="2560" y="1770"/>
                      </a:lnTo>
                      <a:lnTo>
                        <a:pt x="2563" y="1770"/>
                      </a:lnTo>
                      <a:lnTo>
                        <a:pt x="2567" y="1770"/>
                      </a:lnTo>
                      <a:lnTo>
                        <a:pt x="2570" y="1770"/>
                      </a:lnTo>
                      <a:lnTo>
                        <a:pt x="2574" y="1769"/>
                      </a:lnTo>
                      <a:lnTo>
                        <a:pt x="2577" y="1769"/>
                      </a:lnTo>
                      <a:lnTo>
                        <a:pt x="2581" y="1769"/>
                      </a:lnTo>
                      <a:lnTo>
                        <a:pt x="2584" y="1769"/>
                      </a:lnTo>
                      <a:lnTo>
                        <a:pt x="2587" y="1770"/>
                      </a:lnTo>
                      <a:lnTo>
                        <a:pt x="2591" y="1770"/>
                      </a:lnTo>
                      <a:lnTo>
                        <a:pt x="2594" y="1771"/>
                      </a:lnTo>
                      <a:lnTo>
                        <a:pt x="2598" y="1771"/>
                      </a:lnTo>
                      <a:lnTo>
                        <a:pt x="2601" y="1771"/>
                      </a:lnTo>
                      <a:lnTo>
                        <a:pt x="2604" y="1771"/>
                      </a:lnTo>
                      <a:lnTo>
                        <a:pt x="2608" y="1772"/>
                      </a:lnTo>
                      <a:lnTo>
                        <a:pt x="2611" y="1773"/>
                      </a:lnTo>
                      <a:lnTo>
                        <a:pt x="2615" y="1774"/>
                      </a:lnTo>
                      <a:lnTo>
                        <a:pt x="2618" y="1774"/>
                      </a:lnTo>
                      <a:lnTo>
                        <a:pt x="2622" y="1775"/>
                      </a:lnTo>
                      <a:lnTo>
                        <a:pt x="2625" y="1776"/>
                      </a:lnTo>
                      <a:lnTo>
                        <a:pt x="2629" y="1777"/>
                      </a:lnTo>
                      <a:lnTo>
                        <a:pt x="2632" y="1777"/>
                      </a:lnTo>
                      <a:lnTo>
                        <a:pt x="2635" y="1777"/>
                      </a:lnTo>
                      <a:lnTo>
                        <a:pt x="2639" y="1779"/>
                      </a:lnTo>
                      <a:lnTo>
                        <a:pt x="2642" y="1779"/>
                      </a:lnTo>
                      <a:lnTo>
                        <a:pt x="2646" y="1779"/>
                      </a:lnTo>
                      <a:lnTo>
                        <a:pt x="2649" y="1780"/>
                      </a:lnTo>
                      <a:lnTo>
                        <a:pt x="2653" y="1780"/>
                      </a:lnTo>
                      <a:lnTo>
                        <a:pt x="2656" y="1780"/>
                      </a:lnTo>
                      <a:lnTo>
                        <a:pt x="2659" y="1781"/>
                      </a:lnTo>
                      <a:lnTo>
                        <a:pt x="2663" y="1781"/>
                      </a:lnTo>
                      <a:lnTo>
                        <a:pt x="2666" y="1781"/>
                      </a:lnTo>
                      <a:lnTo>
                        <a:pt x="2670" y="1781"/>
                      </a:lnTo>
                      <a:lnTo>
                        <a:pt x="2673" y="1781"/>
                      </a:lnTo>
                      <a:lnTo>
                        <a:pt x="2677" y="1780"/>
                      </a:lnTo>
                      <a:lnTo>
                        <a:pt x="2680" y="1781"/>
                      </a:lnTo>
                      <a:lnTo>
                        <a:pt x="2684" y="1780"/>
                      </a:lnTo>
                      <a:lnTo>
                        <a:pt x="2687" y="1781"/>
                      </a:lnTo>
                      <a:lnTo>
                        <a:pt x="2690" y="1781"/>
                      </a:lnTo>
                      <a:lnTo>
                        <a:pt x="2694" y="1780"/>
                      </a:lnTo>
                      <a:lnTo>
                        <a:pt x="2697" y="1781"/>
                      </a:lnTo>
                      <a:lnTo>
                        <a:pt x="2701" y="1782"/>
                      </a:lnTo>
                      <a:lnTo>
                        <a:pt x="2704" y="1781"/>
                      </a:lnTo>
                      <a:lnTo>
                        <a:pt x="2707" y="1781"/>
                      </a:lnTo>
                      <a:lnTo>
                        <a:pt x="2711" y="1781"/>
                      </a:lnTo>
                      <a:lnTo>
                        <a:pt x="2714" y="1781"/>
                      </a:lnTo>
                      <a:lnTo>
                        <a:pt x="2718" y="1781"/>
                      </a:lnTo>
                      <a:lnTo>
                        <a:pt x="2721" y="1781"/>
                      </a:lnTo>
                      <a:lnTo>
                        <a:pt x="2725" y="1782"/>
                      </a:lnTo>
                      <a:lnTo>
                        <a:pt x="2728" y="1782"/>
                      </a:lnTo>
                      <a:lnTo>
                        <a:pt x="2732" y="1782"/>
                      </a:lnTo>
                      <a:lnTo>
                        <a:pt x="2735" y="1781"/>
                      </a:lnTo>
                      <a:lnTo>
                        <a:pt x="2738" y="1782"/>
                      </a:lnTo>
                      <a:lnTo>
                        <a:pt x="2742" y="1783"/>
                      </a:lnTo>
                      <a:lnTo>
                        <a:pt x="2745" y="1783"/>
                      </a:lnTo>
                      <a:lnTo>
                        <a:pt x="2749" y="1783"/>
                      </a:lnTo>
                      <a:lnTo>
                        <a:pt x="2752" y="1782"/>
                      </a:lnTo>
                      <a:lnTo>
                        <a:pt x="2756" y="1783"/>
                      </a:lnTo>
                      <a:lnTo>
                        <a:pt x="2759" y="1783"/>
                      </a:lnTo>
                      <a:lnTo>
                        <a:pt x="2763" y="1783"/>
                      </a:lnTo>
                      <a:lnTo>
                        <a:pt x="2766" y="1784"/>
                      </a:lnTo>
                      <a:lnTo>
                        <a:pt x="2769" y="1784"/>
                      </a:lnTo>
                      <a:lnTo>
                        <a:pt x="2773" y="1784"/>
                      </a:lnTo>
                      <a:lnTo>
                        <a:pt x="2776" y="1784"/>
                      </a:lnTo>
                      <a:lnTo>
                        <a:pt x="2780" y="1784"/>
                      </a:lnTo>
                      <a:lnTo>
                        <a:pt x="2783" y="1784"/>
                      </a:lnTo>
                      <a:lnTo>
                        <a:pt x="2787" y="1784"/>
                      </a:lnTo>
                      <a:lnTo>
                        <a:pt x="2790" y="1784"/>
                      </a:lnTo>
                      <a:lnTo>
                        <a:pt x="2793" y="1784"/>
                      </a:lnTo>
                      <a:lnTo>
                        <a:pt x="2797" y="1784"/>
                      </a:lnTo>
                      <a:lnTo>
                        <a:pt x="2800" y="1785"/>
                      </a:lnTo>
                      <a:lnTo>
                        <a:pt x="2804" y="1784"/>
                      </a:lnTo>
                      <a:lnTo>
                        <a:pt x="2807" y="1784"/>
                      </a:lnTo>
                      <a:lnTo>
                        <a:pt x="2811" y="1785"/>
                      </a:lnTo>
                      <a:lnTo>
                        <a:pt x="2814" y="1784"/>
                      </a:lnTo>
                      <a:lnTo>
                        <a:pt x="2818" y="1785"/>
                      </a:lnTo>
                      <a:lnTo>
                        <a:pt x="2821" y="1785"/>
                      </a:lnTo>
                      <a:lnTo>
                        <a:pt x="2824" y="1784"/>
                      </a:lnTo>
                      <a:lnTo>
                        <a:pt x="2828" y="1784"/>
                      </a:lnTo>
                      <a:lnTo>
                        <a:pt x="2831" y="1784"/>
                      </a:lnTo>
                      <a:lnTo>
                        <a:pt x="2835" y="1784"/>
                      </a:lnTo>
                      <a:lnTo>
                        <a:pt x="2838" y="1784"/>
                      </a:lnTo>
                      <a:lnTo>
                        <a:pt x="2842" y="1784"/>
                      </a:lnTo>
                      <a:lnTo>
                        <a:pt x="2845" y="1785"/>
                      </a:lnTo>
                      <a:lnTo>
                        <a:pt x="2848" y="1784"/>
                      </a:lnTo>
                      <a:lnTo>
                        <a:pt x="2852" y="1784"/>
                      </a:lnTo>
                      <a:lnTo>
                        <a:pt x="2855" y="1784"/>
                      </a:lnTo>
                      <a:lnTo>
                        <a:pt x="2859" y="1784"/>
                      </a:lnTo>
                      <a:lnTo>
                        <a:pt x="2862" y="1784"/>
                      </a:lnTo>
                      <a:lnTo>
                        <a:pt x="2866" y="1783"/>
                      </a:lnTo>
                      <a:lnTo>
                        <a:pt x="2869" y="1784"/>
                      </a:lnTo>
                      <a:lnTo>
                        <a:pt x="2873" y="1783"/>
                      </a:lnTo>
                      <a:lnTo>
                        <a:pt x="2876" y="1784"/>
                      </a:lnTo>
                      <a:lnTo>
                        <a:pt x="2879" y="1783"/>
                      </a:lnTo>
                      <a:lnTo>
                        <a:pt x="2883" y="1784"/>
                      </a:lnTo>
                      <a:lnTo>
                        <a:pt x="2886" y="1783"/>
                      </a:lnTo>
                      <a:lnTo>
                        <a:pt x="2890" y="1783"/>
                      </a:lnTo>
                      <a:lnTo>
                        <a:pt x="2893" y="1782"/>
                      </a:lnTo>
                      <a:lnTo>
                        <a:pt x="2896" y="1782"/>
                      </a:lnTo>
                      <a:lnTo>
                        <a:pt x="2900" y="1783"/>
                      </a:lnTo>
                      <a:lnTo>
                        <a:pt x="2903" y="1783"/>
                      </a:lnTo>
                      <a:lnTo>
                        <a:pt x="2907" y="1782"/>
                      </a:lnTo>
                      <a:lnTo>
                        <a:pt x="2910" y="1783"/>
                      </a:lnTo>
                      <a:lnTo>
                        <a:pt x="2914" y="1783"/>
                      </a:lnTo>
                      <a:lnTo>
                        <a:pt x="2917" y="1783"/>
                      </a:lnTo>
                      <a:lnTo>
                        <a:pt x="2921" y="1782"/>
                      </a:lnTo>
                      <a:lnTo>
                        <a:pt x="2924" y="1782"/>
                      </a:lnTo>
                      <a:lnTo>
                        <a:pt x="2928" y="1783"/>
                      </a:lnTo>
                      <a:lnTo>
                        <a:pt x="2931" y="1782"/>
                      </a:lnTo>
                      <a:lnTo>
                        <a:pt x="2934" y="1782"/>
                      </a:lnTo>
                      <a:lnTo>
                        <a:pt x="2938" y="1783"/>
                      </a:lnTo>
                      <a:lnTo>
                        <a:pt x="2941" y="1783"/>
                      </a:lnTo>
                      <a:lnTo>
                        <a:pt x="2945" y="1782"/>
                      </a:lnTo>
                      <a:lnTo>
                        <a:pt x="2948" y="1782"/>
                      </a:lnTo>
                      <a:lnTo>
                        <a:pt x="2951" y="1781"/>
                      </a:lnTo>
                      <a:lnTo>
                        <a:pt x="2955" y="1782"/>
                      </a:lnTo>
                      <a:lnTo>
                        <a:pt x="2958" y="1782"/>
                      </a:lnTo>
                      <a:lnTo>
                        <a:pt x="2962" y="1782"/>
                      </a:lnTo>
                      <a:lnTo>
                        <a:pt x="2965" y="1782"/>
                      </a:lnTo>
                      <a:lnTo>
                        <a:pt x="2969" y="1781"/>
                      </a:lnTo>
                      <a:lnTo>
                        <a:pt x="2972" y="1782"/>
                      </a:lnTo>
                      <a:lnTo>
                        <a:pt x="2976" y="1781"/>
                      </a:lnTo>
                      <a:lnTo>
                        <a:pt x="2979" y="1781"/>
                      </a:lnTo>
                      <a:lnTo>
                        <a:pt x="2982" y="1781"/>
                      </a:lnTo>
                      <a:lnTo>
                        <a:pt x="2986" y="1781"/>
                      </a:lnTo>
                      <a:lnTo>
                        <a:pt x="2989" y="1780"/>
                      </a:lnTo>
                      <a:lnTo>
                        <a:pt x="2993" y="1780"/>
                      </a:lnTo>
                      <a:lnTo>
                        <a:pt x="2996" y="1780"/>
                      </a:lnTo>
                      <a:lnTo>
                        <a:pt x="3000" y="1781"/>
                      </a:lnTo>
                      <a:lnTo>
                        <a:pt x="3003" y="1781"/>
                      </a:lnTo>
                      <a:lnTo>
                        <a:pt x="3006" y="1780"/>
                      </a:lnTo>
                      <a:lnTo>
                        <a:pt x="3010" y="1780"/>
                      </a:lnTo>
                      <a:lnTo>
                        <a:pt x="3013" y="1780"/>
                      </a:lnTo>
                      <a:lnTo>
                        <a:pt x="3017" y="1780"/>
                      </a:lnTo>
                      <a:lnTo>
                        <a:pt x="3020" y="1780"/>
                      </a:lnTo>
                      <a:lnTo>
                        <a:pt x="3024" y="1779"/>
                      </a:lnTo>
                      <a:lnTo>
                        <a:pt x="3027" y="1778"/>
                      </a:lnTo>
                      <a:lnTo>
                        <a:pt x="3031" y="1779"/>
                      </a:lnTo>
                      <a:lnTo>
                        <a:pt x="3034" y="1778"/>
                      </a:lnTo>
                      <a:lnTo>
                        <a:pt x="3037" y="1778"/>
                      </a:lnTo>
                      <a:lnTo>
                        <a:pt x="3041" y="1778"/>
                      </a:lnTo>
                      <a:lnTo>
                        <a:pt x="3044" y="1778"/>
                      </a:lnTo>
                      <a:lnTo>
                        <a:pt x="3048" y="1777"/>
                      </a:lnTo>
                      <a:lnTo>
                        <a:pt x="3051" y="1778"/>
                      </a:lnTo>
                      <a:lnTo>
                        <a:pt x="3055" y="1777"/>
                      </a:lnTo>
                      <a:lnTo>
                        <a:pt x="3058" y="1777"/>
                      </a:lnTo>
                      <a:lnTo>
                        <a:pt x="3061" y="1777"/>
                      </a:lnTo>
                      <a:lnTo>
                        <a:pt x="3065" y="1776"/>
                      </a:lnTo>
                      <a:lnTo>
                        <a:pt x="3068" y="1775"/>
                      </a:lnTo>
                      <a:lnTo>
                        <a:pt x="3072" y="1775"/>
                      </a:lnTo>
                      <a:lnTo>
                        <a:pt x="3075" y="1774"/>
                      </a:lnTo>
                      <a:lnTo>
                        <a:pt x="3079" y="1774"/>
                      </a:lnTo>
                      <a:lnTo>
                        <a:pt x="3082" y="1773"/>
                      </a:lnTo>
                      <a:lnTo>
                        <a:pt x="3086" y="1774"/>
                      </a:lnTo>
                      <a:lnTo>
                        <a:pt x="3089" y="1772"/>
                      </a:lnTo>
                      <a:lnTo>
                        <a:pt x="3092" y="1772"/>
                      </a:lnTo>
                      <a:lnTo>
                        <a:pt x="3096" y="1772"/>
                      </a:lnTo>
                      <a:lnTo>
                        <a:pt x="3099" y="1772"/>
                      </a:lnTo>
                      <a:lnTo>
                        <a:pt x="3103" y="1771"/>
                      </a:lnTo>
                      <a:lnTo>
                        <a:pt x="3106" y="1771"/>
                      </a:lnTo>
                      <a:lnTo>
                        <a:pt x="3110" y="1769"/>
                      </a:lnTo>
                      <a:lnTo>
                        <a:pt x="3113" y="1769"/>
                      </a:lnTo>
                      <a:lnTo>
                        <a:pt x="3117" y="1769"/>
                      </a:lnTo>
                      <a:lnTo>
                        <a:pt x="3120" y="1768"/>
                      </a:lnTo>
                      <a:lnTo>
                        <a:pt x="3123" y="1768"/>
                      </a:lnTo>
                      <a:lnTo>
                        <a:pt x="3127" y="1768"/>
                      </a:lnTo>
                      <a:lnTo>
                        <a:pt x="3130" y="1767"/>
                      </a:lnTo>
                      <a:lnTo>
                        <a:pt x="3134" y="1767"/>
                      </a:lnTo>
                      <a:lnTo>
                        <a:pt x="3137" y="1767"/>
                      </a:lnTo>
                      <a:lnTo>
                        <a:pt x="3140" y="1766"/>
                      </a:lnTo>
                      <a:lnTo>
                        <a:pt x="3144" y="1766"/>
                      </a:lnTo>
                      <a:lnTo>
                        <a:pt x="3147" y="1765"/>
                      </a:lnTo>
                      <a:lnTo>
                        <a:pt x="3151" y="1763"/>
                      </a:lnTo>
                      <a:lnTo>
                        <a:pt x="3154" y="1764"/>
                      </a:lnTo>
                      <a:lnTo>
                        <a:pt x="3158" y="1763"/>
                      </a:lnTo>
                      <a:lnTo>
                        <a:pt x="3161" y="1762"/>
                      </a:lnTo>
                      <a:lnTo>
                        <a:pt x="3165" y="1761"/>
                      </a:lnTo>
                      <a:lnTo>
                        <a:pt x="3168" y="1760"/>
                      </a:lnTo>
                      <a:lnTo>
                        <a:pt x="3171" y="1760"/>
                      </a:lnTo>
                      <a:lnTo>
                        <a:pt x="3175" y="1760"/>
                      </a:lnTo>
                      <a:lnTo>
                        <a:pt x="3178" y="1758"/>
                      </a:lnTo>
                      <a:lnTo>
                        <a:pt x="3182" y="1757"/>
                      </a:lnTo>
                      <a:lnTo>
                        <a:pt x="3185" y="1755"/>
                      </a:lnTo>
                      <a:lnTo>
                        <a:pt x="3189" y="1754"/>
                      </a:lnTo>
                      <a:lnTo>
                        <a:pt x="3192" y="1753"/>
                      </a:lnTo>
                      <a:lnTo>
                        <a:pt x="3195" y="1751"/>
                      </a:lnTo>
                      <a:lnTo>
                        <a:pt x="3199" y="1748"/>
                      </a:lnTo>
                      <a:lnTo>
                        <a:pt x="3202" y="1745"/>
                      </a:lnTo>
                      <a:lnTo>
                        <a:pt x="3206" y="1742"/>
                      </a:lnTo>
                      <a:lnTo>
                        <a:pt x="3209" y="1738"/>
                      </a:lnTo>
                      <a:lnTo>
                        <a:pt x="3213" y="1733"/>
                      </a:lnTo>
                      <a:lnTo>
                        <a:pt x="3216" y="1727"/>
                      </a:lnTo>
                      <a:lnTo>
                        <a:pt x="3220" y="1720"/>
                      </a:lnTo>
                      <a:lnTo>
                        <a:pt x="3223" y="1713"/>
                      </a:lnTo>
                      <a:lnTo>
                        <a:pt x="3226" y="1703"/>
                      </a:lnTo>
                      <a:lnTo>
                        <a:pt x="3230" y="1694"/>
                      </a:lnTo>
                      <a:lnTo>
                        <a:pt x="3233" y="1682"/>
                      </a:lnTo>
                      <a:lnTo>
                        <a:pt x="3237" y="1668"/>
                      </a:lnTo>
                      <a:lnTo>
                        <a:pt x="3240" y="1654"/>
                      </a:lnTo>
                      <a:lnTo>
                        <a:pt x="3244" y="1638"/>
                      </a:lnTo>
                      <a:lnTo>
                        <a:pt x="3247" y="1622"/>
                      </a:lnTo>
                      <a:lnTo>
                        <a:pt x="3250" y="1605"/>
                      </a:lnTo>
                      <a:lnTo>
                        <a:pt x="3254" y="1587"/>
                      </a:lnTo>
                      <a:lnTo>
                        <a:pt x="3257" y="1568"/>
                      </a:lnTo>
                      <a:lnTo>
                        <a:pt x="3261" y="1549"/>
                      </a:lnTo>
                      <a:lnTo>
                        <a:pt x="3264" y="1531"/>
                      </a:lnTo>
                      <a:lnTo>
                        <a:pt x="3268" y="1512"/>
                      </a:lnTo>
                      <a:lnTo>
                        <a:pt x="3271" y="1494"/>
                      </a:lnTo>
                      <a:lnTo>
                        <a:pt x="3275" y="1477"/>
                      </a:lnTo>
                      <a:lnTo>
                        <a:pt x="3278" y="1464"/>
                      </a:lnTo>
                      <a:lnTo>
                        <a:pt x="3281" y="1450"/>
                      </a:lnTo>
                      <a:lnTo>
                        <a:pt x="3285" y="1440"/>
                      </a:lnTo>
                      <a:lnTo>
                        <a:pt x="3288" y="1433"/>
                      </a:lnTo>
                      <a:lnTo>
                        <a:pt x="3292" y="1428"/>
                      </a:lnTo>
                      <a:lnTo>
                        <a:pt x="3295" y="1426"/>
                      </a:lnTo>
                      <a:lnTo>
                        <a:pt x="3298" y="1426"/>
                      </a:lnTo>
                      <a:lnTo>
                        <a:pt x="3302" y="1429"/>
                      </a:lnTo>
                      <a:lnTo>
                        <a:pt x="3305" y="1434"/>
                      </a:lnTo>
                      <a:lnTo>
                        <a:pt x="3309" y="1441"/>
                      </a:lnTo>
                      <a:lnTo>
                        <a:pt x="3312" y="1450"/>
                      </a:lnTo>
                      <a:lnTo>
                        <a:pt x="3316" y="1458"/>
                      </a:lnTo>
                      <a:lnTo>
                        <a:pt x="3319" y="1468"/>
                      </a:lnTo>
                      <a:lnTo>
                        <a:pt x="3323" y="1479"/>
                      </a:lnTo>
                      <a:lnTo>
                        <a:pt x="3326" y="1489"/>
                      </a:lnTo>
                      <a:lnTo>
                        <a:pt x="3329" y="1501"/>
                      </a:lnTo>
                      <a:lnTo>
                        <a:pt x="3333" y="1512"/>
                      </a:lnTo>
                      <a:lnTo>
                        <a:pt x="3336" y="1522"/>
                      </a:lnTo>
                      <a:lnTo>
                        <a:pt x="3340" y="1533"/>
                      </a:lnTo>
                      <a:lnTo>
                        <a:pt x="3343" y="1545"/>
                      </a:lnTo>
                      <a:lnTo>
                        <a:pt x="3347" y="1555"/>
                      </a:lnTo>
                      <a:lnTo>
                        <a:pt x="3350" y="1566"/>
                      </a:lnTo>
                      <a:lnTo>
                        <a:pt x="3353" y="1576"/>
                      </a:lnTo>
                      <a:lnTo>
                        <a:pt x="3357" y="1586"/>
                      </a:lnTo>
                      <a:lnTo>
                        <a:pt x="3360" y="1596"/>
                      </a:lnTo>
                      <a:lnTo>
                        <a:pt x="3364" y="1606"/>
                      </a:lnTo>
                      <a:lnTo>
                        <a:pt x="3367" y="1615"/>
                      </a:lnTo>
                      <a:lnTo>
                        <a:pt x="3371" y="1624"/>
                      </a:lnTo>
                      <a:lnTo>
                        <a:pt x="3374" y="1633"/>
                      </a:lnTo>
                      <a:lnTo>
                        <a:pt x="3378" y="1642"/>
                      </a:lnTo>
                      <a:lnTo>
                        <a:pt x="3381" y="1650"/>
                      </a:lnTo>
                      <a:lnTo>
                        <a:pt x="3384" y="1658"/>
                      </a:lnTo>
                      <a:lnTo>
                        <a:pt x="3388" y="1666"/>
                      </a:lnTo>
                      <a:lnTo>
                        <a:pt x="3391" y="1673"/>
                      </a:lnTo>
                      <a:lnTo>
                        <a:pt x="3395" y="1680"/>
                      </a:lnTo>
                      <a:lnTo>
                        <a:pt x="3398" y="1687"/>
                      </a:lnTo>
                      <a:lnTo>
                        <a:pt x="3402" y="1693"/>
                      </a:lnTo>
                      <a:lnTo>
                        <a:pt x="3405" y="1699"/>
                      </a:lnTo>
                      <a:lnTo>
                        <a:pt x="3409" y="1705"/>
                      </a:lnTo>
                      <a:lnTo>
                        <a:pt x="3412" y="1710"/>
                      </a:lnTo>
                      <a:lnTo>
                        <a:pt x="3415" y="1715"/>
                      </a:lnTo>
                      <a:lnTo>
                        <a:pt x="3419" y="1719"/>
                      </a:lnTo>
                      <a:lnTo>
                        <a:pt x="3422" y="1723"/>
                      </a:lnTo>
                      <a:lnTo>
                        <a:pt x="3426" y="1727"/>
                      </a:lnTo>
                      <a:lnTo>
                        <a:pt x="3429" y="1731"/>
                      </a:lnTo>
                      <a:lnTo>
                        <a:pt x="3433" y="1734"/>
                      </a:lnTo>
                      <a:lnTo>
                        <a:pt x="3436" y="1737"/>
                      </a:lnTo>
                      <a:lnTo>
                        <a:pt x="3439" y="1740"/>
                      </a:lnTo>
                      <a:lnTo>
                        <a:pt x="3443" y="1743"/>
                      </a:lnTo>
                      <a:lnTo>
                        <a:pt x="3446" y="1746"/>
                      </a:lnTo>
                      <a:lnTo>
                        <a:pt x="3450" y="1748"/>
                      </a:lnTo>
                      <a:lnTo>
                        <a:pt x="3453" y="1751"/>
                      </a:lnTo>
                      <a:lnTo>
                        <a:pt x="3457" y="1753"/>
                      </a:lnTo>
                      <a:lnTo>
                        <a:pt x="3460" y="1755"/>
                      </a:lnTo>
                      <a:lnTo>
                        <a:pt x="3464" y="1757"/>
                      </a:lnTo>
                      <a:lnTo>
                        <a:pt x="3467" y="1759"/>
                      </a:lnTo>
                      <a:lnTo>
                        <a:pt x="3470" y="1760"/>
                      </a:lnTo>
                      <a:lnTo>
                        <a:pt x="3474" y="1762"/>
                      </a:lnTo>
                      <a:lnTo>
                        <a:pt x="3477" y="1764"/>
                      </a:lnTo>
                      <a:lnTo>
                        <a:pt x="3481" y="1766"/>
                      </a:lnTo>
                      <a:lnTo>
                        <a:pt x="3484" y="1767"/>
                      </a:lnTo>
                      <a:lnTo>
                        <a:pt x="3487" y="1768"/>
                      </a:lnTo>
                      <a:lnTo>
                        <a:pt x="3491" y="1769"/>
                      </a:lnTo>
                      <a:lnTo>
                        <a:pt x="3494" y="1771"/>
                      </a:lnTo>
                      <a:lnTo>
                        <a:pt x="3498" y="1771"/>
                      </a:lnTo>
                      <a:lnTo>
                        <a:pt x="3501" y="1772"/>
                      </a:lnTo>
                      <a:lnTo>
                        <a:pt x="3505" y="1774"/>
                      </a:lnTo>
                      <a:lnTo>
                        <a:pt x="3508" y="1774"/>
                      </a:lnTo>
                      <a:lnTo>
                        <a:pt x="3512" y="1775"/>
                      </a:lnTo>
                      <a:lnTo>
                        <a:pt x="3515" y="1776"/>
                      </a:lnTo>
                      <a:lnTo>
                        <a:pt x="3518" y="1777"/>
                      </a:lnTo>
                      <a:lnTo>
                        <a:pt x="3522" y="1777"/>
                      </a:lnTo>
                      <a:lnTo>
                        <a:pt x="3525" y="1777"/>
                      </a:lnTo>
                      <a:lnTo>
                        <a:pt x="3529" y="1778"/>
                      </a:lnTo>
                      <a:lnTo>
                        <a:pt x="3532" y="1779"/>
                      </a:lnTo>
                      <a:lnTo>
                        <a:pt x="3536" y="1779"/>
                      </a:lnTo>
                      <a:lnTo>
                        <a:pt x="3539" y="1779"/>
                      </a:lnTo>
                      <a:lnTo>
                        <a:pt x="3542" y="1781"/>
                      </a:lnTo>
                      <a:lnTo>
                        <a:pt x="3546" y="1781"/>
                      </a:lnTo>
                      <a:lnTo>
                        <a:pt x="3549" y="1781"/>
                      </a:lnTo>
                      <a:lnTo>
                        <a:pt x="3553" y="1781"/>
                      </a:lnTo>
                      <a:lnTo>
                        <a:pt x="3556" y="1782"/>
                      </a:lnTo>
                      <a:lnTo>
                        <a:pt x="3560" y="1782"/>
                      </a:lnTo>
                      <a:lnTo>
                        <a:pt x="3563" y="1782"/>
                      </a:lnTo>
                      <a:lnTo>
                        <a:pt x="3567" y="1783"/>
                      </a:lnTo>
                      <a:lnTo>
                        <a:pt x="3570" y="1783"/>
                      </a:lnTo>
                      <a:lnTo>
                        <a:pt x="3573" y="1783"/>
                      </a:lnTo>
                      <a:lnTo>
                        <a:pt x="3577" y="1783"/>
                      </a:lnTo>
                      <a:lnTo>
                        <a:pt x="3580" y="1783"/>
                      </a:lnTo>
                      <a:lnTo>
                        <a:pt x="3584" y="1784"/>
                      </a:lnTo>
                      <a:lnTo>
                        <a:pt x="3587" y="1784"/>
                      </a:lnTo>
                      <a:lnTo>
                        <a:pt x="3591" y="1784"/>
                      </a:lnTo>
                      <a:lnTo>
                        <a:pt x="3594" y="1784"/>
                      </a:lnTo>
                      <a:lnTo>
                        <a:pt x="3597" y="1784"/>
                      </a:lnTo>
                      <a:lnTo>
                        <a:pt x="3601" y="1785"/>
                      </a:lnTo>
                      <a:lnTo>
                        <a:pt x="3604" y="1785"/>
                      </a:lnTo>
                      <a:lnTo>
                        <a:pt x="3608" y="1785"/>
                      </a:lnTo>
                      <a:lnTo>
                        <a:pt x="3611" y="1786"/>
                      </a:lnTo>
                      <a:lnTo>
                        <a:pt x="3615" y="1785"/>
                      </a:lnTo>
                      <a:lnTo>
                        <a:pt x="3618" y="1785"/>
                      </a:lnTo>
                      <a:lnTo>
                        <a:pt x="3622" y="1785"/>
                      </a:lnTo>
                      <a:lnTo>
                        <a:pt x="3625" y="1785"/>
                      </a:lnTo>
                      <a:lnTo>
                        <a:pt x="3628" y="1784"/>
                      </a:lnTo>
                      <a:lnTo>
                        <a:pt x="3632" y="1786"/>
                      </a:lnTo>
                      <a:lnTo>
                        <a:pt x="3635" y="1786"/>
                      </a:lnTo>
                      <a:lnTo>
                        <a:pt x="3639" y="1785"/>
                      </a:lnTo>
                      <a:lnTo>
                        <a:pt x="3642" y="1786"/>
                      </a:lnTo>
                      <a:lnTo>
                        <a:pt x="3646" y="1786"/>
                      </a:lnTo>
                      <a:lnTo>
                        <a:pt x="3649" y="1785"/>
                      </a:lnTo>
                      <a:lnTo>
                        <a:pt x="3652" y="1785"/>
                      </a:lnTo>
                      <a:lnTo>
                        <a:pt x="3656" y="1785"/>
                      </a:lnTo>
                      <a:lnTo>
                        <a:pt x="3659" y="1785"/>
                      </a:lnTo>
                      <a:lnTo>
                        <a:pt x="3663" y="1785"/>
                      </a:lnTo>
                      <a:lnTo>
                        <a:pt x="3666" y="1785"/>
                      </a:lnTo>
                      <a:lnTo>
                        <a:pt x="3670" y="1784"/>
                      </a:lnTo>
                      <a:lnTo>
                        <a:pt x="3673" y="1785"/>
                      </a:lnTo>
                      <a:lnTo>
                        <a:pt x="3676" y="1785"/>
                      </a:lnTo>
                      <a:lnTo>
                        <a:pt x="3680" y="1785"/>
                      </a:lnTo>
                      <a:lnTo>
                        <a:pt x="3683" y="1784"/>
                      </a:lnTo>
                      <a:lnTo>
                        <a:pt x="3687" y="1785"/>
                      </a:lnTo>
                      <a:lnTo>
                        <a:pt x="3690" y="1784"/>
                      </a:lnTo>
                      <a:lnTo>
                        <a:pt x="3694" y="1784"/>
                      </a:lnTo>
                      <a:lnTo>
                        <a:pt x="3697" y="1784"/>
                      </a:lnTo>
                      <a:lnTo>
                        <a:pt x="3701" y="1784"/>
                      </a:lnTo>
                      <a:lnTo>
                        <a:pt x="3704" y="1784"/>
                      </a:lnTo>
                      <a:lnTo>
                        <a:pt x="3707" y="1784"/>
                      </a:lnTo>
                      <a:lnTo>
                        <a:pt x="3711" y="1784"/>
                      </a:lnTo>
                      <a:lnTo>
                        <a:pt x="3714" y="1784"/>
                      </a:lnTo>
                      <a:lnTo>
                        <a:pt x="3718" y="1784"/>
                      </a:lnTo>
                      <a:lnTo>
                        <a:pt x="3721" y="1784"/>
                      </a:lnTo>
                      <a:lnTo>
                        <a:pt x="3725" y="1784"/>
                      </a:lnTo>
                      <a:lnTo>
                        <a:pt x="3728" y="1784"/>
                      </a:lnTo>
                      <a:lnTo>
                        <a:pt x="3731" y="1784"/>
                      </a:lnTo>
                      <a:lnTo>
                        <a:pt x="3735" y="1785"/>
                      </a:lnTo>
                      <a:lnTo>
                        <a:pt x="3738" y="1784"/>
                      </a:lnTo>
                      <a:lnTo>
                        <a:pt x="3742" y="1785"/>
                      </a:lnTo>
                      <a:lnTo>
                        <a:pt x="3745" y="1786"/>
                      </a:lnTo>
                      <a:lnTo>
                        <a:pt x="3749" y="1785"/>
                      </a:lnTo>
                      <a:lnTo>
                        <a:pt x="3752" y="1785"/>
                      </a:lnTo>
                      <a:lnTo>
                        <a:pt x="3756" y="1785"/>
                      </a:lnTo>
                      <a:lnTo>
                        <a:pt x="3759" y="1785"/>
                      </a:lnTo>
                      <a:lnTo>
                        <a:pt x="3762" y="1785"/>
                      </a:lnTo>
                      <a:lnTo>
                        <a:pt x="3766" y="1785"/>
                      </a:lnTo>
                      <a:lnTo>
                        <a:pt x="3769" y="1787"/>
                      </a:lnTo>
                      <a:lnTo>
                        <a:pt x="3773" y="1786"/>
                      </a:lnTo>
                      <a:lnTo>
                        <a:pt x="3776" y="1786"/>
                      </a:lnTo>
                      <a:lnTo>
                        <a:pt x="3780" y="1786"/>
                      </a:lnTo>
                      <a:lnTo>
                        <a:pt x="3783" y="1786"/>
                      </a:lnTo>
                      <a:lnTo>
                        <a:pt x="3786" y="1787"/>
                      </a:lnTo>
                      <a:lnTo>
                        <a:pt x="3790" y="1787"/>
                      </a:lnTo>
                      <a:lnTo>
                        <a:pt x="3793" y="1788"/>
                      </a:lnTo>
                      <a:lnTo>
                        <a:pt x="3797" y="1787"/>
                      </a:lnTo>
                      <a:lnTo>
                        <a:pt x="3800" y="1788"/>
                      </a:lnTo>
                      <a:lnTo>
                        <a:pt x="3804" y="1787"/>
                      </a:lnTo>
                      <a:lnTo>
                        <a:pt x="3807" y="1787"/>
                      </a:lnTo>
                      <a:lnTo>
                        <a:pt x="3811" y="1787"/>
                      </a:lnTo>
                      <a:lnTo>
                        <a:pt x="3814" y="1787"/>
                      </a:lnTo>
                      <a:lnTo>
                        <a:pt x="3817" y="1788"/>
                      </a:lnTo>
                      <a:lnTo>
                        <a:pt x="3821" y="1788"/>
                      </a:lnTo>
                      <a:lnTo>
                        <a:pt x="3824" y="1788"/>
                      </a:lnTo>
                      <a:lnTo>
                        <a:pt x="3828" y="1788"/>
                      </a:lnTo>
                      <a:lnTo>
                        <a:pt x="3831" y="1788"/>
                      </a:lnTo>
                      <a:lnTo>
                        <a:pt x="3834" y="1788"/>
                      </a:lnTo>
                      <a:lnTo>
                        <a:pt x="3838" y="1789"/>
                      </a:lnTo>
                      <a:lnTo>
                        <a:pt x="3841" y="1789"/>
                      </a:lnTo>
                      <a:lnTo>
                        <a:pt x="3845" y="1788"/>
                      </a:lnTo>
                      <a:lnTo>
                        <a:pt x="3848" y="1788"/>
                      </a:lnTo>
                      <a:lnTo>
                        <a:pt x="3852" y="1789"/>
                      </a:lnTo>
                      <a:lnTo>
                        <a:pt x="3855" y="1789"/>
                      </a:lnTo>
                      <a:lnTo>
                        <a:pt x="3859" y="1788"/>
                      </a:lnTo>
                      <a:lnTo>
                        <a:pt x="3862" y="1789"/>
                      </a:lnTo>
                      <a:lnTo>
                        <a:pt x="3866" y="1788"/>
                      </a:lnTo>
                      <a:lnTo>
                        <a:pt x="3869" y="1788"/>
                      </a:lnTo>
                      <a:lnTo>
                        <a:pt x="3872" y="1789"/>
                      </a:lnTo>
                      <a:lnTo>
                        <a:pt x="3876" y="1789"/>
                      </a:lnTo>
                      <a:lnTo>
                        <a:pt x="3879" y="1789"/>
                      </a:lnTo>
                      <a:lnTo>
                        <a:pt x="3883" y="1789"/>
                      </a:lnTo>
                      <a:lnTo>
                        <a:pt x="3886" y="1789"/>
                      </a:lnTo>
                      <a:lnTo>
                        <a:pt x="3889" y="1789"/>
                      </a:lnTo>
                      <a:lnTo>
                        <a:pt x="3893" y="1789"/>
                      </a:lnTo>
                      <a:lnTo>
                        <a:pt x="3896" y="1789"/>
                      </a:lnTo>
                      <a:lnTo>
                        <a:pt x="3900" y="1788"/>
                      </a:lnTo>
                      <a:lnTo>
                        <a:pt x="3903" y="1789"/>
                      </a:lnTo>
                      <a:lnTo>
                        <a:pt x="3907" y="1789"/>
                      </a:lnTo>
                      <a:lnTo>
                        <a:pt x="3910" y="1788"/>
                      </a:lnTo>
                      <a:lnTo>
                        <a:pt x="3914" y="1789"/>
                      </a:lnTo>
                      <a:lnTo>
                        <a:pt x="3917" y="1789"/>
                      </a:lnTo>
                      <a:lnTo>
                        <a:pt x="3920" y="1790"/>
                      </a:lnTo>
                      <a:lnTo>
                        <a:pt x="3924" y="1789"/>
                      </a:lnTo>
                      <a:lnTo>
                        <a:pt x="3927" y="1789"/>
                      </a:lnTo>
                      <a:lnTo>
                        <a:pt x="3931" y="1789"/>
                      </a:lnTo>
                      <a:lnTo>
                        <a:pt x="3934" y="1789"/>
                      </a:lnTo>
                      <a:lnTo>
                        <a:pt x="3938" y="1789"/>
                      </a:lnTo>
                      <a:lnTo>
                        <a:pt x="3941" y="1789"/>
                      </a:lnTo>
                      <a:lnTo>
                        <a:pt x="3944" y="1789"/>
                      </a:lnTo>
                      <a:lnTo>
                        <a:pt x="3948" y="1789"/>
                      </a:lnTo>
                      <a:lnTo>
                        <a:pt x="3951" y="1789"/>
                      </a:lnTo>
                      <a:lnTo>
                        <a:pt x="3955" y="1789"/>
                      </a:lnTo>
                      <a:lnTo>
                        <a:pt x="3958" y="1790"/>
                      </a:lnTo>
                      <a:lnTo>
                        <a:pt x="3962" y="1789"/>
                      </a:lnTo>
                      <a:lnTo>
                        <a:pt x="3965" y="1789"/>
                      </a:lnTo>
                      <a:lnTo>
                        <a:pt x="3969" y="1789"/>
                      </a:lnTo>
                      <a:lnTo>
                        <a:pt x="3972" y="1790"/>
                      </a:lnTo>
                      <a:lnTo>
                        <a:pt x="3975" y="1790"/>
                      </a:lnTo>
                      <a:lnTo>
                        <a:pt x="3979" y="1790"/>
                      </a:lnTo>
                      <a:lnTo>
                        <a:pt x="3982" y="1790"/>
                      </a:lnTo>
                      <a:lnTo>
                        <a:pt x="3986" y="1790"/>
                      </a:lnTo>
                      <a:lnTo>
                        <a:pt x="3989" y="1790"/>
                      </a:lnTo>
                      <a:lnTo>
                        <a:pt x="3993" y="1790"/>
                      </a:lnTo>
                      <a:lnTo>
                        <a:pt x="3996" y="1790"/>
                      </a:lnTo>
                      <a:lnTo>
                        <a:pt x="4000" y="1790"/>
                      </a:lnTo>
                      <a:lnTo>
                        <a:pt x="4003" y="1790"/>
                      </a:lnTo>
                      <a:lnTo>
                        <a:pt x="4006" y="1790"/>
                      </a:lnTo>
                      <a:lnTo>
                        <a:pt x="4010" y="1790"/>
                      </a:lnTo>
                      <a:lnTo>
                        <a:pt x="4013" y="1790"/>
                      </a:lnTo>
                      <a:lnTo>
                        <a:pt x="4017" y="1790"/>
                      </a:lnTo>
                      <a:lnTo>
                        <a:pt x="4020" y="1791"/>
                      </a:lnTo>
                      <a:lnTo>
                        <a:pt x="4024" y="1789"/>
                      </a:lnTo>
                      <a:lnTo>
                        <a:pt x="4027" y="1790"/>
                      </a:lnTo>
                      <a:lnTo>
                        <a:pt x="4030" y="1790"/>
                      </a:lnTo>
                      <a:lnTo>
                        <a:pt x="4034" y="1790"/>
                      </a:lnTo>
                      <a:lnTo>
                        <a:pt x="4037" y="1790"/>
                      </a:lnTo>
                      <a:lnTo>
                        <a:pt x="4041" y="1790"/>
                      </a:lnTo>
                      <a:lnTo>
                        <a:pt x="4044" y="1790"/>
                      </a:lnTo>
                      <a:lnTo>
                        <a:pt x="4048" y="1790"/>
                      </a:lnTo>
                      <a:lnTo>
                        <a:pt x="4051" y="1790"/>
                      </a:lnTo>
                      <a:lnTo>
                        <a:pt x="4055" y="1790"/>
                      </a:lnTo>
                      <a:lnTo>
                        <a:pt x="4058" y="1790"/>
                      </a:lnTo>
                      <a:lnTo>
                        <a:pt x="4061" y="1790"/>
                      </a:lnTo>
                      <a:lnTo>
                        <a:pt x="4065" y="1790"/>
                      </a:lnTo>
                      <a:lnTo>
                        <a:pt x="4068" y="1791"/>
                      </a:lnTo>
                      <a:lnTo>
                        <a:pt x="4072" y="1790"/>
                      </a:lnTo>
                      <a:lnTo>
                        <a:pt x="4075" y="1790"/>
                      </a:lnTo>
                      <a:lnTo>
                        <a:pt x="4078" y="1791"/>
                      </a:lnTo>
                      <a:lnTo>
                        <a:pt x="4082" y="1790"/>
                      </a:lnTo>
                      <a:lnTo>
                        <a:pt x="4085" y="1790"/>
                      </a:lnTo>
                      <a:lnTo>
                        <a:pt x="4089" y="1790"/>
                      </a:lnTo>
                      <a:lnTo>
                        <a:pt x="4092" y="1790"/>
                      </a:lnTo>
                      <a:lnTo>
                        <a:pt x="4096" y="1791"/>
                      </a:lnTo>
                      <a:lnTo>
                        <a:pt x="4099" y="1791"/>
                      </a:lnTo>
                      <a:lnTo>
                        <a:pt x="4103" y="1790"/>
                      </a:lnTo>
                      <a:lnTo>
                        <a:pt x="4106" y="1790"/>
                      </a:lnTo>
                      <a:lnTo>
                        <a:pt x="4109" y="1790"/>
                      </a:lnTo>
                      <a:lnTo>
                        <a:pt x="4113" y="1790"/>
                      </a:lnTo>
                      <a:lnTo>
                        <a:pt x="4116" y="1790"/>
                      </a:lnTo>
                      <a:lnTo>
                        <a:pt x="4120" y="1791"/>
                      </a:lnTo>
                      <a:lnTo>
                        <a:pt x="4123" y="1790"/>
                      </a:lnTo>
                      <a:lnTo>
                        <a:pt x="4127" y="1791"/>
                      </a:lnTo>
                      <a:lnTo>
                        <a:pt x="4130" y="1790"/>
                      </a:lnTo>
                      <a:lnTo>
                        <a:pt x="4133" y="1790"/>
                      </a:lnTo>
                      <a:lnTo>
                        <a:pt x="4137" y="1790"/>
                      </a:lnTo>
                      <a:lnTo>
                        <a:pt x="4140" y="1790"/>
                      </a:lnTo>
                      <a:lnTo>
                        <a:pt x="4144" y="1790"/>
                      </a:lnTo>
                      <a:lnTo>
                        <a:pt x="4147" y="1791"/>
                      </a:lnTo>
                      <a:lnTo>
                        <a:pt x="4151" y="1791"/>
                      </a:lnTo>
                      <a:lnTo>
                        <a:pt x="4154" y="1790"/>
                      </a:lnTo>
                      <a:lnTo>
                        <a:pt x="4158" y="1791"/>
                      </a:lnTo>
                      <a:lnTo>
                        <a:pt x="4161" y="1790"/>
                      </a:lnTo>
                      <a:lnTo>
                        <a:pt x="4164" y="1791"/>
                      </a:lnTo>
                      <a:lnTo>
                        <a:pt x="4168" y="1790"/>
                      </a:lnTo>
                      <a:lnTo>
                        <a:pt x="4171" y="1791"/>
                      </a:lnTo>
                      <a:lnTo>
                        <a:pt x="4175" y="1791"/>
                      </a:lnTo>
                      <a:lnTo>
                        <a:pt x="4178" y="1791"/>
                      </a:lnTo>
                      <a:lnTo>
                        <a:pt x="4182" y="1790"/>
                      </a:lnTo>
                      <a:lnTo>
                        <a:pt x="4185" y="1791"/>
                      </a:lnTo>
                      <a:lnTo>
                        <a:pt x="4188" y="1790"/>
                      </a:lnTo>
                      <a:lnTo>
                        <a:pt x="4192" y="1790"/>
                      </a:lnTo>
                      <a:lnTo>
                        <a:pt x="4195" y="1791"/>
                      </a:lnTo>
                      <a:lnTo>
                        <a:pt x="4199" y="1790"/>
                      </a:lnTo>
                      <a:lnTo>
                        <a:pt x="4202" y="1791"/>
                      </a:lnTo>
                      <a:lnTo>
                        <a:pt x="4206" y="1791"/>
                      </a:lnTo>
                      <a:lnTo>
                        <a:pt x="4209" y="1791"/>
                      </a:lnTo>
                      <a:lnTo>
                        <a:pt x="4213" y="1791"/>
                      </a:lnTo>
                      <a:lnTo>
                        <a:pt x="4216" y="1790"/>
                      </a:lnTo>
                      <a:lnTo>
                        <a:pt x="4219" y="1790"/>
                      </a:lnTo>
                      <a:lnTo>
                        <a:pt x="4223" y="1791"/>
                      </a:lnTo>
                      <a:lnTo>
                        <a:pt x="4226" y="1790"/>
                      </a:lnTo>
                      <a:lnTo>
                        <a:pt x="4230" y="1790"/>
                      </a:lnTo>
                      <a:lnTo>
                        <a:pt x="4233" y="1791"/>
                      </a:lnTo>
                      <a:lnTo>
                        <a:pt x="4236" y="1791"/>
                      </a:lnTo>
                      <a:lnTo>
                        <a:pt x="4240" y="1791"/>
                      </a:lnTo>
                      <a:lnTo>
                        <a:pt x="4243" y="1791"/>
                      </a:lnTo>
                      <a:lnTo>
                        <a:pt x="4247" y="1791"/>
                      </a:lnTo>
                      <a:lnTo>
                        <a:pt x="4250" y="1790"/>
                      </a:lnTo>
                      <a:lnTo>
                        <a:pt x="4254" y="1791"/>
                      </a:lnTo>
                      <a:lnTo>
                        <a:pt x="4257" y="1791"/>
                      </a:lnTo>
                      <a:lnTo>
                        <a:pt x="4261" y="1792"/>
                      </a:lnTo>
                      <a:lnTo>
                        <a:pt x="4264" y="1791"/>
                      </a:lnTo>
                      <a:lnTo>
                        <a:pt x="4267" y="1790"/>
                      </a:lnTo>
                      <a:lnTo>
                        <a:pt x="4271" y="1791"/>
                      </a:lnTo>
                      <a:lnTo>
                        <a:pt x="4274" y="1791"/>
                      </a:lnTo>
                      <a:lnTo>
                        <a:pt x="4278" y="1791"/>
                      </a:lnTo>
                      <a:lnTo>
                        <a:pt x="4281" y="1791"/>
                      </a:lnTo>
                      <a:lnTo>
                        <a:pt x="4285" y="1790"/>
                      </a:lnTo>
                      <a:lnTo>
                        <a:pt x="4288" y="1791"/>
                      </a:lnTo>
                      <a:lnTo>
                        <a:pt x="4292" y="1791"/>
                      </a:lnTo>
                      <a:lnTo>
                        <a:pt x="4295" y="1791"/>
                      </a:lnTo>
                      <a:lnTo>
                        <a:pt x="4298" y="1791"/>
                      </a:lnTo>
                      <a:lnTo>
                        <a:pt x="4302" y="1791"/>
                      </a:lnTo>
                      <a:lnTo>
                        <a:pt x="4305" y="1791"/>
                      </a:lnTo>
                      <a:lnTo>
                        <a:pt x="4309" y="1791"/>
                      </a:lnTo>
                      <a:lnTo>
                        <a:pt x="4312" y="1791"/>
                      </a:lnTo>
                      <a:lnTo>
                        <a:pt x="4316" y="1791"/>
                      </a:lnTo>
                      <a:lnTo>
                        <a:pt x="4319" y="1790"/>
                      </a:lnTo>
                      <a:lnTo>
                        <a:pt x="4322" y="1791"/>
                      </a:lnTo>
                      <a:lnTo>
                        <a:pt x="4326" y="1791"/>
                      </a:lnTo>
                      <a:lnTo>
                        <a:pt x="4329" y="1791"/>
                      </a:lnTo>
                      <a:lnTo>
                        <a:pt x="4333" y="1791"/>
                      </a:lnTo>
                      <a:lnTo>
                        <a:pt x="4336" y="1791"/>
                      </a:lnTo>
                      <a:lnTo>
                        <a:pt x="4340" y="1790"/>
                      </a:lnTo>
                      <a:lnTo>
                        <a:pt x="4343" y="1791"/>
                      </a:lnTo>
                      <a:lnTo>
                        <a:pt x="4347" y="1791"/>
                      </a:lnTo>
                      <a:lnTo>
                        <a:pt x="4350" y="1791"/>
                      </a:lnTo>
                      <a:lnTo>
                        <a:pt x="4353" y="1791"/>
                      </a:lnTo>
                      <a:lnTo>
                        <a:pt x="4357" y="1790"/>
                      </a:lnTo>
                      <a:lnTo>
                        <a:pt x="4360" y="1791"/>
                      </a:lnTo>
                      <a:lnTo>
                        <a:pt x="4364" y="1790"/>
                      </a:lnTo>
                      <a:lnTo>
                        <a:pt x="4367" y="1791"/>
                      </a:lnTo>
                      <a:lnTo>
                        <a:pt x="4371" y="1791"/>
                      </a:lnTo>
                      <a:lnTo>
                        <a:pt x="4374" y="1791"/>
                      </a:lnTo>
                      <a:lnTo>
                        <a:pt x="4377" y="1790"/>
                      </a:lnTo>
                      <a:lnTo>
                        <a:pt x="4381" y="1791"/>
                      </a:lnTo>
                      <a:lnTo>
                        <a:pt x="4384" y="1790"/>
                      </a:lnTo>
                      <a:lnTo>
                        <a:pt x="4388" y="1791"/>
                      </a:lnTo>
                      <a:lnTo>
                        <a:pt x="4391" y="1791"/>
                      </a:lnTo>
                      <a:lnTo>
                        <a:pt x="4395" y="1791"/>
                      </a:lnTo>
                      <a:lnTo>
                        <a:pt x="4398" y="1791"/>
                      </a:lnTo>
                      <a:lnTo>
                        <a:pt x="4402" y="1790"/>
                      </a:lnTo>
                      <a:lnTo>
                        <a:pt x="4405" y="1791"/>
                      </a:lnTo>
                      <a:lnTo>
                        <a:pt x="4408" y="1791"/>
                      </a:lnTo>
                      <a:lnTo>
                        <a:pt x="4412" y="1791"/>
                      </a:lnTo>
                      <a:lnTo>
                        <a:pt x="4415" y="1791"/>
                      </a:lnTo>
                      <a:lnTo>
                        <a:pt x="4419" y="1790"/>
                      </a:lnTo>
                      <a:lnTo>
                        <a:pt x="4422" y="1791"/>
                      </a:lnTo>
                      <a:lnTo>
                        <a:pt x="4425" y="1791"/>
                      </a:lnTo>
                      <a:lnTo>
                        <a:pt x="4429" y="1791"/>
                      </a:lnTo>
                      <a:lnTo>
                        <a:pt x="4432" y="1791"/>
                      </a:lnTo>
                      <a:lnTo>
                        <a:pt x="4436" y="1791"/>
                      </a:lnTo>
                      <a:lnTo>
                        <a:pt x="4439" y="1791"/>
                      </a:lnTo>
                      <a:lnTo>
                        <a:pt x="4443" y="1791"/>
                      </a:lnTo>
                      <a:lnTo>
                        <a:pt x="4446" y="1791"/>
                      </a:lnTo>
                      <a:lnTo>
                        <a:pt x="4450" y="1791"/>
                      </a:lnTo>
                      <a:lnTo>
                        <a:pt x="4453" y="1791"/>
                      </a:lnTo>
                      <a:lnTo>
                        <a:pt x="4456" y="1791"/>
                      </a:lnTo>
                      <a:lnTo>
                        <a:pt x="4460" y="1791"/>
                      </a:lnTo>
                      <a:lnTo>
                        <a:pt x="4463" y="1791"/>
                      </a:lnTo>
                      <a:lnTo>
                        <a:pt x="4467" y="1791"/>
                      </a:lnTo>
                      <a:lnTo>
                        <a:pt x="4470" y="1791"/>
                      </a:lnTo>
                      <a:lnTo>
                        <a:pt x="4474" y="1791"/>
                      </a:lnTo>
                      <a:lnTo>
                        <a:pt x="4477" y="1791"/>
                      </a:lnTo>
                      <a:lnTo>
                        <a:pt x="4480" y="1790"/>
                      </a:lnTo>
                      <a:lnTo>
                        <a:pt x="4484" y="1791"/>
                      </a:lnTo>
                      <a:lnTo>
                        <a:pt x="4487" y="1791"/>
                      </a:lnTo>
                      <a:lnTo>
                        <a:pt x="4491" y="1792"/>
                      </a:lnTo>
                      <a:lnTo>
                        <a:pt x="4494" y="1791"/>
                      </a:lnTo>
                      <a:lnTo>
                        <a:pt x="4498" y="1791"/>
                      </a:lnTo>
                      <a:lnTo>
                        <a:pt x="4501" y="1791"/>
                      </a:lnTo>
                      <a:lnTo>
                        <a:pt x="4505" y="1792"/>
                      </a:lnTo>
                      <a:lnTo>
                        <a:pt x="4508" y="1791"/>
                      </a:lnTo>
                      <a:lnTo>
                        <a:pt x="4511" y="1791"/>
                      </a:lnTo>
                      <a:lnTo>
                        <a:pt x="4515" y="1791"/>
                      </a:lnTo>
                      <a:lnTo>
                        <a:pt x="4518" y="1791"/>
                      </a:lnTo>
                      <a:lnTo>
                        <a:pt x="4522" y="1791"/>
                      </a:lnTo>
                      <a:lnTo>
                        <a:pt x="4525" y="1791"/>
                      </a:lnTo>
                      <a:lnTo>
                        <a:pt x="4529" y="1791"/>
                      </a:lnTo>
                      <a:lnTo>
                        <a:pt x="4532" y="1792"/>
                      </a:lnTo>
                      <a:lnTo>
                        <a:pt x="4535" y="1791"/>
                      </a:lnTo>
                      <a:lnTo>
                        <a:pt x="4536" y="1792"/>
                      </a:lnTo>
                    </a:path>
                  </a:pathLst>
                </a:custGeom>
                <a:noFill/>
                <a:ln w="9525" cap="flat" cmpd="sng">
                  <a:solidFill>
                    <a:srgbClr val="FF3CFF"/>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rgbClr val="000000"/>
                    </a:solidFill>
                    <a:latin typeface="Arial"/>
                    <a:ea typeface="Arial"/>
                    <a:cs typeface="Arial"/>
                    <a:sym typeface="Arial"/>
                  </a:endParaRPr>
                </a:p>
              </p:txBody>
            </p:sp>
            <p:sp>
              <p:nvSpPr>
                <p:cNvPr id="1562" name="Google Shape;1562;p11"/>
                <p:cNvSpPr/>
                <p:nvPr/>
              </p:nvSpPr>
              <p:spPr>
                <a:xfrm>
                  <a:off x="1432" y="2224"/>
                  <a:ext cx="4536" cy="1191"/>
                </a:xfrm>
                <a:custGeom>
                  <a:avLst/>
                  <a:gdLst/>
                  <a:ahLst/>
                  <a:cxnLst/>
                  <a:rect l="l" t="t" r="r" b="b"/>
                  <a:pathLst>
                    <a:path w="4536" h="1191" extrusionOk="0">
                      <a:moveTo>
                        <a:pt x="0" y="1188"/>
                      </a:moveTo>
                      <a:lnTo>
                        <a:pt x="3" y="1188"/>
                      </a:lnTo>
                      <a:lnTo>
                        <a:pt x="7" y="1189"/>
                      </a:lnTo>
                      <a:lnTo>
                        <a:pt x="10" y="1189"/>
                      </a:lnTo>
                      <a:lnTo>
                        <a:pt x="14" y="1189"/>
                      </a:lnTo>
                      <a:lnTo>
                        <a:pt x="17" y="1189"/>
                      </a:lnTo>
                      <a:lnTo>
                        <a:pt x="21" y="1190"/>
                      </a:lnTo>
                      <a:lnTo>
                        <a:pt x="24" y="1190"/>
                      </a:lnTo>
                      <a:lnTo>
                        <a:pt x="28" y="1190"/>
                      </a:lnTo>
                      <a:lnTo>
                        <a:pt x="31" y="1190"/>
                      </a:lnTo>
                      <a:lnTo>
                        <a:pt x="34" y="1190"/>
                      </a:lnTo>
                      <a:lnTo>
                        <a:pt x="38" y="1189"/>
                      </a:lnTo>
                      <a:lnTo>
                        <a:pt x="41" y="1189"/>
                      </a:lnTo>
                      <a:lnTo>
                        <a:pt x="45" y="1189"/>
                      </a:lnTo>
                      <a:lnTo>
                        <a:pt x="48" y="1191"/>
                      </a:lnTo>
                      <a:lnTo>
                        <a:pt x="52" y="1191"/>
                      </a:lnTo>
                      <a:lnTo>
                        <a:pt x="55" y="1190"/>
                      </a:lnTo>
                      <a:lnTo>
                        <a:pt x="58" y="1191"/>
                      </a:lnTo>
                      <a:lnTo>
                        <a:pt x="62" y="1190"/>
                      </a:lnTo>
                      <a:lnTo>
                        <a:pt x="65" y="1191"/>
                      </a:lnTo>
                      <a:lnTo>
                        <a:pt x="69" y="1191"/>
                      </a:lnTo>
                      <a:lnTo>
                        <a:pt x="72" y="1191"/>
                      </a:lnTo>
                      <a:lnTo>
                        <a:pt x="76" y="1191"/>
                      </a:lnTo>
                      <a:lnTo>
                        <a:pt x="79" y="1191"/>
                      </a:lnTo>
                      <a:lnTo>
                        <a:pt x="82" y="1191"/>
                      </a:lnTo>
                      <a:lnTo>
                        <a:pt x="86" y="1191"/>
                      </a:lnTo>
                      <a:lnTo>
                        <a:pt x="89" y="1191"/>
                      </a:lnTo>
                      <a:lnTo>
                        <a:pt x="93" y="1190"/>
                      </a:lnTo>
                      <a:lnTo>
                        <a:pt x="96" y="1190"/>
                      </a:lnTo>
                      <a:lnTo>
                        <a:pt x="100" y="1190"/>
                      </a:lnTo>
                      <a:lnTo>
                        <a:pt x="103" y="1191"/>
                      </a:lnTo>
                      <a:lnTo>
                        <a:pt x="107" y="1190"/>
                      </a:lnTo>
                      <a:lnTo>
                        <a:pt x="110" y="1190"/>
                      </a:lnTo>
                      <a:lnTo>
                        <a:pt x="114" y="1191"/>
                      </a:lnTo>
                      <a:lnTo>
                        <a:pt x="117" y="1190"/>
                      </a:lnTo>
                      <a:lnTo>
                        <a:pt x="120" y="1190"/>
                      </a:lnTo>
                      <a:lnTo>
                        <a:pt x="124" y="1190"/>
                      </a:lnTo>
                      <a:lnTo>
                        <a:pt x="127" y="1191"/>
                      </a:lnTo>
                      <a:lnTo>
                        <a:pt x="131" y="1191"/>
                      </a:lnTo>
                      <a:lnTo>
                        <a:pt x="134" y="1191"/>
                      </a:lnTo>
                      <a:lnTo>
                        <a:pt x="137" y="1191"/>
                      </a:lnTo>
                      <a:lnTo>
                        <a:pt x="141" y="1190"/>
                      </a:lnTo>
                      <a:lnTo>
                        <a:pt x="144" y="1190"/>
                      </a:lnTo>
                      <a:lnTo>
                        <a:pt x="148" y="1190"/>
                      </a:lnTo>
                      <a:lnTo>
                        <a:pt x="151" y="1190"/>
                      </a:lnTo>
                      <a:lnTo>
                        <a:pt x="155" y="1191"/>
                      </a:lnTo>
                      <a:lnTo>
                        <a:pt x="158" y="1190"/>
                      </a:lnTo>
                      <a:lnTo>
                        <a:pt x="162" y="1190"/>
                      </a:lnTo>
                      <a:lnTo>
                        <a:pt x="165" y="1190"/>
                      </a:lnTo>
                      <a:lnTo>
                        <a:pt x="168" y="1189"/>
                      </a:lnTo>
                      <a:lnTo>
                        <a:pt x="172" y="1189"/>
                      </a:lnTo>
                      <a:lnTo>
                        <a:pt x="175" y="1189"/>
                      </a:lnTo>
                      <a:lnTo>
                        <a:pt x="179" y="1188"/>
                      </a:lnTo>
                      <a:lnTo>
                        <a:pt x="182" y="1188"/>
                      </a:lnTo>
                      <a:lnTo>
                        <a:pt x="186" y="1187"/>
                      </a:lnTo>
                      <a:lnTo>
                        <a:pt x="189" y="1187"/>
                      </a:lnTo>
                      <a:lnTo>
                        <a:pt x="192" y="1187"/>
                      </a:lnTo>
                      <a:lnTo>
                        <a:pt x="196" y="1185"/>
                      </a:lnTo>
                      <a:lnTo>
                        <a:pt x="199" y="1184"/>
                      </a:lnTo>
                      <a:lnTo>
                        <a:pt x="203" y="1182"/>
                      </a:lnTo>
                      <a:lnTo>
                        <a:pt x="206" y="1180"/>
                      </a:lnTo>
                      <a:lnTo>
                        <a:pt x="210" y="1178"/>
                      </a:lnTo>
                      <a:lnTo>
                        <a:pt x="213" y="1175"/>
                      </a:lnTo>
                      <a:lnTo>
                        <a:pt x="217" y="1173"/>
                      </a:lnTo>
                      <a:lnTo>
                        <a:pt x="220" y="1173"/>
                      </a:lnTo>
                      <a:lnTo>
                        <a:pt x="223" y="1174"/>
                      </a:lnTo>
                      <a:lnTo>
                        <a:pt x="227" y="1175"/>
                      </a:lnTo>
                      <a:lnTo>
                        <a:pt x="230" y="1178"/>
                      </a:lnTo>
                      <a:lnTo>
                        <a:pt x="234" y="1181"/>
                      </a:lnTo>
                      <a:lnTo>
                        <a:pt x="237" y="1183"/>
                      </a:lnTo>
                      <a:lnTo>
                        <a:pt x="240" y="1184"/>
                      </a:lnTo>
                      <a:lnTo>
                        <a:pt x="244" y="1183"/>
                      </a:lnTo>
                      <a:lnTo>
                        <a:pt x="247" y="1183"/>
                      </a:lnTo>
                      <a:lnTo>
                        <a:pt x="251" y="1183"/>
                      </a:lnTo>
                      <a:lnTo>
                        <a:pt x="254" y="1182"/>
                      </a:lnTo>
                      <a:lnTo>
                        <a:pt x="258" y="1181"/>
                      </a:lnTo>
                      <a:lnTo>
                        <a:pt x="261" y="1180"/>
                      </a:lnTo>
                      <a:lnTo>
                        <a:pt x="265" y="1179"/>
                      </a:lnTo>
                      <a:lnTo>
                        <a:pt x="268" y="1177"/>
                      </a:lnTo>
                      <a:lnTo>
                        <a:pt x="272" y="1177"/>
                      </a:lnTo>
                      <a:lnTo>
                        <a:pt x="275" y="1176"/>
                      </a:lnTo>
                      <a:lnTo>
                        <a:pt x="278" y="1175"/>
                      </a:lnTo>
                      <a:lnTo>
                        <a:pt x="282" y="1175"/>
                      </a:lnTo>
                      <a:lnTo>
                        <a:pt x="285" y="1174"/>
                      </a:lnTo>
                      <a:lnTo>
                        <a:pt x="289" y="1172"/>
                      </a:lnTo>
                      <a:lnTo>
                        <a:pt x="292" y="1170"/>
                      </a:lnTo>
                      <a:lnTo>
                        <a:pt x="295" y="1169"/>
                      </a:lnTo>
                      <a:lnTo>
                        <a:pt x="299" y="1170"/>
                      </a:lnTo>
                      <a:lnTo>
                        <a:pt x="302" y="1170"/>
                      </a:lnTo>
                      <a:lnTo>
                        <a:pt x="306" y="1170"/>
                      </a:lnTo>
                      <a:lnTo>
                        <a:pt x="309" y="1170"/>
                      </a:lnTo>
                      <a:lnTo>
                        <a:pt x="313" y="1170"/>
                      </a:lnTo>
                      <a:lnTo>
                        <a:pt x="316" y="1168"/>
                      </a:lnTo>
                      <a:lnTo>
                        <a:pt x="320" y="1167"/>
                      </a:lnTo>
                      <a:lnTo>
                        <a:pt x="323" y="1165"/>
                      </a:lnTo>
                      <a:lnTo>
                        <a:pt x="326" y="1163"/>
                      </a:lnTo>
                      <a:lnTo>
                        <a:pt x="330" y="1164"/>
                      </a:lnTo>
                      <a:lnTo>
                        <a:pt x="333" y="1164"/>
                      </a:lnTo>
                      <a:lnTo>
                        <a:pt x="337" y="1167"/>
                      </a:lnTo>
                      <a:lnTo>
                        <a:pt x="340" y="1169"/>
                      </a:lnTo>
                      <a:lnTo>
                        <a:pt x="344" y="1171"/>
                      </a:lnTo>
                      <a:lnTo>
                        <a:pt x="347" y="1173"/>
                      </a:lnTo>
                      <a:lnTo>
                        <a:pt x="351" y="1174"/>
                      </a:lnTo>
                      <a:lnTo>
                        <a:pt x="354" y="1175"/>
                      </a:lnTo>
                      <a:lnTo>
                        <a:pt x="357" y="1176"/>
                      </a:lnTo>
                      <a:lnTo>
                        <a:pt x="361" y="1178"/>
                      </a:lnTo>
                      <a:lnTo>
                        <a:pt x="364" y="1179"/>
                      </a:lnTo>
                      <a:lnTo>
                        <a:pt x="368" y="1179"/>
                      </a:lnTo>
                      <a:lnTo>
                        <a:pt x="371" y="1180"/>
                      </a:lnTo>
                      <a:lnTo>
                        <a:pt x="375" y="1180"/>
                      </a:lnTo>
                      <a:lnTo>
                        <a:pt x="378" y="1180"/>
                      </a:lnTo>
                      <a:lnTo>
                        <a:pt x="381" y="1181"/>
                      </a:lnTo>
                      <a:lnTo>
                        <a:pt x="385" y="1181"/>
                      </a:lnTo>
                      <a:lnTo>
                        <a:pt x="388" y="1181"/>
                      </a:lnTo>
                      <a:lnTo>
                        <a:pt x="392" y="1182"/>
                      </a:lnTo>
                      <a:lnTo>
                        <a:pt x="395" y="1182"/>
                      </a:lnTo>
                      <a:lnTo>
                        <a:pt x="399" y="1183"/>
                      </a:lnTo>
                      <a:lnTo>
                        <a:pt x="402" y="1182"/>
                      </a:lnTo>
                      <a:lnTo>
                        <a:pt x="406" y="1183"/>
                      </a:lnTo>
                      <a:lnTo>
                        <a:pt x="409" y="1182"/>
                      </a:lnTo>
                      <a:lnTo>
                        <a:pt x="412" y="1181"/>
                      </a:lnTo>
                      <a:lnTo>
                        <a:pt x="416" y="1180"/>
                      </a:lnTo>
                      <a:lnTo>
                        <a:pt x="419" y="1179"/>
                      </a:lnTo>
                      <a:lnTo>
                        <a:pt x="423" y="1179"/>
                      </a:lnTo>
                      <a:lnTo>
                        <a:pt x="426" y="1179"/>
                      </a:lnTo>
                      <a:lnTo>
                        <a:pt x="430" y="1177"/>
                      </a:lnTo>
                      <a:lnTo>
                        <a:pt x="433" y="1177"/>
                      </a:lnTo>
                      <a:lnTo>
                        <a:pt x="436" y="1178"/>
                      </a:lnTo>
                      <a:lnTo>
                        <a:pt x="440" y="1178"/>
                      </a:lnTo>
                      <a:lnTo>
                        <a:pt x="443" y="1179"/>
                      </a:lnTo>
                      <a:lnTo>
                        <a:pt x="447" y="1180"/>
                      </a:lnTo>
                      <a:lnTo>
                        <a:pt x="450" y="1180"/>
                      </a:lnTo>
                      <a:lnTo>
                        <a:pt x="454" y="1181"/>
                      </a:lnTo>
                      <a:lnTo>
                        <a:pt x="457" y="1181"/>
                      </a:lnTo>
                      <a:lnTo>
                        <a:pt x="461" y="1182"/>
                      </a:lnTo>
                      <a:lnTo>
                        <a:pt x="464" y="1182"/>
                      </a:lnTo>
                      <a:lnTo>
                        <a:pt x="467" y="1182"/>
                      </a:lnTo>
                      <a:lnTo>
                        <a:pt x="471" y="1181"/>
                      </a:lnTo>
                      <a:lnTo>
                        <a:pt x="474" y="1182"/>
                      </a:lnTo>
                      <a:lnTo>
                        <a:pt x="478" y="1181"/>
                      </a:lnTo>
                      <a:lnTo>
                        <a:pt x="481" y="1180"/>
                      </a:lnTo>
                      <a:lnTo>
                        <a:pt x="484" y="1179"/>
                      </a:lnTo>
                      <a:lnTo>
                        <a:pt x="488" y="1179"/>
                      </a:lnTo>
                      <a:lnTo>
                        <a:pt x="491" y="1179"/>
                      </a:lnTo>
                      <a:lnTo>
                        <a:pt x="495" y="1180"/>
                      </a:lnTo>
                      <a:lnTo>
                        <a:pt x="498" y="1180"/>
                      </a:lnTo>
                      <a:lnTo>
                        <a:pt x="502" y="1179"/>
                      </a:lnTo>
                      <a:lnTo>
                        <a:pt x="505" y="1180"/>
                      </a:lnTo>
                      <a:lnTo>
                        <a:pt x="509" y="1180"/>
                      </a:lnTo>
                      <a:lnTo>
                        <a:pt x="512" y="1180"/>
                      </a:lnTo>
                      <a:lnTo>
                        <a:pt x="515" y="1179"/>
                      </a:lnTo>
                      <a:lnTo>
                        <a:pt x="519" y="1180"/>
                      </a:lnTo>
                      <a:lnTo>
                        <a:pt x="522" y="1179"/>
                      </a:lnTo>
                      <a:lnTo>
                        <a:pt x="526" y="1180"/>
                      </a:lnTo>
                      <a:lnTo>
                        <a:pt x="529" y="1178"/>
                      </a:lnTo>
                      <a:lnTo>
                        <a:pt x="533" y="1176"/>
                      </a:lnTo>
                      <a:lnTo>
                        <a:pt x="536" y="1172"/>
                      </a:lnTo>
                      <a:lnTo>
                        <a:pt x="539" y="1164"/>
                      </a:lnTo>
                      <a:lnTo>
                        <a:pt x="543" y="1150"/>
                      </a:lnTo>
                      <a:lnTo>
                        <a:pt x="546" y="1129"/>
                      </a:lnTo>
                      <a:lnTo>
                        <a:pt x="550" y="1103"/>
                      </a:lnTo>
                      <a:lnTo>
                        <a:pt x="553" y="1073"/>
                      </a:lnTo>
                      <a:lnTo>
                        <a:pt x="557" y="1047"/>
                      </a:lnTo>
                      <a:lnTo>
                        <a:pt x="560" y="1028"/>
                      </a:lnTo>
                      <a:lnTo>
                        <a:pt x="564" y="1023"/>
                      </a:lnTo>
                      <a:lnTo>
                        <a:pt x="567" y="1032"/>
                      </a:lnTo>
                      <a:lnTo>
                        <a:pt x="570" y="1052"/>
                      </a:lnTo>
                      <a:lnTo>
                        <a:pt x="574" y="1078"/>
                      </a:lnTo>
                      <a:lnTo>
                        <a:pt x="577" y="1106"/>
                      </a:lnTo>
                      <a:lnTo>
                        <a:pt x="581" y="1129"/>
                      </a:lnTo>
                      <a:lnTo>
                        <a:pt x="584" y="1147"/>
                      </a:lnTo>
                      <a:lnTo>
                        <a:pt x="588" y="1160"/>
                      </a:lnTo>
                      <a:lnTo>
                        <a:pt x="591" y="1167"/>
                      </a:lnTo>
                      <a:lnTo>
                        <a:pt x="594" y="1172"/>
                      </a:lnTo>
                      <a:lnTo>
                        <a:pt x="598" y="1175"/>
                      </a:lnTo>
                      <a:lnTo>
                        <a:pt x="601" y="1177"/>
                      </a:lnTo>
                      <a:lnTo>
                        <a:pt x="605" y="1178"/>
                      </a:lnTo>
                      <a:lnTo>
                        <a:pt x="608" y="1179"/>
                      </a:lnTo>
                      <a:lnTo>
                        <a:pt x="612" y="1180"/>
                      </a:lnTo>
                      <a:lnTo>
                        <a:pt x="615" y="1180"/>
                      </a:lnTo>
                      <a:lnTo>
                        <a:pt x="619" y="1180"/>
                      </a:lnTo>
                      <a:lnTo>
                        <a:pt x="622" y="1180"/>
                      </a:lnTo>
                      <a:lnTo>
                        <a:pt x="625" y="1180"/>
                      </a:lnTo>
                      <a:lnTo>
                        <a:pt x="629" y="1179"/>
                      </a:lnTo>
                      <a:lnTo>
                        <a:pt x="632" y="1180"/>
                      </a:lnTo>
                      <a:lnTo>
                        <a:pt x="636" y="1180"/>
                      </a:lnTo>
                      <a:lnTo>
                        <a:pt x="639" y="1180"/>
                      </a:lnTo>
                      <a:lnTo>
                        <a:pt x="643" y="1180"/>
                      </a:lnTo>
                      <a:lnTo>
                        <a:pt x="646" y="1180"/>
                      </a:lnTo>
                      <a:lnTo>
                        <a:pt x="649" y="1181"/>
                      </a:lnTo>
                      <a:lnTo>
                        <a:pt x="653" y="1181"/>
                      </a:lnTo>
                      <a:lnTo>
                        <a:pt x="656" y="1182"/>
                      </a:lnTo>
                      <a:lnTo>
                        <a:pt x="660" y="1183"/>
                      </a:lnTo>
                      <a:lnTo>
                        <a:pt x="663" y="1182"/>
                      </a:lnTo>
                      <a:lnTo>
                        <a:pt x="667" y="1183"/>
                      </a:lnTo>
                      <a:lnTo>
                        <a:pt x="670" y="1183"/>
                      </a:lnTo>
                      <a:lnTo>
                        <a:pt x="673" y="1182"/>
                      </a:lnTo>
                      <a:lnTo>
                        <a:pt x="677" y="1183"/>
                      </a:lnTo>
                      <a:lnTo>
                        <a:pt x="680" y="1183"/>
                      </a:lnTo>
                      <a:lnTo>
                        <a:pt x="684" y="1183"/>
                      </a:lnTo>
                      <a:lnTo>
                        <a:pt x="687" y="1182"/>
                      </a:lnTo>
                      <a:lnTo>
                        <a:pt x="691" y="1182"/>
                      </a:lnTo>
                      <a:lnTo>
                        <a:pt x="694" y="1182"/>
                      </a:lnTo>
                      <a:lnTo>
                        <a:pt x="698" y="1182"/>
                      </a:lnTo>
                      <a:lnTo>
                        <a:pt x="701" y="1182"/>
                      </a:lnTo>
                      <a:lnTo>
                        <a:pt x="704" y="1182"/>
                      </a:lnTo>
                      <a:lnTo>
                        <a:pt x="708" y="1182"/>
                      </a:lnTo>
                      <a:lnTo>
                        <a:pt x="711" y="1181"/>
                      </a:lnTo>
                      <a:lnTo>
                        <a:pt x="715" y="1183"/>
                      </a:lnTo>
                      <a:lnTo>
                        <a:pt x="718" y="1182"/>
                      </a:lnTo>
                      <a:lnTo>
                        <a:pt x="722" y="1182"/>
                      </a:lnTo>
                      <a:lnTo>
                        <a:pt x="725" y="1182"/>
                      </a:lnTo>
                      <a:lnTo>
                        <a:pt x="728" y="1182"/>
                      </a:lnTo>
                      <a:lnTo>
                        <a:pt x="732" y="1181"/>
                      </a:lnTo>
                      <a:lnTo>
                        <a:pt x="735" y="1181"/>
                      </a:lnTo>
                      <a:lnTo>
                        <a:pt x="739" y="1180"/>
                      </a:lnTo>
                      <a:lnTo>
                        <a:pt x="742" y="1180"/>
                      </a:lnTo>
                      <a:lnTo>
                        <a:pt x="746" y="1180"/>
                      </a:lnTo>
                      <a:lnTo>
                        <a:pt x="749" y="1179"/>
                      </a:lnTo>
                      <a:lnTo>
                        <a:pt x="753" y="1179"/>
                      </a:lnTo>
                      <a:lnTo>
                        <a:pt x="756" y="1179"/>
                      </a:lnTo>
                      <a:lnTo>
                        <a:pt x="759" y="1179"/>
                      </a:lnTo>
                      <a:lnTo>
                        <a:pt x="763" y="1178"/>
                      </a:lnTo>
                      <a:lnTo>
                        <a:pt x="766" y="1178"/>
                      </a:lnTo>
                      <a:lnTo>
                        <a:pt x="770" y="1177"/>
                      </a:lnTo>
                      <a:lnTo>
                        <a:pt x="773" y="1177"/>
                      </a:lnTo>
                      <a:lnTo>
                        <a:pt x="777" y="1177"/>
                      </a:lnTo>
                      <a:lnTo>
                        <a:pt x="780" y="1177"/>
                      </a:lnTo>
                      <a:lnTo>
                        <a:pt x="783" y="1177"/>
                      </a:lnTo>
                      <a:lnTo>
                        <a:pt x="787" y="1176"/>
                      </a:lnTo>
                      <a:lnTo>
                        <a:pt x="790" y="1174"/>
                      </a:lnTo>
                      <a:lnTo>
                        <a:pt x="794" y="1171"/>
                      </a:lnTo>
                      <a:lnTo>
                        <a:pt x="797" y="1168"/>
                      </a:lnTo>
                      <a:lnTo>
                        <a:pt x="801" y="1162"/>
                      </a:lnTo>
                      <a:lnTo>
                        <a:pt x="804" y="1154"/>
                      </a:lnTo>
                      <a:lnTo>
                        <a:pt x="808" y="1143"/>
                      </a:lnTo>
                      <a:lnTo>
                        <a:pt x="811" y="1132"/>
                      </a:lnTo>
                      <a:lnTo>
                        <a:pt x="814" y="1121"/>
                      </a:lnTo>
                      <a:lnTo>
                        <a:pt x="818" y="1111"/>
                      </a:lnTo>
                      <a:lnTo>
                        <a:pt x="821" y="1104"/>
                      </a:lnTo>
                      <a:lnTo>
                        <a:pt x="825" y="1101"/>
                      </a:lnTo>
                      <a:lnTo>
                        <a:pt x="828" y="1100"/>
                      </a:lnTo>
                      <a:lnTo>
                        <a:pt x="831" y="1100"/>
                      </a:lnTo>
                      <a:lnTo>
                        <a:pt x="835" y="1100"/>
                      </a:lnTo>
                      <a:lnTo>
                        <a:pt x="838" y="1102"/>
                      </a:lnTo>
                      <a:lnTo>
                        <a:pt x="842" y="1101"/>
                      </a:lnTo>
                      <a:lnTo>
                        <a:pt x="845" y="1099"/>
                      </a:lnTo>
                      <a:lnTo>
                        <a:pt x="849" y="1097"/>
                      </a:lnTo>
                      <a:lnTo>
                        <a:pt x="852" y="1095"/>
                      </a:lnTo>
                      <a:lnTo>
                        <a:pt x="856" y="1092"/>
                      </a:lnTo>
                      <a:lnTo>
                        <a:pt x="859" y="1091"/>
                      </a:lnTo>
                      <a:lnTo>
                        <a:pt x="863" y="1092"/>
                      </a:lnTo>
                      <a:lnTo>
                        <a:pt x="866" y="1093"/>
                      </a:lnTo>
                      <a:lnTo>
                        <a:pt x="869" y="1096"/>
                      </a:lnTo>
                      <a:lnTo>
                        <a:pt x="873" y="1100"/>
                      </a:lnTo>
                      <a:lnTo>
                        <a:pt x="876" y="1105"/>
                      </a:lnTo>
                      <a:lnTo>
                        <a:pt x="880" y="1111"/>
                      </a:lnTo>
                      <a:lnTo>
                        <a:pt x="883" y="1116"/>
                      </a:lnTo>
                      <a:lnTo>
                        <a:pt x="886" y="1122"/>
                      </a:lnTo>
                      <a:lnTo>
                        <a:pt x="890" y="1127"/>
                      </a:lnTo>
                      <a:lnTo>
                        <a:pt x="893" y="1132"/>
                      </a:lnTo>
                      <a:lnTo>
                        <a:pt x="897" y="1138"/>
                      </a:lnTo>
                      <a:lnTo>
                        <a:pt x="900" y="1142"/>
                      </a:lnTo>
                      <a:lnTo>
                        <a:pt x="904" y="1147"/>
                      </a:lnTo>
                      <a:lnTo>
                        <a:pt x="907" y="1151"/>
                      </a:lnTo>
                      <a:lnTo>
                        <a:pt x="911" y="1154"/>
                      </a:lnTo>
                      <a:lnTo>
                        <a:pt x="914" y="1155"/>
                      </a:lnTo>
                      <a:lnTo>
                        <a:pt x="917" y="1157"/>
                      </a:lnTo>
                      <a:lnTo>
                        <a:pt x="921" y="1160"/>
                      </a:lnTo>
                      <a:lnTo>
                        <a:pt x="924" y="1161"/>
                      </a:lnTo>
                      <a:lnTo>
                        <a:pt x="928" y="1162"/>
                      </a:lnTo>
                      <a:lnTo>
                        <a:pt x="931" y="1163"/>
                      </a:lnTo>
                      <a:lnTo>
                        <a:pt x="935" y="1164"/>
                      </a:lnTo>
                      <a:lnTo>
                        <a:pt x="938" y="1165"/>
                      </a:lnTo>
                      <a:lnTo>
                        <a:pt x="941" y="1166"/>
                      </a:lnTo>
                      <a:lnTo>
                        <a:pt x="945" y="1167"/>
                      </a:lnTo>
                      <a:lnTo>
                        <a:pt x="948" y="1168"/>
                      </a:lnTo>
                      <a:lnTo>
                        <a:pt x="952" y="1168"/>
                      </a:lnTo>
                      <a:lnTo>
                        <a:pt x="955" y="1169"/>
                      </a:lnTo>
                      <a:lnTo>
                        <a:pt x="959" y="1169"/>
                      </a:lnTo>
                      <a:lnTo>
                        <a:pt x="962" y="1171"/>
                      </a:lnTo>
                      <a:lnTo>
                        <a:pt x="966" y="1170"/>
                      </a:lnTo>
                      <a:lnTo>
                        <a:pt x="969" y="1171"/>
                      </a:lnTo>
                      <a:lnTo>
                        <a:pt x="972" y="1171"/>
                      </a:lnTo>
                      <a:lnTo>
                        <a:pt x="976" y="1171"/>
                      </a:lnTo>
                      <a:lnTo>
                        <a:pt x="979" y="1173"/>
                      </a:lnTo>
                      <a:lnTo>
                        <a:pt x="983" y="1173"/>
                      </a:lnTo>
                      <a:lnTo>
                        <a:pt x="986" y="1172"/>
                      </a:lnTo>
                      <a:lnTo>
                        <a:pt x="990" y="1173"/>
                      </a:lnTo>
                      <a:lnTo>
                        <a:pt x="993" y="1173"/>
                      </a:lnTo>
                      <a:lnTo>
                        <a:pt x="997" y="1173"/>
                      </a:lnTo>
                      <a:lnTo>
                        <a:pt x="1000" y="1173"/>
                      </a:lnTo>
                      <a:lnTo>
                        <a:pt x="1003" y="1173"/>
                      </a:lnTo>
                      <a:lnTo>
                        <a:pt x="1007" y="1173"/>
                      </a:lnTo>
                      <a:lnTo>
                        <a:pt x="1010" y="1172"/>
                      </a:lnTo>
                      <a:lnTo>
                        <a:pt x="1014" y="1172"/>
                      </a:lnTo>
                      <a:lnTo>
                        <a:pt x="1017" y="1172"/>
                      </a:lnTo>
                      <a:lnTo>
                        <a:pt x="1020" y="1172"/>
                      </a:lnTo>
                      <a:lnTo>
                        <a:pt x="1024" y="1171"/>
                      </a:lnTo>
                      <a:lnTo>
                        <a:pt x="1027" y="1170"/>
                      </a:lnTo>
                      <a:lnTo>
                        <a:pt x="1031" y="1170"/>
                      </a:lnTo>
                      <a:lnTo>
                        <a:pt x="1034" y="1170"/>
                      </a:lnTo>
                      <a:lnTo>
                        <a:pt x="1038" y="1169"/>
                      </a:lnTo>
                      <a:lnTo>
                        <a:pt x="1041" y="1169"/>
                      </a:lnTo>
                      <a:lnTo>
                        <a:pt x="1045" y="1168"/>
                      </a:lnTo>
                      <a:lnTo>
                        <a:pt x="1048" y="1167"/>
                      </a:lnTo>
                      <a:lnTo>
                        <a:pt x="1052" y="1166"/>
                      </a:lnTo>
                      <a:lnTo>
                        <a:pt x="1055" y="1164"/>
                      </a:lnTo>
                      <a:lnTo>
                        <a:pt x="1058" y="1162"/>
                      </a:lnTo>
                      <a:lnTo>
                        <a:pt x="1062" y="1160"/>
                      </a:lnTo>
                      <a:lnTo>
                        <a:pt x="1065" y="1158"/>
                      </a:lnTo>
                      <a:lnTo>
                        <a:pt x="1069" y="1155"/>
                      </a:lnTo>
                      <a:lnTo>
                        <a:pt x="1072" y="1154"/>
                      </a:lnTo>
                      <a:lnTo>
                        <a:pt x="1075" y="1155"/>
                      </a:lnTo>
                      <a:lnTo>
                        <a:pt x="1079" y="1156"/>
                      </a:lnTo>
                      <a:lnTo>
                        <a:pt x="1082" y="1157"/>
                      </a:lnTo>
                      <a:lnTo>
                        <a:pt x="1086" y="1159"/>
                      </a:lnTo>
                      <a:lnTo>
                        <a:pt x="1089" y="1161"/>
                      </a:lnTo>
                      <a:lnTo>
                        <a:pt x="1093" y="1163"/>
                      </a:lnTo>
                      <a:lnTo>
                        <a:pt x="1096" y="1165"/>
                      </a:lnTo>
                      <a:lnTo>
                        <a:pt x="1100" y="1166"/>
                      </a:lnTo>
                      <a:lnTo>
                        <a:pt x="1103" y="1169"/>
                      </a:lnTo>
                      <a:lnTo>
                        <a:pt x="1106" y="1170"/>
                      </a:lnTo>
                      <a:lnTo>
                        <a:pt x="1110" y="1171"/>
                      </a:lnTo>
                      <a:lnTo>
                        <a:pt x="1113" y="1172"/>
                      </a:lnTo>
                      <a:lnTo>
                        <a:pt x="1117" y="1174"/>
                      </a:lnTo>
                      <a:lnTo>
                        <a:pt x="1120" y="1174"/>
                      </a:lnTo>
                      <a:lnTo>
                        <a:pt x="1124" y="1174"/>
                      </a:lnTo>
                      <a:lnTo>
                        <a:pt x="1127" y="1174"/>
                      </a:lnTo>
                      <a:lnTo>
                        <a:pt x="1130" y="1174"/>
                      </a:lnTo>
                      <a:lnTo>
                        <a:pt x="1134" y="1174"/>
                      </a:lnTo>
                      <a:lnTo>
                        <a:pt x="1137" y="1174"/>
                      </a:lnTo>
                      <a:lnTo>
                        <a:pt x="1141" y="1174"/>
                      </a:lnTo>
                      <a:lnTo>
                        <a:pt x="1144" y="1173"/>
                      </a:lnTo>
                      <a:lnTo>
                        <a:pt x="1148" y="1173"/>
                      </a:lnTo>
                      <a:lnTo>
                        <a:pt x="1151" y="1173"/>
                      </a:lnTo>
                      <a:lnTo>
                        <a:pt x="1155" y="1173"/>
                      </a:lnTo>
                      <a:lnTo>
                        <a:pt x="1158" y="1173"/>
                      </a:lnTo>
                      <a:lnTo>
                        <a:pt x="1161" y="1173"/>
                      </a:lnTo>
                      <a:lnTo>
                        <a:pt x="1165" y="1172"/>
                      </a:lnTo>
                      <a:lnTo>
                        <a:pt x="1168" y="1171"/>
                      </a:lnTo>
                      <a:lnTo>
                        <a:pt x="1172" y="1170"/>
                      </a:lnTo>
                      <a:lnTo>
                        <a:pt x="1175" y="1169"/>
                      </a:lnTo>
                      <a:lnTo>
                        <a:pt x="1178" y="1167"/>
                      </a:lnTo>
                      <a:lnTo>
                        <a:pt x="1182" y="1165"/>
                      </a:lnTo>
                      <a:lnTo>
                        <a:pt x="1185" y="1158"/>
                      </a:lnTo>
                      <a:lnTo>
                        <a:pt x="1189" y="1153"/>
                      </a:lnTo>
                      <a:lnTo>
                        <a:pt x="1192" y="1145"/>
                      </a:lnTo>
                      <a:lnTo>
                        <a:pt x="1196" y="1135"/>
                      </a:lnTo>
                      <a:lnTo>
                        <a:pt x="1199" y="1125"/>
                      </a:lnTo>
                      <a:lnTo>
                        <a:pt x="1203" y="1114"/>
                      </a:lnTo>
                      <a:lnTo>
                        <a:pt x="1206" y="1106"/>
                      </a:lnTo>
                      <a:lnTo>
                        <a:pt x="1210" y="1101"/>
                      </a:lnTo>
                      <a:lnTo>
                        <a:pt x="1213" y="1099"/>
                      </a:lnTo>
                      <a:lnTo>
                        <a:pt x="1216" y="1101"/>
                      </a:lnTo>
                      <a:lnTo>
                        <a:pt x="1220" y="1106"/>
                      </a:lnTo>
                      <a:lnTo>
                        <a:pt x="1223" y="1111"/>
                      </a:lnTo>
                      <a:lnTo>
                        <a:pt x="1227" y="1117"/>
                      </a:lnTo>
                      <a:lnTo>
                        <a:pt x="1230" y="1125"/>
                      </a:lnTo>
                      <a:lnTo>
                        <a:pt x="1234" y="1131"/>
                      </a:lnTo>
                      <a:lnTo>
                        <a:pt x="1237" y="1136"/>
                      </a:lnTo>
                      <a:lnTo>
                        <a:pt x="1240" y="1141"/>
                      </a:lnTo>
                      <a:lnTo>
                        <a:pt x="1244" y="1146"/>
                      </a:lnTo>
                      <a:lnTo>
                        <a:pt x="1247" y="1150"/>
                      </a:lnTo>
                      <a:lnTo>
                        <a:pt x="1251" y="1153"/>
                      </a:lnTo>
                      <a:lnTo>
                        <a:pt x="1254" y="1153"/>
                      </a:lnTo>
                      <a:lnTo>
                        <a:pt x="1258" y="1155"/>
                      </a:lnTo>
                      <a:lnTo>
                        <a:pt x="1261" y="1157"/>
                      </a:lnTo>
                      <a:lnTo>
                        <a:pt x="1264" y="1158"/>
                      </a:lnTo>
                      <a:lnTo>
                        <a:pt x="1268" y="1158"/>
                      </a:lnTo>
                      <a:lnTo>
                        <a:pt x="1271" y="1158"/>
                      </a:lnTo>
                      <a:lnTo>
                        <a:pt x="1275" y="1159"/>
                      </a:lnTo>
                      <a:lnTo>
                        <a:pt x="1278" y="1161"/>
                      </a:lnTo>
                      <a:lnTo>
                        <a:pt x="1282" y="1161"/>
                      </a:lnTo>
                      <a:lnTo>
                        <a:pt x="1285" y="1162"/>
                      </a:lnTo>
                      <a:lnTo>
                        <a:pt x="1289" y="1162"/>
                      </a:lnTo>
                      <a:lnTo>
                        <a:pt x="1292" y="1162"/>
                      </a:lnTo>
                      <a:lnTo>
                        <a:pt x="1295" y="1162"/>
                      </a:lnTo>
                      <a:lnTo>
                        <a:pt x="1299" y="1160"/>
                      </a:lnTo>
                      <a:lnTo>
                        <a:pt x="1302" y="1158"/>
                      </a:lnTo>
                      <a:lnTo>
                        <a:pt x="1306" y="1154"/>
                      </a:lnTo>
                      <a:lnTo>
                        <a:pt x="1309" y="1150"/>
                      </a:lnTo>
                      <a:lnTo>
                        <a:pt x="1313" y="1146"/>
                      </a:lnTo>
                      <a:lnTo>
                        <a:pt x="1316" y="1141"/>
                      </a:lnTo>
                      <a:lnTo>
                        <a:pt x="1319" y="1136"/>
                      </a:lnTo>
                      <a:lnTo>
                        <a:pt x="1323" y="1134"/>
                      </a:lnTo>
                      <a:lnTo>
                        <a:pt x="1326" y="1132"/>
                      </a:lnTo>
                      <a:lnTo>
                        <a:pt x="1330" y="1132"/>
                      </a:lnTo>
                      <a:lnTo>
                        <a:pt x="1333" y="1131"/>
                      </a:lnTo>
                      <a:lnTo>
                        <a:pt x="1337" y="1131"/>
                      </a:lnTo>
                      <a:lnTo>
                        <a:pt x="1340" y="1130"/>
                      </a:lnTo>
                      <a:lnTo>
                        <a:pt x="1344" y="1129"/>
                      </a:lnTo>
                      <a:lnTo>
                        <a:pt x="1347" y="1128"/>
                      </a:lnTo>
                      <a:lnTo>
                        <a:pt x="1350" y="1126"/>
                      </a:lnTo>
                      <a:lnTo>
                        <a:pt x="1354" y="1125"/>
                      </a:lnTo>
                      <a:lnTo>
                        <a:pt x="1357" y="1125"/>
                      </a:lnTo>
                      <a:lnTo>
                        <a:pt x="1361" y="1127"/>
                      </a:lnTo>
                      <a:lnTo>
                        <a:pt x="1364" y="1131"/>
                      </a:lnTo>
                      <a:lnTo>
                        <a:pt x="1368" y="1135"/>
                      </a:lnTo>
                      <a:lnTo>
                        <a:pt x="1371" y="1140"/>
                      </a:lnTo>
                      <a:lnTo>
                        <a:pt x="1374" y="1144"/>
                      </a:lnTo>
                      <a:lnTo>
                        <a:pt x="1378" y="1147"/>
                      </a:lnTo>
                      <a:lnTo>
                        <a:pt x="1381" y="1149"/>
                      </a:lnTo>
                      <a:lnTo>
                        <a:pt x="1385" y="1151"/>
                      </a:lnTo>
                      <a:lnTo>
                        <a:pt x="1388" y="1151"/>
                      </a:lnTo>
                      <a:lnTo>
                        <a:pt x="1392" y="1151"/>
                      </a:lnTo>
                      <a:lnTo>
                        <a:pt x="1395" y="1150"/>
                      </a:lnTo>
                      <a:lnTo>
                        <a:pt x="1399" y="1147"/>
                      </a:lnTo>
                      <a:lnTo>
                        <a:pt x="1402" y="1144"/>
                      </a:lnTo>
                      <a:lnTo>
                        <a:pt x="1405" y="1141"/>
                      </a:lnTo>
                      <a:lnTo>
                        <a:pt x="1409" y="1140"/>
                      </a:lnTo>
                      <a:lnTo>
                        <a:pt x="1412" y="1139"/>
                      </a:lnTo>
                      <a:lnTo>
                        <a:pt x="1416" y="1139"/>
                      </a:lnTo>
                      <a:lnTo>
                        <a:pt x="1419" y="1140"/>
                      </a:lnTo>
                      <a:lnTo>
                        <a:pt x="1422" y="1142"/>
                      </a:lnTo>
                      <a:lnTo>
                        <a:pt x="1426" y="1144"/>
                      </a:lnTo>
                      <a:lnTo>
                        <a:pt x="1429" y="1145"/>
                      </a:lnTo>
                      <a:lnTo>
                        <a:pt x="1433" y="1145"/>
                      </a:lnTo>
                      <a:lnTo>
                        <a:pt x="1436" y="1145"/>
                      </a:lnTo>
                      <a:lnTo>
                        <a:pt x="1440" y="1145"/>
                      </a:lnTo>
                      <a:lnTo>
                        <a:pt x="1443" y="1143"/>
                      </a:lnTo>
                      <a:lnTo>
                        <a:pt x="1447" y="1142"/>
                      </a:lnTo>
                      <a:lnTo>
                        <a:pt x="1450" y="1142"/>
                      </a:lnTo>
                      <a:lnTo>
                        <a:pt x="1453" y="1141"/>
                      </a:lnTo>
                      <a:lnTo>
                        <a:pt x="1457" y="1141"/>
                      </a:lnTo>
                      <a:lnTo>
                        <a:pt x="1460" y="1142"/>
                      </a:lnTo>
                      <a:lnTo>
                        <a:pt x="1464" y="1142"/>
                      </a:lnTo>
                      <a:lnTo>
                        <a:pt x="1467" y="1143"/>
                      </a:lnTo>
                      <a:lnTo>
                        <a:pt x="1471" y="1142"/>
                      </a:lnTo>
                      <a:lnTo>
                        <a:pt x="1474" y="1142"/>
                      </a:lnTo>
                      <a:lnTo>
                        <a:pt x="1477" y="1142"/>
                      </a:lnTo>
                      <a:lnTo>
                        <a:pt x="1481" y="1141"/>
                      </a:lnTo>
                      <a:lnTo>
                        <a:pt x="1484" y="1141"/>
                      </a:lnTo>
                      <a:lnTo>
                        <a:pt x="1488" y="1141"/>
                      </a:lnTo>
                      <a:lnTo>
                        <a:pt x="1491" y="1140"/>
                      </a:lnTo>
                      <a:lnTo>
                        <a:pt x="1495" y="1138"/>
                      </a:lnTo>
                      <a:lnTo>
                        <a:pt x="1498" y="1139"/>
                      </a:lnTo>
                      <a:lnTo>
                        <a:pt x="1502" y="1138"/>
                      </a:lnTo>
                      <a:lnTo>
                        <a:pt x="1505" y="1138"/>
                      </a:lnTo>
                      <a:lnTo>
                        <a:pt x="1508" y="1138"/>
                      </a:lnTo>
                      <a:lnTo>
                        <a:pt x="1512" y="1138"/>
                      </a:lnTo>
                      <a:lnTo>
                        <a:pt x="1515" y="1138"/>
                      </a:lnTo>
                      <a:lnTo>
                        <a:pt x="1519" y="1138"/>
                      </a:lnTo>
                      <a:lnTo>
                        <a:pt x="1522" y="1139"/>
                      </a:lnTo>
                      <a:lnTo>
                        <a:pt x="1526" y="1140"/>
                      </a:lnTo>
                      <a:lnTo>
                        <a:pt x="1529" y="1140"/>
                      </a:lnTo>
                      <a:lnTo>
                        <a:pt x="1532" y="1141"/>
                      </a:lnTo>
                      <a:lnTo>
                        <a:pt x="1536" y="1140"/>
                      </a:lnTo>
                      <a:lnTo>
                        <a:pt x="1539" y="1141"/>
                      </a:lnTo>
                      <a:lnTo>
                        <a:pt x="1543" y="1141"/>
                      </a:lnTo>
                      <a:lnTo>
                        <a:pt x="1546" y="1142"/>
                      </a:lnTo>
                      <a:lnTo>
                        <a:pt x="1550" y="1142"/>
                      </a:lnTo>
                      <a:lnTo>
                        <a:pt x="1553" y="1142"/>
                      </a:lnTo>
                      <a:lnTo>
                        <a:pt x="1557" y="1143"/>
                      </a:lnTo>
                      <a:lnTo>
                        <a:pt x="1560" y="1143"/>
                      </a:lnTo>
                      <a:lnTo>
                        <a:pt x="1563" y="1143"/>
                      </a:lnTo>
                      <a:lnTo>
                        <a:pt x="1567" y="1143"/>
                      </a:lnTo>
                      <a:lnTo>
                        <a:pt x="1570" y="1143"/>
                      </a:lnTo>
                      <a:lnTo>
                        <a:pt x="1574" y="1142"/>
                      </a:lnTo>
                      <a:lnTo>
                        <a:pt x="1577" y="1143"/>
                      </a:lnTo>
                      <a:lnTo>
                        <a:pt x="1581" y="1142"/>
                      </a:lnTo>
                      <a:lnTo>
                        <a:pt x="1584" y="1142"/>
                      </a:lnTo>
                      <a:lnTo>
                        <a:pt x="1587" y="1141"/>
                      </a:lnTo>
                      <a:lnTo>
                        <a:pt x="1591" y="1141"/>
                      </a:lnTo>
                      <a:lnTo>
                        <a:pt x="1594" y="1140"/>
                      </a:lnTo>
                      <a:lnTo>
                        <a:pt x="1598" y="1138"/>
                      </a:lnTo>
                      <a:lnTo>
                        <a:pt x="1601" y="1136"/>
                      </a:lnTo>
                      <a:lnTo>
                        <a:pt x="1605" y="1134"/>
                      </a:lnTo>
                      <a:lnTo>
                        <a:pt x="1608" y="1133"/>
                      </a:lnTo>
                      <a:lnTo>
                        <a:pt x="1611" y="1131"/>
                      </a:lnTo>
                      <a:lnTo>
                        <a:pt x="1615" y="1129"/>
                      </a:lnTo>
                      <a:lnTo>
                        <a:pt x="1618" y="1126"/>
                      </a:lnTo>
                      <a:lnTo>
                        <a:pt x="1622" y="1123"/>
                      </a:lnTo>
                      <a:lnTo>
                        <a:pt x="1625" y="1122"/>
                      </a:lnTo>
                      <a:lnTo>
                        <a:pt x="1629" y="1120"/>
                      </a:lnTo>
                      <a:lnTo>
                        <a:pt x="1632" y="1117"/>
                      </a:lnTo>
                      <a:lnTo>
                        <a:pt x="1636" y="1116"/>
                      </a:lnTo>
                      <a:lnTo>
                        <a:pt x="1639" y="1115"/>
                      </a:lnTo>
                      <a:lnTo>
                        <a:pt x="1643" y="1115"/>
                      </a:lnTo>
                      <a:lnTo>
                        <a:pt x="1646" y="1116"/>
                      </a:lnTo>
                      <a:lnTo>
                        <a:pt x="1649" y="1117"/>
                      </a:lnTo>
                      <a:lnTo>
                        <a:pt x="1653" y="1118"/>
                      </a:lnTo>
                      <a:lnTo>
                        <a:pt x="1656" y="1120"/>
                      </a:lnTo>
                      <a:lnTo>
                        <a:pt x="1660" y="1121"/>
                      </a:lnTo>
                      <a:lnTo>
                        <a:pt x="1663" y="1123"/>
                      </a:lnTo>
                      <a:lnTo>
                        <a:pt x="1666" y="1124"/>
                      </a:lnTo>
                      <a:lnTo>
                        <a:pt x="1670" y="1124"/>
                      </a:lnTo>
                      <a:lnTo>
                        <a:pt x="1673" y="1125"/>
                      </a:lnTo>
                      <a:lnTo>
                        <a:pt x="1677" y="1127"/>
                      </a:lnTo>
                      <a:lnTo>
                        <a:pt x="1680" y="1127"/>
                      </a:lnTo>
                      <a:lnTo>
                        <a:pt x="1684" y="1128"/>
                      </a:lnTo>
                      <a:lnTo>
                        <a:pt x="1687" y="1129"/>
                      </a:lnTo>
                      <a:lnTo>
                        <a:pt x="1691" y="1128"/>
                      </a:lnTo>
                      <a:lnTo>
                        <a:pt x="1694" y="1127"/>
                      </a:lnTo>
                      <a:lnTo>
                        <a:pt x="1697" y="1127"/>
                      </a:lnTo>
                      <a:lnTo>
                        <a:pt x="1701" y="1125"/>
                      </a:lnTo>
                      <a:lnTo>
                        <a:pt x="1704" y="1125"/>
                      </a:lnTo>
                      <a:lnTo>
                        <a:pt x="1708" y="1123"/>
                      </a:lnTo>
                      <a:lnTo>
                        <a:pt x="1711" y="1122"/>
                      </a:lnTo>
                      <a:lnTo>
                        <a:pt x="1715" y="1121"/>
                      </a:lnTo>
                      <a:lnTo>
                        <a:pt x="1718" y="1122"/>
                      </a:lnTo>
                      <a:lnTo>
                        <a:pt x="1721" y="1123"/>
                      </a:lnTo>
                      <a:lnTo>
                        <a:pt x="1725" y="1124"/>
                      </a:lnTo>
                      <a:lnTo>
                        <a:pt x="1728" y="1124"/>
                      </a:lnTo>
                      <a:lnTo>
                        <a:pt x="1732" y="1124"/>
                      </a:lnTo>
                      <a:lnTo>
                        <a:pt x="1735" y="1126"/>
                      </a:lnTo>
                      <a:lnTo>
                        <a:pt x="1739" y="1125"/>
                      </a:lnTo>
                      <a:lnTo>
                        <a:pt x="1742" y="1125"/>
                      </a:lnTo>
                      <a:lnTo>
                        <a:pt x="1746" y="1123"/>
                      </a:lnTo>
                      <a:lnTo>
                        <a:pt x="1749" y="1122"/>
                      </a:lnTo>
                      <a:lnTo>
                        <a:pt x="1752" y="1121"/>
                      </a:lnTo>
                      <a:lnTo>
                        <a:pt x="1756" y="1119"/>
                      </a:lnTo>
                      <a:lnTo>
                        <a:pt x="1759" y="1117"/>
                      </a:lnTo>
                      <a:lnTo>
                        <a:pt x="1763" y="1115"/>
                      </a:lnTo>
                      <a:lnTo>
                        <a:pt x="1766" y="1112"/>
                      </a:lnTo>
                      <a:lnTo>
                        <a:pt x="1769" y="1111"/>
                      </a:lnTo>
                      <a:lnTo>
                        <a:pt x="1773" y="1109"/>
                      </a:lnTo>
                      <a:lnTo>
                        <a:pt x="1776" y="1108"/>
                      </a:lnTo>
                      <a:lnTo>
                        <a:pt x="1780" y="1107"/>
                      </a:lnTo>
                      <a:lnTo>
                        <a:pt x="1783" y="1106"/>
                      </a:lnTo>
                      <a:lnTo>
                        <a:pt x="1787" y="1105"/>
                      </a:lnTo>
                      <a:lnTo>
                        <a:pt x="1790" y="1105"/>
                      </a:lnTo>
                      <a:lnTo>
                        <a:pt x="1794" y="1105"/>
                      </a:lnTo>
                      <a:lnTo>
                        <a:pt x="1797" y="1104"/>
                      </a:lnTo>
                      <a:lnTo>
                        <a:pt x="1800" y="1104"/>
                      </a:lnTo>
                      <a:lnTo>
                        <a:pt x="1804" y="1104"/>
                      </a:lnTo>
                      <a:lnTo>
                        <a:pt x="1807" y="1103"/>
                      </a:lnTo>
                      <a:lnTo>
                        <a:pt x="1811" y="1102"/>
                      </a:lnTo>
                      <a:lnTo>
                        <a:pt x="1814" y="1100"/>
                      </a:lnTo>
                      <a:lnTo>
                        <a:pt x="1818" y="1099"/>
                      </a:lnTo>
                      <a:lnTo>
                        <a:pt x="1821" y="1096"/>
                      </a:lnTo>
                      <a:lnTo>
                        <a:pt x="1824" y="1094"/>
                      </a:lnTo>
                      <a:lnTo>
                        <a:pt x="1828" y="1092"/>
                      </a:lnTo>
                      <a:lnTo>
                        <a:pt x="1831" y="1090"/>
                      </a:lnTo>
                      <a:lnTo>
                        <a:pt x="1835" y="1090"/>
                      </a:lnTo>
                      <a:lnTo>
                        <a:pt x="1838" y="1089"/>
                      </a:lnTo>
                      <a:lnTo>
                        <a:pt x="1842" y="1088"/>
                      </a:lnTo>
                      <a:lnTo>
                        <a:pt x="1845" y="1087"/>
                      </a:lnTo>
                      <a:lnTo>
                        <a:pt x="1849" y="1087"/>
                      </a:lnTo>
                      <a:lnTo>
                        <a:pt x="1852" y="1085"/>
                      </a:lnTo>
                      <a:lnTo>
                        <a:pt x="1855" y="1084"/>
                      </a:lnTo>
                      <a:lnTo>
                        <a:pt x="1859" y="1083"/>
                      </a:lnTo>
                      <a:lnTo>
                        <a:pt x="1862" y="1080"/>
                      </a:lnTo>
                      <a:lnTo>
                        <a:pt x="1866" y="1078"/>
                      </a:lnTo>
                      <a:lnTo>
                        <a:pt x="1869" y="1077"/>
                      </a:lnTo>
                      <a:lnTo>
                        <a:pt x="1873" y="1074"/>
                      </a:lnTo>
                      <a:lnTo>
                        <a:pt x="1876" y="1072"/>
                      </a:lnTo>
                      <a:lnTo>
                        <a:pt x="1880" y="1069"/>
                      </a:lnTo>
                      <a:lnTo>
                        <a:pt x="1883" y="1065"/>
                      </a:lnTo>
                      <a:lnTo>
                        <a:pt x="1886" y="1063"/>
                      </a:lnTo>
                      <a:lnTo>
                        <a:pt x="1890" y="1060"/>
                      </a:lnTo>
                      <a:lnTo>
                        <a:pt x="1893" y="1058"/>
                      </a:lnTo>
                      <a:lnTo>
                        <a:pt x="1897" y="1057"/>
                      </a:lnTo>
                      <a:lnTo>
                        <a:pt x="1900" y="1056"/>
                      </a:lnTo>
                      <a:lnTo>
                        <a:pt x="1904" y="1056"/>
                      </a:lnTo>
                      <a:lnTo>
                        <a:pt x="1907" y="1056"/>
                      </a:lnTo>
                      <a:lnTo>
                        <a:pt x="1910" y="1056"/>
                      </a:lnTo>
                      <a:lnTo>
                        <a:pt x="1914" y="1055"/>
                      </a:lnTo>
                      <a:lnTo>
                        <a:pt x="1917" y="1054"/>
                      </a:lnTo>
                      <a:lnTo>
                        <a:pt x="1921" y="1052"/>
                      </a:lnTo>
                      <a:lnTo>
                        <a:pt x="1924" y="1048"/>
                      </a:lnTo>
                      <a:lnTo>
                        <a:pt x="1928" y="1045"/>
                      </a:lnTo>
                      <a:lnTo>
                        <a:pt x="1931" y="1041"/>
                      </a:lnTo>
                      <a:lnTo>
                        <a:pt x="1935" y="1036"/>
                      </a:lnTo>
                      <a:lnTo>
                        <a:pt x="1938" y="1033"/>
                      </a:lnTo>
                      <a:lnTo>
                        <a:pt x="1941" y="1030"/>
                      </a:lnTo>
                      <a:lnTo>
                        <a:pt x="1945" y="1028"/>
                      </a:lnTo>
                      <a:lnTo>
                        <a:pt x="1948" y="1029"/>
                      </a:lnTo>
                      <a:lnTo>
                        <a:pt x="1952" y="1029"/>
                      </a:lnTo>
                      <a:lnTo>
                        <a:pt x="1955" y="1033"/>
                      </a:lnTo>
                      <a:lnTo>
                        <a:pt x="1958" y="1036"/>
                      </a:lnTo>
                      <a:lnTo>
                        <a:pt x="1962" y="1038"/>
                      </a:lnTo>
                      <a:lnTo>
                        <a:pt x="1965" y="1039"/>
                      </a:lnTo>
                      <a:lnTo>
                        <a:pt x="1969" y="1040"/>
                      </a:lnTo>
                      <a:lnTo>
                        <a:pt x="1972" y="1039"/>
                      </a:lnTo>
                      <a:lnTo>
                        <a:pt x="1976" y="1036"/>
                      </a:lnTo>
                      <a:lnTo>
                        <a:pt x="1979" y="1032"/>
                      </a:lnTo>
                      <a:lnTo>
                        <a:pt x="1983" y="1028"/>
                      </a:lnTo>
                      <a:lnTo>
                        <a:pt x="1986" y="1024"/>
                      </a:lnTo>
                      <a:lnTo>
                        <a:pt x="1990" y="1021"/>
                      </a:lnTo>
                      <a:lnTo>
                        <a:pt x="1993" y="1018"/>
                      </a:lnTo>
                      <a:lnTo>
                        <a:pt x="1996" y="1016"/>
                      </a:lnTo>
                      <a:lnTo>
                        <a:pt x="2000" y="1016"/>
                      </a:lnTo>
                      <a:lnTo>
                        <a:pt x="2003" y="1015"/>
                      </a:lnTo>
                      <a:lnTo>
                        <a:pt x="2007" y="1015"/>
                      </a:lnTo>
                      <a:lnTo>
                        <a:pt x="2010" y="1016"/>
                      </a:lnTo>
                      <a:lnTo>
                        <a:pt x="2013" y="1018"/>
                      </a:lnTo>
                      <a:lnTo>
                        <a:pt x="2017" y="1020"/>
                      </a:lnTo>
                      <a:lnTo>
                        <a:pt x="2020" y="1024"/>
                      </a:lnTo>
                      <a:lnTo>
                        <a:pt x="2024" y="1026"/>
                      </a:lnTo>
                      <a:lnTo>
                        <a:pt x="2027" y="1029"/>
                      </a:lnTo>
                      <a:lnTo>
                        <a:pt x="2031" y="1033"/>
                      </a:lnTo>
                      <a:lnTo>
                        <a:pt x="2034" y="1034"/>
                      </a:lnTo>
                      <a:lnTo>
                        <a:pt x="2038" y="1033"/>
                      </a:lnTo>
                      <a:lnTo>
                        <a:pt x="2041" y="1031"/>
                      </a:lnTo>
                      <a:lnTo>
                        <a:pt x="2044" y="1029"/>
                      </a:lnTo>
                      <a:lnTo>
                        <a:pt x="2048" y="1024"/>
                      </a:lnTo>
                      <a:lnTo>
                        <a:pt x="2051" y="1019"/>
                      </a:lnTo>
                      <a:lnTo>
                        <a:pt x="2055" y="1014"/>
                      </a:lnTo>
                      <a:lnTo>
                        <a:pt x="2058" y="1008"/>
                      </a:lnTo>
                      <a:lnTo>
                        <a:pt x="2062" y="1001"/>
                      </a:lnTo>
                      <a:lnTo>
                        <a:pt x="2065" y="995"/>
                      </a:lnTo>
                      <a:lnTo>
                        <a:pt x="2068" y="987"/>
                      </a:lnTo>
                      <a:lnTo>
                        <a:pt x="2072" y="978"/>
                      </a:lnTo>
                      <a:lnTo>
                        <a:pt x="2075" y="968"/>
                      </a:lnTo>
                      <a:lnTo>
                        <a:pt x="2079" y="955"/>
                      </a:lnTo>
                      <a:lnTo>
                        <a:pt x="2082" y="940"/>
                      </a:lnTo>
                      <a:lnTo>
                        <a:pt x="2086" y="924"/>
                      </a:lnTo>
                      <a:lnTo>
                        <a:pt x="2089" y="906"/>
                      </a:lnTo>
                      <a:lnTo>
                        <a:pt x="2093" y="886"/>
                      </a:lnTo>
                      <a:lnTo>
                        <a:pt x="2096" y="864"/>
                      </a:lnTo>
                      <a:lnTo>
                        <a:pt x="2099" y="843"/>
                      </a:lnTo>
                      <a:lnTo>
                        <a:pt x="2103" y="819"/>
                      </a:lnTo>
                      <a:lnTo>
                        <a:pt x="2106" y="799"/>
                      </a:lnTo>
                      <a:lnTo>
                        <a:pt x="2110" y="783"/>
                      </a:lnTo>
                      <a:lnTo>
                        <a:pt x="2113" y="774"/>
                      </a:lnTo>
                      <a:lnTo>
                        <a:pt x="2116" y="775"/>
                      </a:lnTo>
                      <a:lnTo>
                        <a:pt x="2120" y="785"/>
                      </a:lnTo>
                      <a:lnTo>
                        <a:pt x="2123" y="800"/>
                      </a:lnTo>
                      <a:lnTo>
                        <a:pt x="2127" y="816"/>
                      </a:lnTo>
                      <a:lnTo>
                        <a:pt x="2130" y="823"/>
                      </a:lnTo>
                      <a:lnTo>
                        <a:pt x="2134" y="812"/>
                      </a:lnTo>
                      <a:lnTo>
                        <a:pt x="2137" y="773"/>
                      </a:lnTo>
                      <a:lnTo>
                        <a:pt x="2141" y="701"/>
                      </a:lnTo>
                      <a:lnTo>
                        <a:pt x="2144" y="599"/>
                      </a:lnTo>
                      <a:lnTo>
                        <a:pt x="2148" y="477"/>
                      </a:lnTo>
                      <a:lnTo>
                        <a:pt x="2151" y="348"/>
                      </a:lnTo>
                      <a:lnTo>
                        <a:pt x="2154" y="236"/>
                      </a:lnTo>
                      <a:lnTo>
                        <a:pt x="2155" y="217"/>
                      </a:lnTo>
                      <a:lnTo>
                        <a:pt x="2158" y="159"/>
                      </a:lnTo>
                      <a:lnTo>
                        <a:pt x="2159" y="148"/>
                      </a:lnTo>
                      <a:lnTo>
                        <a:pt x="2161" y="129"/>
                      </a:lnTo>
                      <a:lnTo>
                        <a:pt x="2162" y="130"/>
                      </a:lnTo>
                      <a:lnTo>
                        <a:pt x="2165" y="155"/>
                      </a:lnTo>
                      <a:lnTo>
                        <a:pt x="2165" y="167"/>
                      </a:lnTo>
                      <a:lnTo>
                        <a:pt x="2168" y="231"/>
                      </a:lnTo>
                      <a:lnTo>
                        <a:pt x="2172" y="342"/>
                      </a:lnTo>
                      <a:lnTo>
                        <a:pt x="2175" y="471"/>
                      </a:lnTo>
                      <a:lnTo>
                        <a:pt x="2178" y="599"/>
                      </a:lnTo>
                      <a:lnTo>
                        <a:pt x="2182" y="711"/>
                      </a:lnTo>
                      <a:lnTo>
                        <a:pt x="2185" y="803"/>
                      </a:lnTo>
                      <a:lnTo>
                        <a:pt x="2189" y="871"/>
                      </a:lnTo>
                      <a:lnTo>
                        <a:pt x="2192" y="918"/>
                      </a:lnTo>
                      <a:lnTo>
                        <a:pt x="2196" y="949"/>
                      </a:lnTo>
                      <a:lnTo>
                        <a:pt x="2199" y="967"/>
                      </a:lnTo>
                      <a:lnTo>
                        <a:pt x="2202" y="978"/>
                      </a:lnTo>
                      <a:lnTo>
                        <a:pt x="2206" y="981"/>
                      </a:lnTo>
                      <a:lnTo>
                        <a:pt x="2209" y="982"/>
                      </a:lnTo>
                      <a:lnTo>
                        <a:pt x="2213" y="978"/>
                      </a:lnTo>
                      <a:lnTo>
                        <a:pt x="2216" y="974"/>
                      </a:lnTo>
                      <a:lnTo>
                        <a:pt x="2220" y="968"/>
                      </a:lnTo>
                      <a:lnTo>
                        <a:pt x="2223" y="961"/>
                      </a:lnTo>
                      <a:lnTo>
                        <a:pt x="2227" y="955"/>
                      </a:lnTo>
                      <a:lnTo>
                        <a:pt x="2230" y="949"/>
                      </a:lnTo>
                      <a:lnTo>
                        <a:pt x="2233" y="944"/>
                      </a:lnTo>
                      <a:lnTo>
                        <a:pt x="2237" y="939"/>
                      </a:lnTo>
                      <a:lnTo>
                        <a:pt x="2240" y="936"/>
                      </a:lnTo>
                      <a:lnTo>
                        <a:pt x="2244" y="934"/>
                      </a:lnTo>
                      <a:lnTo>
                        <a:pt x="2247" y="931"/>
                      </a:lnTo>
                      <a:lnTo>
                        <a:pt x="2251" y="928"/>
                      </a:lnTo>
                      <a:lnTo>
                        <a:pt x="2254" y="926"/>
                      </a:lnTo>
                      <a:lnTo>
                        <a:pt x="2257" y="925"/>
                      </a:lnTo>
                      <a:lnTo>
                        <a:pt x="2261" y="925"/>
                      </a:lnTo>
                      <a:lnTo>
                        <a:pt x="2264" y="925"/>
                      </a:lnTo>
                      <a:lnTo>
                        <a:pt x="2268" y="925"/>
                      </a:lnTo>
                      <a:lnTo>
                        <a:pt x="2271" y="926"/>
                      </a:lnTo>
                      <a:lnTo>
                        <a:pt x="2275" y="926"/>
                      </a:lnTo>
                      <a:lnTo>
                        <a:pt x="2278" y="924"/>
                      </a:lnTo>
                      <a:lnTo>
                        <a:pt x="2282" y="918"/>
                      </a:lnTo>
                      <a:lnTo>
                        <a:pt x="2285" y="909"/>
                      </a:lnTo>
                      <a:lnTo>
                        <a:pt x="2288" y="895"/>
                      </a:lnTo>
                      <a:lnTo>
                        <a:pt x="2292" y="878"/>
                      </a:lnTo>
                      <a:lnTo>
                        <a:pt x="2295" y="855"/>
                      </a:lnTo>
                      <a:lnTo>
                        <a:pt x="2299" y="824"/>
                      </a:lnTo>
                      <a:lnTo>
                        <a:pt x="2302" y="782"/>
                      </a:lnTo>
                      <a:lnTo>
                        <a:pt x="2306" y="724"/>
                      </a:lnTo>
                      <a:lnTo>
                        <a:pt x="2309" y="645"/>
                      </a:lnTo>
                      <a:lnTo>
                        <a:pt x="2312" y="545"/>
                      </a:lnTo>
                      <a:lnTo>
                        <a:pt x="2316" y="425"/>
                      </a:lnTo>
                      <a:lnTo>
                        <a:pt x="2319" y="296"/>
                      </a:lnTo>
                      <a:lnTo>
                        <a:pt x="2323" y="171"/>
                      </a:lnTo>
                      <a:lnTo>
                        <a:pt x="2326" y="71"/>
                      </a:lnTo>
                      <a:lnTo>
                        <a:pt x="2329" y="18"/>
                      </a:lnTo>
                      <a:lnTo>
                        <a:pt x="2330" y="9"/>
                      </a:lnTo>
                      <a:lnTo>
                        <a:pt x="2330" y="4"/>
                      </a:lnTo>
                      <a:lnTo>
                        <a:pt x="2333" y="0"/>
                      </a:lnTo>
                      <a:lnTo>
                        <a:pt x="2334" y="5"/>
                      </a:lnTo>
                      <a:lnTo>
                        <a:pt x="2337" y="46"/>
                      </a:lnTo>
                      <a:lnTo>
                        <a:pt x="2337" y="61"/>
                      </a:lnTo>
                      <a:lnTo>
                        <a:pt x="2340" y="139"/>
                      </a:lnTo>
                      <a:lnTo>
                        <a:pt x="2343" y="265"/>
                      </a:lnTo>
                      <a:lnTo>
                        <a:pt x="2347" y="409"/>
                      </a:lnTo>
                      <a:lnTo>
                        <a:pt x="2350" y="551"/>
                      </a:lnTo>
                      <a:lnTo>
                        <a:pt x="2354" y="683"/>
                      </a:lnTo>
                      <a:lnTo>
                        <a:pt x="2357" y="797"/>
                      </a:lnTo>
                      <a:lnTo>
                        <a:pt x="2360" y="888"/>
                      </a:lnTo>
                      <a:lnTo>
                        <a:pt x="2364" y="959"/>
                      </a:lnTo>
                      <a:lnTo>
                        <a:pt x="2367" y="1011"/>
                      </a:lnTo>
                      <a:lnTo>
                        <a:pt x="2371" y="1050"/>
                      </a:lnTo>
                      <a:lnTo>
                        <a:pt x="2374" y="1077"/>
                      </a:lnTo>
                      <a:lnTo>
                        <a:pt x="2378" y="1097"/>
                      </a:lnTo>
                      <a:lnTo>
                        <a:pt x="2381" y="1111"/>
                      </a:lnTo>
                      <a:lnTo>
                        <a:pt x="2385" y="1122"/>
                      </a:lnTo>
                      <a:lnTo>
                        <a:pt x="2388" y="1129"/>
                      </a:lnTo>
                      <a:lnTo>
                        <a:pt x="2391" y="1135"/>
                      </a:lnTo>
                      <a:lnTo>
                        <a:pt x="2395" y="1139"/>
                      </a:lnTo>
                      <a:lnTo>
                        <a:pt x="2398" y="1143"/>
                      </a:lnTo>
                      <a:lnTo>
                        <a:pt x="2402" y="1145"/>
                      </a:lnTo>
                      <a:lnTo>
                        <a:pt x="2405" y="1148"/>
                      </a:lnTo>
                      <a:lnTo>
                        <a:pt x="2409" y="1150"/>
                      </a:lnTo>
                      <a:lnTo>
                        <a:pt x="2412" y="1152"/>
                      </a:lnTo>
                      <a:lnTo>
                        <a:pt x="2415" y="1153"/>
                      </a:lnTo>
                      <a:lnTo>
                        <a:pt x="2419" y="1153"/>
                      </a:lnTo>
                      <a:lnTo>
                        <a:pt x="2422" y="1154"/>
                      </a:lnTo>
                      <a:lnTo>
                        <a:pt x="2426" y="1154"/>
                      </a:lnTo>
                      <a:lnTo>
                        <a:pt x="2429" y="1155"/>
                      </a:lnTo>
                      <a:lnTo>
                        <a:pt x="2433" y="1156"/>
                      </a:lnTo>
                      <a:lnTo>
                        <a:pt x="2436" y="1156"/>
                      </a:lnTo>
                      <a:lnTo>
                        <a:pt x="2440" y="1157"/>
                      </a:lnTo>
                      <a:lnTo>
                        <a:pt x="2443" y="1159"/>
                      </a:lnTo>
                      <a:lnTo>
                        <a:pt x="2446" y="1160"/>
                      </a:lnTo>
                      <a:lnTo>
                        <a:pt x="2450" y="1162"/>
                      </a:lnTo>
                      <a:lnTo>
                        <a:pt x="2453" y="1164"/>
                      </a:lnTo>
                      <a:lnTo>
                        <a:pt x="2457" y="1166"/>
                      </a:lnTo>
                      <a:lnTo>
                        <a:pt x="2460" y="1169"/>
                      </a:lnTo>
                      <a:lnTo>
                        <a:pt x="2464" y="1171"/>
                      </a:lnTo>
                      <a:lnTo>
                        <a:pt x="2467" y="1172"/>
                      </a:lnTo>
                      <a:lnTo>
                        <a:pt x="2470" y="1174"/>
                      </a:lnTo>
                      <a:lnTo>
                        <a:pt x="2474" y="1176"/>
                      </a:lnTo>
                      <a:lnTo>
                        <a:pt x="2477" y="1177"/>
                      </a:lnTo>
                      <a:lnTo>
                        <a:pt x="2481" y="1177"/>
                      </a:lnTo>
                      <a:lnTo>
                        <a:pt x="2484" y="1177"/>
                      </a:lnTo>
                      <a:lnTo>
                        <a:pt x="2488" y="1178"/>
                      </a:lnTo>
                      <a:lnTo>
                        <a:pt x="2491" y="1179"/>
                      </a:lnTo>
                      <a:lnTo>
                        <a:pt x="2495" y="1180"/>
                      </a:lnTo>
                      <a:lnTo>
                        <a:pt x="2498" y="1180"/>
                      </a:lnTo>
                      <a:lnTo>
                        <a:pt x="2501" y="1180"/>
                      </a:lnTo>
                      <a:lnTo>
                        <a:pt x="2505" y="1179"/>
                      </a:lnTo>
                      <a:lnTo>
                        <a:pt x="2508" y="1179"/>
                      </a:lnTo>
                      <a:lnTo>
                        <a:pt x="2512" y="1179"/>
                      </a:lnTo>
                      <a:lnTo>
                        <a:pt x="2515" y="1180"/>
                      </a:lnTo>
                      <a:lnTo>
                        <a:pt x="2519" y="1180"/>
                      </a:lnTo>
                      <a:lnTo>
                        <a:pt x="2522" y="1180"/>
                      </a:lnTo>
                      <a:lnTo>
                        <a:pt x="2526" y="1180"/>
                      </a:lnTo>
                      <a:lnTo>
                        <a:pt x="2529" y="1179"/>
                      </a:lnTo>
                      <a:lnTo>
                        <a:pt x="2532" y="1180"/>
                      </a:lnTo>
                      <a:lnTo>
                        <a:pt x="2536" y="1180"/>
                      </a:lnTo>
                      <a:lnTo>
                        <a:pt x="2539" y="1180"/>
                      </a:lnTo>
                      <a:lnTo>
                        <a:pt x="2543" y="1180"/>
                      </a:lnTo>
                      <a:lnTo>
                        <a:pt x="2546" y="1180"/>
                      </a:lnTo>
                      <a:lnTo>
                        <a:pt x="2549" y="1180"/>
                      </a:lnTo>
                      <a:lnTo>
                        <a:pt x="2553" y="1180"/>
                      </a:lnTo>
                      <a:lnTo>
                        <a:pt x="2556" y="1180"/>
                      </a:lnTo>
                      <a:lnTo>
                        <a:pt x="2560" y="1180"/>
                      </a:lnTo>
                      <a:lnTo>
                        <a:pt x="2563" y="1179"/>
                      </a:lnTo>
                      <a:lnTo>
                        <a:pt x="2567" y="1180"/>
                      </a:lnTo>
                      <a:lnTo>
                        <a:pt x="2570" y="1180"/>
                      </a:lnTo>
                      <a:lnTo>
                        <a:pt x="2574" y="1179"/>
                      </a:lnTo>
                      <a:lnTo>
                        <a:pt x="2577" y="1180"/>
                      </a:lnTo>
                      <a:lnTo>
                        <a:pt x="2581" y="1180"/>
                      </a:lnTo>
                      <a:lnTo>
                        <a:pt x="2584" y="1179"/>
                      </a:lnTo>
                      <a:lnTo>
                        <a:pt x="2587" y="1180"/>
                      </a:lnTo>
                      <a:lnTo>
                        <a:pt x="2591" y="1179"/>
                      </a:lnTo>
                      <a:lnTo>
                        <a:pt x="2594" y="1180"/>
                      </a:lnTo>
                      <a:lnTo>
                        <a:pt x="2598" y="1179"/>
                      </a:lnTo>
                      <a:lnTo>
                        <a:pt x="2601" y="1180"/>
                      </a:lnTo>
                      <a:lnTo>
                        <a:pt x="2604" y="1180"/>
                      </a:lnTo>
                      <a:lnTo>
                        <a:pt x="2608" y="1180"/>
                      </a:lnTo>
                      <a:lnTo>
                        <a:pt x="2611" y="1180"/>
                      </a:lnTo>
                      <a:lnTo>
                        <a:pt x="2615" y="1179"/>
                      </a:lnTo>
                      <a:lnTo>
                        <a:pt x="2618" y="1180"/>
                      </a:lnTo>
                      <a:lnTo>
                        <a:pt x="2622" y="1180"/>
                      </a:lnTo>
                      <a:lnTo>
                        <a:pt x="2625" y="1179"/>
                      </a:lnTo>
                      <a:lnTo>
                        <a:pt x="2629" y="1180"/>
                      </a:lnTo>
                      <a:lnTo>
                        <a:pt x="2632" y="1179"/>
                      </a:lnTo>
                      <a:lnTo>
                        <a:pt x="2635" y="1179"/>
                      </a:lnTo>
                      <a:lnTo>
                        <a:pt x="2639" y="1179"/>
                      </a:lnTo>
                      <a:lnTo>
                        <a:pt x="2642" y="1179"/>
                      </a:lnTo>
                      <a:lnTo>
                        <a:pt x="2646" y="1179"/>
                      </a:lnTo>
                      <a:lnTo>
                        <a:pt x="2649" y="1179"/>
                      </a:lnTo>
                      <a:lnTo>
                        <a:pt x="2653" y="1179"/>
                      </a:lnTo>
                      <a:lnTo>
                        <a:pt x="2656" y="1179"/>
                      </a:lnTo>
                      <a:lnTo>
                        <a:pt x="2659" y="1178"/>
                      </a:lnTo>
                      <a:lnTo>
                        <a:pt x="2663" y="1178"/>
                      </a:lnTo>
                      <a:lnTo>
                        <a:pt x="2666" y="1178"/>
                      </a:lnTo>
                      <a:lnTo>
                        <a:pt x="2670" y="1178"/>
                      </a:lnTo>
                      <a:lnTo>
                        <a:pt x="2673" y="1179"/>
                      </a:lnTo>
                      <a:lnTo>
                        <a:pt x="2677" y="1178"/>
                      </a:lnTo>
                      <a:lnTo>
                        <a:pt x="2680" y="1179"/>
                      </a:lnTo>
                      <a:lnTo>
                        <a:pt x="2684" y="1179"/>
                      </a:lnTo>
                      <a:lnTo>
                        <a:pt x="2687" y="1179"/>
                      </a:lnTo>
                      <a:lnTo>
                        <a:pt x="2690" y="1180"/>
                      </a:lnTo>
                      <a:lnTo>
                        <a:pt x="2694" y="1179"/>
                      </a:lnTo>
                      <a:lnTo>
                        <a:pt x="2697" y="1179"/>
                      </a:lnTo>
                      <a:lnTo>
                        <a:pt x="2701" y="1179"/>
                      </a:lnTo>
                      <a:lnTo>
                        <a:pt x="2704" y="1180"/>
                      </a:lnTo>
                      <a:lnTo>
                        <a:pt x="2707" y="1180"/>
                      </a:lnTo>
                      <a:lnTo>
                        <a:pt x="2711" y="1180"/>
                      </a:lnTo>
                      <a:lnTo>
                        <a:pt x="2714" y="1181"/>
                      </a:lnTo>
                      <a:lnTo>
                        <a:pt x="2718" y="1182"/>
                      </a:lnTo>
                      <a:lnTo>
                        <a:pt x="2721" y="1181"/>
                      </a:lnTo>
                      <a:lnTo>
                        <a:pt x="2725" y="1181"/>
                      </a:lnTo>
                      <a:lnTo>
                        <a:pt x="2728" y="1181"/>
                      </a:lnTo>
                      <a:lnTo>
                        <a:pt x="2732" y="1182"/>
                      </a:lnTo>
                      <a:lnTo>
                        <a:pt x="2735" y="1181"/>
                      </a:lnTo>
                      <a:lnTo>
                        <a:pt x="2738" y="1182"/>
                      </a:lnTo>
                      <a:lnTo>
                        <a:pt x="2742" y="1183"/>
                      </a:lnTo>
                      <a:lnTo>
                        <a:pt x="2745" y="1182"/>
                      </a:lnTo>
                      <a:lnTo>
                        <a:pt x="2749" y="1182"/>
                      </a:lnTo>
                      <a:lnTo>
                        <a:pt x="2752" y="1182"/>
                      </a:lnTo>
                      <a:lnTo>
                        <a:pt x="2756" y="1182"/>
                      </a:lnTo>
                      <a:lnTo>
                        <a:pt x="2759" y="1182"/>
                      </a:lnTo>
                      <a:lnTo>
                        <a:pt x="2763" y="1182"/>
                      </a:lnTo>
                      <a:lnTo>
                        <a:pt x="2766" y="1183"/>
                      </a:lnTo>
                      <a:lnTo>
                        <a:pt x="2769" y="1182"/>
                      </a:lnTo>
                      <a:lnTo>
                        <a:pt x="2773" y="1181"/>
                      </a:lnTo>
                      <a:lnTo>
                        <a:pt x="2776" y="1183"/>
                      </a:lnTo>
                      <a:lnTo>
                        <a:pt x="2780" y="1181"/>
                      </a:lnTo>
                      <a:lnTo>
                        <a:pt x="2783" y="1182"/>
                      </a:lnTo>
                      <a:lnTo>
                        <a:pt x="2787" y="1182"/>
                      </a:lnTo>
                      <a:lnTo>
                        <a:pt x="2790" y="1182"/>
                      </a:lnTo>
                      <a:lnTo>
                        <a:pt x="2793" y="1181"/>
                      </a:lnTo>
                      <a:lnTo>
                        <a:pt x="2797" y="1182"/>
                      </a:lnTo>
                      <a:lnTo>
                        <a:pt x="2800" y="1181"/>
                      </a:lnTo>
                      <a:lnTo>
                        <a:pt x="2804" y="1181"/>
                      </a:lnTo>
                      <a:lnTo>
                        <a:pt x="2807" y="1180"/>
                      </a:lnTo>
                      <a:lnTo>
                        <a:pt x="2811" y="1180"/>
                      </a:lnTo>
                      <a:lnTo>
                        <a:pt x="2814" y="1180"/>
                      </a:lnTo>
                      <a:lnTo>
                        <a:pt x="2818" y="1180"/>
                      </a:lnTo>
                      <a:lnTo>
                        <a:pt x="2821" y="1180"/>
                      </a:lnTo>
                      <a:lnTo>
                        <a:pt x="2824" y="1179"/>
                      </a:lnTo>
                      <a:lnTo>
                        <a:pt x="2828" y="1179"/>
                      </a:lnTo>
                      <a:lnTo>
                        <a:pt x="2831" y="1180"/>
                      </a:lnTo>
                      <a:lnTo>
                        <a:pt x="2835" y="1180"/>
                      </a:lnTo>
                      <a:lnTo>
                        <a:pt x="2838" y="1179"/>
                      </a:lnTo>
                      <a:lnTo>
                        <a:pt x="2842" y="1179"/>
                      </a:lnTo>
                      <a:lnTo>
                        <a:pt x="2845" y="1178"/>
                      </a:lnTo>
                      <a:lnTo>
                        <a:pt x="2848" y="1179"/>
                      </a:lnTo>
                      <a:lnTo>
                        <a:pt x="2852" y="1179"/>
                      </a:lnTo>
                      <a:lnTo>
                        <a:pt x="2855" y="1178"/>
                      </a:lnTo>
                      <a:lnTo>
                        <a:pt x="2859" y="1178"/>
                      </a:lnTo>
                      <a:lnTo>
                        <a:pt x="2862" y="1178"/>
                      </a:lnTo>
                      <a:lnTo>
                        <a:pt x="2866" y="1178"/>
                      </a:lnTo>
                      <a:lnTo>
                        <a:pt x="2869" y="1178"/>
                      </a:lnTo>
                      <a:lnTo>
                        <a:pt x="2873" y="1177"/>
                      </a:lnTo>
                      <a:lnTo>
                        <a:pt x="2876" y="1177"/>
                      </a:lnTo>
                      <a:lnTo>
                        <a:pt x="2879" y="1177"/>
                      </a:lnTo>
                      <a:lnTo>
                        <a:pt x="2883" y="1177"/>
                      </a:lnTo>
                      <a:lnTo>
                        <a:pt x="2886" y="1178"/>
                      </a:lnTo>
                      <a:lnTo>
                        <a:pt x="2890" y="1177"/>
                      </a:lnTo>
                      <a:lnTo>
                        <a:pt x="2893" y="1177"/>
                      </a:lnTo>
                      <a:lnTo>
                        <a:pt x="2896" y="1176"/>
                      </a:lnTo>
                      <a:lnTo>
                        <a:pt x="2900" y="1176"/>
                      </a:lnTo>
                      <a:lnTo>
                        <a:pt x="2903" y="1176"/>
                      </a:lnTo>
                      <a:lnTo>
                        <a:pt x="2907" y="1175"/>
                      </a:lnTo>
                      <a:lnTo>
                        <a:pt x="2910" y="1176"/>
                      </a:lnTo>
                      <a:lnTo>
                        <a:pt x="2914" y="1176"/>
                      </a:lnTo>
                      <a:lnTo>
                        <a:pt x="2917" y="1176"/>
                      </a:lnTo>
                      <a:lnTo>
                        <a:pt x="2921" y="1176"/>
                      </a:lnTo>
                      <a:lnTo>
                        <a:pt x="2924" y="1175"/>
                      </a:lnTo>
                      <a:lnTo>
                        <a:pt x="2928" y="1174"/>
                      </a:lnTo>
                      <a:lnTo>
                        <a:pt x="2931" y="1175"/>
                      </a:lnTo>
                      <a:lnTo>
                        <a:pt x="2934" y="1175"/>
                      </a:lnTo>
                      <a:lnTo>
                        <a:pt x="2938" y="1175"/>
                      </a:lnTo>
                      <a:lnTo>
                        <a:pt x="2941" y="1174"/>
                      </a:lnTo>
                      <a:lnTo>
                        <a:pt x="2945" y="1174"/>
                      </a:lnTo>
                      <a:lnTo>
                        <a:pt x="2948" y="1174"/>
                      </a:lnTo>
                      <a:lnTo>
                        <a:pt x="2951" y="1174"/>
                      </a:lnTo>
                      <a:lnTo>
                        <a:pt x="2955" y="1174"/>
                      </a:lnTo>
                      <a:lnTo>
                        <a:pt x="2958" y="1174"/>
                      </a:lnTo>
                      <a:lnTo>
                        <a:pt x="2962" y="1174"/>
                      </a:lnTo>
                      <a:lnTo>
                        <a:pt x="2965" y="1174"/>
                      </a:lnTo>
                      <a:lnTo>
                        <a:pt x="2969" y="1173"/>
                      </a:lnTo>
                      <a:lnTo>
                        <a:pt x="2972" y="1174"/>
                      </a:lnTo>
                      <a:lnTo>
                        <a:pt x="2976" y="1174"/>
                      </a:lnTo>
                      <a:lnTo>
                        <a:pt x="2979" y="1172"/>
                      </a:lnTo>
                      <a:lnTo>
                        <a:pt x="2982" y="1173"/>
                      </a:lnTo>
                      <a:lnTo>
                        <a:pt x="2986" y="1172"/>
                      </a:lnTo>
                      <a:lnTo>
                        <a:pt x="2989" y="1172"/>
                      </a:lnTo>
                      <a:lnTo>
                        <a:pt x="2993" y="1172"/>
                      </a:lnTo>
                      <a:lnTo>
                        <a:pt x="2996" y="1172"/>
                      </a:lnTo>
                      <a:lnTo>
                        <a:pt x="3000" y="1172"/>
                      </a:lnTo>
                      <a:lnTo>
                        <a:pt x="3003" y="1172"/>
                      </a:lnTo>
                      <a:lnTo>
                        <a:pt x="3006" y="1172"/>
                      </a:lnTo>
                      <a:lnTo>
                        <a:pt x="3010" y="1171"/>
                      </a:lnTo>
                      <a:lnTo>
                        <a:pt x="3013" y="1171"/>
                      </a:lnTo>
                      <a:lnTo>
                        <a:pt x="3017" y="1171"/>
                      </a:lnTo>
                      <a:lnTo>
                        <a:pt x="3020" y="1170"/>
                      </a:lnTo>
                      <a:lnTo>
                        <a:pt x="3024" y="1170"/>
                      </a:lnTo>
                      <a:lnTo>
                        <a:pt x="3027" y="1169"/>
                      </a:lnTo>
                      <a:lnTo>
                        <a:pt x="3031" y="1169"/>
                      </a:lnTo>
                      <a:lnTo>
                        <a:pt x="3034" y="1168"/>
                      </a:lnTo>
                      <a:lnTo>
                        <a:pt x="3037" y="1169"/>
                      </a:lnTo>
                      <a:lnTo>
                        <a:pt x="3041" y="1168"/>
                      </a:lnTo>
                      <a:lnTo>
                        <a:pt x="3044" y="1168"/>
                      </a:lnTo>
                      <a:lnTo>
                        <a:pt x="3048" y="1167"/>
                      </a:lnTo>
                      <a:lnTo>
                        <a:pt x="3051" y="1166"/>
                      </a:lnTo>
                      <a:lnTo>
                        <a:pt x="3055" y="1166"/>
                      </a:lnTo>
                      <a:lnTo>
                        <a:pt x="3058" y="1164"/>
                      </a:lnTo>
                      <a:lnTo>
                        <a:pt x="3061" y="1164"/>
                      </a:lnTo>
                      <a:lnTo>
                        <a:pt x="3065" y="1164"/>
                      </a:lnTo>
                      <a:lnTo>
                        <a:pt x="3068" y="1163"/>
                      </a:lnTo>
                      <a:lnTo>
                        <a:pt x="3072" y="1162"/>
                      </a:lnTo>
                      <a:lnTo>
                        <a:pt x="3075" y="1161"/>
                      </a:lnTo>
                      <a:lnTo>
                        <a:pt x="3079" y="1161"/>
                      </a:lnTo>
                      <a:lnTo>
                        <a:pt x="3082" y="1159"/>
                      </a:lnTo>
                      <a:lnTo>
                        <a:pt x="3086" y="1159"/>
                      </a:lnTo>
                      <a:lnTo>
                        <a:pt x="3089" y="1159"/>
                      </a:lnTo>
                      <a:lnTo>
                        <a:pt x="3092" y="1158"/>
                      </a:lnTo>
                      <a:lnTo>
                        <a:pt x="3096" y="1156"/>
                      </a:lnTo>
                      <a:lnTo>
                        <a:pt x="3099" y="1157"/>
                      </a:lnTo>
                      <a:lnTo>
                        <a:pt x="3103" y="1156"/>
                      </a:lnTo>
                      <a:lnTo>
                        <a:pt x="3106" y="1154"/>
                      </a:lnTo>
                      <a:lnTo>
                        <a:pt x="3110" y="1154"/>
                      </a:lnTo>
                      <a:lnTo>
                        <a:pt x="3113" y="1153"/>
                      </a:lnTo>
                      <a:lnTo>
                        <a:pt x="3117" y="1152"/>
                      </a:lnTo>
                      <a:lnTo>
                        <a:pt x="3120" y="1150"/>
                      </a:lnTo>
                      <a:lnTo>
                        <a:pt x="3123" y="1150"/>
                      </a:lnTo>
                      <a:lnTo>
                        <a:pt x="3127" y="1148"/>
                      </a:lnTo>
                      <a:lnTo>
                        <a:pt x="3130" y="1146"/>
                      </a:lnTo>
                      <a:lnTo>
                        <a:pt x="3134" y="1145"/>
                      </a:lnTo>
                      <a:lnTo>
                        <a:pt x="3137" y="1143"/>
                      </a:lnTo>
                      <a:lnTo>
                        <a:pt x="3140" y="1141"/>
                      </a:lnTo>
                      <a:lnTo>
                        <a:pt x="3144" y="1138"/>
                      </a:lnTo>
                      <a:lnTo>
                        <a:pt x="3147" y="1134"/>
                      </a:lnTo>
                      <a:lnTo>
                        <a:pt x="3151" y="1131"/>
                      </a:lnTo>
                      <a:lnTo>
                        <a:pt x="3154" y="1125"/>
                      </a:lnTo>
                      <a:lnTo>
                        <a:pt x="3158" y="1119"/>
                      </a:lnTo>
                      <a:lnTo>
                        <a:pt x="3161" y="1111"/>
                      </a:lnTo>
                      <a:lnTo>
                        <a:pt x="3165" y="1101"/>
                      </a:lnTo>
                      <a:lnTo>
                        <a:pt x="3168" y="1091"/>
                      </a:lnTo>
                      <a:lnTo>
                        <a:pt x="3171" y="1076"/>
                      </a:lnTo>
                      <a:lnTo>
                        <a:pt x="3175" y="1060"/>
                      </a:lnTo>
                      <a:lnTo>
                        <a:pt x="3178" y="1041"/>
                      </a:lnTo>
                      <a:lnTo>
                        <a:pt x="3182" y="1019"/>
                      </a:lnTo>
                      <a:lnTo>
                        <a:pt x="3185" y="994"/>
                      </a:lnTo>
                      <a:lnTo>
                        <a:pt x="3189" y="967"/>
                      </a:lnTo>
                      <a:lnTo>
                        <a:pt x="3192" y="936"/>
                      </a:lnTo>
                      <a:lnTo>
                        <a:pt x="3195" y="901"/>
                      </a:lnTo>
                      <a:lnTo>
                        <a:pt x="3199" y="865"/>
                      </a:lnTo>
                      <a:lnTo>
                        <a:pt x="3202" y="826"/>
                      </a:lnTo>
                      <a:lnTo>
                        <a:pt x="3206" y="785"/>
                      </a:lnTo>
                      <a:lnTo>
                        <a:pt x="3209" y="743"/>
                      </a:lnTo>
                      <a:lnTo>
                        <a:pt x="3213" y="700"/>
                      </a:lnTo>
                      <a:lnTo>
                        <a:pt x="3216" y="657"/>
                      </a:lnTo>
                      <a:lnTo>
                        <a:pt x="3220" y="615"/>
                      </a:lnTo>
                      <a:lnTo>
                        <a:pt x="3223" y="575"/>
                      </a:lnTo>
                      <a:lnTo>
                        <a:pt x="3226" y="535"/>
                      </a:lnTo>
                      <a:lnTo>
                        <a:pt x="3230" y="500"/>
                      </a:lnTo>
                      <a:lnTo>
                        <a:pt x="3233" y="467"/>
                      </a:lnTo>
                      <a:lnTo>
                        <a:pt x="3237" y="438"/>
                      </a:lnTo>
                      <a:lnTo>
                        <a:pt x="3240" y="414"/>
                      </a:lnTo>
                      <a:lnTo>
                        <a:pt x="3244" y="394"/>
                      </a:lnTo>
                      <a:lnTo>
                        <a:pt x="3247" y="380"/>
                      </a:lnTo>
                      <a:lnTo>
                        <a:pt x="3250" y="371"/>
                      </a:lnTo>
                      <a:lnTo>
                        <a:pt x="3254" y="369"/>
                      </a:lnTo>
                      <a:lnTo>
                        <a:pt x="3257" y="371"/>
                      </a:lnTo>
                      <a:lnTo>
                        <a:pt x="3261" y="378"/>
                      </a:lnTo>
                      <a:lnTo>
                        <a:pt x="3264" y="388"/>
                      </a:lnTo>
                      <a:lnTo>
                        <a:pt x="3268" y="403"/>
                      </a:lnTo>
                      <a:lnTo>
                        <a:pt x="3271" y="421"/>
                      </a:lnTo>
                      <a:lnTo>
                        <a:pt x="3275" y="441"/>
                      </a:lnTo>
                      <a:lnTo>
                        <a:pt x="3278" y="463"/>
                      </a:lnTo>
                      <a:lnTo>
                        <a:pt x="3281" y="485"/>
                      </a:lnTo>
                      <a:lnTo>
                        <a:pt x="3285" y="510"/>
                      </a:lnTo>
                      <a:lnTo>
                        <a:pt x="3288" y="534"/>
                      </a:lnTo>
                      <a:lnTo>
                        <a:pt x="3292" y="560"/>
                      </a:lnTo>
                      <a:lnTo>
                        <a:pt x="3295" y="586"/>
                      </a:lnTo>
                      <a:lnTo>
                        <a:pt x="3298" y="611"/>
                      </a:lnTo>
                      <a:lnTo>
                        <a:pt x="3302" y="636"/>
                      </a:lnTo>
                      <a:lnTo>
                        <a:pt x="3305" y="662"/>
                      </a:lnTo>
                      <a:lnTo>
                        <a:pt x="3309" y="685"/>
                      </a:lnTo>
                      <a:lnTo>
                        <a:pt x="3312" y="709"/>
                      </a:lnTo>
                      <a:lnTo>
                        <a:pt x="3316" y="732"/>
                      </a:lnTo>
                      <a:lnTo>
                        <a:pt x="3319" y="755"/>
                      </a:lnTo>
                      <a:lnTo>
                        <a:pt x="3323" y="777"/>
                      </a:lnTo>
                      <a:lnTo>
                        <a:pt x="3326" y="798"/>
                      </a:lnTo>
                      <a:lnTo>
                        <a:pt x="3329" y="819"/>
                      </a:lnTo>
                      <a:lnTo>
                        <a:pt x="3333" y="839"/>
                      </a:lnTo>
                      <a:lnTo>
                        <a:pt x="3336" y="858"/>
                      </a:lnTo>
                      <a:lnTo>
                        <a:pt x="3340" y="877"/>
                      </a:lnTo>
                      <a:lnTo>
                        <a:pt x="3343" y="893"/>
                      </a:lnTo>
                      <a:lnTo>
                        <a:pt x="3347" y="912"/>
                      </a:lnTo>
                      <a:lnTo>
                        <a:pt x="3350" y="927"/>
                      </a:lnTo>
                      <a:lnTo>
                        <a:pt x="3353" y="943"/>
                      </a:lnTo>
                      <a:lnTo>
                        <a:pt x="3357" y="958"/>
                      </a:lnTo>
                      <a:lnTo>
                        <a:pt x="3360" y="972"/>
                      </a:lnTo>
                      <a:lnTo>
                        <a:pt x="3364" y="986"/>
                      </a:lnTo>
                      <a:lnTo>
                        <a:pt x="3367" y="999"/>
                      </a:lnTo>
                      <a:lnTo>
                        <a:pt x="3371" y="1011"/>
                      </a:lnTo>
                      <a:lnTo>
                        <a:pt x="3374" y="1023"/>
                      </a:lnTo>
                      <a:lnTo>
                        <a:pt x="3378" y="1035"/>
                      </a:lnTo>
                      <a:lnTo>
                        <a:pt x="3381" y="1045"/>
                      </a:lnTo>
                      <a:lnTo>
                        <a:pt x="3384" y="1056"/>
                      </a:lnTo>
                      <a:lnTo>
                        <a:pt x="3388" y="1065"/>
                      </a:lnTo>
                      <a:lnTo>
                        <a:pt x="3391" y="1074"/>
                      </a:lnTo>
                      <a:lnTo>
                        <a:pt x="3395" y="1082"/>
                      </a:lnTo>
                      <a:lnTo>
                        <a:pt x="3398" y="1089"/>
                      </a:lnTo>
                      <a:lnTo>
                        <a:pt x="3402" y="1097"/>
                      </a:lnTo>
                      <a:lnTo>
                        <a:pt x="3405" y="1103"/>
                      </a:lnTo>
                      <a:lnTo>
                        <a:pt x="3409" y="1109"/>
                      </a:lnTo>
                      <a:lnTo>
                        <a:pt x="3412" y="1115"/>
                      </a:lnTo>
                      <a:lnTo>
                        <a:pt x="3415" y="1120"/>
                      </a:lnTo>
                      <a:lnTo>
                        <a:pt x="3419" y="1124"/>
                      </a:lnTo>
                      <a:lnTo>
                        <a:pt x="3422" y="1128"/>
                      </a:lnTo>
                      <a:lnTo>
                        <a:pt x="3426" y="1133"/>
                      </a:lnTo>
                      <a:lnTo>
                        <a:pt x="3429" y="1136"/>
                      </a:lnTo>
                      <a:lnTo>
                        <a:pt x="3433" y="1139"/>
                      </a:lnTo>
                      <a:lnTo>
                        <a:pt x="3436" y="1142"/>
                      </a:lnTo>
                      <a:lnTo>
                        <a:pt x="3439" y="1145"/>
                      </a:lnTo>
                      <a:lnTo>
                        <a:pt x="3443" y="1148"/>
                      </a:lnTo>
                      <a:lnTo>
                        <a:pt x="3446" y="1151"/>
                      </a:lnTo>
                      <a:lnTo>
                        <a:pt x="3450" y="1152"/>
                      </a:lnTo>
                      <a:lnTo>
                        <a:pt x="3453" y="1154"/>
                      </a:lnTo>
                      <a:lnTo>
                        <a:pt x="3457" y="1156"/>
                      </a:lnTo>
                      <a:lnTo>
                        <a:pt x="3460" y="1157"/>
                      </a:lnTo>
                      <a:lnTo>
                        <a:pt x="3464" y="1160"/>
                      </a:lnTo>
                      <a:lnTo>
                        <a:pt x="3467" y="1161"/>
                      </a:lnTo>
                      <a:lnTo>
                        <a:pt x="3470" y="1162"/>
                      </a:lnTo>
                      <a:lnTo>
                        <a:pt x="3474" y="1164"/>
                      </a:lnTo>
                      <a:lnTo>
                        <a:pt x="3477" y="1165"/>
                      </a:lnTo>
                      <a:lnTo>
                        <a:pt x="3481" y="1167"/>
                      </a:lnTo>
                      <a:lnTo>
                        <a:pt x="3484" y="1168"/>
                      </a:lnTo>
                      <a:lnTo>
                        <a:pt x="3487" y="1170"/>
                      </a:lnTo>
                      <a:lnTo>
                        <a:pt x="3491" y="1170"/>
                      </a:lnTo>
                      <a:lnTo>
                        <a:pt x="3494" y="1171"/>
                      </a:lnTo>
                      <a:lnTo>
                        <a:pt x="3498" y="1172"/>
                      </a:lnTo>
                      <a:lnTo>
                        <a:pt x="3501" y="1173"/>
                      </a:lnTo>
                      <a:lnTo>
                        <a:pt x="3505" y="1173"/>
                      </a:lnTo>
                      <a:lnTo>
                        <a:pt x="3508" y="1175"/>
                      </a:lnTo>
                      <a:lnTo>
                        <a:pt x="3512" y="1174"/>
                      </a:lnTo>
                      <a:lnTo>
                        <a:pt x="3515" y="1175"/>
                      </a:lnTo>
                      <a:lnTo>
                        <a:pt x="3518" y="1176"/>
                      </a:lnTo>
                      <a:lnTo>
                        <a:pt x="3522" y="1176"/>
                      </a:lnTo>
                      <a:lnTo>
                        <a:pt x="3525" y="1177"/>
                      </a:lnTo>
                      <a:lnTo>
                        <a:pt x="3529" y="1177"/>
                      </a:lnTo>
                      <a:lnTo>
                        <a:pt x="3532" y="1178"/>
                      </a:lnTo>
                      <a:lnTo>
                        <a:pt x="3536" y="1178"/>
                      </a:lnTo>
                      <a:lnTo>
                        <a:pt x="3539" y="1179"/>
                      </a:lnTo>
                      <a:lnTo>
                        <a:pt x="3542" y="1180"/>
                      </a:lnTo>
                      <a:lnTo>
                        <a:pt x="3546" y="1180"/>
                      </a:lnTo>
                      <a:lnTo>
                        <a:pt x="3549" y="1180"/>
                      </a:lnTo>
                      <a:lnTo>
                        <a:pt x="3553" y="1181"/>
                      </a:lnTo>
                      <a:lnTo>
                        <a:pt x="3556" y="1180"/>
                      </a:lnTo>
                      <a:lnTo>
                        <a:pt x="3560" y="1180"/>
                      </a:lnTo>
                      <a:lnTo>
                        <a:pt x="3563" y="1181"/>
                      </a:lnTo>
                      <a:lnTo>
                        <a:pt x="3567" y="1182"/>
                      </a:lnTo>
                      <a:lnTo>
                        <a:pt x="3570" y="1181"/>
                      </a:lnTo>
                      <a:lnTo>
                        <a:pt x="3573" y="1183"/>
                      </a:lnTo>
                      <a:lnTo>
                        <a:pt x="3577" y="1182"/>
                      </a:lnTo>
                      <a:lnTo>
                        <a:pt x="3580" y="1182"/>
                      </a:lnTo>
                      <a:lnTo>
                        <a:pt x="3584" y="1182"/>
                      </a:lnTo>
                      <a:lnTo>
                        <a:pt x="3587" y="1182"/>
                      </a:lnTo>
                      <a:lnTo>
                        <a:pt x="3591" y="1182"/>
                      </a:lnTo>
                      <a:lnTo>
                        <a:pt x="3594" y="1182"/>
                      </a:lnTo>
                      <a:lnTo>
                        <a:pt x="3597" y="1182"/>
                      </a:lnTo>
                      <a:lnTo>
                        <a:pt x="3601" y="1183"/>
                      </a:lnTo>
                      <a:lnTo>
                        <a:pt x="3604" y="1183"/>
                      </a:lnTo>
                      <a:lnTo>
                        <a:pt x="3608" y="1183"/>
                      </a:lnTo>
                      <a:lnTo>
                        <a:pt x="3611" y="1184"/>
                      </a:lnTo>
                      <a:lnTo>
                        <a:pt x="3615" y="1184"/>
                      </a:lnTo>
                      <a:lnTo>
                        <a:pt x="3618" y="1183"/>
                      </a:lnTo>
                      <a:lnTo>
                        <a:pt x="3622" y="1184"/>
                      </a:lnTo>
                      <a:lnTo>
                        <a:pt x="3625" y="1183"/>
                      </a:lnTo>
                      <a:lnTo>
                        <a:pt x="3628" y="1184"/>
                      </a:lnTo>
                      <a:lnTo>
                        <a:pt x="3632" y="1184"/>
                      </a:lnTo>
                      <a:lnTo>
                        <a:pt x="3635" y="1184"/>
                      </a:lnTo>
                      <a:lnTo>
                        <a:pt x="3639" y="1184"/>
                      </a:lnTo>
                      <a:lnTo>
                        <a:pt x="3642" y="1184"/>
                      </a:lnTo>
                      <a:lnTo>
                        <a:pt x="3646" y="1184"/>
                      </a:lnTo>
                      <a:lnTo>
                        <a:pt x="3649" y="1184"/>
                      </a:lnTo>
                      <a:lnTo>
                        <a:pt x="3652" y="1184"/>
                      </a:lnTo>
                      <a:lnTo>
                        <a:pt x="3656" y="1183"/>
                      </a:lnTo>
                      <a:lnTo>
                        <a:pt x="3659" y="1184"/>
                      </a:lnTo>
                      <a:lnTo>
                        <a:pt x="3663" y="1184"/>
                      </a:lnTo>
                      <a:lnTo>
                        <a:pt x="3666" y="1183"/>
                      </a:lnTo>
                      <a:lnTo>
                        <a:pt x="3670" y="1183"/>
                      </a:lnTo>
                      <a:lnTo>
                        <a:pt x="3673" y="1184"/>
                      </a:lnTo>
                      <a:lnTo>
                        <a:pt x="3676" y="1184"/>
                      </a:lnTo>
                      <a:lnTo>
                        <a:pt x="3680" y="1184"/>
                      </a:lnTo>
                      <a:lnTo>
                        <a:pt x="3683" y="1183"/>
                      </a:lnTo>
                      <a:lnTo>
                        <a:pt x="3687" y="1183"/>
                      </a:lnTo>
                      <a:lnTo>
                        <a:pt x="3690" y="1184"/>
                      </a:lnTo>
                      <a:lnTo>
                        <a:pt x="3694" y="1184"/>
                      </a:lnTo>
                      <a:lnTo>
                        <a:pt x="3697" y="1183"/>
                      </a:lnTo>
                      <a:lnTo>
                        <a:pt x="3701" y="1183"/>
                      </a:lnTo>
                      <a:lnTo>
                        <a:pt x="3704" y="1183"/>
                      </a:lnTo>
                      <a:lnTo>
                        <a:pt x="3707" y="1183"/>
                      </a:lnTo>
                      <a:lnTo>
                        <a:pt x="3711" y="1183"/>
                      </a:lnTo>
                      <a:lnTo>
                        <a:pt x="3714" y="1183"/>
                      </a:lnTo>
                      <a:lnTo>
                        <a:pt x="3718" y="1183"/>
                      </a:lnTo>
                      <a:lnTo>
                        <a:pt x="3721" y="1182"/>
                      </a:lnTo>
                      <a:lnTo>
                        <a:pt x="3725" y="1183"/>
                      </a:lnTo>
                      <a:lnTo>
                        <a:pt x="3728" y="1184"/>
                      </a:lnTo>
                      <a:lnTo>
                        <a:pt x="3731" y="1184"/>
                      </a:lnTo>
                      <a:lnTo>
                        <a:pt x="3735" y="1184"/>
                      </a:lnTo>
                      <a:lnTo>
                        <a:pt x="3738" y="1184"/>
                      </a:lnTo>
                      <a:lnTo>
                        <a:pt x="3742" y="1184"/>
                      </a:lnTo>
                      <a:lnTo>
                        <a:pt x="3745" y="1184"/>
                      </a:lnTo>
                      <a:lnTo>
                        <a:pt x="3749" y="1184"/>
                      </a:lnTo>
                      <a:lnTo>
                        <a:pt x="3752" y="1184"/>
                      </a:lnTo>
                      <a:lnTo>
                        <a:pt x="3756" y="1184"/>
                      </a:lnTo>
                      <a:lnTo>
                        <a:pt x="3759" y="1185"/>
                      </a:lnTo>
                      <a:lnTo>
                        <a:pt x="3762" y="1185"/>
                      </a:lnTo>
                      <a:lnTo>
                        <a:pt x="3766" y="1185"/>
                      </a:lnTo>
                      <a:lnTo>
                        <a:pt x="3769" y="1185"/>
                      </a:lnTo>
                      <a:lnTo>
                        <a:pt x="3773" y="1185"/>
                      </a:lnTo>
                      <a:lnTo>
                        <a:pt x="3776" y="1185"/>
                      </a:lnTo>
                      <a:lnTo>
                        <a:pt x="3780" y="1185"/>
                      </a:lnTo>
                      <a:lnTo>
                        <a:pt x="3783" y="1185"/>
                      </a:lnTo>
                      <a:lnTo>
                        <a:pt x="3786" y="1185"/>
                      </a:lnTo>
                      <a:lnTo>
                        <a:pt x="3790" y="1186"/>
                      </a:lnTo>
                      <a:lnTo>
                        <a:pt x="3793" y="1186"/>
                      </a:lnTo>
                      <a:lnTo>
                        <a:pt x="3797" y="1186"/>
                      </a:lnTo>
                      <a:lnTo>
                        <a:pt x="3800" y="1186"/>
                      </a:lnTo>
                      <a:lnTo>
                        <a:pt x="3804" y="1186"/>
                      </a:lnTo>
                      <a:lnTo>
                        <a:pt x="3807" y="1186"/>
                      </a:lnTo>
                      <a:lnTo>
                        <a:pt x="3811" y="1186"/>
                      </a:lnTo>
                      <a:lnTo>
                        <a:pt x="3814" y="1186"/>
                      </a:lnTo>
                      <a:lnTo>
                        <a:pt x="3817" y="1186"/>
                      </a:lnTo>
                      <a:lnTo>
                        <a:pt x="3821" y="1186"/>
                      </a:lnTo>
                      <a:lnTo>
                        <a:pt x="3824" y="1186"/>
                      </a:lnTo>
                      <a:lnTo>
                        <a:pt x="3828" y="1186"/>
                      </a:lnTo>
                      <a:lnTo>
                        <a:pt x="3831" y="1187"/>
                      </a:lnTo>
                      <a:lnTo>
                        <a:pt x="3834" y="1187"/>
                      </a:lnTo>
                      <a:lnTo>
                        <a:pt x="3838" y="1186"/>
                      </a:lnTo>
                      <a:lnTo>
                        <a:pt x="3841" y="1186"/>
                      </a:lnTo>
                      <a:lnTo>
                        <a:pt x="3845" y="1186"/>
                      </a:lnTo>
                      <a:lnTo>
                        <a:pt x="3848" y="1187"/>
                      </a:lnTo>
                      <a:lnTo>
                        <a:pt x="3852" y="1187"/>
                      </a:lnTo>
                      <a:lnTo>
                        <a:pt x="3855" y="1187"/>
                      </a:lnTo>
                      <a:lnTo>
                        <a:pt x="3859" y="1187"/>
                      </a:lnTo>
                      <a:lnTo>
                        <a:pt x="3862" y="1187"/>
                      </a:lnTo>
                      <a:lnTo>
                        <a:pt x="3866" y="1187"/>
                      </a:lnTo>
                      <a:lnTo>
                        <a:pt x="3869" y="1186"/>
                      </a:lnTo>
                      <a:lnTo>
                        <a:pt x="3872" y="1187"/>
                      </a:lnTo>
                      <a:lnTo>
                        <a:pt x="3876" y="1187"/>
                      </a:lnTo>
                      <a:lnTo>
                        <a:pt x="3879" y="1186"/>
                      </a:lnTo>
                      <a:lnTo>
                        <a:pt x="3883" y="1187"/>
                      </a:lnTo>
                      <a:lnTo>
                        <a:pt x="3886" y="1187"/>
                      </a:lnTo>
                      <a:lnTo>
                        <a:pt x="3889" y="1187"/>
                      </a:lnTo>
                      <a:lnTo>
                        <a:pt x="3893" y="1187"/>
                      </a:lnTo>
                      <a:lnTo>
                        <a:pt x="3896" y="1186"/>
                      </a:lnTo>
                      <a:lnTo>
                        <a:pt x="3900" y="1187"/>
                      </a:lnTo>
                      <a:lnTo>
                        <a:pt x="3903" y="1188"/>
                      </a:lnTo>
                      <a:lnTo>
                        <a:pt x="3907" y="1187"/>
                      </a:lnTo>
                      <a:lnTo>
                        <a:pt x="3910" y="1187"/>
                      </a:lnTo>
                      <a:lnTo>
                        <a:pt x="3914" y="1187"/>
                      </a:lnTo>
                      <a:lnTo>
                        <a:pt x="3917" y="1187"/>
                      </a:lnTo>
                      <a:lnTo>
                        <a:pt x="3920" y="1186"/>
                      </a:lnTo>
                      <a:lnTo>
                        <a:pt x="3924" y="1187"/>
                      </a:lnTo>
                      <a:lnTo>
                        <a:pt x="3927" y="1187"/>
                      </a:lnTo>
                      <a:lnTo>
                        <a:pt x="3931" y="1188"/>
                      </a:lnTo>
                      <a:lnTo>
                        <a:pt x="3934" y="1187"/>
                      </a:lnTo>
                      <a:lnTo>
                        <a:pt x="3938" y="1187"/>
                      </a:lnTo>
                      <a:lnTo>
                        <a:pt x="3941" y="1188"/>
                      </a:lnTo>
                      <a:lnTo>
                        <a:pt x="3944" y="1188"/>
                      </a:lnTo>
                      <a:lnTo>
                        <a:pt x="3948" y="1188"/>
                      </a:lnTo>
                      <a:lnTo>
                        <a:pt x="3951" y="1188"/>
                      </a:lnTo>
                      <a:lnTo>
                        <a:pt x="3955" y="1188"/>
                      </a:lnTo>
                      <a:lnTo>
                        <a:pt x="3958" y="1188"/>
                      </a:lnTo>
                      <a:lnTo>
                        <a:pt x="3962" y="1188"/>
                      </a:lnTo>
                      <a:lnTo>
                        <a:pt x="3965" y="1187"/>
                      </a:lnTo>
                      <a:lnTo>
                        <a:pt x="3969" y="1187"/>
                      </a:lnTo>
                      <a:lnTo>
                        <a:pt x="3972" y="1188"/>
                      </a:lnTo>
                      <a:lnTo>
                        <a:pt x="3975" y="1188"/>
                      </a:lnTo>
                      <a:lnTo>
                        <a:pt x="3979" y="1187"/>
                      </a:lnTo>
                      <a:lnTo>
                        <a:pt x="3982" y="1188"/>
                      </a:lnTo>
                      <a:lnTo>
                        <a:pt x="3986" y="1187"/>
                      </a:lnTo>
                      <a:lnTo>
                        <a:pt x="3989" y="1188"/>
                      </a:lnTo>
                      <a:lnTo>
                        <a:pt x="3993" y="1188"/>
                      </a:lnTo>
                      <a:lnTo>
                        <a:pt x="3996" y="1187"/>
                      </a:lnTo>
                      <a:lnTo>
                        <a:pt x="4000" y="1187"/>
                      </a:lnTo>
                      <a:lnTo>
                        <a:pt x="4003" y="1187"/>
                      </a:lnTo>
                      <a:lnTo>
                        <a:pt x="4006" y="1188"/>
                      </a:lnTo>
                      <a:lnTo>
                        <a:pt x="4010" y="1188"/>
                      </a:lnTo>
                      <a:lnTo>
                        <a:pt x="4013" y="1188"/>
                      </a:lnTo>
                      <a:lnTo>
                        <a:pt x="4017" y="1188"/>
                      </a:lnTo>
                      <a:lnTo>
                        <a:pt x="4020" y="1187"/>
                      </a:lnTo>
                      <a:lnTo>
                        <a:pt x="4024" y="1188"/>
                      </a:lnTo>
                      <a:lnTo>
                        <a:pt x="4027" y="1188"/>
                      </a:lnTo>
                      <a:lnTo>
                        <a:pt x="4030" y="1188"/>
                      </a:lnTo>
                      <a:lnTo>
                        <a:pt x="4034" y="1188"/>
                      </a:lnTo>
                      <a:lnTo>
                        <a:pt x="4037" y="1188"/>
                      </a:lnTo>
                      <a:lnTo>
                        <a:pt x="4041" y="1188"/>
                      </a:lnTo>
                      <a:lnTo>
                        <a:pt x="4044" y="1188"/>
                      </a:lnTo>
                      <a:lnTo>
                        <a:pt x="4048" y="1188"/>
                      </a:lnTo>
                      <a:lnTo>
                        <a:pt x="4051" y="1188"/>
                      </a:lnTo>
                      <a:lnTo>
                        <a:pt x="4055" y="1188"/>
                      </a:lnTo>
                      <a:lnTo>
                        <a:pt x="4058" y="1188"/>
                      </a:lnTo>
                      <a:lnTo>
                        <a:pt x="4061" y="1188"/>
                      </a:lnTo>
                      <a:lnTo>
                        <a:pt x="4065" y="1189"/>
                      </a:lnTo>
                      <a:lnTo>
                        <a:pt x="4068" y="1188"/>
                      </a:lnTo>
                      <a:lnTo>
                        <a:pt x="4072" y="1188"/>
                      </a:lnTo>
                      <a:lnTo>
                        <a:pt x="4075" y="1188"/>
                      </a:lnTo>
                      <a:lnTo>
                        <a:pt x="4078" y="1189"/>
                      </a:lnTo>
                      <a:lnTo>
                        <a:pt x="4082" y="1188"/>
                      </a:lnTo>
                      <a:lnTo>
                        <a:pt x="4085" y="1189"/>
                      </a:lnTo>
                      <a:lnTo>
                        <a:pt x="4089" y="1187"/>
                      </a:lnTo>
                      <a:lnTo>
                        <a:pt x="4092" y="1188"/>
                      </a:lnTo>
                      <a:lnTo>
                        <a:pt x="4096" y="1188"/>
                      </a:lnTo>
                      <a:lnTo>
                        <a:pt x="4099" y="1189"/>
                      </a:lnTo>
                      <a:lnTo>
                        <a:pt x="4103" y="1188"/>
                      </a:lnTo>
                      <a:lnTo>
                        <a:pt x="4106" y="1188"/>
                      </a:lnTo>
                      <a:lnTo>
                        <a:pt x="4109" y="1189"/>
                      </a:lnTo>
                      <a:lnTo>
                        <a:pt x="4113" y="1189"/>
                      </a:lnTo>
                      <a:lnTo>
                        <a:pt x="4116" y="1188"/>
                      </a:lnTo>
                      <a:lnTo>
                        <a:pt x="4120" y="1189"/>
                      </a:lnTo>
                      <a:lnTo>
                        <a:pt x="4123" y="1189"/>
                      </a:lnTo>
                      <a:lnTo>
                        <a:pt x="4127" y="1188"/>
                      </a:lnTo>
                      <a:lnTo>
                        <a:pt x="4130" y="1188"/>
                      </a:lnTo>
                      <a:lnTo>
                        <a:pt x="4133" y="1188"/>
                      </a:lnTo>
                      <a:lnTo>
                        <a:pt x="4137" y="1189"/>
                      </a:lnTo>
                      <a:lnTo>
                        <a:pt x="4140" y="1188"/>
                      </a:lnTo>
                      <a:lnTo>
                        <a:pt x="4144" y="1188"/>
                      </a:lnTo>
                      <a:lnTo>
                        <a:pt x="4147" y="1188"/>
                      </a:lnTo>
                      <a:lnTo>
                        <a:pt x="4151" y="1189"/>
                      </a:lnTo>
                      <a:lnTo>
                        <a:pt x="4154" y="1188"/>
                      </a:lnTo>
                      <a:lnTo>
                        <a:pt x="4158" y="1188"/>
                      </a:lnTo>
                      <a:lnTo>
                        <a:pt x="4161" y="1188"/>
                      </a:lnTo>
                      <a:lnTo>
                        <a:pt x="4164" y="1188"/>
                      </a:lnTo>
                      <a:lnTo>
                        <a:pt x="4168" y="1189"/>
                      </a:lnTo>
                      <a:lnTo>
                        <a:pt x="4171" y="1189"/>
                      </a:lnTo>
                      <a:lnTo>
                        <a:pt x="4175" y="1189"/>
                      </a:lnTo>
                      <a:lnTo>
                        <a:pt x="4178" y="1189"/>
                      </a:lnTo>
                      <a:lnTo>
                        <a:pt x="4182" y="1189"/>
                      </a:lnTo>
                      <a:lnTo>
                        <a:pt x="4185" y="1189"/>
                      </a:lnTo>
                      <a:lnTo>
                        <a:pt x="4188" y="1189"/>
                      </a:lnTo>
                      <a:lnTo>
                        <a:pt x="4192" y="1188"/>
                      </a:lnTo>
                      <a:lnTo>
                        <a:pt x="4195" y="1189"/>
                      </a:lnTo>
                      <a:lnTo>
                        <a:pt x="4199" y="1189"/>
                      </a:lnTo>
                      <a:lnTo>
                        <a:pt x="4202" y="1189"/>
                      </a:lnTo>
                      <a:lnTo>
                        <a:pt x="4206" y="1189"/>
                      </a:lnTo>
                      <a:lnTo>
                        <a:pt x="4209" y="1188"/>
                      </a:lnTo>
                      <a:lnTo>
                        <a:pt x="4213" y="1188"/>
                      </a:lnTo>
                      <a:lnTo>
                        <a:pt x="4216" y="1189"/>
                      </a:lnTo>
                      <a:lnTo>
                        <a:pt x="4219" y="1188"/>
                      </a:lnTo>
                      <a:lnTo>
                        <a:pt x="4223" y="1188"/>
                      </a:lnTo>
                      <a:lnTo>
                        <a:pt x="4226" y="1189"/>
                      </a:lnTo>
                      <a:lnTo>
                        <a:pt x="4230" y="1187"/>
                      </a:lnTo>
                      <a:lnTo>
                        <a:pt x="4233" y="1188"/>
                      </a:lnTo>
                      <a:lnTo>
                        <a:pt x="4236" y="1189"/>
                      </a:lnTo>
                      <a:lnTo>
                        <a:pt x="4240" y="1188"/>
                      </a:lnTo>
                      <a:lnTo>
                        <a:pt x="4243" y="1188"/>
                      </a:lnTo>
                      <a:lnTo>
                        <a:pt x="4247" y="1189"/>
                      </a:lnTo>
                      <a:lnTo>
                        <a:pt x="4250" y="1188"/>
                      </a:lnTo>
                      <a:lnTo>
                        <a:pt x="4254" y="1189"/>
                      </a:lnTo>
                      <a:lnTo>
                        <a:pt x="4257" y="1188"/>
                      </a:lnTo>
                      <a:lnTo>
                        <a:pt x="4261" y="1188"/>
                      </a:lnTo>
                      <a:lnTo>
                        <a:pt x="4264" y="1189"/>
                      </a:lnTo>
                      <a:lnTo>
                        <a:pt x="4267" y="1188"/>
                      </a:lnTo>
                      <a:lnTo>
                        <a:pt x="4271" y="1189"/>
                      </a:lnTo>
                      <a:lnTo>
                        <a:pt x="4274" y="1189"/>
                      </a:lnTo>
                      <a:lnTo>
                        <a:pt x="4278" y="1189"/>
                      </a:lnTo>
                      <a:lnTo>
                        <a:pt x="4281" y="1189"/>
                      </a:lnTo>
                      <a:lnTo>
                        <a:pt x="4285" y="1189"/>
                      </a:lnTo>
                      <a:lnTo>
                        <a:pt x="4288" y="1188"/>
                      </a:lnTo>
                      <a:lnTo>
                        <a:pt x="4292" y="1189"/>
                      </a:lnTo>
                      <a:lnTo>
                        <a:pt x="4295" y="1190"/>
                      </a:lnTo>
                      <a:lnTo>
                        <a:pt x="4298" y="1189"/>
                      </a:lnTo>
                      <a:lnTo>
                        <a:pt x="4302" y="1189"/>
                      </a:lnTo>
                      <a:lnTo>
                        <a:pt x="4305" y="1189"/>
                      </a:lnTo>
                      <a:lnTo>
                        <a:pt x="4309" y="1189"/>
                      </a:lnTo>
                      <a:lnTo>
                        <a:pt x="4312" y="1189"/>
                      </a:lnTo>
                      <a:lnTo>
                        <a:pt x="4316" y="1189"/>
                      </a:lnTo>
                      <a:lnTo>
                        <a:pt x="4319" y="1189"/>
                      </a:lnTo>
                      <a:lnTo>
                        <a:pt x="4322" y="1189"/>
                      </a:lnTo>
                      <a:lnTo>
                        <a:pt x="4326" y="1188"/>
                      </a:lnTo>
                      <a:lnTo>
                        <a:pt x="4329" y="1189"/>
                      </a:lnTo>
                      <a:lnTo>
                        <a:pt x="4333" y="1188"/>
                      </a:lnTo>
                      <a:lnTo>
                        <a:pt x="4336" y="1189"/>
                      </a:lnTo>
                      <a:lnTo>
                        <a:pt x="4340" y="1189"/>
                      </a:lnTo>
                      <a:lnTo>
                        <a:pt x="4343" y="1190"/>
                      </a:lnTo>
                      <a:lnTo>
                        <a:pt x="4347" y="1189"/>
                      </a:lnTo>
                      <a:lnTo>
                        <a:pt x="4350" y="1189"/>
                      </a:lnTo>
                      <a:lnTo>
                        <a:pt x="4353" y="1189"/>
                      </a:lnTo>
                      <a:lnTo>
                        <a:pt x="4357" y="1188"/>
                      </a:lnTo>
                      <a:lnTo>
                        <a:pt x="4360" y="1189"/>
                      </a:lnTo>
                      <a:lnTo>
                        <a:pt x="4364" y="1189"/>
                      </a:lnTo>
                      <a:lnTo>
                        <a:pt x="4367" y="1188"/>
                      </a:lnTo>
                      <a:lnTo>
                        <a:pt x="4371" y="1189"/>
                      </a:lnTo>
                      <a:lnTo>
                        <a:pt x="4374" y="1189"/>
                      </a:lnTo>
                      <a:lnTo>
                        <a:pt x="4377" y="1190"/>
                      </a:lnTo>
                      <a:lnTo>
                        <a:pt x="4381" y="1189"/>
                      </a:lnTo>
                      <a:lnTo>
                        <a:pt x="4384" y="1189"/>
                      </a:lnTo>
                      <a:lnTo>
                        <a:pt x="4388" y="1189"/>
                      </a:lnTo>
                      <a:lnTo>
                        <a:pt x="4391" y="1189"/>
                      </a:lnTo>
                      <a:lnTo>
                        <a:pt x="4395" y="1188"/>
                      </a:lnTo>
                      <a:lnTo>
                        <a:pt x="4398" y="1189"/>
                      </a:lnTo>
                      <a:lnTo>
                        <a:pt x="4402" y="1190"/>
                      </a:lnTo>
                      <a:lnTo>
                        <a:pt x="4405" y="1189"/>
                      </a:lnTo>
                      <a:lnTo>
                        <a:pt x="4408" y="1189"/>
                      </a:lnTo>
                      <a:lnTo>
                        <a:pt x="4412" y="1189"/>
                      </a:lnTo>
                      <a:lnTo>
                        <a:pt x="4415" y="1189"/>
                      </a:lnTo>
                      <a:lnTo>
                        <a:pt x="4419" y="1189"/>
                      </a:lnTo>
                      <a:lnTo>
                        <a:pt x="4422" y="1189"/>
                      </a:lnTo>
                      <a:lnTo>
                        <a:pt x="4425" y="1189"/>
                      </a:lnTo>
                      <a:lnTo>
                        <a:pt x="4429" y="1189"/>
                      </a:lnTo>
                      <a:lnTo>
                        <a:pt x="4432" y="1189"/>
                      </a:lnTo>
                      <a:lnTo>
                        <a:pt x="4436" y="1189"/>
                      </a:lnTo>
                      <a:lnTo>
                        <a:pt x="4439" y="1188"/>
                      </a:lnTo>
                      <a:lnTo>
                        <a:pt x="4443" y="1189"/>
                      </a:lnTo>
                      <a:lnTo>
                        <a:pt x="4446" y="1189"/>
                      </a:lnTo>
                      <a:lnTo>
                        <a:pt x="4450" y="1189"/>
                      </a:lnTo>
                      <a:lnTo>
                        <a:pt x="4453" y="1190"/>
                      </a:lnTo>
                      <a:lnTo>
                        <a:pt x="4456" y="1190"/>
                      </a:lnTo>
                      <a:lnTo>
                        <a:pt x="4460" y="1190"/>
                      </a:lnTo>
                      <a:lnTo>
                        <a:pt x="4463" y="1189"/>
                      </a:lnTo>
                      <a:lnTo>
                        <a:pt x="4467" y="1189"/>
                      </a:lnTo>
                      <a:lnTo>
                        <a:pt x="4470" y="1189"/>
                      </a:lnTo>
                      <a:lnTo>
                        <a:pt x="4474" y="1189"/>
                      </a:lnTo>
                      <a:lnTo>
                        <a:pt x="4477" y="1189"/>
                      </a:lnTo>
                      <a:lnTo>
                        <a:pt x="4480" y="1190"/>
                      </a:lnTo>
                      <a:lnTo>
                        <a:pt x="4484" y="1189"/>
                      </a:lnTo>
                      <a:lnTo>
                        <a:pt x="4487" y="1190"/>
                      </a:lnTo>
                      <a:lnTo>
                        <a:pt x="4491" y="1189"/>
                      </a:lnTo>
                      <a:lnTo>
                        <a:pt x="4494" y="1189"/>
                      </a:lnTo>
                      <a:lnTo>
                        <a:pt x="4498" y="1189"/>
                      </a:lnTo>
                      <a:lnTo>
                        <a:pt x="4501" y="1189"/>
                      </a:lnTo>
                      <a:lnTo>
                        <a:pt x="4505" y="1190"/>
                      </a:lnTo>
                      <a:lnTo>
                        <a:pt x="4508" y="1190"/>
                      </a:lnTo>
                      <a:lnTo>
                        <a:pt x="4511" y="1190"/>
                      </a:lnTo>
                      <a:lnTo>
                        <a:pt x="4515" y="1189"/>
                      </a:lnTo>
                      <a:lnTo>
                        <a:pt x="4518" y="1190"/>
                      </a:lnTo>
                      <a:lnTo>
                        <a:pt x="4522" y="1189"/>
                      </a:lnTo>
                      <a:lnTo>
                        <a:pt x="4525" y="1190"/>
                      </a:lnTo>
                      <a:lnTo>
                        <a:pt x="4529" y="1190"/>
                      </a:lnTo>
                      <a:lnTo>
                        <a:pt x="4532" y="1189"/>
                      </a:lnTo>
                      <a:lnTo>
                        <a:pt x="4535" y="1190"/>
                      </a:lnTo>
                      <a:lnTo>
                        <a:pt x="4536" y="1190"/>
                      </a:lnTo>
                    </a:path>
                  </a:pathLst>
                </a:custGeom>
                <a:noFill/>
                <a:ln w="9525" cap="flat" cmpd="sng">
                  <a:solidFill>
                    <a:srgbClr val="0000FF"/>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rgbClr val="000000"/>
                    </a:solidFill>
                    <a:latin typeface="Arial"/>
                    <a:ea typeface="Arial"/>
                    <a:cs typeface="Arial"/>
                    <a:sym typeface="Arial"/>
                  </a:endParaRPr>
                </a:p>
              </p:txBody>
            </p:sp>
            <p:sp>
              <p:nvSpPr>
                <p:cNvPr id="1563" name="Google Shape;1563;p11"/>
                <p:cNvSpPr/>
                <p:nvPr/>
              </p:nvSpPr>
              <p:spPr>
                <a:xfrm>
                  <a:off x="1432" y="1555"/>
                  <a:ext cx="4536" cy="1858"/>
                </a:xfrm>
                <a:custGeom>
                  <a:avLst/>
                  <a:gdLst/>
                  <a:ahLst/>
                  <a:cxnLst/>
                  <a:rect l="l" t="t" r="r" b="b"/>
                  <a:pathLst>
                    <a:path w="4536" h="1858" extrusionOk="0">
                      <a:moveTo>
                        <a:pt x="0" y="1858"/>
                      </a:moveTo>
                      <a:lnTo>
                        <a:pt x="3" y="1858"/>
                      </a:lnTo>
                      <a:lnTo>
                        <a:pt x="7" y="1858"/>
                      </a:lnTo>
                      <a:lnTo>
                        <a:pt x="10" y="1858"/>
                      </a:lnTo>
                      <a:lnTo>
                        <a:pt x="14" y="1858"/>
                      </a:lnTo>
                      <a:lnTo>
                        <a:pt x="17" y="1858"/>
                      </a:lnTo>
                      <a:lnTo>
                        <a:pt x="21" y="1857"/>
                      </a:lnTo>
                      <a:lnTo>
                        <a:pt x="24" y="1858"/>
                      </a:lnTo>
                      <a:lnTo>
                        <a:pt x="28" y="1858"/>
                      </a:lnTo>
                      <a:lnTo>
                        <a:pt x="31" y="1858"/>
                      </a:lnTo>
                      <a:lnTo>
                        <a:pt x="34" y="1858"/>
                      </a:lnTo>
                      <a:lnTo>
                        <a:pt x="38" y="1857"/>
                      </a:lnTo>
                      <a:lnTo>
                        <a:pt x="41" y="1858"/>
                      </a:lnTo>
                      <a:lnTo>
                        <a:pt x="45" y="1857"/>
                      </a:lnTo>
                      <a:lnTo>
                        <a:pt x="48" y="1858"/>
                      </a:lnTo>
                      <a:lnTo>
                        <a:pt x="52" y="1858"/>
                      </a:lnTo>
                      <a:lnTo>
                        <a:pt x="55" y="1858"/>
                      </a:lnTo>
                      <a:lnTo>
                        <a:pt x="58" y="1858"/>
                      </a:lnTo>
                      <a:lnTo>
                        <a:pt x="62" y="1858"/>
                      </a:lnTo>
                      <a:lnTo>
                        <a:pt x="65" y="1858"/>
                      </a:lnTo>
                      <a:lnTo>
                        <a:pt x="69" y="1858"/>
                      </a:lnTo>
                      <a:lnTo>
                        <a:pt x="72" y="1858"/>
                      </a:lnTo>
                      <a:lnTo>
                        <a:pt x="76" y="1858"/>
                      </a:lnTo>
                      <a:lnTo>
                        <a:pt x="79" y="1858"/>
                      </a:lnTo>
                      <a:lnTo>
                        <a:pt x="82" y="1858"/>
                      </a:lnTo>
                      <a:lnTo>
                        <a:pt x="86" y="1857"/>
                      </a:lnTo>
                      <a:lnTo>
                        <a:pt x="89" y="1857"/>
                      </a:lnTo>
                      <a:lnTo>
                        <a:pt x="93" y="1857"/>
                      </a:lnTo>
                      <a:lnTo>
                        <a:pt x="96" y="1857"/>
                      </a:lnTo>
                      <a:lnTo>
                        <a:pt x="100" y="1857"/>
                      </a:lnTo>
                      <a:lnTo>
                        <a:pt x="103" y="1857"/>
                      </a:lnTo>
                      <a:lnTo>
                        <a:pt x="107" y="1857"/>
                      </a:lnTo>
                      <a:lnTo>
                        <a:pt x="110" y="1857"/>
                      </a:lnTo>
                      <a:lnTo>
                        <a:pt x="114" y="1857"/>
                      </a:lnTo>
                      <a:lnTo>
                        <a:pt x="117" y="1858"/>
                      </a:lnTo>
                      <a:lnTo>
                        <a:pt x="120" y="1858"/>
                      </a:lnTo>
                      <a:lnTo>
                        <a:pt x="124" y="1857"/>
                      </a:lnTo>
                      <a:lnTo>
                        <a:pt x="127" y="1857"/>
                      </a:lnTo>
                      <a:lnTo>
                        <a:pt x="131" y="1858"/>
                      </a:lnTo>
                      <a:lnTo>
                        <a:pt x="134" y="1858"/>
                      </a:lnTo>
                      <a:lnTo>
                        <a:pt x="137" y="1857"/>
                      </a:lnTo>
                      <a:lnTo>
                        <a:pt x="141" y="1857"/>
                      </a:lnTo>
                      <a:lnTo>
                        <a:pt x="144" y="1857"/>
                      </a:lnTo>
                      <a:lnTo>
                        <a:pt x="148" y="1857"/>
                      </a:lnTo>
                      <a:lnTo>
                        <a:pt x="151" y="1857"/>
                      </a:lnTo>
                      <a:lnTo>
                        <a:pt x="155" y="1857"/>
                      </a:lnTo>
                      <a:lnTo>
                        <a:pt x="158" y="1858"/>
                      </a:lnTo>
                      <a:lnTo>
                        <a:pt x="162" y="1857"/>
                      </a:lnTo>
                      <a:lnTo>
                        <a:pt x="165" y="1857"/>
                      </a:lnTo>
                      <a:lnTo>
                        <a:pt x="168" y="1856"/>
                      </a:lnTo>
                      <a:lnTo>
                        <a:pt x="172" y="1856"/>
                      </a:lnTo>
                      <a:lnTo>
                        <a:pt x="175" y="1856"/>
                      </a:lnTo>
                      <a:lnTo>
                        <a:pt x="179" y="1855"/>
                      </a:lnTo>
                      <a:lnTo>
                        <a:pt x="182" y="1855"/>
                      </a:lnTo>
                      <a:lnTo>
                        <a:pt x="186" y="1853"/>
                      </a:lnTo>
                      <a:lnTo>
                        <a:pt x="189" y="1853"/>
                      </a:lnTo>
                      <a:lnTo>
                        <a:pt x="192" y="1852"/>
                      </a:lnTo>
                      <a:lnTo>
                        <a:pt x="196" y="1851"/>
                      </a:lnTo>
                      <a:lnTo>
                        <a:pt x="199" y="1848"/>
                      </a:lnTo>
                      <a:lnTo>
                        <a:pt x="203" y="1847"/>
                      </a:lnTo>
                      <a:lnTo>
                        <a:pt x="206" y="1843"/>
                      </a:lnTo>
                      <a:lnTo>
                        <a:pt x="210" y="1840"/>
                      </a:lnTo>
                      <a:lnTo>
                        <a:pt x="213" y="1838"/>
                      </a:lnTo>
                      <a:lnTo>
                        <a:pt x="217" y="1837"/>
                      </a:lnTo>
                      <a:lnTo>
                        <a:pt x="220" y="1837"/>
                      </a:lnTo>
                      <a:lnTo>
                        <a:pt x="223" y="1839"/>
                      </a:lnTo>
                      <a:lnTo>
                        <a:pt x="227" y="1843"/>
                      </a:lnTo>
                      <a:lnTo>
                        <a:pt x="230" y="1845"/>
                      </a:lnTo>
                      <a:lnTo>
                        <a:pt x="234" y="1845"/>
                      </a:lnTo>
                      <a:lnTo>
                        <a:pt x="237" y="1846"/>
                      </a:lnTo>
                      <a:lnTo>
                        <a:pt x="240" y="1846"/>
                      </a:lnTo>
                      <a:lnTo>
                        <a:pt x="244" y="1846"/>
                      </a:lnTo>
                      <a:lnTo>
                        <a:pt x="247" y="1844"/>
                      </a:lnTo>
                      <a:lnTo>
                        <a:pt x="251" y="1843"/>
                      </a:lnTo>
                      <a:lnTo>
                        <a:pt x="254" y="1841"/>
                      </a:lnTo>
                      <a:lnTo>
                        <a:pt x="258" y="1839"/>
                      </a:lnTo>
                      <a:lnTo>
                        <a:pt x="261" y="1838"/>
                      </a:lnTo>
                      <a:lnTo>
                        <a:pt x="265" y="1835"/>
                      </a:lnTo>
                      <a:lnTo>
                        <a:pt x="268" y="1835"/>
                      </a:lnTo>
                      <a:lnTo>
                        <a:pt x="272" y="1834"/>
                      </a:lnTo>
                      <a:lnTo>
                        <a:pt x="275" y="1834"/>
                      </a:lnTo>
                      <a:lnTo>
                        <a:pt x="278" y="1834"/>
                      </a:lnTo>
                      <a:lnTo>
                        <a:pt x="282" y="1833"/>
                      </a:lnTo>
                      <a:lnTo>
                        <a:pt x="285" y="1831"/>
                      </a:lnTo>
                      <a:lnTo>
                        <a:pt x="289" y="1829"/>
                      </a:lnTo>
                      <a:lnTo>
                        <a:pt x="292" y="1829"/>
                      </a:lnTo>
                      <a:lnTo>
                        <a:pt x="295" y="1828"/>
                      </a:lnTo>
                      <a:lnTo>
                        <a:pt x="299" y="1828"/>
                      </a:lnTo>
                      <a:lnTo>
                        <a:pt x="302" y="1828"/>
                      </a:lnTo>
                      <a:lnTo>
                        <a:pt x="306" y="1828"/>
                      </a:lnTo>
                      <a:lnTo>
                        <a:pt x="309" y="1827"/>
                      </a:lnTo>
                      <a:lnTo>
                        <a:pt x="313" y="1824"/>
                      </a:lnTo>
                      <a:lnTo>
                        <a:pt x="316" y="1821"/>
                      </a:lnTo>
                      <a:lnTo>
                        <a:pt x="320" y="1818"/>
                      </a:lnTo>
                      <a:lnTo>
                        <a:pt x="323" y="1815"/>
                      </a:lnTo>
                      <a:lnTo>
                        <a:pt x="326" y="1815"/>
                      </a:lnTo>
                      <a:lnTo>
                        <a:pt x="330" y="1815"/>
                      </a:lnTo>
                      <a:lnTo>
                        <a:pt x="333" y="1819"/>
                      </a:lnTo>
                      <a:lnTo>
                        <a:pt x="337" y="1823"/>
                      </a:lnTo>
                      <a:lnTo>
                        <a:pt x="340" y="1825"/>
                      </a:lnTo>
                      <a:lnTo>
                        <a:pt x="344" y="1829"/>
                      </a:lnTo>
                      <a:lnTo>
                        <a:pt x="347" y="1831"/>
                      </a:lnTo>
                      <a:lnTo>
                        <a:pt x="351" y="1833"/>
                      </a:lnTo>
                      <a:lnTo>
                        <a:pt x="354" y="1836"/>
                      </a:lnTo>
                      <a:lnTo>
                        <a:pt x="357" y="1839"/>
                      </a:lnTo>
                      <a:lnTo>
                        <a:pt x="361" y="1840"/>
                      </a:lnTo>
                      <a:lnTo>
                        <a:pt x="364" y="1842"/>
                      </a:lnTo>
                      <a:lnTo>
                        <a:pt x="368" y="1843"/>
                      </a:lnTo>
                      <a:lnTo>
                        <a:pt x="371" y="1843"/>
                      </a:lnTo>
                      <a:lnTo>
                        <a:pt x="375" y="1843"/>
                      </a:lnTo>
                      <a:lnTo>
                        <a:pt x="378" y="1844"/>
                      </a:lnTo>
                      <a:lnTo>
                        <a:pt x="381" y="1845"/>
                      </a:lnTo>
                      <a:lnTo>
                        <a:pt x="385" y="1845"/>
                      </a:lnTo>
                      <a:lnTo>
                        <a:pt x="388" y="1846"/>
                      </a:lnTo>
                      <a:lnTo>
                        <a:pt x="392" y="1847"/>
                      </a:lnTo>
                      <a:lnTo>
                        <a:pt x="395" y="1846"/>
                      </a:lnTo>
                      <a:lnTo>
                        <a:pt x="399" y="1847"/>
                      </a:lnTo>
                      <a:lnTo>
                        <a:pt x="402" y="1847"/>
                      </a:lnTo>
                      <a:lnTo>
                        <a:pt x="406" y="1847"/>
                      </a:lnTo>
                      <a:lnTo>
                        <a:pt x="409" y="1846"/>
                      </a:lnTo>
                      <a:lnTo>
                        <a:pt x="412" y="1846"/>
                      </a:lnTo>
                      <a:lnTo>
                        <a:pt x="416" y="1845"/>
                      </a:lnTo>
                      <a:lnTo>
                        <a:pt x="419" y="1845"/>
                      </a:lnTo>
                      <a:lnTo>
                        <a:pt x="423" y="1845"/>
                      </a:lnTo>
                      <a:lnTo>
                        <a:pt x="426" y="1844"/>
                      </a:lnTo>
                      <a:lnTo>
                        <a:pt x="430" y="1844"/>
                      </a:lnTo>
                      <a:lnTo>
                        <a:pt x="433" y="1844"/>
                      </a:lnTo>
                      <a:lnTo>
                        <a:pt x="436" y="1845"/>
                      </a:lnTo>
                      <a:lnTo>
                        <a:pt x="440" y="1846"/>
                      </a:lnTo>
                      <a:lnTo>
                        <a:pt x="443" y="1847"/>
                      </a:lnTo>
                      <a:lnTo>
                        <a:pt x="447" y="1847"/>
                      </a:lnTo>
                      <a:lnTo>
                        <a:pt x="450" y="1848"/>
                      </a:lnTo>
                      <a:lnTo>
                        <a:pt x="454" y="1849"/>
                      </a:lnTo>
                      <a:lnTo>
                        <a:pt x="457" y="1849"/>
                      </a:lnTo>
                      <a:lnTo>
                        <a:pt x="461" y="1851"/>
                      </a:lnTo>
                      <a:lnTo>
                        <a:pt x="464" y="1851"/>
                      </a:lnTo>
                      <a:lnTo>
                        <a:pt x="467" y="1851"/>
                      </a:lnTo>
                      <a:lnTo>
                        <a:pt x="471" y="1851"/>
                      </a:lnTo>
                      <a:lnTo>
                        <a:pt x="474" y="1851"/>
                      </a:lnTo>
                      <a:lnTo>
                        <a:pt x="478" y="1849"/>
                      </a:lnTo>
                      <a:lnTo>
                        <a:pt x="481" y="1849"/>
                      </a:lnTo>
                      <a:lnTo>
                        <a:pt x="484" y="1849"/>
                      </a:lnTo>
                      <a:lnTo>
                        <a:pt x="488" y="1850"/>
                      </a:lnTo>
                      <a:lnTo>
                        <a:pt x="491" y="1850"/>
                      </a:lnTo>
                      <a:lnTo>
                        <a:pt x="495" y="1849"/>
                      </a:lnTo>
                      <a:lnTo>
                        <a:pt x="498" y="1850"/>
                      </a:lnTo>
                      <a:lnTo>
                        <a:pt x="502" y="1850"/>
                      </a:lnTo>
                      <a:lnTo>
                        <a:pt x="505" y="1849"/>
                      </a:lnTo>
                      <a:lnTo>
                        <a:pt x="509" y="1849"/>
                      </a:lnTo>
                      <a:lnTo>
                        <a:pt x="512" y="1850"/>
                      </a:lnTo>
                      <a:lnTo>
                        <a:pt x="515" y="1849"/>
                      </a:lnTo>
                      <a:lnTo>
                        <a:pt x="519" y="1849"/>
                      </a:lnTo>
                      <a:lnTo>
                        <a:pt x="522" y="1849"/>
                      </a:lnTo>
                      <a:lnTo>
                        <a:pt x="526" y="1848"/>
                      </a:lnTo>
                      <a:lnTo>
                        <a:pt x="529" y="1846"/>
                      </a:lnTo>
                      <a:lnTo>
                        <a:pt x="533" y="1843"/>
                      </a:lnTo>
                      <a:lnTo>
                        <a:pt x="536" y="1835"/>
                      </a:lnTo>
                      <a:lnTo>
                        <a:pt x="539" y="1822"/>
                      </a:lnTo>
                      <a:lnTo>
                        <a:pt x="543" y="1801"/>
                      </a:lnTo>
                      <a:lnTo>
                        <a:pt x="546" y="1774"/>
                      </a:lnTo>
                      <a:lnTo>
                        <a:pt x="550" y="1741"/>
                      </a:lnTo>
                      <a:lnTo>
                        <a:pt x="553" y="1709"/>
                      </a:lnTo>
                      <a:lnTo>
                        <a:pt x="557" y="1684"/>
                      </a:lnTo>
                      <a:lnTo>
                        <a:pt x="560" y="1670"/>
                      </a:lnTo>
                      <a:lnTo>
                        <a:pt x="564" y="1674"/>
                      </a:lnTo>
                      <a:lnTo>
                        <a:pt x="567" y="1691"/>
                      </a:lnTo>
                      <a:lnTo>
                        <a:pt x="570" y="1718"/>
                      </a:lnTo>
                      <a:lnTo>
                        <a:pt x="574" y="1750"/>
                      </a:lnTo>
                      <a:lnTo>
                        <a:pt x="577" y="1779"/>
                      </a:lnTo>
                      <a:lnTo>
                        <a:pt x="581" y="1802"/>
                      </a:lnTo>
                      <a:lnTo>
                        <a:pt x="584" y="1820"/>
                      </a:lnTo>
                      <a:lnTo>
                        <a:pt x="588" y="1832"/>
                      </a:lnTo>
                      <a:lnTo>
                        <a:pt x="591" y="1840"/>
                      </a:lnTo>
                      <a:lnTo>
                        <a:pt x="594" y="1843"/>
                      </a:lnTo>
                      <a:lnTo>
                        <a:pt x="598" y="1846"/>
                      </a:lnTo>
                      <a:lnTo>
                        <a:pt x="601" y="1847"/>
                      </a:lnTo>
                      <a:lnTo>
                        <a:pt x="605" y="1848"/>
                      </a:lnTo>
                      <a:lnTo>
                        <a:pt x="608" y="1848"/>
                      </a:lnTo>
                      <a:lnTo>
                        <a:pt x="612" y="1848"/>
                      </a:lnTo>
                      <a:lnTo>
                        <a:pt x="615" y="1849"/>
                      </a:lnTo>
                      <a:lnTo>
                        <a:pt x="619" y="1849"/>
                      </a:lnTo>
                      <a:lnTo>
                        <a:pt x="622" y="1849"/>
                      </a:lnTo>
                      <a:lnTo>
                        <a:pt x="625" y="1848"/>
                      </a:lnTo>
                      <a:lnTo>
                        <a:pt x="629" y="1848"/>
                      </a:lnTo>
                      <a:lnTo>
                        <a:pt x="632" y="1848"/>
                      </a:lnTo>
                      <a:lnTo>
                        <a:pt x="636" y="1848"/>
                      </a:lnTo>
                      <a:lnTo>
                        <a:pt x="639" y="1848"/>
                      </a:lnTo>
                      <a:lnTo>
                        <a:pt x="643" y="1849"/>
                      </a:lnTo>
                      <a:lnTo>
                        <a:pt x="646" y="1849"/>
                      </a:lnTo>
                      <a:lnTo>
                        <a:pt x="649" y="1849"/>
                      </a:lnTo>
                      <a:lnTo>
                        <a:pt x="653" y="1850"/>
                      </a:lnTo>
                      <a:lnTo>
                        <a:pt x="656" y="1850"/>
                      </a:lnTo>
                      <a:lnTo>
                        <a:pt x="660" y="1849"/>
                      </a:lnTo>
                      <a:lnTo>
                        <a:pt x="663" y="1849"/>
                      </a:lnTo>
                      <a:lnTo>
                        <a:pt x="667" y="1849"/>
                      </a:lnTo>
                      <a:lnTo>
                        <a:pt x="670" y="1849"/>
                      </a:lnTo>
                      <a:lnTo>
                        <a:pt x="673" y="1850"/>
                      </a:lnTo>
                      <a:lnTo>
                        <a:pt x="677" y="1849"/>
                      </a:lnTo>
                      <a:lnTo>
                        <a:pt x="680" y="1849"/>
                      </a:lnTo>
                      <a:lnTo>
                        <a:pt x="684" y="1850"/>
                      </a:lnTo>
                      <a:lnTo>
                        <a:pt x="687" y="1849"/>
                      </a:lnTo>
                      <a:lnTo>
                        <a:pt x="691" y="1849"/>
                      </a:lnTo>
                      <a:lnTo>
                        <a:pt x="694" y="1849"/>
                      </a:lnTo>
                      <a:lnTo>
                        <a:pt x="698" y="1848"/>
                      </a:lnTo>
                      <a:lnTo>
                        <a:pt x="701" y="1848"/>
                      </a:lnTo>
                      <a:lnTo>
                        <a:pt x="704" y="1847"/>
                      </a:lnTo>
                      <a:lnTo>
                        <a:pt x="708" y="1847"/>
                      </a:lnTo>
                      <a:lnTo>
                        <a:pt x="711" y="1848"/>
                      </a:lnTo>
                      <a:lnTo>
                        <a:pt x="715" y="1848"/>
                      </a:lnTo>
                      <a:lnTo>
                        <a:pt x="718" y="1847"/>
                      </a:lnTo>
                      <a:lnTo>
                        <a:pt x="722" y="1848"/>
                      </a:lnTo>
                      <a:lnTo>
                        <a:pt x="725" y="1848"/>
                      </a:lnTo>
                      <a:lnTo>
                        <a:pt x="728" y="1848"/>
                      </a:lnTo>
                      <a:lnTo>
                        <a:pt x="732" y="1848"/>
                      </a:lnTo>
                      <a:lnTo>
                        <a:pt x="735" y="1848"/>
                      </a:lnTo>
                      <a:lnTo>
                        <a:pt x="739" y="1848"/>
                      </a:lnTo>
                      <a:lnTo>
                        <a:pt x="742" y="1847"/>
                      </a:lnTo>
                      <a:lnTo>
                        <a:pt x="746" y="1847"/>
                      </a:lnTo>
                      <a:lnTo>
                        <a:pt x="749" y="1847"/>
                      </a:lnTo>
                      <a:lnTo>
                        <a:pt x="753" y="1847"/>
                      </a:lnTo>
                      <a:lnTo>
                        <a:pt x="756" y="1847"/>
                      </a:lnTo>
                      <a:lnTo>
                        <a:pt x="759" y="1846"/>
                      </a:lnTo>
                      <a:lnTo>
                        <a:pt x="763" y="1846"/>
                      </a:lnTo>
                      <a:lnTo>
                        <a:pt x="766" y="1847"/>
                      </a:lnTo>
                      <a:lnTo>
                        <a:pt x="770" y="1846"/>
                      </a:lnTo>
                      <a:lnTo>
                        <a:pt x="773" y="1847"/>
                      </a:lnTo>
                      <a:lnTo>
                        <a:pt x="777" y="1846"/>
                      </a:lnTo>
                      <a:lnTo>
                        <a:pt x="780" y="1846"/>
                      </a:lnTo>
                      <a:lnTo>
                        <a:pt x="783" y="1846"/>
                      </a:lnTo>
                      <a:lnTo>
                        <a:pt x="787" y="1846"/>
                      </a:lnTo>
                      <a:lnTo>
                        <a:pt x="790" y="1846"/>
                      </a:lnTo>
                      <a:lnTo>
                        <a:pt x="794" y="1845"/>
                      </a:lnTo>
                      <a:lnTo>
                        <a:pt x="797" y="1844"/>
                      </a:lnTo>
                      <a:lnTo>
                        <a:pt x="801" y="1844"/>
                      </a:lnTo>
                      <a:lnTo>
                        <a:pt x="804" y="1843"/>
                      </a:lnTo>
                      <a:lnTo>
                        <a:pt x="808" y="1841"/>
                      </a:lnTo>
                      <a:lnTo>
                        <a:pt x="811" y="1840"/>
                      </a:lnTo>
                      <a:lnTo>
                        <a:pt x="814" y="1838"/>
                      </a:lnTo>
                      <a:lnTo>
                        <a:pt x="818" y="1837"/>
                      </a:lnTo>
                      <a:lnTo>
                        <a:pt x="821" y="1836"/>
                      </a:lnTo>
                      <a:lnTo>
                        <a:pt x="825" y="1835"/>
                      </a:lnTo>
                      <a:lnTo>
                        <a:pt x="828" y="1834"/>
                      </a:lnTo>
                      <a:lnTo>
                        <a:pt x="831" y="1834"/>
                      </a:lnTo>
                      <a:lnTo>
                        <a:pt x="835" y="1834"/>
                      </a:lnTo>
                      <a:lnTo>
                        <a:pt x="838" y="1833"/>
                      </a:lnTo>
                      <a:lnTo>
                        <a:pt x="842" y="1832"/>
                      </a:lnTo>
                      <a:lnTo>
                        <a:pt x="845" y="1830"/>
                      </a:lnTo>
                      <a:lnTo>
                        <a:pt x="849" y="1828"/>
                      </a:lnTo>
                      <a:lnTo>
                        <a:pt x="852" y="1827"/>
                      </a:lnTo>
                      <a:lnTo>
                        <a:pt x="856" y="1823"/>
                      </a:lnTo>
                      <a:lnTo>
                        <a:pt x="859" y="1822"/>
                      </a:lnTo>
                      <a:lnTo>
                        <a:pt x="863" y="1821"/>
                      </a:lnTo>
                      <a:lnTo>
                        <a:pt x="866" y="1821"/>
                      </a:lnTo>
                      <a:lnTo>
                        <a:pt x="869" y="1822"/>
                      </a:lnTo>
                      <a:lnTo>
                        <a:pt x="873" y="1823"/>
                      </a:lnTo>
                      <a:lnTo>
                        <a:pt x="876" y="1824"/>
                      </a:lnTo>
                      <a:lnTo>
                        <a:pt x="880" y="1826"/>
                      </a:lnTo>
                      <a:lnTo>
                        <a:pt x="883" y="1828"/>
                      </a:lnTo>
                      <a:lnTo>
                        <a:pt x="886" y="1829"/>
                      </a:lnTo>
                      <a:lnTo>
                        <a:pt x="890" y="1831"/>
                      </a:lnTo>
                      <a:lnTo>
                        <a:pt x="893" y="1833"/>
                      </a:lnTo>
                      <a:lnTo>
                        <a:pt x="897" y="1835"/>
                      </a:lnTo>
                      <a:lnTo>
                        <a:pt x="900" y="1836"/>
                      </a:lnTo>
                      <a:lnTo>
                        <a:pt x="904" y="1838"/>
                      </a:lnTo>
                      <a:lnTo>
                        <a:pt x="907" y="1839"/>
                      </a:lnTo>
                      <a:lnTo>
                        <a:pt x="911" y="1840"/>
                      </a:lnTo>
                      <a:lnTo>
                        <a:pt x="914" y="1840"/>
                      </a:lnTo>
                      <a:lnTo>
                        <a:pt x="917" y="1840"/>
                      </a:lnTo>
                      <a:lnTo>
                        <a:pt x="921" y="1840"/>
                      </a:lnTo>
                      <a:lnTo>
                        <a:pt x="924" y="1840"/>
                      </a:lnTo>
                      <a:lnTo>
                        <a:pt x="928" y="1840"/>
                      </a:lnTo>
                      <a:lnTo>
                        <a:pt x="931" y="1841"/>
                      </a:lnTo>
                      <a:lnTo>
                        <a:pt x="935" y="1840"/>
                      </a:lnTo>
                      <a:lnTo>
                        <a:pt x="938" y="1840"/>
                      </a:lnTo>
                      <a:lnTo>
                        <a:pt x="941" y="1840"/>
                      </a:lnTo>
                      <a:lnTo>
                        <a:pt x="945" y="1840"/>
                      </a:lnTo>
                      <a:lnTo>
                        <a:pt x="948" y="1841"/>
                      </a:lnTo>
                      <a:lnTo>
                        <a:pt x="952" y="1842"/>
                      </a:lnTo>
                      <a:lnTo>
                        <a:pt x="955" y="1842"/>
                      </a:lnTo>
                      <a:lnTo>
                        <a:pt x="959" y="1842"/>
                      </a:lnTo>
                      <a:lnTo>
                        <a:pt x="962" y="1842"/>
                      </a:lnTo>
                      <a:lnTo>
                        <a:pt x="966" y="1842"/>
                      </a:lnTo>
                      <a:lnTo>
                        <a:pt x="969" y="1842"/>
                      </a:lnTo>
                      <a:lnTo>
                        <a:pt x="972" y="1842"/>
                      </a:lnTo>
                      <a:lnTo>
                        <a:pt x="976" y="1841"/>
                      </a:lnTo>
                      <a:lnTo>
                        <a:pt x="979" y="1841"/>
                      </a:lnTo>
                      <a:lnTo>
                        <a:pt x="983" y="1841"/>
                      </a:lnTo>
                      <a:lnTo>
                        <a:pt x="986" y="1841"/>
                      </a:lnTo>
                      <a:lnTo>
                        <a:pt x="990" y="1840"/>
                      </a:lnTo>
                      <a:lnTo>
                        <a:pt x="993" y="1840"/>
                      </a:lnTo>
                      <a:lnTo>
                        <a:pt x="997" y="1841"/>
                      </a:lnTo>
                      <a:lnTo>
                        <a:pt x="1000" y="1841"/>
                      </a:lnTo>
                      <a:lnTo>
                        <a:pt x="1003" y="1841"/>
                      </a:lnTo>
                      <a:lnTo>
                        <a:pt x="1007" y="1841"/>
                      </a:lnTo>
                      <a:lnTo>
                        <a:pt x="1010" y="1840"/>
                      </a:lnTo>
                      <a:lnTo>
                        <a:pt x="1014" y="1840"/>
                      </a:lnTo>
                      <a:lnTo>
                        <a:pt x="1017" y="1840"/>
                      </a:lnTo>
                      <a:lnTo>
                        <a:pt x="1020" y="1840"/>
                      </a:lnTo>
                      <a:lnTo>
                        <a:pt x="1024" y="1839"/>
                      </a:lnTo>
                      <a:lnTo>
                        <a:pt x="1027" y="1839"/>
                      </a:lnTo>
                      <a:lnTo>
                        <a:pt x="1031" y="1839"/>
                      </a:lnTo>
                      <a:lnTo>
                        <a:pt x="1034" y="1838"/>
                      </a:lnTo>
                      <a:lnTo>
                        <a:pt x="1038" y="1839"/>
                      </a:lnTo>
                      <a:lnTo>
                        <a:pt x="1041" y="1839"/>
                      </a:lnTo>
                      <a:lnTo>
                        <a:pt x="1045" y="1839"/>
                      </a:lnTo>
                      <a:lnTo>
                        <a:pt x="1048" y="1840"/>
                      </a:lnTo>
                      <a:lnTo>
                        <a:pt x="1052" y="1840"/>
                      </a:lnTo>
                      <a:lnTo>
                        <a:pt x="1055" y="1841"/>
                      </a:lnTo>
                      <a:lnTo>
                        <a:pt x="1058" y="1840"/>
                      </a:lnTo>
                      <a:lnTo>
                        <a:pt x="1062" y="1841"/>
                      </a:lnTo>
                      <a:lnTo>
                        <a:pt x="1065" y="1841"/>
                      </a:lnTo>
                      <a:lnTo>
                        <a:pt x="1069" y="1842"/>
                      </a:lnTo>
                      <a:lnTo>
                        <a:pt x="1072" y="1842"/>
                      </a:lnTo>
                      <a:lnTo>
                        <a:pt x="1075" y="1841"/>
                      </a:lnTo>
                      <a:lnTo>
                        <a:pt x="1079" y="1842"/>
                      </a:lnTo>
                      <a:lnTo>
                        <a:pt x="1082" y="1841"/>
                      </a:lnTo>
                      <a:lnTo>
                        <a:pt x="1086" y="1840"/>
                      </a:lnTo>
                      <a:lnTo>
                        <a:pt x="1089" y="1841"/>
                      </a:lnTo>
                      <a:lnTo>
                        <a:pt x="1093" y="1841"/>
                      </a:lnTo>
                      <a:lnTo>
                        <a:pt x="1096" y="1840"/>
                      </a:lnTo>
                      <a:lnTo>
                        <a:pt x="1100" y="1840"/>
                      </a:lnTo>
                      <a:lnTo>
                        <a:pt x="1103" y="1839"/>
                      </a:lnTo>
                      <a:lnTo>
                        <a:pt x="1106" y="1840"/>
                      </a:lnTo>
                      <a:lnTo>
                        <a:pt x="1110" y="1840"/>
                      </a:lnTo>
                      <a:lnTo>
                        <a:pt x="1113" y="1839"/>
                      </a:lnTo>
                      <a:lnTo>
                        <a:pt x="1117" y="1840"/>
                      </a:lnTo>
                      <a:lnTo>
                        <a:pt x="1120" y="1839"/>
                      </a:lnTo>
                      <a:lnTo>
                        <a:pt x="1124" y="1838"/>
                      </a:lnTo>
                      <a:lnTo>
                        <a:pt x="1127" y="1839"/>
                      </a:lnTo>
                      <a:lnTo>
                        <a:pt x="1130" y="1839"/>
                      </a:lnTo>
                      <a:lnTo>
                        <a:pt x="1134" y="1838"/>
                      </a:lnTo>
                      <a:lnTo>
                        <a:pt x="1137" y="1838"/>
                      </a:lnTo>
                      <a:lnTo>
                        <a:pt x="1141" y="1838"/>
                      </a:lnTo>
                      <a:lnTo>
                        <a:pt x="1144" y="1837"/>
                      </a:lnTo>
                      <a:lnTo>
                        <a:pt x="1148" y="1838"/>
                      </a:lnTo>
                      <a:lnTo>
                        <a:pt x="1151" y="1837"/>
                      </a:lnTo>
                      <a:lnTo>
                        <a:pt x="1155" y="1837"/>
                      </a:lnTo>
                      <a:lnTo>
                        <a:pt x="1158" y="1837"/>
                      </a:lnTo>
                      <a:lnTo>
                        <a:pt x="1161" y="1837"/>
                      </a:lnTo>
                      <a:lnTo>
                        <a:pt x="1165" y="1838"/>
                      </a:lnTo>
                      <a:lnTo>
                        <a:pt x="1168" y="1838"/>
                      </a:lnTo>
                      <a:lnTo>
                        <a:pt x="1172" y="1837"/>
                      </a:lnTo>
                      <a:lnTo>
                        <a:pt x="1175" y="1837"/>
                      </a:lnTo>
                      <a:lnTo>
                        <a:pt x="1178" y="1837"/>
                      </a:lnTo>
                      <a:lnTo>
                        <a:pt x="1182" y="1837"/>
                      </a:lnTo>
                      <a:lnTo>
                        <a:pt x="1185" y="1836"/>
                      </a:lnTo>
                      <a:lnTo>
                        <a:pt x="1189" y="1837"/>
                      </a:lnTo>
                      <a:lnTo>
                        <a:pt x="1192" y="1837"/>
                      </a:lnTo>
                      <a:lnTo>
                        <a:pt x="1196" y="1837"/>
                      </a:lnTo>
                      <a:lnTo>
                        <a:pt x="1199" y="1837"/>
                      </a:lnTo>
                      <a:lnTo>
                        <a:pt x="1203" y="1836"/>
                      </a:lnTo>
                      <a:lnTo>
                        <a:pt x="1206" y="1836"/>
                      </a:lnTo>
                      <a:lnTo>
                        <a:pt x="1210" y="1836"/>
                      </a:lnTo>
                      <a:lnTo>
                        <a:pt x="1213" y="1837"/>
                      </a:lnTo>
                      <a:lnTo>
                        <a:pt x="1216" y="1836"/>
                      </a:lnTo>
                      <a:lnTo>
                        <a:pt x="1220" y="1836"/>
                      </a:lnTo>
                      <a:lnTo>
                        <a:pt x="1223" y="1836"/>
                      </a:lnTo>
                      <a:lnTo>
                        <a:pt x="1227" y="1836"/>
                      </a:lnTo>
                      <a:lnTo>
                        <a:pt x="1230" y="1836"/>
                      </a:lnTo>
                      <a:lnTo>
                        <a:pt x="1234" y="1834"/>
                      </a:lnTo>
                      <a:lnTo>
                        <a:pt x="1237" y="1834"/>
                      </a:lnTo>
                      <a:lnTo>
                        <a:pt x="1240" y="1834"/>
                      </a:lnTo>
                      <a:lnTo>
                        <a:pt x="1244" y="1832"/>
                      </a:lnTo>
                      <a:lnTo>
                        <a:pt x="1247" y="1832"/>
                      </a:lnTo>
                      <a:lnTo>
                        <a:pt x="1251" y="1832"/>
                      </a:lnTo>
                      <a:lnTo>
                        <a:pt x="1254" y="1830"/>
                      </a:lnTo>
                      <a:lnTo>
                        <a:pt x="1258" y="1828"/>
                      </a:lnTo>
                      <a:lnTo>
                        <a:pt x="1261" y="1829"/>
                      </a:lnTo>
                      <a:lnTo>
                        <a:pt x="1264" y="1827"/>
                      </a:lnTo>
                      <a:lnTo>
                        <a:pt x="1268" y="1828"/>
                      </a:lnTo>
                      <a:lnTo>
                        <a:pt x="1271" y="1828"/>
                      </a:lnTo>
                      <a:lnTo>
                        <a:pt x="1275" y="1828"/>
                      </a:lnTo>
                      <a:lnTo>
                        <a:pt x="1278" y="1827"/>
                      </a:lnTo>
                      <a:lnTo>
                        <a:pt x="1282" y="1828"/>
                      </a:lnTo>
                      <a:lnTo>
                        <a:pt x="1285" y="1828"/>
                      </a:lnTo>
                      <a:lnTo>
                        <a:pt x="1289" y="1827"/>
                      </a:lnTo>
                      <a:lnTo>
                        <a:pt x="1292" y="1826"/>
                      </a:lnTo>
                      <a:lnTo>
                        <a:pt x="1295" y="1825"/>
                      </a:lnTo>
                      <a:lnTo>
                        <a:pt x="1299" y="1824"/>
                      </a:lnTo>
                      <a:lnTo>
                        <a:pt x="1302" y="1824"/>
                      </a:lnTo>
                      <a:lnTo>
                        <a:pt x="1306" y="1824"/>
                      </a:lnTo>
                      <a:lnTo>
                        <a:pt x="1309" y="1824"/>
                      </a:lnTo>
                      <a:lnTo>
                        <a:pt x="1313" y="1824"/>
                      </a:lnTo>
                      <a:lnTo>
                        <a:pt x="1316" y="1824"/>
                      </a:lnTo>
                      <a:lnTo>
                        <a:pt x="1319" y="1825"/>
                      </a:lnTo>
                      <a:lnTo>
                        <a:pt x="1323" y="1825"/>
                      </a:lnTo>
                      <a:lnTo>
                        <a:pt x="1326" y="1825"/>
                      </a:lnTo>
                      <a:lnTo>
                        <a:pt x="1330" y="1826"/>
                      </a:lnTo>
                      <a:lnTo>
                        <a:pt x="1333" y="1824"/>
                      </a:lnTo>
                      <a:lnTo>
                        <a:pt x="1337" y="1823"/>
                      </a:lnTo>
                      <a:lnTo>
                        <a:pt x="1340" y="1821"/>
                      </a:lnTo>
                      <a:lnTo>
                        <a:pt x="1344" y="1820"/>
                      </a:lnTo>
                      <a:lnTo>
                        <a:pt x="1347" y="1818"/>
                      </a:lnTo>
                      <a:lnTo>
                        <a:pt x="1350" y="1817"/>
                      </a:lnTo>
                      <a:lnTo>
                        <a:pt x="1354" y="1817"/>
                      </a:lnTo>
                      <a:lnTo>
                        <a:pt x="1357" y="1817"/>
                      </a:lnTo>
                      <a:lnTo>
                        <a:pt x="1361" y="1818"/>
                      </a:lnTo>
                      <a:lnTo>
                        <a:pt x="1364" y="1818"/>
                      </a:lnTo>
                      <a:lnTo>
                        <a:pt x="1368" y="1819"/>
                      </a:lnTo>
                      <a:lnTo>
                        <a:pt x="1371" y="1819"/>
                      </a:lnTo>
                      <a:lnTo>
                        <a:pt x="1374" y="1818"/>
                      </a:lnTo>
                      <a:lnTo>
                        <a:pt x="1378" y="1818"/>
                      </a:lnTo>
                      <a:lnTo>
                        <a:pt x="1381" y="1817"/>
                      </a:lnTo>
                      <a:lnTo>
                        <a:pt x="1385" y="1815"/>
                      </a:lnTo>
                      <a:lnTo>
                        <a:pt x="1388" y="1812"/>
                      </a:lnTo>
                      <a:lnTo>
                        <a:pt x="1392" y="1809"/>
                      </a:lnTo>
                      <a:lnTo>
                        <a:pt x="1395" y="1805"/>
                      </a:lnTo>
                      <a:lnTo>
                        <a:pt x="1399" y="1800"/>
                      </a:lnTo>
                      <a:lnTo>
                        <a:pt x="1402" y="1797"/>
                      </a:lnTo>
                      <a:lnTo>
                        <a:pt x="1405" y="1796"/>
                      </a:lnTo>
                      <a:lnTo>
                        <a:pt x="1409" y="1796"/>
                      </a:lnTo>
                      <a:lnTo>
                        <a:pt x="1412" y="1799"/>
                      </a:lnTo>
                      <a:lnTo>
                        <a:pt x="1416" y="1803"/>
                      </a:lnTo>
                      <a:lnTo>
                        <a:pt x="1419" y="1808"/>
                      </a:lnTo>
                      <a:lnTo>
                        <a:pt x="1422" y="1812"/>
                      </a:lnTo>
                      <a:lnTo>
                        <a:pt x="1426" y="1814"/>
                      </a:lnTo>
                      <a:lnTo>
                        <a:pt x="1429" y="1816"/>
                      </a:lnTo>
                      <a:lnTo>
                        <a:pt x="1433" y="1816"/>
                      </a:lnTo>
                      <a:lnTo>
                        <a:pt x="1436" y="1815"/>
                      </a:lnTo>
                      <a:lnTo>
                        <a:pt x="1440" y="1815"/>
                      </a:lnTo>
                      <a:lnTo>
                        <a:pt x="1443" y="1814"/>
                      </a:lnTo>
                      <a:lnTo>
                        <a:pt x="1447" y="1814"/>
                      </a:lnTo>
                      <a:lnTo>
                        <a:pt x="1450" y="1813"/>
                      </a:lnTo>
                      <a:lnTo>
                        <a:pt x="1453" y="1813"/>
                      </a:lnTo>
                      <a:lnTo>
                        <a:pt x="1457" y="1814"/>
                      </a:lnTo>
                      <a:lnTo>
                        <a:pt x="1460" y="1814"/>
                      </a:lnTo>
                      <a:lnTo>
                        <a:pt x="1464" y="1815"/>
                      </a:lnTo>
                      <a:lnTo>
                        <a:pt x="1467" y="1815"/>
                      </a:lnTo>
                      <a:lnTo>
                        <a:pt x="1471" y="1815"/>
                      </a:lnTo>
                      <a:lnTo>
                        <a:pt x="1474" y="1814"/>
                      </a:lnTo>
                      <a:lnTo>
                        <a:pt x="1477" y="1814"/>
                      </a:lnTo>
                      <a:lnTo>
                        <a:pt x="1481" y="1814"/>
                      </a:lnTo>
                      <a:lnTo>
                        <a:pt x="1484" y="1813"/>
                      </a:lnTo>
                      <a:lnTo>
                        <a:pt x="1488" y="1812"/>
                      </a:lnTo>
                      <a:lnTo>
                        <a:pt x="1491" y="1813"/>
                      </a:lnTo>
                      <a:lnTo>
                        <a:pt x="1495" y="1813"/>
                      </a:lnTo>
                      <a:lnTo>
                        <a:pt x="1498" y="1812"/>
                      </a:lnTo>
                      <a:lnTo>
                        <a:pt x="1502" y="1811"/>
                      </a:lnTo>
                      <a:lnTo>
                        <a:pt x="1505" y="1812"/>
                      </a:lnTo>
                      <a:lnTo>
                        <a:pt x="1508" y="1811"/>
                      </a:lnTo>
                      <a:lnTo>
                        <a:pt x="1512" y="1811"/>
                      </a:lnTo>
                      <a:lnTo>
                        <a:pt x="1515" y="1810"/>
                      </a:lnTo>
                      <a:lnTo>
                        <a:pt x="1519" y="1808"/>
                      </a:lnTo>
                      <a:lnTo>
                        <a:pt x="1522" y="1809"/>
                      </a:lnTo>
                      <a:lnTo>
                        <a:pt x="1526" y="1808"/>
                      </a:lnTo>
                      <a:lnTo>
                        <a:pt x="1529" y="1807"/>
                      </a:lnTo>
                      <a:lnTo>
                        <a:pt x="1532" y="1807"/>
                      </a:lnTo>
                      <a:lnTo>
                        <a:pt x="1536" y="1806"/>
                      </a:lnTo>
                      <a:lnTo>
                        <a:pt x="1539" y="1806"/>
                      </a:lnTo>
                      <a:lnTo>
                        <a:pt x="1543" y="1805"/>
                      </a:lnTo>
                      <a:lnTo>
                        <a:pt x="1546" y="1804"/>
                      </a:lnTo>
                      <a:lnTo>
                        <a:pt x="1550" y="1804"/>
                      </a:lnTo>
                      <a:lnTo>
                        <a:pt x="1553" y="1804"/>
                      </a:lnTo>
                      <a:lnTo>
                        <a:pt x="1557" y="1805"/>
                      </a:lnTo>
                      <a:lnTo>
                        <a:pt x="1560" y="1804"/>
                      </a:lnTo>
                      <a:lnTo>
                        <a:pt x="1563" y="1804"/>
                      </a:lnTo>
                      <a:lnTo>
                        <a:pt x="1567" y="1804"/>
                      </a:lnTo>
                      <a:lnTo>
                        <a:pt x="1570" y="1804"/>
                      </a:lnTo>
                      <a:lnTo>
                        <a:pt x="1574" y="1803"/>
                      </a:lnTo>
                      <a:lnTo>
                        <a:pt x="1577" y="1802"/>
                      </a:lnTo>
                      <a:lnTo>
                        <a:pt x="1581" y="1802"/>
                      </a:lnTo>
                      <a:lnTo>
                        <a:pt x="1584" y="1802"/>
                      </a:lnTo>
                      <a:lnTo>
                        <a:pt x="1587" y="1800"/>
                      </a:lnTo>
                      <a:lnTo>
                        <a:pt x="1591" y="1798"/>
                      </a:lnTo>
                      <a:lnTo>
                        <a:pt x="1594" y="1798"/>
                      </a:lnTo>
                      <a:lnTo>
                        <a:pt x="1598" y="1796"/>
                      </a:lnTo>
                      <a:lnTo>
                        <a:pt x="1601" y="1795"/>
                      </a:lnTo>
                      <a:lnTo>
                        <a:pt x="1605" y="1793"/>
                      </a:lnTo>
                      <a:lnTo>
                        <a:pt x="1608" y="1790"/>
                      </a:lnTo>
                      <a:lnTo>
                        <a:pt x="1611" y="1788"/>
                      </a:lnTo>
                      <a:lnTo>
                        <a:pt x="1615" y="1785"/>
                      </a:lnTo>
                      <a:lnTo>
                        <a:pt x="1618" y="1783"/>
                      </a:lnTo>
                      <a:lnTo>
                        <a:pt x="1622" y="1779"/>
                      </a:lnTo>
                      <a:lnTo>
                        <a:pt x="1625" y="1777"/>
                      </a:lnTo>
                      <a:lnTo>
                        <a:pt x="1629" y="1775"/>
                      </a:lnTo>
                      <a:lnTo>
                        <a:pt x="1632" y="1774"/>
                      </a:lnTo>
                      <a:lnTo>
                        <a:pt x="1636" y="1774"/>
                      </a:lnTo>
                      <a:lnTo>
                        <a:pt x="1639" y="1775"/>
                      </a:lnTo>
                      <a:lnTo>
                        <a:pt x="1643" y="1776"/>
                      </a:lnTo>
                      <a:lnTo>
                        <a:pt x="1646" y="1777"/>
                      </a:lnTo>
                      <a:lnTo>
                        <a:pt x="1649" y="1779"/>
                      </a:lnTo>
                      <a:lnTo>
                        <a:pt x="1653" y="1781"/>
                      </a:lnTo>
                      <a:lnTo>
                        <a:pt x="1656" y="1781"/>
                      </a:lnTo>
                      <a:lnTo>
                        <a:pt x="1660" y="1783"/>
                      </a:lnTo>
                      <a:lnTo>
                        <a:pt x="1663" y="1784"/>
                      </a:lnTo>
                      <a:lnTo>
                        <a:pt x="1666" y="1785"/>
                      </a:lnTo>
                      <a:lnTo>
                        <a:pt x="1670" y="1785"/>
                      </a:lnTo>
                      <a:lnTo>
                        <a:pt x="1673" y="1787"/>
                      </a:lnTo>
                      <a:lnTo>
                        <a:pt x="1677" y="1788"/>
                      </a:lnTo>
                      <a:lnTo>
                        <a:pt x="1680" y="1787"/>
                      </a:lnTo>
                      <a:lnTo>
                        <a:pt x="1684" y="1787"/>
                      </a:lnTo>
                      <a:lnTo>
                        <a:pt x="1687" y="1787"/>
                      </a:lnTo>
                      <a:lnTo>
                        <a:pt x="1691" y="1786"/>
                      </a:lnTo>
                      <a:lnTo>
                        <a:pt x="1694" y="1784"/>
                      </a:lnTo>
                      <a:lnTo>
                        <a:pt x="1697" y="1782"/>
                      </a:lnTo>
                      <a:lnTo>
                        <a:pt x="1701" y="1781"/>
                      </a:lnTo>
                      <a:lnTo>
                        <a:pt x="1704" y="1780"/>
                      </a:lnTo>
                      <a:lnTo>
                        <a:pt x="1708" y="1779"/>
                      </a:lnTo>
                      <a:lnTo>
                        <a:pt x="1711" y="1780"/>
                      </a:lnTo>
                      <a:lnTo>
                        <a:pt x="1715" y="1780"/>
                      </a:lnTo>
                      <a:lnTo>
                        <a:pt x="1718" y="1782"/>
                      </a:lnTo>
                      <a:lnTo>
                        <a:pt x="1721" y="1783"/>
                      </a:lnTo>
                      <a:lnTo>
                        <a:pt x="1725" y="1784"/>
                      </a:lnTo>
                      <a:lnTo>
                        <a:pt x="1728" y="1785"/>
                      </a:lnTo>
                      <a:lnTo>
                        <a:pt x="1732" y="1785"/>
                      </a:lnTo>
                      <a:lnTo>
                        <a:pt x="1735" y="1783"/>
                      </a:lnTo>
                      <a:lnTo>
                        <a:pt x="1739" y="1782"/>
                      </a:lnTo>
                      <a:lnTo>
                        <a:pt x="1742" y="1780"/>
                      </a:lnTo>
                      <a:lnTo>
                        <a:pt x="1746" y="1778"/>
                      </a:lnTo>
                      <a:lnTo>
                        <a:pt x="1749" y="1776"/>
                      </a:lnTo>
                      <a:lnTo>
                        <a:pt x="1752" y="1775"/>
                      </a:lnTo>
                      <a:lnTo>
                        <a:pt x="1756" y="1772"/>
                      </a:lnTo>
                      <a:lnTo>
                        <a:pt x="1759" y="1770"/>
                      </a:lnTo>
                      <a:lnTo>
                        <a:pt x="1763" y="1768"/>
                      </a:lnTo>
                      <a:lnTo>
                        <a:pt x="1766" y="1766"/>
                      </a:lnTo>
                      <a:lnTo>
                        <a:pt x="1769" y="1765"/>
                      </a:lnTo>
                      <a:lnTo>
                        <a:pt x="1773" y="1763"/>
                      </a:lnTo>
                      <a:lnTo>
                        <a:pt x="1776" y="1764"/>
                      </a:lnTo>
                      <a:lnTo>
                        <a:pt x="1780" y="1763"/>
                      </a:lnTo>
                      <a:lnTo>
                        <a:pt x="1783" y="1762"/>
                      </a:lnTo>
                      <a:lnTo>
                        <a:pt x="1787" y="1761"/>
                      </a:lnTo>
                      <a:lnTo>
                        <a:pt x="1790" y="1761"/>
                      </a:lnTo>
                      <a:lnTo>
                        <a:pt x="1794" y="1761"/>
                      </a:lnTo>
                      <a:lnTo>
                        <a:pt x="1797" y="1760"/>
                      </a:lnTo>
                      <a:lnTo>
                        <a:pt x="1800" y="1758"/>
                      </a:lnTo>
                      <a:lnTo>
                        <a:pt x="1804" y="1757"/>
                      </a:lnTo>
                      <a:lnTo>
                        <a:pt x="1807" y="1756"/>
                      </a:lnTo>
                      <a:lnTo>
                        <a:pt x="1811" y="1755"/>
                      </a:lnTo>
                      <a:lnTo>
                        <a:pt x="1814" y="1752"/>
                      </a:lnTo>
                      <a:lnTo>
                        <a:pt x="1818" y="1751"/>
                      </a:lnTo>
                      <a:lnTo>
                        <a:pt x="1821" y="1750"/>
                      </a:lnTo>
                      <a:lnTo>
                        <a:pt x="1824" y="1749"/>
                      </a:lnTo>
                      <a:lnTo>
                        <a:pt x="1828" y="1749"/>
                      </a:lnTo>
                      <a:lnTo>
                        <a:pt x="1831" y="1748"/>
                      </a:lnTo>
                      <a:lnTo>
                        <a:pt x="1835" y="1749"/>
                      </a:lnTo>
                      <a:lnTo>
                        <a:pt x="1838" y="1749"/>
                      </a:lnTo>
                      <a:lnTo>
                        <a:pt x="1842" y="1749"/>
                      </a:lnTo>
                      <a:lnTo>
                        <a:pt x="1845" y="1748"/>
                      </a:lnTo>
                      <a:lnTo>
                        <a:pt x="1849" y="1747"/>
                      </a:lnTo>
                      <a:lnTo>
                        <a:pt x="1852" y="1746"/>
                      </a:lnTo>
                      <a:lnTo>
                        <a:pt x="1855" y="1744"/>
                      </a:lnTo>
                      <a:lnTo>
                        <a:pt x="1859" y="1743"/>
                      </a:lnTo>
                      <a:lnTo>
                        <a:pt x="1862" y="1741"/>
                      </a:lnTo>
                      <a:lnTo>
                        <a:pt x="1866" y="1738"/>
                      </a:lnTo>
                      <a:lnTo>
                        <a:pt x="1869" y="1735"/>
                      </a:lnTo>
                      <a:lnTo>
                        <a:pt x="1873" y="1732"/>
                      </a:lnTo>
                      <a:lnTo>
                        <a:pt x="1876" y="1728"/>
                      </a:lnTo>
                      <a:lnTo>
                        <a:pt x="1880" y="1726"/>
                      </a:lnTo>
                      <a:lnTo>
                        <a:pt x="1883" y="1723"/>
                      </a:lnTo>
                      <a:lnTo>
                        <a:pt x="1886" y="1721"/>
                      </a:lnTo>
                      <a:lnTo>
                        <a:pt x="1890" y="1720"/>
                      </a:lnTo>
                      <a:lnTo>
                        <a:pt x="1893" y="1719"/>
                      </a:lnTo>
                      <a:lnTo>
                        <a:pt x="1897" y="1718"/>
                      </a:lnTo>
                      <a:lnTo>
                        <a:pt x="1900" y="1716"/>
                      </a:lnTo>
                      <a:lnTo>
                        <a:pt x="1904" y="1715"/>
                      </a:lnTo>
                      <a:lnTo>
                        <a:pt x="1907" y="1712"/>
                      </a:lnTo>
                      <a:lnTo>
                        <a:pt x="1910" y="1708"/>
                      </a:lnTo>
                      <a:lnTo>
                        <a:pt x="1914" y="1705"/>
                      </a:lnTo>
                      <a:lnTo>
                        <a:pt x="1917" y="1700"/>
                      </a:lnTo>
                      <a:lnTo>
                        <a:pt x="1921" y="1697"/>
                      </a:lnTo>
                      <a:lnTo>
                        <a:pt x="1924" y="1692"/>
                      </a:lnTo>
                      <a:lnTo>
                        <a:pt x="1928" y="1689"/>
                      </a:lnTo>
                      <a:lnTo>
                        <a:pt x="1931" y="1688"/>
                      </a:lnTo>
                      <a:lnTo>
                        <a:pt x="1935" y="1688"/>
                      </a:lnTo>
                      <a:lnTo>
                        <a:pt x="1938" y="1688"/>
                      </a:lnTo>
                      <a:lnTo>
                        <a:pt x="1941" y="1691"/>
                      </a:lnTo>
                      <a:lnTo>
                        <a:pt x="1945" y="1693"/>
                      </a:lnTo>
                      <a:lnTo>
                        <a:pt x="1948" y="1696"/>
                      </a:lnTo>
                      <a:lnTo>
                        <a:pt x="1952" y="1699"/>
                      </a:lnTo>
                      <a:lnTo>
                        <a:pt x="1955" y="1699"/>
                      </a:lnTo>
                      <a:lnTo>
                        <a:pt x="1958" y="1698"/>
                      </a:lnTo>
                      <a:lnTo>
                        <a:pt x="1962" y="1697"/>
                      </a:lnTo>
                      <a:lnTo>
                        <a:pt x="1965" y="1692"/>
                      </a:lnTo>
                      <a:lnTo>
                        <a:pt x="1969" y="1687"/>
                      </a:lnTo>
                      <a:lnTo>
                        <a:pt x="1972" y="1683"/>
                      </a:lnTo>
                      <a:lnTo>
                        <a:pt x="1976" y="1678"/>
                      </a:lnTo>
                      <a:lnTo>
                        <a:pt x="1979" y="1675"/>
                      </a:lnTo>
                      <a:lnTo>
                        <a:pt x="1983" y="1672"/>
                      </a:lnTo>
                      <a:lnTo>
                        <a:pt x="1986" y="1670"/>
                      </a:lnTo>
                      <a:lnTo>
                        <a:pt x="1990" y="1668"/>
                      </a:lnTo>
                      <a:lnTo>
                        <a:pt x="1993" y="1667"/>
                      </a:lnTo>
                      <a:lnTo>
                        <a:pt x="1996" y="1668"/>
                      </a:lnTo>
                      <a:lnTo>
                        <a:pt x="2000" y="1668"/>
                      </a:lnTo>
                      <a:lnTo>
                        <a:pt x="2003" y="1670"/>
                      </a:lnTo>
                      <a:lnTo>
                        <a:pt x="2007" y="1672"/>
                      </a:lnTo>
                      <a:lnTo>
                        <a:pt x="2010" y="1675"/>
                      </a:lnTo>
                      <a:lnTo>
                        <a:pt x="2013" y="1678"/>
                      </a:lnTo>
                      <a:lnTo>
                        <a:pt x="2017" y="1681"/>
                      </a:lnTo>
                      <a:lnTo>
                        <a:pt x="2020" y="1683"/>
                      </a:lnTo>
                      <a:lnTo>
                        <a:pt x="2024" y="1684"/>
                      </a:lnTo>
                      <a:lnTo>
                        <a:pt x="2027" y="1683"/>
                      </a:lnTo>
                      <a:lnTo>
                        <a:pt x="2031" y="1680"/>
                      </a:lnTo>
                      <a:lnTo>
                        <a:pt x="2034" y="1676"/>
                      </a:lnTo>
                      <a:lnTo>
                        <a:pt x="2038" y="1672"/>
                      </a:lnTo>
                      <a:lnTo>
                        <a:pt x="2041" y="1666"/>
                      </a:lnTo>
                      <a:lnTo>
                        <a:pt x="2044" y="1662"/>
                      </a:lnTo>
                      <a:lnTo>
                        <a:pt x="2048" y="1656"/>
                      </a:lnTo>
                      <a:lnTo>
                        <a:pt x="2051" y="1650"/>
                      </a:lnTo>
                      <a:lnTo>
                        <a:pt x="2055" y="1643"/>
                      </a:lnTo>
                      <a:lnTo>
                        <a:pt x="2058" y="1635"/>
                      </a:lnTo>
                      <a:lnTo>
                        <a:pt x="2062" y="1626"/>
                      </a:lnTo>
                      <a:lnTo>
                        <a:pt x="2065" y="1614"/>
                      </a:lnTo>
                      <a:lnTo>
                        <a:pt x="2068" y="1603"/>
                      </a:lnTo>
                      <a:lnTo>
                        <a:pt x="2072" y="1588"/>
                      </a:lnTo>
                      <a:lnTo>
                        <a:pt x="2075" y="1574"/>
                      </a:lnTo>
                      <a:lnTo>
                        <a:pt x="2079" y="1561"/>
                      </a:lnTo>
                      <a:lnTo>
                        <a:pt x="2082" y="1548"/>
                      </a:lnTo>
                      <a:lnTo>
                        <a:pt x="2086" y="1537"/>
                      </a:lnTo>
                      <a:lnTo>
                        <a:pt x="2089" y="1526"/>
                      </a:lnTo>
                      <a:lnTo>
                        <a:pt x="2093" y="1518"/>
                      </a:lnTo>
                      <a:lnTo>
                        <a:pt x="2096" y="1510"/>
                      </a:lnTo>
                      <a:lnTo>
                        <a:pt x="2099" y="1504"/>
                      </a:lnTo>
                      <a:lnTo>
                        <a:pt x="2103" y="1502"/>
                      </a:lnTo>
                      <a:lnTo>
                        <a:pt x="2106" y="1500"/>
                      </a:lnTo>
                      <a:lnTo>
                        <a:pt x="2110" y="1497"/>
                      </a:lnTo>
                      <a:lnTo>
                        <a:pt x="2113" y="1483"/>
                      </a:lnTo>
                      <a:lnTo>
                        <a:pt x="2116" y="1446"/>
                      </a:lnTo>
                      <a:lnTo>
                        <a:pt x="2117" y="1434"/>
                      </a:lnTo>
                      <a:lnTo>
                        <a:pt x="2120" y="1371"/>
                      </a:lnTo>
                      <a:lnTo>
                        <a:pt x="2121" y="1351"/>
                      </a:lnTo>
                      <a:lnTo>
                        <a:pt x="2123" y="1250"/>
                      </a:lnTo>
                      <a:lnTo>
                        <a:pt x="2124" y="1220"/>
                      </a:lnTo>
                      <a:lnTo>
                        <a:pt x="2127" y="1081"/>
                      </a:lnTo>
                      <a:lnTo>
                        <a:pt x="2130" y="875"/>
                      </a:lnTo>
                      <a:lnTo>
                        <a:pt x="2134" y="657"/>
                      </a:lnTo>
                      <a:lnTo>
                        <a:pt x="2137" y="456"/>
                      </a:lnTo>
                      <a:lnTo>
                        <a:pt x="2138" y="420"/>
                      </a:lnTo>
                      <a:lnTo>
                        <a:pt x="2140" y="329"/>
                      </a:lnTo>
                      <a:lnTo>
                        <a:pt x="2141" y="305"/>
                      </a:lnTo>
                      <a:lnTo>
                        <a:pt x="2141" y="283"/>
                      </a:lnTo>
                      <a:lnTo>
                        <a:pt x="2143" y="237"/>
                      </a:lnTo>
                      <a:lnTo>
                        <a:pt x="2144" y="228"/>
                      </a:lnTo>
                      <a:lnTo>
                        <a:pt x="2146" y="221"/>
                      </a:lnTo>
                      <a:lnTo>
                        <a:pt x="2147" y="231"/>
                      </a:lnTo>
                      <a:lnTo>
                        <a:pt x="2148" y="240"/>
                      </a:lnTo>
                      <a:lnTo>
                        <a:pt x="2148" y="254"/>
                      </a:lnTo>
                      <a:lnTo>
                        <a:pt x="2150" y="312"/>
                      </a:lnTo>
                      <a:lnTo>
                        <a:pt x="2151" y="337"/>
                      </a:lnTo>
                      <a:lnTo>
                        <a:pt x="2152" y="366"/>
                      </a:lnTo>
                      <a:lnTo>
                        <a:pt x="2154" y="499"/>
                      </a:lnTo>
                      <a:lnTo>
                        <a:pt x="2158" y="697"/>
                      </a:lnTo>
                      <a:lnTo>
                        <a:pt x="2161" y="902"/>
                      </a:lnTo>
                      <a:lnTo>
                        <a:pt x="2165" y="1092"/>
                      </a:lnTo>
                      <a:lnTo>
                        <a:pt x="2168" y="1252"/>
                      </a:lnTo>
                      <a:lnTo>
                        <a:pt x="2172" y="1379"/>
                      </a:lnTo>
                      <a:lnTo>
                        <a:pt x="2175" y="1472"/>
                      </a:lnTo>
                      <a:lnTo>
                        <a:pt x="2178" y="1537"/>
                      </a:lnTo>
                      <a:lnTo>
                        <a:pt x="2182" y="1580"/>
                      </a:lnTo>
                      <a:lnTo>
                        <a:pt x="2185" y="1605"/>
                      </a:lnTo>
                      <a:lnTo>
                        <a:pt x="2189" y="1620"/>
                      </a:lnTo>
                      <a:lnTo>
                        <a:pt x="2192" y="1627"/>
                      </a:lnTo>
                      <a:lnTo>
                        <a:pt x="2196" y="1628"/>
                      </a:lnTo>
                      <a:lnTo>
                        <a:pt x="2199" y="1628"/>
                      </a:lnTo>
                      <a:lnTo>
                        <a:pt x="2202" y="1623"/>
                      </a:lnTo>
                      <a:lnTo>
                        <a:pt x="2206" y="1618"/>
                      </a:lnTo>
                      <a:lnTo>
                        <a:pt x="2209" y="1611"/>
                      </a:lnTo>
                      <a:lnTo>
                        <a:pt x="2213" y="1604"/>
                      </a:lnTo>
                      <a:lnTo>
                        <a:pt x="2216" y="1596"/>
                      </a:lnTo>
                      <a:lnTo>
                        <a:pt x="2220" y="1590"/>
                      </a:lnTo>
                      <a:lnTo>
                        <a:pt x="2223" y="1583"/>
                      </a:lnTo>
                      <a:lnTo>
                        <a:pt x="2227" y="1576"/>
                      </a:lnTo>
                      <a:lnTo>
                        <a:pt x="2230" y="1571"/>
                      </a:lnTo>
                      <a:lnTo>
                        <a:pt x="2233" y="1566"/>
                      </a:lnTo>
                      <a:lnTo>
                        <a:pt x="2237" y="1562"/>
                      </a:lnTo>
                      <a:lnTo>
                        <a:pt x="2240" y="1558"/>
                      </a:lnTo>
                      <a:lnTo>
                        <a:pt x="2244" y="1557"/>
                      </a:lnTo>
                      <a:lnTo>
                        <a:pt x="2247" y="1556"/>
                      </a:lnTo>
                      <a:lnTo>
                        <a:pt x="2251" y="1555"/>
                      </a:lnTo>
                      <a:lnTo>
                        <a:pt x="2254" y="1554"/>
                      </a:lnTo>
                      <a:lnTo>
                        <a:pt x="2257" y="1553"/>
                      </a:lnTo>
                      <a:lnTo>
                        <a:pt x="2261" y="1550"/>
                      </a:lnTo>
                      <a:lnTo>
                        <a:pt x="2264" y="1545"/>
                      </a:lnTo>
                      <a:lnTo>
                        <a:pt x="2268" y="1537"/>
                      </a:lnTo>
                      <a:lnTo>
                        <a:pt x="2271" y="1525"/>
                      </a:lnTo>
                      <a:lnTo>
                        <a:pt x="2275" y="1507"/>
                      </a:lnTo>
                      <a:lnTo>
                        <a:pt x="2278" y="1484"/>
                      </a:lnTo>
                      <a:lnTo>
                        <a:pt x="2282" y="1451"/>
                      </a:lnTo>
                      <a:lnTo>
                        <a:pt x="2285" y="1405"/>
                      </a:lnTo>
                      <a:lnTo>
                        <a:pt x="2288" y="1340"/>
                      </a:lnTo>
                      <a:lnTo>
                        <a:pt x="2292" y="1242"/>
                      </a:lnTo>
                      <a:lnTo>
                        <a:pt x="2295" y="1137"/>
                      </a:lnTo>
                      <a:lnTo>
                        <a:pt x="2295" y="1107"/>
                      </a:lnTo>
                      <a:lnTo>
                        <a:pt x="2296" y="1075"/>
                      </a:lnTo>
                      <a:lnTo>
                        <a:pt x="2299" y="932"/>
                      </a:lnTo>
                      <a:lnTo>
                        <a:pt x="2302" y="725"/>
                      </a:lnTo>
                      <a:lnTo>
                        <a:pt x="2306" y="505"/>
                      </a:lnTo>
                      <a:lnTo>
                        <a:pt x="2309" y="295"/>
                      </a:lnTo>
                      <a:lnTo>
                        <a:pt x="2310" y="256"/>
                      </a:lnTo>
                      <a:lnTo>
                        <a:pt x="2312" y="154"/>
                      </a:lnTo>
                      <a:lnTo>
                        <a:pt x="2312" y="125"/>
                      </a:lnTo>
                      <a:lnTo>
                        <a:pt x="2313" y="98"/>
                      </a:lnTo>
                      <a:lnTo>
                        <a:pt x="2315" y="36"/>
                      </a:lnTo>
                      <a:lnTo>
                        <a:pt x="2316" y="22"/>
                      </a:lnTo>
                      <a:lnTo>
                        <a:pt x="2317" y="12"/>
                      </a:lnTo>
                      <a:lnTo>
                        <a:pt x="2319" y="0"/>
                      </a:lnTo>
                      <a:lnTo>
                        <a:pt x="2319" y="4"/>
                      </a:lnTo>
                      <a:lnTo>
                        <a:pt x="2320" y="11"/>
                      </a:lnTo>
                      <a:lnTo>
                        <a:pt x="2322" y="55"/>
                      </a:lnTo>
                      <a:lnTo>
                        <a:pt x="2323" y="75"/>
                      </a:lnTo>
                      <a:lnTo>
                        <a:pt x="2323" y="99"/>
                      </a:lnTo>
                      <a:lnTo>
                        <a:pt x="2325" y="189"/>
                      </a:lnTo>
                      <a:lnTo>
                        <a:pt x="2326" y="223"/>
                      </a:lnTo>
                      <a:lnTo>
                        <a:pt x="2327" y="260"/>
                      </a:lnTo>
                      <a:lnTo>
                        <a:pt x="2330" y="424"/>
                      </a:lnTo>
                      <a:lnTo>
                        <a:pt x="2333" y="650"/>
                      </a:lnTo>
                      <a:lnTo>
                        <a:pt x="2337" y="876"/>
                      </a:lnTo>
                      <a:lnTo>
                        <a:pt x="2340" y="1082"/>
                      </a:lnTo>
                      <a:lnTo>
                        <a:pt x="2343" y="1258"/>
                      </a:lnTo>
                      <a:lnTo>
                        <a:pt x="2347" y="1400"/>
                      </a:lnTo>
                      <a:lnTo>
                        <a:pt x="2350" y="1509"/>
                      </a:lnTo>
                      <a:lnTo>
                        <a:pt x="2354" y="1592"/>
                      </a:lnTo>
                      <a:lnTo>
                        <a:pt x="2357" y="1651"/>
                      </a:lnTo>
                      <a:lnTo>
                        <a:pt x="2360" y="1693"/>
                      </a:lnTo>
                      <a:lnTo>
                        <a:pt x="2364" y="1724"/>
                      </a:lnTo>
                      <a:lnTo>
                        <a:pt x="2367" y="1745"/>
                      </a:lnTo>
                      <a:lnTo>
                        <a:pt x="2371" y="1761"/>
                      </a:lnTo>
                      <a:lnTo>
                        <a:pt x="2374" y="1773"/>
                      </a:lnTo>
                      <a:lnTo>
                        <a:pt x="2378" y="1782"/>
                      </a:lnTo>
                      <a:lnTo>
                        <a:pt x="2381" y="1789"/>
                      </a:lnTo>
                      <a:lnTo>
                        <a:pt x="2385" y="1794"/>
                      </a:lnTo>
                      <a:lnTo>
                        <a:pt x="2388" y="1799"/>
                      </a:lnTo>
                      <a:lnTo>
                        <a:pt x="2391" y="1803"/>
                      </a:lnTo>
                      <a:lnTo>
                        <a:pt x="2395" y="1806"/>
                      </a:lnTo>
                      <a:lnTo>
                        <a:pt x="2398" y="1809"/>
                      </a:lnTo>
                      <a:lnTo>
                        <a:pt x="2402" y="1811"/>
                      </a:lnTo>
                      <a:lnTo>
                        <a:pt x="2405" y="1813"/>
                      </a:lnTo>
                      <a:lnTo>
                        <a:pt x="2409" y="1815"/>
                      </a:lnTo>
                      <a:lnTo>
                        <a:pt x="2412" y="1816"/>
                      </a:lnTo>
                      <a:lnTo>
                        <a:pt x="2415" y="1816"/>
                      </a:lnTo>
                      <a:lnTo>
                        <a:pt x="2419" y="1816"/>
                      </a:lnTo>
                      <a:lnTo>
                        <a:pt x="2422" y="1817"/>
                      </a:lnTo>
                      <a:lnTo>
                        <a:pt x="2426" y="1818"/>
                      </a:lnTo>
                      <a:lnTo>
                        <a:pt x="2429" y="1818"/>
                      </a:lnTo>
                      <a:lnTo>
                        <a:pt x="2433" y="1820"/>
                      </a:lnTo>
                      <a:lnTo>
                        <a:pt x="2436" y="1822"/>
                      </a:lnTo>
                      <a:lnTo>
                        <a:pt x="2440" y="1823"/>
                      </a:lnTo>
                      <a:lnTo>
                        <a:pt x="2443" y="1823"/>
                      </a:lnTo>
                      <a:lnTo>
                        <a:pt x="2446" y="1827"/>
                      </a:lnTo>
                      <a:lnTo>
                        <a:pt x="2450" y="1828"/>
                      </a:lnTo>
                      <a:lnTo>
                        <a:pt x="2453" y="1830"/>
                      </a:lnTo>
                      <a:lnTo>
                        <a:pt x="2457" y="1832"/>
                      </a:lnTo>
                      <a:lnTo>
                        <a:pt x="2460" y="1834"/>
                      </a:lnTo>
                      <a:lnTo>
                        <a:pt x="2464" y="1835"/>
                      </a:lnTo>
                      <a:lnTo>
                        <a:pt x="2467" y="1836"/>
                      </a:lnTo>
                      <a:lnTo>
                        <a:pt x="2470" y="1837"/>
                      </a:lnTo>
                      <a:lnTo>
                        <a:pt x="2474" y="1837"/>
                      </a:lnTo>
                      <a:lnTo>
                        <a:pt x="2477" y="1838"/>
                      </a:lnTo>
                      <a:lnTo>
                        <a:pt x="2481" y="1838"/>
                      </a:lnTo>
                      <a:lnTo>
                        <a:pt x="2484" y="1839"/>
                      </a:lnTo>
                      <a:lnTo>
                        <a:pt x="2488" y="1839"/>
                      </a:lnTo>
                      <a:lnTo>
                        <a:pt x="2491" y="1839"/>
                      </a:lnTo>
                      <a:lnTo>
                        <a:pt x="2495" y="1839"/>
                      </a:lnTo>
                      <a:lnTo>
                        <a:pt x="2498" y="1840"/>
                      </a:lnTo>
                      <a:lnTo>
                        <a:pt x="2501" y="1840"/>
                      </a:lnTo>
                      <a:lnTo>
                        <a:pt x="2505" y="1840"/>
                      </a:lnTo>
                      <a:lnTo>
                        <a:pt x="2508" y="1840"/>
                      </a:lnTo>
                      <a:lnTo>
                        <a:pt x="2512" y="1841"/>
                      </a:lnTo>
                      <a:lnTo>
                        <a:pt x="2515" y="1841"/>
                      </a:lnTo>
                      <a:lnTo>
                        <a:pt x="2519" y="1841"/>
                      </a:lnTo>
                      <a:lnTo>
                        <a:pt x="2522" y="1841"/>
                      </a:lnTo>
                      <a:lnTo>
                        <a:pt x="2526" y="1841"/>
                      </a:lnTo>
                      <a:lnTo>
                        <a:pt x="2529" y="1841"/>
                      </a:lnTo>
                      <a:lnTo>
                        <a:pt x="2532" y="1841"/>
                      </a:lnTo>
                      <a:lnTo>
                        <a:pt x="2536" y="1842"/>
                      </a:lnTo>
                      <a:lnTo>
                        <a:pt x="2539" y="1842"/>
                      </a:lnTo>
                      <a:lnTo>
                        <a:pt x="2543" y="1842"/>
                      </a:lnTo>
                      <a:lnTo>
                        <a:pt x="2546" y="1842"/>
                      </a:lnTo>
                      <a:lnTo>
                        <a:pt x="2549" y="1842"/>
                      </a:lnTo>
                      <a:lnTo>
                        <a:pt x="2553" y="1843"/>
                      </a:lnTo>
                      <a:lnTo>
                        <a:pt x="2556" y="1843"/>
                      </a:lnTo>
                      <a:lnTo>
                        <a:pt x="2560" y="1843"/>
                      </a:lnTo>
                      <a:lnTo>
                        <a:pt x="2563" y="1842"/>
                      </a:lnTo>
                      <a:lnTo>
                        <a:pt x="2567" y="1843"/>
                      </a:lnTo>
                      <a:lnTo>
                        <a:pt x="2570" y="1843"/>
                      </a:lnTo>
                      <a:lnTo>
                        <a:pt x="2574" y="1843"/>
                      </a:lnTo>
                      <a:lnTo>
                        <a:pt x="2577" y="1844"/>
                      </a:lnTo>
                      <a:lnTo>
                        <a:pt x="2581" y="1844"/>
                      </a:lnTo>
                      <a:lnTo>
                        <a:pt x="2584" y="1845"/>
                      </a:lnTo>
                      <a:lnTo>
                        <a:pt x="2587" y="1844"/>
                      </a:lnTo>
                      <a:lnTo>
                        <a:pt x="2591" y="1844"/>
                      </a:lnTo>
                      <a:lnTo>
                        <a:pt x="2594" y="1845"/>
                      </a:lnTo>
                      <a:lnTo>
                        <a:pt x="2598" y="1845"/>
                      </a:lnTo>
                      <a:lnTo>
                        <a:pt x="2601" y="1845"/>
                      </a:lnTo>
                      <a:lnTo>
                        <a:pt x="2604" y="1846"/>
                      </a:lnTo>
                      <a:lnTo>
                        <a:pt x="2608" y="1846"/>
                      </a:lnTo>
                      <a:lnTo>
                        <a:pt x="2611" y="1846"/>
                      </a:lnTo>
                      <a:lnTo>
                        <a:pt x="2615" y="1846"/>
                      </a:lnTo>
                      <a:lnTo>
                        <a:pt x="2618" y="1846"/>
                      </a:lnTo>
                      <a:lnTo>
                        <a:pt x="2622" y="1846"/>
                      </a:lnTo>
                      <a:lnTo>
                        <a:pt x="2625" y="1846"/>
                      </a:lnTo>
                      <a:lnTo>
                        <a:pt x="2629" y="1846"/>
                      </a:lnTo>
                      <a:lnTo>
                        <a:pt x="2632" y="1847"/>
                      </a:lnTo>
                      <a:lnTo>
                        <a:pt x="2635" y="1847"/>
                      </a:lnTo>
                      <a:lnTo>
                        <a:pt x="2639" y="1847"/>
                      </a:lnTo>
                      <a:lnTo>
                        <a:pt x="2642" y="1847"/>
                      </a:lnTo>
                      <a:lnTo>
                        <a:pt x="2646" y="1847"/>
                      </a:lnTo>
                      <a:lnTo>
                        <a:pt x="2649" y="1846"/>
                      </a:lnTo>
                      <a:lnTo>
                        <a:pt x="2653" y="1847"/>
                      </a:lnTo>
                      <a:lnTo>
                        <a:pt x="2656" y="1846"/>
                      </a:lnTo>
                      <a:lnTo>
                        <a:pt x="2659" y="1847"/>
                      </a:lnTo>
                      <a:lnTo>
                        <a:pt x="2663" y="1847"/>
                      </a:lnTo>
                      <a:lnTo>
                        <a:pt x="2666" y="1847"/>
                      </a:lnTo>
                      <a:lnTo>
                        <a:pt x="2670" y="1847"/>
                      </a:lnTo>
                      <a:lnTo>
                        <a:pt x="2673" y="1847"/>
                      </a:lnTo>
                      <a:lnTo>
                        <a:pt x="2677" y="1848"/>
                      </a:lnTo>
                      <a:lnTo>
                        <a:pt x="2680" y="1848"/>
                      </a:lnTo>
                      <a:lnTo>
                        <a:pt x="2684" y="1847"/>
                      </a:lnTo>
                      <a:lnTo>
                        <a:pt x="2687" y="1848"/>
                      </a:lnTo>
                      <a:lnTo>
                        <a:pt x="2690" y="1847"/>
                      </a:lnTo>
                      <a:lnTo>
                        <a:pt x="2694" y="1847"/>
                      </a:lnTo>
                      <a:lnTo>
                        <a:pt x="2697" y="1848"/>
                      </a:lnTo>
                      <a:lnTo>
                        <a:pt x="2701" y="1847"/>
                      </a:lnTo>
                      <a:lnTo>
                        <a:pt x="2704" y="1848"/>
                      </a:lnTo>
                      <a:lnTo>
                        <a:pt x="2707" y="1848"/>
                      </a:lnTo>
                      <a:lnTo>
                        <a:pt x="2711" y="1848"/>
                      </a:lnTo>
                      <a:lnTo>
                        <a:pt x="2714" y="1848"/>
                      </a:lnTo>
                      <a:lnTo>
                        <a:pt x="2718" y="1848"/>
                      </a:lnTo>
                      <a:lnTo>
                        <a:pt x="2721" y="1848"/>
                      </a:lnTo>
                      <a:lnTo>
                        <a:pt x="2725" y="1848"/>
                      </a:lnTo>
                      <a:lnTo>
                        <a:pt x="2728" y="1848"/>
                      </a:lnTo>
                      <a:lnTo>
                        <a:pt x="2732" y="1848"/>
                      </a:lnTo>
                      <a:lnTo>
                        <a:pt x="2735" y="1848"/>
                      </a:lnTo>
                      <a:lnTo>
                        <a:pt x="2738" y="1849"/>
                      </a:lnTo>
                      <a:lnTo>
                        <a:pt x="2742" y="1849"/>
                      </a:lnTo>
                      <a:lnTo>
                        <a:pt x="2745" y="1849"/>
                      </a:lnTo>
                      <a:lnTo>
                        <a:pt x="2749" y="1848"/>
                      </a:lnTo>
                      <a:lnTo>
                        <a:pt x="2752" y="1849"/>
                      </a:lnTo>
                      <a:lnTo>
                        <a:pt x="2756" y="1849"/>
                      </a:lnTo>
                      <a:lnTo>
                        <a:pt x="2759" y="1849"/>
                      </a:lnTo>
                      <a:lnTo>
                        <a:pt x="2763" y="1849"/>
                      </a:lnTo>
                      <a:lnTo>
                        <a:pt x="2766" y="1849"/>
                      </a:lnTo>
                      <a:lnTo>
                        <a:pt x="2769" y="1849"/>
                      </a:lnTo>
                      <a:lnTo>
                        <a:pt x="2773" y="1849"/>
                      </a:lnTo>
                      <a:lnTo>
                        <a:pt x="2776" y="1849"/>
                      </a:lnTo>
                      <a:lnTo>
                        <a:pt x="2780" y="1849"/>
                      </a:lnTo>
                      <a:lnTo>
                        <a:pt x="2783" y="1849"/>
                      </a:lnTo>
                      <a:lnTo>
                        <a:pt x="2787" y="1849"/>
                      </a:lnTo>
                      <a:lnTo>
                        <a:pt x="2790" y="1848"/>
                      </a:lnTo>
                      <a:lnTo>
                        <a:pt x="2793" y="1848"/>
                      </a:lnTo>
                      <a:lnTo>
                        <a:pt x="2797" y="1849"/>
                      </a:lnTo>
                      <a:lnTo>
                        <a:pt x="2800" y="1848"/>
                      </a:lnTo>
                      <a:lnTo>
                        <a:pt x="2804" y="1849"/>
                      </a:lnTo>
                      <a:lnTo>
                        <a:pt x="2807" y="1848"/>
                      </a:lnTo>
                      <a:lnTo>
                        <a:pt x="2811" y="1848"/>
                      </a:lnTo>
                      <a:lnTo>
                        <a:pt x="2814" y="1848"/>
                      </a:lnTo>
                      <a:lnTo>
                        <a:pt x="2818" y="1847"/>
                      </a:lnTo>
                      <a:lnTo>
                        <a:pt x="2821" y="1847"/>
                      </a:lnTo>
                      <a:lnTo>
                        <a:pt x="2824" y="1847"/>
                      </a:lnTo>
                      <a:lnTo>
                        <a:pt x="2828" y="1847"/>
                      </a:lnTo>
                      <a:lnTo>
                        <a:pt x="2831" y="1848"/>
                      </a:lnTo>
                      <a:lnTo>
                        <a:pt x="2835" y="1847"/>
                      </a:lnTo>
                      <a:lnTo>
                        <a:pt x="2838" y="1847"/>
                      </a:lnTo>
                      <a:lnTo>
                        <a:pt x="2842" y="1847"/>
                      </a:lnTo>
                      <a:lnTo>
                        <a:pt x="2845" y="1846"/>
                      </a:lnTo>
                      <a:lnTo>
                        <a:pt x="2848" y="1846"/>
                      </a:lnTo>
                      <a:lnTo>
                        <a:pt x="2852" y="1846"/>
                      </a:lnTo>
                      <a:lnTo>
                        <a:pt x="2855" y="1846"/>
                      </a:lnTo>
                      <a:lnTo>
                        <a:pt x="2859" y="1845"/>
                      </a:lnTo>
                      <a:lnTo>
                        <a:pt x="2862" y="1845"/>
                      </a:lnTo>
                      <a:lnTo>
                        <a:pt x="2866" y="1845"/>
                      </a:lnTo>
                      <a:lnTo>
                        <a:pt x="2869" y="1845"/>
                      </a:lnTo>
                      <a:lnTo>
                        <a:pt x="2873" y="1844"/>
                      </a:lnTo>
                      <a:lnTo>
                        <a:pt x="2876" y="1844"/>
                      </a:lnTo>
                      <a:lnTo>
                        <a:pt x="2879" y="1844"/>
                      </a:lnTo>
                      <a:lnTo>
                        <a:pt x="2883" y="1844"/>
                      </a:lnTo>
                      <a:lnTo>
                        <a:pt x="2886" y="1844"/>
                      </a:lnTo>
                      <a:lnTo>
                        <a:pt x="2890" y="1844"/>
                      </a:lnTo>
                      <a:lnTo>
                        <a:pt x="2893" y="1844"/>
                      </a:lnTo>
                      <a:lnTo>
                        <a:pt x="2896" y="1844"/>
                      </a:lnTo>
                      <a:lnTo>
                        <a:pt x="2900" y="1844"/>
                      </a:lnTo>
                      <a:lnTo>
                        <a:pt x="2903" y="1843"/>
                      </a:lnTo>
                      <a:lnTo>
                        <a:pt x="2907" y="1843"/>
                      </a:lnTo>
                      <a:lnTo>
                        <a:pt x="2910" y="1843"/>
                      </a:lnTo>
                      <a:lnTo>
                        <a:pt x="2914" y="1843"/>
                      </a:lnTo>
                      <a:lnTo>
                        <a:pt x="2917" y="1843"/>
                      </a:lnTo>
                      <a:lnTo>
                        <a:pt x="2921" y="1844"/>
                      </a:lnTo>
                      <a:lnTo>
                        <a:pt x="2924" y="1843"/>
                      </a:lnTo>
                      <a:lnTo>
                        <a:pt x="2928" y="1843"/>
                      </a:lnTo>
                      <a:lnTo>
                        <a:pt x="2931" y="1843"/>
                      </a:lnTo>
                      <a:lnTo>
                        <a:pt x="2934" y="1843"/>
                      </a:lnTo>
                      <a:lnTo>
                        <a:pt x="2938" y="1843"/>
                      </a:lnTo>
                      <a:lnTo>
                        <a:pt x="2941" y="1843"/>
                      </a:lnTo>
                      <a:lnTo>
                        <a:pt x="2945" y="1842"/>
                      </a:lnTo>
                      <a:lnTo>
                        <a:pt x="2948" y="1842"/>
                      </a:lnTo>
                      <a:lnTo>
                        <a:pt x="2951" y="1842"/>
                      </a:lnTo>
                      <a:lnTo>
                        <a:pt x="2955" y="1842"/>
                      </a:lnTo>
                      <a:lnTo>
                        <a:pt x="2958" y="1841"/>
                      </a:lnTo>
                      <a:lnTo>
                        <a:pt x="2962" y="1842"/>
                      </a:lnTo>
                      <a:lnTo>
                        <a:pt x="2965" y="1842"/>
                      </a:lnTo>
                      <a:lnTo>
                        <a:pt x="2969" y="1840"/>
                      </a:lnTo>
                      <a:lnTo>
                        <a:pt x="2972" y="1841"/>
                      </a:lnTo>
                      <a:lnTo>
                        <a:pt x="2976" y="1841"/>
                      </a:lnTo>
                      <a:lnTo>
                        <a:pt x="2979" y="1841"/>
                      </a:lnTo>
                      <a:lnTo>
                        <a:pt x="2982" y="1840"/>
                      </a:lnTo>
                      <a:lnTo>
                        <a:pt x="2986" y="1840"/>
                      </a:lnTo>
                      <a:lnTo>
                        <a:pt x="2989" y="1841"/>
                      </a:lnTo>
                      <a:lnTo>
                        <a:pt x="2993" y="1840"/>
                      </a:lnTo>
                      <a:lnTo>
                        <a:pt x="2996" y="1841"/>
                      </a:lnTo>
                      <a:lnTo>
                        <a:pt x="3000" y="1840"/>
                      </a:lnTo>
                      <a:lnTo>
                        <a:pt x="3003" y="1840"/>
                      </a:lnTo>
                      <a:lnTo>
                        <a:pt x="3006" y="1840"/>
                      </a:lnTo>
                      <a:lnTo>
                        <a:pt x="3010" y="1840"/>
                      </a:lnTo>
                      <a:lnTo>
                        <a:pt x="3013" y="1839"/>
                      </a:lnTo>
                      <a:lnTo>
                        <a:pt x="3017" y="1839"/>
                      </a:lnTo>
                      <a:lnTo>
                        <a:pt x="3020" y="1839"/>
                      </a:lnTo>
                      <a:lnTo>
                        <a:pt x="3024" y="1839"/>
                      </a:lnTo>
                      <a:lnTo>
                        <a:pt x="3027" y="1838"/>
                      </a:lnTo>
                      <a:lnTo>
                        <a:pt x="3031" y="1838"/>
                      </a:lnTo>
                      <a:lnTo>
                        <a:pt x="3034" y="1838"/>
                      </a:lnTo>
                      <a:lnTo>
                        <a:pt x="3037" y="1838"/>
                      </a:lnTo>
                      <a:lnTo>
                        <a:pt x="3041" y="1837"/>
                      </a:lnTo>
                      <a:lnTo>
                        <a:pt x="3044" y="1837"/>
                      </a:lnTo>
                      <a:lnTo>
                        <a:pt x="3048" y="1836"/>
                      </a:lnTo>
                      <a:lnTo>
                        <a:pt x="3051" y="1836"/>
                      </a:lnTo>
                      <a:lnTo>
                        <a:pt x="3055" y="1835"/>
                      </a:lnTo>
                      <a:lnTo>
                        <a:pt x="3058" y="1834"/>
                      </a:lnTo>
                      <a:lnTo>
                        <a:pt x="3061" y="1834"/>
                      </a:lnTo>
                      <a:lnTo>
                        <a:pt x="3065" y="1832"/>
                      </a:lnTo>
                      <a:lnTo>
                        <a:pt x="3068" y="1832"/>
                      </a:lnTo>
                      <a:lnTo>
                        <a:pt x="3072" y="1831"/>
                      </a:lnTo>
                      <a:lnTo>
                        <a:pt x="3075" y="1831"/>
                      </a:lnTo>
                      <a:lnTo>
                        <a:pt x="3079" y="1829"/>
                      </a:lnTo>
                      <a:lnTo>
                        <a:pt x="3082" y="1829"/>
                      </a:lnTo>
                      <a:lnTo>
                        <a:pt x="3086" y="1827"/>
                      </a:lnTo>
                      <a:lnTo>
                        <a:pt x="3089" y="1826"/>
                      </a:lnTo>
                      <a:lnTo>
                        <a:pt x="3092" y="1825"/>
                      </a:lnTo>
                      <a:lnTo>
                        <a:pt x="3096" y="1825"/>
                      </a:lnTo>
                      <a:lnTo>
                        <a:pt x="3099" y="1823"/>
                      </a:lnTo>
                      <a:lnTo>
                        <a:pt x="3103" y="1823"/>
                      </a:lnTo>
                      <a:lnTo>
                        <a:pt x="3106" y="1821"/>
                      </a:lnTo>
                      <a:lnTo>
                        <a:pt x="3110" y="1820"/>
                      </a:lnTo>
                      <a:lnTo>
                        <a:pt x="3113" y="1819"/>
                      </a:lnTo>
                      <a:lnTo>
                        <a:pt x="3117" y="1817"/>
                      </a:lnTo>
                      <a:lnTo>
                        <a:pt x="3120" y="1817"/>
                      </a:lnTo>
                      <a:lnTo>
                        <a:pt x="3123" y="1815"/>
                      </a:lnTo>
                      <a:lnTo>
                        <a:pt x="3127" y="1813"/>
                      </a:lnTo>
                      <a:lnTo>
                        <a:pt x="3130" y="1812"/>
                      </a:lnTo>
                      <a:lnTo>
                        <a:pt x="3134" y="1811"/>
                      </a:lnTo>
                      <a:lnTo>
                        <a:pt x="3137" y="1810"/>
                      </a:lnTo>
                      <a:lnTo>
                        <a:pt x="3140" y="1808"/>
                      </a:lnTo>
                      <a:lnTo>
                        <a:pt x="3144" y="1808"/>
                      </a:lnTo>
                      <a:lnTo>
                        <a:pt x="3147" y="1807"/>
                      </a:lnTo>
                      <a:lnTo>
                        <a:pt x="3151" y="1806"/>
                      </a:lnTo>
                      <a:lnTo>
                        <a:pt x="3154" y="1805"/>
                      </a:lnTo>
                      <a:lnTo>
                        <a:pt x="3158" y="1805"/>
                      </a:lnTo>
                      <a:lnTo>
                        <a:pt x="3161" y="1805"/>
                      </a:lnTo>
                      <a:lnTo>
                        <a:pt x="3165" y="1803"/>
                      </a:lnTo>
                      <a:lnTo>
                        <a:pt x="3168" y="1803"/>
                      </a:lnTo>
                      <a:lnTo>
                        <a:pt x="3171" y="1802"/>
                      </a:lnTo>
                      <a:lnTo>
                        <a:pt x="3175" y="1801"/>
                      </a:lnTo>
                      <a:lnTo>
                        <a:pt x="3178" y="1798"/>
                      </a:lnTo>
                      <a:lnTo>
                        <a:pt x="3182" y="1796"/>
                      </a:lnTo>
                      <a:lnTo>
                        <a:pt x="3185" y="1795"/>
                      </a:lnTo>
                      <a:lnTo>
                        <a:pt x="3189" y="1790"/>
                      </a:lnTo>
                      <a:lnTo>
                        <a:pt x="3192" y="1787"/>
                      </a:lnTo>
                      <a:lnTo>
                        <a:pt x="3195" y="1783"/>
                      </a:lnTo>
                      <a:lnTo>
                        <a:pt x="3199" y="1778"/>
                      </a:lnTo>
                      <a:lnTo>
                        <a:pt x="3202" y="1774"/>
                      </a:lnTo>
                      <a:lnTo>
                        <a:pt x="3206" y="1768"/>
                      </a:lnTo>
                      <a:lnTo>
                        <a:pt x="3209" y="1762"/>
                      </a:lnTo>
                      <a:lnTo>
                        <a:pt x="3213" y="1757"/>
                      </a:lnTo>
                      <a:lnTo>
                        <a:pt x="3216" y="1750"/>
                      </a:lnTo>
                      <a:lnTo>
                        <a:pt x="3220" y="1744"/>
                      </a:lnTo>
                      <a:lnTo>
                        <a:pt x="3223" y="1738"/>
                      </a:lnTo>
                      <a:lnTo>
                        <a:pt x="3226" y="1730"/>
                      </a:lnTo>
                      <a:lnTo>
                        <a:pt x="3230" y="1723"/>
                      </a:lnTo>
                      <a:lnTo>
                        <a:pt x="3233" y="1716"/>
                      </a:lnTo>
                      <a:lnTo>
                        <a:pt x="3237" y="1709"/>
                      </a:lnTo>
                      <a:lnTo>
                        <a:pt x="3240" y="1702"/>
                      </a:lnTo>
                      <a:lnTo>
                        <a:pt x="3244" y="1695"/>
                      </a:lnTo>
                      <a:lnTo>
                        <a:pt x="3247" y="1687"/>
                      </a:lnTo>
                      <a:lnTo>
                        <a:pt x="3250" y="1679"/>
                      </a:lnTo>
                      <a:lnTo>
                        <a:pt x="3254" y="1670"/>
                      </a:lnTo>
                      <a:lnTo>
                        <a:pt x="3257" y="1662"/>
                      </a:lnTo>
                      <a:lnTo>
                        <a:pt x="3261" y="1654"/>
                      </a:lnTo>
                      <a:lnTo>
                        <a:pt x="3264" y="1645"/>
                      </a:lnTo>
                      <a:lnTo>
                        <a:pt x="3268" y="1637"/>
                      </a:lnTo>
                      <a:lnTo>
                        <a:pt x="3271" y="1630"/>
                      </a:lnTo>
                      <a:lnTo>
                        <a:pt x="3275" y="1622"/>
                      </a:lnTo>
                      <a:lnTo>
                        <a:pt x="3278" y="1616"/>
                      </a:lnTo>
                      <a:lnTo>
                        <a:pt x="3281" y="1610"/>
                      </a:lnTo>
                      <a:lnTo>
                        <a:pt x="3285" y="1605"/>
                      </a:lnTo>
                      <a:lnTo>
                        <a:pt x="3288" y="1603"/>
                      </a:lnTo>
                      <a:lnTo>
                        <a:pt x="3292" y="1601"/>
                      </a:lnTo>
                      <a:lnTo>
                        <a:pt x="3295" y="1601"/>
                      </a:lnTo>
                      <a:lnTo>
                        <a:pt x="3298" y="1602"/>
                      </a:lnTo>
                      <a:lnTo>
                        <a:pt x="3302" y="1607"/>
                      </a:lnTo>
                      <a:lnTo>
                        <a:pt x="3305" y="1610"/>
                      </a:lnTo>
                      <a:lnTo>
                        <a:pt x="3309" y="1617"/>
                      </a:lnTo>
                      <a:lnTo>
                        <a:pt x="3312" y="1624"/>
                      </a:lnTo>
                      <a:lnTo>
                        <a:pt x="3316" y="1631"/>
                      </a:lnTo>
                      <a:lnTo>
                        <a:pt x="3319" y="1640"/>
                      </a:lnTo>
                      <a:lnTo>
                        <a:pt x="3323" y="1649"/>
                      </a:lnTo>
                      <a:lnTo>
                        <a:pt x="3326" y="1659"/>
                      </a:lnTo>
                      <a:lnTo>
                        <a:pt x="3329" y="1668"/>
                      </a:lnTo>
                      <a:lnTo>
                        <a:pt x="3333" y="1677"/>
                      </a:lnTo>
                      <a:lnTo>
                        <a:pt x="3336" y="1686"/>
                      </a:lnTo>
                      <a:lnTo>
                        <a:pt x="3340" y="1696"/>
                      </a:lnTo>
                      <a:lnTo>
                        <a:pt x="3343" y="1704"/>
                      </a:lnTo>
                      <a:lnTo>
                        <a:pt x="3347" y="1714"/>
                      </a:lnTo>
                      <a:lnTo>
                        <a:pt x="3350" y="1722"/>
                      </a:lnTo>
                      <a:lnTo>
                        <a:pt x="3353" y="1730"/>
                      </a:lnTo>
                      <a:lnTo>
                        <a:pt x="3357" y="1737"/>
                      </a:lnTo>
                      <a:lnTo>
                        <a:pt x="3360" y="1745"/>
                      </a:lnTo>
                      <a:lnTo>
                        <a:pt x="3364" y="1752"/>
                      </a:lnTo>
                      <a:lnTo>
                        <a:pt x="3367" y="1759"/>
                      </a:lnTo>
                      <a:lnTo>
                        <a:pt x="3371" y="1766"/>
                      </a:lnTo>
                      <a:lnTo>
                        <a:pt x="3374" y="1772"/>
                      </a:lnTo>
                      <a:lnTo>
                        <a:pt x="3378" y="1777"/>
                      </a:lnTo>
                      <a:lnTo>
                        <a:pt x="3381" y="1782"/>
                      </a:lnTo>
                      <a:lnTo>
                        <a:pt x="3384" y="1788"/>
                      </a:lnTo>
                      <a:lnTo>
                        <a:pt x="3388" y="1792"/>
                      </a:lnTo>
                      <a:lnTo>
                        <a:pt x="3391" y="1797"/>
                      </a:lnTo>
                      <a:lnTo>
                        <a:pt x="3395" y="1801"/>
                      </a:lnTo>
                      <a:lnTo>
                        <a:pt x="3398" y="1804"/>
                      </a:lnTo>
                      <a:lnTo>
                        <a:pt x="3402" y="1807"/>
                      </a:lnTo>
                      <a:lnTo>
                        <a:pt x="3405" y="1811"/>
                      </a:lnTo>
                      <a:lnTo>
                        <a:pt x="3409" y="1814"/>
                      </a:lnTo>
                      <a:lnTo>
                        <a:pt x="3412" y="1818"/>
                      </a:lnTo>
                      <a:lnTo>
                        <a:pt x="3415" y="1821"/>
                      </a:lnTo>
                      <a:lnTo>
                        <a:pt x="3419" y="1823"/>
                      </a:lnTo>
                      <a:lnTo>
                        <a:pt x="3422" y="1825"/>
                      </a:lnTo>
                      <a:lnTo>
                        <a:pt x="3426" y="1827"/>
                      </a:lnTo>
                      <a:lnTo>
                        <a:pt x="3429" y="1829"/>
                      </a:lnTo>
                      <a:lnTo>
                        <a:pt x="3433" y="1830"/>
                      </a:lnTo>
                      <a:lnTo>
                        <a:pt x="3436" y="1833"/>
                      </a:lnTo>
                      <a:lnTo>
                        <a:pt x="3439" y="1834"/>
                      </a:lnTo>
                      <a:lnTo>
                        <a:pt x="3443" y="1836"/>
                      </a:lnTo>
                      <a:lnTo>
                        <a:pt x="3446" y="1837"/>
                      </a:lnTo>
                      <a:lnTo>
                        <a:pt x="3450" y="1838"/>
                      </a:lnTo>
                      <a:lnTo>
                        <a:pt x="3453" y="1839"/>
                      </a:lnTo>
                      <a:lnTo>
                        <a:pt x="3457" y="1840"/>
                      </a:lnTo>
                      <a:lnTo>
                        <a:pt x="3460" y="1841"/>
                      </a:lnTo>
                      <a:lnTo>
                        <a:pt x="3464" y="1841"/>
                      </a:lnTo>
                      <a:lnTo>
                        <a:pt x="3467" y="1842"/>
                      </a:lnTo>
                      <a:lnTo>
                        <a:pt x="3470" y="1843"/>
                      </a:lnTo>
                      <a:lnTo>
                        <a:pt x="3474" y="1843"/>
                      </a:lnTo>
                      <a:lnTo>
                        <a:pt x="3477" y="1844"/>
                      </a:lnTo>
                      <a:lnTo>
                        <a:pt x="3481" y="1844"/>
                      </a:lnTo>
                      <a:lnTo>
                        <a:pt x="3484" y="1845"/>
                      </a:lnTo>
                      <a:lnTo>
                        <a:pt x="3487" y="1845"/>
                      </a:lnTo>
                      <a:lnTo>
                        <a:pt x="3491" y="1845"/>
                      </a:lnTo>
                      <a:lnTo>
                        <a:pt x="3494" y="1846"/>
                      </a:lnTo>
                      <a:lnTo>
                        <a:pt x="3498" y="1846"/>
                      </a:lnTo>
                      <a:lnTo>
                        <a:pt x="3501" y="1846"/>
                      </a:lnTo>
                      <a:lnTo>
                        <a:pt x="3505" y="1846"/>
                      </a:lnTo>
                      <a:lnTo>
                        <a:pt x="3508" y="1846"/>
                      </a:lnTo>
                      <a:lnTo>
                        <a:pt x="3512" y="1847"/>
                      </a:lnTo>
                      <a:lnTo>
                        <a:pt x="3515" y="1847"/>
                      </a:lnTo>
                      <a:lnTo>
                        <a:pt x="3518" y="1848"/>
                      </a:lnTo>
                      <a:lnTo>
                        <a:pt x="3522" y="1847"/>
                      </a:lnTo>
                      <a:lnTo>
                        <a:pt x="3525" y="1848"/>
                      </a:lnTo>
                      <a:lnTo>
                        <a:pt x="3529" y="1848"/>
                      </a:lnTo>
                      <a:lnTo>
                        <a:pt x="3532" y="1849"/>
                      </a:lnTo>
                      <a:lnTo>
                        <a:pt x="3536" y="1849"/>
                      </a:lnTo>
                      <a:lnTo>
                        <a:pt x="3539" y="1849"/>
                      </a:lnTo>
                      <a:lnTo>
                        <a:pt x="3542" y="1850"/>
                      </a:lnTo>
                      <a:lnTo>
                        <a:pt x="3546" y="1849"/>
                      </a:lnTo>
                      <a:lnTo>
                        <a:pt x="3549" y="1850"/>
                      </a:lnTo>
                      <a:lnTo>
                        <a:pt x="3553" y="1850"/>
                      </a:lnTo>
                      <a:lnTo>
                        <a:pt x="3556" y="1850"/>
                      </a:lnTo>
                      <a:lnTo>
                        <a:pt x="3560" y="1850"/>
                      </a:lnTo>
                      <a:lnTo>
                        <a:pt x="3563" y="1850"/>
                      </a:lnTo>
                      <a:lnTo>
                        <a:pt x="3567" y="1850"/>
                      </a:lnTo>
                      <a:lnTo>
                        <a:pt x="3570" y="1850"/>
                      </a:lnTo>
                      <a:lnTo>
                        <a:pt x="3573" y="1850"/>
                      </a:lnTo>
                      <a:lnTo>
                        <a:pt x="3577" y="1850"/>
                      </a:lnTo>
                      <a:lnTo>
                        <a:pt x="3580" y="1851"/>
                      </a:lnTo>
                      <a:lnTo>
                        <a:pt x="3584" y="1851"/>
                      </a:lnTo>
                      <a:lnTo>
                        <a:pt x="3587" y="1851"/>
                      </a:lnTo>
                      <a:lnTo>
                        <a:pt x="3591" y="1851"/>
                      </a:lnTo>
                      <a:lnTo>
                        <a:pt x="3594" y="1851"/>
                      </a:lnTo>
                      <a:lnTo>
                        <a:pt x="3597" y="1851"/>
                      </a:lnTo>
                      <a:lnTo>
                        <a:pt x="3601" y="1851"/>
                      </a:lnTo>
                      <a:lnTo>
                        <a:pt x="3604" y="1851"/>
                      </a:lnTo>
                      <a:lnTo>
                        <a:pt x="3608" y="1851"/>
                      </a:lnTo>
                      <a:lnTo>
                        <a:pt x="3611" y="1851"/>
                      </a:lnTo>
                      <a:lnTo>
                        <a:pt x="3615" y="1852"/>
                      </a:lnTo>
                      <a:lnTo>
                        <a:pt x="3618" y="1851"/>
                      </a:lnTo>
                      <a:lnTo>
                        <a:pt x="3622" y="1852"/>
                      </a:lnTo>
                      <a:lnTo>
                        <a:pt x="3625" y="1851"/>
                      </a:lnTo>
                      <a:lnTo>
                        <a:pt x="3628" y="1851"/>
                      </a:lnTo>
                      <a:lnTo>
                        <a:pt x="3632" y="1852"/>
                      </a:lnTo>
                      <a:lnTo>
                        <a:pt x="3635" y="1851"/>
                      </a:lnTo>
                      <a:lnTo>
                        <a:pt x="3639" y="1851"/>
                      </a:lnTo>
                      <a:lnTo>
                        <a:pt x="3642" y="1851"/>
                      </a:lnTo>
                      <a:lnTo>
                        <a:pt x="3646" y="1850"/>
                      </a:lnTo>
                      <a:lnTo>
                        <a:pt x="3649" y="1850"/>
                      </a:lnTo>
                      <a:lnTo>
                        <a:pt x="3652" y="1850"/>
                      </a:lnTo>
                      <a:lnTo>
                        <a:pt x="3656" y="1851"/>
                      </a:lnTo>
                      <a:lnTo>
                        <a:pt x="3659" y="1850"/>
                      </a:lnTo>
                      <a:lnTo>
                        <a:pt x="3663" y="1849"/>
                      </a:lnTo>
                      <a:lnTo>
                        <a:pt x="3666" y="1850"/>
                      </a:lnTo>
                      <a:lnTo>
                        <a:pt x="3670" y="1850"/>
                      </a:lnTo>
                      <a:lnTo>
                        <a:pt x="3673" y="1850"/>
                      </a:lnTo>
                      <a:lnTo>
                        <a:pt x="3676" y="1850"/>
                      </a:lnTo>
                      <a:lnTo>
                        <a:pt x="3680" y="1850"/>
                      </a:lnTo>
                      <a:lnTo>
                        <a:pt x="3683" y="1849"/>
                      </a:lnTo>
                      <a:lnTo>
                        <a:pt x="3687" y="1849"/>
                      </a:lnTo>
                      <a:lnTo>
                        <a:pt x="3690" y="1849"/>
                      </a:lnTo>
                      <a:lnTo>
                        <a:pt x="3694" y="1849"/>
                      </a:lnTo>
                      <a:lnTo>
                        <a:pt x="3697" y="1849"/>
                      </a:lnTo>
                      <a:lnTo>
                        <a:pt x="3701" y="1849"/>
                      </a:lnTo>
                      <a:lnTo>
                        <a:pt x="3704" y="1850"/>
                      </a:lnTo>
                      <a:lnTo>
                        <a:pt x="3707" y="1849"/>
                      </a:lnTo>
                      <a:lnTo>
                        <a:pt x="3711" y="1849"/>
                      </a:lnTo>
                      <a:lnTo>
                        <a:pt x="3714" y="1849"/>
                      </a:lnTo>
                      <a:lnTo>
                        <a:pt x="3718" y="1850"/>
                      </a:lnTo>
                      <a:lnTo>
                        <a:pt x="3721" y="1849"/>
                      </a:lnTo>
                      <a:lnTo>
                        <a:pt x="3725" y="1849"/>
                      </a:lnTo>
                      <a:lnTo>
                        <a:pt x="3728" y="1849"/>
                      </a:lnTo>
                      <a:lnTo>
                        <a:pt x="3731" y="1850"/>
                      </a:lnTo>
                      <a:lnTo>
                        <a:pt x="3735" y="1850"/>
                      </a:lnTo>
                      <a:lnTo>
                        <a:pt x="3738" y="1850"/>
                      </a:lnTo>
                      <a:lnTo>
                        <a:pt x="3742" y="1850"/>
                      </a:lnTo>
                      <a:lnTo>
                        <a:pt x="3745" y="1850"/>
                      </a:lnTo>
                      <a:lnTo>
                        <a:pt x="3749" y="1850"/>
                      </a:lnTo>
                      <a:lnTo>
                        <a:pt x="3752" y="1851"/>
                      </a:lnTo>
                      <a:lnTo>
                        <a:pt x="3756" y="1851"/>
                      </a:lnTo>
                      <a:lnTo>
                        <a:pt x="3759" y="1851"/>
                      </a:lnTo>
                      <a:lnTo>
                        <a:pt x="3762" y="1851"/>
                      </a:lnTo>
                      <a:lnTo>
                        <a:pt x="3766" y="1852"/>
                      </a:lnTo>
                      <a:lnTo>
                        <a:pt x="3769" y="1852"/>
                      </a:lnTo>
                      <a:lnTo>
                        <a:pt x="3773" y="1851"/>
                      </a:lnTo>
                      <a:lnTo>
                        <a:pt x="3776" y="1852"/>
                      </a:lnTo>
                      <a:lnTo>
                        <a:pt x="3780" y="1852"/>
                      </a:lnTo>
                      <a:lnTo>
                        <a:pt x="3783" y="1852"/>
                      </a:lnTo>
                      <a:lnTo>
                        <a:pt x="3786" y="1852"/>
                      </a:lnTo>
                      <a:lnTo>
                        <a:pt x="3790" y="1851"/>
                      </a:lnTo>
                      <a:lnTo>
                        <a:pt x="3793" y="1852"/>
                      </a:lnTo>
                      <a:lnTo>
                        <a:pt x="3797" y="1853"/>
                      </a:lnTo>
                      <a:lnTo>
                        <a:pt x="3800" y="1853"/>
                      </a:lnTo>
                      <a:lnTo>
                        <a:pt x="3804" y="1853"/>
                      </a:lnTo>
                      <a:lnTo>
                        <a:pt x="3807" y="1853"/>
                      </a:lnTo>
                      <a:lnTo>
                        <a:pt x="3811" y="1853"/>
                      </a:lnTo>
                      <a:lnTo>
                        <a:pt x="3814" y="1853"/>
                      </a:lnTo>
                      <a:lnTo>
                        <a:pt x="3817" y="1853"/>
                      </a:lnTo>
                      <a:lnTo>
                        <a:pt x="3821" y="1853"/>
                      </a:lnTo>
                      <a:lnTo>
                        <a:pt x="3824" y="1852"/>
                      </a:lnTo>
                      <a:lnTo>
                        <a:pt x="3828" y="1853"/>
                      </a:lnTo>
                      <a:lnTo>
                        <a:pt x="3831" y="1854"/>
                      </a:lnTo>
                      <a:lnTo>
                        <a:pt x="3834" y="1853"/>
                      </a:lnTo>
                      <a:lnTo>
                        <a:pt x="3838" y="1853"/>
                      </a:lnTo>
                      <a:lnTo>
                        <a:pt x="3841" y="1854"/>
                      </a:lnTo>
                      <a:lnTo>
                        <a:pt x="3845" y="1853"/>
                      </a:lnTo>
                      <a:lnTo>
                        <a:pt x="3848" y="1853"/>
                      </a:lnTo>
                      <a:lnTo>
                        <a:pt x="3852" y="1854"/>
                      </a:lnTo>
                      <a:lnTo>
                        <a:pt x="3855" y="1853"/>
                      </a:lnTo>
                      <a:lnTo>
                        <a:pt x="3859" y="1853"/>
                      </a:lnTo>
                      <a:lnTo>
                        <a:pt x="3862" y="1854"/>
                      </a:lnTo>
                      <a:lnTo>
                        <a:pt x="3866" y="1854"/>
                      </a:lnTo>
                      <a:lnTo>
                        <a:pt x="3869" y="1854"/>
                      </a:lnTo>
                      <a:lnTo>
                        <a:pt x="3872" y="1854"/>
                      </a:lnTo>
                      <a:lnTo>
                        <a:pt x="3876" y="1854"/>
                      </a:lnTo>
                      <a:lnTo>
                        <a:pt x="3879" y="1855"/>
                      </a:lnTo>
                      <a:lnTo>
                        <a:pt x="3883" y="1854"/>
                      </a:lnTo>
                      <a:lnTo>
                        <a:pt x="3886" y="1854"/>
                      </a:lnTo>
                      <a:lnTo>
                        <a:pt x="3889" y="1855"/>
                      </a:lnTo>
                      <a:lnTo>
                        <a:pt x="3893" y="1854"/>
                      </a:lnTo>
                      <a:lnTo>
                        <a:pt x="3896" y="1853"/>
                      </a:lnTo>
                      <a:lnTo>
                        <a:pt x="3900" y="1855"/>
                      </a:lnTo>
                      <a:lnTo>
                        <a:pt x="3903" y="1854"/>
                      </a:lnTo>
                      <a:lnTo>
                        <a:pt x="3907" y="1855"/>
                      </a:lnTo>
                      <a:lnTo>
                        <a:pt x="3910" y="1855"/>
                      </a:lnTo>
                      <a:lnTo>
                        <a:pt x="3914" y="1854"/>
                      </a:lnTo>
                      <a:lnTo>
                        <a:pt x="3917" y="1855"/>
                      </a:lnTo>
                      <a:lnTo>
                        <a:pt x="3920" y="1854"/>
                      </a:lnTo>
                      <a:lnTo>
                        <a:pt x="3924" y="1854"/>
                      </a:lnTo>
                      <a:lnTo>
                        <a:pt x="3927" y="1853"/>
                      </a:lnTo>
                      <a:lnTo>
                        <a:pt x="3931" y="1855"/>
                      </a:lnTo>
                      <a:lnTo>
                        <a:pt x="3934" y="1854"/>
                      </a:lnTo>
                      <a:lnTo>
                        <a:pt x="3938" y="1854"/>
                      </a:lnTo>
                      <a:lnTo>
                        <a:pt x="3941" y="1854"/>
                      </a:lnTo>
                      <a:lnTo>
                        <a:pt x="3944" y="1854"/>
                      </a:lnTo>
                      <a:lnTo>
                        <a:pt x="3948" y="1855"/>
                      </a:lnTo>
                      <a:lnTo>
                        <a:pt x="3951" y="1854"/>
                      </a:lnTo>
                      <a:lnTo>
                        <a:pt x="3955" y="1854"/>
                      </a:lnTo>
                      <a:lnTo>
                        <a:pt x="3958" y="1854"/>
                      </a:lnTo>
                      <a:lnTo>
                        <a:pt x="3962" y="1854"/>
                      </a:lnTo>
                      <a:lnTo>
                        <a:pt x="3965" y="1855"/>
                      </a:lnTo>
                      <a:lnTo>
                        <a:pt x="3969" y="1854"/>
                      </a:lnTo>
                      <a:lnTo>
                        <a:pt x="3972" y="1855"/>
                      </a:lnTo>
                      <a:lnTo>
                        <a:pt x="3975" y="1855"/>
                      </a:lnTo>
                      <a:lnTo>
                        <a:pt x="3979" y="1855"/>
                      </a:lnTo>
                      <a:lnTo>
                        <a:pt x="3982" y="1855"/>
                      </a:lnTo>
                      <a:lnTo>
                        <a:pt x="3986" y="1855"/>
                      </a:lnTo>
                      <a:lnTo>
                        <a:pt x="3989" y="1855"/>
                      </a:lnTo>
                      <a:lnTo>
                        <a:pt x="3993" y="1854"/>
                      </a:lnTo>
                      <a:lnTo>
                        <a:pt x="3996" y="1855"/>
                      </a:lnTo>
                      <a:lnTo>
                        <a:pt x="4000" y="1855"/>
                      </a:lnTo>
                      <a:lnTo>
                        <a:pt x="4003" y="1854"/>
                      </a:lnTo>
                      <a:lnTo>
                        <a:pt x="4006" y="1855"/>
                      </a:lnTo>
                      <a:lnTo>
                        <a:pt x="4010" y="1855"/>
                      </a:lnTo>
                      <a:lnTo>
                        <a:pt x="4013" y="1855"/>
                      </a:lnTo>
                      <a:lnTo>
                        <a:pt x="4017" y="1855"/>
                      </a:lnTo>
                      <a:lnTo>
                        <a:pt x="4020" y="1855"/>
                      </a:lnTo>
                      <a:lnTo>
                        <a:pt x="4024" y="1855"/>
                      </a:lnTo>
                      <a:lnTo>
                        <a:pt x="4027" y="1854"/>
                      </a:lnTo>
                      <a:lnTo>
                        <a:pt x="4030" y="1855"/>
                      </a:lnTo>
                      <a:lnTo>
                        <a:pt x="4034" y="1855"/>
                      </a:lnTo>
                      <a:lnTo>
                        <a:pt x="4037" y="1855"/>
                      </a:lnTo>
                      <a:lnTo>
                        <a:pt x="4041" y="1855"/>
                      </a:lnTo>
                      <a:lnTo>
                        <a:pt x="4044" y="1855"/>
                      </a:lnTo>
                      <a:lnTo>
                        <a:pt x="4048" y="1855"/>
                      </a:lnTo>
                      <a:lnTo>
                        <a:pt x="4051" y="1855"/>
                      </a:lnTo>
                      <a:lnTo>
                        <a:pt x="4055" y="1855"/>
                      </a:lnTo>
                      <a:lnTo>
                        <a:pt x="4058" y="1855"/>
                      </a:lnTo>
                      <a:lnTo>
                        <a:pt x="4061" y="1854"/>
                      </a:lnTo>
                      <a:lnTo>
                        <a:pt x="4065" y="1855"/>
                      </a:lnTo>
                      <a:lnTo>
                        <a:pt x="4068" y="1855"/>
                      </a:lnTo>
                      <a:lnTo>
                        <a:pt x="4072" y="1855"/>
                      </a:lnTo>
                      <a:lnTo>
                        <a:pt x="4075" y="1855"/>
                      </a:lnTo>
                      <a:lnTo>
                        <a:pt x="4078" y="1855"/>
                      </a:lnTo>
                      <a:lnTo>
                        <a:pt x="4082" y="1855"/>
                      </a:lnTo>
                      <a:lnTo>
                        <a:pt x="4085" y="1855"/>
                      </a:lnTo>
                      <a:lnTo>
                        <a:pt x="4089" y="1855"/>
                      </a:lnTo>
                      <a:lnTo>
                        <a:pt x="4092" y="1854"/>
                      </a:lnTo>
                      <a:lnTo>
                        <a:pt x="4096" y="1855"/>
                      </a:lnTo>
                      <a:lnTo>
                        <a:pt x="4099" y="1855"/>
                      </a:lnTo>
                      <a:lnTo>
                        <a:pt x="4103" y="1855"/>
                      </a:lnTo>
                      <a:lnTo>
                        <a:pt x="4106" y="1855"/>
                      </a:lnTo>
                      <a:lnTo>
                        <a:pt x="4109" y="1855"/>
                      </a:lnTo>
                      <a:lnTo>
                        <a:pt x="4113" y="1856"/>
                      </a:lnTo>
                      <a:lnTo>
                        <a:pt x="4116" y="1855"/>
                      </a:lnTo>
                      <a:lnTo>
                        <a:pt x="4120" y="1855"/>
                      </a:lnTo>
                      <a:lnTo>
                        <a:pt x="4123" y="1855"/>
                      </a:lnTo>
                      <a:lnTo>
                        <a:pt x="4127" y="1855"/>
                      </a:lnTo>
                      <a:lnTo>
                        <a:pt x="4130" y="1855"/>
                      </a:lnTo>
                      <a:lnTo>
                        <a:pt x="4133" y="1855"/>
                      </a:lnTo>
                      <a:lnTo>
                        <a:pt x="4137" y="1855"/>
                      </a:lnTo>
                      <a:lnTo>
                        <a:pt x="4140" y="1855"/>
                      </a:lnTo>
                      <a:lnTo>
                        <a:pt x="4144" y="1855"/>
                      </a:lnTo>
                      <a:lnTo>
                        <a:pt x="4147" y="1856"/>
                      </a:lnTo>
                      <a:lnTo>
                        <a:pt x="4151" y="1855"/>
                      </a:lnTo>
                      <a:lnTo>
                        <a:pt x="4154" y="1855"/>
                      </a:lnTo>
                      <a:lnTo>
                        <a:pt x="4158" y="1856"/>
                      </a:lnTo>
                      <a:lnTo>
                        <a:pt x="4161" y="1855"/>
                      </a:lnTo>
                      <a:lnTo>
                        <a:pt x="4164" y="1855"/>
                      </a:lnTo>
                      <a:lnTo>
                        <a:pt x="4168" y="1855"/>
                      </a:lnTo>
                      <a:lnTo>
                        <a:pt x="4171" y="1855"/>
                      </a:lnTo>
                      <a:lnTo>
                        <a:pt x="4175" y="1855"/>
                      </a:lnTo>
                      <a:lnTo>
                        <a:pt x="4178" y="1856"/>
                      </a:lnTo>
                      <a:lnTo>
                        <a:pt x="4182" y="1855"/>
                      </a:lnTo>
                      <a:lnTo>
                        <a:pt x="4185" y="1855"/>
                      </a:lnTo>
                      <a:lnTo>
                        <a:pt x="4188" y="1855"/>
                      </a:lnTo>
                      <a:lnTo>
                        <a:pt x="4192" y="1855"/>
                      </a:lnTo>
                      <a:lnTo>
                        <a:pt x="4195" y="1855"/>
                      </a:lnTo>
                      <a:lnTo>
                        <a:pt x="4199" y="1856"/>
                      </a:lnTo>
                      <a:lnTo>
                        <a:pt x="4202" y="1855"/>
                      </a:lnTo>
                      <a:lnTo>
                        <a:pt x="4206" y="1856"/>
                      </a:lnTo>
                      <a:lnTo>
                        <a:pt x="4209" y="1856"/>
                      </a:lnTo>
                      <a:lnTo>
                        <a:pt x="4213" y="1855"/>
                      </a:lnTo>
                      <a:lnTo>
                        <a:pt x="4216" y="1855"/>
                      </a:lnTo>
                      <a:lnTo>
                        <a:pt x="4219" y="1855"/>
                      </a:lnTo>
                      <a:lnTo>
                        <a:pt x="4223" y="1855"/>
                      </a:lnTo>
                      <a:lnTo>
                        <a:pt x="4226" y="1855"/>
                      </a:lnTo>
                      <a:lnTo>
                        <a:pt x="4230" y="1855"/>
                      </a:lnTo>
                      <a:lnTo>
                        <a:pt x="4233" y="1855"/>
                      </a:lnTo>
                      <a:lnTo>
                        <a:pt x="4236" y="1856"/>
                      </a:lnTo>
                      <a:lnTo>
                        <a:pt x="4240" y="1855"/>
                      </a:lnTo>
                      <a:lnTo>
                        <a:pt x="4243" y="1855"/>
                      </a:lnTo>
                      <a:lnTo>
                        <a:pt x="4247" y="1856"/>
                      </a:lnTo>
                      <a:lnTo>
                        <a:pt x="4250" y="1855"/>
                      </a:lnTo>
                      <a:lnTo>
                        <a:pt x="4254" y="1856"/>
                      </a:lnTo>
                      <a:lnTo>
                        <a:pt x="4257" y="1855"/>
                      </a:lnTo>
                      <a:lnTo>
                        <a:pt x="4261" y="1855"/>
                      </a:lnTo>
                      <a:lnTo>
                        <a:pt x="4264" y="1856"/>
                      </a:lnTo>
                      <a:lnTo>
                        <a:pt x="4267" y="1855"/>
                      </a:lnTo>
                      <a:lnTo>
                        <a:pt x="4271" y="1855"/>
                      </a:lnTo>
                      <a:lnTo>
                        <a:pt x="4274" y="1855"/>
                      </a:lnTo>
                      <a:lnTo>
                        <a:pt x="4278" y="1856"/>
                      </a:lnTo>
                      <a:lnTo>
                        <a:pt x="4281" y="1855"/>
                      </a:lnTo>
                      <a:lnTo>
                        <a:pt x="4285" y="1856"/>
                      </a:lnTo>
                      <a:lnTo>
                        <a:pt x="4288" y="1856"/>
                      </a:lnTo>
                      <a:lnTo>
                        <a:pt x="4292" y="1855"/>
                      </a:lnTo>
                      <a:lnTo>
                        <a:pt x="4295" y="1856"/>
                      </a:lnTo>
                      <a:lnTo>
                        <a:pt x="4298" y="1855"/>
                      </a:lnTo>
                      <a:lnTo>
                        <a:pt x="4302" y="1856"/>
                      </a:lnTo>
                      <a:lnTo>
                        <a:pt x="4305" y="1855"/>
                      </a:lnTo>
                      <a:lnTo>
                        <a:pt x="4309" y="1855"/>
                      </a:lnTo>
                      <a:lnTo>
                        <a:pt x="4312" y="1855"/>
                      </a:lnTo>
                      <a:lnTo>
                        <a:pt x="4316" y="1856"/>
                      </a:lnTo>
                      <a:lnTo>
                        <a:pt x="4319" y="1856"/>
                      </a:lnTo>
                      <a:lnTo>
                        <a:pt x="4322" y="1855"/>
                      </a:lnTo>
                      <a:lnTo>
                        <a:pt x="4326" y="1856"/>
                      </a:lnTo>
                      <a:lnTo>
                        <a:pt x="4329" y="1855"/>
                      </a:lnTo>
                      <a:lnTo>
                        <a:pt x="4333" y="1855"/>
                      </a:lnTo>
                      <a:lnTo>
                        <a:pt x="4336" y="1855"/>
                      </a:lnTo>
                      <a:lnTo>
                        <a:pt x="4340" y="1856"/>
                      </a:lnTo>
                      <a:lnTo>
                        <a:pt x="4343" y="1855"/>
                      </a:lnTo>
                      <a:lnTo>
                        <a:pt x="4347" y="1856"/>
                      </a:lnTo>
                      <a:lnTo>
                        <a:pt x="4350" y="1856"/>
                      </a:lnTo>
                      <a:lnTo>
                        <a:pt x="4353" y="1855"/>
                      </a:lnTo>
                      <a:lnTo>
                        <a:pt x="4357" y="1856"/>
                      </a:lnTo>
                      <a:lnTo>
                        <a:pt x="4360" y="1855"/>
                      </a:lnTo>
                      <a:lnTo>
                        <a:pt x="4364" y="1855"/>
                      </a:lnTo>
                      <a:lnTo>
                        <a:pt x="4367" y="1855"/>
                      </a:lnTo>
                      <a:lnTo>
                        <a:pt x="4371" y="1855"/>
                      </a:lnTo>
                      <a:lnTo>
                        <a:pt x="4374" y="1856"/>
                      </a:lnTo>
                      <a:lnTo>
                        <a:pt x="4377" y="1855"/>
                      </a:lnTo>
                      <a:lnTo>
                        <a:pt x="4381" y="1856"/>
                      </a:lnTo>
                      <a:lnTo>
                        <a:pt x="4384" y="1855"/>
                      </a:lnTo>
                      <a:lnTo>
                        <a:pt x="4388" y="1856"/>
                      </a:lnTo>
                      <a:lnTo>
                        <a:pt x="4391" y="1855"/>
                      </a:lnTo>
                      <a:lnTo>
                        <a:pt x="4395" y="1855"/>
                      </a:lnTo>
                      <a:lnTo>
                        <a:pt x="4398" y="1855"/>
                      </a:lnTo>
                      <a:lnTo>
                        <a:pt x="4402" y="1855"/>
                      </a:lnTo>
                      <a:lnTo>
                        <a:pt x="4405" y="1855"/>
                      </a:lnTo>
                      <a:lnTo>
                        <a:pt x="4408" y="1855"/>
                      </a:lnTo>
                      <a:lnTo>
                        <a:pt x="4412" y="1855"/>
                      </a:lnTo>
                      <a:lnTo>
                        <a:pt x="4415" y="1856"/>
                      </a:lnTo>
                      <a:lnTo>
                        <a:pt x="4419" y="1855"/>
                      </a:lnTo>
                      <a:lnTo>
                        <a:pt x="4422" y="1855"/>
                      </a:lnTo>
                      <a:lnTo>
                        <a:pt x="4425" y="1856"/>
                      </a:lnTo>
                      <a:lnTo>
                        <a:pt x="4429" y="1856"/>
                      </a:lnTo>
                      <a:lnTo>
                        <a:pt x="4432" y="1856"/>
                      </a:lnTo>
                      <a:lnTo>
                        <a:pt x="4436" y="1855"/>
                      </a:lnTo>
                      <a:lnTo>
                        <a:pt x="4439" y="1855"/>
                      </a:lnTo>
                      <a:lnTo>
                        <a:pt x="4443" y="1856"/>
                      </a:lnTo>
                      <a:lnTo>
                        <a:pt x="4446" y="1856"/>
                      </a:lnTo>
                      <a:lnTo>
                        <a:pt x="4450" y="1855"/>
                      </a:lnTo>
                      <a:lnTo>
                        <a:pt x="4453" y="1856"/>
                      </a:lnTo>
                      <a:lnTo>
                        <a:pt x="4456" y="1856"/>
                      </a:lnTo>
                      <a:lnTo>
                        <a:pt x="4460" y="1856"/>
                      </a:lnTo>
                      <a:lnTo>
                        <a:pt x="4463" y="1855"/>
                      </a:lnTo>
                      <a:lnTo>
                        <a:pt x="4467" y="1856"/>
                      </a:lnTo>
                      <a:lnTo>
                        <a:pt x="4470" y="1856"/>
                      </a:lnTo>
                      <a:lnTo>
                        <a:pt x="4474" y="1856"/>
                      </a:lnTo>
                      <a:lnTo>
                        <a:pt x="4477" y="1855"/>
                      </a:lnTo>
                      <a:lnTo>
                        <a:pt x="4480" y="1855"/>
                      </a:lnTo>
                      <a:lnTo>
                        <a:pt x="4484" y="1855"/>
                      </a:lnTo>
                      <a:lnTo>
                        <a:pt x="4487" y="1855"/>
                      </a:lnTo>
                      <a:lnTo>
                        <a:pt x="4491" y="1855"/>
                      </a:lnTo>
                      <a:lnTo>
                        <a:pt x="4494" y="1856"/>
                      </a:lnTo>
                      <a:lnTo>
                        <a:pt x="4498" y="1856"/>
                      </a:lnTo>
                      <a:lnTo>
                        <a:pt x="4501" y="1856"/>
                      </a:lnTo>
                      <a:lnTo>
                        <a:pt x="4505" y="1856"/>
                      </a:lnTo>
                      <a:lnTo>
                        <a:pt x="4508" y="1856"/>
                      </a:lnTo>
                      <a:lnTo>
                        <a:pt x="4511" y="1856"/>
                      </a:lnTo>
                      <a:lnTo>
                        <a:pt x="4515" y="1855"/>
                      </a:lnTo>
                      <a:lnTo>
                        <a:pt x="4518" y="1856"/>
                      </a:lnTo>
                      <a:lnTo>
                        <a:pt x="4522" y="1856"/>
                      </a:lnTo>
                      <a:lnTo>
                        <a:pt x="4525" y="1856"/>
                      </a:lnTo>
                      <a:lnTo>
                        <a:pt x="4529" y="1856"/>
                      </a:lnTo>
                      <a:lnTo>
                        <a:pt x="4532" y="1856"/>
                      </a:lnTo>
                      <a:lnTo>
                        <a:pt x="4535" y="1856"/>
                      </a:lnTo>
                      <a:lnTo>
                        <a:pt x="4536" y="1856"/>
                      </a:lnTo>
                    </a:path>
                  </a:pathLst>
                </a:custGeom>
                <a:noFill/>
                <a:ln w="9525" cap="flat" cmpd="sng">
                  <a:solidFill>
                    <a:srgbClr val="000000"/>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rgbClr val="000000"/>
                    </a:solidFill>
                    <a:latin typeface="Arial"/>
                    <a:ea typeface="Arial"/>
                    <a:cs typeface="Arial"/>
                    <a:sym typeface="Arial"/>
                  </a:endParaRPr>
                </a:p>
              </p:txBody>
            </p:sp>
            <p:sp>
              <p:nvSpPr>
                <p:cNvPr id="1564" name="Google Shape;1564;p11"/>
                <p:cNvSpPr/>
                <p:nvPr/>
              </p:nvSpPr>
              <p:spPr>
                <a:xfrm>
                  <a:off x="1431" y="1153"/>
                  <a:ext cx="2" cy="45"/>
                </a:xfrm>
                <a:prstGeom prst="rect">
                  <a:avLst/>
                </a:prstGeom>
                <a:solidFill>
                  <a:srgbClr val="F3F6FF"/>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endParaRPr sz="800" b="0" i="0" u="none" strike="noStrike" cap="none">
                    <a:solidFill>
                      <a:srgbClr val="000000"/>
                    </a:solidFill>
                    <a:latin typeface="Arial"/>
                    <a:ea typeface="Arial"/>
                    <a:cs typeface="Arial"/>
                    <a:sym typeface="Arial"/>
                  </a:endParaRPr>
                </a:p>
              </p:txBody>
            </p:sp>
          </p:grpSp>
          <p:sp>
            <p:nvSpPr>
              <p:cNvPr id="1565" name="Google Shape;1565;p11"/>
              <p:cNvSpPr/>
              <p:nvPr/>
            </p:nvSpPr>
            <p:spPr>
              <a:xfrm>
                <a:off x="8570819" y="3012956"/>
                <a:ext cx="117609" cy="92753"/>
              </a:xfrm>
              <a:prstGeom prst="rect">
                <a:avLst/>
              </a:prstGeom>
              <a:solidFill>
                <a:srgbClr val="0000FF"/>
              </a:solidFill>
              <a:ln w="25400" cap="flat" cmpd="sng">
                <a:solidFill>
                  <a:srgbClr val="0000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800" b="0" i="0" u="none" strike="noStrike" cap="none">
                  <a:solidFill>
                    <a:schemeClr val="lt1"/>
                  </a:solidFill>
                  <a:latin typeface="Arial"/>
                  <a:ea typeface="Arial"/>
                  <a:cs typeface="Arial"/>
                  <a:sym typeface="Arial"/>
                </a:endParaRPr>
              </a:p>
            </p:txBody>
          </p:sp>
          <p:sp>
            <p:nvSpPr>
              <p:cNvPr id="1566" name="Google Shape;1566;p11"/>
              <p:cNvSpPr/>
              <p:nvPr/>
            </p:nvSpPr>
            <p:spPr>
              <a:xfrm>
                <a:off x="8570691" y="2457380"/>
                <a:ext cx="117600" cy="92700"/>
              </a:xfrm>
              <a:prstGeom prst="rect">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800" b="0" i="0" u="none" strike="noStrike" cap="none">
                  <a:solidFill>
                    <a:schemeClr val="dk1"/>
                  </a:solidFill>
                  <a:latin typeface="Arial"/>
                  <a:ea typeface="Arial"/>
                  <a:cs typeface="Arial"/>
                  <a:sym typeface="Arial"/>
                </a:endParaRPr>
              </a:p>
            </p:txBody>
          </p:sp>
          <p:sp>
            <p:nvSpPr>
              <p:cNvPr id="1567" name="Google Shape;1567;p11"/>
              <p:cNvSpPr txBox="1"/>
              <p:nvPr/>
            </p:nvSpPr>
            <p:spPr>
              <a:xfrm>
                <a:off x="8669731" y="2826658"/>
                <a:ext cx="586501" cy="43507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3T</a:t>
                </a:r>
                <a:endParaRPr sz="800" b="0" i="0" u="none" strike="noStrike" cap="none">
                  <a:solidFill>
                    <a:srgbClr val="000000"/>
                  </a:solidFill>
                  <a:latin typeface="Arial"/>
                  <a:ea typeface="Arial"/>
                  <a:cs typeface="Arial"/>
                  <a:sym typeface="Arial"/>
                </a:endParaRPr>
              </a:p>
            </p:txBody>
          </p:sp>
          <p:sp>
            <p:nvSpPr>
              <p:cNvPr id="1568" name="Google Shape;1568;p11"/>
              <p:cNvSpPr txBox="1"/>
              <p:nvPr/>
            </p:nvSpPr>
            <p:spPr>
              <a:xfrm>
                <a:off x="8669730" y="2210807"/>
                <a:ext cx="586501" cy="43507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NT</a:t>
                </a:r>
                <a:endParaRPr sz="800" b="0" i="0" u="none" strike="noStrike" cap="none">
                  <a:solidFill>
                    <a:srgbClr val="000000"/>
                  </a:solidFill>
                  <a:latin typeface="Arial"/>
                  <a:ea typeface="Arial"/>
                  <a:cs typeface="Arial"/>
                  <a:sym typeface="Arial"/>
                </a:endParaRPr>
              </a:p>
            </p:txBody>
          </p:sp>
          <p:sp>
            <p:nvSpPr>
              <p:cNvPr id="1569" name="Google Shape;1569;p11"/>
              <p:cNvSpPr/>
              <p:nvPr/>
            </p:nvSpPr>
            <p:spPr>
              <a:xfrm>
                <a:off x="8566433" y="2716994"/>
                <a:ext cx="117609" cy="92753"/>
              </a:xfrm>
              <a:prstGeom prst="rect">
                <a:avLst/>
              </a:prstGeom>
              <a:solidFill>
                <a:srgbClr val="FF5CFF"/>
              </a:solidFill>
              <a:ln w="25400" cap="flat" cmpd="sng">
                <a:solidFill>
                  <a:srgbClr val="FF5C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800" b="0" i="0" u="none" strike="noStrike" cap="none">
                  <a:solidFill>
                    <a:schemeClr val="lt1"/>
                  </a:solidFill>
                  <a:latin typeface="Arial"/>
                  <a:ea typeface="Arial"/>
                  <a:cs typeface="Arial"/>
                  <a:sym typeface="Arial"/>
                </a:endParaRPr>
              </a:p>
            </p:txBody>
          </p:sp>
          <p:sp>
            <p:nvSpPr>
              <p:cNvPr id="1570" name="Google Shape;1570;p11"/>
              <p:cNvSpPr txBox="1"/>
              <p:nvPr/>
            </p:nvSpPr>
            <p:spPr>
              <a:xfrm>
                <a:off x="8660948" y="2513122"/>
                <a:ext cx="506401" cy="43507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a:solidFill>
                      <a:srgbClr val="000000"/>
                    </a:solidFill>
                    <a:latin typeface="Arial"/>
                    <a:ea typeface="Arial"/>
                    <a:cs typeface="Arial"/>
                    <a:sym typeface="Arial"/>
                  </a:rPr>
                  <a:t>1T</a:t>
                </a:r>
                <a:endParaRPr sz="800" b="0" i="0" u="none" strike="noStrike" cap="none">
                  <a:solidFill>
                    <a:srgbClr val="000000"/>
                  </a:solidFill>
                  <a:latin typeface="Arial"/>
                  <a:ea typeface="Arial"/>
                  <a:cs typeface="Arial"/>
                  <a:sym typeface="Arial"/>
                </a:endParaRPr>
              </a:p>
            </p:txBody>
          </p:sp>
          <p:sp>
            <p:nvSpPr>
              <p:cNvPr id="1573" name="Google Shape;1573;p11"/>
              <p:cNvSpPr txBox="1"/>
              <p:nvPr/>
            </p:nvSpPr>
            <p:spPr>
              <a:xfrm>
                <a:off x="7378407" y="3403914"/>
                <a:ext cx="992100" cy="43507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dirty="0">
                    <a:solidFill>
                      <a:srgbClr val="000000"/>
                    </a:solidFill>
                    <a:latin typeface="Arial"/>
                    <a:ea typeface="Arial"/>
                    <a:cs typeface="Arial"/>
                    <a:sym typeface="Arial"/>
                  </a:rPr>
                  <a:t>dsRNA</a:t>
                </a:r>
                <a:endParaRPr sz="800" b="0" i="0" u="none" strike="noStrike" cap="none" dirty="0">
                  <a:solidFill>
                    <a:srgbClr val="000000"/>
                  </a:solidFill>
                  <a:latin typeface="Arial"/>
                  <a:ea typeface="Arial"/>
                  <a:cs typeface="Arial"/>
                  <a:sym typeface="Arial"/>
                </a:endParaRPr>
              </a:p>
            </p:txBody>
          </p:sp>
          <p:sp>
            <p:nvSpPr>
              <p:cNvPr id="1574" name="Google Shape;1574;p11"/>
              <p:cNvSpPr txBox="1"/>
              <p:nvPr/>
            </p:nvSpPr>
            <p:spPr>
              <a:xfrm>
                <a:off x="5813127" y="1527176"/>
                <a:ext cx="1070100" cy="49174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dirty="0">
                    <a:solidFill>
                      <a:srgbClr val="000000"/>
                    </a:solidFill>
                    <a:latin typeface="Arial"/>
                    <a:ea typeface="Arial"/>
                    <a:cs typeface="Arial"/>
                    <a:sym typeface="Arial"/>
                  </a:rPr>
                  <a:t>23S </a:t>
                </a:r>
                <a:r>
                  <a:rPr lang="en-GB" sz="800" b="0" i="0" u="none" strike="noStrike" cap="none" dirty="0" err="1">
                    <a:solidFill>
                      <a:srgbClr val="000000"/>
                    </a:solidFill>
                    <a:latin typeface="Arial"/>
                    <a:ea typeface="Arial"/>
                    <a:cs typeface="Arial"/>
                    <a:sym typeface="Arial"/>
                  </a:rPr>
                  <a:t>rRNA</a:t>
                </a:r>
                <a:endParaRPr sz="800" b="0" i="0" u="none" strike="noStrike" cap="none" dirty="0">
                  <a:solidFill>
                    <a:srgbClr val="000000"/>
                  </a:solidFill>
                  <a:latin typeface="Arial"/>
                  <a:ea typeface="Arial"/>
                  <a:cs typeface="Arial"/>
                  <a:sym typeface="Arial"/>
                </a:endParaRPr>
              </a:p>
            </p:txBody>
          </p:sp>
          <p:sp>
            <p:nvSpPr>
              <p:cNvPr id="1575" name="Google Shape;1575;p11"/>
              <p:cNvSpPr txBox="1"/>
              <p:nvPr/>
            </p:nvSpPr>
            <p:spPr>
              <a:xfrm>
                <a:off x="5234593" y="1744712"/>
                <a:ext cx="1070100" cy="49174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800" b="0" i="0" u="none" strike="noStrike" cap="none" dirty="0">
                    <a:solidFill>
                      <a:srgbClr val="000000"/>
                    </a:solidFill>
                    <a:latin typeface="Arial"/>
                    <a:ea typeface="Arial"/>
                    <a:cs typeface="Arial"/>
                    <a:sym typeface="Arial"/>
                  </a:rPr>
                  <a:t>16S </a:t>
                </a:r>
                <a:r>
                  <a:rPr lang="en-GB" sz="800" b="0" i="0" u="none" strike="noStrike" cap="none" dirty="0" err="1">
                    <a:solidFill>
                      <a:srgbClr val="000000"/>
                    </a:solidFill>
                    <a:latin typeface="Arial"/>
                    <a:ea typeface="Arial"/>
                    <a:cs typeface="Arial"/>
                    <a:sym typeface="Arial"/>
                  </a:rPr>
                  <a:t>rRNA</a:t>
                </a:r>
                <a:endParaRPr sz="800" b="0" i="0" u="none" strike="noStrike" cap="none" dirty="0">
                  <a:solidFill>
                    <a:srgbClr val="000000"/>
                  </a:solidFill>
                  <a:latin typeface="Arial"/>
                  <a:ea typeface="Arial"/>
                  <a:cs typeface="Arial"/>
                  <a:sym typeface="Arial"/>
                </a:endParaRPr>
              </a:p>
            </p:txBody>
          </p:sp>
        </p:grpSp>
        <p:grpSp>
          <p:nvGrpSpPr>
            <p:cNvPr id="1577" name="Google Shape;1577;p11"/>
            <p:cNvGrpSpPr/>
            <p:nvPr/>
          </p:nvGrpSpPr>
          <p:grpSpPr>
            <a:xfrm>
              <a:off x="381313" y="2572049"/>
              <a:ext cx="6684611" cy="2230789"/>
              <a:chOff x="1897062" y="1954213"/>
              <a:chExt cx="8512175" cy="4238625"/>
            </a:xfrm>
          </p:grpSpPr>
          <p:grpSp>
            <p:nvGrpSpPr>
              <p:cNvPr id="1578" name="Google Shape;1578;p11"/>
              <p:cNvGrpSpPr/>
              <p:nvPr/>
            </p:nvGrpSpPr>
            <p:grpSpPr>
              <a:xfrm>
                <a:off x="1897062" y="1954213"/>
                <a:ext cx="8512175" cy="4238625"/>
                <a:chOff x="1195" y="1231"/>
                <a:chExt cx="5362" cy="2670"/>
              </a:xfrm>
            </p:grpSpPr>
            <p:cxnSp>
              <p:nvCxnSpPr>
                <p:cNvPr id="1579" name="Google Shape;1579;p11"/>
                <p:cNvCxnSpPr/>
                <p:nvPr/>
              </p:nvCxnSpPr>
              <p:spPr>
                <a:xfrm>
                  <a:off x="1434" y="3741"/>
                  <a:ext cx="4964" cy="0"/>
                </a:xfrm>
                <a:prstGeom prst="straightConnector1">
                  <a:avLst/>
                </a:prstGeom>
                <a:noFill/>
                <a:ln w="9525" cap="flat" cmpd="sng">
                  <a:solidFill>
                    <a:srgbClr val="000000"/>
                  </a:solidFill>
                  <a:prstDash val="solid"/>
                  <a:round/>
                  <a:headEnd type="none" w="sm" len="sm"/>
                  <a:tailEnd type="none" w="sm" len="sm"/>
                </a:ln>
              </p:spPr>
            </p:cxnSp>
            <p:cxnSp>
              <p:nvCxnSpPr>
                <p:cNvPr id="1580" name="Google Shape;1580;p11"/>
                <p:cNvCxnSpPr/>
                <p:nvPr/>
              </p:nvCxnSpPr>
              <p:spPr>
                <a:xfrm>
                  <a:off x="1434" y="3741"/>
                  <a:ext cx="0" cy="15"/>
                </a:xfrm>
                <a:prstGeom prst="straightConnector1">
                  <a:avLst/>
                </a:prstGeom>
                <a:noFill/>
                <a:ln w="9525" cap="flat" cmpd="sng">
                  <a:solidFill>
                    <a:srgbClr val="000000"/>
                  </a:solidFill>
                  <a:prstDash val="solid"/>
                  <a:round/>
                  <a:headEnd type="none" w="sm" len="sm"/>
                  <a:tailEnd type="none" w="sm" len="sm"/>
                </a:ln>
              </p:spPr>
            </p:cxnSp>
            <p:sp>
              <p:nvSpPr>
                <p:cNvPr id="1581" name="Google Shape;1581;p11"/>
                <p:cNvSpPr/>
                <p:nvPr/>
              </p:nvSpPr>
              <p:spPr>
                <a:xfrm>
                  <a:off x="1378" y="3754"/>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4.00</a:t>
                  </a:r>
                  <a:endParaRPr sz="800" b="0" i="0" u="none" strike="noStrike" cap="none">
                    <a:solidFill>
                      <a:srgbClr val="000000"/>
                    </a:solidFill>
                    <a:latin typeface="Arial"/>
                    <a:ea typeface="Arial"/>
                    <a:cs typeface="Arial"/>
                    <a:sym typeface="Arial"/>
                  </a:endParaRPr>
                </a:p>
              </p:txBody>
            </p:sp>
            <p:cxnSp>
              <p:nvCxnSpPr>
                <p:cNvPr id="1582" name="Google Shape;1582;p11"/>
                <p:cNvCxnSpPr/>
                <p:nvPr/>
              </p:nvCxnSpPr>
              <p:spPr>
                <a:xfrm>
                  <a:off x="1434" y="3741"/>
                  <a:ext cx="0" cy="15"/>
                </a:xfrm>
                <a:prstGeom prst="straightConnector1">
                  <a:avLst/>
                </a:prstGeom>
                <a:noFill/>
                <a:ln w="9525" cap="flat" cmpd="sng">
                  <a:solidFill>
                    <a:srgbClr val="000000"/>
                  </a:solidFill>
                  <a:prstDash val="solid"/>
                  <a:round/>
                  <a:headEnd type="none" w="sm" len="sm"/>
                  <a:tailEnd type="none" w="sm" len="sm"/>
                </a:ln>
              </p:spPr>
            </p:cxnSp>
            <p:cxnSp>
              <p:nvCxnSpPr>
                <p:cNvPr id="1583" name="Google Shape;1583;p11"/>
                <p:cNvCxnSpPr/>
                <p:nvPr/>
              </p:nvCxnSpPr>
              <p:spPr>
                <a:xfrm>
                  <a:off x="1600" y="3741"/>
                  <a:ext cx="0" cy="9"/>
                </a:xfrm>
                <a:prstGeom prst="straightConnector1">
                  <a:avLst/>
                </a:prstGeom>
                <a:noFill/>
                <a:ln w="9525" cap="flat" cmpd="sng">
                  <a:solidFill>
                    <a:srgbClr val="000000"/>
                  </a:solidFill>
                  <a:prstDash val="solid"/>
                  <a:round/>
                  <a:headEnd type="none" w="sm" len="sm"/>
                  <a:tailEnd type="none" w="sm" len="sm"/>
                </a:ln>
              </p:spPr>
            </p:cxnSp>
            <p:cxnSp>
              <p:nvCxnSpPr>
                <p:cNvPr id="1584" name="Google Shape;1584;p11"/>
                <p:cNvCxnSpPr/>
                <p:nvPr/>
              </p:nvCxnSpPr>
              <p:spPr>
                <a:xfrm>
                  <a:off x="1765" y="3741"/>
                  <a:ext cx="0" cy="9"/>
                </a:xfrm>
                <a:prstGeom prst="straightConnector1">
                  <a:avLst/>
                </a:prstGeom>
                <a:noFill/>
                <a:ln w="9525" cap="flat" cmpd="sng">
                  <a:solidFill>
                    <a:srgbClr val="000000"/>
                  </a:solidFill>
                  <a:prstDash val="solid"/>
                  <a:round/>
                  <a:headEnd type="none" w="sm" len="sm"/>
                  <a:tailEnd type="none" w="sm" len="sm"/>
                </a:ln>
              </p:spPr>
            </p:cxnSp>
            <p:cxnSp>
              <p:nvCxnSpPr>
                <p:cNvPr id="1585" name="Google Shape;1585;p11"/>
                <p:cNvCxnSpPr/>
                <p:nvPr/>
              </p:nvCxnSpPr>
              <p:spPr>
                <a:xfrm>
                  <a:off x="1931" y="3741"/>
                  <a:ext cx="0" cy="9"/>
                </a:xfrm>
                <a:prstGeom prst="straightConnector1">
                  <a:avLst/>
                </a:prstGeom>
                <a:noFill/>
                <a:ln w="9525" cap="flat" cmpd="sng">
                  <a:solidFill>
                    <a:srgbClr val="000000"/>
                  </a:solidFill>
                  <a:prstDash val="solid"/>
                  <a:round/>
                  <a:headEnd type="none" w="sm" len="sm"/>
                  <a:tailEnd type="none" w="sm" len="sm"/>
                </a:ln>
              </p:spPr>
            </p:cxnSp>
            <p:cxnSp>
              <p:nvCxnSpPr>
                <p:cNvPr id="1586" name="Google Shape;1586;p11"/>
                <p:cNvCxnSpPr/>
                <p:nvPr/>
              </p:nvCxnSpPr>
              <p:spPr>
                <a:xfrm>
                  <a:off x="2096" y="3741"/>
                  <a:ext cx="0" cy="15"/>
                </a:xfrm>
                <a:prstGeom prst="straightConnector1">
                  <a:avLst/>
                </a:prstGeom>
                <a:noFill/>
                <a:ln w="9525" cap="flat" cmpd="sng">
                  <a:solidFill>
                    <a:srgbClr val="000000"/>
                  </a:solidFill>
                  <a:prstDash val="solid"/>
                  <a:round/>
                  <a:headEnd type="none" w="sm" len="sm"/>
                  <a:tailEnd type="none" w="sm" len="sm"/>
                </a:ln>
              </p:spPr>
            </p:cxnSp>
            <p:sp>
              <p:nvSpPr>
                <p:cNvPr id="1587" name="Google Shape;1587;p11"/>
                <p:cNvSpPr/>
                <p:nvPr/>
              </p:nvSpPr>
              <p:spPr>
                <a:xfrm>
                  <a:off x="2039" y="3754"/>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5.00</a:t>
                  </a:r>
                  <a:endParaRPr sz="800" b="0" i="0" u="none" strike="noStrike" cap="none">
                    <a:solidFill>
                      <a:srgbClr val="000000"/>
                    </a:solidFill>
                    <a:latin typeface="Arial"/>
                    <a:ea typeface="Arial"/>
                    <a:cs typeface="Arial"/>
                    <a:sym typeface="Arial"/>
                  </a:endParaRPr>
                </a:p>
              </p:txBody>
            </p:sp>
            <p:cxnSp>
              <p:nvCxnSpPr>
                <p:cNvPr id="1588" name="Google Shape;1588;p11"/>
                <p:cNvCxnSpPr/>
                <p:nvPr/>
              </p:nvCxnSpPr>
              <p:spPr>
                <a:xfrm>
                  <a:off x="2262" y="3741"/>
                  <a:ext cx="0" cy="9"/>
                </a:xfrm>
                <a:prstGeom prst="straightConnector1">
                  <a:avLst/>
                </a:prstGeom>
                <a:noFill/>
                <a:ln w="9525" cap="flat" cmpd="sng">
                  <a:solidFill>
                    <a:srgbClr val="000000"/>
                  </a:solidFill>
                  <a:prstDash val="solid"/>
                  <a:round/>
                  <a:headEnd type="none" w="sm" len="sm"/>
                  <a:tailEnd type="none" w="sm" len="sm"/>
                </a:ln>
              </p:spPr>
            </p:cxnSp>
            <p:cxnSp>
              <p:nvCxnSpPr>
                <p:cNvPr id="1589" name="Google Shape;1589;p11"/>
                <p:cNvCxnSpPr/>
                <p:nvPr/>
              </p:nvCxnSpPr>
              <p:spPr>
                <a:xfrm>
                  <a:off x="2427" y="3741"/>
                  <a:ext cx="0" cy="9"/>
                </a:xfrm>
                <a:prstGeom prst="straightConnector1">
                  <a:avLst/>
                </a:prstGeom>
                <a:noFill/>
                <a:ln w="9525" cap="flat" cmpd="sng">
                  <a:solidFill>
                    <a:srgbClr val="000000"/>
                  </a:solidFill>
                  <a:prstDash val="solid"/>
                  <a:round/>
                  <a:headEnd type="none" w="sm" len="sm"/>
                  <a:tailEnd type="none" w="sm" len="sm"/>
                </a:ln>
              </p:spPr>
            </p:cxnSp>
            <p:cxnSp>
              <p:nvCxnSpPr>
                <p:cNvPr id="1590" name="Google Shape;1590;p11"/>
                <p:cNvCxnSpPr/>
                <p:nvPr/>
              </p:nvCxnSpPr>
              <p:spPr>
                <a:xfrm>
                  <a:off x="2593" y="3741"/>
                  <a:ext cx="0" cy="9"/>
                </a:xfrm>
                <a:prstGeom prst="straightConnector1">
                  <a:avLst/>
                </a:prstGeom>
                <a:noFill/>
                <a:ln w="9525" cap="flat" cmpd="sng">
                  <a:solidFill>
                    <a:srgbClr val="000000"/>
                  </a:solidFill>
                  <a:prstDash val="solid"/>
                  <a:round/>
                  <a:headEnd type="none" w="sm" len="sm"/>
                  <a:tailEnd type="none" w="sm" len="sm"/>
                </a:ln>
              </p:spPr>
            </p:cxnSp>
            <p:cxnSp>
              <p:nvCxnSpPr>
                <p:cNvPr id="1591" name="Google Shape;1591;p11"/>
                <p:cNvCxnSpPr/>
                <p:nvPr/>
              </p:nvCxnSpPr>
              <p:spPr>
                <a:xfrm>
                  <a:off x="2758" y="3741"/>
                  <a:ext cx="0" cy="15"/>
                </a:xfrm>
                <a:prstGeom prst="straightConnector1">
                  <a:avLst/>
                </a:prstGeom>
                <a:noFill/>
                <a:ln w="9525" cap="flat" cmpd="sng">
                  <a:solidFill>
                    <a:srgbClr val="000000"/>
                  </a:solidFill>
                  <a:prstDash val="solid"/>
                  <a:round/>
                  <a:headEnd type="none" w="sm" len="sm"/>
                  <a:tailEnd type="none" w="sm" len="sm"/>
                </a:ln>
              </p:spPr>
            </p:cxnSp>
            <p:sp>
              <p:nvSpPr>
                <p:cNvPr id="1592" name="Google Shape;1592;p11"/>
                <p:cNvSpPr/>
                <p:nvPr/>
              </p:nvSpPr>
              <p:spPr>
                <a:xfrm>
                  <a:off x="2702" y="3754"/>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6.00</a:t>
                  </a:r>
                  <a:endParaRPr sz="800" b="0" i="0" u="none" strike="noStrike" cap="none">
                    <a:solidFill>
                      <a:srgbClr val="000000"/>
                    </a:solidFill>
                    <a:latin typeface="Arial"/>
                    <a:ea typeface="Arial"/>
                    <a:cs typeface="Arial"/>
                    <a:sym typeface="Arial"/>
                  </a:endParaRPr>
                </a:p>
              </p:txBody>
            </p:sp>
            <p:cxnSp>
              <p:nvCxnSpPr>
                <p:cNvPr id="1593" name="Google Shape;1593;p11"/>
                <p:cNvCxnSpPr/>
                <p:nvPr/>
              </p:nvCxnSpPr>
              <p:spPr>
                <a:xfrm>
                  <a:off x="2923" y="3741"/>
                  <a:ext cx="0" cy="9"/>
                </a:xfrm>
                <a:prstGeom prst="straightConnector1">
                  <a:avLst/>
                </a:prstGeom>
                <a:noFill/>
                <a:ln w="9525" cap="flat" cmpd="sng">
                  <a:solidFill>
                    <a:srgbClr val="000000"/>
                  </a:solidFill>
                  <a:prstDash val="solid"/>
                  <a:round/>
                  <a:headEnd type="none" w="sm" len="sm"/>
                  <a:tailEnd type="none" w="sm" len="sm"/>
                </a:ln>
              </p:spPr>
            </p:cxnSp>
            <p:cxnSp>
              <p:nvCxnSpPr>
                <p:cNvPr id="1594" name="Google Shape;1594;p11"/>
                <p:cNvCxnSpPr/>
                <p:nvPr/>
              </p:nvCxnSpPr>
              <p:spPr>
                <a:xfrm>
                  <a:off x="3089" y="3741"/>
                  <a:ext cx="0" cy="9"/>
                </a:xfrm>
                <a:prstGeom prst="straightConnector1">
                  <a:avLst/>
                </a:prstGeom>
                <a:noFill/>
                <a:ln w="9525" cap="flat" cmpd="sng">
                  <a:solidFill>
                    <a:srgbClr val="000000"/>
                  </a:solidFill>
                  <a:prstDash val="solid"/>
                  <a:round/>
                  <a:headEnd type="none" w="sm" len="sm"/>
                  <a:tailEnd type="none" w="sm" len="sm"/>
                </a:ln>
              </p:spPr>
            </p:cxnSp>
            <p:cxnSp>
              <p:nvCxnSpPr>
                <p:cNvPr id="1595" name="Google Shape;1595;p11"/>
                <p:cNvCxnSpPr/>
                <p:nvPr/>
              </p:nvCxnSpPr>
              <p:spPr>
                <a:xfrm>
                  <a:off x="3254" y="3741"/>
                  <a:ext cx="0" cy="9"/>
                </a:xfrm>
                <a:prstGeom prst="straightConnector1">
                  <a:avLst/>
                </a:prstGeom>
                <a:noFill/>
                <a:ln w="9525" cap="flat" cmpd="sng">
                  <a:solidFill>
                    <a:srgbClr val="000000"/>
                  </a:solidFill>
                  <a:prstDash val="solid"/>
                  <a:round/>
                  <a:headEnd type="none" w="sm" len="sm"/>
                  <a:tailEnd type="none" w="sm" len="sm"/>
                </a:ln>
              </p:spPr>
            </p:cxnSp>
            <p:cxnSp>
              <p:nvCxnSpPr>
                <p:cNvPr id="1596" name="Google Shape;1596;p11"/>
                <p:cNvCxnSpPr/>
                <p:nvPr/>
              </p:nvCxnSpPr>
              <p:spPr>
                <a:xfrm>
                  <a:off x="3420" y="3741"/>
                  <a:ext cx="0" cy="15"/>
                </a:xfrm>
                <a:prstGeom prst="straightConnector1">
                  <a:avLst/>
                </a:prstGeom>
                <a:noFill/>
                <a:ln w="9525" cap="flat" cmpd="sng">
                  <a:solidFill>
                    <a:srgbClr val="000000"/>
                  </a:solidFill>
                  <a:prstDash val="solid"/>
                  <a:round/>
                  <a:headEnd type="none" w="sm" len="sm"/>
                  <a:tailEnd type="none" w="sm" len="sm"/>
                </a:ln>
              </p:spPr>
            </p:cxnSp>
            <p:sp>
              <p:nvSpPr>
                <p:cNvPr id="1597" name="Google Shape;1597;p11"/>
                <p:cNvSpPr/>
                <p:nvPr/>
              </p:nvSpPr>
              <p:spPr>
                <a:xfrm>
                  <a:off x="3362" y="3754"/>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7.00</a:t>
                  </a:r>
                  <a:endParaRPr sz="800" b="0" i="0" u="none" strike="noStrike" cap="none">
                    <a:solidFill>
                      <a:srgbClr val="000000"/>
                    </a:solidFill>
                    <a:latin typeface="Arial"/>
                    <a:ea typeface="Arial"/>
                    <a:cs typeface="Arial"/>
                    <a:sym typeface="Arial"/>
                  </a:endParaRPr>
                </a:p>
              </p:txBody>
            </p:sp>
            <p:cxnSp>
              <p:nvCxnSpPr>
                <p:cNvPr id="1598" name="Google Shape;1598;p11"/>
                <p:cNvCxnSpPr/>
                <p:nvPr/>
              </p:nvCxnSpPr>
              <p:spPr>
                <a:xfrm>
                  <a:off x="3585" y="3741"/>
                  <a:ext cx="0" cy="9"/>
                </a:xfrm>
                <a:prstGeom prst="straightConnector1">
                  <a:avLst/>
                </a:prstGeom>
                <a:noFill/>
                <a:ln w="9525" cap="flat" cmpd="sng">
                  <a:solidFill>
                    <a:srgbClr val="000000"/>
                  </a:solidFill>
                  <a:prstDash val="solid"/>
                  <a:round/>
                  <a:headEnd type="none" w="sm" len="sm"/>
                  <a:tailEnd type="none" w="sm" len="sm"/>
                </a:ln>
              </p:spPr>
            </p:cxnSp>
            <p:cxnSp>
              <p:nvCxnSpPr>
                <p:cNvPr id="1599" name="Google Shape;1599;p11"/>
                <p:cNvCxnSpPr/>
                <p:nvPr/>
              </p:nvCxnSpPr>
              <p:spPr>
                <a:xfrm>
                  <a:off x="3751" y="3741"/>
                  <a:ext cx="0" cy="9"/>
                </a:xfrm>
                <a:prstGeom prst="straightConnector1">
                  <a:avLst/>
                </a:prstGeom>
                <a:noFill/>
                <a:ln w="9525" cap="flat" cmpd="sng">
                  <a:solidFill>
                    <a:srgbClr val="000000"/>
                  </a:solidFill>
                  <a:prstDash val="solid"/>
                  <a:round/>
                  <a:headEnd type="none" w="sm" len="sm"/>
                  <a:tailEnd type="none" w="sm" len="sm"/>
                </a:ln>
              </p:spPr>
            </p:cxnSp>
            <p:cxnSp>
              <p:nvCxnSpPr>
                <p:cNvPr id="1600" name="Google Shape;1600;p11"/>
                <p:cNvCxnSpPr/>
                <p:nvPr/>
              </p:nvCxnSpPr>
              <p:spPr>
                <a:xfrm>
                  <a:off x="3916" y="3741"/>
                  <a:ext cx="0" cy="9"/>
                </a:xfrm>
                <a:prstGeom prst="straightConnector1">
                  <a:avLst/>
                </a:prstGeom>
                <a:noFill/>
                <a:ln w="9525" cap="flat" cmpd="sng">
                  <a:solidFill>
                    <a:srgbClr val="000000"/>
                  </a:solidFill>
                  <a:prstDash val="solid"/>
                  <a:round/>
                  <a:headEnd type="none" w="sm" len="sm"/>
                  <a:tailEnd type="none" w="sm" len="sm"/>
                </a:ln>
              </p:spPr>
            </p:cxnSp>
            <p:cxnSp>
              <p:nvCxnSpPr>
                <p:cNvPr id="1601" name="Google Shape;1601;p11"/>
                <p:cNvCxnSpPr/>
                <p:nvPr/>
              </p:nvCxnSpPr>
              <p:spPr>
                <a:xfrm>
                  <a:off x="4082" y="3741"/>
                  <a:ext cx="0" cy="15"/>
                </a:xfrm>
                <a:prstGeom prst="straightConnector1">
                  <a:avLst/>
                </a:prstGeom>
                <a:noFill/>
                <a:ln w="9525" cap="flat" cmpd="sng">
                  <a:solidFill>
                    <a:srgbClr val="000000"/>
                  </a:solidFill>
                  <a:prstDash val="solid"/>
                  <a:round/>
                  <a:headEnd type="none" w="sm" len="sm"/>
                  <a:tailEnd type="none" w="sm" len="sm"/>
                </a:ln>
              </p:spPr>
            </p:cxnSp>
            <p:sp>
              <p:nvSpPr>
                <p:cNvPr id="1602" name="Google Shape;1602;p11"/>
                <p:cNvSpPr/>
                <p:nvPr/>
              </p:nvSpPr>
              <p:spPr>
                <a:xfrm>
                  <a:off x="4026" y="3754"/>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8.00</a:t>
                  </a:r>
                  <a:endParaRPr sz="800" b="0" i="0" u="none" strike="noStrike" cap="none">
                    <a:solidFill>
                      <a:srgbClr val="000000"/>
                    </a:solidFill>
                    <a:latin typeface="Arial"/>
                    <a:ea typeface="Arial"/>
                    <a:cs typeface="Arial"/>
                    <a:sym typeface="Arial"/>
                  </a:endParaRPr>
                </a:p>
              </p:txBody>
            </p:sp>
            <p:cxnSp>
              <p:nvCxnSpPr>
                <p:cNvPr id="1603" name="Google Shape;1603;p11"/>
                <p:cNvCxnSpPr/>
                <p:nvPr/>
              </p:nvCxnSpPr>
              <p:spPr>
                <a:xfrm>
                  <a:off x="4247" y="3741"/>
                  <a:ext cx="0" cy="9"/>
                </a:xfrm>
                <a:prstGeom prst="straightConnector1">
                  <a:avLst/>
                </a:prstGeom>
                <a:noFill/>
                <a:ln w="9525" cap="flat" cmpd="sng">
                  <a:solidFill>
                    <a:srgbClr val="000000"/>
                  </a:solidFill>
                  <a:prstDash val="solid"/>
                  <a:round/>
                  <a:headEnd type="none" w="sm" len="sm"/>
                  <a:tailEnd type="none" w="sm" len="sm"/>
                </a:ln>
              </p:spPr>
            </p:cxnSp>
            <p:cxnSp>
              <p:nvCxnSpPr>
                <p:cNvPr id="1604" name="Google Shape;1604;p11"/>
                <p:cNvCxnSpPr/>
                <p:nvPr/>
              </p:nvCxnSpPr>
              <p:spPr>
                <a:xfrm>
                  <a:off x="4412" y="3741"/>
                  <a:ext cx="0" cy="9"/>
                </a:xfrm>
                <a:prstGeom prst="straightConnector1">
                  <a:avLst/>
                </a:prstGeom>
                <a:noFill/>
                <a:ln w="9525" cap="flat" cmpd="sng">
                  <a:solidFill>
                    <a:srgbClr val="000000"/>
                  </a:solidFill>
                  <a:prstDash val="solid"/>
                  <a:round/>
                  <a:headEnd type="none" w="sm" len="sm"/>
                  <a:tailEnd type="none" w="sm" len="sm"/>
                </a:ln>
              </p:spPr>
            </p:cxnSp>
            <p:cxnSp>
              <p:nvCxnSpPr>
                <p:cNvPr id="1605" name="Google Shape;1605;p11"/>
                <p:cNvCxnSpPr/>
                <p:nvPr/>
              </p:nvCxnSpPr>
              <p:spPr>
                <a:xfrm>
                  <a:off x="4578" y="3741"/>
                  <a:ext cx="0" cy="9"/>
                </a:xfrm>
                <a:prstGeom prst="straightConnector1">
                  <a:avLst/>
                </a:prstGeom>
                <a:noFill/>
                <a:ln w="9525" cap="flat" cmpd="sng">
                  <a:solidFill>
                    <a:srgbClr val="000000"/>
                  </a:solidFill>
                  <a:prstDash val="solid"/>
                  <a:round/>
                  <a:headEnd type="none" w="sm" len="sm"/>
                  <a:tailEnd type="none" w="sm" len="sm"/>
                </a:ln>
              </p:spPr>
            </p:cxnSp>
            <p:cxnSp>
              <p:nvCxnSpPr>
                <p:cNvPr id="1606" name="Google Shape;1606;p11"/>
                <p:cNvCxnSpPr/>
                <p:nvPr/>
              </p:nvCxnSpPr>
              <p:spPr>
                <a:xfrm>
                  <a:off x="4743" y="3741"/>
                  <a:ext cx="0" cy="15"/>
                </a:xfrm>
                <a:prstGeom prst="straightConnector1">
                  <a:avLst/>
                </a:prstGeom>
                <a:noFill/>
                <a:ln w="9525" cap="flat" cmpd="sng">
                  <a:solidFill>
                    <a:srgbClr val="000000"/>
                  </a:solidFill>
                  <a:prstDash val="solid"/>
                  <a:round/>
                  <a:headEnd type="none" w="sm" len="sm"/>
                  <a:tailEnd type="none" w="sm" len="sm"/>
                </a:ln>
              </p:spPr>
            </p:cxnSp>
            <p:sp>
              <p:nvSpPr>
                <p:cNvPr id="1607" name="Google Shape;1607;p11"/>
                <p:cNvSpPr/>
                <p:nvPr/>
              </p:nvSpPr>
              <p:spPr>
                <a:xfrm>
                  <a:off x="4686" y="3754"/>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9.00</a:t>
                  </a:r>
                  <a:endParaRPr sz="800" b="0" i="0" u="none" strike="noStrike" cap="none">
                    <a:solidFill>
                      <a:srgbClr val="000000"/>
                    </a:solidFill>
                    <a:latin typeface="Arial"/>
                    <a:ea typeface="Arial"/>
                    <a:cs typeface="Arial"/>
                    <a:sym typeface="Arial"/>
                  </a:endParaRPr>
                </a:p>
              </p:txBody>
            </p:sp>
            <p:cxnSp>
              <p:nvCxnSpPr>
                <p:cNvPr id="1608" name="Google Shape;1608;p11"/>
                <p:cNvCxnSpPr/>
                <p:nvPr/>
              </p:nvCxnSpPr>
              <p:spPr>
                <a:xfrm>
                  <a:off x="4909" y="3741"/>
                  <a:ext cx="0" cy="9"/>
                </a:xfrm>
                <a:prstGeom prst="straightConnector1">
                  <a:avLst/>
                </a:prstGeom>
                <a:noFill/>
                <a:ln w="9525" cap="flat" cmpd="sng">
                  <a:solidFill>
                    <a:srgbClr val="000000"/>
                  </a:solidFill>
                  <a:prstDash val="solid"/>
                  <a:round/>
                  <a:headEnd type="none" w="sm" len="sm"/>
                  <a:tailEnd type="none" w="sm" len="sm"/>
                </a:ln>
              </p:spPr>
            </p:cxnSp>
            <p:cxnSp>
              <p:nvCxnSpPr>
                <p:cNvPr id="1609" name="Google Shape;1609;p11"/>
                <p:cNvCxnSpPr/>
                <p:nvPr/>
              </p:nvCxnSpPr>
              <p:spPr>
                <a:xfrm>
                  <a:off x="5074" y="3741"/>
                  <a:ext cx="0" cy="9"/>
                </a:xfrm>
                <a:prstGeom prst="straightConnector1">
                  <a:avLst/>
                </a:prstGeom>
                <a:noFill/>
                <a:ln w="9525" cap="flat" cmpd="sng">
                  <a:solidFill>
                    <a:srgbClr val="000000"/>
                  </a:solidFill>
                  <a:prstDash val="solid"/>
                  <a:round/>
                  <a:headEnd type="none" w="sm" len="sm"/>
                  <a:tailEnd type="none" w="sm" len="sm"/>
                </a:ln>
              </p:spPr>
            </p:cxnSp>
            <p:cxnSp>
              <p:nvCxnSpPr>
                <p:cNvPr id="1610" name="Google Shape;1610;p11"/>
                <p:cNvCxnSpPr/>
                <p:nvPr/>
              </p:nvCxnSpPr>
              <p:spPr>
                <a:xfrm>
                  <a:off x="5240" y="3741"/>
                  <a:ext cx="0" cy="9"/>
                </a:xfrm>
                <a:prstGeom prst="straightConnector1">
                  <a:avLst/>
                </a:prstGeom>
                <a:noFill/>
                <a:ln w="9525" cap="flat" cmpd="sng">
                  <a:solidFill>
                    <a:srgbClr val="000000"/>
                  </a:solidFill>
                  <a:prstDash val="solid"/>
                  <a:round/>
                  <a:headEnd type="none" w="sm" len="sm"/>
                  <a:tailEnd type="none" w="sm" len="sm"/>
                </a:ln>
              </p:spPr>
            </p:cxnSp>
            <p:cxnSp>
              <p:nvCxnSpPr>
                <p:cNvPr id="1611" name="Google Shape;1611;p11"/>
                <p:cNvCxnSpPr/>
                <p:nvPr/>
              </p:nvCxnSpPr>
              <p:spPr>
                <a:xfrm>
                  <a:off x="5405" y="3741"/>
                  <a:ext cx="0" cy="15"/>
                </a:xfrm>
                <a:prstGeom prst="straightConnector1">
                  <a:avLst/>
                </a:prstGeom>
                <a:noFill/>
                <a:ln w="9525" cap="flat" cmpd="sng">
                  <a:solidFill>
                    <a:srgbClr val="000000"/>
                  </a:solidFill>
                  <a:prstDash val="solid"/>
                  <a:round/>
                  <a:headEnd type="none" w="sm" len="sm"/>
                  <a:tailEnd type="none" w="sm" len="sm"/>
                </a:ln>
              </p:spPr>
            </p:cxnSp>
            <p:sp>
              <p:nvSpPr>
                <p:cNvPr id="1612" name="Google Shape;1612;p11"/>
                <p:cNvSpPr/>
                <p:nvPr/>
              </p:nvSpPr>
              <p:spPr>
                <a:xfrm>
                  <a:off x="5333" y="3754"/>
                  <a:ext cx="230"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10.00</a:t>
                  </a:r>
                  <a:endParaRPr sz="800" b="0" i="0" u="none" strike="noStrike" cap="none">
                    <a:solidFill>
                      <a:srgbClr val="000000"/>
                    </a:solidFill>
                    <a:latin typeface="Arial"/>
                    <a:ea typeface="Arial"/>
                    <a:cs typeface="Arial"/>
                    <a:sym typeface="Arial"/>
                  </a:endParaRPr>
                </a:p>
              </p:txBody>
            </p:sp>
            <p:cxnSp>
              <p:nvCxnSpPr>
                <p:cNvPr id="1613" name="Google Shape;1613;p11"/>
                <p:cNvCxnSpPr/>
                <p:nvPr/>
              </p:nvCxnSpPr>
              <p:spPr>
                <a:xfrm>
                  <a:off x="5571" y="3741"/>
                  <a:ext cx="0" cy="9"/>
                </a:xfrm>
                <a:prstGeom prst="straightConnector1">
                  <a:avLst/>
                </a:prstGeom>
                <a:noFill/>
                <a:ln w="9525" cap="flat" cmpd="sng">
                  <a:solidFill>
                    <a:srgbClr val="000000"/>
                  </a:solidFill>
                  <a:prstDash val="solid"/>
                  <a:round/>
                  <a:headEnd type="none" w="sm" len="sm"/>
                  <a:tailEnd type="none" w="sm" len="sm"/>
                </a:ln>
              </p:spPr>
            </p:cxnSp>
            <p:cxnSp>
              <p:nvCxnSpPr>
                <p:cNvPr id="1614" name="Google Shape;1614;p11"/>
                <p:cNvCxnSpPr/>
                <p:nvPr/>
              </p:nvCxnSpPr>
              <p:spPr>
                <a:xfrm>
                  <a:off x="5736" y="3741"/>
                  <a:ext cx="0" cy="9"/>
                </a:xfrm>
                <a:prstGeom prst="straightConnector1">
                  <a:avLst/>
                </a:prstGeom>
                <a:noFill/>
                <a:ln w="9525" cap="flat" cmpd="sng">
                  <a:solidFill>
                    <a:srgbClr val="000000"/>
                  </a:solidFill>
                  <a:prstDash val="solid"/>
                  <a:round/>
                  <a:headEnd type="none" w="sm" len="sm"/>
                  <a:tailEnd type="none" w="sm" len="sm"/>
                </a:ln>
              </p:spPr>
            </p:cxnSp>
            <p:cxnSp>
              <p:nvCxnSpPr>
                <p:cNvPr id="1615" name="Google Shape;1615;p11"/>
                <p:cNvCxnSpPr/>
                <p:nvPr/>
              </p:nvCxnSpPr>
              <p:spPr>
                <a:xfrm>
                  <a:off x="5901" y="3741"/>
                  <a:ext cx="0" cy="9"/>
                </a:xfrm>
                <a:prstGeom prst="straightConnector1">
                  <a:avLst/>
                </a:prstGeom>
                <a:noFill/>
                <a:ln w="9525" cap="flat" cmpd="sng">
                  <a:solidFill>
                    <a:srgbClr val="000000"/>
                  </a:solidFill>
                  <a:prstDash val="solid"/>
                  <a:round/>
                  <a:headEnd type="none" w="sm" len="sm"/>
                  <a:tailEnd type="none" w="sm" len="sm"/>
                </a:ln>
              </p:spPr>
            </p:cxnSp>
            <p:cxnSp>
              <p:nvCxnSpPr>
                <p:cNvPr id="1616" name="Google Shape;1616;p11"/>
                <p:cNvCxnSpPr/>
                <p:nvPr/>
              </p:nvCxnSpPr>
              <p:spPr>
                <a:xfrm>
                  <a:off x="6067" y="3741"/>
                  <a:ext cx="0" cy="15"/>
                </a:xfrm>
                <a:prstGeom prst="straightConnector1">
                  <a:avLst/>
                </a:prstGeom>
                <a:noFill/>
                <a:ln w="9525" cap="flat" cmpd="sng">
                  <a:solidFill>
                    <a:srgbClr val="000000"/>
                  </a:solidFill>
                  <a:prstDash val="solid"/>
                  <a:round/>
                  <a:headEnd type="none" w="sm" len="sm"/>
                  <a:tailEnd type="none" w="sm" len="sm"/>
                </a:ln>
              </p:spPr>
            </p:cxnSp>
            <p:sp>
              <p:nvSpPr>
                <p:cNvPr id="1617" name="Google Shape;1617;p11"/>
                <p:cNvSpPr/>
                <p:nvPr/>
              </p:nvSpPr>
              <p:spPr>
                <a:xfrm>
                  <a:off x="5997" y="3754"/>
                  <a:ext cx="230"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11.00</a:t>
                  </a:r>
                  <a:endParaRPr sz="800" b="0" i="0" u="none" strike="noStrike" cap="none">
                    <a:solidFill>
                      <a:srgbClr val="000000"/>
                    </a:solidFill>
                    <a:latin typeface="Arial"/>
                    <a:ea typeface="Arial"/>
                    <a:cs typeface="Arial"/>
                    <a:sym typeface="Arial"/>
                  </a:endParaRPr>
                </a:p>
              </p:txBody>
            </p:sp>
            <p:cxnSp>
              <p:nvCxnSpPr>
                <p:cNvPr id="1618" name="Google Shape;1618;p11"/>
                <p:cNvCxnSpPr/>
                <p:nvPr/>
              </p:nvCxnSpPr>
              <p:spPr>
                <a:xfrm>
                  <a:off x="6232" y="3741"/>
                  <a:ext cx="0" cy="9"/>
                </a:xfrm>
                <a:prstGeom prst="straightConnector1">
                  <a:avLst/>
                </a:prstGeom>
                <a:noFill/>
                <a:ln w="9525" cap="flat" cmpd="sng">
                  <a:solidFill>
                    <a:srgbClr val="000000"/>
                  </a:solidFill>
                  <a:prstDash val="solid"/>
                  <a:round/>
                  <a:headEnd type="none" w="sm" len="sm"/>
                  <a:tailEnd type="none" w="sm" len="sm"/>
                </a:ln>
              </p:spPr>
            </p:cxnSp>
            <p:cxnSp>
              <p:nvCxnSpPr>
                <p:cNvPr id="1619" name="Google Shape;1619;p11"/>
                <p:cNvCxnSpPr/>
                <p:nvPr/>
              </p:nvCxnSpPr>
              <p:spPr>
                <a:xfrm>
                  <a:off x="6398" y="3741"/>
                  <a:ext cx="0" cy="15"/>
                </a:xfrm>
                <a:prstGeom prst="straightConnector1">
                  <a:avLst/>
                </a:prstGeom>
                <a:noFill/>
                <a:ln w="9525" cap="flat" cmpd="sng">
                  <a:solidFill>
                    <a:srgbClr val="000000"/>
                  </a:solidFill>
                  <a:prstDash val="solid"/>
                  <a:round/>
                  <a:headEnd type="none" w="sm" len="sm"/>
                  <a:tailEnd type="none" w="sm" len="sm"/>
                </a:ln>
              </p:spPr>
            </p:cxnSp>
            <p:sp>
              <p:nvSpPr>
                <p:cNvPr id="1620" name="Google Shape;1620;p11"/>
                <p:cNvSpPr/>
                <p:nvPr/>
              </p:nvSpPr>
              <p:spPr>
                <a:xfrm>
                  <a:off x="6327" y="3754"/>
                  <a:ext cx="230"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11.50</a:t>
                  </a:r>
                  <a:endParaRPr sz="800" b="0" i="0" u="none" strike="noStrike" cap="none">
                    <a:solidFill>
                      <a:srgbClr val="000000"/>
                    </a:solidFill>
                    <a:latin typeface="Arial"/>
                    <a:ea typeface="Arial"/>
                    <a:cs typeface="Arial"/>
                    <a:sym typeface="Arial"/>
                  </a:endParaRPr>
                </a:p>
              </p:txBody>
            </p:sp>
            <p:cxnSp>
              <p:nvCxnSpPr>
                <p:cNvPr id="1621" name="Google Shape;1621;p11"/>
                <p:cNvCxnSpPr/>
                <p:nvPr/>
              </p:nvCxnSpPr>
              <p:spPr>
                <a:xfrm>
                  <a:off x="1422" y="1286"/>
                  <a:ext cx="0" cy="2443"/>
                </a:xfrm>
                <a:prstGeom prst="straightConnector1">
                  <a:avLst/>
                </a:prstGeom>
                <a:noFill/>
                <a:ln w="9525" cap="flat" cmpd="sng">
                  <a:solidFill>
                    <a:srgbClr val="000000"/>
                  </a:solidFill>
                  <a:prstDash val="solid"/>
                  <a:round/>
                  <a:headEnd type="none" w="sm" len="sm"/>
                  <a:tailEnd type="none" w="sm" len="sm"/>
                </a:ln>
              </p:spPr>
            </p:cxnSp>
            <p:cxnSp>
              <p:nvCxnSpPr>
                <p:cNvPr id="1622" name="Google Shape;1622;p11"/>
                <p:cNvCxnSpPr/>
                <p:nvPr/>
              </p:nvCxnSpPr>
              <p:spPr>
                <a:xfrm rot="10800000">
                  <a:off x="1407" y="3729"/>
                  <a:ext cx="15" cy="0"/>
                </a:xfrm>
                <a:prstGeom prst="straightConnector1">
                  <a:avLst/>
                </a:prstGeom>
                <a:noFill/>
                <a:ln w="9525" cap="flat" cmpd="sng">
                  <a:solidFill>
                    <a:srgbClr val="000000"/>
                  </a:solidFill>
                  <a:prstDash val="solid"/>
                  <a:round/>
                  <a:headEnd type="none" w="sm" len="sm"/>
                  <a:tailEnd type="none" w="sm" len="sm"/>
                </a:ln>
              </p:spPr>
            </p:cxnSp>
            <p:sp>
              <p:nvSpPr>
                <p:cNvPr id="1623" name="Google Shape;1623;p11"/>
                <p:cNvSpPr/>
                <p:nvPr/>
              </p:nvSpPr>
              <p:spPr>
                <a:xfrm>
                  <a:off x="1243" y="3674"/>
                  <a:ext cx="15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dirty="0">
                      <a:solidFill>
                        <a:schemeClr val="dk1"/>
                      </a:solidFill>
                      <a:latin typeface="Arial"/>
                      <a:ea typeface="Arial"/>
                      <a:cs typeface="Arial"/>
                      <a:sym typeface="Arial"/>
                    </a:rPr>
                    <a:t>-5.0</a:t>
                  </a:r>
                  <a:endParaRPr sz="800" b="0" i="0" u="none" strike="noStrike" cap="none" dirty="0">
                    <a:solidFill>
                      <a:srgbClr val="000000"/>
                    </a:solidFill>
                    <a:latin typeface="Arial"/>
                    <a:ea typeface="Arial"/>
                    <a:cs typeface="Arial"/>
                    <a:sym typeface="Arial"/>
                  </a:endParaRPr>
                </a:p>
              </p:txBody>
            </p:sp>
            <p:cxnSp>
              <p:nvCxnSpPr>
                <p:cNvPr id="1624" name="Google Shape;1624;p11"/>
                <p:cNvCxnSpPr/>
                <p:nvPr/>
              </p:nvCxnSpPr>
              <p:spPr>
                <a:xfrm rot="10800000">
                  <a:off x="1414" y="3688"/>
                  <a:ext cx="8" cy="0"/>
                </a:xfrm>
                <a:prstGeom prst="straightConnector1">
                  <a:avLst/>
                </a:prstGeom>
                <a:noFill/>
                <a:ln w="9525" cap="flat" cmpd="sng">
                  <a:solidFill>
                    <a:srgbClr val="000000"/>
                  </a:solidFill>
                  <a:prstDash val="solid"/>
                  <a:round/>
                  <a:headEnd type="none" w="sm" len="sm"/>
                  <a:tailEnd type="none" w="sm" len="sm"/>
                </a:ln>
              </p:spPr>
            </p:cxnSp>
            <p:cxnSp>
              <p:nvCxnSpPr>
                <p:cNvPr id="1625" name="Google Shape;1625;p11"/>
                <p:cNvCxnSpPr/>
                <p:nvPr/>
              </p:nvCxnSpPr>
              <p:spPr>
                <a:xfrm rot="10800000">
                  <a:off x="1414" y="3647"/>
                  <a:ext cx="8" cy="0"/>
                </a:xfrm>
                <a:prstGeom prst="straightConnector1">
                  <a:avLst/>
                </a:prstGeom>
                <a:noFill/>
                <a:ln w="9525" cap="flat" cmpd="sng">
                  <a:solidFill>
                    <a:srgbClr val="000000"/>
                  </a:solidFill>
                  <a:prstDash val="solid"/>
                  <a:round/>
                  <a:headEnd type="none" w="sm" len="sm"/>
                  <a:tailEnd type="none" w="sm" len="sm"/>
                </a:ln>
              </p:spPr>
            </p:cxnSp>
            <p:cxnSp>
              <p:nvCxnSpPr>
                <p:cNvPr id="1626" name="Google Shape;1626;p11"/>
                <p:cNvCxnSpPr/>
                <p:nvPr/>
              </p:nvCxnSpPr>
              <p:spPr>
                <a:xfrm rot="10800000">
                  <a:off x="1414" y="3607"/>
                  <a:ext cx="8" cy="0"/>
                </a:xfrm>
                <a:prstGeom prst="straightConnector1">
                  <a:avLst/>
                </a:prstGeom>
                <a:noFill/>
                <a:ln w="9525" cap="flat" cmpd="sng">
                  <a:solidFill>
                    <a:srgbClr val="000000"/>
                  </a:solidFill>
                  <a:prstDash val="solid"/>
                  <a:round/>
                  <a:headEnd type="none" w="sm" len="sm"/>
                  <a:tailEnd type="none" w="sm" len="sm"/>
                </a:ln>
              </p:spPr>
            </p:cxnSp>
            <p:cxnSp>
              <p:nvCxnSpPr>
                <p:cNvPr id="1627" name="Google Shape;1627;p11"/>
                <p:cNvCxnSpPr/>
                <p:nvPr/>
              </p:nvCxnSpPr>
              <p:spPr>
                <a:xfrm rot="10800000">
                  <a:off x="1414" y="3566"/>
                  <a:ext cx="8" cy="0"/>
                </a:xfrm>
                <a:prstGeom prst="straightConnector1">
                  <a:avLst/>
                </a:prstGeom>
                <a:noFill/>
                <a:ln w="9525" cap="flat" cmpd="sng">
                  <a:solidFill>
                    <a:srgbClr val="000000"/>
                  </a:solidFill>
                  <a:prstDash val="solid"/>
                  <a:round/>
                  <a:headEnd type="none" w="sm" len="sm"/>
                  <a:tailEnd type="none" w="sm" len="sm"/>
                </a:ln>
              </p:spPr>
            </p:cxnSp>
            <p:cxnSp>
              <p:nvCxnSpPr>
                <p:cNvPr id="1628" name="Google Shape;1628;p11"/>
                <p:cNvCxnSpPr/>
                <p:nvPr/>
              </p:nvCxnSpPr>
              <p:spPr>
                <a:xfrm rot="10800000">
                  <a:off x="1407" y="3525"/>
                  <a:ext cx="15" cy="0"/>
                </a:xfrm>
                <a:prstGeom prst="straightConnector1">
                  <a:avLst/>
                </a:prstGeom>
                <a:noFill/>
                <a:ln w="9525" cap="flat" cmpd="sng">
                  <a:solidFill>
                    <a:srgbClr val="000000"/>
                  </a:solidFill>
                  <a:prstDash val="solid"/>
                  <a:round/>
                  <a:headEnd type="none" w="sm" len="sm"/>
                  <a:tailEnd type="none" w="sm" len="sm"/>
                </a:ln>
              </p:spPr>
            </p:cxnSp>
            <p:sp>
              <p:nvSpPr>
                <p:cNvPr id="1629" name="Google Shape;1629;p11"/>
                <p:cNvSpPr/>
                <p:nvPr/>
              </p:nvSpPr>
              <p:spPr>
                <a:xfrm>
                  <a:off x="1243" y="3471"/>
                  <a:ext cx="15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2.5</a:t>
                  </a:r>
                  <a:endParaRPr sz="800" b="0" i="0" u="none" strike="noStrike" cap="none">
                    <a:solidFill>
                      <a:srgbClr val="000000"/>
                    </a:solidFill>
                    <a:latin typeface="Arial"/>
                    <a:ea typeface="Arial"/>
                    <a:cs typeface="Arial"/>
                    <a:sym typeface="Arial"/>
                  </a:endParaRPr>
                </a:p>
              </p:txBody>
            </p:sp>
            <p:cxnSp>
              <p:nvCxnSpPr>
                <p:cNvPr id="1630" name="Google Shape;1630;p11"/>
                <p:cNvCxnSpPr/>
                <p:nvPr/>
              </p:nvCxnSpPr>
              <p:spPr>
                <a:xfrm rot="10800000">
                  <a:off x="1414" y="3484"/>
                  <a:ext cx="8" cy="0"/>
                </a:xfrm>
                <a:prstGeom prst="straightConnector1">
                  <a:avLst/>
                </a:prstGeom>
                <a:noFill/>
                <a:ln w="9525" cap="flat" cmpd="sng">
                  <a:solidFill>
                    <a:srgbClr val="000000"/>
                  </a:solidFill>
                  <a:prstDash val="solid"/>
                  <a:round/>
                  <a:headEnd type="none" w="sm" len="sm"/>
                  <a:tailEnd type="none" w="sm" len="sm"/>
                </a:ln>
              </p:spPr>
            </p:cxnSp>
            <p:cxnSp>
              <p:nvCxnSpPr>
                <p:cNvPr id="1631" name="Google Shape;1631;p11"/>
                <p:cNvCxnSpPr/>
                <p:nvPr/>
              </p:nvCxnSpPr>
              <p:spPr>
                <a:xfrm rot="10800000">
                  <a:off x="1414" y="3444"/>
                  <a:ext cx="8" cy="0"/>
                </a:xfrm>
                <a:prstGeom prst="straightConnector1">
                  <a:avLst/>
                </a:prstGeom>
                <a:noFill/>
                <a:ln w="9525" cap="flat" cmpd="sng">
                  <a:solidFill>
                    <a:srgbClr val="000000"/>
                  </a:solidFill>
                  <a:prstDash val="solid"/>
                  <a:round/>
                  <a:headEnd type="none" w="sm" len="sm"/>
                  <a:tailEnd type="none" w="sm" len="sm"/>
                </a:ln>
              </p:spPr>
            </p:cxnSp>
            <p:cxnSp>
              <p:nvCxnSpPr>
                <p:cNvPr id="1632" name="Google Shape;1632;p11"/>
                <p:cNvCxnSpPr/>
                <p:nvPr/>
              </p:nvCxnSpPr>
              <p:spPr>
                <a:xfrm rot="10800000">
                  <a:off x="1414" y="3403"/>
                  <a:ext cx="8" cy="0"/>
                </a:xfrm>
                <a:prstGeom prst="straightConnector1">
                  <a:avLst/>
                </a:prstGeom>
                <a:noFill/>
                <a:ln w="9525" cap="flat" cmpd="sng">
                  <a:solidFill>
                    <a:srgbClr val="000000"/>
                  </a:solidFill>
                  <a:prstDash val="solid"/>
                  <a:round/>
                  <a:headEnd type="none" w="sm" len="sm"/>
                  <a:tailEnd type="none" w="sm" len="sm"/>
                </a:ln>
              </p:spPr>
            </p:cxnSp>
            <p:cxnSp>
              <p:nvCxnSpPr>
                <p:cNvPr id="1633" name="Google Shape;1633;p11"/>
                <p:cNvCxnSpPr/>
                <p:nvPr/>
              </p:nvCxnSpPr>
              <p:spPr>
                <a:xfrm rot="10800000">
                  <a:off x="1414" y="3362"/>
                  <a:ext cx="8" cy="0"/>
                </a:xfrm>
                <a:prstGeom prst="straightConnector1">
                  <a:avLst/>
                </a:prstGeom>
                <a:noFill/>
                <a:ln w="9525" cap="flat" cmpd="sng">
                  <a:solidFill>
                    <a:srgbClr val="000000"/>
                  </a:solidFill>
                  <a:prstDash val="solid"/>
                  <a:round/>
                  <a:headEnd type="none" w="sm" len="sm"/>
                  <a:tailEnd type="none" w="sm" len="sm"/>
                </a:ln>
              </p:spPr>
            </p:cxnSp>
            <p:cxnSp>
              <p:nvCxnSpPr>
                <p:cNvPr id="1634" name="Google Shape;1634;p11"/>
                <p:cNvCxnSpPr/>
                <p:nvPr/>
              </p:nvCxnSpPr>
              <p:spPr>
                <a:xfrm rot="10800000">
                  <a:off x="1407" y="3322"/>
                  <a:ext cx="15" cy="0"/>
                </a:xfrm>
                <a:prstGeom prst="straightConnector1">
                  <a:avLst/>
                </a:prstGeom>
                <a:noFill/>
                <a:ln w="9525" cap="flat" cmpd="sng">
                  <a:solidFill>
                    <a:srgbClr val="000000"/>
                  </a:solidFill>
                  <a:prstDash val="solid"/>
                  <a:round/>
                  <a:headEnd type="none" w="sm" len="sm"/>
                  <a:tailEnd type="none" w="sm" len="sm"/>
                </a:ln>
              </p:spPr>
            </p:cxnSp>
            <p:sp>
              <p:nvSpPr>
                <p:cNvPr id="1635" name="Google Shape;1635;p11"/>
                <p:cNvSpPr/>
                <p:nvPr/>
              </p:nvSpPr>
              <p:spPr>
                <a:xfrm>
                  <a:off x="1262" y="3268"/>
                  <a:ext cx="128"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0.0</a:t>
                  </a:r>
                  <a:endParaRPr sz="800" b="0" i="0" u="none" strike="noStrike" cap="none">
                    <a:solidFill>
                      <a:srgbClr val="000000"/>
                    </a:solidFill>
                    <a:latin typeface="Arial"/>
                    <a:ea typeface="Arial"/>
                    <a:cs typeface="Arial"/>
                    <a:sym typeface="Arial"/>
                  </a:endParaRPr>
                </a:p>
              </p:txBody>
            </p:sp>
            <p:cxnSp>
              <p:nvCxnSpPr>
                <p:cNvPr id="1636" name="Google Shape;1636;p11"/>
                <p:cNvCxnSpPr/>
                <p:nvPr/>
              </p:nvCxnSpPr>
              <p:spPr>
                <a:xfrm rot="10800000">
                  <a:off x="1414" y="3281"/>
                  <a:ext cx="8" cy="0"/>
                </a:xfrm>
                <a:prstGeom prst="straightConnector1">
                  <a:avLst/>
                </a:prstGeom>
                <a:noFill/>
                <a:ln w="9525" cap="flat" cmpd="sng">
                  <a:solidFill>
                    <a:srgbClr val="000000"/>
                  </a:solidFill>
                  <a:prstDash val="solid"/>
                  <a:round/>
                  <a:headEnd type="none" w="sm" len="sm"/>
                  <a:tailEnd type="none" w="sm" len="sm"/>
                </a:ln>
              </p:spPr>
            </p:cxnSp>
            <p:cxnSp>
              <p:nvCxnSpPr>
                <p:cNvPr id="1637" name="Google Shape;1637;p11"/>
                <p:cNvCxnSpPr/>
                <p:nvPr/>
              </p:nvCxnSpPr>
              <p:spPr>
                <a:xfrm rot="10800000">
                  <a:off x="1414" y="3240"/>
                  <a:ext cx="8" cy="0"/>
                </a:xfrm>
                <a:prstGeom prst="straightConnector1">
                  <a:avLst/>
                </a:prstGeom>
                <a:noFill/>
                <a:ln w="9525" cap="flat" cmpd="sng">
                  <a:solidFill>
                    <a:srgbClr val="000000"/>
                  </a:solidFill>
                  <a:prstDash val="solid"/>
                  <a:round/>
                  <a:headEnd type="none" w="sm" len="sm"/>
                  <a:tailEnd type="none" w="sm" len="sm"/>
                </a:ln>
              </p:spPr>
            </p:cxnSp>
            <p:cxnSp>
              <p:nvCxnSpPr>
                <p:cNvPr id="1638" name="Google Shape;1638;p11"/>
                <p:cNvCxnSpPr/>
                <p:nvPr/>
              </p:nvCxnSpPr>
              <p:spPr>
                <a:xfrm rot="10800000">
                  <a:off x="1414" y="3199"/>
                  <a:ext cx="8" cy="0"/>
                </a:xfrm>
                <a:prstGeom prst="straightConnector1">
                  <a:avLst/>
                </a:prstGeom>
                <a:noFill/>
                <a:ln w="9525" cap="flat" cmpd="sng">
                  <a:solidFill>
                    <a:srgbClr val="000000"/>
                  </a:solidFill>
                  <a:prstDash val="solid"/>
                  <a:round/>
                  <a:headEnd type="none" w="sm" len="sm"/>
                  <a:tailEnd type="none" w="sm" len="sm"/>
                </a:ln>
              </p:spPr>
            </p:cxnSp>
            <p:cxnSp>
              <p:nvCxnSpPr>
                <p:cNvPr id="1639" name="Google Shape;1639;p11"/>
                <p:cNvCxnSpPr/>
                <p:nvPr/>
              </p:nvCxnSpPr>
              <p:spPr>
                <a:xfrm rot="10800000">
                  <a:off x="1414" y="3159"/>
                  <a:ext cx="8" cy="0"/>
                </a:xfrm>
                <a:prstGeom prst="straightConnector1">
                  <a:avLst/>
                </a:prstGeom>
                <a:noFill/>
                <a:ln w="9525" cap="flat" cmpd="sng">
                  <a:solidFill>
                    <a:srgbClr val="000000"/>
                  </a:solidFill>
                  <a:prstDash val="solid"/>
                  <a:round/>
                  <a:headEnd type="none" w="sm" len="sm"/>
                  <a:tailEnd type="none" w="sm" len="sm"/>
                </a:ln>
              </p:spPr>
            </p:cxnSp>
            <p:cxnSp>
              <p:nvCxnSpPr>
                <p:cNvPr id="1640" name="Google Shape;1640;p11"/>
                <p:cNvCxnSpPr/>
                <p:nvPr/>
              </p:nvCxnSpPr>
              <p:spPr>
                <a:xfrm rot="10800000">
                  <a:off x="1407" y="3118"/>
                  <a:ext cx="15" cy="0"/>
                </a:xfrm>
                <a:prstGeom prst="straightConnector1">
                  <a:avLst/>
                </a:prstGeom>
                <a:noFill/>
                <a:ln w="9525" cap="flat" cmpd="sng">
                  <a:solidFill>
                    <a:srgbClr val="000000"/>
                  </a:solidFill>
                  <a:prstDash val="solid"/>
                  <a:round/>
                  <a:headEnd type="none" w="sm" len="sm"/>
                  <a:tailEnd type="none" w="sm" len="sm"/>
                </a:ln>
              </p:spPr>
            </p:cxnSp>
            <p:sp>
              <p:nvSpPr>
                <p:cNvPr id="1641" name="Google Shape;1641;p11"/>
                <p:cNvSpPr/>
                <p:nvPr/>
              </p:nvSpPr>
              <p:spPr>
                <a:xfrm>
                  <a:off x="1262" y="3062"/>
                  <a:ext cx="128"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2.5</a:t>
                  </a:r>
                  <a:endParaRPr sz="800" b="0" i="0" u="none" strike="noStrike" cap="none">
                    <a:solidFill>
                      <a:srgbClr val="000000"/>
                    </a:solidFill>
                    <a:latin typeface="Arial"/>
                    <a:ea typeface="Arial"/>
                    <a:cs typeface="Arial"/>
                    <a:sym typeface="Arial"/>
                  </a:endParaRPr>
                </a:p>
              </p:txBody>
            </p:sp>
            <p:cxnSp>
              <p:nvCxnSpPr>
                <p:cNvPr id="1642" name="Google Shape;1642;p11"/>
                <p:cNvCxnSpPr/>
                <p:nvPr/>
              </p:nvCxnSpPr>
              <p:spPr>
                <a:xfrm rot="10800000">
                  <a:off x="1414" y="3077"/>
                  <a:ext cx="8" cy="0"/>
                </a:xfrm>
                <a:prstGeom prst="straightConnector1">
                  <a:avLst/>
                </a:prstGeom>
                <a:noFill/>
                <a:ln w="9525" cap="flat" cmpd="sng">
                  <a:solidFill>
                    <a:srgbClr val="000000"/>
                  </a:solidFill>
                  <a:prstDash val="solid"/>
                  <a:round/>
                  <a:headEnd type="none" w="sm" len="sm"/>
                  <a:tailEnd type="none" w="sm" len="sm"/>
                </a:ln>
              </p:spPr>
            </p:cxnSp>
            <p:cxnSp>
              <p:nvCxnSpPr>
                <p:cNvPr id="1643" name="Google Shape;1643;p11"/>
                <p:cNvCxnSpPr/>
                <p:nvPr/>
              </p:nvCxnSpPr>
              <p:spPr>
                <a:xfrm rot="10800000">
                  <a:off x="1414" y="3037"/>
                  <a:ext cx="8" cy="0"/>
                </a:xfrm>
                <a:prstGeom prst="straightConnector1">
                  <a:avLst/>
                </a:prstGeom>
                <a:noFill/>
                <a:ln w="9525" cap="flat" cmpd="sng">
                  <a:solidFill>
                    <a:srgbClr val="000000"/>
                  </a:solidFill>
                  <a:prstDash val="solid"/>
                  <a:round/>
                  <a:headEnd type="none" w="sm" len="sm"/>
                  <a:tailEnd type="none" w="sm" len="sm"/>
                </a:ln>
              </p:spPr>
            </p:cxnSp>
            <p:cxnSp>
              <p:nvCxnSpPr>
                <p:cNvPr id="1644" name="Google Shape;1644;p11"/>
                <p:cNvCxnSpPr/>
                <p:nvPr/>
              </p:nvCxnSpPr>
              <p:spPr>
                <a:xfrm rot="10800000">
                  <a:off x="1414" y="2996"/>
                  <a:ext cx="8" cy="0"/>
                </a:xfrm>
                <a:prstGeom prst="straightConnector1">
                  <a:avLst/>
                </a:prstGeom>
                <a:noFill/>
                <a:ln w="9525" cap="flat" cmpd="sng">
                  <a:solidFill>
                    <a:srgbClr val="000000"/>
                  </a:solidFill>
                  <a:prstDash val="solid"/>
                  <a:round/>
                  <a:headEnd type="none" w="sm" len="sm"/>
                  <a:tailEnd type="none" w="sm" len="sm"/>
                </a:ln>
              </p:spPr>
            </p:cxnSp>
            <p:cxnSp>
              <p:nvCxnSpPr>
                <p:cNvPr id="1645" name="Google Shape;1645;p11"/>
                <p:cNvCxnSpPr/>
                <p:nvPr/>
              </p:nvCxnSpPr>
              <p:spPr>
                <a:xfrm rot="10800000">
                  <a:off x="1414" y="2955"/>
                  <a:ext cx="8" cy="0"/>
                </a:xfrm>
                <a:prstGeom prst="straightConnector1">
                  <a:avLst/>
                </a:prstGeom>
                <a:noFill/>
                <a:ln w="9525" cap="flat" cmpd="sng">
                  <a:solidFill>
                    <a:srgbClr val="000000"/>
                  </a:solidFill>
                  <a:prstDash val="solid"/>
                  <a:round/>
                  <a:headEnd type="none" w="sm" len="sm"/>
                  <a:tailEnd type="none" w="sm" len="sm"/>
                </a:ln>
              </p:spPr>
            </p:cxnSp>
            <p:cxnSp>
              <p:nvCxnSpPr>
                <p:cNvPr id="1646" name="Google Shape;1646;p11"/>
                <p:cNvCxnSpPr/>
                <p:nvPr/>
              </p:nvCxnSpPr>
              <p:spPr>
                <a:xfrm rot="10800000">
                  <a:off x="1407" y="2915"/>
                  <a:ext cx="15" cy="0"/>
                </a:xfrm>
                <a:prstGeom prst="straightConnector1">
                  <a:avLst/>
                </a:prstGeom>
                <a:noFill/>
                <a:ln w="9525" cap="flat" cmpd="sng">
                  <a:solidFill>
                    <a:srgbClr val="000000"/>
                  </a:solidFill>
                  <a:prstDash val="solid"/>
                  <a:round/>
                  <a:headEnd type="none" w="sm" len="sm"/>
                  <a:tailEnd type="none" w="sm" len="sm"/>
                </a:ln>
              </p:spPr>
            </p:cxnSp>
            <p:sp>
              <p:nvSpPr>
                <p:cNvPr id="1647" name="Google Shape;1647;p11"/>
                <p:cNvSpPr/>
                <p:nvPr/>
              </p:nvSpPr>
              <p:spPr>
                <a:xfrm>
                  <a:off x="1262" y="2859"/>
                  <a:ext cx="128"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5.0</a:t>
                  </a:r>
                  <a:endParaRPr sz="800" b="0" i="0" u="none" strike="noStrike" cap="none">
                    <a:solidFill>
                      <a:srgbClr val="000000"/>
                    </a:solidFill>
                    <a:latin typeface="Arial"/>
                    <a:ea typeface="Arial"/>
                    <a:cs typeface="Arial"/>
                    <a:sym typeface="Arial"/>
                  </a:endParaRPr>
                </a:p>
              </p:txBody>
            </p:sp>
            <p:cxnSp>
              <p:nvCxnSpPr>
                <p:cNvPr id="1648" name="Google Shape;1648;p11"/>
                <p:cNvCxnSpPr/>
                <p:nvPr/>
              </p:nvCxnSpPr>
              <p:spPr>
                <a:xfrm rot="10800000">
                  <a:off x="1414" y="2874"/>
                  <a:ext cx="8" cy="0"/>
                </a:xfrm>
                <a:prstGeom prst="straightConnector1">
                  <a:avLst/>
                </a:prstGeom>
                <a:noFill/>
                <a:ln w="9525" cap="flat" cmpd="sng">
                  <a:solidFill>
                    <a:srgbClr val="000000"/>
                  </a:solidFill>
                  <a:prstDash val="solid"/>
                  <a:round/>
                  <a:headEnd type="none" w="sm" len="sm"/>
                  <a:tailEnd type="none" w="sm" len="sm"/>
                </a:ln>
              </p:spPr>
            </p:cxnSp>
            <p:cxnSp>
              <p:nvCxnSpPr>
                <p:cNvPr id="1649" name="Google Shape;1649;p11"/>
                <p:cNvCxnSpPr/>
                <p:nvPr/>
              </p:nvCxnSpPr>
              <p:spPr>
                <a:xfrm rot="10800000">
                  <a:off x="1414" y="2833"/>
                  <a:ext cx="8" cy="0"/>
                </a:xfrm>
                <a:prstGeom prst="straightConnector1">
                  <a:avLst/>
                </a:prstGeom>
                <a:noFill/>
                <a:ln w="9525" cap="flat" cmpd="sng">
                  <a:solidFill>
                    <a:srgbClr val="000000"/>
                  </a:solidFill>
                  <a:prstDash val="solid"/>
                  <a:round/>
                  <a:headEnd type="none" w="sm" len="sm"/>
                  <a:tailEnd type="none" w="sm" len="sm"/>
                </a:ln>
              </p:spPr>
            </p:cxnSp>
            <p:cxnSp>
              <p:nvCxnSpPr>
                <p:cNvPr id="1650" name="Google Shape;1650;p11"/>
                <p:cNvCxnSpPr/>
                <p:nvPr/>
              </p:nvCxnSpPr>
              <p:spPr>
                <a:xfrm rot="10800000">
                  <a:off x="1414" y="2792"/>
                  <a:ext cx="8" cy="0"/>
                </a:xfrm>
                <a:prstGeom prst="straightConnector1">
                  <a:avLst/>
                </a:prstGeom>
                <a:noFill/>
                <a:ln w="9525" cap="flat" cmpd="sng">
                  <a:solidFill>
                    <a:srgbClr val="000000"/>
                  </a:solidFill>
                  <a:prstDash val="solid"/>
                  <a:round/>
                  <a:headEnd type="none" w="sm" len="sm"/>
                  <a:tailEnd type="none" w="sm" len="sm"/>
                </a:ln>
              </p:spPr>
            </p:cxnSp>
            <p:cxnSp>
              <p:nvCxnSpPr>
                <p:cNvPr id="1651" name="Google Shape;1651;p11"/>
                <p:cNvCxnSpPr/>
                <p:nvPr/>
              </p:nvCxnSpPr>
              <p:spPr>
                <a:xfrm rot="10800000">
                  <a:off x="1414" y="2752"/>
                  <a:ext cx="8" cy="0"/>
                </a:xfrm>
                <a:prstGeom prst="straightConnector1">
                  <a:avLst/>
                </a:prstGeom>
                <a:noFill/>
                <a:ln w="9525" cap="flat" cmpd="sng">
                  <a:solidFill>
                    <a:srgbClr val="000000"/>
                  </a:solidFill>
                  <a:prstDash val="solid"/>
                  <a:round/>
                  <a:headEnd type="none" w="sm" len="sm"/>
                  <a:tailEnd type="none" w="sm" len="sm"/>
                </a:ln>
              </p:spPr>
            </p:cxnSp>
            <p:cxnSp>
              <p:nvCxnSpPr>
                <p:cNvPr id="1652" name="Google Shape;1652;p11"/>
                <p:cNvCxnSpPr/>
                <p:nvPr/>
              </p:nvCxnSpPr>
              <p:spPr>
                <a:xfrm rot="10800000">
                  <a:off x="1407" y="2711"/>
                  <a:ext cx="15" cy="0"/>
                </a:xfrm>
                <a:prstGeom prst="straightConnector1">
                  <a:avLst/>
                </a:prstGeom>
                <a:noFill/>
                <a:ln w="9525" cap="flat" cmpd="sng">
                  <a:solidFill>
                    <a:srgbClr val="000000"/>
                  </a:solidFill>
                  <a:prstDash val="solid"/>
                  <a:round/>
                  <a:headEnd type="none" w="sm" len="sm"/>
                  <a:tailEnd type="none" w="sm" len="sm"/>
                </a:ln>
              </p:spPr>
            </p:cxnSp>
            <p:sp>
              <p:nvSpPr>
                <p:cNvPr id="1653" name="Google Shape;1653;p11"/>
                <p:cNvSpPr/>
                <p:nvPr/>
              </p:nvSpPr>
              <p:spPr>
                <a:xfrm>
                  <a:off x="1262" y="2656"/>
                  <a:ext cx="128"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7.5</a:t>
                  </a:r>
                  <a:endParaRPr sz="800" b="0" i="0" u="none" strike="noStrike" cap="none">
                    <a:solidFill>
                      <a:srgbClr val="000000"/>
                    </a:solidFill>
                    <a:latin typeface="Arial"/>
                    <a:ea typeface="Arial"/>
                    <a:cs typeface="Arial"/>
                    <a:sym typeface="Arial"/>
                  </a:endParaRPr>
                </a:p>
              </p:txBody>
            </p:sp>
            <p:cxnSp>
              <p:nvCxnSpPr>
                <p:cNvPr id="1654" name="Google Shape;1654;p11"/>
                <p:cNvCxnSpPr/>
                <p:nvPr/>
              </p:nvCxnSpPr>
              <p:spPr>
                <a:xfrm rot="10800000">
                  <a:off x="1414" y="2670"/>
                  <a:ext cx="8" cy="0"/>
                </a:xfrm>
                <a:prstGeom prst="straightConnector1">
                  <a:avLst/>
                </a:prstGeom>
                <a:noFill/>
                <a:ln w="9525" cap="flat" cmpd="sng">
                  <a:solidFill>
                    <a:srgbClr val="000000"/>
                  </a:solidFill>
                  <a:prstDash val="solid"/>
                  <a:round/>
                  <a:headEnd type="none" w="sm" len="sm"/>
                  <a:tailEnd type="none" w="sm" len="sm"/>
                </a:ln>
              </p:spPr>
            </p:cxnSp>
            <p:cxnSp>
              <p:nvCxnSpPr>
                <p:cNvPr id="1655" name="Google Shape;1655;p11"/>
                <p:cNvCxnSpPr/>
                <p:nvPr/>
              </p:nvCxnSpPr>
              <p:spPr>
                <a:xfrm rot="10800000">
                  <a:off x="1414" y="2629"/>
                  <a:ext cx="8" cy="0"/>
                </a:xfrm>
                <a:prstGeom prst="straightConnector1">
                  <a:avLst/>
                </a:prstGeom>
                <a:noFill/>
                <a:ln w="9525" cap="flat" cmpd="sng">
                  <a:solidFill>
                    <a:srgbClr val="000000"/>
                  </a:solidFill>
                  <a:prstDash val="solid"/>
                  <a:round/>
                  <a:headEnd type="none" w="sm" len="sm"/>
                  <a:tailEnd type="none" w="sm" len="sm"/>
                </a:ln>
              </p:spPr>
            </p:cxnSp>
            <p:cxnSp>
              <p:nvCxnSpPr>
                <p:cNvPr id="1656" name="Google Shape;1656;p11"/>
                <p:cNvCxnSpPr/>
                <p:nvPr/>
              </p:nvCxnSpPr>
              <p:spPr>
                <a:xfrm rot="10800000">
                  <a:off x="1414" y="2589"/>
                  <a:ext cx="8" cy="0"/>
                </a:xfrm>
                <a:prstGeom prst="straightConnector1">
                  <a:avLst/>
                </a:prstGeom>
                <a:noFill/>
                <a:ln w="9525" cap="flat" cmpd="sng">
                  <a:solidFill>
                    <a:srgbClr val="000000"/>
                  </a:solidFill>
                  <a:prstDash val="solid"/>
                  <a:round/>
                  <a:headEnd type="none" w="sm" len="sm"/>
                  <a:tailEnd type="none" w="sm" len="sm"/>
                </a:ln>
              </p:spPr>
            </p:cxnSp>
            <p:cxnSp>
              <p:nvCxnSpPr>
                <p:cNvPr id="1657" name="Google Shape;1657;p11"/>
                <p:cNvCxnSpPr/>
                <p:nvPr/>
              </p:nvCxnSpPr>
              <p:spPr>
                <a:xfrm rot="10800000">
                  <a:off x="1414" y="2548"/>
                  <a:ext cx="8" cy="0"/>
                </a:xfrm>
                <a:prstGeom prst="straightConnector1">
                  <a:avLst/>
                </a:prstGeom>
                <a:noFill/>
                <a:ln w="9525" cap="flat" cmpd="sng">
                  <a:solidFill>
                    <a:srgbClr val="000000"/>
                  </a:solidFill>
                  <a:prstDash val="solid"/>
                  <a:round/>
                  <a:headEnd type="none" w="sm" len="sm"/>
                  <a:tailEnd type="none" w="sm" len="sm"/>
                </a:ln>
              </p:spPr>
            </p:cxnSp>
            <p:cxnSp>
              <p:nvCxnSpPr>
                <p:cNvPr id="1658" name="Google Shape;1658;p11"/>
                <p:cNvCxnSpPr/>
                <p:nvPr/>
              </p:nvCxnSpPr>
              <p:spPr>
                <a:xfrm rot="10800000">
                  <a:off x="1407" y="2507"/>
                  <a:ext cx="15" cy="0"/>
                </a:xfrm>
                <a:prstGeom prst="straightConnector1">
                  <a:avLst/>
                </a:prstGeom>
                <a:noFill/>
                <a:ln w="9525" cap="flat" cmpd="sng">
                  <a:solidFill>
                    <a:srgbClr val="000000"/>
                  </a:solidFill>
                  <a:prstDash val="solid"/>
                  <a:round/>
                  <a:headEnd type="none" w="sm" len="sm"/>
                  <a:tailEnd type="none" w="sm" len="sm"/>
                </a:ln>
              </p:spPr>
            </p:cxnSp>
            <p:sp>
              <p:nvSpPr>
                <p:cNvPr id="1659" name="Google Shape;1659;p11"/>
                <p:cNvSpPr/>
                <p:nvPr/>
              </p:nvSpPr>
              <p:spPr>
                <a:xfrm>
                  <a:off x="1230" y="2453"/>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10.0</a:t>
                  </a:r>
                  <a:endParaRPr sz="800" b="0" i="0" u="none" strike="noStrike" cap="none">
                    <a:solidFill>
                      <a:srgbClr val="000000"/>
                    </a:solidFill>
                    <a:latin typeface="Arial"/>
                    <a:ea typeface="Arial"/>
                    <a:cs typeface="Arial"/>
                    <a:sym typeface="Arial"/>
                  </a:endParaRPr>
                </a:p>
              </p:txBody>
            </p:sp>
            <p:cxnSp>
              <p:nvCxnSpPr>
                <p:cNvPr id="1660" name="Google Shape;1660;p11"/>
                <p:cNvCxnSpPr/>
                <p:nvPr/>
              </p:nvCxnSpPr>
              <p:spPr>
                <a:xfrm rot="10800000">
                  <a:off x="1414" y="2467"/>
                  <a:ext cx="8" cy="0"/>
                </a:xfrm>
                <a:prstGeom prst="straightConnector1">
                  <a:avLst/>
                </a:prstGeom>
                <a:noFill/>
                <a:ln w="9525" cap="flat" cmpd="sng">
                  <a:solidFill>
                    <a:srgbClr val="000000"/>
                  </a:solidFill>
                  <a:prstDash val="solid"/>
                  <a:round/>
                  <a:headEnd type="none" w="sm" len="sm"/>
                  <a:tailEnd type="none" w="sm" len="sm"/>
                </a:ln>
              </p:spPr>
            </p:cxnSp>
            <p:cxnSp>
              <p:nvCxnSpPr>
                <p:cNvPr id="1661" name="Google Shape;1661;p11"/>
                <p:cNvCxnSpPr/>
                <p:nvPr/>
              </p:nvCxnSpPr>
              <p:spPr>
                <a:xfrm rot="10800000">
                  <a:off x="1414" y="2426"/>
                  <a:ext cx="8" cy="0"/>
                </a:xfrm>
                <a:prstGeom prst="straightConnector1">
                  <a:avLst/>
                </a:prstGeom>
                <a:noFill/>
                <a:ln w="9525" cap="flat" cmpd="sng">
                  <a:solidFill>
                    <a:srgbClr val="000000"/>
                  </a:solidFill>
                  <a:prstDash val="solid"/>
                  <a:round/>
                  <a:headEnd type="none" w="sm" len="sm"/>
                  <a:tailEnd type="none" w="sm" len="sm"/>
                </a:ln>
              </p:spPr>
            </p:cxnSp>
            <p:cxnSp>
              <p:nvCxnSpPr>
                <p:cNvPr id="1662" name="Google Shape;1662;p11"/>
                <p:cNvCxnSpPr/>
                <p:nvPr/>
              </p:nvCxnSpPr>
              <p:spPr>
                <a:xfrm rot="10800000">
                  <a:off x="1414" y="2385"/>
                  <a:ext cx="8" cy="0"/>
                </a:xfrm>
                <a:prstGeom prst="straightConnector1">
                  <a:avLst/>
                </a:prstGeom>
                <a:noFill/>
                <a:ln w="9525" cap="flat" cmpd="sng">
                  <a:solidFill>
                    <a:srgbClr val="000000"/>
                  </a:solidFill>
                  <a:prstDash val="solid"/>
                  <a:round/>
                  <a:headEnd type="none" w="sm" len="sm"/>
                  <a:tailEnd type="none" w="sm" len="sm"/>
                </a:ln>
              </p:spPr>
            </p:cxnSp>
            <p:cxnSp>
              <p:nvCxnSpPr>
                <p:cNvPr id="1663" name="Google Shape;1663;p11"/>
                <p:cNvCxnSpPr/>
                <p:nvPr/>
              </p:nvCxnSpPr>
              <p:spPr>
                <a:xfrm rot="10800000">
                  <a:off x="1414" y="2344"/>
                  <a:ext cx="8" cy="0"/>
                </a:xfrm>
                <a:prstGeom prst="straightConnector1">
                  <a:avLst/>
                </a:prstGeom>
                <a:noFill/>
                <a:ln w="9525" cap="flat" cmpd="sng">
                  <a:solidFill>
                    <a:srgbClr val="000000"/>
                  </a:solidFill>
                  <a:prstDash val="solid"/>
                  <a:round/>
                  <a:headEnd type="none" w="sm" len="sm"/>
                  <a:tailEnd type="none" w="sm" len="sm"/>
                </a:ln>
              </p:spPr>
            </p:cxnSp>
            <p:cxnSp>
              <p:nvCxnSpPr>
                <p:cNvPr id="1664" name="Google Shape;1664;p11"/>
                <p:cNvCxnSpPr/>
                <p:nvPr/>
              </p:nvCxnSpPr>
              <p:spPr>
                <a:xfrm rot="10800000">
                  <a:off x="1407" y="2304"/>
                  <a:ext cx="15" cy="0"/>
                </a:xfrm>
                <a:prstGeom prst="straightConnector1">
                  <a:avLst/>
                </a:prstGeom>
                <a:noFill/>
                <a:ln w="9525" cap="flat" cmpd="sng">
                  <a:solidFill>
                    <a:srgbClr val="000000"/>
                  </a:solidFill>
                  <a:prstDash val="solid"/>
                  <a:round/>
                  <a:headEnd type="none" w="sm" len="sm"/>
                  <a:tailEnd type="none" w="sm" len="sm"/>
                </a:ln>
              </p:spPr>
            </p:cxnSp>
            <p:sp>
              <p:nvSpPr>
                <p:cNvPr id="1665" name="Google Shape;1665;p11"/>
                <p:cNvSpPr/>
                <p:nvPr/>
              </p:nvSpPr>
              <p:spPr>
                <a:xfrm>
                  <a:off x="1230" y="2249"/>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12.5</a:t>
                  </a:r>
                  <a:endParaRPr sz="800" b="0" i="0" u="none" strike="noStrike" cap="none">
                    <a:solidFill>
                      <a:srgbClr val="000000"/>
                    </a:solidFill>
                    <a:latin typeface="Arial"/>
                    <a:ea typeface="Arial"/>
                    <a:cs typeface="Arial"/>
                    <a:sym typeface="Arial"/>
                  </a:endParaRPr>
                </a:p>
              </p:txBody>
            </p:sp>
            <p:cxnSp>
              <p:nvCxnSpPr>
                <p:cNvPr id="1666" name="Google Shape;1666;p11"/>
                <p:cNvCxnSpPr/>
                <p:nvPr/>
              </p:nvCxnSpPr>
              <p:spPr>
                <a:xfrm rot="10800000">
                  <a:off x="1414" y="2263"/>
                  <a:ext cx="8" cy="0"/>
                </a:xfrm>
                <a:prstGeom prst="straightConnector1">
                  <a:avLst/>
                </a:prstGeom>
                <a:noFill/>
                <a:ln w="9525" cap="flat" cmpd="sng">
                  <a:solidFill>
                    <a:srgbClr val="000000"/>
                  </a:solidFill>
                  <a:prstDash val="solid"/>
                  <a:round/>
                  <a:headEnd type="none" w="sm" len="sm"/>
                  <a:tailEnd type="none" w="sm" len="sm"/>
                </a:ln>
              </p:spPr>
            </p:cxnSp>
            <p:cxnSp>
              <p:nvCxnSpPr>
                <p:cNvPr id="1667" name="Google Shape;1667;p11"/>
                <p:cNvCxnSpPr/>
                <p:nvPr/>
              </p:nvCxnSpPr>
              <p:spPr>
                <a:xfrm rot="10800000">
                  <a:off x="1414" y="2222"/>
                  <a:ext cx="8" cy="0"/>
                </a:xfrm>
                <a:prstGeom prst="straightConnector1">
                  <a:avLst/>
                </a:prstGeom>
                <a:noFill/>
                <a:ln w="9525" cap="flat" cmpd="sng">
                  <a:solidFill>
                    <a:srgbClr val="000000"/>
                  </a:solidFill>
                  <a:prstDash val="solid"/>
                  <a:round/>
                  <a:headEnd type="none" w="sm" len="sm"/>
                  <a:tailEnd type="none" w="sm" len="sm"/>
                </a:ln>
              </p:spPr>
            </p:cxnSp>
            <p:cxnSp>
              <p:nvCxnSpPr>
                <p:cNvPr id="1668" name="Google Shape;1668;p11"/>
                <p:cNvCxnSpPr/>
                <p:nvPr/>
              </p:nvCxnSpPr>
              <p:spPr>
                <a:xfrm rot="10800000">
                  <a:off x="1414" y="2182"/>
                  <a:ext cx="8" cy="0"/>
                </a:xfrm>
                <a:prstGeom prst="straightConnector1">
                  <a:avLst/>
                </a:prstGeom>
                <a:noFill/>
                <a:ln w="9525" cap="flat" cmpd="sng">
                  <a:solidFill>
                    <a:srgbClr val="000000"/>
                  </a:solidFill>
                  <a:prstDash val="solid"/>
                  <a:round/>
                  <a:headEnd type="none" w="sm" len="sm"/>
                  <a:tailEnd type="none" w="sm" len="sm"/>
                </a:ln>
              </p:spPr>
            </p:cxnSp>
            <p:cxnSp>
              <p:nvCxnSpPr>
                <p:cNvPr id="1669" name="Google Shape;1669;p11"/>
                <p:cNvCxnSpPr/>
                <p:nvPr/>
              </p:nvCxnSpPr>
              <p:spPr>
                <a:xfrm rot="10800000">
                  <a:off x="1414" y="2141"/>
                  <a:ext cx="8" cy="0"/>
                </a:xfrm>
                <a:prstGeom prst="straightConnector1">
                  <a:avLst/>
                </a:prstGeom>
                <a:noFill/>
                <a:ln w="9525" cap="flat" cmpd="sng">
                  <a:solidFill>
                    <a:srgbClr val="000000"/>
                  </a:solidFill>
                  <a:prstDash val="solid"/>
                  <a:round/>
                  <a:headEnd type="none" w="sm" len="sm"/>
                  <a:tailEnd type="none" w="sm" len="sm"/>
                </a:ln>
              </p:spPr>
            </p:cxnSp>
            <p:cxnSp>
              <p:nvCxnSpPr>
                <p:cNvPr id="1670" name="Google Shape;1670;p11"/>
                <p:cNvCxnSpPr/>
                <p:nvPr/>
              </p:nvCxnSpPr>
              <p:spPr>
                <a:xfrm rot="10800000">
                  <a:off x="1407" y="2100"/>
                  <a:ext cx="15" cy="0"/>
                </a:xfrm>
                <a:prstGeom prst="straightConnector1">
                  <a:avLst/>
                </a:prstGeom>
                <a:noFill/>
                <a:ln w="9525" cap="flat" cmpd="sng">
                  <a:solidFill>
                    <a:srgbClr val="000000"/>
                  </a:solidFill>
                  <a:prstDash val="solid"/>
                  <a:round/>
                  <a:headEnd type="none" w="sm" len="sm"/>
                  <a:tailEnd type="none" w="sm" len="sm"/>
                </a:ln>
              </p:spPr>
            </p:cxnSp>
            <p:sp>
              <p:nvSpPr>
                <p:cNvPr id="1671" name="Google Shape;1671;p11"/>
                <p:cNvSpPr/>
                <p:nvPr/>
              </p:nvSpPr>
              <p:spPr>
                <a:xfrm>
                  <a:off x="1230" y="2046"/>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15.0</a:t>
                  </a:r>
                  <a:endParaRPr sz="800" b="0" i="0" u="none" strike="noStrike" cap="none">
                    <a:solidFill>
                      <a:srgbClr val="000000"/>
                    </a:solidFill>
                    <a:latin typeface="Arial"/>
                    <a:ea typeface="Arial"/>
                    <a:cs typeface="Arial"/>
                    <a:sym typeface="Arial"/>
                  </a:endParaRPr>
                </a:p>
              </p:txBody>
            </p:sp>
            <p:cxnSp>
              <p:nvCxnSpPr>
                <p:cNvPr id="1672" name="Google Shape;1672;p11"/>
                <p:cNvCxnSpPr/>
                <p:nvPr/>
              </p:nvCxnSpPr>
              <p:spPr>
                <a:xfrm rot="10800000">
                  <a:off x="1414" y="2060"/>
                  <a:ext cx="8" cy="0"/>
                </a:xfrm>
                <a:prstGeom prst="straightConnector1">
                  <a:avLst/>
                </a:prstGeom>
                <a:noFill/>
                <a:ln w="9525" cap="flat" cmpd="sng">
                  <a:solidFill>
                    <a:srgbClr val="000000"/>
                  </a:solidFill>
                  <a:prstDash val="solid"/>
                  <a:round/>
                  <a:headEnd type="none" w="sm" len="sm"/>
                  <a:tailEnd type="none" w="sm" len="sm"/>
                </a:ln>
              </p:spPr>
            </p:cxnSp>
            <p:cxnSp>
              <p:nvCxnSpPr>
                <p:cNvPr id="1673" name="Google Shape;1673;p11"/>
                <p:cNvCxnSpPr/>
                <p:nvPr/>
              </p:nvCxnSpPr>
              <p:spPr>
                <a:xfrm rot="10800000">
                  <a:off x="1414" y="2019"/>
                  <a:ext cx="8" cy="0"/>
                </a:xfrm>
                <a:prstGeom prst="straightConnector1">
                  <a:avLst/>
                </a:prstGeom>
                <a:noFill/>
                <a:ln w="9525" cap="flat" cmpd="sng">
                  <a:solidFill>
                    <a:srgbClr val="000000"/>
                  </a:solidFill>
                  <a:prstDash val="solid"/>
                  <a:round/>
                  <a:headEnd type="none" w="sm" len="sm"/>
                  <a:tailEnd type="none" w="sm" len="sm"/>
                </a:ln>
              </p:spPr>
            </p:cxnSp>
            <p:cxnSp>
              <p:nvCxnSpPr>
                <p:cNvPr id="1674" name="Google Shape;1674;p11"/>
                <p:cNvCxnSpPr/>
                <p:nvPr/>
              </p:nvCxnSpPr>
              <p:spPr>
                <a:xfrm rot="10800000">
                  <a:off x="1414" y="1978"/>
                  <a:ext cx="8" cy="0"/>
                </a:xfrm>
                <a:prstGeom prst="straightConnector1">
                  <a:avLst/>
                </a:prstGeom>
                <a:noFill/>
                <a:ln w="9525" cap="flat" cmpd="sng">
                  <a:solidFill>
                    <a:srgbClr val="000000"/>
                  </a:solidFill>
                  <a:prstDash val="solid"/>
                  <a:round/>
                  <a:headEnd type="none" w="sm" len="sm"/>
                  <a:tailEnd type="none" w="sm" len="sm"/>
                </a:ln>
              </p:spPr>
            </p:cxnSp>
            <p:cxnSp>
              <p:nvCxnSpPr>
                <p:cNvPr id="1675" name="Google Shape;1675;p11"/>
                <p:cNvCxnSpPr/>
                <p:nvPr/>
              </p:nvCxnSpPr>
              <p:spPr>
                <a:xfrm rot="10800000">
                  <a:off x="1414" y="1937"/>
                  <a:ext cx="8" cy="0"/>
                </a:xfrm>
                <a:prstGeom prst="straightConnector1">
                  <a:avLst/>
                </a:prstGeom>
                <a:noFill/>
                <a:ln w="9525" cap="flat" cmpd="sng">
                  <a:solidFill>
                    <a:srgbClr val="000000"/>
                  </a:solidFill>
                  <a:prstDash val="solid"/>
                  <a:round/>
                  <a:headEnd type="none" w="sm" len="sm"/>
                  <a:tailEnd type="none" w="sm" len="sm"/>
                </a:ln>
              </p:spPr>
            </p:cxnSp>
            <p:cxnSp>
              <p:nvCxnSpPr>
                <p:cNvPr id="1676" name="Google Shape;1676;p11"/>
                <p:cNvCxnSpPr/>
                <p:nvPr/>
              </p:nvCxnSpPr>
              <p:spPr>
                <a:xfrm rot="10800000">
                  <a:off x="1407" y="1897"/>
                  <a:ext cx="15" cy="0"/>
                </a:xfrm>
                <a:prstGeom prst="straightConnector1">
                  <a:avLst/>
                </a:prstGeom>
                <a:noFill/>
                <a:ln w="9525" cap="flat" cmpd="sng">
                  <a:solidFill>
                    <a:srgbClr val="000000"/>
                  </a:solidFill>
                  <a:prstDash val="solid"/>
                  <a:round/>
                  <a:headEnd type="none" w="sm" len="sm"/>
                  <a:tailEnd type="none" w="sm" len="sm"/>
                </a:ln>
              </p:spPr>
            </p:cxnSp>
            <p:sp>
              <p:nvSpPr>
                <p:cNvPr id="1677" name="Google Shape;1677;p11"/>
                <p:cNvSpPr/>
                <p:nvPr/>
              </p:nvSpPr>
              <p:spPr>
                <a:xfrm>
                  <a:off x="1230" y="1840"/>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17.5</a:t>
                  </a:r>
                  <a:endParaRPr sz="800" b="0" i="0" u="none" strike="noStrike" cap="none">
                    <a:solidFill>
                      <a:srgbClr val="000000"/>
                    </a:solidFill>
                    <a:latin typeface="Arial"/>
                    <a:ea typeface="Arial"/>
                    <a:cs typeface="Arial"/>
                    <a:sym typeface="Arial"/>
                  </a:endParaRPr>
                </a:p>
              </p:txBody>
            </p:sp>
            <p:cxnSp>
              <p:nvCxnSpPr>
                <p:cNvPr id="1678" name="Google Shape;1678;p11"/>
                <p:cNvCxnSpPr/>
                <p:nvPr/>
              </p:nvCxnSpPr>
              <p:spPr>
                <a:xfrm rot="10800000">
                  <a:off x="1414" y="1856"/>
                  <a:ext cx="8" cy="0"/>
                </a:xfrm>
                <a:prstGeom prst="straightConnector1">
                  <a:avLst/>
                </a:prstGeom>
                <a:noFill/>
                <a:ln w="9525" cap="flat" cmpd="sng">
                  <a:solidFill>
                    <a:srgbClr val="000000"/>
                  </a:solidFill>
                  <a:prstDash val="solid"/>
                  <a:round/>
                  <a:headEnd type="none" w="sm" len="sm"/>
                  <a:tailEnd type="none" w="sm" len="sm"/>
                </a:ln>
              </p:spPr>
            </p:cxnSp>
            <p:cxnSp>
              <p:nvCxnSpPr>
                <p:cNvPr id="1679" name="Google Shape;1679;p11"/>
                <p:cNvCxnSpPr/>
                <p:nvPr/>
              </p:nvCxnSpPr>
              <p:spPr>
                <a:xfrm rot="10800000">
                  <a:off x="1414" y="1815"/>
                  <a:ext cx="8" cy="0"/>
                </a:xfrm>
                <a:prstGeom prst="straightConnector1">
                  <a:avLst/>
                </a:prstGeom>
                <a:noFill/>
                <a:ln w="9525" cap="flat" cmpd="sng">
                  <a:solidFill>
                    <a:srgbClr val="000000"/>
                  </a:solidFill>
                  <a:prstDash val="solid"/>
                  <a:round/>
                  <a:headEnd type="none" w="sm" len="sm"/>
                  <a:tailEnd type="none" w="sm" len="sm"/>
                </a:ln>
              </p:spPr>
            </p:cxnSp>
            <p:cxnSp>
              <p:nvCxnSpPr>
                <p:cNvPr id="1680" name="Google Shape;1680;p11"/>
                <p:cNvCxnSpPr/>
                <p:nvPr/>
              </p:nvCxnSpPr>
              <p:spPr>
                <a:xfrm rot="10800000">
                  <a:off x="1414" y="1774"/>
                  <a:ext cx="8" cy="0"/>
                </a:xfrm>
                <a:prstGeom prst="straightConnector1">
                  <a:avLst/>
                </a:prstGeom>
                <a:noFill/>
                <a:ln w="9525" cap="flat" cmpd="sng">
                  <a:solidFill>
                    <a:srgbClr val="000000"/>
                  </a:solidFill>
                  <a:prstDash val="solid"/>
                  <a:round/>
                  <a:headEnd type="none" w="sm" len="sm"/>
                  <a:tailEnd type="none" w="sm" len="sm"/>
                </a:ln>
              </p:spPr>
            </p:cxnSp>
            <p:cxnSp>
              <p:nvCxnSpPr>
                <p:cNvPr id="1681" name="Google Shape;1681;p11"/>
                <p:cNvCxnSpPr/>
                <p:nvPr/>
              </p:nvCxnSpPr>
              <p:spPr>
                <a:xfrm rot="10800000">
                  <a:off x="1414" y="1734"/>
                  <a:ext cx="8" cy="0"/>
                </a:xfrm>
                <a:prstGeom prst="straightConnector1">
                  <a:avLst/>
                </a:prstGeom>
                <a:noFill/>
                <a:ln w="9525" cap="flat" cmpd="sng">
                  <a:solidFill>
                    <a:srgbClr val="000000"/>
                  </a:solidFill>
                  <a:prstDash val="solid"/>
                  <a:round/>
                  <a:headEnd type="none" w="sm" len="sm"/>
                  <a:tailEnd type="none" w="sm" len="sm"/>
                </a:ln>
              </p:spPr>
            </p:cxnSp>
            <p:cxnSp>
              <p:nvCxnSpPr>
                <p:cNvPr id="1682" name="Google Shape;1682;p11"/>
                <p:cNvCxnSpPr/>
                <p:nvPr/>
              </p:nvCxnSpPr>
              <p:spPr>
                <a:xfrm rot="10800000">
                  <a:off x="1407" y="1693"/>
                  <a:ext cx="15" cy="0"/>
                </a:xfrm>
                <a:prstGeom prst="straightConnector1">
                  <a:avLst/>
                </a:prstGeom>
                <a:noFill/>
                <a:ln w="9525" cap="flat" cmpd="sng">
                  <a:solidFill>
                    <a:srgbClr val="000000"/>
                  </a:solidFill>
                  <a:prstDash val="solid"/>
                  <a:round/>
                  <a:headEnd type="none" w="sm" len="sm"/>
                  <a:tailEnd type="none" w="sm" len="sm"/>
                </a:ln>
              </p:spPr>
            </p:cxnSp>
            <p:sp>
              <p:nvSpPr>
                <p:cNvPr id="1683" name="Google Shape;1683;p11"/>
                <p:cNvSpPr/>
                <p:nvPr/>
              </p:nvSpPr>
              <p:spPr>
                <a:xfrm>
                  <a:off x="1230" y="1637"/>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20.0</a:t>
                  </a:r>
                  <a:endParaRPr sz="800" b="0" i="0" u="none" strike="noStrike" cap="none">
                    <a:solidFill>
                      <a:srgbClr val="000000"/>
                    </a:solidFill>
                    <a:latin typeface="Arial"/>
                    <a:ea typeface="Arial"/>
                    <a:cs typeface="Arial"/>
                    <a:sym typeface="Arial"/>
                  </a:endParaRPr>
                </a:p>
              </p:txBody>
            </p:sp>
            <p:cxnSp>
              <p:nvCxnSpPr>
                <p:cNvPr id="1684" name="Google Shape;1684;p11"/>
                <p:cNvCxnSpPr/>
                <p:nvPr/>
              </p:nvCxnSpPr>
              <p:spPr>
                <a:xfrm rot="10800000">
                  <a:off x="1414" y="1652"/>
                  <a:ext cx="8" cy="0"/>
                </a:xfrm>
                <a:prstGeom prst="straightConnector1">
                  <a:avLst/>
                </a:prstGeom>
                <a:noFill/>
                <a:ln w="9525" cap="flat" cmpd="sng">
                  <a:solidFill>
                    <a:srgbClr val="000000"/>
                  </a:solidFill>
                  <a:prstDash val="solid"/>
                  <a:round/>
                  <a:headEnd type="none" w="sm" len="sm"/>
                  <a:tailEnd type="none" w="sm" len="sm"/>
                </a:ln>
              </p:spPr>
            </p:cxnSp>
            <p:cxnSp>
              <p:nvCxnSpPr>
                <p:cNvPr id="1685" name="Google Shape;1685;p11"/>
                <p:cNvCxnSpPr/>
                <p:nvPr/>
              </p:nvCxnSpPr>
              <p:spPr>
                <a:xfrm rot="10800000">
                  <a:off x="1414" y="1612"/>
                  <a:ext cx="8" cy="0"/>
                </a:xfrm>
                <a:prstGeom prst="straightConnector1">
                  <a:avLst/>
                </a:prstGeom>
                <a:noFill/>
                <a:ln w="9525" cap="flat" cmpd="sng">
                  <a:solidFill>
                    <a:srgbClr val="000000"/>
                  </a:solidFill>
                  <a:prstDash val="solid"/>
                  <a:round/>
                  <a:headEnd type="none" w="sm" len="sm"/>
                  <a:tailEnd type="none" w="sm" len="sm"/>
                </a:ln>
              </p:spPr>
            </p:cxnSp>
            <p:cxnSp>
              <p:nvCxnSpPr>
                <p:cNvPr id="1686" name="Google Shape;1686;p11"/>
                <p:cNvCxnSpPr/>
                <p:nvPr/>
              </p:nvCxnSpPr>
              <p:spPr>
                <a:xfrm rot="10800000">
                  <a:off x="1414" y="1571"/>
                  <a:ext cx="8" cy="0"/>
                </a:xfrm>
                <a:prstGeom prst="straightConnector1">
                  <a:avLst/>
                </a:prstGeom>
                <a:noFill/>
                <a:ln w="9525" cap="flat" cmpd="sng">
                  <a:solidFill>
                    <a:srgbClr val="000000"/>
                  </a:solidFill>
                  <a:prstDash val="solid"/>
                  <a:round/>
                  <a:headEnd type="none" w="sm" len="sm"/>
                  <a:tailEnd type="none" w="sm" len="sm"/>
                </a:ln>
              </p:spPr>
            </p:cxnSp>
            <p:cxnSp>
              <p:nvCxnSpPr>
                <p:cNvPr id="1687" name="Google Shape;1687;p11"/>
                <p:cNvCxnSpPr/>
                <p:nvPr/>
              </p:nvCxnSpPr>
              <p:spPr>
                <a:xfrm rot="10800000">
                  <a:off x="1414" y="1530"/>
                  <a:ext cx="8" cy="0"/>
                </a:xfrm>
                <a:prstGeom prst="straightConnector1">
                  <a:avLst/>
                </a:prstGeom>
                <a:noFill/>
                <a:ln w="9525" cap="flat" cmpd="sng">
                  <a:solidFill>
                    <a:srgbClr val="000000"/>
                  </a:solidFill>
                  <a:prstDash val="solid"/>
                  <a:round/>
                  <a:headEnd type="none" w="sm" len="sm"/>
                  <a:tailEnd type="none" w="sm" len="sm"/>
                </a:ln>
              </p:spPr>
            </p:cxnSp>
            <p:cxnSp>
              <p:nvCxnSpPr>
                <p:cNvPr id="1688" name="Google Shape;1688;p11"/>
                <p:cNvCxnSpPr/>
                <p:nvPr/>
              </p:nvCxnSpPr>
              <p:spPr>
                <a:xfrm rot="10800000">
                  <a:off x="1407" y="1489"/>
                  <a:ext cx="15" cy="0"/>
                </a:xfrm>
                <a:prstGeom prst="straightConnector1">
                  <a:avLst/>
                </a:prstGeom>
                <a:noFill/>
                <a:ln w="9525" cap="flat" cmpd="sng">
                  <a:solidFill>
                    <a:srgbClr val="000000"/>
                  </a:solidFill>
                  <a:prstDash val="solid"/>
                  <a:round/>
                  <a:headEnd type="none" w="sm" len="sm"/>
                  <a:tailEnd type="none" w="sm" len="sm"/>
                </a:ln>
              </p:spPr>
            </p:cxnSp>
            <p:sp>
              <p:nvSpPr>
                <p:cNvPr id="1689" name="Google Shape;1689;p11"/>
                <p:cNvSpPr/>
                <p:nvPr/>
              </p:nvSpPr>
              <p:spPr>
                <a:xfrm>
                  <a:off x="1230" y="1434"/>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22.5</a:t>
                  </a:r>
                  <a:endParaRPr sz="800" b="0" i="0" u="none" strike="noStrike" cap="none">
                    <a:solidFill>
                      <a:srgbClr val="000000"/>
                    </a:solidFill>
                    <a:latin typeface="Arial"/>
                    <a:ea typeface="Arial"/>
                    <a:cs typeface="Arial"/>
                    <a:sym typeface="Arial"/>
                  </a:endParaRPr>
                </a:p>
              </p:txBody>
            </p:sp>
            <p:cxnSp>
              <p:nvCxnSpPr>
                <p:cNvPr id="1690" name="Google Shape;1690;p11"/>
                <p:cNvCxnSpPr/>
                <p:nvPr/>
              </p:nvCxnSpPr>
              <p:spPr>
                <a:xfrm rot="10800000">
                  <a:off x="1414" y="1449"/>
                  <a:ext cx="8" cy="0"/>
                </a:xfrm>
                <a:prstGeom prst="straightConnector1">
                  <a:avLst/>
                </a:prstGeom>
                <a:noFill/>
                <a:ln w="9525" cap="flat" cmpd="sng">
                  <a:solidFill>
                    <a:srgbClr val="000000"/>
                  </a:solidFill>
                  <a:prstDash val="solid"/>
                  <a:round/>
                  <a:headEnd type="none" w="sm" len="sm"/>
                  <a:tailEnd type="none" w="sm" len="sm"/>
                </a:ln>
              </p:spPr>
            </p:cxnSp>
            <p:cxnSp>
              <p:nvCxnSpPr>
                <p:cNvPr id="1691" name="Google Shape;1691;p11"/>
                <p:cNvCxnSpPr/>
                <p:nvPr/>
              </p:nvCxnSpPr>
              <p:spPr>
                <a:xfrm rot="10800000">
                  <a:off x="1414" y="1408"/>
                  <a:ext cx="8" cy="0"/>
                </a:xfrm>
                <a:prstGeom prst="straightConnector1">
                  <a:avLst/>
                </a:prstGeom>
                <a:noFill/>
                <a:ln w="9525" cap="flat" cmpd="sng">
                  <a:solidFill>
                    <a:srgbClr val="000000"/>
                  </a:solidFill>
                  <a:prstDash val="solid"/>
                  <a:round/>
                  <a:headEnd type="none" w="sm" len="sm"/>
                  <a:tailEnd type="none" w="sm" len="sm"/>
                </a:ln>
              </p:spPr>
            </p:cxnSp>
            <p:cxnSp>
              <p:nvCxnSpPr>
                <p:cNvPr id="1692" name="Google Shape;1692;p11"/>
                <p:cNvCxnSpPr/>
                <p:nvPr/>
              </p:nvCxnSpPr>
              <p:spPr>
                <a:xfrm rot="10800000">
                  <a:off x="1414" y="1367"/>
                  <a:ext cx="8" cy="0"/>
                </a:xfrm>
                <a:prstGeom prst="straightConnector1">
                  <a:avLst/>
                </a:prstGeom>
                <a:noFill/>
                <a:ln w="9525" cap="flat" cmpd="sng">
                  <a:solidFill>
                    <a:srgbClr val="000000"/>
                  </a:solidFill>
                  <a:prstDash val="solid"/>
                  <a:round/>
                  <a:headEnd type="none" w="sm" len="sm"/>
                  <a:tailEnd type="none" w="sm" len="sm"/>
                </a:ln>
              </p:spPr>
            </p:cxnSp>
            <p:cxnSp>
              <p:nvCxnSpPr>
                <p:cNvPr id="1693" name="Google Shape;1693;p11"/>
                <p:cNvCxnSpPr/>
                <p:nvPr/>
              </p:nvCxnSpPr>
              <p:spPr>
                <a:xfrm rot="10800000">
                  <a:off x="1414" y="1327"/>
                  <a:ext cx="8" cy="0"/>
                </a:xfrm>
                <a:prstGeom prst="straightConnector1">
                  <a:avLst/>
                </a:prstGeom>
                <a:noFill/>
                <a:ln w="9525" cap="flat" cmpd="sng">
                  <a:solidFill>
                    <a:srgbClr val="000000"/>
                  </a:solidFill>
                  <a:prstDash val="solid"/>
                  <a:round/>
                  <a:headEnd type="none" w="sm" len="sm"/>
                  <a:tailEnd type="none" w="sm" len="sm"/>
                </a:ln>
              </p:spPr>
            </p:cxnSp>
            <p:cxnSp>
              <p:nvCxnSpPr>
                <p:cNvPr id="1694" name="Google Shape;1694;p11"/>
                <p:cNvCxnSpPr/>
                <p:nvPr/>
              </p:nvCxnSpPr>
              <p:spPr>
                <a:xfrm rot="10800000">
                  <a:off x="1407" y="1286"/>
                  <a:ext cx="15" cy="0"/>
                </a:xfrm>
                <a:prstGeom prst="straightConnector1">
                  <a:avLst/>
                </a:prstGeom>
                <a:noFill/>
                <a:ln w="9525" cap="flat" cmpd="sng">
                  <a:solidFill>
                    <a:srgbClr val="000000"/>
                  </a:solidFill>
                  <a:prstDash val="solid"/>
                  <a:round/>
                  <a:headEnd type="none" w="sm" len="sm"/>
                  <a:tailEnd type="none" w="sm" len="sm"/>
                </a:ln>
              </p:spPr>
            </p:cxnSp>
            <p:sp>
              <p:nvSpPr>
                <p:cNvPr id="1695" name="Google Shape;1695;p11"/>
                <p:cNvSpPr/>
                <p:nvPr/>
              </p:nvSpPr>
              <p:spPr>
                <a:xfrm>
                  <a:off x="1230" y="1231"/>
                  <a:ext cx="179"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25.0</a:t>
                  </a:r>
                  <a:endParaRPr sz="800" b="0" i="0" u="none" strike="noStrike" cap="none">
                    <a:solidFill>
                      <a:srgbClr val="000000"/>
                    </a:solidFill>
                    <a:latin typeface="Arial"/>
                    <a:ea typeface="Arial"/>
                    <a:cs typeface="Arial"/>
                    <a:sym typeface="Arial"/>
                  </a:endParaRPr>
                </a:p>
              </p:txBody>
            </p:sp>
            <p:sp>
              <p:nvSpPr>
                <p:cNvPr id="1696" name="Google Shape;1696;p11"/>
                <p:cNvSpPr/>
                <p:nvPr/>
              </p:nvSpPr>
              <p:spPr>
                <a:xfrm rot="16200000">
                  <a:off x="1224" y="2368"/>
                  <a:ext cx="41" cy="99"/>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r>
                    <a:rPr lang="en-GB" sz="800" b="0" i="0" u="none" strike="noStrike" cap="none">
                      <a:solidFill>
                        <a:schemeClr val="dk1"/>
                      </a:solidFill>
                      <a:latin typeface="Arial"/>
                      <a:ea typeface="Arial"/>
                      <a:cs typeface="Arial"/>
                      <a:sym typeface="Arial"/>
                    </a:rPr>
                    <a:t> </a:t>
                  </a:r>
                  <a:endParaRPr sz="800" b="0" i="0" u="none" strike="noStrike" cap="none">
                    <a:solidFill>
                      <a:srgbClr val="000000"/>
                    </a:solidFill>
                    <a:latin typeface="Arial"/>
                    <a:ea typeface="Arial"/>
                    <a:cs typeface="Arial"/>
                    <a:sym typeface="Arial"/>
                  </a:endParaRPr>
                </a:p>
              </p:txBody>
            </p:sp>
            <p:sp>
              <p:nvSpPr>
                <p:cNvPr id="1697" name="Google Shape;1697;p11"/>
                <p:cNvSpPr/>
                <p:nvPr/>
              </p:nvSpPr>
              <p:spPr>
                <a:xfrm rot="10800000">
                  <a:off x="1245" y="2257"/>
                  <a:ext cx="0" cy="14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chemeClr val="dk1"/>
                    </a:buClr>
                    <a:buSzPts val="1000"/>
                    <a:buFont typeface="Arial"/>
                    <a:buNone/>
                  </a:pPr>
                  <a:endParaRPr sz="800" b="0" i="0" u="none" strike="noStrike" cap="none">
                    <a:solidFill>
                      <a:schemeClr val="dk1"/>
                    </a:solidFill>
                    <a:latin typeface="Arial"/>
                    <a:ea typeface="Arial"/>
                    <a:cs typeface="Arial"/>
                    <a:sym typeface="Arial"/>
                  </a:endParaRPr>
                </a:p>
              </p:txBody>
            </p:sp>
            <p:sp>
              <p:nvSpPr>
                <p:cNvPr id="1698" name="Google Shape;1698;p11"/>
                <p:cNvSpPr/>
                <p:nvPr/>
              </p:nvSpPr>
              <p:spPr>
                <a:xfrm>
                  <a:off x="1434" y="1286"/>
                  <a:ext cx="4964" cy="2443"/>
                </a:xfrm>
                <a:prstGeom prst="rect">
                  <a:avLst/>
                </a:prstGeom>
                <a:solidFill>
                  <a:srgbClr val="FFFFFF"/>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000"/>
                    <a:buFont typeface="Arial"/>
                    <a:buNone/>
                  </a:pPr>
                  <a:endParaRPr sz="800" b="0" i="0" u="none" strike="noStrike" cap="none">
                    <a:solidFill>
                      <a:srgbClr val="000000"/>
                    </a:solidFill>
                    <a:latin typeface="Arial"/>
                    <a:ea typeface="Arial"/>
                    <a:cs typeface="Arial"/>
                    <a:sym typeface="Arial"/>
                  </a:endParaRPr>
                </a:p>
              </p:txBody>
            </p:sp>
            <p:sp>
              <p:nvSpPr>
                <p:cNvPr id="1699" name="Google Shape;1699;p11"/>
                <p:cNvSpPr/>
                <p:nvPr/>
              </p:nvSpPr>
              <p:spPr>
                <a:xfrm>
                  <a:off x="1434" y="2793"/>
                  <a:ext cx="4965" cy="527"/>
                </a:xfrm>
                <a:custGeom>
                  <a:avLst/>
                  <a:gdLst/>
                  <a:ahLst/>
                  <a:cxnLst/>
                  <a:rect l="l" t="t" r="r" b="b"/>
                  <a:pathLst>
                    <a:path w="4965" h="527" extrusionOk="0">
                      <a:moveTo>
                        <a:pt x="0" y="520"/>
                      </a:moveTo>
                      <a:lnTo>
                        <a:pt x="4" y="520"/>
                      </a:lnTo>
                      <a:lnTo>
                        <a:pt x="7" y="521"/>
                      </a:lnTo>
                      <a:lnTo>
                        <a:pt x="10" y="521"/>
                      </a:lnTo>
                      <a:lnTo>
                        <a:pt x="13" y="521"/>
                      </a:lnTo>
                      <a:lnTo>
                        <a:pt x="17" y="520"/>
                      </a:lnTo>
                      <a:lnTo>
                        <a:pt x="20" y="520"/>
                      </a:lnTo>
                      <a:lnTo>
                        <a:pt x="23" y="519"/>
                      </a:lnTo>
                      <a:lnTo>
                        <a:pt x="27" y="520"/>
                      </a:lnTo>
                      <a:lnTo>
                        <a:pt x="30" y="520"/>
                      </a:lnTo>
                      <a:lnTo>
                        <a:pt x="33" y="521"/>
                      </a:lnTo>
                      <a:lnTo>
                        <a:pt x="36" y="520"/>
                      </a:lnTo>
                      <a:lnTo>
                        <a:pt x="40" y="521"/>
                      </a:lnTo>
                      <a:lnTo>
                        <a:pt x="43" y="521"/>
                      </a:lnTo>
                      <a:lnTo>
                        <a:pt x="46" y="522"/>
                      </a:lnTo>
                      <a:lnTo>
                        <a:pt x="50" y="520"/>
                      </a:lnTo>
                      <a:lnTo>
                        <a:pt x="53" y="521"/>
                      </a:lnTo>
                      <a:lnTo>
                        <a:pt x="56" y="521"/>
                      </a:lnTo>
                      <a:lnTo>
                        <a:pt x="60" y="521"/>
                      </a:lnTo>
                      <a:lnTo>
                        <a:pt x="63" y="521"/>
                      </a:lnTo>
                      <a:lnTo>
                        <a:pt x="66" y="519"/>
                      </a:lnTo>
                      <a:lnTo>
                        <a:pt x="70" y="521"/>
                      </a:lnTo>
                      <a:lnTo>
                        <a:pt x="73" y="521"/>
                      </a:lnTo>
                      <a:lnTo>
                        <a:pt x="76" y="520"/>
                      </a:lnTo>
                      <a:lnTo>
                        <a:pt x="80" y="520"/>
                      </a:lnTo>
                      <a:lnTo>
                        <a:pt x="83" y="521"/>
                      </a:lnTo>
                      <a:lnTo>
                        <a:pt x="86" y="521"/>
                      </a:lnTo>
                      <a:lnTo>
                        <a:pt x="89" y="521"/>
                      </a:lnTo>
                      <a:lnTo>
                        <a:pt x="93" y="519"/>
                      </a:lnTo>
                      <a:lnTo>
                        <a:pt x="96" y="519"/>
                      </a:lnTo>
                      <a:lnTo>
                        <a:pt x="99" y="520"/>
                      </a:lnTo>
                      <a:lnTo>
                        <a:pt x="103" y="520"/>
                      </a:lnTo>
                      <a:lnTo>
                        <a:pt x="106" y="522"/>
                      </a:lnTo>
                      <a:lnTo>
                        <a:pt x="109" y="522"/>
                      </a:lnTo>
                      <a:lnTo>
                        <a:pt x="113" y="520"/>
                      </a:lnTo>
                      <a:lnTo>
                        <a:pt x="116" y="522"/>
                      </a:lnTo>
                      <a:lnTo>
                        <a:pt x="119" y="521"/>
                      </a:lnTo>
                      <a:lnTo>
                        <a:pt x="123" y="519"/>
                      </a:lnTo>
                      <a:lnTo>
                        <a:pt x="126" y="521"/>
                      </a:lnTo>
                      <a:lnTo>
                        <a:pt x="129" y="521"/>
                      </a:lnTo>
                      <a:lnTo>
                        <a:pt x="133" y="520"/>
                      </a:lnTo>
                      <a:lnTo>
                        <a:pt x="136" y="521"/>
                      </a:lnTo>
                      <a:lnTo>
                        <a:pt x="139" y="522"/>
                      </a:lnTo>
                      <a:lnTo>
                        <a:pt x="142" y="522"/>
                      </a:lnTo>
                      <a:lnTo>
                        <a:pt x="146" y="521"/>
                      </a:lnTo>
                      <a:lnTo>
                        <a:pt x="149" y="521"/>
                      </a:lnTo>
                      <a:lnTo>
                        <a:pt x="152" y="520"/>
                      </a:lnTo>
                      <a:lnTo>
                        <a:pt x="156" y="522"/>
                      </a:lnTo>
                      <a:lnTo>
                        <a:pt x="159" y="521"/>
                      </a:lnTo>
                      <a:lnTo>
                        <a:pt x="162" y="521"/>
                      </a:lnTo>
                      <a:lnTo>
                        <a:pt x="166" y="520"/>
                      </a:lnTo>
                      <a:lnTo>
                        <a:pt x="169" y="522"/>
                      </a:lnTo>
                      <a:lnTo>
                        <a:pt x="172" y="522"/>
                      </a:lnTo>
                      <a:lnTo>
                        <a:pt x="176" y="521"/>
                      </a:lnTo>
                      <a:lnTo>
                        <a:pt x="179" y="521"/>
                      </a:lnTo>
                      <a:lnTo>
                        <a:pt x="182" y="523"/>
                      </a:lnTo>
                      <a:lnTo>
                        <a:pt x="185" y="520"/>
                      </a:lnTo>
                      <a:lnTo>
                        <a:pt x="189" y="521"/>
                      </a:lnTo>
                      <a:lnTo>
                        <a:pt x="192" y="521"/>
                      </a:lnTo>
                      <a:lnTo>
                        <a:pt x="195" y="519"/>
                      </a:lnTo>
                      <a:lnTo>
                        <a:pt x="199" y="521"/>
                      </a:lnTo>
                      <a:lnTo>
                        <a:pt x="202" y="521"/>
                      </a:lnTo>
                      <a:lnTo>
                        <a:pt x="205" y="522"/>
                      </a:lnTo>
                      <a:lnTo>
                        <a:pt x="209" y="521"/>
                      </a:lnTo>
                      <a:lnTo>
                        <a:pt x="212" y="521"/>
                      </a:lnTo>
                      <a:lnTo>
                        <a:pt x="215" y="521"/>
                      </a:lnTo>
                      <a:lnTo>
                        <a:pt x="219" y="520"/>
                      </a:lnTo>
                      <a:lnTo>
                        <a:pt x="222" y="521"/>
                      </a:lnTo>
                      <a:lnTo>
                        <a:pt x="225" y="522"/>
                      </a:lnTo>
                      <a:lnTo>
                        <a:pt x="229" y="522"/>
                      </a:lnTo>
                      <a:lnTo>
                        <a:pt x="232" y="521"/>
                      </a:lnTo>
                      <a:lnTo>
                        <a:pt x="235" y="521"/>
                      </a:lnTo>
                      <a:lnTo>
                        <a:pt x="238" y="521"/>
                      </a:lnTo>
                      <a:lnTo>
                        <a:pt x="242" y="521"/>
                      </a:lnTo>
                      <a:lnTo>
                        <a:pt x="245" y="519"/>
                      </a:lnTo>
                      <a:lnTo>
                        <a:pt x="248" y="524"/>
                      </a:lnTo>
                      <a:lnTo>
                        <a:pt x="252" y="521"/>
                      </a:lnTo>
                      <a:lnTo>
                        <a:pt x="255" y="521"/>
                      </a:lnTo>
                      <a:lnTo>
                        <a:pt x="258" y="522"/>
                      </a:lnTo>
                      <a:lnTo>
                        <a:pt x="262" y="521"/>
                      </a:lnTo>
                      <a:lnTo>
                        <a:pt x="265" y="521"/>
                      </a:lnTo>
                      <a:lnTo>
                        <a:pt x="268" y="522"/>
                      </a:lnTo>
                      <a:lnTo>
                        <a:pt x="272" y="520"/>
                      </a:lnTo>
                      <a:lnTo>
                        <a:pt x="275" y="522"/>
                      </a:lnTo>
                      <a:lnTo>
                        <a:pt x="278" y="519"/>
                      </a:lnTo>
                      <a:lnTo>
                        <a:pt x="281" y="519"/>
                      </a:lnTo>
                      <a:lnTo>
                        <a:pt x="285" y="520"/>
                      </a:lnTo>
                      <a:lnTo>
                        <a:pt x="288" y="520"/>
                      </a:lnTo>
                      <a:lnTo>
                        <a:pt x="291" y="521"/>
                      </a:lnTo>
                      <a:lnTo>
                        <a:pt x="295" y="521"/>
                      </a:lnTo>
                      <a:lnTo>
                        <a:pt x="298" y="521"/>
                      </a:lnTo>
                      <a:lnTo>
                        <a:pt x="301" y="519"/>
                      </a:lnTo>
                      <a:lnTo>
                        <a:pt x="305" y="520"/>
                      </a:lnTo>
                      <a:lnTo>
                        <a:pt x="308" y="518"/>
                      </a:lnTo>
                      <a:lnTo>
                        <a:pt x="311" y="518"/>
                      </a:lnTo>
                      <a:lnTo>
                        <a:pt x="314" y="518"/>
                      </a:lnTo>
                      <a:lnTo>
                        <a:pt x="318" y="519"/>
                      </a:lnTo>
                      <a:lnTo>
                        <a:pt x="321" y="519"/>
                      </a:lnTo>
                      <a:lnTo>
                        <a:pt x="325" y="521"/>
                      </a:lnTo>
                      <a:lnTo>
                        <a:pt x="328" y="522"/>
                      </a:lnTo>
                      <a:lnTo>
                        <a:pt x="331" y="520"/>
                      </a:lnTo>
                      <a:lnTo>
                        <a:pt x="334" y="520"/>
                      </a:lnTo>
                      <a:lnTo>
                        <a:pt x="338" y="521"/>
                      </a:lnTo>
                      <a:lnTo>
                        <a:pt x="341" y="522"/>
                      </a:lnTo>
                      <a:lnTo>
                        <a:pt x="344" y="522"/>
                      </a:lnTo>
                      <a:lnTo>
                        <a:pt x="348" y="522"/>
                      </a:lnTo>
                      <a:lnTo>
                        <a:pt x="351" y="519"/>
                      </a:lnTo>
                      <a:lnTo>
                        <a:pt x="352" y="527"/>
                      </a:lnTo>
                      <a:lnTo>
                        <a:pt x="354" y="521"/>
                      </a:lnTo>
                      <a:lnTo>
                        <a:pt x="357" y="522"/>
                      </a:lnTo>
                      <a:lnTo>
                        <a:pt x="361" y="521"/>
                      </a:lnTo>
                      <a:lnTo>
                        <a:pt x="364" y="521"/>
                      </a:lnTo>
                      <a:lnTo>
                        <a:pt x="367" y="522"/>
                      </a:lnTo>
                      <a:lnTo>
                        <a:pt x="371" y="521"/>
                      </a:lnTo>
                      <a:lnTo>
                        <a:pt x="374" y="521"/>
                      </a:lnTo>
                      <a:lnTo>
                        <a:pt x="377" y="522"/>
                      </a:lnTo>
                      <a:lnTo>
                        <a:pt x="381" y="521"/>
                      </a:lnTo>
                      <a:lnTo>
                        <a:pt x="384" y="520"/>
                      </a:lnTo>
                      <a:lnTo>
                        <a:pt x="387" y="522"/>
                      </a:lnTo>
                      <a:lnTo>
                        <a:pt x="391" y="522"/>
                      </a:lnTo>
                      <a:lnTo>
                        <a:pt x="394" y="521"/>
                      </a:lnTo>
                      <a:lnTo>
                        <a:pt x="397" y="522"/>
                      </a:lnTo>
                      <a:lnTo>
                        <a:pt x="401" y="522"/>
                      </a:lnTo>
                      <a:lnTo>
                        <a:pt x="404" y="521"/>
                      </a:lnTo>
                      <a:lnTo>
                        <a:pt x="407" y="522"/>
                      </a:lnTo>
                      <a:lnTo>
                        <a:pt x="410" y="522"/>
                      </a:lnTo>
                      <a:lnTo>
                        <a:pt x="414" y="522"/>
                      </a:lnTo>
                      <a:lnTo>
                        <a:pt x="417" y="521"/>
                      </a:lnTo>
                      <a:lnTo>
                        <a:pt x="420" y="521"/>
                      </a:lnTo>
                      <a:lnTo>
                        <a:pt x="424" y="522"/>
                      </a:lnTo>
                      <a:lnTo>
                        <a:pt x="427" y="522"/>
                      </a:lnTo>
                      <a:lnTo>
                        <a:pt x="430" y="521"/>
                      </a:lnTo>
                      <a:lnTo>
                        <a:pt x="434" y="521"/>
                      </a:lnTo>
                      <a:lnTo>
                        <a:pt x="437" y="520"/>
                      </a:lnTo>
                      <a:lnTo>
                        <a:pt x="440" y="522"/>
                      </a:lnTo>
                      <a:lnTo>
                        <a:pt x="444" y="523"/>
                      </a:lnTo>
                      <a:lnTo>
                        <a:pt x="447" y="520"/>
                      </a:lnTo>
                      <a:lnTo>
                        <a:pt x="450" y="521"/>
                      </a:lnTo>
                      <a:lnTo>
                        <a:pt x="453" y="521"/>
                      </a:lnTo>
                      <a:lnTo>
                        <a:pt x="457" y="522"/>
                      </a:lnTo>
                      <a:lnTo>
                        <a:pt x="460" y="522"/>
                      </a:lnTo>
                      <a:lnTo>
                        <a:pt x="463" y="520"/>
                      </a:lnTo>
                      <a:lnTo>
                        <a:pt x="467" y="521"/>
                      </a:lnTo>
                      <a:lnTo>
                        <a:pt x="470" y="520"/>
                      </a:lnTo>
                      <a:lnTo>
                        <a:pt x="473" y="522"/>
                      </a:lnTo>
                      <a:lnTo>
                        <a:pt x="477" y="522"/>
                      </a:lnTo>
                      <a:lnTo>
                        <a:pt x="480" y="521"/>
                      </a:lnTo>
                      <a:lnTo>
                        <a:pt x="483" y="522"/>
                      </a:lnTo>
                      <a:lnTo>
                        <a:pt x="487" y="521"/>
                      </a:lnTo>
                      <a:lnTo>
                        <a:pt x="490" y="520"/>
                      </a:lnTo>
                      <a:lnTo>
                        <a:pt x="493" y="521"/>
                      </a:lnTo>
                      <a:lnTo>
                        <a:pt x="497" y="520"/>
                      </a:lnTo>
                      <a:lnTo>
                        <a:pt x="500" y="519"/>
                      </a:lnTo>
                      <a:lnTo>
                        <a:pt x="503" y="520"/>
                      </a:lnTo>
                      <a:lnTo>
                        <a:pt x="506" y="522"/>
                      </a:lnTo>
                      <a:lnTo>
                        <a:pt x="510" y="522"/>
                      </a:lnTo>
                      <a:lnTo>
                        <a:pt x="513" y="522"/>
                      </a:lnTo>
                      <a:lnTo>
                        <a:pt x="516" y="521"/>
                      </a:lnTo>
                      <a:lnTo>
                        <a:pt x="520" y="521"/>
                      </a:lnTo>
                      <a:lnTo>
                        <a:pt x="523" y="521"/>
                      </a:lnTo>
                      <a:lnTo>
                        <a:pt x="526" y="520"/>
                      </a:lnTo>
                      <a:lnTo>
                        <a:pt x="530" y="520"/>
                      </a:lnTo>
                      <a:lnTo>
                        <a:pt x="533" y="520"/>
                      </a:lnTo>
                      <a:lnTo>
                        <a:pt x="536" y="520"/>
                      </a:lnTo>
                      <a:lnTo>
                        <a:pt x="540" y="521"/>
                      </a:lnTo>
                      <a:lnTo>
                        <a:pt x="543" y="522"/>
                      </a:lnTo>
                      <a:lnTo>
                        <a:pt x="546" y="520"/>
                      </a:lnTo>
                      <a:lnTo>
                        <a:pt x="550" y="521"/>
                      </a:lnTo>
                      <a:lnTo>
                        <a:pt x="553" y="520"/>
                      </a:lnTo>
                      <a:lnTo>
                        <a:pt x="556" y="521"/>
                      </a:lnTo>
                      <a:lnTo>
                        <a:pt x="559" y="522"/>
                      </a:lnTo>
                      <a:lnTo>
                        <a:pt x="563" y="520"/>
                      </a:lnTo>
                      <a:lnTo>
                        <a:pt x="566" y="521"/>
                      </a:lnTo>
                      <a:lnTo>
                        <a:pt x="569" y="520"/>
                      </a:lnTo>
                      <a:lnTo>
                        <a:pt x="573" y="520"/>
                      </a:lnTo>
                      <a:lnTo>
                        <a:pt x="576" y="521"/>
                      </a:lnTo>
                      <a:lnTo>
                        <a:pt x="579" y="521"/>
                      </a:lnTo>
                      <a:lnTo>
                        <a:pt x="582" y="520"/>
                      </a:lnTo>
                      <a:lnTo>
                        <a:pt x="586" y="521"/>
                      </a:lnTo>
                      <a:lnTo>
                        <a:pt x="589" y="519"/>
                      </a:lnTo>
                      <a:lnTo>
                        <a:pt x="593" y="521"/>
                      </a:lnTo>
                      <a:lnTo>
                        <a:pt x="596" y="521"/>
                      </a:lnTo>
                      <a:lnTo>
                        <a:pt x="599" y="520"/>
                      </a:lnTo>
                      <a:lnTo>
                        <a:pt x="602" y="520"/>
                      </a:lnTo>
                      <a:lnTo>
                        <a:pt x="606" y="519"/>
                      </a:lnTo>
                      <a:lnTo>
                        <a:pt x="609" y="520"/>
                      </a:lnTo>
                      <a:lnTo>
                        <a:pt x="612" y="521"/>
                      </a:lnTo>
                      <a:lnTo>
                        <a:pt x="616" y="520"/>
                      </a:lnTo>
                      <a:lnTo>
                        <a:pt x="619" y="522"/>
                      </a:lnTo>
                      <a:lnTo>
                        <a:pt x="622" y="520"/>
                      </a:lnTo>
                      <a:lnTo>
                        <a:pt x="625" y="521"/>
                      </a:lnTo>
                      <a:lnTo>
                        <a:pt x="629" y="519"/>
                      </a:lnTo>
                      <a:lnTo>
                        <a:pt x="632" y="519"/>
                      </a:lnTo>
                      <a:lnTo>
                        <a:pt x="635" y="519"/>
                      </a:lnTo>
                      <a:lnTo>
                        <a:pt x="639" y="521"/>
                      </a:lnTo>
                      <a:lnTo>
                        <a:pt x="642" y="518"/>
                      </a:lnTo>
                      <a:lnTo>
                        <a:pt x="645" y="519"/>
                      </a:lnTo>
                      <a:lnTo>
                        <a:pt x="649" y="520"/>
                      </a:lnTo>
                      <a:lnTo>
                        <a:pt x="652" y="519"/>
                      </a:lnTo>
                      <a:lnTo>
                        <a:pt x="655" y="518"/>
                      </a:lnTo>
                      <a:lnTo>
                        <a:pt x="659" y="520"/>
                      </a:lnTo>
                      <a:lnTo>
                        <a:pt x="662" y="519"/>
                      </a:lnTo>
                      <a:lnTo>
                        <a:pt x="665" y="519"/>
                      </a:lnTo>
                      <a:lnTo>
                        <a:pt x="669" y="518"/>
                      </a:lnTo>
                      <a:lnTo>
                        <a:pt x="672" y="521"/>
                      </a:lnTo>
                      <a:lnTo>
                        <a:pt x="675" y="519"/>
                      </a:lnTo>
                      <a:lnTo>
                        <a:pt x="678" y="517"/>
                      </a:lnTo>
                      <a:lnTo>
                        <a:pt x="682" y="520"/>
                      </a:lnTo>
                      <a:lnTo>
                        <a:pt x="685" y="517"/>
                      </a:lnTo>
                      <a:lnTo>
                        <a:pt x="688" y="519"/>
                      </a:lnTo>
                      <a:lnTo>
                        <a:pt x="692" y="519"/>
                      </a:lnTo>
                      <a:lnTo>
                        <a:pt x="695" y="519"/>
                      </a:lnTo>
                      <a:lnTo>
                        <a:pt x="698" y="520"/>
                      </a:lnTo>
                      <a:lnTo>
                        <a:pt x="702" y="519"/>
                      </a:lnTo>
                      <a:lnTo>
                        <a:pt x="705" y="519"/>
                      </a:lnTo>
                      <a:lnTo>
                        <a:pt x="708" y="520"/>
                      </a:lnTo>
                      <a:lnTo>
                        <a:pt x="712" y="519"/>
                      </a:lnTo>
                      <a:lnTo>
                        <a:pt x="715" y="518"/>
                      </a:lnTo>
                      <a:lnTo>
                        <a:pt x="718" y="520"/>
                      </a:lnTo>
                      <a:lnTo>
                        <a:pt x="722" y="518"/>
                      </a:lnTo>
                      <a:lnTo>
                        <a:pt x="725" y="518"/>
                      </a:lnTo>
                      <a:lnTo>
                        <a:pt x="728" y="520"/>
                      </a:lnTo>
                      <a:lnTo>
                        <a:pt x="731" y="518"/>
                      </a:lnTo>
                      <a:lnTo>
                        <a:pt x="735" y="519"/>
                      </a:lnTo>
                      <a:lnTo>
                        <a:pt x="738" y="520"/>
                      </a:lnTo>
                      <a:lnTo>
                        <a:pt x="741" y="518"/>
                      </a:lnTo>
                      <a:lnTo>
                        <a:pt x="745" y="519"/>
                      </a:lnTo>
                      <a:lnTo>
                        <a:pt x="748" y="518"/>
                      </a:lnTo>
                      <a:lnTo>
                        <a:pt x="751" y="518"/>
                      </a:lnTo>
                      <a:lnTo>
                        <a:pt x="755" y="519"/>
                      </a:lnTo>
                      <a:lnTo>
                        <a:pt x="758" y="520"/>
                      </a:lnTo>
                      <a:lnTo>
                        <a:pt x="761" y="520"/>
                      </a:lnTo>
                      <a:lnTo>
                        <a:pt x="765" y="520"/>
                      </a:lnTo>
                      <a:lnTo>
                        <a:pt x="768" y="519"/>
                      </a:lnTo>
                      <a:lnTo>
                        <a:pt x="771" y="518"/>
                      </a:lnTo>
                      <a:lnTo>
                        <a:pt x="774" y="519"/>
                      </a:lnTo>
                      <a:lnTo>
                        <a:pt x="778" y="519"/>
                      </a:lnTo>
                      <a:lnTo>
                        <a:pt x="781" y="520"/>
                      </a:lnTo>
                      <a:lnTo>
                        <a:pt x="784" y="520"/>
                      </a:lnTo>
                      <a:lnTo>
                        <a:pt x="788" y="519"/>
                      </a:lnTo>
                      <a:lnTo>
                        <a:pt x="791" y="520"/>
                      </a:lnTo>
                      <a:lnTo>
                        <a:pt x="794" y="519"/>
                      </a:lnTo>
                      <a:lnTo>
                        <a:pt x="798" y="522"/>
                      </a:lnTo>
                      <a:lnTo>
                        <a:pt x="801" y="520"/>
                      </a:lnTo>
                      <a:lnTo>
                        <a:pt x="804" y="519"/>
                      </a:lnTo>
                      <a:lnTo>
                        <a:pt x="808" y="521"/>
                      </a:lnTo>
                      <a:lnTo>
                        <a:pt x="811" y="520"/>
                      </a:lnTo>
                      <a:lnTo>
                        <a:pt x="814" y="520"/>
                      </a:lnTo>
                      <a:lnTo>
                        <a:pt x="818" y="520"/>
                      </a:lnTo>
                      <a:lnTo>
                        <a:pt x="821" y="520"/>
                      </a:lnTo>
                      <a:lnTo>
                        <a:pt x="824" y="519"/>
                      </a:lnTo>
                      <a:lnTo>
                        <a:pt x="827" y="518"/>
                      </a:lnTo>
                      <a:lnTo>
                        <a:pt x="831" y="519"/>
                      </a:lnTo>
                      <a:lnTo>
                        <a:pt x="834" y="522"/>
                      </a:lnTo>
                      <a:lnTo>
                        <a:pt x="837" y="520"/>
                      </a:lnTo>
                      <a:lnTo>
                        <a:pt x="841" y="521"/>
                      </a:lnTo>
                      <a:lnTo>
                        <a:pt x="844" y="519"/>
                      </a:lnTo>
                      <a:lnTo>
                        <a:pt x="847" y="520"/>
                      </a:lnTo>
                      <a:lnTo>
                        <a:pt x="850" y="520"/>
                      </a:lnTo>
                      <a:lnTo>
                        <a:pt x="854" y="520"/>
                      </a:lnTo>
                      <a:lnTo>
                        <a:pt x="857" y="519"/>
                      </a:lnTo>
                      <a:lnTo>
                        <a:pt x="861" y="520"/>
                      </a:lnTo>
                      <a:lnTo>
                        <a:pt x="864" y="520"/>
                      </a:lnTo>
                      <a:lnTo>
                        <a:pt x="867" y="519"/>
                      </a:lnTo>
                      <a:lnTo>
                        <a:pt x="871" y="520"/>
                      </a:lnTo>
                      <a:lnTo>
                        <a:pt x="874" y="520"/>
                      </a:lnTo>
                      <a:lnTo>
                        <a:pt x="877" y="520"/>
                      </a:lnTo>
                      <a:lnTo>
                        <a:pt x="880" y="520"/>
                      </a:lnTo>
                      <a:lnTo>
                        <a:pt x="884" y="521"/>
                      </a:lnTo>
                      <a:lnTo>
                        <a:pt x="887" y="519"/>
                      </a:lnTo>
                      <a:lnTo>
                        <a:pt x="890" y="519"/>
                      </a:lnTo>
                      <a:lnTo>
                        <a:pt x="894" y="521"/>
                      </a:lnTo>
                      <a:lnTo>
                        <a:pt x="897" y="519"/>
                      </a:lnTo>
                      <a:lnTo>
                        <a:pt x="900" y="520"/>
                      </a:lnTo>
                      <a:lnTo>
                        <a:pt x="903" y="521"/>
                      </a:lnTo>
                      <a:lnTo>
                        <a:pt x="907" y="521"/>
                      </a:lnTo>
                      <a:lnTo>
                        <a:pt x="910" y="521"/>
                      </a:lnTo>
                      <a:lnTo>
                        <a:pt x="913" y="520"/>
                      </a:lnTo>
                      <a:lnTo>
                        <a:pt x="917" y="521"/>
                      </a:lnTo>
                      <a:lnTo>
                        <a:pt x="920" y="520"/>
                      </a:lnTo>
                      <a:lnTo>
                        <a:pt x="923" y="519"/>
                      </a:lnTo>
                      <a:lnTo>
                        <a:pt x="927" y="520"/>
                      </a:lnTo>
                      <a:lnTo>
                        <a:pt x="930" y="521"/>
                      </a:lnTo>
                      <a:lnTo>
                        <a:pt x="933" y="521"/>
                      </a:lnTo>
                      <a:lnTo>
                        <a:pt x="937" y="519"/>
                      </a:lnTo>
                      <a:lnTo>
                        <a:pt x="940" y="519"/>
                      </a:lnTo>
                      <a:lnTo>
                        <a:pt x="943" y="520"/>
                      </a:lnTo>
                      <a:lnTo>
                        <a:pt x="946" y="519"/>
                      </a:lnTo>
                      <a:lnTo>
                        <a:pt x="950" y="520"/>
                      </a:lnTo>
                      <a:lnTo>
                        <a:pt x="953" y="519"/>
                      </a:lnTo>
                      <a:lnTo>
                        <a:pt x="956" y="520"/>
                      </a:lnTo>
                      <a:lnTo>
                        <a:pt x="960" y="519"/>
                      </a:lnTo>
                      <a:lnTo>
                        <a:pt x="963" y="520"/>
                      </a:lnTo>
                      <a:lnTo>
                        <a:pt x="966" y="519"/>
                      </a:lnTo>
                      <a:lnTo>
                        <a:pt x="970" y="520"/>
                      </a:lnTo>
                      <a:lnTo>
                        <a:pt x="973" y="520"/>
                      </a:lnTo>
                      <a:lnTo>
                        <a:pt x="976" y="520"/>
                      </a:lnTo>
                      <a:lnTo>
                        <a:pt x="980" y="520"/>
                      </a:lnTo>
                      <a:lnTo>
                        <a:pt x="983" y="520"/>
                      </a:lnTo>
                      <a:lnTo>
                        <a:pt x="986" y="520"/>
                      </a:lnTo>
                      <a:lnTo>
                        <a:pt x="990" y="520"/>
                      </a:lnTo>
                      <a:lnTo>
                        <a:pt x="993" y="520"/>
                      </a:lnTo>
                      <a:lnTo>
                        <a:pt x="996" y="520"/>
                      </a:lnTo>
                      <a:lnTo>
                        <a:pt x="999" y="520"/>
                      </a:lnTo>
                      <a:lnTo>
                        <a:pt x="1003" y="519"/>
                      </a:lnTo>
                      <a:lnTo>
                        <a:pt x="1006" y="521"/>
                      </a:lnTo>
                      <a:lnTo>
                        <a:pt x="1009" y="520"/>
                      </a:lnTo>
                      <a:lnTo>
                        <a:pt x="1013" y="521"/>
                      </a:lnTo>
                      <a:lnTo>
                        <a:pt x="1016" y="521"/>
                      </a:lnTo>
                      <a:lnTo>
                        <a:pt x="1019" y="520"/>
                      </a:lnTo>
                      <a:lnTo>
                        <a:pt x="1023" y="520"/>
                      </a:lnTo>
                      <a:lnTo>
                        <a:pt x="1026" y="521"/>
                      </a:lnTo>
                      <a:lnTo>
                        <a:pt x="1029" y="520"/>
                      </a:lnTo>
                      <a:lnTo>
                        <a:pt x="1033" y="520"/>
                      </a:lnTo>
                      <a:lnTo>
                        <a:pt x="1036" y="520"/>
                      </a:lnTo>
                      <a:lnTo>
                        <a:pt x="1039" y="519"/>
                      </a:lnTo>
                      <a:lnTo>
                        <a:pt x="1043" y="519"/>
                      </a:lnTo>
                      <a:lnTo>
                        <a:pt x="1046" y="519"/>
                      </a:lnTo>
                      <a:lnTo>
                        <a:pt x="1049" y="519"/>
                      </a:lnTo>
                      <a:lnTo>
                        <a:pt x="1052" y="520"/>
                      </a:lnTo>
                      <a:lnTo>
                        <a:pt x="1056" y="520"/>
                      </a:lnTo>
                      <a:lnTo>
                        <a:pt x="1059" y="521"/>
                      </a:lnTo>
                      <a:lnTo>
                        <a:pt x="1062" y="520"/>
                      </a:lnTo>
                      <a:lnTo>
                        <a:pt x="1066" y="518"/>
                      </a:lnTo>
                      <a:lnTo>
                        <a:pt x="1069" y="518"/>
                      </a:lnTo>
                      <a:lnTo>
                        <a:pt x="1072" y="520"/>
                      </a:lnTo>
                      <a:lnTo>
                        <a:pt x="1076" y="520"/>
                      </a:lnTo>
                      <a:lnTo>
                        <a:pt x="1079" y="520"/>
                      </a:lnTo>
                      <a:lnTo>
                        <a:pt x="1082" y="522"/>
                      </a:lnTo>
                      <a:lnTo>
                        <a:pt x="1086" y="520"/>
                      </a:lnTo>
                      <a:lnTo>
                        <a:pt x="1089" y="519"/>
                      </a:lnTo>
                      <a:lnTo>
                        <a:pt x="1092" y="521"/>
                      </a:lnTo>
                      <a:lnTo>
                        <a:pt x="1095" y="519"/>
                      </a:lnTo>
                      <a:lnTo>
                        <a:pt x="1099" y="520"/>
                      </a:lnTo>
                      <a:lnTo>
                        <a:pt x="1102" y="519"/>
                      </a:lnTo>
                      <a:lnTo>
                        <a:pt x="1105" y="519"/>
                      </a:lnTo>
                      <a:lnTo>
                        <a:pt x="1109" y="521"/>
                      </a:lnTo>
                      <a:lnTo>
                        <a:pt x="1112" y="519"/>
                      </a:lnTo>
                      <a:lnTo>
                        <a:pt x="1115" y="518"/>
                      </a:lnTo>
                      <a:lnTo>
                        <a:pt x="1118" y="519"/>
                      </a:lnTo>
                      <a:lnTo>
                        <a:pt x="1122" y="520"/>
                      </a:lnTo>
                      <a:lnTo>
                        <a:pt x="1125" y="520"/>
                      </a:lnTo>
                      <a:lnTo>
                        <a:pt x="1129" y="521"/>
                      </a:lnTo>
                      <a:lnTo>
                        <a:pt x="1132" y="519"/>
                      </a:lnTo>
                      <a:lnTo>
                        <a:pt x="1135" y="520"/>
                      </a:lnTo>
                      <a:lnTo>
                        <a:pt x="1139" y="520"/>
                      </a:lnTo>
                      <a:lnTo>
                        <a:pt x="1142" y="520"/>
                      </a:lnTo>
                      <a:lnTo>
                        <a:pt x="1145" y="520"/>
                      </a:lnTo>
                      <a:lnTo>
                        <a:pt x="1148" y="519"/>
                      </a:lnTo>
                      <a:lnTo>
                        <a:pt x="1152" y="520"/>
                      </a:lnTo>
                      <a:lnTo>
                        <a:pt x="1155" y="519"/>
                      </a:lnTo>
                      <a:lnTo>
                        <a:pt x="1158" y="521"/>
                      </a:lnTo>
                      <a:lnTo>
                        <a:pt x="1162" y="520"/>
                      </a:lnTo>
                      <a:lnTo>
                        <a:pt x="1165" y="520"/>
                      </a:lnTo>
                      <a:lnTo>
                        <a:pt x="1168" y="519"/>
                      </a:lnTo>
                      <a:lnTo>
                        <a:pt x="1171" y="518"/>
                      </a:lnTo>
                      <a:lnTo>
                        <a:pt x="1175" y="519"/>
                      </a:lnTo>
                      <a:lnTo>
                        <a:pt x="1178" y="519"/>
                      </a:lnTo>
                      <a:lnTo>
                        <a:pt x="1181" y="518"/>
                      </a:lnTo>
                      <a:lnTo>
                        <a:pt x="1185" y="518"/>
                      </a:lnTo>
                      <a:lnTo>
                        <a:pt x="1188" y="519"/>
                      </a:lnTo>
                      <a:lnTo>
                        <a:pt x="1191" y="519"/>
                      </a:lnTo>
                      <a:lnTo>
                        <a:pt x="1195" y="520"/>
                      </a:lnTo>
                      <a:lnTo>
                        <a:pt x="1198" y="519"/>
                      </a:lnTo>
                      <a:lnTo>
                        <a:pt x="1201" y="519"/>
                      </a:lnTo>
                      <a:lnTo>
                        <a:pt x="1205" y="521"/>
                      </a:lnTo>
                      <a:lnTo>
                        <a:pt x="1208" y="519"/>
                      </a:lnTo>
                      <a:lnTo>
                        <a:pt x="1211" y="519"/>
                      </a:lnTo>
                      <a:lnTo>
                        <a:pt x="1215" y="520"/>
                      </a:lnTo>
                      <a:lnTo>
                        <a:pt x="1218" y="520"/>
                      </a:lnTo>
                      <a:lnTo>
                        <a:pt x="1221" y="519"/>
                      </a:lnTo>
                      <a:lnTo>
                        <a:pt x="1224" y="519"/>
                      </a:lnTo>
                      <a:lnTo>
                        <a:pt x="1228" y="517"/>
                      </a:lnTo>
                      <a:lnTo>
                        <a:pt x="1231" y="518"/>
                      </a:lnTo>
                      <a:lnTo>
                        <a:pt x="1234" y="519"/>
                      </a:lnTo>
                      <a:lnTo>
                        <a:pt x="1238" y="520"/>
                      </a:lnTo>
                      <a:lnTo>
                        <a:pt x="1241" y="518"/>
                      </a:lnTo>
                      <a:lnTo>
                        <a:pt x="1244" y="518"/>
                      </a:lnTo>
                      <a:lnTo>
                        <a:pt x="1248" y="519"/>
                      </a:lnTo>
                      <a:lnTo>
                        <a:pt x="1251" y="519"/>
                      </a:lnTo>
                      <a:lnTo>
                        <a:pt x="1254" y="518"/>
                      </a:lnTo>
                      <a:lnTo>
                        <a:pt x="1258" y="517"/>
                      </a:lnTo>
                      <a:lnTo>
                        <a:pt x="1261" y="520"/>
                      </a:lnTo>
                      <a:lnTo>
                        <a:pt x="1264" y="519"/>
                      </a:lnTo>
                      <a:lnTo>
                        <a:pt x="1267" y="518"/>
                      </a:lnTo>
                      <a:lnTo>
                        <a:pt x="1271" y="519"/>
                      </a:lnTo>
                      <a:lnTo>
                        <a:pt x="1274" y="517"/>
                      </a:lnTo>
                      <a:lnTo>
                        <a:pt x="1277" y="517"/>
                      </a:lnTo>
                      <a:lnTo>
                        <a:pt x="1281" y="519"/>
                      </a:lnTo>
                      <a:lnTo>
                        <a:pt x="1284" y="517"/>
                      </a:lnTo>
                      <a:lnTo>
                        <a:pt x="1287" y="519"/>
                      </a:lnTo>
                      <a:lnTo>
                        <a:pt x="1291" y="519"/>
                      </a:lnTo>
                      <a:lnTo>
                        <a:pt x="1294" y="520"/>
                      </a:lnTo>
                      <a:lnTo>
                        <a:pt x="1297" y="518"/>
                      </a:lnTo>
                      <a:lnTo>
                        <a:pt x="1301" y="519"/>
                      </a:lnTo>
                      <a:lnTo>
                        <a:pt x="1304" y="518"/>
                      </a:lnTo>
                      <a:lnTo>
                        <a:pt x="1307" y="519"/>
                      </a:lnTo>
                      <a:lnTo>
                        <a:pt x="1311" y="518"/>
                      </a:lnTo>
                      <a:lnTo>
                        <a:pt x="1314" y="518"/>
                      </a:lnTo>
                      <a:lnTo>
                        <a:pt x="1317" y="517"/>
                      </a:lnTo>
                      <a:lnTo>
                        <a:pt x="1320" y="518"/>
                      </a:lnTo>
                      <a:lnTo>
                        <a:pt x="1324" y="517"/>
                      </a:lnTo>
                      <a:lnTo>
                        <a:pt x="1327" y="519"/>
                      </a:lnTo>
                      <a:lnTo>
                        <a:pt x="1330" y="518"/>
                      </a:lnTo>
                      <a:lnTo>
                        <a:pt x="1334" y="518"/>
                      </a:lnTo>
                      <a:lnTo>
                        <a:pt x="1337" y="517"/>
                      </a:lnTo>
                      <a:lnTo>
                        <a:pt x="1340" y="516"/>
                      </a:lnTo>
                      <a:lnTo>
                        <a:pt x="1344" y="517"/>
                      </a:lnTo>
                      <a:lnTo>
                        <a:pt x="1347" y="519"/>
                      </a:lnTo>
                      <a:lnTo>
                        <a:pt x="1350" y="517"/>
                      </a:lnTo>
                      <a:lnTo>
                        <a:pt x="1354" y="518"/>
                      </a:lnTo>
                      <a:lnTo>
                        <a:pt x="1357" y="519"/>
                      </a:lnTo>
                      <a:lnTo>
                        <a:pt x="1360" y="519"/>
                      </a:lnTo>
                      <a:lnTo>
                        <a:pt x="1363" y="517"/>
                      </a:lnTo>
                      <a:lnTo>
                        <a:pt x="1367" y="517"/>
                      </a:lnTo>
                      <a:lnTo>
                        <a:pt x="1370" y="519"/>
                      </a:lnTo>
                      <a:lnTo>
                        <a:pt x="1373" y="519"/>
                      </a:lnTo>
                      <a:lnTo>
                        <a:pt x="1377" y="516"/>
                      </a:lnTo>
                      <a:lnTo>
                        <a:pt x="1380" y="518"/>
                      </a:lnTo>
                      <a:lnTo>
                        <a:pt x="1383" y="519"/>
                      </a:lnTo>
                      <a:lnTo>
                        <a:pt x="1387" y="518"/>
                      </a:lnTo>
                      <a:lnTo>
                        <a:pt x="1390" y="517"/>
                      </a:lnTo>
                      <a:lnTo>
                        <a:pt x="1393" y="518"/>
                      </a:lnTo>
                      <a:lnTo>
                        <a:pt x="1397" y="518"/>
                      </a:lnTo>
                      <a:lnTo>
                        <a:pt x="1400" y="518"/>
                      </a:lnTo>
                      <a:lnTo>
                        <a:pt x="1403" y="519"/>
                      </a:lnTo>
                      <a:lnTo>
                        <a:pt x="1407" y="519"/>
                      </a:lnTo>
                      <a:lnTo>
                        <a:pt x="1410" y="518"/>
                      </a:lnTo>
                      <a:lnTo>
                        <a:pt x="1413" y="518"/>
                      </a:lnTo>
                      <a:lnTo>
                        <a:pt x="1416" y="516"/>
                      </a:lnTo>
                      <a:lnTo>
                        <a:pt x="1420" y="517"/>
                      </a:lnTo>
                      <a:lnTo>
                        <a:pt x="1423" y="516"/>
                      </a:lnTo>
                      <a:lnTo>
                        <a:pt x="1426" y="517"/>
                      </a:lnTo>
                      <a:lnTo>
                        <a:pt x="1430" y="519"/>
                      </a:lnTo>
                      <a:lnTo>
                        <a:pt x="1433" y="519"/>
                      </a:lnTo>
                      <a:lnTo>
                        <a:pt x="1436" y="517"/>
                      </a:lnTo>
                      <a:lnTo>
                        <a:pt x="1439" y="517"/>
                      </a:lnTo>
                      <a:lnTo>
                        <a:pt x="1443" y="519"/>
                      </a:lnTo>
                      <a:lnTo>
                        <a:pt x="1446" y="518"/>
                      </a:lnTo>
                      <a:lnTo>
                        <a:pt x="1449" y="518"/>
                      </a:lnTo>
                      <a:lnTo>
                        <a:pt x="1453" y="518"/>
                      </a:lnTo>
                      <a:lnTo>
                        <a:pt x="1456" y="518"/>
                      </a:lnTo>
                      <a:lnTo>
                        <a:pt x="1459" y="518"/>
                      </a:lnTo>
                      <a:lnTo>
                        <a:pt x="1463" y="516"/>
                      </a:lnTo>
                      <a:lnTo>
                        <a:pt x="1466" y="517"/>
                      </a:lnTo>
                      <a:lnTo>
                        <a:pt x="1469" y="518"/>
                      </a:lnTo>
                      <a:lnTo>
                        <a:pt x="1473" y="518"/>
                      </a:lnTo>
                      <a:lnTo>
                        <a:pt x="1476" y="516"/>
                      </a:lnTo>
                      <a:lnTo>
                        <a:pt x="1479" y="517"/>
                      </a:lnTo>
                      <a:lnTo>
                        <a:pt x="1483" y="518"/>
                      </a:lnTo>
                      <a:lnTo>
                        <a:pt x="1486" y="518"/>
                      </a:lnTo>
                      <a:lnTo>
                        <a:pt x="1489" y="517"/>
                      </a:lnTo>
                      <a:lnTo>
                        <a:pt x="1492" y="517"/>
                      </a:lnTo>
                      <a:lnTo>
                        <a:pt x="1496" y="517"/>
                      </a:lnTo>
                      <a:lnTo>
                        <a:pt x="1499" y="518"/>
                      </a:lnTo>
                      <a:lnTo>
                        <a:pt x="1502" y="517"/>
                      </a:lnTo>
                      <a:lnTo>
                        <a:pt x="1506" y="517"/>
                      </a:lnTo>
                      <a:lnTo>
                        <a:pt x="1509" y="518"/>
                      </a:lnTo>
                      <a:lnTo>
                        <a:pt x="1512" y="518"/>
                      </a:lnTo>
                      <a:lnTo>
                        <a:pt x="1516" y="518"/>
                      </a:lnTo>
                      <a:lnTo>
                        <a:pt x="1519" y="518"/>
                      </a:lnTo>
                      <a:lnTo>
                        <a:pt x="1522" y="516"/>
                      </a:lnTo>
                      <a:lnTo>
                        <a:pt x="1526" y="517"/>
                      </a:lnTo>
                      <a:lnTo>
                        <a:pt x="1529" y="517"/>
                      </a:lnTo>
                      <a:lnTo>
                        <a:pt x="1532" y="517"/>
                      </a:lnTo>
                      <a:lnTo>
                        <a:pt x="1535" y="516"/>
                      </a:lnTo>
                      <a:lnTo>
                        <a:pt x="1539" y="517"/>
                      </a:lnTo>
                      <a:lnTo>
                        <a:pt x="1542" y="518"/>
                      </a:lnTo>
                      <a:lnTo>
                        <a:pt x="1545" y="516"/>
                      </a:lnTo>
                      <a:lnTo>
                        <a:pt x="1549" y="518"/>
                      </a:lnTo>
                      <a:lnTo>
                        <a:pt x="1552" y="517"/>
                      </a:lnTo>
                      <a:lnTo>
                        <a:pt x="1555" y="516"/>
                      </a:lnTo>
                      <a:lnTo>
                        <a:pt x="1559" y="516"/>
                      </a:lnTo>
                      <a:lnTo>
                        <a:pt x="1562" y="516"/>
                      </a:lnTo>
                      <a:lnTo>
                        <a:pt x="1565" y="517"/>
                      </a:lnTo>
                      <a:lnTo>
                        <a:pt x="1569" y="516"/>
                      </a:lnTo>
                      <a:lnTo>
                        <a:pt x="1572" y="517"/>
                      </a:lnTo>
                      <a:lnTo>
                        <a:pt x="1575" y="517"/>
                      </a:lnTo>
                      <a:lnTo>
                        <a:pt x="1579" y="515"/>
                      </a:lnTo>
                      <a:lnTo>
                        <a:pt x="1582" y="516"/>
                      </a:lnTo>
                      <a:lnTo>
                        <a:pt x="1585" y="518"/>
                      </a:lnTo>
                      <a:lnTo>
                        <a:pt x="1588" y="515"/>
                      </a:lnTo>
                      <a:lnTo>
                        <a:pt x="1592" y="516"/>
                      </a:lnTo>
                      <a:lnTo>
                        <a:pt x="1595" y="516"/>
                      </a:lnTo>
                      <a:lnTo>
                        <a:pt x="1598" y="516"/>
                      </a:lnTo>
                      <a:lnTo>
                        <a:pt x="1602" y="517"/>
                      </a:lnTo>
                      <a:lnTo>
                        <a:pt x="1605" y="515"/>
                      </a:lnTo>
                      <a:lnTo>
                        <a:pt x="1608" y="516"/>
                      </a:lnTo>
                      <a:lnTo>
                        <a:pt x="1612" y="516"/>
                      </a:lnTo>
                      <a:lnTo>
                        <a:pt x="1615" y="517"/>
                      </a:lnTo>
                      <a:lnTo>
                        <a:pt x="1618" y="516"/>
                      </a:lnTo>
                      <a:lnTo>
                        <a:pt x="1622" y="517"/>
                      </a:lnTo>
                      <a:lnTo>
                        <a:pt x="1625" y="515"/>
                      </a:lnTo>
                      <a:lnTo>
                        <a:pt x="1628" y="516"/>
                      </a:lnTo>
                      <a:lnTo>
                        <a:pt x="1632" y="515"/>
                      </a:lnTo>
                      <a:lnTo>
                        <a:pt x="1635" y="517"/>
                      </a:lnTo>
                      <a:lnTo>
                        <a:pt x="1638" y="515"/>
                      </a:lnTo>
                      <a:lnTo>
                        <a:pt x="1641" y="515"/>
                      </a:lnTo>
                      <a:lnTo>
                        <a:pt x="1645" y="517"/>
                      </a:lnTo>
                      <a:lnTo>
                        <a:pt x="1648" y="517"/>
                      </a:lnTo>
                      <a:lnTo>
                        <a:pt x="1651" y="516"/>
                      </a:lnTo>
                      <a:lnTo>
                        <a:pt x="1655" y="515"/>
                      </a:lnTo>
                      <a:lnTo>
                        <a:pt x="1658" y="515"/>
                      </a:lnTo>
                      <a:lnTo>
                        <a:pt x="1661" y="517"/>
                      </a:lnTo>
                      <a:lnTo>
                        <a:pt x="1665" y="516"/>
                      </a:lnTo>
                      <a:lnTo>
                        <a:pt x="1668" y="516"/>
                      </a:lnTo>
                      <a:lnTo>
                        <a:pt x="1671" y="515"/>
                      </a:lnTo>
                      <a:lnTo>
                        <a:pt x="1675" y="515"/>
                      </a:lnTo>
                      <a:lnTo>
                        <a:pt x="1678" y="517"/>
                      </a:lnTo>
                      <a:lnTo>
                        <a:pt x="1681" y="515"/>
                      </a:lnTo>
                      <a:lnTo>
                        <a:pt x="1684" y="517"/>
                      </a:lnTo>
                      <a:lnTo>
                        <a:pt x="1688" y="517"/>
                      </a:lnTo>
                      <a:lnTo>
                        <a:pt x="1691" y="517"/>
                      </a:lnTo>
                      <a:lnTo>
                        <a:pt x="1694" y="516"/>
                      </a:lnTo>
                      <a:lnTo>
                        <a:pt x="1698" y="517"/>
                      </a:lnTo>
                      <a:lnTo>
                        <a:pt x="1701" y="516"/>
                      </a:lnTo>
                      <a:lnTo>
                        <a:pt x="1704" y="515"/>
                      </a:lnTo>
                      <a:lnTo>
                        <a:pt x="1707" y="517"/>
                      </a:lnTo>
                      <a:lnTo>
                        <a:pt x="1711" y="515"/>
                      </a:lnTo>
                      <a:lnTo>
                        <a:pt x="1714" y="514"/>
                      </a:lnTo>
                      <a:lnTo>
                        <a:pt x="1717" y="516"/>
                      </a:lnTo>
                      <a:lnTo>
                        <a:pt x="1721" y="516"/>
                      </a:lnTo>
                      <a:lnTo>
                        <a:pt x="1724" y="514"/>
                      </a:lnTo>
                      <a:lnTo>
                        <a:pt x="1727" y="514"/>
                      </a:lnTo>
                      <a:lnTo>
                        <a:pt x="1731" y="517"/>
                      </a:lnTo>
                      <a:lnTo>
                        <a:pt x="1734" y="516"/>
                      </a:lnTo>
                      <a:lnTo>
                        <a:pt x="1737" y="514"/>
                      </a:lnTo>
                      <a:lnTo>
                        <a:pt x="1741" y="514"/>
                      </a:lnTo>
                      <a:lnTo>
                        <a:pt x="1744" y="515"/>
                      </a:lnTo>
                      <a:lnTo>
                        <a:pt x="1747" y="515"/>
                      </a:lnTo>
                      <a:lnTo>
                        <a:pt x="1751" y="513"/>
                      </a:lnTo>
                      <a:lnTo>
                        <a:pt x="1754" y="514"/>
                      </a:lnTo>
                      <a:lnTo>
                        <a:pt x="1757" y="513"/>
                      </a:lnTo>
                      <a:lnTo>
                        <a:pt x="1760" y="514"/>
                      </a:lnTo>
                      <a:lnTo>
                        <a:pt x="1764" y="513"/>
                      </a:lnTo>
                      <a:lnTo>
                        <a:pt x="1767" y="515"/>
                      </a:lnTo>
                      <a:lnTo>
                        <a:pt x="1770" y="514"/>
                      </a:lnTo>
                      <a:lnTo>
                        <a:pt x="1774" y="512"/>
                      </a:lnTo>
                      <a:lnTo>
                        <a:pt x="1777" y="516"/>
                      </a:lnTo>
                      <a:lnTo>
                        <a:pt x="1780" y="514"/>
                      </a:lnTo>
                      <a:lnTo>
                        <a:pt x="1784" y="513"/>
                      </a:lnTo>
                      <a:lnTo>
                        <a:pt x="1787" y="513"/>
                      </a:lnTo>
                      <a:lnTo>
                        <a:pt x="1790" y="514"/>
                      </a:lnTo>
                      <a:lnTo>
                        <a:pt x="1794" y="513"/>
                      </a:lnTo>
                      <a:lnTo>
                        <a:pt x="1797" y="514"/>
                      </a:lnTo>
                      <a:lnTo>
                        <a:pt x="1800" y="513"/>
                      </a:lnTo>
                      <a:lnTo>
                        <a:pt x="1804" y="514"/>
                      </a:lnTo>
                      <a:lnTo>
                        <a:pt x="1807" y="514"/>
                      </a:lnTo>
                      <a:lnTo>
                        <a:pt x="1810" y="514"/>
                      </a:lnTo>
                      <a:lnTo>
                        <a:pt x="1813" y="512"/>
                      </a:lnTo>
                      <a:lnTo>
                        <a:pt x="1817" y="513"/>
                      </a:lnTo>
                      <a:lnTo>
                        <a:pt x="1820" y="513"/>
                      </a:lnTo>
                      <a:lnTo>
                        <a:pt x="1823" y="512"/>
                      </a:lnTo>
                      <a:lnTo>
                        <a:pt x="1827" y="513"/>
                      </a:lnTo>
                      <a:lnTo>
                        <a:pt x="1830" y="514"/>
                      </a:lnTo>
                      <a:lnTo>
                        <a:pt x="1833" y="512"/>
                      </a:lnTo>
                      <a:lnTo>
                        <a:pt x="1837" y="514"/>
                      </a:lnTo>
                      <a:lnTo>
                        <a:pt x="1840" y="511"/>
                      </a:lnTo>
                      <a:lnTo>
                        <a:pt x="1843" y="512"/>
                      </a:lnTo>
                      <a:lnTo>
                        <a:pt x="1847" y="513"/>
                      </a:lnTo>
                      <a:lnTo>
                        <a:pt x="1850" y="512"/>
                      </a:lnTo>
                      <a:lnTo>
                        <a:pt x="1853" y="511"/>
                      </a:lnTo>
                      <a:lnTo>
                        <a:pt x="1856" y="513"/>
                      </a:lnTo>
                      <a:lnTo>
                        <a:pt x="1860" y="512"/>
                      </a:lnTo>
                      <a:lnTo>
                        <a:pt x="1863" y="512"/>
                      </a:lnTo>
                      <a:lnTo>
                        <a:pt x="1866" y="510"/>
                      </a:lnTo>
                      <a:lnTo>
                        <a:pt x="1870" y="512"/>
                      </a:lnTo>
                      <a:lnTo>
                        <a:pt x="1873" y="511"/>
                      </a:lnTo>
                      <a:lnTo>
                        <a:pt x="1876" y="512"/>
                      </a:lnTo>
                      <a:lnTo>
                        <a:pt x="1880" y="511"/>
                      </a:lnTo>
                      <a:lnTo>
                        <a:pt x="1883" y="510"/>
                      </a:lnTo>
                      <a:lnTo>
                        <a:pt x="1886" y="509"/>
                      </a:lnTo>
                      <a:lnTo>
                        <a:pt x="1890" y="512"/>
                      </a:lnTo>
                      <a:lnTo>
                        <a:pt x="1893" y="512"/>
                      </a:lnTo>
                      <a:lnTo>
                        <a:pt x="1896" y="511"/>
                      </a:lnTo>
                      <a:lnTo>
                        <a:pt x="1900" y="511"/>
                      </a:lnTo>
                      <a:lnTo>
                        <a:pt x="1903" y="511"/>
                      </a:lnTo>
                      <a:lnTo>
                        <a:pt x="1906" y="511"/>
                      </a:lnTo>
                      <a:lnTo>
                        <a:pt x="1909" y="511"/>
                      </a:lnTo>
                      <a:lnTo>
                        <a:pt x="1913" y="511"/>
                      </a:lnTo>
                      <a:lnTo>
                        <a:pt x="1916" y="511"/>
                      </a:lnTo>
                      <a:lnTo>
                        <a:pt x="1919" y="510"/>
                      </a:lnTo>
                      <a:lnTo>
                        <a:pt x="1923" y="511"/>
                      </a:lnTo>
                      <a:lnTo>
                        <a:pt x="1926" y="509"/>
                      </a:lnTo>
                      <a:lnTo>
                        <a:pt x="1929" y="509"/>
                      </a:lnTo>
                      <a:lnTo>
                        <a:pt x="1933" y="511"/>
                      </a:lnTo>
                      <a:lnTo>
                        <a:pt x="1936" y="511"/>
                      </a:lnTo>
                      <a:lnTo>
                        <a:pt x="1939" y="510"/>
                      </a:lnTo>
                      <a:lnTo>
                        <a:pt x="1943" y="510"/>
                      </a:lnTo>
                      <a:lnTo>
                        <a:pt x="1946" y="509"/>
                      </a:lnTo>
                      <a:lnTo>
                        <a:pt x="1949" y="509"/>
                      </a:lnTo>
                      <a:lnTo>
                        <a:pt x="1953" y="512"/>
                      </a:lnTo>
                      <a:lnTo>
                        <a:pt x="1956" y="509"/>
                      </a:lnTo>
                      <a:lnTo>
                        <a:pt x="1959" y="510"/>
                      </a:lnTo>
                      <a:lnTo>
                        <a:pt x="1962" y="510"/>
                      </a:lnTo>
                      <a:lnTo>
                        <a:pt x="1966" y="511"/>
                      </a:lnTo>
                      <a:lnTo>
                        <a:pt x="1969" y="510"/>
                      </a:lnTo>
                      <a:lnTo>
                        <a:pt x="1972" y="511"/>
                      </a:lnTo>
                      <a:lnTo>
                        <a:pt x="1976" y="510"/>
                      </a:lnTo>
                      <a:lnTo>
                        <a:pt x="1979" y="511"/>
                      </a:lnTo>
                      <a:lnTo>
                        <a:pt x="1982" y="512"/>
                      </a:lnTo>
                      <a:lnTo>
                        <a:pt x="1985" y="510"/>
                      </a:lnTo>
                      <a:lnTo>
                        <a:pt x="1989" y="510"/>
                      </a:lnTo>
                      <a:lnTo>
                        <a:pt x="1992" y="508"/>
                      </a:lnTo>
                      <a:lnTo>
                        <a:pt x="1995" y="509"/>
                      </a:lnTo>
                      <a:lnTo>
                        <a:pt x="1999" y="510"/>
                      </a:lnTo>
                      <a:lnTo>
                        <a:pt x="2002" y="510"/>
                      </a:lnTo>
                      <a:lnTo>
                        <a:pt x="2005" y="509"/>
                      </a:lnTo>
                      <a:lnTo>
                        <a:pt x="2009" y="509"/>
                      </a:lnTo>
                      <a:lnTo>
                        <a:pt x="2012" y="509"/>
                      </a:lnTo>
                      <a:lnTo>
                        <a:pt x="2015" y="508"/>
                      </a:lnTo>
                      <a:lnTo>
                        <a:pt x="2019" y="510"/>
                      </a:lnTo>
                      <a:lnTo>
                        <a:pt x="2022" y="509"/>
                      </a:lnTo>
                      <a:lnTo>
                        <a:pt x="2025" y="511"/>
                      </a:lnTo>
                      <a:lnTo>
                        <a:pt x="2028" y="510"/>
                      </a:lnTo>
                      <a:lnTo>
                        <a:pt x="2032" y="511"/>
                      </a:lnTo>
                      <a:lnTo>
                        <a:pt x="2035" y="509"/>
                      </a:lnTo>
                      <a:lnTo>
                        <a:pt x="2038" y="509"/>
                      </a:lnTo>
                      <a:lnTo>
                        <a:pt x="2042" y="510"/>
                      </a:lnTo>
                      <a:lnTo>
                        <a:pt x="2045" y="512"/>
                      </a:lnTo>
                      <a:lnTo>
                        <a:pt x="2048" y="511"/>
                      </a:lnTo>
                      <a:lnTo>
                        <a:pt x="2052" y="512"/>
                      </a:lnTo>
                      <a:lnTo>
                        <a:pt x="2055" y="513"/>
                      </a:lnTo>
                      <a:lnTo>
                        <a:pt x="2058" y="512"/>
                      </a:lnTo>
                      <a:lnTo>
                        <a:pt x="2062" y="511"/>
                      </a:lnTo>
                      <a:lnTo>
                        <a:pt x="2065" y="512"/>
                      </a:lnTo>
                      <a:lnTo>
                        <a:pt x="2068" y="510"/>
                      </a:lnTo>
                      <a:lnTo>
                        <a:pt x="2072" y="511"/>
                      </a:lnTo>
                      <a:lnTo>
                        <a:pt x="2075" y="512"/>
                      </a:lnTo>
                      <a:lnTo>
                        <a:pt x="2078" y="513"/>
                      </a:lnTo>
                      <a:lnTo>
                        <a:pt x="2081" y="512"/>
                      </a:lnTo>
                      <a:lnTo>
                        <a:pt x="2085" y="511"/>
                      </a:lnTo>
                      <a:lnTo>
                        <a:pt x="2088" y="512"/>
                      </a:lnTo>
                      <a:lnTo>
                        <a:pt x="2091" y="512"/>
                      </a:lnTo>
                      <a:lnTo>
                        <a:pt x="2095" y="512"/>
                      </a:lnTo>
                      <a:lnTo>
                        <a:pt x="2098" y="511"/>
                      </a:lnTo>
                      <a:lnTo>
                        <a:pt x="2101" y="512"/>
                      </a:lnTo>
                      <a:lnTo>
                        <a:pt x="2105" y="512"/>
                      </a:lnTo>
                      <a:lnTo>
                        <a:pt x="2108" y="512"/>
                      </a:lnTo>
                      <a:lnTo>
                        <a:pt x="2111" y="513"/>
                      </a:lnTo>
                      <a:lnTo>
                        <a:pt x="2115" y="510"/>
                      </a:lnTo>
                      <a:lnTo>
                        <a:pt x="2118" y="512"/>
                      </a:lnTo>
                      <a:lnTo>
                        <a:pt x="2121" y="513"/>
                      </a:lnTo>
                      <a:lnTo>
                        <a:pt x="2125" y="511"/>
                      </a:lnTo>
                      <a:lnTo>
                        <a:pt x="2128" y="513"/>
                      </a:lnTo>
                      <a:lnTo>
                        <a:pt x="2131" y="513"/>
                      </a:lnTo>
                      <a:lnTo>
                        <a:pt x="2134" y="512"/>
                      </a:lnTo>
                      <a:lnTo>
                        <a:pt x="2138" y="513"/>
                      </a:lnTo>
                      <a:lnTo>
                        <a:pt x="2141" y="511"/>
                      </a:lnTo>
                      <a:lnTo>
                        <a:pt x="2144" y="513"/>
                      </a:lnTo>
                      <a:lnTo>
                        <a:pt x="2148" y="513"/>
                      </a:lnTo>
                      <a:lnTo>
                        <a:pt x="2151" y="514"/>
                      </a:lnTo>
                      <a:lnTo>
                        <a:pt x="2154" y="514"/>
                      </a:lnTo>
                      <a:lnTo>
                        <a:pt x="2158" y="514"/>
                      </a:lnTo>
                      <a:lnTo>
                        <a:pt x="2161" y="515"/>
                      </a:lnTo>
                      <a:lnTo>
                        <a:pt x="2164" y="514"/>
                      </a:lnTo>
                      <a:lnTo>
                        <a:pt x="2168" y="512"/>
                      </a:lnTo>
                      <a:lnTo>
                        <a:pt x="2171" y="514"/>
                      </a:lnTo>
                      <a:lnTo>
                        <a:pt x="2174" y="514"/>
                      </a:lnTo>
                      <a:lnTo>
                        <a:pt x="2177" y="514"/>
                      </a:lnTo>
                      <a:lnTo>
                        <a:pt x="2181" y="513"/>
                      </a:lnTo>
                      <a:lnTo>
                        <a:pt x="2184" y="513"/>
                      </a:lnTo>
                      <a:lnTo>
                        <a:pt x="2187" y="513"/>
                      </a:lnTo>
                      <a:lnTo>
                        <a:pt x="2191" y="513"/>
                      </a:lnTo>
                      <a:lnTo>
                        <a:pt x="2194" y="513"/>
                      </a:lnTo>
                      <a:lnTo>
                        <a:pt x="2197" y="514"/>
                      </a:lnTo>
                      <a:lnTo>
                        <a:pt x="2201" y="515"/>
                      </a:lnTo>
                      <a:lnTo>
                        <a:pt x="2204" y="513"/>
                      </a:lnTo>
                      <a:lnTo>
                        <a:pt x="2207" y="513"/>
                      </a:lnTo>
                      <a:lnTo>
                        <a:pt x="2211" y="513"/>
                      </a:lnTo>
                      <a:lnTo>
                        <a:pt x="2214" y="513"/>
                      </a:lnTo>
                      <a:lnTo>
                        <a:pt x="2217" y="514"/>
                      </a:lnTo>
                      <a:lnTo>
                        <a:pt x="2221" y="513"/>
                      </a:lnTo>
                      <a:lnTo>
                        <a:pt x="2224" y="514"/>
                      </a:lnTo>
                      <a:lnTo>
                        <a:pt x="2227" y="512"/>
                      </a:lnTo>
                      <a:lnTo>
                        <a:pt x="2230" y="513"/>
                      </a:lnTo>
                      <a:lnTo>
                        <a:pt x="2234" y="513"/>
                      </a:lnTo>
                      <a:lnTo>
                        <a:pt x="2237" y="513"/>
                      </a:lnTo>
                      <a:lnTo>
                        <a:pt x="2240" y="515"/>
                      </a:lnTo>
                      <a:lnTo>
                        <a:pt x="2244" y="513"/>
                      </a:lnTo>
                      <a:lnTo>
                        <a:pt x="2247" y="513"/>
                      </a:lnTo>
                      <a:lnTo>
                        <a:pt x="2250" y="514"/>
                      </a:lnTo>
                      <a:lnTo>
                        <a:pt x="2253" y="513"/>
                      </a:lnTo>
                      <a:lnTo>
                        <a:pt x="2257" y="512"/>
                      </a:lnTo>
                      <a:lnTo>
                        <a:pt x="2260" y="513"/>
                      </a:lnTo>
                      <a:lnTo>
                        <a:pt x="2263" y="514"/>
                      </a:lnTo>
                      <a:lnTo>
                        <a:pt x="2267" y="512"/>
                      </a:lnTo>
                      <a:lnTo>
                        <a:pt x="2270" y="512"/>
                      </a:lnTo>
                      <a:lnTo>
                        <a:pt x="2273" y="512"/>
                      </a:lnTo>
                      <a:lnTo>
                        <a:pt x="2277" y="515"/>
                      </a:lnTo>
                      <a:lnTo>
                        <a:pt x="2280" y="512"/>
                      </a:lnTo>
                      <a:lnTo>
                        <a:pt x="2283" y="514"/>
                      </a:lnTo>
                      <a:lnTo>
                        <a:pt x="2287" y="512"/>
                      </a:lnTo>
                      <a:lnTo>
                        <a:pt x="2290" y="513"/>
                      </a:lnTo>
                      <a:lnTo>
                        <a:pt x="2293" y="514"/>
                      </a:lnTo>
                      <a:lnTo>
                        <a:pt x="2297" y="512"/>
                      </a:lnTo>
                      <a:lnTo>
                        <a:pt x="2300" y="512"/>
                      </a:lnTo>
                      <a:lnTo>
                        <a:pt x="2303" y="511"/>
                      </a:lnTo>
                      <a:lnTo>
                        <a:pt x="2306" y="512"/>
                      </a:lnTo>
                      <a:lnTo>
                        <a:pt x="2310" y="511"/>
                      </a:lnTo>
                      <a:lnTo>
                        <a:pt x="2313" y="511"/>
                      </a:lnTo>
                      <a:lnTo>
                        <a:pt x="2316" y="513"/>
                      </a:lnTo>
                      <a:lnTo>
                        <a:pt x="2320" y="512"/>
                      </a:lnTo>
                      <a:lnTo>
                        <a:pt x="2323" y="511"/>
                      </a:lnTo>
                      <a:lnTo>
                        <a:pt x="2326" y="511"/>
                      </a:lnTo>
                      <a:lnTo>
                        <a:pt x="2330" y="511"/>
                      </a:lnTo>
                      <a:lnTo>
                        <a:pt x="2333" y="512"/>
                      </a:lnTo>
                      <a:lnTo>
                        <a:pt x="2336" y="511"/>
                      </a:lnTo>
                      <a:lnTo>
                        <a:pt x="2340" y="512"/>
                      </a:lnTo>
                      <a:lnTo>
                        <a:pt x="2343" y="511"/>
                      </a:lnTo>
                      <a:lnTo>
                        <a:pt x="2346" y="510"/>
                      </a:lnTo>
                      <a:lnTo>
                        <a:pt x="2349" y="511"/>
                      </a:lnTo>
                      <a:lnTo>
                        <a:pt x="2353" y="511"/>
                      </a:lnTo>
                      <a:lnTo>
                        <a:pt x="2356" y="512"/>
                      </a:lnTo>
                      <a:lnTo>
                        <a:pt x="2359" y="511"/>
                      </a:lnTo>
                      <a:lnTo>
                        <a:pt x="2363" y="512"/>
                      </a:lnTo>
                      <a:lnTo>
                        <a:pt x="2366" y="510"/>
                      </a:lnTo>
                      <a:lnTo>
                        <a:pt x="2369" y="510"/>
                      </a:lnTo>
                      <a:lnTo>
                        <a:pt x="2373" y="511"/>
                      </a:lnTo>
                      <a:lnTo>
                        <a:pt x="2376" y="509"/>
                      </a:lnTo>
                      <a:lnTo>
                        <a:pt x="2379" y="511"/>
                      </a:lnTo>
                      <a:lnTo>
                        <a:pt x="2383" y="511"/>
                      </a:lnTo>
                      <a:lnTo>
                        <a:pt x="2386" y="511"/>
                      </a:lnTo>
                      <a:lnTo>
                        <a:pt x="2389" y="510"/>
                      </a:lnTo>
                      <a:lnTo>
                        <a:pt x="2393" y="511"/>
                      </a:lnTo>
                      <a:lnTo>
                        <a:pt x="2396" y="511"/>
                      </a:lnTo>
                      <a:lnTo>
                        <a:pt x="2399" y="510"/>
                      </a:lnTo>
                      <a:lnTo>
                        <a:pt x="2402" y="511"/>
                      </a:lnTo>
                      <a:lnTo>
                        <a:pt x="2406" y="511"/>
                      </a:lnTo>
                      <a:lnTo>
                        <a:pt x="2409" y="511"/>
                      </a:lnTo>
                      <a:lnTo>
                        <a:pt x="2412" y="509"/>
                      </a:lnTo>
                      <a:lnTo>
                        <a:pt x="2416" y="511"/>
                      </a:lnTo>
                      <a:lnTo>
                        <a:pt x="2419" y="512"/>
                      </a:lnTo>
                      <a:lnTo>
                        <a:pt x="2422" y="511"/>
                      </a:lnTo>
                      <a:lnTo>
                        <a:pt x="2426" y="511"/>
                      </a:lnTo>
                      <a:lnTo>
                        <a:pt x="2429" y="513"/>
                      </a:lnTo>
                      <a:lnTo>
                        <a:pt x="2432" y="510"/>
                      </a:lnTo>
                      <a:lnTo>
                        <a:pt x="2436" y="511"/>
                      </a:lnTo>
                      <a:lnTo>
                        <a:pt x="2439" y="512"/>
                      </a:lnTo>
                      <a:lnTo>
                        <a:pt x="2442" y="512"/>
                      </a:lnTo>
                      <a:lnTo>
                        <a:pt x="2445" y="511"/>
                      </a:lnTo>
                      <a:lnTo>
                        <a:pt x="2449" y="512"/>
                      </a:lnTo>
                      <a:lnTo>
                        <a:pt x="2452" y="513"/>
                      </a:lnTo>
                      <a:lnTo>
                        <a:pt x="2455" y="512"/>
                      </a:lnTo>
                      <a:lnTo>
                        <a:pt x="2459" y="510"/>
                      </a:lnTo>
                      <a:lnTo>
                        <a:pt x="2462" y="510"/>
                      </a:lnTo>
                      <a:lnTo>
                        <a:pt x="2465" y="512"/>
                      </a:lnTo>
                      <a:lnTo>
                        <a:pt x="2469" y="511"/>
                      </a:lnTo>
                      <a:lnTo>
                        <a:pt x="2472" y="512"/>
                      </a:lnTo>
                      <a:lnTo>
                        <a:pt x="2475" y="510"/>
                      </a:lnTo>
                      <a:lnTo>
                        <a:pt x="2479" y="510"/>
                      </a:lnTo>
                      <a:lnTo>
                        <a:pt x="2482" y="510"/>
                      </a:lnTo>
                      <a:lnTo>
                        <a:pt x="2485" y="510"/>
                      </a:lnTo>
                      <a:lnTo>
                        <a:pt x="2489" y="510"/>
                      </a:lnTo>
                      <a:lnTo>
                        <a:pt x="2492" y="510"/>
                      </a:lnTo>
                      <a:lnTo>
                        <a:pt x="2495" y="512"/>
                      </a:lnTo>
                      <a:lnTo>
                        <a:pt x="2498" y="511"/>
                      </a:lnTo>
                      <a:lnTo>
                        <a:pt x="2502" y="511"/>
                      </a:lnTo>
                      <a:lnTo>
                        <a:pt x="2505" y="510"/>
                      </a:lnTo>
                      <a:lnTo>
                        <a:pt x="2508" y="510"/>
                      </a:lnTo>
                      <a:lnTo>
                        <a:pt x="2512" y="512"/>
                      </a:lnTo>
                      <a:lnTo>
                        <a:pt x="2515" y="511"/>
                      </a:lnTo>
                      <a:lnTo>
                        <a:pt x="2518" y="511"/>
                      </a:lnTo>
                      <a:lnTo>
                        <a:pt x="2521" y="511"/>
                      </a:lnTo>
                      <a:lnTo>
                        <a:pt x="2525" y="510"/>
                      </a:lnTo>
                      <a:lnTo>
                        <a:pt x="2528" y="511"/>
                      </a:lnTo>
                      <a:lnTo>
                        <a:pt x="2531" y="513"/>
                      </a:lnTo>
                      <a:lnTo>
                        <a:pt x="2535" y="510"/>
                      </a:lnTo>
                      <a:lnTo>
                        <a:pt x="2538" y="511"/>
                      </a:lnTo>
                      <a:lnTo>
                        <a:pt x="2541" y="512"/>
                      </a:lnTo>
                      <a:lnTo>
                        <a:pt x="2545" y="510"/>
                      </a:lnTo>
                      <a:lnTo>
                        <a:pt x="2548" y="509"/>
                      </a:lnTo>
                      <a:lnTo>
                        <a:pt x="2551" y="512"/>
                      </a:lnTo>
                      <a:lnTo>
                        <a:pt x="2555" y="509"/>
                      </a:lnTo>
                      <a:lnTo>
                        <a:pt x="2558" y="511"/>
                      </a:lnTo>
                      <a:lnTo>
                        <a:pt x="2561" y="511"/>
                      </a:lnTo>
                      <a:lnTo>
                        <a:pt x="2565" y="512"/>
                      </a:lnTo>
                      <a:lnTo>
                        <a:pt x="2568" y="512"/>
                      </a:lnTo>
                      <a:lnTo>
                        <a:pt x="2571" y="511"/>
                      </a:lnTo>
                      <a:lnTo>
                        <a:pt x="2574" y="512"/>
                      </a:lnTo>
                      <a:lnTo>
                        <a:pt x="2578" y="511"/>
                      </a:lnTo>
                      <a:lnTo>
                        <a:pt x="2581" y="510"/>
                      </a:lnTo>
                      <a:lnTo>
                        <a:pt x="2584" y="511"/>
                      </a:lnTo>
                      <a:lnTo>
                        <a:pt x="2588" y="511"/>
                      </a:lnTo>
                      <a:lnTo>
                        <a:pt x="2591" y="512"/>
                      </a:lnTo>
                      <a:lnTo>
                        <a:pt x="2594" y="510"/>
                      </a:lnTo>
                      <a:lnTo>
                        <a:pt x="2598" y="510"/>
                      </a:lnTo>
                      <a:lnTo>
                        <a:pt x="2601" y="510"/>
                      </a:lnTo>
                      <a:lnTo>
                        <a:pt x="2604" y="511"/>
                      </a:lnTo>
                      <a:lnTo>
                        <a:pt x="2608" y="510"/>
                      </a:lnTo>
                      <a:lnTo>
                        <a:pt x="2611" y="511"/>
                      </a:lnTo>
                      <a:lnTo>
                        <a:pt x="2614" y="511"/>
                      </a:lnTo>
                      <a:lnTo>
                        <a:pt x="2617" y="511"/>
                      </a:lnTo>
                      <a:lnTo>
                        <a:pt x="2621" y="512"/>
                      </a:lnTo>
                      <a:lnTo>
                        <a:pt x="2624" y="511"/>
                      </a:lnTo>
                      <a:lnTo>
                        <a:pt x="2627" y="511"/>
                      </a:lnTo>
                      <a:lnTo>
                        <a:pt x="2631" y="511"/>
                      </a:lnTo>
                      <a:lnTo>
                        <a:pt x="2634" y="512"/>
                      </a:lnTo>
                      <a:lnTo>
                        <a:pt x="2637" y="509"/>
                      </a:lnTo>
                      <a:lnTo>
                        <a:pt x="2641" y="509"/>
                      </a:lnTo>
                      <a:lnTo>
                        <a:pt x="2644" y="510"/>
                      </a:lnTo>
                      <a:lnTo>
                        <a:pt x="2647" y="511"/>
                      </a:lnTo>
                      <a:lnTo>
                        <a:pt x="2651" y="509"/>
                      </a:lnTo>
                      <a:lnTo>
                        <a:pt x="2654" y="511"/>
                      </a:lnTo>
                      <a:lnTo>
                        <a:pt x="2657" y="511"/>
                      </a:lnTo>
                      <a:lnTo>
                        <a:pt x="2661" y="511"/>
                      </a:lnTo>
                      <a:lnTo>
                        <a:pt x="2664" y="510"/>
                      </a:lnTo>
                      <a:lnTo>
                        <a:pt x="2667" y="511"/>
                      </a:lnTo>
                      <a:lnTo>
                        <a:pt x="2670" y="509"/>
                      </a:lnTo>
                      <a:lnTo>
                        <a:pt x="2674" y="510"/>
                      </a:lnTo>
                      <a:lnTo>
                        <a:pt x="2677" y="510"/>
                      </a:lnTo>
                      <a:lnTo>
                        <a:pt x="2680" y="509"/>
                      </a:lnTo>
                      <a:lnTo>
                        <a:pt x="2684" y="509"/>
                      </a:lnTo>
                      <a:lnTo>
                        <a:pt x="2687" y="511"/>
                      </a:lnTo>
                      <a:lnTo>
                        <a:pt x="2690" y="510"/>
                      </a:lnTo>
                      <a:lnTo>
                        <a:pt x="2694" y="508"/>
                      </a:lnTo>
                      <a:lnTo>
                        <a:pt x="2697" y="510"/>
                      </a:lnTo>
                      <a:lnTo>
                        <a:pt x="2700" y="511"/>
                      </a:lnTo>
                      <a:lnTo>
                        <a:pt x="2704" y="509"/>
                      </a:lnTo>
                      <a:lnTo>
                        <a:pt x="2707" y="507"/>
                      </a:lnTo>
                      <a:lnTo>
                        <a:pt x="2710" y="508"/>
                      </a:lnTo>
                      <a:lnTo>
                        <a:pt x="2714" y="509"/>
                      </a:lnTo>
                      <a:lnTo>
                        <a:pt x="2717" y="510"/>
                      </a:lnTo>
                      <a:lnTo>
                        <a:pt x="2720" y="510"/>
                      </a:lnTo>
                      <a:lnTo>
                        <a:pt x="2723" y="509"/>
                      </a:lnTo>
                      <a:lnTo>
                        <a:pt x="2727" y="507"/>
                      </a:lnTo>
                      <a:lnTo>
                        <a:pt x="2730" y="509"/>
                      </a:lnTo>
                      <a:lnTo>
                        <a:pt x="2733" y="509"/>
                      </a:lnTo>
                      <a:lnTo>
                        <a:pt x="2737" y="507"/>
                      </a:lnTo>
                      <a:lnTo>
                        <a:pt x="2740" y="508"/>
                      </a:lnTo>
                      <a:lnTo>
                        <a:pt x="2743" y="506"/>
                      </a:lnTo>
                      <a:lnTo>
                        <a:pt x="2747" y="508"/>
                      </a:lnTo>
                      <a:lnTo>
                        <a:pt x="2750" y="508"/>
                      </a:lnTo>
                      <a:lnTo>
                        <a:pt x="2753" y="510"/>
                      </a:lnTo>
                      <a:lnTo>
                        <a:pt x="2757" y="508"/>
                      </a:lnTo>
                      <a:lnTo>
                        <a:pt x="2760" y="510"/>
                      </a:lnTo>
                      <a:lnTo>
                        <a:pt x="2763" y="508"/>
                      </a:lnTo>
                      <a:lnTo>
                        <a:pt x="2766" y="508"/>
                      </a:lnTo>
                      <a:lnTo>
                        <a:pt x="2770" y="510"/>
                      </a:lnTo>
                      <a:lnTo>
                        <a:pt x="2773" y="508"/>
                      </a:lnTo>
                      <a:lnTo>
                        <a:pt x="2776" y="508"/>
                      </a:lnTo>
                      <a:lnTo>
                        <a:pt x="2780" y="509"/>
                      </a:lnTo>
                      <a:lnTo>
                        <a:pt x="2783" y="511"/>
                      </a:lnTo>
                      <a:lnTo>
                        <a:pt x="2786" y="508"/>
                      </a:lnTo>
                      <a:lnTo>
                        <a:pt x="2789" y="507"/>
                      </a:lnTo>
                      <a:lnTo>
                        <a:pt x="2793" y="508"/>
                      </a:lnTo>
                      <a:lnTo>
                        <a:pt x="2796" y="507"/>
                      </a:lnTo>
                      <a:lnTo>
                        <a:pt x="2799" y="506"/>
                      </a:lnTo>
                      <a:lnTo>
                        <a:pt x="2803" y="507"/>
                      </a:lnTo>
                      <a:lnTo>
                        <a:pt x="2806" y="506"/>
                      </a:lnTo>
                      <a:lnTo>
                        <a:pt x="2809" y="506"/>
                      </a:lnTo>
                      <a:lnTo>
                        <a:pt x="2813" y="507"/>
                      </a:lnTo>
                      <a:lnTo>
                        <a:pt x="2816" y="506"/>
                      </a:lnTo>
                      <a:lnTo>
                        <a:pt x="2819" y="506"/>
                      </a:lnTo>
                      <a:lnTo>
                        <a:pt x="2823" y="507"/>
                      </a:lnTo>
                      <a:lnTo>
                        <a:pt x="2826" y="506"/>
                      </a:lnTo>
                      <a:lnTo>
                        <a:pt x="2829" y="506"/>
                      </a:lnTo>
                      <a:lnTo>
                        <a:pt x="2833" y="505"/>
                      </a:lnTo>
                      <a:lnTo>
                        <a:pt x="2836" y="506"/>
                      </a:lnTo>
                      <a:lnTo>
                        <a:pt x="2839" y="504"/>
                      </a:lnTo>
                      <a:lnTo>
                        <a:pt x="2842" y="506"/>
                      </a:lnTo>
                      <a:lnTo>
                        <a:pt x="2846" y="504"/>
                      </a:lnTo>
                      <a:lnTo>
                        <a:pt x="2849" y="505"/>
                      </a:lnTo>
                      <a:lnTo>
                        <a:pt x="2852" y="504"/>
                      </a:lnTo>
                      <a:lnTo>
                        <a:pt x="2856" y="504"/>
                      </a:lnTo>
                      <a:lnTo>
                        <a:pt x="2859" y="504"/>
                      </a:lnTo>
                      <a:lnTo>
                        <a:pt x="2862" y="502"/>
                      </a:lnTo>
                      <a:lnTo>
                        <a:pt x="2866" y="502"/>
                      </a:lnTo>
                      <a:lnTo>
                        <a:pt x="2869" y="504"/>
                      </a:lnTo>
                      <a:lnTo>
                        <a:pt x="2872" y="502"/>
                      </a:lnTo>
                      <a:lnTo>
                        <a:pt x="2876" y="504"/>
                      </a:lnTo>
                      <a:lnTo>
                        <a:pt x="2879" y="502"/>
                      </a:lnTo>
                      <a:lnTo>
                        <a:pt x="2882" y="502"/>
                      </a:lnTo>
                      <a:lnTo>
                        <a:pt x="2886" y="502"/>
                      </a:lnTo>
                      <a:lnTo>
                        <a:pt x="2889" y="500"/>
                      </a:lnTo>
                      <a:lnTo>
                        <a:pt x="2892" y="499"/>
                      </a:lnTo>
                      <a:lnTo>
                        <a:pt x="2895" y="501"/>
                      </a:lnTo>
                      <a:lnTo>
                        <a:pt x="2899" y="500"/>
                      </a:lnTo>
                      <a:lnTo>
                        <a:pt x="2902" y="500"/>
                      </a:lnTo>
                      <a:lnTo>
                        <a:pt x="2905" y="498"/>
                      </a:lnTo>
                      <a:lnTo>
                        <a:pt x="2909" y="498"/>
                      </a:lnTo>
                      <a:lnTo>
                        <a:pt x="2912" y="498"/>
                      </a:lnTo>
                      <a:lnTo>
                        <a:pt x="2915" y="498"/>
                      </a:lnTo>
                      <a:lnTo>
                        <a:pt x="2919" y="498"/>
                      </a:lnTo>
                      <a:lnTo>
                        <a:pt x="2922" y="497"/>
                      </a:lnTo>
                      <a:lnTo>
                        <a:pt x="2925" y="497"/>
                      </a:lnTo>
                      <a:lnTo>
                        <a:pt x="2929" y="496"/>
                      </a:lnTo>
                      <a:lnTo>
                        <a:pt x="2932" y="496"/>
                      </a:lnTo>
                      <a:lnTo>
                        <a:pt x="2935" y="495"/>
                      </a:lnTo>
                      <a:lnTo>
                        <a:pt x="2938" y="495"/>
                      </a:lnTo>
                      <a:lnTo>
                        <a:pt x="2942" y="492"/>
                      </a:lnTo>
                      <a:lnTo>
                        <a:pt x="2945" y="492"/>
                      </a:lnTo>
                      <a:lnTo>
                        <a:pt x="2948" y="491"/>
                      </a:lnTo>
                      <a:lnTo>
                        <a:pt x="2952" y="491"/>
                      </a:lnTo>
                      <a:lnTo>
                        <a:pt x="2955" y="491"/>
                      </a:lnTo>
                      <a:lnTo>
                        <a:pt x="2958" y="489"/>
                      </a:lnTo>
                      <a:lnTo>
                        <a:pt x="2962" y="490"/>
                      </a:lnTo>
                      <a:lnTo>
                        <a:pt x="2965" y="488"/>
                      </a:lnTo>
                      <a:lnTo>
                        <a:pt x="2968" y="489"/>
                      </a:lnTo>
                      <a:lnTo>
                        <a:pt x="2972" y="488"/>
                      </a:lnTo>
                      <a:lnTo>
                        <a:pt x="2975" y="485"/>
                      </a:lnTo>
                      <a:lnTo>
                        <a:pt x="2978" y="484"/>
                      </a:lnTo>
                      <a:lnTo>
                        <a:pt x="2982" y="484"/>
                      </a:lnTo>
                      <a:lnTo>
                        <a:pt x="2985" y="485"/>
                      </a:lnTo>
                      <a:lnTo>
                        <a:pt x="2988" y="483"/>
                      </a:lnTo>
                      <a:lnTo>
                        <a:pt x="2991" y="483"/>
                      </a:lnTo>
                      <a:lnTo>
                        <a:pt x="2995" y="481"/>
                      </a:lnTo>
                      <a:lnTo>
                        <a:pt x="2998" y="481"/>
                      </a:lnTo>
                      <a:lnTo>
                        <a:pt x="3001" y="482"/>
                      </a:lnTo>
                      <a:lnTo>
                        <a:pt x="3005" y="479"/>
                      </a:lnTo>
                      <a:lnTo>
                        <a:pt x="3008" y="479"/>
                      </a:lnTo>
                      <a:lnTo>
                        <a:pt x="3011" y="481"/>
                      </a:lnTo>
                      <a:lnTo>
                        <a:pt x="3015" y="478"/>
                      </a:lnTo>
                      <a:lnTo>
                        <a:pt x="3018" y="477"/>
                      </a:lnTo>
                      <a:lnTo>
                        <a:pt x="3021" y="477"/>
                      </a:lnTo>
                      <a:lnTo>
                        <a:pt x="3025" y="479"/>
                      </a:lnTo>
                      <a:lnTo>
                        <a:pt x="3028" y="477"/>
                      </a:lnTo>
                      <a:lnTo>
                        <a:pt x="3031" y="476"/>
                      </a:lnTo>
                      <a:lnTo>
                        <a:pt x="3035" y="475"/>
                      </a:lnTo>
                      <a:lnTo>
                        <a:pt x="3038" y="475"/>
                      </a:lnTo>
                      <a:lnTo>
                        <a:pt x="3041" y="474"/>
                      </a:lnTo>
                      <a:lnTo>
                        <a:pt x="3044" y="473"/>
                      </a:lnTo>
                      <a:lnTo>
                        <a:pt x="3048" y="472"/>
                      </a:lnTo>
                      <a:lnTo>
                        <a:pt x="3051" y="470"/>
                      </a:lnTo>
                      <a:lnTo>
                        <a:pt x="3054" y="470"/>
                      </a:lnTo>
                      <a:lnTo>
                        <a:pt x="3058" y="470"/>
                      </a:lnTo>
                      <a:lnTo>
                        <a:pt x="3061" y="470"/>
                      </a:lnTo>
                      <a:lnTo>
                        <a:pt x="3064" y="468"/>
                      </a:lnTo>
                      <a:lnTo>
                        <a:pt x="3067" y="468"/>
                      </a:lnTo>
                      <a:lnTo>
                        <a:pt x="3071" y="467"/>
                      </a:lnTo>
                      <a:lnTo>
                        <a:pt x="3074" y="466"/>
                      </a:lnTo>
                      <a:lnTo>
                        <a:pt x="3077" y="464"/>
                      </a:lnTo>
                      <a:lnTo>
                        <a:pt x="3081" y="465"/>
                      </a:lnTo>
                      <a:lnTo>
                        <a:pt x="3084" y="463"/>
                      </a:lnTo>
                      <a:lnTo>
                        <a:pt x="3087" y="462"/>
                      </a:lnTo>
                      <a:lnTo>
                        <a:pt x="3091" y="461"/>
                      </a:lnTo>
                      <a:lnTo>
                        <a:pt x="3094" y="461"/>
                      </a:lnTo>
                      <a:lnTo>
                        <a:pt x="3097" y="459"/>
                      </a:lnTo>
                      <a:lnTo>
                        <a:pt x="3101" y="458"/>
                      </a:lnTo>
                      <a:lnTo>
                        <a:pt x="3104" y="456"/>
                      </a:lnTo>
                      <a:lnTo>
                        <a:pt x="3107" y="458"/>
                      </a:lnTo>
                      <a:lnTo>
                        <a:pt x="3110" y="456"/>
                      </a:lnTo>
                      <a:lnTo>
                        <a:pt x="3114" y="454"/>
                      </a:lnTo>
                      <a:lnTo>
                        <a:pt x="3117" y="454"/>
                      </a:lnTo>
                      <a:lnTo>
                        <a:pt x="3120" y="453"/>
                      </a:lnTo>
                      <a:lnTo>
                        <a:pt x="3124" y="450"/>
                      </a:lnTo>
                      <a:lnTo>
                        <a:pt x="3127" y="452"/>
                      </a:lnTo>
                      <a:lnTo>
                        <a:pt x="3130" y="451"/>
                      </a:lnTo>
                      <a:lnTo>
                        <a:pt x="3134" y="449"/>
                      </a:lnTo>
                      <a:lnTo>
                        <a:pt x="3137" y="446"/>
                      </a:lnTo>
                      <a:lnTo>
                        <a:pt x="3140" y="446"/>
                      </a:lnTo>
                      <a:lnTo>
                        <a:pt x="3144" y="449"/>
                      </a:lnTo>
                      <a:lnTo>
                        <a:pt x="3147" y="447"/>
                      </a:lnTo>
                      <a:lnTo>
                        <a:pt x="3150" y="444"/>
                      </a:lnTo>
                      <a:lnTo>
                        <a:pt x="3154" y="444"/>
                      </a:lnTo>
                      <a:lnTo>
                        <a:pt x="3157" y="445"/>
                      </a:lnTo>
                      <a:lnTo>
                        <a:pt x="3160" y="441"/>
                      </a:lnTo>
                      <a:lnTo>
                        <a:pt x="3163" y="441"/>
                      </a:lnTo>
                      <a:lnTo>
                        <a:pt x="3167" y="441"/>
                      </a:lnTo>
                      <a:lnTo>
                        <a:pt x="3170" y="438"/>
                      </a:lnTo>
                      <a:lnTo>
                        <a:pt x="3173" y="435"/>
                      </a:lnTo>
                      <a:lnTo>
                        <a:pt x="3177" y="434"/>
                      </a:lnTo>
                      <a:lnTo>
                        <a:pt x="3180" y="433"/>
                      </a:lnTo>
                      <a:lnTo>
                        <a:pt x="3183" y="430"/>
                      </a:lnTo>
                      <a:lnTo>
                        <a:pt x="3187" y="426"/>
                      </a:lnTo>
                      <a:lnTo>
                        <a:pt x="3190" y="423"/>
                      </a:lnTo>
                      <a:lnTo>
                        <a:pt x="3193" y="419"/>
                      </a:lnTo>
                      <a:lnTo>
                        <a:pt x="3197" y="414"/>
                      </a:lnTo>
                      <a:lnTo>
                        <a:pt x="3200" y="408"/>
                      </a:lnTo>
                      <a:lnTo>
                        <a:pt x="3203" y="400"/>
                      </a:lnTo>
                      <a:lnTo>
                        <a:pt x="3207" y="392"/>
                      </a:lnTo>
                      <a:lnTo>
                        <a:pt x="3210" y="382"/>
                      </a:lnTo>
                      <a:lnTo>
                        <a:pt x="3213" y="372"/>
                      </a:lnTo>
                      <a:lnTo>
                        <a:pt x="3216" y="362"/>
                      </a:lnTo>
                      <a:lnTo>
                        <a:pt x="3220" y="348"/>
                      </a:lnTo>
                      <a:lnTo>
                        <a:pt x="3223" y="335"/>
                      </a:lnTo>
                      <a:lnTo>
                        <a:pt x="3226" y="319"/>
                      </a:lnTo>
                      <a:lnTo>
                        <a:pt x="3230" y="301"/>
                      </a:lnTo>
                      <a:lnTo>
                        <a:pt x="3233" y="283"/>
                      </a:lnTo>
                      <a:lnTo>
                        <a:pt x="3236" y="267"/>
                      </a:lnTo>
                      <a:lnTo>
                        <a:pt x="3240" y="248"/>
                      </a:lnTo>
                      <a:lnTo>
                        <a:pt x="3243" y="228"/>
                      </a:lnTo>
                      <a:lnTo>
                        <a:pt x="3246" y="208"/>
                      </a:lnTo>
                      <a:lnTo>
                        <a:pt x="3250" y="187"/>
                      </a:lnTo>
                      <a:lnTo>
                        <a:pt x="3253" y="167"/>
                      </a:lnTo>
                      <a:lnTo>
                        <a:pt x="3256" y="148"/>
                      </a:lnTo>
                      <a:lnTo>
                        <a:pt x="3259" y="128"/>
                      </a:lnTo>
                      <a:lnTo>
                        <a:pt x="3263" y="110"/>
                      </a:lnTo>
                      <a:lnTo>
                        <a:pt x="3266" y="94"/>
                      </a:lnTo>
                      <a:lnTo>
                        <a:pt x="3269" y="78"/>
                      </a:lnTo>
                      <a:lnTo>
                        <a:pt x="3273" y="61"/>
                      </a:lnTo>
                      <a:lnTo>
                        <a:pt x="3276" y="48"/>
                      </a:lnTo>
                      <a:lnTo>
                        <a:pt x="3279" y="38"/>
                      </a:lnTo>
                      <a:lnTo>
                        <a:pt x="3283" y="29"/>
                      </a:lnTo>
                      <a:lnTo>
                        <a:pt x="3286" y="18"/>
                      </a:lnTo>
                      <a:lnTo>
                        <a:pt x="3289" y="12"/>
                      </a:lnTo>
                      <a:lnTo>
                        <a:pt x="3293" y="9"/>
                      </a:lnTo>
                      <a:lnTo>
                        <a:pt x="3296" y="4"/>
                      </a:lnTo>
                      <a:lnTo>
                        <a:pt x="3299" y="2"/>
                      </a:lnTo>
                      <a:lnTo>
                        <a:pt x="3303" y="0"/>
                      </a:lnTo>
                      <a:lnTo>
                        <a:pt x="3306" y="1"/>
                      </a:lnTo>
                      <a:lnTo>
                        <a:pt x="3309" y="2"/>
                      </a:lnTo>
                      <a:lnTo>
                        <a:pt x="3312" y="6"/>
                      </a:lnTo>
                      <a:lnTo>
                        <a:pt x="3316" y="10"/>
                      </a:lnTo>
                      <a:lnTo>
                        <a:pt x="3319" y="13"/>
                      </a:lnTo>
                      <a:lnTo>
                        <a:pt x="3322" y="19"/>
                      </a:lnTo>
                      <a:lnTo>
                        <a:pt x="3326" y="25"/>
                      </a:lnTo>
                      <a:lnTo>
                        <a:pt x="3329" y="32"/>
                      </a:lnTo>
                      <a:lnTo>
                        <a:pt x="3332" y="38"/>
                      </a:lnTo>
                      <a:lnTo>
                        <a:pt x="3335" y="47"/>
                      </a:lnTo>
                      <a:lnTo>
                        <a:pt x="3339" y="56"/>
                      </a:lnTo>
                      <a:lnTo>
                        <a:pt x="3342" y="68"/>
                      </a:lnTo>
                      <a:lnTo>
                        <a:pt x="3345" y="75"/>
                      </a:lnTo>
                      <a:lnTo>
                        <a:pt x="3349" y="85"/>
                      </a:lnTo>
                      <a:lnTo>
                        <a:pt x="3352" y="96"/>
                      </a:lnTo>
                      <a:lnTo>
                        <a:pt x="3355" y="107"/>
                      </a:lnTo>
                      <a:lnTo>
                        <a:pt x="3359" y="117"/>
                      </a:lnTo>
                      <a:lnTo>
                        <a:pt x="3362" y="128"/>
                      </a:lnTo>
                      <a:lnTo>
                        <a:pt x="3365" y="141"/>
                      </a:lnTo>
                      <a:lnTo>
                        <a:pt x="3369" y="152"/>
                      </a:lnTo>
                      <a:lnTo>
                        <a:pt x="3372" y="163"/>
                      </a:lnTo>
                      <a:lnTo>
                        <a:pt x="3375" y="174"/>
                      </a:lnTo>
                      <a:lnTo>
                        <a:pt x="3379" y="186"/>
                      </a:lnTo>
                      <a:lnTo>
                        <a:pt x="3382" y="198"/>
                      </a:lnTo>
                      <a:lnTo>
                        <a:pt x="3385" y="210"/>
                      </a:lnTo>
                      <a:lnTo>
                        <a:pt x="3388" y="221"/>
                      </a:lnTo>
                      <a:lnTo>
                        <a:pt x="3392" y="233"/>
                      </a:lnTo>
                      <a:lnTo>
                        <a:pt x="3395" y="243"/>
                      </a:lnTo>
                      <a:lnTo>
                        <a:pt x="3398" y="254"/>
                      </a:lnTo>
                      <a:lnTo>
                        <a:pt x="3402" y="265"/>
                      </a:lnTo>
                      <a:lnTo>
                        <a:pt x="3405" y="278"/>
                      </a:lnTo>
                      <a:lnTo>
                        <a:pt x="3408" y="288"/>
                      </a:lnTo>
                      <a:lnTo>
                        <a:pt x="3412" y="298"/>
                      </a:lnTo>
                      <a:lnTo>
                        <a:pt x="3415" y="308"/>
                      </a:lnTo>
                      <a:lnTo>
                        <a:pt x="3418" y="317"/>
                      </a:lnTo>
                      <a:lnTo>
                        <a:pt x="3422" y="327"/>
                      </a:lnTo>
                      <a:lnTo>
                        <a:pt x="3425" y="336"/>
                      </a:lnTo>
                      <a:lnTo>
                        <a:pt x="3428" y="345"/>
                      </a:lnTo>
                      <a:lnTo>
                        <a:pt x="3431" y="354"/>
                      </a:lnTo>
                      <a:lnTo>
                        <a:pt x="3435" y="361"/>
                      </a:lnTo>
                      <a:lnTo>
                        <a:pt x="3438" y="369"/>
                      </a:lnTo>
                      <a:lnTo>
                        <a:pt x="3441" y="376"/>
                      </a:lnTo>
                      <a:lnTo>
                        <a:pt x="3445" y="386"/>
                      </a:lnTo>
                      <a:lnTo>
                        <a:pt x="3448" y="392"/>
                      </a:lnTo>
                      <a:lnTo>
                        <a:pt x="3451" y="399"/>
                      </a:lnTo>
                      <a:lnTo>
                        <a:pt x="3455" y="406"/>
                      </a:lnTo>
                      <a:lnTo>
                        <a:pt x="3458" y="411"/>
                      </a:lnTo>
                      <a:lnTo>
                        <a:pt x="3461" y="419"/>
                      </a:lnTo>
                      <a:lnTo>
                        <a:pt x="3465" y="424"/>
                      </a:lnTo>
                      <a:lnTo>
                        <a:pt x="3468" y="430"/>
                      </a:lnTo>
                      <a:lnTo>
                        <a:pt x="3471" y="435"/>
                      </a:lnTo>
                      <a:lnTo>
                        <a:pt x="3475" y="439"/>
                      </a:lnTo>
                      <a:lnTo>
                        <a:pt x="3478" y="444"/>
                      </a:lnTo>
                      <a:lnTo>
                        <a:pt x="3481" y="447"/>
                      </a:lnTo>
                      <a:lnTo>
                        <a:pt x="3484" y="452"/>
                      </a:lnTo>
                      <a:lnTo>
                        <a:pt x="3488" y="457"/>
                      </a:lnTo>
                      <a:lnTo>
                        <a:pt x="3491" y="459"/>
                      </a:lnTo>
                      <a:lnTo>
                        <a:pt x="3494" y="464"/>
                      </a:lnTo>
                      <a:lnTo>
                        <a:pt x="3498" y="467"/>
                      </a:lnTo>
                      <a:lnTo>
                        <a:pt x="3501" y="470"/>
                      </a:lnTo>
                      <a:lnTo>
                        <a:pt x="3504" y="472"/>
                      </a:lnTo>
                      <a:lnTo>
                        <a:pt x="3508" y="476"/>
                      </a:lnTo>
                      <a:lnTo>
                        <a:pt x="3511" y="477"/>
                      </a:lnTo>
                      <a:lnTo>
                        <a:pt x="3514" y="478"/>
                      </a:lnTo>
                      <a:lnTo>
                        <a:pt x="3518" y="479"/>
                      </a:lnTo>
                      <a:lnTo>
                        <a:pt x="3521" y="483"/>
                      </a:lnTo>
                      <a:lnTo>
                        <a:pt x="3524" y="486"/>
                      </a:lnTo>
                      <a:lnTo>
                        <a:pt x="3527" y="487"/>
                      </a:lnTo>
                      <a:lnTo>
                        <a:pt x="3531" y="488"/>
                      </a:lnTo>
                      <a:lnTo>
                        <a:pt x="3534" y="491"/>
                      </a:lnTo>
                      <a:lnTo>
                        <a:pt x="3537" y="491"/>
                      </a:lnTo>
                      <a:lnTo>
                        <a:pt x="3541" y="492"/>
                      </a:lnTo>
                      <a:lnTo>
                        <a:pt x="3544" y="494"/>
                      </a:lnTo>
                      <a:lnTo>
                        <a:pt x="3547" y="497"/>
                      </a:lnTo>
                      <a:lnTo>
                        <a:pt x="3551" y="496"/>
                      </a:lnTo>
                      <a:lnTo>
                        <a:pt x="3554" y="496"/>
                      </a:lnTo>
                      <a:lnTo>
                        <a:pt x="3557" y="499"/>
                      </a:lnTo>
                      <a:lnTo>
                        <a:pt x="3561" y="499"/>
                      </a:lnTo>
                      <a:lnTo>
                        <a:pt x="3564" y="500"/>
                      </a:lnTo>
                      <a:lnTo>
                        <a:pt x="3567" y="500"/>
                      </a:lnTo>
                      <a:lnTo>
                        <a:pt x="3571" y="502"/>
                      </a:lnTo>
                      <a:lnTo>
                        <a:pt x="3574" y="502"/>
                      </a:lnTo>
                      <a:lnTo>
                        <a:pt x="3577" y="503"/>
                      </a:lnTo>
                      <a:lnTo>
                        <a:pt x="3580" y="503"/>
                      </a:lnTo>
                      <a:lnTo>
                        <a:pt x="3584" y="504"/>
                      </a:lnTo>
                      <a:lnTo>
                        <a:pt x="3587" y="503"/>
                      </a:lnTo>
                      <a:lnTo>
                        <a:pt x="3590" y="505"/>
                      </a:lnTo>
                      <a:lnTo>
                        <a:pt x="3594" y="506"/>
                      </a:lnTo>
                      <a:lnTo>
                        <a:pt x="3597" y="507"/>
                      </a:lnTo>
                      <a:lnTo>
                        <a:pt x="3600" y="507"/>
                      </a:lnTo>
                      <a:lnTo>
                        <a:pt x="3603" y="508"/>
                      </a:lnTo>
                      <a:lnTo>
                        <a:pt x="3607" y="507"/>
                      </a:lnTo>
                      <a:lnTo>
                        <a:pt x="3610" y="506"/>
                      </a:lnTo>
                      <a:lnTo>
                        <a:pt x="3613" y="506"/>
                      </a:lnTo>
                      <a:lnTo>
                        <a:pt x="3617" y="510"/>
                      </a:lnTo>
                      <a:lnTo>
                        <a:pt x="3620" y="510"/>
                      </a:lnTo>
                      <a:lnTo>
                        <a:pt x="3624" y="511"/>
                      </a:lnTo>
                      <a:lnTo>
                        <a:pt x="3627" y="508"/>
                      </a:lnTo>
                      <a:lnTo>
                        <a:pt x="3630" y="510"/>
                      </a:lnTo>
                      <a:lnTo>
                        <a:pt x="3633" y="511"/>
                      </a:lnTo>
                      <a:lnTo>
                        <a:pt x="3637" y="510"/>
                      </a:lnTo>
                      <a:lnTo>
                        <a:pt x="3640" y="511"/>
                      </a:lnTo>
                      <a:lnTo>
                        <a:pt x="3643" y="511"/>
                      </a:lnTo>
                      <a:lnTo>
                        <a:pt x="3647" y="512"/>
                      </a:lnTo>
                      <a:lnTo>
                        <a:pt x="3650" y="512"/>
                      </a:lnTo>
                      <a:lnTo>
                        <a:pt x="3653" y="511"/>
                      </a:lnTo>
                      <a:lnTo>
                        <a:pt x="3656" y="512"/>
                      </a:lnTo>
                      <a:lnTo>
                        <a:pt x="3660" y="513"/>
                      </a:lnTo>
                      <a:lnTo>
                        <a:pt x="3663" y="513"/>
                      </a:lnTo>
                      <a:lnTo>
                        <a:pt x="3666" y="513"/>
                      </a:lnTo>
                      <a:lnTo>
                        <a:pt x="3670" y="512"/>
                      </a:lnTo>
                      <a:lnTo>
                        <a:pt x="3673" y="513"/>
                      </a:lnTo>
                      <a:lnTo>
                        <a:pt x="3676" y="514"/>
                      </a:lnTo>
                      <a:lnTo>
                        <a:pt x="3680" y="512"/>
                      </a:lnTo>
                      <a:lnTo>
                        <a:pt x="3683" y="514"/>
                      </a:lnTo>
                      <a:lnTo>
                        <a:pt x="3686" y="514"/>
                      </a:lnTo>
                      <a:lnTo>
                        <a:pt x="3690" y="514"/>
                      </a:lnTo>
                      <a:lnTo>
                        <a:pt x="3693" y="514"/>
                      </a:lnTo>
                      <a:lnTo>
                        <a:pt x="3696" y="514"/>
                      </a:lnTo>
                      <a:lnTo>
                        <a:pt x="3699" y="514"/>
                      </a:lnTo>
                      <a:lnTo>
                        <a:pt x="3703" y="513"/>
                      </a:lnTo>
                      <a:lnTo>
                        <a:pt x="3706" y="515"/>
                      </a:lnTo>
                      <a:lnTo>
                        <a:pt x="3709" y="514"/>
                      </a:lnTo>
                      <a:lnTo>
                        <a:pt x="3713" y="515"/>
                      </a:lnTo>
                      <a:lnTo>
                        <a:pt x="3716" y="515"/>
                      </a:lnTo>
                      <a:lnTo>
                        <a:pt x="3719" y="516"/>
                      </a:lnTo>
                      <a:lnTo>
                        <a:pt x="3723" y="515"/>
                      </a:lnTo>
                      <a:lnTo>
                        <a:pt x="3726" y="514"/>
                      </a:lnTo>
                      <a:lnTo>
                        <a:pt x="3729" y="517"/>
                      </a:lnTo>
                      <a:lnTo>
                        <a:pt x="3733" y="516"/>
                      </a:lnTo>
                      <a:lnTo>
                        <a:pt x="3736" y="514"/>
                      </a:lnTo>
                      <a:lnTo>
                        <a:pt x="3739" y="514"/>
                      </a:lnTo>
                      <a:lnTo>
                        <a:pt x="3743" y="516"/>
                      </a:lnTo>
                      <a:lnTo>
                        <a:pt x="3746" y="515"/>
                      </a:lnTo>
                      <a:lnTo>
                        <a:pt x="3749" y="513"/>
                      </a:lnTo>
                      <a:lnTo>
                        <a:pt x="3752" y="515"/>
                      </a:lnTo>
                      <a:lnTo>
                        <a:pt x="3756" y="515"/>
                      </a:lnTo>
                      <a:lnTo>
                        <a:pt x="3759" y="517"/>
                      </a:lnTo>
                      <a:lnTo>
                        <a:pt x="3762" y="516"/>
                      </a:lnTo>
                      <a:lnTo>
                        <a:pt x="3766" y="515"/>
                      </a:lnTo>
                      <a:lnTo>
                        <a:pt x="3769" y="515"/>
                      </a:lnTo>
                      <a:lnTo>
                        <a:pt x="3772" y="515"/>
                      </a:lnTo>
                      <a:lnTo>
                        <a:pt x="3776" y="517"/>
                      </a:lnTo>
                      <a:lnTo>
                        <a:pt x="3779" y="517"/>
                      </a:lnTo>
                      <a:lnTo>
                        <a:pt x="3782" y="517"/>
                      </a:lnTo>
                      <a:lnTo>
                        <a:pt x="3786" y="516"/>
                      </a:lnTo>
                      <a:lnTo>
                        <a:pt x="3789" y="514"/>
                      </a:lnTo>
                      <a:lnTo>
                        <a:pt x="3792" y="516"/>
                      </a:lnTo>
                      <a:lnTo>
                        <a:pt x="3796" y="518"/>
                      </a:lnTo>
                      <a:lnTo>
                        <a:pt x="3799" y="516"/>
                      </a:lnTo>
                      <a:lnTo>
                        <a:pt x="3802" y="517"/>
                      </a:lnTo>
                      <a:lnTo>
                        <a:pt x="3805" y="515"/>
                      </a:lnTo>
                      <a:lnTo>
                        <a:pt x="3809" y="516"/>
                      </a:lnTo>
                      <a:lnTo>
                        <a:pt x="3812" y="516"/>
                      </a:lnTo>
                      <a:lnTo>
                        <a:pt x="3815" y="515"/>
                      </a:lnTo>
                      <a:lnTo>
                        <a:pt x="3819" y="516"/>
                      </a:lnTo>
                      <a:lnTo>
                        <a:pt x="3822" y="515"/>
                      </a:lnTo>
                      <a:lnTo>
                        <a:pt x="3825" y="515"/>
                      </a:lnTo>
                      <a:lnTo>
                        <a:pt x="3829" y="516"/>
                      </a:lnTo>
                      <a:lnTo>
                        <a:pt x="3832" y="514"/>
                      </a:lnTo>
                      <a:lnTo>
                        <a:pt x="3835" y="514"/>
                      </a:lnTo>
                      <a:lnTo>
                        <a:pt x="3839" y="514"/>
                      </a:lnTo>
                      <a:lnTo>
                        <a:pt x="3842" y="514"/>
                      </a:lnTo>
                      <a:lnTo>
                        <a:pt x="3845" y="515"/>
                      </a:lnTo>
                      <a:lnTo>
                        <a:pt x="3848" y="515"/>
                      </a:lnTo>
                      <a:lnTo>
                        <a:pt x="3852" y="515"/>
                      </a:lnTo>
                      <a:lnTo>
                        <a:pt x="3855" y="515"/>
                      </a:lnTo>
                      <a:lnTo>
                        <a:pt x="3858" y="514"/>
                      </a:lnTo>
                      <a:lnTo>
                        <a:pt x="3862" y="516"/>
                      </a:lnTo>
                      <a:lnTo>
                        <a:pt x="3865" y="516"/>
                      </a:lnTo>
                      <a:lnTo>
                        <a:pt x="3868" y="515"/>
                      </a:lnTo>
                      <a:lnTo>
                        <a:pt x="3871" y="516"/>
                      </a:lnTo>
                      <a:lnTo>
                        <a:pt x="3875" y="516"/>
                      </a:lnTo>
                      <a:lnTo>
                        <a:pt x="3878" y="515"/>
                      </a:lnTo>
                      <a:lnTo>
                        <a:pt x="3881" y="515"/>
                      </a:lnTo>
                      <a:lnTo>
                        <a:pt x="3885" y="515"/>
                      </a:lnTo>
                      <a:lnTo>
                        <a:pt x="3888" y="515"/>
                      </a:lnTo>
                      <a:lnTo>
                        <a:pt x="3892" y="515"/>
                      </a:lnTo>
                      <a:lnTo>
                        <a:pt x="3895" y="514"/>
                      </a:lnTo>
                      <a:lnTo>
                        <a:pt x="3898" y="515"/>
                      </a:lnTo>
                      <a:lnTo>
                        <a:pt x="3901" y="514"/>
                      </a:lnTo>
                      <a:lnTo>
                        <a:pt x="3905" y="514"/>
                      </a:lnTo>
                      <a:lnTo>
                        <a:pt x="3908" y="516"/>
                      </a:lnTo>
                      <a:lnTo>
                        <a:pt x="3911" y="515"/>
                      </a:lnTo>
                      <a:lnTo>
                        <a:pt x="3915" y="516"/>
                      </a:lnTo>
                      <a:lnTo>
                        <a:pt x="3918" y="515"/>
                      </a:lnTo>
                      <a:lnTo>
                        <a:pt x="3921" y="515"/>
                      </a:lnTo>
                      <a:lnTo>
                        <a:pt x="3924" y="515"/>
                      </a:lnTo>
                      <a:lnTo>
                        <a:pt x="3928" y="516"/>
                      </a:lnTo>
                      <a:lnTo>
                        <a:pt x="3931" y="516"/>
                      </a:lnTo>
                      <a:lnTo>
                        <a:pt x="3934" y="515"/>
                      </a:lnTo>
                      <a:lnTo>
                        <a:pt x="3938" y="514"/>
                      </a:lnTo>
                      <a:lnTo>
                        <a:pt x="3941" y="515"/>
                      </a:lnTo>
                      <a:lnTo>
                        <a:pt x="3944" y="514"/>
                      </a:lnTo>
                      <a:lnTo>
                        <a:pt x="3948" y="516"/>
                      </a:lnTo>
                      <a:lnTo>
                        <a:pt x="3951" y="516"/>
                      </a:lnTo>
                      <a:lnTo>
                        <a:pt x="3954" y="516"/>
                      </a:lnTo>
                      <a:lnTo>
                        <a:pt x="3958" y="515"/>
                      </a:lnTo>
                      <a:lnTo>
                        <a:pt x="3961" y="514"/>
                      </a:lnTo>
                      <a:lnTo>
                        <a:pt x="3964" y="516"/>
                      </a:lnTo>
                      <a:lnTo>
                        <a:pt x="3968" y="515"/>
                      </a:lnTo>
                      <a:lnTo>
                        <a:pt x="3971" y="514"/>
                      </a:lnTo>
                      <a:lnTo>
                        <a:pt x="3974" y="514"/>
                      </a:lnTo>
                      <a:lnTo>
                        <a:pt x="3977" y="514"/>
                      </a:lnTo>
                      <a:lnTo>
                        <a:pt x="3981" y="515"/>
                      </a:lnTo>
                      <a:lnTo>
                        <a:pt x="3984" y="516"/>
                      </a:lnTo>
                      <a:lnTo>
                        <a:pt x="3987" y="516"/>
                      </a:lnTo>
                      <a:lnTo>
                        <a:pt x="3991" y="516"/>
                      </a:lnTo>
                      <a:lnTo>
                        <a:pt x="3994" y="515"/>
                      </a:lnTo>
                      <a:lnTo>
                        <a:pt x="3997" y="515"/>
                      </a:lnTo>
                      <a:lnTo>
                        <a:pt x="4001" y="516"/>
                      </a:lnTo>
                      <a:lnTo>
                        <a:pt x="4004" y="517"/>
                      </a:lnTo>
                      <a:lnTo>
                        <a:pt x="4007" y="517"/>
                      </a:lnTo>
                      <a:lnTo>
                        <a:pt x="4011" y="516"/>
                      </a:lnTo>
                      <a:lnTo>
                        <a:pt x="4014" y="513"/>
                      </a:lnTo>
                      <a:lnTo>
                        <a:pt x="4017" y="516"/>
                      </a:lnTo>
                      <a:lnTo>
                        <a:pt x="4020" y="514"/>
                      </a:lnTo>
                      <a:lnTo>
                        <a:pt x="4024" y="514"/>
                      </a:lnTo>
                      <a:lnTo>
                        <a:pt x="4027" y="515"/>
                      </a:lnTo>
                      <a:lnTo>
                        <a:pt x="4030" y="515"/>
                      </a:lnTo>
                      <a:lnTo>
                        <a:pt x="4034" y="516"/>
                      </a:lnTo>
                      <a:lnTo>
                        <a:pt x="4037" y="515"/>
                      </a:lnTo>
                      <a:lnTo>
                        <a:pt x="4040" y="515"/>
                      </a:lnTo>
                      <a:lnTo>
                        <a:pt x="4044" y="516"/>
                      </a:lnTo>
                      <a:lnTo>
                        <a:pt x="4047" y="515"/>
                      </a:lnTo>
                      <a:lnTo>
                        <a:pt x="4050" y="514"/>
                      </a:lnTo>
                      <a:lnTo>
                        <a:pt x="4054" y="516"/>
                      </a:lnTo>
                      <a:lnTo>
                        <a:pt x="4057" y="515"/>
                      </a:lnTo>
                      <a:lnTo>
                        <a:pt x="4060" y="515"/>
                      </a:lnTo>
                      <a:lnTo>
                        <a:pt x="4064" y="514"/>
                      </a:lnTo>
                      <a:lnTo>
                        <a:pt x="4067" y="515"/>
                      </a:lnTo>
                      <a:lnTo>
                        <a:pt x="4070" y="515"/>
                      </a:lnTo>
                      <a:lnTo>
                        <a:pt x="4073" y="515"/>
                      </a:lnTo>
                      <a:lnTo>
                        <a:pt x="4077" y="515"/>
                      </a:lnTo>
                      <a:lnTo>
                        <a:pt x="4080" y="514"/>
                      </a:lnTo>
                      <a:lnTo>
                        <a:pt x="4083" y="517"/>
                      </a:lnTo>
                      <a:lnTo>
                        <a:pt x="4087" y="516"/>
                      </a:lnTo>
                      <a:lnTo>
                        <a:pt x="4090" y="515"/>
                      </a:lnTo>
                      <a:lnTo>
                        <a:pt x="4093" y="514"/>
                      </a:lnTo>
                      <a:lnTo>
                        <a:pt x="4097" y="516"/>
                      </a:lnTo>
                      <a:lnTo>
                        <a:pt x="4100" y="514"/>
                      </a:lnTo>
                      <a:lnTo>
                        <a:pt x="4103" y="517"/>
                      </a:lnTo>
                      <a:lnTo>
                        <a:pt x="4107" y="515"/>
                      </a:lnTo>
                      <a:lnTo>
                        <a:pt x="4110" y="514"/>
                      </a:lnTo>
                      <a:lnTo>
                        <a:pt x="4113" y="514"/>
                      </a:lnTo>
                      <a:lnTo>
                        <a:pt x="4117" y="516"/>
                      </a:lnTo>
                      <a:lnTo>
                        <a:pt x="4120" y="515"/>
                      </a:lnTo>
                      <a:lnTo>
                        <a:pt x="4123" y="515"/>
                      </a:lnTo>
                      <a:lnTo>
                        <a:pt x="4126" y="515"/>
                      </a:lnTo>
                      <a:lnTo>
                        <a:pt x="4130" y="517"/>
                      </a:lnTo>
                      <a:lnTo>
                        <a:pt x="4133" y="515"/>
                      </a:lnTo>
                      <a:lnTo>
                        <a:pt x="4136" y="515"/>
                      </a:lnTo>
                      <a:lnTo>
                        <a:pt x="4140" y="515"/>
                      </a:lnTo>
                      <a:lnTo>
                        <a:pt x="4143" y="516"/>
                      </a:lnTo>
                      <a:lnTo>
                        <a:pt x="4146" y="516"/>
                      </a:lnTo>
                      <a:lnTo>
                        <a:pt x="4149" y="515"/>
                      </a:lnTo>
                      <a:lnTo>
                        <a:pt x="4153" y="516"/>
                      </a:lnTo>
                      <a:lnTo>
                        <a:pt x="4156" y="516"/>
                      </a:lnTo>
                      <a:lnTo>
                        <a:pt x="4160" y="516"/>
                      </a:lnTo>
                      <a:lnTo>
                        <a:pt x="4163" y="515"/>
                      </a:lnTo>
                      <a:lnTo>
                        <a:pt x="4166" y="515"/>
                      </a:lnTo>
                      <a:lnTo>
                        <a:pt x="4169" y="516"/>
                      </a:lnTo>
                      <a:lnTo>
                        <a:pt x="4173" y="516"/>
                      </a:lnTo>
                      <a:lnTo>
                        <a:pt x="4176" y="516"/>
                      </a:lnTo>
                      <a:lnTo>
                        <a:pt x="4179" y="516"/>
                      </a:lnTo>
                      <a:lnTo>
                        <a:pt x="4183" y="514"/>
                      </a:lnTo>
                      <a:lnTo>
                        <a:pt x="4186" y="514"/>
                      </a:lnTo>
                      <a:lnTo>
                        <a:pt x="4189" y="515"/>
                      </a:lnTo>
                      <a:lnTo>
                        <a:pt x="4192" y="515"/>
                      </a:lnTo>
                      <a:lnTo>
                        <a:pt x="4196" y="514"/>
                      </a:lnTo>
                      <a:lnTo>
                        <a:pt x="4199" y="515"/>
                      </a:lnTo>
                      <a:lnTo>
                        <a:pt x="4202" y="516"/>
                      </a:lnTo>
                      <a:lnTo>
                        <a:pt x="4206" y="516"/>
                      </a:lnTo>
                      <a:lnTo>
                        <a:pt x="4209" y="516"/>
                      </a:lnTo>
                      <a:lnTo>
                        <a:pt x="4212" y="517"/>
                      </a:lnTo>
                      <a:lnTo>
                        <a:pt x="4216" y="516"/>
                      </a:lnTo>
                      <a:lnTo>
                        <a:pt x="4219" y="516"/>
                      </a:lnTo>
                      <a:lnTo>
                        <a:pt x="4222" y="514"/>
                      </a:lnTo>
                      <a:lnTo>
                        <a:pt x="4226" y="515"/>
                      </a:lnTo>
                      <a:lnTo>
                        <a:pt x="4229" y="516"/>
                      </a:lnTo>
                      <a:lnTo>
                        <a:pt x="4232" y="517"/>
                      </a:lnTo>
                      <a:lnTo>
                        <a:pt x="4236" y="515"/>
                      </a:lnTo>
                      <a:lnTo>
                        <a:pt x="4239" y="515"/>
                      </a:lnTo>
                      <a:lnTo>
                        <a:pt x="4242" y="516"/>
                      </a:lnTo>
                      <a:lnTo>
                        <a:pt x="4245" y="515"/>
                      </a:lnTo>
                      <a:lnTo>
                        <a:pt x="4249" y="515"/>
                      </a:lnTo>
                      <a:lnTo>
                        <a:pt x="4252" y="516"/>
                      </a:lnTo>
                      <a:lnTo>
                        <a:pt x="4255" y="515"/>
                      </a:lnTo>
                      <a:lnTo>
                        <a:pt x="4259" y="515"/>
                      </a:lnTo>
                      <a:lnTo>
                        <a:pt x="4262" y="515"/>
                      </a:lnTo>
                      <a:lnTo>
                        <a:pt x="4265" y="517"/>
                      </a:lnTo>
                      <a:lnTo>
                        <a:pt x="4269" y="515"/>
                      </a:lnTo>
                      <a:lnTo>
                        <a:pt x="4272" y="516"/>
                      </a:lnTo>
                      <a:lnTo>
                        <a:pt x="4275" y="515"/>
                      </a:lnTo>
                      <a:lnTo>
                        <a:pt x="4279" y="514"/>
                      </a:lnTo>
                      <a:lnTo>
                        <a:pt x="4282" y="516"/>
                      </a:lnTo>
                      <a:lnTo>
                        <a:pt x="4285" y="517"/>
                      </a:lnTo>
                      <a:lnTo>
                        <a:pt x="4289" y="517"/>
                      </a:lnTo>
                      <a:lnTo>
                        <a:pt x="4292" y="515"/>
                      </a:lnTo>
                      <a:lnTo>
                        <a:pt x="4295" y="516"/>
                      </a:lnTo>
                      <a:lnTo>
                        <a:pt x="4298" y="515"/>
                      </a:lnTo>
                      <a:lnTo>
                        <a:pt x="4302" y="515"/>
                      </a:lnTo>
                      <a:lnTo>
                        <a:pt x="4305" y="515"/>
                      </a:lnTo>
                      <a:lnTo>
                        <a:pt x="4308" y="514"/>
                      </a:lnTo>
                      <a:lnTo>
                        <a:pt x="4312" y="514"/>
                      </a:lnTo>
                      <a:lnTo>
                        <a:pt x="4315" y="516"/>
                      </a:lnTo>
                      <a:lnTo>
                        <a:pt x="4318" y="515"/>
                      </a:lnTo>
                      <a:lnTo>
                        <a:pt x="4322" y="515"/>
                      </a:lnTo>
                      <a:lnTo>
                        <a:pt x="4325" y="515"/>
                      </a:lnTo>
                      <a:lnTo>
                        <a:pt x="4328" y="515"/>
                      </a:lnTo>
                      <a:lnTo>
                        <a:pt x="4332" y="515"/>
                      </a:lnTo>
                      <a:lnTo>
                        <a:pt x="4335" y="517"/>
                      </a:lnTo>
                      <a:lnTo>
                        <a:pt x="4338" y="516"/>
                      </a:lnTo>
                      <a:lnTo>
                        <a:pt x="4341" y="514"/>
                      </a:lnTo>
                      <a:lnTo>
                        <a:pt x="4345" y="515"/>
                      </a:lnTo>
                      <a:lnTo>
                        <a:pt x="4348" y="515"/>
                      </a:lnTo>
                      <a:lnTo>
                        <a:pt x="4351" y="515"/>
                      </a:lnTo>
                      <a:lnTo>
                        <a:pt x="4355" y="515"/>
                      </a:lnTo>
                      <a:lnTo>
                        <a:pt x="4358" y="515"/>
                      </a:lnTo>
                      <a:lnTo>
                        <a:pt x="4361" y="515"/>
                      </a:lnTo>
                      <a:lnTo>
                        <a:pt x="4365" y="514"/>
                      </a:lnTo>
                      <a:lnTo>
                        <a:pt x="4368" y="515"/>
                      </a:lnTo>
                      <a:lnTo>
                        <a:pt x="4371" y="516"/>
                      </a:lnTo>
                      <a:lnTo>
                        <a:pt x="4375" y="516"/>
                      </a:lnTo>
                      <a:lnTo>
                        <a:pt x="4378" y="515"/>
                      </a:lnTo>
                      <a:lnTo>
                        <a:pt x="4381" y="515"/>
                      </a:lnTo>
                      <a:lnTo>
                        <a:pt x="4385" y="514"/>
                      </a:lnTo>
                      <a:lnTo>
                        <a:pt x="4388" y="515"/>
                      </a:lnTo>
                      <a:lnTo>
                        <a:pt x="4391" y="516"/>
                      </a:lnTo>
                      <a:lnTo>
                        <a:pt x="4394" y="516"/>
                      </a:lnTo>
                      <a:lnTo>
                        <a:pt x="4398" y="514"/>
                      </a:lnTo>
                      <a:lnTo>
                        <a:pt x="4401" y="515"/>
                      </a:lnTo>
                      <a:lnTo>
                        <a:pt x="4404" y="515"/>
                      </a:lnTo>
                      <a:lnTo>
                        <a:pt x="4408" y="515"/>
                      </a:lnTo>
                      <a:lnTo>
                        <a:pt x="4411" y="515"/>
                      </a:lnTo>
                      <a:lnTo>
                        <a:pt x="4414" y="516"/>
                      </a:lnTo>
                      <a:lnTo>
                        <a:pt x="4417" y="515"/>
                      </a:lnTo>
                      <a:lnTo>
                        <a:pt x="4421" y="515"/>
                      </a:lnTo>
                      <a:lnTo>
                        <a:pt x="4424" y="516"/>
                      </a:lnTo>
                      <a:lnTo>
                        <a:pt x="4428" y="514"/>
                      </a:lnTo>
                      <a:lnTo>
                        <a:pt x="4431" y="514"/>
                      </a:lnTo>
                      <a:lnTo>
                        <a:pt x="4434" y="515"/>
                      </a:lnTo>
                      <a:lnTo>
                        <a:pt x="4437" y="515"/>
                      </a:lnTo>
                      <a:lnTo>
                        <a:pt x="4441" y="515"/>
                      </a:lnTo>
                      <a:lnTo>
                        <a:pt x="4444" y="516"/>
                      </a:lnTo>
                      <a:lnTo>
                        <a:pt x="4447" y="514"/>
                      </a:lnTo>
                      <a:lnTo>
                        <a:pt x="4451" y="515"/>
                      </a:lnTo>
                      <a:lnTo>
                        <a:pt x="4454" y="515"/>
                      </a:lnTo>
                      <a:lnTo>
                        <a:pt x="4457" y="514"/>
                      </a:lnTo>
                      <a:lnTo>
                        <a:pt x="4461" y="514"/>
                      </a:lnTo>
                      <a:lnTo>
                        <a:pt x="4464" y="514"/>
                      </a:lnTo>
                      <a:lnTo>
                        <a:pt x="4467" y="514"/>
                      </a:lnTo>
                      <a:lnTo>
                        <a:pt x="4470" y="515"/>
                      </a:lnTo>
                      <a:lnTo>
                        <a:pt x="4474" y="513"/>
                      </a:lnTo>
                      <a:lnTo>
                        <a:pt x="4477" y="513"/>
                      </a:lnTo>
                      <a:lnTo>
                        <a:pt x="4480" y="513"/>
                      </a:lnTo>
                      <a:lnTo>
                        <a:pt x="4484" y="514"/>
                      </a:lnTo>
                      <a:lnTo>
                        <a:pt x="4487" y="514"/>
                      </a:lnTo>
                      <a:lnTo>
                        <a:pt x="4490" y="516"/>
                      </a:lnTo>
                      <a:lnTo>
                        <a:pt x="4494" y="516"/>
                      </a:lnTo>
                      <a:lnTo>
                        <a:pt x="4497" y="514"/>
                      </a:lnTo>
                      <a:lnTo>
                        <a:pt x="4500" y="513"/>
                      </a:lnTo>
                      <a:lnTo>
                        <a:pt x="4504" y="515"/>
                      </a:lnTo>
                      <a:lnTo>
                        <a:pt x="4507" y="514"/>
                      </a:lnTo>
                      <a:lnTo>
                        <a:pt x="4510" y="514"/>
                      </a:lnTo>
                      <a:lnTo>
                        <a:pt x="4513" y="515"/>
                      </a:lnTo>
                      <a:lnTo>
                        <a:pt x="4517" y="514"/>
                      </a:lnTo>
                      <a:lnTo>
                        <a:pt x="4520" y="515"/>
                      </a:lnTo>
                      <a:lnTo>
                        <a:pt x="4523" y="515"/>
                      </a:lnTo>
                      <a:lnTo>
                        <a:pt x="4527" y="515"/>
                      </a:lnTo>
                      <a:lnTo>
                        <a:pt x="4530" y="515"/>
                      </a:lnTo>
                      <a:lnTo>
                        <a:pt x="4533" y="515"/>
                      </a:lnTo>
                      <a:lnTo>
                        <a:pt x="4537" y="514"/>
                      </a:lnTo>
                      <a:lnTo>
                        <a:pt x="4540" y="514"/>
                      </a:lnTo>
                      <a:lnTo>
                        <a:pt x="4543" y="515"/>
                      </a:lnTo>
                      <a:lnTo>
                        <a:pt x="4547" y="514"/>
                      </a:lnTo>
                      <a:lnTo>
                        <a:pt x="4550" y="515"/>
                      </a:lnTo>
                      <a:lnTo>
                        <a:pt x="4553" y="516"/>
                      </a:lnTo>
                      <a:lnTo>
                        <a:pt x="4557" y="514"/>
                      </a:lnTo>
                      <a:lnTo>
                        <a:pt x="4560" y="515"/>
                      </a:lnTo>
                      <a:lnTo>
                        <a:pt x="4563" y="514"/>
                      </a:lnTo>
                      <a:lnTo>
                        <a:pt x="4566" y="516"/>
                      </a:lnTo>
                      <a:lnTo>
                        <a:pt x="4570" y="515"/>
                      </a:lnTo>
                      <a:lnTo>
                        <a:pt x="4573" y="514"/>
                      </a:lnTo>
                      <a:lnTo>
                        <a:pt x="4576" y="514"/>
                      </a:lnTo>
                      <a:lnTo>
                        <a:pt x="4580" y="514"/>
                      </a:lnTo>
                      <a:lnTo>
                        <a:pt x="4583" y="513"/>
                      </a:lnTo>
                      <a:lnTo>
                        <a:pt x="4586" y="513"/>
                      </a:lnTo>
                      <a:lnTo>
                        <a:pt x="4590" y="514"/>
                      </a:lnTo>
                      <a:lnTo>
                        <a:pt x="4593" y="515"/>
                      </a:lnTo>
                      <a:lnTo>
                        <a:pt x="4596" y="517"/>
                      </a:lnTo>
                      <a:lnTo>
                        <a:pt x="4600" y="514"/>
                      </a:lnTo>
                      <a:lnTo>
                        <a:pt x="4603" y="513"/>
                      </a:lnTo>
                      <a:lnTo>
                        <a:pt x="4606" y="514"/>
                      </a:lnTo>
                      <a:lnTo>
                        <a:pt x="4609" y="513"/>
                      </a:lnTo>
                      <a:lnTo>
                        <a:pt x="4613" y="514"/>
                      </a:lnTo>
                      <a:lnTo>
                        <a:pt x="4616" y="515"/>
                      </a:lnTo>
                      <a:lnTo>
                        <a:pt x="4619" y="514"/>
                      </a:lnTo>
                      <a:lnTo>
                        <a:pt x="4623" y="514"/>
                      </a:lnTo>
                      <a:lnTo>
                        <a:pt x="4626" y="515"/>
                      </a:lnTo>
                      <a:lnTo>
                        <a:pt x="4629" y="515"/>
                      </a:lnTo>
                      <a:lnTo>
                        <a:pt x="4633" y="513"/>
                      </a:lnTo>
                      <a:lnTo>
                        <a:pt x="4636" y="514"/>
                      </a:lnTo>
                      <a:lnTo>
                        <a:pt x="4639" y="514"/>
                      </a:lnTo>
                      <a:lnTo>
                        <a:pt x="4643" y="514"/>
                      </a:lnTo>
                      <a:lnTo>
                        <a:pt x="4646" y="515"/>
                      </a:lnTo>
                      <a:lnTo>
                        <a:pt x="4649" y="514"/>
                      </a:lnTo>
                      <a:lnTo>
                        <a:pt x="4653" y="514"/>
                      </a:lnTo>
                      <a:lnTo>
                        <a:pt x="4656" y="514"/>
                      </a:lnTo>
                      <a:lnTo>
                        <a:pt x="4659" y="514"/>
                      </a:lnTo>
                      <a:lnTo>
                        <a:pt x="4662" y="513"/>
                      </a:lnTo>
                      <a:lnTo>
                        <a:pt x="4666" y="515"/>
                      </a:lnTo>
                      <a:lnTo>
                        <a:pt x="4669" y="514"/>
                      </a:lnTo>
                      <a:lnTo>
                        <a:pt x="4672" y="514"/>
                      </a:lnTo>
                      <a:lnTo>
                        <a:pt x="4676" y="514"/>
                      </a:lnTo>
                      <a:lnTo>
                        <a:pt x="4679" y="514"/>
                      </a:lnTo>
                      <a:lnTo>
                        <a:pt x="4682" y="514"/>
                      </a:lnTo>
                      <a:lnTo>
                        <a:pt x="4685" y="514"/>
                      </a:lnTo>
                      <a:lnTo>
                        <a:pt x="4689" y="514"/>
                      </a:lnTo>
                      <a:lnTo>
                        <a:pt x="4692" y="514"/>
                      </a:lnTo>
                      <a:lnTo>
                        <a:pt x="4696" y="514"/>
                      </a:lnTo>
                      <a:lnTo>
                        <a:pt x="4699" y="513"/>
                      </a:lnTo>
                      <a:lnTo>
                        <a:pt x="4702" y="513"/>
                      </a:lnTo>
                      <a:lnTo>
                        <a:pt x="4706" y="514"/>
                      </a:lnTo>
                      <a:lnTo>
                        <a:pt x="4709" y="515"/>
                      </a:lnTo>
                      <a:lnTo>
                        <a:pt x="4712" y="515"/>
                      </a:lnTo>
                      <a:lnTo>
                        <a:pt x="4715" y="515"/>
                      </a:lnTo>
                      <a:lnTo>
                        <a:pt x="4719" y="514"/>
                      </a:lnTo>
                      <a:lnTo>
                        <a:pt x="4722" y="514"/>
                      </a:lnTo>
                      <a:lnTo>
                        <a:pt x="4725" y="512"/>
                      </a:lnTo>
                      <a:lnTo>
                        <a:pt x="4729" y="513"/>
                      </a:lnTo>
                      <a:lnTo>
                        <a:pt x="4732" y="514"/>
                      </a:lnTo>
                      <a:lnTo>
                        <a:pt x="4735" y="514"/>
                      </a:lnTo>
                      <a:lnTo>
                        <a:pt x="4738" y="515"/>
                      </a:lnTo>
                      <a:lnTo>
                        <a:pt x="4742" y="515"/>
                      </a:lnTo>
                      <a:lnTo>
                        <a:pt x="4745" y="515"/>
                      </a:lnTo>
                      <a:lnTo>
                        <a:pt x="4748" y="513"/>
                      </a:lnTo>
                      <a:lnTo>
                        <a:pt x="4752" y="513"/>
                      </a:lnTo>
                      <a:lnTo>
                        <a:pt x="4755" y="514"/>
                      </a:lnTo>
                      <a:lnTo>
                        <a:pt x="4758" y="513"/>
                      </a:lnTo>
                      <a:lnTo>
                        <a:pt x="4762" y="514"/>
                      </a:lnTo>
                      <a:lnTo>
                        <a:pt x="4765" y="514"/>
                      </a:lnTo>
                      <a:lnTo>
                        <a:pt x="4768" y="514"/>
                      </a:lnTo>
                      <a:lnTo>
                        <a:pt x="4772" y="513"/>
                      </a:lnTo>
                      <a:lnTo>
                        <a:pt x="4775" y="514"/>
                      </a:lnTo>
                      <a:lnTo>
                        <a:pt x="4778" y="514"/>
                      </a:lnTo>
                      <a:lnTo>
                        <a:pt x="4781" y="514"/>
                      </a:lnTo>
                      <a:lnTo>
                        <a:pt x="4785" y="514"/>
                      </a:lnTo>
                      <a:lnTo>
                        <a:pt x="4788" y="514"/>
                      </a:lnTo>
                      <a:lnTo>
                        <a:pt x="4791" y="514"/>
                      </a:lnTo>
                      <a:lnTo>
                        <a:pt x="4795" y="515"/>
                      </a:lnTo>
                      <a:lnTo>
                        <a:pt x="4798" y="514"/>
                      </a:lnTo>
                      <a:lnTo>
                        <a:pt x="4801" y="513"/>
                      </a:lnTo>
                      <a:lnTo>
                        <a:pt x="4805" y="512"/>
                      </a:lnTo>
                      <a:lnTo>
                        <a:pt x="4808" y="514"/>
                      </a:lnTo>
                      <a:lnTo>
                        <a:pt x="4811" y="512"/>
                      </a:lnTo>
                      <a:lnTo>
                        <a:pt x="4815" y="514"/>
                      </a:lnTo>
                      <a:lnTo>
                        <a:pt x="4818" y="514"/>
                      </a:lnTo>
                      <a:lnTo>
                        <a:pt x="4821" y="514"/>
                      </a:lnTo>
                      <a:lnTo>
                        <a:pt x="4825" y="514"/>
                      </a:lnTo>
                      <a:lnTo>
                        <a:pt x="4828" y="514"/>
                      </a:lnTo>
                      <a:lnTo>
                        <a:pt x="4831" y="513"/>
                      </a:lnTo>
                      <a:lnTo>
                        <a:pt x="4834" y="514"/>
                      </a:lnTo>
                      <a:lnTo>
                        <a:pt x="4838" y="514"/>
                      </a:lnTo>
                      <a:lnTo>
                        <a:pt x="4841" y="514"/>
                      </a:lnTo>
                      <a:lnTo>
                        <a:pt x="4844" y="515"/>
                      </a:lnTo>
                      <a:lnTo>
                        <a:pt x="4848" y="512"/>
                      </a:lnTo>
                      <a:lnTo>
                        <a:pt x="4851" y="514"/>
                      </a:lnTo>
                      <a:lnTo>
                        <a:pt x="4854" y="513"/>
                      </a:lnTo>
                      <a:lnTo>
                        <a:pt x="4858" y="513"/>
                      </a:lnTo>
                      <a:lnTo>
                        <a:pt x="4861" y="513"/>
                      </a:lnTo>
                      <a:lnTo>
                        <a:pt x="4864" y="512"/>
                      </a:lnTo>
                      <a:lnTo>
                        <a:pt x="4868" y="513"/>
                      </a:lnTo>
                      <a:lnTo>
                        <a:pt x="4871" y="513"/>
                      </a:lnTo>
                      <a:lnTo>
                        <a:pt x="4874" y="512"/>
                      </a:lnTo>
                      <a:lnTo>
                        <a:pt x="4878" y="513"/>
                      </a:lnTo>
                      <a:lnTo>
                        <a:pt x="4881" y="512"/>
                      </a:lnTo>
                      <a:lnTo>
                        <a:pt x="4884" y="513"/>
                      </a:lnTo>
                      <a:lnTo>
                        <a:pt x="4887" y="514"/>
                      </a:lnTo>
                      <a:lnTo>
                        <a:pt x="4891" y="513"/>
                      </a:lnTo>
                      <a:lnTo>
                        <a:pt x="4894" y="513"/>
                      </a:lnTo>
                      <a:lnTo>
                        <a:pt x="4897" y="512"/>
                      </a:lnTo>
                      <a:lnTo>
                        <a:pt x="4901" y="513"/>
                      </a:lnTo>
                      <a:lnTo>
                        <a:pt x="4904" y="512"/>
                      </a:lnTo>
                      <a:lnTo>
                        <a:pt x="4907" y="513"/>
                      </a:lnTo>
                      <a:lnTo>
                        <a:pt x="4911" y="512"/>
                      </a:lnTo>
                      <a:lnTo>
                        <a:pt x="4914" y="513"/>
                      </a:lnTo>
                      <a:lnTo>
                        <a:pt x="4917" y="512"/>
                      </a:lnTo>
                      <a:lnTo>
                        <a:pt x="4921" y="513"/>
                      </a:lnTo>
                      <a:lnTo>
                        <a:pt x="4924" y="513"/>
                      </a:lnTo>
                      <a:lnTo>
                        <a:pt x="4927" y="513"/>
                      </a:lnTo>
                      <a:lnTo>
                        <a:pt x="4930" y="514"/>
                      </a:lnTo>
                      <a:lnTo>
                        <a:pt x="4934" y="513"/>
                      </a:lnTo>
                      <a:lnTo>
                        <a:pt x="4937" y="514"/>
                      </a:lnTo>
                      <a:lnTo>
                        <a:pt x="4940" y="514"/>
                      </a:lnTo>
                      <a:lnTo>
                        <a:pt x="4944" y="513"/>
                      </a:lnTo>
                      <a:lnTo>
                        <a:pt x="4947" y="512"/>
                      </a:lnTo>
                      <a:lnTo>
                        <a:pt x="4950" y="511"/>
                      </a:lnTo>
                      <a:lnTo>
                        <a:pt x="4953" y="512"/>
                      </a:lnTo>
                      <a:lnTo>
                        <a:pt x="4957" y="512"/>
                      </a:lnTo>
                      <a:lnTo>
                        <a:pt x="4960" y="511"/>
                      </a:lnTo>
                      <a:lnTo>
                        <a:pt x="4964" y="512"/>
                      </a:lnTo>
                      <a:lnTo>
                        <a:pt x="4965" y="512"/>
                      </a:lnTo>
                    </a:path>
                  </a:pathLst>
                </a:custGeom>
                <a:ln>
                  <a:headEnd type="none" w="sm" len="sm"/>
                  <a:tailEnd type="none" w="sm" len="sm"/>
                </a:ln>
              </p:spPr>
              <p:style>
                <a:lnRef idx="1">
                  <a:schemeClr val="dk1"/>
                </a:lnRef>
                <a:fillRef idx="0">
                  <a:schemeClr val="dk1"/>
                </a:fillRef>
                <a:effectRef idx="0">
                  <a:schemeClr val="dk1"/>
                </a:effectRef>
                <a:fontRef idx="minor">
                  <a:schemeClr val="tx1"/>
                </a:fontRef>
              </p:style>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000"/>
                    <a:buFont typeface="Arial"/>
                    <a:buNone/>
                  </a:pPr>
                  <a:endParaRPr sz="800" b="0" i="0" u="none" strike="noStrike" cap="none">
                    <a:solidFill>
                      <a:srgbClr val="000000"/>
                    </a:solidFill>
                    <a:latin typeface="Arial"/>
                    <a:ea typeface="Arial"/>
                    <a:cs typeface="Arial"/>
                    <a:sym typeface="Arial"/>
                  </a:endParaRPr>
                </a:p>
              </p:txBody>
            </p:sp>
            <p:sp>
              <p:nvSpPr>
                <p:cNvPr id="1700" name="Google Shape;1700;p11"/>
                <p:cNvSpPr/>
                <p:nvPr/>
              </p:nvSpPr>
              <p:spPr>
                <a:xfrm>
                  <a:off x="1434" y="2368"/>
                  <a:ext cx="4965" cy="948"/>
                </a:xfrm>
                <a:custGeom>
                  <a:avLst/>
                  <a:gdLst/>
                  <a:ahLst/>
                  <a:cxnLst/>
                  <a:rect l="l" t="t" r="r" b="b"/>
                  <a:pathLst>
                    <a:path w="4965" h="948" extrusionOk="0">
                      <a:moveTo>
                        <a:pt x="0" y="944"/>
                      </a:moveTo>
                      <a:lnTo>
                        <a:pt x="4" y="944"/>
                      </a:lnTo>
                      <a:lnTo>
                        <a:pt x="7" y="946"/>
                      </a:lnTo>
                      <a:lnTo>
                        <a:pt x="10" y="945"/>
                      </a:lnTo>
                      <a:lnTo>
                        <a:pt x="13" y="945"/>
                      </a:lnTo>
                      <a:lnTo>
                        <a:pt x="17" y="945"/>
                      </a:lnTo>
                      <a:lnTo>
                        <a:pt x="20" y="946"/>
                      </a:lnTo>
                      <a:lnTo>
                        <a:pt x="23" y="947"/>
                      </a:lnTo>
                      <a:lnTo>
                        <a:pt x="27" y="946"/>
                      </a:lnTo>
                      <a:lnTo>
                        <a:pt x="30" y="945"/>
                      </a:lnTo>
                      <a:lnTo>
                        <a:pt x="33" y="945"/>
                      </a:lnTo>
                      <a:lnTo>
                        <a:pt x="36" y="945"/>
                      </a:lnTo>
                      <a:lnTo>
                        <a:pt x="40" y="945"/>
                      </a:lnTo>
                      <a:lnTo>
                        <a:pt x="43" y="945"/>
                      </a:lnTo>
                      <a:lnTo>
                        <a:pt x="46" y="946"/>
                      </a:lnTo>
                      <a:lnTo>
                        <a:pt x="50" y="943"/>
                      </a:lnTo>
                      <a:lnTo>
                        <a:pt x="53" y="944"/>
                      </a:lnTo>
                      <a:lnTo>
                        <a:pt x="56" y="944"/>
                      </a:lnTo>
                      <a:lnTo>
                        <a:pt x="60" y="945"/>
                      </a:lnTo>
                      <a:lnTo>
                        <a:pt x="63" y="943"/>
                      </a:lnTo>
                      <a:lnTo>
                        <a:pt x="66" y="945"/>
                      </a:lnTo>
                      <a:lnTo>
                        <a:pt x="70" y="944"/>
                      </a:lnTo>
                      <a:lnTo>
                        <a:pt x="73" y="945"/>
                      </a:lnTo>
                      <a:lnTo>
                        <a:pt x="76" y="946"/>
                      </a:lnTo>
                      <a:lnTo>
                        <a:pt x="80" y="945"/>
                      </a:lnTo>
                      <a:lnTo>
                        <a:pt x="83" y="946"/>
                      </a:lnTo>
                      <a:lnTo>
                        <a:pt x="86" y="944"/>
                      </a:lnTo>
                      <a:lnTo>
                        <a:pt x="89" y="946"/>
                      </a:lnTo>
                      <a:lnTo>
                        <a:pt x="93" y="945"/>
                      </a:lnTo>
                      <a:lnTo>
                        <a:pt x="96" y="946"/>
                      </a:lnTo>
                      <a:lnTo>
                        <a:pt x="99" y="946"/>
                      </a:lnTo>
                      <a:lnTo>
                        <a:pt x="103" y="946"/>
                      </a:lnTo>
                      <a:lnTo>
                        <a:pt x="106" y="946"/>
                      </a:lnTo>
                      <a:lnTo>
                        <a:pt x="109" y="947"/>
                      </a:lnTo>
                      <a:lnTo>
                        <a:pt x="113" y="946"/>
                      </a:lnTo>
                      <a:lnTo>
                        <a:pt x="116" y="946"/>
                      </a:lnTo>
                      <a:lnTo>
                        <a:pt x="119" y="946"/>
                      </a:lnTo>
                      <a:lnTo>
                        <a:pt x="123" y="946"/>
                      </a:lnTo>
                      <a:lnTo>
                        <a:pt x="126" y="946"/>
                      </a:lnTo>
                      <a:lnTo>
                        <a:pt x="129" y="946"/>
                      </a:lnTo>
                      <a:lnTo>
                        <a:pt x="133" y="946"/>
                      </a:lnTo>
                      <a:lnTo>
                        <a:pt x="136" y="947"/>
                      </a:lnTo>
                      <a:lnTo>
                        <a:pt x="139" y="947"/>
                      </a:lnTo>
                      <a:lnTo>
                        <a:pt x="142" y="946"/>
                      </a:lnTo>
                      <a:lnTo>
                        <a:pt x="146" y="947"/>
                      </a:lnTo>
                      <a:lnTo>
                        <a:pt x="149" y="947"/>
                      </a:lnTo>
                      <a:lnTo>
                        <a:pt x="152" y="945"/>
                      </a:lnTo>
                      <a:lnTo>
                        <a:pt x="156" y="947"/>
                      </a:lnTo>
                      <a:lnTo>
                        <a:pt x="159" y="946"/>
                      </a:lnTo>
                      <a:lnTo>
                        <a:pt x="162" y="944"/>
                      </a:lnTo>
                      <a:lnTo>
                        <a:pt x="166" y="945"/>
                      </a:lnTo>
                      <a:lnTo>
                        <a:pt x="169" y="947"/>
                      </a:lnTo>
                      <a:lnTo>
                        <a:pt x="172" y="946"/>
                      </a:lnTo>
                      <a:lnTo>
                        <a:pt x="176" y="948"/>
                      </a:lnTo>
                      <a:lnTo>
                        <a:pt x="179" y="946"/>
                      </a:lnTo>
                      <a:lnTo>
                        <a:pt x="182" y="946"/>
                      </a:lnTo>
                      <a:lnTo>
                        <a:pt x="185" y="946"/>
                      </a:lnTo>
                      <a:lnTo>
                        <a:pt x="189" y="945"/>
                      </a:lnTo>
                      <a:lnTo>
                        <a:pt x="192" y="946"/>
                      </a:lnTo>
                      <a:lnTo>
                        <a:pt x="195" y="947"/>
                      </a:lnTo>
                      <a:lnTo>
                        <a:pt x="199" y="947"/>
                      </a:lnTo>
                      <a:lnTo>
                        <a:pt x="202" y="946"/>
                      </a:lnTo>
                      <a:lnTo>
                        <a:pt x="205" y="944"/>
                      </a:lnTo>
                      <a:lnTo>
                        <a:pt x="209" y="946"/>
                      </a:lnTo>
                      <a:lnTo>
                        <a:pt x="212" y="948"/>
                      </a:lnTo>
                      <a:lnTo>
                        <a:pt x="215" y="946"/>
                      </a:lnTo>
                      <a:lnTo>
                        <a:pt x="219" y="947"/>
                      </a:lnTo>
                      <a:lnTo>
                        <a:pt x="222" y="946"/>
                      </a:lnTo>
                      <a:lnTo>
                        <a:pt x="225" y="948"/>
                      </a:lnTo>
                      <a:lnTo>
                        <a:pt x="229" y="947"/>
                      </a:lnTo>
                      <a:lnTo>
                        <a:pt x="232" y="944"/>
                      </a:lnTo>
                      <a:lnTo>
                        <a:pt x="235" y="945"/>
                      </a:lnTo>
                      <a:lnTo>
                        <a:pt x="238" y="945"/>
                      </a:lnTo>
                      <a:lnTo>
                        <a:pt x="242" y="947"/>
                      </a:lnTo>
                      <a:lnTo>
                        <a:pt x="245" y="946"/>
                      </a:lnTo>
                      <a:lnTo>
                        <a:pt x="248" y="946"/>
                      </a:lnTo>
                      <a:lnTo>
                        <a:pt x="252" y="946"/>
                      </a:lnTo>
                      <a:lnTo>
                        <a:pt x="255" y="945"/>
                      </a:lnTo>
                      <a:lnTo>
                        <a:pt x="258" y="946"/>
                      </a:lnTo>
                      <a:lnTo>
                        <a:pt x="262" y="946"/>
                      </a:lnTo>
                      <a:lnTo>
                        <a:pt x="265" y="944"/>
                      </a:lnTo>
                      <a:lnTo>
                        <a:pt x="268" y="945"/>
                      </a:lnTo>
                      <a:lnTo>
                        <a:pt x="272" y="946"/>
                      </a:lnTo>
                      <a:lnTo>
                        <a:pt x="275" y="946"/>
                      </a:lnTo>
                      <a:lnTo>
                        <a:pt x="278" y="945"/>
                      </a:lnTo>
                      <a:lnTo>
                        <a:pt x="281" y="945"/>
                      </a:lnTo>
                      <a:lnTo>
                        <a:pt x="285" y="944"/>
                      </a:lnTo>
                      <a:lnTo>
                        <a:pt x="288" y="946"/>
                      </a:lnTo>
                      <a:lnTo>
                        <a:pt x="291" y="946"/>
                      </a:lnTo>
                      <a:lnTo>
                        <a:pt x="295" y="947"/>
                      </a:lnTo>
                      <a:lnTo>
                        <a:pt x="298" y="946"/>
                      </a:lnTo>
                      <a:lnTo>
                        <a:pt x="301" y="947"/>
                      </a:lnTo>
                      <a:lnTo>
                        <a:pt x="305" y="945"/>
                      </a:lnTo>
                      <a:lnTo>
                        <a:pt x="308" y="945"/>
                      </a:lnTo>
                      <a:lnTo>
                        <a:pt x="311" y="945"/>
                      </a:lnTo>
                      <a:lnTo>
                        <a:pt x="314" y="945"/>
                      </a:lnTo>
                      <a:lnTo>
                        <a:pt x="318" y="946"/>
                      </a:lnTo>
                      <a:lnTo>
                        <a:pt x="321" y="946"/>
                      </a:lnTo>
                      <a:lnTo>
                        <a:pt x="325" y="946"/>
                      </a:lnTo>
                      <a:lnTo>
                        <a:pt x="328" y="946"/>
                      </a:lnTo>
                      <a:lnTo>
                        <a:pt x="331" y="947"/>
                      </a:lnTo>
                      <a:lnTo>
                        <a:pt x="334" y="945"/>
                      </a:lnTo>
                      <a:lnTo>
                        <a:pt x="338" y="946"/>
                      </a:lnTo>
                      <a:lnTo>
                        <a:pt x="341" y="946"/>
                      </a:lnTo>
                      <a:lnTo>
                        <a:pt x="344" y="945"/>
                      </a:lnTo>
                      <a:lnTo>
                        <a:pt x="348" y="947"/>
                      </a:lnTo>
                      <a:lnTo>
                        <a:pt x="351" y="946"/>
                      </a:lnTo>
                      <a:lnTo>
                        <a:pt x="354" y="946"/>
                      </a:lnTo>
                      <a:lnTo>
                        <a:pt x="357" y="946"/>
                      </a:lnTo>
                      <a:lnTo>
                        <a:pt x="361" y="946"/>
                      </a:lnTo>
                      <a:lnTo>
                        <a:pt x="364" y="946"/>
                      </a:lnTo>
                      <a:lnTo>
                        <a:pt x="367" y="943"/>
                      </a:lnTo>
                      <a:lnTo>
                        <a:pt x="371" y="947"/>
                      </a:lnTo>
                      <a:lnTo>
                        <a:pt x="374" y="946"/>
                      </a:lnTo>
                      <a:lnTo>
                        <a:pt x="377" y="946"/>
                      </a:lnTo>
                      <a:lnTo>
                        <a:pt x="381" y="945"/>
                      </a:lnTo>
                      <a:lnTo>
                        <a:pt x="384" y="945"/>
                      </a:lnTo>
                      <a:lnTo>
                        <a:pt x="387" y="945"/>
                      </a:lnTo>
                      <a:lnTo>
                        <a:pt x="391" y="947"/>
                      </a:lnTo>
                      <a:lnTo>
                        <a:pt x="394" y="945"/>
                      </a:lnTo>
                      <a:lnTo>
                        <a:pt x="397" y="946"/>
                      </a:lnTo>
                      <a:lnTo>
                        <a:pt x="401" y="946"/>
                      </a:lnTo>
                      <a:lnTo>
                        <a:pt x="404" y="946"/>
                      </a:lnTo>
                      <a:lnTo>
                        <a:pt x="407" y="944"/>
                      </a:lnTo>
                      <a:lnTo>
                        <a:pt x="410" y="947"/>
                      </a:lnTo>
                      <a:lnTo>
                        <a:pt x="414" y="945"/>
                      </a:lnTo>
                      <a:lnTo>
                        <a:pt x="417" y="946"/>
                      </a:lnTo>
                      <a:lnTo>
                        <a:pt x="420" y="945"/>
                      </a:lnTo>
                      <a:lnTo>
                        <a:pt x="424" y="945"/>
                      </a:lnTo>
                      <a:lnTo>
                        <a:pt x="427" y="944"/>
                      </a:lnTo>
                      <a:lnTo>
                        <a:pt x="430" y="946"/>
                      </a:lnTo>
                      <a:lnTo>
                        <a:pt x="434" y="943"/>
                      </a:lnTo>
                      <a:lnTo>
                        <a:pt x="437" y="945"/>
                      </a:lnTo>
                      <a:lnTo>
                        <a:pt x="440" y="945"/>
                      </a:lnTo>
                      <a:lnTo>
                        <a:pt x="444" y="946"/>
                      </a:lnTo>
                      <a:lnTo>
                        <a:pt x="447" y="946"/>
                      </a:lnTo>
                      <a:lnTo>
                        <a:pt x="450" y="946"/>
                      </a:lnTo>
                      <a:lnTo>
                        <a:pt x="453" y="944"/>
                      </a:lnTo>
                      <a:lnTo>
                        <a:pt x="457" y="946"/>
                      </a:lnTo>
                      <a:lnTo>
                        <a:pt x="460" y="946"/>
                      </a:lnTo>
                      <a:lnTo>
                        <a:pt x="463" y="944"/>
                      </a:lnTo>
                      <a:lnTo>
                        <a:pt x="467" y="945"/>
                      </a:lnTo>
                      <a:lnTo>
                        <a:pt x="470" y="946"/>
                      </a:lnTo>
                      <a:lnTo>
                        <a:pt x="473" y="945"/>
                      </a:lnTo>
                      <a:lnTo>
                        <a:pt x="477" y="947"/>
                      </a:lnTo>
                      <a:lnTo>
                        <a:pt x="480" y="946"/>
                      </a:lnTo>
                      <a:lnTo>
                        <a:pt x="483" y="944"/>
                      </a:lnTo>
                      <a:lnTo>
                        <a:pt x="487" y="946"/>
                      </a:lnTo>
                      <a:lnTo>
                        <a:pt x="490" y="944"/>
                      </a:lnTo>
                      <a:lnTo>
                        <a:pt x="493" y="945"/>
                      </a:lnTo>
                      <a:lnTo>
                        <a:pt x="497" y="946"/>
                      </a:lnTo>
                      <a:lnTo>
                        <a:pt x="500" y="943"/>
                      </a:lnTo>
                      <a:lnTo>
                        <a:pt x="503" y="945"/>
                      </a:lnTo>
                      <a:lnTo>
                        <a:pt x="506" y="946"/>
                      </a:lnTo>
                      <a:lnTo>
                        <a:pt x="510" y="946"/>
                      </a:lnTo>
                      <a:lnTo>
                        <a:pt x="513" y="945"/>
                      </a:lnTo>
                      <a:lnTo>
                        <a:pt x="516" y="943"/>
                      </a:lnTo>
                      <a:lnTo>
                        <a:pt x="520" y="945"/>
                      </a:lnTo>
                      <a:lnTo>
                        <a:pt x="523" y="946"/>
                      </a:lnTo>
                      <a:lnTo>
                        <a:pt x="526" y="945"/>
                      </a:lnTo>
                      <a:lnTo>
                        <a:pt x="530" y="945"/>
                      </a:lnTo>
                      <a:lnTo>
                        <a:pt x="533" y="944"/>
                      </a:lnTo>
                      <a:lnTo>
                        <a:pt x="536" y="945"/>
                      </a:lnTo>
                      <a:lnTo>
                        <a:pt x="540" y="945"/>
                      </a:lnTo>
                      <a:lnTo>
                        <a:pt x="543" y="946"/>
                      </a:lnTo>
                      <a:lnTo>
                        <a:pt x="546" y="945"/>
                      </a:lnTo>
                      <a:lnTo>
                        <a:pt x="550" y="945"/>
                      </a:lnTo>
                      <a:lnTo>
                        <a:pt x="553" y="945"/>
                      </a:lnTo>
                      <a:lnTo>
                        <a:pt x="556" y="946"/>
                      </a:lnTo>
                      <a:lnTo>
                        <a:pt x="559" y="945"/>
                      </a:lnTo>
                      <a:lnTo>
                        <a:pt x="563" y="945"/>
                      </a:lnTo>
                      <a:lnTo>
                        <a:pt x="566" y="945"/>
                      </a:lnTo>
                      <a:lnTo>
                        <a:pt x="569" y="945"/>
                      </a:lnTo>
                      <a:lnTo>
                        <a:pt x="573" y="946"/>
                      </a:lnTo>
                      <a:lnTo>
                        <a:pt x="576" y="945"/>
                      </a:lnTo>
                      <a:lnTo>
                        <a:pt x="579" y="946"/>
                      </a:lnTo>
                      <a:lnTo>
                        <a:pt x="582" y="945"/>
                      </a:lnTo>
                      <a:lnTo>
                        <a:pt x="586" y="945"/>
                      </a:lnTo>
                      <a:lnTo>
                        <a:pt x="589" y="946"/>
                      </a:lnTo>
                      <a:lnTo>
                        <a:pt x="593" y="946"/>
                      </a:lnTo>
                      <a:lnTo>
                        <a:pt x="596" y="945"/>
                      </a:lnTo>
                      <a:lnTo>
                        <a:pt x="599" y="945"/>
                      </a:lnTo>
                      <a:lnTo>
                        <a:pt x="602" y="944"/>
                      </a:lnTo>
                      <a:lnTo>
                        <a:pt x="606" y="944"/>
                      </a:lnTo>
                      <a:lnTo>
                        <a:pt x="609" y="945"/>
                      </a:lnTo>
                      <a:lnTo>
                        <a:pt x="612" y="944"/>
                      </a:lnTo>
                      <a:lnTo>
                        <a:pt x="616" y="945"/>
                      </a:lnTo>
                      <a:lnTo>
                        <a:pt x="619" y="945"/>
                      </a:lnTo>
                      <a:lnTo>
                        <a:pt x="622" y="944"/>
                      </a:lnTo>
                      <a:lnTo>
                        <a:pt x="625" y="944"/>
                      </a:lnTo>
                      <a:lnTo>
                        <a:pt x="629" y="946"/>
                      </a:lnTo>
                      <a:lnTo>
                        <a:pt x="632" y="944"/>
                      </a:lnTo>
                      <a:lnTo>
                        <a:pt x="635" y="944"/>
                      </a:lnTo>
                      <a:lnTo>
                        <a:pt x="639" y="944"/>
                      </a:lnTo>
                      <a:lnTo>
                        <a:pt x="642" y="944"/>
                      </a:lnTo>
                      <a:lnTo>
                        <a:pt x="645" y="944"/>
                      </a:lnTo>
                      <a:lnTo>
                        <a:pt x="649" y="944"/>
                      </a:lnTo>
                      <a:lnTo>
                        <a:pt x="652" y="943"/>
                      </a:lnTo>
                      <a:lnTo>
                        <a:pt x="655" y="944"/>
                      </a:lnTo>
                      <a:lnTo>
                        <a:pt x="659" y="944"/>
                      </a:lnTo>
                      <a:lnTo>
                        <a:pt x="662" y="945"/>
                      </a:lnTo>
                      <a:lnTo>
                        <a:pt x="665" y="944"/>
                      </a:lnTo>
                      <a:lnTo>
                        <a:pt x="669" y="943"/>
                      </a:lnTo>
                      <a:lnTo>
                        <a:pt x="672" y="943"/>
                      </a:lnTo>
                      <a:lnTo>
                        <a:pt x="675" y="942"/>
                      </a:lnTo>
                      <a:lnTo>
                        <a:pt x="678" y="943"/>
                      </a:lnTo>
                      <a:lnTo>
                        <a:pt x="682" y="944"/>
                      </a:lnTo>
                      <a:lnTo>
                        <a:pt x="685" y="944"/>
                      </a:lnTo>
                      <a:lnTo>
                        <a:pt x="688" y="943"/>
                      </a:lnTo>
                      <a:lnTo>
                        <a:pt x="692" y="944"/>
                      </a:lnTo>
                      <a:lnTo>
                        <a:pt x="695" y="944"/>
                      </a:lnTo>
                      <a:lnTo>
                        <a:pt x="698" y="942"/>
                      </a:lnTo>
                      <a:lnTo>
                        <a:pt x="702" y="943"/>
                      </a:lnTo>
                      <a:lnTo>
                        <a:pt x="705" y="943"/>
                      </a:lnTo>
                      <a:lnTo>
                        <a:pt x="708" y="944"/>
                      </a:lnTo>
                      <a:lnTo>
                        <a:pt x="712" y="942"/>
                      </a:lnTo>
                      <a:lnTo>
                        <a:pt x="715" y="943"/>
                      </a:lnTo>
                      <a:lnTo>
                        <a:pt x="718" y="943"/>
                      </a:lnTo>
                      <a:lnTo>
                        <a:pt x="722" y="943"/>
                      </a:lnTo>
                      <a:lnTo>
                        <a:pt x="725" y="941"/>
                      </a:lnTo>
                      <a:lnTo>
                        <a:pt x="728" y="941"/>
                      </a:lnTo>
                      <a:lnTo>
                        <a:pt x="731" y="944"/>
                      </a:lnTo>
                      <a:lnTo>
                        <a:pt x="735" y="944"/>
                      </a:lnTo>
                      <a:lnTo>
                        <a:pt x="738" y="944"/>
                      </a:lnTo>
                      <a:lnTo>
                        <a:pt x="741" y="943"/>
                      </a:lnTo>
                      <a:lnTo>
                        <a:pt x="745" y="943"/>
                      </a:lnTo>
                      <a:lnTo>
                        <a:pt x="748" y="942"/>
                      </a:lnTo>
                      <a:lnTo>
                        <a:pt x="751" y="941"/>
                      </a:lnTo>
                      <a:lnTo>
                        <a:pt x="755" y="942"/>
                      </a:lnTo>
                      <a:lnTo>
                        <a:pt x="758" y="944"/>
                      </a:lnTo>
                      <a:lnTo>
                        <a:pt x="761" y="942"/>
                      </a:lnTo>
                      <a:lnTo>
                        <a:pt x="765" y="944"/>
                      </a:lnTo>
                      <a:lnTo>
                        <a:pt x="768" y="945"/>
                      </a:lnTo>
                      <a:lnTo>
                        <a:pt x="771" y="943"/>
                      </a:lnTo>
                      <a:lnTo>
                        <a:pt x="774" y="945"/>
                      </a:lnTo>
                      <a:lnTo>
                        <a:pt x="778" y="945"/>
                      </a:lnTo>
                      <a:lnTo>
                        <a:pt x="781" y="942"/>
                      </a:lnTo>
                      <a:lnTo>
                        <a:pt x="784" y="944"/>
                      </a:lnTo>
                      <a:lnTo>
                        <a:pt x="788" y="943"/>
                      </a:lnTo>
                      <a:lnTo>
                        <a:pt x="791" y="943"/>
                      </a:lnTo>
                      <a:lnTo>
                        <a:pt x="794" y="945"/>
                      </a:lnTo>
                      <a:lnTo>
                        <a:pt x="798" y="943"/>
                      </a:lnTo>
                      <a:lnTo>
                        <a:pt x="801" y="944"/>
                      </a:lnTo>
                      <a:lnTo>
                        <a:pt x="804" y="942"/>
                      </a:lnTo>
                      <a:lnTo>
                        <a:pt x="808" y="943"/>
                      </a:lnTo>
                      <a:lnTo>
                        <a:pt x="811" y="943"/>
                      </a:lnTo>
                      <a:lnTo>
                        <a:pt x="814" y="944"/>
                      </a:lnTo>
                      <a:lnTo>
                        <a:pt x="818" y="945"/>
                      </a:lnTo>
                      <a:lnTo>
                        <a:pt x="821" y="945"/>
                      </a:lnTo>
                      <a:lnTo>
                        <a:pt x="824" y="944"/>
                      </a:lnTo>
                      <a:lnTo>
                        <a:pt x="827" y="944"/>
                      </a:lnTo>
                      <a:lnTo>
                        <a:pt x="831" y="943"/>
                      </a:lnTo>
                      <a:lnTo>
                        <a:pt x="834" y="944"/>
                      </a:lnTo>
                      <a:lnTo>
                        <a:pt x="837" y="945"/>
                      </a:lnTo>
                      <a:lnTo>
                        <a:pt x="841" y="944"/>
                      </a:lnTo>
                      <a:lnTo>
                        <a:pt x="844" y="943"/>
                      </a:lnTo>
                      <a:lnTo>
                        <a:pt x="847" y="944"/>
                      </a:lnTo>
                      <a:lnTo>
                        <a:pt x="850" y="944"/>
                      </a:lnTo>
                      <a:lnTo>
                        <a:pt x="854" y="944"/>
                      </a:lnTo>
                      <a:lnTo>
                        <a:pt x="857" y="945"/>
                      </a:lnTo>
                      <a:lnTo>
                        <a:pt x="861" y="943"/>
                      </a:lnTo>
                      <a:lnTo>
                        <a:pt x="864" y="944"/>
                      </a:lnTo>
                      <a:lnTo>
                        <a:pt x="867" y="944"/>
                      </a:lnTo>
                      <a:lnTo>
                        <a:pt x="871" y="943"/>
                      </a:lnTo>
                      <a:lnTo>
                        <a:pt x="874" y="944"/>
                      </a:lnTo>
                      <a:lnTo>
                        <a:pt x="877" y="944"/>
                      </a:lnTo>
                      <a:lnTo>
                        <a:pt x="880" y="944"/>
                      </a:lnTo>
                      <a:lnTo>
                        <a:pt x="884" y="946"/>
                      </a:lnTo>
                      <a:lnTo>
                        <a:pt x="887" y="944"/>
                      </a:lnTo>
                      <a:lnTo>
                        <a:pt x="890" y="944"/>
                      </a:lnTo>
                      <a:lnTo>
                        <a:pt x="894" y="944"/>
                      </a:lnTo>
                      <a:lnTo>
                        <a:pt x="897" y="945"/>
                      </a:lnTo>
                      <a:lnTo>
                        <a:pt x="900" y="945"/>
                      </a:lnTo>
                      <a:lnTo>
                        <a:pt x="903" y="944"/>
                      </a:lnTo>
                      <a:lnTo>
                        <a:pt x="907" y="944"/>
                      </a:lnTo>
                      <a:lnTo>
                        <a:pt x="910" y="945"/>
                      </a:lnTo>
                      <a:lnTo>
                        <a:pt x="913" y="944"/>
                      </a:lnTo>
                      <a:lnTo>
                        <a:pt x="917" y="943"/>
                      </a:lnTo>
                      <a:lnTo>
                        <a:pt x="920" y="945"/>
                      </a:lnTo>
                      <a:lnTo>
                        <a:pt x="923" y="944"/>
                      </a:lnTo>
                      <a:lnTo>
                        <a:pt x="927" y="944"/>
                      </a:lnTo>
                      <a:lnTo>
                        <a:pt x="930" y="945"/>
                      </a:lnTo>
                      <a:lnTo>
                        <a:pt x="933" y="944"/>
                      </a:lnTo>
                      <a:lnTo>
                        <a:pt x="937" y="944"/>
                      </a:lnTo>
                      <a:lnTo>
                        <a:pt x="940" y="943"/>
                      </a:lnTo>
                      <a:lnTo>
                        <a:pt x="943" y="944"/>
                      </a:lnTo>
                      <a:lnTo>
                        <a:pt x="946" y="945"/>
                      </a:lnTo>
                      <a:lnTo>
                        <a:pt x="950" y="945"/>
                      </a:lnTo>
                      <a:lnTo>
                        <a:pt x="953" y="943"/>
                      </a:lnTo>
                      <a:lnTo>
                        <a:pt x="956" y="945"/>
                      </a:lnTo>
                      <a:lnTo>
                        <a:pt x="960" y="944"/>
                      </a:lnTo>
                      <a:lnTo>
                        <a:pt x="963" y="944"/>
                      </a:lnTo>
                      <a:lnTo>
                        <a:pt x="966" y="945"/>
                      </a:lnTo>
                      <a:lnTo>
                        <a:pt x="970" y="945"/>
                      </a:lnTo>
                      <a:lnTo>
                        <a:pt x="973" y="942"/>
                      </a:lnTo>
                      <a:lnTo>
                        <a:pt x="976" y="944"/>
                      </a:lnTo>
                      <a:lnTo>
                        <a:pt x="980" y="945"/>
                      </a:lnTo>
                      <a:lnTo>
                        <a:pt x="983" y="944"/>
                      </a:lnTo>
                      <a:lnTo>
                        <a:pt x="986" y="945"/>
                      </a:lnTo>
                      <a:lnTo>
                        <a:pt x="990" y="943"/>
                      </a:lnTo>
                      <a:lnTo>
                        <a:pt x="993" y="944"/>
                      </a:lnTo>
                      <a:lnTo>
                        <a:pt x="996" y="943"/>
                      </a:lnTo>
                      <a:lnTo>
                        <a:pt x="999" y="943"/>
                      </a:lnTo>
                      <a:lnTo>
                        <a:pt x="1003" y="943"/>
                      </a:lnTo>
                      <a:lnTo>
                        <a:pt x="1006" y="944"/>
                      </a:lnTo>
                      <a:lnTo>
                        <a:pt x="1009" y="944"/>
                      </a:lnTo>
                      <a:lnTo>
                        <a:pt x="1013" y="943"/>
                      </a:lnTo>
                      <a:lnTo>
                        <a:pt x="1016" y="942"/>
                      </a:lnTo>
                      <a:lnTo>
                        <a:pt x="1019" y="944"/>
                      </a:lnTo>
                      <a:lnTo>
                        <a:pt x="1023" y="943"/>
                      </a:lnTo>
                      <a:lnTo>
                        <a:pt x="1026" y="944"/>
                      </a:lnTo>
                      <a:lnTo>
                        <a:pt x="1029" y="943"/>
                      </a:lnTo>
                      <a:lnTo>
                        <a:pt x="1033" y="944"/>
                      </a:lnTo>
                      <a:lnTo>
                        <a:pt x="1036" y="944"/>
                      </a:lnTo>
                      <a:lnTo>
                        <a:pt x="1039" y="944"/>
                      </a:lnTo>
                      <a:lnTo>
                        <a:pt x="1043" y="943"/>
                      </a:lnTo>
                      <a:lnTo>
                        <a:pt x="1046" y="943"/>
                      </a:lnTo>
                      <a:lnTo>
                        <a:pt x="1049" y="942"/>
                      </a:lnTo>
                      <a:lnTo>
                        <a:pt x="1052" y="944"/>
                      </a:lnTo>
                      <a:lnTo>
                        <a:pt x="1056" y="945"/>
                      </a:lnTo>
                      <a:lnTo>
                        <a:pt x="1059" y="944"/>
                      </a:lnTo>
                      <a:lnTo>
                        <a:pt x="1062" y="945"/>
                      </a:lnTo>
                      <a:lnTo>
                        <a:pt x="1066" y="942"/>
                      </a:lnTo>
                      <a:lnTo>
                        <a:pt x="1069" y="944"/>
                      </a:lnTo>
                      <a:lnTo>
                        <a:pt x="1072" y="946"/>
                      </a:lnTo>
                      <a:lnTo>
                        <a:pt x="1076" y="944"/>
                      </a:lnTo>
                      <a:lnTo>
                        <a:pt x="1079" y="944"/>
                      </a:lnTo>
                      <a:lnTo>
                        <a:pt x="1082" y="943"/>
                      </a:lnTo>
                      <a:lnTo>
                        <a:pt x="1086" y="943"/>
                      </a:lnTo>
                      <a:lnTo>
                        <a:pt x="1089" y="944"/>
                      </a:lnTo>
                      <a:lnTo>
                        <a:pt x="1092" y="945"/>
                      </a:lnTo>
                      <a:lnTo>
                        <a:pt x="1095" y="943"/>
                      </a:lnTo>
                      <a:lnTo>
                        <a:pt x="1099" y="944"/>
                      </a:lnTo>
                      <a:lnTo>
                        <a:pt x="1102" y="943"/>
                      </a:lnTo>
                      <a:lnTo>
                        <a:pt x="1105" y="944"/>
                      </a:lnTo>
                      <a:lnTo>
                        <a:pt x="1109" y="943"/>
                      </a:lnTo>
                      <a:lnTo>
                        <a:pt x="1112" y="943"/>
                      </a:lnTo>
                      <a:lnTo>
                        <a:pt x="1115" y="944"/>
                      </a:lnTo>
                      <a:lnTo>
                        <a:pt x="1118" y="943"/>
                      </a:lnTo>
                      <a:lnTo>
                        <a:pt x="1122" y="943"/>
                      </a:lnTo>
                      <a:lnTo>
                        <a:pt x="1125" y="944"/>
                      </a:lnTo>
                      <a:lnTo>
                        <a:pt x="1129" y="943"/>
                      </a:lnTo>
                      <a:lnTo>
                        <a:pt x="1132" y="944"/>
                      </a:lnTo>
                      <a:lnTo>
                        <a:pt x="1135" y="942"/>
                      </a:lnTo>
                      <a:lnTo>
                        <a:pt x="1139" y="943"/>
                      </a:lnTo>
                      <a:lnTo>
                        <a:pt x="1142" y="944"/>
                      </a:lnTo>
                      <a:lnTo>
                        <a:pt x="1145" y="944"/>
                      </a:lnTo>
                      <a:lnTo>
                        <a:pt x="1148" y="944"/>
                      </a:lnTo>
                      <a:lnTo>
                        <a:pt x="1152" y="943"/>
                      </a:lnTo>
                      <a:lnTo>
                        <a:pt x="1155" y="943"/>
                      </a:lnTo>
                      <a:lnTo>
                        <a:pt x="1158" y="943"/>
                      </a:lnTo>
                      <a:lnTo>
                        <a:pt x="1162" y="942"/>
                      </a:lnTo>
                      <a:lnTo>
                        <a:pt x="1165" y="943"/>
                      </a:lnTo>
                      <a:lnTo>
                        <a:pt x="1168" y="943"/>
                      </a:lnTo>
                      <a:lnTo>
                        <a:pt x="1171" y="943"/>
                      </a:lnTo>
                      <a:lnTo>
                        <a:pt x="1175" y="943"/>
                      </a:lnTo>
                      <a:lnTo>
                        <a:pt x="1178" y="944"/>
                      </a:lnTo>
                      <a:lnTo>
                        <a:pt x="1181" y="942"/>
                      </a:lnTo>
                      <a:lnTo>
                        <a:pt x="1185" y="943"/>
                      </a:lnTo>
                      <a:lnTo>
                        <a:pt x="1188" y="943"/>
                      </a:lnTo>
                      <a:lnTo>
                        <a:pt x="1191" y="942"/>
                      </a:lnTo>
                      <a:lnTo>
                        <a:pt x="1195" y="943"/>
                      </a:lnTo>
                      <a:lnTo>
                        <a:pt x="1198" y="942"/>
                      </a:lnTo>
                      <a:lnTo>
                        <a:pt x="1201" y="943"/>
                      </a:lnTo>
                      <a:lnTo>
                        <a:pt x="1205" y="943"/>
                      </a:lnTo>
                      <a:lnTo>
                        <a:pt x="1208" y="943"/>
                      </a:lnTo>
                      <a:lnTo>
                        <a:pt x="1211" y="944"/>
                      </a:lnTo>
                      <a:lnTo>
                        <a:pt x="1215" y="943"/>
                      </a:lnTo>
                      <a:lnTo>
                        <a:pt x="1218" y="942"/>
                      </a:lnTo>
                      <a:lnTo>
                        <a:pt x="1221" y="944"/>
                      </a:lnTo>
                      <a:lnTo>
                        <a:pt x="1224" y="944"/>
                      </a:lnTo>
                      <a:lnTo>
                        <a:pt x="1228" y="943"/>
                      </a:lnTo>
                      <a:lnTo>
                        <a:pt x="1231" y="943"/>
                      </a:lnTo>
                      <a:lnTo>
                        <a:pt x="1234" y="944"/>
                      </a:lnTo>
                      <a:lnTo>
                        <a:pt x="1238" y="942"/>
                      </a:lnTo>
                      <a:lnTo>
                        <a:pt x="1241" y="942"/>
                      </a:lnTo>
                      <a:lnTo>
                        <a:pt x="1244" y="942"/>
                      </a:lnTo>
                      <a:lnTo>
                        <a:pt x="1248" y="942"/>
                      </a:lnTo>
                      <a:lnTo>
                        <a:pt x="1251" y="941"/>
                      </a:lnTo>
                      <a:lnTo>
                        <a:pt x="1254" y="943"/>
                      </a:lnTo>
                      <a:lnTo>
                        <a:pt x="1258" y="944"/>
                      </a:lnTo>
                      <a:lnTo>
                        <a:pt x="1261" y="941"/>
                      </a:lnTo>
                      <a:lnTo>
                        <a:pt x="1264" y="943"/>
                      </a:lnTo>
                      <a:lnTo>
                        <a:pt x="1267" y="945"/>
                      </a:lnTo>
                      <a:lnTo>
                        <a:pt x="1271" y="943"/>
                      </a:lnTo>
                      <a:lnTo>
                        <a:pt x="1274" y="944"/>
                      </a:lnTo>
                      <a:lnTo>
                        <a:pt x="1277" y="945"/>
                      </a:lnTo>
                      <a:lnTo>
                        <a:pt x="1281" y="942"/>
                      </a:lnTo>
                      <a:lnTo>
                        <a:pt x="1284" y="942"/>
                      </a:lnTo>
                      <a:lnTo>
                        <a:pt x="1287" y="942"/>
                      </a:lnTo>
                      <a:lnTo>
                        <a:pt x="1291" y="944"/>
                      </a:lnTo>
                      <a:lnTo>
                        <a:pt x="1294" y="943"/>
                      </a:lnTo>
                      <a:lnTo>
                        <a:pt x="1297" y="943"/>
                      </a:lnTo>
                      <a:lnTo>
                        <a:pt x="1301" y="943"/>
                      </a:lnTo>
                      <a:lnTo>
                        <a:pt x="1304" y="945"/>
                      </a:lnTo>
                      <a:lnTo>
                        <a:pt x="1307" y="942"/>
                      </a:lnTo>
                      <a:lnTo>
                        <a:pt x="1311" y="944"/>
                      </a:lnTo>
                      <a:lnTo>
                        <a:pt x="1314" y="942"/>
                      </a:lnTo>
                      <a:lnTo>
                        <a:pt x="1317" y="942"/>
                      </a:lnTo>
                      <a:lnTo>
                        <a:pt x="1320" y="943"/>
                      </a:lnTo>
                      <a:lnTo>
                        <a:pt x="1324" y="943"/>
                      </a:lnTo>
                      <a:lnTo>
                        <a:pt x="1327" y="943"/>
                      </a:lnTo>
                      <a:lnTo>
                        <a:pt x="1330" y="943"/>
                      </a:lnTo>
                      <a:lnTo>
                        <a:pt x="1334" y="942"/>
                      </a:lnTo>
                      <a:lnTo>
                        <a:pt x="1337" y="944"/>
                      </a:lnTo>
                      <a:lnTo>
                        <a:pt x="1340" y="944"/>
                      </a:lnTo>
                      <a:lnTo>
                        <a:pt x="1344" y="942"/>
                      </a:lnTo>
                      <a:lnTo>
                        <a:pt x="1347" y="943"/>
                      </a:lnTo>
                      <a:lnTo>
                        <a:pt x="1350" y="943"/>
                      </a:lnTo>
                      <a:lnTo>
                        <a:pt x="1354" y="942"/>
                      </a:lnTo>
                      <a:lnTo>
                        <a:pt x="1357" y="943"/>
                      </a:lnTo>
                      <a:lnTo>
                        <a:pt x="1360" y="944"/>
                      </a:lnTo>
                      <a:lnTo>
                        <a:pt x="1363" y="943"/>
                      </a:lnTo>
                      <a:lnTo>
                        <a:pt x="1367" y="940"/>
                      </a:lnTo>
                      <a:lnTo>
                        <a:pt x="1370" y="943"/>
                      </a:lnTo>
                      <a:lnTo>
                        <a:pt x="1373" y="943"/>
                      </a:lnTo>
                      <a:lnTo>
                        <a:pt x="1377" y="944"/>
                      </a:lnTo>
                      <a:lnTo>
                        <a:pt x="1380" y="942"/>
                      </a:lnTo>
                      <a:lnTo>
                        <a:pt x="1383" y="943"/>
                      </a:lnTo>
                      <a:lnTo>
                        <a:pt x="1387" y="943"/>
                      </a:lnTo>
                      <a:lnTo>
                        <a:pt x="1390" y="943"/>
                      </a:lnTo>
                      <a:lnTo>
                        <a:pt x="1393" y="942"/>
                      </a:lnTo>
                      <a:lnTo>
                        <a:pt x="1397" y="941"/>
                      </a:lnTo>
                      <a:lnTo>
                        <a:pt x="1400" y="942"/>
                      </a:lnTo>
                      <a:lnTo>
                        <a:pt x="1403" y="941"/>
                      </a:lnTo>
                      <a:lnTo>
                        <a:pt x="1407" y="940"/>
                      </a:lnTo>
                      <a:lnTo>
                        <a:pt x="1410" y="943"/>
                      </a:lnTo>
                      <a:lnTo>
                        <a:pt x="1413" y="943"/>
                      </a:lnTo>
                      <a:lnTo>
                        <a:pt x="1416" y="942"/>
                      </a:lnTo>
                      <a:lnTo>
                        <a:pt x="1420" y="941"/>
                      </a:lnTo>
                      <a:lnTo>
                        <a:pt x="1423" y="942"/>
                      </a:lnTo>
                      <a:lnTo>
                        <a:pt x="1426" y="943"/>
                      </a:lnTo>
                      <a:lnTo>
                        <a:pt x="1430" y="942"/>
                      </a:lnTo>
                      <a:lnTo>
                        <a:pt x="1433" y="943"/>
                      </a:lnTo>
                      <a:lnTo>
                        <a:pt x="1436" y="942"/>
                      </a:lnTo>
                      <a:lnTo>
                        <a:pt x="1439" y="942"/>
                      </a:lnTo>
                      <a:lnTo>
                        <a:pt x="1443" y="942"/>
                      </a:lnTo>
                      <a:lnTo>
                        <a:pt x="1446" y="941"/>
                      </a:lnTo>
                      <a:lnTo>
                        <a:pt x="1449" y="944"/>
                      </a:lnTo>
                      <a:lnTo>
                        <a:pt x="1453" y="941"/>
                      </a:lnTo>
                      <a:lnTo>
                        <a:pt x="1456" y="942"/>
                      </a:lnTo>
                      <a:lnTo>
                        <a:pt x="1459" y="942"/>
                      </a:lnTo>
                      <a:lnTo>
                        <a:pt x="1463" y="942"/>
                      </a:lnTo>
                      <a:lnTo>
                        <a:pt x="1466" y="941"/>
                      </a:lnTo>
                      <a:lnTo>
                        <a:pt x="1469" y="942"/>
                      </a:lnTo>
                      <a:lnTo>
                        <a:pt x="1473" y="941"/>
                      </a:lnTo>
                      <a:lnTo>
                        <a:pt x="1476" y="942"/>
                      </a:lnTo>
                      <a:lnTo>
                        <a:pt x="1479" y="940"/>
                      </a:lnTo>
                      <a:lnTo>
                        <a:pt x="1483" y="942"/>
                      </a:lnTo>
                      <a:lnTo>
                        <a:pt x="1486" y="942"/>
                      </a:lnTo>
                      <a:lnTo>
                        <a:pt x="1489" y="942"/>
                      </a:lnTo>
                      <a:lnTo>
                        <a:pt x="1492" y="942"/>
                      </a:lnTo>
                      <a:lnTo>
                        <a:pt x="1496" y="942"/>
                      </a:lnTo>
                      <a:lnTo>
                        <a:pt x="1499" y="941"/>
                      </a:lnTo>
                      <a:lnTo>
                        <a:pt x="1502" y="941"/>
                      </a:lnTo>
                      <a:lnTo>
                        <a:pt x="1506" y="941"/>
                      </a:lnTo>
                      <a:lnTo>
                        <a:pt x="1509" y="941"/>
                      </a:lnTo>
                      <a:lnTo>
                        <a:pt x="1512" y="942"/>
                      </a:lnTo>
                      <a:lnTo>
                        <a:pt x="1516" y="940"/>
                      </a:lnTo>
                      <a:lnTo>
                        <a:pt x="1519" y="941"/>
                      </a:lnTo>
                      <a:lnTo>
                        <a:pt x="1522" y="942"/>
                      </a:lnTo>
                      <a:lnTo>
                        <a:pt x="1526" y="942"/>
                      </a:lnTo>
                      <a:lnTo>
                        <a:pt x="1529" y="942"/>
                      </a:lnTo>
                      <a:lnTo>
                        <a:pt x="1532" y="941"/>
                      </a:lnTo>
                      <a:lnTo>
                        <a:pt x="1535" y="941"/>
                      </a:lnTo>
                      <a:lnTo>
                        <a:pt x="1539" y="943"/>
                      </a:lnTo>
                      <a:lnTo>
                        <a:pt x="1542" y="944"/>
                      </a:lnTo>
                      <a:lnTo>
                        <a:pt x="1545" y="943"/>
                      </a:lnTo>
                      <a:lnTo>
                        <a:pt x="1549" y="941"/>
                      </a:lnTo>
                      <a:lnTo>
                        <a:pt x="1552" y="940"/>
                      </a:lnTo>
                      <a:lnTo>
                        <a:pt x="1555" y="941"/>
                      </a:lnTo>
                      <a:lnTo>
                        <a:pt x="1559" y="941"/>
                      </a:lnTo>
                      <a:lnTo>
                        <a:pt x="1562" y="940"/>
                      </a:lnTo>
                      <a:lnTo>
                        <a:pt x="1565" y="940"/>
                      </a:lnTo>
                      <a:lnTo>
                        <a:pt x="1569" y="939"/>
                      </a:lnTo>
                      <a:lnTo>
                        <a:pt x="1572" y="942"/>
                      </a:lnTo>
                      <a:lnTo>
                        <a:pt x="1575" y="942"/>
                      </a:lnTo>
                      <a:lnTo>
                        <a:pt x="1579" y="941"/>
                      </a:lnTo>
                      <a:lnTo>
                        <a:pt x="1582" y="941"/>
                      </a:lnTo>
                      <a:lnTo>
                        <a:pt x="1585" y="941"/>
                      </a:lnTo>
                      <a:lnTo>
                        <a:pt x="1588" y="941"/>
                      </a:lnTo>
                      <a:lnTo>
                        <a:pt x="1592" y="941"/>
                      </a:lnTo>
                      <a:lnTo>
                        <a:pt x="1595" y="940"/>
                      </a:lnTo>
                      <a:lnTo>
                        <a:pt x="1598" y="941"/>
                      </a:lnTo>
                      <a:lnTo>
                        <a:pt x="1602" y="942"/>
                      </a:lnTo>
                      <a:lnTo>
                        <a:pt x="1605" y="941"/>
                      </a:lnTo>
                      <a:lnTo>
                        <a:pt x="1608" y="940"/>
                      </a:lnTo>
                      <a:lnTo>
                        <a:pt x="1612" y="940"/>
                      </a:lnTo>
                      <a:lnTo>
                        <a:pt x="1615" y="940"/>
                      </a:lnTo>
                      <a:lnTo>
                        <a:pt x="1618" y="939"/>
                      </a:lnTo>
                      <a:lnTo>
                        <a:pt x="1622" y="941"/>
                      </a:lnTo>
                      <a:lnTo>
                        <a:pt x="1625" y="940"/>
                      </a:lnTo>
                      <a:lnTo>
                        <a:pt x="1628" y="939"/>
                      </a:lnTo>
                      <a:lnTo>
                        <a:pt x="1632" y="942"/>
                      </a:lnTo>
                      <a:lnTo>
                        <a:pt x="1635" y="940"/>
                      </a:lnTo>
                      <a:lnTo>
                        <a:pt x="1638" y="940"/>
                      </a:lnTo>
                      <a:lnTo>
                        <a:pt x="1641" y="941"/>
                      </a:lnTo>
                      <a:lnTo>
                        <a:pt x="1645" y="940"/>
                      </a:lnTo>
                      <a:lnTo>
                        <a:pt x="1648" y="940"/>
                      </a:lnTo>
                      <a:lnTo>
                        <a:pt x="1651" y="941"/>
                      </a:lnTo>
                      <a:lnTo>
                        <a:pt x="1655" y="940"/>
                      </a:lnTo>
                      <a:lnTo>
                        <a:pt x="1658" y="941"/>
                      </a:lnTo>
                      <a:lnTo>
                        <a:pt x="1661" y="940"/>
                      </a:lnTo>
                      <a:lnTo>
                        <a:pt x="1665" y="941"/>
                      </a:lnTo>
                      <a:lnTo>
                        <a:pt x="1668" y="939"/>
                      </a:lnTo>
                      <a:lnTo>
                        <a:pt x="1671" y="939"/>
                      </a:lnTo>
                      <a:lnTo>
                        <a:pt x="1675" y="941"/>
                      </a:lnTo>
                      <a:lnTo>
                        <a:pt x="1678" y="939"/>
                      </a:lnTo>
                      <a:lnTo>
                        <a:pt x="1681" y="939"/>
                      </a:lnTo>
                      <a:lnTo>
                        <a:pt x="1684" y="941"/>
                      </a:lnTo>
                      <a:lnTo>
                        <a:pt x="1688" y="941"/>
                      </a:lnTo>
                      <a:lnTo>
                        <a:pt x="1691" y="941"/>
                      </a:lnTo>
                      <a:lnTo>
                        <a:pt x="1694" y="940"/>
                      </a:lnTo>
                      <a:lnTo>
                        <a:pt x="1698" y="941"/>
                      </a:lnTo>
                      <a:lnTo>
                        <a:pt x="1701" y="939"/>
                      </a:lnTo>
                      <a:lnTo>
                        <a:pt x="1704" y="939"/>
                      </a:lnTo>
                      <a:lnTo>
                        <a:pt x="1707" y="940"/>
                      </a:lnTo>
                      <a:lnTo>
                        <a:pt x="1711" y="941"/>
                      </a:lnTo>
                      <a:lnTo>
                        <a:pt x="1714" y="940"/>
                      </a:lnTo>
                      <a:lnTo>
                        <a:pt x="1717" y="939"/>
                      </a:lnTo>
                      <a:lnTo>
                        <a:pt x="1721" y="939"/>
                      </a:lnTo>
                      <a:lnTo>
                        <a:pt x="1724" y="938"/>
                      </a:lnTo>
                      <a:lnTo>
                        <a:pt x="1727" y="939"/>
                      </a:lnTo>
                      <a:lnTo>
                        <a:pt x="1731" y="939"/>
                      </a:lnTo>
                      <a:lnTo>
                        <a:pt x="1734" y="939"/>
                      </a:lnTo>
                      <a:lnTo>
                        <a:pt x="1737" y="939"/>
                      </a:lnTo>
                      <a:lnTo>
                        <a:pt x="1741" y="938"/>
                      </a:lnTo>
                      <a:lnTo>
                        <a:pt x="1744" y="939"/>
                      </a:lnTo>
                      <a:lnTo>
                        <a:pt x="1747" y="940"/>
                      </a:lnTo>
                      <a:lnTo>
                        <a:pt x="1751" y="939"/>
                      </a:lnTo>
                      <a:lnTo>
                        <a:pt x="1754" y="939"/>
                      </a:lnTo>
                      <a:lnTo>
                        <a:pt x="1757" y="937"/>
                      </a:lnTo>
                      <a:lnTo>
                        <a:pt x="1760" y="938"/>
                      </a:lnTo>
                      <a:lnTo>
                        <a:pt x="1764" y="938"/>
                      </a:lnTo>
                      <a:lnTo>
                        <a:pt x="1767" y="939"/>
                      </a:lnTo>
                      <a:lnTo>
                        <a:pt x="1770" y="939"/>
                      </a:lnTo>
                      <a:lnTo>
                        <a:pt x="1774" y="938"/>
                      </a:lnTo>
                      <a:lnTo>
                        <a:pt x="1777" y="938"/>
                      </a:lnTo>
                      <a:lnTo>
                        <a:pt x="1780" y="937"/>
                      </a:lnTo>
                      <a:lnTo>
                        <a:pt x="1784" y="936"/>
                      </a:lnTo>
                      <a:lnTo>
                        <a:pt x="1787" y="938"/>
                      </a:lnTo>
                      <a:lnTo>
                        <a:pt x="1790" y="939"/>
                      </a:lnTo>
                      <a:lnTo>
                        <a:pt x="1794" y="939"/>
                      </a:lnTo>
                      <a:lnTo>
                        <a:pt x="1797" y="936"/>
                      </a:lnTo>
                      <a:lnTo>
                        <a:pt x="1800" y="935"/>
                      </a:lnTo>
                      <a:lnTo>
                        <a:pt x="1804" y="938"/>
                      </a:lnTo>
                      <a:lnTo>
                        <a:pt x="1807" y="937"/>
                      </a:lnTo>
                      <a:lnTo>
                        <a:pt x="1810" y="937"/>
                      </a:lnTo>
                      <a:lnTo>
                        <a:pt x="1813" y="936"/>
                      </a:lnTo>
                      <a:lnTo>
                        <a:pt x="1817" y="935"/>
                      </a:lnTo>
                      <a:lnTo>
                        <a:pt x="1820" y="938"/>
                      </a:lnTo>
                      <a:lnTo>
                        <a:pt x="1823" y="938"/>
                      </a:lnTo>
                      <a:lnTo>
                        <a:pt x="1827" y="937"/>
                      </a:lnTo>
                      <a:lnTo>
                        <a:pt x="1830" y="937"/>
                      </a:lnTo>
                      <a:lnTo>
                        <a:pt x="1833" y="936"/>
                      </a:lnTo>
                      <a:lnTo>
                        <a:pt x="1837" y="937"/>
                      </a:lnTo>
                      <a:lnTo>
                        <a:pt x="1840" y="934"/>
                      </a:lnTo>
                      <a:lnTo>
                        <a:pt x="1843" y="936"/>
                      </a:lnTo>
                      <a:lnTo>
                        <a:pt x="1847" y="936"/>
                      </a:lnTo>
                      <a:lnTo>
                        <a:pt x="1850" y="935"/>
                      </a:lnTo>
                      <a:lnTo>
                        <a:pt x="1853" y="936"/>
                      </a:lnTo>
                      <a:lnTo>
                        <a:pt x="1856" y="935"/>
                      </a:lnTo>
                      <a:lnTo>
                        <a:pt x="1860" y="936"/>
                      </a:lnTo>
                      <a:lnTo>
                        <a:pt x="1863" y="936"/>
                      </a:lnTo>
                      <a:lnTo>
                        <a:pt x="1866" y="937"/>
                      </a:lnTo>
                      <a:lnTo>
                        <a:pt x="1870" y="936"/>
                      </a:lnTo>
                      <a:lnTo>
                        <a:pt x="1873" y="936"/>
                      </a:lnTo>
                      <a:lnTo>
                        <a:pt x="1876" y="936"/>
                      </a:lnTo>
                      <a:lnTo>
                        <a:pt x="1880" y="937"/>
                      </a:lnTo>
                      <a:lnTo>
                        <a:pt x="1883" y="936"/>
                      </a:lnTo>
                      <a:lnTo>
                        <a:pt x="1886" y="935"/>
                      </a:lnTo>
                      <a:lnTo>
                        <a:pt x="1890" y="935"/>
                      </a:lnTo>
                      <a:lnTo>
                        <a:pt x="1893" y="934"/>
                      </a:lnTo>
                      <a:lnTo>
                        <a:pt x="1896" y="936"/>
                      </a:lnTo>
                      <a:lnTo>
                        <a:pt x="1900" y="935"/>
                      </a:lnTo>
                      <a:lnTo>
                        <a:pt x="1903" y="935"/>
                      </a:lnTo>
                      <a:lnTo>
                        <a:pt x="1906" y="935"/>
                      </a:lnTo>
                      <a:lnTo>
                        <a:pt x="1909" y="934"/>
                      </a:lnTo>
                      <a:lnTo>
                        <a:pt x="1913" y="935"/>
                      </a:lnTo>
                      <a:lnTo>
                        <a:pt x="1916" y="933"/>
                      </a:lnTo>
                      <a:lnTo>
                        <a:pt x="1919" y="933"/>
                      </a:lnTo>
                      <a:lnTo>
                        <a:pt x="1923" y="934"/>
                      </a:lnTo>
                      <a:lnTo>
                        <a:pt x="1926" y="935"/>
                      </a:lnTo>
                      <a:lnTo>
                        <a:pt x="1929" y="935"/>
                      </a:lnTo>
                      <a:lnTo>
                        <a:pt x="1933" y="934"/>
                      </a:lnTo>
                      <a:lnTo>
                        <a:pt x="1936" y="933"/>
                      </a:lnTo>
                      <a:lnTo>
                        <a:pt x="1939" y="934"/>
                      </a:lnTo>
                      <a:lnTo>
                        <a:pt x="1943" y="934"/>
                      </a:lnTo>
                      <a:lnTo>
                        <a:pt x="1946" y="934"/>
                      </a:lnTo>
                      <a:lnTo>
                        <a:pt x="1949" y="935"/>
                      </a:lnTo>
                      <a:lnTo>
                        <a:pt x="1953" y="933"/>
                      </a:lnTo>
                      <a:lnTo>
                        <a:pt x="1956" y="933"/>
                      </a:lnTo>
                      <a:lnTo>
                        <a:pt x="1959" y="933"/>
                      </a:lnTo>
                      <a:lnTo>
                        <a:pt x="1962" y="932"/>
                      </a:lnTo>
                      <a:lnTo>
                        <a:pt x="1966" y="933"/>
                      </a:lnTo>
                      <a:lnTo>
                        <a:pt x="1969" y="933"/>
                      </a:lnTo>
                      <a:lnTo>
                        <a:pt x="1972" y="932"/>
                      </a:lnTo>
                      <a:lnTo>
                        <a:pt x="1976" y="932"/>
                      </a:lnTo>
                      <a:lnTo>
                        <a:pt x="1979" y="933"/>
                      </a:lnTo>
                      <a:lnTo>
                        <a:pt x="1982" y="932"/>
                      </a:lnTo>
                      <a:lnTo>
                        <a:pt x="1985" y="933"/>
                      </a:lnTo>
                      <a:lnTo>
                        <a:pt x="1989" y="933"/>
                      </a:lnTo>
                      <a:lnTo>
                        <a:pt x="1992" y="933"/>
                      </a:lnTo>
                      <a:lnTo>
                        <a:pt x="1995" y="934"/>
                      </a:lnTo>
                      <a:lnTo>
                        <a:pt x="1999" y="932"/>
                      </a:lnTo>
                      <a:lnTo>
                        <a:pt x="2002" y="935"/>
                      </a:lnTo>
                      <a:lnTo>
                        <a:pt x="2005" y="934"/>
                      </a:lnTo>
                      <a:lnTo>
                        <a:pt x="2009" y="933"/>
                      </a:lnTo>
                      <a:lnTo>
                        <a:pt x="2012" y="933"/>
                      </a:lnTo>
                      <a:lnTo>
                        <a:pt x="2015" y="935"/>
                      </a:lnTo>
                      <a:lnTo>
                        <a:pt x="2019" y="934"/>
                      </a:lnTo>
                      <a:lnTo>
                        <a:pt x="2022" y="935"/>
                      </a:lnTo>
                      <a:lnTo>
                        <a:pt x="2025" y="935"/>
                      </a:lnTo>
                      <a:lnTo>
                        <a:pt x="2028" y="935"/>
                      </a:lnTo>
                      <a:lnTo>
                        <a:pt x="2032" y="935"/>
                      </a:lnTo>
                      <a:lnTo>
                        <a:pt x="2035" y="935"/>
                      </a:lnTo>
                      <a:lnTo>
                        <a:pt x="2038" y="935"/>
                      </a:lnTo>
                      <a:lnTo>
                        <a:pt x="2042" y="935"/>
                      </a:lnTo>
                      <a:lnTo>
                        <a:pt x="2045" y="935"/>
                      </a:lnTo>
                      <a:lnTo>
                        <a:pt x="2048" y="935"/>
                      </a:lnTo>
                      <a:lnTo>
                        <a:pt x="2052" y="936"/>
                      </a:lnTo>
                      <a:lnTo>
                        <a:pt x="2055" y="936"/>
                      </a:lnTo>
                      <a:lnTo>
                        <a:pt x="2058" y="935"/>
                      </a:lnTo>
                      <a:lnTo>
                        <a:pt x="2062" y="935"/>
                      </a:lnTo>
                      <a:lnTo>
                        <a:pt x="2065" y="936"/>
                      </a:lnTo>
                      <a:lnTo>
                        <a:pt x="2068" y="936"/>
                      </a:lnTo>
                      <a:lnTo>
                        <a:pt x="2072" y="937"/>
                      </a:lnTo>
                      <a:lnTo>
                        <a:pt x="2075" y="936"/>
                      </a:lnTo>
                      <a:lnTo>
                        <a:pt x="2078" y="937"/>
                      </a:lnTo>
                      <a:lnTo>
                        <a:pt x="2081" y="937"/>
                      </a:lnTo>
                      <a:lnTo>
                        <a:pt x="2085" y="937"/>
                      </a:lnTo>
                      <a:lnTo>
                        <a:pt x="2088" y="936"/>
                      </a:lnTo>
                      <a:lnTo>
                        <a:pt x="2091" y="938"/>
                      </a:lnTo>
                      <a:lnTo>
                        <a:pt x="2095" y="937"/>
                      </a:lnTo>
                      <a:lnTo>
                        <a:pt x="2098" y="937"/>
                      </a:lnTo>
                      <a:lnTo>
                        <a:pt x="2101" y="938"/>
                      </a:lnTo>
                      <a:lnTo>
                        <a:pt x="2105" y="938"/>
                      </a:lnTo>
                      <a:lnTo>
                        <a:pt x="2108" y="939"/>
                      </a:lnTo>
                      <a:lnTo>
                        <a:pt x="2111" y="937"/>
                      </a:lnTo>
                      <a:lnTo>
                        <a:pt x="2115" y="938"/>
                      </a:lnTo>
                      <a:lnTo>
                        <a:pt x="2118" y="939"/>
                      </a:lnTo>
                      <a:lnTo>
                        <a:pt x="2121" y="939"/>
                      </a:lnTo>
                      <a:lnTo>
                        <a:pt x="2125" y="938"/>
                      </a:lnTo>
                      <a:lnTo>
                        <a:pt x="2128" y="936"/>
                      </a:lnTo>
                      <a:lnTo>
                        <a:pt x="2131" y="938"/>
                      </a:lnTo>
                      <a:lnTo>
                        <a:pt x="2134" y="938"/>
                      </a:lnTo>
                      <a:lnTo>
                        <a:pt x="2138" y="938"/>
                      </a:lnTo>
                      <a:lnTo>
                        <a:pt x="2141" y="936"/>
                      </a:lnTo>
                      <a:lnTo>
                        <a:pt x="2144" y="938"/>
                      </a:lnTo>
                      <a:lnTo>
                        <a:pt x="2148" y="936"/>
                      </a:lnTo>
                      <a:lnTo>
                        <a:pt x="2151" y="937"/>
                      </a:lnTo>
                      <a:lnTo>
                        <a:pt x="2154" y="937"/>
                      </a:lnTo>
                      <a:lnTo>
                        <a:pt x="2158" y="938"/>
                      </a:lnTo>
                      <a:lnTo>
                        <a:pt x="2161" y="937"/>
                      </a:lnTo>
                      <a:lnTo>
                        <a:pt x="2164" y="938"/>
                      </a:lnTo>
                      <a:lnTo>
                        <a:pt x="2168" y="937"/>
                      </a:lnTo>
                      <a:lnTo>
                        <a:pt x="2171" y="938"/>
                      </a:lnTo>
                      <a:lnTo>
                        <a:pt x="2174" y="939"/>
                      </a:lnTo>
                      <a:lnTo>
                        <a:pt x="2177" y="937"/>
                      </a:lnTo>
                      <a:lnTo>
                        <a:pt x="2181" y="938"/>
                      </a:lnTo>
                      <a:lnTo>
                        <a:pt x="2184" y="939"/>
                      </a:lnTo>
                      <a:lnTo>
                        <a:pt x="2187" y="939"/>
                      </a:lnTo>
                      <a:lnTo>
                        <a:pt x="2191" y="938"/>
                      </a:lnTo>
                      <a:lnTo>
                        <a:pt x="2194" y="936"/>
                      </a:lnTo>
                      <a:lnTo>
                        <a:pt x="2197" y="938"/>
                      </a:lnTo>
                      <a:lnTo>
                        <a:pt x="2201" y="939"/>
                      </a:lnTo>
                      <a:lnTo>
                        <a:pt x="2204" y="939"/>
                      </a:lnTo>
                      <a:lnTo>
                        <a:pt x="2207" y="937"/>
                      </a:lnTo>
                      <a:lnTo>
                        <a:pt x="2211" y="938"/>
                      </a:lnTo>
                      <a:lnTo>
                        <a:pt x="2214" y="939"/>
                      </a:lnTo>
                      <a:lnTo>
                        <a:pt x="2217" y="936"/>
                      </a:lnTo>
                      <a:lnTo>
                        <a:pt x="2221" y="938"/>
                      </a:lnTo>
                      <a:lnTo>
                        <a:pt x="2224" y="939"/>
                      </a:lnTo>
                      <a:lnTo>
                        <a:pt x="2227" y="937"/>
                      </a:lnTo>
                      <a:lnTo>
                        <a:pt x="2230" y="938"/>
                      </a:lnTo>
                      <a:lnTo>
                        <a:pt x="2234" y="939"/>
                      </a:lnTo>
                      <a:lnTo>
                        <a:pt x="2237" y="937"/>
                      </a:lnTo>
                      <a:lnTo>
                        <a:pt x="2240" y="938"/>
                      </a:lnTo>
                      <a:lnTo>
                        <a:pt x="2244" y="938"/>
                      </a:lnTo>
                      <a:lnTo>
                        <a:pt x="2247" y="938"/>
                      </a:lnTo>
                      <a:lnTo>
                        <a:pt x="2250" y="938"/>
                      </a:lnTo>
                      <a:lnTo>
                        <a:pt x="2253" y="937"/>
                      </a:lnTo>
                      <a:lnTo>
                        <a:pt x="2257" y="938"/>
                      </a:lnTo>
                      <a:lnTo>
                        <a:pt x="2260" y="937"/>
                      </a:lnTo>
                      <a:lnTo>
                        <a:pt x="2263" y="936"/>
                      </a:lnTo>
                      <a:lnTo>
                        <a:pt x="2267" y="937"/>
                      </a:lnTo>
                      <a:lnTo>
                        <a:pt x="2270" y="935"/>
                      </a:lnTo>
                      <a:lnTo>
                        <a:pt x="2273" y="935"/>
                      </a:lnTo>
                      <a:lnTo>
                        <a:pt x="2277" y="936"/>
                      </a:lnTo>
                      <a:lnTo>
                        <a:pt x="2280" y="936"/>
                      </a:lnTo>
                      <a:lnTo>
                        <a:pt x="2283" y="937"/>
                      </a:lnTo>
                      <a:lnTo>
                        <a:pt x="2287" y="938"/>
                      </a:lnTo>
                      <a:lnTo>
                        <a:pt x="2290" y="935"/>
                      </a:lnTo>
                      <a:lnTo>
                        <a:pt x="2293" y="937"/>
                      </a:lnTo>
                      <a:lnTo>
                        <a:pt x="2297" y="935"/>
                      </a:lnTo>
                      <a:lnTo>
                        <a:pt x="2300" y="937"/>
                      </a:lnTo>
                      <a:lnTo>
                        <a:pt x="2303" y="936"/>
                      </a:lnTo>
                      <a:lnTo>
                        <a:pt x="2306" y="937"/>
                      </a:lnTo>
                      <a:lnTo>
                        <a:pt x="2310" y="935"/>
                      </a:lnTo>
                      <a:lnTo>
                        <a:pt x="2313" y="936"/>
                      </a:lnTo>
                      <a:lnTo>
                        <a:pt x="2316" y="936"/>
                      </a:lnTo>
                      <a:lnTo>
                        <a:pt x="2320" y="935"/>
                      </a:lnTo>
                      <a:lnTo>
                        <a:pt x="2323" y="936"/>
                      </a:lnTo>
                      <a:lnTo>
                        <a:pt x="2326" y="936"/>
                      </a:lnTo>
                      <a:lnTo>
                        <a:pt x="2330" y="936"/>
                      </a:lnTo>
                      <a:lnTo>
                        <a:pt x="2333" y="937"/>
                      </a:lnTo>
                      <a:lnTo>
                        <a:pt x="2336" y="936"/>
                      </a:lnTo>
                      <a:lnTo>
                        <a:pt x="2340" y="935"/>
                      </a:lnTo>
                      <a:lnTo>
                        <a:pt x="2343" y="935"/>
                      </a:lnTo>
                      <a:lnTo>
                        <a:pt x="2346" y="935"/>
                      </a:lnTo>
                      <a:lnTo>
                        <a:pt x="2349" y="935"/>
                      </a:lnTo>
                      <a:lnTo>
                        <a:pt x="2353" y="937"/>
                      </a:lnTo>
                      <a:lnTo>
                        <a:pt x="2356" y="936"/>
                      </a:lnTo>
                      <a:lnTo>
                        <a:pt x="2359" y="935"/>
                      </a:lnTo>
                      <a:lnTo>
                        <a:pt x="2363" y="934"/>
                      </a:lnTo>
                      <a:lnTo>
                        <a:pt x="2366" y="936"/>
                      </a:lnTo>
                      <a:lnTo>
                        <a:pt x="2369" y="934"/>
                      </a:lnTo>
                      <a:lnTo>
                        <a:pt x="2373" y="935"/>
                      </a:lnTo>
                      <a:lnTo>
                        <a:pt x="2376" y="936"/>
                      </a:lnTo>
                      <a:lnTo>
                        <a:pt x="2379" y="935"/>
                      </a:lnTo>
                      <a:lnTo>
                        <a:pt x="2383" y="936"/>
                      </a:lnTo>
                      <a:lnTo>
                        <a:pt x="2386" y="936"/>
                      </a:lnTo>
                      <a:lnTo>
                        <a:pt x="2389" y="935"/>
                      </a:lnTo>
                      <a:lnTo>
                        <a:pt x="2393" y="936"/>
                      </a:lnTo>
                      <a:lnTo>
                        <a:pt x="2396" y="935"/>
                      </a:lnTo>
                      <a:lnTo>
                        <a:pt x="2399" y="936"/>
                      </a:lnTo>
                      <a:lnTo>
                        <a:pt x="2402" y="935"/>
                      </a:lnTo>
                      <a:lnTo>
                        <a:pt x="2406" y="934"/>
                      </a:lnTo>
                      <a:lnTo>
                        <a:pt x="2409" y="934"/>
                      </a:lnTo>
                      <a:lnTo>
                        <a:pt x="2412" y="934"/>
                      </a:lnTo>
                      <a:lnTo>
                        <a:pt x="2416" y="935"/>
                      </a:lnTo>
                      <a:lnTo>
                        <a:pt x="2419" y="934"/>
                      </a:lnTo>
                      <a:lnTo>
                        <a:pt x="2422" y="933"/>
                      </a:lnTo>
                      <a:lnTo>
                        <a:pt x="2426" y="936"/>
                      </a:lnTo>
                      <a:lnTo>
                        <a:pt x="2429" y="934"/>
                      </a:lnTo>
                      <a:lnTo>
                        <a:pt x="2432" y="936"/>
                      </a:lnTo>
                      <a:lnTo>
                        <a:pt x="2436" y="935"/>
                      </a:lnTo>
                      <a:lnTo>
                        <a:pt x="2439" y="936"/>
                      </a:lnTo>
                      <a:lnTo>
                        <a:pt x="2442" y="936"/>
                      </a:lnTo>
                      <a:lnTo>
                        <a:pt x="2445" y="936"/>
                      </a:lnTo>
                      <a:lnTo>
                        <a:pt x="2449" y="936"/>
                      </a:lnTo>
                      <a:lnTo>
                        <a:pt x="2452" y="934"/>
                      </a:lnTo>
                      <a:lnTo>
                        <a:pt x="2455" y="935"/>
                      </a:lnTo>
                      <a:lnTo>
                        <a:pt x="2459" y="936"/>
                      </a:lnTo>
                      <a:lnTo>
                        <a:pt x="2462" y="937"/>
                      </a:lnTo>
                      <a:lnTo>
                        <a:pt x="2465" y="935"/>
                      </a:lnTo>
                      <a:lnTo>
                        <a:pt x="2469" y="933"/>
                      </a:lnTo>
                      <a:lnTo>
                        <a:pt x="2472" y="936"/>
                      </a:lnTo>
                      <a:lnTo>
                        <a:pt x="2475" y="937"/>
                      </a:lnTo>
                      <a:lnTo>
                        <a:pt x="2479" y="935"/>
                      </a:lnTo>
                      <a:lnTo>
                        <a:pt x="2482" y="935"/>
                      </a:lnTo>
                      <a:lnTo>
                        <a:pt x="2485" y="935"/>
                      </a:lnTo>
                      <a:lnTo>
                        <a:pt x="2489" y="937"/>
                      </a:lnTo>
                      <a:lnTo>
                        <a:pt x="2492" y="935"/>
                      </a:lnTo>
                      <a:lnTo>
                        <a:pt x="2495" y="933"/>
                      </a:lnTo>
                      <a:lnTo>
                        <a:pt x="2498" y="936"/>
                      </a:lnTo>
                      <a:lnTo>
                        <a:pt x="2502" y="936"/>
                      </a:lnTo>
                      <a:lnTo>
                        <a:pt x="2505" y="937"/>
                      </a:lnTo>
                      <a:lnTo>
                        <a:pt x="2508" y="937"/>
                      </a:lnTo>
                      <a:lnTo>
                        <a:pt x="2512" y="937"/>
                      </a:lnTo>
                      <a:lnTo>
                        <a:pt x="2515" y="936"/>
                      </a:lnTo>
                      <a:lnTo>
                        <a:pt x="2518" y="937"/>
                      </a:lnTo>
                      <a:lnTo>
                        <a:pt x="2521" y="936"/>
                      </a:lnTo>
                      <a:lnTo>
                        <a:pt x="2525" y="937"/>
                      </a:lnTo>
                      <a:lnTo>
                        <a:pt x="2528" y="937"/>
                      </a:lnTo>
                      <a:lnTo>
                        <a:pt x="2531" y="937"/>
                      </a:lnTo>
                      <a:lnTo>
                        <a:pt x="2535" y="937"/>
                      </a:lnTo>
                      <a:lnTo>
                        <a:pt x="2538" y="937"/>
                      </a:lnTo>
                      <a:lnTo>
                        <a:pt x="2541" y="936"/>
                      </a:lnTo>
                      <a:lnTo>
                        <a:pt x="2545" y="938"/>
                      </a:lnTo>
                      <a:lnTo>
                        <a:pt x="2548" y="937"/>
                      </a:lnTo>
                      <a:lnTo>
                        <a:pt x="2551" y="936"/>
                      </a:lnTo>
                      <a:lnTo>
                        <a:pt x="2555" y="936"/>
                      </a:lnTo>
                      <a:lnTo>
                        <a:pt x="2558" y="934"/>
                      </a:lnTo>
                      <a:lnTo>
                        <a:pt x="2561" y="936"/>
                      </a:lnTo>
                      <a:lnTo>
                        <a:pt x="2565" y="935"/>
                      </a:lnTo>
                      <a:lnTo>
                        <a:pt x="2568" y="936"/>
                      </a:lnTo>
                      <a:lnTo>
                        <a:pt x="2571" y="937"/>
                      </a:lnTo>
                      <a:lnTo>
                        <a:pt x="2574" y="937"/>
                      </a:lnTo>
                      <a:lnTo>
                        <a:pt x="2578" y="935"/>
                      </a:lnTo>
                      <a:lnTo>
                        <a:pt x="2581" y="936"/>
                      </a:lnTo>
                      <a:lnTo>
                        <a:pt x="2584" y="935"/>
                      </a:lnTo>
                      <a:lnTo>
                        <a:pt x="2588" y="936"/>
                      </a:lnTo>
                      <a:lnTo>
                        <a:pt x="2591" y="936"/>
                      </a:lnTo>
                      <a:lnTo>
                        <a:pt x="2594" y="936"/>
                      </a:lnTo>
                      <a:lnTo>
                        <a:pt x="2598" y="935"/>
                      </a:lnTo>
                      <a:lnTo>
                        <a:pt x="2601" y="936"/>
                      </a:lnTo>
                      <a:lnTo>
                        <a:pt x="2604" y="936"/>
                      </a:lnTo>
                      <a:lnTo>
                        <a:pt x="2608" y="936"/>
                      </a:lnTo>
                      <a:lnTo>
                        <a:pt x="2611" y="935"/>
                      </a:lnTo>
                      <a:lnTo>
                        <a:pt x="2614" y="935"/>
                      </a:lnTo>
                      <a:lnTo>
                        <a:pt x="2617" y="934"/>
                      </a:lnTo>
                      <a:lnTo>
                        <a:pt x="2621" y="934"/>
                      </a:lnTo>
                      <a:lnTo>
                        <a:pt x="2624" y="935"/>
                      </a:lnTo>
                      <a:lnTo>
                        <a:pt x="2627" y="934"/>
                      </a:lnTo>
                      <a:lnTo>
                        <a:pt x="2631" y="933"/>
                      </a:lnTo>
                      <a:lnTo>
                        <a:pt x="2634" y="933"/>
                      </a:lnTo>
                      <a:lnTo>
                        <a:pt x="2637" y="934"/>
                      </a:lnTo>
                      <a:lnTo>
                        <a:pt x="2641" y="933"/>
                      </a:lnTo>
                      <a:lnTo>
                        <a:pt x="2644" y="934"/>
                      </a:lnTo>
                      <a:lnTo>
                        <a:pt x="2647" y="934"/>
                      </a:lnTo>
                      <a:lnTo>
                        <a:pt x="2651" y="934"/>
                      </a:lnTo>
                      <a:lnTo>
                        <a:pt x="2654" y="934"/>
                      </a:lnTo>
                      <a:lnTo>
                        <a:pt x="2657" y="934"/>
                      </a:lnTo>
                      <a:lnTo>
                        <a:pt x="2661" y="933"/>
                      </a:lnTo>
                      <a:lnTo>
                        <a:pt x="2664" y="933"/>
                      </a:lnTo>
                      <a:lnTo>
                        <a:pt x="2667" y="933"/>
                      </a:lnTo>
                      <a:lnTo>
                        <a:pt x="2670" y="933"/>
                      </a:lnTo>
                      <a:lnTo>
                        <a:pt x="2674" y="934"/>
                      </a:lnTo>
                      <a:lnTo>
                        <a:pt x="2677" y="933"/>
                      </a:lnTo>
                      <a:lnTo>
                        <a:pt x="2680" y="934"/>
                      </a:lnTo>
                      <a:lnTo>
                        <a:pt x="2684" y="934"/>
                      </a:lnTo>
                      <a:lnTo>
                        <a:pt x="2687" y="934"/>
                      </a:lnTo>
                      <a:lnTo>
                        <a:pt x="2690" y="932"/>
                      </a:lnTo>
                      <a:lnTo>
                        <a:pt x="2694" y="934"/>
                      </a:lnTo>
                      <a:lnTo>
                        <a:pt x="2697" y="934"/>
                      </a:lnTo>
                      <a:lnTo>
                        <a:pt x="2700" y="933"/>
                      </a:lnTo>
                      <a:lnTo>
                        <a:pt x="2704" y="935"/>
                      </a:lnTo>
                      <a:lnTo>
                        <a:pt x="2707" y="935"/>
                      </a:lnTo>
                      <a:lnTo>
                        <a:pt x="2710" y="934"/>
                      </a:lnTo>
                      <a:lnTo>
                        <a:pt x="2714" y="934"/>
                      </a:lnTo>
                      <a:lnTo>
                        <a:pt x="2717" y="935"/>
                      </a:lnTo>
                      <a:lnTo>
                        <a:pt x="2720" y="932"/>
                      </a:lnTo>
                      <a:lnTo>
                        <a:pt x="2723" y="932"/>
                      </a:lnTo>
                      <a:lnTo>
                        <a:pt x="2727" y="933"/>
                      </a:lnTo>
                      <a:lnTo>
                        <a:pt x="2730" y="933"/>
                      </a:lnTo>
                      <a:lnTo>
                        <a:pt x="2733" y="934"/>
                      </a:lnTo>
                      <a:lnTo>
                        <a:pt x="2737" y="932"/>
                      </a:lnTo>
                      <a:lnTo>
                        <a:pt x="2740" y="934"/>
                      </a:lnTo>
                      <a:lnTo>
                        <a:pt x="2743" y="933"/>
                      </a:lnTo>
                      <a:lnTo>
                        <a:pt x="2747" y="934"/>
                      </a:lnTo>
                      <a:lnTo>
                        <a:pt x="2750" y="935"/>
                      </a:lnTo>
                      <a:lnTo>
                        <a:pt x="2753" y="934"/>
                      </a:lnTo>
                      <a:lnTo>
                        <a:pt x="2757" y="933"/>
                      </a:lnTo>
                      <a:lnTo>
                        <a:pt x="2760" y="932"/>
                      </a:lnTo>
                      <a:lnTo>
                        <a:pt x="2763" y="933"/>
                      </a:lnTo>
                      <a:lnTo>
                        <a:pt x="2766" y="934"/>
                      </a:lnTo>
                      <a:lnTo>
                        <a:pt x="2770" y="933"/>
                      </a:lnTo>
                      <a:lnTo>
                        <a:pt x="2773" y="933"/>
                      </a:lnTo>
                      <a:lnTo>
                        <a:pt x="2776" y="931"/>
                      </a:lnTo>
                      <a:lnTo>
                        <a:pt x="2780" y="933"/>
                      </a:lnTo>
                      <a:lnTo>
                        <a:pt x="2783" y="933"/>
                      </a:lnTo>
                      <a:lnTo>
                        <a:pt x="2786" y="932"/>
                      </a:lnTo>
                      <a:lnTo>
                        <a:pt x="2789" y="933"/>
                      </a:lnTo>
                      <a:lnTo>
                        <a:pt x="2793" y="933"/>
                      </a:lnTo>
                      <a:lnTo>
                        <a:pt x="2796" y="932"/>
                      </a:lnTo>
                      <a:lnTo>
                        <a:pt x="2799" y="932"/>
                      </a:lnTo>
                      <a:lnTo>
                        <a:pt x="2803" y="934"/>
                      </a:lnTo>
                      <a:lnTo>
                        <a:pt x="2806" y="933"/>
                      </a:lnTo>
                      <a:lnTo>
                        <a:pt x="2809" y="932"/>
                      </a:lnTo>
                      <a:lnTo>
                        <a:pt x="2813" y="932"/>
                      </a:lnTo>
                      <a:lnTo>
                        <a:pt x="2816" y="933"/>
                      </a:lnTo>
                      <a:lnTo>
                        <a:pt x="2819" y="933"/>
                      </a:lnTo>
                      <a:lnTo>
                        <a:pt x="2823" y="930"/>
                      </a:lnTo>
                      <a:lnTo>
                        <a:pt x="2826" y="931"/>
                      </a:lnTo>
                      <a:lnTo>
                        <a:pt x="2829" y="931"/>
                      </a:lnTo>
                      <a:lnTo>
                        <a:pt x="2833" y="931"/>
                      </a:lnTo>
                      <a:lnTo>
                        <a:pt x="2836" y="929"/>
                      </a:lnTo>
                      <a:lnTo>
                        <a:pt x="2839" y="931"/>
                      </a:lnTo>
                      <a:lnTo>
                        <a:pt x="2842" y="931"/>
                      </a:lnTo>
                      <a:lnTo>
                        <a:pt x="2846" y="931"/>
                      </a:lnTo>
                      <a:lnTo>
                        <a:pt x="2849" y="929"/>
                      </a:lnTo>
                      <a:lnTo>
                        <a:pt x="2852" y="929"/>
                      </a:lnTo>
                      <a:lnTo>
                        <a:pt x="2856" y="928"/>
                      </a:lnTo>
                      <a:lnTo>
                        <a:pt x="2859" y="928"/>
                      </a:lnTo>
                      <a:lnTo>
                        <a:pt x="2862" y="928"/>
                      </a:lnTo>
                      <a:lnTo>
                        <a:pt x="2866" y="927"/>
                      </a:lnTo>
                      <a:lnTo>
                        <a:pt x="2869" y="927"/>
                      </a:lnTo>
                      <a:lnTo>
                        <a:pt x="2872" y="928"/>
                      </a:lnTo>
                      <a:lnTo>
                        <a:pt x="2876" y="926"/>
                      </a:lnTo>
                      <a:lnTo>
                        <a:pt x="2879" y="926"/>
                      </a:lnTo>
                      <a:lnTo>
                        <a:pt x="2882" y="925"/>
                      </a:lnTo>
                      <a:lnTo>
                        <a:pt x="2886" y="925"/>
                      </a:lnTo>
                      <a:lnTo>
                        <a:pt x="2889" y="923"/>
                      </a:lnTo>
                      <a:lnTo>
                        <a:pt x="2892" y="924"/>
                      </a:lnTo>
                      <a:lnTo>
                        <a:pt x="2895" y="922"/>
                      </a:lnTo>
                      <a:lnTo>
                        <a:pt x="2899" y="921"/>
                      </a:lnTo>
                      <a:lnTo>
                        <a:pt x="2902" y="921"/>
                      </a:lnTo>
                      <a:lnTo>
                        <a:pt x="2905" y="920"/>
                      </a:lnTo>
                      <a:lnTo>
                        <a:pt x="2909" y="919"/>
                      </a:lnTo>
                      <a:lnTo>
                        <a:pt x="2912" y="918"/>
                      </a:lnTo>
                      <a:lnTo>
                        <a:pt x="2915" y="917"/>
                      </a:lnTo>
                      <a:lnTo>
                        <a:pt x="2919" y="916"/>
                      </a:lnTo>
                      <a:lnTo>
                        <a:pt x="2922" y="916"/>
                      </a:lnTo>
                      <a:lnTo>
                        <a:pt x="2925" y="915"/>
                      </a:lnTo>
                      <a:lnTo>
                        <a:pt x="2929" y="914"/>
                      </a:lnTo>
                      <a:lnTo>
                        <a:pt x="2932" y="912"/>
                      </a:lnTo>
                      <a:lnTo>
                        <a:pt x="2935" y="912"/>
                      </a:lnTo>
                      <a:lnTo>
                        <a:pt x="2938" y="910"/>
                      </a:lnTo>
                      <a:lnTo>
                        <a:pt x="2942" y="909"/>
                      </a:lnTo>
                      <a:lnTo>
                        <a:pt x="2945" y="907"/>
                      </a:lnTo>
                      <a:lnTo>
                        <a:pt x="2948" y="908"/>
                      </a:lnTo>
                      <a:lnTo>
                        <a:pt x="2952" y="907"/>
                      </a:lnTo>
                      <a:lnTo>
                        <a:pt x="2955" y="906"/>
                      </a:lnTo>
                      <a:lnTo>
                        <a:pt x="2958" y="904"/>
                      </a:lnTo>
                      <a:lnTo>
                        <a:pt x="2962" y="905"/>
                      </a:lnTo>
                      <a:lnTo>
                        <a:pt x="2965" y="903"/>
                      </a:lnTo>
                      <a:lnTo>
                        <a:pt x="2968" y="902"/>
                      </a:lnTo>
                      <a:lnTo>
                        <a:pt x="2972" y="904"/>
                      </a:lnTo>
                      <a:lnTo>
                        <a:pt x="2975" y="902"/>
                      </a:lnTo>
                      <a:lnTo>
                        <a:pt x="2978" y="902"/>
                      </a:lnTo>
                      <a:lnTo>
                        <a:pt x="2982" y="902"/>
                      </a:lnTo>
                      <a:lnTo>
                        <a:pt x="2985" y="900"/>
                      </a:lnTo>
                      <a:lnTo>
                        <a:pt x="2988" y="902"/>
                      </a:lnTo>
                      <a:lnTo>
                        <a:pt x="2991" y="901"/>
                      </a:lnTo>
                      <a:lnTo>
                        <a:pt x="2995" y="901"/>
                      </a:lnTo>
                      <a:lnTo>
                        <a:pt x="2998" y="899"/>
                      </a:lnTo>
                      <a:lnTo>
                        <a:pt x="3001" y="900"/>
                      </a:lnTo>
                      <a:lnTo>
                        <a:pt x="3005" y="900"/>
                      </a:lnTo>
                      <a:lnTo>
                        <a:pt x="3008" y="898"/>
                      </a:lnTo>
                      <a:lnTo>
                        <a:pt x="3011" y="898"/>
                      </a:lnTo>
                      <a:lnTo>
                        <a:pt x="3015" y="897"/>
                      </a:lnTo>
                      <a:lnTo>
                        <a:pt x="3018" y="896"/>
                      </a:lnTo>
                      <a:lnTo>
                        <a:pt x="3021" y="896"/>
                      </a:lnTo>
                      <a:lnTo>
                        <a:pt x="3025" y="894"/>
                      </a:lnTo>
                      <a:lnTo>
                        <a:pt x="3028" y="896"/>
                      </a:lnTo>
                      <a:lnTo>
                        <a:pt x="3031" y="892"/>
                      </a:lnTo>
                      <a:lnTo>
                        <a:pt x="3035" y="893"/>
                      </a:lnTo>
                      <a:lnTo>
                        <a:pt x="3038" y="890"/>
                      </a:lnTo>
                      <a:lnTo>
                        <a:pt x="3041" y="891"/>
                      </a:lnTo>
                      <a:lnTo>
                        <a:pt x="3044" y="888"/>
                      </a:lnTo>
                      <a:lnTo>
                        <a:pt x="3048" y="888"/>
                      </a:lnTo>
                      <a:lnTo>
                        <a:pt x="3051" y="888"/>
                      </a:lnTo>
                      <a:lnTo>
                        <a:pt x="3054" y="885"/>
                      </a:lnTo>
                      <a:lnTo>
                        <a:pt x="3058" y="883"/>
                      </a:lnTo>
                      <a:lnTo>
                        <a:pt x="3061" y="882"/>
                      </a:lnTo>
                      <a:lnTo>
                        <a:pt x="3064" y="881"/>
                      </a:lnTo>
                      <a:lnTo>
                        <a:pt x="3067" y="878"/>
                      </a:lnTo>
                      <a:lnTo>
                        <a:pt x="3071" y="877"/>
                      </a:lnTo>
                      <a:lnTo>
                        <a:pt x="3074" y="876"/>
                      </a:lnTo>
                      <a:lnTo>
                        <a:pt x="3077" y="875"/>
                      </a:lnTo>
                      <a:lnTo>
                        <a:pt x="3081" y="873"/>
                      </a:lnTo>
                      <a:lnTo>
                        <a:pt x="3084" y="872"/>
                      </a:lnTo>
                      <a:lnTo>
                        <a:pt x="3087" y="871"/>
                      </a:lnTo>
                      <a:lnTo>
                        <a:pt x="3091" y="868"/>
                      </a:lnTo>
                      <a:lnTo>
                        <a:pt x="3094" y="868"/>
                      </a:lnTo>
                      <a:lnTo>
                        <a:pt x="3097" y="865"/>
                      </a:lnTo>
                      <a:lnTo>
                        <a:pt x="3101" y="864"/>
                      </a:lnTo>
                      <a:lnTo>
                        <a:pt x="3104" y="860"/>
                      </a:lnTo>
                      <a:lnTo>
                        <a:pt x="3107" y="861"/>
                      </a:lnTo>
                      <a:lnTo>
                        <a:pt x="3110" y="859"/>
                      </a:lnTo>
                      <a:lnTo>
                        <a:pt x="3114" y="859"/>
                      </a:lnTo>
                      <a:lnTo>
                        <a:pt x="3117" y="855"/>
                      </a:lnTo>
                      <a:lnTo>
                        <a:pt x="3120" y="854"/>
                      </a:lnTo>
                      <a:lnTo>
                        <a:pt x="3124" y="853"/>
                      </a:lnTo>
                      <a:lnTo>
                        <a:pt x="3127" y="847"/>
                      </a:lnTo>
                      <a:lnTo>
                        <a:pt x="3130" y="846"/>
                      </a:lnTo>
                      <a:lnTo>
                        <a:pt x="3134" y="842"/>
                      </a:lnTo>
                      <a:lnTo>
                        <a:pt x="3137" y="839"/>
                      </a:lnTo>
                      <a:lnTo>
                        <a:pt x="3140" y="833"/>
                      </a:lnTo>
                      <a:lnTo>
                        <a:pt x="3144" y="827"/>
                      </a:lnTo>
                      <a:lnTo>
                        <a:pt x="3147" y="820"/>
                      </a:lnTo>
                      <a:lnTo>
                        <a:pt x="3150" y="811"/>
                      </a:lnTo>
                      <a:lnTo>
                        <a:pt x="3154" y="803"/>
                      </a:lnTo>
                      <a:lnTo>
                        <a:pt x="3157" y="791"/>
                      </a:lnTo>
                      <a:lnTo>
                        <a:pt x="3160" y="773"/>
                      </a:lnTo>
                      <a:lnTo>
                        <a:pt x="3163" y="757"/>
                      </a:lnTo>
                      <a:lnTo>
                        <a:pt x="3167" y="737"/>
                      </a:lnTo>
                      <a:lnTo>
                        <a:pt x="3170" y="713"/>
                      </a:lnTo>
                      <a:lnTo>
                        <a:pt x="3173" y="687"/>
                      </a:lnTo>
                      <a:lnTo>
                        <a:pt x="3177" y="658"/>
                      </a:lnTo>
                      <a:lnTo>
                        <a:pt x="3180" y="625"/>
                      </a:lnTo>
                      <a:lnTo>
                        <a:pt x="3183" y="589"/>
                      </a:lnTo>
                      <a:lnTo>
                        <a:pt x="3187" y="553"/>
                      </a:lnTo>
                      <a:lnTo>
                        <a:pt x="3190" y="512"/>
                      </a:lnTo>
                      <a:lnTo>
                        <a:pt x="3193" y="468"/>
                      </a:lnTo>
                      <a:lnTo>
                        <a:pt x="3197" y="427"/>
                      </a:lnTo>
                      <a:lnTo>
                        <a:pt x="3200" y="383"/>
                      </a:lnTo>
                      <a:lnTo>
                        <a:pt x="3203" y="340"/>
                      </a:lnTo>
                      <a:lnTo>
                        <a:pt x="3207" y="297"/>
                      </a:lnTo>
                      <a:lnTo>
                        <a:pt x="3210" y="255"/>
                      </a:lnTo>
                      <a:lnTo>
                        <a:pt x="3213" y="218"/>
                      </a:lnTo>
                      <a:lnTo>
                        <a:pt x="3216" y="182"/>
                      </a:lnTo>
                      <a:lnTo>
                        <a:pt x="3220" y="148"/>
                      </a:lnTo>
                      <a:lnTo>
                        <a:pt x="3223" y="117"/>
                      </a:lnTo>
                      <a:lnTo>
                        <a:pt x="3226" y="92"/>
                      </a:lnTo>
                      <a:lnTo>
                        <a:pt x="3230" y="68"/>
                      </a:lnTo>
                      <a:lnTo>
                        <a:pt x="3233" y="49"/>
                      </a:lnTo>
                      <a:lnTo>
                        <a:pt x="3236" y="32"/>
                      </a:lnTo>
                      <a:lnTo>
                        <a:pt x="3240" y="20"/>
                      </a:lnTo>
                      <a:lnTo>
                        <a:pt x="3243" y="12"/>
                      </a:lnTo>
                      <a:lnTo>
                        <a:pt x="3246" y="5"/>
                      </a:lnTo>
                      <a:lnTo>
                        <a:pt x="3250" y="1"/>
                      </a:lnTo>
                      <a:lnTo>
                        <a:pt x="3253" y="0"/>
                      </a:lnTo>
                      <a:lnTo>
                        <a:pt x="3256" y="2"/>
                      </a:lnTo>
                      <a:lnTo>
                        <a:pt x="3259" y="5"/>
                      </a:lnTo>
                      <a:lnTo>
                        <a:pt x="3263" y="9"/>
                      </a:lnTo>
                      <a:lnTo>
                        <a:pt x="3266" y="17"/>
                      </a:lnTo>
                      <a:lnTo>
                        <a:pt x="3269" y="26"/>
                      </a:lnTo>
                      <a:lnTo>
                        <a:pt x="3273" y="36"/>
                      </a:lnTo>
                      <a:lnTo>
                        <a:pt x="3276" y="47"/>
                      </a:lnTo>
                      <a:lnTo>
                        <a:pt x="3279" y="60"/>
                      </a:lnTo>
                      <a:lnTo>
                        <a:pt x="3283" y="75"/>
                      </a:lnTo>
                      <a:lnTo>
                        <a:pt x="3286" y="88"/>
                      </a:lnTo>
                      <a:lnTo>
                        <a:pt x="3289" y="103"/>
                      </a:lnTo>
                      <a:lnTo>
                        <a:pt x="3293" y="122"/>
                      </a:lnTo>
                      <a:lnTo>
                        <a:pt x="3296" y="139"/>
                      </a:lnTo>
                      <a:lnTo>
                        <a:pt x="3299" y="156"/>
                      </a:lnTo>
                      <a:lnTo>
                        <a:pt x="3303" y="175"/>
                      </a:lnTo>
                      <a:lnTo>
                        <a:pt x="3306" y="194"/>
                      </a:lnTo>
                      <a:lnTo>
                        <a:pt x="3309" y="215"/>
                      </a:lnTo>
                      <a:lnTo>
                        <a:pt x="3312" y="232"/>
                      </a:lnTo>
                      <a:lnTo>
                        <a:pt x="3316" y="254"/>
                      </a:lnTo>
                      <a:lnTo>
                        <a:pt x="3319" y="273"/>
                      </a:lnTo>
                      <a:lnTo>
                        <a:pt x="3322" y="294"/>
                      </a:lnTo>
                      <a:lnTo>
                        <a:pt x="3326" y="314"/>
                      </a:lnTo>
                      <a:lnTo>
                        <a:pt x="3329" y="334"/>
                      </a:lnTo>
                      <a:lnTo>
                        <a:pt x="3332" y="355"/>
                      </a:lnTo>
                      <a:lnTo>
                        <a:pt x="3335" y="374"/>
                      </a:lnTo>
                      <a:lnTo>
                        <a:pt x="3339" y="396"/>
                      </a:lnTo>
                      <a:lnTo>
                        <a:pt x="3342" y="417"/>
                      </a:lnTo>
                      <a:lnTo>
                        <a:pt x="3345" y="436"/>
                      </a:lnTo>
                      <a:lnTo>
                        <a:pt x="3349" y="457"/>
                      </a:lnTo>
                      <a:lnTo>
                        <a:pt x="3352" y="474"/>
                      </a:lnTo>
                      <a:lnTo>
                        <a:pt x="3355" y="494"/>
                      </a:lnTo>
                      <a:lnTo>
                        <a:pt x="3359" y="513"/>
                      </a:lnTo>
                      <a:lnTo>
                        <a:pt x="3362" y="532"/>
                      </a:lnTo>
                      <a:lnTo>
                        <a:pt x="3365" y="550"/>
                      </a:lnTo>
                      <a:lnTo>
                        <a:pt x="3369" y="569"/>
                      </a:lnTo>
                      <a:lnTo>
                        <a:pt x="3372" y="585"/>
                      </a:lnTo>
                      <a:lnTo>
                        <a:pt x="3375" y="603"/>
                      </a:lnTo>
                      <a:lnTo>
                        <a:pt x="3379" y="620"/>
                      </a:lnTo>
                      <a:lnTo>
                        <a:pt x="3382" y="636"/>
                      </a:lnTo>
                      <a:lnTo>
                        <a:pt x="3385" y="652"/>
                      </a:lnTo>
                      <a:lnTo>
                        <a:pt x="3388" y="666"/>
                      </a:lnTo>
                      <a:lnTo>
                        <a:pt x="3392" y="683"/>
                      </a:lnTo>
                      <a:lnTo>
                        <a:pt x="3395" y="697"/>
                      </a:lnTo>
                      <a:lnTo>
                        <a:pt x="3398" y="709"/>
                      </a:lnTo>
                      <a:lnTo>
                        <a:pt x="3402" y="722"/>
                      </a:lnTo>
                      <a:lnTo>
                        <a:pt x="3405" y="735"/>
                      </a:lnTo>
                      <a:lnTo>
                        <a:pt x="3408" y="744"/>
                      </a:lnTo>
                      <a:lnTo>
                        <a:pt x="3412" y="759"/>
                      </a:lnTo>
                      <a:lnTo>
                        <a:pt x="3415" y="771"/>
                      </a:lnTo>
                      <a:lnTo>
                        <a:pt x="3418" y="781"/>
                      </a:lnTo>
                      <a:lnTo>
                        <a:pt x="3422" y="791"/>
                      </a:lnTo>
                      <a:lnTo>
                        <a:pt x="3425" y="800"/>
                      </a:lnTo>
                      <a:lnTo>
                        <a:pt x="3428" y="810"/>
                      </a:lnTo>
                      <a:lnTo>
                        <a:pt x="3431" y="819"/>
                      </a:lnTo>
                      <a:lnTo>
                        <a:pt x="3435" y="826"/>
                      </a:lnTo>
                      <a:lnTo>
                        <a:pt x="3438" y="835"/>
                      </a:lnTo>
                      <a:lnTo>
                        <a:pt x="3441" y="843"/>
                      </a:lnTo>
                      <a:lnTo>
                        <a:pt x="3445" y="849"/>
                      </a:lnTo>
                      <a:lnTo>
                        <a:pt x="3448" y="856"/>
                      </a:lnTo>
                      <a:lnTo>
                        <a:pt x="3451" y="862"/>
                      </a:lnTo>
                      <a:lnTo>
                        <a:pt x="3455" y="868"/>
                      </a:lnTo>
                      <a:lnTo>
                        <a:pt x="3458" y="873"/>
                      </a:lnTo>
                      <a:lnTo>
                        <a:pt x="3461" y="878"/>
                      </a:lnTo>
                      <a:lnTo>
                        <a:pt x="3465" y="883"/>
                      </a:lnTo>
                      <a:lnTo>
                        <a:pt x="3468" y="888"/>
                      </a:lnTo>
                      <a:lnTo>
                        <a:pt x="3471" y="890"/>
                      </a:lnTo>
                      <a:lnTo>
                        <a:pt x="3475" y="894"/>
                      </a:lnTo>
                      <a:lnTo>
                        <a:pt x="3478" y="898"/>
                      </a:lnTo>
                      <a:lnTo>
                        <a:pt x="3481" y="902"/>
                      </a:lnTo>
                      <a:lnTo>
                        <a:pt x="3484" y="904"/>
                      </a:lnTo>
                      <a:lnTo>
                        <a:pt x="3488" y="908"/>
                      </a:lnTo>
                      <a:lnTo>
                        <a:pt x="3491" y="908"/>
                      </a:lnTo>
                      <a:lnTo>
                        <a:pt x="3494" y="911"/>
                      </a:lnTo>
                      <a:lnTo>
                        <a:pt x="3498" y="914"/>
                      </a:lnTo>
                      <a:lnTo>
                        <a:pt x="3501" y="916"/>
                      </a:lnTo>
                      <a:lnTo>
                        <a:pt x="3504" y="918"/>
                      </a:lnTo>
                      <a:lnTo>
                        <a:pt x="3508" y="921"/>
                      </a:lnTo>
                      <a:lnTo>
                        <a:pt x="3511" y="921"/>
                      </a:lnTo>
                      <a:lnTo>
                        <a:pt x="3514" y="923"/>
                      </a:lnTo>
                      <a:lnTo>
                        <a:pt x="3518" y="924"/>
                      </a:lnTo>
                      <a:lnTo>
                        <a:pt x="3521" y="924"/>
                      </a:lnTo>
                      <a:lnTo>
                        <a:pt x="3524" y="926"/>
                      </a:lnTo>
                      <a:lnTo>
                        <a:pt x="3527" y="928"/>
                      </a:lnTo>
                      <a:lnTo>
                        <a:pt x="3531" y="928"/>
                      </a:lnTo>
                      <a:lnTo>
                        <a:pt x="3534" y="929"/>
                      </a:lnTo>
                      <a:lnTo>
                        <a:pt x="3537" y="930"/>
                      </a:lnTo>
                      <a:lnTo>
                        <a:pt x="3541" y="930"/>
                      </a:lnTo>
                      <a:lnTo>
                        <a:pt x="3544" y="930"/>
                      </a:lnTo>
                      <a:lnTo>
                        <a:pt x="3547" y="931"/>
                      </a:lnTo>
                      <a:lnTo>
                        <a:pt x="3551" y="932"/>
                      </a:lnTo>
                      <a:lnTo>
                        <a:pt x="3554" y="931"/>
                      </a:lnTo>
                      <a:lnTo>
                        <a:pt x="3557" y="934"/>
                      </a:lnTo>
                      <a:lnTo>
                        <a:pt x="3561" y="934"/>
                      </a:lnTo>
                      <a:lnTo>
                        <a:pt x="3564" y="933"/>
                      </a:lnTo>
                      <a:lnTo>
                        <a:pt x="3567" y="932"/>
                      </a:lnTo>
                      <a:lnTo>
                        <a:pt x="3571" y="934"/>
                      </a:lnTo>
                      <a:lnTo>
                        <a:pt x="3574" y="935"/>
                      </a:lnTo>
                      <a:lnTo>
                        <a:pt x="3577" y="935"/>
                      </a:lnTo>
                      <a:lnTo>
                        <a:pt x="3580" y="937"/>
                      </a:lnTo>
                      <a:lnTo>
                        <a:pt x="3584" y="934"/>
                      </a:lnTo>
                      <a:lnTo>
                        <a:pt x="3587" y="936"/>
                      </a:lnTo>
                      <a:lnTo>
                        <a:pt x="3590" y="935"/>
                      </a:lnTo>
                      <a:lnTo>
                        <a:pt x="3594" y="935"/>
                      </a:lnTo>
                      <a:lnTo>
                        <a:pt x="3597" y="937"/>
                      </a:lnTo>
                      <a:lnTo>
                        <a:pt x="3600" y="937"/>
                      </a:lnTo>
                      <a:lnTo>
                        <a:pt x="3603" y="937"/>
                      </a:lnTo>
                      <a:lnTo>
                        <a:pt x="3607" y="935"/>
                      </a:lnTo>
                      <a:lnTo>
                        <a:pt x="3610" y="938"/>
                      </a:lnTo>
                      <a:lnTo>
                        <a:pt x="3613" y="937"/>
                      </a:lnTo>
                      <a:lnTo>
                        <a:pt x="3617" y="939"/>
                      </a:lnTo>
                      <a:lnTo>
                        <a:pt x="3620" y="938"/>
                      </a:lnTo>
                      <a:lnTo>
                        <a:pt x="3624" y="939"/>
                      </a:lnTo>
                      <a:lnTo>
                        <a:pt x="3627" y="938"/>
                      </a:lnTo>
                      <a:lnTo>
                        <a:pt x="3630" y="937"/>
                      </a:lnTo>
                      <a:lnTo>
                        <a:pt x="3633" y="938"/>
                      </a:lnTo>
                      <a:lnTo>
                        <a:pt x="3637" y="938"/>
                      </a:lnTo>
                      <a:lnTo>
                        <a:pt x="3640" y="939"/>
                      </a:lnTo>
                      <a:lnTo>
                        <a:pt x="3643" y="938"/>
                      </a:lnTo>
                      <a:lnTo>
                        <a:pt x="3647" y="937"/>
                      </a:lnTo>
                      <a:lnTo>
                        <a:pt x="3650" y="939"/>
                      </a:lnTo>
                      <a:lnTo>
                        <a:pt x="3653" y="939"/>
                      </a:lnTo>
                      <a:lnTo>
                        <a:pt x="3656" y="939"/>
                      </a:lnTo>
                      <a:lnTo>
                        <a:pt x="3660" y="939"/>
                      </a:lnTo>
                      <a:lnTo>
                        <a:pt x="3663" y="939"/>
                      </a:lnTo>
                      <a:lnTo>
                        <a:pt x="3666" y="940"/>
                      </a:lnTo>
                      <a:lnTo>
                        <a:pt x="3670" y="939"/>
                      </a:lnTo>
                      <a:lnTo>
                        <a:pt x="3673" y="939"/>
                      </a:lnTo>
                      <a:lnTo>
                        <a:pt x="3676" y="939"/>
                      </a:lnTo>
                      <a:lnTo>
                        <a:pt x="3680" y="939"/>
                      </a:lnTo>
                      <a:lnTo>
                        <a:pt x="3683" y="938"/>
                      </a:lnTo>
                      <a:lnTo>
                        <a:pt x="3686" y="939"/>
                      </a:lnTo>
                      <a:lnTo>
                        <a:pt x="3690" y="939"/>
                      </a:lnTo>
                      <a:lnTo>
                        <a:pt x="3693" y="939"/>
                      </a:lnTo>
                      <a:lnTo>
                        <a:pt x="3696" y="939"/>
                      </a:lnTo>
                      <a:lnTo>
                        <a:pt x="3699" y="939"/>
                      </a:lnTo>
                      <a:lnTo>
                        <a:pt x="3703" y="940"/>
                      </a:lnTo>
                      <a:lnTo>
                        <a:pt x="3706" y="939"/>
                      </a:lnTo>
                      <a:lnTo>
                        <a:pt x="3709" y="938"/>
                      </a:lnTo>
                      <a:lnTo>
                        <a:pt x="3713" y="939"/>
                      </a:lnTo>
                      <a:lnTo>
                        <a:pt x="3716" y="940"/>
                      </a:lnTo>
                      <a:lnTo>
                        <a:pt x="3719" y="940"/>
                      </a:lnTo>
                      <a:lnTo>
                        <a:pt x="3723" y="937"/>
                      </a:lnTo>
                      <a:lnTo>
                        <a:pt x="3726" y="939"/>
                      </a:lnTo>
                      <a:lnTo>
                        <a:pt x="3729" y="938"/>
                      </a:lnTo>
                      <a:lnTo>
                        <a:pt x="3733" y="938"/>
                      </a:lnTo>
                      <a:lnTo>
                        <a:pt x="3736" y="938"/>
                      </a:lnTo>
                      <a:lnTo>
                        <a:pt x="3739" y="941"/>
                      </a:lnTo>
                      <a:lnTo>
                        <a:pt x="3743" y="940"/>
                      </a:lnTo>
                      <a:lnTo>
                        <a:pt x="3746" y="940"/>
                      </a:lnTo>
                      <a:lnTo>
                        <a:pt x="3749" y="939"/>
                      </a:lnTo>
                      <a:lnTo>
                        <a:pt x="3752" y="940"/>
                      </a:lnTo>
                      <a:lnTo>
                        <a:pt x="3756" y="940"/>
                      </a:lnTo>
                      <a:lnTo>
                        <a:pt x="3759" y="939"/>
                      </a:lnTo>
                      <a:lnTo>
                        <a:pt x="3762" y="939"/>
                      </a:lnTo>
                      <a:lnTo>
                        <a:pt x="3766" y="939"/>
                      </a:lnTo>
                      <a:lnTo>
                        <a:pt x="3769" y="938"/>
                      </a:lnTo>
                      <a:lnTo>
                        <a:pt x="3772" y="936"/>
                      </a:lnTo>
                      <a:lnTo>
                        <a:pt x="3776" y="938"/>
                      </a:lnTo>
                      <a:lnTo>
                        <a:pt x="3779" y="937"/>
                      </a:lnTo>
                      <a:lnTo>
                        <a:pt x="3782" y="938"/>
                      </a:lnTo>
                      <a:lnTo>
                        <a:pt x="3786" y="939"/>
                      </a:lnTo>
                      <a:lnTo>
                        <a:pt x="3789" y="940"/>
                      </a:lnTo>
                      <a:lnTo>
                        <a:pt x="3792" y="937"/>
                      </a:lnTo>
                      <a:lnTo>
                        <a:pt x="3796" y="939"/>
                      </a:lnTo>
                      <a:lnTo>
                        <a:pt x="3799" y="937"/>
                      </a:lnTo>
                      <a:lnTo>
                        <a:pt x="3802" y="937"/>
                      </a:lnTo>
                      <a:lnTo>
                        <a:pt x="3805" y="939"/>
                      </a:lnTo>
                      <a:lnTo>
                        <a:pt x="3809" y="937"/>
                      </a:lnTo>
                      <a:lnTo>
                        <a:pt x="3812" y="939"/>
                      </a:lnTo>
                      <a:lnTo>
                        <a:pt x="3815" y="938"/>
                      </a:lnTo>
                      <a:lnTo>
                        <a:pt x="3819" y="938"/>
                      </a:lnTo>
                      <a:lnTo>
                        <a:pt x="3822" y="939"/>
                      </a:lnTo>
                      <a:lnTo>
                        <a:pt x="3825" y="940"/>
                      </a:lnTo>
                      <a:lnTo>
                        <a:pt x="3829" y="937"/>
                      </a:lnTo>
                      <a:lnTo>
                        <a:pt x="3832" y="938"/>
                      </a:lnTo>
                      <a:lnTo>
                        <a:pt x="3835" y="939"/>
                      </a:lnTo>
                      <a:lnTo>
                        <a:pt x="3839" y="938"/>
                      </a:lnTo>
                      <a:lnTo>
                        <a:pt x="3842" y="938"/>
                      </a:lnTo>
                      <a:lnTo>
                        <a:pt x="3845" y="938"/>
                      </a:lnTo>
                      <a:lnTo>
                        <a:pt x="3848" y="937"/>
                      </a:lnTo>
                      <a:lnTo>
                        <a:pt x="3852" y="937"/>
                      </a:lnTo>
                      <a:lnTo>
                        <a:pt x="3855" y="938"/>
                      </a:lnTo>
                      <a:lnTo>
                        <a:pt x="3858" y="938"/>
                      </a:lnTo>
                      <a:lnTo>
                        <a:pt x="3862" y="937"/>
                      </a:lnTo>
                      <a:lnTo>
                        <a:pt x="3865" y="939"/>
                      </a:lnTo>
                      <a:lnTo>
                        <a:pt x="3868" y="938"/>
                      </a:lnTo>
                      <a:lnTo>
                        <a:pt x="3871" y="938"/>
                      </a:lnTo>
                      <a:lnTo>
                        <a:pt x="3875" y="936"/>
                      </a:lnTo>
                      <a:lnTo>
                        <a:pt x="3878" y="938"/>
                      </a:lnTo>
                      <a:lnTo>
                        <a:pt x="3881" y="938"/>
                      </a:lnTo>
                      <a:lnTo>
                        <a:pt x="3885" y="937"/>
                      </a:lnTo>
                      <a:lnTo>
                        <a:pt x="3888" y="938"/>
                      </a:lnTo>
                      <a:lnTo>
                        <a:pt x="3892" y="937"/>
                      </a:lnTo>
                      <a:lnTo>
                        <a:pt x="3895" y="938"/>
                      </a:lnTo>
                      <a:lnTo>
                        <a:pt x="3898" y="937"/>
                      </a:lnTo>
                      <a:lnTo>
                        <a:pt x="3901" y="938"/>
                      </a:lnTo>
                      <a:lnTo>
                        <a:pt x="3905" y="938"/>
                      </a:lnTo>
                      <a:lnTo>
                        <a:pt x="3908" y="939"/>
                      </a:lnTo>
                      <a:lnTo>
                        <a:pt x="3911" y="938"/>
                      </a:lnTo>
                      <a:lnTo>
                        <a:pt x="3915" y="939"/>
                      </a:lnTo>
                      <a:lnTo>
                        <a:pt x="3918" y="939"/>
                      </a:lnTo>
                      <a:lnTo>
                        <a:pt x="3921" y="938"/>
                      </a:lnTo>
                      <a:lnTo>
                        <a:pt x="3924" y="938"/>
                      </a:lnTo>
                      <a:lnTo>
                        <a:pt x="3928" y="937"/>
                      </a:lnTo>
                      <a:lnTo>
                        <a:pt x="3931" y="939"/>
                      </a:lnTo>
                      <a:lnTo>
                        <a:pt x="3934" y="937"/>
                      </a:lnTo>
                      <a:lnTo>
                        <a:pt x="3938" y="938"/>
                      </a:lnTo>
                      <a:lnTo>
                        <a:pt x="3941" y="936"/>
                      </a:lnTo>
                      <a:lnTo>
                        <a:pt x="3944" y="937"/>
                      </a:lnTo>
                      <a:lnTo>
                        <a:pt x="3948" y="937"/>
                      </a:lnTo>
                      <a:lnTo>
                        <a:pt x="3951" y="937"/>
                      </a:lnTo>
                      <a:lnTo>
                        <a:pt x="3954" y="938"/>
                      </a:lnTo>
                      <a:lnTo>
                        <a:pt x="3958" y="939"/>
                      </a:lnTo>
                      <a:lnTo>
                        <a:pt x="3961" y="939"/>
                      </a:lnTo>
                      <a:lnTo>
                        <a:pt x="3964" y="938"/>
                      </a:lnTo>
                      <a:lnTo>
                        <a:pt x="3968" y="938"/>
                      </a:lnTo>
                      <a:lnTo>
                        <a:pt x="3971" y="938"/>
                      </a:lnTo>
                      <a:lnTo>
                        <a:pt x="3974" y="938"/>
                      </a:lnTo>
                      <a:lnTo>
                        <a:pt x="3977" y="939"/>
                      </a:lnTo>
                      <a:lnTo>
                        <a:pt x="3981" y="937"/>
                      </a:lnTo>
                      <a:lnTo>
                        <a:pt x="3984" y="938"/>
                      </a:lnTo>
                      <a:lnTo>
                        <a:pt x="3987" y="938"/>
                      </a:lnTo>
                      <a:lnTo>
                        <a:pt x="3991" y="937"/>
                      </a:lnTo>
                      <a:lnTo>
                        <a:pt x="3994" y="938"/>
                      </a:lnTo>
                      <a:lnTo>
                        <a:pt x="3997" y="939"/>
                      </a:lnTo>
                      <a:lnTo>
                        <a:pt x="4001" y="938"/>
                      </a:lnTo>
                      <a:lnTo>
                        <a:pt x="4004" y="938"/>
                      </a:lnTo>
                      <a:lnTo>
                        <a:pt x="4007" y="938"/>
                      </a:lnTo>
                      <a:lnTo>
                        <a:pt x="4011" y="938"/>
                      </a:lnTo>
                      <a:lnTo>
                        <a:pt x="4014" y="938"/>
                      </a:lnTo>
                      <a:lnTo>
                        <a:pt x="4017" y="938"/>
                      </a:lnTo>
                      <a:lnTo>
                        <a:pt x="4020" y="938"/>
                      </a:lnTo>
                      <a:lnTo>
                        <a:pt x="4024" y="938"/>
                      </a:lnTo>
                      <a:lnTo>
                        <a:pt x="4027" y="936"/>
                      </a:lnTo>
                      <a:lnTo>
                        <a:pt x="4030" y="938"/>
                      </a:lnTo>
                      <a:lnTo>
                        <a:pt x="4034" y="936"/>
                      </a:lnTo>
                      <a:lnTo>
                        <a:pt x="4037" y="937"/>
                      </a:lnTo>
                      <a:lnTo>
                        <a:pt x="4040" y="938"/>
                      </a:lnTo>
                      <a:lnTo>
                        <a:pt x="4044" y="938"/>
                      </a:lnTo>
                      <a:lnTo>
                        <a:pt x="4047" y="937"/>
                      </a:lnTo>
                      <a:lnTo>
                        <a:pt x="4050" y="939"/>
                      </a:lnTo>
                      <a:lnTo>
                        <a:pt x="4054" y="938"/>
                      </a:lnTo>
                      <a:lnTo>
                        <a:pt x="4057" y="939"/>
                      </a:lnTo>
                      <a:lnTo>
                        <a:pt x="4060" y="936"/>
                      </a:lnTo>
                      <a:lnTo>
                        <a:pt x="4064" y="937"/>
                      </a:lnTo>
                      <a:lnTo>
                        <a:pt x="4067" y="937"/>
                      </a:lnTo>
                      <a:lnTo>
                        <a:pt x="4070" y="937"/>
                      </a:lnTo>
                      <a:lnTo>
                        <a:pt x="4073" y="938"/>
                      </a:lnTo>
                      <a:lnTo>
                        <a:pt x="4077" y="937"/>
                      </a:lnTo>
                      <a:lnTo>
                        <a:pt x="4080" y="938"/>
                      </a:lnTo>
                      <a:lnTo>
                        <a:pt x="4083" y="939"/>
                      </a:lnTo>
                      <a:lnTo>
                        <a:pt x="4087" y="939"/>
                      </a:lnTo>
                      <a:lnTo>
                        <a:pt x="4090" y="939"/>
                      </a:lnTo>
                      <a:lnTo>
                        <a:pt x="4093" y="938"/>
                      </a:lnTo>
                      <a:lnTo>
                        <a:pt x="4097" y="940"/>
                      </a:lnTo>
                      <a:lnTo>
                        <a:pt x="4100" y="939"/>
                      </a:lnTo>
                      <a:lnTo>
                        <a:pt x="4103" y="940"/>
                      </a:lnTo>
                      <a:lnTo>
                        <a:pt x="4107" y="938"/>
                      </a:lnTo>
                      <a:lnTo>
                        <a:pt x="4110" y="939"/>
                      </a:lnTo>
                      <a:lnTo>
                        <a:pt x="4113" y="939"/>
                      </a:lnTo>
                      <a:lnTo>
                        <a:pt x="4117" y="938"/>
                      </a:lnTo>
                      <a:lnTo>
                        <a:pt x="4120" y="939"/>
                      </a:lnTo>
                      <a:lnTo>
                        <a:pt x="4123" y="939"/>
                      </a:lnTo>
                      <a:lnTo>
                        <a:pt x="4126" y="939"/>
                      </a:lnTo>
                      <a:lnTo>
                        <a:pt x="4130" y="939"/>
                      </a:lnTo>
                      <a:lnTo>
                        <a:pt x="4133" y="940"/>
                      </a:lnTo>
                      <a:lnTo>
                        <a:pt x="4136" y="939"/>
                      </a:lnTo>
                      <a:lnTo>
                        <a:pt x="4140" y="939"/>
                      </a:lnTo>
                      <a:lnTo>
                        <a:pt x="4143" y="939"/>
                      </a:lnTo>
                      <a:lnTo>
                        <a:pt x="4146" y="940"/>
                      </a:lnTo>
                      <a:lnTo>
                        <a:pt x="4149" y="940"/>
                      </a:lnTo>
                      <a:lnTo>
                        <a:pt x="4153" y="940"/>
                      </a:lnTo>
                      <a:lnTo>
                        <a:pt x="4156" y="939"/>
                      </a:lnTo>
                      <a:lnTo>
                        <a:pt x="4160" y="938"/>
                      </a:lnTo>
                      <a:lnTo>
                        <a:pt x="4163" y="938"/>
                      </a:lnTo>
                      <a:lnTo>
                        <a:pt x="4166" y="939"/>
                      </a:lnTo>
                      <a:lnTo>
                        <a:pt x="4169" y="939"/>
                      </a:lnTo>
                      <a:lnTo>
                        <a:pt x="4173" y="939"/>
                      </a:lnTo>
                      <a:lnTo>
                        <a:pt x="4176" y="939"/>
                      </a:lnTo>
                      <a:lnTo>
                        <a:pt x="4179" y="939"/>
                      </a:lnTo>
                      <a:lnTo>
                        <a:pt x="4183" y="940"/>
                      </a:lnTo>
                      <a:lnTo>
                        <a:pt x="4186" y="939"/>
                      </a:lnTo>
                      <a:lnTo>
                        <a:pt x="4189" y="941"/>
                      </a:lnTo>
                      <a:lnTo>
                        <a:pt x="4192" y="940"/>
                      </a:lnTo>
                      <a:lnTo>
                        <a:pt x="4196" y="940"/>
                      </a:lnTo>
                      <a:lnTo>
                        <a:pt x="4199" y="940"/>
                      </a:lnTo>
                      <a:lnTo>
                        <a:pt x="4202" y="939"/>
                      </a:lnTo>
                      <a:lnTo>
                        <a:pt x="4206" y="941"/>
                      </a:lnTo>
                      <a:lnTo>
                        <a:pt x="4209" y="938"/>
                      </a:lnTo>
                      <a:lnTo>
                        <a:pt x="4212" y="941"/>
                      </a:lnTo>
                      <a:lnTo>
                        <a:pt x="4216" y="940"/>
                      </a:lnTo>
                      <a:lnTo>
                        <a:pt x="4219" y="940"/>
                      </a:lnTo>
                      <a:lnTo>
                        <a:pt x="4222" y="940"/>
                      </a:lnTo>
                      <a:lnTo>
                        <a:pt x="4226" y="940"/>
                      </a:lnTo>
                      <a:lnTo>
                        <a:pt x="4229" y="939"/>
                      </a:lnTo>
                      <a:lnTo>
                        <a:pt x="4232" y="939"/>
                      </a:lnTo>
                      <a:lnTo>
                        <a:pt x="4236" y="939"/>
                      </a:lnTo>
                      <a:lnTo>
                        <a:pt x="4239" y="939"/>
                      </a:lnTo>
                      <a:lnTo>
                        <a:pt x="4242" y="940"/>
                      </a:lnTo>
                      <a:lnTo>
                        <a:pt x="4245" y="939"/>
                      </a:lnTo>
                      <a:lnTo>
                        <a:pt x="4249" y="938"/>
                      </a:lnTo>
                      <a:lnTo>
                        <a:pt x="4252" y="939"/>
                      </a:lnTo>
                      <a:lnTo>
                        <a:pt x="4255" y="939"/>
                      </a:lnTo>
                      <a:lnTo>
                        <a:pt x="4259" y="939"/>
                      </a:lnTo>
                      <a:lnTo>
                        <a:pt x="4262" y="939"/>
                      </a:lnTo>
                      <a:lnTo>
                        <a:pt x="4265" y="940"/>
                      </a:lnTo>
                      <a:lnTo>
                        <a:pt x="4269" y="940"/>
                      </a:lnTo>
                      <a:lnTo>
                        <a:pt x="4272" y="939"/>
                      </a:lnTo>
                      <a:lnTo>
                        <a:pt x="4275" y="940"/>
                      </a:lnTo>
                      <a:lnTo>
                        <a:pt x="4279" y="938"/>
                      </a:lnTo>
                      <a:lnTo>
                        <a:pt x="4282" y="939"/>
                      </a:lnTo>
                      <a:lnTo>
                        <a:pt x="4285" y="939"/>
                      </a:lnTo>
                      <a:lnTo>
                        <a:pt x="4289" y="939"/>
                      </a:lnTo>
                      <a:lnTo>
                        <a:pt x="4292" y="939"/>
                      </a:lnTo>
                      <a:lnTo>
                        <a:pt x="4295" y="939"/>
                      </a:lnTo>
                      <a:lnTo>
                        <a:pt x="4298" y="939"/>
                      </a:lnTo>
                      <a:lnTo>
                        <a:pt x="4302" y="939"/>
                      </a:lnTo>
                      <a:lnTo>
                        <a:pt x="4305" y="939"/>
                      </a:lnTo>
                      <a:lnTo>
                        <a:pt x="4308" y="939"/>
                      </a:lnTo>
                      <a:lnTo>
                        <a:pt x="4312" y="938"/>
                      </a:lnTo>
                      <a:lnTo>
                        <a:pt x="4315" y="939"/>
                      </a:lnTo>
                      <a:lnTo>
                        <a:pt x="4318" y="939"/>
                      </a:lnTo>
                      <a:lnTo>
                        <a:pt x="4322" y="941"/>
                      </a:lnTo>
                      <a:lnTo>
                        <a:pt x="4325" y="939"/>
                      </a:lnTo>
                      <a:lnTo>
                        <a:pt x="4328" y="939"/>
                      </a:lnTo>
                      <a:lnTo>
                        <a:pt x="4332" y="939"/>
                      </a:lnTo>
                      <a:lnTo>
                        <a:pt x="4335" y="940"/>
                      </a:lnTo>
                      <a:lnTo>
                        <a:pt x="4338" y="939"/>
                      </a:lnTo>
                      <a:lnTo>
                        <a:pt x="4341" y="941"/>
                      </a:lnTo>
                      <a:lnTo>
                        <a:pt x="4345" y="939"/>
                      </a:lnTo>
                      <a:lnTo>
                        <a:pt x="4348" y="939"/>
                      </a:lnTo>
                      <a:lnTo>
                        <a:pt x="4351" y="938"/>
                      </a:lnTo>
                      <a:lnTo>
                        <a:pt x="4355" y="938"/>
                      </a:lnTo>
                      <a:lnTo>
                        <a:pt x="4358" y="940"/>
                      </a:lnTo>
                      <a:lnTo>
                        <a:pt x="4361" y="938"/>
                      </a:lnTo>
                      <a:lnTo>
                        <a:pt x="4365" y="939"/>
                      </a:lnTo>
                      <a:lnTo>
                        <a:pt x="4368" y="940"/>
                      </a:lnTo>
                      <a:lnTo>
                        <a:pt x="4371" y="940"/>
                      </a:lnTo>
                      <a:lnTo>
                        <a:pt x="4375" y="940"/>
                      </a:lnTo>
                      <a:lnTo>
                        <a:pt x="4378" y="939"/>
                      </a:lnTo>
                      <a:lnTo>
                        <a:pt x="4381" y="938"/>
                      </a:lnTo>
                      <a:lnTo>
                        <a:pt x="4385" y="941"/>
                      </a:lnTo>
                      <a:lnTo>
                        <a:pt x="4388" y="940"/>
                      </a:lnTo>
                      <a:lnTo>
                        <a:pt x="4391" y="939"/>
                      </a:lnTo>
                      <a:lnTo>
                        <a:pt x="4394" y="938"/>
                      </a:lnTo>
                      <a:lnTo>
                        <a:pt x="4398" y="939"/>
                      </a:lnTo>
                      <a:lnTo>
                        <a:pt x="4401" y="939"/>
                      </a:lnTo>
                      <a:lnTo>
                        <a:pt x="4404" y="938"/>
                      </a:lnTo>
                      <a:lnTo>
                        <a:pt x="4408" y="939"/>
                      </a:lnTo>
                      <a:lnTo>
                        <a:pt x="4411" y="941"/>
                      </a:lnTo>
                      <a:lnTo>
                        <a:pt x="4414" y="938"/>
                      </a:lnTo>
                      <a:lnTo>
                        <a:pt x="4417" y="939"/>
                      </a:lnTo>
                      <a:lnTo>
                        <a:pt x="4421" y="939"/>
                      </a:lnTo>
                      <a:lnTo>
                        <a:pt x="4424" y="939"/>
                      </a:lnTo>
                      <a:lnTo>
                        <a:pt x="4428" y="936"/>
                      </a:lnTo>
                      <a:lnTo>
                        <a:pt x="4431" y="939"/>
                      </a:lnTo>
                      <a:lnTo>
                        <a:pt x="4434" y="938"/>
                      </a:lnTo>
                      <a:lnTo>
                        <a:pt x="4437" y="939"/>
                      </a:lnTo>
                      <a:lnTo>
                        <a:pt x="4441" y="939"/>
                      </a:lnTo>
                      <a:lnTo>
                        <a:pt x="4444" y="939"/>
                      </a:lnTo>
                      <a:lnTo>
                        <a:pt x="4447" y="939"/>
                      </a:lnTo>
                      <a:lnTo>
                        <a:pt x="4451" y="940"/>
                      </a:lnTo>
                      <a:lnTo>
                        <a:pt x="4454" y="939"/>
                      </a:lnTo>
                      <a:lnTo>
                        <a:pt x="4457" y="939"/>
                      </a:lnTo>
                      <a:lnTo>
                        <a:pt x="4461" y="939"/>
                      </a:lnTo>
                      <a:lnTo>
                        <a:pt x="4464" y="937"/>
                      </a:lnTo>
                      <a:lnTo>
                        <a:pt x="4467" y="937"/>
                      </a:lnTo>
                      <a:lnTo>
                        <a:pt x="4470" y="939"/>
                      </a:lnTo>
                      <a:lnTo>
                        <a:pt x="4474" y="939"/>
                      </a:lnTo>
                      <a:lnTo>
                        <a:pt x="4477" y="937"/>
                      </a:lnTo>
                      <a:lnTo>
                        <a:pt x="4480" y="939"/>
                      </a:lnTo>
                      <a:lnTo>
                        <a:pt x="4484" y="939"/>
                      </a:lnTo>
                      <a:lnTo>
                        <a:pt x="4487" y="939"/>
                      </a:lnTo>
                      <a:lnTo>
                        <a:pt x="4490" y="939"/>
                      </a:lnTo>
                      <a:lnTo>
                        <a:pt x="4494" y="938"/>
                      </a:lnTo>
                      <a:lnTo>
                        <a:pt x="4497" y="940"/>
                      </a:lnTo>
                      <a:lnTo>
                        <a:pt x="4500" y="937"/>
                      </a:lnTo>
                      <a:lnTo>
                        <a:pt x="4504" y="936"/>
                      </a:lnTo>
                      <a:lnTo>
                        <a:pt x="4507" y="938"/>
                      </a:lnTo>
                      <a:lnTo>
                        <a:pt x="4510" y="939"/>
                      </a:lnTo>
                      <a:lnTo>
                        <a:pt x="4513" y="939"/>
                      </a:lnTo>
                      <a:lnTo>
                        <a:pt x="4517" y="938"/>
                      </a:lnTo>
                      <a:lnTo>
                        <a:pt x="4520" y="939"/>
                      </a:lnTo>
                      <a:lnTo>
                        <a:pt x="4523" y="939"/>
                      </a:lnTo>
                      <a:lnTo>
                        <a:pt x="4527" y="937"/>
                      </a:lnTo>
                      <a:lnTo>
                        <a:pt x="4530" y="937"/>
                      </a:lnTo>
                      <a:lnTo>
                        <a:pt x="4533" y="939"/>
                      </a:lnTo>
                      <a:lnTo>
                        <a:pt x="4537" y="938"/>
                      </a:lnTo>
                      <a:lnTo>
                        <a:pt x="4540" y="939"/>
                      </a:lnTo>
                      <a:lnTo>
                        <a:pt x="4543" y="939"/>
                      </a:lnTo>
                      <a:lnTo>
                        <a:pt x="4547" y="938"/>
                      </a:lnTo>
                      <a:lnTo>
                        <a:pt x="4550" y="937"/>
                      </a:lnTo>
                      <a:lnTo>
                        <a:pt x="4553" y="938"/>
                      </a:lnTo>
                      <a:lnTo>
                        <a:pt x="4557" y="938"/>
                      </a:lnTo>
                      <a:lnTo>
                        <a:pt x="4560" y="935"/>
                      </a:lnTo>
                      <a:lnTo>
                        <a:pt x="4563" y="939"/>
                      </a:lnTo>
                      <a:lnTo>
                        <a:pt x="4566" y="939"/>
                      </a:lnTo>
                      <a:lnTo>
                        <a:pt x="4570" y="937"/>
                      </a:lnTo>
                      <a:lnTo>
                        <a:pt x="4573" y="938"/>
                      </a:lnTo>
                      <a:lnTo>
                        <a:pt x="4576" y="936"/>
                      </a:lnTo>
                      <a:lnTo>
                        <a:pt x="4580" y="938"/>
                      </a:lnTo>
                      <a:lnTo>
                        <a:pt x="4583" y="937"/>
                      </a:lnTo>
                      <a:lnTo>
                        <a:pt x="4586" y="938"/>
                      </a:lnTo>
                      <a:lnTo>
                        <a:pt x="4590" y="938"/>
                      </a:lnTo>
                      <a:lnTo>
                        <a:pt x="4593" y="937"/>
                      </a:lnTo>
                      <a:lnTo>
                        <a:pt x="4596" y="938"/>
                      </a:lnTo>
                      <a:lnTo>
                        <a:pt x="4600" y="938"/>
                      </a:lnTo>
                      <a:lnTo>
                        <a:pt x="4603" y="938"/>
                      </a:lnTo>
                      <a:lnTo>
                        <a:pt x="4606" y="939"/>
                      </a:lnTo>
                      <a:lnTo>
                        <a:pt x="4609" y="939"/>
                      </a:lnTo>
                      <a:lnTo>
                        <a:pt x="4613" y="936"/>
                      </a:lnTo>
                      <a:lnTo>
                        <a:pt x="4616" y="938"/>
                      </a:lnTo>
                      <a:lnTo>
                        <a:pt x="4619" y="939"/>
                      </a:lnTo>
                      <a:lnTo>
                        <a:pt x="4623" y="939"/>
                      </a:lnTo>
                      <a:lnTo>
                        <a:pt x="4626" y="938"/>
                      </a:lnTo>
                      <a:lnTo>
                        <a:pt x="4629" y="936"/>
                      </a:lnTo>
                      <a:lnTo>
                        <a:pt x="4633" y="937"/>
                      </a:lnTo>
                      <a:lnTo>
                        <a:pt x="4636" y="937"/>
                      </a:lnTo>
                      <a:lnTo>
                        <a:pt x="4639" y="937"/>
                      </a:lnTo>
                      <a:lnTo>
                        <a:pt x="4643" y="936"/>
                      </a:lnTo>
                      <a:lnTo>
                        <a:pt x="4646" y="939"/>
                      </a:lnTo>
                      <a:lnTo>
                        <a:pt x="4649" y="936"/>
                      </a:lnTo>
                      <a:lnTo>
                        <a:pt x="4653" y="937"/>
                      </a:lnTo>
                      <a:lnTo>
                        <a:pt x="4656" y="936"/>
                      </a:lnTo>
                      <a:lnTo>
                        <a:pt x="4659" y="939"/>
                      </a:lnTo>
                      <a:lnTo>
                        <a:pt x="4662" y="938"/>
                      </a:lnTo>
                      <a:lnTo>
                        <a:pt x="4666" y="937"/>
                      </a:lnTo>
                      <a:lnTo>
                        <a:pt x="4669" y="937"/>
                      </a:lnTo>
                      <a:lnTo>
                        <a:pt x="4672" y="937"/>
                      </a:lnTo>
                      <a:lnTo>
                        <a:pt x="4676" y="939"/>
                      </a:lnTo>
                      <a:lnTo>
                        <a:pt x="4679" y="937"/>
                      </a:lnTo>
                      <a:lnTo>
                        <a:pt x="4682" y="937"/>
                      </a:lnTo>
                      <a:lnTo>
                        <a:pt x="4685" y="938"/>
                      </a:lnTo>
                      <a:lnTo>
                        <a:pt x="4689" y="939"/>
                      </a:lnTo>
                      <a:lnTo>
                        <a:pt x="4692" y="938"/>
                      </a:lnTo>
                      <a:lnTo>
                        <a:pt x="4696" y="937"/>
                      </a:lnTo>
                      <a:lnTo>
                        <a:pt x="4699" y="938"/>
                      </a:lnTo>
                      <a:lnTo>
                        <a:pt x="4702" y="938"/>
                      </a:lnTo>
                      <a:lnTo>
                        <a:pt x="4706" y="937"/>
                      </a:lnTo>
                      <a:lnTo>
                        <a:pt x="4709" y="937"/>
                      </a:lnTo>
                      <a:lnTo>
                        <a:pt x="4712" y="938"/>
                      </a:lnTo>
                      <a:lnTo>
                        <a:pt x="4715" y="939"/>
                      </a:lnTo>
                      <a:lnTo>
                        <a:pt x="4719" y="938"/>
                      </a:lnTo>
                      <a:lnTo>
                        <a:pt x="4722" y="939"/>
                      </a:lnTo>
                      <a:lnTo>
                        <a:pt x="4725" y="937"/>
                      </a:lnTo>
                      <a:lnTo>
                        <a:pt x="4729" y="938"/>
                      </a:lnTo>
                      <a:lnTo>
                        <a:pt x="4732" y="939"/>
                      </a:lnTo>
                      <a:lnTo>
                        <a:pt x="4735" y="937"/>
                      </a:lnTo>
                      <a:lnTo>
                        <a:pt x="4738" y="937"/>
                      </a:lnTo>
                      <a:lnTo>
                        <a:pt x="4742" y="938"/>
                      </a:lnTo>
                      <a:lnTo>
                        <a:pt x="4745" y="939"/>
                      </a:lnTo>
                      <a:lnTo>
                        <a:pt x="4748" y="937"/>
                      </a:lnTo>
                      <a:lnTo>
                        <a:pt x="4752" y="938"/>
                      </a:lnTo>
                      <a:lnTo>
                        <a:pt x="4755" y="937"/>
                      </a:lnTo>
                      <a:lnTo>
                        <a:pt x="4758" y="938"/>
                      </a:lnTo>
                      <a:lnTo>
                        <a:pt x="4762" y="939"/>
                      </a:lnTo>
                      <a:lnTo>
                        <a:pt x="4765" y="939"/>
                      </a:lnTo>
                      <a:lnTo>
                        <a:pt x="4768" y="938"/>
                      </a:lnTo>
                      <a:lnTo>
                        <a:pt x="4772" y="939"/>
                      </a:lnTo>
                      <a:lnTo>
                        <a:pt x="4775" y="938"/>
                      </a:lnTo>
                      <a:lnTo>
                        <a:pt x="4778" y="939"/>
                      </a:lnTo>
                      <a:lnTo>
                        <a:pt x="4781" y="939"/>
                      </a:lnTo>
                      <a:lnTo>
                        <a:pt x="4785" y="938"/>
                      </a:lnTo>
                      <a:lnTo>
                        <a:pt x="4788" y="939"/>
                      </a:lnTo>
                      <a:lnTo>
                        <a:pt x="4791" y="939"/>
                      </a:lnTo>
                      <a:lnTo>
                        <a:pt x="4795" y="939"/>
                      </a:lnTo>
                      <a:lnTo>
                        <a:pt x="4798" y="939"/>
                      </a:lnTo>
                      <a:lnTo>
                        <a:pt x="4801" y="938"/>
                      </a:lnTo>
                      <a:lnTo>
                        <a:pt x="4805" y="939"/>
                      </a:lnTo>
                      <a:lnTo>
                        <a:pt x="4808" y="939"/>
                      </a:lnTo>
                      <a:lnTo>
                        <a:pt x="4811" y="938"/>
                      </a:lnTo>
                      <a:lnTo>
                        <a:pt x="4815" y="939"/>
                      </a:lnTo>
                      <a:lnTo>
                        <a:pt x="4818" y="939"/>
                      </a:lnTo>
                      <a:lnTo>
                        <a:pt x="4821" y="940"/>
                      </a:lnTo>
                      <a:lnTo>
                        <a:pt x="4825" y="938"/>
                      </a:lnTo>
                      <a:lnTo>
                        <a:pt x="4828" y="939"/>
                      </a:lnTo>
                      <a:lnTo>
                        <a:pt x="4831" y="938"/>
                      </a:lnTo>
                      <a:lnTo>
                        <a:pt x="4834" y="938"/>
                      </a:lnTo>
                      <a:lnTo>
                        <a:pt x="4838" y="938"/>
                      </a:lnTo>
                      <a:lnTo>
                        <a:pt x="4841" y="938"/>
                      </a:lnTo>
                      <a:lnTo>
                        <a:pt x="4844" y="940"/>
                      </a:lnTo>
                      <a:lnTo>
                        <a:pt x="4848" y="940"/>
                      </a:lnTo>
                      <a:lnTo>
                        <a:pt x="4851" y="939"/>
                      </a:lnTo>
                      <a:lnTo>
                        <a:pt x="4854" y="939"/>
                      </a:lnTo>
                      <a:lnTo>
                        <a:pt x="4858" y="939"/>
                      </a:lnTo>
                      <a:lnTo>
                        <a:pt x="4861" y="940"/>
                      </a:lnTo>
                      <a:lnTo>
                        <a:pt x="4864" y="939"/>
                      </a:lnTo>
                      <a:lnTo>
                        <a:pt x="4868" y="938"/>
                      </a:lnTo>
                      <a:lnTo>
                        <a:pt x="4871" y="938"/>
                      </a:lnTo>
                      <a:lnTo>
                        <a:pt x="4874" y="939"/>
                      </a:lnTo>
                      <a:lnTo>
                        <a:pt x="4878" y="941"/>
                      </a:lnTo>
                      <a:lnTo>
                        <a:pt x="4881" y="938"/>
                      </a:lnTo>
                      <a:lnTo>
                        <a:pt x="4884" y="939"/>
                      </a:lnTo>
                      <a:lnTo>
                        <a:pt x="4887" y="939"/>
                      </a:lnTo>
                      <a:lnTo>
                        <a:pt x="4891" y="939"/>
                      </a:lnTo>
                      <a:lnTo>
                        <a:pt x="4894" y="937"/>
                      </a:lnTo>
                      <a:lnTo>
                        <a:pt x="4897" y="938"/>
                      </a:lnTo>
                      <a:lnTo>
                        <a:pt x="4901" y="937"/>
                      </a:lnTo>
                      <a:lnTo>
                        <a:pt x="4904" y="938"/>
                      </a:lnTo>
                      <a:lnTo>
                        <a:pt x="4907" y="938"/>
                      </a:lnTo>
                      <a:lnTo>
                        <a:pt x="4911" y="940"/>
                      </a:lnTo>
                      <a:lnTo>
                        <a:pt x="4914" y="938"/>
                      </a:lnTo>
                      <a:lnTo>
                        <a:pt x="4917" y="938"/>
                      </a:lnTo>
                      <a:lnTo>
                        <a:pt x="4921" y="939"/>
                      </a:lnTo>
                      <a:lnTo>
                        <a:pt x="4924" y="938"/>
                      </a:lnTo>
                      <a:lnTo>
                        <a:pt x="4927" y="940"/>
                      </a:lnTo>
                      <a:lnTo>
                        <a:pt x="4930" y="938"/>
                      </a:lnTo>
                      <a:lnTo>
                        <a:pt x="4934" y="938"/>
                      </a:lnTo>
                      <a:lnTo>
                        <a:pt x="4937" y="937"/>
                      </a:lnTo>
                      <a:lnTo>
                        <a:pt x="4940" y="938"/>
                      </a:lnTo>
                      <a:lnTo>
                        <a:pt x="4944" y="939"/>
                      </a:lnTo>
                      <a:lnTo>
                        <a:pt x="4947" y="939"/>
                      </a:lnTo>
                      <a:lnTo>
                        <a:pt x="4950" y="939"/>
                      </a:lnTo>
                      <a:lnTo>
                        <a:pt x="4953" y="939"/>
                      </a:lnTo>
                      <a:lnTo>
                        <a:pt x="4957" y="938"/>
                      </a:lnTo>
                      <a:lnTo>
                        <a:pt x="4960" y="939"/>
                      </a:lnTo>
                      <a:lnTo>
                        <a:pt x="4964" y="939"/>
                      </a:lnTo>
                      <a:lnTo>
                        <a:pt x="4965" y="938"/>
                      </a:lnTo>
                    </a:path>
                  </a:pathLst>
                </a:custGeom>
                <a:noFill/>
                <a:ln w="9525" cap="flat" cmpd="sng">
                  <a:solidFill>
                    <a:srgbClr val="FF5CFF"/>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000"/>
                    <a:buFont typeface="Arial"/>
                    <a:buNone/>
                  </a:pPr>
                  <a:endParaRPr sz="800" b="0" i="0" u="none" strike="noStrike" cap="none">
                    <a:solidFill>
                      <a:srgbClr val="000000"/>
                    </a:solidFill>
                    <a:latin typeface="Arial"/>
                    <a:ea typeface="Arial"/>
                    <a:cs typeface="Arial"/>
                    <a:sym typeface="Arial"/>
                  </a:endParaRPr>
                </a:p>
              </p:txBody>
            </p:sp>
            <p:sp>
              <p:nvSpPr>
                <p:cNvPr id="1701" name="Google Shape;1701;p11"/>
                <p:cNvSpPr/>
                <p:nvPr/>
              </p:nvSpPr>
              <p:spPr>
                <a:xfrm>
                  <a:off x="1434" y="1632"/>
                  <a:ext cx="4965" cy="1689"/>
                </a:xfrm>
                <a:custGeom>
                  <a:avLst/>
                  <a:gdLst/>
                  <a:ahLst/>
                  <a:cxnLst/>
                  <a:rect l="l" t="t" r="r" b="b"/>
                  <a:pathLst>
                    <a:path w="4965" h="1689" extrusionOk="0">
                      <a:moveTo>
                        <a:pt x="0" y="1687"/>
                      </a:moveTo>
                      <a:lnTo>
                        <a:pt x="4" y="1686"/>
                      </a:lnTo>
                      <a:lnTo>
                        <a:pt x="7" y="1687"/>
                      </a:lnTo>
                      <a:lnTo>
                        <a:pt x="10" y="1687"/>
                      </a:lnTo>
                      <a:lnTo>
                        <a:pt x="13" y="1687"/>
                      </a:lnTo>
                      <a:lnTo>
                        <a:pt x="17" y="1688"/>
                      </a:lnTo>
                      <a:lnTo>
                        <a:pt x="20" y="1688"/>
                      </a:lnTo>
                      <a:lnTo>
                        <a:pt x="23" y="1686"/>
                      </a:lnTo>
                      <a:lnTo>
                        <a:pt x="27" y="1687"/>
                      </a:lnTo>
                      <a:lnTo>
                        <a:pt x="30" y="1687"/>
                      </a:lnTo>
                      <a:lnTo>
                        <a:pt x="33" y="1686"/>
                      </a:lnTo>
                      <a:lnTo>
                        <a:pt x="36" y="1687"/>
                      </a:lnTo>
                      <a:lnTo>
                        <a:pt x="40" y="1686"/>
                      </a:lnTo>
                      <a:lnTo>
                        <a:pt x="43" y="1686"/>
                      </a:lnTo>
                      <a:lnTo>
                        <a:pt x="46" y="1686"/>
                      </a:lnTo>
                      <a:lnTo>
                        <a:pt x="50" y="1687"/>
                      </a:lnTo>
                      <a:lnTo>
                        <a:pt x="53" y="1688"/>
                      </a:lnTo>
                      <a:lnTo>
                        <a:pt x="56" y="1686"/>
                      </a:lnTo>
                      <a:lnTo>
                        <a:pt x="60" y="1687"/>
                      </a:lnTo>
                      <a:lnTo>
                        <a:pt x="63" y="1687"/>
                      </a:lnTo>
                      <a:lnTo>
                        <a:pt x="66" y="1688"/>
                      </a:lnTo>
                      <a:lnTo>
                        <a:pt x="70" y="1687"/>
                      </a:lnTo>
                      <a:lnTo>
                        <a:pt x="73" y="1688"/>
                      </a:lnTo>
                      <a:lnTo>
                        <a:pt x="76" y="1687"/>
                      </a:lnTo>
                      <a:lnTo>
                        <a:pt x="80" y="1686"/>
                      </a:lnTo>
                      <a:lnTo>
                        <a:pt x="83" y="1687"/>
                      </a:lnTo>
                      <a:lnTo>
                        <a:pt x="86" y="1687"/>
                      </a:lnTo>
                      <a:lnTo>
                        <a:pt x="89" y="1686"/>
                      </a:lnTo>
                      <a:lnTo>
                        <a:pt x="93" y="1687"/>
                      </a:lnTo>
                      <a:lnTo>
                        <a:pt x="96" y="1688"/>
                      </a:lnTo>
                      <a:lnTo>
                        <a:pt x="99" y="1689"/>
                      </a:lnTo>
                      <a:lnTo>
                        <a:pt x="103" y="1686"/>
                      </a:lnTo>
                      <a:lnTo>
                        <a:pt x="106" y="1688"/>
                      </a:lnTo>
                      <a:lnTo>
                        <a:pt x="109" y="1687"/>
                      </a:lnTo>
                      <a:lnTo>
                        <a:pt x="113" y="1688"/>
                      </a:lnTo>
                      <a:lnTo>
                        <a:pt x="116" y="1687"/>
                      </a:lnTo>
                      <a:lnTo>
                        <a:pt x="119" y="1688"/>
                      </a:lnTo>
                      <a:lnTo>
                        <a:pt x="123" y="1686"/>
                      </a:lnTo>
                      <a:lnTo>
                        <a:pt x="126" y="1687"/>
                      </a:lnTo>
                      <a:lnTo>
                        <a:pt x="129" y="1685"/>
                      </a:lnTo>
                      <a:lnTo>
                        <a:pt x="133" y="1687"/>
                      </a:lnTo>
                      <a:lnTo>
                        <a:pt x="136" y="1687"/>
                      </a:lnTo>
                      <a:lnTo>
                        <a:pt x="139" y="1686"/>
                      </a:lnTo>
                      <a:lnTo>
                        <a:pt x="142" y="1687"/>
                      </a:lnTo>
                      <a:lnTo>
                        <a:pt x="146" y="1687"/>
                      </a:lnTo>
                      <a:lnTo>
                        <a:pt x="149" y="1688"/>
                      </a:lnTo>
                      <a:lnTo>
                        <a:pt x="152" y="1687"/>
                      </a:lnTo>
                      <a:lnTo>
                        <a:pt x="156" y="1686"/>
                      </a:lnTo>
                      <a:lnTo>
                        <a:pt x="159" y="1686"/>
                      </a:lnTo>
                      <a:lnTo>
                        <a:pt x="162" y="1686"/>
                      </a:lnTo>
                      <a:lnTo>
                        <a:pt x="166" y="1686"/>
                      </a:lnTo>
                      <a:lnTo>
                        <a:pt x="169" y="1686"/>
                      </a:lnTo>
                      <a:lnTo>
                        <a:pt x="172" y="1686"/>
                      </a:lnTo>
                      <a:lnTo>
                        <a:pt x="176" y="1686"/>
                      </a:lnTo>
                      <a:lnTo>
                        <a:pt x="179" y="1686"/>
                      </a:lnTo>
                      <a:lnTo>
                        <a:pt x="182" y="1684"/>
                      </a:lnTo>
                      <a:lnTo>
                        <a:pt x="185" y="1686"/>
                      </a:lnTo>
                      <a:lnTo>
                        <a:pt x="189" y="1685"/>
                      </a:lnTo>
                      <a:lnTo>
                        <a:pt x="192" y="1684"/>
                      </a:lnTo>
                      <a:lnTo>
                        <a:pt x="195" y="1687"/>
                      </a:lnTo>
                      <a:lnTo>
                        <a:pt x="199" y="1686"/>
                      </a:lnTo>
                      <a:lnTo>
                        <a:pt x="202" y="1685"/>
                      </a:lnTo>
                      <a:lnTo>
                        <a:pt x="205" y="1684"/>
                      </a:lnTo>
                      <a:lnTo>
                        <a:pt x="209" y="1684"/>
                      </a:lnTo>
                      <a:lnTo>
                        <a:pt x="212" y="1683"/>
                      </a:lnTo>
                      <a:lnTo>
                        <a:pt x="215" y="1684"/>
                      </a:lnTo>
                      <a:lnTo>
                        <a:pt x="219" y="1686"/>
                      </a:lnTo>
                      <a:lnTo>
                        <a:pt x="222" y="1686"/>
                      </a:lnTo>
                      <a:lnTo>
                        <a:pt x="225" y="1685"/>
                      </a:lnTo>
                      <a:lnTo>
                        <a:pt x="229" y="1684"/>
                      </a:lnTo>
                      <a:lnTo>
                        <a:pt x="232" y="1685"/>
                      </a:lnTo>
                      <a:lnTo>
                        <a:pt x="235" y="1686"/>
                      </a:lnTo>
                      <a:lnTo>
                        <a:pt x="238" y="1684"/>
                      </a:lnTo>
                      <a:lnTo>
                        <a:pt x="242" y="1685"/>
                      </a:lnTo>
                      <a:lnTo>
                        <a:pt x="245" y="1686"/>
                      </a:lnTo>
                      <a:lnTo>
                        <a:pt x="248" y="1685"/>
                      </a:lnTo>
                      <a:lnTo>
                        <a:pt x="252" y="1685"/>
                      </a:lnTo>
                      <a:lnTo>
                        <a:pt x="255" y="1685"/>
                      </a:lnTo>
                      <a:lnTo>
                        <a:pt x="258" y="1686"/>
                      </a:lnTo>
                      <a:lnTo>
                        <a:pt x="262" y="1685"/>
                      </a:lnTo>
                      <a:lnTo>
                        <a:pt x="265" y="1685"/>
                      </a:lnTo>
                      <a:lnTo>
                        <a:pt x="268" y="1686"/>
                      </a:lnTo>
                      <a:lnTo>
                        <a:pt x="272" y="1687"/>
                      </a:lnTo>
                      <a:lnTo>
                        <a:pt x="275" y="1686"/>
                      </a:lnTo>
                      <a:lnTo>
                        <a:pt x="278" y="1685"/>
                      </a:lnTo>
                      <a:lnTo>
                        <a:pt x="281" y="1686"/>
                      </a:lnTo>
                      <a:lnTo>
                        <a:pt x="285" y="1686"/>
                      </a:lnTo>
                      <a:lnTo>
                        <a:pt x="288" y="1686"/>
                      </a:lnTo>
                      <a:lnTo>
                        <a:pt x="291" y="1686"/>
                      </a:lnTo>
                      <a:lnTo>
                        <a:pt x="295" y="1685"/>
                      </a:lnTo>
                      <a:lnTo>
                        <a:pt x="298" y="1685"/>
                      </a:lnTo>
                      <a:lnTo>
                        <a:pt x="301" y="1686"/>
                      </a:lnTo>
                      <a:lnTo>
                        <a:pt x="305" y="1686"/>
                      </a:lnTo>
                      <a:lnTo>
                        <a:pt x="308" y="1686"/>
                      </a:lnTo>
                      <a:lnTo>
                        <a:pt x="311" y="1685"/>
                      </a:lnTo>
                      <a:lnTo>
                        <a:pt x="314" y="1686"/>
                      </a:lnTo>
                      <a:lnTo>
                        <a:pt x="318" y="1685"/>
                      </a:lnTo>
                      <a:lnTo>
                        <a:pt x="321" y="1685"/>
                      </a:lnTo>
                      <a:lnTo>
                        <a:pt x="325" y="1685"/>
                      </a:lnTo>
                      <a:lnTo>
                        <a:pt x="328" y="1686"/>
                      </a:lnTo>
                      <a:lnTo>
                        <a:pt x="331" y="1685"/>
                      </a:lnTo>
                      <a:lnTo>
                        <a:pt x="334" y="1686"/>
                      </a:lnTo>
                      <a:lnTo>
                        <a:pt x="338" y="1686"/>
                      </a:lnTo>
                      <a:lnTo>
                        <a:pt x="341" y="1686"/>
                      </a:lnTo>
                      <a:lnTo>
                        <a:pt x="344" y="1687"/>
                      </a:lnTo>
                      <a:lnTo>
                        <a:pt x="348" y="1687"/>
                      </a:lnTo>
                      <a:lnTo>
                        <a:pt x="351" y="1685"/>
                      </a:lnTo>
                      <a:lnTo>
                        <a:pt x="354" y="1686"/>
                      </a:lnTo>
                      <a:lnTo>
                        <a:pt x="357" y="1686"/>
                      </a:lnTo>
                      <a:lnTo>
                        <a:pt x="361" y="1684"/>
                      </a:lnTo>
                      <a:lnTo>
                        <a:pt x="364" y="1686"/>
                      </a:lnTo>
                      <a:lnTo>
                        <a:pt x="367" y="1685"/>
                      </a:lnTo>
                      <a:lnTo>
                        <a:pt x="371" y="1686"/>
                      </a:lnTo>
                      <a:lnTo>
                        <a:pt x="374" y="1685"/>
                      </a:lnTo>
                      <a:lnTo>
                        <a:pt x="377" y="1685"/>
                      </a:lnTo>
                      <a:lnTo>
                        <a:pt x="381" y="1685"/>
                      </a:lnTo>
                      <a:lnTo>
                        <a:pt x="384" y="1686"/>
                      </a:lnTo>
                      <a:lnTo>
                        <a:pt x="387" y="1687"/>
                      </a:lnTo>
                      <a:lnTo>
                        <a:pt x="391" y="1686"/>
                      </a:lnTo>
                      <a:lnTo>
                        <a:pt x="394" y="1685"/>
                      </a:lnTo>
                      <a:lnTo>
                        <a:pt x="397" y="1687"/>
                      </a:lnTo>
                      <a:lnTo>
                        <a:pt x="401" y="1686"/>
                      </a:lnTo>
                      <a:lnTo>
                        <a:pt x="404" y="1687"/>
                      </a:lnTo>
                      <a:lnTo>
                        <a:pt x="407" y="1686"/>
                      </a:lnTo>
                      <a:lnTo>
                        <a:pt x="410" y="1688"/>
                      </a:lnTo>
                      <a:lnTo>
                        <a:pt x="414" y="1687"/>
                      </a:lnTo>
                      <a:lnTo>
                        <a:pt x="417" y="1687"/>
                      </a:lnTo>
                      <a:lnTo>
                        <a:pt x="420" y="1685"/>
                      </a:lnTo>
                      <a:lnTo>
                        <a:pt x="424" y="1686"/>
                      </a:lnTo>
                      <a:lnTo>
                        <a:pt x="427" y="1687"/>
                      </a:lnTo>
                      <a:lnTo>
                        <a:pt x="430" y="1686"/>
                      </a:lnTo>
                      <a:lnTo>
                        <a:pt x="434" y="1687"/>
                      </a:lnTo>
                      <a:lnTo>
                        <a:pt x="437" y="1688"/>
                      </a:lnTo>
                      <a:lnTo>
                        <a:pt x="440" y="1689"/>
                      </a:lnTo>
                      <a:lnTo>
                        <a:pt x="444" y="1688"/>
                      </a:lnTo>
                      <a:lnTo>
                        <a:pt x="447" y="1686"/>
                      </a:lnTo>
                      <a:lnTo>
                        <a:pt x="450" y="1687"/>
                      </a:lnTo>
                      <a:lnTo>
                        <a:pt x="453" y="1686"/>
                      </a:lnTo>
                      <a:lnTo>
                        <a:pt x="457" y="1687"/>
                      </a:lnTo>
                      <a:lnTo>
                        <a:pt x="460" y="1687"/>
                      </a:lnTo>
                      <a:lnTo>
                        <a:pt x="463" y="1687"/>
                      </a:lnTo>
                      <a:lnTo>
                        <a:pt x="467" y="1685"/>
                      </a:lnTo>
                      <a:lnTo>
                        <a:pt x="470" y="1687"/>
                      </a:lnTo>
                      <a:lnTo>
                        <a:pt x="473" y="1689"/>
                      </a:lnTo>
                      <a:lnTo>
                        <a:pt x="477" y="1687"/>
                      </a:lnTo>
                      <a:lnTo>
                        <a:pt x="480" y="1687"/>
                      </a:lnTo>
                      <a:lnTo>
                        <a:pt x="483" y="1688"/>
                      </a:lnTo>
                      <a:lnTo>
                        <a:pt x="487" y="1687"/>
                      </a:lnTo>
                      <a:lnTo>
                        <a:pt x="490" y="1688"/>
                      </a:lnTo>
                      <a:lnTo>
                        <a:pt x="493" y="1688"/>
                      </a:lnTo>
                      <a:lnTo>
                        <a:pt x="497" y="1687"/>
                      </a:lnTo>
                      <a:lnTo>
                        <a:pt x="500" y="1687"/>
                      </a:lnTo>
                      <a:lnTo>
                        <a:pt x="503" y="1687"/>
                      </a:lnTo>
                      <a:lnTo>
                        <a:pt x="506" y="1686"/>
                      </a:lnTo>
                      <a:lnTo>
                        <a:pt x="510" y="1687"/>
                      </a:lnTo>
                      <a:lnTo>
                        <a:pt x="513" y="1688"/>
                      </a:lnTo>
                      <a:lnTo>
                        <a:pt x="516" y="1686"/>
                      </a:lnTo>
                      <a:lnTo>
                        <a:pt x="520" y="1686"/>
                      </a:lnTo>
                      <a:lnTo>
                        <a:pt x="523" y="1686"/>
                      </a:lnTo>
                      <a:lnTo>
                        <a:pt x="526" y="1686"/>
                      </a:lnTo>
                      <a:lnTo>
                        <a:pt x="530" y="1687"/>
                      </a:lnTo>
                      <a:lnTo>
                        <a:pt x="533" y="1687"/>
                      </a:lnTo>
                      <a:lnTo>
                        <a:pt x="536" y="1687"/>
                      </a:lnTo>
                      <a:lnTo>
                        <a:pt x="540" y="1686"/>
                      </a:lnTo>
                      <a:lnTo>
                        <a:pt x="543" y="1685"/>
                      </a:lnTo>
                      <a:lnTo>
                        <a:pt x="546" y="1686"/>
                      </a:lnTo>
                      <a:lnTo>
                        <a:pt x="550" y="1685"/>
                      </a:lnTo>
                      <a:lnTo>
                        <a:pt x="553" y="1686"/>
                      </a:lnTo>
                      <a:lnTo>
                        <a:pt x="556" y="1686"/>
                      </a:lnTo>
                      <a:lnTo>
                        <a:pt x="559" y="1685"/>
                      </a:lnTo>
                      <a:lnTo>
                        <a:pt x="563" y="1684"/>
                      </a:lnTo>
                      <a:lnTo>
                        <a:pt x="566" y="1686"/>
                      </a:lnTo>
                      <a:lnTo>
                        <a:pt x="569" y="1685"/>
                      </a:lnTo>
                      <a:lnTo>
                        <a:pt x="573" y="1686"/>
                      </a:lnTo>
                      <a:lnTo>
                        <a:pt x="576" y="1686"/>
                      </a:lnTo>
                      <a:lnTo>
                        <a:pt x="579" y="1684"/>
                      </a:lnTo>
                      <a:lnTo>
                        <a:pt x="582" y="1684"/>
                      </a:lnTo>
                      <a:lnTo>
                        <a:pt x="586" y="1684"/>
                      </a:lnTo>
                      <a:lnTo>
                        <a:pt x="589" y="1684"/>
                      </a:lnTo>
                      <a:lnTo>
                        <a:pt x="593" y="1685"/>
                      </a:lnTo>
                      <a:lnTo>
                        <a:pt x="596" y="1686"/>
                      </a:lnTo>
                      <a:lnTo>
                        <a:pt x="599" y="1685"/>
                      </a:lnTo>
                      <a:lnTo>
                        <a:pt x="602" y="1683"/>
                      </a:lnTo>
                      <a:lnTo>
                        <a:pt x="606" y="1684"/>
                      </a:lnTo>
                      <a:lnTo>
                        <a:pt x="609" y="1684"/>
                      </a:lnTo>
                      <a:lnTo>
                        <a:pt x="612" y="1683"/>
                      </a:lnTo>
                      <a:lnTo>
                        <a:pt x="616" y="1684"/>
                      </a:lnTo>
                      <a:lnTo>
                        <a:pt x="619" y="1685"/>
                      </a:lnTo>
                      <a:lnTo>
                        <a:pt x="622" y="1683"/>
                      </a:lnTo>
                      <a:lnTo>
                        <a:pt x="625" y="1684"/>
                      </a:lnTo>
                      <a:lnTo>
                        <a:pt x="629" y="1686"/>
                      </a:lnTo>
                      <a:lnTo>
                        <a:pt x="632" y="1686"/>
                      </a:lnTo>
                      <a:lnTo>
                        <a:pt x="635" y="1686"/>
                      </a:lnTo>
                      <a:lnTo>
                        <a:pt x="639" y="1686"/>
                      </a:lnTo>
                      <a:lnTo>
                        <a:pt x="642" y="1686"/>
                      </a:lnTo>
                      <a:lnTo>
                        <a:pt x="645" y="1684"/>
                      </a:lnTo>
                      <a:lnTo>
                        <a:pt x="649" y="1685"/>
                      </a:lnTo>
                      <a:lnTo>
                        <a:pt x="652" y="1685"/>
                      </a:lnTo>
                      <a:lnTo>
                        <a:pt x="655" y="1684"/>
                      </a:lnTo>
                      <a:lnTo>
                        <a:pt x="659" y="1687"/>
                      </a:lnTo>
                      <a:lnTo>
                        <a:pt x="662" y="1686"/>
                      </a:lnTo>
                      <a:lnTo>
                        <a:pt x="665" y="1687"/>
                      </a:lnTo>
                      <a:lnTo>
                        <a:pt x="669" y="1685"/>
                      </a:lnTo>
                      <a:lnTo>
                        <a:pt x="672" y="1685"/>
                      </a:lnTo>
                      <a:lnTo>
                        <a:pt x="675" y="1685"/>
                      </a:lnTo>
                      <a:lnTo>
                        <a:pt x="678" y="1685"/>
                      </a:lnTo>
                      <a:lnTo>
                        <a:pt x="682" y="1687"/>
                      </a:lnTo>
                      <a:lnTo>
                        <a:pt x="685" y="1686"/>
                      </a:lnTo>
                      <a:lnTo>
                        <a:pt x="688" y="1686"/>
                      </a:lnTo>
                      <a:lnTo>
                        <a:pt x="692" y="1684"/>
                      </a:lnTo>
                      <a:lnTo>
                        <a:pt x="695" y="1686"/>
                      </a:lnTo>
                      <a:lnTo>
                        <a:pt x="698" y="1685"/>
                      </a:lnTo>
                      <a:lnTo>
                        <a:pt x="702" y="1685"/>
                      </a:lnTo>
                      <a:lnTo>
                        <a:pt x="705" y="1686"/>
                      </a:lnTo>
                      <a:lnTo>
                        <a:pt x="708" y="1686"/>
                      </a:lnTo>
                      <a:lnTo>
                        <a:pt x="712" y="1685"/>
                      </a:lnTo>
                      <a:lnTo>
                        <a:pt x="715" y="1686"/>
                      </a:lnTo>
                      <a:lnTo>
                        <a:pt x="718" y="1686"/>
                      </a:lnTo>
                      <a:lnTo>
                        <a:pt x="722" y="1686"/>
                      </a:lnTo>
                      <a:lnTo>
                        <a:pt x="725" y="1686"/>
                      </a:lnTo>
                      <a:lnTo>
                        <a:pt x="728" y="1687"/>
                      </a:lnTo>
                      <a:lnTo>
                        <a:pt x="731" y="1687"/>
                      </a:lnTo>
                      <a:lnTo>
                        <a:pt x="735" y="1687"/>
                      </a:lnTo>
                      <a:lnTo>
                        <a:pt x="738" y="1686"/>
                      </a:lnTo>
                      <a:lnTo>
                        <a:pt x="741" y="1687"/>
                      </a:lnTo>
                      <a:lnTo>
                        <a:pt x="745" y="1688"/>
                      </a:lnTo>
                      <a:lnTo>
                        <a:pt x="748" y="1685"/>
                      </a:lnTo>
                      <a:lnTo>
                        <a:pt x="751" y="1686"/>
                      </a:lnTo>
                      <a:lnTo>
                        <a:pt x="755" y="1687"/>
                      </a:lnTo>
                      <a:lnTo>
                        <a:pt x="758" y="1686"/>
                      </a:lnTo>
                      <a:lnTo>
                        <a:pt x="761" y="1686"/>
                      </a:lnTo>
                      <a:lnTo>
                        <a:pt x="765" y="1686"/>
                      </a:lnTo>
                      <a:lnTo>
                        <a:pt x="768" y="1686"/>
                      </a:lnTo>
                      <a:lnTo>
                        <a:pt x="771" y="1686"/>
                      </a:lnTo>
                      <a:lnTo>
                        <a:pt x="774" y="1686"/>
                      </a:lnTo>
                      <a:lnTo>
                        <a:pt x="778" y="1688"/>
                      </a:lnTo>
                      <a:lnTo>
                        <a:pt x="781" y="1687"/>
                      </a:lnTo>
                      <a:lnTo>
                        <a:pt x="784" y="1687"/>
                      </a:lnTo>
                      <a:lnTo>
                        <a:pt x="788" y="1686"/>
                      </a:lnTo>
                      <a:lnTo>
                        <a:pt x="791" y="1686"/>
                      </a:lnTo>
                      <a:lnTo>
                        <a:pt x="794" y="1688"/>
                      </a:lnTo>
                      <a:lnTo>
                        <a:pt x="798" y="1686"/>
                      </a:lnTo>
                      <a:lnTo>
                        <a:pt x="801" y="1687"/>
                      </a:lnTo>
                      <a:lnTo>
                        <a:pt x="804" y="1687"/>
                      </a:lnTo>
                      <a:lnTo>
                        <a:pt x="808" y="1687"/>
                      </a:lnTo>
                      <a:lnTo>
                        <a:pt x="811" y="1687"/>
                      </a:lnTo>
                      <a:lnTo>
                        <a:pt x="814" y="1687"/>
                      </a:lnTo>
                      <a:lnTo>
                        <a:pt x="818" y="1687"/>
                      </a:lnTo>
                      <a:lnTo>
                        <a:pt x="821" y="1685"/>
                      </a:lnTo>
                      <a:lnTo>
                        <a:pt x="824" y="1688"/>
                      </a:lnTo>
                      <a:lnTo>
                        <a:pt x="827" y="1686"/>
                      </a:lnTo>
                      <a:lnTo>
                        <a:pt x="831" y="1686"/>
                      </a:lnTo>
                      <a:lnTo>
                        <a:pt x="834" y="1687"/>
                      </a:lnTo>
                      <a:lnTo>
                        <a:pt x="837" y="1687"/>
                      </a:lnTo>
                      <a:lnTo>
                        <a:pt x="841" y="1687"/>
                      </a:lnTo>
                      <a:lnTo>
                        <a:pt x="844" y="1687"/>
                      </a:lnTo>
                      <a:lnTo>
                        <a:pt x="847" y="1688"/>
                      </a:lnTo>
                      <a:lnTo>
                        <a:pt x="850" y="1687"/>
                      </a:lnTo>
                      <a:lnTo>
                        <a:pt x="854" y="1686"/>
                      </a:lnTo>
                      <a:lnTo>
                        <a:pt x="857" y="1687"/>
                      </a:lnTo>
                      <a:lnTo>
                        <a:pt x="861" y="1685"/>
                      </a:lnTo>
                      <a:lnTo>
                        <a:pt x="864" y="1686"/>
                      </a:lnTo>
                      <a:lnTo>
                        <a:pt x="867" y="1686"/>
                      </a:lnTo>
                      <a:lnTo>
                        <a:pt x="871" y="1686"/>
                      </a:lnTo>
                      <a:lnTo>
                        <a:pt x="874" y="1686"/>
                      </a:lnTo>
                      <a:lnTo>
                        <a:pt x="877" y="1685"/>
                      </a:lnTo>
                      <a:lnTo>
                        <a:pt x="880" y="1687"/>
                      </a:lnTo>
                      <a:lnTo>
                        <a:pt x="884" y="1687"/>
                      </a:lnTo>
                      <a:lnTo>
                        <a:pt x="887" y="1686"/>
                      </a:lnTo>
                      <a:lnTo>
                        <a:pt x="890" y="1687"/>
                      </a:lnTo>
                      <a:lnTo>
                        <a:pt x="894" y="1685"/>
                      </a:lnTo>
                      <a:lnTo>
                        <a:pt x="897" y="1688"/>
                      </a:lnTo>
                      <a:lnTo>
                        <a:pt x="900" y="1687"/>
                      </a:lnTo>
                      <a:lnTo>
                        <a:pt x="903" y="1686"/>
                      </a:lnTo>
                      <a:lnTo>
                        <a:pt x="907" y="1686"/>
                      </a:lnTo>
                      <a:lnTo>
                        <a:pt x="910" y="1688"/>
                      </a:lnTo>
                      <a:lnTo>
                        <a:pt x="913" y="1687"/>
                      </a:lnTo>
                      <a:lnTo>
                        <a:pt x="917" y="1687"/>
                      </a:lnTo>
                      <a:lnTo>
                        <a:pt x="920" y="1686"/>
                      </a:lnTo>
                      <a:lnTo>
                        <a:pt x="923" y="1688"/>
                      </a:lnTo>
                      <a:lnTo>
                        <a:pt x="927" y="1685"/>
                      </a:lnTo>
                      <a:lnTo>
                        <a:pt x="930" y="1686"/>
                      </a:lnTo>
                      <a:lnTo>
                        <a:pt x="933" y="1685"/>
                      </a:lnTo>
                      <a:lnTo>
                        <a:pt x="937" y="1686"/>
                      </a:lnTo>
                      <a:lnTo>
                        <a:pt x="940" y="1686"/>
                      </a:lnTo>
                      <a:lnTo>
                        <a:pt x="943" y="1686"/>
                      </a:lnTo>
                      <a:lnTo>
                        <a:pt x="946" y="1686"/>
                      </a:lnTo>
                      <a:lnTo>
                        <a:pt x="950" y="1687"/>
                      </a:lnTo>
                      <a:lnTo>
                        <a:pt x="953" y="1687"/>
                      </a:lnTo>
                      <a:lnTo>
                        <a:pt x="956" y="1687"/>
                      </a:lnTo>
                      <a:lnTo>
                        <a:pt x="960" y="1686"/>
                      </a:lnTo>
                      <a:lnTo>
                        <a:pt x="963" y="1688"/>
                      </a:lnTo>
                      <a:lnTo>
                        <a:pt x="966" y="1687"/>
                      </a:lnTo>
                      <a:lnTo>
                        <a:pt x="970" y="1687"/>
                      </a:lnTo>
                      <a:lnTo>
                        <a:pt x="973" y="1687"/>
                      </a:lnTo>
                      <a:lnTo>
                        <a:pt x="976" y="1687"/>
                      </a:lnTo>
                      <a:lnTo>
                        <a:pt x="980" y="1688"/>
                      </a:lnTo>
                      <a:lnTo>
                        <a:pt x="983" y="1686"/>
                      </a:lnTo>
                      <a:lnTo>
                        <a:pt x="986" y="1687"/>
                      </a:lnTo>
                      <a:lnTo>
                        <a:pt x="990" y="1686"/>
                      </a:lnTo>
                      <a:lnTo>
                        <a:pt x="993" y="1686"/>
                      </a:lnTo>
                      <a:lnTo>
                        <a:pt x="996" y="1688"/>
                      </a:lnTo>
                      <a:lnTo>
                        <a:pt x="999" y="1687"/>
                      </a:lnTo>
                      <a:lnTo>
                        <a:pt x="1003" y="1687"/>
                      </a:lnTo>
                      <a:lnTo>
                        <a:pt x="1006" y="1687"/>
                      </a:lnTo>
                      <a:lnTo>
                        <a:pt x="1009" y="1686"/>
                      </a:lnTo>
                      <a:lnTo>
                        <a:pt x="1013" y="1688"/>
                      </a:lnTo>
                      <a:lnTo>
                        <a:pt x="1016" y="1687"/>
                      </a:lnTo>
                      <a:lnTo>
                        <a:pt x="1019" y="1687"/>
                      </a:lnTo>
                      <a:lnTo>
                        <a:pt x="1023" y="1687"/>
                      </a:lnTo>
                      <a:lnTo>
                        <a:pt x="1026" y="1685"/>
                      </a:lnTo>
                      <a:lnTo>
                        <a:pt x="1029" y="1686"/>
                      </a:lnTo>
                      <a:lnTo>
                        <a:pt x="1033" y="1687"/>
                      </a:lnTo>
                      <a:lnTo>
                        <a:pt x="1036" y="1685"/>
                      </a:lnTo>
                      <a:lnTo>
                        <a:pt x="1039" y="1684"/>
                      </a:lnTo>
                      <a:lnTo>
                        <a:pt x="1043" y="1686"/>
                      </a:lnTo>
                      <a:lnTo>
                        <a:pt x="1046" y="1685"/>
                      </a:lnTo>
                      <a:lnTo>
                        <a:pt x="1049" y="1685"/>
                      </a:lnTo>
                      <a:lnTo>
                        <a:pt x="1052" y="1687"/>
                      </a:lnTo>
                      <a:lnTo>
                        <a:pt x="1056" y="1685"/>
                      </a:lnTo>
                      <a:lnTo>
                        <a:pt x="1059" y="1684"/>
                      </a:lnTo>
                      <a:lnTo>
                        <a:pt x="1062" y="1686"/>
                      </a:lnTo>
                      <a:lnTo>
                        <a:pt x="1066" y="1685"/>
                      </a:lnTo>
                      <a:lnTo>
                        <a:pt x="1069" y="1684"/>
                      </a:lnTo>
                      <a:lnTo>
                        <a:pt x="1072" y="1685"/>
                      </a:lnTo>
                      <a:lnTo>
                        <a:pt x="1076" y="1685"/>
                      </a:lnTo>
                      <a:lnTo>
                        <a:pt x="1079" y="1684"/>
                      </a:lnTo>
                      <a:lnTo>
                        <a:pt x="1082" y="1685"/>
                      </a:lnTo>
                      <a:lnTo>
                        <a:pt x="1086" y="1685"/>
                      </a:lnTo>
                      <a:lnTo>
                        <a:pt x="1089" y="1685"/>
                      </a:lnTo>
                      <a:lnTo>
                        <a:pt x="1092" y="1685"/>
                      </a:lnTo>
                      <a:lnTo>
                        <a:pt x="1095" y="1686"/>
                      </a:lnTo>
                      <a:lnTo>
                        <a:pt x="1099" y="1684"/>
                      </a:lnTo>
                      <a:lnTo>
                        <a:pt x="1102" y="1686"/>
                      </a:lnTo>
                      <a:lnTo>
                        <a:pt x="1105" y="1685"/>
                      </a:lnTo>
                      <a:lnTo>
                        <a:pt x="1109" y="1685"/>
                      </a:lnTo>
                      <a:lnTo>
                        <a:pt x="1112" y="1685"/>
                      </a:lnTo>
                      <a:lnTo>
                        <a:pt x="1115" y="1686"/>
                      </a:lnTo>
                      <a:lnTo>
                        <a:pt x="1118" y="1684"/>
                      </a:lnTo>
                      <a:lnTo>
                        <a:pt x="1122" y="1684"/>
                      </a:lnTo>
                      <a:lnTo>
                        <a:pt x="1125" y="1685"/>
                      </a:lnTo>
                      <a:lnTo>
                        <a:pt x="1129" y="1685"/>
                      </a:lnTo>
                      <a:lnTo>
                        <a:pt x="1132" y="1683"/>
                      </a:lnTo>
                      <a:lnTo>
                        <a:pt x="1135" y="1685"/>
                      </a:lnTo>
                      <a:lnTo>
                        <a:pt x="1139" y="1685"/>
                      </a:lnTo>
                      <a:lnTo>
                        <a:pt x="1142" y="1685"/>
                      </a:lnTo>
                      <a:lnTo>
                        <a:pt x="1145" y="1685"/>
                      </a:lnTo>
                      <a:lnTo>
                        <a:pt x="1148" y="1685"/>
                      </a:lnTo>
                      <a:lnTo>
                        <a:pt x="1152" y="1685"/>
                      </a:lnTo>
                      <a:lnTo>
                        <a:pt x="1155" y="1685"/>
                      </a:lnTo>
                      <a:lnTo>
                        <a:pt x="1158" y="1683"/>
                      </a:lnTo>
                      <a:lnTo>
                        <a:pt x="1162" y="1684"/>
                      </a:lnTo>
                      <a:lnTo>
                        <a:pt x="1165" y="1684"/>
                      </a:lnTo>
                      <a:lnTo>
                        <a:pt x="1168" y="1685"/>
                      </a:lnTo>
                      <a:lnTo>
                        <a:pt x="1171" y="1685"/>
                      </a:lnTo>
                      <a:lnTo>
                        <a:pt x="1175" y="1684"/>
                      </a:lnTo>
                      <a:lnTo>
                        <a:pt x="1178" y="1685"/>
                      </a:lnTo>
                      <a:lnTo>
                        <a:pt x="1181" y="1684"/>
                      </a:lnTo>
                      <a:lnTo>
                        <a:pt x="1185" y="1685"/>
                      </a:lnTo>
                      <a:lnTo>
                        <a:pt x="1188" y="1682"/>
                      </a:lnTo>
                      <a:lnTo>
                        <a:pt x="1191" y="1684"/>
                      </a:lnTo>
                      <a:lnTo>
                        <a:pt x="1195" y="1686"/>
                      </a:lnTo>
                      <a:lnTo>
                        <a:pt x="1198" y="1685"/>
                      </a:lnTo>
                      <a:lnTo>
                        <a:pt x="1201" y="1684"/>
                      </a:lnTo>
                      <a:lnTo>
                        <a:pt x="1205" y="1683"/>
                      </a:lnTo>
                      <a:lnTo>
                        <a:pt x="1208" y="1682"/>
                      </a:lnTo>
                      <a:lnTo>
                        <a:pt x="1211" y="1683"/>
                      </a:lnTo>
                      <a:lnTo>
                        <a:pt x="1215" y="1683"/>
                      </a:lnTo>
                      <a:lnTo>
                        <a:pt x="1218" y="1684"/>
                      </a:lnTo>
                      <a:lnTo>
                        <a:pt x="1221" y="1685"/>
                      </a:lnTo>
                      <a:lnTo>
                        <a:pt x="1224" y="1684"/>
                      </a:lnTo>
                      <a:lnTo>
                        <a:pt x="1228" y="1685"/>
                      </a:lnTo>
                      <a:lnTo>
                        <a:pt x="1231" y="1685"/>
                      </a:lnTo>
                      <a:lnTo>
                        <a:pt x="1234" y="1685"/>
                      </a:lnTo>
                      <a:lnTo>
                        <a:pt x="1238" y="1684"/>
                      </a:lnTo>
                      <a:lnTo>
                        <a:pt x="1241" y="1685"/>
                      </a:lnTo>
                      <a:lnTo>
                        <a:pt x="1244" y="1684"/>
                      </a:lnTo>
                      <a:lnTo>
                        <a:pt x="1248" y="1684"/>
                      </a:lnTo>
                      <a:lnTo>
                        <a:pt x="1251" y="1685"/>
                      </a:lnTo>
                      <a:lnTo>
                        <a:pt x="1254" y="1685"/>
                      </a:lnTo>
                      <a:lnTo>
                        <a:pt x="1258" y="1686"/>
                      </a:lnTo>
                      <a:lnTo>
                        <a:pt x="1261" y="1685"/>
                      </a:lnTo>
                      <a:lnTo>
                        <a:pt x="1264" y="1685"/>
                      </a:lnTo>
                      <a:lnTo>
                        <a:pt x="1267" y="1686"/>
                      </a:lnTo>
                      <a:lnTo>
                        <a:pt x="1271" y="1687"/>
                      </a:lnTo>
                      <a:lnTo>
                        <a:pt x="1274" y="1686"/>
                      </a:lnTo>
                      <a:lnTo>
                        <a:pt x="1277" y="1686"/>
                      </a:lnTo>
                      <a:lnTo>
                        <a:pt x="1281" y="1685"/>
                      </a:lnTo>
                      <a:lnTo>
                        <a:pt x="1284" y="1685"/>
                      </a:lnTo>
                      <a:lnTo>
                        <a:pt x="1287" y="1685"/>
                      </a:lnTo>
                      <a:lnTo>
                        <a:pt x="1291" y="1685"/>
                      </a:lnTo>
                      <a:lnTo>
                        <a:pt x="1294" y="1686"/>
                      </a:lnTo>
                      <a:lnTo>
                        <a:pt x="1297" y="1685"/>
                      </a:lnTo>
                      <a:lnTo>
                        <a:pt x="1301" y="1685"/>
                      </a:lnTo>
                      <a:lnTo>
                        <a:pt x="1304" y="1686"/>
                      </a:lnTo>
                      <a:lnTo>
                        <a:pt x="1307" y="1685"/>
                      </a:lnTo>
                      <a:lnTo>
                        <a:pt x="1311" y="1686"/>
                      </a:lnTo>
                      <a:lnTo>
                        <a:pt x="1314" y="1685"/>
                      </a:lnTo>
                      <a:lnTo>
                        <a:pt x="1317" y="1687"/>
                      </a:lnTo>
                      <a:lnTo>
                        <a:pt x="1320" y="1685"/>
                      </a:lnTo>
                      <a:lnTo>
                        <a:pt x="1324" y="1685"/>
                      </a:lnTo>
                      <a:lnTo>
                        <a:pt x="1327" y="1687"/>
                      </a:lnTo>
                      <a:lnTo>
                        <a:pt x="1330" y="1685"/>
                      </a:lnTo>
                      <a:lnTo>
                        <a:pt x="1334" y="1684"/>
                      </a:lnTo>
                      <a:lnTo>
                        <a:pt x="1337" y="1685"/>
                      </a:lnTo>
                      <a:lnTo>
                        <a:pt x="1340" y="1684"/>
                      </a:lnTo>
                      <a:lnTo>
                        <a:pt x="1344" y="1685"/>
                      </a:lnTo>
                      <a:lnTo>
                        <a:pt x="1347" y="1685"/>
                      </a:lnTo>
                      <a:lnTo>
                        <a:pt x="1350" y="1684"/>
                      </a:lnTo>
                      <a:lnTo>
                        <a:pt x="1354" y="1685"/>
                      </a:lnTo>
                      <a:lnTo>
                        <a:pt x="1357" y="1685"/>
                      </a:lnTo>
                      <a:lnTo>
                        <a:pt x="1360" y="1684"/>
                      </a:lnTo>
                      <a:lnTo>
                        <a:pt x="1363" y="1685"/>
                      </a:lnTo>
                      <a:lnTo>
                        <a:pt x="1367" y="1685"/>
                      </a:lnTo>
                      <a:lnTo>
                        <a:pt x="1370" y="1684"/>
                      </a:lnTo>
                      <a:lnTo>
                        <a:pt x="1373" y="1684"/>
                      </a:lnTo>
                      <a:lnTo>
                        <a:pt x="1377" y="1684"/>
                      </a:lnTo>
                      <a:lnTo>
                        <a:pt x="1380" y="1685"/>
                      </a:lnTo>
                      <a:lnTo>
                        <a:pt x="1383" y="1683"/>
                      </a:lnTo>
                      <a:lnTo>
                        <a:pt x="1387" y="1684"/>
                      </a:lnTo>
                      <a:lnTo>
                        <a:pt x="1390" y="1684"/>
                      </a:lnTo>
                      <a:lnTo>
                        <a:pt x="1393" y="1684"/>
                      </a:lnTo>
                      <a:lnTo>
                        <a:pt x="1397" y="1686"/>
                      </a:lnTo>
                      <a:lnTo>
                        <a:pt x="1400" y="1682"/>
                      </a:lnTo>
                      <a:lnTo>
                        <a:pt x="1403" y="1685"/>
                      </a:lnTo>
                      <a:lnTo>
                        <a:pt x="1407" y="1686"/>
                      </a:lnTo>
                      <a:lnTo>
                        <a:pt x="1410" y="1684"/>
                      </a:lnTo>
                      <a:lnTo>
                        <a:pt x="1413" y="1685"/>
                      </a:lnTo>
                      <a:lnTo>
                        <a:pt x="1416" y="1683"/>
                      </a:lnTo>
                      <a:lnTo>
                        <a:pt x="1420" y="1683"/>
                      </a:lnTo>
                      <a:lnTo>
                        <a:pt x="1423" y="1684"/>
                      </a:lnTo>
                      <a:lnTo>
                        <a:pt x="1426" y="1685"/>
                      </a:lnTo>
                      <a:lnTo>
                        <a:pt x="1430" y="1684"/>
                      </a:lnTo>
                      <a:lnTo>
                        <a:pt x="1433" y="1683"/>
                      </a:lnTo>
                      <a:lnTo>
                        <a:pt x="1436" y="1686"/>
                      </a:lnTo>
                      <a:lnTo>
                        <a:pt x="1439" y="1683"/>
                      </a:lnTo>
                      <a:lnTo>
                        <a:pt x="1443" y="1684"/>
                      </a:lnTo>
                      <a:lnTo>
                        <a:pt x="1446" y="1685"/>
                      </a:lnTo>
                      <a:lnTo>
                        <a:pt x="1449" y="1684"/>
                      </a:lnTo>
                      <a:lnTo>
                        <a:pt x="1453" y="1683"/>
                      </a:lnTo>
                      <a:lnTo>
                        <a:pt x="1456" y="1684"/>
                      </a:lnTo>
                      <a:lnTo>
                        <a:pt x="1459" y="1684"/>
                      </a:lnTo>
                      <a:lnTo>
                        <a:pt x="1463" y="1683"/>
                      </a:lnTo>
                      <a:lnTo>
                        <a:pt x="1466" y="1685"/>
                      </a:lnTo>
                      <a:lnTo>
                        <a:pt x="1469" y="1684"/>
                      </a:lnTo>
                      <a:lnTo>
                        <a:pt x="1473" y="1682"/>
                      </a:lnTo>
                      <a:lnTo>
                        <a:pt x="1476" y="1683"/>
                      </a:lnTo>
                      <a:lnTo>
                        <a:pt x="1479" y="1684"/>
                      </a:lnTo>
                      <a:lnTo>
                        <a:pt x="1483" y="1684"/>
                      </a:lnTo>
                      <a:lnTo>
                        <a:pt x="1486" y="1685"/>
                      </a:lnTo>
                      <a:lnTo>
                        <a:pt x="1489" y="1684"/>
                      </a:lnTo>
                      <a:lnTo>
                        <a:pt x="1492" y="1685"/>
                      </a:lnTo>
                      <a:lnTo>
                        <a:pt x="1496" y="1685"/>
                      </a:lnTo>
                      <a:lnTo>
                        <a:pt x="1499" y="1684"/>
                      </a:lnTo>
                      <a:lnTo>
                        <a:pt x="1502" y="1683"/>
                      </a:lnTo>
                      <a:lnTo>
                        <a:pt x="1506" y="1684"/>
                      </a:lnTo>
                      <a:lnTo>
                        <a:pt x="1509" y="1683"/>
                      </a:lnTo>
                      <a:lnTo>
                        <a:pt x="1512" y="1683"/>
                      </a:lnTo>
                      <a:lnTo>
                        <a:pt x="1516" y="1683"/>
                      </a:lnTo>
                      <a:lnTo>
                        <a:pt x="1519" y="1684"/>
                      </a:lnTo>
                      <a:lnTo>
                        <a:pt x="1522" y="1685"/>
                      </a:lnTo>
                      <a:lnTo>
                        <a:pt x="1526" y="1682"/>
                      </a:lnTo>
                      <a:lnTo>
                        <a:pt x="1529" y="1684"/>
                      </a:lnTo>
                      <a:lnTo>
                        <a:pt x="1532" y="1683"/>
                      </a:lnTo>
                      <a:lnTo>
                        <a:pt x="1535" y="1683"/>
                      </a:lnTo>
                      <a:lnTo>
                        <a:pt x="1539" y="1684"/>
                      </a:lnTo>
                      <a:lnTo>
                        <a:pt x="1542" y="1685"/>
                      </a:lnTo>
                      <a:lnTo>
                        <a:pt x="1545" y="1684"/>
                      </a:lnTo>
                      <a:lnTo>
                        <a:pt x="1549" y="1684"/>
                      </a:lnTo>
                      <a:lnTo>
                        <a:pt x="1552" y="1684"/>
                      </a:lnTo>
                      <a:lnTo>
                        <a:pt x="1555" y="1684"/>
                      </a:lnTo>
                      <a:lnTo>
                        <a:pt x="1559" y="1685"/>
                      </a:lnTo>
                      <a:lnTo>
                        <a:pt x="1562" y="1685"/>
                      </a:lnTo>
                      <a:lnTo>
                        <a:pt x="1565" y="1685"/>
                      </a:lnTo>
                      <a:lnTo>
                        <a:pt x="1569" y="1685"/>
                      </a:lnTo>
                      <a:lnTo>
                        <a:pt x="1572" y="1683"/>
                      </a:lnTo>
                      <a:lnTo>
                        <a:pt x="1575" y="1683"/>
                      </a:lnTo>
                      <a:lnTo>
                        <a:pt x="1579" y="1684"/>
                      </a:lnTo>
                      <a:lnTo>
                        <a:pt x="1582" y="1684"/>
                      </a:lnTo>
                      <a:lnTo>
                        <a:pt x="1585" y="1685"/>
                      </a:lnTo>
                      <a:lnTo>
                        <a:pt x="1588" y="1684"/>
                      </a:lnTo>
                      <a:lnTo>
                        <a:pt x="1592" y="1683"/>
                      </a:lnTo>
                      <a:lnTo>
                        <a:pt x="1595" y="1683"/>
                      </a:lnTo>
                      <a:lnTo>
                        <a:pt x="1598" y="1683"/>
                      </a:lnTo>
                      <a:lnTo>
                        <a:pt x="1602" y="1685"/>
                      </a:lnTo>
                      <a:lnTo>
                        <a:pt x="1605" y="1684"/>
                      </a:lnTo>
                      <a:lnTo>
                        <a:pt x="1608" y="1683"/>
                      </a:lnTo>
                      <a:lnTo>
                        <a:pt x="1612" y="1683"/>
                      </a:lnTo>
                      <a:lnTo>
                        <a:pt x="1615" y="1685"/>
                      </a:lnTo>
                      <a:lnTo>
                        <a:pt x="1618" y="1685"/>
                      </a:lnTo>
                      <a:lnTo>
                        <a:pt x="1622" y="1686"/>
                      </a:lnTo>
                      <a:lnTo>
                        <a:pt x="1625" y="1683"/>
                      </a:lnTo>
                      <a:lnTo>
                        <a:pt x="1628" y="1684"/>
                      </a:lnTo>
                      <a:lnTo>
                        <a:pt x="1632" y="1685"/>
                      </a:lnTo>
                      <a:lnTo>
                        <a:pt x="1635" y="1685"/>
                      </a:lnTo>
                      <a:lnTo>
                        <a:pt x="1638" y="1685"/>
                      </a:lnTo>
                      <a:lnTo>
                        <a:pt x="1641" y="1684"/>
                      </a:lnTo>
                      <a:lnTo>
                        <a:pt x="1645" y="1684"/>
                      </a:lnTo>
                      <a:lnTo>
                        <a:pt x="1648" y="1684"/>
                      </a:lnTo>
                      <a:lnTo>
                        <a:pt x="1651" y="1684"/>
                      </a:lnTo>
                      <a:lnTo>
                        <a:pt x="1655" y="1684"/>
                      </a:lnTo>
                      <a:lnTo>
                        <a:pt x="1658" y="1684"/>
                      </a:lnTo>
                      <a:lnTo>
                        <a:pt x="1661" y="1685"/>
                      </a:lnTo>
                      <a:lnTo>
                        <a:pt x="1665" y="1684"/>
                      </a:lnTo>
                      <a:lnTo>
                        <a:pt x="1668" y="1685"/>
                      </a:lnTo>
                      <a:lnTo>
                        <a:pt x="1671" y="1684"/>
                      </a:lnTo>
                      <a:lnTo>
                        <a:pt x="1675" y="1683"/>
                      </a:lnTo>
                      <a:lnTo>
                        <a:pt x="1678" y="1683"/>
                      </a:lnTo>
                      <a:lnTo>
                        <a:pt x="1681" y="1684"/>
                      </a:lnTo>
                      <a:lnTo>
                        <a:pt x="1684" y="1684"/>
                      </a:lnTo>
                      <a:lnTo>
                        <a:pt x="1688" y="1684"/>
                      </a:lnTo>
                      <a:lnTo>
                        <a:pt x="1691" y="1684"/>
                      </a:lnTo>
                      <a:lnTo>
                        <a:pt x="1694" y="1684"/>
                      </a:lnTo>
                      <a:lnTo>
                        <a:pt x="1698" y="1684"/>
                      </a:lnTo>
                      <a:lnTo>
                        <a:pt x="1701" y="1681"/>
                      </a:lnTo>
                      <a:lnTo>
                        <a:pt x="1704" y="1685"/>
                      </a:lnTo>
                      <a:lnTo>
                        <a:pt x="1707" y="1684"/>
                      </a:lnTo>
                      <a:lnTo>
                        <a:pt x="1711" y="1683"/>
                      </a:lnTo>
                      <a:lnTo>
                        <a:pt x="1714" y="1683"/>
                      </a:lnTo>
                      <a:lnTo>
                        <a:pt x="1717" y="1683"/>
                      </a:lnTo>
                      <a:lnTo>
                        <a:pt x="1721" y="1682"/>
                      </a:lnTo>
                      <a:lnTo>
                        <a:pt x="1724" y="1683"/>
                      </a:lnTo>
                      <a:lnTo>
                        <a:pt x="1727" y="1683"/>
                      </a:lnTo>
                      <a:lnTo>
                        <a:pt x="1731" y="1684"/>
                      </a:lnTo>
                      <a:lnTo>
                        <a:pt x="1734" y="1682"/>
                      </a:lnTo>
                      <a:lnTo>
                        <a:pt x="1737" y="1683"/>
                      </a:lnTo>
                      <a:lnTo>
                        <a:pt x="1741" y="1682"/>
                      </a:lnTo>
                      <a:lnTo>
                        <a:pt x="1744" y="1683"/>
                      </a:lnTo>
                      <a:lnTo>
                        <a:pt x="1747" y="1683"/>
                      </a:lnTo>
                      <a:lnTo>
                        <a:pt x="1751" y="1683"/>
                      </a:lnTo>
                      <a:lnTo>
                        <a:pt x="1754" y="1683"/>
                      </a:lnTo>
                      <a:lnTo>
                        <a:pt x="1757" y="1683"/>
                      </a:lnTo>
                      <a:lnTo>
                        <a:pt x="1760" y="1683"/>
                      </a:lnTo>
                      <a:lnTo>
                        <a:pt x="1764" y="1683"/>
                      </a:lnTo>
                      <a:lnTo>
                        <a:pt x="1767" y="1683"/>
                      </a:lnTo>
                      <a:lnTo>
                        <a:pt x="1770" y="1684"/>
                      </a:lnTo>
                      <a:lnTo>
                        <a:pt x="1774" y="1683"/>
                      </a:lnTo>
                      <a:lnTo>
                        <a:pt x="1777" y="1684"/>
                      </a:lnTo>
                      <a:lnTo>
                        <a:pt x="1780" y="1683"/>
                      </a:lnTo>
                      <a:lnTo>
                        <a:pt x="1784" y="1683"/>
                      </a:lnTo>
                      <a:lnTo>
                        <a:pt x="1787" y="1683"/>
                      </a:lnTo>
                      <a:lnTo>
                        <a:pt x="1790" y="1682"/>
                      </a:lnTo>
                      <a:lnTo>
                        <a:pt x="1794" y="1683"/>
                      </a:lnTo>
                      <a:lnTo>
                        <a:pt x="1797" y="1683"/>
                      </a:lnTo>
                      <a:lnTo>
                        <a:pt x="1800" y="1682"/>
                      </a:lnTo>
                      <a:lnTo>
                        <a:pt x="1804" y="1683"/>
                      </a:lnTo>
                      <a:lnTo>
                        <a:pt x="1807" y="1681"/>
                      </a:lnTo>
                      <a:lnTo>
                        <a:pt x="1810" y="1681"/>
                      </a:lnTo>
                      <a:lnTo>
                        <a:pt x="1813" y="1681"/>
                      </a:lnTo>
                      <a:lnTo>
                        <a:pt x="1817" y="1681"/>
                      </a:lnTo>
                      <a:lnTo>
                        <a:pt x="1820" y="1683"/>
                      </a:lnTo>
                      <a:lnTo>
                        <a:pt x="1823" y="1682"/>
                      </a:lnTo>
                      <a:lnTo>
                        <a:pt x="1827" y="1683"/>
                      </a:lnTo>
                      <a:lnTo>
                        <a:pt x="1830" y="1681"/>
                      </a:lnTo>
                      <a:lnTo>
                        <a:pt x="1833" y="1682"/>
                      </a:lnTo>
                      <a:lnTo>
                        <a:pt x="1837" y="1682"/>
                      </a:lnTo>
                      <a:lnTo>
                        <a:pt x="1840" y="1682"/>
                      </a:lnTo>
                      <a:lnTo>
                        <a:pt x="1843" y="1682"/>
                      </a:lnTo>
                      <a:lnTo>
                        <a:pt x="1847" y="1682"/>
                      </a:lnTo>
                      <a:lnTo>
                        <a:pt x="1850" y="1681"/>
                      </a:lnTo>
                      <a:lnTo>
                        <a:pt x="1853" y="1680"/>
                      </a:lnTo>
                      <a:lnTo>
                        <a:pt x="1856" y="1680"/>
                      </a:lnTo>
                      <a:lnTo>
                        <a:pt x="1860" y="1682"/>
                      </a:lnTo>
                      <a:lnTo>
                        <a:pt x="1863" y="1680"/>
                      </a:lnTo>
                      <a:lnTo>
                        <a:pt x="1866" y="1681"/>
                      </a:lnTo>
                      <a:lnTo>
                        <a:pt x="1870" y="1681"/>
                      </a:lnTo>
                      <a:lnTo>
                        <a:pt x="1873" y="1681"/>
                      </a:lnTo>
                      <a:lnTo>
                        <a:pt x="1876" y="1681"/>
                      </a:lnTo>
                      <a:lnTo>
                        <a:pt x="1880" y="1682"/>
                      </a:lnTo>
                      <a:lnTo>
                        <a:pt x="1883" y="1681"/>
                      </a:lnTo>
                      <a:lnTo>
                        <a:pt x="1886" y="1680"/>
                      </a:lnTo>
                      <a:lnTo>
                        <a:pt x="1890" y="1680"/>
                      </a:lnTo>
                      <a:lnTo>
                        <a:pt x="1893" y="1679"/>
                      </a:lnTo>
                      <a:lnTo>
                        <a:pt x="1896" y="1679"/>
                      </a:lnTo>
                      <a:lnTo>
                        <a:pt x="1900" y="1678"/>
                      </a:lnTo>
                      <a:lnTo>
                        <a:pt x="1903" y="1680"/>
                      </a:lnTo>
                      <a:lnTo>
                        <a:pt x="1906" y="1679"/>
                      </a:lnTo>
                      <a:lnTo>
                        <a:pt x="1909" y="1679"/>
                      </a:lnTo>
                      <a:lnTo>
                        <a:pt x="1913" y="1680"/>
                      </a:lnTo>
                      <a:lnTo>
                        <a:pt x="1916" y="1681"/>
                      </a:lnTo>
                      <a:lnTo>
                        <a:pt x="1919" y="1680"/>
                      </a:lnTo>
                      <a:lnTo>
                        <a:pt x="1923" y="1679"/>
                      </a:lnTo>
                      <a:lnTo>
                        <a:pt x="1926" y="1680"/>
                      </a:lnTo>
                      <a:lnTo>
                        <a:pt x="1929" y="1680"/>
                      </a:lnTo>
                      <a:lnTo>
                        <a:pt x="1933" y="1680"/>
                      </a:lnTo>
                      <a:lnTo>
                        <a:pt x="1936" y="1679"/>
                      </a:lnTo>
                      <a:lnTo>
                        <a:pt x="1939" y="1679"/>
                      </a:lnTo>
                      <a:lnTo>
                        <a:pt x="1943" y="1681"/>
                      </a:lnTo>
                      <a:lnTo>
                        <a:pt x="1946" y="1682"/>
                      </a:lnTo>
                      <a:lnTo>
                        <a:pt x="1949" y="1681"/>
                      </a:lnTo>
                      <a:lnTo>
                        <a:pt x="1953" y="1682"/>
                      </a:lnTo>
                      <a:lnTo>
                        <a:pt x="1956" y="1682"/>
                      </a:lnTo>
                      <a:lnTo>
                        <a:pt x="1959" y="1681"/>
                      </a:lnTo>
                      <a:lnTo>
                        <a:pt x="1962" y="1681"/>
                      </a:lnTo>
                      <a:lnTo>
                        <a:pt x="1966" y="1680"/>
                      </a:lnTo>
                      <a:lnTo>
                        <a:pt x="1969" y="1681"/>
                      </a:lnTo>
                      <a:lnTo>
                        <a:pt x="1972" y="1680"/>
                      </a:lnTo>
                      <a:lnTo>
                        <a:pt x="1976" y="1681"/>
                      </a:lnTo>
                      <a:lnTo>
                        <a:pt x="1979" y="1679"/>
                      </a:lnTo>
                      <a:lnTo>
                        <a:pt x="1982" y="1681"/>
                      </a:lnTo>
                      <a:lnTo>
                        <a:pt x="1985" y="1682"/>
                      </a:lnTo>
                      <a:lnTo>
                        <a:pt x="1989" y="1682"/>
                      </a:lnTo>
                      <a:lnTo>
                        <a:pt x="1992" y="1682"/>
                      </a:lnTo>
                      <a:lnTo>
                        <a:pt x="1995" y="1681"/>
                      </a:lnTo>
                      <a:lnTo>
                        <a:pt x="1999" y="1682"/>
                      </a:lnTo>
                      <a:lnTo>
                        <a:pt x="2002" y="1681"/>
                      </a:lnTo>
                      <a:lnTo>
                        <a:pt x="2005" y="1681"/>
                      </a:lnTo>
                      <a:lnTo>
                        <a:pt x="2009" y="1681"/>
                      </a:lnTo>
                      <a:lnTo>
                        <a:pt x="2012" y="1681"/>
                      </a:lnTo>
                      <a:lnTo>
                        <a:pt x="2015" y="1681"/>
                      </a:lnTo>
                      <a:lnTo>
                        <a:pt x="2019" y="1681"/>
                      </a:lnTo>
                      <a:lnTo>
                        <a:pt x="2022" y="1680"/>
                      </a:lnTo>
                      <a:lnTo>
                        <a:pt x="2025" y="1681"/>
                      </a:lnTo>
                      <a:lnTo>
                        <a:pt x="2028" y="1682"/>
                      </a:lnTo>
                      <a:lnTo>
                        <a:pt x="2032" y="1680"/>
                      </a:lnTo>
                      <a:lnTo>
                        <a:pt x="2035" y="1681"/>
                      </a:lnTo>
                      <a:lnTo>
                        <a:pt x="2038" y="1681"/>
                      </a:lnTo>
                      <a:lnTo>
                        <a:pt x="2042" y="1682"/>
                      </a:lnTo>
                      <a:lnTo>
                        <a:pt x="2045" y="1681"/>
                      </a:lnTo>
                      <a:lnTo>
                        <a:pt x="2048" y="1680"/>
                      </a:lnTo>
                      <a:lnTo>
                        <a:pt x="2052" y="1682"/>
                      </a:lnTo>
                      <a:lnTo>
                        <a:pt x="2055" y="1681"/>
                      </a:lnTo>
                      <a:lnTo>
                        <a:pt x="2058" y="1682"/>
                      </a:lnTo>
                      <a:lnTo>
                        <a:pt x="2062" y="1682"/>
                      </a:lnTo>
                      <a:lnTo>
                        <a:pt x="2065" y="1681"/>
                      </a:lnTo>
                      <a:lnTo>
                        <a:pt x="2068" y="1681"/>
                      </a:lnTo>
                      <a:lnTo>
                        <a:pt x="2072" y="1679"/>
                      </a:lnTo>
                      <a:lnTo>
                        <a:pt x="2075" y="1681"/>
                      </a:lnTo>
                      <a:lnTo>
                        <a:pt x="2078" y="1682"/>
                      </a:lnTo>
                      <a:lnTo>
                        <a:pt x="2081" y="1681"/>
                      </a:lnTo>
                      <a:lnTo>
                        <a:pt x="2085" y="1681"/>
                      </a:lnTo>
                      <a:lnTo>
                        <a:pt x="2088" y="1680"/>
                      </a:lnTo>
                      <a:lnTo>
                        <a:pt x="2091" y="1681"/>
                      </a:lnTo>
                      <a:lnTo>
                        <a:pt x="2095" y="1681"/>
                      </a:lnTo>
                      <a:lnTo>
                        <a:pt x="2098" y="1679"/>
                      </a:lnTo>
                      <a:lnTo>
                        <a:pt x="2101" y="1679"/>
                      </a:lnTo>
                      <a:lnTo>
                        <a:pt x="2105" y="1680"/>
                      </a:lnTo>
                      <a:lnTo>
                        <a:pt x="2108" y="1678"/>
                      </a:lnTo>
                      <a:lnTo>
                        <a:pt x="2111" y="1679"/>
                      </a:lnTo>
                      <a:lnTo>
                        <a:pt x="2115" y="1680"/>
                      </a:lnTo>
                      <a:lnTo>
                        <a:pt x="2118" y="1679"/>
                      </a:lnTo>
                      <a:lnTo>
                        <a:pt x="2121" y="1678"/>
                      </a:lnTo>
                      <a:lnTo>
                        <a:pt x="2125" y="1679"/>
                      </a:lnTo>
                      <a:lnTo>
                        <a:pt x="2128" y="1680"/>
                      </a:lnTo>
                      <a:lnTo>
                        <a:pt x="2131" y="1678"/>
                      </a:lnTo>
                      <a:lnTo>
                        <a:pt x="2134" y="1676"/>
                      </a:lnTo>
                      <a:lnTo>
                        <a:pt x="2138" y="1676"/>
                      </a:lnTo>
                      <a:lnTo>
                        <a:pt x="2141" y="1677"/>
                      </a:lnTo>
                      <a:lnTo>
                        <a:pt x="2144" y="1676"/>
                      </a:lnTo>
                      <a:lnTo>
                        <a:pt x="2148" y="1676"/>
                      </a:lnTo>
                      <a:lnTo>
                        <a:pt x="2151" y="1675"/>
                      </a:lnTo>
                      <a:lnTo>
                        <a:pt x="2154" y="1674"/>
                      </a:lnTo>
                      <a:lnTo>
                        <a:pt x="2158" y="1674"/>
                      </a:lnTo>
                      <a:lnTo>
                        <a:pt x="2161" y="1674"/>
                      </a:lnTo>
                      <a:lnTo>
                        <a:pt x="2164" y="1673"/>
                      </a:lnTo>
                      <a:lnTo>
                        <a:pt x="2168" y="1672"/>
                      </a:lnTo>
                      <a:lnTo>
                        <a:pt x="2171" y="1673"/>
                      </a:lnTo>
                      <a:lnTo>
                        <a:pt x="2174" y="1673"/>
                      </a:lnTo>
                      <a:lnTo>
                        <a:pt x="2177" y="1671"/>
                      </a:lnTo>
                      <a:lnTo>
                        <a:pt x="2181" y="1672"/>
                      </a:lnTo>
                      <a:lnTo>
                        <a:pt x="2184" y="1672"/>
                      </a:lnTo>
                      <a:lnTo>
                        <a:pt x="2187" y="1671"/>
                      </a:lnTo>
                      <a:lnTo>
                        <a:pt x="2191" y="1671"/>
                      </a:lnTo>
                      <a:lnTo>
                        <a:pt x="2194" y="1671"/>
                      </a:lnTo>
                      <a:lnTo>
                        <a:pt x="2197" y="1670"/>
                      </a:lnTo>
                      <a:lnTo>
                        <a:pt x="2201" y="1671"/>
                      </a:lnTo>
                      <a:lnTo>
                        <a:pt x="2204" y="1671"/>
                      </a:lnTo>
                      <a:lnTo>
                        <a:pt x="2207" y="1671"/>
                      </a:lnTo>
                      <a:lnTo>
                        <a:pt x="2211" y="1670"/>
                      </a:lnTo>
                      <a:lnTo>
                        <a:pt x="2214" y="1671"/>
                      </a:lnTo>
                      <a:lnTo>
                        <a:pt x="2217" y="1669"/>
                      </a:lnTo>
                      <a:lnTo>
                        <a:pt x="2221" y="1669"/>
                      </a:lnTo>
                      <a:lnTo>
                        <a:pt x="2224" y="1669"/>
                      </a:lnTo>
                      <a:lnTo>
                        <a:pt x="2227" y="1668"/>
                      </a:lnTo>
                      <a:lnTo>
                        <a:pt x="2230" y="1669"/>
                      </a:lnTo>
                      <a:lnTo>
                        <a:pt x="2234" y="1669"/>
                      </a:lnTo>
                      <a:lnTo>
                        <a:pt x="2237" y="1670"/>
                      </a:lnTo>
                      <a:lnTo>
                        <a:pt x="2240" y="1669"/>
                      </a:lnTo>
                      <a:lnTo>
                        <a:pt x="2244" y="1670"/>
                      </a:lnTo>
                      <a:lnTo>
                        <a:pt x="2247" y="1669"/>
                      </a:lnTo>
                      <a:lnTo>
                        <a:pt x="2250" y="1669"/>
                      </a:lnTo>
                      <a:lnTo>
                        <a:pt x="2253" y="1669"/>
                      </a:lnTo>
                      <a:lnTo>
                        <a:pt x="2257" y="1671"/>
                      </a:lnTo>
                      <a:lnTo>
                        <a:pt x="2260" y="1671"/>
                      </a:lnTo>
                      <a:lnTo>
                        <a:pt x="2263" y="1670"/>
                      </a:lnTo>
                      <a:lnTo>
                        <a:pt x="2267" y="1670"/>
                      </a:lnTo>
                      <a:lnTo>
                        <a:pt x="2270" y="1669"/>
                      </a:lnTo>
                      <a:lnTo>
                        <a:pt x="2273" y="1671"/>
                      </a:lnTo>
                      <a:lnTo>
                        <a:pt x="2277" y="1671"/>
                      </a:lnTo>
                      <a:lnTo>
                        <a:pt x="2280" y="1670"/>
                      </a:lnTo>
                      <a:lnTo>
                        <a:pt x="2283" y="1670"/>
                      </a:lnTo>
                      <a:lnTo>
                        <a:pt x="2287" y="1670"/>
                      </a:lnTo>
                      <a:lnTo>
                        <a:pt x="2290" y="1672"/>
                      </a:lnTo>
                      <a:lnTo>
                        <a:pt x="2293" y="1671"/>
                      </a:lnTo>
                      <a:lnTo>
                        <a:pt x="2297" y="1673"/>
                      </a:lnTo>
                      <a:lnTo>
                        <a:pt x="2300" y="1672"/>
                      </a:lnTo>
                      <a:lnTo>
                        <a:pt x="2303" y="1674"/>
                      </a:lnTo>
                      <a:lnTo>
                        <a:pt x="2306" y="1675"/>
                      </a:lnTo>
                      <a:lnTo>
                        <a:pt x="2310" y="1672"/>
                      </a:lnTo>
                      <a:lnTo>
                        <a:pt x="2313" y="1674"/>
                      </a:lnTo>
                      <a:lnTo>
                        <a:pt x="2316" y="1673"/>
                      </a:lnTo>
                      <a:lnTo>
                        <a:pt x="2320" y="1673"/>
                      </a:lnTo>
                      <a:lnTo>
                        <a:pt x="2323" y="1673"/>
                      </a:lnTo>
                      <a:lnTo>
                        <a:pt x="2326" y="1674"/>
                      </a:lnTo>
                      <a:lnTo>
                        <a:pt x="2330" y="1674"/>
                      </a:lnTo>
                      <a:lnTo>
                        <a:pt x="2333" y="1674"/>
                      </a:lnTo>
                      <a:lnTo>
                        <a:pt x="2336" y="1673"/>
                      </a:lnTo>
                      <a:lnTo>
                        <a:pt x="2340" y="1674"/>
                      </a:lnTo>
                      <a:lnTo>
                        <a:pt x="2343" y="1675"/>
                      </a:lnTo>
                      <a:lnTo>
                        <a:pt x="2346" y="1675"/>
                      </a:lnTo>
                      <a:lnTo>
                        <a:pt x="2349" y="1675"/>
                      </a:lnTo>
                      <a:lnTo>
                        <a:pt x="2353" y="1674"/>
                      </a:lnTo>
                      <a:lnTo>
                        <a:pt x="2356" y="1674"/>
                      </a:lnTo>
                      <a:lnTo>
                        <a:pt x="2359" y="1674"/>
                      </a:lnTo>
                      <a:lnTo>
                        <a:pt x="2363" y="1672"/>
                      </a:lnTo>
                      <a:lnTo>
                        <a:pt x="2366" y="1675"/>
                      </a:lnTo>
                      <a:lnTo>
                        <a:pt x="2369" y="1674"/>
                      </a:lnTo>
                      <a:lnTo>
                        <a:pt x="2373" y="1676"/>
                      </a:lnTo>
                      <a:lnTo>
                        <a:pt x="2376" y="1675"/>
                      </a:lnTo>
                      <a:lnTo>
                        <a:pt x="2379" y="1675"/>
                      </a:lnTo>
                      <a:lnTo>
                        <a:pt x="2383" y="1677"/>
                      </a:lnTo>
                      <a:lnTo>
                        <a:pt x="2386" y="1675"/>
                      </a:lnTo>
                      <a:lnTo>
                        <a:pt x="2389" y="1675"/>
                      </a:lnTo>
                      <a:lnTo>
                        <a:pt x="2393" y="1675"/>
                      </a:lnTo>
                      <a:lnTo>
                        <a:pt x="2396" y="1676"/>
                      </a:lnTo>
                      <a:lnTo>
                        <a:pt x="2399" y="1676"/>
                      </a:lnTo>
                      <a:lnTo>
                        <a:pt x="2402" y="1675"/>
                      </a:lnTo>
                      <a:lnTo>
                        <a:pt x="2406" y="1677"/>
                      </a:lnTo>
                      <a:lnTo>
                        <a:pt x="2409" y="1676"/>
                      </a:lnTo>
                      <a:lnTo>
                        <a:pt x="2412" y="1675"/>
                      </a:lnTo>
                      <a:lnTo>
                        <a:pt x="2416" y="1676"/>
                      </a:lnTo>
                      <a:lnTo>
                        <a:pt x="2419" y="1676"/>
                      </a:lnTo>
                      <a:lnTo>
                        <a:pt x="2422" y="1675"/>
                      </a:lnTo>
                      <a:lnTo>
                        <a:pt x="2426" y="1676"/>
                      </a:lnTo>
                      <a:lnTo>
                        <a:pt x="2429" y="1675"/>
                      </a:lnTo>
                      <a:lnTo>
                        <a:pt x="2432" y="1676"/>
                      </a:lnTo>
                      <a:lnTo>
                        <a:pt x="2436" y="1676"/>
                      </a:lnTo>
                      <a:lnTo>
                        <a:pt x="2439" y="1676"/>
                      </a:lnTo>
                      <a:lnTo>
                        <a:pt x="2442" y="1676"/>
                      </a:lnTo>
                      <a:lnTo>
                        <a:pt x="2445" y="1676"/>
                      </a:lnTo>
                      <a:lnTo>
                        <a:pt x="2449" y="1677"/>
                      </a:lnTo>
                      <a:lnTo>
                        <a:pt x="2452" y="1675"/>
                      </a:lnTo>
                      <a:lnTo>
                        <a:pt x="2455" y="1676"/>
                      </a:lnTo>
                      <a:lnTo>
                        <a:pt x="2459" y="1675"/>
                      </a:lnTo>
                      <a:lnTo>
                        <a:pt x="2462" y="1675"/>
                      </a:lnTo>
                      <a:lnTo>
                        <a:pt x="2465" y="1675"/>
                      </a:lnTo>
                      <a:lnTo>
                        <a:pt x="2469" y="1675"/>
                      </a:lnTo>
                      <a:lnTo>
                        <a:pt x="2472" y="1675"/>
                      </a:lnTo>
                      <a:lnTo>
                        <a:pt x="2475" y="1677"/>
                      </a:lnTo>
                      <a:lnTo>
                        <a:pt x="2479" y="1674"/>
                      </a:lnTo>
                      <a:lnTo>
                        <a:pt x="2482" y="1674"/>
                      </a:lnTo>
                      <a:lnTo>
                        <a:pt x="2485" y="1674"/>
                      </a:lnTo>
                      <a:lnTo>
                        <a:pt x="2489" y="1676"/>
                      </a:lnTo>
                      <a:lnTo>
                        <a:pt x="2492" y="1675"/>
                      </a:lnTo>
                      <a:lnTo>
                        <a:pt x="2495" y="1676"/>
                      </a:lnTo>
                      <a:lnTo>
                        <a:pt x="2498" y="1675"/>
                      </a:lnTo>
                      <a:lnTo>
                        <a:pt x="2502" y="1674"/>
                      </a:lnTo>
                      <a:lnTo>
                        <a:pt x="2505" y="1674"/>
                      </a:lnTo>
                      <a:lnTo>
                        <a:pt x="2508" y="1675"/>
                      </a:lnTo>
                      <a:lnTo>
                        <a:pt x="2512" y="1675"/>
                      </a:lnTo>
                      <a:lnTo>
                        <a:pt x="2515" y="1674"/>
                      </a:lnTo>
                      <a:lnTo>
                        <a:pt x="2518" y="1675"/>
                      </a:lnTo>
                      <a:lnTo>
                        <a:pt x="2521" y="1675"/>
                      </a:lnTo>
                      <a:lnTo>
                        <a:pt x="2525" y="1674"/>
                      </a:lnTo>
                      <a:lnTo>
                        <a:pt x="2528" y="1675"/>
                      </a:lnTo>
                      <a:lnTo>
                        <a:pt x="2531" y="1675"/>
                      </a:lnTo>
                      <a:lnTo>
                        <a:pt x="2535" y="1674"/>
                      </a:lnTo>
                      <a:lnTo>
                        <a:pt x="2538" y="1675"/>
                      </a:lnTo>
                      <a:lnTo>
                        <a:pt x="2541" y="1674"/>
                      </a:lnTo>
                      <a:lnTo>
                        <a:pt x="2545" y="1675"/>
                      </a:lnTo>
                      <a:lnTo>
                        <a:pt x="2548" y="1675"/>
                      </a:lnTo>
                      <a:lnTo>
                        <a:pt x="2551" y="1676"/>
                      </a:lnTo>
                      <a:lnTo>
                        <a:pt x="2555" y="1676"/>
                      </a:lnTo>
                      <a:lnTo>
                        <a:pt x="2558" y="1675"/>
                      </a:lnTo>
                      <a:lnTo>
                        <a:pt x="2561" y="1675"/>
                      </a:lnTo>
                      <a:lnTo>
                        <a:pt x="2565" y="1676"/>
                      </a:lnTo>
                      <a:lnTo>
                        <a:pt x="2568" y="1675"/>
                      </a:lnTo>
                      <a:lnTo>
                        <a:pt x="2571" y="1675"/>
                      </a:lnTo>
                      <a:lnTo>
                        <a:pt x="2574" y="1676"/>
                      </a:lnTo>
                      <a:lnTo>
                        <a:pt x="2578" y="1675"/>
                      </a:lnTo>
                      <a:lnTo>
                        <a:pt x="2581" y="1674"/>
                      </a:lnTo>
                      <a:lnTo>
                        <a:pt x="2584" y="1675"/>
                      </a:lnTo>
                      <a:lnTo>
                        <a:pt x="2588" y="1675"/>
                      </a:lnTo>
                      <a:lnTo>
                        <a:pt x="2591" y="1675"/>
                      </a:lnTo>
                      <a:lnTo>
                        <a:pt x="2594" y="1677"/>
                      </a:lnTo>
                      <a:lnTo>
                        <a:pt x="2598" y="1676"/>
                      </a:lnTo>
                      <a:lnTo>
                        <a:pt x="2601" y="1675"/>
                      </a:lnTo>
                      <a:lnTo>
                        <a:pt x="2604" y="1677"/>
                      </a:lnTo>
                      <a:lnTo>
                        <a:pt x="2608" y="1675"/>
                      </a:lnTo>
                      <a:lnTo>
                        <a:pt x="2611" y="1675"/>
                      </a:lnTo>
                      <a:lnTo>
                        <a:pt x="2614" y="1675"/>
                      </a:lnTo>
                      <a:lnTo>
                        <a:pt x="2617" y="1676"/>
                      </a:lnTo>
                      <a:lnTo>
                        <a:pt x="2621" y="1677"/>
                      </a:lnTo>
                      <a:lnTo>
                        <a:pt x="2624" y="1677"/>
                      </a:lnTo>
                      <a:lnTo>
                        <a:pt x="2627" y="1677"/>
                      </a:lnTo>
                      <a:lnTo>
                        <a:pt x="2631" y="1675"/>
                      </a:lnTo>
                      <a:lnTo>
                        <a:pt x="2634" y="1675"/>
                      </a:lnTo>
                      <a:lnTo>
                        <a:pt x="2637" y="1675"/>
                      </a:lnTo>
                      <a:lnTo>
                        <a:pt x="2641" y="1676"/>
                      </a:lnTo>
                      <a:lnTo>
                        <a:pt x="2644" y="1676"/>
                      </a:lnTo>
                      <a:lnTo>
                        <a:pt x="2647" y="1676"/>
                      </a:lnTo>
                      <a:lnTo>
                        <a:pt x="2651" y="1677"/>
                      </a:lnTo>
                      <a:lnTo>
                        <a:pt x="2654" y="1676"/>
                      </a:lnTo>
                      <a:lnTo>
                        <a:pt x="2657" y="1676"/>
                      </a:lnTo>
                      <a:lnTo>
                        <a:pt x="2661" y="1676"/>
                      </a:lnTo>
                      <a:lnTo>
                        <a:pt x="2664" y="1677"/>
                      </a:lnTo>
                      <a:lnTo>
                        <a:pt x="2667" y="1675"/>
                      </a:lnTo>
                      <a:lnTo>
                        <a:pt x="2670" y="1676"/>
                      </a:lnTo>
                      <a:lnTo>
                        <a:pt x="2674" y="1677"/>
                      </a:lnTo>
                      <a:lnTo>
                        <a:pt x="2677" y="1675"/>
                      </a:lnTo>
                      <a:lnTo>
                        <a:pt x="2680" y="1676"/>
                      </a:lnTo>
                      <a:lnTo>
                        <a:pt x="2684" y="1675"/>
                      </a:lnTo>
                      <a:lnTo>
                        <a:pt x="2687" y="1676"/>
                      </a:lnTo>
                      <a:lnTo>
                        <a:pt x="2690" y="1676"/>
                      </a:lnTo>
                      <a:lnTo>
                        <a:pt x="2694" y="1675"/>
                      </a:lnTo>
                      <a:lnTo>
                        <a:pt x="2697" y="1676"/>
                      </a:lnTo>
                      <a:lnTo>
                        <a:pt x="2700" y="1676"/>
                      </a:lnTo>
                      <a:lnTo>
                        <a:pt x="2704" y="1676"/>
                      </a:lnTo>
                      <a:lnTo>
                        <a:pt x="2707" y="1675"/>
                      </a:lnTo>
                      <a:lnTo>
                        <a:pt x="2710" y="1676"/>
                      </a:lnTo>
                      <a:lnTo>
                        <a:pt x="2714" y="1676"/>
                      </a:lnTo>
                      <a:lnTo>
                        <a:pt x="2717" y="1676"/>
                      </a:lnTo>
                      <a:lnTo>
                        <a:pt x="2720" y="1674"/>
                      </a:lnTo>
                      <a:lnTo>
                        <a:pt x="2723" y="1675"/>
                      </a:lnTo>
                      <a:lnTo>
                        <a:pt x="2727" y="1675"/>
                      </a:lnTo>
                      <a:lnTo>
                        <a:pt x="2730" y="1675"/>
                      </a:lnTo>
                      <a:lnTo>
                        <a:pt x="2733" y="1675"/>
                      </a:lnTo>
                      <a:lnTo>
                        <a:pt x="2737" y="1674"/>
                      </a:lnTo>
                      <a:lnTo>
                        <a:pt x="2740" y="1673"/>
                      </a:lnTo>
                      <a:lnTo>
                        <a:pt x="2743" y="1673"/>
                      </a:lnTo>
                      <a:lnTo>
                        <a:pt x="2747" y="1673"/>
                      </a:lnTo>
                      <a:lnTo>
                        <a:pt x="2750" y="1673"/>
                      </a:lnTo>
                      <a:lnTo>
                        <a:pt x="2753" y="1673"/>
                      </a:lnTo>
                      <a:lnTo>
                        <a:pt x="2757" y="1672"/>
                      </a:lnTo>
                      <a:lnTo>
                        <a:pt x="2760" y="1672"/>
                      </a:lnTo>
                      <a:lnTo>
                        <a:pt x="2763" y="1672"/>
                      </a:lnTo>
                      <a:lnTo>
                        <a:pt x="2766" y="1671"/>
                      </a:lnTo>
                      <a:lnTo>
                        <a:pt x="2770" y="1670"/>
                      </a:lnTo>
                      <a:lnTo>
                        <a:pt x="2773" y="1671"/>
                      </a:lnTo>
                      <a:lnTo>
                        <a:pt x="2776" y="1669"/>
                      </a:lnTo>
                      <a:lnTo>
                        <a:pt x="2780" y="1670"/>
                      </a:lnTo>
                      <a:lnTo>
                        <a:pt x="2783" y="1669"/>
                      </a:lnTo>
                      <a:lnTo>
                        <a:pt x="2786" y="1668"/>
                      </a:lnTo>
                      <a:lnTo>
                        <a:pt x="2789" y="1667"/>
                      </a:lnTo>
                      <a:lnTo>
                        <a:pt x="2793" y="1666"/>
                      </a:lnTo>
                      <a:lnTo>
                        <a:pt x="2796" y="1664"/>
                      </a:lnTo>
                      <a:lnTo>
                        <a:pt x="2799" y="1663"/>
                      </a:lnTo>
                      <a:lnTo>
                        <a:pt x="2803" y="1662"/>
                      </a:lnTo>
                      <a:lnTo>
                        <a:pt x="2806" y="1661"/>
                      </a:lnTo>
                      <a:lnTo>
                        <a:pt x="2809" y="1661"/>
                      </a:lnTo>
                      <a:lnTo>
                        <a:pt x="2813" y="1658"/>
                      </a:lnTo>
                      <a:lnTo>
                        <a:pt x="2816" y="1656"/>
                      </a:lnTo>
                      <a:lnTo>
                        <a:pt x="2819" y="1655"/>
                      </a:lnTo>
                      <a:lnTo>
                        <a:pt x="2823" y="1654"/>
                      </a:lnTo>
                      <a:lnTo>
                        <a:pt x="2826" y="1652"/>
                      </a:lnTo>
                      <a:lnTo>
                        <a:pt x="2829" y="1649"/>
                      </a:lnTo>
                      <a:lnTo>
                        <a:pt x="2833" y="1649"/>
                      </a:lnTo>
                      <a:lnTo>
                        <a:pt x="2836" y="1649"/>
                      </a:lnTo>
                      <a:lnTo>
                        <a:pt x="2839" y="1646"/>
                      </a:lnTo>
                      <a:lnTo>
                        <a:pt x="2842" y="1646"/>
                      </a:lnTo>
                      <a:lnTo>
                        <a:pt x="2846" y="1643"/>
                      </a:lnTo>
                      <a:lnTo>
                        <a:pt x="2849" y="1643"/>
                      </a:lnTo>
                      <a:lnTo>
                        <a:pt x="2852" y="1640"/>
                      </a:lnTo>
                      <a:lnTo>
                        <a:pt x="2856" y="1640"/>
                      </a:lnTo>
                      <a:lnTo>
                        <a:pt x="2859" y="1636"/>
                      </a:lnTo>
                      <a:lnTo>
                        <a:pt x="2862" y="1637"/>
                      </a:lnTo>
                      <a:lnTo>
                        <a:pt x="2866" y="1636"/>
                      </a:lnTo>
                      <a:lnTo>
                        <a:pt x="2869" y="1634"/>
                      </a:lnTo>
                      <a:lnTo>
                        <a:pt x="2872" y="1632"/>
                      </a:lnTo>
                      <a:lnTo>
                        <a:pt x="2876" y="1631"/>
                      </a:lnTo>
                      <a:lnTo>
                        <a:pt x="2879" y="1631"/>
                      </a:lnTo>
                      <a:lnTo>
                        <a:pt x="2882" y="1628"/>
                      </a:lnTo>
                      <a:lnTo>
                        <a:pt x="2886" y="1626"/>
                      </a:lnTo>
                      <a:lnTo>
                        <a:pt x="2889" y="1626"/>
                      </a:lnTo>
                      <a:lnTo>
                        <a:pt x="2892" y="1625"/>
                      </a:lnTo>
                      <a:lnTo>
                        <a:pt x="2895" y="1623"/>
                      </a:lnTo>
                      <a:lnTo>
                        <a:pt x="2899" y="1622"/>
                      </a:lnTo>
                      <a:lnTo>
                        <a:pt x="2902" y="1622"/>
                      </a:lnTo>
                      <a:lnTo>
                        <a:pt x="2905" y="1620"/>
                      </a:lnTo>
                      <a:lnTo>
                        <a:pt x="2909" y="1619"/>
                      </a:lnTo>
                      <a:lnTo>
                        <a:pt x="2912" y="1617"/>
                      </a:lnTo>
                      <a:lnTo>
                        <a:pt x="2915" y="1613"/>
                      </a:lnTo>
                      <a:lnTo>
                        <a:pt x="2919" y="1612"/>
                      </a:lnTo>
                      <a:lnTo>
                        <a:pt x="2922" y="1612"/>
                      </a:lnTo>
                      <a:lnTo>
                        <a:pt x="2925" y="1609"/>
                      </a:lnTo>
                      <a:lnTo>
                        <a:pt x="2929" y="1608"/>
                      </a:lnTo>
                      <a:lnTo>
                        <a:pt x="2932" y="1607"/>
                      </a:lnTo>
                      <a:lnTo>
                        <a:pt x="2935" y="1604"/>
                      </a:lnTo>
                      <a:lnTo>
                        <a:pt x="2938" y="1601"/>
                      </a:lnTo>
                      <a:lnTo>
                        <a:pt x="2942" y="1599"/>
                      </a:lnTo>
                      <a:lnTo>
                        <a:pt x="2945" y="1598"/>
                      </a:lnTo>
                      <a:lnTo>
                        <a:pt x="2948" y="1595"/>
                      </a:lnTo>
                      <a:lnTo>
                        <a:pt x="2952" y="1590"/>
                      </a:lnTo>
                      <a:lnTo>
                        <a:pt x="2955" y="1587"/>
                      </a:lnTo>
                      <a:lnTo>
                        <a:pt x="2958" y="1585"/>
                      </a:lnTo>
                      <a:lnTo>
                        <a:pt x="2962" y="1582"/>
                      </a:lnTo>
                      <a:lnTo>
                        <a:pt x="2965" y="1577"/>
                      </a:lnTo>
                      <a:lnTo>
                        <a:pt x="2968" y="1575"/>
                      </a:lnTo>
                      <a:lnTo>
                        <a:pt x="2972" y="1572"/>
                      </a:lnTo>
                      <a:lnTo>
                        <a:pt x="2975" y="1568"/>
                      </a:lnTo>
                      <a:lnTo>
                        <a:pt x="2978" y="1564"/>
                      </a:lnTo>
                      <a:lnTo>
                        <a:pt x="2982" y="1561"/>
                      </a:lnTo>
                      <a:lnTo>
                        <a:pt x="2985" y="1558"/>
                      </a:lnTo>
                      <a:lnTo>
                        <a:pt x="2988" y="1555"/>
                      </a:lnTo>
                      <a:lnTo>
                        <a:pt x="2991" y="1551"/>
                      </a:lnTo>
                      <a:lnTo>
                        <a:pt x="2995" y="1549"/>
                      </a:lnTo>
                      <a:lnTo>
                        <a:pt x="2998" y="1545"/>
                      </a:lnTo>
                      <a:lnTo>
                        <a:pt x="3001" y="1542"/>
                      </a:lnTo>
                      <a:lnTo>
                        <a:pt x="3005" y="1540"/>
                      </a:lnTo>
                      <a:lnTo>
                        <a:pt x="3008" y="1537"/>
                      </a:lnTo>
                      <a:lnTo>
                        <a:pt x="3011" y="1534"/>
                      </a:lnTo>
                      <a:lnTo>
                        <a:pt x="3015" y="1529"/>
                      </a:lnTo>
                      <a:lnTo>
                        <a:pt x="3018" y="1526"/>
                      </a:lnTo>
                      <a:lnTo>
                        <a:pt x="3021" y="1523"/>
                      </a:lnTo>
                      <a:lnTo>
                        <a:pt x="3025" y="1516"/>
                      </a:lnTo>
                      <a:lnTo>
                        <a:pt x="3028" y="1513"/>
                      </a:lnTo>
                      <a:lnTo>
                        <a:pt x="3031" y="1510"/>
                      </a:lnTo>
                      <a:lnTo>
                        <a:pt x="3035" y="1501"/>
                      </a:lnTo>
                      <a:lnTo>
                        <a:pt x="3038" y="1493"/>
                      </a:lnTo>
                      <a:lnTo>
                        <a:pt x="3041" y="1481"/>
                      </a:lnTo>
                      <a:lnTo>
                        <a:pt x="3044" y="1469"/>
                      </a:lnTo>
                      <a:lnTo>
                        <a:pt x="3048" y="1450"/>
                      </a:lnTo>
                      <a:lnTo>
                        <a:pt x="3051" y="1430"/>
                      </a:lnTo>
                      <a:lnTo>
                        <a:pt x="3054" y="1402"/>
                      </a:lnTo>
                      <a:lnTo>
                        <a:pt x="3058" y="1368"/>
                      </a:lnTo>
                      <a:lnTo>
                        <a:pt x="3061" y="1331"/>
                      </a:lnTo>
                      <a:lnTo>
                        <a:pt x="3064" y="1287"/>
                      </a:lnTo>
                      <a:lnTo>
                        <a:pt x="3067" y="1236"/>
                      </a:lnTo>
                      <a:lnTo>
                        <a:pt x="3071" y="1179"/>
                      </a:lnTo>
                      <a:lnTo>
                        <a:pt x="3074" y="1115"/>
                      </a:lnTo>
                      <a:lnTo>
                        <a:pt x="3077" y="1045"/>
                      </a:lnTo>
                      <a:lnTo>
                        <a:pt x="3081" y="969"/>
                      </a:lnTo>
                      <a:lnTo>
                        <a:pt x="3084" y="891"/>
                      </a:lnTo>
                      <a:lnTo>
                        <a:pt x="3087" y="807"/>
                      </a:lnTo>
                      <a:lnTo>
                        <a:pt x="3091" y="724"/>
                      </a:lnTo>
                      <a:lnTo>
                        <a:pt x="3094" y="639"/>
                      </a:lnTo>
                      <a:lnTo>
                        <a:pt x="3097" y="554"/>
                      </a:lnTo>
                      <a:lnTo>
                        <a:pt x="3101" y="475"/>
                      </a:lnTo>
                      <a:lnTo>
                        <a:pt x="3104" y="396"/>
                      </a:lnTo>
                      <a:lnTo>
                        <a:pt x="3107" y="321"/>
                      </a:lnTo>
                      <a:lnTo>
                        <a:pt x="3110" y="253"/>
                      </a:lnTo>
                      <a:lnTo>
                        <a:pt x="3114" y="193"/>
                      </a:lnTo>
                      <a:lnTo>
                        <a:pt x="3117" y="140"/>
                      </a:lnTo>
                      <a:lnTo>
                        <a:pt x="3120" y="94"/>
                      </a:lnTo>
                      <a:lnTo>
                        <a:pt x="3124" y="58"/>
                      </a:lnTo>
                      <a:lnTo>
                        <a:pt x="3127" y="33"/>
                      </a:lnTo>
                      <a:lnTo>
                        <a:pt x="3130" y="14"/>
                      </a:lnTo>
                      <a:lnTo>
                        <a:pt x="3134" y="5"/>
                      </a:lnTo>
                      <a:lnTo>
                        <a:pt x="3137" y="0"/>
                      </a:lnTo>
                      <a:lnTo>
                        <a:pt x="3140" y="2"/>
                      </a:lnTo>
                      <a:lnTo>
                        <a:pt x="3144" y="10"/>
                      </a:lnTo>
                      <a:lnTo>
                        <a:pt x="3147" y="22"/>
                      </a:lnTo>
                      <a:lnTo>
                        <a:pt x="3150" y="40"/>
                      </a:lnTo>
                      <a:lnTo>
                        <a:pt x="3154" y="58"/>
                      </a:lnTo>
                      <a:lnTo>
                        <a:pt x="3157" y="80"/>
                      </a:lnTo>
                      <a:lnTo>
                        <a:pt x="3160" y="104"/>
                      </a:lnTo>
                      <a:lnTo>
                        <a:pt x="3163" y="127"/>
                      </a:lnTo>
                      <a:lnTo>
                        <a:pt x="3167" y="152"/>
                      </a:lnTo>
                      <a:lnTo>
                        <a:pt x="3170" y="178"/>
                      </a:lnTo>
                      <a:lnTo>
                        <a:pt x="3173" y="205"/>
                      </a:lnTo>
                      <a:lnTo>
                        <a:pt x="3177" y="232"/>
                      </a:lnTo>
                      <a:lnTo>
                        <a:pt x="3180" y="259"/>
                      </a:lnTo>
                      <a:lnTo>
                        <a:pt x="3183" y="288"/>
                      </a:lnTo>
                      <a:lnTo>
                        <a:pt x="3187" y="316"/>
                      </a:lnTo>
                      <a:lnTo>
                        <a:pt x="3190" y="344"/>
                      </a:lnTo>
                      <a:lnTo>
                        <a:pt x="3193" y="373"/>
                      </a:lnTo>
                      <a:lnTo>
                        <a:pt x="3197" y="401"/>
                      </a:lnTo>
                      <a:lnTo>
                        <a:pt x="3200" y="427"/>
                      </a:lnTo>
                      <a:lnTo>
                        <a:pt x="3203" y="457"/>
                      </a:lnTo>
                      <a:lnTo>
                        <a:pt x="3207" y="484"/>
                      </a:lnTo>
                      <a:lnTo>
                        <a:pt x="3210" y="512"/>
                      </a:lnTo>
                      <a:lnTo>
                        <a:pt x="3213" y="541"/>
                      </a:lnTo>
                      <a:lnTo>
                        <a:pt x="3216" y="568"/>
                      </a:lnTo>
                      <a:lnTo>
                        <a:pt x="3220" y="598"/>
                      </a:lnTo>
                      <a:lnTo>
                        <a:pt x="3223" y="627"/>
                      </a:lnTo>
                      <a:lnTo>
                        <a:pt x="3226" y="653"/>
                      </a:lnTo>
                      <a:lnTo>
                        <a:pt x="3230" y="682"/>
                      </a:lnTo>
                      <a:lnTo>
                        <a:pt x="3233" y="710"/>
                      </a:lnTo>
                      <a:lnTo>
                        <a:pt x="3236" y="738"/>
                      </a:lnTo>
                      <a:lnTo>
                        <a:pt x="3240" y="765"/>
                      </a:lnTo>
                      <a:lnTo>
                        <a:pt x="3243" y="795"/>
                      </a:lnTo>
                      <a:lnTo>
                        <a:pt x="3246" y="821"/>
                      </a:lnTo>
                      <a:lnTo>
                        <a:pt x="3250" y="850"/>
                      </a:lnTo>
                      <a:lnTo>
                        <a:pt x="3253" y="878"/>
                      </a:lnTo>
                      <a:lnTo>
                        <a:pt x="3256" y="901"/>
                      </a:lnTo>
                      <a:lnTo>
                        <a:pt x="3259" y="927"/>
                      </a:lnTo>
                      <a:lnTo>
                        <a:pt x="3263" y="955"/>
                      </a:lnTo>
                      <a:lnTo>
                        <a:pt x="3266" y="980"/>
                      </a:lnTo>
                      <a:lnTo>
                        <a:pt x="3269" y="1006"/>
                      </a:lnTo>
                      <a:lnTo>
                        <a:pt x="3273" y="1031"/>
                      </a:lnTo>
                      <a:lnTo>
                        <a:pt x="3276" y="1054"/>
                      </a:lnTo>
                      <a:lnTo>
                        <a:pt x="3279" y="1078"/>
                      </a:lnTo>
                      <a:lnTo>
                        <a:pt x="3283" y="1102"/>
                      </a:lnTo>
                      <a:lnTo>
                        <a:pt x="3286" y="1125"/>
                      </a:lnTo>
                      <a:lnTo>
                        <a:pt x="3289" y="1148"/>
                      </a:lnTo>
                      <a:lnTo>
                        <a:pt x="3293" y="1170"/>
                      </a:lnTo>
                      <a:lnTo>
                        <a:pt x="3296" y="1190"/>
                      </a:lnTo>
                      <a:lnTo>
                        <a:pt x="3299" y="1213"/>
                      </a:lnTo>
                      <a:lnTo>
                        <a:pt x="3303" y="1231"/>
                      </a:lnTo>
                      <a:lnTo>
                        <a:pt x="3306" y="1252"/>
                      </a:lnTo>
                      <a:lnTo>
                        <a:pt x="3309" y="1272"/>
                      </a:lnTo>
                      <a:lnTo>
                        <a:pt x="3312" y="1288"/>
                      </a:lnTo>
                      <a:lnTo>
                        <a:pt x="3316" y="1309"/>
                      </a:lnTo>
                      <a:lnTo>
                        <a:pt x="3319" y="1328"/>
                      </a:lnTo>
                      <a:lnTo>
                        <a:pt x="3322" y="1344"/>
                      </a:lnTo>
                      <a:lnTo>
                        <a:pt x="3326" y="1362"/>
                      </a:lnTo>
                      <a:lnTo>
                        <a:pt x="3329" y="1379"/>
                      </a:lnTo>
                      <a:lnTo>
                        <a:pt x="3332" y="1393"/>
                      </a:lnTo>
                      <a:lnTo>
                        <a:pt x="3335" y="1408"/>
                      </a:lnTo>
                      <a:lnTo>
                        <a:pt x="3339" y="1423"/>
                      </a:lnTo>
                      <a:lnTo>
                        <a:pt x="3342" y="1436"/>
                      </a:lnTo>
                      <a:lnTo>
                        <a:pt x="3345" y="1450"/>
                      </a:lnTo>
                      <a:lnTo>
                        <a:pt x="3349" y="1465"/>
                      </a:lnTo>
                      <a:lnTo>
                        <a:pt x="3352" y="1476"/>
                      </a:lnTo>
                      <a:lnTo>
                        <a:pt x="3355" y="1487"/>
                      </a:lnTo>
                      <a:lnTo>
                        <a:pt x="3359" y="1499"/>
                      </a:lnTo>
                      <a:lnTo>
                        <a:pt x="3362" y="1510"/>
                      </a:lnTo>
                      <a:lnTo>
                        <a:pt x="3365" y="1520"/>
                      </a:lnTo>
                      <a:lnTo>
                        <a:pt x="3369" y="1530"/>
                      </a:lnTo>
                      <a:lnTo>
                        <a:pt x="3372" y="1539"/>
                      </a:lnTo>
                      <a:lnTo>
                        <a:pt x="3375" y="1549"/>
                      </a:lnTo>
                      <a:lnTo>
                        <a:pt x="3379" y="1557"/>
                      </a:lnTo>
                      <a:lnTo>
                        <a:pt x="3382" y="1564"/>
                      </a:lnTo>
                      <a:lnTo>
                        <a:pt x="3385" y="1571"/>
                      </a:lnTo>
                      <a:lnTo>
                        <a:pt x="3388" y="1578"/>
                      </a:lnTo>
                      <a:lnTo>
                        <a:pt x="3392" y="1587"/>
                      </a:lnTo>
                      <a:lnTo>
                        <a:pt x="3395" y="1591"/>
                      </a:lnTo>
                      <a:lnTo>
                        <a:pt x="3398" y="1598"/>
                      </a:lnTo>
                      <a:lnTo>
                        <a:pt x="3402" y="1602"/>
                      </a:lnTo>
                      <a:lnTo>
                        <a:pt x="3405" y="1610"/>
                      </a:lnTo>
                      <a:lnTo>
                        <a:pt x="3408" y="1613"/>
                      </a:lnTo>
                      <a:lnTo>
                        <a:pt x="3412" y="1619"/>
                      </a:lnTo>
                      <a:lnTo>
                        <a:pt x="3415" y="1624"/>
                      </a:lnTo>
                      <a:lnTo>
                        <a:pt x="3418" y="1627"/>
                      </a:lnTo>
                      <a:lnTo>
                        <a:pt x="3422" y="1631"/>
                      </a:lnTo>
                      <a:lnTo>
                        <a:pt x="3425" y="1635"/>
                      </a:lnTo>
                      <a:lnTo>
                        <a:pt x="3428" y="1640"/>
                      </a:lnTo>
                      <a:lnTo>
                        <a:pt x="3431" y="1641"/>
                      </a:lnTo>
                      <a:lnTo>
                        <a:pt x="3435" y="1646"/>
                      </a:lnTo>
                      <a:lnTo>
                        <a:pt x="3438" y="1646"/>
                      </a:lnTo>
                      <a:lnTo>
                        <a:pt x="3441" y="1650"/>
                      </a:lnTo>
                      <a:lnTo>
                        <a:pt x="3445" y="1653"/>
                      </a:lnTo>
                      <a:lnTo>
                        <a:pt x="3448" y="1656"/>
                      </a:lnTo>
                      <a:lnTo>
                        <a:pt x="3451" y="1659"/>
                      </a:lnTo>
                      <a:lnTo>
                        <a:pt x="3455" y="1659"/>
                      </a:lnTo>
                      <a:lnTo>
                        <a:pt x="3458" y="1660"/>
                      </a:lnTo>
                      <a:lnTo>
                        <a:pt x="3461" y="1663"/>
                      </a:lnTo>
                      <a:lnTo>
                        <a:pt x="3465" y="1664"/>
                      </a:lnTo>
                      <a:lnTo>
                        <a:pt x="3468" y="1664"/>
                      </a:lnTo>
                      <a:lnTo>
                        <a:pt x="3471" y="1668"/>
                      </a:lnTo>
                      <a:lnTo>
                        <a:pt x="3475" y="1668"/>
                      </a:lnTo>
                      <a:lnTo>
                        <a:pt x="3478" y="1670"/>
                      </a:lnTo>
                      <a:lnTo>
                        <a:pt x="3481" y="1671"/>
                      </a:lnTo>
                      <a:lnTo>
                        <a:pt x="3484" y="1671"/>
                      </a:lnTo>
                      <a:lnTo>
                        <a:pt x="3488" y="1670"/>
                      </a:lnTo>
                      <a:lnTo>
                        <a:pt x="3491" y="1673"/>
                      </a:lnTo>
                      <a:lnTo>
                        <a:pt x="3494" y="1674"/>
                      </a:lnTo>
                      <a:lnTo>
                        <a:pt x="3498" y="1674"/>
                      </a:lnTo>
                      <a:lnTo>
                        <a:pt x="3501" y="1674"/>
                      </a:lnTo>
                      <a:lnTo>
                        <a:pt x="3504" y="1675"/>
                      </a:lnTo>
                      <a:lnTo>
                        <a:pt x="3508" y="1676"/>
                      </a:lnTo>
                      <a:lnTo>
                        <a:pt x="3511" y="1677"/>
                      </a:lnTo>
                      <a:lnTo>
                        <a:pt x="3514" y="1676"/>
                      </a:lnTo>
                      <a:lnTo>
                        <a:pt x="3518" y="1675"/>
                      </a:lnTo>
                      <a:lnTo>
                        <a:pt x="3521" y="1676"/>
                      </a:lnTo>
                      <a:lnTo>
                        <a:pt x="3524" y="1677"/>
                      </a:lnTo>
                      <a:lnTo>
                        <a:pt x="3527" y="1677"/>
                      </a:lnTo>
                      <a:lnTo>
                        <a:pt x="3531" y="1680"/>
                      </a:lnTo>
                      <a:lnTo>
                        <a:pt x="3534" y="1678"/>
                      </a:lnTo>
                      <a:lnTo>
                        <a:pt x="3537" y="1679"/>
                      </a:lnTo>
                      <a:lnTo>
                        <a:pt x="3541" y="1679"/>
                      </a:lnTo>
                      <a:lnTo>
                        <a:pt x="3544" y="1681"/>
                      </a:lnTo>
                      <a:lnTo>
                        <a:pt x="3547" y="1681"/>
                      </a:lnTo>
                      <a:lnTo>
                        <a:pt x="3551" y="1681"/>
                      </a:lnTo>
                      <a:lnTo>
                        <a:pt x="3554" y="1679"/>
                      </a:lnTo>
                      <a:lnTo>
                        <a:pt x="3557" y="1679"/>
                      </a:lnTo>
                      <a:lnTo>
                        <a:pt x="3561" y="1680"/>
                      </a:lnTo>
                      <a:lnTo>
                        <a:pt x="3564" y="1682"/>
                      </a:lnTo>
                      <a:lnTo>
                        <a:pt x="3567" y="1682"/>
                      </a:lnTo>
                      <a:lnTo>
                        <a:pt x="3571" y="1682"/>
                      </a:lnTo>
                      <a:lnTo>
                        <a:pt x="3574" y="1681"/>
                      </a:lnTo>
                      <a:lnTo>
                        <a:pt x="3577" y="1681"/>
                      </a:lnTo>
                      <a:lnTo>
                        <a:pt x="3580" y="1681"/>
                      </a:lnTo>
                      <a:lnTo>
                        <a:pt x="3584" y="1681"/>
                      </a:lnTo>
                      <a:lnTo>
                        <a:pt x="3587" y="1682"/>
                      </a:lnTo>
                      <a:lnTo>
                        <a:pt x="3590" y="1681"/>
                      </a:lnTo>
                      <a:lnTo>
                        <a:pt x="3594" y="1682"/>
                      </a:lnTo>
                      <a:lnTo>
                        <a:pt x="3597" y="1681"/>
                      </a:lnTo>
                      <a:lnTo>
                        <a:pt x="3600" y="1682"/>
                      </a:lnTo>
                      <a:lnTo>
                        <a:pt x="3603" y="1683"/>
                      </a:lnTo>
                      <a:lnTo>
                        <a:pt x="3607" y="1684"/>
                      </a:lnTo>
                      <a:lnTo>
                        <a:pt x="3610" y="1683"/>
                      </a:lnTo>
                      <a:lnTo>
                        <a:pt x="3613" y="1682"/>
                      </a:lnTo>
                      <a:lnTo>
                        <a:pt x="3617" y="1683"/>
                      </a:lnTo>
                      <a:lnTo>
                        <a:pt x="3620" y="1684"/>
                      </a:lnTo>
                      <a:lnTo>
                        <a:pt x="3624" y="1683"/>
                      </a:lnTo>
                      <a:lnTo>
                        <a:pt x="3627" y="1683"/>
                      </a:lnTo>
                      <a:lnTo>
                        <a:pt x="3630" y="1685"/>
                      </a:lnTo>
                      <a:lnTo>
                        <a:pt x="3633" y="1683"/>
                      </a:lnTo>
                      <a:lnTo>
                        <a:pt x="3637" y="1683"/>
                      </a:lnTo>
                      <a:lnTo>
                        <a:pt x="3640" y="1682"/>
                      </a:lnTo>
                      <a:lnTo>
                        <a:pt x="3643" y="1683"/>
                      </a:lnTo>
                      <a:lnTo>
                        <a:pt x="3647" y="1683"/>
                      </a:lnTo>
                      <a:lnTo>
                        <a:pt x="3650" y="1683"/>
                      </a:lnTo>
                      <a:lnTo>
                        <a:pt x="3653" y="1683"/>
                      </a:lnTo>
                      <a:lnTo>
                        <a:pt x="3656" y="1682"/>
                      </a:lnTo>
                      <a:lnTo>
                        <a:pt x="3660" y="1683"/>
                      </a:lnTo>
                      <a:lnTo>
                        <a:pt x="3663" y="1682"/>
                      </a:lnTo>
                      <a:lnTo>
                        <a:pt x="3666" y="1684"/>
                      </a:lnTo>
                      <a:lnTo>
                        <a:pt x="3670" y="1684"/>
                      </a:lnTo>
                      <a:lnTo>
                        <a:pt x="3673" y="1683"/>
                      </a:lnTo>
                      <a:lnTo>
                        <a:pt x="3676" y="1684"/>
                      </a:lnTo>
                      <a:lnTo>
                        <a:pt x="3680" y="1684"/>
                      </a:lnTo>
                      <a:lnTo>
                        <a:pt x="3683" y="1683"/>
                      </a:lnTo>
                      <a:lnTo>
                        <a:pt x="3686" y="1683"/>
                      </a:lnTo>
                      <a:lnTo>
                        <a:pt x="3690" y="1683"/>
                      </a:lnTo>
                      <a:lnTo>
                        <a:pt x="3693" y="1685"/>
                      </a:lnTo>
                      <a:lnTo>
                        <a:pt x="3696" y="1683"/>
                      </a:lnTo>
                      <a:lnTo>
                        <a:pt x="3699" y="1684"/>
                      </a:lnTo>
                      <a:lnTo>
                        <a:pt x="3703" y="1684"/>
                      </a:lnTo>
                      <a:lnTo>
                        <a:pt x="3706" y="1683"/>
                      </a:lnTo>
                      <a:lnTo>
                        <a:pt x="3709" y="1682"/>
                      </a:lnTo>
                      <a:lnTo>
                        <a:pt x="3713" y="1683"/>
                      </a:lnTo>
                      <a:lnTo>
                        <a:pt x="3716" y="1684"/>
                      </a:lnTo>
                      <a:lnTo>
                        <a:pt x="3719" y="1684"/>
                      </a:lnTo>
                      <a:lnTo>
                        <a:pt x="3723" y="1685"/>
                      </a:lnTo>
                      <a:lnTo>
                        <a:pt x="3726" y="1683"/>
                      </a:lnTo>
                      <a:lnTo>
                        <a:pt x="3729" y="1683"/>
                      </a:lnTo>
                      <a:lnTo>
                        <a:pt x="3733" y="1682"/>
                      </a:lnTo>
                      <a:lnTo>
                        <a:pt x="3736" y="1685"/>
                      </a:lnTo>
                      <a:lnTo>
                        <a:pt x="3739" y="1684"/>
                      </a:lnTo>
                      <a:lnTo>
                        <a:pt x="3743" y="1684"/>
                      </a:lnTo>
                      <a:lnTo>
                        <a:pt x="3746" y="1684"/>
                      </a:lnTo>
                      <a:lnTo>
                        <a:pt x="3749" y="1685"/>
                      </a:lnTo>
                      <a:lnTo>
                        <a:pt x="3752" y="1685"/>
                      </a:lnTo>
                      <a:lnTo>
                        <a:pt x="3756" y="1684"/>
                      </a:lnTo>
                      <a:lnTo>
                        <a:pt x="3759" y="1682"/>
                      </a:lnTo>
                      <a:lnTo>
                        <a:pt x="3762" y="1682"/>
                      </a:lnTo>
                      <a:lnTo>
                        <a:pt x="3766" y="1684"/>
                      </a:lnTo>
                      <a:lnTo>
                        <a:pt x="3769" y="1684"/>
                      </a:lnTo>
                      <a:lnTo>
                        <a:pt x="3772" y="1684"/>
                      </a:lnTo>
                      <a:lnTo>
                        <a:pt x="3776" y="1684"/>
                      </a:lnTo>
                      <a:lnTo>
                        <a:pt x="3779" y="1683"/>
                      </a:lnTo>
                      <a:lnTo>
                        <a:pt x="3782" y="1684"/>
                      </a:lnTo>
                      <a:lnTo>
                        <a:pt x="3786" y="1685"/>
                      </a:lnTo>
                      <a:lnTo>
                        <a:pt x="3789" y="1684"/>
                      </a:lnTo>
                      <a:lnTo>
                        <a:pt x="3792" y="1684"/>
                      </a:lnTo>
                      <a:lnTo>
                        <a:pt x="3796" y="1684"/>
                      </a:lnTo>
                      <a:lnTo>
                        <a:pt x="3799" y="1684"/>
                      </a:lnTo>
                      <a:lnTo>
                        <a:pt x="3802" y="1683"/>
                      </a:lnTo>
                      <a:lnTo>
                        <a:pt x="3805" y="1683"/>
                      </a:lnTo>
                      <a:lnTo>
                        <a:pt x="3809" y="1683"/>
                      </a:lnTo>
                      <a:lnTo>
                        <a:pt x="3812" y="1682"/>
                      </a:lnTo>
                      <a:lnTo>
                        <a:pt x="3815" y="1682"/>
                      </a:lnTo>
                      <a:lnTo>
                        <a:pt x="3819" y="1685"/>
                      </a:lnTo>
                      <a:lnTo>
                        <a:pt x="3822" y="1683"/>
                      </a:lnTo>
                      <a:lnTo>
                        <a:pt x="3825" y="1684"/>
                      </a:lnTo>
                      <a:lnTo>
                        <a:pt x="3829" y="1683"/>
                      </a:lnTo>
                      <a:lnTo>
                        <a:pt x="3832" y="1684"/>
                      </a:lnTo>
                      <a:lnTo>
                        <a:pt x="3835" y="1683"/>
                      </a:lnTo>
                      <a:lnTo>
                        <a:pt x="3839" y="1683"/>
                      </a:lnTo>
                      <a:lnTo>
                        <a:pt x="3842" y="1682"/>
                      </a:lnTo>
                      <a:lnTo>
                        <a:pt x="3845" y="1684"/>
                      </a:lnTo>
                      <a:lnTo>
                        <a:pt x="3848" y="1682"/>
                      </a:lnTo>
                      <a:lnTo>
                        <a:pt x="3852" y="1685"/>
                      </a:lnTo>
                      <a:lnTo>
                        <a:pt x="3855" y="1683"/>
                      </a:lnTo>
                      <a:lnTo>
                        <a:pt x="3858" y="1684"/>
                      </a:lnTo>
                      <a:lnTo>
                        <a:pt x="3862" y="1684"/>
                      </a:lnTo>
                      <a:lnTo>
                        <a:pt x="3865" y="1684"/>
                      </a:lnTo>
                      <a:lnTo>
                        <a:pt x="3868" y="1682"/>
                      </a:lnTo>
                      <a:lnTo>
                        <a:pt x="3871" y="1684"/>
                      </a:lnTo>
                      <a:lnTo>
                        <a:pt x="3875" y="1683"/>
                      </a:lnTo>
                      <a:lnTo>
                        <a:pt x="3878" y="1684"/>
                      </a:lnTo>
                      <a:lnTo>
                        <a:pt x="3881" y="1683"/>
                      </a:lnTo>
                      <a:lnTo>
                        <a:pt x="3885" y="1683"/>
                      </a:lnTo>
                      <a:lnTo>
                        <a:pt x="3888" y="1684"/>
                      </a:lnTo>
                      <a:lnTo>
                        <a:pt x="3892" y="1684"/>
                      </a:lnTo>
                      <a:lnTo>
                        <a:pt x="3895" y="1683"/>
                      </a:lnTo>
                      <a:lnTo>
                        <a:pt x="3898" y="1684"/>
                      </a:lnTo>
                      <a:lnTo>
                        <a:pt x="3901" y="1683"/>
                      </a:lnTo>
                      <a:lnTo>
                        <a:pt x="3905" y="1682"/>
                      </a:lnTo>
                      <a:lnTo>
                        <a:pt x="3908" y="1682"/>
                      </a:lnTo>
                      <a:lnTo>
                        <a:pt x="3911" y="1682"/>
                      </a:lnTo>
                      <a:lnTo>
                        <a:pt x="3915" y="1682"/>
                      </a:lnTo>
                      <a:lnTo>
                        <a:pt x="3918" y="1681"/>
                      </a:lnTo>
                      <a:lnTo>
                        <a:pt x="3921" y="1684"/>
                      </a:lnTo>
                      <a:lnTo>
                        <a:pt x="3924" y="1683"/>
                      </a:lnTo>
                      <a:lnTo>
                        <a:pt x="3928" y="1683"/>
                      </a:lnTo>
                      <a:lnTo>
                        <a:pt x="3931" y="1681"/>
                      </a:lnTo>
                      <a:lnTo>
                        <a:pt x="3934" y="1682"/>
                      </a:lnTo>
                      <a:lnTo>
                        <a:pt x="3938" y="1683"/>
                      </a:lnTo>
                      <a:lnTo>
                        <a:pt x="3941" y="1682"/>
                      </a:lnTo>
                      <a:lnTo>
                        <a:pt x="3944" y="1681"/>
                      </a:lnTo>
                      <a:lnTo>
                        <a:pt x="3948" y="1681"/>
                      </a:lnTo>
                      <a:lnTo>
                        <a:pt x="3951" y="1683"/>
                      </a:lnTo>
                      <a:lnTo>
                        <a:pt x="3954" y="1683"/>
                      </a:lnTo>
                      <a:lnTo>
                        <a:pt x="3958" y="1682"/>
                      </a:lnTo>
                      <a:lnTo>
                        <a:pt x="3961" y="1682"/>
                      </a:lnTo>
                      <a:lnTo>
                        <a:pt x="3964" y="1682"/>
                      </a:lnTo>
                      <a:lnTo>
                        <a:pt x="3968" y="1682"/>
                      </a:lnTo>
                      <a:lnTo>
                        <a:pt x="3971" y="1681"/>
                      </a:lnTo>
                      <a:lnTo>
                        <a:pt x="3974" y="1683"/>
                      </a:lnTo>
                      <a:lnTo>
                        <a:pt x="3977" y="1683"/>
                      </a:lnTo>
                      <a:lnTo>
                        <a:pt x="3981" y="1681"/>
                      </a:lnTo>
                      <a:lnTo>
                        <a:pt x="3984" y="1682"/>
                      </a:lnTo>
                      <a:lnTo>
                        <a:pt x="3987" y="1683"/>
                      </a:lnTo>
                      <a:lnTo>
                        <a:pt x="3991" y="1683"/>
                      </a:lnTo>
                      <a:lnTo>
                        <a:pt x="3994" y="1683"/>
                      </a:lnTo>
                      <a:lnTo>
                        <a:pt x="3997" y="1682"/>
                      </a:lnTo>
                      <a:lnTo>
                        <a:pt x="4001" y="1682"/>
                      </a:lnTo>
                      <a:lnTo>
                        <a:pt x="4004" y="1681"/>
                      </a:lnTo>
                      <a:lnTo>
                        <a:pt x="4007" y="1684"/>
                      </a:lnTo>
                      <a:lnTo>
                        <a:pt x="4011" y="1682"/>
                      </a:lnTo>
                      <a:lnTo>
                        <a:pt x="4014" y="1682"/>
                      </a:lnTo>
                      <a:lnTo>
                        <a:pt x="4017" y="1683"/>
                      </a:lnTo>
                      <a:lnTo>
                        <a:pt x="4020" y="1681"/>
                      </a:lnTo>
                      <a:lnTo>
                        <a:pt x="4024" y="1682"/>
                      </a:lnTo>
                      <a:lnTo>
                        <a:pt x="4027" y="1683"/>
                      </a:lnTo>
                      <a:lnTo>
                        <a:pt x="4030" y="1683"/>
                      </a:lnTo>
                      <a:lnTo>
                        <a:pt x="4034" y="1682"/>
                      </a:lnTo>
                      <a:lnTo>
                        <a:pt x="4037" y="1681"/>
                      </a:lnTo>
                      <a:lnTo>
                        <a:pt x="4040" y="1684"/>
                      </a:lnTo>
                      <a:lnTo>
                        <a:pt x="4044" y="1683"/>
                      </a:lnTo>
                      <a:lnTo>
                        <a:pt x="4047" y="1681"/>
                      </a:lnTo>
                      <a:lnTo>
                        <a:pt x="4050" y="1683"/>
                      </a:lnTo>
                      <a:lnTo>
                        <a:pt x="4054" y="1682"/>
                      </a:lnTo>
                      <a:lnTo>
                        <a:pt x="4057" y="1682"/>
                      </a:lnTo>
                      <a:lnTo>
                        <a:pt x="4060" y="1682"/>
                      </a:lnTo>
                      <a:lnTo>
                        <a:pt x="4064" y="1683"/>
                      </a:lnTo>
                      <a:lnTo>
                        <a:pt x="4067" y="1682"/>
                      </a:lnTo>
                      <a:lnTo>
                        <a:pt x="4070" y="1684"/>
                      </a:lnTo>
                      <a:lnTo>
                        <a:pt x="4073" y="1683"/>
                      </a:lnTo>
                      <a:lnTo>
                        <a:pt x="4077" y="1683"/>
                      </a:lnTo>
                      <a:lnTo>
                        <a:pt x="4080" y="1681"/>
                      </a:lnTo>
                      <a:lnTo>
                        <a:pt x="4083" y="1683"/>
                      </a:lnTo>
                      <a:lnTo>
                        <a:pt x="4087" y="1684"/>
                      </a:lnTo>
                      <a:lnTo>
                        <a:pt x="4090" y="1683"/>
                      </a:lnTo>
                      <a:lnTo>
                        <a:pt x="4093" y="1684"/>
                      </a:lnTo>
                      <a:lnTo>
                        <a:pt x="4097" y="1683"/>
                      </a:lnTo>
                      <a:lnTo>
                        <a:pt x="4100" y="1682"/>
                      </a:lnTo>
                      <a:lnTo>
                        <a:pt x="4103" y="1682"/>
                      </a:lnTo>
                      <a:lnTo>
                        <a:pt x="4107" y="1682"/>
                      </a:lnTo>
                      <a:lnTo>
                        <a:pt x="4110" y="1681"/>
                      </a:lnTo>
                      <a:lnTo>
                        <a:pt x="4113" y="1683"/>
                      </a:lnTo>
                      <a:lnTo>
                        <a:pt x="4117" y="1684"/>
                      </a:lnTo>
                      <a:lnTo>
                        <a:pt x="4120" y="1681"/>
                      </a:lnTo>
                      <a:lnTo>
                        <a:pt x="4123" y="1683"/>
                      </a:lnTo>
                      <a:lnTo>
                        <a:pt x="4126" y="1683"/>
                      </a:lnTo>
                      <a:lnTo>
                        <a:pt x="4130" y="1681"/>
                      </a:lnTo>
                      <a:lnTo>
                        <a:pt x="4133" y="1683"/>
                      </a:lnTo>
                      <a:lnTo>
                        <a:pt x="4136" y="1683"/>
                      </a:lnTo>
                      <a:lnTo>
                        <a:pt x="4140" y="1683"/>
                      </a:lnTo>
                      <a:lnTo>
                        <a:pt x="4143" y="1682"/>
                      </a:lnTo>
                      <a:lnTo>
                        <a:pt x="4146" y="1683"/>
                      </a:lnTo>
                      <a:lnTo>
                        <a:pt x="4149" y="1684"/>
                      </a:lnTo>
                      <a:lnTo>
                        <a:pt x="4153" y="1683"/>
                      </a:lnTo>
                      <a:lnTo>
                        <a:pt x="4156" y="1684"/>
                      </a:lnTo>
                      <a:lnTo>
                        <a:pt x="4160" y="1683"/>
                      </a:lnTo>
                      <a:lnTo>
                        <a:pt x="4163" y="1683"/>
                      </a:lnTo>
                      <a:lnTo>
                        <a:pt x="4166" y="1683"/>
                      </a:lnTo>
                      <a:lnTo>
                        <a:pt x="4169" y="1681"/>
                      </a:lnTo>
                      <a:lnTo>
                        <a:pt x="4173" y="1684"/>
                      </a:lnTo>
                      <a:lnTo>
                        <a:pt x="4176" y="1682"/>
                      </a:lnTo>
                      <a:lnTo>
                        <a:pt x="4179" y="1684"/>
                      </a:lnTo>
                      <a:lnTo>
                        <a:pt x="4183" y="1683"/>
                      </a:lnTo>
                      <a:lnTo>
                        <a:pt x="4186" y="1684"/>
                      </a:lnTo>
                      <a:lnTo>
                        <a:pt x="4189" y="1684"/>
                      </a:lnTo>
                      <a:lnTo>
                        <a:pt x="4192" y="1684"/>
                      </a:lnTo>
                      <a:lnTo>
                        <a:pt x="4196" y="1683"/>
                      </a:lnTo>
                      <a:lnTo>
                        <a:pt x="4199" y="1683"/>
                      </a:lnTo>
                      <a:lnTo>
                        <a:pt x="4202" y="1684"/>
                      </a:lnTo>
                      <a:lnTo>
                        <a:pt x="4206" y="1683"/>
                      </a:lnTo>
                      <a:lnTo>
                        <a:pt x="4209" y="1682"/>
                      </a:lnTo>
                      <a:lnTo>
                        <a:pt x="4212" y="1684"/>
                      </a:lnTo>
                      <a:lnTo>
                        <a:pt x="4216" y="1684"/>
                      </a:lnTo>
                      <a:lnTo>
                        <a:pt x="4219" y="1684"/>
                      </a:lnTo>
                      <a:lnTo>
                        <a:pt x="4222" y="1681"/>
                      </a:lnTo>
                      <a:lnTo>
                        <a:pt x="4226" y="1682"/>
                      </a:lnTo>
                      <a:lnTo>
                        <a:pt x="4229" y="1684"/>
                      </a:lnTo>
                      <a:lnTo>
                        <a:pt x="4232" y="1684"/>
                      </a:lnTo>
                      <a:lnTo>
                        <a:pt x="4236" y="1683"/>
                      </a:lnTo>
                      <a:lnTo>
                        <a:pt x="4239" y="1684"/>
                      </a:lnTo>
                      <a:lnTo>
                        <a:pt x="4242" y="1684"/>
                      </a:lnTo>
                      <a:lnTo>
                        <a:pt x="4245" y="1683"/>
                      </a:lnTo>
                      <a:lnTo>
                        <a:pt x="4249" y="1683"/>
                      </a:lnTo>
                      <a:lnTo>
                        <a:pt x="4252" y="1683"/>
                      </a:lnTo>
                      <a:lnTo>
                        <a:pt x="4255" y="1683"/>
                      </a:lnTo>
                      <a:lnTo>
                        <a:pt x="4259" y="1684"/>
                      </a:lnTo>
                      <a:lnTo>
                        <a:pt x="4262" y="1684"/>
                      </a:lnTo>
                      <a:lnTo>
                        <a:pt x="4265" y="1682"/>
                      </a:lnTo>
                      <a:lnTo>
                        <a:pt x="4269" y="1683"/>
                      </a:lnTo>
                      <a:lnTo>
                        <a:pt x="4272" y="1683"/>
                      </a:lnTo>
                      <a:lnTo>
                        <a:pt x="4275" y="1683"/>
                      </a:lnTo>
                      <a:lnTo>
                        <a:pt x="4279" y="1683"/>
                      </a:lnTo>
                      <a:lnTo>
                        <a:pt x="4282" y="1682"/>
                      </a:lnTo>
                      <a:lnTo>
                        <a:pt x="4285" y="1685"/>
                      </a:lnTo>
                      <a:lnTo>
                        <a:pt x="4289" y="1683"/>
                      </a:lnTo>
                      <a:lnTo>
                        <a:pt x="4292" y="1681"/>
                      </a:lnTo>
                      <a:lnTo>
                        <a:pt x="4295" y="1684"/>
                      </a:lnTo>
                      <a:lnTo>
                        <a:pt x="4298" y="1683"/>
                      </a:lnTo>
                      <a:lnTo>
                        <a:pt x="4302" y="1683"/>
                      </a:lnTo>
                      <a:lnTo>
                        <a:pt x="4305" y="1682"/>
                      </a:lnTo>
                      <a:lnTo>
                        <a:pt x="4308" y="1682"/>
                      </a:lnTo>
                      <a:lnTo>
                        <a:pt x="4312" y="1683"/>
                      </a:lnTo>
                      <a:lnTo>
                        <a:pt x="4315" y="1682"/>
                      </a:lnTo>
                      <a:lnTo>
                        <a:pt x="4318" y="1683"/>
                      </a:lnTo>
                      <a:lnTo>
                        <a:pt x="4322" y="1685"/>
                      </a:lnTo>
                      <a:lnTo>
                        <a:pt x="4325" y="1683"/>
                      </a:lnTo>
                      <a:lnTo>
                        <a:pt x="4328" y="1683"/>
                      </a:lnTo>
                      <a:lnTo>
                        <a:pt x="4332" y="1683"/>
                      </a:lnTo>
                      <a:lnTo>
                        <a:pt x="4335" y="1684"/>
                      </a:lnTo>
                      <a:lnTo>
                        <a:pt x="4338" y="1683"/>
                      </a:lnTo>
                      <a:lnTo>
                        <a:pt x="4341" y="1683"/>
                      </a:lnTo>
                      <a:lnTo>
                        <a:pt x="4345" y="1683"/>
                      </a:lnTo>
                      <a:lnTo>
                        <a:pt x="4348" y="1683"/>
                      </a:lnTo>
                      <a:lnTo>
                        <a:pt x="4351" y="1683"/>
                      </a:lnTo>
                      <a:lnTo>
                        <a:pt x="4355" y="1681"/>
                      </a:lnTo>
                      <a:lnTo>
                        <a:pt x="4358" y="1682"/>
                      </a:lnTo>
                      <a:lnTo>
                        <a:pt x="4361" y="1683"/>
                      </a:lnTo>
                      <a:lnTo>
                        <a:pt x="4365" y="1684"/>
                      </a:lnTo>
                      <a:lnTo>
                        <a:pt x="4368" y="1684"/>
                      </a:lnTo>
                      <a:lnTo>
                        <a:pt x="4371" y="1683"/>
                      </a:lnTo>
                      <a:lnTo>
                        <a:pt x="4375" y="1683"/>
                      </a:lnTo>
                      <a:lnTo>
                        <a:pt x="4378" y="1684"/>
                      </a:lnTo>
                      <a:lnTo>
                        <a:pt x="4381" y="1682"/>
                      </a:lnTo>
                      <a:lnTo>
                        <a:pt x="4385" y="1681"/>
                      </a:lnTo>
                      <a:lnTo>
                        <a:pt x="4388" y="1683"/>
                      </a:lnTo>
                      <a:lnTo>
                        <a:pt x="4391" y="1683"/>
                      </a:lnTo>
                      <a:lnTo>
                        <a:pt x="4394" y="1682"/>
                      </a:lnTo>
                      <a:lnTo>
                        <a:pt x="4398" y="1683"/>
                      </a:lnTo>
                      <a:lnTo>
                        <a:pt x="4401" y="1682"/>
                      </a:lnTo>
                      <a:lnTo>
                        <a:pt x="4404" y="1683"/>
                      </a:lnTo>
                      <a:lnTo>
                        <a:pt x="4408" y="1681"/>
                      </a:lnTo>
                      <a:lnTo>
                        <a:pt x="4411" y="1683"/>
                      </a:lnTo>
                      <a:lnTo>
                        <a:pt x="4414" y="1683"/>
                      </a:lnTo>
                      <a:lnTo>
                        <a:pt x="4417" y="1684"/>
                      </a:lnTo>
                      <a:lnTo>
                        <a:pt x="4421" y="1683"/>
                      </a:lnTo>
                      <a:lnTo>
                        <a:pt x="4424" y="1682"/>
                      </a:lnTo>
                      <a:lnTo>
                        <a:pt x="4428" y="1683"/>
                      </a:lnTo>
                      <a:lnTo>
                        <a:pt x="4431" y="1682"/>
                      </a:lnTo>
                      <a:lnTo>
                        <a:pt x="4434" y="1683"/>
                      </a:lnTo>
                      <a:lnTo>
                        <a:pt x="4437" y="1681"/>
                      </a:lnTo>
                      <a:lnTo>
                        <a:pt x="4441" y="1681"/>
                      </a:lnTo>
                      <a:lnTo>
                        <a:pt x="4444" y="1683"/>
                      </a:lnTo>
                      <a:lnTo>
                        <a:pt x="4447" y="1683"/>
                      </a:lnTo>
                      <a:lnTo>
                        <a:pt x="4451" y="1682"/>
                      </a:lnTo>
                      <a:lnTo>
                        <a:pt x="4454" y="1681"/>
                      </a:lnTo>
                      <a:lnTo>
                        <a:pt x="4457" y="1681"/>
                      </a:lnTo>
                      <a:lnTo>
                        <a:pt x="4461" y="1683"/>
                      </a:lnTo>
                      <a:lnTo>
                        <a:pt x="4464" y="1682"/>
                      </a:lnTo>
                      <a:lnTo>
                        <a:pt x="4467" y="1682"/>
                      </a:lnTo>
                      <a:lnTo>
                        <a:pt x="4470" y="1684"/>
                      </a:lnTo>
                      <a:lnTo>
                        <a:pt x="4474" y="1682"/>
                      </a:lnTo>
                      <a:lnTo>
                        <a:pt x="4477" y="1682"/>
                      </a:lnTo>
                      <a:lnTo>
                        <a:pt x="4480" y="1680"/>
                      </a:lnTo>
                      <a:lnTo>
                        <a:pt x="4484" y="1681"/>
                      </a:lnTo>
                      <a:lnTo>
                        <a:pt x="4487" y="1680"/>
                      </a:lnTo>
                      <a:lnTo>
                        <a:pt x="4490" y="1682"/>
                      </a:lnTo>
                      <a:lnTo>
                        <a:pt x="4494" y="1683"/>
                      </a:lnTo>
                      <a:lnTo>
                        <a:pt x="4497" y="1683"/>
                      </a:lnTo>
                      <a:lnTo>
                        <a:pt x="4500" y="1682"/>
                      </a:lnTo>
                      <a:lnTo>
                        <a:pt x="4504" y="1683"/>
                      </a:lnTo>
                      <a:lnTo>
                        <a:pt x="4507" y="1682"/>
                      </a:lnTo>
                      <a:lnTo>
                        <a:pt x="4510" y="1682"/>
                      </a:lnTo>
                      <a:lnTo>
                        <a:pt x="4513" y="1681"/>
                      </a:lnTo>
                      <a:lnTo>
                        <a:pt x="4517" y="1681"/>
                      </a:lnTo>
                      <a:lnTo>
                        <a:pt x="4520" y="1682"/>
                      </a:lnTo>
                      <a:lnTo>
                        <a:pt x="4523" y="1681"/>
                      </a:lnTo>
                      <a:lnTo>
                        <a:pt x="4527" y="1681"/>
                      </a:lnTo>
                      <a:lnTo>
                        <a:pt x="4530" y="1679"/>
                      </a:lnTo>
                      <a:lnTo>
                        <a:pt x="4533" y="1680"/>
                      </a:lnTo>
                      <a:lnTo>
                        <a:pt x="4537" y="1680"/>
                      </a:lnTo>
                      <a:lnTo>
                        <a:pt x="4540" y="1681"/>
                      </a:lnTo>
                      <a:lnTo>
                        <a:pt x="4543" y="1681"/>
                      </a:lnTo>
                      <a:lnTo>
                        <a:pt x="4547" y="1680"/>
                      </a:lnTo>
                      <a:lnTo>
                        <a:pt x="4550" y="1681"/>
                      </a:lnTo>
                      <a:lnTo>
                        <a:pt x="4553" y="1681"/>
                      </a:lnTo>
                      <a:lnTo>
                        <a:pt x="4557" y="1680"/>
                      </a:lnTo>
                      <a:lnTo>
                        <a:pt x="4560" y="1680"/>
                      </a:lnTo>
                      <a:lnTo>
                        <a:pt x="4563" y="1680"/>
                      </a:lnTo>
                      <a:lnTo>
                        <a:pt x="4566" y="1680"/>
                      </a:lnTo>
                      <a:lnTo>
                        <a:pt x="4570" y="1679"/>
                      </a:lnTo>
                      <a:lnTo>
                        <a:pt x="4573" y="1679"/>
                      </a:lnTo>
                      <a:lnTo>
                        <a:pt x="4576" y="1681"/>
                      </a:lnTo>
                      <a:lnTo>
                        <a:pt x="4580" y="1681"/>
                      </a:lnTo>
                      <a:lnTo>
                        <a:pt x="4583" y="1682"/>
                      </a:lnTo>
                      <a:lnTo>
                        <a:pt x="4586" y="1681"/>
                      </a:lnTo>
                      <a:lnTo>
                        <a:pt x="4590" y="1680"/>
                      </a:lnTo>
                      <a:lnTo>
                        <a:pt x="4593" y="1682"/>
                      </a:lnTo>
                      <a:lnTo>
                        <a:pt x="4596" y="1682"/>
                      </a:lnTo>
                      <a:lnTo>
                        <a:pt x="4600" y="1680"/>
                      </a:lnTo>
                      <a:lnTo>
                        <a:pt x="4603" y="1679"/>
                      </a:lnTo>
                      <a:lnTo>
                        <a:pt x="4606" y="1680"/>
                      </a:lnTo>
                      <a:lnTo>
                        <a:pt x="4609" y="1681"/>
                      </a:lnTo>
                      <a:lnTo>
                        <a:pt x="4613" y="1681"/>
                      </a:lnTo>
                      <a:lnTo>
                        <a:pt x="4616" y="1681"/>
                      </a:lnTo>
                      <a:lnTo>
                        <a:pt x="4619" y="1681"/>
                      </a:lnTo>
                      <a:lnTo>
                        <a:pt x="4623" y="1681"/>
                      </a:lnTo>
                      <a:lnTo>
                        <a:pt x="4626" y="1681"/>
                      </a:lnTo>
                      <a:lnTo>
                        <a:pt x="4629" y="1680"/>
                      </a:lnTo>
                      <a:lnTo>
                        <a:pt x="4633" y="1684"/>
                      </a:lnTo>
                      <a:lnTo>
                        <a:pt x="4636" y="1681"/>
                      </a:lnTo>
                      <a:lnTo>
                        <a:pt x="4639" y="1681"/>
                      </a:lnTo>
                      <a:lnTo>
                        <a:pt x="4643" y="1682"/>
                      </a:lnTo>
                      <a:lnTo>
                        <a:pt x="4646" y="1683"/>
                      </a:lnTo>
                      <a:lnTo>
                        <a:pt x="4649" y="1683"/>
                      </a:lnTo>
                      <a:lnTo>
                        <a:pt x="4653" y="1682"/>
                      </a:lnTo>
                      <a:lnTo>
                        <a:pt x="4656" y="1683"/>
                      </a:lnTo>
                      <a:lnTo>
                        <a:pt x="4659" y="1681"/>
                      </a:lnTo>
                      <a:lnTo>
                        <a:pt x="4662" y="1682"/>
                      </a:lnTo>
                      <a:lnTo>
                        <a:pt x="4666" y="1682"/>
                      </a:lnTo>
                      <a:lnTo>
                        <a:pt x="4669" y="1682"/>
                      </a:lnTo>
                      <a:lnTo>
                        <a:pt x="4672" y="1681"/>
                      </a:lnTo>
                      <a:lnTo>
                        <a:pt x="4676" y="1682"/>
                      </a:lnTo>
                      <a:lnTo>
                        <a:pt x="4679" y="1682"/>
                      </a:lnTo>
                      <a:lnTo>
                        <a:pt x="4682" y="1683"/>
                      </a:lnTo>
                      <a:lnTo>
                        <a:pt x="4685" y="1683"/>
                      </a:lnTo>
                      <a:lnTo>
                        <a:pt x="4689" y="1682"/>
                      </a:lnTo>
                      <a:lnTo>
                        <a:pt x="4692" y="1682"/>
                      </a:lnTo>
                      <a:lnTo>
                        <a:pt x="4696" y="1682"/>
                      </a:lnTo>
                      <a:lnTo>
                        <a:pt x="4699" y="1684"/>
                      </a:lnTo>
                      <a:lnTo>
                        <a:pt x="4702" y="1684"/>
                      </a:lnTo>
                      <a:lnTo>
                        <a:pt x="4706" y="1684"/>
                      </a:lnTo>
                      <a:lnTo>
                        <a:pt x="4709" y="1683"/>
                      </a:lnTo>
                      <a:lnTo>
                        <a:pt x="4712" y="1683"/>
                      </a:lnTo>
                      <a:lnTo>
                        <a:pt x="4715" y="1682"/>
                      </a:lnTo>
                      <a:lnTo>
                        <a:pt x="4719" y="1682"/>
                      </a:lnTo>
                      <a:lnTo>
                        <a:pt x="4722" y="1684"/>
                      </a:lnTo>
                      <a:lnTo>
                        <a:pt x="4725" y="1682"/>
                      </a:lnTo>
                      <a:lnTo>
                        <a:pt x="4729" y="1681"/>
                      </a:lnTo>
                      <a:lnTo>
                        <a:pt x="4732" y="1683"/>
                      </a:lnTo>
                      <a:lnTo>
                        <a:pt x="4735" y="1682"/>
                      </a:lnTo>
                      <a:lnTo>
                        <a:pt x="4738" y="1682"/>
                      </a:lnTo>
                      <a:lnTo>
                        <a:pt x="4742" y="1682"/>
                      </a:lnTo>
                      <a:lnTo>
                        <a:pt x="4745" y="1683"/>
                      </a:lnTo>
                      <a:lnTo>
                        <a:pt x="4748" y="1683"/>
                      </a:lnTo>
                      <a:lnTo>
                        <a:pt x="4752" y="1682"/>
                      </a:lnTo>
                      <a:lnTo>
                        <a:pt x="4755" y="1682"/>
                      </a:lnTo>
                      <a:lnTo>
                        <a:pt x="4758" y="1683"/>
                      </a:lnTo>
                      <a:lnTo>
                        <a:pt x="4762" y="1685"/>
                      </a:lnTo>
                      <a:lnTo>
                        <a:pt x="4765" y="1684"/>
                      </a:lnTo>
                      <a:lnTo>
                        <a:pt x="4768" y="1682"/>
                      </a:lnTo>
                      <a:lnTo>
                        <a:pt x="4772" y="1683"/>
                      </a:lnTo>
                      <a:lnTo>
                        <a:pt x="4775" y="1683"/>
                      </a:lnTo>
                      <a:lnTo>
                        <a:pt x="4778" y="1682"/>
                      </a:lnTo>
                      <a:lnTo>
                        <a:pt x="4781" y="1682"/>
                      </a:lnTo>
                      <a:lnTo>
                        <a:pt x="4785" y="1682"/>
                      </a:lnTo>
                      <a:lnTo>
                        <a:pt x="4788" y="1683"/>
                      </a:lnTo>
                      <a:lnTo>
                        <a:pt x="4791" y="1684"/>
                      </a:lnTo>
                      <a:lnTo>
                        <a:pt x="4795" y="1683"/>
                      </a:lnTo>
                      <a:lnTo>
                        <a:pt x="4798" y="1683"/>
                      </a:lnTo>
                      <a:lnTo>
                        <a:pt x="4801" y="1683"/>
                      </a:lnTo>
                      <a:lnTo>
                        <a:pt x="4805" y="1683"/>
                      </a:lnTo>
                      <a:lnTo>
                        <a:pt x="4808" y="1683"/>
                      </a:lnTo>
                      <a:lnTo>
                        <a:pt x="4811" y="1684"/>
                      </a:lnTo>
                      <a:lnTo>
                        <a:pt x="4815" y="1684"/>
                      </a:lnTo>
                      <a:lnTo>
                        <a:pt x="4818" y="1683"/>
                      </a:lnTo>
                      <a:lnTo>
                        <a:pt x="4821" y="1683"/>
                      </a:lnTo>
                      <a:lnTo>
                        <a:pt x="4825" y="1684"/>
                      </a:lnTo>
                      <a:lnTo>
                        <a:pt x="4828" y="1683"/>
                      </a:lnTo>
                      <a:lnTo>
                        <a:pt x="4831" y="1686"/>
                      </a:lnTo>
                      <a:lnTo>
                        <a:pt x="4834" y="1683"/>
                      </a:lnTo>
                      <a:lnTo>
                        <a:pt x="4838" y="1683"/>
                      </a:lnTo>
                      <a:lnTo>
                        <a:pt x="4841" y="1682"/>
                      </a:lnTo>
                      <a:lnTo>
                        <a:pt x="4844" y="1682"/>
                      </a:lnTo>
                      <a:lnTo>
                        <a:pt x="4848" y="1683"/>
                      </a:lnTo>
                      <a:lnTo>
                        <a:pt x="4851" y="1683"/>
                      </a:lnTo>
                      <a:lnTo>
                        <a:pt x="4854" y="1683"/>
                      </a:lnTo>
                      <a:lnTo>
                        <a:pt x="4858" y="1683"/>
                      </a:lnTo>
                      <a:lnTo>
                        <a:pt x="4861" y="1684"/>
                      </a:lnTo>
                      <a:lnTo>
                        <a:pt x="4864" y="1684"/>
                      </a:lnTo>
                      <a:lnTo>
                        <a:pt x="4868" y="1683"/>
                      </a:lnTo>
                      <a:lnTo>
                        <a:pt x="4871" y="1683"/>
                      </a:lnTo>
                      <a:lnTo>
                        <a:pt x="4874" y="1683"/>
                      </a:lnTo>
                      <a:lnTo>
                        <a:pt x="4878" y="1684"/>
                      </a:lnTo>
                      <a:lnTo>
                        <a:pt x="4881" y="1683"/>
                      </a:lnTo>
                      <a:lnTo>
                        <a:pt x="4884" y="1684"/>
                      </a:lnTo>
                      <a:lnTo>
                        <a:pt x="4887" y="1683"/>
                      </a:lnTo>
                      <a:lnTo>
                        <a:pt x="4891" y="1683"/>
                      </a:lnTo>
                      <a:lnTo>
                        <a:pt x="4894" y="1683"/>
                      </a:lnTo>
                      <a:lnTo>
                        <a:pt x="4897" y="1684"/>
                      </a:lnTo>
                      <a:lnTo>
                        <a:pt x="4901" y="1682"/>
                      </a:lnTo>
                      <a:lnTo>
                        <a:pt x="4904" y="1684"/>
                      </a:lnTo>
                      <a:lnTo>
                        <a:pt x="4907" y="1683"/>
                      </a:lnTo>
                      <a:lnTo>
                        <a:pt x="4911" y="1682"/>
                      </a:lnTo>
                      <a:lnTo>
                        <a:pt x="4914" y="1682"/>
                      </a:lnTo>
                      <a:lnTo>
                        <a:pt x="4917" y="1682"/>
                      </a:lnTo>
                      <a:lnTo>
                        <a:pt x="4921" y="1685"/>
                      </a:lnTo>
                      <a:lnTo>
                        <a:pt x="4924" y="1684"/>
                      </a:lnTo>
                      <a:lnTo>
                        <a:pt x="4927" y="1683"/>
                      </a:lnTo>
                      <a:lnTo>
                        <a:pt x="4930" y="1684"/>
                      </a:lnTo>
                      <a:lnTo>
                        <a:pt x="4934" y="1683"/>
                      </a:lnTo>
                      <a:lnTo>
                        <a:pt x="4937" y="1685"/>
                      </a:lnTo>
                      <a:lnTo>
                        <a:pt x="4940" y="1684"/>
                      </a:lnTo>
                      <a:lnTo>
                        <a:pt x="4944" y="1685"/>
                      </a:lnTo>
                      <a:lnTo>
                        <a:pt x="4947" y="1682"/>
                      </a:lnTo>
                      <a:lnTo>
                        <a:pt x="4950" y="1684"/>
                      </a:lnTo>
                      <a:lnTo>
                        <a:pt x="4953" y="1683"/>
                      </a:lnTo>
                      <a:lnTo>
                        <a:pt x="4957" y="1685"/>
                      </a:lnTo>
                      <a:lnTo>
                        <a:pt x="4960" y="1684"/>
                      </a:lnTo>
                      <a:lnTo>
                        <a:pt x="4964" y="1681"/>
                      </a:lnTo>
                      <a:lnTo>
                        <a:pt x="4965" y="1682"/>
                      </a:lnTo>
                    </a:path>
                  </a:pathLst>
                </a:custGeom>
                <a:noFill/>
                <a:ln w="9525" cap="flat" cmpd="sng">
                  <a:solidFill>
                    <a:srgbClr val="0000FF"/>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000"/>
                    <a:buFont typeface="Arial"/>
                    <a:buNone/>
                  </a:pPr>
                  <a:endParaRPr sz="800" b="0" i="0" u="none" strike="noStrike" cap="none">
                    <a:solidFill>
                      <a:srgbClr val="000000"/>
                    </a:solidFill>
                    <a:latin typeface="Arial"/>
                    <a:ea typeface="Arial"/>
                    <a:cs typeface="Arial"/>
                    <a:sym typeface="Arial"/>
                  </a:endParaRPr>
                </a:p>
              </p:txBody>
            </p:sp>
            <p:cxnSp>
              <p:nvCxnSpPr>
                <p:cNvPr id="1702" name="Google Shape;1702;p11"/>
                <p:cNvCxnSpPr/>
                <p:nvPr/>
              </p:nvCxnSpPr>
              <p:spPr>
                <a:xfrm>
                  <a:off x="4571" y="1608"/>
                  <a:ext cx="0" cy="18"/>
                </a:xfrm>
                <a:prstGeom prst="straightConnector1">
                  <a:avLst/>
                </a:prstGeom>
                <a:noFill/>
                <a:ln w="9525" cap="flat" cmpd="sng">
                  <a:solidFill>
                    <a:srgbClr val="0000FF"/>
                  </a:solidFill>
                  <a:prstDash val="solid"/>
                  <a:round/>
                  <a:headEnd type="none" w="sm" len="sm"/>
                  <a:tailEnd type="none" w="sm" len="sm"/>
                </a:ln>
              </p:spPr>
            </p:cxnSp>
          </p:grpSp>
          <p:sp>
            <p:nvSpPr>
              <p:cNvPr id="1703" name="Google Shape;1703;p11"/>
              <p:cNvSpPr/>
              <p:nvPr/>
            </p:nvSpPr>
            <p:spPr>
              <a:xfrm>
                <a:off x="8808893" y="3520525"/>
                <a:ext cx="117609" cy="92754"/>
              </a:xfrm>
              <a:prstGeom prst="rect">
                <a:avLst/>
              </a:prstGeom>
              <a:solidFill>
                <a:srgbClr val="0000FF"/>
              </a:solidFill>
              <a:ln w="25400" cap="flat" cmpd="sng">
                <a:solidFill>
                  <a:srgbClr val="0000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100"/>
                  <a:buFont typeface="Arial"/>
                  <a:buNone/>
                </a:pPr>
                <a:endParaRPr sz="800" b="0" i="0" u="none" strike="noStrike" cap="none">
                  <a:solidFill>
                    <a:schemeClr val="lt1"/>
                  </a:solidFill>
                  <a:latin typeface="Arial"/>
                  <a:ea typeface="Arial"/>
                  <a:cs typeface="Arial"/>
                  <a:sym typeface="Arial"/>
                </a:endParaRPr>
              </a:p>
            </p:txBody>
          </p:sp>
          <p:sp>
            <p:nvSpPr>
              <p:cNvPr id="1704" name="Google Shape;1704;p11"/>
              <p:cNvSpPr/>
              <p:nvPr/>
            </p:nvSpPr>
            <p:spPr>
              <a:xfrm>
                <a:off x="8808893" y="2927132"/>
                <a:ext cx="117609" cy="92754"/>
              </a:xfrm>
              <a:prstGeom prst="rect">
                <a:avLst/>
              </a:prstGeom>
              <a:solidFill>
                <a:schemeClr val="dk1"/>
              </a:solid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100"/>
                  <a:buFont typeface="Arial"/>
                  <a:buNone/>
                </a:pPr>
                <a:endParaRPr sz="800" b="0" i="0" u="none" strike="noStrike" cap="none">
                  <a:solidFill>
                    <a:schemeClr val="dk1"/>
                  </a:solidFill>
                  <a:latin typeface="Arial"/>
                  <a:ea typeface="Arial"/>
                  <a:cs typeface="Arial"/>
                  <a:sym typeface="Arial"/>
                </a:endParaRPr>
              </a:p>
            </p:txBody>
          </p:sp>
          <p:sp>
            <p:nvSpPr>
              <p:cNvPr id="1705" name="Google Shape;1705;p11"/>
              <p:cNvSpPr txBox="1"/>
              <p:nvPr/>
            </p:nvSpPr>
            <p:spPr>
              <a:xfrm>
                <a:off x="8902780" y="3383105"/>
                <a:ext cx="531000" cy="7311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000"/>
                  <a:buFont typeface="Arial"/>
                  <a:buNone/>
                </a:pPr>
                <a:r>
                  <a:rPr lang="en-GB" sz="800" b="0" i="0" u="none" strike="noStrike" cap="none">
                    <a:solidFill>
                      <a:srgbClr val="000000"/>
                    </a:solidFill>
                    <a:latin typeface="Arial"/>
                    <a:ea typeface="Arial"/>
                    <a:cs typeface="Arial"/>
                    <a:sym typeface="Arial"/>
                  </a:rPr>
                  <a:t>3T</a:t>
                </a:r>
                <a:endParaRPr sz="800" b="0" i="0" u="none" strike="noStrike" cap="none">
                  <a:solidFill>
                    <a:srgbClr val="000000"/>
                  </a:solidFill>
                  <a:latin typeface="Arial"/>
                  <a:ea typeface="Arial"/>
                  <a:cs typeface="Arial"/>
                  <a:sym typeface="Arial"/>
                </a:endParaRPr>
              </a:p>
            </p:txBody>
          </p:sp>
          <p:sp>
            <p:nvSpPr>
              <p:cNvPr id="1706" name="Google Shape;1706;p11"/>
              <p:cNvSpPr txBox="1"/>
              <p:nvPr/>
            </p:nvSpPr>
            <p:spPr>
              <a:xfrm>
                <a:off x="8883523" y="2746332"/>
                <a:ext cx="470219" cy="44991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000"/>
                  <a:buFont typeface="Arial"/>
                  <a:buNone/>
                </a:pPr>
                <a:r>
                  <a:rPr lang="en-GB" sz="800" dirty="0"/>
                  <a:t>N</a:t>
                </a:r>
                <a:r>
                  <a:rPr lang="en-GB" sz="800" b="0" i="0" u="none" strike="noStrike" cap="none" dirty="0">
                    <a:solidFill>
                      <a:srgbClr val="000000"/>
                    </a:solidFill>
                    <a:latin typeface="Arial"/>
                    <a:ea typeface="Arial"/>
                    <a:cs typeface="Arial"/>
                    <a:sym typeface="Arial"/>
                  </a:rPr>
                  <a:t>T</a:t>
                </a:r>
                <a:endParaRPr sz="800" b="0" i="0" u="none" strike="noStrike" cap="none" dirty="0">
                  <a:solidFill>
                    <a:srgbClr val="000000"/>
                  </a:solidFill>
                  <a:latin typeface="Arial"/>
                  <a:ea typeface="Arial"/>
                  <a:cs typeface="Arial"/>
                  <a:sym typeface="Arial"/>
                </a:endParaRPr>
              </a:p>
            </p:txBody>
          </p:sp>
          <p:sp>
            <p:nvSpPr>
              <p:cNvPr id="1707" name="Google Shape;1707;p11"/>
              <p:cNvSpPr/>
              <p:nvPr/>
            </p:nvSpPr>
            <p:spPr>
              <a:xfrm>
                <a:off x="8808893" y="3222613"/>
                <a:ext cx="117609" cy="92753"/>
              </a:xfrm>
              <a:prstGeom prst="rect">
                <a:avLst/>
              </a:prstGeom>
              <a:solidFill>
                <a:srgbClr val="FF5CFF"/>
              </a:solidFill>
              <a:ln w="25400" cap="flat" cmpd="sng">
                <a:solidFill>
                  <a:srgbClr val="FF5C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100"/>
                  <a:buFont typeface="Arial"/>
                  <a:buNone/>
                </a:pPr>
                <a:endParaRPr sz="800" b="0" i="0" u="none" strike="noStrike" cap="none">
                  <a:solidFill>
                    <a:schemeClr val="lt1"/>
                  </a:solidFill>
                  <a:latin typeface="Arial"/>
                  <a:ea typeface="Arial"/>
                  <a:cs typeface="Arial"/>
                  <a:sym typeface="Arial"/>
                </a:endParaRPr>
              </a:p>
            </p:txBody>
          </p:sp>
          <p:sp>
            <p:nvSpPr>
              <p:cNvPr id="1708" name="Google Shape;1708;p11"/>
              <p:cNvSpPr txBox="1"/>
              <p:nvPr/>
            </p:nvSpPr>
            <p:spPr>
              <a:xfrm>
                <a:off x="8883523" y="3064646"/>
                <a:ext cx="531000" cy="45000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000"/>
                  <a:buFont typeface="Arial"/>
                  <a:buNone/>
                </a:pPr>
                <a:r>
                  <a:rPr lang="en-GB" sz="800" b="0" i="0" u="none" strike="noStrike" cap="none">
                    <a:solidFill>
                      <a:srgbClr val="000000"/>
                    </a:solidFill>
                    <a:latin typeface="Arial"/>
                    <a:ea typeface="Arial"/>
                    <a:cs typeface="Arial"/>
                    <a:sym typeface="Arial"/>
                  </a:rPr>
                  <a:t>1T</a:t>
                </a:r>
                <a:endParaRPr sz="800" b="0" i="0" u="none" strike="noStrike" cap="none">
                  <a:solidFill>
                    <a:srgbClr val="000000"/>
                  </a:solidFill>
                  <a:latin typeface="Arial"/>
                  <a:ea typeface="Arial"/>
                  <a:cs typeface="Arial"/>
                  <a:sym typeface="Arial"/>
                </a:endParaRPr>
              </a:p>
            </p:txBody>
          </p:sp>
          <p:sp>
            <p:nvSpPr>
              <p:cNvPr id="1709" name="Google Shape;1709;p11"/>
              <p:cNvSpPr txBox="1"/>
              <p:nvPr/>
            </p:nvSpPr>
            <p:spPr>
              <a:xfrm>
                <a:off x="6898652" y="2148542"/>
                <a:ext cx="992100" cy="45000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000"/>
                  <a:buFont typeface="Arial"/>
                  <a:buNone/>
                </a:pPr>
                <a:r>
                  <a:rPr lang="en-GB" sz="800" b="0" i="0" u="none" strike="noStrike" cap="none" dirty="0">
                    <a:solidFill>
                      <a:srgbClr val="000000"/>
                    </a:solidFill>
                    <a:latin typeface="Arial"/>
                    <a:ea typeface="Arial"/>
                    <a:cs typeface="Arial"/>
                    <a:sym typeface="Arial"/>
                  </a:rPr>
                  <a:t>dsRNA</a:t>
                </a:r>
                <a:endParaRPr sz="800" b="0" i="0" u="none" strike="noStrike" cap="none" dirty="0">
                  <a:solidFill>
                    <a:srgbClr val="000000"/>
                  </a:solidFill>
                  <a:latin typeface="Arial"/>
                  <a:ea typeface="Arial"/>
                  <a:cs typeface="Arial"/>
                  <a:sym typeface="Arial"/>
                </a:endParaRPr>
              </a:p>
            </p:txBody>
          </p:sp>
        </p:grpSp>
        <p:sp>
          <p:nvSpPr>
            <p:cNvPr id="1711" name="Google Shape;1711;p11"/>
            <p:cNvSpPr txBox="1"/>
            <p:nvPr/>
          </p:nvSpPr>
          <p:spPr>
            <a:xfrm flipH="1">
              <a:off x="-15343" y="2542140"/>
              <a:ext cx="387300" cy="21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endParaRPr sz="800" b="0" i="0" u="none" strike="noStrike" cap="none">
                <a:solidFill>
                  <a:srgbClr val="000000"/>
                </a:solidFill>
                <a:latin typeface="Arial"/>
                <a:ea typeface="Arial"/>
                <a:cs typeface="Arial"/>
                <a:sym typeface="Arial"/>
              </a:endParaRPr>
            </a:p>
          </p:txBody>
        </p:sp>
        <p:sp>
          <p:nvSpPr>
            <p:cNvPr id="1712" name="Google Shape;1712;p11"/>
            <p:cNvSpPr txBox="1"/>
            <p:nvPr/>
          </p:nvSpPr>
          <p:spPr>
            <a:xfrm>
              <a:off x="884775" y="2631225"/>
              <a:ext cx="1386300" cy="21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GB" sz="800" b="0" i="0" u="none" strike="noStrike" cap="none" dirty="0">
                  <a:solidFill>
                    <a:srgbClr val="000000"/>
                  </a:solidFill>
                  <a:latin typeface="Arial"/>
                  <a:ea typeface="Arial"/>
                  <a:cs typeface="Arial"/>
                  <a:sym typeface="Arial"/>
                </a:rPr>
                <a:t>GFP +RNase T1</a:t>
              </a:r>
              <a:endParaRPr sz="800" b="0" i="0" u="none" strike="noStrike" cap="none" dirty="0">
                <a:solidFill>
                  <a:srgbClr val="000000"/>
                </a:solidFill>
                <a:latin typeface="Arial"/>
                <a:ea typeface="Arial"/>
                <a:cs typeface="Arial"/>
                <a:sym typeface="Arial"/>
              </a:endParaRPr>
            </a:p>
          </p:txBody>
        </p:sp>
        <p:sp>
          <p:nvSpPr>
            <p:cNvPr id="1713" name="Google Shape;1713;p11"/>
            <p:cNvSpPr txBox="1"/>
            <p:nvPr/>
          </p:nvSpPr>
          <p:spPr>
            <a:xfrm>
              <a:off x="878625" y="5133649"/>
              <a:ext cx="1665600" cy="24346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GB" sz="800" b="0" i="0" u="none" strike="noStrike" cap="none" dirty="0">
                  <a:solidFill>
                    <a:schemeClr val="dk1"/>
                  </a:solidFill>
                  <a:latin typeface="Arial"/>
                  <a:ea typeface="Arial"/>
                  <a:cs typeface="Arial"/>
                  <a:sym typeface="Arial"/>
                </a:rPr>
                <a:t>β-Actin</a:t>
              </a:r>
              <a:r>
                <a:rPr lang="en-GB" sz="800" b="0" i="0" u="none" strike="noStrike" cap="none" dirty="0">
                  <a:solidFill>
                    <a:srgbClr val="000000"/>
                  </a:solidFill>
                  <a:latin typeface="Arial"/>
                  <a:ea typeface="Arial"/>
                  <a:cs typeface="Arial"/>
                  <a:sym typeface="Arial"/>
                </a:rPr>
                <a:t> -RNase T1</a:t>
              </a:r>
              <a:endParaRPr sz="800" b="0" i="0" u="none" strike="noStrike" cap="none" dirty="0">
                <a:solidFill>
                  <a:srgbClr val="000000"/>
                </a:solidFill>
                <a:latin typeface="Arial"/>
                <a:ea typeface="Arial"/>
                <a:cs typeface="Arial"/>
                <a:sym typeface="Arial"/>
              </a:endParaRPr>
            </a:p>
          </p:txBody>
        </p:sp>
        <p:sp>
          <p:nvSpPr>
            <p:cNvPr id="1714" name="Google Shape;1714;p11"/>
            <p:cNvSpPr txBox="1"/>
            <p:nvPr/>
          </p:nvSpPr>
          <p:spPr>
            <a:xfrm>
              <a:off x="872025" y="7581250"/>
              <a:ext cx="1910400" cy="24346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GB" sz="800" b="0" i="0" u="none" strike="noStrike" cap="none" dirty="0">
                  <a:solidFill>
                    <a:schemeClr val="dk1"/>
                  </a:solidFill>
                  <a:latin typeface="Arial"/>
                  <a:ea typeface="Arial"/>
                  <a:cs typeface="Arial"/>
                  <a:sym typeface="Arial"/>
                </a:rPr>
                <a:t>β-Actin</a:t>
              </a:r>
              <a:r>
                <a:rPr lang="en-GB" sz="800" b="0" i="0" u="none" strike="noStrike" cap="none" dirty="0">
                  <a:solidFill>
                    <a:srgbClr val="000000"/>
                  </a:solidFill>
                  <a:latin typeface="Arial"/>
                  <a:ea typeface="Arial"/>
                  <a:cs typeface="Arial"/>
                  <a:sym typeface="Arial"/>
                </a:rPr>
                <a:t> +RNase T1</a:t>
              </a:r>
              <a:endParaRPr sz="800" b="0" i="0" u="none" strike="noStrike" cap="none" dirty="0">
                <a:solidFill>
                  <a:srgbClr val="000000"/>
                </a:solidFill>
                <a:latin typeface="Arial"/>
                <a:ea typeface="Arial"/>
                <a:cs typeface="Arial"/>
                <a:sym typeface="Arial"/>
              </a:endParaRPr>
            </a:p>
          </p:txBody>
        </p:sp>
        <p:sp>
          <p:nvSpPr>
            <p:cNvPr id="1715" name="Google Shape;1715;p11"/>
            <p:cNvSpPr txBox="1"/>
            <p:nvPr/>
          </p:nvSpPr>
          <p:spPr>
            <a:xfrm>
              <a:off x="891375" y="115625"/>
              <a:ext cx="1386300" cy="21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GB" sz="800" b="0" i="0" u="none" strike="noStrike" cap="none" dirty="0">
                  <a:solidFill>
                    <a:srgbClr val="000000"/>
                  </a:solidFill>
                  <a:latin typeface="Arial"/>
                  <a:ea typeface="Arial"/>
                  <a:cs typeface="Arial"/>
                  <a:sym typeface="Arial"/>
                </a:rPr>
                <a:t>GFP -RNase T1</a:t>
              </a:r>
              <a:endParaRPr sz="800" b="0" i="0" u="none" strike="noStrike" cap="none" dirty="0">
                <a:solidFill>
                  <a:srgbClr val="000000"/>
                </a:solidFill>
                <a:latin typeface="Arial"/>
                <a:ea typeface="Arial"/>
                <a:cs typeface="Arial"/>
                <a:sym typeface="Arial"/>
              </a:endParaRPr>
            </a:p>
          </p:txBody>
        </p:sp>
        <p:sp>
          <p:nvSpPr>
            <p:cNvPr id="1716" name="Google Shape;1716;p11"/>
            <p:cNvSpPr/>
            <p:nvPr/>
          </p:nvSpPr>
          <p:spPr>
            <a:xfrm>
              <a:off x="5367381" y="7156257"/>
              <a:ext cx="214200" cy="90300"/>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3.0</a:t>
              </a:r>
              <a:endParaRPr sz="800" b="0" i="0" u="none" strike="noStrike" cap="none">
                <a:solidFill>
                  <a:srgbClr val="000000"/>
                </a:solidFill>
                <a:latin typeface="Arial"/>
                <a:ea typeface="Arial"/>
                <a:cs typeface="Arial"/>
                <a:sym typeface="Arial"/>
              </a:endParaRPr>
            </a:p>
          </p:txBody>
        </p:sp>
        <p:sp>
          <p:nvSpPr>
            <p:cNvPr id="1717" name="Google Shape;1717;p11"/>
            <p:cNvSpPr/>
            <p:nvPr/>
          </p:nvSpPr>
          <p:spPr>
            <a:xfrm>
              <a:off x="5924581" y="7156257"/>
              <a:ext cx="214200" cy="90300"/>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1100"/>
                <a:buFont typeface="Arial"/>
                <a:buNone/>
              </a:pPr>
              <a:r>
                <a:rPr lang="en-GB" sz="800" b="0" i="0" u="none" strike="noStrike" cap="none">
                  <a:solidFill>
                    <a:schemeClr val="dk1"/>
                  </a:solidFill>
                  <a:latin typeface="Arial"/>
                  <a:ea typeface="Arial"/>
                  <a:cs typeface="Arial"/>
                  <a:sym typeface="Arial"/>
                </a:rPr>
                <a:t>14.0</a:t>
              </a:r>
              <a:endParaRPr sz="800" b="0" i="0" u="none" strike="noStrike" cap="none">
                <a:solidFill>
                  <a:srgbClr val="000000"/>
                </a:solidFill>
                <a:latin typeface="Arial"/>
                <a:ea typeface="Arial"/>
                <a:cs typeface="Arial"/>
                <a:sym typeface="Arial"/>
              </a:endParaRPr>
            </a:p>
          </p:txBody>
        </p:sp>
      </p:grpSp>
      <p:sp>
        <p:nvSpPr>
          <p:cNvPr id="1718" name="Google Shape;1718;p11"/>
          <p:cNvSpPr txBox="1"/>
          <p:nvPr/>
        </p:nvSpPr>
        <p:spPr>
          <a:xfrm>
            <a:off x="527219" y="9385664"/>
            <a:ext cx="6518819" cy="2277506"/>
          </a:xfrm>
          <a:prstGeom prst="rect">
            <a:avLst/>
          </a:prstGeom>
          <a:noFill/>
          <a:ln>
            <a:noFill/>
          </a:ln>
        </p:spPr>
        <p:txBody>
          <a:bodyPr spcFirstLastPara="1" wrap="square" lIns="91425" tIns="45700" rIns="91425" bIns="45700" anchor="t" anchorCtr="0">
            <a:spAutoFit/>
          </a:bodyPr>
          <a:lstStyle/>
          <a:p>
            <a:pPr marL="0" marR="0" lvl="0" indent="0" algn="l" rtl="0">
              <a:lnSpc>
                <a:spcPct val="200000"/>
              </a:lnSpc>
              <a:spcBef>
                <a:spcPts val="0"/>
              </a:spcBef>
              <a:spcAft>
                <a:spcPts val="0"/>
              </a:spcAft>
              <a:buClr>
                <a:srgbClr val="000000"/>
              </a:buClr>
              <a:buSzPts val="1000"/>
              <a:buFont typeface="Arial"/>
              <a:buNone/>
            </a:pPr>
            <a:r>
              <a:rPr lang="en-GB" sz="1100" b="1" i="0" u="none" strike="noStrike" cap="none" dirty="0">
                <a:solidFill>
                  <a:srgbClr val="000000"/>
                </a:solidFill>
                <a:latin typeface="Arial"/>
                <a:ea typeface="Arial"/>
                <a:cs typeface="Arial"/>
                <a:sym typeface="Arial"/>
              </a:rPr>
              <a:t>Supplementary Figure S1.</a:t>
            </a:r>
            <a:r>
              <a:rPr lang="en-GB" sz="1100" b="0" i="0" u="none" strike="noStrike" cap="none" dirty="0">
                <a:solidFill>
                  <a:srgbClr val="000000"/>
                </a:solidFill>
                <a:latin typeface="Arial"/>
                <a:ea typeface="Arial"/>
                <a:cs typeface="Arial"/>
                <a:sym typeface="Arial"/>
              </a:rPr>
              <a:t> </a:t>
            </a:r>
            <a:r>
              <a:rPr lang="en-GB" sz="1100" b="1" i="0" u="none" strike="noStrike" cap="none" dirty="0">
                <a:solidFill>
                  <a:srgbClr val="000000"/>
                </a:solidFill>
                <a:latin typeface="Arial"/>
                <a:ea typeface="Arial"/>
                <a:cs typeface="Arial"/>
                <a:sym typeface="Arial"/>
              </a:rPr>
              <a:t>IP-RP HPLC chromatograms of GFP and β-Actin RNA extracts.</a:t>
            </a:r>
            <a:r>
              <a:rPr lang="en-GB" sz="1100" b="0" i="0" u="none" strike="noStrike" cap="none" dirty="0">
                <a:solidFill>
                  <a:srgbClr val="000000"/>
                </a:solidFill>
                <a:latin typeface="Arial"/>
                <a:ea typeface="Arial"/>
                <a:cs typeface="Arial"/>
                <a:sym typeface="Arial"/>
              </a:rPr>
              <a:t> </a:t>
            </a:r>
            <a:r>
              <a:rPr lang="en-GB" sz="1100" b="1" i="0" u="none" strike="noStrike" cap="none" dirty="0">
                <a:solidFill>
                  <a:srgbClr val="000000"/>
                </a:solidFill>
                <a:latin typeface="Arial"/>
                <a:ea typeface="Arial"/>
                <a:cs typeface="Arial"/>
                <a:sym typeface="Arial"/>
              </a:rPr>
              <a:t>A</a:t>
            </a:r>
            <a:r>
              <a:rPr lang="en-GB" sz="1100" b="0" i="0" u="none" strike="noStrike" cap="none" dirty="0">
                <a:solidFill>
                  <a:srgbClr val="000000"/>
                </a:solidFill>
                <a:latin typeface="Arial"/>
                <a:ea typeface="Arial"/>
                <a:cs typeface="Arial"/>
                <a:sym typeface="Arial"/>
              </a:rPr>
              <a:t> RNA extracts from </a:t>
            </a:r>
            <a:r>
              <a:rPr lang="en-GB" sz="1100" b="0" i="0" u="none" strike="noStrike" cap="none" dirty="0" err="1">
                <a:solidFill>
                  <a:srgbClr val="000000"/>
                </a:solidFill>
                <a:latin typeface="Arial"/>
                <a:ea typeface="Arial"/>
                <a:cs typeface="Arial"/>
                <a:sym typeface="Arial"/>
              </a:rPr>
              <a:t>pNT</a:t>
            </a:r>
            <a:r>
              <a:rPr lang="en-GB" sz="1100" b="0" i="0" u="none" strike="noStrike" cap="none" dirty="0">
                <a:solidFill>
                  <a:srgbClr val="000000"/>
                </a:solidFill>
                <a:latin typeface="Arial"/>
                <a:ea typeface="Arial"/>
                <a:cs typeface="Arial"/>
                <a:sym typeface="Arial"/>
              </a:rPr>
              <a:t>/1T/3T_GFP inductions in E.coli HT115 cells. </a:t>
            </a:r>
            <a:r>
              <a:rPr lang="en-GB" sz="1100" b="1" i="0" u="none" strike="noStrike" cap="none" dirty="0">
                <a:solidFill>
                  <a:srgbClr val="000000"/>
                </a:solidFill>
                <a:latin typeface="Arial"/>
                <a:ea typeface="Arial"/>
                <a:cs typeface="Arial"/>
                <a:sym typeface="Arial"/>
              </a:rPr>
              <a:t>B. </a:t>
            </a:r>
            <a:r>
              <a:rPr lang="en-GB" sz="1100" b="0" i="0" u="none" strike="noStrike" cap="none" dirty="0">
                <a:solidFill>
                  <a:srgbClr val="000000"/>
                </a:solidFill>
                <a:latin typeface="Arial"/>
                <a:ea typeface="Arial"/>
                <a:cs typeface="Arial"/>
                <a:sym typeface="Arial"/>
              </a:rPr>
              <a:t>RNA extracts from </a:t>
            </a:r>
            <a:r>
              <a:rPr lang="en-GB" sz="1100" b="0" i="0" u="none" strike="noStrike" cap="none" dirty="0" err="1">
                <a:solidFill>
                  <a:srgbClr val="000000"/>
                </a:solidFill>
                <a:latin typeface="Arial"/>
                <a:ea typeface="Arial"/>
                <a:cs typeface="Arial"/>
                <a:sym typeface="Arial"/>
              </a:rPr>
              <a:t>pNT</a:t>
            </a:r>
            <a:r>
              <a:rPr lang="en-GB" sz="1100" b="0" i="0" u="none" strike="noStrike" cap="none" dirty="0">
                <a:solidFill>
                  <a:srgbClr val="000000"/>
                </a:solidFill>
                <a:latin typeface="Arial"/>
                <a:ea typeface="Arial"/>
                <a:cs typeface="Arial"/>
                <a:sym typeface="Arial"/>
              </a:rPr>
              <a:t>/3T_β-Actin inductions in E.coli HT115 . RNA samples NT-3T are colour coded and indicated in figure. Analysis was at 50 °C; mobile phase Buffer A, 100 </a:t>
            </a:r>
            <a:r>
              <a:rPr lang="en-GB" sz="1100" b="0" i="0" u="none" strike="noStrike" cap="none" dirty="0" err="1">
                <a:solidFill>
                  <a:srgbClr val="000000"/>
                </a:solidFill>
                <a:latin typeface="Arial"/>
                <a:ea typeface="Arial"/>
                <a:cs typeface="Arial"/>
                <a:sym typeface="Arial"/>
              </a:rPr>
              <a:t>mM</a:t>
            </a:r>
            <a:r>
              <a:rPr lang="en-GB" sz="1100" b="0" i="0" u="none" strike="noStrike" cap="none" dirty="0">
                <a:solidFill>
                  <a:srgbClr val="000000"/>
                </a:solidFill>
                <a:latin typeface="Arial"/>
                <a:ea typeface="Arial"/>
                <a:cs typeface="Arial"/>
                <a:sym typeface="Arial"/>
              </a:rPr>
              <a:t> TEAA pH 7.0, Buffer B 0.1 M TEAA at pH 7.0 containing 25% acetonitrile, UV absorbance at 260 nm.  </a:t>
            </a:r>
            <a:r>
              <a:rPr lang="en-US" sz="1100" b="0" i="0" u="none" strike="noStrike" cap="none" dirty="0">
                <a:solidFill>
                  <a:srgbClr val="000000"/>
                </a:solidFill>
                <a:latin typeface="Arial"/>
                <a:ea typeface="Arial"/>
                <a:cs typeface="Arial"/>
                <a:sym typeface="Arial"/>
              </a:rPr>
              <a:t>The gradient use and quantity of RNA analysed can be found in Section XX. </a:t>
            </a:r>
            <a:endParaRPr sz="11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000"/>
              <a:buFont typeface="Arial"/>
              <a:buNone/>
            </a:pPr>
            <a:endParaRPr sz="1000" b="0" i="0" u="none" strike="noStrike" cap="none" dirty="0">
              <a:solidFill>
                <a:srgbClr val="000000"/>
              </a:solidFill>
              <a:latin typeface="Arial"/>
              <a:ea typeface="Arial"/>
              <a:cs typeface="Arial"/>
              <a:sym typeface="Arial"/>
            </a:endParaRPr>
          </a:p>
        </p:txBody>
      </p:sp>
      <p:sp>
        <p:nvSpPr>
          <p:cNvPr id="1719" name="Google Shape;1719;p11"/>
          <p:cNvSpPr txBox="1"/>
          <p:nvPr/>
        </p:nvSpPr>
        <p:spPr>
          <a:xfrm flipH="1">
            <a:off x="7" y="309265"/>
            <a:ext cx="387300" cy="461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GB" sz="2400" b="0" i="0" u="none" strike="noStrike" cap="none">
                <a:solidFill>
                  <a:srgbClr val="000000"/>
                </a:solidFill>
                <a:latin typeface="Arial"/>
                <a:ea typeface="Arial"/>
                <a:cs typeface="Arial"/>
                <a:sym typeface="Arial"/>
              </a:rPr>
              <a:t>A</a:t>
            </a:r>
            <a:endParaRPr sz="2400" b="0" i="0" u="none" strike="noStrike" cap="none">
              <a:solidFill>
                <a:srgbClr val="000000"/>
              </a:solidFill>
              <a:latin typeface="Arial"/>
              <a:ea typeface="Arial"/>
              <a:cs typeface="Arial"/>
              <a:sym typeface="Arial"/>
            </a:endParaRPr>
          </a:p>
        </p:txBody>
      </p:sp>
      <p:sp>
        <p:nvSpPr>
          <p:cNvPr id="1720" name="Google Shape;1720;p11"/>
          <p:cNvSpPr txBox="1"/>
          <p:nvPr/>
        </p:nvSpPr>
        <p:spPr>
          <a:xfrm flipH="1">
            <a:off x="7" y="4531078"/>
            <a:ext cx="387300" cy="461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GB" sz="2400" b="0" i="0" u="none" strike="noStrike" cap="none">
                <a:solidFill>
                  <a:srgbClr val="000000"/>
                </a:solidFill>
                <a:latin typeface="Arial"/>
                <a:ea typeface="Arial"/>
                <a:cs typeface="Arial"/>
                <a:sym typeface="Arial"/>
              </a:rPr>
              <a:t>B</a:t>
            </a:r>
            <a:endParaRPr sz="2400" b="0" i="0" u="none" strike="noStrike" cap="none">
              <a:solidFill>
                <a:srgbClr val="000000"/>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768"/>
        <p:cNvGrpSpPr/>
        <p:nvPr/>
      </p:nvGrpSpPr>
      <p:grpSpPr>
        <a:xfrm>
          <a:off x="0" y="0"/>
          <a:ext cx="0" cy="0"/>
          <a:chOff x="0" y="0"/>
          <a:chExt cx="0" cy="0"/>
        </a:xfrm>
      </p:grpSpPr>
      <p:grpSp>
        <p:nvGrpSpPr>
          <p:cNvPr id="1769" name="Google Shape;1769;p13"/>
          <p:cNvGrpSpPr/>
          <p:nvPr/>
        </p:nvGrpSpPr>
        <p:grpSpPr>
          <a:xfrm>
            <a:off x="164293" y="1066600"/>
            <a:ext cx="7230282" cy="2947520"/>
            <a:chOff x="188306" y="1092000"/>
            <a:chExt cx="7230282" cy="2947520"/>
          </a:xfrm>
        </p:grpSpPr>
        <p:grpSp>
          <p:nvGrpSpPr>
            <p:cNvPr id="1770" name="Google Shape;1770;p13"/>
            <p:cNvGrpSpPr/>
            <p:nvPr/>
          </p:nvGrpSpPr>
          <p:grpSpPr>
            <a:xfrm>
              <a:off x="410513" y="1092000"/>
              <a:ext cx="6651763" cy="1058534"/>
              <a:chOff x="410513" y="1092000"/>
              <a:chExt cx="6651763" cy="1058534"/>
            </a:xfrm>
          </p:grpSpPr>
          <p:grpSp>
            <p:nvGrpSpPr>
              <p:cNvPr id="1771" name="Google Shape;1771;p13"/>
              <p:cNvGrpSpPr/>
              <p:nvPr/>
            </p:nvGrpSpPr>
            <p:grpSpPr>
              <a:xfrm>
                <a:off x="410513" y="1092000"/>
                <a:ext cx="6651763" cy="558349"/>
                <a:chOff x="410513" y="1092000"/>
                <a:chExt cx="6651763" cy="558349"/>
              </a:xfrm>
            </p:grpSpPr>
            <p:grpSp>
              <p:nvGrpSpPr>
                <p:cNvPr id="1772" name="Google Shape;1772;p13"/>
                <p:cNvGrpSpPr/>
                <p:nvPr/>
              </p:nvGrpSpPr>
              <p:grpSpPr>
                <a:xfrm>
                  <a:off x="615031" y="1234172"/>
                  <a:ext cx="6228000" cy="416177"/>
                  <a:chOff x="641464" y="2986772"/>
                  <a:chExt cx="7200000" cy="416177"/>
                </a:xfrm>
              </p:grpSpPr>
              <p:grpSp>
                <p:nvGrpSpPr>
                  <p:cNvPr id="1773" name="Google Shape;1773;p13"/>
                  <p:cNvGrpSpPr/>
                  <p:nvPr/>
                </p:nvGrpSpPr>
                <p:grpSpPr>
                  <a:xfrm>
                    <a:off x="641464" y="2986772"/>
                    <a:ext cx="7200000" cy="416177"/>
                    <a:chOff x="600725" y="397195"/>
                    <a:chExt cx="7200000" cy="416177"/>
                  </a:xfrm>
                </p:grpSpPr>
                <p:grpSp>
                  <p:nvGrpSpPr>
                    <p:cNvPr id="1774" name="Google Shape;1774;p13"/>
                    <p:cNvGrpSpPr/>
                    <p:nvPr/>
                  </p:nvGrpSpPr>
                  <p:grpSpPr>
                    <a:xfrm rot="10800000">
                      <a:off x="4232707" y="604624"/>
                      <a:ext cx="156596" cy="208748"/>
                      <a:chOff x="5380130" y="867147"/>
                      <a:chExt cx="156596" cy="208748"/>
                    </a:xfrm>
                  </p:grpSpPr>
                  <p:cxnSp>
                    <p:nvCxnSpPr>
                      <p:cNvPr id="1775" name="Google Shape;1775;p13"/>
                      <p:cNvCxnSpPr/>
                      <p:nvPr/>
                    </p:nvCxnSpPr>
                    <p:spPr>
                      <a:xfrm rot="10800000">
                        <a:off x="5386465" y="867147"/>
                        <a:ext cx="0" cy="208748"/>
                      </a:xfrm>
                      <a:prstGeom prst="straightConnector1">
                        <a:avLst/>
                      </a:prstGeom>
                      <a:noFill/>
                      <a:ln w="12700" cap="flat" cmpd="sng">
                        <a:solidFill>
                          <a:schemeClr val="dk1"/>
                        </a:solidFill>
                        <a:prstDash val="solid"/>
                        <a:round/>
                        <a:headEnd type="none" w="sm" len="sm"/>
                        <a:tailEnd type="none" w="sm" len="sm"/>
                      </a:ln>
                    </p:spPr>
                  </p:cxnSp>
                  <p:cxnSp>
                    <p:nvCxnSpPr>
                      <p:cNvPr id="1776" name="Google Shape;1776;p13"/>
                      <p:cNvCxnSpPr/>
                      <p:nvPr/>
                    </p:nvCxnSpPr>
                    <p:spPr>
                      <a:xfrm>
                        <a:off x="5380130" y="869950"/>
                        <a:ext cx="156596" cy="0"/>
                      </a:xfrm>
                      <a:prstGeom prst="straightConnector1">
                        <a:avLst/>
                      </a:prstGeom>
                      <a:noFill/>
                      <a:ln w="12700" cap="flat" cmpd="sng">
                        <a:solidFill>
                          <a:schemeClr val="dk1"/>
                        </a:solidFill>
                        <a:prstDash val="solid"/>
                        <a:round/>
                        <a:headEnd type="none" w="sm" len="sm"/>
                        <a:tailEnd type="triangle" w="med" len="med"/>
                      </a:ln>
                    </p:spPr>
                  </p:cxnSp>
                </p:grpSp>
                <p:cxnSp>
                  <p:nvCxnSpPr>
                    <p:cNvPr id="1777" name="Google Shape;1777;p13"/>
                    <p:cNvCxnSpPr>
                      <a:stCxn id="1778" idx="3"/>
                    </p:cNvCxnSpPr>
                    <p:nvPr/>
                  </p:nvCxnSpPr>
                  <p:spPr>
                    <a:xfrm rot="10800000">
                      <a:off x="2717837" y="397195"/>
                      <a:ext cx="0" cy="208800"/>
                    </a:xfrm>
                    <a:prstGeom prst="straightConnector1">
                      <a:avLst/>
                    </a:prstGeom>
                    <a:noFill/>
                    <a:ln w="12700" cap="flat" cmpd="sng">
                      <a:solidFill>
                        <a:schemeClr val="dk1"/>
                      </a:solidFill>
                      <a:prstDash val="solid"/>
                      <a:round/>
                      <a:headEnd type="none" w="sm" len="sm"/>
                      <a:tailEnd type="none" w="sm" len="sm"/>
                    </a:ln>
                  </p:spPr>
                </p:cxnSp>
                <p:cxnSp>
                  <p:nvCxnSpPr>
                    <p:cNvPr id="1779" name="Google Shape;1779;p13"/>
                    <p:cNvCxnSpPr/>
                    <p:nvPr/>
                  </p:nvCxnSpPr>
                  <p:spPr>
                    <a:xfrm>
                      <a:off x="600725" y="604624"/>
                      <a:ext cx="7200000" cy="0"/>
                    </a:xfrm>
                    <a:prstGeom prst="straightConnector1">
                      <a:avLst/>
                    </a:prstGeom>
                    <a:noFill/>
                    <a:ln w="28575" cap="flat" cmpd="sng">
                      <a:solidFill>
                        <a:schemeClr val="dk1"/>
                      </a:solidFill>
                      <a:prstDash val="solid"/>
                      <a:round/>
                      <a:headEnd type="none" w="sm" len="sm"/>
                      <a:tailEnd type="none" w="sm" len="sm"/>
                    </a:ln>
                  </p:spPr>
                </p:cxnSp>
                <p:sp>
                  <p:nvSpPr>
                    <p:cNvPr id="1780" name="Google Shape;1780;p13"/>
                    <p:cNvSpPr/>
                    <p:nvPr/>
                  </p:nvSpPr>
                  <p:spPr>
                    <a:xfrm>
                      <a:off x="2717837" y="515309"/>
                      <a:ext cx="1664740" cy="180000"/>
                    </a:xfrm>
                    <a:prstGeom prst="rect">
                      <a:avLst/>
                    </a:prstGeom>
                    <a:solidFill>
                      <a:srgbClr val="FFCA2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Target Gene</a:t>
                      </a:r>
                      <a:endParaRPr sz="1400" b="0" i="0" u="none" strike="noStrike" cap="none">
                        <a:solidFill>
                          <a:srgbClr val="000000"/>
                        </a:solidFill>
                        <a:latin typeface="Arial"/>
                        <a:ea typeface="Arial"/>
                        <a:cs typeface="Arial"/>
                        <a:sym typeface="Arial"/>
                      </a:endParaRPr>
                    </a:p>
                  </p:txBody>
                </p:sp>
                <p:sp>
                  <p:nvSpPr>
                    <p:cNvPr id="1781" name="Google Shape;1781;p13"/>
                    <p:cNvSpPr/>
                    <p:nvPr/>
                  </p:nvSpPr>
                  <p:spPr>
                    <a:xfrm>
                      <a:off x="4383000" y="515309"/>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pT7</a:t>
                      </a:r>
                      <a:endParaRPr sz="1400" b="0" i="0" u="none" strike="noStrike" cap="none">
                        <a:solidFill>
                          <a:srgbClr val="000000"/>
                        </a:solidFill>
                        <a:latin typeface="Arial"/>
                        <a:ea typeface="Arial"/>
                        <a:cs typeface="Arial"/>
                        <a:sym typeface="Arial"/>
                      </a:endParaRPr>
                    </a:p>
                  </p:txBody>
                </p:sp>
                <p:sp>
                  <p:nvSpPr>
                    <p:cNvPr id="1778" name="Google Shape;1778;p13"/>
                    <p:cNvSpPr/>
                    <p:nvPr/>
                  </p:nvSpPr>
                  <p:spPr>
                    <a:xfrm>
                      <a:off x="2304280" y="515995"/>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pT7</a:t>
                      </a:r>
                      <a:endParaRPr sz="1400" b="0" i="0" u="none" strike="noStrike" cap="none">
                        <a:solidFill>
                          <a:srgbClr val="000000"/>
                        </a:solidFill>
                        <a:latin typeface="Arial"/>
                        <a:ea typeface="Arial"/>
                        <a:cs typeface="Arial"/>
                        <a:sym typeface="Arial"/>
                      </a:endParaRPr>
                    </a:p>
                  </p:txBody>
                </p:sp>
                <p:cxnSp>
                  <p:nvCxnSpPr>
                    <p:cNvPr id="1782" name="Google Shape;1782;p13"/>
                    <p:cNvCxnSpPr/>
                    <p:nvPr/>
                  </p:nvCxnSpPr>
                  <p:spPr>
                    <a:xfrm>
                      <a:off x="2711487" y="400050"/>
                      <a:ext cx="156596" cy="0"/>
                    </a:xfrm>
                    <a:prstGeom prst="straightConnector1">
                      <a:avLst/>
                    </a:prstGeom>
                    <a:noFill/>
                    <a:ln w="12700" cap="flat" cmpd="sng">
                      <a:solidFill>
                        <a:schemeClr val="dk1"/>
                      </a:solidFill>
                      <a:prstDash val="solid"/>
                      <a:round/>
                      <a:headEnd type="none" w="sm" len="sm"/>
                      <a:tailEnd type="triangle" w="med" len="med"/>
                    </a:ln>
                  </p:spPr>
                </p:cxnSp>
              </p:grpSp>
              <p:sp>
                <p:nvSpPr>
                  <p:cNvPr id="1783" name="Google Shape;1783;p13"/>
                  <p:cNvSpPr/>
                  <p:nvPr/>
                </p:nvSpPr>
                <p:spPr>
                  <a:xfrm>
                    <a:off x="1734118" y="3105618"/>
                    <a:ext cx="612000" cy="178805"/>
                  </a:xfrm>
                  <a:prstGeom prst="rect">
                    <a:avLst/>
                  </a:prstGeom>
                  <a:solidFill>
                    <a:srgbClr val="FF6969"/>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4T-1T</a:t>
                    </a:r>
                    <a:endParaRPr sz="1400" b="0" i="0" u="none" strike="noStrike" cap="none">
                      <a:solidFill>
                        <a:srgbClr val="000000"/>
                      </a:solidFill>
                      <a:latin typeface="Arial"/>
                      <a:ea typeface="Arial"/>
                      <a:cs typeface="Arial"/>
                      <a:sym typeface="Arial"/>
                    </a:endParaRPr>
                  </a:p>
                </p:txBody>
              </p:sp>
              <p:sp>
                <p:nvSpPr>
                  <p:cNvPr id="1784" name="Google Shape;1784;p13"/>
                  <p:cNvSpPr/>
                  <p:nvPr/>
                </p:nvSpPr>
                <p:spPr>
                  <a:xfrm>
                    <a:off x="4836535" y="3104574"/>
                    <a:ext cx="611792" cy="179844"/>
                  </a:xfrm>
                  <a:prstGeom prst="rect">
                    <a:avLst/>
                  </a:prstGeom>
                  <a:solidFill>
                    <a:srgbClr val="FF6969"/>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1T-4T</a:t>
                    </a:r>
                    <a:endParaRPr sz="1400" b="0" i="0" u="none" strike="noStrike" cap="none">
                      <a:solidFill>
                        <a:srgbClr val="000000"/>
                      </a:solidFill>
                      <a:latin typeface="Arial"/>
                      <a:ea typeface="Arial"/>
                      <a:cs typeface="Arial"/>
                      <a:sym typeface="Arial"/>
                    </a:endParaRPr>
                  </a:p>
                </p:txBody>
              </p:sp>
            </p:grpSp>
            <p:sp>
              <p:nvSpPr>
                <p:cNvPr id="1785" name="Google Shape;1785;p13"/>
                <p:cNvSpPr/>
                <p:nvPr/>
              </p:nvSpPr>
              <p:spPr>
                <a:xfrm>
                  <a:off x="609074" y="1351297"/>
                  <a:ext cx="529380" cy="178805"/>
                </a:xfrm>
                <a:prstGeom prst="rect">
                  <a:avLst/>
                </a:prstGeom>
                <a:solidFill>
                  <a:srgbClr val="C198E0"/>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AmpR</a:t>
                  </a:r>
                  <a:endParaRPr sz="775" b="0" i="0" u="none" strike="noStrike" cap="none">
                    <a:solidFill>
                      <a:schemeClr val="dk1"/>
                    </a:solidFill>
                    <a:latin typeface="Arial"/>
                    <a:ea typeface="Arial"/>
                    <a:cs typeface="Arial"/>
                    <a:sym typeface="Arial"/>
                  </a:endParaRPr>
                </a:p>
              </p:txBody>
            </p:sp>
            <p:sp>
              <p:nvSpPr>
                <p:cNvPr id="1786" name="Google Shape;1786;p13"/>
                <p:cNvSpPr/>
                <p:nvPr/>
              </p:nvSpPr>
              <p:spPr>
                <a:xfrm>
                  <a:off x="6319608" y="1353520"/>
                  <a:ext cx="529380" cy="178805"/>
                </a:xfrm>
                <a:prstGeom prst="rect">
                  <a:avLst/>
                </a:prstGeom>
                <a:solidFill>
                  <a:srgbClr val="C198E0"/>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AmpR</a:t>
                  </a:r>
                  <a:endParaRPr sz="775" b="0" i="0" u="none" strike="noStrike" cap="none">
                    <a:solidFill>
                      <a:schemeClr val="dk1"/>
                    </a:solidFill>
                    <a:latin typeface="Arial"/>
                    <a:ea typeface="Arial"/>
                    <a:cs typeface="Arial"/>
                    <a:sym typeface="Arial"/>
                  </a:endParaRPr>
                </a:p>
              </p:txBody>
            </p:sp>
            <p:sp>
              <p:nvSpPr>
                <p:cNvPr id="1787" name="Google Shape;1787;p13"/>
                <p:cNvSpPr/>
                <p:nvPr/>
              </p:nvSpPr>
              <p:spPr>
                <a:xfrm>
                  <a:off x="5217793" y="1351296"/>
                  <a:ext cx="743721" cy="178805"/>
                </a:xfrm>
                <a:prstGeom prst="rect">
                  <a:avLst/>
                </a:prstGeom>
                <a:solidFill>
                  <a:srgbClr val="FFFF00"/>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ColE1</a:t>
                  </a:r>
                  <a:endParaRPr sz="1400" b="0" i="0" u="none" strike="noStrike" cap="none">
                    <a:solidFill>
                      <a:srgbClr val="000000"/>
                    </a:solidFill>
                    <a:latin typeface="Arial"/>
                    <a:ea typeface="Arial"/>
                    <a:cs typeface="Arial"/>
                    <a:sym typeface="Arial"/>
                  </a:endParaRPr>
                </a:p>
              </p:txBody>
            </p:sp>
            <p:cxnSp>
              <p:nvCxnSpPr>
                <p:cNvPr id="1788" name="Google Shape;1788;p13"/>
                <p:cNvCxnSpPr/>
                <p:nvPr/>
              </p:nvCxnSpPr>
              <p:spPr>
                <a:xfrm>
                  <a:off x="6855731" y="1295400"/>
                  <a:ext cx="0" cy="304800"/>
                </a:xfrm>
                <a:prstGeom prst="straightConnector1">
                  <a:avLst/>
                </a:prstGeom>
                <a:noFill/>
                <a:ln w="9525" cap="flat" cmpd="sng">
                  <a:solidFill>
                    <a:schemeClr val="dk1"/>
                  </a:solidFill>
                  <a:prstDash val="dash"/>
                  <a:round/>
                  <a:headEnd type="none" w="sm" len="sm"/>
                  <a:tailEnd type="none" w="sm" len="sm"/>
                </a:ln>
              </p:spPr>
            </p:cxnSp>
            <p:cxnSp>
              <p:nvCxnSpPr>
                <p:cNvPr id="1789" name="Google Shape;1789;p13"/>
                <p:cNvCxnSpPr/>
                <p:nvPr/>
              </p:nvCxnSpPr>
              <p:spPr>
                <a:xfrm>
                  <a:off x="609074" y="1295400"/>
                  <a:ext cx="0" cy="304800"/>
                </a:xfrm>
                <a:prstGeom prst="straightConnector1">
                  <a:avLst/>
                </a:prstGeom>
                <a:noFill/>
                <a:ln w="9525" cap="flat" cmpd="sng">
                  <a:solidFill>
                    <a:schemeClr val="dk1"/>
                  </a:solidFill>
                  <a:prstDash val="dash"/>
                  <a:round/>
                  <a:headEnd type="none" w="sm" len="sm"/>
                  <a:tailEnd type="none" w="sm" len="sm"/>
                </a:ln>
              </p:spPr>
            </p:cxnSp>
            <p:sp>
              <p:nvSpPr>
                <p:cNvPr id="1790" name="Google Shape;1790;p13"/>
                <p:cNvSpPr txBox="1"/>
                <p:nvPr/>
              </p:nvSpPr>
              <p:spPr>
                <a:xfrm>
                  <a:off x="410513" y="1092000"/>
                  <a:ext cx="413100" cy="227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0"/>
                    <a:buFont typeface="Arial"/>
                    <a:buNone/>
                  </a:pPr>
                  <a:r>
                    <a:rPr lang="en-GB" sz="880" b="0" i="0" u="none" strike="noStrike" cap="none">
                      <a:solidFill>
                        <a:srgbClr val="000000"/>
                      </a:solidFill>
                      <a:latin typeface="Arial"/>
                      <a:ea typeface="Arial"/>
                      <a:cs typeface="Arial"/>
                      <a:sym typeface="Arial"/>
                    </a:rPr>
                    <a:t>PvuI</a:t>
                  </a:r>
                  <a:endParaRPr sz="880" b="0" i="0" u="none" strike="noStrike" cap="none">
                    <a:solidFill>
                      <a:srgbClr val="000000"/>
                    </a:solidFill>
                    <a:latin typeface="Arial"/>
                    <a:ea typeface="Arial"/>
                    <a:cs typeface="Arial"/>
                    <a:sym typeface="Arial"/>
                  </a:endParaRPr>
                </a:p>
              </p:txBody>
            </p:sp>
            <p:sp>
              <p:nvSpPr>
                <p:cNvPr id="1791" name="Google Shape;1791;p13"/>
                <p:cNvSpPr txBox="1"/>
                <p:nvPr/>
              </p:nvSpPr>
              <p:spPr>
                <a:xfrm>
                  <a:off x="6649176" y="1092009"/>
                  <a:ext cx="413100" cy="227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80"/>
                    <a:buFont typeface="Arial"/>
                    <a:buNone/>
                  </a:pPr>
                  <a:r>
                    <a:rPr lang="en-GB" sz="880" b="0" i="0" u="none" strike="noStrike" cap="none">
                      <a:solidFill>
                        <a:srgbClr val="000000"/>
                      </a:solidFill>
                      <a:latin typeface="Arial"/>
                      <a:ea typeface="Arial"/>
                      <a:cs typeface="Arial"/>
                      <a:sym typeface="Arial"/>
                    </a:rPr>
                    <a:t>PvuI</a:t>
                  </a:r>
                  <a:endParaRPr sz="880" b="0" i="0" u="none" strike="noStrike" cap="none">
                    <a:solidFill>
                      <a:srgbClr val="000000"/>
                    </a:solidFill>
                    <a:latin typeface="Arial"/>
                    <a:ea typeface="Arial"/>
                    <a:cs typeface="Arial"/>
                    <a:sym typeface="Arial"/>
                  </a:endParaRPr>
                </a:p>
              </p:txBody>
            </p:sp>
          </p:grpSp>
          <p:cxnSp>
            <p:nvCxnSpPr>
              <p:cNvPr id="1792" name="Google Shape;1792;p13"/>
              <p:cNvCxnSpPr/>
              <p:nvPr/>
            </p:nvCxnSpPr>
            <p:spPr>
              <a:xfrm>
                <a:off x="3166333" y="1647546"/>
                <a:ext cx="0" cy="502988"/>
              </a:xfrm>
              <a:prstGeom prst="straightConnector1">
                <a:avLst/>
              </a:prstGeom>
              <a:noFill/>
              <a:ln w="19050" cap="flat" cmpd="sng">
                <a:solidFill>
                  <a:schemeClr val="dk1"/>
                </a:solidFill>
                <a:prstDash val="solid"/>
                <a:round/>
                <a:headEnd type="none" w="sm" len="sm"/>
                <a:tailEnd type="triangle" w="med" len="med"/>
              </a:ln>
            </p:spPr>
          </p:cxnSp>
          <p:sp>
            <p:nvSpPr>
              <p:cNvPr id="1793" name="Google Shape;1793;p13"/>
              <p:cNvSpPr txBox="1"/>
              <p:nvPr/>
            </p:nvSpPr>
            <p:spPr>
              <a:xfrm>
                <a:off x="1861174" y="1736796"/>
                <a:ext cx="1757145"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GB" sz="1000" b="0" i="1" u="none" strike="noStrike" cap="none">
                    <a:solidFill>
                      <a:srgbClr val="000000"/>
                    </a:solidFill>
                    <a:latin typeface="Arial"/>
                    <a:ea typeface="Arial"/>
                    <a:cs typeface="Arial"/>
                    <a:sym typeface="Arial"/>
                  </a:rPr>
                  <a:t>In vitro </a:t>
                </a:r>
                <a:r>
                  <a:rPr lang="en-GB" sz="1000" b="0" i="0" u="none" strike="noStrike" cap="none">
                    <a:solidFill>
                      <a:srgbClr val="000000"/>
                    </a:solidFill>
                    <a:latin typeface="Arial"/>
                    <a:ea typeface="Arial"/>
                    <a:cs typeface="Arial"/>
                    <a:sym typeface="Arial"/>
                  </a:rPr>
                  <a:t>transcription </a:t>
                </a:r>
                <a:endParaRPr sz="1000" b="0" i="1" u="none" strike="noStrike" cap="none">
                  <a:solidFill>
                    <a:srgbClr val="000000"/>
                  </a:solidFill>
                  <a:latin typeface="Arial"/>
                  <a:ea typeface="Arial"/>
                  <a:cs typeface="Arial"/>
                  <a:sym typeface="Arial"/>
                </a:endParaRPr>
              </a:p>
            </p:txBody>
          </p:sp>
        </p:grpSp>
        <p:grpSp>
          <p:nvGrpSpPr>
            <p:cNvPr id="1794" name="Google Shape;1794;p13"/>
            <p:cNvGrpSpPr/>
            <p:nvPr/>
          </p:nvGrpSpPr>
          <p:grpSpPr>
            <a:xfrm>
              <a:off x="188306" y="2609379"/>
              <a:ext cx="3278313" cy="416177"/>
              <a:chOff x="609074" y="1234172"/>
              <a:chExt cx="3278313" cy="416177"/>
            </a:xfrm>
          </p:grpSpPr>
          <p:grpSp>
            <p:nvGrpSpPr>
              <p:cNvPr id="1795" name="Google Shape;1795;p13"/>
              <p:cNvGrpSpPr/>
              <p:nvPr/>
            </p:nvGrpSpPr>
            <p:grpSpPr>
              <a:xfrm>
                <a:off x="615076" y="1234172"/>
                <a:ext cx="3272311" cy="416177"/>
                <a:chOff x="641516" y="2986772"/>
                <a:chExt cx="3783018" cy="416177"/>
              </a:xfrm>
            </p:grpSpPr>
            <p:grpSp>
              <p:nvGrpSpPr>
                <p:cNvPr id="1796" name="Google Shape;1796;p13"/>
                <p:cNvGrpSpPr/>
                <p:nvPr/>
              </p:nvGrpSpPr>
              <p:grpSpPr>
                <a:xfrm>
                  <a:off x="641516" y="2986772"/>
                  <a:ext cx="3783018" cy="416177"/>
                  <a:chOff x="600777" y="397195"/>
                  <a:chExt cx="3783018" cy="416177"/>
                </a:xfrm>
              </p:grpSpPr>
              <p:grpSp>
                <p:nvGrpSpPr>
                  <p:cNvPr id="1797" name="Google Shape;1797;p13"/>
                  <p:cNvGrpSpPr/>
                  <p:nvPr/>
                </p:nvGrpSpPr>
                <p:grpSpPr>
                  <a:xfrm rot="10800000">
                    <a:off x="4227199" y="604624"/>
                    <a:ext cx="156596" cy="208748"/>
                    <a:chOff x="5385638" y="867147"/>
                    <a:chExt cx="156596" cy="208748"/>
                  </a:xfrm>
                </p:grpSpPr>
                <p:cxnSp>
                  <p:nvCxnSpPr>
                    <p:cNvPr id="1798" name="Google Shape;1798;p13"/>
                    <p:cNvCxnSpPr/>
                    <p:nvPr/>
                  </p:nvCxnSpPr>
                  <p:spPr>
                    <a:xfrm rot="10800000">
                      <a:off x="5391973" y="867147"/>
                      <a:ext cx="0" cy="208748"/>
                    </a:xfrm>
                    <a:prstGeom prst="straightConnector1">
                      <a:avLst/>
                    </a:prstGeom>
                    <a:noFill/>
                    <a:ln w="12700" cap="flat" cmpd="sng">
                      <a:solidFill>
                        <a:schemeClr val="dk1"/>
                      </a:solidFill>
                      <a:prstDash val="solid"/>
                      <a:round/>
                      <a:headEnd type="none" w="sm" len="sm"/>
                      <a:tailEnd type="none" w="sm" len="sm"/>
                    </a:ln>
                  </p:spPr>
                </p:cxnSp>
                <p:cxnSp>
                  <p:nvCxnSpPr>
                    <p:cNvPr id="1799" name="Google Shape;1799;p13"/>
                    <p:cNvCxnSpPr/>
                    <p:nvPr/>
                  </p:nvCxnSpPr>
                  <p:spPr>
                    <a:xfrm>
                      <a:off x="5385638" y="869950"/>
                      <a:ext cx="156596" cy="0"/>
                    </a:xfrm>
                    <a:prstGeom prst="straightConnector1">
                      <a:avLst/>
                    </a:prstGeom>
                    <a:noFill/>
                    <a:ln w="12700" cap="flat" cmpd="sng">
                      <a:solidFill>
                        <a:schemeClr val="dk1"/>
                      </a:solidFill>
                      <a:prstDash val="solid"/>
                      <a:round/>
                      <a:headEnd type="none" w="sm" len="sm"/>
                      <a:tailEnd type="triangle" w="med" len="med"/>
                    </a:ln>
                  </p:spPr>
                </p:cxnSp>
              </p:grpSp>
              <p:cxnSp>
                <p:nvCxnSpPr>
                  <p:cNvPr id="1800" name="Google Shape;1800;p13"/>
                  <p:cNvCxnSpPr>
                    <a:stCxn id="1801" idx="3"/>
                  </p:cNvCxnSpPr>
                  <p:nvPr/>
                </p:nvCxnSpPr>
                <p:spPr>
                  <a:xfrm rot="10800000">
                    <a:off x="2717837" y="397195"/>
                    <a:ext cx="0" cy="208800"/>
                  </a:xfrm>
                  <a:prstGeom prst="straightConnector1">
                    <a:avLst/>
                  </a:prstGeom>
                  <a:noFill/>
                  <a:ln w="12700" cap="flat" cmpd="sng">
                    <a:solidFill>
                      <a:schemeClr val="dk1"/>
                    </a:solidFill>
                    <a:prstDash val="solid"/>
                    <a:round/>
                    <a:headEnd type="none" w="sm" len="sm"/>
                    <a:tailEnd type="none" w="sm" len="sm"/>
                  </a:ln>
                </p:spPr>
              </p:cxnSp>
              <p:cxnSp>
                <p:nvCxnSpPr>
                  <p:cNvPr id="1802" name="Google Shape;1802;p13"/>
                  <p:cNvCxnSpPr>
                    <a:endCxn id="1803" idx="3"/>
                  </p:cNvCxnSpPr>
                  <p:nvPr/>
                </p:nvCxnSpPr>
                <p:spPr>
                  <a:xfrm>
                    <a:off x="600777" y="604709"/>
                    <a:ext cx="3781800" cy="600"/>
                  </a:xfrm>
                  <a:prstGeom prst="straightConnector1">
                    <a:avLst/>
                  </a:prstGeom>
                  <a:noFill/>
                  <a:ln w="28575" cap="flat" cmpd="sng">
                    <a:solidFill>
                      <a:schemeClr val="dk1"/>
                    </a:solidFill>
                    <a:prstDash val="solid"/>
                    <a:round/>
                    <a:headEnd type="none" w="sm" len="sm"/>
                    <a:tailEnd type="none" w="sm" len="sm"/>
                  </a:ln>
                </p:spPr>
              </p:cxnSp>
              <p:sp>
                <p:nvSpPr>
                  <p:cNvPr id="1803" name="Google Shape;1803;p13"/>
                  <p:cNvSpPr/>
                  <p:nvPr/>
                </p:nvSpPr>
                <p:spPr>
                  <a:xfrm>
                    <a:off x="2717837" y="515309"/>
                    <a:ext cx="1664740" cy="180000"/>
                  </a:xfrm>
                  <a:prstGeom prst="rect">
                    <a:avLst/>
                  </a:prstGeom>
                  <a:solidFill>
                    <a:srgbClr val="FFCA2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Target Gene</a:t>
                    </a:r>
                    <a:endParaRPr sz="1400" b="0" i="0" u="none" strike="noStrike" cap="none">
                      <a:solidFill>
                        <a:srgbClr val="000000"/>
                      </a:solidFill>
                      <a:latin typeface="Arial"/>
                      <a:ea typeface="Arial"/>
                      <a:cs typeface="Arial"/>
                      <a:sym typeface="Arial"/>
                    </a:endParaRPr>
                  </a:p>
                </p:txBody>
              </p:sp>
              <p:sp>
                <p:nvSpPr>
                  <p:cNvPr id="1801" name="Google Shape;1801;p13"/>
                  <p:cNvSpPr/>
                  <p:nvPr/>
                </p:nvSpPr>
                <p:spPr>
                  <a:xfrm>
                    <a:off x="2304280" y="515995"/>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pT7</a:t>
                    </a:r>
                    <a:endParaRPr sz="1400" b="0" i="0" u="none" strike="noStrike" cap="none">
                      <a:solidFill>
                        <a:srgbClr val="000000"/>
                      </a:solidFill>
                      <a:latin typeface="Arial"/>
                      <a:ea typeface="Arial"/>
                      <a:cs typeface="Arial"/>
                      <a:sym typeface="Arial"/>
                    </a:endParaRPr>
                  </a:p>
                </p:txBody>
              </p:sp>
              <p:cxnSp>
                <p:nvCxnSpPr>
                  <p:cNvPr id="1804" name="Google Shape;1804;p13"/>
                  <p:cNvCxnSpPr/>
                  <p:nvPr/>
                </p:nvCxnSpPr>
                <p:spPr>
                  <a:xfrm>
                    <a:off x="2711487" y="400050"/>
                    <a:ext cx="156596" cy="0"/>
                  </a:xfrm>
                  <a:prstGeom prst="straightConnector1">
                    <a:avLst/>
                  </a:prstGeom>
                  <a:noFill/>
                  <a:ln w="12700" cap="flat" cmpd="sng">
                    <a:solidFill>
                      <a:schemeClr val="dk1"/>
                    </a:solidFill>
                    <a:prstDash val="solid"/>
                    <a:round/>
                    <a:headEnd type="none" w="sm" len="sm"/>
                    <a:tailEnd type="triangle" w="med" len="med"/>
                  </a:ln>
                </p:spPr>
              </p:cxnSp>
            </p:grpSp>
            <p:sp>
              <p:nvSpPr>
                <p:cNvPr id="1805" name="Google Shape;1805;p13"/>
                <p:cNvSpPr/>
                <p:nvPr/>
              </p:nvSpPr>
              <p:spPr>
                <a:xfrm>
                  <a:off x="1734118" y="3105618"/>
                  <a:ext cx="612000" cy="178805"/>
                </a:xfrm>
                <a:prstGeom prst="rect">
                  <a:avLst/>
                </a:prstGeom>
                <a:solidFill>
                  <a:srgbClr val="FF6969"/>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4T-1T</a:t>
                  </a:r>
                  <a:endParaRPr sz="1400" b="0" i="0" u="none" strike="noStrike" cap="none">
                    <a:solidFill>
                      <a:srgbClr val="000000"/>
                    </a:solidFill>
                    <a:latin typeface="Arial"/>
                    <a:ea typeface="Arial"/>
                    <a:cs typeface="Arial"/>
                    <a:sym typeface="Arial"/>
                  </a:endParaRPr>
                </a:p>
              </p:txBody>
            </p:sp>
          </p:grpSp>
          <p:sp>
            <p:nvSpPr>
              <p:cNvPr id="1806" name="Google Shape;1806;p13"/>
              <p:cNvSpPr/>
              <p:nvPr/>
            </p:nvSpPr>
            <p:spPr>
              <a:xfrm>
                <a:off x="609074" y="1351297"/>
                <a:ext cx="529380" cy="178805"/>
              </a:xfrm>
              <a:prstGeom prst="rect">
                <a:avLst/>
              </a:prstGeom>
              <a:solidFill>
                <a:srgbClr val="C198E0"/>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AmpR</a:t>
                </a:r>
                <a:endParaRPr sz="775" b="0" i="0" u="none" strike="noStrike" cap="none">
                  <a:solidFill>
                    <a:schemeClr val="dk1"/>
                  </a:solidFill>
                  <a:latin typeface="Arial"/>
                  <a:ea typeface="Arial"/>
                  <a:cs typeface="Arial"/>
                  <a:sym typeface="Arial"/>
                </a:endParaRPr>
              </a:p>
            </p:txBody>
          </p:sp>
        </p:grpSp>
        <p:grpSp>
          <p:nvGrpSpPr>
            <p:cNvPr id="1807" name="Google Shape;1807;p13"/>
            <p:cNvGrpSpPr/>
            <p:nvPr/>
          </p:nvGrpSpPr>
          <p:grpSpPr>
            <a:xfrm>
              <a:off x="406091" y="3623343"/>
              <a:ext cx="2326158" cy="416177"/>
              <a:chOff x="1734118" y="2986772"/>
              <a:chExt cx="2689200" cy="416177"/>
            </a:xfrm>
          </p:grpSpPr>
          <p:grpSp>
            <p:nvGrpSpPr>
              <p:cNvPr id="1808" name="Google Shape;1808;p13"/>
              <p:cNvGrpSpPr/>
              <p:nvPr/>
            </p:nvGrpSpPr>
            <p:grpSpPr>
              <a:xfrm>
                <a:off x="1734118" y="2986772"/>
                <a:ext cx="2689200" cy="416177"/>
                <a:chOff x="1693379" y="397195"/>
                <a:chExt cx="2689200" cy="416177"/>
              </a:xfrm>
            </p:grpSpPr>
            <p:grpSp>
              <p:nvGrpSpPr>
                <p:cNvPr id="1809" name="Google Shape;1809;p13"/>
                <p:cNvGrpSpPr/>
                <p:nvPr/>
              </p:nvGrpSpPr>
              <p:grpSpPr>
                <a:xfrm rot="10800000">
                  <a:off x="4225363" y="604624"/>
                  <a:ext cx="156596" cy="208748"/>
                  <a:chOff x="5387474" y="867147"/>
                  <a:chExt cx="156596" cy="208748"/>
                </a:xfrm>
              </p:grpSpPr>
              <p:cxnSp>
                <p:nvCxnSpPr>
                  <p:cNvPr id="1810" name="Google Shape;1810;p13"/>
                  <p:cNvCxnSpPr/>
                  <p:nvPr/>
                </p:nvCxnSpPr>
                <p:spPr>
                  <a:xfrm rot="10800000">
                    <a:off x="5393809" y="867147"/>
                    <a:ext cx="0" cy="208748"/>
                  </a:xfrm>
                  <a:prstGeom prst="straightConnector1">
                    <a:avLst/>
                  </a:prstGeom>
                  <a:noFill/>
                  <a:ln w="12700" cap="flat" cmpd="sng">
                    <a:solidFill>
                      <a:schemeClr val="dk1"/>
                    </a:solidFill>
                    <a:prstDash val="solid"/>
                    <a:round/>
                    <a:headEnd type="none" w="sm" len="sm"/>
                    <a:tailEnd type="none" w="sm" len="sm"/>
                  </a:ln>
                </p:spPr>
              </p:cxnSp>
              <p:cxnSp>
                <p:nvCxnSpPr>
                  <p:cNvPr id="1811" name="Google Shape;1811;p13"/>
                  <p:cNvCxnSpPr/>
                  <p:nvPr/>
                </p:nvCxnSpPr>
                <p:spPr>
                  <a:xfrm>
                    <a:off x="5387474" y="869950"/>
                    <a:ext cx="156596" cy="0"/>
                  </a:xfrm>
                  <a:prstGeom prst="straightConnector1">
                    <a:avLst/>
                  </a:prstGeom>
                  <a:noFill/>
                  <a:ln w="12700" cap="flat" cmpd="sng">
                    <a:solidFill>
                      <a:schemeClr val="dk1"/>
                    </a:solidFill>
                    <a:prstDash val="solid"/>
                    <a:round/>
                    <a:headEnd type="none" w="sm" len="sm"/>
                    <a:tailEnd type="triangle" w="med" len="med"/>
                  </a:ln>
                </p:spPr>
              </p:cxnSp>
            </p:grpSp>
            <p:cxnSp>
              <p:nvCxnSpPr>
                <p:cNvPr id="1812" name="Google Shape;1812;p13"/>
                <p:cNvCxnSpPr>
                  <a:stCxn id="1813" idx="3"/>
                </p:cNvCxnSpPr>
                <p:nvPr/>
              </p:nvCxnSpPr>
              <p:spPr>
                <a:xfrm rot="10800000">
                  <a:off x="2717837" y="397195"/>
                  <a:ext cx="0" cy="208800"/>
                </a:xfrm>
                <a:prstGeom prst="straightConnector1">
                  <a:avLst/>
                </a:prstGeom>
                <a:noFill/>
                <a:ln w="12700" cap="flat" cmpd="sng">
                  <a:solidFill>
                    <a:schemeClr val="dk1"/>
                  </a:solidFill>
                  <a:prstDash val="solid"/>
                  <a:round/>
                  <a:headEnd type="none" w="sm" len="sm"/>
                  <a:tailEnd type="none" w="sm" len="sm"/>
                </a:ln>
              </p:spPr>
            </p:cxnSp>
            <p:cxnSp>
              <p:nvCxnSpPr>
                <p:cNvPr id="1814" name="Google Shape;1814;p13"/>
                <p:cNvCxnSpPr>
                  <a:stCxn id="1815" idx="1"/>
                  <a:endCxn id="1816" idx="3"/>
                </p:cNvCxnSpPr>
                <p:nvPr/>
              </p:nvCxnSpPr>
              <p:spPr>
                <a:xfrm>
                  <a:off x="1693379" y="605444"/>
                  <a:ext cx="2689200" cy="0"/>
                </a:xfrm>
                <a:prstGeom prst="straightConnector1">
                  <a:avLst/>
                </a:prstGeom>
                <a:noFill/>
                <a:ln w="28575" cap="flat" cmpd="sng">
                  <a:solidFill>
                    <a:schemeClr val="dk1"/>
                  </a:solidFill>
                  <a:prstDash val="solid"/>
                  <a:round/>
                  <a:headEnd type="none" w="sm" len="sm"/>
                  <a:tailEnd type="none" w="sm" len="sm"/>
                </a:ln>
              </p:spPr>
            </p:cxnSp>
            <p:sp>
              <p:nvSpPr>
                <p:cNvPr id="1816" name="Google Shape;1816;p13"/>
                <p:cNvSpPr/>
                <p:nvPr/>
              </p:nvSpPr>
              <p:spPr>
                <a:xfrm>
                  <a:off x="2717837" y="515309"/>
                  <a:ext cx="1664740" cy="180000"/>
                </a:xfrm>
                <a:prstGeom prst="rect">
                  <a:avLst/>
                </a:prstGeom>
                <a:solidFill>
                  <a:srgbClr val="FFCA2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dirty="0">
                      <a:solidFill>
                        <a:schemeClr val="dk1"/>
                      </a:solidFill>
                      <a:latin typeface="Arial"/>
                      <a:ea typeface="Arial"/>
                      <a:cs typeface="Arial"/>
                      <a:sym typeface="Arial"/>
                    </a:rPr>
                    <a:t>Target Gene</a:t>
                  </a:r>
                  <a:endParaRPr sz="1400" b="0" i="0" u="none" strike="noStrike" cap="none" dirty="0">
                    <a:solidFill>
                      <a:srgbClr val="000000"/>
                    </a:solidFill>
                    <a:latin typeface="Arial"/>
                    <a:ea typeface="Arial"/>
                    <a:cs typeface="Arial"/>
                    <a:sym typeface="Arial"/>
                  </a:endParaRPr>
                </a:p>
              </p:txBody>
            </p:sp>
            <p:sp>
              <p:nvSpPr>
                <p:cNvPr id="1813" name="Google Shape;1813;p13"/>
                <p:cNvSpPr/>
                <p:nvPr/>
              </p:nvSpPr>
              <p:spPr>
                <a:xfrm>
                  <a:off x="2304280" y="515995"/>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pT7</a:t>
                  </a:r>
                  <a:endParaRPr sz="1400" b="0" i="0" u="none" strike="noStrike" cap="none">
                    <a:solidFill>
                      <a:srgbClr val="000000"/>
                    </a:solidFill>
                    <a:latin typeface="Arial"/>
                    <a:ea typeface="Arial"/>
                    <a:cs typeface="Arial"/>
                    <a:sym typeface="Arial"/>
                  </a:endParaRPr>
                </a:p>
              </p:txBody>
            </p:sp>
            <p:cxnSp>
              <p:nvCxnSpPr>
                <p:cNvPr id="1817" name="Google Shape;1817;p13"/>
                <p:cNvCxnSpPr/>
                <p:nvPr/>
              </p:nvCxnSpPr>
              <p:spPr>
                <a:xfrm>
                  <a:off x="2711487" y="400050"/>
                  <a:ext cx="156597" cy="0"/>
                </a:xfrm>
                <a:prstGeom prst="straightConnector1">
                  <a:avLst/>
                </a:prstGeom>
                <a:noFill/>
                <a:ln w="12700" cap="flat" cmpd="sng">
                  <a:solidFill>
                    <a:schemeClr val="dk1"/>
                  </a:solidFill>
                  <a:prstDash val="solid"/>
                  <a:round/>
                  <a:headEnd type="none" w="sm" len="sm"/>
                  <a:tailEnd type="triangle" w="med" len="med"/>
                </a:ln>
              </p:spPr>
            </p:cxnSp>
          </p:grpSp>
          <p:sp>
            <p:nvSpPr>
              <p:cNvPr id="1815" name="Google Shape;1815;p13"/>
              <p:cNvSpPr/>
              <p:nvPr/>
            </p:nvSpPr>
            <p:spPr>
              <a:xfrm>
                <a:off x="1734118" y="3105618"/>
                <a:ext cx="612000" cy="178805"/>
              </a:xfrm>
              <a:prstGeom prst="rect">
                <a:avLst/>
              </a:prstGeom>
              <a:solidFill>
                <a:srgbClr val="FF6969"/>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4T-1T</a:t>
                </a:r>
                <a:endParaRPr sz="1400" b="0" i="0" u="none" strike="noStrike" cap="none">
                  <a:solidFill>
                    <a:srgbClr val="000000"/>
                  </a:solidFill>
                  <a:latin typeface="Arial"/>
                  <a:ea typeface="Arial"/>
                  <a:cs typeface="Arial"/>
                  <a:sym typeface="Arial"/>
                </a:endParaRPr>
              </a:p>
            </p:txBody>
          </p:sp>
        </p:grpSp>
        <p:grpSp>
          <p:nvGrpSpPr>
            <p:cNvPr id="1818" name="Google Shape;1818;p13"/>
            <p:cNvGrpSpPr/>
            <p:nvPr/>
          </p:nvGrpSpPr>
          <p:grpSpPr>
            <a:xfrm>
              <a:off x="3015732" y="3623271"/>
              <a:ext cx="4402856" cy="416125"/>
              <a:chOff x="2446132" y="1234224"/>
              <a:chExt cx="4402856" cy="416125"/>
            </a:xfrm>
          </p:grpSpPr>
          <p:grpSp>
            <p:nvGrpSpPr>
              <p:cNvPr id="1819" name="Google Shape;1819;p13"/>
              <p:cNvGrpSpPr/>
              <p:nvPr/>
            </p:nvGrpSpPr>
            <p:grpSpPr>
              <a:xfrm>
                <a:off x="2446132" y="1234224"/>
                <a:ext cx="4396909" cy="416125"/>
                <a:chOff x="2758344" y="2986824"/>
                <a:chExt cx="5083132" cy="416125"/>
              </a:xfrm>
            </p:grpSpPr>
            <p:grpSp>
              <p:nvGrpSpPr>
                <p:cNvPr id="1820" name="Google Shape;1820;p13"/>
                <p:cNvGrpSpPr/>
                <p:nvPr/>
              </p:nvGrpSpPr>
              <p:grpSpPr>
                <a:xfrm>
                  <a:off x="2758344" y="2986824"/>
                  <a:ext cx="5083132" cy="416125"/>
                  <a:chOff x="2717605" y="397247"/>
                  <a:chExt cx="5083132" cy="416125"/>
                </a:xfrm>
              </p:grpSpPr>
              <p:grpSp>
                <p:nvGrpSpPr>
                  <p:cNvPr id="1821" name="Google Shape;1821;p13"/>
                  <p:cNvGrpSpPr/>
                  <p:nvPr/>
                </p:nvGrpSpPr>
                <p:grpSpPr>
                  <a:xfrm rot="10800000">
                    <a:off x="4232707" y="604624"/>
                    <a:ext cx="156596" cy="208748"/>
                    <a:chOff x="5380130" y="867147"/>
                    <a:chExt cx="156596" cy="208748"/>
                  </a:xfrm>
                </p:grpSpPr>
                <p:cxnSp>
                  <p:nvCxnSpPr>
                    <p:cNvPr id="1822" name="Google Shape;1822;p13"/>
                    <p:cNvCxnSpPr/>
                    <p:nvPr/>
                  </p:nvCxnSpPr>
                  <p:spPr>
                    <a:xfrm rot="10800000">
                      <a:off x="5386465" y="867147"/>
                      <a:ext cx="0" cy="208748"/>
                    </a:xfrm>
                    <a:prstGeom prst="straightConnector1">
                      <a:avLst/>
                    </a:prstGeom>
                    <a:noFill/>
                    <a:ln w="12700" cap="flat" cmpd="sng">
                      <a:solidFill>
                        <a:schemeClr val="dk1"/>
                      </a:solidFill>
                      <a:prstDash val="solid"/>
                      <a:round/>
                      <a:headEnd type="none" w="sm" len="sm"/>
                      <a:tailEnd type="none" w="sm" len="sm"/>
                    </a:ln>
                  </p:spPr>
                </p:cxnSp>
                <p:cxnSp>
                  <p:nvCxnSpPr>
                    <p:cNvPr id="1823" name="Google Shape;1823;p13"/>
                    <p:cNvCxnSpPr/>
                    <p:nvPr/>
                  </p:nvCxnSpPr>
                  <p:spPr>
                    <a:xfrm>
                      <a:off x="5380130" y="869950"/>
                      <a:ext cx="156596" cy="0"/>
                    </a:xfrm>
                    <a:prstGeom prst="straightConnector1">
                      <a:avLst/>
                    </a:prstGeom>
                    <a:noFill/>
                    <a:ln w="12700" cap="flat" cmpd="sng">
                      <a:solidFill>
                        <a:schemeClr val="dk1"/>
                      </a:solidFill>
                      <a:prstDash val="solid"/>
                      <a:round/>
                      <a:headEnd type="none" w="sm" len="sm"/>
                      <a:tailEnd type="triangle" w="med" len="med"/>
                    </a:ln>
                  </p:spPr>
                </p:cxnSp>
              </p:grpSp>
              <p:cxnSp>
                <p:nvCxnSpPr>
                  <p:cNvPr id="1824" name="Google Shape;1824;p13"/>
                  <p:cNvCxnSpPr/>
                  <p:nvPr/>
                </p:nvCxnSpPr>
                <p:spPr>
                  <a:xfrm rot="10800000">
                    <a:off x="2724569" y="397247"/>
                    <a:ext cx="0" cy="192220"/>
                  </a:xfrm>
                  <a:prstGeom prst="straightConnector1">
                    <a:avLst/>
                  </a:prstGeom>
                  <a:noFill/>
                  <a:ln w="12700" cap="flat" cmpd="sng">
                    <a:solidFill>
                      <a:schemeClr val="dk1"/>
                    </a:solidFill>
                    <a:prstDash val="solid"/>
                    <a:round/>
                    <a:headEnd type="none" w="sm" len="sm"/>
                    <a:tailEnd type="none" w="sm" len="sm"/>
                  </a:ln>
                </p:spPr>
              </p:cxnSp>
              <p:cxnSp>
                <p:nvCxnSpPr>
                  <p:cNvPr id="1825" name="Google Shape;1825;p13"/>
                  <p:cNvCxnSpPr>
                    <a:stCxn id="1826" idx="1"/>
                  </p:cNvCxnSpPr>
                  <p:nvPr/>
                </p:nvCxnSpPr>
                <p:spPr>
                  <a:xfrm rot="10800000" flipH="1">
                    <a:off x="2717837" y="604709"/>
                    <a:ext cx="5082900" cy="600"/>
                  </a:xfrm>
                  <a:prstGeom prst="straightConnector1">
                    <a:avLst/>
                  </a:prstGeom>
                  <a:noFill/>
                  <a:ln w="28575" cap="flat" cmpd="sng">
                    <a:solidFill>
                      <a:schemeClr val="dk1"/>
                    </a:solidFill>
                    <a:prstDash val="solid"/>
                    <a:round/>
                    <a:headEnd type="none" w="sm" len="sm"/>
                    <a:tailEnd type="none" w="sm" len="sm"/>
                  </a:ln>
                </p:spPr>
              </p:cxnSp>
              <p:sp>
                <p:nvSpPr>
                  <p:cNvPr id="1826" name="Google Shape;1826;p13"/>
                  <p:cNvSpPr/>
                  <p:nvPr/>
                </p:nvSpPr>
                <p:spPr>
                  <a:xfrm>
                    <a:off x="2717837" y="515309"/>
                    <a:ext cx="1664740" cy="180000"/>
                  </a:xfrm>
                  <a:prstGeom prst="rect">
                    <a:avLst/>
                  </a:prstGeom>
                  <a:solidFill>
                    <a:srgbClr val="FFCA2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Target Gene</a:t>
                    </a:r>
                    <a:endParaRPr sz="1400" b="0" i="0" u="none" strike="noStrike" cap="none">
                      <a:solidFill>
                        <a:srgbClr val="000000"/>
                      </a:solidFill>
                      <a:latin typeface="Arial"/>
                      <a:ea typeface="Arial"/>
                      <a:cs typeface="Arial"/>
                      <a:sym typeface="Arial"/>
                    </a:endParaRPr>
                  </a:p>
                </p:txBody>
              </p:sp>
              <p:sp>
                <p:nvSpPr>
                  <p:cNvPr id="1827" name="Google Shape;1827;p13"/>
                  <p:cNvSpPr/>
                  <p:nvPr/>
                </p:nvSpPr>
                <p:spPr>
                  <a:xfrm>
                    <a:off x="4383000" y="515309"/>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pT7</a:t>
                    </a:r>
                    <a:endParaRPr sz="1400" b="0" i="0" u="none" strike="noStrike" cap="none">
                      <a:solidFill>
                        <a:srgbClr val="000000"/>
                      </a:solidFill>
                      <a:latin typeface="Arial"/>
                      <a:ea typeface="Arial"/>
                      <a:cs typeface="Arial"/>
                      <a:sym typeface="Arial"/>
                    </a:endParaRPr>
                  </a:p>
                </p:txBody>
              </p:sp>
              <p:cxnSp>
                <p:nvCxnSpPr>
                  <p:cNvPr id="1828" name="Google Shape;1828;p13"/>
                  <p:cNvCxnSpPr/>
                  <p:nvPr/>
                </p:nvCxnSpPr>
                <p:spPr>
                  <a:xfrm>
                    <a:off x="2717605" y="400050"/>
                    <a:ext cx="156597" cy="0"/>
                  </a:xfrm>
                  <a:prstGeom prst="straightConnector1">
                    <a:avLst/>
                  </a:prstGeom>
                  <a:noFill/>
                  <a:ln w="12700" cap="flat" cmpd="sng">
                    <a:solidFill>
                      <a:schemeClr val="dk1"/>
                    </a:solidFill>
                    <a:prstDash val="solid"/>
                    <a:round/>
                    <a:headEnd type="none" w="sm" len="sm"/>
                    <a:tailEnd type="triangle" w="med" len="med"/>
                  </a:ln>
                </p:spPr>
              </p:cxnSp>
            </p:grpSp>
            <p:sp>
              <p:nvSpPr>
                <p:cNvPr id="1829" name="Google Shape;1829;p13"/>
                <p:cNvSpPr/>
                <p:nvPr/>
              </p:nvSpPr>
              <p:spPr>
                <a:xfrm>
                  <a:off x="4836535" y="3104574"/>
                  <a:ext cx="611792" cy="179844"/>
                </a:xfrm>
                <a:prstGeom prst="rect">
                  <a:avLst/>
                </a:prstGeom>
                <a:solidFill>
                  <a:srgbClr val="FF6969"/>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dirty="0">
                      <a:solidFill>
                        <a:schemeClr val="dk1"/>
                      </a:solidFill>
                      <a:latin typeface="Arial"/>
                      <a:ea typeface="Arial"/>
                      <a:cs typeface="Arial"/>
                      <a:sym typeface="Arial"/>
                    </a:rPr>
                    <a:t>1T-4T</a:t>
                  </a:r>
                  <a:endParaRPr sz="1400" b="0" i="0" u="none" strike="noStrike" cap="none" dirty="0">
                    <a:solidFill>
                      <a:srgbClr val="000000"/>
                    </a:solidFill>
                    <a:latin typeface="Arial"/>
                    <a:ea typeface="Arial"/>
                    <a:cs typeface="Arial"/>
                    <a:sym typeface="Arial"/>
                  </a:endParaRPr>
                </a:p>
              </p:txBody>
            </p:sp>
          </p:grpSp>
          <p:sp>
            <p:nvSpPr>
              <p:cNvPr id="1830" name="Google Shape;1830;p13"/>
              <p:cNvSpPr/>
              <p:nvPr/>
            </p:nvSpPr>
            <p:spPr>
              <a:xfrm>
                <a:off x="6319608" y="1353520"/>
                <a:ext cx="529380" cy="178805"/>
              </a:xfrm>
              <a:prstGeom prst="rect">
                <a:avLst/>
              </a:prstGeom>
              <a:solidFill>
                <a:srgbClr val="C198E0"/>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AmpR</a:t>
                </a:r>
                <a:endParaRPr sz="775" b="0" i="0" u="none" strike="noStrike" cap="none">
                  <a:solidFill>
                    <a:schemeClr val="dk1"/>
                  </a:solidFill>
                  <a:latin typeface="Arial"/>
                  <a:ea typeface="Arial"/>
                  <a:cs typeface="Arial"/>
                  <a:sym typeface="Arial"/>
                </a:endParaRPr>
              </a:p>
            </p:txBody>
          </p:sp>
          <p:sp>
            <p:nvSpPr>
              <p:cNvPr id="1831" name="Google Shape;1831;p13"/>
              <p:cNvSpPr/>
              <p:nvPr/>
            </p:nvSpPr>
            <p:spPr>
              <a:xfrm>
                <a:off x="5217793" y="1351296"/>
                <a:ext cx="743721" cy="178805"/>
              </a:xfrm>
              <a:prstGeom prst="rect">
                <a:avLst/>
              </a:prstGeom>
              <a:solidFill>
                <a:srgbClr val="FFFF00"/>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ColE1</a:t>
                </a:r>
                <a:endParaRPr sz="1400" b="0" i="0" u="none" strike="noStrike" cap="none">
                  <a:solidFill>
                    <a:srgbClr val="000000"/>
                  </a:solidFill>
                  <a:latin typeface="Arial"/>
                  <a:ea typeface="Arial"/>
                  <a:cs typeface="Arial"/>
                  <a:sym typeface="Arial"/>
                </a:endParaRPr>
              </a:p>
            </p:txBody>
          </p:sp>
        </p:grpSp>
        <p:grpSp>
          <p:nvGrpSpPr>
            <p:cNvPr id="1832" name="Google Shape;1832;p13"/>
            <p:cNvGrpSpPr/>
            <p:nvPr/>
          </p:nvGrpSpPr>
          <p:grpSpPr>
            <a:xfrm>
              <a:off x="4317456" y="2611615"/>
              <a:ext cx="2328465" cy="416125"/>
              <a:chOff x="2756508" y="2986824"/>
              <a:chExt cx="2691868" cy="416125"/>
            </a:xfrm>
          </p:grpSpPr>
          <p:grpSp>
            <p:nvGrpSpPr>
              <p:cNvPr id="1833" name="Google Shape;1833;p13"/>
              <p:cNvGrpSpPr/>
              <p:nvPr/>
            </p:nvGrpSpPr>
            <p:grpSpPr>
              <a:xfrm>
                <a:off x="2756508" y="2986824"/>
                <a:ext cx="2691868" cy="416125"/>
                <a:chOff x="2715769" y="397247"/>
                <a:chExt cx="2691868" cy="416125"/>
              </a:xfrm>
            </p:grpSpPr>
            <p:grpSp>
              <p:nvGrpSpPr>
                <p:cNvPr id="1834" name="Google Shape;1834;p13"/>
                <p:cNvGrpSpPr/>
                <p:nvPr/>
              </p:nvGrpSpPr>
              <p:grpSpPr>
                <a:xfrm rot="10800000">
                  <a:off x="4232707" y="604624"/>
                  <a:ext cx="156596" cy="208748"/>
                  <a:chOff x="5380130" y="867147"/>
                  <a:chExt cx="156596" cy="208748"/>
                </a:xfrm>
              </p:grpSpPr>
              <p:cxnSp>
                <p:nvCxnSpPr>
                  <p:cNvPr id="1835" name="Google Shape;1835;p13"/>
                  <p:cNvCxnSpPr/>
                  <p:nvPr/>
                </p:nvCxnSpPr>
                <p:spPr>
                  <a:xfrm rot="10800000">
                    <a:off x="5386465" y="867147"/>
                    <a:ext cx="0" cy="208748"/>
                  </a:xfrm>
                  <a:prstGeom prst="straightConnector1">
                    <a:avLst/>
                  </a:prstGeom>
                  <a:noFill/>
                  <a:ln w="12700" cap="flat" cmpd="sng">
                    <a:solidFill>
                      <a:schemeClr val="dk1"/>
                    </a:solidFill>
                    <a:prstDash val="solid"/>
                    <a:round/>
                    <a:headEnd type="none" w="sm" len="sm"/>
                    <a:tailEnd type="none" w="sm" len="sm"/>
                  </a:ln>
                </p:spPr>
              </p:cxnSp>
              <p:cxnSp>
                <p:nvCxnSpPr>
                  <p:cNvPr id="1836" name="Google Shape;1836;p13"/>
                  <p:cNvCxnSpPr/>
                  <p:nvPr/>
                </p:nvCxnSpPr>
                <p:spPr>
                  <a:xfrm>
                    <a:off x="5380130" y="869950"/>
                    <a:ext cx="156596" cy="0"/>
                  </a:xfrm>
                  <a:prstGeom prst="straightConnector1">
                    <a:avLst/>
                  </a:prstGeom>
                  <a:noFill/>
                  <a:ln w="12700" cap="flat" cmpd="sng">
                    <a:solidFill>
                      <a:schemeClr val="dk1"/>
                    </a:solidFill>
                    <a:prstDash val="solid"/>
                    <a:round/>
                    <a:headEnd type="none" w="sm" len="sm"/>
                    <a:tailEnd type="triangle" w="med" len="med"/>
                  </a:ln>
                </p:spPr>
              </p:cxnSp>
            </p:grpSp>
            <p:cxnSp>
              <p:nvCxnSpPr>
                <p:cNvPr id="1837" name="Google Shape;1837;p13"/>
                <p:cNvCxnSpPr/>
                <p:nvPr/>
              </p:nvCxnSpPr>
              <p:spPr>
                <a:xfrm rot="10800000">
                  <a:off x="2722733" y="397247"/>
                  <a:ext cx="0" cy="192220"/>
                </a:xfrm>
                <a:prstGeom prst="straightConnector1">
                  <a:avLst/>
                </a:prstGeom>
                <a:noFill/>
                <a:ln w="12700" cap="flat" cmpd="sng">
                  <a:solidFill>
                    <a:schemeClr val="dk1"/>
                  </a:solidFill>
                  <a:prstDash val="solid"/>
                  <a:round/>
                  <a:headEnd type="none" w="sm" len="sm"/>
                  <a:tailEnd type="none" w="sm" len="sm"/>
                </a:ln>
              </p:spPr>
            </p:cxnSp>
            <p:cxnSp>
              <p:nvCxnSpPr>
                <p:cNvPr id="1838" name="Google Shape;1838;p13"/>
                <p:cNvCxnSpPr>
                  <a:stCxn id="1839" idx="1"/>
                  <a:endCxn id="1840" idx="3"/>
                </p:cNvCxnSpPr>
                <p:nvPr/>
              </p:nvCxnSpPr>
              <p:spPr>
                <a:xfrm rot="10800000" flipH="1">
                  <a:off x="2717837" y="605009"/>
                  <a:ext cx="2689800" cy="300"/>
                </a:xfrm>
                <a:prstGeom prst="straightConnector1">
                  <a:avLst/>
                </a:prstGeom>
                <a:noFill/>
                <a:ln w="28575" cap="flat" cmpd="sng">
                  <a:solidFill>
                    <a:schemeClr val="dk1"/>
                  </a:solidFill>
                  <a:prstDash val="solid"/>
                  <a:round/>
                  <a:headEnd type="none" w="sm" len="sm"/>
                  <a:tailEnd type="none" w="sm" len="sm"/>
                </a:ln>
              </p:spPr>
            </p:cxnSp>
            <p:sp>
              <p:nvSpPr>
                <p:cNvPr id="1839" name="Google Shape;1839;p13"/>
                <p:cNvSpPr/>
                <p:nvPr/>
              </p:nvSpPr>
              <p:spPr>
                <a:xfrm>
                  <a:off x="2717837" y="515309"/>
                  <a:ext cx="1664740" cy="180000"/>
                </a:xfrm>
                <a:prstGeom prst="rect">
                  <a:avLst/>
                </a:prstGeom>
                <a:solidFill>
                  <a:srgbClr val="FFCA2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Target Gene</a:t>
                  </a:r>
                  <a:endParaRPr sz="1400" b="0" i="0" u="none" strike="noStrike" cap="none">
                    <a:solidFill>
                      <a:srgbClr val="000000"/>
                    </a:solidFill>
                    <a:latin typeface="Arial"/>
                    <a:ea typeface="Arial"/>
                    <a:cs typeface="Arial"/>
                    <a:sym typeface="Arial"/>
                  </a:endParaRPr>
                </a:p>
              </p:txBody>
            </p:sp>
            <p:sp>
              <p:nvSpPr>
                <p:cNvPr id="1841" name="Google Shape;1841;p13"/>
                <p:cNvSpPr/>
                <p:nvPr/>
              </p:nvSpPr>
              <p:spPr>
                <a:xfrm>
                  <a:off x="4383000" y="515309"/>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pT7</a:t>
                  </a:r>
                  <a:endParaRPr sz="1400" b="0" i="0" u="none" strike="noStrike" cap="none">
                    <a:solidFill>
                      <a:srgbClr val="000000"/>
                    </a:solidFill>
                    <a:latin typeface="Arial"/>
                    <a:ea typeface="Arial"/>
                    <a:cs typeface="Arial"/>
                    <a:sym typeface="Arial"/>
                  </a:endParaRPr>
                </a:p>
              </p:txBody>
            </p:sp>
            <p:cxnSp>
              <p:nvCxnSpPr>
                <p:cNvPr id="1842" name="Google Shape;1842;p13"/>
                <p:cNvCxnSpPr/>
                <p:nvPr/>
              </p:nvCxnSpPr>
              <p:spPr>
                <a:xfrm>
                  <a:off x="2715769" y="400050"/>
                  <a:ext cx="156597" cy="0"/>
                </a:xfrm>
                <a:prstGeom prst="straightConnector1">
                  <a:avLst/>
                </a:prstGeom>
                <a:noFill/>
                <a:ln w="12700" cap="flat" cmpd="sng">
                  <a:solidFill>
                    <a:schemeClr val="dk1"/>
                  </a:solidFill>
                  <a:prstDash val="solid"/>
                  <a:round/>
                  <a:headEnd type="none" w="sm" len="sm"/>
                  <a:tailEnd type="triangle" w="med" len="med"/>
                </a:ln>
              </p:spPr>
            </p:cxnSp>
          </p:grpSp>
          <p:sp>
            <p:nvSpPr>
              <p:cNvPr id="1840" name="Google Shape;1840;p13"/>
              <p:cNvSpPr/>
              <p:nvPr/>
            </p:nvSpPr>
            <p:spPr>
              <a:xfrm>
                <a:off x="4836535" y="3104574"/>
                <a:ext cx="611792" cy="179844"/>
              </a:xfrm>
              <a:prstGeom prst="rect">
                <a:avLst/>
              </a:prstGeom>
              <a:solidFill>
                <a:srgbClr val="FF6969"/>
              </a:solidFill>
              <a:ln w="9525" cap="flat" cmpd="sng">
                <a:solidFill>
                  <a:schemeClr val="dk1">
                    <a:alpha val="9490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775"/>
                  <a:buFont typeface="Arial"/>
                  <a:buNone/>
                </a:pPr>
                <a:r>
                  <a:rPr lang="en-GB" sz="775" b="0" i="0" u="none" strike="noStrike" cap="none">
                    <a:solidFill>
                      <a:schemeClr val="dk1"/>
                    </a:solidFill>
                    <a:latin typeface="Arial"/>
                    <a:ea typeface="Arial"/>
                    <a:cs typeface="Arial"/>
                    <a:sym typeface="Arial"/>
                  </a:rPr>
                  <a:t>1T-4T</a:t>
                </a:r>
                <a:endParaRPr sz="1400" b="0" i="0" u="none" strike="noStrike" cap="none">
                  <a:solidFill>
                    <a:srgbClr val="000000"/>
                  </a:solidFill>
                  <a:latin typeface="Arial"/>
                  <a:ea typeface="Arial"/>
                  <a:cs typeface="Arial"/>
                  <a:sym typeface="Arial"/>
                </a:endParaRPr>
              </a:p>
            </p:txBody>
          </p:sp>
        </p:grpSp>
        <p:cxnSp>
          <p:nvCxnSpPr>
            <p:cNvPr id="1843" name="Google Shape;1843;p13"/>
            <p:cNvCxnSpPr/>
            <p:nvPr/>
          </p:nvCxnSpPr>
          <p:spPr>
            <a:xfrm>
              <a:off x="200387" y="2479755"/>
              <a:ext cx="3273216" cy="0"/>
            </a:xfrm>
            <a:prstGeom prst="straightConnector1">
              <a:avLst/>
            </a:prstGeom>
            <a:noFill/>
            <a:ln w="19050" cap="flat" cmpd="sng">
              <a:solidFill>
                <a:schemeClr val="dk1"/>
              </a:solidFill>
              <a:prstDash val="dash"/>
              <a:round/>
              <a:headEnd type="none" w="sm" len="sm"/>
              <a:tailEnd type="none" w="sm" len="sm"/>
            </a:ln>
          </p:spPr>
        </p:cxnSp>
        <p:cxnSp>
          <p:nvCxnSpPr>
            <p:cNvPr id="1844" name="Google Shape;1844;p13"/>
            <p:cNvCxnSpPr/>
            <p:nvPr/>
          </p:nvCxnSpPr>
          <p:spPr>
            <a:xfrm rot="10800000">
              <a:off x="200387" y="2375080"/>
              <a:ext cx="0" cy="209349"/>
            </a:xfrm>
            <a:prstGeom prst="straightConnector1">
              <a:avLst/>
            </a:prstGeom>
            <a:noFill/>
            <a:ln w="19050" cap="flat" cmpd="sng">
              <a:solidFill>
                <a:schemeClr val="dk1"/>
              </a:solidFill>
              <a:prstDash val="solid"/>
              <a:round/>
              <a:headEnd type="none" w="sm" len="sm"/>
              <a:tailEnd type="none" w="sm" len="sm"/>
            </a:ln>
          </p:spPr>
        </p:cxnSp>
        <p:cxnSp>
          <p:nvCxnSpPr>
            <p:cNvPr id="1845" name="Google Shape;1845;p13"/>
            <p:cNvCxnSpPr/>
            <p:nvPr/>
          </p:nvCxnSpPr>
          <p:spPr>
            <a:xfrm rot="10800000">
              <a:off x="3473603" y="2375080"/>
              <a:ext cx="0" cy="209349"/>
            </a:xfrm>
            <a:prstGeom prst="straightConnector1">
              <a:avLst/>
            </a:prstGeom>
            <a:noFill/>
            <a:ln w="19050" cap="flat" cmpd="sng">
              <a:solidFill>
                <a:schemeClr val="dk1"/>
              </a:solidFill>
              <a:prstDash val="solid"/>
              <a:round/>
              <a:headEnd type="none" w="sm" len="sm"/>
              <a:tailEnd type="none" w="sm" len="sm"/>
            </a:ln>
          </p:spPr>
        </p:cxnSp>
        <p:cxnSp>
          <p:nvCxnSpPr>
            <p:cNvPr id="1846" name="Google Shape;1846;p13"/>
            <p:cNvCxnSpPr/>
            <p:nvPr/>
          </p:nvCxnSpPr>
          <p:spPr>
            <a:xfrm>
              <a:off x="399254" y="3435709"/>
              <a:ext cx="2334420" cy="0"/>
            </a:xfrm>
            <a:prstGeom prst="straightConnector1">
              <a:avLst/>
            </a:prstGeom>
            <a:noFill/>
            <a:ln w="19050" cap="flat" cmpd="sng">
              <a:solidFill>
                <a:schemeClr val="dk1"/>
              </a:solidFill>
              <a:prstDash val="dash"/>
              <a:round/>
              <a:headEnd type="none" w="sm" len="sm"/>
              <a:tailEnd type="none" w="sm" len="sm"/>
            </a:ln>
          </p:spPr>
        </p:cxnSp>
        <p:cxnSp>
          <p:nvCxnSpPr>
            <p:cNvPr id="1847" name="Google Shape;1847;p13"/>
            <p:cNvCxnSpPr/>
            <p:nvPr/>
          </p:nvCxnSpPr>
          <p:spPr>
            <a:xfrm rot="10800000">
              <a:off x="399254" y="3331034"/>
              <a:ext cx="0" cy="209349"/>
            </a:xfrm>
            <a:prstGeom prst="straightConnector1">
              <a:avLst/>
            </a:prstGeom>
            <a:noFill/>
            <a:ln w="19050" cap="flat" cmpd="sng">
              <a:solidFill>
                <a:schemeClr val="dk1"/>
              </a:solidFill>
              <a:prstDash val="solid"/>
              <a:round/>
              <a:headEnd type="none" w="sm" len="sm"/>
              <a:tailEnd type="none" w="sm" len="sm"/>
            </a:ln>
          </p:spPr>
        </p:cxnSp>
        <p:cxnSp>
          <p:nvCxnSpPr>
            <p:cNvPr id="1848" name="Google Shape;1848;p13"/>
            <p:cNvCxnSpPr/>
            <p:nvPr/>
          </p:nvCxnSpPr>
          <p:spPr>
            <a:xfrm rot="10800000">
              <a:off x="2733674" y="3331034"/>
              <a:ext cx="0" cy="209349"/>
            </a:xfrm>
            <a:prstGeom prst="straightConnector1">
              <a:avLst/>
            </a:prstGeom>
            <a:noFill/>
            <a:ln w="19050" cap="flat" cmpd="sng">
              <a:solidFill>
                <a:schemeClr val="dk1"/>
              </a:solidFill>
              <a:prstDash val="solid"/>
              <a:round/>
              <a:headEnd type="none" w="sm" len="sm"/>
              <a:tailEnd type="none" w="sm" len="sm"/>
            </a:ln>
          </p:spPr>
        </p:cxnSp>
        <p:cxnSp>
          <p:nvCxnSpPr>
            <p:cNvPr id="1849" name="Google Shape;1849;p13"/>
            <p:cNvCxnSpPr/>
            <p:nvPr/>
          </p:nvCxnSpPr>
          <p:spPr>
            <a:xfrm>
              <a:off x="3007994" y="3435709"/>
              <a:ext cx="4404637" cy="0"/>
            </a:xfrm>
            <a:prstGeom prst="straightConnector1">
              <a:avLst/>
            </a:prstGeom>
            <a:noFill/>
            <a:ln w="19050" cap="flat" cmpd="sng">
              <a:solidFill>
                <a:schemeClr val="dk1"/>
              </a:solidFill>
              <a:prstDash val="dash"/>
              <a:round/>
              <a:headEnd type="none" w="sm" len="sm"/>
              <a:tailEnd type="none" w="sm" len="sm"/>
            </a:ln>
          </p:spPr>
        </p:cxnSp>
        <p:cxnSp>
          <p:nvCxnSpPr>
            <p:cNvPr id="1850" name="Google Shape;1850;p13"/>
            <p:cNvCxnSpPr/>
            <p:nvPr/>
          </p:nvCxnSpPr>
          <p:spPr>
            <a:xfrm rot="10800000">
              <a:off x="3007994" y="3331034"/>
              <a:ext cx="0" cy="209349"/>
            </a:xfrm>
            <a:prstGeom prst="straightConnector1">
              <a:avLst/>
            </a:prstGeom>
            <a:noFill/>
            <a:ln w="19050" cap="flat" cmpd="sng">
              <a:solidFill>
                <a:schemeClr val="dk1"/>
              </a:solidFill>
              <a:prstDash val="solid"/>
              <a:round/>
              <a:headEnd type="none" w="sm" len="sm"/>
              <a:tailEnd type="none" w="sm" len="sm"/>
            </a:ln>
          </p:spPr>
        </p:cxnSp>
        <p:cxnSp>
          <p:nvCxnSpPr>
            <p:cNvPr id="1851" name="Google Shape;1851;p13"/>
            <p:cNvCxnSpPr/>
            <p:nvPr/>
          </p:nvCxnSpPr>
          <p:spPr>
            <a:xfrm rot="10800000">
              <a:off x="7412631" y="3331034"/>
              <a:ext cx="0" cy="209349"/>
            </a:xfrm>
            <a:prstGeom prst="straightConnector1">
              <a:avLst/>
            </a:prstGeom>
            <a:noFill/>
            <a:ln w="19050" cap="flat" cmpd="sng">
              <a:solidFill>
                <a:schemeClr val="dk1"/>
              </a:solidFill>
              <a:prstDash val="solid"/>
              <a:round/>
              <a:headEnd type="none" w="sm" len="sm"/>
              <a:tailEnd type="none" w="sm" len="sm"/>
            </a:ln>
          </p:spPr>
        </p:cxnSp>
        <p:cxnSp>
          <p:nvCxnSpPr>
            <p:cNvPr id="1852" name="Google Shape;1852;p13"/>
            <p:cNvCxnSpPr/>
            <p:nvPr/>
          </p:nvCxnSpPr>
          <p:spPr>
            <a:xfrm>
              <a:off x="4311459" y="2479754"/>
              <a:ext cx="2334420" cy="0"/>
            </a:xfrm>
            <a:prstGeom prst="straightConnector1">
              <a:avLst/>
            </a:prstGeom>
            <a:noFill/>
            <a:ln w="19050" cap="flat" cmpd="sng">
              <a:solidFill>
                <a:schemeClr val="dk1"/>
              </a:solidFill>
              <a:prstDash val="dash"/>
              <a:round/>
              <a:headEnd type="none" w="sm" len="sm"/>
              <a:tailEnd type="none" w="sm" len="sm"/>
            </a:ln>
          </p:spPr>
        </p:cxnSp>
        <p:cxnSp>
          <p:nvCxnSpPr>
            <p:cNvPr id="1853" name="Google Shape;1853;p13"/>
            <p:cNvCxnSpPr/>
            <p:nvPr/>
          </p:nvCxnSpPr>
          <p:spPr>
            <a:xfrm rot="10800000">
              <a:off x="4311459" y="2375079"/>
              <a:ext cx="0" cy="209349"/>
            </a:xfrm>
            <a:prstGeom prst="straightConnector1">
              <a:avLst/>
            </a:prstGeom>
            <a:noFill/>
            <a:ln w="19050" cap="flat" cmpd="sng">
              <a:solidFill>
                <a:schemeClr val="dk1"/>
              </a:solidFill>
              <a:prstDash val="solid"/>
              <a:round/>
              <a:headEnd type="none" w="sm" len="sm"/>
              <a:tailEnd type="none" w="sm" len="sm"/>
            </a:ln>
          </p:spPr>
        </p:cxnSp>
        <p:cxnSp>
          <p:nvCxnSpPr>
            <p:cNvPr id="1854" name="Google Shape;1854;p13"/>
            <p:cNvCxnSpPr/>
            <p:nvPr/>
          </p:nvCxnSpPr>
          <p:spPr>
            <a:xfrm rot="10800000">
              <a:off x="6645879" y="2375079"/>
              <a:ext cx="0" cy="209349"/>
            </a:xfrm>
            <a:prstGeom prst="straightConnector1">
              <a:avLst/>
            </a:prstGeom>
            <a:noFill/>
            <a:ln w="19050" cap="flat" cmpd="sng">
              <a:solidFill>
                <a:schemeClr val="dk1"/>
              </a:solidFill>
              <a:prstDash val="solid"/>
              <a:round/>
              <a:headEnd type="none" w="sm" len="sm"/>
              <a:tailEnd type="none" w="sm" len="sm"/>
            </a:ln>
          </p:spPr>
        </p:cxnSp>
        <p:sp>
          <p:nvSpPr>
            <p:cNvPr id="1855" name="Google Shape;1855;p13"/>
            <p:cNvSpPr txBox="1"/>
            <p:nvPr/>
          </p:nvSpPr>
          <p:spPr>
            <a:xfrm>
              <a:off x="1398281" y="2206138"/>
              <a:ext cx="1757145"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GB" sz="1000" b="0" i="0" u="none" strike="noStrike" cap="none">
                  <a:solidFill>
                    <a:srgbClr val="000000"/>
                  </a:solidFill>
                  <a:latin typeface="Arial"/>
                  <a:ea typeface="Arial"/>
                  <a:cs typeface="Arial"/>
                  <a:sym typeface="Arial"/>
                </a:rPr>
                <a:t>1318 - 1562 nts</a:t>
              </a:r>
              <a:endParaRPr sz="1000" b="0" i="0" u="none" strike="noStrike" cap="none">
                <a:solidFill>
                  <a:srgbClr val="000000"/>
                </a:solidFill>
                <a:latin typeface="Arial"/>
                <a:ea typeface="Arial"/>
                <a:cs typeface="Arial"/>
                <a:sym typeface="Arial"/>
              </a:endParaRPr>
            </a:p>
          </p:txBody>
        </p:sp>
        <p:sp>
          <p:nvSpPr>
            <p:cNvPr id="1856" name="Google Shape;1856;p13"/>
            <p:cNvSpPr txBox="1"/>
            <p:nvPr/>
          </p:nvSpPr>
          <p:spPr>
            <a:xfrm>
              <a:off x="1133674" y="3158023"/>
              <a:ext cx="1757145"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GB" sz="1000" b="0" i="0" u="none" strike="noStrike" cap="none">
                  <a:solidFill>
                    <a:srgbClr val="000000"/>
                  </a:solidFill>
                  <a:latin typeface="Arial"/>
                  <a:ea typeface="Arial"/>
                  <a:cs typeface="Arial"/>
                  <a:sym typeface="Arial"/>
                </a:rPr>
                <a:t>427 – 581 nts</a:t>
              </a:r>
              <a:endParaRPr sz="1000" b="0" i="0" u="none" strike="noStrike" cap="none">
                <a:solidFill>
                  <a:srgbClr val="000000"/>
                </a:solidFill>
                <a:latin typeface="Arial"/>
                <a:ea typeface="Arial"/>
                <a:cs typeface="Arial"/>
                <a:sym typeface="Arial"/>
              </a:endParaRPr>
            </a:p>
          </p:txBody>
        </p:sp>
        <p:sp>
          <p:nvSpPr>
            <p:cNvPr id="1857" name="Google Shape;1857;p13"/>
            <p:cNvSpPr txBox="1"/>
            <p:nvPr/>
          </p:nvSpPr>
          <p:spPr>
            <a:xfrm>
              <a:off x="4755117" y="3181950"/>
              <a:ext cx="1512000" cy="246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GB" sz="1000" b="0" i="0" u="none" strike="noStrike" cap="none">
                  <a:solidFill>
                    <a:srgbClr val="000000"/>
                  </a:solidFill>
                  <a:latin typeface="Arial"/>
                  <a:ea typeface="Arial"/>
                  <a:cs typeface="Arial"/>
                  <a:sym typeface="Arial"/>
                </a:rPr>
                <a:t>1873 - 2632 nts</a:t>
              </a:r>
              <a:endParaRPr sz="1000" b="0" i="0" u="none" strike="noStrike" cap="none">
                <a:solidFill>
                  <a:srgbClr val="000000"/>
                </a:solidFill>
                <a:latin typeface="Arial"/>
                <a:ea typeface="Arial"/>
                <a:cs typeface="Arial"/>
                <a:sym typeface="Arial"/>
              </a:endParaRPr>
            </a:p>
          </p:txBody>
        </p:sp>
        <p:sp>
          <p:nvSpPr>
            <p:cNvPr id="1858" name="Google Shape;1858;p13"/>
            <p:cNvSpPr txBox="1"/>
            <p:nvPr/>
          </p:nvSpPr>
          <p:spPr>
            <a:xfrm>
              <a:off x="5106974" y="2229832"/>
              <a:ext cx="1757145"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GB" sz="1000" b="0" i="0" u="none" strike="noStrike" cap="none">
                  <a:solidFill>
                    <a:srgbClr val="000000"/>
                  </a:solidFill>
                  <a:latin typeface="Arial"/>
                  <a:ea typeface="Arial"/>
                  <a:cs typeface="Arial"/>
                  <a:sym typeface="Arial"/>
                </a:rPr>
                <a:t>427 - 581 nts</a:t>
              </a:r>
              <a:endParaRPr sz="1000" b="0" i="0" u="none" strike="noStrike" cap="none">
                <a:solidFill>
                  <a:srgbClr val="000000"/>
                </a:solidFill>
                <a:latin typeface="Arial"/>
                <a:ea typeface="Arial"/>
                <a:cs typeface="Arial"/>
                <a:sym typeface="Arial"/>
              </a:endParaRPr>
            </a:p>
          </p:txBody>
        </p:sp>
      </p:grpSp>
      <p:grpSp>
        <p:nvGrpSpPr>
          <p:cNvPr id="1861" name="Google Shape;1861;p13"/>
          <p:cNvGrpSpPr/>
          <p:nvPr/>
        </p:nvGrpSpPr>
        <p:grpSpPr>
          <a:xfrm>
            <a:off x="270000" y="4293119"/>
            <a:ext cx="5477424" cy="1270487"/>
            <a:chOff x="270000" y="4293119"/>
            <a:chExt cx="5477424" cy="1270487"/>
          </a:xfrm>
        </p:grpSpPr>
        <p:sp>
          <p:nvSpPr>
            <p:cNvPr id="1862" name="Google Shape;1862;p13"/>
            <p:cNvSpPr/>
            <p:nvPr/>
          </p:nvSpPr>
          <p:spPr>
            <a:xfrm>
              <a:off x="306000" y="5004450"/>
              <a:ext cx="540000" cy="178800"/>
            </a:xfrm>
            <a:prstGeom prst="rect">
              <a:avLst/>
            </a:prstGeom>
            <a:solidFill>
              <a:srgbClr val="FFFF00"/>
            </a:solidFill>
            <a:ln w="9525" cap="flat" cmpd="sng">
              <a:solidFill>
                <a:schemeClr val="dk1">
                  <a:alpha val="95294"/>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r>
                <a:rPr lang="en-GB" sz="1000" b="0" i="0" u="none" strike="noStrike" cap="none">
                  <a:solidFill>
                    <a:schemeClr val="dk1"/>
                  </a:solidFill>
                  <a:latin typeface="Arial"/>
                  <a:ea typeface="Arial"/>
                  <a:cs typeface="Arial"/>
                  <a:sym typeface="Arial"/>
                </a:rPr>
                <a:t>ColE1</a:t>
              </a:r>
              <a:endParaRPr sz="1000" b="0" i="0" u="none" strike="noStrike" cap="none">
                <a:solidFill>
                  <a:srgbClr val="000000"/>
                </a:solidFill>
                <a:latin typeface="Arial"/>
                <a:ea typeface="Arial"/>
                <a:cs typeface="Arial"/>
                <a:sym typeface="Arial"/>
              </a:endParaRPr>
            </a:p>
          </p:txBody>
        </p:sp>
        <p:grpSp>
          <p:nvGrpSpPr>
            <p:cNvPr id="1863" name="Google Shape;1863;p13"/>
            <p:cNvGrpSpPr/>
            <p:nvPr/>
          </p:nvGrpSpPr>
          <p:grpSpPr>
            <a:xfrm>
              <a:off x="270000" y="4293119"/>
              <a:ext cx="5477424" cy="1270487"/>
              <a:chOff x="2082375" y="3759719"/>
              <a:chExt cx="5477424" cy="1270487"/>
            </a:xfrm>
          </p:grpSpPr>
          <p:sp>
            <p:nvSpPr>
              <p:cNvPr id="1864" name="Google Shape;1864;p13"/>
              <p:cNvSpPr/>
              <p:nvPr/>
            </p:nvSpPr>
            <p:spPr>
              <a:xfrm>
                <a:off x="2250998" y="3807128"/>
                <a:ext cx="413700"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r>
                  <a:rPr lang="en-GB" sz="1000" b="0" i="0" u="none" strike="noStrike" cap="none">
                    <a:solidFill>
                      <a:schemeClr val="dk1"/>
                    </a:solidFill>
                    <a:latin typeface="Arial"/>
                    <a:ea typeface="Arial"/>
                    <a:cs typeface="Arial"/>
                    <a:sym typeface="Arial"/>
                  </a:rPr>
                  <a:t>pT7</a:t>
                </a:r>
                <a:endParaRPr sz="1000" b="0" i="0" u="none" strike="noStrike" cap="none">
                  <a:solidFill>
                    <a:srgbClr val="000000"/>
                  </a:solidFill>
                  <a:latin typeface="Arial"/>
                  <a:ea typeface="Arial"/>
                  <a:cs typeface="Arial"/>
                  <a:sym typeface="Arial"/>
                </a:endParaRPr>
              </a:p>
            </p:txBody>
          </p:sp>
          <p:sp>
            <p:nvSpPr>
              <p:cNvPr id="1865" name="Google Shape;1865;p13"/>
              <p:cNvSpPr/>
              <p:nvPr/>
            </p:nvSpPr>
            <p:spPr>
              <a:xfrm>
                <a:off x="2082375" y="4147950"/>
                <a:ext cx="594900" cy="178800"/>
              </a:xfrm>
              <a:prstGeom prst="rect">
                <a:avLst/>
              </a:prstGeom>
              <a:solidFill>
                <a:srgbClr val="FF6969"/>
              </a:solidFill>
              <a:ln w="9525" cap="flat" cmpd="sng">
                <a:solidFill>
                  <a:schemeClr val="dk1">
                    <a:alpha val="95294"/>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r>
                  <a:rPr lang="en-GB" sz="1000" b="0" i="0" u="none" strike="noStrike" cap="none">
                    <a:solidFill>
                      <a:schemeClr val="dk1"/>
                    </a:solidFill>
                    <a:latin typeface="Arial"/>
                    <a:ea typeface="Arial"/>
                    <a:cs typeface="Arial"/>
                    <a:sym typeface="Arial"/>
                  </a:rPr>
                  <a:t>1T - 4T</a:t>
                </a:r>
                <a:endParaRPr sz="1000" b="0" i="0" u="none" strike="noStrike" cap="none">
                  <a:solidFill>
                    <a:srgbClr val="000000"/>
                  </a:solidFill>
                  <a:latin typeface="Arial"/>
                  <a:ea typeface="Arial"/>
                  <a:cs typeface="Arial"/>
                  <a:sym typeface="Arial"/>
                </a:endParaRPr>
              </a:p>
            </p:txBody>
          </p:sp>
          <p:sp>
            <p:nvSpPr>
              <p:cNvPr id="1866" name="Google Shape;1866;p13"/>
              <p:cNvSpPr/>
              <p:nvPr/>
            </p:nvSpPr>
            <p:spPr>
              <a:xfrm>
                <a:off x="2117067" y="4812398"/>
                <a:ext cx="540000" cy="180000"/>
              </a:xfrm>
              <a:prstGeom prst="rect">
                <a:avLst/>
              </a:prstGeom>
              <a:solidFill>
                <a:srgbClr val="C198E0"/>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r>
                  <a:rPr lang="en-GB" sz="1000" b="0" i="0" u="none" strike="noStrike" cap="none">
                    <a:solidFill>
                      <a:schemeClr val="dk1"/>
                    </a:solidFill>
                    <a:latin typeface="Arial"/>
                    <a:ea typeface="Arial"/>
                    <a:cs typeface="Arial"/>
                    <a:sym typeface="Arial"/>
                  </a:rPr>
                  <a:t>AmpR</a:t>
                </a:r>
                <a:endParaRPr sz="1000" b="0" i="0" u="none" strike="noStrike" cap="none">
                  <a:solidFill>
                    <a:srgbClr val="000000"/>
                  </a:solidFill>
                  <a:latin typeface="Arial"/>
                  <a:ea typeface="Arial"/>
                  <a:cs typeface="Arial"/>
                  <a:sym typeface="Arial"/>
                </a:endParaRPr>
              </a:p>
            </p:txBody>
          </p:sp>
          <p:cxnSp>
            <p:nvCxnSpPr>
              <p:cNvPr id="1867" name="Google Shape;1867;p13"/>
              <p:cNvCxnSpPr/>
              <p:nvPr/>
            </p:nvCxnSpPr>
            <p:spPr>
              <a:xfrm>
                <a:off x="2712098" y="3897128"/>
                <a:ext cx="392400" cy="0"/>
              </a:xfrm>
              <a:prstGeom prst="straightConnector1">
                <a:avLst/>
              </a:prstGeom>
              <a:noFill/>
              <a:ln w="19050" cap="flat" cmpd="sng">
                <a:solidFill>
                  <a:schemeClr val="dk1"/>
                </a:solidFill>
                <a:prstDash val="solid"/>
                <a:round/>
                <a:headEnd type="none" w="sm" len="sm"/>
                <a:tailEnd type="none" w="sm" len="sm"/>
              </a:ln>
            </p:spPr>
          </p:cxnSp>
          <p:cxnSp>
            <p:nvCxnSpPr>
              <p:cNvPr id="1868" name="Google Shape;1868;p13"/>
              <p:cNvCxnSpPr/>
              <p:nvPr/>
            </p:nvCxnSpPr>
            <p:spPr>
              <a:xfrm>
                <a:off x="2712097" y="4237344"/>
                <a:ext cx="392400" cy="0"/>
              </a:xfrm>
              <a:prstGeom prst="straightConnector1">
                <a:avLst/>
              </a:prstGeom>
              <a:noFill/>
              <a:ln w="19050" cap="flat" cmpd="sng">
                <a:solidFill>
                  <a:schemeClr val="dk1"/>
                </a:solidFill>
                <a:prstDash val="solid"/>
                <a:round/>
                <a:headEnd type="none" w="sm" len="sm"/>
                <a:tailEnd type="none" w="sm" len="sm"/>
              </a:ln>
            </p:spPr>
          </p:cxnSp>
          <p:cxnSp>
            <p:nvCxnSpPr>
              <p:cNvPr id="1869" name="Google Shape;1869;p13"/>
              <p:cNvCxnSpPr/>
              <p:nvPr/>
            </p:nvCxnSpPr>
            <p:spPr>
              <a:xfrm>
                <a:off x="2712096" y="4582363"/>
                <a:ext cx="392400" cy="0"/>
              </a:xfrm>
              <a:prstGeom prst="straightConnector1">
                <a:avLst/>
              </a:prstGeom>
              <a:noFill/>
              <a:ln w="19050" cap="flat" cmpd="sng">
                <a:solidFill>
                  <a:schemeClr val="dk1"/>
                </a:solidFill>
                <a:prstDash val="solid"/>
                <a:round/>
                <a:headEnd type="none" w="sm" len="sm"/>
                <a:tailEnd type="none" w="sm" len="sm"/>
              </a:ln>
            </p:spPr>
          </p:cxnSp>
          <p:cxnSp>
            <p:nvCxnSpPr>
              <p:cNvPr id="1870" name="Google Shape;1870;p13"/>
              <p:cNvCxnSpPr/>
              <p:nvPr/>
            </p:nvCxnSpPr>
            <p:spPr>
              <a:xfrm>
                <a:off x="2712095" y="4910864"/>
                <a:ext cx="392400" cy="0"/>
              </a:xfrm>
              <a:prstGeom prst="straightConnector1">
                <a:avLst/>
              </a:prstGeom>
              <a:noFill/>
              <a:ln w="19050" cap="flat" cmpd="sng">
                <a:solidFill>
                  <a:schemeClr val="dk1"/>
                </a:solidFill>
                <a:prstDash val="solid"/>
                <a:round/>
                <a:headEnd type="none" w="sm" len="sm"/>
                <a:tailEnd type="none" w="sm" len="sm"/>
              </a:ln>
            </p:spPr>
          </p:cxnSp>
          <p:sp>
            <p:nvSpPr>
              <p:cNvPr id="1871" name="Google Shape;1871;p13"/>
              <p:cNvSpPr txBox="1"/>
              <p:nvPr/>
            </p:nvSpPr>
            <p:spPr>
              <a:xfrm>
                <a:off x="3279100" y="3759719"/>
                <a:ext cx="2406900" cy="246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en-GB" sz="1000" b="0" i="0" u="none" strike="noStrike" cap="none">
                    <a:solidFill>
                      <a:srgbClr val="000000"/>
                    </a:solidFill>
                    <a:latin typeface="Arial"/>
                    <a:ea typeface="Arial"/>
                    <a:cs typeface="Arial"/>
                    <a:sym typeface="Arial"/>
                  </a:rPr>
                  <a:t>T7 RNA Polymerase promoter</a:t>
                </a:r>
                <a:endParaRPr sz="1000" b="0" i="0" u="none" strike="noStrike" cap="none">
                  <a:solidFill>
                    <a:srgbClr val="000000"/>
                  </a:solidFill>
                  <a:latin typeface="Arial"/>
                  <a:ea typeface="Arial"/>
                  <a:cs typeface="Arial"/>
                  <a:sym typeface="Arial"/>
                </a:endParaRPr>
              </a:p>
            </p:txBody>
          </p:sp>
          <p:sp>
            <p:nvSpPr>
              <p:cNvPr id="1872" name="Google Shape;1872;p13"/>
              <p:cNvSpPr txBox="1"/>
              <p:nvPr/>
            </p:nvSpPr>
            <p:spPr>
              <a:xfrm>
                <a:off x="3279100" y="4107509"/>
                <a:ext cx="2901600" cy="246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en-GB" sz="1000" b="0" i="0" u="none" strike="noStrike" cap="none">
                    <a:solidFill>
                      <a:srgbClr val="000000"/>
                    </a:solidFill>
                    <a:latin typeface="Arial"/>
                    <a:ea typeface="Arial"/>
                    <a:cs typeface="Arial"/>
                    <a:sym typeface="Arial"/>
                  </a:rPr>
                  <a:t>T7 RNA Polymerase synthetic terminator</a:t>
                </a:r>
                <a:endParaRPr sz="1000" b="0" i="0" u="none" strike="noStrike" cap="none">
                  <a:solidFill>
                    <a:srgbClr val="000000"/>
                  </a:solidFill>
                  <a:latin typeface="Arial"/>
                  <a:ea typeface="Arial"/>
                  <a:cs typeface="Arial"/>
                  <a:sym typeface="Arial"/>
                </a:endParaRPr>
              </a:p>
            </p:txBody>
          </p:sp>
          <p:sp>
            <p:nvSpPr>
              <p:cNvPr id="1873" name="Google Shape;1873;p13"/>
              <p:cNvSpPr txBox="1"/>
              <p:nvPr/>
            </p:nvSpPr>
            <p:spPr>
              <a:xfrm>
                <a:off x="3279099" y="4437299"/>
                <a:ext cx="4280700" cy="246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en-GB" sz="1000" b="0" i="0" u="none" strike="noStrike" cap="none">
                    <a:solidFill>
                      <a:srgbClr val="000000"/>
                    </a:solidFill>
                    <a:latin typeface="Arial"/>
                    <a:ea typeface="Arial"/>
                    <a:cs typeface="Arial"/>
                    <a:sym typeface="Arial"/>
                  </a:rPr>
                  <a:t>ColE1 origin of replication </a:t>
                </a:r>
                <a:endParaRPr sz="1000" b="0" i="0" u="none" strike="noStrike" cap="none">
                  <a:solidFill>
                    <a:srgbClr val="000000"/>
                  </a:solidFill>
                  <a:latin typeface="Arial"/>
                  <a:ea typeface="Arial"/>
                  <a:cs typeface="Arial"/>
                  <a:sym typeface="Arial"/>
                </a:endParaRPr>
              </a:p>
            </p:txBody>
          </p:sp>
          <p:sp>
            <p:nvSpPr>
              <p:cNvPr id="1874" name="Google Shape;1874;p13"/>
              <p:cNvSpPr txBox="1"/>
              <p:nvPr/>
            </p:nvSpPr>
            <p:spPr>
              <a:xfrm>
                <a:off x="3279099" y="4783906"/>
                <a:ext cx="3164700" cy="246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en-GB" sz="1000" b="0" i="0" u="none" strike="noStrike" cap="none">
                    <a:solidFill>
                      <a:srgbClr val="000000"/>
                    </a:solidFill>
                    <a:latin typeface="Arial"/>
                    <a:ea typeface="Arial"/>
                    <a:cs typeface="Arial"/>
                    <a:sym typeface="Arial"/>
                  </a:rPr>
                  <a:t>Ampicillin resistance gene</a:t>
                </a:r>
                <a:endParaRPr sz="1000" b="0" i="0" u="none" strike="noStrike" cap="none">
                  <a:solidFill>
                    <a:srgbClr val="000000"/>
                  </a:solidFill>
                  <a:latin typeface="Arial"/>
                  <a:ea typeface="Arial"/>
                  <a:cs typeface="Arial"/>
                  <a:sym typeface="Arial"/>
                </a:endParaRPr>
              </a:p>
            </p:txBody>
          </p:sp>
        </p:grpSp>
      </p:grpSp>
      <p:sp>
        <p:nvSpPr>
          <p:cNvPr id="1875" name="Google Shape;1875;p13"/>
          <p:cNvSpPr/>
          <p:nvPr/>
        </p:nvSpPr>
        <p:spPr>
          <a:xfrm>
            <a:off x="375241" y="6210785"/>
            <a:ext cx="6792041" cy="2123618"/>
          </a:xfrm>
          <a:prstGeom prst="rect">
            <a:avLst/>
          </a:prstGeom>
          <a:noFill/>
          <a:ln>
            <a:noFill/>
          </a:ln>
        </p:spPr>
        <p:txBody>
          <a:bodyPr spcFirstLastPara="1" wrap="square" lIns="91425" tIns="45700" rIns="91425" bIns="45700" anchor="t" anchorCtr="0">
            <a:spAutoFit/>
          </a:bodyPr>
          <a:lstStyle/>
          <a:p>
            <a:pPr marL="0" marR="0" lvl="0" indent="0" algn="l" rtl="0">
              <a:lnSpc>
                <a:spcPct val="200000"/>
              </a:lnSpc>
              <a:spcBef>
                <a:spcPts val="0"/>
              </a:spcBef>
              <a:spcAft>
                <a:spcPts val="0"/>
              </a:spcAft>
              <a:buClr>
                <a:srgbClr val="000000"/>
              </a:buClr>
              <a:buSzPts val="1400"/>
              <a:buFont typeface="Arial"/>
              <a:buNone/>
            </a:pPr>
            <a:r>
              <a:rPr lang="en-GB" sz="1100" b="1" i="0" u="none" strike="noStrike" cap="none" dirty="0">
                <a:solidFill>
                  <a:srgbClr val="000000"/>
                </a:solidFill>
                <a:latin typeface="Arial"/>
                <a:ea typeface="Arial"/>
                <a:cs typeface="Arial"/>
                <a:sym typeface="Arial"/>
              </a:rPr>
              <a:t>Supplementary figure </a:t>
            </a:r>
            <a:r>
              <a:rPr lang="en-GB" sz="1100" b="1" dirty="0"/>
              <a:t>S2</a:t>
            </a:r>
            <a:r>
              <a:rPr lang="en-GB" sz="1100" b="1" i="0" u="none" strike="noStrike" cap="none" dirty="0">
                <a:solidFill>
                  <a:srgbClr val="000000"/>
                </a:solidFill>
                <a:latin typeface="Arial"/>
                <a:ea typeface="Arial"/>
                <a:cs typeface="Arial"/>
                <a:sym typeface="Arial"/>
              </a:rPr>
              <a:t>.</a:t>
            </a:r>
            <a:r>
              <a:rPr lang="en-GB" sz="1100" b="0" i="0" u="none" strike="noStrike" cap="none" dirty="0">
                <a:solidFill>
                  <a:srgbClr val="000000"/>
                </a:solidFill>
                <a:latin typeface="Arial"/>
                <a:ea typeface="Arial"/>
                <a:cs typeface="Arial"/>
                <a:sym typeface="Arial"/>
              </a:rPr>
              <a:t> </a:t>
            </a:r>
            <a:r>
              <a:rPr lang="en-GB" sz="1100" b="1" i="0" u="none" strike="noStrike" cap="none" dirty="0">
                <a:solidFill>
                  <a:srgbClr val="000000"/>
                </a:solidFill>
                <a:latin typeface="Arial"/>
                <a:ea typeface="Arial"/>
                <a:cs typeface="Arial"/>
                <a:sym typeface="Arial"/>
              </a:rPr>
              <a:t>Schematic illustration of </a:t>
            </a:r>
            <a:r>
              <a:rPr lang="en-GB" sz="1100" b="1" i="0" u="none" strike="noStrike" cap="none" dirty="0" err="1">
                <a:solidFill>
                  <a:srgbClr val="000000"/>
                </a:solidFill>
                <a:latin typeface="Arial"/>
                <a:ea typeface="Arial"/>
                <a:cs typeface="Arial"/>
                <a:sym typeface="Arial"/>
              </a:rPr>
              <a:t>linearised</a:t>
            </a:r>
            <a:r>
              <a:rPr lang="en-GB" sz="1100" b="1" i="0" u="none" strike="noStrike" cap="none" dirty="0">
                <a:solidFill>
                  <a:srgbClr val="000000"/>
                </a:solidFill>
                <a:latin typeface="Arial"/>
                <a:ea typeface="Arial"/>
                <a:cs typeface="Arial"/>
                <a:sym typeface="Arial"/>
              </a:rPr>
              <a:t> DNA template and potential products produced via </a:t>
            </a:r>
            <a:r>
              <a:rPr lang="en-GB" sz="1100" b="1" i="1" u="none" strike="noStrike" cap="none" dirty="0">
                <a:solidFill>
                  <a:srgbClr val="000000"/>
                </a:solidFill>
                <a:latin typeface="Arial"/>
                <a:ea typeface="Arial"/>
                <a:cs typeface="Arial"/>
                <a:sym typeface="Arial"/>
              </a:rPr>
              <a:t>in vitro</a:t>
            </a:r>
            <a:r>
              <a:rPr lang="en-GB" sz="1100" b="1" i="0" u="none" strike="noStrike" cap="none" dirty="0">
                <a:solidFill>
                  <a:srgbClr val="000000"/>
                </a:solidFill>
                <a:latin typeface="Arial"/>
                <a:ea typeface="Arial"/>
                <a:cs typeface="Arial"/>
                <a:sym typeface="Arial"/>
              </a:rPr>
              <a:t> transcription. </a:t>
            </a:r>
            <a:r>
              <a:rPr lang="en-GB" sz="1100" b="0" i="0" u="none" strike="noStrike" cap="none" dirty="0">
                <a:solidFill>
                  <a:srgbClr val="000000"/>
                </a:solidFill>
                <a:latin typeface="Arial"/>
                <a:ea typeface="Arial"/>
                <a:cs typeface="Arial"/>
                <a:sym typeface="Arial"/>
              </a:rPr>
              <a:t>RNA was synthesised using </a:t>
            </a:r>
            <a:r>
              <a:rPr lang="en-GB" sz="1100" b="0" i="0" u="none" strike="noStrike" cap="none" dirty="0" err="1">
                <a:solidFill>
                  <a:srgbClr val="000000"/>
                </a:solidFill>
                <a:latin typeface="Arial"/>
                <a:ea typeface="Arial"/>
                <a:cs typeface="Arial"/>
                <a:sym typeface="Arial"/>
              </a:rPr>
              <a:t>linearised</a:t>
            </a:r>
            <a:r>
              <a:rPr lang="en-GB" sz="1100" b="0" i="0" u="none" strike="noStrike" cap="none" dirty="0">
                <a:solidFill>
                  <a:srgbClr val="000000"/>
                </a:solidFill>
                <a:latin typeface="Arial"/>
                <a:ea typeface="Arial"/>
                <a:cs typeface="Arial"/>
                <a:sym typeface="Arial"/>
              </a:rPr>
              <a:t> pNT-4T_Dome11 templates via </a:t>
            </a:r>
            <a:r>
              <a:rPr lang="en-GB" sz="1100" b="0" i="1" u="none" strike="noStrike" cap="none" dirty="0">
                <a:solidFill>
                  <a:srgbClr val="000000"/>
                </a:solidFill>
                <a:latin typeface="Arial"/>
                <a:ea typeface="Arial"/>
                <a:cs typeface="Arial"/>
                <a:sym typeface="Arial"/>
              </a:rPr>
              <a:t>In vitro</a:t>
            </a:r>
            <a:r>
              <a:rPr lang="en-GB" sz="1100" b="0" i="0" u="none" strike="noStrike" cap="none" dirty="0">
                <a:solidFill>
                  <a:srgbClr val="000000"/>
                </a:solidFill>
                <a:latin typeface="Arial"/>
                <a:ea typeface="Arial"/>
                <a:cs typeface="Arial"/>
                <a:sym typeface="Arial"/>
              </a:rPr>
              <a:t> transcription. Templates were </a:t>
            </a:r>
            <a:r>
              <a:rPr lang="en-GB" sz="1100" b="0" i="0" u="none" strike="noStrike" cap="none" dirty="0" err="1">
                <a:solidFill>
                  <a:srgbClr val="000000"/>
                </a:solidFill>
                <a:latin typeface="Arial"/>
                <a:ea typeface="Arial"/>
                <a:cs typeface="Arial"/>
                <a:sym typeface="Arial"/>
              </a:rPr>
              <a:t>linearised</a:t>
            </a:r>
            <a:r>
              <a:rPr lang="en-GB" sz="1100" b="0" i="0" u="none" strike="noStrike" cap="none" dirty="0">
                <a:solidFill>
                  <a:srgbClr val="000000"/>
                </a:solidFill>
                <a:latin typeface="Arial"/>
                <a:ea typeface="Arial"/>
                <a:cs typeface="Arial"/>
                <a:sym typeface="Arial"/>
              </a:rPr>
              <a:t> within the ampicillin resistance gene located within the plasmid backbone. Four potential products are indicated in the schematic and the sizes depending on the number of transcriptional terminators, the potential sizes are as follows, 427 - 581 </a:t>
            </a:r>
            <a:r>
              <a:rPr lang="en-GB" sz="1100" b="0" i="0" u="none" strike="noStrike" cap="none" dirty="0" err="1">
                <a:solidFill>
                  <a:srgbClr val="000000"/>
                </a:solidFill>
                <a:latin typeface="Arial"/>
                <a:ea typeface="Arial"/>
                <a:cs typeface="Arial"/>
                <a:sym typeface="Arial"/>
              </a:rPr>
              <a:t>nts</a:t>
            </a:r>
            <a:r>
              <a:rPr lang="en-GB" sz="1100" b="0" i="0" u="none" strike="noStrike" cap="none" dirty="0">
                <a:solidFill>
                  <a:srgbClr val="000000"/>
                </a:solidFill>
                <a:latin typeface="Arial"/>
                <a:ea typeface="Arial"/>
                <a:cs typeface="Arial"/>
                <a:sym typeface="Arial"/>
              </a:rPr>
              <a:t>, 1318 - 1562 </a:t>
            </a:r>
            <a:r>
              <a:rPr lang="en-GB" sz="1100" b="0" i="0" u="none" strike="noStrike" cap="none" dirty="0" err="1">
                <a:solidFill>
                  <a:srgbClr val="000000"/>
                </a:solidFill>
                <a:latin typeface="Arial"/>
                <a:ea typeface="Arial"/>
                <a:cs typeface="Arial"/>
                <a:sym typeface="Arial"/>
              </a:rPr>
              <a:t>nts</a:t>
            </a:r>
            <a:r>
              <a:rPr lang="en-GB" sz="1100" b="0" i="0" u="none" strike="noStrike" cap="none" dirty="0">
                <a:solidFill>
                  <a:srgbClr val="000000"/>
                </a:solidFill>
                <a:latin typeface="Arial"/>
                <a:ea typeface="Arial"/>
                <a:cs typeface="Arial"/>
                <a:sym typeface="Arial"/>
              </a:rPr>
              <a:t>, and 1873 - 2632 </a:t>
            </a:r>
            <a:r>
              <a:rPr lang="en-GB" sz="1100" b="0" i="0" u="none" strike="noStrike" cap="none" dirty="0" err="1">
                <a:solidFill>
                  <a:srgbClr val="000000"/>
                </a:solidFill>
                <a:latin typeface="Arial"/>
                <a:ea typeface="Arial"/>
                <a:cs typeface="Arial"/>
                <a:sym typeface="Arial"/>
              </a:rPr>
              <a:t>nts</a:t>
            </a:r>
            <a:r>
              <a:rPr lang="en-GB" sz="1100" b="0" i="0" u="none" strike="noStrike" cap="none" dirty="0">
                <a:solidFill>
                  <a:srgbClr val="000000"/>
                </a:solidFill>
                <a:latin typeface="Arial"/>
                <a:ea typeface="Arial"/>
                <a:cs typeface="Arial"/>
                <a:sym typeface="Arial"/>
              </a:rPr>
              <a:t>. The key indicates the various components within the plasmids. </a:t>
            </a:r>
            <a:endParaRPr sz="1100" b="0" i="0" u="none" strike="noStrike" cap="none" dirty="0">
              <a:solidFill>
                <a:srgbClr val="000000"/>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725"/>
        <p:cNvGrpSpPr/>
        <p:nvPr/>
      </p:nvGrpSpPr>
      <p:grpSpPr>
        <a:xfrm>
          <a:off x="0" y="0"/>
          <a:ext cx="0" cy="0"/>
          <a:chOff x="0" y="0"/>
          <a:chExt cx="0" cy="0"/>
        </a:xfrm>
      </p:grpSpPr>
      <p:grpSp>
        <p:nvGrpSpPr>
          <p:cNvPr id="1726" name="Google Shape;1726;p12"/>
          <p:cNvGrpSpPr/>
          <p:nvPr/>
        </p:nvGrpSpPr>
        <p:grpSpPr>
          <a:xfrm>
            <a:off x="3438570" y="1036000"/>
            <a:ext cx="4072240" cy="1921192"/>
            <a:chOff x="3145807" y="3447429"/>
            <a:chExt cx="3179448" cy="1487222"/>
          </a:xfrm>
        </p:grpSpPr>
        <p:pic>
          <p:nvPicPr>
            <p:cNvPr id="1727" name="Google Shape;1727;p12"/>
            <p:cNvPicPr preferRelativeResize="0"/>
            <p:nvPr/>
          </p:nvPicPr>
          <p:blipFill rotWithShape="1">
            <a:blip r:embed="rId3">
              <a:alphaModFix/>
            </a:blip>
            <a:srcRect b="25942"/>
            <a:stretch/>
          </p:blipFill>
          <p:spPr>
            <a:xfrm>
              <a:off x="3723522" y="3918851"/>
              <a:ext cx="2012550" cy="1015800"/>
            </a:xfrm>
            <a:prstGeom prst="rect">
              <a:avLst/>
            </a:prstGeom>
            <a:noFill/>
            <a:ln>
              <a:noFill/>
            </a:ln>
          </p:spPr>
        </p:pic>
        <p:sp>
          <p:nvSpPr>
            <p:cNvPr id="1728" name="Google Shape;1728;p12"/>
            <p:cNvSpPr txBox="1"/>
            <p:nvPr/>
          </p:nvSpPr>
          <p:spPr>
            <a:xfrm>
              <a:off x="3145807" y="4611684"/>
              <a:ext cx="637200" cy="184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500 nt</a:t>
              </a:r>
              <a:endParaRPr sz="950" b="0" i="0" u="none" strike="noStrike" cap="none">
                <a:solidFill>
                  <a:srgbClr val="000000"/>
                </a:solidFill>
                <a:latin typeface="Arial"/>
                <a:ea typeface="Arial"/>
                <a:cs typeface="Arial"/>
                <a:sym typeface="Arial"/>
              </a:endParaRPr>
            </a:p>
          </p:txBody>
        </p:sp>
        <p:cxnSp>
          <p:nvCxnSpPr>
            <p:cNvPr id="1729" name="Google Shape;1729;p12"/>
            <p:cNvCxnSpPr/>
            <p:nvPr/>
          </p:nvCxnSpPr>
          <p:spPr>
            <a:xfrm>
              <a:off x="3492855" y="4704084"/>
              <a:ext cx="188700" cy="0"/>
            </a:xfrm>
            <a:prstGeom prst="straightConnector1">
              <a:avLst/>
            </a:prstGeom>
            <a:noFill/>
            <a:ln w="12700" cap="flat" cmpd="sng">
              <a:solidFill>
                <a:schemeClr val="dk1"/>
              </a:solidFill>
              <a:prstDash val="solid"/>
              <a:round/>
              <a:headEnd type="none" w="sm" len="sm"/>
              <a:tailEnd type="triangle" w="med" len="med"/>
            </a:ln>
          </p:spPr>
        </p:cxnSp>
        <p:sp>
          <p:nvSpPr>
            <p:cNvPr id="1730" name="Google Shape;1730;p12"/>
            <p:cNvSpPr txBox="1"/>
            <p:nvPr/>
          </p:nvSpPr>
          <p:spPr>
            <a:xfrm>
              <a:off x="3983563" y="3666440"/>
              <a:ext cx="365700" cy="184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NT</a:t>
              </a:r>
              <a:endParaRPr sz="1400" b="0" i="0" u="none" strike="noStrike" cap="none">
                <a:solidFill>
                  <a:srgbClr val="000000"/>
                </a:solidFill>
                <a:latin typeface="Arial"/>
                <a:ea typeface="Arial"/>
                <a:cs typeface="Arial"/>
                <a:sym typeface="Arial"/>
              </a:endParaRPr>
            </a:p>
          </p:txBody>
        </p:sp>
        <p:sp>
          <p:nvSpPr>
            <p:cNvPr id="1731" name="Google Shape;1731;p12"/>
            <p:cNvSpPr txBox="1"/>
            <p:nvPr/>
          </p:nvSpPr>
          <p:spPr>
            <a:xfrm>
              <a:off x="4256872" y="3666440"/>
              <a:ext cx="365700" cy="184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1T</a:t>
              </a:r>
              <a:endParaRPr sz="1400" b="0" i="0" u="none" strike="noStrike" cap="none">
                <a:solidFill>
                  <a:srgbClr val="000000"/>
                </a:solidFill>
                <a:latin typeface="Arial"/>
                <a:ea typeface="Arial"/>
                <a:cs typeface="Arial"/>
                <a:sym typeface="Arial"/>
              </a:endParaRPr>
            </a:p>
          </p:txBody>
        </p:sp>
        <p:sp>
          <p:nvSpPr>
            <p:cNvPr id="1732" name="Google Shape;1732;p12"/>
            <p:cNvSpPr txBox="1"/>
            <p:nvPr/>
          </p:nvSpPr>
          <p:spPr>
            <a:xfrm>
              <a:off x="4547237" y="3666440"/>
              <a:ext cx="365700" cy="184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2T</a:t>
              </a:r>
              <a:endParaRPr sz="1400" b="0" i="0" u="none" strike="noStrike" cap="none">
                <a:solidFill>
                  <a:srgbClr val="000000"/>
                </a:solidFill>
                <a:latin typeface="Arial"/>
                <a:ea typeface="Arial"/>
                <a:cs typeface="Arial"/>
                <a:sym typeface="Arial"/>
              </a:endParaRPr>
            </a:p>
          </p:txBody>
        </p:sp>
        <p:sp>
          <p:nvSpPr>
            <p:cNvPr id="1733" name="Google Shape;1733;p12"/>
            <p:cNvSpPr txBox="1"/>
            <p:nvPr/>
          </p:nvSpPr>
          <p:spPr>
            <a:xfrm>
              <a:off x="4820136" y="3666440"/>
              <a:ext cx="365700" cy="184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3T</a:t>
              </a:r>
              <a:endParaRPr sz="1400" b="0" i="0" u="none" strike="noStrike" cap="none">
                <a:solidFill>
                  <a:srgbClr val="000000"/>
                </a:solidFill>
                <a:latin typeface="Arial"/>
                <a:ea typeface="Arial"/>
                <a:cs typeface="Arial"/>
                <a:sym typeface="Arial"/>
              </a:endParaRPr>
            </a:p>
          </p:txBody>
        </p:sp>
        <p:sp>
          <p:nvSpPr>
            <p:cNvPr id="1734" name="Google Shape;1734;p12"/>
            <p:cNvSpPr txBox="1"/>
            <p:nvPr/>
          </p:nvSpPr>
          <p:spPr>
            <a:xfrm>
              <a:off x="5108121" y="3666440"/>
              <a:ext cx="365700" cy="184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4T</a:t>
              </a:r>
              <a:endParaRPr sz="1400" b="0" i="0" u="none" strike="noStrike" cap="none">
                <a:solidFill>
                  <a:srgbClr val="000000"/>
                </a:solidFill>
                <a:latin typeface="Arial"/>
                <a:ea typeface="Arial"/>
                <a:cs typeface="Arial"/>
                <a:sym typeface="Arial"/>
              </a:endParaRPr>
            </a:p>
          </p:txBody>
        </p:sp>
        <p:sp>
          <p:nvSpPr>
            <p:cNvPr id="1735" name="Google Shape;1735;p12"/>
            <p:cNvSpPr txBox="1"/>
            <p:nvPr/>
          </p:nvSpPr>
          <p:spPr>
            <a:xfrm rot="-2700000">
              <a:off x="5308776" y="3447429"/>
              <a:ext cx="929563" cy="18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T1 digested</a:t>
              </a:r>
              <a:endParaRPr sz="1400" b="0" i="0" u="none" strike="noStrike" cap="none">
                <a:solidFill>
                  <a:srgbClr val="000000"/>
                </a:solidFill>
                <a:latin typeface="Arial"/>
                <a:ea typeface="Arial"/>
                <a:cs typeface="Arial"/>
                <a:sym typeface="Arial"/>
              </a:endParaRPr>
            </a:p>
          </p:txBody>
        </p:sp>
        <p:sp>
          <p:nvSpPr>
            <p:cNvPr id="1736" name="Google Shape;1736;p12"/>
            <p:cNvSpPr txBox="1"/>
            <p:nvPr/>
          </p:nvSpPr>
          <p:spPr>
            <a:xfrm>
              <a:off x="5681155" y="4741074"/>
              <a:ext cx="644100" cy="184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dirty="0">
                  <a:solidFill>
                    <a:srgbClr val="000000"/>
                  </a:solidFill>
                  <a:latin typeface="Arial"/>
                  <a:ea typeface="Arial"/>
                  <a:cs typeface="Arial"/>
                  <a:sym typeface="Arial"/>
                </a:rPr>
                <a:t>dsRNA</a:t>
              </a:r>
              <a:endParaRPr sz="1400" b="0" i="0" u="none" strike="noStrike" cap="none" dirty="0">
                <a:solidFill>
                  <a:srgbClr val="000000"/>
                </a:solidFill>
                <a:latin typeface="Arial"/>
                <a:ea typeface="Arial"/>
                <a:cs typeface="Arial"/>
                <a:sym typeface="Arial"/>
              </a:endParaRPr>
            </a:p>
          </p:txBody>
        </p:sp>
      </p:grpSp>
      <p:grpSp>
        <p:nvGrpSpPr>
          <p:cNvPr id="1738" name="Google Shape;1738;p12"/>
          <p:cNvGrpSpPr/>
          <p:nvPr/>
        </p:nvGrpSpPr>
        <p:grpSpPr>
          <a:xfrm>
            <a:off x="-76189" y="1045648"/>
            <a:ext cx="4200479" cy="2063550"/>
            <a:chOff x="200704" y="3006871"/>
            <a:chExt cx="4811540" cy="1905226"/>
          </a:xfrm>
        </p:grpSpPr>
        <p:sp>
          <p:nvSpPr>
            <p:cNvPr id="1739" name="Google Shape;1739;p12"/>
            <p:cNvSpPr txBox="1"/>
            <p:nvPr/>
          </p:nvSpPr>
          <p:spPr>
            <a:xfrm>
              <a:off x="3800245" y="3723269"/>
              <a:ext cx="1211999"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dirty="0">
                  <a:solidFill>
                    <a:srgbClr val="000000"/>
                  </a:solidFill>
                  <a:latin typeface="Arial"/>
                  <a:ea typeface="Arial"/>
                  <a:cs typeface="Arial"/>
                  <a:sym typeface="Arial"/>
                </a:rPr>
                <a:t>23S </a:t>
              </a:r>
              <a:r>
                <a:rPr lang="en-GB" sz="950" b="0" i="0" u="none" strike="noStrike" cap="none" dirty="0" err="1">
                  <a:solidFill>
                    <a:srgbClr val="000000"/>
                  </a:solidFill>
                  <a:latin typeface="Arial"/>
                  <a:ea typeface="Arial"/>
                  <a:cs typeface="Arial"/>
                  <a:sym typeface="Arial"/>
                </a:rPr>
                <a:t>rRNA</a:t>
              </a:r>
              <a:endParaRPr sz="1400" b="0" i="0" u="none" strike="noStrike" cap="none" dirty="0">
                <a:solidFill>
                  <a:srgbClr val="000000"/>
                </a:solidFill>
                <a:latin typeface="Arial"/>
                <a:ea typeface="Arial"/>
                <a:cs typeface="Arial"/>
                <a:sym typeface="Arial"/>
              </a:endParaRPr>
            </a:p>
          </p:txBody>
        </p:sp>
        <p:grpSp>
          <p:nvGrpSpPr>
            <p:cNvPr id="1740" name="Google Shape;1740;p12"/>
            <p:cNvGrpSpPr/>
            <p:nvPr/>
          </p:nvGrpSpPr>
          <p:grpSpPr>
            <a:xfrm>
              <a:off x="200704" y="3006871"/>
              <a:ext cx="4484251" cy="1905226"/>
              <a:chOff x="200704" y="3006871"/>
              <a:chExt cx="4484251" cy="1905226"/>
            </a:xfrm>
          </p:grpSpPr>
          <p:pic>
            <p:nvPicPr>
              <p:cNvPr id="1741" name="Google Shape;1741;p12"/>
              <p:cNvPicPr preferRelativeResize="0"/>
              <p:nvPr/>
            </p:nvPicPr>
            <p:blipFill rotWithShape="1">
              <a:blip r:embed="rId4">
                <a:alphaModFix/>
              </a:blip>
              <a:srcRect b="14066"/>
              <a:stretch/>
            </p:blipFill>
            <p:spPr>
              <a:xfrm>
                <a:off x="1020563" y="3571118"/>
                <a:ext cx="2879995" cy="1282435"/>
              </a:xfrm>
              <a:prstGeom prst="rect">
                <a:avLst/>
              </a:prstGeom>
              <a:noFill/>
              <a:ln>
                <a:noFill/>
              </a:ln>
            </p:spPr>
          </p:pic>
          <p:sp>
            <p:nvSpPr>
              <p:cNvPr id="1742" name="Google Shape;1742;p12"/>
              <p:cNvSpPr txBox="1"/>
              <p:nvPr/>
            </p:nvSpPr>
            <p:spPr>
              <a:xfrm>
                <a:off x="1621080" y="3324206"/>
                <a:ext cx="494100"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NT</a:t>
                </a:r>
                <a:endParaRPr sz="1400" b="0" i="0" u="none" strike="noStrike" cap="none">
                  <a:solidFill>
                    <a:srgbClr val="000000"/>
                  </a:solidFill>
                  <a:latin typeface="Arial"/>
                  <a:ea typeface="Arial"/>
                  <a:cs typeface="Arial"/>
                  <a:sym typeface="Arial"/>
                </a:endParaRPr>
              </a:p>
            </p:txBody>
          </p:sp>
          <p:sp>
            <p:nvSpPr>
              <p:cNvPr id="1743" name="Google Shape;1743;p12"/>
              <p:cNvSpPr txBox="1"/>
              <p:nvPr/>
            </p:nvSpPr>
            <p:spPr>
              <a:xfrm>
                <a:off x="1955363" y="3324203"/>
                <a:ext cx="494100"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1T</a:t>
                </a:r>
                <a:endParaRPr sz="1400" b="0" i="0" u="none" strike="noStrike" cap="none">
                  <a:solidFill>
                    <a:srgbClr val="000000"/>
                  </a:solidFill>
                  <a:latin typeface="Arial"/>
                  <a:ea typeface="Arial"/>
                  <a:cs typeface="Arial"/>
                  <a:sym typeface="Arial"/>
                </a:endParaRPr>
              </a:p>
            </p:txBody>
          </p:sp>
          <p:sp>
            <p:nvSpPr>
              <p:cNvPr id="1744" name="Google Shape;1744;p12"/>
              <p:cNvSpPr txBox="1"/>
              <p:nvPr/>
            </p:nvSpPr>
            <p:spPr>
              <a:xfrm>
                <a:off x="2296510" y="3324203"/>
                <a:ext cx="443700"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2T</a:t>
                </a:r>
                <a:endParaRPr sz="1400" b="0" i="0" u="none" strike="noStrike" cap="none">
                  <a:solidFill>
                    <a:srgbClr val="000000"/>
                  </a:solidFill>
                  <a:latin typeface="Arial"/>
                  <a:ea typeface="Arial"/>
                  <a:cs typeface="Arial"/>
                  <a:sym typeface="Arial"/>
                </a:endParaRPr>
              </a:p>
            </p:txBody>
          </p:sp>
          <p:sp>
            <p:nvSpPr>
              <p:cNvPr id="1745" name="Google Shape;1745;p12"/>
              <p:cNvSpPr txBox="1"/>
              <p:nvPr/>
            </p:nvSpPr>
            <p:spPr>
              <a:xfrm>
                <a:off x="2610057" y="3324203"/>
                <a:ext cx="494100"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3T</a:t>
                </a:r>
                <a:endParaRPr sz="1400" b="0" i="0" u="none" strike="noStrike" cap="none">
                  <a:solidFill>
                    <a:srgbClr val="000000"/>
                  </a:solidFill>
                  <a:latin typeface="Arial"/>
                  <a:ea typeface="Arial"/>
                  <a:cs typeface="Arial"/>
                  <a:sym typeface="Arial"/>
                </a:endParaRPr>
              </a:p>
            </p:txBody>
          </p:sp>
          <p:sp>
            <p:nvSpPr>
              <p:cNvPr id="1746" name="Google Shape;1746;p12"/>
              <p:cNvSpPr txBox="1"/>
              <p:nvPr/>
            </p:nvSpPr>
            <p:spPr>
              <a:xfrm>
                <a:off x="2938698" y="3324203"/>
                <a:ext cx="494100"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4T</a:t>
                </a:r>
                <a:endParaRPr sz="1400" b="0" i="0" u="none" strike="noStrike" cap="none">
                  <a:solidFill>
                    <a:srgbClr val="000000"/>
                  </a:solidFill>
                  <a:latin typeface="Arial"/>
                  <a:ea typeface="Arial"/>
                  <a:cs typeface="Arial"/>
                  <a:sym typeface="Arial"/>
                </a:endParaRPr>
              </a:p>
            </p:txBody>
          </p:sp>
          <p:sp>
            <p:nvSpPr>
              <p:cNvPr id="1747" name="Google Shape;1747;p12"/>
              <p:cNvSpPr txBox="1"/>
              <p:nvPr/>
            </p:nvSpPr>
            <p:spPr>
              <a:xfrm rot="18900000">
                <a:off x="3202174" y="3110002"/>
                <a:ext cx="929563" cy="220188"/>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dirty="0">
                    <a:solidFill>
                      <a:srgbClr val="000000"/>
                    </a:solidFill>
                    <a:latin typeface="Arial"/>
                    <a:ea typeface="Arial"/>
                    <a:cs typeface="Arial"/>
                    <a:sym typeface="Arial"/>
                  </a:rPr>
                  <a:t>T7hyb6</a:t>
                </a:r>
                <a:endParaRPr sz="1400" b="0" i="0" u="none" strike="noStrike" cap="none" dirty="0">
                  <a:solidFill>
                    <a:srgbClr val="000000"/>
                  </a:solidFill>
                  <a:latin typeface="Arial"/>
                  <a:ea typeface="Arial"/>
                  <a:cs typeface="Arial"/>
                  <a:sym typeface="Arial"/>
                </a:endParaRPr>
              </a:p>
            </p:txBody>
          </p:sp>
          <p:sp>
            <p:nvSpPr>
              <p:cNvPr id="1748" name="Google Shape;1748;p12"/>
              <p:cNvSpPr txBox="1"/>
              <p:nvPr/>
            </p:nvSpPr>
            <p:spPr>
              <a:xfrm>
                <a:off x="200704" y="4394288"/>
                <a:ext cx="637200"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500 bp</a:t>
                </a:r>
                <a:endParaRPr sz="950" b="0" i="0" u="none" strike="noStrike" cap="none">
                  <a:solidFill>
                    <a:srgbClr val="000000"/>
                  </a:solidFill>
                  <a:latin typeface="Arial"/>
                  <a:ea typeface="Arial"/>
                  <a:cs typeface="Arial"/>
                  <a:sym typeface="Arial"/>
                </a:endParaRPr>
              </a:p>
            </p:txBody>
          </p:sp>
          <p:sp>
            <p:nvSpPr>
              <p:cNvPr id="1749" name="Google Shape;1749;p12"/>
              <p:cNvSpPr txBox="1"/>
              <p:nvPr/>
            </p:nvSpPr>
            <p:spPr>
              <a:xfrm>
                <a:off x="3786156" y="3885588"/>
                <a:ext cx="898799"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dirty="0">
                    <a:solidFill>
                      <a:srgbClr val="000000"/>
                    </a:solidFill>
                    <a:latin typeface="Arial"/>
                    <a:ea typeface="Arial"/>
                    <a:cs typeface="Arial"/>
                    <a:sym typeface="Arial"/>
                  </a:rPr>
                  <a:t>16S </a:t>
                </a:r>
                <a:r>
                  <a:rPr lang="en-GB" sz="950" b="0" i="0" u="none" strike="noStrike" cap="none" dirty="0" err="1">
                    <a:solidFill>
                      <a:srgbClr val="000000"/>
                    </a:solidFill>
                    <a:latin typeface="Arial"/>
                    <a:ea typeface="Arial"/>
                    <a:cs typeface="Arial"/>
                    <a:sym typeface="Arial"/>
                  </a:rPr>
                  <a:t>rRNA</a:t>
                </a:r>
                <a:endParaRPr sz="1400" b="0" i="0" u="none" strike="noStrike" cap="none" dirty="0">
                  <a:solidFill>
                    <a:srgbClr val="000000"/>
                  </a:solidFill>
                  <a:latin typeface="Arial"/>
                  <a:ea typeface="Arial"/>
                  <a:cs typeface="Arial"/>
                  <a:sym typeface="Arial"/>
                </a:endParaRPr>
              </a:p>
            </p:txBody>
          </p:sp>
          <p:sp>
            <p:nvSpPr>
              <p:cNvPr id="1750" name="Google Shape;1750;p12"/>
              <p:cNvSpPr txBox="1"/>
              <p:nvPr/>
            </p:nvSpPr>
            <p:spPr>
              <a:xfrm>
                <a:off x="3816272" y="4581589"/>
                <a:ext cx="746100"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dirty="0">
                    <a:solidFill>
                      <a:srgbClr val="000000"/>
                    </a:solidFill>
                    <a:latin typeface="Arial"/>
                    <a:ea typeface="Arial"/>
                    <a:cs typeface="Arial"/>
                    <a:sym typeface="Arial"/>
                  </a:rPr>
                  <a:t>dsRNA</a:t>
                </a:r>
                <a:endParaRPr sz="1400" b="0" i="0" u="none" strike="noStrike" cap="none" dirty="0">
                  <a:solidFill>
                    <a:srgbClr val="000000"/>
                  </a:solidFill>
                  <a:latin typeface="Arial"/>
                  <a:ea typeface="Arial"/>
                  <a:cs typeface="Arial"/>
                  <a:sym typeface="Arial"/>
                </a:endParaRPr>
              </a:p>
            </p:txBody>
          </p:sp>
          <p:cxnSp>
            <p:nvCxnSpPr>
              <p:cNvPr id="1751" name="Google Shape;1751;p12"/>
              <p:cNvCxnSpPr/>
              <p:nvPr/>
            </p:nvCxnSpPr>
            <p:spPr>
              <a:xfrm>
                <a:off x="814612" y="4787344"/>
                <a:ext cx="188700" cy="0"/>
              </a:xfrm>
              <a:prstGeom prst="straightConnector1">
                <a:avLst/>
              </a:prstGeom>
              <a:noFill/>
              <a:ln w="12700" cap="flat" cmpd="sng">
                <a:solidFill>
                  <a:schemeClr val="dk1"/>
                </a:solidFill>
                <a:prstDash val="solid"/>
                <a:round/>
                <a:headEnd type="none" w="sm" len="sm"/>
                <a:tailEnd type="triangle" w="med" len="med"/>
              </a:ln>
            </p:spPr>
          </p:cxnSp>
          <p:cxnSp>
            <p:nvCxnSpPr>
              <p:cNvPr id="1752" name="Google Shape;1752;p12"/>
              <p:cNvCxnSpPr/>
              <p:nvPr/>
            </p:nvCxnSpPr>
            <p:spPr>
              <a:xfrm>
                <a:off x="814612" y="4509721"/>
                <a:ext cx="188700" cy="0"/>
              </a:xfrm>
              <a:prstGeom prst="straightConnector1">
                <a:avLst/>
              </a:prstGeom>
              <a:noFill/>
              <a:ln w="12700" cap="flat" cmpd="sng">
                <a:solidFill>
                  <a:schemeClr val="dk1"/>
                </a:solidFill>
                <a:prstDash val="solid"/>
                <a:round/>
                <a:headEnd type="none" w="sm" len="sm"/>
                <a:tailEnd type="triangle" w="med" len="med"/>
              </a:ln>
            </p:spPr>
          </p:cxnSp>
          <p:sp>
            <p:nvSpPr>
              <p:cNvPr id="1753" name="Google Shape;1753;p12"/>
              <p:cNvSpPr txBox="1"/>
              <p:nvPr/>
            </p:nvSpPr>
            <p:spPr>
              <a:xfrm rot="-2700000">
                <a:off x="1175996" y="3006871"/>
                <a:ext cx="1145089" cy="24819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ssRNA Ladder</a:t>
                </a:r>
                <a:endParaRPr sz="1400" b="0" i="0" u="none" strike="noStrike" cap="none">
                  <a:solidFill>
                    <a:srgbClr val="000000"/>
                  </a:solidFill>
                  <a:latin typeface="Arial"/>
                  <a:ea typeface="Arial"/>
                  <a:cs typeface="Arial"/>
                  <a:sym typeface="Arial"/>
                </a:endParaRPr>
              </a:p>
            </p:txBody>
          </p:sp>
          <p:sp>
            <p:nvSpPr>
              <p:cNvPr id="1754" name="Google Shape;1754;p12"/>
              <p:cNvSpPr txBox="1"/>
              <p:nvPr/>
            </p:nvSpPr>
            <p:spPr>
              <a:xfrm rot="-2700000">
                <a:off x="898643" y="3022568"/>
                <a:ext cx="1145089" cy="24819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dsRNA Ladder</a:t>
                </a:r>
                <a:endParaRPr sz="1400" b="0" i="0" u="none" strike="noStrike" cap="none">
                  <a:solidFill>
                    <a:srgbClr val="000000"/>
                  </a:solidFill>
                  <a:latin typeface="Arial"/>
                  <a:ea typeface="Arial"/>
                  <a:cs typeface="Arial"/>
                  <a:sym typeface="Arial"/>
                </a:endParaRPr>
              </a:p>
            </p:txBody>
          </p:sp>
          <p:sp>
            <p:nvSpPr>
              <p:cNvPr id="1758" name="Google Shape;1758;p12"/>
              <p:cNvSpPr txBox="1"/>
              <p:nvPr/>
            </p:nvSpPr>
            <p:spPr>
              <a:xfrm rot="18900000">
                <a:off x="3548108" y="3113628"/>
                <a:ext cx="929563" cy="220188"/>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dirty="0">
                    <a:solidFill>
                      <a:srgbClr val="000000"/>
                    </a:solidFill>
                    <a:latin typeface="Arial"/>
                    <a:ea typeface="Arial"/>
                    <a:cs typeface="Arial"/>
                    <a:sym typeface="Arial"/>
                  </a:rPr>
                  <a:t>T7hyb10</a:t>
                </a:r>
                <a:endParaRPr sz="1400" b="0" i="0" u="none" strike="noStrike" cap="none" dirty="0">
                  <a:solidFill>
                    <a:srgbClr val="000000"/>
                  </a:solidFill>
                  <a:latin typeface="Arial"/>
                  <a:ea typeface="Arial"/>
                  <a:cs typeface="Arial"/>
                  <a:sym typeface="Arial"/>
                </a:endParaRPr>
              </a:p>
            </p:txBody>
          </p:sp>
          <p:sp>
            <p:nvSpPr>
              <p:cNvPr id="1759" name="Google Shape;1759;p12"/>
              <p:cNvSpPr txBox="1"/>
              <p:nvPr/>
            </p:nvSpPr>
            <p:spPr>
              <a:xfrm>
                <a:off x="200704" y="4691897"/>
                <a:ext cx="637200" cy="220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a:solidFill>
                      <a:srgbClr val="000000"/>
                    </a:solidFill>
                    <a:latin typeface="Arial"/>
                    <a:ea typeface="Arial"/>
                    <a:cs typeface="Arial"/>
                    <a:sym typeface="Arial"/>
                  </a:rPr>
                  <a:t>400 bp</a:t>
                </a:r>
                <a:endParaRPr sz="1400" b="0" i="0" u="none" strike="noStrike" cap="none">
                  <a:solidFill>
                    <a:srgbClr val="000000"/>
                  </a:solidFill>
                  <a:latin typeface="Arial"/>
                  <a:ea typeface="Arial"/>
                  <a:cs typeface="Arial"/>
                  <a:sym typeface="Arial"/>
                </a:endParaRPr>
              </a:p>
            </p:txBody>
          </p:sp>
        </p:grpSp>
      </p:grpSp>
      <p:sp>
        <p:nvSpPr>
          <p:cNvPr id="1760" name="Google Shape;1760;p12"/>
          <p:cNvSpPr txBox="1"/>
          <p:nvPr/>
        </p:nvSpPr>
        <p:spPr>
          <a:xfrm flipH="1">
            <a:off x="105657" y="646515"/>
            <a:ext cx="387300" cy="461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GB" sz="2400" b="0" i="0" u="none" strike="noStrike" cap="none" dirty="0">
                <a:solidFill>
                  <a:srgbClr val="000000"/>
                </a:solidFill>
                <a:latin typeface="Arial"/>
                <a:ea typeface="Arial"/>
                <a:cs typeface="Arial"/>
                <a:sym typeface="Arial"/>
              </a:rPr>
              <a:t>A</a:t>
            </a:r>
            <a:endParaRPr sz="2400" b="0" i="0" u="none" strike="noStrike" cap="none" dirty="0">
              <a:solidFill>
                <a:srgbClr val="000000"/>
              </a:solidFill>
              <a:latin typeface="Arial"/>
              <a:ea typeface="Arial"/>
              <a:cs typeface="Arial"/>
              <a:sym typeface="Arial"/>
            </a:endParaRPr>
          </a:p>
        </p:txBody>
      </p:sp>
      <p:sp>
        <p:nvSpPr>
          <p:cNvPr id="1761" name="Google Shape;1761;p12"/>
          <p:cNvSpPr txBox="1"/>
          <p:nvPr/>
        </p:nvSpPr>
        <p:spPr>
          <a:xfrm flipH="1">
            <a:off x="3848982" y="646515"/>
            <a:ext cx="387300" cy="461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GB" sz="2400" b="0" i="0" u="none" strike="noStrike" cap="none">
                <a:solidFill>
                  <a:srgbClr val="000000"/>
                </a:solidFill>
                <a:latin typeface="Arial"/>
                <a:ea typeface="Arial"/>
                <a:cs typeface="Arial"/>
                <a:sym typeface="Arial"/>
              </a:rPr>
              <a:t>B</a:t>
            </a:r>
            <a:endParaRPr sz="2400" b="0" i="0" u="none" strike="noStrike" cap="none">
              <a:solidFill>
                <a:srgbClr val="000000"/>
              </a:solidFill>
              <a:latin typeface="Arial"/>
              <a:ea typeface="Arial"/>
              <a:cs typeface="Arial"/>
              <a:sym typeface="Arial"/>
            </a:endParaRPr>
          </a:p>
        </p:txBody>
      </p:sp>
      <p:sp>
        <p:nvSpPr>
          <p:cNvPr id="1762" name="Google Shape;1762;p12"/>
          <p:cNvSpPr txBox="1"/>
          <p:nvPr/>
        </p:nvSpPr>
        <p:spPr>
          <a:xfrm>
            <a:off x="105641" y="1921664"/>
            <a:ext cx="675600" cy="238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GB" sz="950" b="0" i="0" u="none" strike="noStrike" cap="none">
                <a:solidFill>
                  <a:srgbClr val="000000"/>
                </a:solidFill>
                <a:latin typeface="Arial"/>
                <a:ea typeface="Arial"/>
                <a:cs typeface="Arial"/>
                <a:sym typeface="Arial"/>
              </a:rPr>
              <a:t>1500 nt</a:t>
            </a:r>
            <a:endParaRPr sz="950" b="0" i="0" u="none" strike="noStrike" cap="none">
              <a:solidFill>
                <a:srgbClr val="000000"/>
              </a:solidFill>
              <a:latin typeface="Arial"/>
              <a:ea typeface="Arial"/>
              <a:cs typeface="Arial"/>
              <a:sym typeface="Arial"/>
            </a:endParaRPr>
          </a:p>
        </p:txBody>
      </p:sp>
      <p:cxnSp>
        <p:nvCxnSpPr>
          <p:cNvPr id="1763" name="Google Shape;1763;p12"/>
          <p:cNvCxnSpPr/>
          <p:nvPr/>
        </p:nvCxnSpPr>
        <p:spPr>
          <a:xfrm rot="58130">
            <a:off x="622310" y="2040404"/>
            <a:ext cx="266138" cy="900"/>
          </a:xfrm>
          <a:prstGeom prst="straightConnector1">
            <a:avLst/>
          </a:prstGeom>
          <a:noFill/>
          <a:ln w="12700" cap="flat" cmpd="sng">
            <a:solidFill>
              <a:schemeClr val="lt1"/>
            </a:solidFill>
            <a:prstDash val="solid"/>
            <a:round/>
            <a:headEnd type="none" w="sm" len="sm"/>
            <a:tailEnd type="triangle" w="med" len="med"/>
          </a:ln>
        </p:spPr>
      </p:cxnSp>
      <p:sp>
        <p:nvSpPr>
          <p:cNvPr id="1764" name="Google Shape;1764;p12"/>
          <p:cNvSpPr/>
          <p:nvPr/>
        </p:nvSpPr>
        <p:spPr>
          <a:xfrm>
            <a:off x="492957" y="4580730"/>
            <a:ext cx="6816849" cy="4154943"/>
          </a:xfrm>
          <a:prstGeom prst="rect">
            <a:avLst/>
          </a:prstGeom>
          <a:noFill/>
          <a:ln>
            <a:noFill/>
          </a:ln>
        </p:spPr>
        <p:txBody>
          <a:bodyPr spcFirstLastPara="1" wrap="square" lIns="91425" tIns="45700" rIns="91425" bIns="45700" anchor="t" anchorCtr="0">
            <a:spAutoFit/>
          </a:bodyPr>
          <a:lstStyle/>
          <a:p>
            <a:pPr marL="0" marR="0" lvl="0" indent="0" algn="l" rtl="0">
              <a:lnSpc>
                <a:spcPct val="200000"/>
              </a:lnSpc>
              <a:spcBef>
                <a:spcPts val="0"/>
              </a:spcBef>
              <a:spcAft>
                <a:spcPts val="0"/>
              </a:spcAft>
              <a:buClr>
                <a:srgbClr val="000000"/>
              </a:buClr>
              <a:buSzPts val="1400"/>
              <a:buFont typeface="Arial"/>
              <a:buNone/>
            </a:pPr>
            <a:r>
              <a:rPr lang="en-GB" sz="1100" b="1" i="0" u="none" strike="noStrike" cap="none" dirty="0">
                <a:solidFill>
                  <a:srgbClr val="000000"/>
                </a:solidFill>
                <a:latin typeface="Arial"/>
                <a:ea typeface="Arial"/>
                <a:cs typeface="Arial"/>
                <a:sym typeface="Arial"/>
              </a:rPr>
              <a:t>Supplementary figure S3. Ex-Gel electrophoresis analysis</a:t>
            </a:r>
            <a:r>
              <a:rPr lang="en-GB" sz="1100" b="0" i="0" u="none" strike="noStrike" cap="none" dirty="0">
                <a:solidFill>
                  <a:srgbClr val="000000"/>
                </a:solidFill>
                <a:latin typeface="Arial"/>
                <a:ea typeface="Arial"/>
                <a:cs typeface="Arial"/>
                <a:sym typeface="Arial"/>
              </a:rPr>
              <a:t>.  </a:t>
            </a:r>
            <a:r>
              <a:rPr lang="en-GB" sz="1100" b="1" i="0" u="none" strike="noStrike" cap="none" dirty="0">
                <a:solidFill>
                  <a:srgbClr val="000000"/>
                </a:solidFill>
                <a:latin typeface="Arial"/>
                <a:ea typeface="Arial"/>
                <a:cs typeface="Arial"/>
                <a:sym typeface="Arial"/>
              </a:rPr>
              <a:t>A.</a:t>
            </a:r>
            <a:r>
              <a:rPr lang="en-GB" sz="1100" b="0" i="0" u="none" strike="noStrike" cap="none" dirty="0">
                <a:solidFill>
                  <a:srgbClr val="000000"/>
                </a:solidFill>
                <a:latin typeface="Arial"/>
                <a:ea typeface="Arial"/>
                <a:cs typeface="Arial"/>
                <a:sym typeface="Arial"/>
              </a:rPr>
              <a:t> Analysis of RNA extracts from E.coli  HT115 cells transformed with plasmids </a:t>
            </a:r>
            <a:r>
              <a:rPr lang="en-GB" sz="1100" b="0" i="0" u="none" strike="noStrike" cap="none" dirty="0" err="1">
                <a:solidFill>
                  <a:srgbClr val="000000"/>
                </a:solidFill>
                <a:latin typeface="Arial"/>
                <a:ea typeface="Arial"/>
                <a:cs typeface="Arial"/>
                <a:sym typeface="Arial"/>
              </a:rPr>
              <a:t>pNT</a:t>
            </a:r>
            <a:r>
              <a:rPr lang="en-GB" sz="1100" b="0" i="0" u="none" strike="noStrike" cap="none" dirty="0">
                <a:solidFill>
                  <a:srgbClr val="000000"/>
                </a:solidFill>
                <a:latin typeface="Arial"/>
                <a:ea typeface="Arial"/>
                <a:cs typeface="Arial"/>
                <a:sym typeface="Arial"/>
              </a:rPr>
              <a:t>/1T/2T/3T/4T_Dome11, pT7hyb6/10_Dome11. Three independent inductions were performed for each construct. RNA extractions were performed ±RNase T1</a:t>
            </a:r>
            <a:r>
              <a:rPr lang="en-GB" sz="1100" b="1" i="0" u="none" strike="noStrike" cap="none" dirty="0">
                <a:solidFill>
                  <a:srgbClr val="000000"/>
                </a:solidFill>
                <a:latin typeface="Arial"/>
                <a:ea typeface="Arial"/>
                <a:cs typeface="Arial"/>
                <a:sym typeface="Arial"/>
              </a:rPr>
              <a:t>.</a:t>
            </a:r>
            <a:r>
              <a:rPr lang="en-GB" sz="1100" b="0" i="0" u="none" strike="noStrike" cap="none" dirty="0">
                <a:solidFill>
                  <a:srgbClr val="000000"/>
                </a:solidFill>
                <a:latin typeface="Arial"/>
                <a:ea typeface="Arial"/>
                <a:cs typeface="Arial"/>
                <a:sym typeface="Arial"/>
              </a:rPr>
              <a:t> Dome11 dsRNA is highlighted  (~450 </a:t>
            </a:r>
            <a:r>
              <a:rPr lang="en-GB" sz="1100" b="0" i="0" u="none" strike="noStrike" cap="none" dirty="0" err="1">
                <a:solidFill>
                  <a:srgbClr val="000000"/>
                </a:solidFill>
                <a:latin typeface="Arial"/>
                <a:ea typeface="Arial"/>
                <a:cs typeface="Arial"/>
                <a:sym typeface="Arial"/>
              </a:rPr>
              <a:t>bp</a:t>
            </a:r>
            <a:r>
              <a:rPr lang="en-GB" sz="1100" b="0" i="0" u="none" strike="noStrike" cap="none" dirty="0">
                <a:solidFill>
                  <a:srgbClr val="000000"/>
                </a:solidFill>
                <a:latin typeface="Arial"/>
                <a:ea typeface="Arial"/>
                <a:cs typeface="Arial"/>
                <a:sym typeface="Arial"/>
              </a:rPr>
              <a:t>). Additional bands are noted for dsRNA, interestingly approximately the same amount of additional bands is noted for each sample, indicating a universal point for in vivo degradation of </a:t>
            </a:r>
            <a:r>
              <a:rPr lang="en-GB" sz="1100" b="0" i="0" u="none" strike="noStrike" cap="none" dirty="0" err="1">
                <a:solidFill>
                  <a:srgbClr val="000000"/>
                </a:solidFill>
                <a:latin typeface="Arial"/>
                <a:ea typeface="Arial"/>
                <a:cs typeface="Arial"/>
                <a:sym typeface="Arial"/>
              </a:rPr>
              <a:t>ssRNA</a:t>
            </a:r>
            <a:r>
              <a:rPr lang="en-GB" sz="1100" b="0" i="0" u="none" strike="noStrike" cap="none" dirty="0">
                <a:solidFill>
                  <a:srgbClr val="000000"/>
                </a:solidFill>
                <a:latin typeface="Arial"/>
                <a:ea typeface="Arial"/>
                <a:cs typeface="Arial"/>
                <a:sym typeface="Arial"/>
              </a:rPr>
              <a:t> overhangs. Bands are also observed for </a:t>
            </a:r>
            <a:r>
              <a:rPr lang="en-GB" sz="1100" b="0" i="0" u="none" strike="noStrike" cap="none" dirty="0" err="1">
                <a:solidFill>
                  <a:srgbClr val="000000"/>
                </a:solidFill>
                <a:latin typeface="Arial"/>
                <a:ea typeface="Arial"/>
                <a:cs typeface="Arial"/>
                <a:sym typeface="Arial"/>
              </a:rPr>
              <a:t>rRNA</a:t>
            </a:r>
            <a:r>
              <a:rPr lang="en-GB" sz="1100" b="0" i="0" u="none" strike="noStrike" cap="none" dirty="0">
                <a:solidFill>
                  <a:srgbClr val="000000"/>
                </a:solidFill>
                <a:latin typeface="Arial"/>
                <a:ea typeface="Arial"/>
                <a:cs typeface="Arial"/>
                <a:sym typeface="Arial"/>
              </a:rPr>
              <a:t> 16S and 23S at approximately (1500 </a:t>
            </a:r>
            <a:r>
              <a:rPr lang="en-GB" sz="1100" b="0" i="0" u="none" strike="noStrike" cap="none" dirty="0" err="1">
                <a:solidFill>
                  <a:srgbClr val="000000"/>
                </a:solidFill>
                <a:latin typeface="Arial"/>
                <a:ea typeface="Arial"/>
                <a:cs typeface="Arial"/>
                <a:sym typeface="Arial"/>
              </a:rPr>
              <a:t>nt</a:t>
            </a:r>
            <a:r>
              <a:rPr lang="en-GB" sz="1100" b="0" i="0" u="none" strike="noStrike" cap="none" dirty="0">
                <a:solidFill>
                  <a:srgbClr val="000000"/>
                </a:solidFill>
                <a:latin typeface="Arial"/>
                <a:ea typeface="Arial"/>
                <a:cs typeface="Arial"/>
                <a:sym typeface="Arial"/>
              </a:rPr>
              <a:t> to 2000 </a:t>
            </a:r>
            <a:r>
              <a:rPr lang="en-GB" sz="1100" b="0" i="0" u="none" strike="noStrike" cap="none" dirty="0" err="1">
                <a:solidFill>
                  <a:srgbClr val="000000"/>
                </a:solidFill>
                <a:latin typeface="Arial"/>
                <a:ea typeface="Arial"/>
                <a:cs typeface="Arial"/>
                <a:sym typeface="Arial"/>
              </a:rPr>
              <a:t>nt</a:t>
            </a:r>
            <a:r>
              <a:rPr lang="en-GB" sz="1100" b="0" i="0" u="none" strike="noStrike" cap="none" dirty="0">
                <a:solidFill>
                  <a:srgbClr val="000000"/>
                </a:solidFill>
                <a:latin typeface="Arial"/>
                <a:ea typeface="Arial"/>
                <a:cs typeface="Arial"/>
                <a:sym typeface="Arial"/>
              </a:rPr>
              <a:t>). </a:t>
            </a:r>
            <a:r>
              <a:rPr lang="en-GB" sz="1100" b="1" i="0" u="none" strike="noStrike" cap="none" dirty="0">
                <a:solidFill>
                  <a:srgbClr val="000000"/>
                </a:solidFill>
                <a:latin typeface="Arial"/>
                <a:ea typeface="Arial"/>
                <a:cs typeface="Arial"/>
                <a:sym typeface="Arial"/>
              </a:rPr>
              <a:t>B. </a:t>
            </a:r>
            <a:r>
              <a:rPr lang="en-GB" sz="1100" b="0" i="0" u="none" strike="noStrike" cap="none" dirty="0">
                <a:solidFill>
                  <a:srgbClr val="000000"/>
                </a:solidFill>
                <a:latin typeface="Arial"/>
                <a:ea typeface="Arial"/>
                <a:cs typeface="Arial"/>
                <a:sym typeface="Arial"/>
              </a:rPr>
              <a:t>Analysis of RNA extractions non-denaturing conditions including a RNase T1 digested 3T_Dome11 RNA extract. Positive bands for the production of Dome11 dsRNA is noted in all constructs. A reduction in intensity of </a:t>
            </a:r>
            <a:r>
              <a:rPr lang="en-GB" sz="1100" b="0" i="0" u="none" strike="noStrike" cap="none" dirty="0" err="1">
                <a:solidFill>
                  <a:srgbClr val="000000"/>
                </a:solidFill>
                <a:latin typeface="Arial"/>
                <a:ea typeface="Arial"/>
                <a:cs typeface="Arial"/>
                <a:sym typeface="Arial"/>
              </a:rPr>
              <a:t>rRNA</a:t>
            </a:r>
            <a:r>
              <a:rPr lang="en-GB" sz="1100" b="0" i="0" u="none" strike="noStrike" cap="none" dirty="0">
                <a:solidFill>
                  <a:srgbClr val="000000"/>
                </a:solidFill>
                <a:latin typeface="Arial"/>
                <a:ea typeface="Arial"/>
                <a:cs typeface="Arial"/>
                <a:sym typeface="Arial"/>
              </a:rPr>
              <a:t> and additional bands indicated dsRNA with </a:t>
            </a:r>
            <a:r>
              <a:rPr lang="en-GB" sz="1100" b="0" i="0" u="none" strike="noStrike" cap="none" dirty="0" err="1">
                <a:solidFill>
                  <a:srgbClr val="000000"/>
                </a:solidFill>
                <a:latin typeface="Arial"/>
                <a:ea typeface="Arial"/>
                <a:cs typeface="Arial"/>
                <a:sym typeface="Arial"/>
              </a:rPr>
              <a:t>ssRNA</a:t>
            </a:r>
            <a:r>
              <a:rPr lang="en-GB" sz="1100" b="0" i="0" u="none" strike="noStrike" cap="none" dirty="0">
                <a:solidFill>
                  <a:srgbClr val="000000"/>
                </a:solidFill>
                <a:latin typeface="Arial"/>
                <a:ea typeface="Arial"/>
                <a:cs typeface="Arial"/>
                <a:sym typeface="Arial"/>
              </a:rPr>
              <a:t> overhangs reduces upon the addition of transcriptional terminators, while the dsRNA Dome11 bands intensity increases. This is noted due to the normalisation of the sample quantity loaded (100 ng). Bands are also observed for </a:t>
            </a:r>
            <a:r>
              <a:rPr lang="en-GB" sz="1100" b="0" i="0" u="none" strike="noStrike" cap="none" dirty="0" err="1">
                <a:solidFill>
                  <a:srgbClr val="000000"/>
                </a:solidFill>
                <a:latin typeface="Arial"/>
                <a:ea typeface="Arial"/>
                <a:cs typeface="Arial"/>
                <a:sym typeface="Arial"/>
              </a:rPr>
              <a:t>rRNA</a:t>
            </a:r>
            <a:r>
              <a:rPr lang="en-GB" sz="1100" b="0" i="0" u="none" strike="noStrike" cap="none" dirty="0">
                <a:solidFill>
                  <a:srgbClr val="000000"/>
                </a:solidFill>
                <a:latin typeface="Arial"/>
                <a:ea typeface="Arial"/>
                <a:cs typeface="Arial"/>
                <a:sym typeface="Arial"/>
              </a:rPr>
              <a:t> 16S and 23S at approximately. </a:t>
            </a:r>
            <a:endParaRPr sz="1100" b="1" i="0" u="none" strike="noStrike" cap="none" dirty="0">
              <a:solidFill>
                <a:srgbClr val="000000"/>
              </a:solidFill>
              <a:latin typeface="Arial"/>
              <a:ea typeface="Arial"/>
              <a:cs typeface="Arial"/>
              <a:sym typeface="Arial"/>
            </a:endParaRPr>
          </a:p>
        </p:txBody>
      </p:sp>
      <p:sp>
        <p:nvSpPr>
          <p:cNvPr id="37" name="Google Shape;1739;p12"/>
          <p:cNvSpPr txBox="1"/>
          <p:nvPr/>
        </p:nvSpPr>
        <p:spPr>
          <a:xfrm>
            <a:off x="6705133" y="1781214"/>
            <a:ext cx="1058076" cy="23849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dirty="0">
                <a:solidFill>
                  <a:srgbClr val="000000"/>
                </a:solidFill>
                <a:latin typeface="Arial"/>
                <a:ea typeface="Arial"/>
                <a:cs typeface="Arial"/>
                <a:sym typeface="Arial"/>
              </a:rPr>
              <a:t>23S </a:t>
            </a:r>
            <a:r>
              <a:rPr lang="en-GB" sz="950" b="0" i="0" u="none" strike="noStrike" cap="none" dirty="0" err="1">
                <a:solidFill>
                  <a:srgbClr val="000000"/>
                </a:solidFill>
                <a:latin typeface="Arial"/>
                <a:ea typeface="Arial"/>
                <a:cs typeface="Arial"/>
                <a:sym typeface="Arial"/>
              </a:rPr>
              <a:t>rRNA</a:t>
            </a:r>
            <a:endParaRPr sz="1400" b="0" i="0" u="none" strike="noStrike" cap="none" dirty="0">
              <a:solidFill>
                <a:srgbClr val="000000"/>
              </a:solidFill>
              <a:latin typeface="Arial"/>
              <a:ea typeface="Arial"/>
              <a:cs typeface="Arial"/>
              <a:sym typeface="Arial"/>
            </a:endParaRPr>
          </a:p>
        </p:txBody>
      </p:sp>
      <p:sp>
        <p:nvSpPr>
          <p:cNvPr id="38" name="Google Shape;1749;p12"/>
          <p:cNvSpPr txBox="1"/>
          <p:nvPr/>
        </p:nvSpPr>
        <p:spPr>
          <a:xfrm>
            <a:off x="6685846" y="1940828"/>
            <a:ext cx="784652" cy="23849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50"/>
              <a:buFont typeface="Arial"/>
              <a:buNone/>
            </a:pPr>
            <a:r>
              <a:rPr lang="en-GB" sz="950" b="0" i="0" u="none" strike="noStrike" cap="none" dirty="0">
                <a:solidFill>
                  <a:srgbClr val="000000"/>
                </a:solidFill>
                <a:latin typeface="Arial"/>
                <a:ea typeface="Arial"/>
                <a:cs typeface="Arial"/>
                <a:sym typeface="Arial"/>
              </a:rPr>
              <a:t>16S </a:t>
            </a:r>
            <a:r>
              <a:rPr lang="en-GB" sz="950" b="0" i="0" u="none" strike="noStrike" cap="none" dirty="0" err="1">
                <a:solidFill>
                  <a:srgbClr val="000000"/>
                </a:solidFill>
                <a:latin typeface="Arial"/>
                <a:ea typeface="Arial"/>
                <a:cs typeface="Arial"/>
                <a:sym typeface="Arial"/>
              </a:rPr>
              <a:t>rRNA</a:t>
            </a:r>
            <a:endParaRPr sz="1400" b="0" i="0" u="none" strike="noStrike" cap="none" dirty="0">
              <a:solidFill>
                <a:srgbClr val="000000"/>
              </a:solidFill>
              <a:latin typeface="Arial"/>
              <a:ea typeface="Arial"/>
              <a:cs typeface="Arial"/>
              <a:sym typeface="Arial"/>
            </a:endParaRPr>
          </a:p>
        </p:txBody>
      </p:sp>
      <p:cxnSp>
        <p:nvCxnSpPr>
          <p:cNvPr id="39" name="Google Shape;1763;p12"/>
          <p:cNvCxnSpPr/>
          <p:nvPr/>
        </p:nvCxnSpPr>
        <p:spPr>
          <a:xfrm flipH="1" flipV="1">
            <a:off x="6327073" y="1905829"/>
            <a:ext cx="384276" cy="0"/>
          </a:xfrm>
          <a:prstGeom prst="straightConnector1">
            <a:avLst/>
          </a:prstGeom>
          <a:noFill/>
          <a:ln w="12700" cap="flat" cmpd="sng">
            <a:solidFill>
              <a:schemeClr val="lt1"/>
            </a:solidFill>
            <a:prstDash val="solid"/>
            <a:round/>
            <a:headEnd type="none" w="sm" len="sm"/>
            <a:tailEnd type="triangle" w="med" len="med"/>
          </a:ln>
        </p:spPr>
      </p:cxnSp>
      <p:cxnSp>
        <p:nvCxnSpPr>
          <p:cNvPr id="41" name="Google Shape;1763;p12"/>
          <p:cNvCxnSpPr/>
          <p:nvPr/>
        </p:nvCxnSpPr>
        <p:spPr>
          <a:xfrm flipH="1" flipV="1">
            <a:off x="6327073" y="2104764"/>
            <a:ext cx="384276" cy="0"/>
          </a:xfrm>
          <a:prstGeom prst="straightConnector1">
            <a:avLst/>
          </a:prstGeom>
          <a:noFill/>
          <a:ln w="12700" cap="flat" cmpd="sng">
            <a:solidFill>
              <a:schemeClr val="lt1"/>
            </a:solidFill>
            <a:prstDash val="solid"/>
            <a:round/>
            <a:headEnd type="none" w="sm" len="sm"/>
            <a:tailEnd type="triangle" w="med" len="med"/>
          </a:ln>
        </p:spPr>
      </p:cxn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880"/>
        <p:cNvGrpSpPr/>
        <p:nvPr/>
      </p:nvGrpSpPr>
      <p:grpSpPr>
        <a:xfrm>
          <a:off x="0" y="0"/>
          <a:ext cx="0" cy="0"/>
          <a:chOff x="0" y="0"/>
          <a:chExt cx="0" cy="0"/>
        </a:xfrm>
      </p:grpSpPr>
      <p:sp>
        <p:nvSpPr>
          <p:cNvPr id="1883" name="Google Shape;1883;p14"/>
          <p:cNvSpPr txBox="1"/>
          <p:nvPr/>
        </p:nvSpPr>
        <p:spPr>
          <a:xfrm>
            <a:off x="292852" y="250154"/>
            <a:ext cx="408300" cy="470359"/>
          </a:xfrm>
          <a:prstGeom prst="rect">
            <a:avLst/>
          </a:prstGeom>
          <a:noFill/>
          <a:ln>
            <a:noFill/>
          </a:ln>
        </p:spPr>
        <p:txBody>
          <a:bodyPr spcFirstLastPara="1" wrap="square" lIns="100075" tIns="50025" rIns="100075" bIns="50025"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GB" sz="2400" i="0" u="none" strike="noStrike" cap="none">
                <a:solidFill>
                  <a:schemeClr val="dk1"/>
                </a:solidFill>
                <a:latin typeface="+mj-lt"/>
                <a:ea typeface="Calibri"/>
                <a:cs typeface="Calibri"/>
                <a:sym typeface="Calibri"/>
              </a:rPr>
              <a:t>A</a:t>
            </a:r>
            <a:endParaRPr sz="1800" i="0" u="none" strike="noStrike" cap="none">
              <a:solidFill>
                <a:schemeClr val="dk1"/>
              </a:solidFill>
              <a:latin typeface="+mj-lt"/>
              <a:ea typeface="Calibri"/>
              <a:cs typeface="Calibri"/>
              <a:sym typeface="Calibri"/>
            </a:endParaRPr>
          </a:p>
        </p:txBody>
      </p:sp>
      <p:sp>
        <p:nvSpPr>
          <p:cNvPr id="1884" name="Google Shape;1884;p14"/>
          <p:cNvSpPr txBox="1"/>
          <p:nvPr/>
        </p:nvSpPr>
        <p:spPr>
          <a:xfrm>
            <a:off x="292852" y="1690999"/>
            <a:ext cx="408300" cy="470359"/>
          </a:xfrm>
          <a:prstGeom prst="rect">
            <a:avLst/>
          </a:prstGeom>
          <a:noFill/>
          <a:ln>
            <a:noFill/>
          </a:ln>
        </p:spPr>
        <p:txBody>
          <a:bodyPr spcFirstLastPara="1" wrap="square" lIns="100075" tIns="50025" rIns="100075" bIns="50025"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GB" sz="2400" i="0" u="none" strike="noStrike" cap="none">
                <a:solidFill>
                  <a:schemeClr val="dk1"/>
                </a:solidFill>
                <a:latin typeface="+mj-lt"/>
                <a:ea typeface="Calibri"/>
                <a:cs typeface="Calibri"/>
                <a:sym typeface="Calibri"/>
              </a:rPr>
              <a:t>B</a:t>
            </a:r>
            <a:endParaRPr sz="1800" i="0" u="none" strike="noStrike" cap="none">
              <a:solidFill>
                <a:schemeClr val="dk1"/>
              </a:solidFill>
              <a:latin typeface="+mj-lt"/>
              <a:ea typeface="Calibri"/>
              <a:cs typeface="Calibri"/>
              <a:sym typeface="Calibri"/>
            </a:endParaRPr>
          </a:p>
        </p:txBody>
      </p:sp>
      <p:sp>
        <p:nvSpPr>
          <p:cNvPr id="1885" name="Google Shape;1885;p14"/>
          <p:cNvSpPr/>
          <p:nvPr/>
        </p:nvSpPr>
        <p:spPr>
          <a:xfrm>
            <a:off x="292852" y="4006285"/>
            <a:ext cx="6766854" cy="1446509"/>
          </a:xfrm>
          <a:prstGeom prst="rect">
            <a:avLst/>
          </a:prstGeom>
          <a:noFill/>
          <a:ln>
            <a:noFill/>
          </a:ln>
        </p:spPr>
        <p:txBody>
          <a:bodyPr spcFirstLastPara="1" wrap="square" lIns="91425" tIns="45700" rIns="91425" bIns="45700" anchor="t" anchorCtr="0">
            <a:spAutoFit/>
          </a:bodyPr>
          <a:lstStyle/>
          <a:p>
            <a:pPr marL="0" marR="0" lvl="0" indent="0" algn="l" rtl="0">
              <a:lnSpc>
                <a:spcPct val="200000"/>
              </a:lnSpc>
              <a:spcBef>
                <a:spcPts val="0"/>
              </a:spcBef>
              <a:spcAft>
                <a:spcPts val="0"/>
              </a:spcAft>
              <a:buClr>
                <a:srgbClr val="000000"/>
              </a:buClr>
              <a:buSzPts val="1400"/>
              <a:buFont typeface="Arial"/>
              <a:buNone/>
            </a:pPr>
            <a:r>
              <a:rPr lang="en-GB" sz="1100" b="1" i="0" u="none" strike="noStrike" cap="none" dirty="0">
                <a:solidFill>
                  <a:srgbClr val="000000"/>
                </a:solidFill>
                <a:latin typeface="Arial"/>
                <a:ea typeface="Arial"/>
                <a:cs typeface="Arial"/>
                <a:sym typeface="Arial"/>
              </a:rPr>
              <a:t>Supplementary Figure </a:t>
            </a:r>
            <a:r>
              <a:rPr lang="en-GB" sz="1100" b="1" dirty="0"/>
              <a:t>S4</a:t>
            </a:r>
            <a:r>
              <a:rPr lang="en-GB" sz="1100" b="1" i="0" u="none" strike="noStrike" cap="none" dirty="0">
                <a:solidFill>
                  <a:srgbClr val="000000"/>
                </a:solidFill>
                <a:latin typeface="Arial"/>
                <a:ea typeface="Arial"/>
                <a:cs typeface="Arial"/>
                <a:sym typeface="Arial"/>
              </a:rPr>
              <a:t> – </a:t>
            </a:r>
            <a:r>
              <a:rPr lang="en-GB" sz="1100" b="0" i="0" u="none" strike="noStrike" cap="none" dirty="0">
                <a:solidFill>
                  <a:srgbClr val="000000"/>
                </a:solidFill>
                <a:latin typeface="Arial"/>
                <a:ea typeface="Arial"/>
                <a:cs typeface="Arial"/>
                <a:sym typeface="Arial"/>
              </a:rPr>
              <a:t>Expression constructs for short model RNAs. Expression constructs designed to produce short RNAs for intact mass spectrometry analysis. Constructs were designed to produce either a 50nt </a:t>
            </a:r>
            <a:r>
              <a:rPr lang="en-GB" sz="1100" b="0" i="0" u="none" strike="noStrike" cap="none" dirty="0" err="1">
                <a:solidFill>
                  <a:srgbClr val="000000"/>
                </a:solidFill>
                <a:latin typeface="Arial"/>
                <a:ea typeface="Arial"/>
                <a:cs typeface="Arial"/>
                <a:sym typeface="Arial"/>
              </a:rPr>
              <a:t>ssRNA</a:t>
            </a:r>
            <a:r>
              <a:rPr lang="en-GB" sz="1100" b="0" i="0" u="none" strike="noStrike" cap="none" dirty="0">
                <a:solidFill>
                  <a:srgbClr val="000000"/>
                </a:solidFill>
                <a:latin typeface="Arial"/>
                <a:ea typeface="Arial"/>
                <a:cs typeface="Arial"/>
                <a:sym typeface="Arial"/>
              </a:rPr>
              <a:t> (A) or 120bp dsRNA (B). Constructs were designed to include the ‘3T’ terminator combination (T7 S + </a:t>
            </a:r>
            <a:r>
              <a:rPr lang="en-GB" sz="1100" b="0" i="1" u="none" strike="noStrike" cap="none" dirty="0" err="1">
                <a:solidFill>
                  <a:srgbClr val="000000"/>
                </a:solidFill>
                <a:latin typeface="Arial"/>
                <a:ea typeface="Arial"/>
                <a:cs typeface="Arial"/>
                <a:sym typeface="Arial"/>
              </a:rPr>
              <a:t>rrnB</a:t>
            </a:r>
            <a:r>
              <a:rPr lang="en-GB" sz="1100" b="0" i="0" u="none" strike="noStrike" cap="none" dirty="0">
                <a:solidFill>
                  <a:srgbClr val="000000"/>
                </a:solidFill>
                <a:latin typeface="Arial"/>
                <a:ea typeface="Arial"/>
                <a:cs typeface="Arial"/>
                <a:sym typeface="Arial"/>
              </a:rPr>
              <a:t> T1 + T7 S). </a:t>
            </a:r>
            <a:endParaRPr sz="1100" b="0" i="0" u="none" strike="noStrike" cap="none" dirty="0">
              <a:solidFill>
                <a:srgbClr val="000000"/>
              </a:solidFill>
              <a:latin typeface="Arial"/>
              <a:ea typeface="Arial"/>
              <a:cs typeface="Arial"/>
              <a:sym typeface="Arial"/>
            </a:endParaRPr>
          </a:p>
        </p:txBody>
      </p:sp>
      <p:cxnSp>
        <p:nvCxnSpPr>
          <p:cNvPr id="138" name="Google Shape;96;g214ff8381aa_0_18"/>
          <p:cNvCxnSpPr>
            <a:stCxn id="141" idx="3"/>
          </p:cNvCxnSpPr>
          <p:nvPr/>
        </p:nvCxnSpPr>
        <p:spPr>
          <a:xfrm rot="10800000">
            <a:off x="2648791" y="1381074"/>
            <a:ext cx="0" cy="208800"/>
          </a:xfrm>
          <a:prstGeom prst="straightConnector1">
            <a:avLst/>
          </a:prstGeom>
          <a:noFill/>
          <a:ln w="12700" cap="flat" cmpd="sng">
            <a:solidFill>
              <a:schemeClr val="dk1"/>
            </a:solidFill>
            <a:prstDash val="solid"/>
            <a:round/>
            <a:headEnd type="none" w="sm" len="sm"/>
            <a:tailEnd type="none" w="sm" len="sm"/>
          </a:ln>
        </p:spPr>
      </p:cxnSp>
      <p:cxnSp>
        <p:nvCxnSpPr>
          <p:cNvPr id="139" name="Google Shape;98;g214ff8381aa_0_18"/>
          <p:cNvCxnSpPr/>
          <p:nvPr/>
        </p:nvCxnSpPr>
        <p:spPr>
          <a:xfrm>
            <a:off x="110792" y="1589188"/>
            <a:ext cx="7200000" cy="0"/>
          </a:xfrm>
          <a:prstGeom prst="straightConnector1">
            <a:avLst/>
          </a:prstGeom>
          <a:noFill/>
          <a:ln w="28575" cap="flat" cmpd="sng">
            <a:solidFill>
              <a:schemeClr val="dk1"/>
            </a:solidFill>
            <a:prstDash val="solid"/>
            <a:round/>
            <a:headEnd type="none" w="sm" len="sm"/>
            <a:tailEnd type="none" w="sm" len="sm"/>
          </a:ln>
        </p:spPr>
      </p:cxnSp>
      <p:sp>
        <p:nvSpPr>
          <p:cNvPr id="140" name="Google Shape;99;g214ff8381aa_0_18"/>
          <p:cNvSpPr/>
          <p:nvPr/>
        </p:nvSpPr>
        <p:spPr>
          <a:xfrm>
            <a:off x="2648786" y="1498273"/>
            <a:ext cx="748897" cy="180000"/>
          </a:xfrm>
          <a:prstGeom prst="rect">
            <a:avLst/>
          </a:prstGeom>
          <a:solidFill>
            <a:srgbClr val="FFCA2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000" dirty="0">
                <a:solidFill>
                  <a:schemeClr val="dk1"/>
                </a:solidFill>
              </a:rPr>
              <a:t>50</a:t>
            </a:r>
            <a:endParaRPr dirty="0"/>
          </a:p>
        </p:txBody>
      </p:sp>
      <p:sp>
        <p:nvSpPr>
          <p:cNvPr id="141" name="Google Shape;97;g214ff8381aa_0_18"/>
          <p:cNvSpPr/>
          <p:nvPr/>
        </p:nvSpPr>
        <p:spPr>
          <a:xfrm>
            <a:off x="2235234" y="1499874"/>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a:solidFill>
                  <a:schemeClr val="dk1"/>
                </a:solidFill>
                <a:latin typeface="Arial"/>
                <a:ea typeface="Arial"/>
                <a:cs typeface="Arial"/>
                <a:sym typeface="Arial"/>
              </a:rPr>
              <a:t>pT7</a:t>
            </a:r>
            <a:endParaRPr/>
          </a:p>
        </p:txBody>
      </p:sp>
      <p:cxnSp>
        <p:nvCxnSpPr>
          <p:cNvPr id="142" name="Google Shape;101;g214ff8381aa_0_18"/>
          <p:cNvCxnSpPr/>
          <p:nvPr/>
        </p:nvCxnSpPr>
        <p:spPr>
          <a:xfrm>
            <a:off x="2642441" y="1383929"/>
            <a:ext cx="156596" cy="0"/>
          </a:xfrm>
          <a:prstGeom prst="straightConnector1">
            <a:avLst/>
          </a:prstGeom>
          <a:noFill/>
          <a:ln w="12700" cap="flat" cmpd="sng">
            <a:solidFill>
              <a:schemeClr val="dk1"/>
            </a:solidFill>
            <a:prstDash val="solid"/>
            <a:round/>
            <a:headEnd type="none" w="sm" len="sm"/>
            <a:tailEnd type="triangle" w="med" len="med"/>
          </a:ln>
        </p:spPr>
      </p:cxnSp>
      <p:sp>
        <p:nvSpPr>
          <p:cNvPr id="143" name="Google Shape;113;g214ff8381aa_0_18"/>
          <p:cNvSpPr/>
          <p:nvPr/>
        </p:nvSpPr>
        <p:spPr>
          <a:xfrm>
            <a:off x="3402261" y="1498266"/>
            <a:ext cx="432000" cy="179998"/>
          </a:xfrm>
          <a:prstGeom prst="rect">
            <a:avLst/>
          </a:prstGeom>
          <a:solidFill>
            <a:srgbClr val="F20000"/>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dirty="0">
                <a:solidFill>
                  <a:schemeClr val="dk1"/>
                </a:solidFill>
                <a:latin typeface="Arial"/>
                <a:ea typeface="Arial"/>
                <a:cs typeface="Arial"/>
                <a:sym typeface="Arial"/>
              </a:rPr>
              <a:t>T7 s</a:t>
            </a:r>
            <a:endParaRPr dirty="0"/>
          </a:p>
        </p:txBody>
      </p:sp>
      <p:sp>
        <p:nvSpPr>
          <p:cNvPr id="144" name="Google Shape;179;g214ff8381aa_0_18"/>
          <p:cNvSpPr/>
          <p:nvPr/>
        </p:nvSpPr>
        <p:spPr>
          <a:xfrm>
            <a:off x="3834261" y="1498267"/>
            <a:ext cx="612000" cy="179778"/>
          </a:xfrm>
          <a:prstGeom prst="rect">
            <a:avLst/>
          </a:prstGeom>
          <a:solidFill>
            <a:srgbClr val="FF6969"/>
          </a:solidFill>
          <a:ln w="9525" cap="flat" cmpd="sng">
            <a:solidFill>
              <a:schemeClr val="dk1">
                <a:alpha val="96862"/>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dirty="0" err="1">
                <a:solidFill>
                  <a:schemeClr val="dk1"/>
                </a:solidFill>
                <a:latin typeface="Arial"/>
                <a:ea typeface="Arial"/>
                <a:cs typeface="Arial"/>
                <a:sym typeface="Arial"/>
              </a:rPr>
              <a:t>rrnB</a:t>
            </a:r>
            <a:r>
              <a:rPr lang="en-GB" sz="1000" b="0" i="0" u="none" strike="noStrike" cap="none" dirty="0">
                <a:solidFill>
                  <a:schemeClr val="dk1"/>
                </a:solidFill>
                <a:latin typeface="Arial"/>
                <a:ea typeface="Arial"/>
                <a:cs typeface="Arial"/>
                <a:sym typeface="Arial"/>
              </a:rPr>
              <a:t> T1</a:t>
            </a:r>
            <a:endParaRPr dirty="0"/>
          </a:p>
        </p:txBody>
      </p:sp>
      <p:sp>
        <p:nvSpPr>
          <p:cNvPr id="145" name="Google Shape;181;g214ff8381aa_0_18"/>
          <p:cNvSpPr/>
          <p:nvPr/>
        </p:nvSpPr>
        <p:spPr>
          <a:xfrm>
            <a:off x="4447319" y="1499239"/>
            <a:ext cx="432000" cy="178806"/>
          </a:xfrm>
          <a:prstGeom prst="rect">
            <a:avLst/>
          </a:prstGeom>
          <a:solidFill>
            <a:srgbClr val="F20000"/>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a:solidFill>
                  <a:schemeClr val="dk1"/>
                </a:solidFill>
                <a:latin typeface="Arial"/>
                <a:ea typeface="Arial"/>
                <a:cs typeface="Arial"/>
                <a:sym typeface="Arial"/>
              </a:rPr>
              <a:t>T7 s</a:t>
            </a:r>
            <a:endParaRPr/>
          </a:p>
        </p:txBody>
      </p:sp>
      <p:cxnSp>
        <p:nvCxnSpPr>
          <p:cNvPr id="146" name="Google Shape;144;g214ff8381aa_0_18"/>
          <p:cNvCxnSpPr/>
          <p:nvPr/>
        </p:nvCxnSpPr>
        <p:spPr>
          <a:xfrm>
            <a:off x="4781616" y="2423800"/>
            <a:ext cx="0" cy="208748"/>
          </a:xfrm>
          <a:prstGeom prst="straightConnector1">
            <a:avLst/>
          </a:prstGeom>
          <a:noFill/>
          <a:ln w="12700" cap="flat" cmpd="sng">
            <a:solidFill>
              <a:schemeClr val="dk1"/>
            </a:solidFill>
            <a:prstDash val="solid"/>
            <a:round/>
            <a:headEnd type="none" w="sm" len="sm"/>
            <a:tailEnd type="none" w="sm" len="sm"/>
          </a:ln>
        </p:spPr>
      </p:cxnSp>
      <p:cxnSp>
        <p:nvCxnSpPr>
          <p:cNvPr id="147" name="Google Shape;145;g214ff8381aa_0_18"/>
          <p:cNvCxnSpPr/>
          <p:nvPr/>
        </p:nvCxnSpPr>
        <p:spPr>
          <a:xfrm rot="10800000">
            <a:off x="4631370" y="2629745"/>
            <a:ext cx="156596" cy="0"/>
          </a:xfrm>
          <a:prstGeom prst="straightConnector1">
            <a:avLst/>
          </a:prstGeom>
          <a:noFill/>
          <a:ln w="12700" cap="flat" cmpd="sng">
            <a:solidFill>
              <a:schemeClr val="dk1"/>
            </a:solidFill>
            <a:prstDash val="solid"/>
            <a:round/>
            <a:headEnd type="none" w="sm" len="sm"/>
            <a:tailEnd type="triangle" w="med" len="med"/>
          </a:ln>
        </p:spPr>
      </p:cxnSp>
      <p:cxnSp>
        <p:nvCxnSpPr>
          <p:cNvPr id="148" name="Google Shape;146;g214ff8381aa_0_18"/>
          <p:cNvCxnSpPr>
            <a:stCxn id="152" idx="3"/>
          </p:cNvCxnSpPr>
          <p:nvPr/>
        </p:nvCxnSpPr>
        <p:spPr>
          <a:xfrm rot="10800000">
            <a:off x="2657657" y="2216371"/>
            <a:ext cx="0" cy="208800"/>
          </a:xfrm>
          <a:prstGeom prst="straightConnector1">
            <a:avLst/>
          </a:prstGeom>
          <a:noFill/>
          <a:ln w="12700" cap="flat" cmpd="sng">
            <a:solidFill>
              <a:schemeClr val="dk1"/>
            </a:solidFill>
            <a:prstDash val="solid"/>
            <a:round/>
            <a:headEnd type="none" w="sm" len="sm"/>
            <a:tailEnd type="none" w="sm" len="sm"/>
          </a:ln>
        </p:spPr>
      </p:cxnSp>
      <p:cxnSp>
        <p:nvCxnSpPr>
          <p:cNvPr id="149" name="Google Shape;148;g214ff8381aa_0_18"/>
          <p:cNvCxnSpPr/>
          <p:nvPr/>
        </p:nvCxnSpPr>
        <p:spPr>
          <a:xfrm>
            <a:off x="119658" y="2424485"/>
            <a:ext cx="7200000" cy="0"/>
          </a:xfrm>
          <a:prstGeom prst="straightConnector1">
            <a:avLst/>
          </a:prstGeom>
          <a:noFill/>
          <a:ln w="28575" cap="flat" cmpd="sng">
            <a:solidFill>
              <a:schemeClr val="dk1"/>
            </a:solidFill>
            <a:prstDash val="solid"/>
            <a:round/>
            <a:headEnd type="none" w="sm" len="sm"/>
            <a:tailEnd type="none" w="sm" len="sm"/>
          </a:ln>
        </p:spPr>
      </p:cxnSp>
      <p:sp>
        <p:nvSpPr>
          <p:cNvPr id="150" name="Google Shape;149;g214ff8381aa_0_18"/>
          <p:cNvSpPr/>
          <p:nvPr/>
        </p:nvSpPr>
        <p:spPr>
          <a:xfrm>
            <a:off x="2657657" y="2334485"/>
            <a:ext cx="2124000" cy="180000"/>
          </a:xfrm>
          <a:prstGeom prst="rect">
            <a:avLst/>
          </a:prstGeom>
          <a:solidFill>
            <a:srgbClr val="FFCA2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a:solidFill>
                  <a:schemeClr val="dk1"/>
                </a:solidFill>
                <a:latin typeface="Arial"/>
                <a:ea typeface="Arial"/>
                <a:cs typeface="Arial"/>
                <a:sym typeface="Arial"/>
              </a:rPr>
              <a:t>Target Gene</a:t>
            </a:r>
            <a:endParaRPr/>
          </a:p>
        </p:txBody>
      </p:sp>
      <p:sp>
        <p:nvSpPr>
          <p:cNvPr id="151" name="Google Shape;150;g214ff8381aa_0_18"/>
          <p:cNvSpPr/>
          <p:nvPr/>
        </p:nvSpPr>
        <p:spPr>
          <a:xfrm>
            <a:off x="4781656" y="2334485"/>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a:solidFill>
                  <a:schemeClr val="dk1"/>
                </a:solidFill>
                <a:latin typeface="Arial"/>
                <a:ea typeface="Arial"/>
                <a:cs typeface="Arial"/>
                <a:sym typeface="Arial"/>
              </a:rPr>
              <a:t>pT7</a:t>
            </a:r>
            <a:endParaRPr/>
          </a:p>
        </p:txBody>
      </p:sp>
      <p:sp>
        <p:nvSpPr>
          <p:cNvPr id="152" name="Google Shape;147;g214ff8381aa_0_18"/>
          <p:cNvSpPr/>
          <p:nvPr/>
        </p:nvSpPr>
        <p:spPr>
          <a:xfrm>
            <a:off x="2244100" y="2335171"/>
            <a:ext cx="413557" cy="180000"/>
          </a:xfrm>
          <a:prstGeom prst="rect">
            <a:avLst/>
          </a:prstGeom>
          <a:solidFill>
            <a:srgbClr val="34F12F"/>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dirty="0">
                <a:solidFill>
                  <a:schemeClr val="dk1"/>
                </a:solidFill>
                <a:latin typeface="Arial"/>
                <a:ea typeface="Arial"/>
                <a:cs typeface="Arial"/>
                <a:sym typeface="Arial"/>
              </a:rPr>
              <a:t>pT7</a:t>
            </a:r>
            <a:endParaRPr dirty="0"/>
          </a:p>
        </p:txBody>
      </p:sp>
      <p:cxnSp>
        <p:nvCxnSpPr>
          <p:cNvPr id="153" name="Google Shape;151;g214ff8381aa_0_18"/>
          <p:cNvCxnSpPr/>
          <p:nvPr/>
        </p:nvCxnSpPr>
        <p:spPr>
          <a:xfrm>
            <a:off x="2651307" y="2219226"/>
            <a:ext cx="156596" cy="0"/>
          </a:xfrm>
          <a:prstGeom prst="straightConnector1">
            <a:avLst/>
          </a:prstGeom>
          <a:noFill/>
          <a:ln w="12700" cap="flat" cmpd="sng">
            <a:solidFill>
              <a:schemeClr val="dk1"/>
            </a:solidFill>
            <a:prstDash val="solid"/>
            <a:round/>
            <a:headEnd type="none" w="sm" len="sm"/>
            <a:tailEnd type="triangle" w="med" len="med"/>
          </a:ln>
        </p:spPr>
      </p:cxnSp>
      <p:sp>
        <p:nvSpPr>
          <p:cNvPr id="154" name="Google Shape;152;g214ff8381aa_0_18"/>
          <p:cNvSpPr/>
          <p:nvPr/>
        </p:nvSpPr>
        <p:spPr>
          <a:xfrm>
            <a:off x="5240933" y="2333799"/>
            <a:ext cx="432000" cy="179998"/>
          </a:xfrm>
          <a:prstGeom prst="rect">
            <a:avLst/>
          </a:prstGeom>
          <a:solidFill>
            <a:srgbClr val="F20000"/>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dirty="0">
                <a:solidFill>
                  <a:schemeClr val="dk1"/>
                </a:solidFill>
                <a:latin typeface="Arial"/>
                <a:ea typeface="Arial"/>
                <a:cs typeface="Arial"/>
                <a:sym typeface="Arial"/>
              </a:rPr>
              <a:t>T7 s</a:t>
            </a:r>
            <a:endParaRPr dirty="0"/>
          </a:p>
        </p:txBody>
      </p:sp>
      <p:sp>
        <p:nvSpPr>
          <p:cNvPr id="155" name="Google Shape;153;g214ff8381aa_0_18"/>
          <p:cNvSpPr/>
          <p:nvPr/>
        </p:nvSpPr>
        <p:spPr>
          <a:xfrm>
            <a:off x="1768620" y="2334992"/>
            <a:ext cx="432000" cy="178806"/>
          </a:xfrm>
          <a:prstGeom prst="rect">
            <a:avLst/>
          </a:prstGeom>
          <a:solidFill>
            <a:srgbClr val="F20000"/>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dirty="0">
                <a:solidFill>
                  <a:schemeClr val="dk1"/>
                </a:solidFill>
                <a:latin typeface="Arial"/>
                <a:ea typeface="Arial"/>
                <a:cs typeface="Arial"/>
                <a:sym typeface="Arial"/>
              </a:rPr>
              <a:t>T7 s</a:t>
            </a:r>
            <a:endParaRPr dirty="0"/>
          </a:p>
        </p:txBody>
      </p:sp>
      <p:sp>
        <p:nvSpPr>
          <p:cNvPr id="156" name="Google Shape;182;g214ff8381aa_0_18"/>
          <p:cNvSpPr/>
          <p:nvPr/>
        </p:nvSpPr>
        <p:spPr>
          <a:xfrm>
            <a:off x="1154687" y="2333799"/>
            <a:ext cx="612000" cy="180349"/>
          </a:xfrm>
          <a:prstGeom prst="rect">
            <a:avLst/>
          </a:prstGeom>
          <a:solidFill>
            <a:srgbClr val="FF6969"/>
          </a:solidFill>
          <a:ln w="9525" cap="flat" cmpd="sng">
            <a:solidFill>
              <a:schemeClr val="dk1">
                <a:alpha val="96862"/>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a:solidFill>
                  <a:schemeClr val="dk1"/>
                </a:solidFill>
                <a:latin typeface="Arial"/>
                <a:ea typeface="Arial"/>
                <a:cs typeface="Arial"/>
                <a:sym typeface="Arial"/>
              </a:rPr>
              <a:t>rrnB T1</a:t>
            </a:r>
            <a:endParaRPr/>
          </a:p>
        </p:txBody>
      </p:sp>
      <p:sp>
        <p:nvSpPr>
          <p:cNvPr id="157" name="Google Shape;183;g214ff8381aa_0_18"/>
          <p:cNvSpPr/>
          <p:nvPr/>
        </p:nvSpPr>
        <p:spPr>
          <a:xfrm>
            <a:off x="5673166" y="2333800"/>
            <a:ext cx="612000" cy="180892"/>
          </a:xfrm>
          <a:prstGeom prst="rect">
            <a:avLst/>
          </a:prstGeom>
          <a:solidFill>
            <a:srgbClr val="FF6969"/>
          </a:solidFill>
          <a:ln w="9525" cap="flat" cmpd="sng">
            <a:solidFill>
              <a:schemeClr val="dk1">
                <a:alpha val="96862"/>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dirty="0" err="1">
                <a:solidFill>
                  <a:schemeClr val="dk1"/>
                </a:solidFill>
                <a:latin typeface="Arial"/>
                <a:ea typeface="Arial"/>
                <a:cs typeface="Arial"/>
                <a:sym typeface="Arial"/>
              </a:rPr>
              <a:t>rrnB</a:t>
            </a:r>
            <a:r>
              <a:rPr lang="en-GB" sz="1000" b="0" i="0" u="none" strike="noStrike" cap="none" dirty="0">
                <a:solidFill>
                  <a:schemeClr val="dk1"/>
                </a:solidFill>
                <a:latin typeface="Arial"/>
                <a:ea typeface="Arial"/>
                <a:cs typeface="Arial"/>
                <a:sym typeface="Arial"/>
              </a:rPr>
              <a:t> T1</a:t>
            </a:r>
            <a:endParaRPr dirty="0"/>
          </a:p>
        </p:txBody>
      </p:sp>
      <p:sp>
        <p:nvSpPr>
          <p:cNvPr id="158" name="Google Shape;184;g214ff8381aa_0_18"/>
          <p:cNvSpPr/>
          <p:nvPr/>
        </p:nvSpPr>
        <p:spPr>
          <a:xfrm>
            <a:off x="722688" y="2333799"/>
            <a:ext cx="432000" cy="180892"/>
          </a:xfrm>
          <a:prstGeom prst="rect">
            <a:avLst/>
          </a:prstGeom>
          <a:solidFill>
            <a:srgbClr val="F20000"/>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dirty="0">
                <a:solidFill>
                  <a:schemeClr val="dk1"/>
                </a:solidFill>
                <a:latin typeface="Arial"/>
                <a:ea typeface="Arial"/>
                <a:cs typeface="Arial"/>
                <a:sym typeface="Arial"/>
              </a:rPr>
              <a:t>T7 s</a:t>
            </a:r>
            <a:endParaRPr dirty="0"/>
          </a:p>
        </p:txBody>
      </p:sp>
      <p:sp>
        <p:nvSpPr>
          <p:cNvPr id="159" name="Google Shape;185;g214ff8381aa_0_18"/>
          <p:cNvSpPr/>
          <p:nvPr/>
        </p:nvSpPr>
        <p:spPr>
          <a:xfrm>
            <a:off x="6284107" y="2334593"/>
            <a:ext cx="432000" cy="178806"/>
          </a:xfrm>
          <a:prstGeom prst="rect">
            <a:avLst/>
          </a:prstGeom>
          <a:solidFill>
            <a:srgbClr val="F20000"/>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GB" sz="1000" b="0" i="0" u="none" strike="noStrike" cap="none">
                <a:solidFill>
                  <a:schemeClr val="dk1"/>
                </a:solidFill>
                <a:latin typeface="Arial"/>
                <a:ea typeface="Arial"/>
                <a:cs typeface="Arial"/>
                <a:sym typeface="Arial"/>
              </a:rPr>
              <a:t>T7 s</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90"/>
        <p:cNvGrpSpPr/>
        <p:nvPr/>
      </p:nvGrpSpPr>
      <p:grpSpPr>
        <a:xfrm>
          <a:off x="0" y="0"/>
          <a:ext cx="0" cy="0"/>
          <a:chOff x="0" y="0"/>
          <a:chExt cx="0" cy="0"/>
        </a:xfrm>
      </p:grpSpPr>
      <p:grpSp>
        <p:nvGrpSpPr>
          <p:cNvPr id="1891" name="Google Shape;1891;p16"/>
          <p:cNvGrpSpPr/>
          <p:nvPr/>
        </p:nvGrpSpPr>
        <p:grpSpPr>
          <a:xfrm>
            <a:off x="586671" y="636601"/>
            <a:ext cx="6252976" cy="3903529"/>
            <a:chOff x="359189" y="4782742"/>
            <a:chExt cx="5793548" cy="3616723"/>
          </a:xfrm>
        </p:grpSpPr>
        <p:pic>
          <p:nvPicPr>
            <p:cNvPr id="1892" name="Google Shape;1892;p16"/>
            <p:cNvPicPr preferRelativeResize="0"/>
            <p:nvPr/>
          </p:nvPicPr>
          <p:blipFill rotWithShape="1">
            <a:blip r:embed="rId3">
              <a:alphaModFix/>
            </a:blip>
            <a:srcRect/>
            <a:stretch/>
          </p:blipFill>
          <p:spPr>
            <a:xfrm>
              <a:off x="359189" y="4782743"/>
              <a:ext cx="2723737" cy="1800226"/>
            </a:xfrm>
            <a:prstGeom prst="rect">
              <a:avLst/>
            </a:prstGeom>
            <a:noFill/>
            <a:ln>
              <a:noFill/>
            </a:ln>
          </p:spPr>
        </p:pic>
        <p:pic>
          <p:nvPicPr>
            <p:cNvPr id="1893" name="Google Shape;1893;p16"/>
            <p:cNvPicPr preferRelativeResize="0"/>
            <p:nvPr/>
          </p:nvPicPr>
          <p:blipFill rotWithShape="1">
            <a:blip r:embed="rId4">
              <a:alphaModFix/>
            </a:blip>
            <a:srcRect/>
            <a:stretch/>
          </p:blipFill>
          <p:spPr>
            <a:xfrm>
              <a:off x="3429000" y="4782742"/>
              <a:ext cx="2722782" cy="1800226"/>
            </a:xfrm>
            <a:prstGeom prst="rect">
              <a:avLst/>
            </a:prstGeom>
            <a:noFill/>
            <a:ln>
              <a:noFill/>
            </a:ln>
          </p:spPr>
        </p:pic>
        <p:pic>
          <p:nvPicPr>
            <p:cNvPr id="1894" name="Google Shape;1894;p16"/>
            <p:cNvPicPr preferRelativeResize="0"/>
            <p:nvPr/>
          </p:nvPicPr>
          <p:blipFill rotWithShape="1">
            <a:blip r:embed="rId5">
              <a:alphaModFix/>
            </a:blip>
            <a:srcRect/>
            <a:stretch/>
          </p:blipFill>
          <p:spPr>
            <a:xfrm>
              <a:off x="359189" y="6599239"/>
              <a:ext cx="2723737" cy="1800226"/>
            </a:xfrm>
            <a:prstGeom prst="rect">
              <a:avLst/>
            </a:prstGeom>
            <a:noFill/>
            <a:ln>
              <a:noFill/>
            </a:ln>
          </p:spPr>
        </p:pic>
        <p:pic>
          <p:nvPicPr>
            <p:cNvPr id="1895" name="Google Shape;1895;p16"/>
            <p:cNvPicPr preferRelativeResize="0"/>
            <p:nvPr/>
          </p:nvPicPr>
          <p:blipFill rotWithShape="1">
            <a:blip r:embed="rId6">
              <a:alphaModFix/>
            </a:blip>
            <a:srcRect/>
            <a:stretch/>
          </p:blipFill>
          <p:spPr>
            <a:xfrm>
              <a:off x="3429000" y="6599239"/>
              <a:ext cx="2723737" cy="1800226"/>
            </a:xfrm>
            <a:prstGeom prst="rect">
              <a:avLst/>
            </a:prstGeom>
            <a:noFill/>
            <a:ln>
              <a:noFill/>
            </a:ln>
          </p:spPr>
        </p:pic>
      </p:grpSp>
      <p:sp>
        <p:nvSpPr>
          <p:cNvPr id="1896" name="Google Shape;1896;p16"/>
          <p:cNvSpPr txBox="1"/>
          <p:nvPr/>
        </p:nvSpPr>
        <p:spPr>
          <a:xfrm>
            <a:off x="292852" y="124828"/>
            <a:ext cx="408300" cy="470359"/>
          </a:xfrm>
          <a:prstGeom prst="rect">
            <a:avLst/>
          </a:prstGeom>
          <a:noFill/>
          <a:ln>
            <a:noFill/>
          </a:ln>
        </p:spPr>
        <p:txBody>
          <a:bodyPr spcFirstLastPara="1" wrap="square" lIns="100075" tIns="50025" rIns="100075" bIns="50025"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GB" sz="2400" i="0" u="none" strike="noStrike" cap="none" dirty="0">
                <a:solidFill>
                  <a:schemeClr val="dk1"/>
                </a:solidFill>
                <a:latin typeface="+mj-lt"/>
                <a:ea typeface="Calibri"/>
                <a:cs typeface="Calibri"/>
                <a:sym typeface="Calibri"/>
              </a:rPr>
              <a:t>A</a:t>
            </a:r>
            <a:endParaRPr sz="1800" i="0" u="none" strike="noStrike" cap="none" dirty="0">
              <a:solidFill>
                <a:schemeClr val="dk1"/>
              </a:solidFill>
              <a:latin typeface="+mj-lt"/>
              <a:ea typeface="Calibri"/>
              <a:cs typeface="Calibri"/>
              <a:sym typeface="Calibri"/>
            </a:endParaRPr>
          </a:p>
        </p:txBody>
      </p:sp>
      <p:sp>
        <p:nvSpPr>
          <p:cNvPr id="1897" name="Google Shape;1897;p16"/>
          <p:cNvSpPr txBox="1"/>
          <p:nvPr/>
        </p:nvSpPr>
        <p:spPr>
          <a:xfrm>
            <a:off x="292852" y="4557906"/>
            <a:ext cx="408300" cy="470359"/>
          </a:xfrm>
          <a:prstGeom prst="rect">
            <a:avLst/>
          </a:prstGeom>
          <a:noFill/>
          <a:ln>
            <a:noFill/>
          </a:ln>
        </p:spPr>
        <p:txBody>
          <a:bodyPr spcFirstLastPara="1" wrap="square" lIns="100075" tIns="50025" rIns="100075" bIns="50025"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GB" sz="2400" i="0" u="none" strike="noStrike" cap="none" dirty="0">
                <a:solidFill>
                  <a:schemeClr val="dk1"/>
                </a:solidFill>
                <a:latin typeface="+mj-lt"/>
                <a:ea typeface="Calibri"/>
                <a:cs typeface="Calibri"/>
                <a:sym typeface="Calibri"/>
              </a:rPr>
              <a:t>B</a:t>
            </a:r>
            <a:endParaRPr sz="1800" i="0" u="none" strike="noStrike" cap="none" dirty="0">
              <a:solidFill>
                <a:schemeClr val="dk1"/>
              </a:solidFill>
              <a:latin typeface="+mj-lt"/>
              <a:ea typeface="Calibri"/>
              <a:cs typeface="Calibri"/>
              <a:sym typeface="Calibri"/>
            </a:endParaRPr>
          </a:p>
        </p:txBody>
      </p:sp>
      <p:pic>
        <p:nvPicPr>
          <p:cNvPr id="1898" name="Google Shape;1898;p16"/>
          <p:cNvPicPr preferRelativeResize="0"/>
          <p:nvPr/>
        </p:nvPicPr>
        <p:blipFill rotWithShape="1">
          <a:blip r:embed="rId7">
            <a:alphaModFix/>
          </a:blip>
          <a:srcRect/>
          <a:stretch/>
        </p:blipFill>
        <p:spPr>
          <a:xfrm>
            <a:off x="985208" y="5056193"/>
            <a:ext cx="5474406" cy="3229814"/>
          </a:xfrm>
          <a:prstGeom prst="rect">
            <a:avLst/>
          </a:prstGeom>
          <a:noFill/>
          <a:ln>
            <a:noFill/>
          </a:ln>
        </p:spPr>
      </p:pic>
      <p:sp>
        <p:nvSpPr>
          <p:cNvPr id="1899" name="Google Shape;1899;p16"/>
          <p:cNvSpPr/>
          <p:nvPr/>
        </p:nvSpPr>
        <p:spPr>
          <a:xfrm>
            <a:off x="586671" y="8406208"/>
            <a:ext cx="6634400" cy="1877397"/>
          </a:xfrm>
          <a:prstGeom prst="rect">
            <a:avLst/>
          </a:prstGeom>
          <a:noFill/>
          <a:ln>
            <a:noFill/>
          </a:ln>
        </p:spPr>
        <p:txBody>
          <a:bodyPr spcFirstLastPara="1" wrap="square" lIns="91425" tIns="45700" rIns="91425" bIns="45700" anchor="t" anchorCtr="0">
            <a:spAutoFit/>
          </a:bodyPr>
          <a:lstStyle/>
          <a:p>
            <a:pPr marL="0" marR="0" lvl="0" indent="0" algn="l" rtl="0">
              <a:lnSpc>
                <a:spcPct val="200000"/>
              </a:lnSpc>
              <a:spcBef>
                <a:spcPts val="0"/>
              </a:spcBef>
              <a:spcAft>
                <a:spcPts val="0"/>
              </a:spcAft>
              <a:buClr>
                <a:srgbClr val="000000"/>
              </a:buClr>
              <a:buSzPts val="1400"/>
              <a:buFont typeface="Arial"/>
              <a:buNone/>
            </a:pPr>
            <a:r>
              <a:rPr lang="en-GB" sz="1100" b="1" i="0" u="none" strike="noStrike" cap="none" dirty="0">
                <a:solidFill>
                  <a:srgbClr val="000000"/>
                </a:solidFill>
                <a:latin typeface="Arial"/>
                <a:ea typeface="Arial"/>
                <a:cs typeface="Arial"/>
                <a:sym typeface="Arial"/>
              </a:rPr>
              <a:t>Supplementary Figure S5 – </a:t>
            </a:r>
            <a:r>
              <a:rPr lang="en-GB" sz="1100" b="0" i="0" u="none" strike="noStrike" cap="none" dirty="0">
                <a:solidFill>
                  <a:srgbClr val="000000"/>
                </a:solidFill>
                <a:latin typeface="Arial"/>
                <a:ea typeface="Arial"/>
                <a:cs typeface="Arial"/>
                <a:sym typeface="Arial"/>
              </a:rPr>
              <a:t>Mass Spectrometry analysis of </a:t>
            </a:r>
            <a:r>
              <a:rPr lang="en-GB" sz="1100" b="0" i="0" u="none" strike="noStrike" cap="none" dirty="0" err="1">
                <a:solidFill>
                  <a:srgbClr val="000000"/>
                </a:solidFill>
                <a:latin typeface="Arial"/>
                <a:ea typeface="Arial"/>
                <a:cs typeface="Arial"/>
                <a:sym typeface="Arial"/>
              </a:rPr>
              <a:t>ssRNA</a:t>
            </a:r>
            <a:r>
              <a:rPr lang="en-GB" sz="1100" b="0" i="0" u="none" strike="noStrike" cap="none" dirty="0">
                <a:solidFill>
                  <a:srgbClr val="000000"/>
                </a:solidFill>
                <a:latin typeface="Arial"/>
                <a:ea typeface="Arial"/>
                <a:cs typeface="Arial"/>
                <a:sym typeface="Arial"/>
              </a:rPr>
              <a:t> was in vitro transcribed from a linear DNA construct containing three transcriptional terminators (T7 S + </a:t>
            </a:r>
            <a:r>
              <a:rPr lang="en-GB" sz="1100" b="0" i="1" u="none" strike="noStrike" cap="none" dirty="0" err="1">
                <a:solidFill>
                  <a:srgbClr val="000000"/>
                </a:solidFill>
                <a:latin typeface="Arial"/>
                <a:ea typeface="Arial"/>
                <a:cs typeface="Arial"/>
                <a:sym typeface="Arial"/>
              </a:rPr>
              <a:t>rrnB</a:t>
            </a:r>
            <a:r>
              <a:rPr lang="en-GB" sz="1100" b="0" i="0" u="none" strike="noStrike" cap="none" dirty="0">
                <a:solidFill>
                  <a:srgbClr val="000000"/>
                </a:solidFill>
                <a:latin typeface="Arial"/>
                <a:ea typeface="Arial"/>
                <a:cs typeface="Arial"/>
                <a:sym typeface="Arial"/>
              </a:rPr>
              <a:t> T1 + T7 S) (A) Representative MS spectra averaged across the peaks for the major RNA products. (B) Consensus </a:t>
            </a:r>
            <a:r>
              <a:rPr lang="en-GB" sz="1100" b="0" i="0" u="none" strike="noStrike" cap="none" dirty="0" err="1">
                <a:solidFill>
                  <a:srgbClr val="000000"/>
                </a:solidFill>
                <a:latin typeface="Arial"/>
                <a:ea typeface="Arial"/>
                <a:cs typeface="Arial"/>
                <a:sym typeface="Arial"/>
              </a:rPr>
              <a:t>deconvoluted</a:t>
            </a:r>
            <a:r>
              <a:rPr lang="en-GB" sz="1100" b="0" i="0" u="none" strike="noStrike" cap="none" dirty="0">
                <a:solidFill>
                  <a:srgbClr val="000000"/>
                </a:solidFill>
                <a:latin typeface="Arial"/>
                <a:ea typeface="Arial"/>
                <a:cs typeface="Arial"/>
                <a:sym typeface="Arial"/>
              </a:rPr>
              <a:t> spectrum generated using sliding windows and </a:t>
            </a:r>
            <a:r>
              <a:rPr lang="en-GB" sz="1100" b="0" i="0" u="none" strike="noStrike" cap="none" dirty="0" err="1">
                <a:solidFill>
                  <a:srgbClr val="000000"/>
                </a:solidFill>
                <a:latin typeface="Arial"/>
                <a:ea typeface="Arial"/>
                <a:cs typeface="Arial"/>
                <a:sym typeface="Arial"/>
              </a:rPr>
              <a:t>ReSpect</a:t>
            </a:r>
            <a:r>
              <a:rPr lang="en-GB" sz="1100" b="0" i="0" u="none" strike="noStrike" cap="none" dirty="0">
                <a:solidFill>
                  <a:srgbClr val="000000"/>
                </a:solidFill>
                <a:latin typeface="Arial"/>
                <a:ea typeface="Arial"/>
                <a:cs typeface="Arial"/>
                <a:sym typeface="Arial"/>
              </a:rPr>
              <a:t> algorithm in </a:t>
            </a:r>
            <a:r>
              <a:rPr lang="en-GB" sz="1100" b="0" i="0" u="none" strike="noStrike" cap="none" dirty="0" err="1">
                <a:solidFill>
                  <a:srgbClr val="000000"/>
                </a:solidFill>
                <a:latin typeface="Arial"/>
                <a:ea typeface="Arial"/>
                <a:cs typeface="Arial"/>
                <a:sym typeface="Arial"/>
              </a:rPr>
              <a:t>BiopharmaFinder</a:t>
            </a:r>
            <a:r>
              <a:rPr lang="en-GB" sz="1100" b="0" i="0" u="none" strike="noStrike" cap="none" dirty="0">
                <a:solidFill>
                  <a:srgbClr val="000000"/>
                </a:solidFill>
                <a:latin typeface="Arial"/>
                <a:ea typeface="Arial"/>
                <a:cs typeface="Arial"/>
                <a:sym typeface="Arial"/>
              </a:rPr>
              <a:t>.</a:t>
            </a:r>
            <a:endParaRPr sz="1100" b="0" i="0" u="none" strike="noStrike" cap="none" dirty="0">
              <a:solidFill>
                <a:srgbClr val="000000"/>
              </a:solidFill>
              <a:latin typeface="Arial"/>
              <a:ea typeface="Arial"/>
              <a:cs typeface="Arial"/>
              <a:sym typeface="Arial"/>
            </a:endParaRPr>
          </a:p>
          <a:p>
            <a:pPr marL="0" marR="0" lvl="0" indent="0" algn="l" rtl="0">
              <a:lnSpc>
                <a:spcPct val="2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904"/>
        <p:cNvGrpSpPr/>
        <p:nvPr/>
      </p:nvGrpSpPr>
      <p:grpSpPr>
        <a:xfrm>
          <a:off x="0" y="0"/>
          <a:ext cx="0" cy="0"/>
          <a:chOff x="0" y="0"/>
          <a:chExt cx="0" cy="0"/>
        </a:xfrm>
      </p:grpSpPr>
      <p:pic>
        <p:nvPicPr>
          <p:cNvPr id="1905" name="Google Shape;1905;p17"/>
          <p:cNvPicPr preferRelativeResize="0"/>
          <p:nvPr/>
        </p:nvPicPr>
        <p:blipFill rotWithShape="1">
          <a:blip r:embed="rId3">
            <a:alphaModFix/>
          </a:blip>
          <a:srcRect/>
          <a:stretch/>
        </p:blipFill>
        <p:spPr>
          <a:xfrm>
            <a:off x="982581" y="4226388"/>
            <a:ext cx="5477836" cy="3229814"/>
          </a:xfrm>
          <a:prstGeom prst="rect">
            <a:avLst/>
          </a:prstGeom>
          <a:noFill/>
          <a:ln>
            <a:noFill/>
          </a:ln>
        </p:spPr>
      </p:pic>
      <p:pic>
        <p:nvPicPr>
          <p:cNvPr id="1906" name="Google Shape;1906;p17"/>
          <p:cNvPicPr preferRelativeResize="0"/>
          <p:nvPr/>
        </p:nvPicPr>
        <p:blipFill rotWithShape="1">
          <a:blip r:embed="rId4">
            <a:alphaModFix/>
          </a:blip>
          <a:srcRect/>
          <a:stretch/>
        </p:blipFill>
        <p:spPr>
          <a:xfrm>
            <a:off x="1285319" y="498287"/>
            <a:ext cx="4884986" cy="3229815"/>
          </a:xfrm>
          <a:prstGeom prst="rect">
            <a:avLst/>
          </a:prstGeom>
          <a:noFill/>
          <a:ln>
            <a:noFill/>
          </a:ln>
        </p:spPr>
      </p:pic>
      <p:sp>
        <p:nvSpPr>
          <p:cNvPr id="1907" name="Google Shape;1907;p17"/>
          <p:cNvSpPr txBox="1"/>
          <p:nvPr/>
        </p:nvSpPr>
        <p:spPr>
          <a:xfrm>
            <a:off x="292852" y="263107"/>
            <a:ext cx="408300" cy="470359"/>
          </a:xfrm>
          <a:prstGeom prst="rect">
            <a:avLst/>
          </a:prstGeom>
          <a:noFill/>
          <a:ln>
            <a:noFill/>
          </a:ln>
        </p:spPr>
        <p:txBody>
          <a:bodyPr spcFirstLastPara="1" wrap="square" lIns="100075" tIns="50025" rIns="100075" bIns="50025"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GB" sz="2400" i="0" u="none" strike="noStrike" cap="none" dirty="0">
                <a:solidFill>
                  <a:schemeClr val="dk1"/>
                </a:solidFill>
                <a:latin typeface="+mj-lt"/>
                <a:ea typeface="Calibri"/>
                <a:cs typeface="Calibri"/>
                <a:sym typeface="Calibri"/>
              </a:rPr>
              <a:t>A</a:t>
            </a:r>
            <a:endParaRPr sz="2400" i="0" u="none" strike="noStrike" cap="none" dirty="0">
              <a:solidFill>
                <a:schemeClr val="dk1"/>
              </a:solidFill>
              <a:latin typeface="+mj-lt"/>
              <a:ea typeface="Calibri"/>
              <a:cs typeface="Calibri"/>
              <a:sym typeface="Calibri"/>
            </a:endParaRPr>
          </a:p>
        </p:txBody>
      </p:sp>
      <p:sp>
        <p:nvSpPr>
          <p:cNvPr id="1908" name="Google Shape;1908;p17"/>
          <p:cNvSpPr txBox="1"/>
          <p:nvPr/>
        </p:nvSpPr>
        <p:spPr>
          <a:xfrm>
            <a:off x="292852" y="3991208"/>
            <a:ext cx="408300" cy="470359"/>
          </a:xfrm>
          <a:prstGeom prst="rect">
            <a:avLst/>
          </a:prstGeom>
          <a:noFill/>
          <a:ln>
            <a:noFill/>
          </a:ln>
        </p:spPr>
        <p:txBody>
          <a:bodyPr spcFirstLastPara="1" wrap="square" lIns="100075" tIns="50025" rIns="100075" bIns="50025"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GB" sz="2400" i="0" u="none" strike="noStrike" cap="none" dirty="0">
                <a:solidFill>
                  <a:schemeClr val="dk1"/>
                </a:solidFill>
                <a:latin typeface="+mj-lt"/>
                <a:ea typeface="Calibri"/>
                <a:cs typeface="Calibri"/>
                <a:sym typeface="Calibri"/>
              </a:rPr>
              <a:t>B</a:t>
            </a:r>
            <a:endParaRPr sz="2400" i="0" u="none" strike="noStrike" cap="none" dirty="0">
              <a:solidFill>
                <a:schemeClr val="dk1"/>
              </a:solidFill>
              <a:latin typeface="+mj-lt"/>
              <a:ea typeface="Calibri"/>
              <a:cs typeface="Calibri"/>
              <a:sym typeface="Calibri"/>
            </a:endParaRPr>
          </a:p>
        </p:txBody>
      </p:sp>
      <p:sp>
        <p:nvSpPr>
          <p:cNvPr id="1909" name="Google Shape;1909;p17"/>
          <p:cNvSpPr/>
          <p:nvPr/>
        </p:nvSpPr>
        <p:spPr>
          <a:xfrm>
            <a:off x="701152" y="7560700"/>
            <a:ext cx="6008930" cy="1785064"/>
          </a:xfrm>
          <a:prstGeom prst="rect">
            <a:avLst/>
          </a:prstGeom>
          <a:noFill/>
          <a:ln>
            <a:noFill/>
          </a:ln>
        </p:spPr>
        <p:txBody>
          <a:bodyPr spcFirstLastPara="1" wrap="square" lIns="91425" tIns="45700" rIns="91425" bIns="45700" anchor="t" anchorCtr="0">
            <a:spAutoFit/>
          </a:bodyPr>
          <a:lstStyle/>
          <a:p>
            <a:pPr marL="0" marR="0" lvl="0" indent="0" algn="l" rtl="0">
              <a:lnSpc>
                <a:spcPct val="200000"/>
              </a:lnSpc>
              <a:spcBef>
                <a:spcPts val="0"/>
              </a:spcBef>
              <a:spcAft>
                <a:spcPts val="0"/>
              </a:spcAft>
              <a:buClr>
                <a:srgbClr val="000000"/>
              </a:buClr>
              <a:buSzPts val="1400"/>
              <a:buFont typeface="Arial"/>
              <a:buNone/>
            </a:pPr>
            <a:r>
              <a:rPr lang="en-GB" sz="1100" b="1" i="0" u="none" strike="noStrike" cap="none" dirty="0">
                <a:solidFill>
                  <a:srgbClr val="000000"/>
                </a:solidFill>
                <a:latin typeface="Arial"/>
                <a:ea typeface="Arial"/>
                <a:cs typeface="Arial"/>
                <a:sym typeface="Arial"/>
              </a:rPr>
              <a:t>Supplementary Figure S6 – </a:t>
            </a:r>
            <a:r>
              <a:rPr lang="en-GB" sz="1100" b="0" i="0" u="none" strike="noStrike" cap="none" dirty="0">
                <a:solidFill>
                  <a:srgbClr val="000000"/>
                </a:solidFill>
                <a:latin typeface="Arial"/>
                <a:ea typeface="Arial"/>
                <a:cs typeface="Arial"/>
                <a:sym typeface="Arial"/>
              </a:rPr>
              <a:t>Mass Spectrometry analysis of dsRNA was in vitro transcribed from a linear DNA construct containing three transcriptional terminators (T7 S + </a:t>
            </a:r>
            <a:r>
              <a:rPr lang="en-GB" sz="1100" b="0" i="1" u="none" strike="noStrike" cap="none" dirty="0" err="1">
                <a:solidFill>
                  <a:srgbClr val="000000"/>
                </a:solidFill>
                <a:latin typeface="Arial"/>
                <a:ea typeface="Arial"/>
                <a:cs typeface="Arial"/>
                <a:sym typeface="Arial"/>
              </a:rPr>
              <a:t>rrnB</a:t>
            </a:r>
            <a:r>
              <a:rPr lang="en-GB" sz="1100" b="0" i="0" u="none" strike="noStrike" cap="none" dirty="0">
                <a:solidFill>
                  <a:srgbClr val="000000"/>
                </a:solidFill>
                <a:latin typeface="Arial"/>
                <a:ea typeface="Arial"/>
                <a:cs typeface="Arial"/>
                <a:sym typeface="Arial"/>
              </a:rPr>
              <a:t> T1 + T7 S) (A) Representative MS spectra averaged across the peaks for the major RNA products. (B) Consensus </a:t>
            </a:r>
            <a:r>
              <a:rPr lang="en-GB" sz="1100" b="0" i="0" u="none" strike="noStrike" cap="none" dirty="0" err="1">
                <a:solidFill>
                  <a:srgbClr val="000000"/>
                </a:solidFill>
                <a:latin typeface="Arial"/>
                <a:ea typeface="Arial"/>
                <a:cs typeface="Arial"/>
                <a:sym typeface="Arial"/>
              </a:rPr>
              <a:t>deconvoluted</a:t>
            </a:r>
            <a:r>
              <a:rPr lang="en-GB" sz="1100" b="0" i="0" u="none" strike="noStrike" cap="none" dirty="0">
                <a:solidFill>
                  <a:srgbClr val="000000"/>
                </a:solidFill>
                <a:latin typeface="Arial"/>
                <a:ea typeface="Arial"/>
                <a:cs typeface="Arial"/>
                <a:sym typeface="Arial"/>
              </a:rPr>
              <a:t> spectrum generated using sliding windows and </a:t>
            </a:r>
            <a:r>
              <a:rPr lang="en-GB" sz="1100" b="0" i="0" u="none" strike="noStrike" cap="none" dirty="0" err="1">
                <a:solidFill>
                  <a:srgbClr val="000000"/>
                </a:solidFill>
                <a:latin typeface="Arial"/>
                <a:ea typeface="Arial"/>
                <a:cs typeface="Arial"/>
                <a:sym typeface="Arial"/>
              </a:rPr>
              <a:t>ReSpect</a:t>
            </a:r>
            <a:r>
              <a:rPr lang="en-GB" sz="1100" b="0" i="0" u="none" strike="noStrike" cap="none" dirty="0">
                <a:solidFill>
                  <a:srgbClr val="000000"/>
                </a:solidFill>
                <a:latin typeface="Arial"/>
                <a:ea typeface="Arial"/>
                <a:cs typeface="Arial"/>
                <a:sym typeface="Arial"/>
              </a:rPr>
              <a:t> algorithm in </a:t>
            </a:r>
            <a:r>
              <a:rPr lang="en-GB" sz="1100" b="0" i="0" u="none" strike="noStrike" cap="none" dirty="0" err="1">
                <a:solidFill>
                  <a:srgbClr val="000000"/>
                </a:solidFill>
                <a:latin typeface="Arial"/>
                <a:ea typeface="Arial"/>
                <a:cs typeface="Arial"/>
                <a:sym typeface="Arial"/>
              </a:rPr>
              <a:t>BiopharmaFinder</a:t>
            </a:r>
            <a:r>
              <a:rPr lang="en-GB" sz="1100" b="0" i="0" u="none" strike="noStrike" cap="none" dirty="0">
                <a:solidFill>
                  <a:srgbClr val="000000"/>
                </a:solidFill>
                <a:latin typeface="Arial"/>
                <a:ea typeface="Arial"/>
                <a:cs typeface="Arial"/>
                <a:sym typeface="Arial"/>
              </a:rPr>
              <a:t>.</a:t>
            </a:r>
            <a:endParaRPr sz="1100" b="0" i="0" u="none" strike="noStrike" cap="none" dirty="0">
              <a:solidFill>
                <a:srgbClr val="000000"/>
              </a:solidFill>
              <a:latin typeface="Arial"/>
              <a:ea typeface="Arial"/>
              <a:cs typeface="Arial"/>
              <a:sym typeface="Aria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921"/>
        <p:cNvGrpSpPr/>
        <p:nvPr/>
      </p:nvGrpSpPr>
      <p:grpSpPr>
        <a:xfrm>
          <a:off x="0" y="0"/>
          <a:ext cx="0" cy="0"/>
          <a:chOff x="0" y="0"/>
          <a:chExt cx="0" cy="0"/>
        </a:xfrm>
      </p:grpSpPr>
      <p:graphicFrame>
        <p:nvGraphicFramePr>
          <p:cNvPr id="1922" name="Google Shape;1922;p19"/>
          <p:cNvGraphicFramePr/>
          <p:nvPr>
            <p:extLst>
              <p:ext uri="{D42A27DB-BD31-4B8C-83A1-F6EECF244321}">
                <p14:modId xmlns:p14="http://schemas.microsoft.com/office/powerpoint/2010/main" val="2477177200"/>
              </p:ext>
            </p:extLst>
          </p:nvPr>
        </p:nvGraphicFramePr>
        <p:xfrm>
          <a:off x="276213" y="1709305"/>
          <a:ext cx="6731375" cy="3160023"/>
        </p:xfrm>
        <a:graphic>
          <a:graphicData uri="http://schemas.openxmlformats.org/drawingml/2006/table">
            <a:tbl>
              <a:tblPr>
                <a:tableStyleId>{2D5ABB26-0587-4C30-8999-92F81FD0307C}</a:tableStyleId>
              </a:tblPr>
              <a:tblGrid>
                <a:gridCol w="1120787">
                  <a:extLst>
                    <a:ext uri="{9D8B030D-6E8A-4147-A177-3AD203B41FA5}">
                      <a16:colId xmlns:a16="http://schemas.microsoft.com/office/drawing/2014/main" val="20000"/>
                    </a:ext>
                  </a:extLst>
                </a:gridCol>
                <a:gridCol w="1171388">
                  <a:extLst>
                    <a:ext uri="{9D8B030D-6E8A-4147-A177-3AD203B41FA5}">
                      <a16:colId xmlns:a16="http://schemas.microsoft.com/office/drawing/2014/main" val="20001"/>
                    </a:ext>
                  </a:extLst>
                </a:gridCol>
                <a:gridCol w="2447375">
                  <a:extLst>
                    <a:ext uri="{9D8B030D-6E8A-4147-A177-3AD203B41FA5}">
                      <a16:colId xmlns:a16="http://schemas.microsoft.com/office/drawing/2014/main" val="20002"/>
                    </a:ext>
                  </a:extLst>
                </a:gridCol>
                <a:gridCol w="762737">
                  <a:extLst>
                    <a:ext uri="{9D8B030D-6E8A-4147-A177-3AD203B41FA5}">
                      <a16:colId xmlns:a16="http://schemas.microsoft.com/office/drawing/2014/main" val="20003"/>
                    </a:ext>
                  </a:extLst>
                </a:gridCol>
                <a:gridCol w="1229088">
                  <a:extLst>
                    <a:ext uri="{9D8B030D-6E8A-4147-A177-3AD203B41FA5}">
                      <a16:colId xmlns:a16="http://schemas.microsoft.com/office/drawing/2014/main" val="20004"/>
                    </a:ext>
                  </a:extLst>
                </a:gridCol>
              </a:tblGrid>
              <a:tr h="542925">
                <a:tc>
                  <a:txBody>
                    <a:bodyPr/>
                    <a:lstStyle/>
                    <a:p>
                      <a:pPr marL="0" marR="0" lvl="0" indent="0" algn="l" rtl="0">
                        <a:lnSpc>
                          <a:spcPct val="115000"/>
                        </a:lnSpc>
                        <a:spcBef>
                          <a:spcPts val="0"/>
                        </a:spcBef>
                        <a:spcAft>
                          <a:spcPts val="0"/>
                        </a:spcAft>
                        <a:buClr>
                          <a:srgbClr val="000000"/>
                        </a:buClr>
                        <a:buSzPts val="1000"/>
                        <a:buFont typeface="Arial"/>
                        <a:buNone/>
                      </a:pPr>
                      <a:r>
                        <a:rPr lang="en-GB" sz="1000" b="1" u="none" strike="noStrike" cap="none" dirty="0"/>
                        <a:t>Transcriptional   terminator </a:t>
                      </a:r>
                      <a:endParaRPr sz="1000" b="1" u="none" strike="noStrike" cap="none" dirty="0"/>
                    </a:p>
                  </a:txBody>
                  <a:tcPr marL="68575" marR="68575" marT="91425" marB="91425">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b="1" u="none" strike="noStrike" cap="none" dirty="0"/>
                        <a:t>Terminator</a:t>
                      </a:r>
                      <a:endParaRPr sz="1000" b="1"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b="1" u="none" strike="noStrike" cap="none" dirty="0"/>
                        <a:t>Sequence (5’-3’)</a:t>
                      </a:r>
                      <a:endParaRPr sz="1000" b="1"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b="1" u="none" strike="noStrike" cap="none" dirty="0"/>
                        <a:t>Size (</a:t>
                      </a:r>
                      <a:r>
                        <a:rPr lang="en-GB" sz="1000" b="1" u="none" strike="noStrike" cap="none" dirty="0" err="1"/>
                        <a:t>Bp</a:t>
                      </a:r>
                      <a:r>
                        <a:rPr lang="en-GB" sz="1000" b="1" u="none" strike="noStrike" cap="none" dirty="0"/>
                        <a:t>)</a:t>
                      </a:r>
                      <a:endParaRPr sz="1000" b="1"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b="1" u="none" strike="noStrike" cap="none" dirty="0"/>
                        <a:t>Source </a:t>
                      </a:r>
                      <a:endParaRPr sz="1000" b="1" u="none" strike="noStrike" cap="none" dirty="0"/>
                    </a:p>
                  </a:txBody>
                  <a:tcPr marL="68575" marR="68575" marT="91425" marB="91425">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542925">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err="1"/>
                        <a:t>rrnB</a:t>
                      </a:r>
                      <a:r>
                        <a:rPr lang="en-GB" sz="1000" u="none" strike="noStrike" cap="none" dirty="0"/>
                        <a:t> T1</a:t>
                      </a:r>
                      <a:endParaRPr sz="1000" u="none" strike="noStrike" cap="none" dirty="0"/>
                    </a:p>
                  </a:txBody>
                  <a:tcPr marL="68575" marR="68575" marT="91425" marB="91425">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Endogenous </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CAAATAAAACGAAAGGCTCAGTCGAAAGACTGGGCCTTTCGTTTTATCTGTTGTTTGTCGGTGAACGCTCTC</a:t>
                      </a:r>
                      <a:endParaRPr sz="1000" u="none" strike="noStrike" cap="none" dirty="0">
                        <a:solidFill>
                          <a:srgbClr val="FF0000"/>
                        </a:solidFill>
                      </a:endParaRPr>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72</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l" rtl="0">
                        <a:lnSpc>
                          <a:spcPct val="115000"/>
                        </a:lnSpc>
                        <a:spcBef>
                          <a:spcPts val="0"/>
                        </a:spcBef>
                        <a:spcAft>
                          <a:spcPts val="0"/>
                        </a:spcAft>
                        <a:buClr>
                          <a:srgbClr val="000000"/>
                        </a:buClr>
                        <a:buSzPts val="1100"/>
                        <a:buFont typeface="Arial"/>
                        <a:buNone/>
                      </a:pPr>
                      <a:endParaRPr sz="1100" u="none" strike="noStrike" cap="none"/>
                    </a:p>
                    <a:p>
                      <a:pPr marL="0" marR="0" lvl="0" indent="0" algn="l" rtl="0">
                        <a:lnSpc>
                          <a:spcPct val="115000"/>
                        </a:lnSpc>
                        <a:spcBef>
                          <a:spcPts val="0"/>
                        </a:spcBef>
                        <a:spcAft>
                          <a:spcPts val="0"/>
                        </a:spcAft>
                        <a:buClr>
                          <a:srgbClr val="000000"/>
                        </a:buClr>
                        <a:buSzPts val="1000"/>
                        <a:buFont typeface="Arial"/>
                        <a:buNone/>
                      </a:pPr>
                      <a:r>
                        <a:rPr lang="en-GB" sz="1000" u="none" strike="noStrike" cap="none"/>
                        <a:t>Mairhofer et al. (2015)</a:t>
                      </a:r>
                      <a:endParaRPr sz="900" u="none" strike="noStrike" cap="none"/>
                    </a:p>
                  </a:txBody>
                  <a:tcPr marL="68575" marR="68575" marT="91425" marB="91425">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1"/>
                  </a:ext>
                </a:extLst>
              </a:tr>
              <a:tr h="542925">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T7 S</a:t>
                      </a:r>
                      <a:endParaRPr sz="1000" u="none" strike="noStrike" cap="none" dirty="0"/>
                    </a:p>
                  </a:txBody>
                  <a:tcPr marL="68575" marR="68575" marT="91425" marB="91425">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Synthetic </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AACCCCGCGGGGCCTCTTCGGGGGTCTCGCGGGGTTTTTTG</a:t>
                      </a:r>
                      <a:endParaRPr sz="1000" u="none" strike="noStrike" cap="none" dirty="0">
                        <a:solidFill>
                          <a:srgbClr val="FF0000"/>
                        </a:solidFill>
                      </a:endParaRPr>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41</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endParaRPr sz="1000" u="none" strike="noStrike" cap="none"/>
                    </a:p>
                    <a:p>
                      <a:pPr marL="0" marR="0" lvl="0" indent="0" algn="l" rtl="0">
                        <a:lnSpc>
                          <a:spcPct val="115000"/>
                        </a:lnSpc>
                        <a:spcBef>
                          <a:spcPts val="0"/>
                        </a:spcBef>
                        <a:spcAft>
                          <a:spcPts val="0"/>
                        </a:spcAft>
                        <a:buClr>
                          <a:srgbClr val="000000"/>
                        </a:buClr>
                        <a:buSzPts val="1000"/>
                        <a:buFont typeface="Arial"/>
                        <a:buNone/>
                      </a:pPr>
                      <a:r>
                        <a:rPr lang="en-GB" sz="1000" u="none" strike="noStrike" cap="none"/>
                        <a:t>Mairhofer et al. (2015)</a:t>
                      </a:r>
                      <a:endParaRPr sz="1000" u="none" strike="noStrike" cap="none"/>
                    </a:p>
                  </a:txBody>
                  <a:tcPr marL="68575" marR="68575" marT="91425" marB="91425">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10002"/>
                  </a:ext>
                </a:extLst>
              </a:tr>
              <a:tr h="295275">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T7hyb6</a:t>
                      </a:r>
                      <a:endParaRPr sz="1000" u="none" strike="noStrike" cap="none" dirty="0"/>
                    </a:p>
                  </a:txBody>
                  <a:tcPr marL="68575" marR="68575" marT="91425" marB="91425">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Synthetic</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AGATAACAGATACTTCGGTATCTGTTATCTGTTTTTTT</a:t>
                      </a:r>
                      <a:endParaRPr sz="1000" u="none" strike="noStrike" cap="none" dirty="0">
                        <a:solidFill>
                          <a:srgbClr val="FF0000"/>
                        </a:solidFill>
                      </a:endParaRPr>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39</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err="1"/>
                        <a:t>Calvopina</a:t>
                      </a:r>
                      <a:r>
                        <a:rPr lang="en-GB" sz="1000" u="none" strike="noStrike" cap="none" dirty="0"/>
                        <a:t>-Chavez et al. (2022)</a:t>
                      </a:r>
                      <a:endParaRPr sz="1000" u="none" strike="noStrike" cap="none" dirty="0">
                        <a:solidFill>
                          <a:schemeClr val="dk1"/>
                        </a:solidFill>
                      </a:endParaRPr>
                    </a:p>
                  </a:txBody>
                  <a:tcPr marL="68575" marR="68575" marT="91425" marB="91425">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10003"/>
                  </a:ext>
                </a:extLst>
              </a:tr>
              <a:tr h="542925">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T7hyb10 </a:t>
                      </a:r>
                      <a:endParaRPr sz="1000" u="none" strike="noStrike" cap="none" dirty="0"/>
                    </a:p>
                  </a:txBody>
                  <a:tcPr marL="68575" marR="68575" marT="91425" marB="91425">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Synthetic </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AGATAACAGATACTTCGGTATCTGTTATCTGTTTTTTTCAACAGATAGCCGCGTTCGCGCGGCTATCTGTTTTTTTT</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rgbClr val="000000"/>
                        </a:buClr>
                        <a:buSzPts val="1000"/>
                        <a:buFont typeface="Arial"/>
                        <a:buNone/>
                      </a:pPr>
                      <a:r>
                        <a:rPr lang="en-GB" sz="1000" u="none" strike="noStrike" cap="none" dirty="0"/>
                        <a:t>78</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marL="0" marR="0" lvl="0" indent="0" algn="l" rtl="0">
                        <a:lnSpc>
                          <a:spcPct val="115000"/>
                        </a:lnSpc>
                        <a:spcBef>
                          <a:spcPts val="0"/>
                        </a:spcBef>
                        <a:spcAft>
                          <a:spcPts val="0"/>
                        </a:spcAft>
                        <a:buClr>
                          <a:schemeClr val="dk1"/>
                        </a:buClr>
                        <a:buSzPts val="1100"/>
                        <a:buFont typeface="Arial"/>
                        <a:buNone/>
                      </a:pPr>
                      <a:r>
                        <a:rPr lang="en-GB" sz="1000" u="none" strike="noStrike" cap="none" dirty="0" err="1"/>
                        <a:t>Calvopina</a:t>
                      </a:r>
                      <a:r>
                        <a:rPr lang="en-GB" sz="1000" u="none" strike="noStrike" cap="none" dirty="0"/>
                        <a:t>-Chavez et al. (2022)</a:t>
                      </a:r>
                      <a:endParaRPr sz="1000" u="none" strike="noStrike" cap="none" dirty="0"/>
                    </a:p>
                  </a:txBody>
                  <a:tcPr marL="68575" marR="68575" marT="91425" marB="91425">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10004"/>
                  </a:ext>
                </a:extLst>
              </a:tr>
            </a:tbl>
          </a:graphicData>
        </a:graphic>
      </p:graphicFrame>
      <p:sp>
        <p:nvSpPr>
          <p:cNvPr id="1923" name="Google Shape;1923;p19"/>
          <p:cNvSpPr txBox="1"/>
          <p:nvPr/>
        </p:nvSpPr>
        <p:spPr>
          <a:xfrm>
            <a:off x="276213" y="157700"/>
            <a:ext cx="6925800" cy="1508075"/>
          </a:xfrm>
          <a:prstGeom prst="rect">
            <a:avLst/>
          </a:prstGeom>
          <a:noFill/>
          <a:ln>
            <a:noFill/>
          </a:ln>
        </p:spPr>
        <p:txBody>
          <a:bodyPr spcFirstLastPara="1" wrap="square" lIns="91425" tIns="91425" rIns="91425" bIns="91425" anchor="t" anchorCtr="0">
            <a:spAutoFit/>
          </a:bodyPr>
          <a:lstStyle/>
          <a:p>
            <a:pPr marL="0" marR="0" lvl="0" indent="0" algn="l" rtl="0">
              <a:lnSpc>
                <a:spcPct val="200000"/>
              </a:lnSpc>
              <a:spcBef>
                <a:spcPts val="1200"/>
              </a:spcBef>
              <a:spcAft>
                <a:spcPts val="1200"/>
              </a:spcAft>
              <a:buClr>
                <a:srgbClr val="000000"/>
              </a:buClr>
              <a:buSzPts val="1000"/>
              <a:buFont typeface="Arial"/>
              <a:buNone/>
            </a:pPr>
            <a:r>
              <a:rPr lang="en-GB" sz="1100" b="1" i="0" u="none" strike="noStrike" cap="none" dirty="0">
                <a:solidFill>
                  <a:schemeClr val="dk1"/>
                </a:solidFill>
                <a:latin typeface="Arial"/>
                <a:ea typeface="Arial"/>
                <a:cs typeface="Arial"/>
                <a:sym typeface="Arial"/>
              </a:rPr>
              <a:t>Supplementary Table 1.</a:t>
            </a:r>
            <a:r>
              <a:rPr lang="en-GB" sz="1100" b="0" i="0" u="none" strike="noStrike" cap="none" dirty="0">
                <a:solidFill>
                  <a:schemeClr val="dk1"/>
                </a:solidFill>
                <a:latin typeface="Arial"/>
                <a:ea typeface="Arial"/>
                <a:cs typeface="Arial"/>
                <a:sym typeface="Arial"/>
              </a:rPr>
              <a:t> </a:t>
            </a:r>
            <a:r>
              <a:rPr lang="en-GB" sz="1100" b="1" i="0" u="none" strike="noStrike" cap="none" dirty="0">
                <a:solidFill>
                  <a:schemeClr val="dk1"/>
                </a:solidFill>
                <a:latin typeface="Arial"/>
                <a:ea typeface="Arial"/>
                <a:cs typeface="Arial"/>
                <a:sym typeface="Arial"/>
              </a:rPr>
              <a:t>List of transcription terminator sequences used within this study. </a:t>
            </a:r>
            <a:r>
              <a:rPr lang="en-GB" sz="1100" b="0" i="0" u="none" strike="noStrike" cap="none" dirty="0">
                <a:solidFill>
                  <a:schemeClr val="dk1"/>
                </a:solidFill>
                <a:latin typeface="Arial"/>
                <a:ea typeface="Arial"/>
                <a:cs typeface="Arial"/>
                <a:sym typeface="Arial"/>
              </a:rPr>
              <a:t>Transcriptional terminator sequences (5’-3’) are indicated below. The length of the total sequence is indicated (</a:t>
            </a:r>
            <a:r>
              <a:rPr lang="en-GB" sz="1100" b="0" i="0" u="none" strike="noStrike" cap="none" dirty="0" err="1">
                <a:solidFill>
                  <a:schemeClr val="dk1"/>
                </a:solidFill>
                <a:latin typeface="Arial"/>
                <a:ea typeface="Arial"/>
                <a:cs typeface="Arial"/>
                <a:sym typeface="Arial"/>
              </a:rPr>
              <a:t>bp</a:t>
            </a:r>
            <a:r>
              <a:rPr lang="en-GB" sz="1100" b="0" i="0" u="none" strike="noStrike" cap="none" dirty="0">
                <a:solidFill>
                  <a:schemeClr val="dk1"/>
                </a:solidFill>
                <a:latin typeface="Arial"/>
                <a:ea typeface="Arial"/>
                <a:cs typeface="Arial"/>
                <a:sym typeface="Arial"/>
              </a:rPr>
              <a:t>), as well as where they were sourced from. </a:t>
            </a:r>
            <a:endParaRPr sz="1100" b="0" i="0" u="none" strike="noStrike" cap="none" dirty="0">
              <a:solidFill>
                <a:schemeClr val="dk1"/>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40</TotalTime>
  <Words>1781</Words>
  <Application>Microsoft Office PowerPoint</Application>
  <PresentationFormat>Custom</PresentationFormat>
  <Paragraphs>257</Paragraphs>
  <Slides>7</Slides>
  <Notes>7</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7</vt:i4>
      </vt:variant>
    </vt:vector>
  </HeadingPairs>
  <TitlesOfParts>
    <vt:vector size="10"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mes Hough</dc:creator>
  <cp:lastModifiedBy>Sebastian Ross</cp:lastModifiedBy>
  <cp:revision>14</cp:revision>
  <dcterms:created xsi:type="dcterms:W3CDTF">2022-08-03T09:49:44Z</dcterms:created>
  <dcterms:modified xsi:type="dcterms:W3CDTF">2024-01-05T14:40:21Z</dcterms:modified>
</cp:coreProperties>
</file>